
<file path=[Content_Types].xml><?xml version="1.0" encoding="utf-8"?>
<Types xmlns="http://schemas.openxmlformats.org/package/2006/content-types">
  <Default Extension="jpeg" ContentType="image/jpe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0.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1.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12.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13.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14.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15.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notesSlides/notesSlide16.xml" ContentType="application/vnd.openxmlformats-officedocument.presentationml.notesSlide+xml"/>
  <Override PartName="/ppt/diagrams/data11.xml" ContentType="application/vnd.openxmlformats-officedocument.drawingml.diagramData+xml"/>
  <Override PartName="/ppt/diagrams/layout11.xml" ContentType="application/vnd.openxmlformats-officedocument.drawingml.diagramLayout+xml"/>
  <Override PartName="/ppt/diagrams/quickStyle11.xml" ContentType="application/vnd.openxmlformats-officedocument.drawingml.diagramStyle+xml"/>
  <Override PartName="/ppt/diagrams/colors11.xml" ContentType="application/vnd.openxmlformats-officedocument.drawingml.diagramColors+xml"/>
  <Override PartName="/ppt/diagrams/drawing11.xml" ContentType="application/vnd.ms-office.drawingml.diagramDrawing+xml"/>
  <Override PartName="/ppt/notesSlides/notesSlide17.xml" ContentType="application/vnd.openxmlformats-officedocument.presentationml.notesSlide+xml"/>
  <Override PartName="/ppt/diagrams/data12.xml" ContentType="application/vnd.openxmlformats-officedocument.drawingml.diagramData+xml"/>
  <Override PartName="/ppt/diagrams/layout12.xml" ContentType="application/vnd.openxmlformats-officedocument.drawingml.diagramLayout+xml"/>
  <Override PartName="/ppt/diagrams/quickStyle12.xml" ContentType="application/vnd.openxmlformats-officedocument.drawingml.diagramStyle+xml"/>
  <Override PartName="/ppt/diagrams/colors12.xml" ContentType="application/vnd.openxmlformats-officedocument.drawingml.diagramColors+xml"/>
  <Override PartName="/ppt/diagrams/drawing12.xml" ContentType="application/vnd.ms-office.drawingml.diagramDrawing+xml"/>
  <Override PartName="/ppt/notesSlides/notesSlide18.xml" ContentType="application/vnd.openxmlformats-officedocument.presentationml.notesSlide+xml"/>
  <Override PartName="/ppt/diagrams/data13.xml" ContentType="application/vnd.openxmlformats-officedocument.drawingml.diagramData+xml"/>
  <Override PartName="/ppt/diagrams/layout13.xml" ContentType="application/vnd.openxmlformats-officedocument.drawingml.diagramLayout+xml"/>
  <Override PartName="/ppt/diagrams/quickStyle13.xml" ContentType="application/vnd.openxmlformats-officedocument.drawingml.diagramStyle+xml"/>
  <Override PartName="/ppt/diagrams/colors13.xml" ContentType="application/vnd.openxmlformats-officedocument.drawingml.diagramColors+xml"/>
  <Override PartName="/ppt/diagrams/drawing13.xml" ContentType="application/vnd.ms-office.drawingml.diagramDrawing+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52" r:id="rId1"/>
  </p:sldMasterIdLst>
  <p:notesMasterIdLst>
    <p:notesMasterId r:id="rId20"/>
  </p:notesMasterIdLst>
  <p:sldIdLst>
    <p:sldId id="256" r:id="rId2"/>
    <p:sldId id="390" r:id="rId3"/>
    <p:sldId id="391" r:id="rId4"/>
    <p:sldId id="258" r:id="rId5"/>
    <p:sldId id="392" r:id="rId6"/>
    <p:sldId id="393" r:id="rId7"/>
    <p:sldId id="395" r:id="rId8"/>
    <p:sldId id="262" r:id="rId9"/>
    <p:sldId id="261" r:id="rId10"/>
    <p:sldId id="401" r:id="rId11"/>
    <p:sldId id="259" r:id="rId12"/>
    <p:sldId id="396" r:id="rId13"/>
    <p:sldId id="263" r:id="rId14"/>
    <p:sldId id="260" r:id="rId15"/>
    <p:sldId id="399" r:id="rId16"/>
    <p:sldId id="400" r:id="rId17"/>
    <p:sldId id="402" r:id="rId18"/>
    <p:sldId id="397" r:id="rId1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E163D9A7-4F28-1E89-8DC0-8C454E0E4BDA}" name="Vermylen, Julia" initials="JV" userId="S::juhubert@nm.org::6f535ec1-c950-42be-967f-847a4b22a531"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1348"/>
    <p:restoredTop sz="72442"/>
  </p:normalViewPr>
  <p:slideViewPr>
    <p:cSldViewPr snapToGrid="0">
      <p:cViewPr varScale="1">
        <p:scale>
          <a:sx n="90" d="100"/>
          <a:sy n="90" d="100"/>
        </p:scale>
        <p:origin x="448"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microsoft.com/office/2018/10/relationships/authors" Target="author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diagrams/_rels/data1.xml.rels><?xml version="1.0" encoding="UTF-8" standalone="yes"?>
<Relationships xmlns="http://schemas.openxmlformats.org/package/2006/relationships"><Relationship Id="rId3" Type="http://schemas.openxmlformats.org/officeDocument/2006/relationships/image" Target="../media/image4.svg"/><Relationship Id="rId2" Type="http://schemas.openxmlformats.org/officeDocument/2006/relationships/image" Target="../media/image3.svg"/><Relationship Id="rId1" Type="http://schemas.openxmlformats.org/officeDocument/2006/relationships/image" Target="../media/image2.svg"/><Relationship Id="rId6" Type="http://schemas.openxmlformats.org/officeDocument/2006/relationships/image" Target="../media/image7.svg"/><Relationship Id="rId5" Type="http://schemas.openxmlformats.org/officeDocument/2006/relationships/image" Target="../media/image6.svg"/><Relationship Id="rId4" Type="http://schemas.openxmlformats.org/officeDocument/2006/relationships/image" Target="../media/image5.svg"/></Relationships>
</file>

<file path=ppt/diagrams/_rels/data11.xml.rels><?xml version="1.0" encoding="UTF-8" standalone="yes"?>
<Relationships xmlns="http://schemas.openxmlformats.org/package/2006/relationships"><Relationship Id="rId2" Type="http://schemas.openxmlformats.org/officeDocument/2006/relationships/image" Target="../media/image19.svg"/><Relationship Id="rId1" Type="http://schemas.openxmlformats.org/officeDocument/2006/relationships/image" Target="../media/image18.svg"/></Relationships>
</file>

<file path=ppt/diagrams/_rels/data12.xml.rels><?xml version="1.0" encoding="UTF-8" standalone="yes"?>
<Relationships xmlns="http://schemas.openxmlformats.org/package/2006/relationships"><Relationship Id="rId3" Type="http://schemas.openxmlformats.org/officeDocument/2006/relationships/image" Target="../media/image22.svg"/><Relationship Id="rId2" Type="http://schemas.openxmlformats.org/officeDocument/2006/relationships/image" Target="../media/image21.svg"/><Relationship Id="rId1" Type="http://schemas.openxmlformats.org/officeDocument/2006/relationships/image" Target="../media/image20.svg"/><Relationship Id="rId6" Type="http://schemas.openxmlformats.org/officeDocument/2006/relationships/image" Target="../media/image25.svg"/><Relationship Id="rId5" Type="http://schemas.openxmlformats.org/officeDocument/2006/relationships/image" Target="../media/image24.svg"/><Relationship Id="rId4" Type="http://schemas.openxmlformats.org/officeDocument/2006/relationships/image" Target="../media/image23.svg"/></Relationships>
</file>

<file path=ppt/diagrams/_rels/data13.xml.rels><?xml version="1.0" encoding="UTF-8" standalone="yes"?>
<Relationships xmlns="http://schemas.openxmlformats.org/package/2006/relationships"><Relationship Id="rId3" Type="http://schemas.openxmlformats.org/officeDocument/2006/relationships/image" Target="../media/image28.svg"/><Relationship Id="rId2" Type="http://schemas.openxmlformats.org/officeDocument/2006/relationships/image" Target="../media/image27.svg"/><Relationship Id="rId1" Type="http://schemas.openxmlformats.org/officeDocument/2006/relationships/image" Target="../media/image26.svg"/></Relationships>
</file>

<file path=ppt/diagrams/_rels/data2.xml.rels><?xml version="1.0" encoding="UTF-8" standalone="yes"?>
<Relationships xmlns="http://schemas.openxmlformats.org/package/2006/relationships"><Relationship Id="rId2" Type="http://schemas.openxmlformats.org/officeDocument/2006/relationships/image" Target="../media/image9.svg"/><Relationship Id="rId1" Type="http://schemas.openxmlformats.org/officeDocument/2006/relationships/image" Target="../media/image8.svg"/></Relationships>
</file>

<file path=ppt/diagrams/_rels/data4.xml.rels><?xml version="1.0" encoding="UTF-8" standalone="yes"?>
<Relationships xmlns="http://schemas.openxmlformats.org/package/2006/relationships"><Relationship Id="rId2" Type="http://schemas.openxmlformats.org/officeDocument/2006/relationships/image" Target="../media/image11.svg"/><Relationship Id="rId1" Type="http://schemas.openxmlformats.org/officeDocument/2006/relationships/image" Target="../media/image10.svg"/></Relationships>
</file>

<file path=ppt/diagrams/_rels/data5.xml.rels><?xml version="1.0" encoding="UTF-8" standalone="yes"?>
<Relationships xmlns="http://schemas.openxmlformats.org/package/2006/relationships"><Relationship Id="rId3" Type="http://schemas.openxmlformats.org/officeDocument/2006/relationships/image" Target="../media/image14.svg"/><Relationship Id="rId2" Type="http://schemas.openxmlformats.org/officeDocument/2006/relationships/image" Target="../media/image13.svg"/><Relationship Id="rId1" Type="http://schemas.openxmlformats.org/officeDocument/2006/relationships/image" Target="../media/image12.svg"/></Relationships>
</file>

<file path=ppt/diagrams/_rels/data8.xml.rels><?xml version="1.0" encoding="UTF-8" standalone="yes"?>
<Relationships xmlns="http://schemas.openxmlformats.org/package/2006/relationships"><Relationship Id="rId3" Type="http://schemas.openxmlformats.org/officeDocument/2006/relationships/image" Target="../media/image17.svg"/><Relationship Id="rId2" Type="http://schemas.openxmlformats.org/officeDocument/2006/relationships/image" Target="../media/image16.svg"/><Relationship Id="rId1" Type="http://schemas.openxmlformats.org/officeDocument/2006/relationships/image" Target="../media/image15.svg"/></Relationships>
</file>

<file path=ppt/diagrams/_rels/drawing1.xml.rels><?xml version="1.0" encoding="UTF-8" standalone="yes"?>
<Relationships xmlns="http://schemas.openxmlformats.org/package/2006/relationships"><Relationship Id="rId3" Type="http://schemas.openxmlformats.org/officeDocument/2006/relationships/image" Target="../media/image4.svg"/><Relationship Id="rId2" Type="http://schemas.openxmlformats.org/officeDocument/2006/relationships/image" Target="../media/image3.svg"/><Relationship Id="rId1" Type="http://schemas.openxmlformats.org/officeDocument/2006/relationships/image" Target="../media/image2.svg"/><Relationship Id="rId6" Type="http://schemas.openxmlformats.org/officeDocument/2006/relationships/image" Target="../media/image7.svg"/><Relationship Id="rId5" Type="http://schemas.openxmlformats.org/officeDocument/2006/relationships/image" Target="../media/image6.svg"/><Relationship Id="rId4" Type="http://schemas.openxmlformats.org/officeDocument/2006/relationships/image" Target="../media/image5.svg"/></Relationships>
</file>

<file path=ppt/diagrams/_rels/drawing11.xml.rels><?xml version="1.0" encoding="UTF-8" standalone="yes"?>
<Relationships xmlns="http://schemas.openxmlformats.org/package/2006/relationships"><Relationship Id="rId2" Type="http://schemas.openxmlformats.org/officeDocument/2006/relationships/image" Target="../media/image19.svg"/><Relationship Id="rId1" Type="http://schemas.openxmlformats.org/officeDocument/2006/relationships/image" Target="../media/image18.svg"/></Relationships>
</file>

<file path=ppt/diagrams/_rels/drawing12.xml.rels><?xml version="1.0" encoding="UTF-8" standalone="yes"?>
<Relationships xmlns="http://schemas.openxmlformats.org/package/2006/relationships"><Relationship Id="rId3" Type="http://schemas.openxmlformats.org/officeDocument/2006/relationships/image" Target="../media/image22.svg"/><Relationship Id="rId2" Type="http://schemas.openxmlformats.org/officeDocument/2006/relationships/image" Target="../media/image21.svg"/><Relationship Id="rId1" Type="http://schemas.openxmlformats.org/officeDocument/2006/relationships/image" Target="../media/image20.svg"/><Relationship Id="rId6" Type="http://schemas.openxmlformats.org/officeDocument/2006/relationships/image" Target="../media/image25.svg"/><Relationship Id="rId5" Type="http://schemas.openxmlformats.org/officeDocument/2006/relationships/image" Target="../media/image24.svg"/><Relationship Id="rId4" Type="http://schemas.openxmlformats.org/officeDocument/2006/relationships/image" Target="../media/image23.svg"/></Relationships>
</file>

<file path=ppt/diagrams/_rels/drawing13.xml.rels><?xml version="1.0" encoding="UTF-8" standalone="yes"?>
<Relationships xmlns="http://schemas.openxmlformats.org/package/2006/relationships"><Relationship Id="rId3" Type="http://schemas.openxmlformats.org/officeDocument/2006/relationships/image" Target="../media/image28.svg"/><Relationship Id="rId2" Type="http://schemas.openxmlformats.org/officeDocument/2006/relationships/image" Target="../media/image27.svg"/><Relationship Id="rId1" Type="http://schemas.openxmlformats.org/officeDocument/2006/relationships/image" Target="../media/image26.svg"/></Relationships>
</file>

<file path=ppt/diagrams/_rels/drawing2.xml.rels><?xml version="1.0" encoding="UTF-8" standalone="yes"?>
<Relationships xmlns="http://schemas.openxmlformats.org/package/2006/relationships"><Relationship Id="rId2" Type="http://schemas.openxmlformats.org/officeDocument/2006/relationships/image" Target="../media/image9.svg"/><Relationship Id="rId1" Type="http://schemas.openxmlformats.org/officeDocument/2006/relationships/image" Target="../media/image8.svg"/></Relationships>
</file>

<file path=ppt/diagrams/_rels/drawing4.xml.rels><?xml version="1.0" encoding="UTF-8" standalone="yes"?>
<Relationships xmlns="http://schemas.openxmlformats.org/package/2006/relationships"><Relationship Id="rId2" Type="http://schemas.openxmlformats.org/officeDocument/2006/relationships/image" Target="../media/image11.svg"/><Relationship Id="rId1" Type="http://schemas.openxmlformats.org/officeDocument/2006/relationships/image" Target="../media/image10.svg"/></Relationships>
</file>

<file path=ppt/diagrams/_rels/drawing5.xml.rels><?xml version="1.0" encoding="UTF-8" standalone="yes"?>
<Relationships xmlns="http://schemas.openxmlformats.org/package/2006/relationships"><Relationship Id="rId3" Type="http://schemas.openxmlformats.org/officeDocument/2006/relationships/image" Target="../media/image14.svg"/><Relationship Id="rId2" Type="http://schemas.openxmlformats.org/officeDocument/2006/relationships/image" Target="../media/image13.svg"/><Relationship Id="rId1" Type="http://schemas.openxmlformats.org/officeDocument/2006/relationships/image" Target="../media/image12.svg"/></Relationships>
</file>

<file path=ppt/diagrams/_rels/drawing8.xml.rels><?xml version="1.0" encoding="UTF-8" standalone="yes"?>
<Relationships xmlns="http://schemas.openxmlformats.org/package/2006/relationships"><Relationship Id="rId3" Type="http://schemas.openxmlformats.org/officeDocument/2006/relationships/image" Target="../media/image17.svg"/><Relationship Id="rId2" Type="http://schemas.openxmlformats.org/officeDocument/2006/relationships/image" Target="../media/image16.svg"/><Relationship Id="rId1" Type="http://schemas.openxmlformats.org/officeDocument/2006/relationships/image" Target="../media/image15.svg"/></Relationships>
</file>

<file path=ppt/diagrams/colors1.xml><?xml version="1.0" encoding="utf-8"?>
<dgm:colorsDef xmlns:dgm="http://schemas.openxmlformats.org/drawingml/2006/diagram" xmlns:a="http://schemas.openxmlformats.org/drawingml/2006/main" uniqueId="urn:microsoft.com/office/officeart/2018/5/colors/Iconchunking_neutralbg_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a:alpha val="0"/>
      </a:schemeClr>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1.xml><?xml version="1.0" encoding="utf-8"?>
<dgm:colorsDef xmlns:dgm="http://schemas.openxmlformats.org/drawingml/2006/diagram" xmlns:a="http://schemas.openxmlformats.org/drawingml/2006/main" uniqueId="urn:microsoft.com/office/officeart/2018/5/colors/Iconchunking_neutralbg_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a:alpha val="0"/>
      </a:schemeClr>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18/5/colors/Iconchunking_neutralbg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18/5/colors/Iconchunking_neutralbg_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a:alpha val="0"/>
      </a:schemeClr>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18/5/colors/Iconchunking_neutralicontext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bg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18/5/colors/Iconchunking_neutralbg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CA650606-713D-4BAC-9295-9FE722EB6F9E}" type="doc">
      <dgm:prSet loTypeId="urn:microsoft.com/office/officeart/2018/2/layout/IconLabelList" loCatId="icon" qsTypeId="urn:microsoft.com/office/officeart/2005/8/quickstyle/simple1" qsCatId="simple" csTypeId="urn:microsoft.com/office/officeart/2018/5/colors/Iconchunking_neutralbg_colorful5" csCatId="colorful" phldr="1"/>
      <dgm:spPr/>
      <dgm:t>
        <a:bodyPr/>
        <a:lstStyle/>
        <a:p>
          <a:endParaRPr lang="en-US"/>
        </a:p>
      </dgm:t>
    </dgm:pt>
    <dgm:pt modelId="{93A03E4F-34B2-4BB7-B1A8-0B942DF84353}">
      <dgm:prSet/>
      <dgm:spPr/>
      <dgm:t>
        <a:bodyPr/>
        <a:lstStyle/>
        <a:p>
          <a:r>
            <a:rPr lang="en-US" dirty="0"/>
            <a:t>S – Setting</a:t>
          </a:r>
        </a:p>
      </dgm:t>
    </dgm:pt>
    <dgm:pt modelId="{36DB99A9-A2C9-455A-9346-D7EE53B3B798}" type="parTrans" cxnId="{F166ED8B-215C-424C-AC01-E0C3C0551FF9}">
      <dgm:prSet/>
      <dgm:spPr/>
      <dgm:t>
        <a:bodyPr/>
        <a:lstStyle/>
        <a:p>
          <a:endParaRPr lang="en-US"/>
        </a:p>
      </dgm:t>
    </dgm:pt>
    <dgm:pt modelId="{EDCB29F4-1F7D-45F4-84DA-9BB68E2CCCF5}" type="sibTrans" cxnId="{F166ED8B-215C-424C-AC01-E0C3C0551FF9}">
      <dgm:prSet/>
      <dgm:spPr/>
      <dgm:t>
        <a:bodyPr/>
        <a:lstStyle/>
        <a:p>
          <a:endParaRPr lang="en-US"/>
        </a:p>
      </dgm:t>
    </dgm:pt>
    <dgm:pt modelId="{5982ADF8-5CE8-493C-992A-BFED92624864}">
      <dgm:prSet/>
      <dgm:spPr/>
      <dgm:t>
        <a:bodyPr/>
        <a:lstStyle/>
        <a:p>
          <a:r>
            <a:rPr lang="en-US" dirty="0"/>
            <a:t>P – Perception</a:t>
          </a:r>
        </a:p>
      </dgm:t>
    </dgm:pt>
    <dgm:pt modelId="{B06BEB94-12A5-4B6A-BB80-DA1F902BFA9C}" type="parTrans" cxnId="{DD2E95BE-8E6E-44EF-BBAC-D62E6995886F}">
      <dgm:prSet/>
      <dgm:spPr/>
      <dgm:t>
        <a:bodyPr/>
        <a:lstStyle/>
        <a:p>
          <a:endParaRPr lang="en-US"/>
        </a:p>
      </dgm:t>
    </dgm:pt>
    <dgm:pt modelId="{B234EE2B-7670-46D7-8E20-D90205A53697}" type="sibTrans" cxnId="{DD2E95BE-8E6E-44EF-BBAC-D62E6995886F}">
      <dgm:prSet/>
      <dgm:spPr/>
      <dgm:t>
        <a:bodyPr/>
        <a:lstStyle/>
        <a:p>
          <a:endParaRPr lang="en-US"/>
        </a:p>
      </dgm:t>
    </dgm:pt>
    <dgm:pt modelId="{7A5AF635-D867-442C-A028-58AE55DF7CB3}">
      <dgm:prSet/>
      <dgm:spPr/>
      <dgm:t>
        <a:bodyPr/>
        <a:lstStyle/>
        <a:p>
          <a:r>
            <a:rPr lang="en-US" dirty="0"/>
            <a:t>I – Invitation</a:t>
          </a:r>
        </a:p>
      </dgm:t>
    </dgm:pt>
    <dgm:pt modelId="{C979D512-18D6-4765-ADB3-60FE62BB6B59}" type="parTrans" cxnId="{4140A4F4-B8B5-4243-989D-6684B82B7F44}">
      <dgm:prSet/>
      <dgm:spPr/>
      <dgm:t>
        <a:bodyPr/>
        <a:lstStyle/>
        <a:p>
          <a:endParaRPr lang="en-US"/>
        </a:p>
      </dgm:t>
    </dgm:pt>
    <dgm:pt modelId="{BA777F8D-43BD-471C-8862-3D0893A462B2}" type="sibTrans" cxnId="{4140A4F4-B8B5-4243-989D-6684B82B7F44}">
      <dgm:prSet/>
      <dgm:spPr/>
      <dgm:t>
        <a:bodyPr/>
        <a:lstStyle/>
        <a:p>
          <a:endParaRPr lang="en-US"/>
        </a:p>
      </dgm:t>
    </dgm:pt>
    <dgm:pt modelId="{10093778-BECD-4F1E-B87B-231DC5DC2EF2}">
      <dgm:prSet/>
      <dgm:spPr/>
      <dgm:t>
        <a:bodyPr/>
        <a:lstStyle/>
        <a:p>
          <a:r>
            <a:rPr lang="en-US" dirty="0"/>
            <a:t>K – Knowledge</a:t>
          </a:r>
        </a:p>
      </dgm:t>
    </dgm:pt>
    <dgm:pt modelId="{CA50764F-10F4-4685-B054-F7485C60EF3F}" type="parTrans" cxnId="{3954C154-750A-4DB2-B6CD-CAC9F73186A7}">
      <dgm:prSet/>
      <dgm:spPr/>
      <dgm:t>
        <a:bodyPr/>
        <a:lstStyle/>
        <a:p>
          <a:endParaRPr lang="en-US"/>
        </a:p>
      </dgm:t>
    </dgm:pt>
    <dgm:pt modelId="{D5BFE20D-19E6-45DB-A17B-ACBEF89D74D8}" type="sibTrans" cxnId="{3954C154-750A-4DB2-B6CD-CAC9F73186A7}">
      <dgm:prSet/>
      <dgm:spPr/>
      <dgm:t>
        <a:bodyPr/>
        <a:lstStyle/>
        <a:p>
          <a:endParaRPr lang="en-US"/>
        </a:p>
      </dgm:t>
    </dgm:pt>
    <dgm:pt modelId="{66C12B91-3FC5-4AB9-B8BC-0B812DA44F4C}">
      <dgm:prSet/>
      <dgm:spPr/>
      <dgm:t>
        <a:bodyPr/>
        <a:lstStyle/>
        <a:p>
          <a:r>
            <a:rPr lang="en-US" dirty="0"/>
            <a:t>E – Emotions</a:t>
          </a:r>
        </a:p>
      </dgm:t>
    </dgm:pt>
    <dgm:pt modelId="{DC2CBC4E-A2E3-45CB-A4FE-06EE0607F6A0}" type="parTrans" cxnId="{EB1B74B6-C0E8-45BA-98AB-C5CBA6B1BA37}">
      <dgm:prSet/>
      <dgm:spPr/>
      <dgm:t>
        <a:bodyPr/>
        <a:lstStyle/>
        <a:p>
          <a:endParaRPr lang="en-US"/>
        </a:p>
      </dgm:t>
    </dgm:pt>
    <dgm:pt modelId="{0987DAC2-FA98-4D0B-AD66-DC287FBE8C10}" type="sibTrans" cxnId="{EB1B74B6-C0E8-45BA-98AB-C5CBA6B1BA37}">
      <dgm:prSet/>
      <dgm:spPr/>
      <dgm:t>
        <a:bodyPr/>
        <a:lstStyle/>
        <a:p>
          <a:endParaRPr lang="en-US"/>
        </a:p>
      </dgm:t>
    </dgm:pt>
    <dgm:pt modelId="{980B879D-981C-482D-AC6D-9E9BF05B736E}">
      <dgm:prSet/>
      <dgm:spPr/>
      <dgm:t>
        <a:bodyPr/>
        <a:lstStyle/>
        <a:p>
          <a:r>
            <a:rPr lang="en-US" dirty="0"/>
            <a:t>S – Summarize/ Strategize</a:t>
          </a:r>
        </a:p>
      </dgm:t>
    </dgm:pt>
    <dgm:pt modelId="{E67E2AA5-B9FA-4F87-BE33-4589CC1151A4}" type="parTrans" cxnId="{A23BFC4E-CEDA-48CD-B8BA-A5948D8F94D9}">
      <dgm:prSet/>
      <dgm:spPr/>
      <dgm:t>
        <a:bodyPr/>
        <a:lstStyle/>
        <a:p>
          <a:endParaRPr lang="en-US"/>
        </a:p>
      </dgm:t>
    </dgm:pt>
    <dgm:pt modelId="{BAB8F5FB-80E5-4791-B495-F640378C6FE5}" type="sibTrans" cxnId="{A23BFC4E-CEDA-48CD-B8BA-A5948D8F94D9}">
      <dgm:prSet/>
      <dgm:spPr/>
      <dgm:t>
        <a:bodyPr/>
        <a:lstStyle/>
        <a:p>
          <a:endParaRPr lang="en-US"/>
        </a:p>
      </dgm:t>
    </dgm:pt>
    <dgm:pt modelId="{42EE728F-1C3E-40B6-9C74-226DCFC9074F}" type="pres">
      <dgm:prSet presAssocID="{CA650606-713D-4BAC-9295-9FE722EB6F9E}" presName="root" presStyleCnt="0">
        <dgm:presLayoutVars>
          <dgm:dir/>
          <dgm:resizeHandles val="exact"/>
        </dgm:presLayoutVars>
      </dgm:prSet>
      <dgm:spPr/>
    </dgm:pt>
    <dgm:pt modelId="{3B5261E7-D3AC-4CDC-8E80-73A6B13A1E2D}" type="pres">
      <dgm:prSet presAssocID="{93A03E4F-34B2-4BB7-B1A8-0B942DF84353}" presName="compNode" presStyleCnt="0"/>
      <dgm:spPr/>
    </dgm:pt>
    <dgm:pt modelId="{26D19855-592E-49BE-ACDC-44D931B835E8}" type="pres">
      <dgm:prSet presAssocID="{93A03E4F-34B2-4BB7-B1A8-0B942DF84353}" presName="iconRect" presStyleLbl="node1" presStyleIdx="0" presStyleCnt="6"/>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a:noFill/>
        </a:ln>
      </dgm:spPr>
      <dgm:extLst>
        <a:ext uri="{E40237B7-FDA0-4F09-8148-C483321AD2D9}">
          <dgm14:cNvPr xmlns:dgm14="http://schemas.microsoft.com/office/drawing/2010/diagram" id="0" name="" descr="Single gear"/>
        </a:ext>
      </dgm:extLst>
    </dgm:pt>
    <dgm:pt modelId="{B6B0D450-E6D2-4B93-9B5D-D103E8816849}" type="pres">
      <dgm:prSet presAssocID="{93A03E4F-34B2-4BB7-B1A8-0B942DF84353}" presName="spaceRect" presStyleCnt="0"/>
      <dgm:spPr/>
    </dgm:pt>
    <dgm:pt modelId="{14BA6554-D0A5-4C55-8DB1-F1C8225D25D5}" type="pres">
      <dgm:prSet presAssocID="{93A03E4F-34B2-4BB7-B1A8-0B942DF84353}" presName="textRect" presStyleLbl="revTx" presStyleIdx="0" presStyleCnt="6">
        <dgm:presLayoutVars>
          <dgm:chMax val="1"/>
          <dgm:chPref val="1"/>
        </dgm:presLayoutVars>
      </dgm:prSet>
      <dgm:spPr/>
    </dgm:pt>
    <dgm:pt modelId="{4227575C-A50F-488C-A5B6-9876682F857C}" type="pres">
      <dgm:prSet presAssocID="{EDCB29F4-1F7D-45F4-84DA-9BB68E2CCCF5}" presName="sibTrans" presStyleCnt="0"/>
      <dgm:spPr/>
    </dgm:pt>
    <dgm:pt modelId="{B7D12B96-28A5-498E-A9A8-83FBC981E8F1}" type="pres">
      <dgm:prSet presAssocID="{5982ADF8-5CE8-493C-992A-BFED92624864}" presName="compNode" presStyleCnt="0"/>
      <dgm:spPr/>
    </dgm:pt>
    <dgm:pt modelId="{F883629F-64FC-42F5-AEEA-3EAC19D2DA7E}" type="pres">
      <dgm:prSet presAssocID="{5982ADF8-5CE8-493C-992A-BFED92624864}" presName="iconRect" presStyleLbl="node1" presStyleIdx="1" presStyleCnt="6"/>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Ruble"/>
        </a:ext>
      </dgm:extLst>
    </dgm:pt>
    <dgm:pt modelId="{DF0DD5C0-7DD2-43E3-AB01-701597B8B993}" type="pres">
      <dgm:prSet presAssocID="{5982ADF8-5CE8-493C-992A-BFED92624864}" presName="spaceRect" presStyleCnt="0"/>
      <dgm:spPr/>
    </dgm:pt>
    <dgm:pt modelId="{08DC2658-CB03-4EC2-804C-AB24FBC7CA94}" type="pres">
      <dgm:prSet presAssocID="{5982ADF8-5CE8-493C-992A-BFED92624864}" presName="textRect" presStyleLbl="revTx" presStyleIdx="1" presStyleCnt="6">
        <dgm:presLayoutVars>
          <dgm:chMax val="1"/>
          <dgm:chPref val="1"/>
        </dgm:presLayoutVars>
      </dgm:prSet>
      <dgm:spPr/>
    </dgm:pt>
    <dgm:pt modelId="{83EBB83F-9F2B-4E57-B3FD-41C34C2ECB01}" type="pres">
      <dgm:prSet presAssocID="{B234EE2B-7670-46D7-8E20-D90205A53697}" presName="sibTrans" presStyleCnt="0"/>
      <dgm:spPr/>
    </dgm:pt>
    <dgm:pt modelId="{015CFDFD-F1FC-4579-A6BF-63B5FD80DC7B}" type="pres">
      <dgm:prSet presAssocID="{7A5AF635-D867-442C-A028-58AE55DF7CB3}" presName="compNode" presStyleCnt="0"/>
      <dgm:spPr/>
    </dgm:pt>
    <dgm:pt modelId="{F7CA468D-2232-4916-890C-8A12BD74E5FF}" type="pres">
      <dgm:prSet presAssocID="{7A5AF635-D867-442C-A028-58AE55DF7CB3}" presName="iconRect" presStyleLbl="node1" presStyleIdx="2" presStyleCnt="6"/>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a:ln>
          <a:noFill/>
        </a:ln>
      </dgm:spPr>
      <dgm:extLst>
        <a:ext uri="{E40237B7-FDA0-4F09-8148-C483321AD2D9}">
          <dgm14:cNvPr xmlns:dgm14="http://schemas.microsoft.com/office/drawing/2010/diagram" id="0" name="" descr="Open envelope"/>
        </a:ext>
      </dgm:extLst>
    </dgm:pt>
    <dgm:pt modelId="{80CEF3A3-BA6B-47AB-AEB8-D6A44A0FB5E4}" type="pres">
      <dgm:prSet presAssocID="{7A5AF635-D867-442C-A028-58AE55DF7CB3}" presName="spaceRect" presStyleCnt="0"/>
      <dgm:spPr/>
    </dgm:pt>
    <dgm:pt modelId="{BD812F4E-96E4-4679-AA94-88BA51F561D3}" type="pres">
      <dgm:prSet presAssocID="{7A5AF635-D867-442C-A028-58AE55DF7CB3}" presName="textRect" presStyleLbl="revTx" presStyleIdx="2" presStyleCnt="6">
        <dgm:presLayoutVars>
          <dgm:chMax val="1"/>
          <dgm:chPref val="1"/>
        </dgm:presLayoutVars>
      </dgm:prSet>
      <dgm:spPr/>
    </dgm:pt>
    <dgm:pt modelId="{C85F18C5-FDE6-4AE2-81CC-C09FC79F8277}" type="pres">
      <dgm:prSet presAssocID="{BA777F8D-43BD-471C-8862-3D0893A462B2}" presName="sibTrans" presStyleCnt="0"/>
      <dgm:spPr/>
    </dgm:pt>
    <dgm:pt modelId="{0530FB47-CC8C-45A3-9A14-32CF9DE16B74}" type="pres">
      <dgm:prSet presAssocID="{10093778-BECD-4F1E-B87B-231DC5DC2EF2}" presName="compNode" presStyleCnt="0"/>
      <dgm:spPr/>
    </dgm:pt>
    <dgm:pt modelId="{355DE8C0-67B6-4FB4-B82C-7131E5375BE0}" type="pres">
      <dgm:prSet presAssocID="{10093778-BECD-4F1E-B87B-231DC5DC2EF2}" presName="iconRect" presStyleLbl="node1" presStyleIdx="3" presStyleCnt="6"/>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Joker Hat"/>
        </a:ext>
      </dgm:extLst>
    </dgm:pt>
    <dgm:pt modelId="{A62AEA34-FF8D-4185-8438-97DF45DAB522}" type="pres">
      <dgm:prSet presAssocID="{10093778-BECD-4F1E-B87B-231DC5DC2EF2}" presName="spaceRect" presStyleCnt="0"/>
      <dgm:spPr/>
    </dgm:pt>
    <dgm:pt modelId="{5A5A7675-F1A8-4514-9DF1-8C7B6327C061}" type="pres">
      <dgm:prSet presAssocID="{10093778-BECD-4F1E-B87B-231DC5DC2EF2}" presName="textRect" presStyleLbl="revTx" presStyleIdx="3" presStyleCnt="6">
        <dgm:presLayoutVars>
          <dgm:chMax val="1"/>
          <dgm:chPref val="1"/>
        </dgm:presLayoutVars>
      </dgm:prSet>
      <dgm:spPr/>
    </dgm:pt>
    <dgm:pt modelId="{316B6678-58E4-4777-8EEA-9F7262911B5B}" type="pres">
      <dgm:prSet presAssocID="{D5BFE20D-19E6-45DB-A17B-ACBEF89D74D8}" presName="sibTrans" presStyleCnt="0"/>
      <dgm:spPr/>
    </dgm:pt>
    <dgm:pt modelId="{647515FA-85C6-4324-9257-A1E274496F1C}" type="pres">
      <dgm:prSet presAssocID="{66C12B91-3FC5-4AB9-B8BC-0B812DA44F4C}" presName="compNode" presStyleCnt="0"/>
      <dgm:spPr/>
    </dgm:pt>
    <dgm:pt modelId="{FB37D14F-B45A-4EFD-B226-443E29423E60}" type="pres">
      <dgm:prSet presAssocID="{66C12B91-3FC5-4AB9-B8BC-0B812DA44F4C}" presName="iconRect" presStyleLbl="node1" presStyleIdx="4" presStyleCnt="6"/>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a:blipFill>
        <a:ln>
          <a:noFill/>
        </a:ln>
      </dgm:spPr>
      <dgm:extLst>
        <a:ext uri="{E40237B7-FDA0-4F09-8148-C483321AD2D9}">
          <dgm14:cNvPr xmlns:dgm14="http://schemas.microsoft.com/office/drawing/2010/diagram" id="0" name="" descr="Angry Face with No Fill"/>
        </a:ext>
      </dgm:extLst>
    </dgm:pt>
    <dgm:pt modelId="{5533DF92-53FD-41F5-B8C6-4B6055A50AD3}" type="pres">
      <dgm:prSet presAssocID="{66C12B91-3FC5-4AB9-B8BC-0B812DA44F4C}" presName="spaceRect" presStyleCnt="0"/>
      <dgm:spPr/>
    </dgm:pt>
    <dgm:pt modelId="{F562D7C8-010B-4127-9253-07104E1077CA}" type="pres">
      <dgm:prSet presAssocID="{66C12B91-3FC5-4AB9-B8BC-0B812DA44F4C}" presName="textRect" presStyleLbl="revTx" presStyleIdx="4" presStyleCnt="6">
        <dgm:presLayoutVars>
          <dgm:chMax val="1"/>
          <dgm:chPref val="1"/>
        </dgm:presLayoutVars>
      </dgm:prSet>
      <dgm:spPr/>
    </dgm:pt>
    <dgm:pt modelId="{55B80CEE-5499-4196-B444-FFA454D15EC0}" type="pres">
      <dgm:prSet presAssocID="{0987DAC2-FA98-4D0B-AD66-DC287FBE8C10}" presName="sibTrans" presStyleCnt="0"/>
      <dgm:spPr/>
    </dgm:pt>
    <dgm:pt modelId="{99394AD3-82AB-480C-8AB5-F4E853907043}" type="pres">
      <dgm:prSet presAssocID="{980B879D-981C-482D-AC6D-9E9BF05B736E}" presName="compNode" presStyleCnt="0"/>
      <dgm:spPr/>
    </dgm:pt>
    <dgm:pt modelId="{7931FCC8-D17E-4DBA-A279-2E21E39ABA0F}" type="pres">
      <dgm:prSet presAssocID="{980B879D-981C-482D-AC6D-9E9BF05B736E}" presName="iconRect" presStyleLbl="node1" presStyleIdx="5" presStyleCnt="6"/>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Gauge"/>
        </a:ext>
      </dgm:extLst>
    </dgm:pt>
    <dgm:pt modelId="{7C119538-2DB1-4544-B409-8AA987D0D565}" type="pres">
      <dgm:prSet presAssocID="{980B879D-981C-482D-AC6D-9E9BF05B736E}" presName="spaceRect" presStyleCnt="0"/>
      <dgm:spPr/>
    </dgm:pt>
    <dgm:pt modelId="{4E7362DB-6BAA-496B-B512-0740E4ACE467}" type="pres">
      <dgm:prSet presAssocID="{980B879D-981C-482D-AC6D-9E9BF05B736E}" presName="textRect" presStyleLbl="revTx" presStyleIdx="5" presStyleCnt="6">
        <dgm:presLayoutVars>
          <dgm:chMax val="1"/>
          <dgm:chPref val="1"/>
        </dgm:presLayoutVars>
      </dgm:prSet>
      <dgm:spPr/>
    </dgm:pt>
  </dgm:ptLst>
  <dgm:cxnLst>
    <dgm:cxn modelId="{50917119-21BA-43CA-93D1-367C5D695234}" type="presOf" srcId="{93A03E4F-34B2-4BB7-B1A8-0B942DF84353}" destId="{14BA6554-D0A5-4C55-8DB1-F1C8225D25D5}" srcOrd="0" destOrd="0" presId="urn:microsoft.com/office/officeart/2018/2/layout/IconLabelList"/>
    <dgm:cxn modelId="{A54EF046-DE56-4431-B9E3-4FC7007A20B9}" type="presOf" srcId="{5982ADF8-5CE8-493C-992A-BFED92624864}" destId="{08DC2658-CB03-4EC2-804C-AB24FBC7CA94}" srcOrd="0" destOrd="0" presId="urn:microsoft.com/office/officeart/2018/2/layout/IconLabelList"/>
    <dgm:cxn modelId="{98C7344A-50D6-4080-A268-4F0B1F4EA326}" type="presOf" srcId="{7A5AF635-D867-442C-A028-58AE55DF7CB3}" destId="{BD812F4E-96E4-4679-AA94-88BA51F561D3}" srcOrd="0" destOrd="0" presId="urn:microsoft.com/office/officeart/2018/2/layout/IconLabelList"/>
    <dgm:cxn modelId="{A23BFC4E-CEDA-48CD-B8BA-A5948D8F94D9}" srcId="{CA650606-713D-4BAC-9295-9FE722EB6F9E}" destId="{980B879D-981C-482D-AC6D-9E9BF05B736E}" srcOrd="5" destOrd="0" parTransId="{E67E2AA5-B9FA-4F87-BE33-4589CC1151A4}" sibTransId="{BAB8F5FB-80E5-4791-B495-F640378C6FE5}"/>
    <dgm:cxn modelId="{3954C154-750A-4DB2-B6CD-CAC9F73186A7}" srcId="{CA650606-713D-4BAC-9295-9FE722EB6F9E}" destId="{10093778-BECD-4F1E-B87B-231DC5DC2EF2}" srcOrd="3" destOrd="0" parTransId="{CA50764F-10F4-4685-B054-F7485C60EF3F}" sibTransId="{D5BFE20D-19E6-45DB-A17B-ACBEF89D74D8}"/>
    <dgm:cxn modelId="{7625F065-121D-4ACD-BBB4-381328038E1D}" type="presOf" srcId="{CA650606-713D-4BAC-9295-9FE722EB6F9E}" destId="{42EE728F-1C3E-40B6-9C74-226DCFC9074F}" srcOrd="0" destOrd="0" presId="urn:microsoft.com/office/officeart/2018/2/layout/IconLabelList"/>
    <dgm:cxn modelId="{AB2AF365-1DB6-48F3-8295-EFD130DEA3EE}" type="presOf" srcId="{66C12B91-3FC5-4AB9-B8BC-0B812DA44F4C}" destId="{F562D7C8-010B-4127-9253-07104E1077CA}" srcOrd="0" destOrd="0" presId="urn:microsoft.com/office/officeart/2018/2/layout/IconLabelList"/>
    <dgm:cxn modelId="{F166ED8B-215C-424C-AC01-E0C3C0551FF9}" srcId="{CA650606-713D-4BAC-9295-9FE722EB6F9E}" destId="{93A03E4F-34B2-4BB7-B1A8-0B942DF84353}" srcOrd="0" destOrd="0" parTransId="{36DB99A9-A2C9-455A-9346-D7EE53B3B798}" sibTransId="{EDCB29F4-1F7D-45F4-84DA-9BB68E2CCCF5}"/>
    <dgm:cxn modelId="{34E288A4-E15F-4048-88E7-B70117E2B26B}" type="presOf" srcId="{10093778-BECD-4F1E-B87B-231DC5DC2EF2}" destId="{5A5A7675-F1A8-4514-9DF1-8C7B6327C061}" srcOrd="0" destOrd="0" presId="urn:microsoft.com/office/officeart/2018/2/layout/IconLabelList"/>
    <dgm:cxn modelId="{EB1B74B6-C0E8-45BA-98AB-C5CBA6B1BA37}" srcId="{CA650606-713D-4BAC-9295-9FE722EB6F9E}" destId="{66C12B91-3FC5-4AB9-B8BC-0B812DA44F4C}" srcOrd="4" destOrd="0" parTransId="{DC2CBC4E-A2E3-45CB-A4FE-06EE0607F6A0}" sibTransId="{0987DAC2-FA98-4D0B-AD66-DC287FBE8C10}"/>
    <dgm:cxn modelId="{DD2E95BE-8E6E-44EF-BBAC-D62E6995886F}" srcId="{CA650606-713D-4BAC-9295-9FE722EB6F9E}" destId="{5982ADF8-5CE8-493C-992A-BFED92624864}" srcOrd="1" destOrd="0" parTransId="{B06BEB94-12A5-4B6A-BB80-DA1F902BFA9C}" sibTransId="{B234EE2B-7670-46D7-8E20-D90205A53697}"/>
    <dgm:cxn modelId="{13A152C7-245D-4145-B339-1F5D4E954B36}" type="presOf" srcId="{980B879D-981C-482D-AC6D-9E9BF05B736E}" destId="{4E7362DB-6BAA-496B-B512-0740E4ACE467}" srcOrd="0" destOrd="0" presId="urn:microsoft.com/office/officeart/2018/2/layout/IconLabelList"/>
    <dgm:cxn modelId="{4140A4F4-B8B5-4243-989D-6684B82B7F44}" srcId="{CA650606-713D-4BAC-9295-9FE722EB6F9E}" destId="{7A5AF635-D867-442C-A028-58AE55DF7CB3}" srcOrd="2" destOrd="0" parTransId="{C979D512-18D6-4765-ADB3-60FE62BB6B59}" sibTransId="{BA777F8D-43BD-471C-8862-3D0893A462B2}"/>
    <dgm:cxn modelId="{C4BDD06D-E80D-445E-9EA0-3BFBA0683D2E}" type="presParOf" srcId="{42EE728F-1C3E-40B6-9C74-226DCFC9074F}" destId="{3B5261E7-D3AC-4CDC-8E80-73A6B13A1E2D}" srcOrd="0" destOrd="0" presId="urn:microsoft.com/office/officeart/2018/2/layout/IconLabelList"/>
    <dgm:cxn modelId="{96E854B1-398D-4B2E-89A9-52B11A15E676}" type="presParOf" srcId="{3B5261E7-D3AC-4CDC-8E80-73A6B13A1E2D}" destId="{26D19855-592E-49BE-ACDC-44D931B835E8}" srcOrd="0" destOrd="0" presId="urn:microsoft.com/office/officeart/2018/2/layout/IconLabelList"/>
    <dgm:cxn modelId="{46A3E145-05DF-403E-AB19-F043BC140E62}" type="presParOf" srcId="{3B5261E7-D3AC-4CDC-8E80-73A6B13A1E2D}" destId="{B6B0D450-E6D2-4B93-9B5D-D103E8816849}" srcOrd="1" destOrd="0" presId="urn:microsoft.com/office/officeart/2018/2/layout/IconLabelList"/>
    <dgm:cxn modelId="{C14164F5-AE92-43F1-8243-1B7DDAF9C53C}" type="presParOf" srcId="{3B5261E7-D3AC-4CDC-8E80-73A6B13A1E2D}" destId="{14BA6554-D0A5-4C55-8DB1-F1C8225D25D5}" srcOrd="2" destOrd="0" presId="urn:microsoft.com/office/officeart/2018/2/layout/IconLabelList"/>
    <dgm:cxn modelId="{C2463FB2-105B-4327-9CEC-BDCA34A97F7A}" type="presParOf" srcId="{42EE728F-1C3E-40B6-9C74-226DCFC9074F}" destId="{4227575C-A50F-488C-A5B6-9876682F857C}" srcOrd="1" destOrd="0" presId="urn:microsoft.com/office/officeart/2018/2/layout/IconLabelList"/>
    <dgm:cxn modelId="{B5F10EC5-0257-4B48-AFBF-3288B2C6868C}" type="presParOf" srcId="{42EE728F-1C3E-40B6-9C74-226DCFC9074F}" destId="{B7D12B96-28A5-498E-A9A8-83FBC981E8F1}" srcOrd="2" destOrd="0" presId="urn:microsoft.com/office/officeart/2018/2/layout/IconLabelList"/>
    <dgm:cxn modelId="{596AA8FA-A0D1-40D9-9CD6-0907547B7A17}" type="presParOf" srcId="{B7D12B96-28A5-498E-A9A8-83FBC981E8F1}" destId="{F883629F-64FC-42F5-AEEA-3EAC19D2DA7E}" srcOrd="0" destOrd="0" presId="urn:microsoft.com/office/officeart/2018/2/layout/IconLabelList"/>
    <dgm:cxn modelId="{19B46973-A143-42F1-AF21-B5AFD9654439}" type="presParOf" srcId="{B7D12B96-28A5-498E-A9A8-83FBC981E8F1}" destId="{DF0DD5C0-7DD2-43E3-AB01-701597B8B993}" srcOrd="1" destOrd="0" presId="urn:microsoft.com/office/officeart/2018/2/layout/IconLabelList"/>
    <dgm:cxn modelId="{47F7E323-FB94-44D1-84DD-BFC67E870F4B}" type="presParOf" srcId="{B7D12B96-28A5-498E-A9A8-83FBC981E8F1}" destId="{08DC2658-CB03-4EC2-804C-AB24FBC7CA94}" srcOrd="2" destOrd="0" presId="urn:microsoft.com/office/officeart/2018/2/layout/IconLabelList"/>
    <dgm:cxn modelId="{F7418E53-A1FB-4E14-A95F-5194199DB328}" type="presParOf" srcId="{42EE728F-1C3E-40B6-9C74-226DCFC9074F}" destId="{83EBB83F-9F2B-4E57-B3FD-41C34C2ECB01}" srcOrd="3" destOrd="0" presId="urn:microsoft.com/office/officeart/2018/2/layout/IconLabelList"/>
    <dgm:cxn modelId="{7860D767-122D-428C-B00D-427D55D94AA1}" type="presParOf" srcId="{42EE728F-1C3E-40B6-9C74-226DCFC9074F}" destId="{015CFDFD-F1FC-4579-A6BF-63B5FD80DC7B}" srcOrd="4" destOrd="0" presId="urn:microsoft.com/office/officeart/2018/2/layout/IconLabelList"/>
    <dgm:cxn modelId="{3C04FC21-9F55-4A86-AE25-28E0BB868ACB}" type="presParOf" srcId="{015CFDFD-F1FC-4579-A6BF-63B5FD80DC7B}" destId="{F7CA468D-2232-4916-890C-8A12BD74E5FF}" srcOrd="0" destOrd="0" presId="urn:microsoft.com/office/officeart/2018/2/layout/IconLabelList"/>
    <dgm:cxn modelId="{6C0D6FAE-74D7-41B8-89D4-F9553FAABF6F}" type="presParOf" srcId="{015CFDFD-F1FC-4579-A6BF-63B5FD80DC7B}" destId="{80CEF3A3-BA6B-47AB-AEB8-D6A44A0FB5E4}" srcOrd="1" destOrd="0" presId="urn:microsoft.com/office/officeart/2018/2/layout/IconLabelList"/>
    <dgm:cxn modelId="{C91F2D1C-5E7B-4DF2-A954-58B1778AF95D}" type="presParOf" srcId="{015CFDFD-F1FC-4579-A6BF-63B5FD80DC7B}" destId="{BD812F4E-96E4-4679-AA94-88BA51F561D3}" srcOrd="2" destOrd="0" presId="urn:microsoft.com/office/officeart/2018/2/layout/IconLabelList"/>
    <dgm:cxn modelId="{568C4801-8A9F-447B-A6F5-6A9F99C37A12}" type="presParOf" srcId="{42EE728F-1C3E-40B6-9C74-226DCFC9074F}" destId="{C85F18C5-FDE6-4AE2-81CC-C09FC79F8277}" srcOrd="5" destOrd="0" presId="urn:microsoft.com/office/officeart/2018/2/layout/IconLabelList"/>
    <dgm:cxn modelId="{2C399CAA-7F9D-4619-86FA-6616147DB72F}" type="presParOf" srcId="{42EE728F-1C3E-40B6-9C74-226DCFC9074F}" destId="{0530FB47-CC8C-45A3-9A14-32CF9DE16B74}" srcOrd="6" destOrd="0" presId="urn:microsoft.com/office/officeart/2018/2/layout/IconLabelList"/>
    <dgm:cxn modelId="{BDAB83C5-5331-4A4C-BCCD-A179A28FFFEC}" type="presParOf" srcId="{0530FB47-CC8C-45A3-9A14-32CF9DE16B74}" destId="{355DE8C0-67B6-4FB4-B82C-7131E5375BE0}" srcOrd="0" destOrd="0" presId="urn:microsoft.com/office/officeart/2018/2/layout/IconLabelList"/>
    <dgm:cxn modelId="{2D175955-7CDA-4950-9690-37861498795E}" type="presParOf" srcId="{0530FB47-CC8C-45A3-9A14-32CF9DE16B74}" destId="{A62AEA34-FF8D-4185-8438-97DF45DAB522}" srcOrd="1" destOrd="0" presId="urn:microsoft.com/office/officeart/2018/2/layout/IconLabelList"/>
    <dgm:cxn modelId="{EF8DAC06-3FA3-4617-981D-DCB1C7293F39}" type="presParOf" srcId="{0530FB47-CC8C-45A3-9A14-32CF9DE16B74}" destId="{5A5A7675-F1A8-4514-9DF1-8C7B6327C061}" srcOrd="2" destOrd="0" presId="urn:microsoft.com/office/officeart/2018/2/layout/IconLabelList"/>
    <dgm:cxn modelId="{BD9B9794-5B0F-4D52-AD91-70EC8FAB076D}" type="presParOf" srcId="{42EE728F-1C3E-40B6-9C74-226DCFC9074F}" destId="{316B6678-58E4-4777-8EEA-9F7262911B5B}" srcOrd="7" destOrd="0" presId="urn:microsoft.com/office/officeart/2018/2/layout/IconLabelList"/>
    <dgm:cxn modelId="{84596668-6FF8-4CCF-B298-6B215526D475}" type="presParOf" srcId="{42EE728F-1C3E-40B6-9C74-226DCFC9074F}" destId="{647515FA-85C6-4324-9257-A1E274496F1C}" srcOrd="8" destOrd="0" presId="urn:microsoft.com/office/officeart/2018/2/layout/IconLabelList"/>
    <dgm:cxn modelId="{D8AE79F0-C825-4A76-A5C1-C19106EFDA3E}" type="presParOf" srcId="{647515FA-85C6-4324-9257-A1E274496F1C}" destId="{FB37D14F-B45A-4EFD-B226-443E29423E60}" srcOrd="0" destOrd="0" presId="urn:microsoft.com/office/officeart/2018/2/layout/IconLabelList"/>
    <dgm:cxn modelId="{C620F02D-DE63-43E4-88BB-D794E19705DF}" type="presParOf" srcId="{647515FA-85C6-4324-9257-A1E274496F1C}" destId="{5533DF92-53FD-41F5-B8C6-4B6055A50AD3}" srcOrd="1" destOrd="0" presId="urn:microsoft.com/office/officeart/2018/2/layout/IconLabelList"/>
    <dgm:cxn modelId="{459B1BFE-F1DD-4DD6-9744-DEFD40BAC251}" type="presParOf" srcId="{647515FA-85C6-4324-9257-A1E274496F1C}" destId="{F562D7C8-010B-4127-9253-07104E1077CA}" srcOrd="2" destOrd="0" presId="urn:microsoft.com/office/officeart/2018/2/layout/IconLabelList"/>
    <dgm:cxn modelId="{431DECAE-A325-404B-9F1C-214425FC2F4D}" type="presParOf" srcId="{42EE728F-1C3E-40B6-9C74-226DCFC9074F}" destId="{55B80CEE-5499-4196-B444-FFA454D15EC0}" srcOrd="9" destOrd="0" presId="urn:microsoft.com/office/officeart/2018/2/layout/IconLabelList"/>
    <dgm:cxn modelId="{F5F84CEA-E2AA-47DB-88F6-3E68F319273D}" type="presParOf" srcId="{42EE728F-1C3E-40B6-9C74-226DCFC9074F}" destId="{99394AD3-82AB-480C-8AB5-F4E853907043}" srcOrd="10" destOrd="0" presId="urn:microsoft.com/office/officeart/2018/2/layout/IconLabelList"/>
    <dgm:cxn modelId="{C6F43F2A-24BF-45C9-A7B7-78D6398568DE}" type="presParOf" srcId="{99394AD3-82AB-480C-8AB5-F4E853907043}" destId="{7931FCC8-D17E-4DBA-A279-2E21E39ABA0F}" srcOrd="0" destOrd="0" presId="urn:microsoft.com/office/officeart/2018/2/layout/IconLabelList"/>
    <dgm:cxn modelId="{C88647E7-AC66-48B2-A2DF-19CF675F7172}" type="presParOf" srcId="{99394AD3-82AB-480C-8AB5-F4E853907043}" destId="{7C119538-2DB1-4544-B409-8AA987D0D565}" srcOrd="1" destOrd="0" presId="urn:microsoft.com/office/officeart/2018/2/layout/IconLabelList"/>
    <dgm:cxn modelId="{92182C99-6993-4542-BD51-50808260B450}" type="presParOf" srcId="{99394AD3-82AB-480C-8AB5-F4E853907043}" destId="{4E7362DB-6BAA-496B-B512-0740E4ACE467}" srcOrd="2" destOrd="0" presId="urn:microsoft.com/office/officeart/2018/2/layout/IconLabel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0.xml><?xml version="1.0" encoding="utf-8"?>
<dgm:dataModel xmlns:dgm="http://schemas.openxmlformats.org/drawingml/2006/diagram" xmlns:a="http://schemas.openxmlformats.org/drawingml/2006/main">
  <dgm:ptLst>
    <dgm:pt modelId="{0FEC5F71-A4F6-4D1E-AB5D-8BE3D7954440}" type="doc">
      <dgm:prSet loTypeId="urn:microsoft.com/office/officeart/2005/8/layout/hierarchy1" loCatId="hierarchy" qsTypeId="urn:microsoft.com/office/officeart/2005/8/quickstyle/simple1" qsCatId="simple" csTypeId="urn:microsoft.com/office/officeart/2005/8/colors/colorful2" csCatId="colorful" phldr="1"/>
      <dgm:spPr/>
      <dgm:t>
        <a:bodyPr/>
        <a:lstStyle/>
        <a:p>
          <a:endParaRPr lang="en-US"/>
        </a:p>
      </dgm:t>
    </dgm:pt>
    <dgm:pt modelId="{1BEB7012-55BD-4B6B-9BBF-9423DFC526E4}">
      <dgm:prSet/>
      <dgm:spPr/>
      <dgm:t>
        <a:bodyPr/>
        <a:lstStyle/>
        <a:p>
          <a:r>
            <a:rPr lang="en-US" dirty="0"/>
            <a:t>”We will be there to help you through this.”</a:t>
          </a:r>
        </a:p>
      </dgm:t>
    </dgm:pt>
    <dgm:pt modelId="{9465C3A5-941E-419D-84AE-560A8C0A7891}" type="parTrans" cxnId="{B246FC2F-D6AC-4D46-9227-7EEA169D453A}">
      <dgm:prSet/>
      <dgm:spPr/>
      <dgm:t>
        <a:bodyPr/>
        <a:lstStyle/>
        <a:p>
          <a:endParaRPr lang="en-US"/>
        </a:p>
      </dgm:t>
    </dgm:pt>
    <dgm:pt modelId="{6F9E47BD-2A4F-485B-A7F3-B11E45EC96D4}" type="sibTrans" cxnId="{B246FC2F-D6AC-4D46-9227-7EEA169D453A}">
      <dgm:prSet/>
      <dgm:spPr/>
      <dgm:t>
        <a:bodyPr/>
        <a:lstStyle/>
        <a:p>
          <a:endParaRPr lang="en-US"/>
        </a:p>
      </dgm:t>
    </dgm:pt>
    <dgm:pt modelId="{4948095F-A16A-4042-AF46-099869468D6C}">
      <dgm:prSet/>
      <dgm:spPr/>
      <dgm:t>
        <a:bodyPr/>
        <a:lstStyle/>
        <a:p>
          <a:r>
            <a:rPr lang="en-US" dirty="0"/>
            <a:t>”We will work to make sure this doesn’t happen again.”</a:t>
          </a:r>
        </a:p>
      </dgm:t>
    </dgm:pt>
    <dgm:pt modelId="{03DEAAD2-3B7F-484C-BD8C-481482583683}" type="parTrans" cxnId="{251DFE26-062A-4259-88E2-69F89EA9DC8A}">
      <dgm:prSet/>
      <dgm:spPr/>
      <dgm:t>
        <a:bodyPr/>
        <a:lstStyle/>
        <a:p>
          <a:endParaRPr lang="en-US"/>
        </a:p>
      </dgm:t>
    </dgm:pt>
    <dgm:pt modelId="{E8517ABF-E88D-434C-A844-79A84611EE60}" type="sibTrans" cxnId="{251DFE26-062A-4259-88E2-69F89EA9DC8A}">
      <dgm:prSet/>
      <dgm:spPr/>
      <dgm:t>
        <a:bodyPr/>
        <a:lstStyle/>
        <a:p>
          <a:endParaRPr lang="en-US"/>
        </a:p>
      </dgm:t>
    </dgm:pt>
    <dgm:pt modelId="{E8F5829B-5BE6-42B9-B521-FBAD015F9926}">
      <dgm:prSet/>
      <dgm:spPr/>
      <dgm:t>
        <a:bodyPr/>
        <a:lstStyle/>
        <a:p>
          <a:r>
            <a:rPr lang="en-US" dirty="0"/>
            <a:t>“I will be here to answer your questions and provide support.”</a:t>
          </a:r>
        </a:p>
      </dgm:t>
    </dgm:pt>
    <dgm:pt modelId="{1B9033C3-505E-4B8C-B92D-30C446BD7E03}" type="parTrans" cxnId="{E61A069F-4D4B-4877-B201-82B71E0D3180}">
      <dgm:prSet/>
      <dgm:spPr/>
      <dgm:t>
        <a:bodyPr/>
        <a:lstStyle/>
        <a:p>
          <a:endParaRPr lang="en-US"/>
        </a:p>
      </dgm:t>
    </dgm:pt>
    <dgm:pt modelId="{F2989C00-1A44-4CD4-B50E-430E1ED8531B}" type="sibTrans" cxnId="{E61A069F-4D4B-4877-B201-82B71E0D3180}">
      <dgm:prSet/>
      <dgm:spPr/>
      <dgm:t>
        <a:bodyPr/>
        <a:lstStyle/>
        <a:p>
          <a:endParaRPr lang="en-US"/>
        </a:p>
      </dgm:t>
    </dgm:pt>
    <dgm:pt modelId="{709CD3E5-FB9A-ED48-A17E-FD3DE4CD23D9}" type="pres">
      <dgm:prSet presAssocID="{0FEC5F71-A4F6-4D1E-AB5D-8BE3D7954440}" presName="hierChild1" presStyleCnt="0">
        <dgm:presLayoutVars>
          <dgm:chPref val="1"/>
          <dgm:dir/>
          <dgm:animOne val="branch"/>
          <dgm:animLvl val="lvl"/>
          <dgm:resizeHandles/>
        </dgm:presLayoutVars>
      </dgm:prSet>
      <dgm:spPr/>
    </dgm:pt>
    <dgm:pt modelId="{021B9FBE-C991-CA42-AA45-B4FCB9729D12}" type="pres">
      <dgm:prSet presAssocID="{1BEB7012-55BD-4B6B-9BBF-9423DFC526E4}" presName="hierRoot1" presStyleCnt="0"/>
      <dgm:spPr/>
    </dgm:pt>
    <dgm:pt modelId="{6267FFE2-6ABB-494E-BE32-E996280F16F6}" type="pres">
      <dgm:prSet presAssocID="{1BEB7012-55BD-4B6B-9BBF-9423DFC526E4}" presName="composite" presStyleCnt="0"/>
      <dgm:spPr/>
    </dgm:pt>
    <dgm:pt modelId="{5C2B97B4-7FA6-E64B-B9D2-BBB2179E1CD7}" type="pres">
      <dgm:prSet presAssocID="{1BEB7012-55BD-4B6B-9BBF-9423DFC526E4}" presName="background" presStyleLbl="node0" presStyleIdx="0" presStyleCnt="3"/>
      <dgm:spPr/>
    </dgm:pt>
    <dgm:pt modelId="{83A54DD0-E610-8E45-AF70-B71C45A05C4E}" type="pres">
      <dgm:prSet presAssocID="{1BEB7012-55BD-4B6B-9BBF-9423DFC526E4}" presName="text" presStyleLbl="fgAcc0" presStyleIdx="0" presStyleCnt="3">
        <dgm:presLayoutVars>
          <dgm:chPref val="3"/>
        </dgm:presLayoutVars>
      </dgm:prSet>
      <dgm:spPr/>
    </dgm:pt>
    <dgm:pt modelId="{08176267-1C1D-2E4F-A0AC-0A0954566B5F}" type="pres">
      <dgm:prSet presAssocID="{1BEB7012-55BD-4B6B-9BBF-9423DFC526E4}" presName="hierChild2" presStyleCnt="0"/>
      <dgm:spPr/>
    </dgm:pt>
    <dgm:pt modelId="{06107D26-3D70-6E49-81E7-0F1C8D53AFB1}" type="pres">
      <dgm:prSet presAssocID="{4948095F-A16A-4042-AF46-099869468D6C}" presName="hierRoot1" presStyleCnt="0"/>
      <dgm:spPr/>
    </dgm:pt>
    <dgm:pt modelId="{B55EA09B-32BE-594B-BD35-724DBE58A1AF}" type="pres">
      <dgm:prSet presAssocID="{4948095F-A16A-4042-AF46-099869468D6C}" presName="composite" presStyleCnt="0"/>
      <dgm:spPr/>
    </dgm:pt>
    <dgm:pt modelId="{3475F31D-765C-C24F-9DBE-059E75B00609}" type="pres">
      <dgm:prSet presAssocID="{4948095F-A16A-4042-AF46-099869468D6C}" presName="background" presStyleLbl="node0" presStyleIdx="1" presStyleCnt="3"/>
      <dgm:spPr/>
    </dgm:pt>
    <dgm:pt modelId="{3202695E-C2FC-FF42-BCBD-DF44ADA5A488}" type="pres">
      <dgm:prSet presAssocID="{4948095F-A16A-4042-AF46-099869468D6C}" presName="text" presStyleLbl="fgAcc0" presStyleIdx="1" presStyleCnt="3">
        <dgm:presLayoutVars>
          <dgm:chPref val="3"/>
        </dgm:presLayoutVars>
      </dgm:prSet>
      <dgm:spPr/>
    </dgm:pt>
    <dgm:pt modelId="{9B8E4D7A-2611-6E48-807D-04A7A9EFE614}" type="pres">
      <dgm:prSet presAssocID="{4948095F-A16A-4042-AF46-099869468D6C}" presName="hierChild2" presStyleCnt="0"/>
      <dgm:spPr/>
    </dgm:pt>
    <dgm:pt modelId="{C783EF47-0509-EB41-A20D-F9D3C362E603}" type="pres">
      <dgm:prSet presAssocID="{E8F5829B-5BE6-42B9-B521-FBAD015F9926}" presName="hierRoot1" presStyleCnt="0"/>
      <dgm:spPr/>
    </dgm:pt>
    <dgm:pt modelId="{971B8B9A-FBD4-D64B-941B-A6686F17DBC3}" type="pres">
      <dgm:prSet presAssocID="{E8F5829B-5BE6-42B9-B521-FBAD015F9926}" presName="composite" presStyleCnt="0"/>
      <dgm:spPr/>
    </dgm:pt>
    <dgm:pt modelId="{A2D41A18-2C5E-E749-9BD2-8DA423A2AC81}" type="pres">
      <dgm:prSet presAssocID="{E8F5829B-5BE6-42B9-B521-FBAD015F9926}" presName="background" presStyleLbl="node0" presStyleIdx="2" presStyleCnt="3"/>
      <dgm:spPr/>
    </dgm:pt>
    <dgm:pt modelId="{CA925EC7-AFBF-894E-8C81-850641F70039}" type="pres">
      <dgm:prSet presAssocID="{E8F5829B-5BE6-42B9-B521-FBAD015F9926}" presName="text" presStyleLbl="fgAcc0" presStyleIdx="2" presStyleCnt="3">
        <dgm:presLayoutVars>
          <dgm:chPref val="3"/>
        </dgm:presLayoutVars>
      </dgm:prSet>
      <dgm:spPr/>
    </dgm:pt>
    <dgm:pt modelId="{44404FC7-354D-524C-9410-EEA62AF227DE}" type="pres">
      <dgm:prSet presAssocID="{E8F5829B-5BE6-42B9-B521-FBAD015F9926}" presName="hierChild2" presStyleCnt="0"/>
      <dgm:spPr/>
    </dgm:pt>
  </dgm:ptLst>
  <dgm:cxnLst>
    <dgm:cxn modelId="{CC0E4025-7186-E540-8F5E-163B4B972A12}" type="presOf" srcId="{4948095F-A16A-4042-AF46-099869468D6C}" destId="{3202695E-C2FC-FF42-BCBD-DF44ADA5A488}" srcOrd="0" destOrd="0" presId="urn:microsoft.com/office/officeart/2005/8/layout/hierarchy1"/>
    <dgm:cxn modelId="{251DFE26-062A-4259-88E2-69F89EA9DC8A}" srcId="{0FEC5F71-A4F6-4D1E-AB5D-8BE3D7954440}" destId="{4948095F-A16A-4042-AF46-099869468D6C}" srcOrd="1" destOrd="0" parTransId="{03DEAAD2-3B7F-484C-BD8C-481482583683}" sibTransId="{E8517ABF-E88D-434C-A844-79A84611EE60}"/>
    <dgm:cxn modelId="{18EFC328-9C55-F545-8543-AA609E4EF30D}" type="presOf" srcId="{E8F5829B-5BE6-42B9-B521-FBAD015F9926}" destId="{CA925EC7-AFBF-894E-8C81-850641F70039}" srcOrd="0" destOrd="0" presId="urn:microsoft.com/office/officeart/2005/8/layout/hierarchy1"/>
    <dgm:cxn modelId="{B246FC2F-D6AC-4D46-9227-7EEA169D453A}" srcId="{0FEC5F71-A4F6-4D1E-AB5D-8BE3D7954440}" destId="{1BEB7012-55BD-4B6B-9BBF-9423DFC526E4}" srcOrd="0" destOrd="0" parTransId="{9465C3A5-941E-419D-84AE-560A8C0A7891}" sibTransId="{6F9E47BD-2A4F-485B-A7F3-B11E45EC96D4}"/>
    <dgm:cxn modelId="{E61A069F-4D4B-4877-B201-82B71E0D3180}" srcId="{0FEC5F71-A4F6-4D1E-AB5D-8BE3D7954440}" destId="{E8F5829B-5BE6-42B9-B521-FBAD015F9926}" srcOrd="2" destOrd="0" parTransId="{1B9033C3-505E-4B8C-B92D-30C446BD7E03}" sibTransId="{F2989C00-1A44-4CD4-B50E-430E1ED8531B}"/>
    <dgm:cxn modelId="{A7FB76E0-44DE-2640-BC57-2E1C4F99B30A}" type="presOf" srcId="{1BEB7012-55BD-4B6B-9BBF-9423DFC526E4}" destId="{83A54DD0-E610-8E45-AF70-B71C45A05C4E}" srcOrd="0" destOrd="0" presId="urn:microsoft.com/office/officeart/2005/8/layout/hierarchy1"/>
    <dgm:cxn modelId="{914809E8-99AE-0E4B-AF89-F60D3D2AE310}" type="presOf" srcId="{0FEC5F71-A4F6-4D1E-AB5D-8BE3D7954440}" destId="{709CD3E5-FB9A-ED48-A17E-FD3DE4CD23D9}" srcOrd="0" destOrd="0" presId="urn:microsoft.com/office/officeart/2005/8/layout/hierarchy1"/>
    <dgm:cxn modelId="{B4D5EDB6-5612-DD4A-981A-3C39F1E22A13}" type="presParOf" srcId="{709CD3E5-FB9A-ED48-A17E-FD3DE4CD23D9}" destId="{021B9FBE-C991-CA42-AA45-B4FCB9729D12}" srcOrd="0" destOrd="0" presId="urn:microsoft.com/office/officeart/2005/8/layout/hierarchy1"/>
    <dgm:cxn modelId="{7DB69A3B-0547-AC46-A4C5-14E89E4A3701}" type="presParOf" srcId="{021B9FBE-C991-CA42-AA45-B4FCB9729D12}" destId="{6267FFE2-6ABB-494E-BE32-E996280F16F6}" srcOrd="0" destOrd="0" presId="urn:microsoft.com/office/officeart/2005/8/layout/hierarchy1"/>
    <dgm:cxn modelId="{AC8CFBC6-36F5-1145-BD4B-817AC8AE5223}" type="presParOf" srcId="{6267FFE2-6ABB-494E-BE32-E996280F16F6}" destId="{5C2B97B4-7FA6-E64B-B9D2-BBB2179E1CD7}" srcOrd="0" destOrd="0" presId="urn:microsoft.com/office/officeart/2005/8/layout/hierarchy1"/>
    <dgm:cxn modelId="{B8C1F557-6E7C-F249-B599-64A4258453D0}" type="presParOf" srcId="{6267FFE2-6ABB-494E-BE32-E996280F16F6}" destId="{83A54DD0-E610-8E45-AF70-B71C45A05C4E}" srcOrd="1" destOrd="0" presId="urn:microsoft.com/office/officeart/2005/8/layout/hierarchy1"/>
    <dgm:cxn modelId="{26C74148-FE77-8342-B11A-8C4E2E9E09B7}" type="presParOf" srcId="{021B9FBE-C991-CA42-AA45-B4FCB9729D12}" destId="{08176267-1C1D-2E4F-A0AC-0A0954566B5F}" srcOrd="1" destOrd="0" presId="urn:microsoft.com/office/officeart/2005/8/layout/hierarchy1"/>
    <dgm:cxn modelId="{3ECD98D5-4EE7-5446-8CDD-DD6C519B8625}" type="presParOf" srcId="{709CD3E5-FB9A-ED48-A17E-FD3DE4CD23D9}" destId="{06107D26-3D70-6E49-81E7-0F1C8D53AFB1}" srcOrd="1" destOrd="0" presId="urn:microsoft.com/office/officeart/2005/8/layout/hierarchy1"/>
    <dgm:cxn modelId="{DF3E55D1-FBFE-5C48-89F3-0BD6C2D74087}" type="presParOf" srcId="{06107D26-3D70-6E49-81E7-0F1C8D53AFB1}" destId="{B55EA09B-32BE-594B-BD35-724DBE58A1AF}" srcOrd="0" destOrd="0" presId="urn:microsoft.com/office/officeart/2005/8/layout/hierarchy1"/>
    <dgm:cxn modelId="{09607EDA-6E2E-B84B-A017-7EEA9A7EC196}" type="presParOf" srcId="{B55EA09B-32BE-594B-BD35-724DBE58A1AF}" destId="{3475F31D-765C-C24F-9DBE-059E75B00609}" srcOrd="0" destOrd="0" presId="urn:microsoft.com/office/officeart/2005/8/layout/hierarchy1"/>
    <dgm:cxn modelId="{81703DC3-55F0-304B-A8BB-6AAA9742BE67}" type="presParOf" srcId="{B55EA09B-32BE-594B-BD35-724DBE58A1AF}" destId="{3202695E-C2FC-FF42-BCBD-DF44ADA5A488}" srcOrd="1" destOrd="0" presId="urn:microsoft.com/office/officeart/2005/8/layout/hierarchy1"/>
    <dgm:cxn modelId="{C05B7E9F-FBA8-B84A-B468-0D639A549A61}" type="presParOf" srcId="{06107D26-3D70-6E49-81E7-0F1C8D53AFB1}" destId="{9B8E4D7A-2611-6E48-807D-04A7A9EFE614}" srcOrd="1" destOrd="0" presId="urn:microsoft.com/office/officeart/2005/8/layout/hierarchy1"/>
    <dgm:cxn modelId="{D93D25A2-8C07-BB47-81D1-FE209E9419FC}" type="presParOf" srcId="{709CD3E5-FB9A-ED48-A17E-FD3DE4CD23D9}" destId="{C783EF47-0509-EB41-A20D-F9D3C362E603}" srcOrd="2" destOrd="0" presId="urn:microsoft.com/office/officeart/2005/8/layout/hierarchy1"/>
    <dgm:cxn modelId="{EED45B20-1379-9E4A-934F-FC07283C38D8}" type="presParOf" srcId="{C783EF47-0509-EB41-A20D-F9D3C362E603}" destId="{971B8B9A-FBD4-D64B-941B-A6686F17DBC3}" srcOrd="0" destOrd="0" presId="urn:microsoft.com/office/officeart/2005/8/layout/hierarchy1"/>
    <dgm:cxn modelId="{7F48A65D-8367-DF44-A705-018A541899A4}" type="presParOf" srcId="{971B8B9A-FBD4-D64B-941B-A6686F17DBC3}" destId="{A2D41A18-2C5E-E749-9BD2-8DA423A2AC81}" srcOrd="0" destOrd="0" presId="urn:microsoft.com/office/officeart/2005/8/layout/hierarchy1"/>
    <dgm:cxn modelId="{1E94E7D4-CA78-7546-BF21-BB88055B20FC}" type="presParOf" srcId="{971B8B9A-FBD4-D64B-941B-A6686F17DBC3}" destId="{CA925EC7-AFBF-894E-8C81-850641F70039}" srcOrd="1" destOrd="0" presId="urn:microsoft.com/office/officeart/2005/8/layout/hierarchy1"/>
    <dgm:cxn modelId="{D86D852E-9931-0B4B-A40E-9C8FB0C02A92}" type="presParOf" srcId="{C783EF47-0509-EB41-A20D-F9D3C362E603}" destId="{44404FC7-354D-524C-9410-EEA62AF227DE}"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1.xml><?xml version="1.0" encoding="utf-8"?>
<dgm:dataModel xmlns:dgm="http://schemas.openxmlformats.org/drawingml/2006/diagram" xmlns:a="http://schemas.openxmlformats.org/drawingml/2006/main">
  <dgm:ptLst>
    <dgm:pt modelId="{7D32CCBB-5037-4331-9A8D-E6C9EC03C9C7}" type="doc">
      <dgm:prSet loTypeId="urn:microsoft.com/office/officeart/2018/2/layout/IconLabelList" loCatId="icon" qsTypeId="urn:microsoft.com/office/officeart/2005/8/quickstyle/simple1" qsCatId="simple" csTypeId="urn:microsoft.com/office/officeart/2018/5/colors/Iconchunking_neutralbg_colorful5" csCatId="colorful" phldr="1"/>
      <dgm:spPr/>
      <dgm:t>
        <a:bodyPr/>
        <a:lstStyle/>
        <a:p>
          <a:endParaRPr lang="en-US"/>
        </a:p>
      </dgm:t>
    </dgm:pt>
    <dgm:pt modelId="{29C816EF-3E64-48A4-8431-88BD37AE253D}">
      <dgm:prSet/>
      <dgm:spPr/>
      <dgm:t>
        <a:bodyPr/>
        <a:lstStyle/>
        <a:p>
          <a:r>
            <a:rPr lang="en-US" dirty="0"/>
            <a:t>“Tell me more.”</a:t>
          </a:r>
        </a:p>
      </dgm:t>
    </dgm:pt>
    <dgm:pt modelId="{44C2ABAA-29AA-4AC1-BBE9-2BC782FCF122}" type="parTrans" cxnId="{2206D959-604E-407A-8413-0450AEA1B123}">
      <dgm:prSet/>
      <dgm:spPr/>
      <dgm:t>
        <a:bodyPr/>
        <a:lstStyle/>
        <a:p>
          <a:endParaRPr lang="en-US"/>
        </a:p>
      </dgm:t>
    </dgm:pt>
    <dgm:pt modelId="{ECA90194-CCC8-4812-A3BC-8A0A8AF02F30}" type="sibTrans" cxnId="{2206D959-604E-407A-8413-0450AEA1B123}">
      <dgm:prSet/>
      <dgm:spPr/>
      <dgm:t>
        <a:bodyPr/>
        <a:lstStyle/>
        <a:p>
          <a:endParaRPr lang="en-US"/>
        </a:p>
      </dgm:t>
    </dgm:pt>
    <dgm:pt modelId="{FD163E02-3B5A-4384-A693-BE30EBE280D0}">
      <dgm:prSet/>
      <dgm:spPr/>
      <dgm:t>
        <a:bodyPr/>
        <a:lstStyle/>
        <a:p>
          <a:r>
            <a:rPr lang="en-US" dirty="0"/>
            <a:t>“What’s going through your head right now?”</a:t>
          </a:r>
        </a:p>
      </dgm:t>
    </dgm:pt>
    <dgm:pt modelId="{96BB5AF1-7101-4459-8EA7-EFBE5BBCC342}" type="parTrans" cxnId="{E7F24875-3F0E-401B-B317-2DC6B9E7D0D8}">
      <dgm:prSet/>
      <dgm:spPr/>
      <dgm:t>
        <a:bodyPr/>
        <a:lstStyle/>
        <a:p>
          <a:endParaRPr lang="en-US"/>
        </a:p>
      </dgm:t>
    </dgm:pt>
    <dgm:pt modelId="{CDE12582-C9FF-4299-A7F8-E09387777095}" type="sibTrans" cxnId="{E7F24875-3F0E-401B-B317-2DC6B9E7D0D8}">
      <dgm:prSet/>
      <dgm:spPr/>
      <dgm:t>
        <a:bodyPr/>
        <a:lstStyle/>
        <a:p>
          <a:endParaRPr lang="en-US"/>
        </a:p>
      </dgm:t>
    </dgm:pt>
    <dgm:pt modelId="{3A8FE922-A42C-46E8-B37A-02FFA07EB50E}" type="pres">
      <dgm:prSet presAssocID="{7D32CCBB-5037-4331-9A8D-E6C9EC03C9C7}" presName="root" presStyleCnt="0">
        <dgm:presLayoutVars>
          <dgm:dir/>
          <dgm:resizeHandles val="exact"/>
        </dgm:presLayoutVars>
      </dgm:prSet>
      <dgm:spPr/>
    </dgm:pt>
    <dgm:pt modelId="{02F9B1AA-ECE4-49FE-83D4-BF095C3D4827}" type="pres">
      <dgm:prSet presAssocID="{29C816EF-3E64-48A4-8431-88BD37AE253D}" presName="compNode" presStyleCnt="0"/>
      <dgm:spPr/>
    </dgm:pt>
    <dgm:pt modelId="{0541918E-B5C4-4197-8C5F-91FBB402226D}" type="pres">
      <dgm:prSet presAssocID="{29C816EF-3E64-48A4-8431-88BD37AE253D}" presName="iconRect" presStyleLbl="node1" presStyleIdx="0" presStyleCnt="2"/>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a:noFill/>
        </a:ln>
      </dgm:spPr>
      <dgm:extLst>
        <a:ext uri="{E40237B7-FDA0-4F09-8148-C483321AD2D9}">
          <dgm14:cNvPr xmlns:dgm14="http://schemas.microsoft.com/office/drawing/2010/diagram" id="0" name="" descr="Marketing"/>
        </a:ext>
      </dgm:extLst>
    </dgm:pt>
    <dgm:pt modelId="{80FBC6FB-29D5-4A54-99AB-86AD59A98EAA}" type="pres">
      <dgm:prSet presAssocID="{29C816EF-3E64-48A4-8431-88BD37AE253D}" presName="spaceRect" presStyleCnt="0"/>
      <dgm:spPr/>
    </dgm:pt>
    <dgm:pt modelId="{DB5EB062-173F-4595-95B1-40B21279C8B2}" type="pres">
      <dgm:prSet presAssocID="{29C816EF-3E64-48A4-8431-88BD37AE253D}" presName="textRect" presStyleLbl="revTx" presStyleIdx="0" presStyleCnt="2">
        <dgm:presLayoutVars>
          <dgm:chMax val="1"/>
          <dgm:chPref val="1"/>
        </dgm:presLayoutVars>
      </dgm:prSet>
      <dgm:spPr/>
    </dgm:pt>
    <dgm:pt modelId="{51E02BD5-998A-4910-80AD-362BA04820CD}" type="pres">
      <dgm:prSet presAssocID="{ECA90194-CCC8-4812-A3BC-8A0A8AF02F30}" presName="sibTrans" presStyleCnt="0"/>
      <dgm:spPr/>
    </dgm:pt>
    <dgm:pt modelId="{B51D5765-C5FD-46E3-B354-127FCA918722}" type="pres">
      <dgm:prSet presAssocID="{FD163E02-3B5A-4384-A693-BE30EBE280D0}" presName="compNode" presStyleCnt="0"/>
      <dgm:spPr/>
    </dgm:pt>
    <dgm:pt modelId="{AC586C56-2D70-4C1E-A881-B99D4B68953E}" type="pres">
      <dgm:prSet presAssocID="{FD163E02-3B5A-4384-A693-BE30EBE280D0}" presName="iconRect" presStyleLbl="node1" presStyleIdx="1" presStyleCnt="2"/>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Brain"/>
        </a:ext>
      </dgm:extLst>
    </dgm:pt>
    <dgm:pt modelId="{7DE0A8C4-1498-4CC7-AC3A-0F5B54F1CECB}" type="pres">
      <dgm:prSet presAssocID="{FD163E02-3B5A-4384-A693-BE30EBE280D0}" presName="spaceRect" presStyleCnt="0"/>
      <dgm:spPr/>
    </dgm:pt>
    <dgm:pt modelId="{157BF8BB-7C62-4D0E-A56F-BD7A5E815660}" type="pres">
      <dgm:prSet presAssocID="{FD163E02-3B5A-4384-A693-BE30EBE280D0}" presName="textRect" presStyleLbl="revTx" presStyleIdx="1" presStyleCnt="2">
        <dgm:presLayoutVars>
          <dgm:chMax val="1"/>
          <dgm:chPref val="1"/>
        </dgm:presLayoutVars>
      </dgm:prSet>
      <dgm:spPr/>
    </dgm:pt>
  </dgm:ptLst>
  <dgm:cxnLst>
    <dgm:cxn modelId="{2206D959-604E-407A-8413-0450AEA1B123}" srcId="{7D32CCBB-5037-4331-9A8D-E6C9EC03C9C7}" destId="{29C816EF-3E64-48A4-8431-88BD37AE253D}" srcOrd="0" destOrd="0" parTransId="{44C2ABAA-29AA-4AC1-BBE9-2BC782FCF122}" sibTransId="{ECA90194-CCC8-4812-A3BC-8A0A8AF02F30}"/>
    <dgm:cxn modelId="{E7F24875-3F0E-401B-B317-2DC6B9E7D0D8}" srcId="{7D32CCBB-5037-4331-9A8D-E6C9EC03C9C7}" destId="{FD163E02-3B5A-4384-A693-BE30EBE280D0}" srcOrd="1" destOrd="0" parTransId="{96BB5AF1-7101-4459-8EA7-EFBE5BBCC342}" sibTransId="{CDE12582-C9FF-4299-A7F8-E09387777095}"/>
    <dgm:cxn modelId="{30AF99A6-6FB6-482C-B4CD-6785E7311DE0}" type="presOf" srcId="{29C816EF-3E64-48A4-8431-88BD37AE253D}" destId="{DB5EB062-173F-4595-95B1-40B21279C8B2}" srcOrd="0" destOrd="0" presId="urn:microsoft.com/office/officeart/2018/2/layout/IconLabelList"/>
    <dgm:cxn modelId="{4F815BBA-6DD3-41E8-A73C-366A0AEE97D8}" type="presOf" srcId="{FD163E02-3B5A-4384-A693-BE30EBE280D0}" destId="{157BF8BB-7C62-4D0E-A56F-BD7A5E815660}" srcOrd="0" destOrd="0" presId="urn:microsoft.com/office/officeart/2018/2/layout/IconLabelList"/>
    <dgm:cxn modelId="{2DAFC5FF-E0EC-491F-8CA0-800AF5543A99}" type="presOf" srcId="{7D32CCBB-5037-4331-9A8D-E6C9EC03C9C7}" destId="{3A8FE922-A42C-46E8-B37A-02FFA07EB50E}" srcOrd="0" destOrd="0" presId="urn:microsoft.com/office/officeart/2018/2/layout/IconLabelList"/>
    <dgm:cxn modelId="{E0C88E54-82BF-4726-BC0C-F084CB77D1FF}" type="presParOf" srcId="{3A8FE922-A42C-46E8-B37A-02FFA07EB50E}" destId="{02F9B1AA-ECE4-49FE-83D4-BF095C3D4827}" srcOrd="0" destOrd="0" presId="urn:microsoft.com/office/officeart/2018/2/layout/IconLabelList"/>
    <dgm:cxn modelId="{6886091E-52D7-4D23-86FA-4B6C08AD164E}" type="presParOf" srcId="{02F9B1AA-ECE4-49FE-83D4-BF095C3D4827}" destId="{0541918E-B5C4-4197-8C5F-91FBB402226D}" srcOrd="0" destOrd="0" presId="urn:microsoft.com/office/officeart/2018/2/layout/IconLabelList"/>
    <dgm:cxn modelId="{35C7642B-97EB-462B-B6A7-C4631DA779BE}" type="presParOf" srcId="{02F9B1AA-ECE4-49FE-83D4-BF095C3D4827}" destId="{80FBC6FB-29D5-4A54-99AB-86AD59A98EAA}" srcOrd="1" destOrd="0" presId="urn:microsoft.com/office/officeart/2018/2/layout/IconLabelList"/>
    <dgm:cxn modelId="{72268F37-616E-46A6-9BE1-1BA95F1518B3}" type="presParOf" srcId="{02F9B1AA-ECE4-49FE-83D4-BF095C3D4827}" destId="{DB5EB062-173F-4595-95B1-40B21279C8B2}" srcOrd="2" destOrd="0" presId="urn:microsoft.com/office/officeart/2018/2/layout/IconLabelList"/>
    <dgm:cxn modelId="{2AAC7E5F-EBD5-4965-93A6-3BE08419FBC4}" type="presParOf" srcId="{3A8FE922-A42C-46E8-B37A-02FFA07EB50E}" destId="{51E02BD5-998A-4910-80AD-362BA04820CD}" srcOrd="1" destOrd="0" presId="urn:microsoft.com/office/officeart/2018/2/layout/IconLabelList"/>
    <dgm:cxn modelId="{1C6B0215-E3BC-4A3F-883F-ED5D73C72285}" type="presParOf" srcId="{3A8FE922-A42C-46E8-B37A-02FFA07EB50E}" destId="{B51D5765-C5FD-46E3-B354-127FCA918722}" srcOrd="2" destOrd="0" presId="urn:microsoft.com/office/officeart/2018/2/layout/IconLabelList"/>
    <dgm:cxn modelId="{535D5B8A-F92E-4322-A735-90B57A9AA9FA}" type="presParOf" srcId="{B51D5765-C5FD-46E3-B354-127FCA918722}" destId="{AC586C56-2D70-4C1E-A881-B99D4B68953E}" srcOrd="0" destOrd="0" presId="urn:microsoft.com/office/officeart/2018/2/layout/IconLabelList"/>
    <dgm:cxn modelId="{828ED9C8-0A0A-411C-B4D6-2E6C803BD618}" type="presParOf" srcId="{B51D5765-C5FD-46E3-B354-127FCA918722}" destId="{7DE0A8C4-1498-4CC7-AC3A-0F5B54F1CECB}" srcOrd="1" destOrd="0" presId="urn:microsoft.com/office/officeart/2018/2/layout/IconLabelList"/>
    <dgm:cxn modelId="{B05C2923-5BE7-4BED-B097-EBA72629B2E8}" type="presParOf" srcId="{B51D5765-C5FD-46E3-B354-127FCA918722}" destId="{157BF8BB-7C62-4D0E-A56F-BD7A5E815660}" srcOrd="2" destOrd="0" presId="urn:microsoft.com/office/officeart/2018/2/layout/IconLabel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2.xml><?xml version="1.0" encoding="utf-8"?>
<dgm:dataModel xmlns:dgm="http://schemas.openxmlformats.org/drawingml/2006/diagram" xmlns:a="http://schemas.openxmlformats.org/drawingml/2006/main">
  <dgm:ptLst>
    <dgm:pt modelId="{496A023A-4154-41A3-A706-431DC3044A79}" type="doc">
      <dgm:prSet loTypeId="urn:microsoft.com/office/officeart/2018/2/layout/IconVerticalSolidList" loCatId="icon" qsTypeId="urn:microsoft.com/office/officeart/2005/8/quickstyle/simple1" qsCatId="simple" csTypeId="urn:microsoft.com/office/officeart/2005/8/colors/accent1_2" csCatId="accent1" phldr="1"/>
      <dgm:spPr/>
      <dgm:t>
        <a:bodyPr/>
        <a:lstStyle/>
        <a:p>
          <a:endParaRPr lang="en-US"/>
        </a:p>
      </dgm:t>
    </dgm:pt>
    <dgm:pt modelId="{42B3CD17-32B2-4616-9AD5-E2ABBD8F2BCE}">
      <dgm:prSet/>
      <dgm:spPr/>
      <dgm:t>
        <a:bodyPr/>
        <a:lstStyle/>
        <a:p>
          <a:pPr>
            <a:lnSpc>
              <a:spcPct val="100000"/>
            </a:lnSpc>
          </a:pPr>
          <a:r>
            <a:rPr lang="en-US" dirty="0"/>
            <a:t>S – Setting</a:t>
          </a:r>
        </a:p>
      </dgm:t>
    </dgm:pt>
    <dgm:pt modelId="{8B92682A-DB42-4063-8658-FABBE8545BBD}" type="parTrans" cxnId="{B3031236-D9FC-4645-AF38-9D0E96B5DD1B}">
      <dgm:prSet/>
      <dgm:spPr/>
      <dgm:t>
        <a:bodyPr/>
        <a:lstStyle/>
        <a:p>
          <a:endParaRPr lang="en-US"/>
        </a:p>
      </dgm:t>
    </dgm:pt>
    <dgm:pt modelId="{B68D125E-17B1-47EA-9272-53C4E3E6EAD1}" type="sibTrans" cxnId="{B3031236-D9FC-4645-AF38-9D0E96B5DD1B}">
      <dgm:prSet/>
      <dgm:spPr/>
      <dgm:t>
        <a:bodyPr/>
        <a:lstStyle/>
        <a:p>
          <a:endParaRPr lang="en-US"/>
        </a:p>
      </dgm:t>
    </dgm:pt>
    <dgm:pt modelId="{2F033F7A-7130-4E99-B782-4180D1979786}">
      <dgm:prSet/>
      <dgm:spPr/>
      <dgm:t>
        <a:bodyPr/>
        <a:lstStyle/>
        <a:p>
          <a:pPr>
            <a:lnSpc>
              <a:spcPct val="100000"/>
            </a:lnSpc>
          </a:pPr>
          <a:r>
            <a:rPr lang="en-US" dirty="0"/>
            <a:t>P – Perception</a:t>
          </a:r>
        </a:p>
      </dgm:t>
    </dgm:pt>
    <dgm:pt modelId="{F1CDE932-84F1-447C-9852-E2B12394C0D4}" type="parTrans" cxnId="{B19D2CA0-BB6E-4063-A838-B362E949B469}">
      <dgm:prSet/>
      <dgm:spPr/>
      <dgm:t>
        <a:bodyPr/>
        <a:lstStyle/>
        <a:p>
          <a:endParaRPr lang="en-US"/>
        </a:p>
      </dgm:t>
    </dgm:pt>
    <dgm:pt modelId="{FF3A545D-6EC0-46DC-B709-2B97F8BF7124}" type="sibTrans" cxnId="{B19D2CA0-BB6E-4063-A838-B362E949B469}">
      <dgm:prSet/>
      <dgm:spPr/>
      <dgm:t>
        <a:bodyPr/>
        <a:lstStyle/>
        <a:p>
          <a:endParaRPr lang="en-US"/>
        </a:p>
      </dgm:t>
    </dgm:pt>
    <dgm:pt modelId="{7D7EBB3D-9FCA-48B5-8745-5BEAB8C20F79}">
      <dgm:prSet/>
      <dgm:spPr/>
      <dgm:t>
        <a:bodyPr/>
        <a:lstStyle/>
        <a:p>
          <a:pPr>
            <a:lnSpc>
              <a:spcPct val="100000"/>
            </a:lnSpc>
          </a:pPr>
          <a:r>
            <a:rPr lang="en-US" dirty="0"/>
            <a:t>I – Invitation</a:t>
          </a:r>
        </a:p>
      </dgm:t>
    </dgm:pt>
    <dgm:pt modelId="{26F2874E-C26D-4D6B-AC81-D1BF219E5D10}" type="parTrans" cxnId="{52D95C7B-BEE1-46BD-801E-269475AD2760}">
      <dgm:prSet/>
      <dgm:spPr/>
      <dgm:t>
        <a:bodyPr/>
        <a:lstStyle/>
        <a:p>
          <a:endParaRPr lang="en-US"/>
        </a:p>
      </dgm:t>
    </dgm:pt>
    <dgm:pt modelId="{C746D7F9-8A45-4A70-B062-D70D9EED3E34}" type="sibTrans" cxnId="{52D95C7B-BEE1-46BD-801E-269475AD2760}">
      <dgm:prSet/>
      <dgm:spPr/>
      <dgm:t>
        <a:bodyPr/>
        <a:lstStyle/>
        <a:p>
          <a:endParaRPr lang="en-US"/>
        </a:p>
      </dgm:t>
    </dgm:pt>
    <dgm:pt modelId="{75A44660-85C3-40F6-8973-5376FA0BF54B}">
      <dgm:prSet/>
      <dgm:spPr/>
      <dgm:t>
        <a:bodyPr/>
        <a:lstStyle/>
        <a:p>
          <a:pPr>
            <a:lnSpc>
              <a:spcPct val="100000"/>
            </a:lnSpc>
          </a:pPr>
          <a:r>
            <a:rPr lang="en-US" dirty="0"/>
            <a:t>K – Knowledge (Warning shot/ Headline)</a:t>
          </a:r>
        </a:p>
      </dgm:t>
    </dgm:pt>
    <dgm:pt modelId="{CE9BC1C0-73F1-4AC7-9587-EAF43C4A454B}" type="parTrans" cxnId="{9F98654D-E751-4937-A183-8E4AF4B0FDDE}">
      <dgm:prSet/>
      <dgm:spPr/>
      <dgm:t>
        <a:bodyPr/>
        <a:lstStyle/>
        <a:p>
          <a:endParaRPr lang="en-US"/>
        </a:p>
      </dgm:t>
    </dgm:pt>
    <dgm:pt modelId="{16838725-7D73-4015-B9C6-A77646B4D05D}" type="sibTrans" cxnId="{9F98654D-E751-4937-A183-8E4AF4B0FDDE}">
      <dgm:prSet/>
      <dgm:spPr/>
      <dgm:t>
        <a:bodyPr/>
        <a:lstStyle/>
        <a:p>
          <a:endParaRPr lang="en-US"/>
        </a:p>
      </dgm:t>
    </dgm:pt>
    <dgm:pt modelId="{9C03FBB4-DA5E-40EF-AEFD-076F368DAE80}">
      <dgm:prSet/>
      <dgm:spPr/>
      <dgm:t>
        <a:bodyPr/>
        <a:lstStyle/>
        <a:p>
          <a:pPr>
            <a:lnSpc>
              <a:spcPct val="100000"/>
            </a:lnSpc>
          </a:pPr>
          <a:r>
            <a:rPr lang="en-US" dirty="0"/>
            <a:t>E – Emotions (N-U-R-S-E)</a:t>
          </a:r>
        </a:p>
      </dgm:t>
    </dgm:pt>
    <dgm:pt modelId="{DB2E7E75-00D3-4547-B5DF-56802673CC54}" type="parTrans" cxnId="{DF65B979-AD4A-462D-B142-DCC72C5B41ED}">
      <dgm:prSet/>
      <dgm:spPr/>
      <dgm:t>
        <a:bodyPr/>
        <a:lstStyle/>
        <a:p>
          <a:endParaRPr lang="en-US"/>
        </a:p>
      </dgm:t>
    </dgm:pt>
    <dgm:pt modelId="{06AE3834-868F-4B8F-9411-3F3735B7A3A7}" type="sibTrans" cxnId="{DF65B979-AD4A-462D-B142-DCC72C5B41ED}">
      <dgm:prSet/>
      <dgm:spPr/>
      <dgm:t>
        <a:bodyPr/>
        <a:lstStyle/>
        <a:p>
          <a:endParaRPr lang="en-US"/>
        </a:p>
      </dgm:t>
    </dgm:pt>
    <dgm:pt modelId="{DC75E8A7-C401-4975-8C56-A598064389BD}">
      <dgm:prSet/>
      <dgm:spPr/>
      <dgm:t>
        <a:bodyPr/>
        <a:lstStyle/>
        <a:p>
          <a:pPr>
            <a:lnSpc>
              <a:spcPct val="100000"/>
            </a:lnSpc>
          </a:pPr>
          <a:r>
            <a:rPr lang="en-US" dirty="0"/>
            <a:t>S – Summarize/ Strategize</a:t>
          </a:r>
        </a:p>
      </dgm:t>
    </dgm:pt>
    <dgm:pt modelId="{58B31533-D34B-419B-881C-9EAEB3AF0A50}" type="parTrans" cxnId="{96EDF5C5-2CA0-497F-9ADE-D70423B02128}">
      <dgm:prSet/>
      <dgm:spPr/>
      <dgm:t>
        <a:bodyPr/>
        <a:lstStyle/>
        <a:p>
          <a:endParaRPr lang="en-US"/>
        </a:p>
      </dgm:t>
    </dgm:pt>
    <dgm:pt modelId="{4E478654-D9A7-48DE-B0D5-0EC3966E340F}" type="sibTrans" cxnId="{96EDF5C5-2CA0-497F-9ADE-D70423B02128}">
      <dgm:prSet/>
      <dgm:spPr/>
      <dgm:t>
        <a:bodyPr/>
        <a:lstStyle/>
        <a:p>
          <a:endParaRPr lang="en-US"/>
        </a:p>
      </dgm:t>
    </dgm:pt>
    <dgm:pt modelId="{2DEB1B33-F198-48B9-B039-025EAE04C895}" type="pres">
      <dgm:prSet presAssocID="{496A023A-4154-41A3-A706-431DC3044A79}" presName="root" presStyleCnt="0">
        <dgm:presLayoutVars>
          <dgm:dir/>
          <dgm:resizeHandles val="exact"/>
        </dgm:presLayoutVars>
      </dgm:prSet>
      <dgm:spPr/>
    </dgm:pt>
    <dgm:pt modelId="{BE913123-6488-4023-A70B-2EA55AFFA393}" type="pres">
      <dgm:prSet presAssocID="{42B3CD17-32B2-4616-9AD5-E2ABBD8F2BCE}" presName="compNode" presStyleCnt="0"/>
      <dgm:spPr/>
    </dgm:pt>
    <dgm:pt modelId="{5648FA9C-5791-4E38-910F-351A9FD03B4F}" type="pres">
      <dgm:prSet presAssocID="{42B3CD17-32B2-4616-9AD5-E2ABBD8F2BCE}" presName="bgRect" presStyleLbl="bgShp" presStyleIdx="0" presStyleCnt="6"/>
      <dgm:spPr/>
    </dgm:pt>
    <dgm:pt modelId="{3AE8AD64-0148-4DC1-B61E-43529B631A55}" type="pres">
      <dgm:prSet presAssocID="{42B3CD17-32B2-4616-9AD5-E2ABBD8F2BCE}" presName="iconRect" presStyleLbl="node1" presStyleIdx="0" presStyleCnt="6"/>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dgm:spPr>
      <dgm:extLst>
        <a:ext uri="{E40237B7-FDA0-4F09-8148-C483321AD2D9}">
          <dgm14:cNvPr xmlns:dgm14="http://schemas.microsoft.com/office/drawing/2010/diagram" id="0" name="" descr="Single gear"/>
        </a:ext>
      </dgm:extLst>
    </dgm:pt>
    <dgm:pt modelId="{038E57A2-FCF3-4616-885C-A18388BE6F4C}" type="pres">
      <dgm:prSet presAssocID="{42B3CD17-32B2-4616-9AD5-E2ABBD8F2BCE}" presName="spaceRect" presStyleCnt="0"/>
      <dgm:spPr/>
    </dgm:pt>
    <dgm:pt modelId="{534BE3C3-52D9-455D-947B-6617B09E920F}" type="pres">
      <dgm:prSet presAssocID="{42B3CD17-32B2-4616-9AD5-E2ABBD8F2BCE}" presName="parTx" presStyleLbl="revTx" presStyleIdx="0" presStyleCnt="6">
        <dgm:presLayoutVars>
          <dgm:chMax val="0"/>
          <dgm:chPref val="0"/>
        </dgm:presLayoutVars>
      </dgm:prSet>
      <dgm:spPr/>
    </dgm:pt>
    <dgm:pt modelId="{F7AFF24F-D4C0-4B99-AAF4-C01D278409F1}" type="pres">
      <dgm:prSet presAssocID="{B68D125E-17B1-47EA-9272-53C4E3E6EAD1}" presName="sibTrans" presStyleCnt="0"/>
      <dgm:spPr/>
    </dgm:pt>
    <dgm:pt modelId="{A623EC76-A2C8-4C64-A5C6-F23BB6E0F59B}" type="pres">
      <dgm:prSet presAssocID="{2F033F7A-7130-4E99-B782-4180D1979786}" presName="compNode" presStyleCnt="0"/>
      <dgm:spPr/>
    </dgm:pt>
    <dgm:pt modelId="{F85F4DB7-0CEA-42D7-9176-BD08B18B0CBC}" type="pres">
      <dgm:prSet presAssocID="{2F033F7A-7130-4E99-B782-4180D1979786}" presName="bgRect" presStyleLbl="bgShp" presStyleIdx="1" presStyleCnt="6"/>
      <dgm:spPr/>
    </dgm:pt>
    <dgm:pt modelId="{685F2A81-DDF9-460F-9851-C1140F3A46C2}" type="pres">
      <dgm:prSet presAssocID="{2F033F7A-7130-4E99-B782-4180D1979786}" presName="iconRect" presStyleLbl="node1" presStyleIdx="1" presStyleCnt="6"/>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dgm:spPr>
      <dgm:extLst>
        <a:ext uri="{E40237B7-FDA0-4F09-8148-C483321AD2D9}">
          <dgm14:cNvPr xmlns:dgm14="http://schemas.microsoft.com/office/drawing/2010/diagram" id="0" name="" descr="Ruble"/>
        </a:ext>
      </dgm:extLst>
    </dgm:pt>
    <dgm:pt modelId="{577A4A24-7F90-4E43-AF5F-D9B82812AF3E}" type="pres">
      <dgm:prSet presAssocID="{2F033F7A-7130-4E99-B782-4180D1979786}" presName="spaceRect" presStyleCnt="0"/>
      <dgm:spPr/>
    </dgm:pt>
    <dgm:pt modelId="{EBEF747F-BEA2-4FC5-B8BA-03047BC59F08}" type="pres">
      <dgm:prSet presAssocID="{2F033F7A-7130-4E99-B782-4180D1979786}" presName="parTx" presStyleLbl="revTx" presStyleIdx="1" presStyleCnt="6">
        <dgm:presLayoutVars>
          <dgm:chMax val="0"/>
          <dgm:chPref val="0"/>
        </dgm:presLayoutVars>
      </dgm:prSet>
      <dgm:spPr/>
    </dgm:pt>
    <dgm:pt modelId="{52B15100-27C2-4EA3-93B0-2C6958A26DA4}" type="pres">
      <dgm:prSet presAssocID="{FF3A545D-6EC0-46DC-B709-2B97F8BF7124}" presName="sibTrans" presStyleCnt="0"/>
      <dgm:spPr/>
    </dgm:pt>
    <dgm:pt modelId="{6E75EC6E-0B06-4FE4-9D6A-32B76BFF93D1}" type="pres">
      <dgm:prSet presAssocID="{7D7EBB3D-9FCA-48B5-8745-5BEAB8C20F79}" presName="compNode" presStyleCnt="0"/>
      <dgm:spPr/>
    </dgm:pt>
    <dgm:pt modelId="{FE3A851F-EE22-48EC-8705-D984968B9D73}" type="pres">
      <dgm:prSet presAssocID="{7D7EBB3D-9FCA-48B5-8745-5BEAB8C20F79}" presName="bgRect" presStyleLbl="bgShp" presStyleIdx="2" presStyleCnt="6"/>
      <dgm:spPr/>
    </dgm:pt>
    <dgm:pt modelId="{478C50E0-5A50-4C33-B006-7E43966869E6}" type="pres">
      <dgm:prSet presAssocID="{7D7EBB3D-9FCA-48B5-8745-5BEAB8C20F79}" presName="iconRect" presStyleLbl="node1" presStyleIdx="2" presStyleCnt="6"/>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dgm:spPr>
      <dgm:extLst>
        <a:ext uri="{E40237B7-FDA0-4F09-8148-C483321AD2D9}">
          <dgm14:cNvPr xmlns:dgm14="http://schemas.microsoft.com/office/drawing/2010/diagram" id="0" name="" descr="Open envelope"/>
        </a:ext>
      </dgm:extLst>
    </dgm:pt>
    <dgm:pt modelId="{6E222A2C-949A-4EEE-855D-2EE81508C625}" type="pres">
      <dgm:prSet presAssocID="{7D7EBB3D-9FCA-48B5-8745-5BEAB8C20F79}" presName="spaceRect" presStyleCnt="0"/>
      <dgm:spPr/>
    </dgm:pt>
    <dgm:pt modelId="{12255B16-37FA-4748-B5AF-C50CF28DA9B8}" type="pres">
      <dgm:prSet presAssocID="{7D7EBB3D-9FCA-48B5-8745-5BEAB8C20F79}" presName="parTx" presStyleLbl="revTx" presStyleIdx="2" presStyleCnt="6">
        <dgm:presLayoutVars>
          <dgm:chMax val="0"/>
          <dgm:chPref val="0"/>
        </dgm:presLayoutVars>
      </dgm:prSet>
      <dgm:spPr/>
    </dgm:pt>
    <dgm:pt modelId="{3D1DEAD0-9949-4176-BE73-89D1A0879D04}" type="pres">
      <dgm:prSet presAssocID="{C746D7F9-8A45-4A70-B062-D70D9EED3E34}" presName="sibTrans" presStyleCnt="0"/>
      <dgm:spPr/>
    </dgm:pt>
    <dgm:pt modelId="{E1B64812-2311-41B0-9D75-CBCE5AA2C8C7}" type="pres">
      <dgm:prSet presAssocID="{75A44660-85C3-40F6-8973-5376FA0BF54B}" presName="compNode" presStyleCnt="0"/>
      <dgm:spPr/>
    </dgm:pt>
    <dgm:pt modelId="{39B310CD-1752-4310-9109-F2575D303ADC}" type="pres">
      <dgm:prSet presAssocID="{75A44660-85C3-40F6-8973-5376FA0BF54B}" presName="bgRect" presStyleLbl="bgShp" presStyleIdx="3" presStyleCnt="6"/>
      <dgm:spPr/>
    </dgm:pt>
    <dgm:pt modelId="{50A1C648-7A8C-4251-9B6A-DDA960D918B8}" type="pres">
      <dgm:prSet presAssocID="{75A44660-85C3-40F6-8973-5376FA0BF54B}" presName="iconRect" presStyleLbl="node1" presStyleIdx="3" presStyleCnt="6"/>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dgm:spPr>
      <dgm:extLst>
        <a:ext uri="{E40237B7-FDA0-4F09-8148-C483321AD2D9}">
          <dgm14:cNvPr xmlns:dgm14="http://schemas.microsoft.com/office/drawing/2010/diagram" id="0" name="" descr="Joker Hat"/>
        </a:ext>
      </dgm:extLst>
    </dgm:pt>
    <dgm:pt modelId="{E96B7296-4FF9-4BD8-B8B5-CEEC418EC491}" type="pres">
      <dgm:prSet presAssocID="{75A44660-85C3-40F6-8973-5376FA0BF54B}" presName="spaceRect" presStyleCnt="0"/>
      <dgm:spPr/>
    </dgm:pt>
    <dgm:pt modelId="{C0D1BEBD-524B-4E87-BE0C-CA8641868EBF}" type="pres">
      <dgm:prSet presAssocID="{75A44660-85C3-40F6-8973-5376FA0BF54B}" presName="parTx" presStyleLbl="revTx" presStyleIdx="3" presStyleCnt="6">
        <dgm:presLayoutVars>
          <dgm:chMax val="0"/>
          <dgm:chPref val="0"/>
        </dgm:presLayoutVars>
      </dgm:prSet>
      <dgm:spPr/>
    </dgm:pt>
    <dgm:pt modelId="{8C57BEF4-9EE6-4D5C-AD69-0B12491F35C2}" type="pres">
      <dgm:prSet presAssocID="{16838725-7D73-4015-B9C6-A77646B4D05D}" presName="sibTrans" presStyleCnt="0"/>
      <dgm:spPr/>
    </dgm:pt>
    <dgm:pt modelId="{FEA5D4A3-16A4-4AC6-8CAB-97B5FFA8B249}" type="pres">
      <dgm:prSet presAssocID="{9C03FBB4-DA5E-40EF-AEFD-076F368DAE80}" presName="compNode" presStyleCnt="0"/>
      <dgm:spPr/>
    </dgm:pt>
    <dgm:pt modelId="{5A76DE53-C2CE-48BE-B145-E6325D8C7206}" type="pres">
      <dgm:prSet presAssocID="{9C03FBB4-DA5E-40EF-AEFD-076F368DAE80}" presName="bgRect" presStyleLbl="bgShp" presStyleIdx="4" presStyleCnt="6"/>
      <dgm:spPr/>
    </dgm:pt>
    <dgm:pt modelId="{70E7448A-56FF-43D4-8E0E-B23F8EBA08FE}" type="pres">
      <dgm:prSet presAssocID="{9C03FBB4-DA5E-40EF-AEFD-076F368DAE80}" presName="iconRect" presStyleLbl="node1" presStyleIdx="4" presStyleCnt="6"/>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a:blipFill>
      </dgm:spPr>
      <dgm:extLst>
        <a:ext uri="{E40237B7-FDA0-4F09-8148-C483321AD2D9}">
          <dgm14:cNvPr xmlns:dgm14="http://schemas.microsoft.com/office/drawing/2010/diagram" id="0" name="" descr="Angry Face with No Fill"/>
        </a:ext>
      </dgm:extLst>
    </dgm:pt>
    <dgm:pt modelId="{09F32C20-869D-4877-8C12-87B768A68B8E}" type="pres">
      <dgm:prSet presAssocID="{9C03FBB4-DA5E-40EF-AEFD-076F368DAE80}" presName="spaceRect" presStyleCnt="0"/>
      <dgm:spPr/>
    </dgm:pt>
    <dgm:pt modelId="{51D01734-8A0F-4831-9B01-4B48F23DCBF0}" type="pres">
      <dgm:prSet presAssocID="{9C03FBB4-DA5E-40EF-AEFD-076F368DAE80}" presName="parTx" presStyleLbl="revTx" presStyleIdx="4" presStyleCnt="6">
        <dgm:presLayoutVars>
          <dgm:chMax val="0"/>
          <dgm:chPref val="0"/>
        </dgm:presLayoutVars>
      </dgm:prSet>
      <dgm:spPr/>
    </dgm:pt>
    <dgm:pt modelId="{D4C33880-F059-47CB-A3C4-0EA6DD160B3B}" type="pres">
      <dgm:prSet presAssocID="{06AE3834-868F-4B8F-9411-3F3735B7A3A7}" presName="sibTrans" presStyleCnt="0"/>
      <dgm:spPr/>
    </dgm:pt>
    <dgm:pt modelId="{6C380EC1-C192-4A46-B5D7-7D53617CDF6E}" type="pres">
      <dgm:prSet presAssocID="{DC75E8A7-C401-4975-8C56-A598064389BD}" presName="compNode" presStyleCnt="0"/>
      <dgm:spPr/>
    </dgm:pt>
    <dgm:pt modelId="{EC11F550-4088-4D45-8ACB-AF248C43A109}" type="pres">
      <dgm:prSet presAssocID="{DC75E8A7-C401-4975-8C56-A598064389BD}" presName="bgRect" presStyleLbl="bgShp" presStyleIdx="5" presStyleCnt="6"/>
      <dgm:spPr/>
    </dgm:pt>
    <dgm:pt modelId="{8D142D19-8FFD-4A4D-8EAC-F1A9E6308D66}" type="pres">
      <dgm:prSet presAssocID="{DC75E8A7-C401-4975-8C56-A598064389BD}" presName="iconRect" presStyleLbl="node1" presStyleIdx="5" presStyleCnt="6"/>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dgm:spPr>
      <dgm:extLst>
        <a:ext uri="{E40237B7-FDA0-4F09-8148-C483321AD2D9}">
          <dgm14:cNvPr xmlns:dgm14="http://schemas.microsoft.com/office/drawing/2010/diagram" id="0" name="" descr="Gauge"/>
        </a:ext>
      </dgm:extLst>
    </dgm:pt>
    <dgm:pt modelId="{5556D80B-4710-4123-A7B5-20C5BCEE5662}" type="pres">
      <dgm:prSet presAssocID="{DC75E8A7-C401-4975-8C56-A598064389BD}" presName="spaceRect" presStyleCnt="0"/>
      <dgm:spPr/>
    </dgm:pt>
    <dgm:pt modelId="{EA367B86-B21C-4DC4-8973-74BA3B264519}" type="pres">
      <dgm:prSet presAssocID="{DC75E8A7-C401-4975-8C56-A598064389BD}" presName="parTx" presStyleLbl="revTx" presStyleIdx="5" presStyleCnt="6">
        <dgm:presLayoutVars>
          <dgm:chMax val="0"/>
          <dgm:chPref val="0"/>
        </dgm:presLayoutVars>
      </dgm:prSet>
      <dgm:spPr/>
    </dgm:pt>
  </dgm:ptLst>
  <dgm:cxnLst>
    <dgm:cxn modelId="{7FAE1E1B-765E-436A-813C-8D7A3477E1D4}" type="presOf" srcId="{7D7EBB3D-9FCA-48B5-8745-5BEAB8C20F79}" destId="{12255B16-37FA-4748-B5AF-C50CF28DA9B8}" srcOrd="0" destOrd="0" presId="urn:microsoft.com/office/officeart/2018/2/layout/IconVerticalSolidList"/>
    <dgm:cxn modelId="{23EDC833-08B3-4797-BE60-77BE78C9F704}" type="presOf" srcId="{DC75E8A7-C401-4975-8C56-A598064389BD}" destId="{EA367B86-B21C-4DC4-8973-74BA3B264519}" srcOrd="0" destOrd="0" presId="urn:microsoft.com/office/officeart/2018/2/layout/IconVerticalSolidList"/>
    <dgm:cxn modelId="{B3031236-D9FC-4645-AF38-9D0E96B5DD1B}" srcId="{496A023A-4154-41A3-A706-431DC3044A79}" destId="{42B3CD17-32B2-4616-9AD5-E2ABBD8F2BCE}" srcOrd="0" destOrd="0" parTransId="{8B92682A-DB42-4063-8658-FABBE8545BBD}" sibTransId="{B68D125E-17B1-47EA-9272-53C4E3E6EAD1}"/>
    <dgm:cxn modelId="{9F98654D-E751-4937-A183-8E4AF4B0FDDE}" srcId="{496A023A-4154-41A3-A706-431DC3044A79}" destId="{75A44660-85C3-40F6-8973-5376FA0BF54B}" srcOrd="3" destOrd="0" parTransId="{CE9BC1C0-73F1-4AC7-9587-EAF43C4A454B}" sibTransId="{16838725-7D73-4015-B9C6-A77646B4D05D}"/>
    <dgm:cxn modelId="{23FCEE63-1AC9-4343-84E2-E0D5B110B4BA}" type="presOf" srcId="{496A023A-4154-41A3-A706-431DC3044A79}" destId="{2DEB1B33-F198-48B9-B039-025EAE04C895}" srcOrd="0" destOrd="0" presId="urn:microsoft.com/office/officeart/2018/2/layout/IconVerticalSolidList"/>
    <dgm:cxn modelId="{684CD36F-603E-487B-A6FA-9042B16C1D92}" type="presOf" srcId="{42B3CD17-32B2-4616-9AD5-E2ABBD8F2BCE}" destId="{534BE3C3-52D9-455D-947B-6617B09E920F}" srcOrd="0" destOrd="0" presId="urn:microsoft.com/office/officeart/2018/2/layout/IconVerticalSolidList"/>
    <dgm:cxn modelId="{45B56E77-314C-43F6-AE8B-BD8EC427DC3C}" type="presOf" srcId="{2F033F7A-7130-4E99-B782-4180D1979786}" destId="{EBEF747F-BEA2-4FC5-B8BA-03047BC59F08}" srcOrd="0" destOrd="0" presId="urn:microsoft.com/office/officeart/2018/2/layout/IconVerticalSolidList"/>
    <dgm:cxn modelId="{DF65B979-AD4A-462D-B142-DCC72C5B41ED}" srcId="{496A023A-4154-41A3-A706-431DC3044A79}" destId="{9C03FBB4-DA5E-40EF-AEFD-076F368DAE80}" srcOrd="4" destOrd="0" parTransId="{DB2E7E75-00D3-4547-B5DF-56802673CC54}" sibTransId="{06AE3834-868F-4B8F-9411-3F3735B7A3A7}"/>
    <dgm:cxn modelId="{52D95C7B-BEE1-46BD-801E-269475AD2760}" srcId="{496A023A-4154-41A3-A706-431DC3044A79}" destId="{7D7EBB3D-9FCA-48B5-8745-5BEAB8C20F79}" srcOrd="2" destOrd="0" parTransId="{26F2874E-C26D-4D6B-AC81-D1BF219E5D10}" sibTransId="{C746D7F9-8A45-4A70-B062-D70D9EED3E34}"/>
    <dgm:cxn modelId="{3C46438D-D764-4BC0-96C6-E32817D13A31}" type="presOf" srcId="{75A44660-85C3-40F6-8973-5376FA0BF54B}" destId="{C0D1BEBD-524B-4E87-BE0C-CA8641868EBF}" srcOrd="0" destOrd="0" presId="urn:microsoft.com/office/officeart/2018/2/layout/IconVerticalSolidList"/>
    <dgm:cxn modelId="{B19D2CA0-BB6E-4063-A838-B362E949B469}" srcId="{496A023A-4154-41A3-A706-431DC3044A79}" destId="{2F033F7A-7130-4E99-B782-4180D1979786}" srcOrd="1" destOrd="0" parTransId="{F1CDE932-84F1-447C-9852-E2B12394C0D4}" sibTransId="{FF3A545D-6EC0-46DC-B709-2B97F8BF7124}"/>
    <dgm:cxn modelId="{504D6FC3-EFC6-4F29-BFCF-52A25140863B}" type="presOf" srcId="{9C03FBB4-DA5E-40EF-AEFD-076F368DAE80}" destId="{51D01734-8A0F-4831-9B01-4B48F23DCBF0}" srcOrd="0" destOrd="0" presId="urn:microsoft.com/office/officeart/2018/2/layout/IconVerticalSolidList"/>
    <dgm:cxn modelId="{96EDF5C5-2CA0-497F-9ADE-D70423B02128}" srcId="{496A023A-4154-41A3-A706-431DC3044A79}" destId="{DC75E8A7-C401-4975-8C56-A598064389BD}" srcOrd="5" destOrd="0" parTransId="{58B31533-D34B-419B-881C-9EAEB3AF0A50}" sibTransId="{4E478654-D9A7-48DE-B0D5-0EC3966E340F}"/>
    <dgm:cxn modelId="{CDF9087C-DC92-4249-8189-17C22DC22C10}" type="presParOf" srcId="{2DEB1B33-F198-48B9-B039-025EAE04C895}" destId="{BE913123-6488-4023-A70B-2EA55AFFA393}" srcOrd="0" destOrd="0" presId="urn:microsoft.com/office/officeart/2018/2/layout/IconVerticalSolidList"/>
    <dgm:cxn modelId="{52A68034-169B-4320-9A33-10E9401D8D14}" type="presParOf" srcId="{BE913123-6488-4023-A70B-2EA55AFFA393}" destId="{5648FA9C-5791-4E38-910F-351A9FD03B4F}" srcOrd="0" destOrd="0" presId="urn:microsoft.com/office/officeart/2018/2/layout/IconVerticalSolidList"/>
    <dgm:cxn modelId="{FB25AFE8-7B99-4B7D-825F-5E5B5BF9C2E7}" type="presParOf" srcId="{BE913123-6488-4023-A70B-2EA55AFFA393}" destId="{3AE8AD64-0148-4DC1-B61E-43529B631A55}" srcOrd="1" destOrd="0" presId="urn:microsoft.com/office/officeart/2018/2/layout/IconVerticalSolidList"/>
    <dgm:cxn modelId="{45A536F2-80F5-495E-83D3-64E23CCC6A7D}" type="presParOf" srcId="{BE913123-6488-4023-A70B-2EA55AFFA393}" destId="{038E57A2-FCF3-4616-885C-A18388BE6F4C}" srcOrd="2" destOrd="0" presId="urn:microsoft.com/office/officeart/2018/2/layout/IconVerticalSolidList"/>
    <dgm:cxn modelId="{FC9B5CBF-1E5A-4EEC-ABAE-DFCA06258BFF}" type="presParOf" srcId="{BE913123-6488-4023-A70B-2EA55AFFA393}" destId="{534BE3C3-52D9-455D-947B-6617B09E920F}" srcOrd="3" destOrd="0" presId="urn:microsoft.com/office/officeart/2018/2/layout/IconVerticalSolidList"/>
    <dgm:cxn modelId="{9E2D67D4-E45F-4083-9D6D-805FEB8E7A5C}" type="presParOf" srcId="{2DEB1B33-F198-48B9-B039-025EAE04C895}" destId="{F7AFF24F-D4C0-4B99-AAF4-C01D278409F1}" srcOrd="1" destOrd="0" presId="urn:microsoft.com/office/officeart/2018/2/layout/IconVerticalSolidList"/>
    <dgm:cxn modelId="{59BAD4DA-4A94-4DFE-ADB1-3D268F0EEB38}" type="presParOf" srcId="{2DEB1B33-F198-48B9-B039-025EAE04C895}" destId="{A623EC76-A2C8-4C64-A5C6-F23BB6E0F59B}" srcOrd="2" destOrd="0" presId="urn:microsoft.com/office/officeart/2018/2/layout/IconVerticalSolidList"/>
    <dgm:cxn modelId="{C31BCBE9-6183-46E4-91CF-6552F7E0AB11}" type="presParOf" srcId="{A623EC76-A2C8-4C64-A5C6-F23BB6E0F59B}" destId="{F85F4DB7-0CEA-42D7-9176-BD08B18B0CBC}" srcOrd="0" destOrd="0" presId="urn:microsoft.com/office/officeart/2018/2/layout/IconVerticalSolidList"/>
    <dgm:cxn modelId="{146BEF51-058C-4E1F-8592-1B64587BE5C4}" type="presParOf" srcId="{A623EC76-A2C8-4C64-A5C6-F23BB6E0F59B}" destId="{685F2A81-DDF9-460F-9851-C1140F3A46C2}" srcOrd="1" destOrd="0" presId="urn:microsoft.com/office/officeart/2018/2/layout/IconVerticalSolidList"/>
    <dgm:cxn modelId="{1D649447-A268-485C-A4F0-3C56B9F25617}" type="presParOf" srcId="{A623EC76-A2C8-4C64-A5C6-F23BB6E0F59B}" destId="{577A4A24-7F90-4E43-AF5F-D9B82812AF3E}" srcOrd="2" destOrd="0" presId="urn:microsoft.com/office/officeart/2018/2/layout/IconVerticalSolidList"/>
    <dgm:cxn modelId="{8699BDCD-DC72-46C6-BA3C-85C7D3251FA2}" type="presParOf" srcId="{A623EC76-A2C8-4C64-A5C6-F23BB6E0F59B}" destId="{EBEF747F-BEA2-4FC5-B8BA-03047BC59F08}" srcOrd="3" destOrd="0" presId="urn:microsoft.com/office/officeart/2018/2/layout/IconVerticalSolidList"/>
    <dgm:cxn modelId="{93D8A04E-FDB3-479F-BFB5-E5BD887EF7E7}" type="presParOf" srcId="{2DEB1B33-F198-48B9-B039-025EAE04C895}" destId="{52B15100-27C2-4EA3-93B0-2C6958A26DA4}" srcOrd="3" destOrd="0" presId="urn:microsoft.com/office/officeart/2018/2/layout/IconVerticalSolidList"/>
    <dgm:cxn modelId="{3FE4117E-00E6-462A-8E3A-5A77CC0783D9}" type="presParOf" srcId="{2DEB1B33-F198-48B9-B039-025EAE04C895}" destId="{6E75EC6E-0B06-4FE4-9D6A-32B76BFF93D1}" srcOrd="4" destOrd="0" presId="urn:microsoft.com/office/officeart/2018/2/layout/IconVerticalSolidList"/>
    <dgm:cxn modelId="{35103347-2C7C-435C-9762-AAFC110E8B22}" type="presParOf" srcId="{6E75EC6E-0B06-4FE4-9D6A-32B76BFF93D1}" destId="{FE3A851F-EE22-48EC-8705-D984968B9D73}" srcOrd="0" destOrd="0" presId="urn:microsoft.com/office/officeart/2018/2/layout/IconVerticalSolidList"/>
    <dgm:cxn modelId="{1B7EB0FA-6FF9-4C8C-8E23-F962A667C009}" type="presParOf" srcId="{6E75EC6E-0B06-4FE4-9D6A-32B76BFF93D1}" destId="{478C50E0-5A50-4C33-B006-7E43966869E6}" srcOrd="1" destOrd="0" presId="urn:microsoft.com/office/officeart/2018/2/layout/IconVerticalSolidList"/>
    <dgm:cxn modelId="{B9A8DF5F-0DBF-4210-9182-138DE61E951C}" type="presParOf" srcId="{6E75EC6E-0B06-4FE4-9D6A-32B76BFF93D1}" destId="{6E222A2C-949A-4EEE-855D-2EE81508C625}" srcOrd="2" destOrd="0" presId="urn:microsoft.com/office/officeart/2018/2/layout/IconVerticalSolidList"/>
    <dgm:cxn modelId="{D2F4B304-B376-4608-A01F-637469C8D7D7}" type="presParOf" srcId="{6E75EC6E-0B06-4FE4-9D6A-32B76BFF93D1}" destId="{12255B16-37FA-4748-B5AF-C50CF28DA9B8}" srcOrd="3" destOrd="0" presId="urn:microsoft.com/office/officeart/2018/2/layout/IconVerticalSolidList"/>
    <dgm:cxn modelId="{610057B6-0315-44AD-90A5-6DD8758A7468}" type="presParOf" srcId="{2DEB1B33-F198-48B9-B039-025EAE04C895}" destId="{3D1DEAD0-9949-4176-BE73-89D1A0879D04}" srcOrd="5" destOrd="0" presId="urn:microsoft.com/office/officeart/2018/2/layout/IconVerticalSolidList"/>
    <dgm:cxn modelId="{90E59087-18A4-4422-8013-F95B85165774}" type="presParOf" srcId="{2DEB1B33-F198-48B9-B039-025EAE04C895}" destId="{E1B64812-2311-41B0-9D75-CBCE5AA2C8C7}" srcOrd="6" destOrd="0" presId="urn:microsoft.com/office/officeart/2018/2/layout/IconVerticalSolidList"/>
    <dgm:cxn modelId="{4D95366E-9DAC-4CFF-8598-4FF55D0DB1D9}" type="presParOf" srcId="{E1B64812-2311-41B0-9D75-CBCE5AA2C8C7}" destId="{39B310CD-1752-4310-9109-F2575D303ADC}" srcOrd="0" destOrd="0" presId="urn:microsoft.com/office/officeart/2018/2/layout/IconVerticalSolidList"/>
    <dgm:cxn modelId="{11A9F604-A169-4F53-B67C-19A9D0695E0F}" type="presParOf" srcId="{E1B64812-2311-41B0-9D75-CBCE5AA2C8C7}" destId="{50A1C648-7A8C-4251-9B6A-DDA960D918B8}" srcOrd="1" destOrd="0" presId="urn:microsoft.com/office/officeart/2018/2/layout/IconVerticalSolidList"/>
    <dgm:cxn modelId="{ED7D1B6C-0E2E-4955-A96E-D8B85E3CDC4C}" type="presParOf" srcId="{E1B64812-2311-41B0-9D75-CBCE5AA2C8C7}" destId="{E96B7296-4FF9-4BD8-B8B5-CEEC418EC491}" srcOrd="2" destOrd="0" presId="urn:microsoft.com/office/officeart/2018/2/layout/IconVerticalSolidList"/>
    <dgm:cxn modelId="{7160688D-C0CF-4664-9B91-93D972C89402}" type="presParOf" srcId="{E1B64812-2311-41B0-9D75-CBCE5AA2C8C7}" destId="{C0D1BEBD-524B-4E87-BE0C-CA8641868EBF}" srcOrd="3" destOrd="0" presId="urn:microsoft.com/office/officeart/2018/2/layout/IconVerticalSolidList"/>
    <dgm:cxn modelId="{5DF281A2-C9DE-4887-A96D-A894F5DD441B}" type="presParOf" srcId="{2DEB1B33-F198-48B9-B039-025EAE04C895}" destId="{8C57BEF4-9EE6-4D5C-AD69-0B12491F35C2}" srcOrd="7" destOrd="0" presId="urn:microsoft.com/office/officeart/2018/2/layout/IconVerticalSolidList"/>
    <dgm:cxn modelId="{765B5112-3B8B-436D-A91D-C65723DEDD65}" type="presParOf" srcId="{2DEB1B33-F198-48B9-B039-025EAE04C895}" destId="{FEA5D4A3-16A4-4AC6-8CAB-97B5FFA8B249}" srcOrd="8" destOrd="0" presId="urn:microsoft.com/office/officeart/2018/2/layout/IconVerticalSolidList"/>
    <dgm:cxn modelId="{B4A26053-56AE-4CA7-82E0-426D7E381590}" type="presParOf" srcId="{FEA5D4A3-16A4-4AC6-8CAB-97B5FFA8B249}" destId="{5A76DE53-C2CE-48BE-B145-E6325D8C7206}" srcOrd="0" destOrd="0" presId="urn:microsoft.com/office/officeart/2018/2/layout/IconVerticalSolidList"/>
    <dgm:cxn modelId="{9CB01CB5-F9DB-4D0D-B85F-809781804FA8}" type="presParOf" srcId="{FEA5D4A3-16A4-4AC6-8CAB-97B5FFA8B249}" destId="{70E7448A-56FF-43D4-8E0E-B23F8EBA08FE}" srcOrd="1" destOrd="0" presId="urn:microsoft.com/office/officeart/2018/2/layout/IconVerticalSolidList"/>
    <dgm:cxn modelId="{19DB535A-D101-46D1-AC8E-5C1366ACD049}" type="presParOf" srcId="{FEA5D4A3-16A4-4AC6-8CAB-97B5FFA8B249}" destId="{09F32C20-869D-4877-8C12-87B768A68B8E}" srcOrd="2" destOrd="0" presId="urn:microsoft.com/office/officeart/2018/2/layout/IconVerticalSolidList"/>
    <dgm:cxn modelId="{B6BC9EAD-BD6E-4C06-80C2-D93CA7DD0D17}" type="presParOf" srcId="{FEA5D4A3-16A4-4AC6-8CAB-97B5FFA8B249}" destId="{51D01734-8A0F-4831-9B01-4B48F23DCBF0}" srcOrd="3" destOrd="0" presId="urn:microsoft.com/office/officeart/2018/2/layout/IconVerticalSolidList"/>
    <dgm:cxn modelId="{B4DBDE3B-0CBA-436A-9CA7-61FA2E0B0EF3}" type="presParOf" srcId="{2DEB1B33-F198-48B9-B039-025EAE04C895}" destId="{D4C33880-F059-47CB-A3C4-0EA6DD160B3B}" srcOrd="9" destOrd="0" presId="urn:microsoft.com/office/officeart/2018/2/layout/IconVerticalSolidList"/>
    <dgm:cxn modelId="{BF23558C-C5FF-4703-BC4E-BA6C47E776F9}" type="presParOf" srcId="{2DEB1B33-F198-48B9-B039-025EAE04C895}" destId="{6C380EC1-C192-4A46-B5D7-7D53617CDF6E}" srcOrd="10" destOrd="0" presId="urn:microsoft.com/office/officeart/2018/2/layout/IconVerticalSolidList"/>
    <dgm:cxn modelId="{BE8AC4E6-480B-4E25-9628-B168239ED301}" type="presParOf" srcId="{6C380EC1-C192-4A46-B5D7-7D53617CDF6E}" destId="{EC11F550-4088-4D45-8ACB-AF248C43A109}" srcOrd="0" destOrd="0" presId="urn:microsoft.com/office/officeart/2018/2/layout/IconVerticalSolidList"/>
    <dgm:cxn modelId="{3279D73D-A06F-4C7C-87DA-323E23978560}" type="presParOf" srcId="{6C380EC1-C192-4A46-B5D7-7D53617CDF6E}" destId="{8D142D19-8FFD-4A4D-8EAC-F1A9E6308D66}" srcOrd="1" destOrd="0" presId="urn:microsoft.com/office/officeart/2018/2/layout/IconVerticalSolidList"/>
    <dgm:cxn modelId="{CC185888-7479-4E67-91C0-B8E933726363}" type="presParOf" srcId="{6C380EC1-C192-4A46-B5D7-7D53617CDF6E}" destId="{5556D80B-4710-4123-A7B5-20C5BCEE5662}" srcOrd="2" destOrd="0" presId="urn:microsoft.com/office/officeart/2018/2/layout/IconVerticalSolidList"/>
    <dgm:cxn modelId="{8FE53B28-F884-4CAE-835A-7FB12DA753A2}" type="presParOf" srcId="{6C380EC1-C192-4A46-B5D7-7D53617CDF6E}" destId="{EA367B86-B21C-4DC4-8973-74BA3B264519}"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3.xml><?xml version="1.0" encoding="utf-8"?>
<dgm:dataModel xmlns:dgm="http://schemas.openxmlformats.org/drawingml/2006/diagram" xmlns:a="http://schemas.openxmlformats.org/drawingml/2006/main">
  <dgm:ptLst>
    <dgm:pt modelId="{877EA7BB-EA69-49AF-9376-B28DC124BBBD}" type="doc">
      <dgm:prSet loTypeId="urn:microsoft.com/office/officeart/2018/2/layout/IconVerticalSolidList" loCatId="icon" qsTypeId="urn:microsoft.com/office/officeart/2005/8/quickstyle/simple1" qsCatId="simple" csTypeId="urn:microsoft.com/office/officeart/2005/8/colors/accent1_2" csCatId="accent1" phldr="1"/>
      <dgm:spPr/>
      <dgm:t>
        <a:bodyPr/>
        <a:lstStyle/>
        <a:p>
          <a:endParaRPr lang="en-US"/>
        </a:p>
      </dgm:t>
    </dgm:pt>
    <dgm:pt modelId="{940BD540-36B9-4F0E-A9E4-4C9C3B98FC19}">
      <dgm:prSet/>
      <dgm:spPr/>
      <dgm:t>
        <a:bodyPr/>
        <a:lstStyle/>
        <a:p>
          <a:pPr>
            <a:lnSpc>
              <a:spcPct val="100000"/>
            </a:lnSpc>
          </a:pPr>
          <a:r>
            <a:rPr lang="en-US" dirty="0"/>
            <a:t>1. Baile WF, Buckman R, Lenzi R, Glober G, Beale EA, Kudelka AP, SPIKES-A six-step protocol for delivering bad news: application to the patient with cancer. </a:t>
          </a:r>
          <a:r>
            <a:rPr lang="en-US" i="1" dirty="0"/>
            <a:t>The Oncologist</a:t>
          </a:r>
          <a:r>
            <a:rPr lang="en-US" dirty="0"/>
            <a:t>. 2000:5(4):302-311.</a:t>
          </a:r>
        </a:p>
      </dgm:t>
    </dgm:pt>
    <dgm:pt modelId="{2AC20E60-C3FD-4628-9C1A-B891369989F7}" type="parTrans" cxnId="{38C29059-2149-47BB-81D5-7B384F18A25A}">
      <dgm:prSet/>
      <dgm:spPr/>
      <dgm:t>
        <a:bodyPr/>
        <a:lstStyle/>
        <a:p>
          <a:endParaRPr lang="en-US"/>
        </a:p>
      </dgm:t>
    </dgm:pt>
    <dgm:pt modelId="{92F1A063-AB2C-4E03-899F-1E0AE2387F2D}" type="sibTrans" cxnId="{38C29059-2149-47BB-81D5-7B384F18A25A}">
      <dgm:prSet/>
      <dgm:spPr/>
      <dgm:t>
        <a:bodyPr/>
        <a:lstStyle/>
        <a:p>
          <a:endParaRPr lang="en-US"/>
        </a:p>
      </dgm:t>
    </dgm:pt>
    <dgm:pt modelId="{E51BC175-CF16-4F5C-B322-3D513FF79265}">
      <dgm:prSet/>
      <dgm:spPr/>
      <dgm:t>
        <a:bodyPr/>
        <a:lstStyle/>
        <a:p>
          <a:pPr>
            <a:lnSpc>
              <a:spcPct val="100000"/>
            </a:lnSpc>
          </a:pPr>
          <a:r>
            <a:rPr lang="en-US" dirty="0"/>
            <a:t>2. McFarlin J, Tulsky JA, Back AL, Arnold RM. A Talking Map for Family Meetings in the Intensive Care Unit. </a:t>
          </a:r>
          <a:r>
            <a:rPr lang="en-US" i="1" dirty="0"/>
            <a:t>JCOM</a:t>
          </a:r>
          <a:r>
            <a:rPr lang="en-US" dirty="0"/>
            <a:t>. 2017;24(1):15-22.</a:t>
          </a:r>
        </a:p>
      </dgm:t>
    </dgm:pt>
    <dgm:pt modelId="{A7CC23F2-417C-4C22-819D-0FC56531163D}" type="parTrans" cxnId="{A1AB7C6B-9399-403B-9345-879CFD7E2B50}">
      <dgm:prSet/>
      <dgm:spPr/>
      <dgm:t>
        <a:bodyPr/>
        <a:lstStyle/>
        <a:p>
          <a:endParaRPr lang="en-US"/>
        </a:p>
      </dgm:t>
    </dgm:pt>
    <dgm:pt modelId="{D9980DA6-C513-4827-920F-3431DD2B5724}" type="sibTrans" cxnId="{A1AB7C6B-9399-403B-9345-879CFD7E2B50}">
      <dgm:prSet/>
      <dgm:spPr/>
      <dgm:t>
        <a:bodyPr/>
        <a:lstStyle/>
        <a:p>
          <a:endParaRPr lang="en-US"/>
        </a:p>
      </dgm:t>
    </dgm:pt>
    <dgm:pt modelId="{498E12E7-A783-4AAE-A2BB-7936A3A8C2DB}">
      <dgm:prSet/>
      <dgm:spPr/>
      <dgm:t>
        <a:bodyPr/>
        <a:lstStyle/>
        <a:p>
          <a:pPr>
            <a:lnSpc>
              <a:spcPct val="100000"/>
            </a:lnSpc>
          </a:pPr>
          <a:r>
            <a:rPr lang="en-US" dirty="0"/>
            <a:t>3. Back AL, Trinidad SB, Hopley RK, Arnold RM, Baile WF, Edwards KA. What patients value when oncologists give news of cancer recurrence: commentary on specific moments in audio-recorded conversations. </a:t>
          </a:r>
          <a:r>
            <a:rPr lang="en-US" i="1" dirty="0"/>
            <a:t>The Oncologist. </a:t>
          </a:r>
          <a:r>
            <a:rPr lang="en-US" dirty="0"/>
            <a:t>2011;16(3):342-350.</a:t>
          </a:r>
        </a:p>
      </dgm:t>
    </dgm:pt>
    <dgm:pt modelId="{7C4F2579-69FB-40FE-9829-1A432649F831}" type="parTrans" cxnId="{024BC111-477C-4612-8F6D-E0DA32A3EDC8}">
      <dgm:prSet/>
      <dgm:spPr/>
      <dgm:t>
        <a:bodyPr/>
        <a:lstStyle/>
        <a:p>
          <a:endParaRPr lang="en-US"/>
        </a:p>
      </dgm:t>
    </dgm:pt>
    <dgm:pt modelId="{AF862CBF-EC98-45FC-B6DD-64EA53D0B700}" type="sibTrans" cxnId="{024BC111-477C-4612-8F6D-E0DA32A3EDC8}">
      <dgm:prSet/>
      <dgm:spPr/>
      <dgm:t>
        <a:bodyPr/>
        <a:lstStyle/>
        <a:p>
          <a:endParaRPr lang="en-US"/>
        </a:p>
      </dgm:t>
    </dgm:pt>
    <dgm:pt modelId="{B9376EEA-C7BD-40EF-8ECE-F9EEF87BB7B5}" type="pres">
      <dgm:prSet presAssocID="{877EA7BB-EA69-49AF-9376-B28DC124BBBD}" presName="root" presStyleCnt="0">
        <dgm:presLayoutVars>
          <dgm:dir/>
          <dgm:resizeHandles val="exact"/>
        </dgm:presLayoutVars>
      </dgm:prSet>
      <dgm:spPr/>
    </dgm:pt>
    <dgm:pt modelId="{60E4FFC8-304E-4B49-823B-C1C30D774061}" type="pres">
      <dgm:prSet presAssocID="{940BD540-36B9-4F0E-A9E4-4C9C3B98FC19}" presName="compNode" presStyleCnt="0"/>
      <dgm:spPr/>
    </dgm:pt>
    <dgm:pt modelId="{2A5F056D-40AF-4B07-B581-5960672621BE}" type="pres">
      <dgm:prSet presAssocID="{940BD540-36B9-4F0E-A9E4-4C9C3B98FC19}" presName="bgRect" presStyleLbl="bgShp" presStyleIdx="0" presStyleCnt="3"/>
      <dgm:spPr/>
    </dgm:pt>
    <dgm:pt modelId="{AD9F9987-C066-40FD-94DE-CC3353BE782C}" type="pres">
      <dgm:prSet presAssocID="{940BD540-36B9-4F0E-A9E4-4C9C3B98FC19}" presName="iconRect" presStyleLbl="node1" presStyleIdx="0" presStyleCnt="3"/>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dgm:spPr>
      <dgm:extLst>
        <a:ext uri="{E40237B7-FDA0-4F09-8148-C483321AD2D9}">
          <dgm14:cNvPr xmlns:dgm14="http://schemas.microsoft.com/office/drawing/2010/diagram" id="0" name="" descr="Beach umbrella"/>
        </a:ext>
      </dgm:extLst>
    </dgm:pt>
    <dgm:pt modelId="{7DE2301F-663A-48B6-8430-79FA741EF1C6}" type="pres">
      <dgm:prSet presAssocID="{940BD540-36B9-4F0E-A9E4-4C9C3B98FC19}" presName="spaceRect" presStyleCnt="0"/>
      <dgm:spPr/>
    </dgm:pt>
    <dgm:pt modelId="{F93B3F01-420C-4E65-BAC0-A50C36994A8D}" type="pres">
      <dgm:prSet presAssocID="{940BD540-36B9-4F0E-A9E4-4C9C3B98FC19}" presName="parTx" presStyleLbl="revTx" presStyleIdx="0" presStyleCnt="3">
        <dgm:presLayoutVars>
          <dgm:chMax val="0"/>
          <dgm:chPref val="0"/>
        </dgm:presLayoutVars>
      </dgm:prSet>
      <dgm:spPr/>
    </dgm:pt>
    <dgm:pt modelId="{BC99562A-2496-44BA-B50E-48ABC7DFB7D3}" type="pres">
      <dgm:prSet presAssocID="{92F1A063-AB2C-4E03-899F-1E0AE2387F2D}" presName="sibTrans" presStyleCnt="0"/>
      <dgm:spPr/>
    </dgm:pt>
    <dgm:pt modelId="{A7FBBE68-929C-4DE4-9063-4774A7F86A90}" type="pres">
      <dgm:prSet presAssocID="{E51BC175-CF16-4F5C-B322-3D513FF79265}" presName="compNode" presStyleCnt="0"/>
      <dgm:spPr/>
    </dgm:pt>
    <dgm:pt modelId="{96720891-DA80-445A-A89F-E55DFC95B187}" type="pres">
      <dgm:prSet presAssocID="{E51BC175-CF16-4F5C-B322-3D513FF79265}" presName="bgRect" presStyleLbl="bgShp" presStyleIdx="1" presStyleCnt="3"/>
      <dgm:spPr/>
    </dgm:pt>
    <dgm:pt modelId="{A0376A1A-C8F9-4B3C-8471-AD2974CD1905}" type="pres">
      <dgm:prSet presAssocID="{E51BC175-CF16-4F5C-B322-3D513FF79265}" presName="iconRect" presStyleLbl="node1" presStyleIdx="1" presStyleCnt="3"/>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dgm:spPr>
      <dgm:extLst>
        <a:ext uri="{E40237B7-FDA0-4F09-8148-C483321AD2D9}">
          <dgm14:cNvPr xmlns:dgm14="http://schemas.microsoft.com/office/drawing/2010/diagram" id="0" name="" descr="Board Room"/>
        </a:ext>
      </dgm:extLst>
    </dgm:pt>
    <dgm:pt modelId="{EB3CC7B7-156F-4496-A735-E765FE73DBA3}" type="pres">
      <dgm:prSet presAssocID="{E51BC175-CF16-4F5C-B322-3D513FF79265}" presName="spaceRect" presStyleCnt="0"/>
      <dgm:spPr/>
    </dgm:pt>
    <dgm:pt modelId="{1B95DD4F-9F3D-4A52-876A-0F717C9D4398}" type="pres">
      <dgm:prSet presAssocID="{E51BC175-CF16-4F5C-B322-3D513FF79265}" presName="parTx" presStyleLbl="revTx" presStyleIdx="1" presStyleCnt="3">
        <dgm:presLayoutVars>
          <dgm:chMax val="0"/>
          <dgm:chPref val="0"/>
        </dgm:presLayoutVars>
      </dgm:prSet>
      <dgm:spPr/>
    </dgm:pt>
    <dgm:pt modelId="{42690175-0997-4CD2-AE32-613EE112F276}" type="pres">
      <dgm:prSet presAssocID="{D9980DA6-C513-4827-920F-3431DD2B5724}" presName="sibTrans" presStyleCnt="0"/>
      <dgm:spPr/>
    </dgm:pt>
    <dgm:pt modelId="{749F80D1-37F0-48C3-AA2B-49823D0057FC}" type="pres">
      <dgm:prSet presAssocID="{498E12E7-A783-4AAE-A2BB-7936A3A8C2DB}" presName="compNode" presStyleCnt="0"/>
      <dgm:spPr/>
    </dgm:pt>
    <dgm:pt modelId="{9B51B464-9923-4148-B69F-53A083A4F03B}" type="pres">
      <dgm:prSet presAssocID="{498E12E7-A783-4AAE-A2BB-7936A3A8C2DB}" presName="bgRect" presStyleLbl="bgShp" presStyleIdx="2" presStyleCnt="3"/>
      <dgm:spPr/>
    </dgm:pt>
    <dgm:pt modelId="{C64CD0DE-F9E9-4305-B321-73D579F996ED}" type="pres">
      <dgm:prSet presAssocID="{498E12E7-A783-4AAE-A2BB-7936A3A8C2DB}" presName="iconRect" presStyleLbl="node1" presStyleIdx="2" presStyleCnt="3"/>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dgm:spPr>
      <dgm:extLst>
        <a:ext uri="{E40237B7-FDA0-4F09-8148-C483321AD2D9}">
          <dgm14:cNvPr xmlns:dgm14="http://schemas.microsoft.com/office/drawing/2010/diagram" id="0" name="" descr="Questions"/>
        </a:ext>
      </dgm:extLst>
    </dgm:pt>
    <dgm:pt modelId="{49088A19-2B4E-4E3D-B3D9-65F05FA4B8E2}" type="pres">
      <dgm:prSet presAssocID="{498E12E7-A783-4AAE-A2BB-7936A3A8C2DB}" presName="spaceRect" presStyleCnt="0"/>
      <dgm:spPr/>
    </dgm:pt>
    <dgm:pt modelId="{06FF8B16-C155-4CF6-8284-ABBE9887B286}" type="pres">
      <dgm:prSet presAssocID="{498E12E7-A783-4AAE-A2BB-7936A3A8C2DB}" presName="parTx" presStyleLbl="revTx" presStyleIdx="2" presStyleCnt="3">
        <dgm:presLayoutVars>
          <dgm:chMax val="0"/>
          <dgm:chPref val="0"/>
        </dgm:presLayoutVars>
      </dgm:prSet>
      <dgm:spPr/>
    </dgm:pt>
  </dgm:ptLst>
  <dgm:cxnLst>
    <dgm:cxn modelId="{55DB5F09-C85D-4199-A9BA-783B432EEB3A}" type="presOf" srcId="{E51BC175-CF16-4F5C-B322-3D513FF79265}" destId="{1B95DD4F-9F3D-4A52-876A-0F717C9D4398}" srcOrd="0" destOrd="0" presId="urn:microsoft.com/office/officeart/2018/2/layout/IconVerticalSolidList"/>
    <dgm:cxn modelId="{97755C0D-2B1F-4892-BB13-3532021A5831}" type="presOf" srcId="{940BD540-36B9-4F0E-A9E4-4C9C3B98FC19}" destId="{F93B3F01-420C-4E65-BAC0-A50C36994A8D}" srcOrd="0" destOrd="0" presId="urn:microsoft.com/office/officeart/2018/2/layout/IconVerticalSolidList"/>
    <dgm:cxn modelId="{024BC111-477C-4612-8F6D-E0DA32A3EDC8}" srcId="{877EA7BB-EA69-49AF-9376-B28DC124BBBD}" destId="{498E12E7-A783-4AAE-A2BB-7936A3A8C2DB}" srcOrd="2" destOrd="0" parTransId="{7C4F2579-69FB-40FE-9829-1A432649F831}" sibTransId="{AF862CBF-EC98-45FC-B6DD-64EA53D0B700}"/>
    <dgm:cxn modelId="{38C29059-2149-47BB-81D5-7B384F18A25A}" srcId="{877EA7BB-EA69-49AF-9376-B28DC124BBBD}" destId="{940BD540-36B9-4F0E-A9E4-4C9C3B98FC19}" srcOrd="0" destOrd="0" parTransId="{2AC20E60-C3FD-4628-9C1A-B891369989F7}" sibTransId="{92F1A063-AB2C-4E03-899F-1E0AE2387F2D}"/>
    <dgm:cxn modelId="{A1AB7C6B-9399-403B-9345-879CFD7E2B50}" srcId="{877EA7BB-EA69-49AF-9376-B28DC124BBBD}" destId="{E51BC175-CF16-4F5C-B322-3D513FF79265}" srcOrd="1" destOrd="0" parTransId="{A7CC23F2-417C-4C22-819D-0FC56531163D}" sibTransId="{D9980DA6-C513-4827-920F-3431DD2B5724}"/>
    <dgm:cxn modelId="{717AA08F-E909-4EC7-8AC8-3B4E5741C49A}" type="presOf" srcId="{498E12E7-A783-4AAE-A2BB-7936A3A8C2DB}" destId="{06FF8B16-C155-4CF6-8284-ABBE9887B286}" srcOrd="0" destOrd="0" presId="urn:microsoft.com/office/officeart/2018/2/layout/IconVerticalSolidList"/>
    <dgm:cxn modelId="{DA91BBEB-6580-4D5B-AE1D-6888F56B4159}" type="presOf" srcId="{877EA7BB-EA69-49AF-9376-B28DC124BBBD}" destId="{B9376EEA-C7BD-40EF-8ECE-F9EEF87BB7B5}" srcOrd="0" destOrd="0" presId="urn:microsoft.com/office/officeart/2018/2/layout/IconVerticalSolidList"/>
    <dgm:cxn modelId="{E1F6395C-4D2A-4EC7-B1A4-291010F1EFA6}" type="presParOf" srcId="{B9376EEA-C7BD-40EF-8ECE-F9EEF87BB7B5}" destId="{60E4FFC8-304E-4B49-823B-C1C30D774061}" srcOrd="0" destOrd="0" presId="urn:microsoft.com/office/officeart/2018/2/layout/IconVerticalSolidList"/>
    <dgm:cxn modelId="{7C13BDF1-5182-49D0-9DB0-823C7A2EAD8A}" type="presParOf" srcId="{60E4FFC8-304E-4B49-823B-C1C30D774061}" destId="{2A5F056D-40AF-4B07-B581-5960672621BE}" srcOrd="0" destOrd="0" presId="urn:microsoft.com/office/officeart/2018/2/layout/IconVerticalSolidList"/>
    <dgm:cxn modelId="{A5D21C76-B80B-4DD1-BBAC-37A5C5A1FBFF}" type="presParOf" srcId="{60E4FFC8-304E-4B49-823B-C1C30D774061}" destId="{AD9F9987-C066-40FD-94DE-CC3353BE782C}" srcOrd="1" destOrd="0" presId="urn:microsoft.com/office/officeart/2018/2/layout/IconVerticalSolidList"/>
    <dgm:cxn modelId="{5E1B9336-F516-4879-97E9-308B86C77720}" type="presParOf" srcId="{60E4FFC8-304E-4B49-823B-C1C30D774061}" destId="{7DE2301F-663A-48B6-8430-79FA741EF1C6}" srcOrd="2" destOrd="0" presId="urn:microsoft.com/office/officeart/2018/2/layout/IconVerticalSolidList"/>
    <dgm:cxn modelId="{68D821DB-00EC-4148-BE7A-A1E2A685696C}" type="presParOf" srcId="{60E4FFC8-304E-4B49-823B-C1C30D774061}" destId="{F93B3F01-420C-4E65-BAC0-A50C36994A8D}" srcOrd="3" destOrd="0" presId="urn:microsoft.com/office/officeart/2018/2/layout/IconVerticalSolidList"/>
    <dgm:cxn modelId="{B03BECB2-6FF0-40B9-9835-63753029F7A1}" type="presParOf" srcId="{B9376EEA-C7BD-40EF-8ECE-F9EEF87BB7B5}" destId="{BC99562A-2496-44BA-B50E-48ABC7DFB7D3}" srcOrd="1" destOrd="0" presId="urn:microsoft.com/office/officeart/2018/2/layout/IconVerticalSolidList"/>
    <dgm:cxn modelId="{E83664B9-9C95-496D-B24C-413841480459}" type="presParOf" srcId="{B9376EEA-C7BD-40EF-8ECE-F9EEF87BB7B5}" destId="{A7FBBE68-929C-4DE4-9063-4774A7F86A90}" srcOrd="2" destOrd="0" presId="urn:microsoft.com/office/officeart/2018/2/layout/IconVerticalSolidList"/>
    <dgm:cxn modelId="{B4932FE0-3045-4A8A-92A1-D82704BB80C7}" type="presParOf" srcId="{A7FBBE68-929C-4DE4-9063-4774A7F86A90}" destId="{96720891-DA80-445A-A89F-E55DFC95B187}" srcOrd="0" destOrd="0" presId="urn:microsoft.com/office/officeart/2018/2/layout/IconVerticalSolidList"/>
    <dgm:cxn modelId="{0B68CA7A-55F9-43E8-845E-249C0EAE11D7}" type="presParOf" srcId="{A7FBBE68-929C-4DE4-9063-4774A7F86A90}" destId="{A0376A1A-C8F9-4B3C-8471-AD2974CD1905}" srcOrd="1" destOrd="0" presId="urn:microsoft.com/office/officeart/2018/2/layout/IconVerticalSolidList"/>
    <dgm:cxn modelId="{CE7DE243-DD0A-4AB5-99D8-4273D24CB279}" type="presParOf" srcId="{A7FBBE68-929C-4DE4-9063-4774A7F86A90}" destId="{EB3CC7B7-156F-4496-A735-E765FE73DBA3}" srcOrd="2" destOrd="0" presId="urn:microsoft.com/office/officeart/2018/2/layout/IconVerticalSolidList"/>
    <dgm:cxn modelId="{C3DA5B38-64C0-4441-9187-C324563A786C}" type="presParOf" srcId="{A7FBBE68-929C-4DE4-9063-4774A7F86A90}" destId="{1B95DD4F-9F3D-4A52-876A-0F717C9D4398}" srcOrd="3" destOrd="0" presId="urn:microsoft.com/office/officeart/2018/2/layout/IconVerticalSolidList"/>
    <dgm:cxn modelId="{B41C592E-E65A-454A-B62E-A5914B9AE530}" type="presParOf" srcId="{B9376EEA-C7BD-40EF-8ECE-F9EEF87BB7B5}" destId="{42690175-0997-4CD2-AE32-613EE112F276}" srcOrd="3" destOrd="0" presId="urn:microsoft.com/office/officeart/2018/2/layout/IconVerticalSolidList"/>
    <dgm:cxn modelId="{666D6AB8-D667-4E46-94C0-030ED75E2E15}" type="presParOf" srcId="{B9376EEA-C7BD-40EF-8ECE-F9EEF87BB7B5}" destId="{749F80D1-37F0-48C3-AA2B-49823D0057FC}" srcOrd="4" destOrd="0" presId="urn:microsoft.com/office/officeart/2018/2/layout/IconVerticalSolidList"/>
    <dgm:cxn modelId="{6DBDC545-5217-40B5-97BF-E73A903B6ADB}" type="presParOf" srcId="{749F80D1-37F0-48C3-AA2B-49823D0057FC}" destId="{9B51B464-9923-4148-B69F-53A083A4F03B}" srcOrd="0" destOrd="0" presId="urn:microsoft.com/office/officeart/2018/2/layout/IconVerticalSolidList"/>
    <dgm:cxn modelId="{7FFAC408-1B7E-4D45-AF04-DE6B71EEAE58}" type="presParOf" srcId="{749F80D1-37F0-48C3-AA2B-49823D0057FC}" destId="{C64CD0DE-F9E9-4305-B321-73D579F996ED}" srcOrd="1" destOrd="0" presId="urn:microsoft.com/office/officeart/2018/2/layout/IconVerticalSolidList"/>
    <dgm:cxn modelId="{7547817C-66C3-431A-80B1-089A65978181}" type="presParOf" srcId="{749F80D1-37F0-48C3-AA2B-49823D0057FC}" destId="{49088A19-2B4E-4E3D-B3D9-65F05FA4B8E2}" srcOrd="2" destOrd="0" presId="urn:microsoft.com/office/officeart/2018/2/layout/IconVerticalSolidList"/>
    <dgm:cxn modelId="{C699967B-7544-41E5-9E97-29127DDDC078}" type="presParOf" srcId="{749F80D1-37F0-48C3-AA2B-49823D0057FC}" destId="{06FF8B16-C155-4CF6-8284-ABBE9887B286}"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FEB13E97-F55F-4A01-8FC4-00B3F73E5DCE}" type="doc">
      <dgm:prSet loTypeId="urn:microsoft.com/office/officeart/2018/2/layout/IconLabelDescriptionList" loCatId="icon" qsTypeId="urn:microsoft.com/office/officeart/2005/8/quickstyle/simple1" qsCatId="simple" csTypeId="urn:microsoft.com/office/officeart/2018/5/colors/Iconchunking_neutralbg_colorful1" csCatId="colorful" phldr="1"/>
      <dgm:spPr/>
      <dgm:t>
        <a:bodyPr/>
        <a:lstStyle/>
        <a:p>
          <a:endParaRPr lang="en-US"/>
        </a:p>
      </dgm:t>
    </dgm:pt>
    <dgm:pt modelId="{8D80DB37-2B52-4E8B-AB82-3170069DC67A}">
      <dgm:prSet/>
      <dgm:spPr/>
      <dgm:t>
        <a:bodyPr/>
        <a:lstStyle/>
        <a:p>
          <a:pPr>
            <a:defRPr b="1"/>
          </a:pPr>
          <a:r>
            <a:rPr lang="en-US" dirty="0"/>
            <a:t>Quiet Location with seats and tissues</a:t>
          </a:r>
        </a:p>
      </dgm:t>
    </dgm:pt>
    <dgm:pt modelId="{E4178BBC-12C7-46BE-AA49-94E893854AEF}" type="parTrans" cxnId="{2BE7BD32-4ED5-4D81-9FC7-8FFCA4A25C4E}">
      <dgm:prSet/>
      <dgm:spPr/>
      <dgm:t>
        <a:bodyPr/>
        <a:lstStyle/>
        <a:p>
          <a:endParaRPr lang="en-US"/>
        </a:p>
      </dgm:t>
    </dgm:pt>
    <dgm:pt modelId="{005EC969-7EC6-43FB-A44C-AB907AF3B558}" type="sibTrans" cxnId="{2BE7BD32-4ED5-4D81-9FC7-8FFCA4A25C4E}">
      <dgm:prSet/>
      <dgm:spPr/>
      <dgm:t>
        <a:bodyPr/>
        <a:lstStyle/>
        <a:p>
          <a:endParaRPr lang="en-US"/>
        </a:p>
      </dgm:t>
    </dgm:pt>
    <dgm:pt modelId="{F0E226B1-CFDE-44F8-98C4-3928D6166F53}">
      <dgm:prSet/>
      <dgm:spPr/>
      <dgm:t>
        <a:bodyPr/>
        <a:lstStyle/>
        <a:p>
          <a:pPr>
            <a:defRPr b="1"/>
          </a:pPr>
          <a:r>
            <a:rPr lang="en-US" dirty="0"/>
            <a:t>Before meeting with patient</a:t>
          </a:r>
        </a:p>
      </dgm:t>
    </dgm:pt>
    <dgm:pt modelId="{8969184A-2661-4A91-96B8-C128FAF75113}" type="parTrans" cxnId="{C6A483DB-3120-4676-B2F3-024FF8D8F614}">
      <dgm:prSet/>
      <dgm:spPr/>
      <dgm:t>
        <a:bodyPr/>
        <a:lstStyle/>
        <a:p>
          <a:endParaRPr lang="en-US"/>
        </a:p>
      </dgm:t>
    </dgm:pt>
    <dgm:pt modelId="{238982F2-C012-4C19-9E4F-363944E23B17}" type="sibTrans" cxnId="{C6A483DB-3120-4676-B2F3-024FF8D8F614}">
      <dgm:prSet/>
      <dgm:spPr/>
      <dgm:t>
        <a:bodyPr/>
        <a:lstStyle/>
        <a:p>
          <a:endParaRPr lang="en-US"/>
        </a:p>
      </dgm:t>
    </dgm:pt>
    <dgm:pt modelId="{A3624300-B1B7-4DB5-BD66-AB54A3E73DAB}">
      <dgm:prSet/>
      <dgm:spPr/>
      <dgm:t>
        <a:bodyPr/>
        <a:lstStyle/>
        <a:p>
          <a:r>
            <a:rPr lang="en-US" dirty="0"/>
            <a:t>Review and agree on medical facts</a:t>
          </a:r>
        </a:p>
      </dgm:t>
    </dgm:pt>
    <dgm:pt modelId="{AD0337B4-7306-4499-BCC4-0B7924C16269}" type="parTrans" cxnId="{EF85256B-F6A8-4A4A-9BA0-C67E41DE70A9}">
      <dgm:prSet/>
      <dgm:spPr/>
      <dgm:t>
        <a:bodyPr/>
        <a:lstStyle/>
        <a:p>
          <a:endParaRPr lang="en-US"/>
        </a:p>
      </dgm:t>
    </dgm:pt>
    <dgm:pt modelId="{8CF5A6F5-E4C3-4AAE-A6AF-3BDA55CBA139}" type="sibTrans" cxnId="{EF85256B-F6A8-4A4A-9BA0-C67E41DE70A9}">
      <dgm:prSet/>
      <dgm:spPr/>
      <dgm:t>
        <a:bodyPr/>
        <a:lstStyle/>
        <a:p>
          <a:endParaRPr lang="en-US"/>
        </a:p>
      </dgm:t>
    </dgm:pt>
    <dgm:pt modelId="{7BECFAEF-F234-4C11-B580-768598A195E2}">
      <dgm:prSet/>
      <dgm:spPr/>
      <dgm:t>
        <a:bodyPr/>
        <a:lstStyle/>
        <a:p>
          <a:r>
            <a:rPr lang="en-US" dirty="0"/>
            <a:t>Determine who is going to lead the meeting</a:t>
          </a:r>
        </a:p>
      </dgm:t>
    </dgm:pt>
    <dgm:pt modelId="{9BA64F42-12B4-425A-BE78-51C558E5BA1C}" type="parTrans" cxnId="{4847C34F-EBC0-461A-A259-18E97AB9DFD8}">
      <dgm:prSet/>
      <dgm:spPr/>
      <dgm:t>
        <a:bodyPr/>
        <a:lstStyle/>
        <a:p>
          <a:endParaRPr lang="en-US"/>
        </a:p>
      </dgm:t>
    </dgm:pt>
    <dgm:pt modelId="{439F5A8B-A296-4878-8B0C-256E60A7A636}" type="sibTrans" cxnId="{4847C34F-EBC0-461A-A259-18E97AB9DFD8}">
      <dgm:prSet/>
      <dgm:spPr/>
      <dgm:t>
        <a:bodyPr/>
        <a:lstStyle/>
        <a:p>
          <a:endParaRPr lang="en-US"/>
        </a:p>
      </dgm:t>
    </dgm:pt>
    <dgm:pt modelId="{27EEABF8-7D65-4020-B5F7-62E66D0D3858}">
      <dgm:prSet/>
      <dgm:spPr/>
      <dgm:t>
        <a:bodyPr/>
        <a:lstStyle/>
        <a:p>
          <a:r>
            <a:rPr lang="en-US" dirty="0"/>
            <a:t>Forward pagers and turn off cell phones if possible</a:t>
          </a:r>
        </a:p>
      </dgm:t>
    </dgm:pt>
    <dgm:pt modelId="{D84C3B62-B692-4020-85B4-992D0D842AC4}" type="parTrans" cxnId="{9E5FFBA7-66F1-4A82-93E2-7256F207B940}">
      <dgm:prSet/>
      <dgm:spPr/>
      <dgm:t>
        <a:bodyPr/>
        <a:lstStyle/>
        <a:p>
          <a:endParaRPr lang="en-US"/>
        </a:p>
      </dgm:t>
    </dgm:pt>
    <dgm:pt modelId="{249C22AC-EE96-41BD-B0D4-8D1B849BBEC6}" type="sibTrans" cxnId="{9E5FFBA7-66F1-4A82-93E2-7256F207B940}">
      <dgm:prSet/>
      <dgm:spPr/>
      <dgm:t>
        <a:bodyPr/>
        <a:lstStyle/>
        <a:p>
          <a:endParaRPr lang="en-US"/>
        </a:p>
      </dgm:t>
    </dgm:pt>
    <dgm:pt modelId="{4B74B6EF-AAED-4A47-8B8B-465D0A87E4B7}" type="pres">
      <dgm:prSet presAssocID="{FEB13E97-F55F-4A01-8FC4-00B3F73E5DCE}" presName="root" presStyleCnt="0">
        <dgm:presLayoutVars>
          <dgm:dir/>
          <dgm:resizeHandles val="exact"/>
        </dgm:presLayoutVars>
      </dgm:prSet>
      <dgm:spPr/>
    </dgm:pt>
    <dgm:pt modelId="{865022EC-2270-480B-9638-D60449C48357}" type="pres">
      <dgm:prSet presAssocID="{8D80DB37-2B52-4E8B-AB82-3170069DC67A}" presName="compNode" presStyleCnt="0"/>
      <dgm:spPr/>
    </dgm:pt>
    <dgm:pt modelId="{F1CA65E1-2277-4D81-8996-BCD73EBB5D28}" type="pres">
      <dgm:prSet presAssocID="{8D80DB37-2B52-4E8B-AB82-3170069DC67A}" presName="iconRect" presStyleLbl="node1" presStyleIdx="0" presStyleCnt="2"/>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a:noFill/>
        </a:ln>
      </dgm:spPr>
      <dgm:extLst>
        <a:ext uri="{E40237B7-FDA0-4F09-8148-C483321AD2D9}">
          <dgm14:cNvPr xmlns:dgm14="http://schemas.microsoft.com/office/drawing/2010/diagram" id="0" name="" descr="Deaf"/>
        </a:ext>
      </dgm:extLst>
    </dgm:pt>
    <dgm:pt modelId="{FF9E24CA-E6FF-4587-8D2E-2EF1CE459BB2}" type="pres">
      <dgm:prSet presAssocID="{8D80DB37-2B52-4E8B-AB82-3170069DC67A}" presName="iconSpace" presStyleCnt="0"/>
      <dgm:spPr/>
    </dgm:pt>
    <dgm:pt modelId="{E0D81635-0EF4-4426-A2D0-BD94E88AAE8B}" type="pres">
      <dgm:prSet presAssocID="{8D80DB37-2B52-4E8B-AB82-3170069DC67A}" presName="parTx" presStyleLbl="revTx" presStyleIdx="0" presStyleCnt="4">
        <dgm:presLayoutVars>
          <dgm:chMax val="0"/>
          <dgm:chPref val="0"/>
        </dgm:presLayoutVars>
      </dgm:prSet>
      <dgm:spPr/>
    </dgm:pt>
    <dgm:pt modelId="{F7874216-AA8E-4DC2-B885-00A3EB574102}" type="pres">
      <dgm:prSet presAssocID="{8D80DB37-2B52-4E8B-AB82-3170069DC67A}" presName="txSpace" presStyleCnt="0"/>
      <dgm:spPr/>
    </dgm:pt>
    <dgm:pt modelId="{881C8845-0D2F-4FA0-9723-0E544CD7B8C7}" type="pres">
      <dgm:prSet presAssocID="{8D80DB37-2B52-4E8B-AB82-3170069DC67A}" presName="desTx" presStyleLbl="revTx" presStyleIdx="1" presStyleCnt="4">
        <dgm:presLayoutVars/>
      </dgm:prSet>
      <dgm:spPr/>
    </dgm:pt>
    <dgm:pt modelId="{85978B49-B74A-4D9A-92BF-02940AEF1DF9}" type="pres">
      <dgm:prSet presAssocID="{005EC969-7EC6-43FB-A44C-AB907AF3B558}" presName="sibTrans" presStyleCnt="0"/>
      <dgm:spPr/>
    </dgm:pt>
    <dgm:pt modelId="{376BB000-409D-4CBE-8D07-1DB7E309103A}" type="pres">
      <dgm:prSet presAssocID="{F0E226B1-CFDE-44F8-98C4-3928D6166F53}" presName="compNode" presStyleCnt="0"/>
      <dgm:spPr/>
    </dgm:pt>
    <dgm:pt modelId="{56799DAD-D5C7-4273-A800-65EB21120298}" type="pres">
      <dgm:prSet presAssocID="{F0E226B1-CFDE-44F8-98C4-3928D6166F53}" presName="iconRect" presStyleLbl="node1" presStyleIdx="1" presStyleCnt="2"/>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Doctor"/>
        </a:ext>
      </dgm:extLst>
    </dgm:pt>
    <dgm:pt modelId="{B40DADB2-AC7F-4C59-BE32-B31492B0EEF8}" type="pres">
      <dgm:prSet presAssocID="{F0E226B1-CFDE-44F8-98C4-3928D6166F53}" presName="iconSpace" presStyleCnt="0"/>
      <dgm:spPr/>
    </dgm:pt>
    <dgm:pt modelId="{BB308B3B-7C4A-4415-B01C-C85A40454F0C}" type="pres">
      <dgm:prSet presAssocID="{F0E226B1-CFDE-44F8-98C4-3928D6166F53}" presName="parTx" presStyleLbl="revTx" presStyleIdx="2" presStyleCnt="4">
        <dgm:presLayoutVars>
          <dgm:chMax val="0"/>
          <dgm:chPref val="0"/>
        </dgm:presLayoutVars>
      </dgm:prSet>
      <dgm:spPr/>
    </dgm:pt>
    <dgm:pt modelId="{A9F47011-22DE-4DF9-93D5-73775C0EBDA2}" type="pres">
      <dgm:prSet presAssocID="{F0E226B1-CFDE-44F8-98C4-3928D6166F53}" presName="txSpace" presStyleCnt="0"/>
      <dgm:spPr/>
    </dgm:pt>
    <dgm:pt modelId="{D92C95A9-DDEB-4803-A9CA-3E499BFB9F4B}" type="pres">
      <dgm:prSet presAssocID="{F0E226B1-CFDE-44F8-98C4-3928D6166F53}" presName="desTx" presStyleLbl="revTx" presStyleIdx="3" presStyleCnt="4">
        <dgm:presLayoutVars/>
      </dgm:prSet>
      <dgm:spPr/>
    </dgm:pt>
  </dgm:ptLst>
  <dgm:cxnLst>
    <dgm:cxn modelId="{F1E42E09-1662-4DFA-A65A-5CDDFF030F51}" type="presOf" srcId="{7BECFAEF-F234-4C11-B580-768598A195E2}" destId="{D92C95A9-DDEB-4803-A9CA-3E499BFB9F4B}" srcOrd="0" destOrd="1" presId="urn:microsoft.com/office/officeart/2018/2/layout/IconLabelDescriptionList"/>
    <dgm:cxn modelId="{F99F732D-08DE-461A-8A87-35D0FFA0EA20}" type="presOf" srcId="{27EEABF8-7D65-4020-B5F7-62E66D0D3858}" destId="{D92C95A9-DDEB-4803-A9CA-3E499BFB9F4B}" srcOrd="0" destOrd="2" presId="urn:microsoft.com/office/officeart/2018/2/layout/IconLabelDescriptionList"/>
    <dgm:cxn modelId="{2BE7BD32-4ED5-4D81-9FC7-8FFCA4A25C4E}" srcId="{FEB13E97-F55F-4A01-8FC4-00B3F73E5DCE}" destId="{8D80DB37-2B52-4E8B-AB82-3170069DC67A}" srcOrd="0" destOrd="0" parTransId="{E4178BBC-12C7-46BE-AA49-94E893854AEF}" sibTransId="{005EC969-7EC6-43FB-A44C-AB907AF3B558}"/>
    <dgm:cxn modelId="{4847C34F-EBC0-461A-A259-18E97AB9DFD8}" srcId="{F0E226B1-CFDE-44F8-98C4-3928D6166F53}" destId="{7BECFAEF-F234-4C11-B580-768598A195E2}" srcOrd="1" destOrd="0" parTransId="{9BA64F42-12B4-425A-BE78-51C558E5BA1C}" sibTransId="{439F5A8B-A296-4878-8B0C-256E60A7A636}"/>
    <dgm:cxn modelId="{EF85256B-F6A8-4A4A-9BA0-C67E41DE70A9}" srcId="{F0E226B1-CFDE-44F8-98C4-3928D6166F53}" destId="{A3624300-B1B7-4DB5-BD66-AB54A3E73DAB}" srcOrd="0" destOrd="0" parTransId="{AD0337B4-7306-4499-BCC4-0B7924C16269}" sibTransId="{8CF5A6F5-E4C3-4AAE-A6AF-3BDA55CBA139}"/>
    <dgm:cxn modelId="{5A582B89-3E0E-44E8-BEB3-CF4DD88C418B}" type="presOf" srcId="{FEB13E97-F55F-4A01-8FC4-00B3F73E5DCE}" destId="{4B74B6EF-AAED-4A47-8B8B-465D0A87E4B7}" srcOrd="0" destOrd="0" presId="urn:microsoft.com/office/officeart/2018/2/layout/IconLabelDescriptionList"/>
    <dgm:cxn modelId="{4EB42595-7DFA-44A5-9D5C-01C5ED1EB8F5}" type="presOf" srcId="{8D80DB37-2B52-4E8B-AB82-3170069DC67A}" destId="{E0D81635-0EF4-4426-A2D0-BD94E88AAE8B}" srcOrd="0" destOrd="0" presId="urn:microsoft.com/office/officeart/2018/2/layout/IconLabelDescriptionList"/>
    <dgm:cxn modelId="{9E5FFBA7-66F1-4A82-93E2-7256F207B940}" srcId="{F0E226B1-CFDE-44F8-98C4-3928D6166F53}" destId="{27EEABF8-7D65-4020-B5F7-62E66D0D3858}" srcOrd="2" destOrd="0" parTransId="{D84C3B62-B692-4020-85B4-992D0D842AC4}" sibTransId="{249C22AC-EE96-41BD-B0D4-8D1B849BBEC6}"/>
    <dgm:cxn modelId="{D2DDD4AB-0F57-4426-A911-6B250EF8480A}" type="presOf" srcId="{A3624300-B1B7-4DB5-BD66-AB54A3E73DAB}" destId="{D92C95A9-DDEB-4803-A9CA-3E499BFB9F4B}" srcOrd="0" destOrd="0" presId="urn:microsoft.com/office/officeart/2018/2/layout/IconLabelDescriptionList"/>
    <dgm:cxn modelId="{0FA6B5D2-E428-4619-A955-4DE747B8C2E5}" type="presOf" srcId="{F0E226B1-CFDE-44F8-98C4-3928D6166F53}" destId="{BB308B3B-7C4A-4415-B01C-C85A40454F0C}" srcOrd="0" destOrd="0" presId="urn:microsoft.com/office/officeart/2018/2/layout/IconLabelDescriptionList"/>
    <dgm:cxn modelId="{C6A483DB-3120-4676-B2F3-024FF8D8F614}" srcId="{FEB13E97-F55F-4A01-8FC4-00B3F73E5DCE}" destId="{F0E226B1-CFDE-44F8-98C4-3928D6166F53}" srcOrd="1" destOrd="0" parTransId="{8969184A-2661-4A91-96B8-C128FAF75113}" sibTransId="{238982F2-C012-4C19-9E4F-363944E23B17}"/>
    <dgm:cxn modelId="{A96472C5-77FE-488B-BC13-69D04F9E21EC}" type="presParOf" srcId="{4B74B6EF-AAED-4A47-8B8B-465D0A87E4B7}" destId="{865022EC-2270-480B-9638-D60449C48357}" srcOrd="0" destOrd="0" presId="urn:microsoft.com/office/officeart/2018/2/layout/IconLabelDescriptionList"/>
    <dgm:cxn modelId="{D7CEA7EF-2B8D-4D81-A4F4-7A5734B86913}" type="presParOf" srcId="{865022EC-2270-480B-9638-D60449C48357}" destId="{F1CA65E1-2277-4D81-8996-BCD73EBB5D28}" srcOrd="0" destOrd="0" presId="urn:microsoft.com/office/officeart/2018/2/layout/IconLabelDescriptionList"/>
    <dgm:cxn modelId="{DDAAC012-4E11-455F-9EE0-531FADD76A31}" type="presParOf" srcId="{865022EC-2270-480B-9638-D60449C48357}" destId="{FF9E24CA-E6FF-4587-8D2E-2EF1CE459BB2}" srcOrd="1" destOrd="0" presId="urn:microsoft.com/office/officeart/2018/2/layout/IconLabelDescriptionList"/>
    <dgm:cxn modelId="{2655FD76-9EE0-4AEC-A03D-B626B2A2A3FD}" type="presParOf" srcId="{865022EC-2270-480B-9638-D60449C48357}" destId="{E0D81635-0EF4-4426-A2D0-BD94E88AAE8B}" srcOrd="2" destOrd="0" presId="urn:microsoft.com/office/officeart/2018/2/layout/IconLabelDescriptionList"/>
    <dgm:cxn modelId="{76C8C796-CB7B-43AB-A927-939C6A63E384}" type="presParOf" srcId="{865022EC-2270-480B-9638-D60449C48357}" destId="{F7874216-AA8E-4DC2-B885-00A3EB574102}" srcOrd="3" destOrd="0" presId="urn:microsoft.com/office/officeart/2018/2/layout/IconLabelDescriptionList"/>
    <dgm:cxn modelId="{F4C95247-B855-4A53-8033-158775F105C8}" type="presParOf" srcId="{865022EC-2270-480B-9638-D60449C48357}" destId="{881C8845-0D2F-4FA0-9723-0E544CD7B8C7}" srcOrd="4" destOrd="0" presId="urn:microsoft.com/office/officeart/2018/2/layout/IconLabelDescriptionList"/>
    <dgm:cxn modelId="{13815AE7-F32A-42D8-A6C2-9625453253F5}" type="presParOf" srcId="{4B74B6EF-AAED-4A47-8B8B-465D0A87E4B7}" destId="{85978B49-B74A-4D9A-92BF-02940AEF1DF9}" srcOrd="1" destOrd="0" presId="urn:microsoft.com/office/officeart/2018/2/layout/IconLabelDescriptionList"/>
    <dgm:cxn modelId="{6B26D3CA-93DD-45CF-AF86-55E9F06844D5}" type="presParOf" srcId="{4B74B6EF-AAED-4A47-8B8B-465D0A87E4B7}" destId="{376BB000-409D-4CBE-8D07-1DB7E309103A}" srcOrd="2" destOrd="0" presId="urn:microsoft.com/office/officeart/2018/2/layout/IconLabelDescriptionList"/>
    <dgm:cxn modelId="{BEC59FB5-3F6A-4E65-BC3A-D30DB9418115}" type="presParOf" srcId="{376BB000-409D-4CBE-8D07-1DB7E309103A}" destId="{56799DAD-D5C7-4273-A800-65EB21120298}" srcOrd="0" destOrd="0" presId="urn:microsoft.com/office/officeart/2018/2/layout/IconLabelDescriptionList"/>
    <dgm:cxn modelId="{E10E9B02-4721-4EE3-B841-C42D96E99145}" type="presParOf" srcId="{376BB000-409D-4CBE-8D07-1DB7E309103A}" destId="{B40DADB2-AC7F-4C59-BE32-B31492B0EEF8}" srcOrd="1" destOrd="0" presId="urn:microsoft.com/office/officeart/2018/2/layout/IconLabelDescriptionList"/>
    <dgm:cxn modelId="{6FD68DEF-B598-4BB7-B156-371D472D215F}" type="presParOf" srcId="{376BB000-409D-4CBE-8D07-1DB7E309103A}" destId="{BB308B3B-7C4A-4415-B01C-C85A40454F0C}" srcOrd="2" destOrd="0" presId="urn:microsoft.com/office/officeart/2018/2/layout/IconLabelDescriptionList"/>
    <dgm:cxn modelId="{2198920E-0F49-4F72-A3F0-57303BEF9B89}" type="presParOf" srcId="{376BB000-409D-4CBE-8D07-1DB7E309103A}" destId="{A9F47011-22DE-4DF9-93D5-73775C0EBDA2}" srcOrd="3" destOrd="0" presId="urn:microsoft.com/office/officeart/2018/2/layout/IconLabelDescriptionList"/>
    <dgm:cxn modelId="{22338B0A-5C64-4258-B580-EBD1EA6E2DBE}" type="presParOf" srcId="{376BB000-409D-4CBE-8D07-1DB7E309103A}" destId="{D92C95A9-DDEB-4803-A9CA-3E499BFB9F4B}" srcOrd="4" destOrd="0" presId="urn:microsoft.com/office/officeart/2018/2/layout/IconLabelDescription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0FB3AA7A-80AC-4D75-A05E-E7C7E1C54CEE}" type="doc">
      <dgm:prSet loTypeId="urn:microsoft.com/office/officeart/2005/8/layout/hierarchy1" loCatId="hierarchy" qsTypeId="urn:microsoft.com/office/officeart/2005/8/quickstyle/simple1" qsCatId="simple" csTypeId="urn:microsoft.com/office/officeart/2005/8/colors/colorful1" csCatId="colorful" phldr="1"/>
      <dgm:spPr/>
      <dgm:t>
        <a:bodyPr/>
        <a:lstStyle/>
        <a:p>
          <a:endParaRPr lang="en-US"/>
        </a:p>
      </dgm:t>
    </dgm:pt>
    <dgm:pt modelId="{CF146852-8A48-4DFC-A6C0-74B453C70550}">
      <dgm:prSet/>
      <dgm:spPr/>
      <dgm:t>
        <a:bodyPr/>
        <a:lstStyle/>
        <a:p>
          <a:r>
            <a:rPr lang="en-US" dirty="0"/>
            <a:t>“I do have some new information to discuss, is it alright if we do it now?”</a:t>
          </a:r>
        </a:p>
      </dgm:t>
    </dgm:pt>
    <dgm:pt modelId="{C71F3178-2CF4-44FB-A14F-C357BF1304CE}" type="parTrans" cxnId="{FBA1E85A-C1CC-451E-B1FC-F750143B0B1E}">
      <dgm:prSet/>
      <dgm:spPr/>
      <dgm:t>
        <a:bodyPr/>
        <a:lstStyle/>
        <a:p>
          <a:endParaRPr lang="en-US"/>
        </a:p>
      </dgm:t>
    </dgm:pt>
    <dgm:pt modelId="{A3173B20-7956-42EF-9434-9309A7D6273D}" type="sibTrans" cxnId="{FBA1E85A-C1CC-451E-B1FC-F750143B0B1E}">
      <dgm:prSet/>
      <dgm:spPr/>
      <dgm:t>
        <a:bodyPr/>
        <a:lstStyle/>
        <a:p>
          <a:endParaRPr lang="en-US"/>
        </a:p>
      </dgm:t>
    </dgm:pt>
    <dgm:pt modelId="{1BE7A9C4-5C92-4CC7-BC7E-E98497108449}">
      <dgm:prSet/>
      <dgm:spPr/>
      <dgm:t>
        <a:bodyPr/>
        <a:lstStyle/>
        <a:p>
          <a:r>
            <a:rPr lang="en-US" dirty="0"/>
            <a:t>“I have some updates about your child, is now a good time to discuss them?”</a:t>
          </a:r>
        </a:p>
      </dgm:t>
    </dgm:pt>
    <dgm:pt modelId="{F5AFB4B0-9DB5-4E15-B4E8-902FC1A53745}" type="parTrans" cxnId="{AE1345F2-405B-4D23-96CA-F8A737FB4BCA}">
      <dgm:prSet/>
      <dgm:spPr/>
      <dgm:t>
        <a:bodyPr/>
        <a:lstStyle/>
        <a:p>
          <a:endParaRPr lang="en-US"/>
        </a:p>
      </dgm:t>
    </dgm:pt>
    <dgm:pt modelId="{BDCB7B23-1BCF-4377-B916-40CAC2151238}" type="sibTrans" cxnId="{AE1345F2-405B-4D23-96CA-F8A737FB4BCA}">
      <dgm:prSet/>
      <dgm:spPr/>
      <dgm:t>
        <a:bodyPr/>
        <a:lstStyle/>
        <a:p>
          <a:endParaRPr lang="en-US"/>
        </a:p>
      </dgm:t>
    </dgm:pt>
    <dgm:pt modelId="{ADF04C57-89A2-BC44-8F63-3C604108226F}" type="pres">
      <dgm:prSet presAssocID="{0FB3AA7A-80AC-4D75-A05E-E7C7E1C54CEE}" presName="hierChild1" presStyleCnt="0">
        <dgm:presLayoutVars>
          <dgm:chPref val="1"/>
          <dgm:dir/>
          <dgm:animOne val="branch"/>
          <dgm:animLvl val="lvl"/>
          <dgm:resizeHandles/>
        </dgm:presLayoutVars>
      </dgm:prSet>
      <dgm:spPr/>
    </dgm:pt>
    <dgm:pt modelId="{741190F5-1467-4543-82A3-5D6780D93A84}" type="pres">
      <dgm:prSet presAssocID="{CF146852-8A48-4DFC-A6C0-74B453C70550}" presName="hierRoot1" presStyleCnt="0"/>
      <dgm:spPr/>
    </dgm:pt>
    <dgm:pt modelId="{B44FDA70-E453-0244-95E6-3EB0203DD7DC}" type="pres">
      <dgm:prSet presAssocID="{CF146852-8A48-4DFC-A6C0-74B453C70550}" presName="composite" presStyleCnt="0"/>
      <dgm:spPr/>
    </dgm:pt>
    <dgm:pt modelId="{B02EF1E9-6DE7-0C48-A10D-8A81CD1F452D}" type="pres">
      <dgm:prSet presAssocID="{CF146852-8A48-4DFC-A6C0-74B453C70550}" presName="background" presStyleLbl="node0" presStyleIdx="0" presStyleCnt="2"/>
      <dgm:spPr/>
    </dgm:pt>
    <dgm:pt modelId="{05CD5662-09AC-2C48-869F-E03BFD0BC407}" type="pres">
      <dgm:prSet presAssocID="{CF146852-8A48-4DFC-A6C0-74B453C70550}" presName="text" presStyleLbl="fgAcc0" presStyleIdx="0" presStyleCnt="2">
        <dgm:presLayoutVars>
          <dgm:chPref val="3"/>
        </dgm:presLayoutVars>
      </dgm:prSet>
      <dgm:spPr/>
    </dgm:pt>
    <dgm:pt modelId="{695E2F10-B897-FD4D-87B7-68E9CC5FDAFB}" type="pres">
      <dgm:prSet presAssocID="{CF146852-8A48-4DFC-A6C0-74B453C70550}" presName="hierChild2" presStyleCnt="0"/>
      <dgm:spPr/>
    </dgm:pt>
    <dgm:pt modelId="{061D46B0-BA15-874F-8BDB-1BED000C5931}" type="pres">
      <dgm:prSet presAssocID="{1BE7A9C4-5C92-4CC7-BC7E-E98497108449}" presName="hierRoot1" presStyleCnt="0"/>
      <dgm:spPr/>
    </dgm:pt>
    <dgm:pt modelId="{36637607-2C7C-FB42-AC3F-EBE92F68873D}" type="pres">
      <dgm:prSet presAssocID="{1BE7A9C4-5C92-4CC7-BC7E-E98497108449}" presName="composite" presStyleCnt="0"/>
      <dgm:spPr/>
    </dgm:pt>
    <dgm:pt modelId="{CF6F05BC-A4D9-6740-92D7-B3E4901EA3AB}" type="pres">
      <dgm:prSet presAssocID="{1BE7A9C4-5C92-4CC7-BC7E-E98497108449}" presName="background" presStyleLbl="node0" presStyleIdx="1" presStyleCnt="2"/>
      <dgm:spPr/>
    </dgm:pt>
    <dgm:pt modelId="{CADE8567-4785-8743-AD1F-50607A4041FE}" type="pres">
      <dgm:prSet presAssocID="{1BE7A9C4-5C92-4CC7-BC7E-E98497108449}" presName="text" presStyleLbl="fgAcc0" presStyleIdx="1" presStyleCnt="2">
        <dgm:presLayoutVars>
          <dgm:chPref val="3"/>
        </dgm:presLayoutVars>
      </dgm:prSet>
      <dgm:spPr/>
    </dgm:pt>
    <dgm:pt modelId="{04D46982-52A2-294A-B027-3FF8341912F4}" type="pres">
      <dgm:prSet presAssocID="{1BE7A9C4-5C92-4CC7-BC7E-E98497108449}" presName="hierChild2" presStyleCnt="0"/>
      <dgm:spPr/>
    </dgm:pt>
  </dgm:ptLst>
  <dgm:cxnLst>
    <dgm:cxn modelId="{826FFD1E-B5D8-5E4C-9099-403F7E0DE975}" type="presOf" srcId="{0FB3AA7A-80AC-4D75-A05E-E7C7E1C54CEE}" destId="{ADF04C57-89A2-BC44-8F63-3C604108226F}" srcOrd="0" destOrd="0" presId="urn:microsoft.com/office/officeart/2005/8/layout/hierarchy1"/>
    <dgm:cxn modelId="{FE97DB3E-DFEC-154C-9023-760146304067}" type="presOf" srcId="{1BE7A9C4-5C92-4CC7-BC7E-E98497108449}" destId="{CADE8567-4785-8743-AD1F-50607A4041FE}" srcOrd="0" destOrd="0" presId="urn:microsoft.com/office/officeart/2005/8/layout/hierarchy1"/>
    <dgm:cxn modelId="{FBA1E85A-C1CC-451E-B1FC-F750143B0B1E}" srcId="{0FB3AA7A-80AC-4D75-A05E-E7C7E1C54CEE}" destId="{CF146852-8A48-4DFC-A6C0-74B453C70550}" srcOrd="0" destOrd="0" parTransId="{C71F3178-2CF4-44FB-A14F-C357BF1304CE}" sibTransId="{A3173B20-7956-42EF-9434-9309A7D6273D}"/>
    <dgm:cxn modelId="{01B5579F-8167-A243-AB12-552F6833DBFE}" type="presOf" srcId="{CF146852-8A48-4DFC-A6C0-74B453C70550}" destId="{05CD5662-09AC-2C48-869F-E03BFD0BC407}" srcOrd="0" destOrd="0" presId="urn:microsoft.com/office/officeart/2005/8/layout/hierarchy1"/>
    <dgm:cxn modelId="{AE1345F2-405B-4D23-96CA-F8A737FB4BCA}" srcId="{0FB3AA7A-80AC-4D75-A05E-E7C7E1C54CEE}" destId="{1BE7A9C4-5C92-4CC7-BC7E-E98497108449}" srcOrd="1" destOrd="0" parTransId="{F5AFB4B0-9DB5-4E15-B4E8-902FC1A53745}" sibTransId="{BDCB7B23-1BCF-4377-B916-40CAC2151238}"/>
    <dgm:cxn modelId="{E0FFA89B-551C-C949-9DE4-D9BE61E0EB2B}" type="presParOf" srcId="{ADF04C57-89A2-BC44-8F63-3C604108226F}" destId="{741190F5-1467-4543-82A3-5D6780D93A84}" srcOrd="0" destOrd="0" presId="urn:microsoft.com/office/officeart/2005/8/layout/hierarchy1"/>
    <dgm:cxn modelId="{B685B1E7-AC0F-6546-A5EB-1DED2B40192E}" type="presParOf" srcId="{741190F5-1467-4543-82A3-5D6780D93A84}" destId="{B44FDA70-E453-0244-95E6-3EB0203DD7DC}" srcOrd="0" destOrd="0" presId="urn:microsoft.com/office/officeart/2005/8/layout/hierarchy1"/>
    <dgm:cxn modelId="{23BA186B-7A6B-4C47-840E-80BE08CA8A6D}" type="presParOf" srcId="{B44FDA70-E453-0244-95E6-3EB0203DD7DC}" destId="{B02EF1E9-6DE7-0C48-A10D-8A81CD1F452D}" srcOrd="0" destOrd="0" presId="urn:microsoft.com/office/officeart/2005/8/layout/hierarchy1"/>
    <dgm:cxn modelId="{2BCFC5B1-BEA1-BE45-807B-7B188727C4A1}" type="presParOf" srcId="{B44FDA70-E453-0244-95E6-3EB0203DD7DC}" destId="{05CD5662-09AC-2C48-869F-E03BFD0BC407}" srcOrd="1" destOrd="0" presId="urn:microsoft.com/office/officeart/2005/8/layout/hierarchy1"/>
    <dgm:cxn modelId="{DA78D843-78A8-0541-BE2F-7321C6E6B01F}" type="presParOf" srcId="{741190F5-1467-4543-82A3-5D6780D93A84}" destId="{695E2F10-B897-FD4D-87B7-68E9CC5FDAFB}" srcOrd="1" destOrd="0" presId="urn:microsoft.com/office/officeart/2005/8/layout/hierarchy1"/>
    <dgm:cxn modelId="{AFEC7F0B-435F-7547-B402-50C31F597172}" type="presParOf" srcId="{ADF04C57-89A2-BC44-8F63-3C604108226F}" destId="{061D46B0-BA15-874F-8BDB-1BED000C5931}" srcOrd="1" destOrd="0" presId="urn:microsoft.com/office/officeart/2005/8/layout/hierarchy1"/>
    <dgm:cxn modelId="{0BFDDA96-0D85-1D46-94A8-9A22912F0B0D}" type="presParOf" srcId="{061D46B0-BA15-874F-8BDB-1BED000C5931}" destId="{36637607-2C7C-FB42-AC3F-EBE92F68873D}" srcOrd="0" destOrd="0" presId="urn:microsoft.com/office/officeart/2005/8/layout/hierarchy1"/>
    <dgm:cxn modelId="{F0C54ADB-0EA7-0848-AA0D-6119FF1A5BDB}" type="presParOf" srcId="{36637607-2C7C-FB42-AC3F-EBE92F68873D}" destId="{CF6F05BC-A4D9-6740-92D7-B3E4901EA3AB}" srcOrd="0" destOrd="0" presId="urn:microsoft.com/office/officeart/2005/8/layout/hierarchy1"/>
    <dgm:cxn modelId="{B417728F-A801-8349-BC18-437F3674EFDC}" type="presParOf" srcId="{36637607-2C7C-FB42-AC3F-EBE92F68873D}" destId="{CADE8567-4785-8743-AD1F-50607A4041FE}" srcOrd="1" destOrd="0" presId="urn:microsoft.com/office/officeart/2005/8/layout/hierarchy1"/>
    <dgm:cxn modelId="{2875108F-2318-2444-96D4-BAD2E6C1C7DA}" type="presParOf" srcId="{061D46B0-BA15-874F-8BDB-1BED000C5931}" destId="{04D46982-52A2-294A-B027-3FF8341912F4}"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68492104-2AD4-417F-B4E4-8A53B2FBB2DC}" type="doc">
      <dgm:prSet loTypeId="urn:microsoft.com/office/officeart/2018/2/layout/IconLabelList" loCatId="icon" qsTypeId="urn:microsoft.com/office/officeart/2005/8/quickstyle/simple1" qsCatId="simple" csTypeId="urn:microsoft.com/office/officeart/2018/5/colors/Iconchunking_neutralbg_colorful5" csCatId="colorful" phldr="1"/>
      <dgm:spPr/>
      <dgm:t>
        <a:bodyPr/>
        <a:lstStyle/>
        <a:p>
          <a:endParaRPr lang="en-US"/>
        </a:p>
      </dgm:t>
    </dgm:pt>
    <dgm:pt modelId="{2C168CB1-E2EE-4018-B6A0-663A574D2C29}">
      <dgm:prSet/>
      <dgm:spPr/>
      <dgm:t>
        <a:bodyPr/>
        <a:lstStyle/>
        <a:p>
          <a:r>
            <a:rPr lang="en-US" dirty="0"/>
            <a:t>Wait Quietly for parent/patient to process news</a:t>
          </a:r>
        </a:p>
      </dgm:t>
    </dgm:pt>
    <dgm:pt modelId="{7ED2B7B1-158F-4232-A142-B31A73D99A96}" type="parTrans" cxnId="{DCE20646-214D-42AE-951F-68F9E26B64DA}">
      <dgm:prSet/>
      <dgm:spPr/>
      <dgm:t>
        <a:bodyPr/>
        <a:lstStyle/>
        <a:p>
          <a:endParaRPr lang="en-US"/>
        </a:p>
      </dgm:t>
    </dgm:pt>
    <dgm:pt modelId="{02B9A005-2549-470B-B68C-43EBB1D80C3A}" type="sibTrans" cxnId="{DCE20646-214D-42AE-951F-68F9E26B64DA}">
      <dgm:prSet/>
      <dgm:spPr/>
      <dgm:t>
        <a:bodyPr/>
        <a:lstStyle/>
        <a:p>
          <a:endParaRPr lang="en-US"/>
        </a:p>
      </dgm:t>
    </dgm:pt>
    <dgm:pt modelId="{273A0BBE-56EF-40B2-B2EE-DB1AE4EB0E96}">
      <dgm:prSet/>
      <dgm:spPr/>
      <dgm:t>
        <a:bodyPr/>
        <a:lstStyle/>
        <a:p>
          <a:r>
            <a:rPr lang="en-US" dirty="0"/>
            <a:t>N-U-R-S-E the emotion</a:t>
          </a:r>
        </a:p>
      </dgm:t>
    </dgm:pt>
    <dgm:pt modelId="{B130C1D2-4429-4F05-89CF-702E8AC3527C}" type="parTrans" cxnId="{D44C43F1-F3FD-4BD1-82D2-63B154666D97}">
      <dgm:prSet/>
      <dgm:spPr/>
      <dgm:t>
        <a:bodyPr/>
        <a:lstStyle/>
        <a:p>
          <a:endParaRPr lang="en-US"/>
        </a:p>
      </dgm:t>
    </dgm:pt>
    <dgm:pt modelId="{136EA9AB-70FB-4B46-8809-A6E1D4B012FD}" type="sibTrans" cxnId="{D44C43F1-F3FD-4BD1-82D2-63B154666D97}">
      <dgm:prSet/>
      <dgm:spPr/>
      <dgm:t>
        <a:bodyPr/>
        <a:lstStyle/>
        <a:p>
          <a:endParaRPr lang="en-US"/>
        </a:p>
      </dgm:t>
    </dgm:pt>
    <dgm:pt modelId="{0BFE0317-80C2-43EF-9E87-7CC316353DD6}" type="pres">
      <dgm:prSet presAssocID="{68492104-2AD4-417F-B4E4-8A53B2FBB2DC}" presName="root" presStyleCnt="0">
        <dgm:presLayoutVars>
          <dgm:dir/>
          <dgm:resizeHandles val="exact"/>
        </dgm:presLayoutVars>
      </dgm:prSet>
      <dgm:spPr/>
    </dgm:pt>
    <dgm:pt modelId="{E3622725-1A7E-4D66-AED6-9A7F46C37EB9}" type="pres">
      <dgm:prSet presAssocID="{2C168CB1-E2EE-4018-B6A0-663A574D2C29}" presName="compNode" presStyleCnt="0"/>
      <dgm:spPr/>
    </dgm:pt>
    <dgm:pt modelId="{373BE796-188F-433F-A534-1EBD2639105D}" type="pres">
      <dgm:prSet presAssocID="{2C168CB1-E2EE-4018-B6A0-663A574D2C29}" presName="iconRect" presStyleLbl="node1" presStyleIdx="0" presStyleCnt="2"/>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a:noFill/>
        </a:ln>
      </dgm:spPr>
      <dgm:extLst>
        <a:ext uri="{E40237B7-FDA0-4F09-8148-C483321AD2D9}">
          <dgm14:cNvPr xmlns:dgm14="http://schemas.microsoft.com/office/drawing/2010/diagram" id="0" name="" descr="Parent and Child"/>
        </a:ext>
      </dgm:extLst>
    </dgm:pt>
    <dgm:pt modelId="{B5CF78F6-CCB1-4923-9458-1E3D67D0F8F8}" type="pres">
      <dgm:prSet presAssocID="{2C168CB1-E2EE-4018-B6A0-663A574D2C29}" presName="spaceRect" presStyleCnt="0"/>
      <dgm:spPr/>
    </dgm:pt>
    <dgm:pt modelId="{406F981B-0415-4F58-AC62-77F1D9670022}" type="pres">
      <dgm:prSet presAssocID="{2C168CB1-E2EE-4018-B6A0-663A574D2C29}" presName="textRect" presStyleLbl="revTx" presStyleIdx="0" presStyleCnt="2">
        <dgm:presLayoutVars>
          <dgm:chMax val="1"/>
          <dgm:chPref val="1"/>
        </dgm:presLayoutVars>
      </dgm:prSet>
      <dgm:spPr/>
    </dgm:pt>
    <dgm:pt modelId="{37C220D7-F01D-4745-A92D-BA32E3C1895B}" type="pres">
      <dgm:prSet presAssocID="{02B9A005-2549-470B-B68C-43EBB1D80C3A}" presName="sibTrans" presStyleCnt="0"/>
      <dgm:spPr/>
    </dgm:pt>
    <dgm:pt modelId="{D0A765A4-FD09-4BFE-B8C8-61D1E5774CBB}" type="pres">
      <dgm:prSet presAssocID="{273A0BBE-56EF-40B2-B2EE-DB1AE4EB0E96}" presName="compNode" presStyleCnt="0"/>
      <dgm:spPr/>
    </dgm:pt>
    <dgm:pt modelId="{C195BE82-08A6-422E-A4E8-AC2CB40611EA}" type="pres">
      <dgm:prSet presAssocID="{273A0BBE-56EF-40B2-B2EE-DB1AE4EB0E96}" presName="iconRect" presStyleLbl="node1" presStyleIdx="1" presStyleCnt="2"/>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Confused Face with No Fill"/>
        </a:ext>
      </dgm:extLst>
    </dgm:pt>
    <dgm:pt modelId="{DAE5A4B5-1F83-4A37-A414-337AD8B49BBB}" type="pres">
      <dgm:prSet presAssocID="{273A0BBE-56EF-40B2-B2EE-DB1AE4EB0E96}" presName="spaceRect" presStyleCnt="0"/>
      <dgm:spPr/>
    </dgm:pt>
    <dgm:pt modelId="{FAF0E6FF-403E-49BA-BED7-5057CE6A3328}" type="pres">
      <dgm:prSet presAssocID="{273A0BBE-56EF-40B2-B2EE-DB1AE4EB0E96}" presName="textRect" presStyleLbl="revTx" presStyleIdx="1" presStyleCnt="2">
        <dgm:presLayoutVars>
          <dgm:chMax val="1"/>
          <dgm:chPref val="1"/>
        </dgm:presLayoutVars>
      </dgm:prSet>
      <dgm:spPr/>
    </dgm:pt>
  </dgm:ptLst>
  <dgm:cxnLst>
    <dgm:cxn modelId="{DCE20646-214D-42AE-951F-68F9E26B64DA}" srcId="{68492104-2AD4-417F-B4E4-8A53B2FBB2DC}" destId="{2C168CB1-E2EE-4018-B6A0-663A574D2C29}" srcOrd="0" destOrd="0" parTransId="{7ED2B7B1-158F-4232-A142-B31A73D99A96}" sibTransId="{02B9A005-2549-470B-B68C-43EBB1D80C3A}"/>
    <dgm:cxn modelId="{62749974-A29F-48F6-AA63-9BB95ECED8DB}" type="presOf" srcId="{273A0BBE-56EF-40B2-B2EE-DB1AE4EB0E96}" destId="{FAF0E6FF-403E-49BA-BED7-5057CE6A3328}" srcOrd="0" destOrd="0" presId="urn:microsoft.com/office/officeart/2018/2/layout/IconLabelList"/>
    <dgm:cxn modelId="{A6AF9476-32DE-44C7-9855-F365708B0CBD}" type="presOf" srcId="{2C168CB1-E2EE-4018-B6A0-663A574D2C29}" destId="{406F981B-0415-4F58-AC62-77F1D9670022}" srcOrd="0" destOrd="0" presId="urn:microsoft.com/office/officeart/2018/2/layout/IconLabelList"/>
    <dgm:cxn modelId="{F0DB51ED-B4F4-4FE7-8FFE-426C15F540AE}" type="presOf" srcId="{68492104-2AD4-417F-B4E4-8A53B2FBB2DC}" destId="{0BFE0317-80C2-43EF-9E87-7CC316353DD6}" srcOrd="0" destOrd="0" presId="urn:microsoft.com/office/officeart/2018/2/layout/IconLabelList"/>
    <dgm:cxn modelId="{D44C43F1-F3FD-4BD1-82D2-63B154666D97}" srcId="{68492104-2AD4-417F-B4E4-8A53B2FBB2DC}" destId="{273A0BBE-56EF-40B2-B2EE-DB1AE4EB0E96}" srcOrd="1" destOrd="0" parTransId="{B130C1D2-4429-4F05-89CF-702E8AC3527C}" sibTransId="{136EA9AB-70FB-4B46-8809-A6E1D4B012FD}"/>
    <dgm:cxn modelId="{534A0ED9-6138-4DA3-9756-38B0624630C8}" type="presParOf" srcId="{0BFE0317-80C2-43EF-9E87-7CC316353DD6}" destId="{E3622725-1A7E-4D66-AED6-9A7F46C37EB9}" srcOrd="0" destOrd="0" presId="urn:microsoft.com/office/officeart/2018/2/layout/IconLabelList"/>
    <dgm:cxn modelId="{8A3EE976-0C57-46DC-BD00-820BB2E26414}" type="presParOf" srcId="{E3622725-1A7E-4D66-AED6-9A7F46C37EB9}" destId="{373BE796-188F-433F-A534-1EBD2639105D}" srcOrd="0" destOrd="0" presId="urn:microsoft.com/office/officeart/2018/2/layout/IconLabelList"/>
    <dgm:cxn modelId="{1A4A1284-AB85-4B1E-BCD4-CC5105A0EB51}" type="presParOf" srcId="{E3622725-1A7E-4D66-AED6-9A7F46C37EB9}" destId="{B5CF78F6-CCB1-4923-9458-1E3D67D0F8F8}" srcOrd="1" destOrd="0" presId="urn:microsoft.com/office/officeart/2018/2/layout/IconLabelList"/>
    <dgm:cxn modelId="{4034B389-4339-4B6C-A5F7-5194617CDDC8}" type="presParOf" srcId="{E3622725-1A7E-4D66-AED6-9A7F46C37EB9}" destId="{406F981B-0415-4F58-AC62-77F1D9670022}" srcOrd="2" destOrd="0" presId="urn:microsoft.com/office/officeart/2018/2/layout/IconLabelList"/>
    <dgm:cxn modelId="{35DBA39C-30E3-4076-9B9A-7FEE89F2E1F0}" type="presParOf" srcId="{0BFE0317-80C2-43EF-9E87-7CC316353DD6}" destId="{37C220D7-F01D-4745-A92D-BA32E3C1895B}" srcOrd="1" destOrd="0" presId="urn:microsoft.com/office/officeart/2018/2/layout/IconLabelList"/>
    <dgm:cxn modelId="{4DCF3C3E-9E73-4FF5-AC8E-D116C7081310}" type="presParOf" srcId="{0BFE0317-80C2-43EF-9E87-7CC316353DD6}" destId="{D0A765A4-FD09-4BFE-B8C8-61D1E5774CBB}" srcOrd="2" destOrd="0" presId="urn:microsoft.com/office/officeart/2018/2/layout/IconLabelList"/>
    <dgm:cxn modelId="{F8BF9B6E-C5BF-4686-9C05-B5EACC10BBAD}" type="presParOf" srcId="{D0A765A4-FD09-4BFE-B8C8-61D1E5774CBB}" destId="{C195BE82-08A6-422E-A4E8-AC2CB40611EA}" srcOrd="0" destOrd="0" presId="urn:microsoft.com/office/officeart/2018/2/layout/IconLabelList"/>
    <dgm:cxn modelId="{F96B51CE-A3D8-4EB8-A076-D11F58F613C6}" type="presParOf" srcId="{D0A765A4-FD09-4BFE-B8C8-61D1E5774CBB}" destId="{DAE5A4B5-1F83-4A37-A414-337AD8B49BBB}" srcOrd="1" destOrd="0" presId="urn:microsoft.com/office/officeart/2018/2/layout/IconLabelList"/>
    <dgm:cxn modelId="{A4754142-A51A-40B7-A337-31CC2D13D2BE}" type="presParOf" srcId="{D0A765A4-FD09-4BFE-B8C8-61D1E5774CBB}" destId="{FAF0E6FF-403E-49BA-BED7-5057CE6A3328}" srcOrd="2" destOrd="0" presId="urn:microsoft.com/office/officeart/2018/2/layout/IconLabel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C55F5AA2-046A-46C2-BF0F-1FCA3B5C61EA}" type="doc">
      <dgm:prSet loTypeId="urn:microsoft.com/office/officeart/2018/2/layout/IconVerticalSolidList" loCatId="icon" qsTypeId="urn:microsoft.com/office/officeart/2005/8/quickstyle/simple1" qsCatId="simple" csTypeId="urn:microsoft.com/office/officeart/2018/5/colors/Iconchunking_neutralicontext_colorful1" csCatId="colorful" phldr="1"/>
      <dgm:spPr/>
      <dgm:t>
        <a:bodyPr/>
        <a:lstStyle/>
        <a:p>
          <a:endParaRPr lang="en-US"/>
        </a:p>
      </dgm:t>
    </dgm:pt>
    <dgm:pt modelId="{EA9DCAEC-3811-4B8D-889F-ACD3753D10B4}">
      <dgm:prSet/>
      <dgm:spPr/>
      <dgm:t>
        <a:bodyPr/>
        <a:lstStyle/>
        <a:p>
          <a:r>
            <a:rPr lang="en-US" dirty="0"/>
            <a:t>Ask Permission to talk about next steps</a:t>
          </a:r>
        </a:p>
      </dgm:t>
    </dgm:pt>
    <dgm:pt modelId="{D60250CD-E938-4EE2-BEA5-96C945107BE2}" type="parTrans" cxnId="{2EDBD2E8-BBCC-410B-A522-798057E164A1}">
      <dgm:prSet/>
      <dgm:spPr/>
      <dgm:t>
        <a:bodyPr/>
        <a:lstStyle/>
        <a:p>
          <a:endParaRPr lang="en-US"/>
        </a:p>
      </dgm:t>
    </dgm:pt>
    <dgm:pt modelId="{DBD070F1-0F2E-4C45-BD01-DA4BEC5FEA4D}" type="sibTrans" cxnId="{2EDBD2E8-BBCC-410B-A522-798057E164A1}">
      <dgm:prSet/>
      <dgm:spPr/>
      <dgm:t>
        <a:bodyPr/>
        <a:lstStyle/>
        <a:p>
          <a:endParaRPr lang="en-US"/>
        </a:p>
      </dgm:t>
    </dgm:pt>
    <dgm:pt modelId="{82219743-C017-47C3-8CE1-AA98DA6B2398}">
      <dgm:prSet/>
      <dgm:spPr/>
      <dgm:t>
        <a:bodyPr/>
        <a:lstStyle/>
        <a:p>
          <a:r>
            <a:rPr lang="en-US" dirty="0"/>
            <a:t>“I know I’ve given you some big news.  Do you feel ready to discuss where we go from here?”</a:t>
          </a:r>
        </a:p>
      </dgm:t>
    </dgm:pt>
    <dgm:pt modelId="{C0A1E351-CEE9-4698-BAAD-2825153B421A}" type="parTrans" cxnId="{A92586C2-D158-4A40-8608-77D8DA226562}">
      <dgm:prSet/>
      <dgm:spPr/>
      <dgm:t>
        <a:bodyPr/>
        <a:lstStyle/>
        <a:p>
          <a:endParaRPr lang="en-US"/>
        </a:p>
      </dgm:t>
    </dgm:pt>
    <dgm:pt modelId="{5F769CC8-9CDA-4AFB-A345-C3392E67E15C}" type="sibTrans" cxnId="{A92586C2-D158-4A40-8608-77D8DA226562}">
      <dgm:prSet/>
      <dgm:spPr/>
      <dgm:t>
        <a:bodyPr/>
        <a:lstStyle/>
        <a:p>
          <a:endParaRPr lang="en-US"/>
        </a:p>
      </dgm:t>
    </dgm:pt>
    <dgm:pt modelId="{F3B4AD57-054E-48E7-8EDA-8A1821F1E13C}">
      <dgm:prSet/>
      <dgm:spPr/>
      <dgm:t>
        <a:bodyPr/>
        <a:lstStyle/>
        <a:p>
          <a:r>
            <a:rPr lang="en-US" dirty="0"/>
            <a:t>Sometimes it’s hard to take this all in.  Just so I know I was clear, can you tell me what you heard?”</a:t>
          </a:r>
        </a:p>
      </dgm:t>
    </dgm:pt>
    <dgm:pt modelId="{6A54DA9C-C8AA-415C-87DC-EDDD1D15677D}" type="parTrans" cxnId="{D06C6AD8-6365-430C-B80B-62327F541C90}">
      <dgm:prSet/>
      <dgm:spPr/>
      <dgm:t>
        <a:bodyPr/>
        <a:lstStyle/>
        <a:p>
          <a:endParaRPr lang="en-US"/>
        </a:p>
      </dgm:t>
    </dgm:pt>
    <dgm:pt modelId="{022C3FE1-F4C2-4A9B-A1AE-850E40AD5006}" type="sibTrans" cxnId="{D06C6AD8-6365-430C-B80B-62327F541C90}">
      <dgm:prSet/>
      <dgm:spPr/>
      <dgm:t>
        <a:bodyPr/>
        <a:lstStyle/>
        <a:p>
          <a:endParaRPr lang="en-US"/>
        </a:p>
      </dgm:t>
    </dgm:pt>
    <dgm:pt modelId="{CB0ED9EF-3B34-45BE-B7DD-8A4ADB748D8C}" type="pres">
      <dgm:prSet presAssocID="{C55F5AA2-046A-46C2-BF0F-1FCA3B5C61EA}" presName="root" presStyleCnt="0">
        <dgm:presLayoutVars>
          <dgm:dir/>
          <dgm:resizeHandles val="exact"/>
        </dgm:presLayoutVars>
      </dgm:prSet>
      <dgm:spPr/>
    </dgm:pt>
    <dgm:pt modelId="{1040C327-5C54-4256-8061-C2FCC8B5A5F5}" type="pres">
      <dgm:prSet presAssocID="{EA9DCAEC-3811-4B8D-889F-ACD3753D10B4}" presName="compNode" presStyleCnt="0"/>
      <dgm:spPr/>
    </dgm:pt>
    <dgm:pt modelId="{443994BD-C578-47AB-811B-DD6259CF7291}" type="pres">
      <dgm:prSet presAssocID="{EA9DCAEC-3811-4B8D-889F-ACD3753D10B4}" presName="bgRect" presStyleLbl="bgShp" presStyleIdx="0" presStyleCnt="3"/>
      <dgm:spPr/>
    </dgm:pt>
    <dgm:pt modelId="{24361E6E-0DA8-4D5E-87D4-6D2A4C2260AC}" type="pres">
      <dgm:prSet presAssocID="{EA9DCAEC-3811-4B8D-889F-ACD3753D10B4}" presName="iconRect" presStyleLbl="node1" presStyleIdx="0" presStyleCnt="3"/>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a:noFill/>
        </a:ln>
      </dgm:spPr>
      <dgm:extLst>
        <a:ext uri="{E40237B7-FDA0-4F09-8148-C483321AD2D9}">
          <dgm14:cNvPr xmlns:dgm14="http://schemas.microsoft.com/office/drawing/2010/diagram" id="0" name="" descr="Checkmark"/>
        </a:ext>
      </dgm:extLst>
    </dgm:pt>
    <dgm:pt modelId="{3C4E040F-268D-43D2-B956-DB1120DAFEBE}" type="pres">
      <dgm:prSet presAssocID="{EA9DCAEC-3811-4B8D-889F-ACD3753D10B4}" presName="spaceRect" presStyleCnt="0"/>
      <dgm:spPr/>
    </dgm:pt>
    <dgm:pt modelId="{7024B55A-0D3E-44B3-86B1-6ABF7063F4C1}" type="pres">
      <dgm:prSet presAssocID="{EA9DCAEC-3811-4B8D-889F-ACD3753D10B4}" presName="parTx" presStyleLbl="revTx" presStyleIdx="0" presStyleCnt="3">
        <dgm:presLayoutVars>
          <dgm:chMax val="0"/>
          <dgm:chPref val="0"/>
        </dgm:presLayoutVars>
      </dgm:prSet>
      <dgm:spPr/>
    </dgm:pt>
    <dgm:pt modelId="{704C6345-B0D6-4808-B231-5F9051823E4F}" type="pres">
      <dgm:prSet presAssocID="{DBD070F1-0F2E-4C45-BD01-DA4BEC5FEA4D}" presName="sibTrans" presStyleCnt="0"/>
      <dgm:spPr/>
    </dgm:pt>
    <dgm:pt modelId="{2F4D8E64-7102-474D-80C6-2C0B4D56443C}" type="pres">
      <dgm:prSet presAssocID="{82219743-C017-47C3-8CE1-AA98DA6B2398}" presName="compNode" presStyleCnt="0"/>
      <dgm:spPr/>
    </dgm:pt>
    <dgm:pt modelId="{3F0345DA-D301-4516-9B69-90D70E04AEB5}" type="pres">
      <dgm:prSet presAssocID="{82219743-C017-47C3-8CE1-AA98DA6B2398}" presName="bgRect" presStyleLbl="bgShp" presStyleIdx="1" presStyleCnt="3"/>
      <dgm:spPr/>
    </dgm:pt>
    <dgm:pt modelId="{1710AD7B-E2D5-42B3-8A4D-A1D8091B14B3}" type="pres">
      <dgm:prSet presAssocID="{82219743-C017-47C3-8CE1-AA98DA6B2398}" presName="iconRect" presStyleLbl="node1" presStyleIdx="1" presStyleCnt="3"/>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Newspaper"/>
        </a:ext>
      </dgm:extLst>
    </dgm:pt>
    <dgm:pt modelId="{B441A9ED-6916-4E8A-AFB7-784C6B3E1F04}" type="pres">
      <dgm:prSet presAssocID="{82219743-C017-47C3-8CE1-AA98DA6B2398}" presName="spaceRect" presStyleCnt="0"/>
      <dgm:spPr/>
    </dgm:pt>
    <dgm:pt modelId="{FD44FFBD-8872-44A4-B66C-F4D526DE1FF1}" type="pres">
      <dgm:prSet presAssocID="{82219743-C017-47C3-8CE1-AA98DA6B2398}" presName="parTx" presStyleLbl="revTx" presStyleIdx="1" presStyleCnt="3">
        <dgm:presLayoutVars>
          <dgm:chMax val="0"/>
          <dgm:chPref val="0"/>
        </dgm:presLayoutVars>
      </dgm:prSet>
      <dgm:spPr/>
    </dgm:pt>
    <dgm:pt modelId="{E0C7A5B2-748C-481C-9449-89E5B9BB6B40}" type="pres">
      <dgm:prSet presAssocID="{5F769CC8-9CDA-4AFB-A345-C3392E67E15C}" presName="sibTrans" presStyleCnt="0"/>
      <dgm:spPr/>
    </dgm:pt>
    <dgm:pt modelId="{25F024AA-F2F1-4DDF-B75A-E86127CAEBC0}" type="pres">
      <dgm:prSet presAssocID="{F3B4AD57-054E-48E7-8EDA-8A1821F1E13C}" presName="compNode" presStyleCnt="0"/>
      <dgm:spPr/>
    </dgm:pt>
    <dgm:pt modelId="{692876A3-E9F8-446D-80F5-835746A91279}" type="pres">
      <dgm:prSet presAssocID="{F3B4AD57-054E-48E7-8EDA-8A1821F1E13C}" presName="bgRect" presStyleLbl="bgShp" presStyleIdx="2" presStyleCnt="3"/>
      <dgm:spPr/>
    </dgm:pt>
    <dgm:pt modelId="{2870718A-B9B2-418A-A3E0-AE8C8E1BC324}" type="pres">
      <dgm:prSet presAssocID="{F3B4AD57-054E-48E7-8EDA-8A1821F1E13C}" presName="iconRect" presStyleLbl="node1" presStyleIdx="2" presStyleCnt="3"/>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a:ln>
          <a:noFill/>
        </a:ln>
      </dgm:spPr>
      <dgm:extLst>
        <a:ext uri="{E40237B7-FDA0-4F09-8148-C483321AD2D9}">
          <dgm14:cNvPr xmlns:dgm14="http://schemas.microsoft.com/office/drawing/2010/diagram" id="0" name="" descr="Confused Person"/>
        </a:ext>
      </dgm:extLst>
    </dgm:pt>
    <dgm:pt modelId="{D7BDBE48-3BAF-4BC1-80CD-7E3B5C2BC267}" type="pres">
      <dgm:prSet presAssocID="{F3B4AD57-054E-48E7-8EDA-8A1821F1E13C}" presName="spaceRect" presStyleCnt="0"/>
      <dgm:spPr/>
    </dgm:pt>
    <dgm:pt modelId="{90E46CFE-CFF1-46F1-B2DA-15756E19B684}" type="pres">
      <dgm:prSet presAssocID="{F3B4AD57-054E-48E7-8EDA-8A1821F1E13C}" presName="parTx" presStyleLbl="revTx" presStyleIdx="2" presStyleCnt="3">
        <dgm:presLayoutVars>
          <dgm:chMax val="0"/>
          <dgm:chPref val="0"/>
        </dgm:presLayoutVars>
      </dgm:prSet>
      <dgm:spPr/>
    </dgm:pt>
  </dgm:ptLst>
  <dgm:cxnLst>
    <dgm:cxn modelId="{6D53280B-C110-4814-A61A-EE9EA76D667A}" type="presOf" srcId="{EA9DCAEC-3811-4B8D-889F-ACD3753D10B4}" destId="{7024B55A-0D3E-44B3-86B1-6ABF7063F4C1}" srcOrd="0" destOrd="0" presId="urn:microsoft.com/office/officeart/2018/2/layout/IconVerticalSolidList"/>
    <dgm:cxn modelId="{7DE1042E-913D-4A7B-8CE5-00B6F8C0B7C0}" type="presOf" srcId="{C55F5AA2-046A-46C2-BF0F-1FCA3B5C61EA}" destId="{CB0ED9EF-3B34-45BE-B7DD-8A4ADB748D8C}" srcOrd="0" destOrd="0" presId="urn:microsoft.com/office/officeart/2018/2/layout/IconVerticalSolidList"/>
    <dgm:cxn modelId="{678B0E4D-78AD-4C47-8C89-7AED4CE2CDFD}" type="presOf" srcId="{F3B4AD57-054E-48E7-8EDA-8A1821F1E13C}" destId="{90E46CFE-CFF1-46F1-B2DA-15756E19B684}" srcOrd="0" destOrd="0" presId="urn:microsoft.com/office/officeart/2018/2/layout/IconVerticalSolidList"/>
    <dgm:cxn modelId="{F3402A94-916A-47CC-A871-850EA513965C}" type="presOf" srcId="{82219743-C017-47C3-8CE1-AA98DA6B2398}" destId="{FD44FFBD-8872-44A4-B66C-F4D526DE1FF1}" srcOrd="0" destOrd="0" presId="urn:microsoft.com/office/officeart/2018/2/layout/IconVerticalSolidList"/>
    <dgm:cxn modelId="{A92586C2-D158-4A40-8608-77D8DA226562}" srcId="{C55F5AA2-046A-46C2-BF0F-1FCA3B5C61EA}" destId="{82219743-C017-47C3-8CE1-AA98DA6B2398}" srcOrd="1" destOrd="0" parTransId="{C0A1E351-CEE9-4698-BAAD-2825153B421A}" sibTransId="{5F769CC8-9CDA-4AFB-A345-C3392E67E15C}"/>
    <dgm:cxn modelId="{D06C6AD8-6365-430C-B80B-62327F541C90}" srcId="{C55F5AA2-046A-46C2-BF0F-1FCA3B5C61EA}" destId="{F3B4AD57-054E-48E7-8EDA-8A1821F1E13C}" srcOrd="2" destOrd="0" parTransId="{6A54DA9C-C8AA-415C-87DC-EDDD1D15677D}" sibTransId="{022C3FE1-F4C2-4A9B-A1AE-850E40AD5006}"/>
    <dgm:cxn modelId="{2EDBD2E8-BBCC-410B-A522-798057E164A1}" srcId="{C55F5AA2-046A-46C2-BF0F-1FCA3B5C61EA}" destId="{EA9DCAEC-3811-4B8D-889F-ACD3753D10B4}" srcOrd="0" destOrd="0" parTransId="{D60250CD-E938-4EE2-BEA5-96C945107BE2}" sibTransId="{DBD070F1-0F2E-4C45-BD01-DA4BEC5FEA4D}"/>
    <dgm:cxn modelId="{CE1A0392-28EE-45A6-BCAB-B1DECD5E2995}" type="presParOf" srcId="{CB0ED9EF-3B34-45BE-B7DD-8A4ADB748D8C}" destId="{1040C327-5C54-4256-8061-C2FCC8B5A5F5}" srcOrd="0" destOrd="0" presId="urn:microsoft.com/office/officeart/2018/2/layout/IconVerticalSolidList"/>
    <dgm:cxn modelId="{52899252-FB2E-4388-8C0F-E0025C7D2A0E}" type="presParOf" srcId="{1040C327-5C54-4256-8061-C2FCC8B5A5F5}" destId="{443994BD-C578-47AB-811B-DD6259CF7291}" srcOrd="0" destOrd="0" presId="urn:microsoft.com/office/officeart/2018/2/layout/IconVerticalSolidList"/>
    <dgm:cxn modelId="{C48E02B9-E3B8-45D3-AD57-56E1760D4734}" type="presParOf" srcId="{1040C327-5C54-4256-8061-C2FCC8B5A5F5}" destId="{24361E6E-0DA8-4D5E-87D4-6D2A4C2260AC}" srcOrd="1" destOrd="0" presId="urn:microsoft.com/office/officeart/2018/2/layout/IconVerticalSolidList"/>
    <dgm:cxn modelId="{E2568098-F51F-48F7-A992-9B09349B672D}" type="presParOf" srcId="{1040C327-5C54-4256-8061-C2FCC8B5A5F5}" destId="{3C4E040F-268D-43D2-B956-DB1120DAFEBE}" srcOrd="2" destOrd="0" presId="urn:microsoft.com/office/officeart/2018/2/layout/IconVerticalSolidList"/>
    <dgm:cxn modelId="{79FB3322-B519-4B8F-A688-EBFD8DAE00F7}" type="presParOf" srcId="{1040C327-5C54-4256-8061-C2FCC8B5A5F5}" destId="{7024B55A-0D3E-44B3-86B1-6ABF7063F4C1}" srcOrd="3" destOrd="0" presId="urn:microsoft.com/office/officeart/2018/2/layout/IconVerticalSolidList"/>
    <dgm:cxn modelId="{B6C9D718-400B-483F-AA42-7183E0032D21}" type="presParOf" srcId="{CB0ED9EF-3B34-45BE-B7DD-8A4ADB748D8C}" destId="{704C6345-B0D6-4808-B231-5F9051823E4F}" srcOrd="1" destOrd="0" presId="urn:microsoft.com/office/officeart/2018/2/layout/IconVerticalSolidList"/>
    <dgm:cxn modelId="{63CDF029-64DB-4BC4-A5F8-27BAB969EE30}" type="presParOf" srcId="{CB0ED9EF-3B34-45BE-B7DD-8A4ADB748D8C}" destId="{2F4D8E64-7102-474D-80C6-2C0B4D56443C}" srcOrd="2" destOrd="0" presId="urn:microsoft.com/office/officeart/2018/2/layout/IconVerticalSolidList"/>
    <dgm:cxn modelId="{3545AD28-2FB3-4619-A2BD-D012E36D4B72}" type="presParOf" srcId="{2F4D8E64-7102-474D-80C6-2C0B4D56443C}" destId="{3F0345DA-D301-4516-9B69-90D70E04AEB5}" srcOrd="0" destOrd="0" presId="urn:microsoft.com/office/officeart/2018/2/layout/IconVerticalSolidList"/>
    <dgm:cxn modelId="{BBED78C4-85B8-4410-8D6F-D211A0784E51}" type="presParOf" srcId="{2F4D8E64-7102-474D-80C6-2C0B4D56443C}" destId="{1710AD7B-E2D5-42B3-8A4D-A1D8091B14B3}" srcOrd="1" destOrd="0" presId="urn:microsoft.com/office/officeart/2018/2/layout/IconVerticalSolidList"/>
    <dgm:cxn modelId="{9DC99E5B-314A-468D-B2E8-AF43A90B0D6C}" type="presParOf" srcId="{2F4D8E64-7102-474D-80C6-2C0B4D56443C}" destId="{B441A9ED-6916-4E8A-AFB7-784C6B3E1F04}" srcOrd="2" destOrd="0" presId="urn:microsoft.com/office/officeart/2018/2/layout/IconVerticalSolidList"/>
    <dgm:cxn modelId="{CAAA5327-B4E5-4041-9974-9FAAB4A43C09}" type="presParOf" srcId="{2F4D8E64-7102-474D-80C6-2C0B4D56443C}" destId="{FD44FFBD-8872-44A4-B66C-F4D526DE1FF1}" srcOrd="3" destOrd="0" presId="urn:microsoft.com/office/officeart/2018/2/layout/IconVerticalSolidList"/>
    <dgm:cxn modelId="{E34077F8-048C-4441-AE3C-DD8B0F9498CF}" type="presParOf" srcId="{CB0ED9EF-3B34-45BE-B7DD-8A4ADB748D8C}" destId="{E0C7A5B2-748C-481C-9449-89E5B9BB6B40}" srcOrd="3" destOrd="0" presId="urn:microsoft.com/office/officeart/2018/2/layout/IconVerticalSolidList"/>
    <dgm:cxn modelId="{7CC688A2-4107-4B46-A28F-6F9A45183707}" type="presParOf" srcId="{CB0ED9EF-3B34-45BE-B7DD-8A4ADB748D8C}" destId="{25F024AA-F2F1-4DDF-B75A-E86127CAEBC0}" srcOrd="4" destOrd="0" presId="urn:microsoft.com/office/officeart/2018/2/layout/IconVerticalSolidList"/>
    <dgm:cxn modelId="{7FFFE8EA-DFAA-417F-B20D-6A0B126573C2}" type="presParOf" srcId="{25F024AA-F2F1-4DDF-B75A-E86127CAEBC0}" destId="{692876A3-E9F8-446D-80F5-835746A91279}" srcOrd="0" destOrd="0" presId="urn:microsoft.com/office/officeart/2018/2/layout/IconVerticalSolidList"/>
    <dgm:cxn modelId="{71CFF499-9B2C-44D6-A63F-9098B6F3B02A}" type="presParOf" srcId="{25F024AA-F2F1-4DDF-B75A-E86127CAEBC0}" destId="{2870718A-B9B2-418A-A3E0-AE8C8E1BC324}" srcOrd="1" destOrd="0" presId="urn:microsoft.com/office/officeart/2018/2/layout/IconVerticalSolidList"/>
    <dgm:cxn modelId="{9AAF44EC-06A7-41B6-9925-FF6D2C1C7D70}" type="presParOf" srcId="{25F024AA-F2F1-4DDF-B75A-E86127CAEBC0}" destId="{D7BDBE48-3BAF-4BC1-80CD-7E3B5C2BC267}" srcOrd="2" destOrd="0" presId="urn:microsoft.com/office/officeart/2018/2/layout/IconVerticalSolidList"/>
    <dgm:cxn modelId="{4CFF9DA0-0BE5-4597-ACAF-A3F81471D69D}" type="presParOf" srcId="{25F024AA-F2F1-4DDF-B75A-E86127CAEBC0}" destId="{90E46CFE-CFF1-46F1-B2DA-15756E19B684}"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3B53BD60-B6AD-45F7-887B-A923C0AC5D33}" type="doc">
      <dgm:prSet loTypeId="urn:microsoft.com/office/officeart/2005/8/layout/list1" loCatId="list" qsTypeId="urn:microsoft.com/office/officeart/2005/8/quickstyle/simple1" qsCatId="simple" csTypeId="urn:microsoft.com/office/officeart/2005/8/colors/colorful1" csCatId="colorful"/>
      <dgm:spPr/>
      <dgm:t>
        <a:bodyPr/>
        <a:lstStyle/>
        <a:p>
          <a:endParaRPr lang="en-US"/>
        </a:p>
      </dgm:t>
    </dgm:pt>
    <dgm:pt modelId="{FB89D801-6A7A-418A-99F9-6106D549D77A}">
      <dgm:prSet/>
      <dgm:spPr/>
      <dgm:t>
        <a:bodyPr/>
        <a:lstStyle/>
        <a:p>
          <a:r>
            <a:rPr lang="en-US" dirty="0"/>
            <a:t>N – Name</a:t>
          </a:r>
        </a:p>
      </dgm:t>
    </dgm:pt>
    <dgm:pt modelId="{226EC9CB-0B46-48F2-8F9E-4F7D872EB73C}" type="parTrans" cxnId="{B3E31A55-C5F1-449B-B1EC-CD24ACBB0997}">
      <dgm:prSet/>
      <dgm:spPr/>
      <dgm:t>
        <a:bodyPr/>
        <a:lstStyle/>
        <a:p>
          <a:endParaRPr lang="en-US"/>
        </a:p>
      </dgm:t>
    </dgm:pt>
    <dgm:pt modelId="{D14E7584-1C02-4B70-A434-D875E211A312}" type="sibTrans" cxnId="{B3E31A55-C5F1-449B-B1EC-CD24ACBB0997}">
      <dgm:prSet/>
      <dgm:spPr/>
      <dgm:t>
        <a:bodyPr/>
        <a:lstStyle/>
        <a:p>
          <a:endParaRPr lang="en-US"/>
        </a:p>
      </dgm:t>
    </dgm:pt>
    <dgm:pt modelId="{6BCAD5EB-3A20-4159-87DF-848163D6E216}">
      <dgm:prSet/>
      <dgm:spPr/>
      <dgm:t>
        <a:bodyPr/>
        <a:lstStyle/>
        <a:p>
          <a:r>
            <a:rPr lang="en-US" dirty="0"/>
            <a:t>U – Understand</a:t>
          </a:r>
        </a:p>
      </dgm:t>
    </dgm:pt>
    <dgm:pt modelId="{2149FAB2-2173-4152-997C-8CFEF77AF077}" type="parTrans" cxnId="{16443174-DF04-4A17-B4C0-AB9C074DAC2C}">
      <dgm:prSet/>
      <dgm:spPr/>
      <dgm:t>
        <a:bodyPr/>
        <a:lstStyle/>
        <a:p>
          <a:endParaRPr lang="en-US"/>
        </a:p>
      </dgm:t>
    </dgm:pt>
    <dgm:pt modelId="{659B48CF-9673-40C2-A601-B8148A969D1D}" type="sibTrans" cxnId="{16443174-DF04-4A17-B4C0-AB9C074DAC2C}">
      <dgm:prSet/>
      <dgm:spPr/>
      <dgm:t>
        <a:bodyPr/>
        <a:lstStyle/>
        <a:p>
          <a:endParaRPr lang="en-US"/>
        </a:p>
      </dgm:t>
    </dgm:pt>
    <dgm:pt modelId="{6D2EB1E1-5168-4C81-8FF1-E731A72CFCBB}">
      <dgm:prSet/>
      <dgm:spPr/>
      <dgm:t>
        <a:bodyPr/>
        <a:lstStyle/>
        <a:p>
          <a:r>
            <a:rPr lang="en-US" dirty="0"/>
            <a:t>R – Respect</a:t>
          </a:r>
        </a:p>
      </dgm:t>
    </dgm:pt>
    <dgm:pt modelId="{608536AF-E9D9-4DC3-BDC2-C0265CA59016}" type="parTrans" cxnId="{3C14267A-7ABA-484F-A25B-AFC34ABA61FB}">
      <dgm:prSet/>
      <dgm:spPr/>
      <dgm:t>
        <a:bodyPr/>
        <a:lstStyle/>
        <a:p>
          <a:endParaRPr lang="en-US"/>
        </a:p>
      </dgm:t>
    </dgm:pt>
    <dgm:pt modelId="{1D00DE4D-DAA4-4221-BAD5-AB227368E8BB}" type="sibTrans" cxnId="{3C14267A-7ABA-484F-A25B-AFC34ABA61FB}">
      <dgm:prSet/>
      <dgm:spPr/>
      <dgm:t>
        <a:bodyPr/>
        <a:lstStyle/>
        <a:p>
          <a:endParaRPr lang="en-US"/>
        </a:p>
      </dgm:t>
    </dgm:pt>
    <dgm:pt modelId="{626A61FE-1201-4BA4-B69A-4A23FF565EDA}">
      <dgm:prSet/>
      <dgm:spPr/>
      <dgm:t>
        <a:bodyPr/>
        <a:lstStyle/>
        <a:p>
          <a:r>
            <a:rPr lang="en-US" dirty="0"/>
            <a:t>S – Support</a:t>
          </a:r>
        </a:p>
      </dgm:t>
    </dgm:pt>
    <dgm:pt modelId="{9091120D-D8ED-4E42-80CC-90DFD4BF6D6A}" type="parTrans" cxnId="{F668FFFC-5EDF-4671-87A9-A7429D7F2AB6}">
      <dgm:prSet/>
      <dgm:spPr/>
      <dgm:t>
        <a:bodyPr/>
        <a:lstStyle/>
        <a:p>
          <a:endParaRPr lang="en-US"/>
        </a:p>
      </dgm:t>
    </dgm:pt>
    <dgm:pt modelId="{2A9003FF-0247-4A3A-A4FF-0B7822FCB67B}" type="sibTrans" cxnId="{F668FFFC-5EDF-4671-87A9-A7429D7F2AB6}">
      <dgm:prSet/>
      <dgm:spPr/>
      <dgm:t>
        <a:bodyPr/>
        <a:lstStyle/>
        <a:p>
          <a:endParaRPr lang="en-US"/>
        </a:p>
      </dgm:t>
    </dgm:pt>
    <dgm:pt modelId="{5658CFC3-B5EA-4D88-AB58-F995256E90B4}">
      <dgm:prSet/>
      <dgm:spPr/>
      <dgm:t>
        <a:bodyPr/>
        <a:lstStyle/>
        <a:p>
          <a:r>
            <a:rPr lang="en-US" dirty="0"/>
            <a:t>E – Explore</a:t>
          </a:r>
        </a:p>
      </dgm:t>
    </dgm:pt>
    <dgm:pt modelId="{DDA10524-4472-4602-A358-4A807BAE3BA0}" type="parTrans" cxnId="{39BFAC91-B9BC-4260-A471-1B9DAD032630}">
      <dgm:prSet/>
      <dgm:spPr/>
      <dgm:t>
        <a:bodyPr/>
        <a:lstStyle/>
        <a:p>
          <a:endParaRPr lang="en-US"/>
        </a:p>
      </dgm:t>
    </dgm:pt>
    <dgm:pt modelId="{AD98FED8-504C-49C8-B10F-C7FE99BCD23E}" type="sibTrans" cxnId="{39BFAC91-B9BC-4260-A471-1B9DAD032630}">
      <dgm:prSet/>
      <dgm:spPr/>
      <dgm:t>
        <a:bodyPr/>
        <a:lstStyle/>
        <a:p>
          <a:endParaRPr lang="en-US"/>
        </a:p>
      </dgm:t>
    </dgm:pt>
    <dgm:pt modelId="{3B19C6C7-D2C8-F64D-AEF5-D21B247A7A25}" type="pres">
      <dgm:prSet presAssocID="{3B53BD60-B6AD-45F7-887B-A923C0AC5D33}" presName="linear" presStyleCnt="0">
        <dgm:presLayoutVars>
          <dgm:dir/>
          <dgm:animLvl val="lvl"/>
          <dgm:resizeHandles val="exact"/>
        </dgm:presLayoutVars>
      </dgm:prSet>
      <dgm:spPr/>
    </dgm:pt>
    <dgm:pt modelId="{D208DEF7-718D-C14B-BA65-8FFAEC3A51FA}" type="pres">
      <dgm:prSet presAssocID="{FB89D801-6A7A-418A-99F9-6106D549D77A}" presName="parentLin" presStyleCnt="0"/>
      <dgm:spPr/>
    </dgm:pt>
    <dgm:pt modelId="{27E8ABF2-6531-7846-B148-F29B1C2622F9}" type="pres">
      <dgm:prSet presAssocID="{FB89D801-6A7A-418A-99F9-6106D549D77A}" presName="parentLeftMargin" presStyleLbl="node1" presStyleIdx="0" presStyleCnt="5"/>
      <dgm:spPr/>
    </dgm:pt>
    <dgm:pt modelId="{BB7C6D63-2639-D445-866C-7FF1561BE513}" type="pres">
      <dgm:prSet presAssocID="{FB89D801-6A7A-418A-99F9-6106D549D77A}" presName="parentText" presStyleLbl="node1" presStyleIdx="0" presStyleCnt="5">
        <dgm:presLayoutVars>
          <dgm:chMax val="0"/>
          <dgm:bulletEnabled val="1"/>
        </dgm:presLayoutVars>
      </dgm:prSet>
      <dgm:spPr/>
    </dgm:pt>
    <dgm:pt modelId="{8C54B7C4-BE21-4E4E-BE44-C17999B117B4}" type="pres">
      <dgm:prSet presAssocID="{FB89D801-6A7A-418A-99F9-6106D549D77A}" presName="negativeSpace" presStyleCnt="0"/>
      <dgm:spPr/>
    </dgm:pt>
    <dgm:pt modelId="{338ED39E-E051-B243-B3BB-F31C196974DC}" type="pres">
      <dgm:prSet presAssocID="{FB89D801-6A7A-418A-99F9-6106D549D77A}" presName="childText" presStyleLbl="conFgAcc1" presStyleIdx="0" presStyleCnt="5">
        <dgm:presLayoutVars>
          <dgm:bulletEnabled val="1"/>
        </dgm:presLayoutVars>
      </dgm:prSet>
      <dgm:spPr/>
    </dgm:pt>
    <dgm:pt modelId="{304866B8-6A69-FB45-A40A-7AC9FE145DFA}" type="pres">
      <dgm:prSet presAssocID="{D14E7584-1C02-4B70-A434-D875E211A312}" presName="spaceBetweenRectangles" presStyleCnt="0"/>
      <dgm:spPr/>
    </dgm:pt>
    <dgm:pt modelId="{3380C581-CF7F-1A4F-BBD0-39FF77E264E3}" type="pres">
      <dgm:prSet presAssocID="{6BCAD5EB-3A20-4159-87DF-848163D6E216}" presName="parentLin" presStyleCnt="0"/>
      <dgm:spPr/>
    </dgm:pt>
    <dgm:pt modelId="{BA00AE30-C007-7541-8ED4-A8C75F7F8099}" type="pres">
      <dgm:prSet presAssocID="{6BCAD5EB-3A20-4159-87DF-848163D6E216}" presName="parentLeftMargin" presStyleLbl="node1" presStyleIdx="0" presStyleCnt="5"/>
      <dgm:spPr/>
    </dgm:pt>
    <dgm:pt modelId="{A5E7A925-589A-7C4B-9F1C-B67B53C03D71}" type="pres">
      <dgm:prSet presAssocID="{6BCAD5EB-3A20-4159-87DF-848163D6E216}" presName="parentText" presStyleLbl="node1" presStyleIdx="1" presStyleCnt="5">
        <dgm:presLayoutVars>
          <dgm:chMax val="0"/>
          <dgm:bulletEnabled val="1"/>
        </dgm:presLayoutVars>
      </dgm:prSet>
      <dgm:spPr/>
    </dgm:pt>
    <dgm:pt modelId="{718AF397-3D48-9C43-9033-ACE13B6DF96E}" type="pres">
      <dgm:prSet presAssocID="{6BCAD5EB-3A20-4159-87DF-848163D6E216}" presName="negativeSpace" presStyleCnt="0"/>
      <dgm:spPr/>
    </dgm:pt>
    <dgm:pt modelId="{87E49858-EC07-7C4D-BA74-DEDD05CBF403}" type="pres">
      <dgm:prSet presAssocID="{6BCAD5EB-3A20-4159-87DF-848163D6E216}" presName="childText" presStyleLbl="conFgAcc1" presStyleIdx="1" presStyleCnt="5">
        <dgm:presLayoutVars>
          <dgm:bulletEnabled val="1"/>
        </dgm:presLayoutVars>
      </dgm:prSet>
      <dgm:spPr/>
    </dgm:pt>
    <dgm:pt modelId="{7EDD0058-FA68-304B-A176-88E2D0786E17}" type="pres">
      <dgm:prSet presAssocID="{659B48CF-9673-40C2-A601-B8148A969D1D}" presName="spaceBetweenRectangles" presStyleCnt="0"/>
      <dgm:spPr/>
    </dgm:pt>
    <dgm:pt modelId="{2A69C271-DFEA-2F48-971A-B1C8E8E710B8}" type="pres">
      <dgm:prSet presAssocID="{6D2EB1E1-5168-4C81-8FF1-E731A72CFCBB}" presName="parentLin" presStyleCnt="0"/>
      <dgm:spPr/>
    </dgm:pt>
    <dgm:pt modelId="{A9BC0A94-A0B5-7F46-8F27-A6B96602304A}" type="pres">
      <dgm:prSet presAssocID="{6D2EB1E1-5168-4C81-8FF1-E731A72CFCBB}" presName="parentLeftMargin" presStyleLbl="node1" presStyleIdx="1" presStyleCnt="5"/>
      <dgm:spPr/>
    </dgm:pt>
    <dgm:pt modelId="{5E652308-50C2-814D-BB94-3E9777DD4E07}" type="pres">
      <dgm:prSet presAssocID="{6D2EB1E1-5168-4C81-8FF1-E731A72CFCBB}" presName="parentText" presStyleLbl="node1" presStyleIdx="2" presStyleCnt="5">
        <dgm:presLayoutVars>
          <dgm:chMax val="0"/>
          <dgm:bulletEnabled val="1"/>
        </dgm:presLayoutVars>
      </dgm:prSet>
      <dgm:spPr/>
    </dgm:pt>
    <dgm:pt modelId="{2DE66EAD-A634-2548-B7BC-E3FBD6FDC8A0}" type="pres">
      <dgm:prSet presAssocID="{6D2EB1E1-5168-4C81-8FF1-E731A72CFCBB}" presName="negativeSpace" presStyleCnt="0"/>
      <dgm:spPr/>
    </dgm:pt>
    <dgm:pt modelId="{D42C8BD8-FF54-9A4A-992A-FDD111490F12}" type="pres">
      <dgm:prSet presAssocID="{6D2EB1E1-5168-4C81-8FF1-E731A72CFCBB}" presName="childText" presStyleLbl="conFgAcc1" presStyleIdx="2" presStyleCnt="5">
        <dgm:presLayoutVars>
          <dgm:bulletEnabled val="1"/>
        </dgm:presLayoutVars>
      </dgm:prSet>
      <dgm:spPr/>
    </dgm:pt>
    <dgm:pt modelId="{B7603F37-15F0-6B49-B34D-F28A871EB5CF}" type="pres">
      <dgm:prSet presAssocID="{1D00DE4D-DAA4-4221-BAD5-AB227368E8BB}" presName="spaceBetweenRectangles" presStyleCnt="0"/>
      <dgm:spPr/>
    </dgm:pt>
    <dgm:pt modelId="{AC4F74FC-E46B-CB41-82E2-C5166F10EC85}" type="pres">
      <dgm:prSet presAssocID="{626A61FE-1201-4BA4-B69A-4A23FF565EDA}" presName="parentLin" presStyleCnt="0"/>
      <dgm:spPr/>
    </dgm:pt>
    <dgm:pt modelId="{AA5E3EC3-F6A2-AB42-B4AB-465593AAE83B}" type="pres">
      <dgm:prSet presAssocID="{626A61FE-1201-4BA4-B69A-4A23FF565EDA}" presName="parentLeftMargin" presStyleLbl="node1" presStyleIdx="2" presStyleCnt="5"/>
      <dgm:spPr/>
    </dgm:pt>
    <dgm:pt modelId="{B5BB295A-0733-7045-82BB-E38EA9F09D96}" type="pres">
      <dgm:prSet presAssocID="{626A61FE-1201-4BA4-B69A-4A23FF565EDA}" presName="parentText" presStyleLbl="node1" presStyleIdx="3" presStyleCnt="5">
        <dgm:presLayoutVars>
          <dgm:chMax val="0"/>
          <dgm:bulletEnabled val="1"/>
        </dgm:presLayoutVars>
      </dgm:prSet>
      <dgm:spPr/>
    </dgm:pt>
    <dgm:pt modelId="{2F0167FD-7E19-614C-ABD2-E774AA7694BC}" type="pres">
      <dgm:prSet presAssocID="{626A61FE-1201-4BA4-B69A-4A23FF565EDA}" presName="negativeSpace" presStyleCnt="0"/>
      <dgm:spPr/>
    </dgm:pt>
    <dgm:pt modelId="{48D69DE0-15B9-FF48-99A9-7EF235C6D93E}" type="pres">
      <dgm:prSet presAssocID="{626A61FE-1201-4BA4-B69A-4A23FF565EDA}" presName="childText" presStyleLbl="conFgAcc1" presStyleIdx="3" presStyleCnt="5">
        <dgm:presLayoutVars>
          <dgm:bulletEnabled val="1"/>
        </dgm:presLayoutVars>
      </dgm:prSet>
      <dgm:spPr/>
    </dgm:pt>
    <dgm:pt modelId="{2FC39047-2151-5545-ACFD-BD86991E6A44}" type="pres">
      <dgm:prSet presAssocID="{2A9003FF-0247-4A3A-A4FF-0B7822FCB67B}" presName="spaceBetweenRectangles" presStyleCnt="0"/>
      <dgm:spPr/>
    </dgm:pt>
    <dgm:pt modelId="{DDAED815-A159-2246-A5B7-80416D39C49F}" type="pres">
      <dgm:prSet presAssocID="{5658CFC3-B5EA-4D88-AB58-F995256E90B4}" presName="parentLin" presStyleCnt="0"/>
      <dgm:spPr/>
    </dgm:pt>
    <dgm:pt modelId="{B96C0D65-0FB9-B941-8721-39F4B7D9BE64}" type="pres">
      <dgm:prSet presAssocID="{5658CFC3-B5EA-4D88-AB58-F995256E90B4}" presName="parentLeftMargin" presStyleLbl="node1" presStyleIdx="3" presStyleCnt="5"/>
      <dgm:spPr/>
    </dgm:pt>
    <dgm:pt modelId="{3443C13C-1D25-614A-9C26-8591E37F157B}" type="pres">
      <dgm:prSet presAssocID="{5658CFC3-B5EA-4D88-AB58-F995256E90B4}" presName="parentText" presStyleLbl="node1" presStyleIdx="4" presStyleCnt="5">
        <dgm:presLayoutVars>
          <dgm:chMax val="0"/>
          <dgm:bulletEnabled val="1"/>
        </dgm:presLayoutVars>
      </dgm:prSet>
      <dgm:spPr/>
    </dgm:pt>
    <dgm:pt modelId="{5075462D-CDD4-554E-988C-2C8992860856}" type="pres">
      <dgm:prSet presAssocID="{5658CFC3-B5EA-4D88-AB58-F995256E90B4}" presName="negativeSpace" presStyleCnt="0"/>
      <dgm:spPr/>
    </dgm:pt>
    <dgm:pt modelId="{61A359C3-9EE3-C34A-885A-5411C5F3340C}" type="pres">
      <dgm:prSet presAssocID="{5658CFC3-B5EA-4D88-AB58-F995256E90B4}" presName="childText" presStyleLbl="conFgAcc1" presStyleIdx="4" presStyleCnt="5">
        <dgm:presLayoutVars>
          <dgm:bulletEnabled val="1"/>
        </dgm:presLayoutVars>
      </dgm:prSet>
      <dgm:spPr/>
    </dgm:pt>
  </dgm:ptLst>
  <dgm:cxnLst>
    <dgm:cxn modelId="{BD9DEB31-BF4D-5C42-9B7D-622C945BC067}" type="presOf" srcId="{6D2EB1E1-5168-4C81-8FF1-E731A72CFCBB}" destId="{A9BC0A94-A0B5-7F46-8F27-A6B96602304A}" srcOrd="0" destOrd="0" presId="urn:microsoft.com/office/officeart/2005/8/layout/list1"/>
    <dgm:cxn modelId="{B3E31A55-C5F1-449B-B1EC-CD24ACBB0997}" srcId="{3B53BD60-B6AD-45F7-887B-A923C0AC5D33}" destId="{FB89D801-6A7A-418A-99F9-6106D549D77A}" srcOrd="0" destOrd="0" parTransId="{226EC9CB-0B46-48F2-8F9E-4F7D872EB73C}" sibTransId="{D14E7584-1C02-4B70-A434-D875E211A312}"/>
    <dgm:cxn modelId="{2F3ED362-C351-E94C-960B-A1F7267E76E5}" type="presOf" srcId="{5658CFC3-B5EA-4D88-AB58-F995256E90B4}" destId="{B96C0D65-0FB9-B941-8721-39F4B7D9BE64}" srcOrd="0" destOrd="0" presId="urn:microsoft.com/office/officeart/2005/8/layout/list1"/>
    <dgm:cxn modelId="{16443174-DF04-4A17-B4C0-AB9C074DAC2C}" srcId="{3B53BD60-B6AD-45F7-887B-A923C0AC5D33}" destId="{6BCAD5EB-3A20-4159-87DF-848163D6E216}" srcOrd="1" destOrd="0" parTransId="{2149FAB2-2173-4152-997C-8CFEF77AF077}" sibTransId="{659B48CF-9673-40C2-A601-B8148A969D1D}"/>
    <dgm:cxn modelId="{3C14267A-7ABA-484F-A25B-AFC34ABA61FB}" srcId="{3B53BD60-B6AD-45F7-887B-A923C0AC5D33}" destId="{6D2EB1E1-5168-4C81-8FF1-E731A72CFCBB}" srcOrd="2" destOrd="0" parTransId="{608536AF-E9D9-4DC3-BDC2-C0265CA59016}" sibTransId="{1D00DE4D-DAA4-4221-BAD5-AB227368E8BB}"/>
    <dgm:cxn modelId="{9EC4417B-4377-F74A-B913-23925F7FD22C}" type="presOf" srcId="{6D2EB1E1-5168-4C81-8FF1-E731A72CFCBB}" destId="{5E652308-50C2-814D-BB94-3E9777DD4E07}" srcOrd="1" destOrd="0" presId="urn:microsoft.com/office/officeart/2005/8/layout/list1"/>
    <dgm:cxn modelId="{AD986C7F-0125-2949-BAD0-2587B1B0CABD}" type="presOf" srcId="{6BCAD5EB-3A20-4159-87DF-848163D6E216}" destId="{A5E7A925-589A-7C4B-9F1C-B67B53C03D71}" srcOrd="1" destOrd="0" presId="urn:microsoft.com/office/officeart/2005/8/layout/list1"/>
    <dgm:cxn modelId="{2CEDBC8D-ABCD-D247-8969-03614CEAE108}" type="presOf" srcId="{FB89D801-6A7A-418A-99F9-6106D549D77A}" destId="{27E8ABF2-6531-7846-B148-F29B1C2622F9}" srcOrd="0" destOrd="0" presId="urn:microsoft.com/office/officeart/2005/8/layout/list1"/>
    <dgm:cxn modelId="{39BFAC91-B9BC-4260-A471-1B9DAD032630}" srcId="{3B53BD60-B6AD-45F7-887B-A923C0AC5D33}" destId="{5658CFC3-B5EA-4D88-AB58-F995256E90B4}" srcOrd="4" destOrd="0" parTransId="{DDA10524-4472-4602-A358-4A807BAE3BA0}" sibTransId="{AD98FED8-504C-49C8-B10F-C7FE99BCD23E}"/>
    <dgm:cxn modelId="{5E854FC5-5C90-0940-AFB9-741CD5204D0B}" type="presOf" srcId="{6BCAD5EB-3A20-4159-87DF-848163D6E216}" destId="{BA00AE30-C007-7541-8ED4-A8C75F7F8099}" srcOrd="0" destOrd="0" presId="urn:microsoft.com/office/officeart/2005/8/layout/list1"/>
    <dgm:cxn modelId="{450362E5-4859-744C-8748-DCAE066C199F}" type="presOf" srcId="{5658CFC3-B5EA-4D88-AB58-F995256E90B4}" destId="{3443C13C-1D25-614A-9C26-8591E37F157B}" srcOrd="1" destOrd="0" presId="urn:microsoft.com/office/officeart/2005/8/layout/list1"/>
    <dgm:cxn modelId="{86142EE9-D8B8-3448-823E-A806FE4CC3FE}" type="presOf" srcId="{3B53BD60-B6AD-45F7-887B-A923C0AC5D33}" destId="{3B19C6C7-D2C8-F64D-AEF5-D21B247A7A25}" srcOrd="0" destOrd="0" presId="urn:microsoft.com/office/officeart/2005/8/layout/list1"/>
    <dgm:cxn modelId="{CA43D7EC-01DF-D247-80E3-035ADBC630B3}" type="presOf" srcId="{626A61FE-1201-4BA4-B69A-4A23FF565EDA}" destId="{B5BB295A-0733-7045-82BB-E38EA9F09D96}" srcOrd="1" destOrd="0" presId="urn:microsoft.com/office/officeart/2005/8/layout/list1"/>
    <dgm:cxn modelId="{C8CD53EF-379B-5A4C-87ED-03695D834390}" type="presOf" srcId="{FB89D801-6A7A-418A-99F9-6106D549D77A}" destId="{BB7C6D63-2639-D445-866C-7FF1561BE513}" srcOrd="1" destOrd="0" presId="urn:microsoft.com/office/officeart/2005/8/layout/list1"/>
    <dgm:cxn modelId="{4F0C43F2-95D3-614A-82CE-2230A0B1C02B}" type="presOf" srcId="{626A61FE-1201-4BA4-B69A-4A23FF565EDA}" destId="{AA5E3EC3-F6A2-AB42-B4AB-465593AAE83B}" srcOrd="0" destOrd="0" presId="urn:microsoft.com/office/officeart/2005/8/layout/list1"/>
    <dgm:cxn modelId="{F668FFFC-5EDF-4671-87A9-A7429D7F2AB6}" srcId="{3B53BD60-B6AD-45F7-887B-A923C0AC5D33}" destId="{626A61FE-1201-4BA4-B69A-4A23FF565EDA}" srcOrd="3" destOrd="0" parTransId="{9091120D-D8ED-4E42-80CC-90DFD4BF6D6A}" sibTransId="{2A9003FF-0247-4A3A-A4FF-0B7822FCB67B}"/>
    <dgm:cxn modelId="{6850E5E1-9BEA-2243-9004-61B52E104D9A}" type="presParOf" srcId="{3B19C6C7-D2C8-F64D-AEF5-D21B247A7A25}" destId="{D208DEF7-718D-C14B-BA65-8FFAEC3A51FA}" srcOrd="0" destOrd="0" presId="urn:microsoft.com/office/officeart/2005/8/layout/list1"/>
    <dgm:cxn modelId="{9690E068-341A-4B47-B52F-91AF552AD421}" type="presParOf" srcId="{D208DEF7-718D-C14B-BA65-8FFAEC3A51FA}" destId="{27E8ABF2-6531-7846-B148-F29B1C2622F9}" srcOrd="0" destOrd="0" presId="urn:microsoft.com/office/officeart/2005/8/layout/list1"/>
    <dgm:cxn modelId="{57A622E5-E841-5E4C-B58D-35B5146A3C36}" type="presParOf" srcId="{D208DEF7-718D-C14B-BA65-8FFAEC3A51FA}" destId="{BB7C6D63-2639-D445-866C-7FF1561BE513}" srcOrd="1" destOrd="0" presId="urn:microsoft.com/office/officeart/2005/8/layout/list1"/>
    <dgm:cxn modelId="{B8F4DE55-9179-A944-8211-BAB04062B51C}" type="presParOf" srcId="{3B19C6C7-D2C8-F64D-AEF5-D21B247A7A25}" destId="{8C54B7C4-BE21-4E4E-BE44-C17999B117B4}" srcOrd="1" destOrd="0" presId="urn:microsoft.com/office/officeart/2005/8/layout/list1"/>
    <dgm:cxn modelId="{A11F7ACA-0259-5245-A2B0-E29FD1580DE2}" type="presParOf" srcId="{3B19C6C7-D2C8-F64D-AEF5-D21B247A7A25}" destId="{338ED39E-E051-B243-B3BB-F31C196974DC}" srcOrd="2" destOrd="0" presId="urn:microsoft.com/office/officeart/2005/8/layout/list1"/>
    <dgm:cxn modelId="{DA76243B-E728-F54B-9EAA-738052DB0274}" type="presParOf" srcId="{3B19C6C7-D2C8-F64D-AEF5-D21B247A7A25}" destId="{304866B8-6A69-FB45-A40A-7AC9FE145DFA}" srcOrd="3" destOrd="0" presId="urn:microsoft.com/office/officeart/2005/8/layout/list1"/>
    <dgm:cxn modelId="{A47FF69B-10EA-EF45-B970-4CA130A8A694}" type="presParOf" srcId="{3B19C6C7-D2C8-F64D-AEF5-D21B247A7A25}" destId="{3380C581-CF7F-1A4F-BBD0-39FF77E264E3}" srcOrd="4" destOrd="0" presId="urn:microsoft.com/office/officeart/2005/8/layout/list1"/>
    <dgm:cxn modelId="{17C70F95-6188-4548-B4D1-5F4C4EE2ACB4}" type="presParOf" srcId="{3380C581-CF7F-1A4F-BBD0-39FF77E264E3}" destId="{BA00AE30-C007-7541-8ED4-A8C75F7F8099}" srcOrd="0" destOrd="0" presId="urn:microsoft.com/office/officeart/2005/8/layout/list1"/>
    <dgm:cxn modelId="{0D9FE4D3-991F-DC4F-8C18-B0057A77A1C8}" type="presParOf" srcId="{3380C581-CF7F-1A4F-BBD0-39FF77E264E3}" destId="{A5E7A925-589A-7C4B-9F1C-B67B53C03D71}" srcOrd="1" destOrd="0" presId="urn:microsoft.com/office/officeart/2005/8/layout/list1"/>
    <dgm:cxn modelId="{A5246108-FFC6-E142-BFBA-8390CA43F062}" type="presParOf" srcId="{3B19C6C7-D2C8-F64D-AEF5-D21B247A7A25}" destId="{718AF397-3D48-9C43-9033-ACE13B6DF96E}" srcOrd="5" destOrd="0" presId="urn:microsoft.com/office/officeart/2005/8/layout/list1"/>
    <dgm:cxn modelId="{5BB6B95E-8854-AF41-85C4-A282DB82BF5F}" type="presParOf" srcId="{3B19C6C7-D2C8-F64D-AEF5-D21B247A7A25}" destId="{87E49858-EC07-7C4D-BA74-DEDD05CBF403}" srcOrd="6" destOrd="0" presId="urn:microsoft.com/office/officeart/2005/8/layout/list1"/>
    <dgm:cxn modelId="{D615EFB7-DDB7-CE4A-9D8C-D6BE36DC9759}" type="presParOf" srcId="{3B19C6C7-D2C8-F64D-AEF5-D21B247A7A25}" destId="{7EDD0058-FA68-304B-A176-88E2D0786E17}" srcOrd="7" destOrd="0" presId="urn:microsoft.com/office/officeart/2005/8/layout/list1"/>
    <dgm:cxn modelId="{33A27300-D0BC-2542-B21E-AF77775343B8}" type="presParOf" srcId="{3B19C6C7-D2C8-F64D-AEF5-D21B247A7A25}" destId="{2A69C271-DFEA-2F48-971A-B1C8E8E710B8}" srcOrd="8" destOrd="0" presId="urn:microsoft.com/office/officeart/2005/8/layout/list1"/>
    <dgm:cxn modelId="{77C30B34-EF96-1243-8E5E-CD07A89DBD32}" type="presParOf" srcId="{2A69C271-DFEA-2F48-971A-B1C8E8E710B8}" destId="{A9BC0A94-A0B5-7F46-8F27-A6B96602304A}" srcOrd="0" destOrd="0" presId="urn:microsoft.com/office/officeart/2005/8/layout/list1"/>
    <dgm:cxn modelId="{DCA76E47-1097-C54D-B073-1D6899AE65C4}" type="presParOf" srcId="{2A69C271-DFEA-2F48-971A-B1C8E8E710B8}" destId="{5E652308-50C2-814D-BB94-3E9777DD4E07}" srcOrd="1" destOrd="0" presId="urn:microsoft.com/office/officeart/2005/8/layout/list1"/>
    <dgm:cxn modelId="{0F8C8A5B-DACB-7441-93FF-E4BB7E616B5E}" type="presParOf" srcId="{3B19C6C7-D2C8-F64D-AEF5-D21B247A7A25}" destId="{2DE66EAD-A634-2548-B7BC-E3FBD6FDC8A0}" srcOrd="9" destOrd="0" presId="urn:microsoft.com/office/officeart/2005/8/layout/list1"/>
    <dgm:cxn modelId="{A98396FA-0C47-2A40-A387-112A965D879E}" type="presParOf" srcId="{3B19C6C7-D2C8-F64D-AEF5-D21B247A7A25}" destId="{D42C8BD8-FF54-9A4A-992A-FDD111490F12}" srcOrd="10" destOrd="0" presId="urn:microsoft.com/office/officeart/2005/8/layout/list1"/>
    <dgm:cxn modelId="{0B676735-920F-2049-B45D-EF62001DEBCC}" type="presParOf" srcId="{3B19C6C7-D2C8-F64D-AEF5-D21B247A7A25}" destId="{B7603F37-15F0-6B49-B34D-F28A871EB5CF}" srcOrd="11" destOrd="0" presId="urn:microsoft.com/office/officeart/2005/8/layout/list1"/>
    <dgm:cxn modelId="{78C3A132-201A-2B4A-902B-56A90D3FAD93}" type="presParOf" srcId="{3B19C6C7-D2C8-F64D-AEF5-D21B247A7A25}" destId="{AC4F74FC-E46B-CB41-82E2-C5166F10EC85}" srcOrd="12" destOrd="0" presId="urn:microsoft.com/office/officeart/2005/8/layout/list1"/>
    <dgm:cxn modelId="{ED4F8D77-A627-E342-B170-39F7BF7AD939}" type="presParOf" srcId="{AC4F74FC-E46B-CB41-82E2-C5166F10EC85}" destId="{AA5E3EC3-F6A2-AB42-B4AB-465593AAE83B}" srcOrd="0" destOrd="0" presId="urn:microsoft.com/office/officeart/2005/8/layout/list1"/>
    <dgm:cxn modelId="{ABC040F7-93AE-5D48-9369-05C80B244E80}" type="presParOf" srcId="{AC4F74FC-E46B-CB41-82E2-C5166F10EC85}" destId="{B5BB295A-0733-7045-82BB-E38EA9F09D96}" srcOrd="1" destOrd="0" presId="urn:microsoft.com/office/officeart/2005/8/layout/list1"/>
    <dgm:cxn modelId="{12F7313F-6ABC-9049-9EAA-2FEF756E8B68}" type="presParOf" srcId="{3B19C6C7-D2C8-F64D-AEF5-D21B247A7A25}" destId="{2F0167FD-7E19-614C-ABD2-E774AA7694BC}" srcOrd="13" destOrd="0" presId="urn:microsoft.com/office/officeart/2005/8/layout/list1"/>
    <dgm:cxn modelId="{DAE890FA-E6C8-094F-B6FB-46C591068665}" type="presParOf" srcId="{3B19C6C7-D2C8-F64D-AEF5-D21B247A7A25}" destId="{48D69DE0-15B9-FF48-99A9-7EF235C6D93E}" srcOrd="14" destOrd="0" presId="urn:microsoft.com/office/officeart/2005/8/layout/list1"/>
    <dgm:cxn modelId="{116DF1A6-7B8C-9B4D-A338-FFF34B274802}" type="presParOf" srcId="{3B19C6C7-D2C8-F64D-AEF5-D21B247A7A25}" destId="{2FC39047-2151-5545-ACFD-BD86991E6A44}" srcOrd="15" destOrd="0" presId="urn:microsoft.com/office/officeart/2005/8/layout/list1"/>
    <dgm:cxn modelId="{9FA0866D-756C-D44F-A59C-5BC792E2C0C3}" type="presParOf" srcId="{3B19C6C7-D2C8-F64D-AEF5-D21B247A7A25}" destId="{DDAED815-A159-2246-A5B7-80416D39C49F}" srcOrd="16" destOrd="0" presId="urn:microsoft.com/office/officeart/2005/8/layout/list1"/>
    <dgm:cxn modelId="{07B2040C-3171-B94A-89BA-7236AA15BDC4}" type="presParOf" srcId="{DDAED815-A159-2246-A5B7-80416D39C49F}" destId="{B96C0D65-0FB9-B941-8721-39F4B7D9BE64}" srcOrd="0" destOrd="0" presId="urn:microsoft.com/office/officeart/2005/8/layout/list1"/>
    <dgm:cxn modelId="{7B0225C6-5EA7-774F-92E0-6B4289DAC4CF}" type="presParOf" srcId="{DDAED815-A159-2246-A5B7-80416D39C49F}" destId="{3443C13C-1D25-614A-9C26-8591E37F157B}" srcOrd="1" destOrd="0" presId="urn:microsoft.com/office/officeart/2005/8/layout/list1"/>
    <dgm:cxn modelId="{48F1A7D3-1743-3B49-87B6-29DC5D1D165A}" type="presParOf" srcId="{3B19C6C7-D2C8-F64D-AEF5-D21B247A7A25}" destId="{5075462D-CDD4-554E-988C-2C8992860856}" srcOrd="17" destOrd="0" presId="urn:microsoft.com/office/officeart/2005/8/layout/list1"/>
    <dgm:cxn modelId="{29A4A769-D3A8-EE48-BCA0-924AC50CA89C}" type="presParOf" srcId="{3B19C6C7-D2C8-F64D-AEF5-D21B247A7A25}" destId="{61A359C3-9EE3-C34A-885A-5411C5F3340C}" srcOrd="18"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B63688C0-CDDE-4CE3-A8C0-D0776B2BA858}" type="doc">
      <dgm:prSet loTypeId="urn:microsoft.com/office/officeart/2005/8/layout/hierarchy1" loCatId="hierarchy" qsTypeId="urn:microsoft.com/office/officeart/2005/8/quickstyle/simple1" qsCatId="simple" csTypeId="urn:microsoft.com/office/officeart/2005/8/colors/colorful1" csCatId="colorful" phldr="1"/>
      <dgm:spPr/>
      <dgm:t>
        <a:bodyPr/>
        <a:lstStyle/>
        <a:p>
          <a:endParaRPr lang="en-US"/>
        </a:p>
      </dgm:t>
    </dgm:pt>
    <dgm:pt modelId="{C5CC9364-29B6-4E5B-B5CF-1F04AC658DEA}">
      <dgm:prSet/>
      <dgm:spPr/>
      <dgm:t>
        <a:bodyPr/>
        <a:lstStyle/>
        <a:p>
          <a:r>
            <a:rPr lang="en-US" dirty="0"/>
            <a:t>“It sounds like you’re [worried about your family].”</a:t>
          </a:r>
        </a:p>
      </dgm:t>
    </dgm:pt>
    <dgm:pt modelId="{E7A68A88-5061-469D-82D5-4D3F344E6C00}" type="parTrans" cxnId="{6122A703-34BD-4ADA-A765-FB99B170896F}">
      <dgm:prSet/>
      <dgm:spPr/>
      <dgm:t>
        <a:bodyPr/>
        <a:lstStyle/>
        <a:p>
          <a:endParaRPr lang="en-US"/>
        </a:p>
      </dgm:t>
    </dgm:pt>
    <dgm:pt modelId="{4646CEF8-E393-4072-9FA9-6CFD27C9BCD6}" type="sibTrans" cxnId="{6122A703-34BD-4ADA-A765-FB99B170896F}">
      <dgm:prSet/>
      <dgm:spPr/>
      <dgm:t>
        <a:bodyPr/>
        <a:lstStyle/>
        <a:p>
          <a:endParaRPr lang="en-US"/>
        </a:p>
      </dgm:t>
    </dgm:pt>
    <dgm:pt modelId="{7D8D2E37-0C24-4977-87EC-40A2DD2FD787}">
      <dgm:prSet/>
      <dgm:spPr/>
      <dgm:t>
        <a:bodyPr/>
        <a:lstStyle/>
        <a:p>
          <a:r>
            <a:rPr lang="en-US" dirty="0"/>
            <a:t>”This is not what either of us was expecting.”</a:t>
          </a:r>
        </a:p>
      </dgm:t>
    </dgm:pt>
    <dgm:pt modelId="{6828ACC5-C7CB-4CF9-9DFD-A9DE671E5E05}" type="parTrans" cxnId="{3FD06C91-B454-4F56-B8A2-D2AA2B224B16}">
      <dgm:prSet/>
      <dgm:spPr/>
      <dgm:t>
        <a:bodyPr/>
        <a:lstStyle/>
        <a:p>
          <a:endParaRPr lang="en-US"/>
        </a:p>
      </dgm:t>
    </dgm:pt>
    <dgm:pt modelId="{7A5BCE11-952E-4292-9C96-15FBB9148FE9}" type="sibTrans" cxnId="{3FD06C91-B454-4F56-B8A2-D2AA2B224B16}">
      <dgm:prSet/>
      <dgm:spPr/>
      <dgm:t>
        <a:bodyPr/>
        <a:lstStyle/>
        <a:p>
          <a:endParaRPr lang="en-US"/>
        </a:p>
      </dgm:t>
    </dgm:pt>
    <dgm:pt modelId="{52D060E6-A67B-4B3A-8BFB-E27E3232CEF9}">
      <dgm:prSet/>
      <dgm:spPr/>
      <dgm:t>
        <a:bodyPr/>
        <a:lstStyle/>
        <a:p>
          <a:r>
            <a:rPr lang="en-US" dirty="0"/>
            <a:t>“Anyone in your shoes would be [upset, angry].”</a:t>
          </a:r>
        </a:p>
      </dgm:t>
    </dgm:pt>
    <dgm:pt modelId="{3CB56450-E570-4421-88F5-F79DE6DC6154}" type="parTrans" cxnId="{918D8176-372C-470F-9916-2E8A82239B0F}">
      <dgm:prSet/>
      <dgm:spPr/>
      <dgm:t>
        <a:bodyPr/>
        <a:lstStyle/>
        <a:p>
          <a:endParaRPr lang="en-US"/>
        </a:p>
      </dgm:t>
    </dgm:pt>
    <dgm:pt modelId="{DAAFB962-8626-4913-A4CF-FF5AE4226F4D}" type="sibTrans" cxnId="{918D8176-372C-470F-9916-2E8A82239B0F}">
      <dgm:prSet/>
      <dgm:spPr/>
      <dgm:t>
        <a:bodyPr/>
        <a:lstStyle/>
        <a:p>
          <a:endParaRPr lang="en-US"/>
        </a:p>
      </dgm:t>
    </dgm:pt>
    <dgm:pt modelId="{5E12EAB3-0E1C-9A4B-8862-8DF7D7412B68}" type="pres">
      <dgm:prSet presAssocID="{B63688C0-CDDE-4CE3-A8C0-D0776B2BA858}" presName="hierChild1" presStyleCnt="0">
        <dgm:presLayoutVars>
          <dgm:chPref val="1"/>
          <dgm:dir/>
          <dgm:animOne val="branch"/>
          <dgm:animLvl val="lvl"/>
          <dgm:resizeHandles/>
        </dgm:presLayoutVars>
      </dgm:prSet>
      <dgm:spPr/>
    </dgm:pt>
    <dgm:pt modelId="{04CD5426-E837-F84B-BB32-6B5F707E16C7}" type="pres">
      <dgm:prSet presAssocID="{C5CC9364-29B6-4E5B-B5CF-1F04AC658DEA}" presName="hierRoot1" presStyleCnt="0"/>
      <dgm:spPr/>
    </dgm:pt>
    <dgm:pt modelId="{F5DA5F71-01FA-AE42-897E-0A6850041DFD}" type="pres">
      <dgm:prSet presAssocID="{C5CC9364-29B6-4E5B-B5CF-1F04AC658DEA}" presName="composite" presStyleCnt="0"/>
      <dgm:spPr/>
    </dgm:pt>
    <dgm:pt modelId="{5AFB19AF-4D29-BD49-8229-5CCF082B8085}" type="pres">
      <dgm:prSet presAssocID="{C5CC9364-29B6-4E5B-B5CF-1F04AC658DEA}" presName="background" presStyleLbl="node0" presStyleIdx="0" presStyleCnt="3"/>
      <dgm:spPr/>
    </dgm:pt>
    <dgm:pt modelId="{FBA59609-2D8F-4F45-8E31-CE85D7E9BC69}" type="pres">
      <dgm:prSet presAssocID="{C5CC9364-29B6-4E5B-B5CF-1F04AC658DEA}" presName="text" presStyleLbl="fgAcc0" presStyleIdx="0" presStyleCnt="3">
        <dgm:presLayoutVars>
          <dgm:chPref val="3"/>
        </dgm:presLayoutVars>
      </dgm:prSet>
      <dgm:spPr/>
    </dgm:pt>
    <dgm:pt modelId="{005B0FCA-ABFA-C14D-9DAC-705848FF4C1B}" type="pres">
      <dgm:prSet presAssocID="{C5CC9364-29B6-4E5B-B5CF-1F04AC658DEA}" presName="hierChild2" presStyleCnt="0"/>
      <dgm:spPr/>
    </dgm:pt>
    <dgm:pt modelId="{18A10B8A-53AF-2C48-83AD-31F1F972FDB9}" type="pres">
      <dgm:prSet presAssocID="{7D8D2E37-0C24-4977-87EC-40A2DD2FD787}" presName="hierRoot1" presStyleCnt="0"/>
      <dgm:spPr/>
    </dgm:pt>
    <dgm:pt modelId="{5532A645-8D49-E147-A84D-EE5913EBA731}" type="pres">
      <dgm:prSet presAssocID="{7D8D2E37-0C24-4977-87EC-40A2DD2FD787}" presName="composite" presStyleCnt="0"/>
      <dgm:spPr/>
    </dgm:pt>
    <dgm:pt modelId="{84361372-DF3A-C24F-B5AD-83E45FAC1E7D}" type="pres">
      <dgm:prSet presAssocID="{7D8D2E37-0C24-4977-87EC-40A2DD2FD787}" presName="background" presStyleLbl="node0" presStyleIdx="1" presStyleCnt="3"/>
      <dgm:spPr/>
    </dgm:pt>
    <dgm:pt modelId="{7A27BF8E-5B63-D141-8AA1-A0ED266B0B9F}" type="pres">
      <dgm:prSet presAssocID="{7D8D2E37-0C24-4977-87EC-40A2DD2FD787}" presName="text" presStyleLbl="fgAcc0" presStyleIdx="1" presStyleCnt="3">
        <dgm:presLayoutVars>
          <dgm:chPref val="3"/>
        </dgm:presLayoutVars>
      </dgm:prSet>
      <dgm:spPr/>
    </dgm:pt>
    <dgm:pt modelId="{0649D8B7-A9B1-714C-882A-A99A68448669}" type="pres">
      <dgm:prSet presAssocID="{7D8D2E37-0C24-4977-87EC-40A2DD2FD787}" presName="hierChild2" presStyleCnt="0"/>
      <dgm:spPr/>
    </dgm:pt>
    <dgm:pt modelId="{4D71C18A-35AF-2044-B3EC-1712606D6635}" type="pres">
      <dgm:prSet presAssocID="{52D060E6-A67B-4B3A-8BFB-E27E3232CEF9}" presName="hierRoot1" presStyleCnt="0"/>
      <dgm:spPr/>
    </dgm:pt>
    <dgm:pt modelId="{729B6574-35C6-304F-A16A-CBA0F72B316D}" type="pres">
      <dgm:prSet presAssocID="{52D060E6-A67B-4B3A-8BFB-E27E3232CEF9}" presName="composite" presStyleCnt="0"/>
      <dgm:spPr/>
    </dgm:pt>
    <dgm:pt modelId="{4EE9CFFF-8BE6-3C40-9C38-3898E302B344}" type="pres">
      <dgm:prSet presAssocID="{52D060E6-A67B-4B3A-8BFB-E27E3232CEF9}" presName="background" presStyleLbl="node0" presStyleIdx="2" presStyleCnt="3"/>
      <dgm:spPr/>
    </dgm:pt>
    <dgm:pt modelId="{B52FB546-8780-ED4E-9BE0-750F0463D467}" type="pres">
      <dgm:prSet presAssocID="{52D060E6-A67B-4B3A-8BFB-E27E3232CEF9}" presName="text" presStyleLbl="fgAcc0" presStyleIdx="2" presStyleCnt="3">
        <dgm:presLayoutVars>
          <dgm:chPref val="3"/>
        </dgm:presLayoutVars>
      </dgm:prSet>
      <dgm:spPr/>
    </dgm:pt>
    <dgm:pt modelId="{94672764-00B1-9145-BC97-A773FB938012}" type="pres">
      <dgm:prSet presAssocID="{52D060E6-A67B-4B3A-8BFB-E27E3232CEF9}" presName="hierChild2" presStyleCnt="0"/>
      <dgm:spPr/>
    </dgm:pt>
  </dgm:ptLst>
  <dgm:cxnLst>
    <dgm:cxn modelId="{6122A703-34BD-4ADA-A765-FB99B170896F}" srcId="{B63688C0-CDDE-4CE3-A8C0-D0776B2BA858}" destId="{C5CC9364-29B6-4E5B-B5CF-1F04AC658DEA}" srcOrd="0" destOrd="0" parTransId="{E7A68A88-5061-469D-82D5-4D3F344E6C00}" sibTransId="{4646CEF8-E393-4072-9FA9-6CFD27C9BCD6}"/>
    <dgm:cxn modelId="{DCBB4141-B9B3-054E-BC86-56CA5EC612C1}" type="presOf" srcId="{52D060E6-A67B-4B3A-8BFB-E27E3232CEF9}" destId="{B52FB546-8780-ED4E-9BE0-750F0463D467}" srcOrd="0" destOrd="0" presId="urn:microsoft.com/office/officeart/2005/8/layout/hierarchy1"/>
    <dgm:cxn modelId="{918D8176-372C-470F-9916-2E8A82239B0F}" srcId="{B63688C0-CDDE-4CE3-A8C0-D0776B2BA858}" destId="{52D060E6-A67B-4B3A-8BFB-E27E3232CEF9}" srcOrd="2" destOrd="0" parTransId="{3CB56450-E570-4421-88F5-F79DE6DC6154}" sibTransId="{DAAFB962-8626-4913-A4CF-FF5AE4226F4D}"/>
    <dgm:cxn modelId="{3FD06C91-B454-4F56-B8A2-D2AA2B224B16}" srcId="{B63688C0-CDDE-4CE3-A8C0-D0776B2BA858}" destId="{7D8D2E37-0C24-4977-87EC-40A2DD2FD787}" srcOrd="1" destOrd="0" parTransId="{6828ACC5-C7CB-4CF9-9DFD-A9DE671E5E05}" sibTransId="{7A5BCE11-952E-4292-9C96-15FBB9148FE9}"/>
    <dgm:cxn modelId="{6BD646B9-00A4-CB4E-AE4D-A37C01D6A4A8}" type="presOf" srcId="{C5CC9364-29B6-4E5B-B5CF-1F04AC658DEA}" destId="{FBA59609-2D8F-4F45-8E31-CE85D7E9BC69}" srcOrd="0" destOrd="0" presId="urn:microsoft.com/office/officeart/2005/8/layout/hierarchy1"/>
    <dgm:cxn modelId="{C2D9EFC2-40E1-1E45-B231-024B6671C968}" type="presOf" srcId="{7D8D2E37-0C24-4977-87EC-40A2DD2FD787}" destId="{7A27BF8E-5B63-D141-8AA1-A0ED266B0B9F}" srcOrd="0" destOrd="0" presId="urn:microsoft.com/office/officeart/2005/8/layout/hierarchy1"/>
    <dgm:cxn modelId="{96638DD8-FA6A-7844-9E46-80B26DEA49AC}" type="presOf" srcId="{B63688C0-CDDE-4CE3-A8C0-D0776B2BA858}" destId="{5E12EAB3-0E1C-9A4B-8862-8DF7D7412B68}" srcOrd="0" destOrd="0" presId="urn:microsoft.com/office/officeart/2005/8/layout/hierarchy1"/>
    <dgm:cxn modelId="{BD41733C-16FC-7E48-B44E-2C21BB15BBCC}" type="presParOf" srcId="{5E12EAB3-0E1C-9A4B-8862-8DF7D7412B68}" destId="{04CD5426-E837-F84B-BB32-6B5F707E16C7}" srcOrd="0" destOrd="0" presId="urn:microsoft.com/office/officeart/2005/8/layout/hierarchy1"/>
    <dgm:cxn modelId="{BDBBA087-BA22-1E41-B0ED-E079F2A71726}" type="presParOf" srcId="{04CD5426-E837-F84B-BB32-6B5F707E16C7}" destId="{F5DA5F71-01FA-AE42-897E-0A6850041DFD}" srcOrd="0" destOrd="0" presId="urn:microsoft.com/office/officeart/2005/8/layout/hierarchy1"/>
    <dgm:cxn modelId="{B640F6F3-ADBA-CB4F-941D-5592903AE7F1}" type="presParOf" srcId="{F5DA5F71-01FA-AE42-897E-0A6850041DFD}" destId="{5AFB19AF-4D29-BD49-8229-5CCF082B8085}" srcOrd="0" destOrd="0" presId="urn:microsoft.com/office/officeart/2005/8/layout/hierarchy1"/>
    <dgm:cxn modelId="{2190233C-FCD4-F043-AAAA-954595146117}" type="presParOf" srcId="{F5DA5F71-01FA-AE42-897E-0A6850041DFD}" destId="{FBA59609-2D8F-4F45-8E31-CE85D7E9BC69}" srcOrd="1" destOrd="0" presId="urn:microsoft.com/office/officeart/2005/8/layout/hierarchy1"/>
    <dgm:cxn modelId="{AB1D63D2-86BB-2046-BC9C-761B3D8E4D57}" type="presParOf" srcId="{04CD5426-E837-F84B-BB32-6B5F707E16C7}" destId="{005B0FCA-ABFA-C14D-9DAC-705848FF4C1B}" srcOrd="1" destOrd="0" presId="urn:microsoft.com/office/officeart/2005/8/layout/hierarchy1"/>
    <dgm:cxn modelId="{858FE251-FEB4-374D-8CE0-2DAEBE0F166F}" type="presParOf" srcId="{5E12EAB3-0E1C-9A4B-8862-8DF7D7412B68}" destId="{18A10B8A-53AF-2C48-83AD-31F1F972FDB9}" srcOrd="1" destOrd="0" presId="urn:microsoft.com/office/officeart/2005/8/layout/hierarchy1"/>
    <dgm:cxn modelId="{B6AEEE67-0B29-C241-B604-E3C4F180BD47}" type="presParOf" srcId="{18A10B8A-53AF-2C48-83AD-31F1F972FDB9}" destId="{5532A645-8D49-E147-A84D-EE5913EBA731}" srcOrd="0" destOrd="0" presId="urn:microsoft.com/office/officeart/2005/8/layout/hierarchy1"/>
    <dgm:cxn modelId="{23718845-12DC-B644-A348-98FCE069894A}" type="presParOf" srcId="{5532A645-8D49-E147-A84D-EE5913EBA731}" destId="{84361372-DF3A-C24F-B5AD-83E45FAC1E7D}" srcOrd="0" destOrd="0" presId="urn:microsoft.com/office/officeart/2005/8/layout/hierarchy1"/>
    <dgm:cxn modelId="{FDDB2C54-3661-334E-AEFB-A52BE70DF6FE}" type="presParOf" srcId="{5532A645-8D49-E147-A84D-EE5913EBA731}" destId="{7A27BF8E-5B63-D141-8AA1-A0ED266B0B9F}" srcOrd="1" destOrd="0" presId="urn:microsoft.com/office/officeart/2005/8/layout/hierarchy1"/>
    <dgm:cxn modelId="{6674D433-5EBB-8148-AB7A-FF2A9C51AC50}" type="presParOf" srcId="{18A10B8A-53AF-2C48-83AD-31F1F972FDB9}" destId="{0649D8B7-A9B1-714C-882A-A99A68448669}" srcOrd="1" destOrd="0" presId="urn:microsoft.com/office/officeart/2005/8/layout/hierarchy1"/>
    <dgm:cxn modelId="{2FBE5D1C-127D-934F-8A91-A195CBED3871}" type="presParOf" srcId="{5E12EAB3-0E1C-9A4B-8862-8DF7D7412B68}" destId="{4D71C18A-35AF-2044-B3EC-1712606D6635}" srcOrd="2" destOrd="0" presId="urn:microsoft.com/office/officeart/2005/8/layout/hierarchy1"/>
    <dgm:cxn modelId="{4B4D08CC-7FD5-394D-A108-05F66D0ACA2A}" type="presParOf" srcId="{4D71C18A-35AF-2044-B3EC-1712606D6635}" destId="{729B6574-35C6-304F-A16A-CBA0F72B316D}" srcOrd="0" destOrd="0" presId="urn:microsoft.com/office/officeart/2005/8/layout/hierarchy1"/>
    <dgm:cxn modelId="{0875DFF5-1919-6D4C-957D-51BEF3245D8E}" type="presParOf" srcId="{729B6574-35C6-304F-A16A-CBA0F72B316D}" destId="{4EE9CFFF-8BE6-3C40-9C38-3898E302B344}" srcOrd="0" destOrd="0" presId="urn:microsoft.com/office/officeart/2005/8/layout/hierarchy1"/>
    <dgm:cxn modelId="{144B1CC6-5126-0F41-9A8D-1D0DF62D85EB}" type="presParOf" srcId="{729B6574-35C6-304F-A16A-CBA0F72B316D}" destId="{B52FB546-8780-ED4E-9BE0-750F0463D467}" srcOrd="1" destOrd="0" presId="urn:microsoft.com/office/officeart/2005/8/layout/hierarchy1"/>
    <dgm:cxn modelId="{406EE496-ACA6-C347-9038-D27A70B40A84}" type="presParOf" srcId="{4D71C18A-35AF-2044-B3EC-1712606D6635}" destId="{94672764-00B1-9145-BC97-A773FB938012}"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CC7EA3DA-9748-4B84-A8C9-9CB073AB5330}" type="doc">
      <dgm:prSet loTypeId="urn:microsoft.com/office/officeart/2018/2/layout/IconLabelList" loCatId="icon" qsTypeId="urn:microsoft.com/office/officeart/2005/8/quickstyle/simple1" qsCatId="simple" csTypeId="urn:microsoft.com/office/officeart/2018/5/colors/Iconchunking_neutralbg_colorful1" csCatId="colorful" phldr="1"/>
      <dgm:spPr/>
      <dgm:t>
        <a:bodyPr/>
        <a:lstStyle/>
        <a:p>
          <a:endParaRPr lang="en-US"/>
        </a:p>
      </dgm:t>
    </dgm:pt>
    <dgm:pt modelId="{7ADA177F-B99C-41DD-8198-F4B6E919FBF7}">
      <dgm:prSet/>
      <dgm:spPr/>
      <dgm:t>
        <a:bodyPr/>
        <a:lstStyle/>
        <a:p>
          <a:r>
            <a:rPr lang="en-US" dirty="0"/>
            <a:t>“I can’t imagine [how hard this must be].”</a:t>
          </a:r>
        </a:p>
      </dgm:t>
    </dgm:pt>
    <dgm:pt modelId="{8B6BCB5F-7E3D-4867-BF24-10825B971E6E}" type="parTrans" cxnId="{092B5235-53AE-4789-A299-F208A5718155}">
      <dgm:prSet/>
      <dgm:spPr/>
      <dgm:t>
        <a:bodyPr/>
        <a:lstStyle/>
        <a:p>
          <a:endParaRPr lang="en-US"/>
        </a:p>
      </dgm:t>
    </dgm:pt>
    <dgm:pt modelId="{EFBFCA75-B8A6-4AA6-AE80-7C7F7ABEC266}" type="sibTrans" cxnId="{092B5235-53AE-4789-A299-F208A5718155}">
      <dgm:prSet/>
      <dgm:spPr/>
      <dgm:t>
        <a:bodyPr/>
        <a:lstStyle/>
        <a:p>
          <a:endParaRPr lang="en-US"/>
        </a:p>
      </dgm:t>
    </dgm:pt>
    <dgm:pt modelId="{9DD5CAAE-1C89-4820-B4F6-AFBCBDEB83C0}">
      <dgm:prSet/>
      <dgm:spPr/>
      <dgm:t>
        <a:bodyPr/>
        <a:lstStyle/>
        <a:p>
          <a:r>
            <a:rPr lang="en-US" dirty="0"/>
            <a:t>“I know this isn’t what </a:t>
          </a:r>
          <a:r>
            <a:rPr lang="en-US" i="1" dirty="0"/>
            <a:t>we</a:t>
          </a:r>
          <a:r>
            <a:rPr lang="en-US" dirty="0"/>
            <a:t> were hoping for.”</a:t>
          </a:r>
        </a:p>
      </dgm:t>
    </dgm:pt>
    <dgm:pt modelId="{E579C24A-88B1-476F-B03B-B405C58A45A3}" type="parTrans" cxnId="{D18F69C4-4E57-445A-B032-57CC3B4FFC95}">
      <dgm:prSet/>
      <dgm:spPr/>
      <dgm:t>
        <a:bodyPr/>
        <a:lstStyle/>
        <a:p>
          <a:endParaRPr lang="en-US"/>
        </a:p>
      </dgm:t>
    </dgm:pt>
    <dgm:pt modelId="{C192A57E-24E4-4997-9200-A5690C78DD57}" type="sibTrans" cxnId="{D18F69C4-4E57-445A-B032-57CC3B4FFC95}">
      <dgm:prSet/>
      <dgm:spPr/>
      <dgm:t>
        <a:bodyPr/>
        <a:lstStyle/>
        <a:p>
          <a:endParaRPr lang="en-US"/>
        </a:p>
      </dgm:t>
    </dgm:pt>
    <dgm:pt modelId="{9C99FE1E-C26B-49ED-92EC-B3375790E066}">
      <dgm:prSet/>
      <dgm:spPr/>
      <dgm:t>
        <a:bodyPr/>
        <a:lstStyle/>
        <a:p>
          <a:r>
            <a:rPr lang="en-US" dirty="0"/>
            <a:t>“I wish….[this hadn’t happened].”</a:t>
          </a:r>
        </a:p>
      </dgm:t>
    </dgm:pt>
    <dgm:pt modelId="{E1AABBFF-86FE-4DA3-A10E-97E5BCDEDB65}" type="parTrans" cxnId="{8FD6F219-C90D-4A1C-88C4-DAC4D6223C13}">
      <dgm:prSet/>
      <dgm:spPr/>
      <dgm:t>
        <a:bodyPr/>
        <a:lstStyle/>
        <a:p>
          <a:endParaRPr lang="en-US"/>
        </a:p>
      </dgm:t>
    </dgm:pt>
    <dgm:pt modelId="{25238E7B-37A9-42CF-91E1-5DD84FF846AF}" type="sibTrans" cxnId="{8FD6F219-C90D-4A1C-88C4-DAC4D6223C13}">
      <dgm:prSet/>
      <dgm:spPr/>
      <dgm:t>
        <a:bodyPr/>
        <a:lstStyle/>
        <a:p>
          <a:endParaRPr lang="en-US"/>
        </a:p>
      </dgm:t>
    </dgm:pt>
    <dgm:pt modelId="{BF0DBABE-5436-4945-B1F4-F6242C825AEB}" type="pres">
      <dgm:prSet presAssocID="{CC7EA3DA-9748-4B84-A8C9-9CB073AB5330}" presName="root" presStyleCnt="0">
        <dgm:presLayoutVars>
          <dgm:dir/>
          <dgm:resizeHandles val="exact"/>
        </dgm:presLayoutVars>
      </dgm:prSet>
      <dgm:spPr/>
    </dgm:pt>
    <dgm:pt modelId="{E6694723-1AA8-4FAE-A4FE-DEB1CD56BBC7}" type="pres">
      <dgm:prSet presAssocID="{7ADA177F-B99C-41DD-8198-F4B6E919FBF7}" presName="compNode" presStyleCnt="0"/>
      <dgm:spPr/>
    </dgm:pt>
    <dgm:pt modelId="{238C11C0-170C-40B0-9437-DA73AFB2934A}" type="pres">
      <dgm:prSet presAssocID="{7ADA177F-B99C-41DD-8198-F4B6E919FBF7}" presName="iconRect" presStyleLbl="node1" presStyleIdx="0" presStyleCnt="3"/>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a:noFill/>
        </a:ln>
      </dgm:spPr>
      <dgm:extLst>
        <a:ext uri="{E40237B7-FDA0-4F09-8148-C483321AD2D9}">
          <dgm14:cNvPr xmlns:dgm14="http://schemas.microsoft.com/office/drawing/2010/diagram" id="0" name="" descr="Confused Person"/>
        </a:ext>
      </dgm:extLst>
    </dgm:pt>
    <dgm:pt modelId="{6ED5AC75-3CC6-416D-9E6D-77433CA2F8AB}" type="pres">
      <dgm:prSet presAssocID="{7ADA177F-B99C-41DD-8198-F4B6E919FBF7}" presName="spaceRect" presStyleCnt="0"/>
      <dgm:spPr/>
    </dgm:pt>
    <dgm:pt modelId="{BEFBD12D-B6F2-4963-9BA4-67AB0C1349BC}" type="pres">
      <dgm:prSet presAssocID="{7ADA177F-B99C-41DD-8198-F4B6E919FBF7}" presName="textRect" presStyleLbl="revTx" presStyleIdx="0" presStyleCnt="3">
        <dgm:presLayoutVars>
          <dgm:chMax val="1"/>
          <dgm:chPref val="1"/>
        </dgm:presLayoutVars>
      </dgm:prSet>
      <dgm:spPr/>
    </dgm:pt>
    <dgm:pt modelId="{8BB846CA-B37B-40F5-8BA7-99348756E04D}" type="pres">
      <dgm:prSet presAssocID="{EFBFCA75-B8A6-4AA6-AE80-7C7F7ABEC266}" presName="sibTrans" presStyleCnt="0"/>
      <dgm:spPr/>
    </dgm:pt>
    <dgm:pt modelId="{3E57E47A-2872-444B-AD03-217F90657CB9}" type="pres">
      <dgm:prSet presAssocID="{9DD5CAAE-1C89-4820-B4F6-AFBCBDEB83C0}" presName="compNode" presStyleCnt="0"/>
      <dgm:spPr/>
    </dgm:pt>
    <dgm:pt modelId="{D92BB01B-93C5-4A00-80E7-589EFFF5B01B}" type="pres">
      <dgm:prSet presAssocID="{9DD5CAAE-1C89-4820-B4F6-AFBCBDEB83C0}" presName="iconRect" presStyleLbl="node1" presStyleIdx="1" presStyleCnt="3"/>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Angry Face with No Fill"/>
        </a:ext>
      </dgm:extLst>
    </dgm:pt>
    <dgm:pt modelId="{2945FFB3-91EE-4B20-B9D3-B89C9EC55EDB}" type="pres">
      <dgm:prSet presAssocID="{9DD5CAAE-1C89-4820-B4F6-AFBCBDEB83C0}" presName="spaceRect" presStyleCnt="0"/>
      <dgm:spPr/>
    </dgm:pt>
    <dgm:pt modelId="{B0430C96-FFEE-4629-BA7C-2CC8A2DA31FF}" type="pres">
      <dgm:prSet presAssocID="{9DD5CAAE-1C89-4820-B4F6-AFBCBDEB83C0}" presName="textRect" presStyleLbl="revTx" presStyleIdx="1" presStyleCnt="3">
        <dgm:presLayoutVars>
          <dgm:chMax val="1"/>
          <dgm:chPref val="1"/>
        </dgm:presLayoutVars>
      </dgm:prSet>
      <dgm:spPr/>
    </dgm:pt>
    <dgm:pt modelId="{1CBE7CB4-0EFE-4235-BCF4-F7F2BAA32778}" type="pres">
      <dgm:prSet presAssocID="{C192A57E-24E4-4997-9200-A5690C78DD57}" presName="sibTrans" presStyleCnt="0"/>
      <dgm:spPr/>
    </dgm:pt>
    <dgm:pt modelId="{103A874F-E0E8-4589-830F-5C7A1CCF86FA}" type="pres">
      <dgm:prSet presAssocID="{9C99FE1E-C26B-49ED-92EC-B3375790E066}" presName="compNode" presStyleCnt="0"/>
      <dgm:spPr/>
    </dgm:pt>
    <dgm:pt modelId="{95F0C128-DF29-47DC-AAB5-474ABFECD063}" type="pres">
      <dgm:prSet presAssocID="{9C99FE1E-C26B-49ED-92EC-B3375790E066}" presName="iconRect" presStyleLbl="node1" presStyleIdx="2" presStyleCnt="3"/>
      <dgm:spPr>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a:ln>
          <a:noFill/>
        </a:ln>
      </dgm:spPr>
      <dgm:extLst>
        <a:ext uri="{E40237B7-FDA0-4F09-8148-C483321AD2D9}">
          <dgm14:cNvPr xmlns:dgm14="http://schemas.microsoft.com/office/drawing/2010/diagram" id="0" name="" descr="Angel Face Outline"/>
        </a:ext>
      </dgm:extLst>
    </dgm:pt>
    <dgm:pt modelId="{61D5A04D-5B5F-4658-9EB0-D56A8E9237DC}" type="pres">
      <dgm:prSet presAssocID="{9C99FE1E-C26B-49ED-92EC-B3375790E066}" presName="spaceRect" presStyleCnt="0"/>
      <dgm:spPr/>
    </dgm:pt>
    <dgm:pt modelId="{9878B598-8717-420B-9CC1-DCE5F236695D}" type="pres">
      <dgm:prSet presAssocID="{9C99FE1E-C26B-49ED-92EC-B3375790E066}" presName="textRect" presStyleLbl="revTx" presStyleIdx="2" presStyleCnt="3">
        <dgm:presLayoutVars>
          <dgm:chMax val="1"/>
          <dgm:chPref val="1"/>
        </dgm:presLayoutVars>
      </dgm:prSet>
      <dgm:spPr/>
    </dgm:pt>
  </dgm:ptLst>
  <dgm:cxnLst>
    <dgm:cxn modelId="{8FD6F219-C90D-4A1C-88C4-DAC4D6223C13}" srcId="{CC7EA3DA-9748-4B84-A8C9-9CB073AB5330}" destId="{9C99FE1E-C26B-49ED-92EC-B3375790E066}" srcOrd="2" destOrd="0" parTransId="{E1AABBFF-86FE-4DA3-A10E-97E5BCDEDB65}" sibTransId="{25238E7B-37A9-42CF-91E1-5DD84FF846AF}"/>
    <dgm:cxn modelId="{A3AB3B31-BA26-46A0-8F29-FE805AB12E5D}" type="presOf" srcId="{7ADA177F-B99C-41DD-8198-F4B6E919FBF7}" destId="{BEFBD12D-B6F2-4963-9BA4-67AB0C1349BC}" srcOrd="0" destOrd="0" presId="urn:microsoft.com/office/officeart/2018/2/layout/IconLabelList"/>
    <dgm:cxn modelId="{092B5235-53AE-4789-A299-F208A5718155}" srcId="{CC7EA3DA-9748-4B84-A8C9-9CB073AB5330}" destId="{7ADA177F-B99C-41DD-8198-F4B6E919FBF7}" srcOrd="0" destOrd="0" parTransId="{8B6BCB5F-7E3D-4867-BF24-10825B971E6E}" sibTransId="{EFBFCA75-B8A6-4AA6-AE80-7C7F7ABEC266}"/>
    <dgm:cxn modelId="{AF9B0D5B-214A-49CD-AD8B-BE659F1FF040}" type="presOf" srcId="{9DD5CAAE-1C89-4820-B4F6-AFBCBDEB83C0}" destId="{B0430C96-FFEE-4629-BA7C-2CC8A2DA31FF}" srcOrd="0" destOrd="0" presId="urn:microsoft.com/office/officeart/2018/2/layout/IconLabelList"/>
    <dgm:cxn modelId="{7AB5707D-3C89-4D5E-BE33-FEB69A064F15}" type="presOf" srcId="{9C99FE1E-C26B-49ED-92EC-B3375790E066}" destId="{9878B598-8717-420B-9CC1-DCE5F236695D}" srcOrd="0" destOrd="0" presId="urn:microsoft.com/office/officeart/2018/2/layout/IconLabelList"/>
    <dgm:cxn modelId="{2FFD2B80-EDF5-4150-BA2E-2A3BFAC98B8B}" type="presOf" srcId="{CC7EA3DA-9748-4B84-A8C9-9CB073AB5330}" destId="{BF0DBABE-5436-4945-B1F4-F6242C825AEB}" srcOrd="0" destOrd="0" presId="urn:microsoft.com/office/officeart/2018/2/layout/IconLabelList"/>
    <dgm:cxn modelId="{D18F69C4-4E57-445A-B032-57CC3B4FFC95}" srcId="{CC7EA3DA-9748-4B84-A8C9-9CB073AB5330}" destId="{9DD5CAAE-1C89-4820-B4F6-AFBCBDEB83C0}" srcOrd="1" destOrd="0" parTransId="{E579C24A-88B1-476F-B03B-B405C58A45A3}" sibTransId="{C192A57E-24E4-4997-9200-A5690C78DD57}"/>
    <dgm:cxn modelId="{F2FA807B-B073-47ED-BA2C-3CE624810276}" type="presParOf" srcId="{BF0DBABE-5436-4945-B1F4-F6242C825AEB}" destId="{E6694723-1AA8-4FAE-A4FE-DEB1CD56BBC7}" srcOrd="0" destOrd="0" presId="urn:microsoft.com/office/officeart/2018/2/layout/IconLabelList"/>
    <dgm:cxn modelId="{6960B787-E597-4CDA-8F5E-A5EC6233364A}" type="presParOf" srcId="{E6694723-1AA8-4FAE-A4FE-DEB1CD56BBC7}" destId="{238C11C0-170C-40B0-9437-DA73AFB2934A}" srcOrd="0" destOrd="0" presId="urn:microsoft.com/office/officeart/2018/2/layout/IconLabelList"/>
    <dgm:cxn modelId="{C6C52363-394D-476F-A0D5-550F817BC56F}" type="presParOf" srcId="{E6694723-1AA8-4FAE-A4FE-DEB1CD56BBC7}" destId="{6ED5AC75-3CC6-416D-9E6D-77433CA2F8AB}" srcOrd="1" destOrd="0" presId="urn:microsoft.com/office/officeart/2018/2/layout/IconLabelList"/>
    <dgm:cxn modelId="{500A42DF-A5D0-471B-92C0-53A32B008815}" type="presParOf" srcId="{E6694723-1AA8-4FAE-A4FE-DEB1CD56BBC7}" destId="{BEFBD12D-B6F2-4963-9BA4-67AB0C1349BC}" srcOrd="2" destOrd="0" presId="urn:microsoft.com/office/officeart/2018/2/layout/IconLabelList"/>
    <dgm:cxn modelId="{4E84C90C-254C-46CE-8C8B-29DC6FAE3188}" type="presParOf" srcId="{BF0DBABE-5436-4945-B1F4-F6242C825AEB}" destId="{8BB846CA-B37B-40F5-8BA7-99348756E04D}" srcOrd="1" destOrd="0" presId="urn:microsoft.com/office/officeart/2018/2/layout/IconLabelList"/>
    <dgm:cxn modelId="{61B40361-A615-4885-B4C0-8D6CFC3C74D5}" type="presParOf" srcId="{BF0DBABE-5436-4945-B1F4-F6242C825AEB}" destId="{3E57E47A-2872-444B-AD03-217F90657CB9}" srcOrd="2" destOrd="0" presId="urn:microsoft.com/office/officeart/2018/2/layout/IconLabelList"/>
    <dgm:cxn modelId="{7309CBF3-22E3-463B-9FE8-116C274DECE8}" type="presParOf" srcId="{3E57E47A-2872-444B-AD03-217F90657CB9}" destId="{D92BB01B-93C5-4A00-80E7-589EFFF5B01B}" srcOrd="0" destOrd="0" presId="urn:microsoft.com/office/officeart/2018/2/layout/IconLabelList"/>
    <dgm:cxn modelId="{03FD277F-B1BD-4F54-8744-D1484269BD6E}" type="presParOf" srcId="{3E57E47A-2872-444B-AD03-217F90657CB9}" destId="{2945FFB3-91EE-4B20-B9D3-B89C9EC55EDB}" srcOrd="1" destOrd="0" presId="urn:microsoft.com/office/officeart/2018/2/layout/IconLabelList"/>
    <dgm:cxn modelId="{5385C2C6-183A-4EA2-9E1B-BDA5486FD0AE}" type="presParOf" srcId="{3E57E47A-2872-444B-AD03-217F90657CB9}" destId="{B0430C96-FFEE-4629-BA7C-2CC8A2DA31FF}" srcOrd="2" destOrd="0" presId="urn:microsoft.com/office/officeart/2018/2/layout/IconLabelList"/>
    <dgm:cxn modelId="{85ECC24A-4B0C-40AA-91C3-41979A91915D}" type="presParOf" srcId="{BF0DBABE-5436-4945-B1F4-F6242C825AEB}" destId="{1CBE7CB4-0EFE-4235-BCF4-F7F2BAA32778}" srcOrd="3" destOrd="0" presId="urn:microsoft.com/office/officeart/2018/2/layout/IconLabelList"/>
    <dgm:cxn modelId="{5A99288F-A917-4973-8A1F-7523505CD830}" type="presParOf" srcId="{BF0DBABE-5436-4945-B1F4-F6242C825AEB}" destId="{103A874F-E0E8-4589-830F-5C7A1CCF86FA}" srcOrd="4" destOrd="0" presId="urn:microsoft.com/office/officeart/2018/2/layout/IconLabelList"/>
    <dgm:cxn modelId="{8CE1405C-7DED-4591-BF0F-29CBC3B4FEC1}" type="presParOf" srcId="{103A874F-E0E8-4589-830F-5C7A1CCF86FA}" destId="{95F0C128-DF29-47DC-AAB5-474ABFECD063}" srcOrd="0" destOrd="0" presId="urn:microsoft.com/office/officeart/2018/2/layout/IconLabelList"/>
    <dgm:cxn modelId="{3D6B7384-115A-4AB7-B8CE-EAB06AC5F5D4}" type="presParOf" srcId="{103A874F-E0E8-4589-830F-5C7A1CCF86FA}" destId="{61D5A04D-5B5F-4658-9EB0-D56A8E9237DC}" srcOrd="1" destOrd="0" presId="urn:microsoft.com/office/officeart/2018/2/layout/IconLabelList"/>
    <dgm:cxn modelId="{81A33057-5B52-4AAF-998F-763403206E6B}" type="presParOf" srcId="{103A874F-E0E8-4589-830F-5C7A1CCF86FA}" destId="{9878B598-8717-420B-9CC1-DCE5F236695D}" srcOrd="2" destOrd="0" presId="urn:microsoft.com/office/officeart/2018/2/layout/IconLabel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CFF302E5-5B06-43A4-8D4E-73E70BB919F9}" type="doc">
      <dgm:prSet loTypeId="urn:microsoft.com/office/officeart/2005/8/layout/hierarchy3" loCatId="hierarchy" qsTypeId="urn:microsoft.com/office/officeart/2005/8/quickstyle/simple1" qsCatId="simple" csTypeId="urn:microsoft.com/office/officeart/2005/8/colors/colorful1" csCatId="colorful" phldr="1"/>
      <dgm:spPr/>
      <dgm:t>
        <a:bodyPr/>
        <a:lstStyle/>
        <a:p>
          <a:endParaRPr lang="en-US"/>
        </a:p>
      </dgm:t>
    </dgm:pt>
    <dgm:pt modelId="{C977B2DC-3E31-4025-96D9-166524F419DC}">
      <dgm:prSet/>
      <dgm:spPr/>
      <dgm:t>
        <a:bodyPr/>
        <a:lstStyle/>
        <a:p>
          <a:r>
            <a:rPr lang="en-US" dirty="0"/>
            <a:t>“You have done everything right.”</a:t>
          </a:r>
        </a:p>
      </dgm:t>
    </dgm:pt>
    <dgm:pt modelId="{16BA2C89-4779-40BB-B56E-A50FB817667D}" type="parTrans" cxnId="{9602EC4B-0CAC-4E64-9DBE-FA6F35ECF280}">
      <dgm:prSet/>
      <dgm:spPr/>
      <dgm:t>
        <a:bodyPr/>
        <a:lstStyle/>
        <a:p>
          <a:endParaRPr lang="en-US"/>
        </a:p>
      </dgm:t>
    </dgm:pt>
    <dgm:pt modelId="{0D7F044C-970E-40B7-80C2-4E6D20B37E88}" type="sibTrans" cxnId="{9602EC4B-0CAC-4E64-9DBE-FA6F35ECF280}">
      <dgm:prSet/>
      <dgm:spPr/>
      <dgm:t>
        <a:bodyPr/>
        <a:lstStyle/>
        <a:p>
          <a:endParaRPr lang="en-US"/>
        </a:p>
      </dgm:t>
    </dgm:pt>
    <dgm:pt modelId="{031F53ED-ACBC-42DC-BE73-C85C43BFF8A1}">
      <dgm:prSet/>
      <dgm:spPr/>
      <dgm:t>
        <a:bodyPr/>
        <a:lstStyle/>
        <a:p>
          <a:r>
            <a:rPr lang="en-US" dirty="0"/>
            <a:t>“You have been a wonderful advocate for your child.”</a:t>
          </a:r>
        </a:p>
      </dgm:t>
    </dgm:pt>
    <dgm:pt modelId="{5E005809-132A-4246-B5BA-FEBC2E107D64}" type="parTrans" cxnId="{5728D5D9-76D1-4054-9862-B1696FD7867B}">
      <dgm:prSet/>
      <dgm:spPr/>
      <dgm:t>
        <a:bodyPr/>
        <a:lstStyle/>
        <a:p>
          <a:endParaRPr lang="en-US"/>
        </a:p>
      </dgm:t>
    </dgm:pt>
    <dgm:pt modelId="{0076206A-4E0F-4F5F-B2EF-6FFEF2C75D42}" type="sibTrans" cxnId="{5728D5D9-76D1-4054-9862-B1696FD7867B}">
      <dgm:prSet/>
      <dgm:spPr/>
      <dgm:t>
        <a:bodyPr/>
        <a:lstStyle/>
        <a:p>
          <a:endParaRPr lang="en-US"/>
        </a:p>
      </dgm:t>
    </dgm:pt>
    <dgm:pt modelId="{5C5349E0-FBE9-3B4A-8F9C-BB38DFB4EB28}" type="pres">
      <dgm:prSet presAssocID="{CFF302E5-5B06-43A4-8D4E-73E70BB919F9}" presName="diagram" presStyleCnt="0">
        <dgm:presLayoutVars>
          <dgm:chPref val="1"/>
          <dgm:dir/>
          <dgm:animOne val="branch"/>
          <dgm:animLvl val="lvl"/>
          <dgm:resizeHandles/>
        </dgm:presLayoutVars>
      </dgm:prSet>
      <dgm:spPr/>
    </dgm:pt>
    <dgm:pt modelId="{1A881C29-72F7-DB40-AF20-737BAD79ECFE}" type="pres">
      <dgm:prSet presAssocID="{C977B2DC-3E31-4025-96D9-166524F419DC}" presName="root" presStyleCnt="0"/>
      <dgm:spPr/>
    </dgm:pt>
    <dgm:pt modelId="{F5ECD4FC-A42E-374E-9DBD-05661052B2DD}" type="pres">
      <dgm:prSet presAssocID="{C977B2DC-3E31-4025-96D9-166524F419DC}" presName="rootComposite" presStyleCnt="0"/>
      <dgm:spPr/>
    </dgm:pt>
    <dgm:pt modelId="{431FEF4C-3F39-C042-A2FD-C12082B49248}" type="pres">
      <dgm:prSet presAssocID="{C977B2DC-3E31-4025-96D9-166524F419DC}" presName="rootText" presStyleLbl="node1" presStyleIdx="0" presStyleCnt="2"/>
      <dgm:spPr/>
    </dgm:pt>
    <dgm:pt modelId="{BA36CC06-B108-0E4B-B3BD-FAA7823303FD}" type="pres">
      <dgm:prSet presAssocID="{C977B2DC-3E31-4025-96D9-166524F419DC}" presName="rootConnector" presStyleLbl="node1" presStyleIdx="0" presStyleCnt="2"/>
      <dgm:spPr/>
    </dgm:pt>
    <dgm:pt modelId="{545EC1B7-BDB1-A546-AA0B-C6AEC4EA4E8B}" type="pres">
      <dgm:prSet presAssocID="{C977B2DC-3E31-4025-96D9-166524F419DC}" presName="childShape" presStyleCnt="0"/>
      <dgm:spPr/>
    </dgm:pt>
    <dgm:pt modelId="{B5C1F2B4-4FA6-094C-9BEE-375B36F78463}" type="pres">
      <dgm:prSet presAssocID="{031F53ED-ACBC-42DC-BE73-C85C43BFF8A1}" presName="root" presStyleCnt="0"/>
      <dgm:spPr/>
    </dgm:pt>
    <dgm:pt modelId="{26508C5A-6549-0440-B4F4-6162F8492093}" type="pres">
      <dgm:prSet presAssocID="{031F53ED-ACBC-42DC-BE73-C85C43BFF8A1}" presName="rootComposite" presStyleCnt="0"/>
      <dgm:spPr/>
    </dgm:pt>
    <dgm:pt modelId="{92DEBA59-138E-A841-9ADE-32F72C783EF0}" type="pres">
      <dgm:prSet presAssocID="{031F53ED-ACBC-42DC-BE73-C85C43BFF8A1}" presName="rootText" presStyleLbl="node1" presStyleIdx="1" presStyleCnt="2"/>
      <dgm:spPr/>
    </dgm:pt>
    <dgm:pt modelId="{D094E8CB-F106-6643-BBB1-B12D7E1B9795}" type="pres">
      <dgm:prSet presAssocID="{031F53ED-ACBC-42DC-BE73-C85C43BFF8A1}" presName="rootConnector" presStyleLbl="node1" presStyleIdx="1" presStyleCnt="2"/>
      <dgm:spPr/>
    </dgm:pt>
    <dgm:pt modelId="{4FEEFEE6-876C-8545-ACDE-4194B2731D62}" type="pres">
      <dgm:prSet presAssocID="{031F53ED-ACBC-42DC-BE73-C85C43BFF8A1}" presName="childShape" presStyleCnt="0"/>
      <dgm:spPr/>
    </dgm:pt>
  </dgm:ptLst>
  <dgm:cxnLst>
    <dgm:cxn modelId="{DC8CCA1E-FC84-9D4E-9131-D71104FCA72B}" type="presOf" srcId="{031F53ED-ACBC-42DC-BE73-C85C43BFF8A1}" destId="{D094E8CB-F106-6643-BBB1-B12D7E1B9795}" srcOrd="1" destOrd="0" presId="urn:microsoft.com/office/officeart/2005/8/layout/hierarchy3"/>
    <dgm:cxn modelId="{E0373320-23B2-D74A-A15B-097F5FE72CC7}" type="presOf" srcId="{CFF302E5-5B06-43A4-8D4E-73E70BB919F9}" destId="{5C5349E0-FBE9-3B4A-8F9C-BB38DFB4EB28}" srcOrd="0" destOrd="0" presId="urn:microsoft.com/office/officeart/2005/8/layout/hierarchy3"/>
    <dgm:cxn modelId="{A708B633-E8A9-F44A-ACBA-AE3078846647}" type="presOf" srcId="{C977B2DC-3E31-4025-96D9-166524F419DC}" destId="{431FEF4C-3F39-C042-A2FD-C12082B49248}" srcOrd="0" destOrd="0" presId="urn:microsoft.com/office/officeart/2005/8/layout/hierarchy3"/>
    <dgm:cxn modelId="{9602EC4B-0CAC-4E64-9DBE-FA6F35ECF280}" srcId="{CFF302E5-5B06-43A4-8D4E-73E70BB919F9}" destId="{C977B2DC-3E31-4025-96D9-166524F419DC}" srcOrd="0" destOrd="0" parTransId="{16BA2C89-4779-40BB-B56E-A50FB817667D}" sibTransId="{0D7F044C-970E-40B7-80C2-4E6D20B37E88}"/>
    <dgm:cxn modelId="{AA325558-1979-194C-A737-41F94D19136A}" type="presOf" srcId="{031F53ED-ACBC-42DC-BE73-C85C43BFF8A1}" destId="{92DEBA59-138E-A841-9ADE-32F72C783EF0}" srcOrd="0" destOrd="0" presId="urn:microsoft.com/office/officeart/2005/8/layout/hierarchy3"/>
    <dgm:cxn modelId="{CB73BA5F-5707-244C-80A9-4D8E4B504F82}" type="presOf" srcId="{C977B2DC-3E31-4025-96D9-166524F419DC}" destId="{BA36CC06-B108-0E4B-B3BD-FAA7823303FD}" srcOrd="1" destOrd="0" presId="urn:microsoft.com/office/officeart/2005/8/layout/hierarchy3"/>
    <dgm:cxn modelId="{5728D5D9-76D1-4054-9862-B1696FD7867B}" srcId="{CFF302E5-5B06-43A4-8D4E-73E70BB919F9}" destId="{031F53ED-ACBC-42DC-BE73-C85C43BFF8A1}" srcOrd="1" destOrd="0" parTransId="{5E005809-132A-4246-B5BA-FEBC2E107D64}" sibTransId="{0076206A-4E0F-4F5F-B2EF-6FFEF2C75D42}"/>
    <dgm:cxn modelId="{13D85340-72B9-3E40-B6BE-94941BBAD4F4}" type="presParOf" srcId="{5C5349E0-FBE9-3B4A-8F9C-BB38DFB4EB28}" destId="{1A881C29-72F7-DB40-AF20-737BAD79ECFE}" srcOrd="0" destOrd="0" presId="urn:microsoft.com/office/officeart/2005/8/layout/hierarchy3"/>
    <dgm:cxn modelId="{503E3556-24EA-9C4B-BB0D-1D9809F177AD}" type="presParOf" srcId="{1A881C29-72F7-DB40-AF20-737BAD79ECFE}" destId="{F5ECD4FC-A42E-374E-9DBD-05661052B2DD}" srcOrd="0" destOrd="0" presId="urn:microsoft.com/office/officeart/2005/8/layout/hierarchy3"/>
    <dgm:cxn modelId="{DA2FC64B-3B99-FF47-9084-31B46FB89E39}" type="presParOf" srcId="{F5ECD4FC-A42E-374E-9DBD-05661052B2DD}" destId="{431FEF4C-3F39-C042-A2FD-C12082B49248}" srcOrd="0" destOrd="0" presId="urn:microsoft.com/office/officeart/2005/8/layout/hierarchy3"/>
    <dgm:cxn modelId="{02CA21F8-3F19-9740-8BD3-386B67982139}" type="presParOf" srcId="{F5ECD4FC-A42E-374E-9DBD-05661052B2DD}" destId="{BA36CC06-B108-0E4B-B3BD-FAA7823303FD}" srcOrd="1" destOrd="0" presId="urn:microsoft.com/office/officeart/2005/8/layout/hierarchy3"/>
    <dgm:cxn modelId="{B2A25EED-77EC-904A-A4C7-9D790664F2BA}" type="presParOf" srcId="{1A881C29-72F7-DB40-AF20-737BAD79ECFE}" destId="{545EC1B7-BDB1-A546-AA0B-C6AEC4EA4E8B}" srcOrd="1" destOrd="0" presId="urn:microsoft.com/office/officeart/2005/8/layout/hierarchy3"/>
    <dgm:cxn modelId="{5D32854C-A92B-A04C-85F2-60459A3A873B}" type="presParOf" srcId="{5C5349E0-FBE9-3B4A-8F9C-BB38DFB4EB28}" destId="{B5C1F2B4-4FA6-094C-9BEE-375B36F78463}" srcOrd="1" destOrd="0" presId="urn:microsoft.com/office/officeart/2005/8/layout/hierarchy3"/>
    <dgm:cxn modelId="{84B470AF-52FC-3045-B161-A6ACBD3DFDC1}" type="presParOf" srcId="{B5C1F2B4-4FA6-094C-9BEE-375B36F78463}" destId="{26508C5A-6549-0440-B4F4-6162F8492093}" srcOrd="0" destOrd="0" presId="urn:microsoft.com/office/officeart/2005/8/layout/hierarchy3"/>
    <dgm:cxn modelId="{F43C74C0-B558-C146-8E3B-E671C0666D22}" type="presParOf" srcId="{26508C5A-6549-0440-B4F4-6162F8492093}" destId="{92DEBA59-138E-A841-9ADE-32F72C783EF0}" srcOrd="0" destOrd="0" presId="urn:microsoft.com/office/officeart/2005/8/layout/hierarchy3"/>
    <dgm:cxn modelId="{E771648F-FCE1-4E4D-84CE-1FFB788AE712}" type="presParOf" srcId="{26508C5A-6549-0440-B4F4-6162F8492093}" destId="{D094E8CB-F106-6643-BBB1-B12D7E1B9795}" srcOrd="1" destOrd="0" presId="urn:microsoft.com/office/officeart/2005/8/layout/hierarchy3"/>
    <dgm:cxn modelId="{7F0C5990-C95A-CC48-A910-0AB837D2F064}" type="presParOf" srcId="{B5C1F2B4-4FA6-094C-9BEE-375B36F78463}" destId="{4FEEFEE6-876C-8545-ACDE-4194B2731D62}" srcOrd="1" destOrd="0" presId="urn:microsoft.com/office/officeart/2005/8/layout/hierarchy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6D19855-592E-49BE-ACDC-44D931B835E8}">
      <dsp:nvSpPr>
        <dsp:cNvPr id="0" name=""/>
        <dsp:cNvSpPr/>
      </dsp:nvSpPr>
      <dsp:spPr>
        <a:xfrm>
          <a:off x="421398" y="1305642"/>
          <a:ext cx="688183" cy="688183"/>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14BA6554-D0A5-4C55-8DB1-F1C8225D25D5}">
      <dsp:nvSpPr>
        <dsp:cNvPr id="0" name=""/>
        <dsp:cNvSpPr/>
      </dsp:nvSpPr>
      <dsp:spPr>
        <a:xfrm>
          <a:off x="841" y="2243476"/>
          <a:ext cx="1529296" cy="6117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711200">
            <a:lnSpc>
              <a:spcPct val="90000"/>
            </a:lnSpc>
            <a:spcBef>
              <a:spcPct val="0"/>
            </a:spcBef>
            <a:spcAft>
              <a:spcPct val="35000"/>
            </a:spcAft>
            <a:buNone/>
          </a:pPr>
          <a:r>
            <a:rPr lang="en-US" sz="1600" kern="1200" dirty="0"/>
            <a:t>S – Setting</a:t>
          </a:r>
        </a:p>
      </dsp:txBody>
      <dsp:txXfrm>
        <a:off x="841" y="2243476"/>
        <a:ext cx="1529296" cy="611718"/>
      </dsp:txXfrm>
    </dsp:sp>
    <dsp:sp modelId="{F883629F-64FC-42F5-AEEA-3EAC19D2DA7E}">
      <dsp:nvSpPr>
        <dsp:cNvPr id="0" name=""/>
        <dsp:cNvSpPr/>
      </dsp:nvSpPr>
      <dsp:spPr>
        <a:xfrm>
          <a:off x="2218322" y="1305642"/>
          <a:ext cx="688183" cy="688183"/>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08DC2658-CB03-4EC2-804C-AB24FBC7CA94}">
      <dsp:nvSpPr>
        <dsp:cNvPr id="0" name=""/>
        <dsp:cNvSpPr/>
      </dsp:nvSpPr>
      <dsp:spPr>
        <a:xfrm>
          <a:off x="1797765" y="2243476"/>
          <a:ext cx="1529296" cy="6117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711200">
            <a:lnSpc>
              <a:spcPct val="90000"/>
            </a:lnSpc>
            <a:spcBef>
              <a:spcPct val="0"/>
            </a:spcBef>
            <a:spcAft>
              <a:spcPct val="35000"/>
            </a:spcAft>
            <a:buNone/>
          </a:pPr>
          <a:r>
            <a:rPr lang="en-US" sz="1600" kern="1200" dirty="0"/>
            <a:t>P – Perception</a:t>
          </a:r>
        </a:p>
      </dsp:txBody>
      <dsp:txXfrm>
        <a:off x="1797765" y="2243476"/>
        <a:ext cx="1529296" cy="611718"/>
      </dsp:txXfrm>
    </dsp:sp>
    <dsp:sp modelId="{F7CA468D-2232-4916-890C-8A12BD74E5FF}">
      <dsp:nvSpPr>
        <dsp:cNvPr id="0" name=""/>
        <dsp:cNvSpPr/>
      </dsp:nvSpPr>
      <dsp:spPr>
        <a:xfrm>
          <a:off x="4015246" y="1305642"/>
          <a:ext cx="688183" cy="688183"/>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BD812F4E-96E4-4679-AA94-88BA51F561D3}">
      <dsp:nvSpPr>
        <dsp:cNvPr id="0" name=""/>
        <dsp:cNvSpPr/>
      </dsp:nvSpPr>
      <dsp:spPr>
        <a:xfrm>
          <a:off x="3594689" y="2243476"/>
          <a:ext cx="1529296" cy="6117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711200">
            <a:lnSpc>
              <a:spcPct val="90000"/>
            </a:lnSpc>
            <a:spcBef>
              <a:spcPct val="0"/>
            </a:spcBef>
            <a:spcAft>
              <a:spcPct val="35000"/>
            </a:spcAft>
            <a:buNone/>
          </a:pPr>
          <a:r>
            <a:rPr lang="en-US" sz="1600" kern="1200" dirty="0"/>
            <a:t>I – Invitation</a:t>
          </a:r>
        </a:p>
      </dsp:txBody>
      <dsp:txXfrm>
        <a:off x="3594689" y="2243476"/>
        <a:ext cx="1529296" cy="611718"/>
      </dsp:txXfrm>
    </dsp:sp>
    <dsp:sp modelId="{355DE8C0-67B6-4FB4-B82C-7131E5375BE0}">
      <dsp:nvSpPr>
        <dsp:cNvPr id="0" name=""/>
        <dsp:cNvSpPr/>
      </dsp:nvSpPr>
      <dsp:spPr>
        <a:xfrm>
          <a:off x="5812170" y="1305642"/>
          <a:ext cx="688183" cy="688183"/>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5A5A7675-F1A8-4514-9DF1-8C7B6327C061}">
      <dsp:nvSpPr>
        <dsp:cNvPr id="0" name=""/>
        <dsp:cNvSpPr/>
      </dsp:nvSpPr>
      <dsp:spPr>
        <a:xfrm>
          <a:off x="5391613" y="2243476"/>
          <a:ext cx="1529296" cy="6117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711200">
            <a:lnSpc>
              <a:spcPct val="90000"/>
            </a:lnSpc>
            <a:spcBef>
              <a:spcPct val="0"/>
            </a:spcBef>
            <a:spcAft>
              <a:spcPct val="35000"/>
            </a:spcAft>
            <a:buNone/>
          </a:pPr>
          <a:r>
            <a:rPr lang="en-US" sz="1600" kern="1200" dirty="0"/>
            <a:t>K – Knowledge</a:t>
          </a:r>
        </a:p>
      </dsp:txBody>
      <dsp:txXfrm>
        <a:off x="5391613" y="2243476"/>
        <a:ext cx="1529296" cy="611718"/>
      </dsp:txXfrm>
    </dsp:sp>
    <dsp:sp modelId="{FB37D14F-B45A-4EFD-B226-443E29423E60}">
      <dsp:nvSpPr>
        <dsp:cNvPr id="0" name=""/>
        <dsp:cNvSpPr/>
      </dsp:nvSpPr>
      <dsp:spPr>
        <a:xfrm>
          <a:off x="7609093" y="1305642"/>
          <a:ext cx="688183" cy="688183"/>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F562D7C8-010B-4127-9253-07104E1077CA}">
      <dsp:nvSpPr>
        <dsp:cNvPr id="0" name=""/>
        <dsp:cNvSpPr/>
      </dsp:nvSpPr>
      <dsp:spPr>
        <a:xfrm>
          <a:off x="7188537" y="2243476"/>
          <a:ext cx="1529296" cy="6117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711200">
            <a:lnSpc>
              <a:spcPct val="90000"/>
            </a:lnSpc>
            <a:spcBef>
              <a:spcPct val="0"/>
            </a:spcBef>
            <a:spcAft>
              <a:spcPct val="35000"/>
            </a:spcAft>
            <a:buNone/>
          </a:pPr>
          <a:r>
            <a:rPr lang="en-US" sz="1600" kern="1200" dirty="0"/>
            <a:t>E – Emotions</a:t>
          </a:r>
        </a:p>
      </dsp:txBody>
      <dsp:txXfrm>
        <a:off x="7188537" y="2243476"/>
        <a:ext cx="1529296" cy="611718"/>
      </dsp:txXfrm>
    </dsp:sp>
    <dsp:sp modelId="{7931FCC8-D17E-4DBA-A279-2E21E39ABA0F}">
      <dsp:nvSpPr>
        <dsp:cNvPr id="0" name=""/>
        <dsp:cNvSpPr/>
      </dsp:nvSpPr>
      <dsp:spPr>
        <a:xfrm>
          <a:off x="9406017" y="1305642"/>
          <a:ext cx="688183" cy="688183"/>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4E7362DB-6BAA-496B-B512-0740E4ACE467}">
      <dsp:nvSpPr>
        <dsp:cNvPr id="0" name=""/>
        <dsp:cNvSpPr/>
      </dsp:nvSpPr>
      <dsp:spPr>
        <a:xfrm>
          <a:off x="8985461" y="2243476"/>
          <a:ext cx="1529296" cy="6117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711200">
            <a:lnSpc>
              <a:spcPct val="90000"/>
            </a:lnSpc>
            <a:spcBef>
              <a:spcPct val="0"/>
            </a:spcBef>
            <a:spcAft>
              <a:spcPct val="35000"/>
            </a:spcAft>
            <a:buNone/>
          </a:pPr>
          <a:r>
            <a:rPr lang="en-US" sz="1600" kern="1200" dirty="0"/>
            <a:t>S – Summarize/ Strategize</a:t>
          </a:r>
        </a:p>
      </dsp:txBody>
      <dsp:txXfrm>
        <a:off x="8985461" y="2243476"/>
        <a:ext cx="1529296" cy="611718"/>
      </dsp:txXfrm>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C2B97B4-7FA6-E64B-B9D2-BBB2179E1CD7}">
      <dsp:nvSpPr>
        <dsp:cNvPr id="0" name=""/>
        <dsp:cNvSpPr/>
      </dsp:nvSpPr>
      <dsp:spPr>
        <a:xfrm>
          <a:off x="0" y="985317"/>
          <a:ext cx="2957512" cy="1878020"/>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3A54DD0-E610-8E45-AF70-B71C45A05C4E}">
      <dsp:nvSpPr>
        <dsp:cNvPr id="0" name=""/>
        <dsp:cNvSpPr/>
      </dsp:nvSpPr>
      <dsp:spPr>
        <a:xfrm>
          <a:off x="328612" y="1297499"/>
          <a:ext cx="2957512" cy="1878020"/>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We will be there to help you through this.”</a:t>
          </a:r>
        </a:p>
      </dsp:txBody>
      <dsp:txXfrm>
        <a:off x="383617" y="1352504"/>
        <a:ext cx="2847502" cy="1768010"/>
      </dsp:txXfrm>
    </dsp:sp>
    <dsp:sp modelId="{3475F31D-765C-C24F-9DBE-059E75B00609}">
      <dsp:nvSpPr>
        <dsp:cNvPr id="0" name=""/>
        <dsp:cNvSpPr/>
      </dsp:nvSpPr>
      <dsp:spPr>
        <a:xfrm>
          <a:off x="3614737" y="985317"/>
          <a:ext cx="2957512" cy="1878020"/>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3202695E-C2FC-FF42-BCBD-DF44ADA5A488}">
      <dsp:nvSpPr>
        <dsp:cNvPr id="0" name=""/>
        <dsp:cNvSpPr/>
      </dsp:nvSpPr>
      <dsp:spPr>
        <a:xfrm>
          <a:off x="3943350" y="1297499"/>
          <a:ext cx="2957512" cy="1878020"/>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We will work to make sure this doesn’t happen again.”</a:t>
          </a:r>
        </a:p>
      </dsp:txBody>
      <dsp:txXfrm>
        <a:off x="3998355" y="1352504"/>
        <a:ext cx="2847502" cy="1768010"/>
      </dsp:txXfrm>
    </dsp:sp>
    <dsp:sp modelId="{A2D41A18-2C5E-E749-9BD2-8DA423A2AC81}">
      <dsp:nvSpPr>
        <dsp:cNvPr id="0" name=""/>
        <dsp:cNvSpPr/>
      </dsp:nvSpPr>
      <dsp:spPr>
        <a:xfrm>
          <a:off x="7229475" y="985317"/>
          <a:ext cx="2957512" cy="1878020"/>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A925EC7-AFBF-894E-8C81-850641F70039}">
      <dsp:nvSpPr>
        <dsp:cNvPr id="0" name=""/>
        <dsp:cNvSpPr/>
      </dsp:nvSpPr>
      <dsp:spPr>
        <a:xfrm>
          <a:off x="7558087" y="1297499"/>
          <a:ext cx="2957512" cy="1878020"/>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I will be here to answer your questions and provide support.”</a:t>
          </a:r>
        </a:p>
      </dsp:txBody>
      <dsp:txXfrm>
        <a:off x="7613092" y="1352504"/>
        <a:ext cx="2847502" cy="1768010"/>
      </dsp:txXfrm>
    </dsp:sp>
  </dsp:spTree>
</dsp:drawing>
</file>

<file path=ppt/diagrams/drawing1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541918E-B5C4-4197-8C5F-91FBB402226D}">
      <dsp:nvSpPr>
        <dsp:cNvPr id="0" name=""/>
        <dsp:cNvSpPr/>
      </dsp:nvSpPr>
      <dsp:spPr>
        <a:xfrm>
          <a:off x="1747800" y="513274"/>
          <a:ext cx="1944000" cy="1944000"/>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DB5EB062-173F-4595-95B1-40B21279C8B2}">
      <dsp:nvSpPr>
        <dsp:cNvPr id="0" name=""/>
        <dsp:cNvSpPr/>
      </dsp:nvSpPr>
      <dsp:spPr>
        <a:xfrm>
          <a:off x="559800" y="2927562"/>
          <a:ext cx="432000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111250">
            <a:lnSpc>
              <a:spcPct val="90000"/>
            </a:lnSpc>
            <a:spcBef>
              <a:spcPct val="0"/>
            </a:spcBef>
            <a:spcAft>
              <a:spcPct val="35000"/>
            </a:spcAft>
            <a:buNone/>
          </a:pPr>
          <a:r>
            <a:rPr lang="en-US" sz="2500" kern="1200" dirty="0"/>
            <a:t>“Tell me more.”</a:t>
          </a:r>
        </a:p>
      </dsp:txBody>
      <dsp:txXfrm>
        <a:off x="559800" y="2927562"/>
        <a:ext cx="4320000" cy="720000"/>
      </dsp:txXfrm>
    </dsp:sp>
    <dsp:sp modelId="{AC586C56-2D70-4C1E-A881-B99D4B68953E}">
      <dsp:nvSpPr>
        <dsp:cNvPr id="0" name=""/>
        <dsp:cNvSpPr/>
      </dsp:nvSpPr>
      <dsp:spPr>
        <a:xfrm>
          <a:off x="6823800" y="513274"/>
          <a:ext cx="1944000" cy="1944000"/>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157BF8BB-7C62-4D0E-A56F-BD7A5E815660}">
      <dsp:nvSpPr>
        <dsp:cNvPr id="0" name=""/>
        <dsp:cNvSpPr/>
      </dsp:nvSpPr>
      <dsp:spPr>
        <a:xfrm>
          <a:off x="5635800" y="2927562"/>
          <a:ext cx="432000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111250">
            <a:lnSpc>
              <a:spcPct val="90000"/>
            </a:lnSpc>
            <a:spcBef>
              <a:spcPct val="0"/>
            </a:spcBef>
            <a:spcAft>
              <a:spcPct val="35000"/>
            </a:spcAft>
            <a:buNone/>
          </a:pPr>
          <a:r>
            <a:rPr lang="en-US" sz="2500" kern="1200" dirty="0"/>
            <a:t>“What’s going through your head right now?”</a:t>
          </a:r>
        </a:p>
      </dsp:txBody>
      <dsp:txXfrm>
        <a:off x="5635800" y="2927562"/>
        <a:ext cx="4320000" cy="720000"/>
      </dsp:txXfrm>
    </dsp:sp>
  </dsp:spTree>
</dsp:drawing>
</file>

<file path=ppt/diagrams/drawing1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648FA9C-5791-4E38-910F-351A9FD03B4F}">
      <dsp:nvSpPr>
        <dsp:cNvPr id="0" name=""/>
        <dsp:cNvSpPr/>
      </dsp:nvSpPr>
      <dsp:spPr>
        <a:xfrm>
          <a:off x="0" y="1024"/>
          <a:ext cx="5987036" cy="436391"/>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3AE8AD64-0148-4DC1-B61E-43529B631A55}">
      <dsp:nvSpPr>
        <dsp:cNvPr id="0" name=""/>
        <dsp:cNvSpPr/>
      </dsp:nvSpPr>
      <dsp:spPr>
        <a:xfrm>
          <a:off x="132008" y="99212"/>
          <a:ext cx="240015" cy="240015"/>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34BE3C3-52D9-455D-947B-6617B09E920F}">
      <dsp:nvSpPr>
        <dsp:cNvPr id="0" name=""/>
        <dsp:cNvSpPr/>
      </dsp:nvSpPr>
      <dsp:spPr>
        <a:xfrm>
          <a:off x="504032" y="1024"/>
          <a:ext cx="5483004" cy="43639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6185" tIns="46185" rIns="46185" bIns="46185" numCol="1" spcCol="1270" anchor="ctr" anchorCtr="0">
          <a:noAutofit/>
        </a:bodyPr>
        <a:lstStyle/>
        <a:p>
          <a:pPr marL="0" lvl="0" indent="0" algn="l" defTabSz="844550">
            <a:lnSpc>
              <a:spcPct val="100000"/>
            </a:lnSpc>
            <a:spcBef>
              <a:spcPct val="0"/>
            </a:spcBef>
            <a:spcAft>
              <a:spcPct val="35000"/>
            </a:spcAft>
            <a:buNone/>
          </a:pPr>
          <a:r>
            <a:rPr lang="en-US" sz="1900" kern="1200" dirty="0"/>
            <a:t>S – Setting</a:t>
          </a:r>
        </a:p>
      </dsp:txBody>
      <dsp:txXfrm>
        <a:off x="504032" y="1024"/>
        <a:ext cx="5483004" cy="436391"/>
      </dsp:txXfrm>
    </dsp:sp>
    <dsp:sp modelId="{F85F4DB7-0CEA-42D7-9176-BD08B18B0CBC}">
      <dsp:nvSpPr>
        <dsp:cNvPr id="0" name=""/>
        <dsp:cNvSpPr/>
      </dsp:nvSpPr>
      <dsp:spPr>
        <a:xfrm>
          <a:off x="0" y="546513"/>
          <a:ext cx="5987036" cy="436391"/>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685F2A81-DDF9-460F-9851-C1140F3A46C2}">
      <dsp:nvSpPr>
        <dsp:cNvPr id="0" name=""/>
        <dsp:cNvSpPr/>
      </dsp:nvSpPr>
      <dsp:spPr>
        <a:xfrm>
          <a:off x="132008" y="644701"/>
          <a:ext cx="240015" cy="240015"/>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EBEF747F-BEA2-4FC5-B8BA-03047BC59F08}">
      <dsp:nvSpPr>
        <dsp:cNvPr id="0" name=""/>
        <dsp:cNvSpPr/>
      </dsp:nvSpPr>
      <dsp:spPr>
        <a:xfrm>
          <a:off x="504032" y="546513"/>
          <a:ext cx="5483004" cy="43639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6185" tIns="46185" rIns="46185" bIns="46185" numCol="1" spcCol="1270" anchor="ctr" anchorCtr="0">
          <a:noAutofit/>
        </a:bodyPr>
        <a:lstStyle/>
        <a:p>
          <a:pPr marL="0" lvl="0" indent="0" algn="l" defTabSz="844550">
            <a:lnSpc>
              <a:spcPct val="100000"/>
            </a:lnSpc>
            <a:spcBef>
              <a:spcPct val="0"/>
            </a:spcBef>
            <a:spcAft>
              <a:spcPct val="35000"/>
            </a:spcAft>
            <a:buNone/>
          </a:pPr>
          <a:r>
            <a:rPr lang="en-US" sz="1900" kern="1200" dirty="0"/>
            <a:t>P – Perception</a:t>
          </a:r>
        </a:p>
      </dsp:txBody>
      <dsp:txXfrm>
        <a:off x="504032" y="546513"/>
        <a:ext cx="5483004" cy="436391"/>
      </dsp:txXfrm>
    </dsp:sp>
    <dsp:sp modelId="{FE3A851F-EE22-48EC-8705-D984968B9D73}">
      <dsp:nvSpPr>
        <dsp:cNvPr id="0" name=""/>
        <dsp:cNvSpPr/>
      </dsp:nvSpPr>
      <dsp:spPr>
        <a:xfrm>
          <a:off x="0" y="1092003"/>
          <a:ext cx="5987036" cy="436391"/>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478C50E0-5A50-4C33-B006-7E43966869E6}">
      <dsp:nvSpPr>
        <dsp:cNvPr id="0" name=""/>
        <dsp:cNvSpPr/>
      </dsp:nvSpPr>
      <dsp:spPr>
        <a:xfrm>
          <a:off x="132008" y="1190191"/>
          <a:ext cx="240015" cy="240015"/>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12255B16-37FA-4748-B5AF-C50CF28DA9B8}">
      <dsp:nvSpPr>
        <dsp:cNvPr id="0" name=""/>
        <dsp:cNvSpPr/>
      </dsp:nvSpPr>
      <dsp:spPr>
        <a:xfrm>
          <a:off x="504032" y="1092003"/>
          <a:ext cx="5483004" cy="43639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6185" tIns="46185" rIns="46185" bIns="46185" numCol="1" spcCol="1270" anchor="ctr" anchorCtr="0">
          <a:noAutofit/>
        </a:bodyPr>
        <a:lstStyle/>
        <a:p>
          <a:pPr marL="0" lvl="0" indent="0" algn="l" defTabSz="844550">
            <a:lnSpc>
              <a:spcPct val="100000"/>
            </a:lnSpc>
            <a:spcBef>
              <a:spcPct val="0"/>
            </a:spcBef>
            <a:spcAft>
              <a:spcPct val="35000"/>
            </a:spcAft>
            <a:buNone/>
          </a:pPr>
          <a:r>
            <a:rPr lang="en-US" sz="1900" kern="1200" dirty="0"/>
            <a:t>I – Invitation</a:t>
          </a:r>
        </a:p>
      </dsp:txBody>
      <dsp:txXfrm>
        <a:off x="504032" y="1092003"/>
        <a:ext cx="5483004" cy="436391"/>
      </dsp:txXfrm>
    </dsp:sp>
    <dsp:sp modelId="{39B310CD-1752-4310-9109-F2575D303ADC}">
      <dsp:nvSpPr>
        <dsp:cNvPr id="0" name=""/>
        <dsp:cNvSpPr/>
      </dsp:nvSpPr>
      <dsp:spPr>
        <a:xfrm>
          <a:off x="0" y="1637492"/>
          <a:ext cx="5987036" cy="436391"/>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50A1C648-7A8C-4251-9B6A-DDA960D918B8}">
      <dsp:nvSpPr>
        <dsp:cNvPr id="0" name=""/>
        <dsp:cNvSpPr/>
      </dsp:nvSpPr>
      <dsp:spPr>
        <a:xfrm>
          <a:off x="132008" y="1735681"/>
          <a:ext cx="240015" cy="240015"/>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0D1BEBD-524B-4E87-BE0C-CA8641868EBF}">
      <dsp:nvSpPr>
        <dsp:cNvPr id="0" name=""/>
        <dsp:cNvSpPr/>
      </dsp:nvSpPr>
      <dsp:spPr>
        <a:xfrm>
          <a:off x="504032" y="1637492"/>
          <a:ext cx="5483004" cy="43639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6185" tIns="46185" rIns="46185" bIns="46185" numCol="1" spcCol="1270" anchor="ctr" anchorCtr="0">
          <a:noAutofit/>
        </a:bodyPr>
        <a:lstStyle/>
        <a:p>
          <a:pPr marL="0" lvl="0" indent="0" algn="l" defTabSz="844550">
            <a:lnSpc>
              <a:spcPct val="100000"/>
            </a:lnSpc>
            <a:spcBef>
              <a:spcPct val="0"/>
            </a:spcBef>
            <a:spcAft>
              <a:spcPct val="35000"/>
            </a:spcAft>
            <a:buNone/>
          </a:pPr>
          <a:r>
            <a:rPr lang="en-US" sz="1900" kern="1200" dirty="0"/>
            <a:t>K – Knowledge (Warning shot/ Headline)</a:t>
          </a:r>
        </a:p>
      </dsp:txBody>
      <dsp:txXfrm>
        <a:off x="504032" y="1637492"/>
        <a:ext cx="5483004" cy="436391"/>
      </dsp:txXfrm>
    </dsp:sp>
    <dsp:sp modelId="{5A76DE53-C2CE-48BE-B145-E6325D8C7206}">
      <dsp:nvSpPr>
        <dsp:cNvPr id="0" name=""/>
        <dsp:cNvSpPr/>
      </dsp:nvSpPr>
      <dsp:spPr>
        <a:xfrm>
          <a:off x="0" y="2182982"/>
          <a:ext cx="5987036" cy="436391"/>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70E7448A-56FF-43D4-8E0E-B23F8EBA08FE}">
      <dsp:nvSpPr>
        <dsp:cNvPr id="0" name=""/>
        <dsp:cNvSpPr/>
      </dsp:nvSpPr>
      <dsp:spPr>
        <a:xfrm>
          <a:off x="132008" y="2281170"/>
          <a:ext cx="240015" cy="240015"/>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1D01734-8A0F-4831-9B01-4B48F23DCBF0}">
      <dsp:nvSpPr>
        <dsp:cNvPr id="0" name=""/>
        <dsp:cNvSpPr/>
      </dsp:nvSpPr>
      <dsp:spPr>
        <a:xfrm>
          <a:off x="504032" y="2182982"/>
          <a:ext cx="5483004" cy="43639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6185" tIns="46185" rIns="46185" bIns="46185" numCol="1" spcCol="1270" anchor="ctr" anchorCtr="0">
          <a:noAutofit/>
        </a:bodyPr>
        <a:lstStyle/>
        <a:p>
          <a:pPr marL="0" lvl="0" indent="0" algn="l" defTabSz="844550">
            <a:lnSpc>
              <a:spcPct val="100000"/>
            </a:lnSpc>
            <a:spcBef>
              <a:spcPct val="0"/>
            </a:spcBef>
            <a:spcAft>
              <a:spcPct val="35000"/>
            </a:spcAft>
            <a:buNone/>
          </a:pPr>
          <a:r>
            <a:rPr lang="en-US" sz="1900" kern="1200" dirty="0"/>
            <a:t>E – Emotions (N-U-R-S-E)</a:t>
          </a:r>
        </a:p>
      </dsp:txBody>
      <dsp:txXfrm>
        <a:off x="504032" y="2182982"/>
        <a:ext cx="5483004" cy="436391"/>
      </dsp:txXfrm>
    </dsp:sp>
    <dsp:sp modelId="{EC11F550-4088-4D45-8ACB-AF248C43A109}">
      <dsp:nvSpPr>
        <dsp:cNvPr id="0" name=""/>
        <dsp:cNvSpPr/>
      </dsp:nvSpPr>
      <dsp:spPr>
        <a:xfrm>
          <a:off x="0" y="2728472"/>
          <a:ext cx="5987036" cy="436391"/>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8D142D19-8FFD-4A4D-8EAC-F1A9E6308D66}">
      <dsp:nvSpPr>
        <dsp:cNvPr id="0" name=""/>
        <dsp:cNvSpPr/>
      </dsp:nvSpPr>
      <dsp:spPr>
        <a:xfrm>
          <a:off x="132008" y="2826660"/>
          <a:ext cx="240015" cy="240015"/>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EA367B86-B21C-4DC4-8973-74BA3B264519}">
      <dsp:nvSpPr>
        <dsp:cNvPr id="0" name=""/>
        <dsp:cNvSpPr/>
      </dsp:nvSpPr>
      <dsp:spPr>
        <a:xfrm>
          <a:off x="504032" y="2728472"/>
          <a:ext cx="5483004" cy="43639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6185" tIns="46185" rIns="46185" bIns="46185" numCol="1" spcCol="1270" anchor="ctr" anchorCtr="0">
          <a:noAutofit/>
        </a:bodyPr>
        <a:lstStyle/>
        <a:p>
          <a:pPr marL="0" lvl="0" indent="0" algn="l" defTabSz="844550">
            <a:lnSpc>
              <a:spcPct val="100000"/>
            </a:lnSpc>
            <a:spcBef>
              <a:spcPct val="0"/>
            </a:spcBef>
            <a:spcAft>
              <a:spcPct val="35000"/>
            </a:spcAft>
            <a:buNone/>
          </a:pPr>
          <a:r>
            <a:rPr lang="en-US" sz="1900" kern="1200" dirty="0"/>
            <a:t>S – Summarize/ Strategize</a:t>
          </a:r>
        </a:p>
      </dsp:txBody>
      <dsp:txXfrm>
        <a:off x="504032" y="2728472"/>
        <a:ext cx="5483004" cy="436391"/>
      </dsp:txXfrm>
    </dsp:sp>
  </dsp:spTree>
</dsp:drawing>
</file>

<file path=ppt/diagrams/drawing1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A5F056D-40AF-4B07-B581-5960672621BE}">
      <dsp:nvSpPr>
        <dsp:cNvPr id="0" name=""/>
        <dsp:cNvSpPr/>
      </dsp:nvSpPr>
      <dsp:spPr>
        <a:xfrm>
          <a:off x="0" y="507"/>
          <a:ext cx="10515600" cy="1188429"/>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AD9F9987-C066-40FD-94DE-CC3353BE782C}">
      <dsp:nvSpPr>
        <dsp:cNvPr id="0" name=""/>
        <dsp:cNvSpPr/>
      </dsp:nvSpPr>
      <dsp:spPr>
        <a:xfrm>
          <a:off x="359500" y="267904"/>
          <a:ext cx="653636" cy="653636"/>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93B3F01-420C-4E65-BAC0-A50C36994A8D}">
      <dsp:nvSpPr>
        <dsp:cNvPr id="0" name=""/>
        <dsp:cNvSpPr/>
      </dsp:nvSpPr>
      <dsp:spPr>
        <a:xfrm>
          <a:off x="1372636" y="507"/>
          <a:ext cx="9142963" cy="118842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5775" tIns="125775" rIns="125775" bIns="125775" numCol="1" spcCol="1270" anchor="ctr" anchorCtr="0">
          <a:noAutofit/>
        </a:bodyPr>
        <a:lstStyle/>
        <a:p>
          <a:pPr marL="0" lvl="0" indent="0" algn="l" defTabSz="755650">
            <a:lnSpc>
              <a:spcPct val="100000"/>
            </a:lnSpc>
            <a:spcBef>
              <a:spcPct val="0"/>
            </a:spcBef>
            <a:spcAft>
              <a:spcPct val="35000"/>
            </a:spcAft>
            <a:buNone/>
          </a:pPr>
          <a:r>
            <a:rPr lang="en-US" sz="1700" kern="1200" dirty="0"/>
            <a:t>1. Baile WF, Buckman R, Lenzi R, Glober G, Beale EA, Kudelka AP, SPIKES-A six-step protocol for delivering bad news: application to the patient with cancer. </a:t>
          </a:r>
          <a:r>
            <a:rPr lang="en-US" sz="1700" i="1" kern="1200" dirty="0"/>
            <a:t>The Oncologist</a:t>
          </a:r>
          <a:r>
            <a:rPr lang="en-US" sz="1700" kern="1200" dirty="0"/>
            <a:t>. 2000:5(4):302-311.</a:t>
          </a:r>
        </a:p>
      </dsp:txBody>
      <dsp:txXfrm>
        <a:off x="1372636" y="507"/>
        <a:ext cx="9142963" cy="1188429"/>
      </dsp:txXfrm>
    </dsp:sp>
    <dsp:sp modelId="{96720891-DA80-445A-A89F-E55DFC95B187}">
      <dsp:nvSpPr>
        <dsp:cNvPr id="0" name=""/>
        <dsp:cNvSpPr/>
      </dsp:nvSpPr>
      <dsp:spPr>
        <a:xfrm>
          <a:off x="0" y="1486045"/>
          <a:ext cx="10515600" cy="1188429"/>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A0376A1A-C8F9-4B3C-8471-AD2974CD1905}">
      <dsp:nvSpPr>
        <dsp:cNvPr id="0" name=""/>
        <dsp:cNvSpPr/>
      </dsp:nvSpPr>
      <dsp:spPr>
        <a:xfrm>
          <a:off x="359500" y="1753441"/>
          <a:ext cx="653636" cy="653636"/>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1B95DD4F-9F3D-4A52-876A-0F717C9D4398}">
      <dsp:nvSpPr>
        <dsp:cNvPr id="0" name=""/>
        <dsp:cNvSpPr/>
      </dsp:nvSpPr>
      <dsp:spPr>
        <a:xfrm>
          <a:off x="1372636" y="1486045"/>
          <a:ext cx="9142963" cy="118842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5775" tIns="125775" rIns="125775" bIns="125775" numCol="1" spcCol="1270" anchor="ctr" anchorCtr="0">
          <a:noAutofit/>
        </a:bodyPr>
        <a:lstStyle/>
        <a:p>
          <a:pPr marL="0" lvl="0" indent="0" algn="l" defTabSz="755650">
            <a:lnSpc>
              <a:spcPct val="100000"/>
            </a:lnSpc>
            <a:spcBef>
              <a:spcPct val="0"/>
            </a:spcBef>
            <a:spcAft>
              <a:spcPct val="35000"/>
            </a:spcAft>
            <a:buNone/>
          </a:pPr>
          <a:r>
            <a:rPr lang="en-US" sz="1700" kern="1200" dirty="0"/>
            <a:t>2. McFarlin J, Tulsky JA, Back AL, Arnold RM. A Talking Map for Family Meetings in the Intensive Care Unit. </a:t>
          </a:r>
          <a:r>
            <a:rPr lang="en-US" sz="1700" i="1" kern="1200" dirty="0"/>
            <a:t>JCOM</a:t>
          </a:r>
          <a:r>
            <a:rPr lang="en-US" sz="1700" kern="1200" dirty="0"/>
            <a:t>. 2017;24(1):15-22.</a:t>
          </a:r>
        </a:p>
      </dsp:txBody>
      <dsp:txXfrm>
        <a:off x="1372636" y="1486045"/>
        <a:ext cx="9142963" cy="1188429"/>
      </dsp:txXfrm>
    </dsp:sp>
    <dsp:sp modelId="{9B51B464-9923-4148-B69F-53A083A4F03B}">
      <dsp:nvSpPr>
        <dsp:cNvPr id="0" name=""/>
        <dsp:cNvSpPr/>
      </dsp:nvSpPr>
      <dsp:spPr>
        <a:xfrm>
          <a:off x="0" y="2971582"/>
          <a:ext cx="10515600" cy="1188429"/>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C64CD0DE-F9E9-4305-B321-73D579F996ED}">
      <dsp:nvSpPr>
        <dsp:cNvPr id="0" name=""/>
        <dsp:cNvSpPr/>
      </dsp:nvSpPr>
      <dsp:spPr>
        <a:xfrm>
          <a:off x="359500" y="3238979"/>
          <a:ext cx="653636" cy="653636"/>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6FF8B16-C155-4CF6-8284-ABBE9887B286}">
      <dsp:nvSpPr>
        <dsp:cNvPr id="0" name=""/>
        <dsp:cNvSpPr/>
      </dsp:nvSpPr>
      <dsp:spPr>
        <a:xfrm>
          <a:off x="1372636" y="2971582"/>
          <a:ext cx="9142963" cy="118842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5775" tIns="125775" rIns="125775" bIns="125775" numCol="1" spcCol="1270" anchor="ctr" anchorCtr="0">
          <a:noAutofit/>
        </a:bodyPr>
        <a:lstStyle/>
        <a:p>
          <a:pPr marL="0" lvl="0" indent="0" algn="l" defTabSz="755650">
            <a:lnSpc>
              <a:spcPct val="100000"/>
            </a:lnSpc>
            <a:spcBef>
              <a:spcPct val="0"/>
            </a:spcBef>
            <a:spcAft>
              <a:spcPct val="35000"/>
            </a:spcAft>
            <a:buNone/>
          </a:pPr>
          <a:r>
            <a:rPr lang="en-US" sz="1700" kern="1200" dirty="0"/>
            <a:t>3. Back AL, Trinidad SB, Hopley RK, Arnold RM, Baile WF, Edwards KA. What patients value when oncologists give news of cancer recurrence: commentary on specific moments in audio-recorded conversations. </a:t>
          </a:r>
          <a:r>
            <a:rPr lang="en-US" sz="1700" i="1" kern="1200" dirty="0"/>
            <a:t>The Oncologist. </a:t>
          </a:r>
          <a:r>
            <a:rPr lang="en-US" sz="1700" kern="1200" dirty="0"/>
            <a:t>2011;16(3):342-350.</a:t>
          </a:r>
        </a:p>
      </dsp:txBody>
      <dsp:txXfrm>
        <a:off x="1372636" y="2971582"/>
        <a:ext cx="9142963" cy="1188429"/>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1CA65E1-2277-4D81-8996-BCD73EBB5D28}">
      <dsp:nvSpPr>
        <dsp:cNvPr id="0" name=""/>
        <dsp:cNvSpPr/>
      </dsp:nvSpPr>
      <dsp:spPr>
        <a:xfrm>
          <a:off x="559800" y="181767"/>
          <a:ext cx="1512000" cy="1512000"/>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E0D81635-0EF4-4426-A2D0-BD94E88AAE8B}">
      <dsp:nvSpPr>
        <dsp:cNvPr id="0" name=""/>
        <dsp:cNvSpPr/>
      </dsp:nvSpPr>
      <dsp:spPr>
        <a:xfrm>
          <a:off x="559800" y="1857051"/>
          <a:ext cx="4320000" cy="648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l" defTabSz="1022350">
            <a:lnSpc>
              <a:spcPct val="90000"/>
            </a:lnSpc>
            <a:spcBef>
              <a:spcPct val="0"/>
            </a:spcBef>
            <a:spcAft>
              <a:spcPct val="35000"/>
            </a:spcAft>
            <a:buNone/>
            <a:defRPr b="1"/>
          </a:pPr>
          <a:r>
            <a:rPr lang="en-US" sz="2300" kern="1200" dirty="0"/>
            <a:t>Quiet Location with seats and tissues</a:t>
          </a:r>
        </a:p>
      </dsp:txBody>
      <dsp:txXfrm>
        <a:off x="559800" y="1857051"/>
        <a:ext cx="4320000" cy="648000"/>
      </dsp:txXfrm>
    </dsp:sp>
    <dsp:sp modelId="{881C8845-0D2F-4FA0-9723-0E544CD7B8C7}">
      <dsp:nvSpPr>
        <dsp:cNvPr id="0" name=""/>
        <dsp:cNvSpPr/>
      </dsp:nvSpPr>
      <dsp:spPr>
        <a:xfrm>
          <a:off x="559800" y="2580997"/>
          <a:ext cx="4320000" cy="1398072"/>
        </a:xfrm>
        <a:prstGeom prst="rect">
          <a:avLst/>
        </a:prstGeom>
        <a:noFill/>
        <a:ln>
          <a:noFill/>
        </a:ln>
        <a:effectLst/>
      </dsp:spPr>
      <dsp:style>
        <a:lnRef idx="0">
          <a:scrgbClr r="0" g="0" b="0"/>
        </a:lnRef>
        <a:fillRef idx="0">
          <a:scrgbClr r="0" g="0" b="0"/>
        </a:fillRef>
        <a:effectRef idx="0">
          <a:scrgbClr r="0" g="0" b="0"/>
        </a:effectRef>
        <a:fontRef idx="minor"/>
      </dsp:style>
    </dsp:sp>
    <dsp:sp modelId="{56799DAD-D5C7-4273-A800-65EB21120298}">
      <dsp:nvSpPr>
        <dsp:cNvPr id="0" name=""/>
        <dsp:cNvSpPr/>
      </dsp:nvSpPr>
      <dsp:spPr>
        <a:xfrm>
          <a:off x="5635800" y="181767"/>
          <a:ext cx="1512000" cy="1512000"/>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BB308B3B-7C4A-4415-B01C-C85A40454F0C}">
      <dsp:nvSpPr>
        <dsp:cNvPr id="0" name=""/>
        <dsp:cNvSpPr/>
      </dsp:nvSpPr>
      <dsp:spPr>
        <a:xfrm>
          <a:off x="5635800" y="1857051"/>
          <a:ext cx="4320000" cy="648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l" defTabSz="1022350">
            <a:lnSpc>
              <a:spcPct val="90000"/>
            </a:lnSpc>
            <a:spcBef>
              <a:spcPct val="0"/>
            </a:spcBef>
            <a:spcAft>
              <a:spcPct val="35000"/>
            </a:spcAft>
            <a:buNone/>
            <a:defRPr b="1"/>
          </a:pPr>
          <a:r>
            <a:rPr lang="en-US" sz="2300" kern="1200" dirty="0"/>
            <a:t>Before meeting with patient</a:t>
          </a:r>
        </a:p>
      </dsp:txBody>
      <dsp:txXfrm>
        <a:off x="5635800" y="1857051"/>
        <a:ext cx="4320000" cy="648000"/>
      </dsp:txXfrm>
    </dsp:sp>
    <dsp:sp modelId="{D92C95A9-DDEB-4803-A9CA-3E499BFB9F4B}">
      <dsp:nvSpPr>
        <dsp:cNvPr id="0" name=""/>
        <dsp:cNvSpPr/>
      </dsp:nvSpPr>
      <dsp:spPr>
        <a:xfrm>
          <a:off x="5635800" y="2580997"/>
          <a:ext cx="4320000" cy="1398072"/>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l" defTabSz="755650">
            <a:lnSpc>
              <a:spcPct val="90000"/>
            </a:lnSpc>
            <a:spcBef>
              <a:spcPct val="0"/>
            </a:spcBef>
            <a:spcAft>
              <a:spcPct val="35000"/>
            </a:spcAft>
            <a:buNone/>
          </a:pPr>
          <a:r>
            <a:rPr lang="en-US" sz="1700" kern="1200" dirty="0"/>
            <a:t>Review and agree on medical facts</a:t>
          </a:r>
        </a:p>
        <a:p>
          <a:pPr marL="0" lvl="0" indent="0" algn="l" defTabSz="755650">
            <a:lnSpc>
              <a:spcPct val="90000"/>
            </a:lnSpc>
            <a:spcBef>
              <a:spcPct val="0"/>
            </a:spcBef>
            <a:spcAft>
              <a:spcPct val="35000"/>
            </a:spcAft>
            <a:buNone/>
          </a:pPr>
          <a:r>
            <a:rPr lang="en-US" sz="1700" kern="1200" dirty="0"/>
            <a:t>Determine who is going to lead the meeting</a:t>
          </a:r>
        </a:p>
        <a:p>
          <a:pPr marL="0" lvl="0" indent="0" algn="l" defTabSz="755650">
            <a:lnSpc>
              <a:spcPct val="90000"/>
            </a:lnSpc>
            <a:spcBef>
              <a:spcPct val="0"/>
            </a:spcBef>
            <a:spcAft>
              <a:spcPct val="35000"/>
            </a:spcAft>
            <a:buNone/>
          </a:pPr>
          <a:r>
            <a:rPr lang="en-US" sz="1700" kern="1200" dirty="0"/>
            <a:t>Forward pagers and turn off cell phones if possible</a:t>
          </a:r>
        </a:p>
      </dsp:txBody>
      <dsp:txXfrm>
        <a:off x="5635800" y="2580997"/>
        <a:ext cx="4320000" cy="1398072"/>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02EF1E9-6DE7-0C48-A10D-8A81CD1F452D}">
      <dsp:nvSpPr>
        <dsp:cNvPr id="0" name=""/>
        <dsp:cNvSpPr/>
      </dsp:nvSpPr>
      <dsp:spPr>
        <a:xfrm>
          <a:off x="1283" y="412100"/>
          <a:ext cx="4505585" cy="2861046"/>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5CD5662-09AC-2C48-869F-E03BFD0BC407}">
      <dsp:nvSpPr>
        <dsp:cNvPr id="0" name=""/>
        <dsp:cNvSpPr/>
      </dsp:nvSpPr>
      <dsp:spPr>
        <a:xfrm>
          <a:off x="501904" y="887689"/>
          <a:ext cx="4505585" cy="2861046"/>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29540" tIns="129540" rIns="129540" bIns="129540" numCol="1" spcCol="1270" anchor="ctr" anchorCtr="0">
          <a:noAutofit/>
        </a:bodyPr>
        <a:lstStyle/>
        <a:p>
          <a:pPr marL="0" lvl="0" indent="0" algn="ctr" defTabSz="1511300">
            <a:lnSpc>
              <a:spcPct val="90000"/>
            </a:lnSpc>
            <a:spcBef>
              <a:spcPct val="0"/>
            </a:spcBef>
            <a:spcAft>
              <a:spcPct val="35000"/>
            </a:spcAft>
            <a:buNone/>
          </a:pPr>
          <a:r>
            <a:rPr lang="en-US" sz="3400" kern="1200" dirty="0"/>
            <a:t>“I do have some new information to discuss, is it alright if we do it now?”</a:t>
          </a:r>
        </a:p>
      </dsp:txBody>
      <dsp:txXfrm>
        <a:off x="585701" y="971486"/>
        <a:ext cx="4337991" cy="2693452"/>
      </dsp:txXfrm>
    </dsp:sp>
    <dsp:sp modelId="{CF6F05BC-A4D9-6740-92D7-B3E4901EA3AB}">
      <dsp:nvSpPr>
        <dsp:cNvPr id="0" name=""/>
        <dsp:cNvSpPr/>
      </dsp:nvSpPr>
      <dsp:spPr>
        <a:xfrm>
          <a:off x="5508110" y="412100"/>
          <a:ext cx="4505585" cy="2861046"/>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ADE8567-4785-8743-AD1F-50607A4041FE}">
      <dsp:nvSpPr>
        <dsp:cNvPr id="0" name=""/>
        <dsp:cNvSpPr/>
      </dsp:nvSpPr>
      <dsp:spPr>
        <a:xfrm>
          <a:off x="6008730" y="887689"/>
          <a:ext cx="4505585" cy="2861046"/>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29540" tIns="129540" rIns="129540" bIns="129540" numCol="1" spcCol="1270" anchor="ctr" anchorCtr="0">
          <a:noAutofit/>
        </a:bodyPr>
        <a:lstStyle/>
        <a:p>
          <a:pPr marL="0" lvl="0" indent="0" algn="ctr" defTabSz="1511300">
            <a:lnSpc>
              <a:spcPct val="90000"/>
            </a:lnSpc>
            <a:spcBef>
              <a:spcPct val="0"/>
            </a:spcBef>
            <a:spcAft>
              <a:spcPct val="35000"/>
            </a:spcAft>
            <a:buNone/>
          </a:pPr>
          <a:r>
            <a:rPr lang="en-US" sz="3400" kern="1200" dirty="0"/>
            <a:t>“I have some updates about your child, is now a good time to discuss them?”</a:t>
          </a:r>
        </a:p>
      </dsp:txBody>
      <dsp:txXfrm>
        <a:off x="6092527" y="971486"/>
        <a:ext cx="4337991" cy="2693452"/>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73BE796-188F-433F-A534-1EBD2639105D}">
      <dsp:nvSpPr>
        <dsp:cNvPr id="0" name=""/>
        <dsp:cNvSpPr/>
      </dsp:nvSpPr>
      <dsp:spPr>
        <a:xfrm>
          <a:off x="1747800" y="513274"/>
          <a:ext cx="1944000" cy="1944000"/>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406F981B-0415-4F58-AC62-77F1D9670022}">
      <dsp:nvSpPr>
        <dsp:cNvPr id="0" name=""/>
        <dsp:cNvSpPr/>
      </dsp:nvSpPr>
      <dsp:spPr>
        <a:xfrm>
          <a:off x="559800" y="2927562"/>
          <a:ext cx="432000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977900">
            <a:lnSpc>
              <a:spcPct val="90000"/>
            </a:lnSpc>
            <a:spcBef>
              <a:spcPct val="0"/>
            </a:spcBef>
            <a:spcAft>
              <a:spcPct val="35000"/>
            </a:spcAft>
            <a:buNone/>
          </a:pPr>
          <a:r>
            <a:rPr lang="en-US" sz="2200" kern="1200" dirty="0"/>
            <a:t>Wait Quietly for parent/patient to process news</a:t>
          </a:r>
        </a:p>
      </dsp:txBody>
      <dsp:txXfrm>
        <a:off x="559800" y="2927562"/>
        <a:ext cx="4320000" cy="720000"/>
      </dsp:txXfrm>
    </dsp:sp>
    <dsp:sp modelId="{C195BE82-08A6-422E-A4E8-AC2CB40611EA}">
      <dsp:nvSpPr>
        <dsp:cNvPr id="0" name=""/>
        <dsp:cNvSpPr/>
      </dsp:nvSpPr>
      <dsp:spPr>
        <a:xfrm>
          <a:off x="6823800" y="513274"/>
          <a:ext cx="1944000" cy="1944000"/>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FAF0E6FF-403E-49BA-BED7-5057CE6A3328}">
      <dsp:nvSpPr>
        <dsp:cNvPr id="0" name=""/>
        <dsp:cNvSpPr/>
      </dsp:nvSpPr>
      <dsp:spPr>
        <a:xfrm>
          <a:off x="5635800" y="2927562"/>
          <a:ext cx="432000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977900">
            <a:lnSpc>
              <a:spcPct val="90000"/>
            </a:lnSpc>
            <a:spcBef>
              <a:spcPct val="0"/>
            </a:spcBef>
            <a:spcAft>
              <a:spcPct val="35000"/>
            </a:spcAft>
            <a:buNone/>
          </a:pPr>
          <a:r>
            <a:rPr lang="en-US" sz="2200" kern="1200" dirty="0"/>
            <a:t>N-U-R-S-E the emotion</a:t>
          </a:r>
        </a:p>
      </dsp:txBody>
      <dsp:txXfrm>
        <a:off x="5635800" y="2927562"/>
        <a:ext cx="4320000" cy="720000"/>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43994BD-C578-47AB-811B-DD6259CF7291}">
      <dsp:nvSpPr>
        <dsp:cNvPr id="0" name=""/>
        <dsp:cNvSpPr/>
      </dsp:nvSpPr>
      <dsp:spPr>
        <a:xfrm>
          <a:off x="0" y="651"/>
          <a:ext cx="6651253" cy="1524988"/>
        </a:xfrm>
        <a:prstGeom prst="roundRect">
          <a:avLst>
            <a:gd name="adj" fmla="val 1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24361E6E-0DA8-4D5E-87D4-6D2A4C2260AC}">
      <dsp:nvSpPr>
        <dsp:cNvPr id="0" name=""/>
        <dsp:cNvSpPr/>
      </dsp:nvSpPr>
      <dsp:spPr>
        <a:xfrm>
          <a:off x="461309" y="343774"/>
          <a:ext cx="838743" cy="838743"/>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7024B55A-0D3E-44B3-86B1-6ABF7063F4C1}">
      <dsp:nvSpPr>
        <dsp:cNvPr id="0" name=""/>
        <dsp:cNvSpPr/>
      </dsp:nvSpPr>
      <dsp:spPr>
        <a:xfrm>
          <a:off x="1761361" y="651"/>
          <a:ext cx="4889891" cy="152498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61395" tIns="161395" rIns="161395" bIns="161395" numCol="1" spcCol="1270" anchor="ctr" anchorCtr="0">
          <a:noAutofit/>
        </a:bodyPr>
        <a:lstStyle/>
        <a:p>
          <a:pPr marL="0" lvl="0" indent="0" algn="l" defTabSz="977900">
            <a:lnSpc>
              <a:spcPct val="90000"/>
            </a:lnSpc>
            <a:spcBef>
              <a:spcPct val="0"/>
            </a:spcBef>
            <a:spcAft>
              <a:spcPct val="35000"/>
            </a:spcAft>
            <a:buNone/>
          </a:pPr>
          <a:r>
            <a:rPr lang="en-US" sz="2200" kern="1200" dirty="0"/>
            <a:t>Ask Permission to talk about next steps</a:t>
          </a:r>
        </a:p>
      </dsp:txBody>
      <dsp:txXfrm>
        <a:off x="1761361" y="651"/>
        <a:ext cx="4889891" cy="1524988"/>
      </dsp:txXfrm>
    </dsp:sp>
    <dsp:sp modelId="{3F0345DA-D301-4516-9B69-90D70E04AEB5}">
      <dsp:nvSpPr>
        <dsp:cNvPr id="0" name=""/>
        <dsp:cNvSpPr/>
      </dsp:nvSpPr>
      <dsp:spPr>
        <a:xfrm>
          <a:off x="0" y="1906887"/>
          <a:ext cx="6651253" cy="1524988"/>
        </a:xfrm>
        <a:prstGeom prst="roundRect">
          <a:avLst>
            <a:gd name="adj" fmla="val 1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1710AD7B-E2D5-42B3-8A4D-A1D8091B14B3}">
      <dsp:nvSpPr>
        <dsp:cNvPr id="0" name=""/>
        <dsp:cNvSpPr/>
      </dsp:nvSpPr>
      <dsp:spPr>
        <a:xfrm>
          <a:off x="461309" y="2250010"/>
          <a:ext cx="838743" cy="838743"/>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FD44FFBD-8872-44A4-B66C-F4D526DE1FF1}">
      <dsp:nvSpPr>
        <dsp:cNvPr id="0" name=""/>
        <dsp:cNvSpPr/>
      </dsp:nvSpPr>
      <dsp:spPr>
        <a:xfrm>
          <a:off x="1761361" y="1906887"/>
          <a:ext cx="4889891" cy="152498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61395" tIns="161395" rIns="161395" bIns="161395" numCol="1" spcCol="1270" anchor="ctr" anchorCtr="0">
          <a:noAutofit/>
        </a:bodyPr>
        <a:lstStyle/>
        <a:p>
          <a:pPr marL="0" lvl="0" indent="0" algn="l" defTabSz="977900">
            <a:lnSpc>
              <a:spcPct val="90000"/>
            </a:lnSpc>
            <a:spcBef>
              <a:spcPct val="0"/>
            </a:spcBef>
            <a:spcAft>
              <a:spcPct val="35000"/>
            </a:spcAft>
            <a:buNone/>
          </a:pPr>
          <a:r>
            <a:rPr lang="en-US" sz="2200" kern="1200" dirty="0"/>
            <a:t>“I know I’ve given you some big news.  Do you feel ready to discuss where we go from here?”</a:t>
          </a:r>
        </a:p>
      </dsp:txBody>
      <dsp:txXfrm>
        <a:off x="1761361" y="1906887"/>
        <a:ext cx="4889891" cy="1524988"/>
      </dsp:txXfrm>
    </dsp:sp>
    <dsp:sp modelId="{692876A3-E9F8-446D-80F5-835746A91279}">
      <dsp:nvSpPr>
        <dsp:cNvPr id="0" name=""/>
        <dsp:cNvSpPr/>
      </dsp:nvSpPr>
      <dsp:spPr>
        <a:xfrm>
          <a:off x="0" y="3813123"/>
          <a:ext cx="6651253" cy="1524988"/>
        </a:xfrm>
        <a:prstGeom prst="roundRect">
          <a:avLst>
            <a:gd name="adj" fmla="val 10000"/>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2870718A-B9B2-418A-A3E0-AE8C8E1BC324}">
      <dsp:nvSpPr>
        <dsp:cNvPr id="0" name=""/>
        <dsp:cNvSpPr/>
      </dsp:nvSpPr>
      <dsp:spPr>
        <a:xfrm>
          <a:off x="461309" y="4156246"/>
          <a:ext cx="838743" cy="838743"/>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90E46CFE-CFF1-46F1-B2DA-15756E19B684}">
      <dsp:nvSpPr>
        <dsp:cNvPr id="0" name=""/>
        <dsp:cNvSpPr/>
      </dsp:nvSpPr>
      <dsp:spPr>
        <a:xfrm>
          <a:off x="1761361" y="3813123"/>
          <a:ext cx="4889891" cy="152498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61395" tIns="161395" rIns="161395" bIns="161395" numCol="1" spcCol="1270" anchor="ctr" anchorCtr="0">
          <a:noAutofit/>
        </a:bodyPr>
        <a:lstStyle/>
        <a:p>
          <a:pPr marL="0" lvl="0" indent="0" algn="l" defTabSz="977900">
            <a:lnSpc>
              <a:spcPct val="90000"/>
            </a:lnSpc>
            <a:spcBef>
              <a:spcPct val="0"/>
            </a:spcBef>
            <a:spcAft>
              <a:spcPct val="35000"/>
            </a:spcAft>
            <a:buNone/>
          </a:pPr>
          <a:r>
            <a:rPr lang="en-US" sz="2200" kern="1200" dirty="0"/>
            <a:t>Sometimes it’s hard to take this all in.  Just so I know I was clear, can you tell me what you heard?”</a:t>
          </a:r>
        </a:p>
      </dsp:txBody>
      <dsp:txXfrm>
        <a:off x="1761361" y="3813123"/>
        <a:ext cx="4889891" cy="1524988"/>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38ED39E-E051-B243-B3BB-F31C196974DC}">
      <dsp:nvSpPr>
        <dsp:cNvPr id="0" name=""/>
        <dsp:cNvSpPr/>
      </dsp:nvSpPr>
      <dsp:spPr>
        <a:xfrm>
          <a:off x="0" y="353498"/>
          <a:ext cx="10515600" cy="453600"/>
        </a:xfrm>
        <a:prstGeom prst="rect">
          <a:avLst/>
        </a:prstGeom>
        <a:solidFill>
          <a:schemeClr val="lt1">
            <a:alpha val="90000"/>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BB7C6D63-2639-D445-866C-7FF1561BE513}">
      <dsp:nvSpPr>
        <dsp:cNvPr id="0" name=""/>
        <dsp:cNvSpPr/>
      </dsp:nvSpPr>
      <dsp:spPr>
        <a:xfrm>
          <a:off x="525780" y="87818"/>
          <a:ext cx="7360920" cy="531360"/>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78225" tIns="0" rIns="278225" bIns="0" numCol="1" spcCol="1270" anchor="ctr" anchorCtr="0">
          <a:noAutofit/>
        </a:bodyPr>
        <a:lstStyle/>
        <a:p>
          <a:pPr marL="0" lvl="0" indent="0" algn="l" defTabSz="800100">
            <a:lnSpc>
              <a:spcPct val="90000"/>
            </a:lnSpc>
            <a:spcBef>
              <a:spcPct val="0"/>
            </a:spcBef>
            <a:spcAft>
              <a:spcPct val="35000"/>
            </a:spcAft>
            <a:buNone/>
          </a:pPr>
          <a:r>
            <a:rPr lang="en-US" sz="1800" kern="1200" dirty="0"/>
            <a:t>N – Name</a:t>
          </a:r>
        </a:p>
      </dsp:txBody>
      <dsp:txXfrm>
        <a:off x="551719" y="113757"/>
        <a:ext cx="7309042" cy="479482"/>
      </dsp:txXfrm>
    </dsp:sp>
    <dsp:sp modelId="{87E49858-EC07-7C4D-BA74-DEDD05CBF403}">
      <dsp:nvSpPr>
        <dsp:cNvPr id="0" name=""/>
        <dsp:cNvSpPr/>
      </dsp:nvSpPr>
      <dsp:spPr>
        <a:xfrm>
          <a:off x="0" y="1169978"/>
          <a:ext cx="10515600" cy="453600"/>
        </a:xfrm>
        <a:prstGeom prst="rect">
          <a:avLst/>
        </a:prstGeom>
        <a:solidFill>
          <a:schemeClr val="lt1">
            <a:alpha val="90000"/>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A5E7A925-589A-7C4B-9F1C-B67B53C03D71}">
      <dsp:nvSpPr>
        <dsp:cNvPr id="0" name=""/>
        <dsp:cNvSpPr/>
      </dsp:nvSpPr>
      <dsp:spPr>
        <a:xfrm>
          <a:off x="525780" y="904298"/>
          <a:ext cx="7360920" cy="531360"/>
        </a:xfrm>
        <a:prstGeom prst="roundRect">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78225" tIns="0" rIns="278225" bIns="0" numCol="1" spcCol="1270" anchor="ctr" anchorCtr="0">
          <a:noAutofit/>
        </a:bodyPr>
        <a:lstStyle/>
        <a:p>
          <a:pPr marL="0" lvl="0" indent="0" algn="l" defTabSz="800100">
            <a:lnSpc>
              <a:spcPct val="90000"/>
            </a:lnSpc>
            <a:spcBef>
              <a:spcPct val="0"/>
            </a:spcBef>
            <a:spcAft>
              <a:spcPct val="35000"/>
            </a:spcAft>
            <a:buNone/>
          </a:pPr>
          <a:r>
            <a:rPr lang="en-US" sz="1800" kern="1200" dirty="0"/>
            <a:t>U – Understand</a:t>
          </a:r>
        </a:p>
      </dsp:txBody>
      <dsp:txXfrm>
        <a:off x="551719" y="930237"/>
        <a:ext cx="7309042" cy="479482"/>
      </dsp:txXfrm>
    </dsp:sp>
    <dsp:sp modelId="{D42C8BD8-FF54-9A4A-992A-FDD111490F12}">
      <dsp:nvSpPr>
        <dsp:cNvPr id="0" name=""/>
        <dsp:cNvSpPr/>
      </dsp:nvSpPr>
      <dsp:spPr>
        <a:xfrm>
          <a:off x="0" y="1986458"/>
          <a:ext cx="10515600" cy="453600"/>
        </a:xfrm>
        <a:prstGeom prst="rect">
          <a:avLst/>
        </a:prstGeom>
        <a:solidFill>
          <a:schemeClr val="lt1">
            <a:alpha val="90000"/>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5E652308-50C2-814D-BB94-3E9777DD4E07}">
      <dsp:nvSpPr>
        <dsp:cNvPr id="0" name=""/>
        <dsp:cNvSpPr/>
      </dsp:nvSpPr>
      <dsp:spPr>
        <a:xfrm>
          <a:off x="525780" y="1720778"/>
          <a:ext cx="7360920" cy="531360"/>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78225" tIns="0" rIns="278225" bIns="0" numCol="1" spcCol="1270" anchor="ctr" anchorCtr="0">
          <a:noAutofit/>
        </a:bodyPr>
        <a:lstStyle/>
        <a:p>
          <a:pPr marL="0" lvl="0" indent="0" algn="l" defTabSz="800100">
            <a:lnSpc>
              <a:spcPct val="90000"/>
            </a:lnSpc>
            <a:spcBef>
              <a:spcPct val="0"/>
            </a:spcBef>
            <a:spcAft>
              <a:spcPct val="35000"/>
            </a:spcAft>
            <a:buNone/>
          </a:pPr>
          <a:r>
            <a:rPr lang="en-US" sz="1800" kern="1200" dirty="0"/>
            <a:t>R – Respect</a:t>
          </a:r>
        </a:p>
      </dsp:txBody>
      <dsp:txXfrm>
        <a:off x="551719" y="1746717"/>
        <a:ext cx="7309042" cy="479482"/>
      </dsp:txXfrm>
    </dsp:sp>
    <dsp:sp modelId="{48D69DE0-15B9-FF48-99A9-7EF235C6D93E}">
      <dsp:nvSpPr>
        <dsp:cNvPr id="0" name=""/>
        <dsp:cNvSpPr/>
      </dsp:nvSpPr>
      <dsp:spPr>
        <a:xfrm>
          <a:off x="0" y="2802938"/>
          <a:ext cx="10515600" cy="453600"/>
        </a:xfrm>
        <a:prstGeom prst="rect">
          <a:avLst/>
        </a:prstGeom>
        <a:solidFill>
          <a:schemeClr val="lt1">
            <a:alpha val="90000"/>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B5BB295A-0733-7045-82BB-E38EA9F09D96}">
      <dsp:nvSpPr>
        <dsp:cNvPr id="0" name=""/>
        <dsp:cNvSpPr/>
      </dsp:nvSpPr>
      <dsp:spPr>
        <a:xfrm>
          <a:off x="525780" y="2537258"/>
          <a:ext cx="7360920" cy="531360"/>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78225" tIns="0" rIns="278225" bIns="0" numCol="1" spcCol="1270" anchor="ctr" anchorCtr="0">
          <a:noAutofit/>
        </a:bodyPr>
        <a:lstStyle/>
        <a:p>
          <a:pPr marL="0" lvl="0" indent="0" algn="l" defTabSz="800100">
            <a:lnSpc>
              <a:spcPct val="90000"/>
            </a:lnSpc>
            <a:spcBef>
              <a:spcPct val="0"/>
            </a:spcBef>
            <a:spcAft>
              <a:spcPct val="35000"/>
            </a:spcAft>
            <a:buNone/>
          </a:pPr>
          <a:r>
            <a:rPr lang="en-US" sz="1800" kern="1200" dirty="0"/>
            <a:t>S – Support</a:t>
          </a:r>
        </a:p>
      </dsp:txBody>
      <dsp:txXfrm>
        <a:off x="551719" y="2563197"/>
        <a:ext cx="7309042" cy="479482"/>
      </dsp:txXfrm>
    </dsp:sp>
    <dsp:sp modelId="{61A359C3-9EE3-C34A-885A-5411C5F3340C}">
      <dsp:nvSpPr>
        <dsp:cNvPr id="0" name=""/>
        <dsp:cNvSpPr/>
      </dsp:nvSpPr>
      <dsp:spPr>
        <a:xfrm>
          <a:off x="0" y="3619418"/>
          <a:ext cx="10515600" cy="453600"/>
        </a:xfrm>
        <a:prstGeom prst="rect">
          <a:avLst/>
        </a:prstGeom>
        <a:solidFill>
          <a:schemeClr val="lt1">
            <a:alpha val="90000"/>
            <a:hueOff val="0"/>
            <a:satOff val="0"/>
            <a:lumOff val="0"/>
            <a:alphaOff val="0"/>
          </a:schemeClr>
        </a:solidFill>
        <a:ln w="12700" cap="flat" cmpd="sng" algn="ctr">
          <a:solidFill>
            <a:schemeClr val="accent6">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3443C13C-1D25-614A-9C26-8591E37F157B}">
      <dsp:nvSpPr>
        <dsp:cNvPr id="0" name=""/>
        <dsp:cNvSpPr/>
      </dsp:nvSpPr>
      <dsp:spPr>
        <a:xfrm>
          <a:off x="525780" y="3353738"/>
          <a:ext cx="7360920" cy="531360"/>
        </a:xfrm>
        <a:prstGeom prst="roundRect">
          <a:avLst/>
        </a:prstGeom>
        <a:solidFill>
          <a:schemeClr val="accent6">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78225" tIns="0" rIns="278225" bIns="0" numCol="1" spcCol="1270" anchor="ctr" anchorCtr="0">
          <a:noAutofit/>
        </a:bodyPr>
        <a:lstStyle/>
        <a:p>
          <a:pPr marL="0" lvl="0" indent="0" algn="l" defTabSz="800100">
            <a:lnSpc>
              <a:spcPct val="90000"/>
            </a:lnSpc>
            <a:spcBef>
              <a:spcPct val="0"/>
            </a:spcBef>
            <a:spcAft>
              <a:spcPct val="35000"/>
            </a:spcAft>
            <a:buNone/>
          </a:pPr>
          <a:r>
            <a:rPr lang="en-US" sz="1800" kern="1200" dirty="0"/>
            <a:t>E – Explore</a:t>
          </a:r>
        </a:p>
      </dsp:txBody>
      <dsp:txXfrm>
        <a:off x="551719" y="3379677"/>
        <a:ext cx="7309042" cy="479482"/>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AFB19AF-4D29-BD49-8229-5CCF082B8085}">
      <dsp:nvSpPr>
        <dsp:cNvPr id="0" name=""/>
        <dsp:cNvSpPr/>
      </dsp:nvSpPr>
      <dsp:spPr>
        <a:xfrm>
          <a:off x="0" y="985317"/>
          <a:ext cx="2957512" cy="1878020"/>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BA59609-2D8F-4F45-8E31-CE85D7E9BC69}">
      <dsp:nvSpPr>
        <dsp:cNvPr id="0" name=""/>
        <dsp:cNvSpPr/>
      </dsp:nvSpPr>
      <dsp:spPr>
        <a:xfrm>
          <a:off x="328612" y="1297499"/>
          <a:ext cx="2957512" cy="1878020"/>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02870" tIns="102870" rIns="102870" bIns="102870" numCol="1" spcCol="1270" anchor="ctr" anchorCtr="0">
          <a:noAutofit/>
        </a:bodyPr>
        <a:lstStyle/>
        <a:p>
          <a:pPr marL="0" lvl="0" indent="0" algn="ctr" defTabSz="1200150">
            <a:lnSpc>
              <a:spcPct val="90000"/>
            </a:lnSpc>
            <a:spcBef>
              <a:spcPct val="0"/>
            </a:spcBef>
            <a:spcAft>
              <a:spcPct val="35000"/>
            </a:spcAft>
            <a:buNone/>
          </a:pPr>
          <a:r>
            <a:rPr lang="en-US" sz="2700" kern="1200" dirty="0"/>
            <a:t>“It sounds like you’re [worried about your family].”</a:t>
          </a:r>
        </a:p>
      </dsp:txBody>
      <dsp:txXfrm>
        <a:off x="383617" y="1352504"/>
        <a:ext cx="2847502" cy="1768010"/>
      </dsp:txXfrm>
    </dsp:sp>
    <dsp:sp modelId="{84361372-DF3A-C24F-B5AD-83E45FAC1E7D}">
      <dsp:nvSpPr>
        <dsp:cNvPr id="0" name=""/>
        <dsp:cNvSpPr/>
      </dsp:nvSpPr>
      <dsp:spPr>
        <a:xfrm>
          <a:off x="3614737" y="985317"/>
          <a:ext cx="2957512" cy="1878020"/>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7A27BF8E-5B63-D141-8AA1-A0ED266B0B9F}">
      <dsp:nvSpPr>
        <dsp:cNvPr id="0" name=""/>
        <dsp:cNvSpPr/>
      </dsp:nvSpPr>
      <dsp:spPr>
        <a:xfrm>
          <a:off x="3943350" y="1297499"/>
          <a:ext cx="2957512" cy="1878020"/>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02870" tIns="102870" rIns="102870" bIns="102870" numCol="1" spcCol="1270" anchor="ctr" anchorCtr="0">
          <a:noAutofit/>
        </a:bodyPr>
        <a:lstStyle/>
        <a:p>
          <a:pPr marL="0" lvl="0" indent="0" algn="ctr" defTabSz="1200150">
            <a:lnSpc>
              <a:spcPct val="90000"/>
            </a:lnSpc>
            <a:spcBef>
              <a:spcPct val="0"/>
            </a:spcBef>
            <a:spcAft>
              <a:spcPct val="35000"/>
            </a:spcAft>
            <a:buNone/>
          </a:pPr>
          <a:r>
            <a:rPr lang="en-US" sz="2700" kern="1200" dirty="0"/>
            <a:t>”This is not what either of us was expecting.”</a:t>
          </a:r>
        </a:p>
      </dsp:txBody>
      <dsp:txXfrm>
        <a:off x="3998355" y="1352504"/>
        <a:ext cx="2847502" cy="1768010"/>
      </dsp:txXfrm>
    </dsp:sp>
    <dsp:sp modelId="{4EE9CFFF-8BE6-3C40-9C38-3898E302B344}">
      <dsp:nvSpPr>
        <dsp:cNvPr id="0" name=""/>
        <dsp:cNvSpPr/>
      </dsp:nvSpPr>
      <dsp:spPr>
        <a:xfrm>
          <a:off x="7229475" y="985317"/>
          <a:ext cx="2957512" cy="1878020"/>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B52FB546-8780-ED4E-9BE0-750F0463D467}">
      <dsp:nvSpPr>
        <dsp:cNvPr id="0" name=""/>
        <dsp:cNvSpPr/>
      </dsp:nvSpPr>
      <dsp:spPr>
        <a:xfrm>
          <a:off x="7558087" y="1297499"/>
          <a:ext cx="2957512" cy="1878020"/>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02870" tIns="102870" rIns="102870" bIns="102870" numCol="1" spcCol="1270" anchor="ctr" anchorCtr="0">
          <a:noAutofit/>
        </a:bodyPr>
        <a:lstStyle/>
        <a:p>
          <a:pPr marL="0" lvl="0" indent="0" algn="ctr" defTabSz="1200150">
            <a:lnSpc>
              <a:spcPct val="90000"/>
            </a:lnSpc>
            <a:spcBef>
              <a:spcPct val="0"/>
            </a:spcBef>
            <a:spcAft>
              <a:spcPct val="35000"/>
            </a:spcAft>
            <a:buNone/>
          </a:pPr>
          <a:r>
            <a:rPr lang="en-US" sz="2700" kern="1200" dirty="0"/>
            <a:t>“Anyone in your shoes would be [upset, angry].”</a:t>
          </a:r>
        </a:p>
      </dsp:txBody>
      <dsp:txXfrm>
        <a:off x="7613092" y="1352504"/>
        <a:ext cx="2847502" cy="1768010"/>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38C11C0-170C-40B0-9437-DA73AFB2934A}">
      <dsp:nvSpPr>
        <dsp:cNvPr id="0" name=""/>
        <dsp:cNvSpPr/>
      </dsp:nvSpPr>
      <dsp:spPr>
        <a:xfrm>
          <a:off x="1212569" y="891953"/>
          <a:ext cx="1300252" cy="1300252"/>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BEFBD12D-B6F2-4963-9BA4-67AB0C1349BC}">
      <dsp:nvSpPr>
        <dsp:cNvPr id="0" name=""/>
        <dsp:cNvSpPr/>
      </dsp:nvSpPr>
      <dsp:spPr>
        <a:xfrm>
          <a:off x="417971" y="2548883"/>
          <a:ext cx="288945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933450">
            <a:lnSpc>
              <a:spcPct val="90000"/>
            </a:lnSpc>
            <a:spcBef>
              <a:spcPct val="0"/>
            </a:spcBef>
            <a:spcAft>
              <a:spcPct val="35000"/>
            </a:spcAft>
            <a:buNone/>
          </a:pPr>
          <a:r>
            <a:rPr lang="en-US" sz="2100" kern="1200" dirty="0"/>
            <a:t>“I can’t imagine [how hard this must be].”</a:t>
          </a:r>
        </a:p>
      </dsp:txBody>
      <dsp:txXfrm>
        <a:off x="417971" y="2548883"/>
        <a:ext cx="2889450" cy="720000"/>
      </dsp:txXfrm>
    </dsp:sp>
    <dsp:sp modelId="{D92BB01B-93C5-4A00-80E7-589EFFF5B01B}">
      <dsp:nvSpPr>
        <dsp:cNvPr id="0" name=""/>
        <dsp:cNvSpPr/>
      </dsp:nvSpPr>
      <dsp:spPr>
        <a:xfrm>
          <a:off x="4607673" y="891953"/>
          <a:ext cx="1300252" cy="1300252"/>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B0430C96-FFEE-4629-BA7C-2CC8A2DA31FF}">
      <dsp:nvSpPr>
        <dsp:cNvPr id="0" name=""/>
        <dsp:cNvSpPr/>
      </dsp:nvSpPr>
      <dsp:spPr>
        <a:xfrm>
          <a:off x="3813075" y="2548883"/>
          <a:ext cx="288945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933450">
            <a:lnSpc>
              <a:spcPct val="90000"/>
            </a:lnSpc>
            <a:spcBef>
              <a:spcPct val="0"/>
            </a:spcBef>
            <a:spcAft>
              <a:spcPct val="35000"/>
            </a:spcAft>
            <a:buNone/>
          </a:pPr>
          <a:r>
            <a:rPr lang="en-US" sz="2100" kern="1200" dirty="0"/>
            <a:t>“I know this isn’t what </a:t>
          </a:r>
          <a:r>
            <a:rPr lang="en-US" sz="2100" i="1" kern="1200" dirty="0"/>
            <a:t>we</a:t>
          </a:r>
          <a:r>
            <a:rPr lang="en-US" sz="2100" kern="1200" dirty="0"/>
            <a:t> were hoping for.”</a:t>
          </a:r>
        </a:p>
      </dsp:txBody>
      <dsp:txXfrm>
        <a:off x="3813075" y="2548883"/>
        <a:ext cx="2889450" cy="720000"/>
      </dsp:txXfrm>
    </dsp:sp>
    <dsp:sp modelId="{95F0C128-DF29-47DC-AAB5-474ABFECD063}">
      <dsp:nvSpPr>
        <dsp:cNvPr id="0" name=""/>
        <dsp:cNvSpPr/>
      </dsp:nvSpPr>
      <dsp:spPr>
        <a:xfrm>
          <a:off x="8002777" y="891953"/>
          <a:ext cx="1300252" cy="1300252"/>
        </a:xfrm>
        <a:prstGeom prst="rect">
          <a:avLst/>
        </a:prstGeom>
        <a:blipFill>
          <a:blip xmlns:r="http://schemas.openxmlformats.org/officeDocument/2006/relationships">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9878B598-8717-420B-9CC1-DCE5F236695D}">
      <dsp:nvSpPr>
        <dsp:cNvPr id="0" name=""/>
        <dsp:cNvSpPr/>
      </dsp:nvSpPr>
      <dsp:spPr>
        <a:xfrm>
          <a:off x="7208178" y="2548883"/>
          <a:ext cx="288945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933450">
            <a:lnSpc>
              <a:spcPct val="90000"/>
            </a:lnSpc>
            <a:spcBef>
              <a:spcPct val="0"/>
            </a:spcBef>
            <a:spcAft>
              <a:spcPct val="35000"/>
            </a:spcAft>
            <a:buNone/>
          </a:pPr>
          <a:r>
            <a:rPr lang="en-US" sz="2100" kern="1200" dirty="0"/>
            <a:t>“I wish….[this hadn’t happened].”</a:t>
          </a:r>
        </a:p>
      </dsp:txBody>
      <dsp:txXfrm>
        <a:off x="7208178" y="2548883"/>
        <a:ext cx="2889450" cy="720000"/>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31FEF4C-3F39-C042-A2FD-C12082B49248}">
      <dsp:nvSpPr>
        <dsp:cNvPr id="0" name=""/>
        <dsp:cNvSpPr/>
      </dsp:nvSpPr>
      <dsp:spPr>
        <a:xfrm>
          <a:off x="1283" y="912303"/>
          <a:ext cx="4672458" cy="2336229"/>
        </a:xfrm>
        <a:prstGeom prst="roundRect">
          <a:avLst>
            <a:gd name="adj" fmla="val 10000"/>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0485" tIns="46990" rIns="70485" bIns="46990" numCol="1" spcCol="1270" anchor="ctr" anchorCtr="0">
          <a:noAutofit/>
        </a:bodyPr>
        <a:lstStyle/>
        <a:p>
          <a:pPr marL="0" lvl="0" indent="0" algn="ctr" defTabSz="1644650">
            <a:lnSpc>
              <a:spcPct val="90000"/>
            </a:lnSpc>
            <a:spcBef>
              <a:spcPct val="0"/>
            </a:spcBef>
            <a:spcAft>
              <a:spcPct val="35000"/>
            </a:spcAft>
            <a:buNone/>
          </a:pPr>
          <a:r>
            <a:rPr lang="en-US" sz="3700" kern="1200" dirty="0"/>
            <a:t>“You have done everything right.”</a:t>
          </a:r>
        </a:p>
      </dsp:txBody>
      <dsp:txXfrm>
        <a:off x="69709" y="980729"/>
        <a:ext cx="4535606" cy="2199377"/>
      </dsp:txXfrm>
    </dsp:sp>
    <dsp:sp modelId="{92DEBA59-138E-A841-9ADE-32F72C783EF0}">
      <dsp:nvSpPr>
        <dsp:cNvPr id="0" name=""/>
        <dsp:cNvSpPr/>
      </dsp:nvSpPr>
      <dsp:spPr>
        <a:xfrm>
          <a:off x="5841857" y="912303"/>
          <a:ext cx="4672458" cy="2336229"/>
        </a:xfrm>
        <a:prstGeom prst="roundRect">
          <a:avLst>
            <a:gd name="adj" fmla="val 10000"/>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0485" tIns="46990" rIns="70485" bIns="46990" numCol="1" spcCol="1270" anchor="ctr" anchorCtr="0">
          <a:noAutofit/>
        </a:bodyPr>
        <a:lstStyle/>
        <a:p>
          <a:pPr marL="0" lvl="0" indent="0" algn="ctr" defTabSz="1644650">
            <a:lnSpc>
              <a:spcPct val="90000"/>
            </a:lnSpc>
            <a:spcBef>
              <a:spcPct val="0"/>
            </a:spcBef>
            <a:spcAft>
              <a:spcPct val="35000"/>
            </a:spcAft>
            <a:buNone/>
          </a:pPr>
          <a:r>
            <a:rPr lang="en-US" sz="3700" kern="1200" dirty="0"/>
            <a:t>“You have been a wonderful advocate for your child.”</a:t>
          </a:r>
        </a:p>
      </dsp:txBody>
      <dsp:txXfrm>
        <a:off x="5910283" y="980729"/>
        <a:ext cx="4535606" cy="2199377"/>
      </dsp:txXfrm>
    </dsp:sp>
  </dsp:spTree>
</dsp:drawing>
</file>

<file path=ppt/diagrams/layout1.xml><?xml version="1.0" encoding="utf-8"?>
<dgm:layoutDef xmlns:dgm="http://schemas.openxmlformats.org/drawingml/2006/diagram" xmlns:a="http://schemas.openxmlformats.org/drawingml/2006/main" uniqueId="urn:microsoft.com/office/officeart/2018/2/layout/IconLabelList">
  <dgm:title val="Icon Label List"/>
  <dgm:desc val="Use to show non-sequential or grouped chunks of information accompanied by a related visuals. Works best with icons or small pictures with short text ca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snake">
          <dgm:param type="grDir" val="tL"/>
          <dgm:param type="flowDir" val="row"/>
          <dgm:param type="contDir" val="sameDir"/>
          <dgm:param type="off" val="ctr"/>
          <dgm:param type="vertAlign" val="mid"/>
          <dgm:param type="horzAlign" val="ctr"/>
        </dgm:alg>
      </dgm:if>
      <dgm:else name="Name2">
        <dgm:alg type="snake">
          <dgm:param type="grDir" val="tR"/>
          <dgm:param type="flowDir" val="row"/>
          <dgm:param type="contDir" val="sameDir"/>
          <dgm:param type="off" val="ctr"/>
          <dgm:param type="vertAlign" val="mid"/>
          <dgm:param type="horzAlign" val="ctr"/>
        </dgm:alg>
      </dgm:else>
    </dgm:choose>
    <dgm:shape xmlns:r="http://schemas.openxmlformats.org/officeDocument/2006/relationships" r:blip="">
      <dgm:adjLst/>
    </dgm:shape>
    <dgm:presOf/>
    <dgm:choose name="Name3">
      <dgm:if name="Name4" axis="ch" ptType="node" func="cnt" op="lte" val="2">
        <dgm:constrLst>
          <dgm:constr type="h" for="ch" forName="compNode" refType="h" fact="0.4"/>
          <dgm:constr type="w" for="ch" forName="compNode" val="120"/>
          <dgm:constr type="w" for="ch" forName="sibTrans" refType="w" refFor="ch" refForName="compNode" fact="0.175"/>
          <dgm:constr type="sp" refType="w" refFor="ch" refForName="compNode" op="equ" fact="0.25"/>
          <dgm:constr type="primFontSz" for="des" ptType="node" op="equ" val="50"/>
          <dgm:constr type="h" for="des" forName="compNode" op="equ"/>
          <dgm:constr type="h" for="des" forName="textRect" op="equ"/>
        </dgm:constrLst>
      </dgm:if>
      <dgm:if name="Name5" axis="ch" ptType="node" func="cnt" op="lte" val="4">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36"/>
          <dgm:constr type="h" for="des" forName="compNode" op="equ"/>
          <dgm:constr type="h" for="des" forName="textRect" op="equ"/>
        </dgm:constrLst>
      </dgm:if>
      <dgm:else name="Name6">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24"/>
          <dgm:constr type="h" for="des" forName="compNode" op="equ"/>
          <dgm:constr type="h" for="des" forName="textRect" op="equ"/>
        </dgm:constrLst>
      </dgm:else>
    </dgm:choose>
    <dgm:ruleLst>
      <dgm:rule type="w" for="ch" forName="compNode" val="50" fact="NaN" max="NaN"/>
    </dgm:ruleLst>
    <dgm:forEach name="Name7" axis="ch" ptType="node">
      <dgm:layoutNode name="compNode">
        <dgm:alg type="composite"/>
        <dgm:shape xmlns:r="http://schemas.openxmlformats.org/officeDocument/2006/relationships" r:blip="">
          <dgm:adjLst/>
        </dgm:shape>
        <dgm:presOf axis="self"/>
        <dgm:constrLst>
          <dgm:constr type="w" for="ch" forName="iconRect" refType="w" fact="0.45"/>
          <dgm:constr type="h" for="ch" forName="iconRect" refType="w" refFor="ch" refForName="iconRect"/>
          <dgm:constr type="ctrX" for="ch" forName="iconRect" refType="w" fact="0.5"/>
          <dgm:constr type="t" for="ch" forName="iconRect"/>
          <dgm:constr type="h" for="ch" forName="spaceRect" refType="h" fact="0.15"/>
          <dgm:constr type="w" for="ch" forName="spaceRect" refType="w"/>
          <dgm:constr type="l" for="ch" forName="spaceRect"/>
          <dgm:constr type="t" for="ch" forName="spaceRect" refType="b" refFor="ch" refForName="iconRect"/>
          <dgm:constr type="h" for="ch" forName="textRect" val="20"/>
          <dgm:constr type="w" for="ch" forName="textRect" refType="w"/>
          <dgm:constr type="l" for="ch" forName="textRect"/>
          <dgm:constr type="t" for="ch" forName="textRect" refType="b" refFor="ch" refForName="spaceRect"/>
        </dgm:constrLst>
        <dgm:ruleLst>
          <dgm:rule type="h" val="INF" fact="NaN" max="NaN"/>
        </dgm:ruleLst>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alg type="tx">
            <dgm:param type="txAnchorVert" val="t"/>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 type="h" val="INF" fact="NaN" max="NaN"/>
          </dgm:ruleLst>
        </dgm:layoutNode>
      </dgm:layoutNode>
      <dgm:forEach name="Name8"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dgm1612:lstStyle>
    </a:ext>
  </dgm:extLst>
</dgm:layoutDef>
</file>

<file path=ppt/diagrams/layout10.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11.xml><?xml version="1.0" encoding="utf-8"?>
<dgm:layoutDef xmlns:dgm="http://schemas.openxmlformats.org/drawingml/2006/diagram" xmlns:a="http://schemas.openxmlformats.org/drawingml/2006/main" uniqueId="urn:microsoft.com/office/officeart/2018/2/layout/IconLabelList">
  <dgm:title val="Icon Label List"/>
  <dgm:desc val="Use to show non-sequential or grouped chunks of information accompanied by a related visuals. Works best with icons or small pictures with short text ca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snake">
          <dgm:param type="grDir" val="tL"/>
          <dgm:param type="flowDir" val="row"/>
          <dgm:param type="contDir" val="sameDir"/>
          <dgm:param type="off" val="ctr"/>
          <dgm:param type="vertAlign" val="mid"/>
          <dgm:param type="horzAlign" val="ctr"/>
        </dgm:alg>
      </dgm:if>
      <dgm:else name="Name2">
        <dgm:alg type="snake">
          <dgm:param type="grDir" val="tR"/>
          <dgm:param type="flowDir" val="row"/>
          <dgm:param type="contDir" val="sameDir"/>
          <dgm:param type="off" val="ctr"/>
          <dgm:param type="vertAlign" val="mid"/>
          <dgm:param type="horzAlign" val="ctr"/>
        </dgm:alg>
      </dgm:else>
    </dgm:choose>
    <dgm:shape xmlns:r="http://schemas.openxmlformats.org/officeDocument/2006/relationships" r:blip="">
      <dgm:adjLst/>
    </dgm:shape>
    <dgm:presOf/>
    <dgm:choose name="Name3">
      <dgm:if name="Name4" axis="ch" ptType="node" func="cnt" op="lte" val="2">
        <dgm:constrLst>
          <dgm:constr type="h" for="ch" forName="compNode" refType="h" fact="0.4"/>
          <dgm:constr type="w" for="ch" forName="compNode" val="120"/>
          <dgm:constr type="w" for="ch" forName="sibTrans" refType="w" refFor="ch" refForName="compNode" fact="0.175"/>
          <dgm:constr type="sp" refType="w" refFor="ch" refForName="compNode" op="equ" fact="0.25"/>
          <dgm:constr type="primFontSz" for="des" ptType="node" op="equ" val="50"/>
          <dgm:constr type="h" for="des" forName="compNode" op="equ"/>
          <dgm:constr type="h" for="des" forName="textRect" op="equ"/>
        </dgm:constrLst>
      </dgm:if>
      <dgm:if name="Name5" axis="ch" ptType="node" func="cnt" op="lte" val="4">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36"/>
          <dgm:constr type="h" for="des" forName="compNode" op="equ"/>
          <dgm:constr type="h" for="des" forName="textRect" op="equ"/>
        </dgm:constrLst>
      </dgm:if>
      <dgm:else name="Name6">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24"/>
          <dgm:constr type="h" for="des" forName="compNode" op="equ"/>
          <dgm:constr type="h" for="des" forName="textRect" op="equ"/>
        </dgm:constrLst>
      </dgm:else>
    </dgm:choose>
    <dgm:ruleLst>
      <dgm:rule type="w" for="ch" forName="compNode" val="50" fact="NaN" max="NaN"/>
    </dgm:ruleLst>
    <dgm:forEach name="Name7" axis="ch" ptType="node">
      <dgm:layoutNode name="compNode">
        <dgm:alg type="composite"/>
        <dgm:shape xmlns:r="http://schemas.openxmlformats.org/officeDocument/2006/relationships" r:blip="">
          <dgm:adjLst/>
        </dgm:shape>
        <dgm:presOf axis="self"/>
        <dgm:constrLst>
          <dgm:constr type="w" for="ch" forName="iconRect" refType="w" fact="0.45"/>
          <dgm:constr type="h" for="ch" forName="iconRect" refType="w" refFor="ch" refForName="iconRect"/>
          <dgm:constr type="ctrX" for="ch" forName="iconRect" refType="w" fact="0.5"/>
          <dgm:constr type="t" for="ch" forName="iconRect"/>
          <dgm:constr type="h" for="ch" forName="spaceRect" refType="h" fact="0.15"/>
          <dgm:constr type="w" for="ch" forName="spaceRect" refType="w"/>
          <dgm:constr type="l" for="ch" forName="spaceRect"/>
          <dgm:constr type="t" for="ch" forName="spaceRect" refType="b" refFor="ch" refForName="iconRect"/>
          <dgm:constr type="h" for="ch" forName="textRect" val="20"/>
          <dgm:constr type="w" for="ch" forName="textRect" refType="w"/>
          <dgm:constr type="l" for="ch" forName="textRect"/>
          <dgm:constr type="t" for="ch" forName="textRect" refType="b" refFor="ch" refForName="spaceRect"/>
        </dgm:constrLst>
        <dgm:ruleLst>
          <dgm:rule type="h" val="INF" fact="NaN" max="NaN"/>
        </dgm:ruleLst>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alg type="tx">
            <dgm:param type="txAnchorVert" val="t"/>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 type="h" val="INF" fact="NaN" max="NaN"/>
          </dgm:ruleLst>
        </dgm:layoutNode>
      </dgm:layoutNode>
      <dgm:forEach name="Name8"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dgm1612:lstStyle>
    </a:ext>
  </dgm:extLst>
</dgm:layoutDef>
</file>

<file path=ppt/diagrams/layout12.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13.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2.xml><?xml version="1.0" encoding="utf-8"?>
<dgm:layoutDef xmlns:dgm="http://schemas.openxmlformats.org/drawingml/2006/diagram" xmlns:a="http://schemas.openxmlformats.org/drawingml/2006/main" uniqueId="urn:microsoft.com/office/officeart/2018/2/layout/IconLabelDescriptionList">
  <dgm:title val="Icon Label Description List"/>
  <dgm:desc val="Use to show non-sequential or grouped chunks of information. The placeholder holds an icon or small picture, and corresponding text boxes show Level 1 and Level 2 text respectively. Works well for minimal Level 1 text accompanied by lengthier Level two text."/>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if>
      <dgm:else name="Name2">
        <dgm:alg type="lin">
          <dgm:param type="linDir" val="fromR"/>
        </dgm:alg>
      </dgm:else>
    </dgm:choose>
    <dgm:shape xmlns:r="http://schemas.openxmlformats.org/officeDocument/2006/relationships" r:blip="">
      <dgm:adjLst/>
    </dgm:shape>
    <dgm:presOf/>
    <dgm:constrLst>
      <dgm:constr type="h" for="ch" forName="compNode" refType="h" fact="0.45"/>
      <dgm:constr type="w" for="ch" forName="compNode" val="120"/>
      <dgm:constr type="w" for="ch" forName="sibTrans" refType="w" refFor="ch" refForName="compNode" fact="0.175"/>
      <dgm:constr type="primFontSz" for="des" forName="parTx" val="36"/>
      <dgm:constr type="primFontSz" for="des" forName="desTx" refType="primFontSz" refFor="des" refForName="parTx" op="lte" fact="0.75"/>
      <dgm:constr type="h" for="des" forName="compNode" op="equ"/>
      <dgm:constr type="h" for="des" forName="iconRect" op="equ"/>
      <dgm:constr type="w" for="des" forName="iconRect" op="equ"/>
      <dgm:constr type="h" for="des" forName="iconSpace" op="equ"/>
      <dgm:constr type="h" for="des" forName="parTx" op="equ"/>
      <dgm:constr type="h" for="des" forName="txSpace" op="equ"/>
      <dgm:constr type="h" for="des" forName="desTx" op="equ"/>
    </dgm:constrLst>
    <dgm:ruleLst>
      <dgm:rule type="w" for="ch" forName="compNode" val="0" fact="NaN" max="NaN"/>
    </dgm:ruleLst>
    <dgm:forEach name="Name3" axis="ch" ptType="node">
      <dgm:layoutNode name="compNode">
        <dgm:alg type="composite"/>
        <dgm:shape xmlns:r="http://schemas.openxmlformats.org/officeDocument/2006/relationships" r:blip="">
          <dgm:adjLst/>
        </dgm:shape>
        <dgm:presOf axis="self"/>
        <dgm:constrLst>
          <dgm:constr type="w" for="ch" forName="iconRect" refType="w" fact="0.35"/>
          <dgm:constr type="h" for="ch" forName="iconRect" refType="w" refFor="ch" refForName="iconRect"/>
          <dgm:constr type="l" for="ch" forName="iconRect"/>
          <dgm:constr type="t" for="ch" forName="iconRect"/>
          <dgm:constr type="w" for="ch" forName="iconSpace" refType="w"/>
          <dgm:constr type="h" for="ch" forName="iconSpace" refType="h" fact="0.043"/>
          <dgm:constr type="l" for="ch" forName="iconSpace"/>
          <dgm:constr type="t" for="ch" forName="iconSpace" refType="b" refFor="ch" refForName="iconRect"/>
          <dgm:constr type="w" for="ch" forName="parTx" refType="w"/>
          <dgm:constr type="h" for="ch" forName="parTx" refType="w" fact="0.15"/>
          <dgm:constr type="l" for="ch" forName="parTx"/>
          <dgm:constr type="t" for="ch" forName="parTx" refType="b" refFor="ch" refForName="iconSpace"/>
          <dgm:constr type="h" for="ch" forName="txSpace" refType="h" fact="0.02"/>
          <dgm:constr type="w" for="ch" forName="txSpace" refType="w"/>
          <dgm:constr type="l" for="ch" forName="txSpace"/>
          <dgm:constr type="t" for="ch" forName="txSpace" refType="b" refFor="ch" refForName="parTx"/>
          <dgm:constr type="w" for="ch" forName="desTx" refType="w"/>
          <dgm:constr type="l" for="ch" forName="desTx"/>
          <dgm:constr type="t" for="ch" forName="desTx" refType="b" refFor="ch" refForName="txSpace"/>
        </dgm:constrLst>
        <dgm:ruleLst>
          <dgm:rule type="h" val="INF" fact="NaN" max="NaN"/>
        </dgm:ruleLst>
        <dgm:layoutNode name="iconRect" styleLbl="node1">
          <dgm:alg type="sp"/>
          <dgm:shape xmlns:r="http://schemas.openxmlformats.org/officeDocument/2006/relationships" type="rect" r:blip="" blipPhldr="1">
            <dgm:adjLst/>
          </dgm:shape>
          <dgm:presOf/>
          <dgm:constrLst/>
          <dgm:ruleLst/>
        </dgm:layoutNode>
        <dgm:layoutNode name="iconSpace">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t"/>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4" fact="NaN" max="NaN"/>
            <dgm:rule type="h" val="INF" fact="NaN" max="NaN"/>
          </dgm:ruleLst>
        </dgm:layoutNode>
        <dgm:layoutNode name="txSpace">
          <dgm:alg type="sp"/>
          <dgm:shape xmlns:r="http://schemas.openxmlformats.org/officeDocument/2006/relationships" r:blip="">
            <dgm:adjLst/>
          </dgm:shape>
          <dgm:presOf/>
          <dgm:constrLst/>
          <dgm:ruleLst/>
        </dgm:layoutNode>
        <dgm:layoutNode name="desTx" styleLbl="revTx">
          <dgm:varLst/>
          <dgm:alg type="tx">
            <dgm:param type="stBulletLvl" val="0"/>
            <dgm:param type="txAnchorVert" val="t"/>
            <dgm:param type="parTxLTRAlign" val="l"/>
            <dgm:param type="shpTxLTRAlignCh" val="l"/>
            <dgm:param type="parTxRTLAlign" val="r"/>
            <dgm:param type="shpTxRTLAlignCh" val="r"/>
          </dgm:alg>
          <dgm:shape xmlns:r="http://schemas.openxmlformats.org/officeDocument/2006/relationships" type="rect" r:blip="">
            <dgm:adjLst/>
          </dgm:shape>
          <dgm:presOf axis="des" ptType="node"/>
          <dgm:constrLst>
            <dgm:constr type="secFontSz" refType="primFontSz"/>
            <dgm:constr type="lMarg"/>
            <dgm:constr type="rMarg"/>
            <dgm:constr type="tMarg"/>
            <dgm:constr type="bMarg"/>
          </dgm:constrLst>
          <dgm:ruleLst>
            <dgm:rule type="primFontSz" val="NaN" fact="NaN" max="17"/>
            <dgm:rule type="h" val="INF" fact="NaN" max="NaN"/>
          </dgm:ruleLst>
        </dgm:layoutNode>
      </dgm:layoutNode>
      <dgm:forEach name="Name4"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defRPr b="1"/>
        </a:lvl1pPr>
        <a:lvl2pPr>
          <a:lnSpc>
            <a:spcPct val="100000"/>
          </a:lnSpc>
        </a:lvl2pPr>
      </dgm1612:lstStyle>
    </a:ext>
  </dgm:extLst>
</dgm:layoutDef>
</file>

<file path=ppt/diagrams/layout3.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18/2/layout/IconLabelList">
  <dgm:title val="Icon Label List"/>
  <dgm:desc val="Use to show non-sequential or grouped chunks of information accompanied by a related visuals. Works best with icons or small pictures with short text ca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snake">
          <dgm:param type="grDir" val="tL"/>
          <dgm:param type="flowDir" val="row"/>
          <dgm:param type="contDir" val="sameDir"/>
          <dgm:param type="off" val="ctr"/>
          <dgm:param type="vertAlign" val="mid"/>
          <dgm:param type="horzAlign" val="ctr"/>
        </dgm:alg>
      </dgm:if>
      <dgm:else name="Name2">
        <dgm:alg type="snake">
          <dgm:param type="grDir" val="tR"/>
          <dgm:param type="flowDir" val="row"/>
          <dgm:param type="contDir" val="sameDir"/>
          <dgm:param type="off" val="ctr"/>
          <dgm:param type="vertAlign" val="mid"/>
          <dgm:param type="horzAlign" val="ctr"/>
        </dgm:alg>
      </dgm:else>
    </dgm:choose>
    <dgm:shape xmlns:r="http://schemas.openxmlformats.org/officeDocument/2006/relationships" r:blip="">
      <dgm:adjLst/>
    </dgm:shape>
    <dgm:presOf/>
    <dgm:choose name="Name3">
      <dgm:if name="Name4" axis="ch" ptType="node" func="cnt" op="lte" val="2">
        <dgm:constrLst>
          <dgm:constr type="h" for="ch" forName="compNode" refType="h" fact="0.4"/>
          <dgm:constr type="w" for="ch" forName="compNode" val="120"/>
          <dgm:constr type="w" for="ch" forName="sibTrans" refType="w" refFor="ch" refForName="compNode" fact="0.175"/>
          <dgm:constr type="sp" refType="w" refFor="ch" refForName="compNode" op="equ" fact="0.25"/>
          <dgm:constr type="primFontSz" for="des" ptType="node" op="equ" val="50"/>
          <dgm:constr type="h" for="des" forName="compNode" op="equ"/>
          <dgm:constr type="h" for="des" forName="textRect" op="equ"/>
        </dgm:constrLst>
      </dgm:if>
      <dgm:if name="Name5" axis="ch" ptType="node" func="cnt" op="lte" val="4">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36"/>
          <dgm:constr type="h" for="des" forName="compNode" op="equ"/>
          <dgm:constr type="h" for="des" forName="textRect" op="equ"/>
        </dgm:constrLst>
      </dgm:if>
      <dgm:else name="Name6">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24"/>
          <dgm:constr type="h" for="des" forName="compNode" op="equ"/>
          <dgm:constr type="h" for="des" forName="textRect" op="equ"/>
        </dgm:constrLst>
      </dgm:else>
    </dgm:choose>
    <dgm:ruleLst>
      <dgm:rule type="w" for="ch" forName="compNode" val="50" fact="NaN" max="NaN"/>
    </dgm:ruleLst>
    <dgm:forEach name="Name7" axis="ch" ptType="node">
      <dgm:layoutNode name="compNode">
        <dgm:alg type="composite"/>
        <dgm:shape xmlns:r="http://schemas.openxmlformats.org/officeDocument/2006/relationships" r:blip="">
          <dgm:adjLst/>
        </dgm:shape>
        <dgm:presOf axis="self"/>
        <dgm:constrLst>
          <dgm:constr type="w" for="ch" forName="iconRect" refType="w" fact="0.45"/>
          <dgm:constr type="h" for="ch" forName="iconRect" refType="w" refFor="ch" refForName="iconRect"/>
          <dgm:constr type="ctrX" for="ch" forName="iconRect" refType="w" fact="0.5"/>
          <dgm:constr type="t" for="ch" forName="iconRect"/>
          <dgm:constr type="h" for="ch" forName="spaceRect" refType="h" fact="0.15"/>
          <dgm:constr type="w" for="ch" forName="spaceRect" refType="w"/>
          <dgm:constr type="l" for="ch" forName="spaceRect"/>
          <dgm:constr type="t" for="ch" forName="spaceRect" refType="b" refFor="ch" refForName="iconRect"/>
          <dgm:constr type="h" for="ch" forName="textRect" val="20"/>
          <dgm:constr type="w" for="ch" forName="textRect" refType="w"/>
          <dgm:constr type="l" for="ch" forName="textRect"/>
          <dgm:constr type="t" for="ch" forName="textRect" refType="b" refFor="ch" refForName="spaceRect"/>
        </dgm:constrLst>
        <dgm:ruleLst>
          <dgm:rule type="h" val="INF" fact="NaN" max="NaN"/>
        </dgm:ruleLst>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alg type="tx">
            <dgm:param type="txAnchorVert" val="t"/>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 type="h" val="INF" fact="NaN" max="NaN"/>
          </dgm:ruleLst>
        </dgm:layoutNode>
      </dgm:layoutNode>
      <dgm:forEach name="Name8"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dgm1612:lstStyle>
    </a:ext>
  </dgm:extLst>
</dgm:layoutDef>
</file>

<file path=ppt/diagrams/layout5.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6.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8.xml><?xml version="1.0" encoding="utf-8"?>
<dgm:layoutDef xmlns:dgm="http://schemas.openxmlformats.org/drawingml/2006/diagram" xmlns:a="http://schemas.openxmlformats.org/drawingml/2006/main" uniqueId="urn:microsoft.com/office/officeart/2018/2/layout/IconLabelList">
  <dgm:title val="Icon Label List"/>
  <dgm:desc val="Use to show non-sequential or grouped chunks of information accompanied by a related visuals. Works best with icons or small pictures with short text ca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snake">
          <dgm:param type="grDir" val="tL"/>
          <dgm:param type="flowDir" val="row"/>
          <dgm:param type="contDir" val="sameDir"/>
          <dgm:param type="off" val="ctr"/>
          <dgm:param type="vertAlign" val="mid"/>
          <dgm:param type="horzAlign" val="ctr"/>
        </dgm:alg>
      </dgm:if>
      <dgm:else name="Name2">
        <dgm:alg type="snake">
          <dgm:param type="grDir" val="tR"/>
          <dgm:param type="flowDir" val="row"/>
          <dgm:param type="contDir" val="sameDir"/>
          <dgm:param type="off" val="ctr"/>
          <dgm:param type="vertAlign" val="mid"/>
          <dgm:param type="horzAlign" val="ctr"/>
        </dgm:alg>
      </dgm:else>
    </dgm:choose>
    <dgm:shape xmlns:r="http://schemas.openxmlformats.org/officeDocument/2006/relationships" r:blip="">
      <dgm:adjLst/>
    </dgm:shape>
    <dgm:presOf/>
    <dgm:choose name="Name3">
      <dgm:if name="Name4" axis="ch" ptType="node" func="cnt" op="lte" val="2">
        <dgm:constrLst>
          <dgm:constr type="h" for="ch" forName="compNode" refType="h" fact="0.4"/>
          <dgm:constr type="w" for="ch" forName="compNode" val="120"/>
          <dgm:constr type="w" for="ch" forName="sibTrans" refType="w" refFor="ch" refForName="compNode" fact="0.175"/>
          <dgm:constr type="sp" refType="w" refFor="ch" refForName="compNode" op="equ" fact="0.25"/>
          <dgm:constr type="primFontSz" for="des" ptType="node" op="equ" val="50"/>
          <dgm:constr type="h" for="des" forName="compNode" op="equ"/>
          <dgm:constr type="h" for="des" forName="textRect" op="equ"/>
        </dgm:constrLst>
      </dgm:if>
      <dgm:if name="Name5" axis="ch" ptType="node" func="cnt" op="lte" val="4">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36"/>
          <dgm:constr type="h" for="des" forName="compNode" op="equ"/>
          <dgm:constr type="h" for="des" forName="textRect" op="equ"/>
        </dgm:constrLst>
      </dgm:if>
      <dgm:else name="Name6">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24"/>
          <dgm:constr type="h" for="des" forName="compNode" op="equ"/>
          <dgm:constr type="h" for="des" forName="textRect" op="equ"/>
        </dgm:constrLst>
      </dgm:else>
    </dgm:choose>
    <dgm:ruleLst>
      <dgm:rule type="w" for="ch" forName="compNode" val="50" fact="NaN" max="NaN"/>
    </dgm:ruleLst>
    <dgm:forEach name="Name7" axis="ch" ptType="node">
      <dgm:layoutNode name="compNode">
        <dgm:alg type="composite"/>
        <dgm:shape xmlns:r="http://schemas.openxmlformats.org/officeDocument/2006/relationships" r:blip="">
          <dgm:adjLst/>
        </dgm:shape>
        <dgm:presOf axis="self"/>
        <dgm:constrLst>
          <dgm:constr type="w" for="ch" forName="iconRect" refType="w" fact="0.45"/>
          <dgm:constr type="h" for="ch" forName="iconRect" refType="w" refFor="ch" refForName="iconRect"/>
          <dgm:constr type="ctrX" for="ch" forName="iconRect" refType="w" fact="0.5"/>
          <dgm:constr type="t" for="ch" forName="iconRect"/>
          <dgm:constr type="h" for="ch" forName="spaceRect" refType="h" fact="0.15"/>
          <dgm:constr type="w" for="ch" forName="spaceRect" refType="w"/>
          <dgm:constr type="l" for="ch" forName="spaceRect"/>
          <dgm:constr type="t" for="ch" forName="spaceRect" refType="b" refFor="ch" refForName="iconRect"/>
          <dgm:constr type="h" for="ch" forName="textRect" val="20"/>
          <dgm:constr type="w" for="ch" forName="textRect" refType="w"/>
          <dgm:constr type="l" for="ch" forName="textRect"/>
          <dgm:constr type="t" for="ch" forName="textRect" refType="b" refFor="ch" refForName="spaceRect"/>
        </dgm:constrLst>
        <dgm:ruleLst>
          <dgm:rule type="h" val="INF" fact="NaN" max="NaN"/>
        </dgm:ruleLst>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alg type="tx">
            <dgm:param type="txAnchorVert" val="t"/>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 type="h" val="INF" fact="NaN" max="NaN"/>
          </dgm:ruleLst>
        </dgm:layoutNode>
      </dgm:layoutNode>
      <dgm:forEach name="Name8"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dgm1612:lstStyle>
    </a:ext>
  </dgm:extLst>
</dgm:layoutDef>
</file>

<file path=ppt/diagrams/layout9.xml><?xml version="1.0" encoding="utf-8"?>
<dgm:layoutDef xmlns:dgm="http://schemas.openxmlformats.org/drawingml/2006/diagram" xmlns:a="http://schemas.openxmlformats.org/drawingml/2006/main" uniqueId="urn:microsoft.com/office/officeart/2005/8/layout/hierarchy3">
  <dgm:title val=""/>
  <dgm:desc val=""/>
  <dgm:catLst>
    <dgm:cat type="hierarchy" pri="7000"/>
    <dgm:cat type="list" pri="23000"/>
    <dgm:cat type="relationship" pri="15000"/>
    <dgm:cat type="convert" pri="7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Lst>
      <dgm:cxnLst>
        <dgm:cxn modelId="4" srcId="0" destId="1" srcOrd="0" destOrd="0"/>
        <dgm:cxn modelId="5" srcId="1" destId="11" srcOrd="0" destOrd="0"/>
        <dgm:cxn modelId="6" srcId="1" destId="12" srcOrd="1" destOrd="0"/>
        <dgm:cxn modelId="7" srcId="0" destId="2" srcOrd="1" destOrd="0"/>
        <dgm:cxn modelId="8" srcId="2" destId="21" srcOrd="0" destOrd="0"/>
        <dgm:cxn modelId="9" srcId="2" destId="2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diagram">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forName="rootText" op="equ" val="65"/>
      <dgm:constr type="primFontSz" for="des" forName="childText" op="equ" val="65"/>
      <dgm:constr type="w" for="des" forName="rootComposite" refType="w"/>
      <dgm:constr type="h" for="des" forName="rootComposite" refType="w" fact="0.5"/>
      <dgm:constr type="w" for="des" forName="childText" refType="w" refFor="des" refForName="rootComposite" fact="0.8"/>
      <dgm:constr type="h" for="des" forName="childText" refType="h" refFor="des" refForName="rootComposite"/>
      <dgm:constr type="sibSp" refType="w" refFor="des" refForName="rootComposite" fact="0.25"/>
      <dgm:constr type="sibSp" for="des" forName="childShape" refType="h" refFor="des" refForName="childText" fact="0.25"/>
      <dgm:constr type="sp" for="des" forName="root" refType="h" refFor="des" refForName="childText" fact="0.25"/>
    </dgm:constrLst>
    <dgm:ruleLst/>
    <dgm:forEach name="Name3" axis="ch">
      <dgm:forEach name="Name4" axis="self" ptType="node" cnt="1">
        <dgm:layoutNode name="root">
          <dgm:choose name="Name5">
            <dgm:if name="Name6" func="var" arg="dir" op="equ" val="norm">
              <dgm:alg type="hierRoot">
                <dgm:param type="hierAlign" val="tL"/>
              </dgm:alg>
            </dgm:if>
            <dgm:else name="Name7">
              <dgm:alg type="hierRoot">
                <dgm:param type="hierAlign" val="tR"/>
              </dgm:alg>
            </dgm:else>
          </dgm:choose>
          <dgm:shape xmlns:r="http://schemas.openxmlformats.org/officeDocument/2006/relationships" r:blip="">
            <dgm:adjLst/>
          </dgm:shape>
          <dgm:presOf/>
          <dgm:constrLst>
            <dgm:constr type="alignOff" val="0.2"/>
          </dgm:constrLst>
          <dgm:ruleLst/>
          <dgm:layoutNode name="rootComposite">
            <dgm:alg type="composite"/>
            <dgm:shape xmlns:r="http://schemas.openxmlformats.org/officeDocument/2006/relationships" r:blip="">
              <dgm:adjLst/>
            </dgm:shape>
            <dgm:presOf axis="self" ptType="node" cnt="1"/>
            <dgm:choose name="Name8">
              <dgm:if name="Name9" func="var" arg="dir" op="equ" val="norm">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else name="Name10">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else>
            </dgm:choose>
            <dgm:ruleLst/>
            <dgm:layoutNode name="rootText" styleLbl="node1">
              <dgm:alg type="tx"/>
              <dgm:shape xmlns:r="http://schemas.openxmlformats.org/officeDocument/2006/relationships" type="roundRect" r:blip="">
                <dgm:adjLst>
                  <dgm:adj idx="1" val="0.1"/>
                </dgm:adjLst>
              </dgm:shape>
              <dgm:presOf axis="self" ptType="node" cnt="1"/>
              <dgm:constrLst>
                <dgm:constr type="tMarg" refType="primFontSz" fact="0.1"/>
                <dgm:constr type="bMarg" refType="primFontSz" fact="0.1"/>
                <dgm:constr type="lMarg" refType="primFontSz" fact="0.15"/>
                <dgm:constr type="rMarg" refType="primFontSz" fact="0.15"/>
              </dgm:constrLst>
              <dgm:ruleLst>
                <dgm:rule type="primFontSz" val="5" fact="NaN" max="NaN"/>
              </dgm:ruleLst>
            </dgm:layoutNode>
            <dgm:layoutNode name="rootConnector" moveWith="rootText">
              <dgm:alg type="sp"/>
              <dgm:shape xmlns:r="http://schemas.openxmlformats.org/officeDocument/2006/relationships" type="roundRect" r:blip="" hideGeom="1">
                <dgm:adjLst>
                  <dgm:adj idx="1" val="0.1"/>
                </dgm:adjLst>
              </dgm:shape>
              <dgm:presOf axis="self" ptType="node" cnt="1"/>
              <dgm:constrLst/>
              <dgm:ruleLst/>
            </dgm:layoutNode>
          </dgm:layoutNode>
          <dgm:layoutNode name="childShape">
            <dgm:alg type="hierChild">
              <dgm:param type="chAlign" val="l"/>
              <dgm:param type="linDir" val="fromT"/>
            </dgm:alg>
            <dgm:shape xmlns:r="http://schemas.openxmlformats.org/officeDocument/2006/relationships" r:blip="">
              <dgm:adjLst/>
            </dgm:shape>
            <dgm:presOf/>
            <dgm:constrLst/>
            <dgm:ruleLst/>
            <dgm:forEach name="Name11" axis="ch">
              <dgm:forEach name="Name12" axis="self" ptType="parTrans" cnt="1">
                <dgm:layoutNode name="Name13">
                  <dgm:choose name="Name14">
                    <dgm:if name="Name15" func="var" arg="dir" op="equ" val="norm">
                      <dgm:alg type="conn">
                        <dgm:param type="dim" val="1D"/>
                        <dgm:param type="endSty" val="noArr"/>
                        <dgm:param type="connRout" val="bend"/>
                        <dgm:param type="srcNode" val="rootConnector"/>
                        <dgm:param type="begPts" val="bCtr"/>
                        <dgm:param type="endPts" val="midL"/>
                      </dgm:alg>
                    </dgm:if>
                    <dgm:else name="Name16">
                      <dgm:alg type="conn">
                        <dgm:param type="dim" val="1D"/>
                        <dgm:param type="endSty" val="noArr"/>
                        <dgm:param type="connRout" val="bend"/>
                        <dgm:param type="srcNode" val="rootConnector"/>
                        <dgm:param type="begPts" val="bCtr"/>
                        <dgm:param type="endPts" val="midR"/>
                      </dgm:alg>
                    </dgm:else>
                  </dgm:choose>
                  <dgm:shape xmlns:r="http://schemas.openxmlformats.org/officeDocument/2006/relationships" type="conn" r:blip="">
                    <dgm:adjLst/>
                  </dgm:shape>
                  <dgm:presOf axis="self"/>
                  <dgm:constrLst>
                    <dgm:constr type="begPad"/>
                    <dgm:constr type="endPad"/>
                  </dgm:constrLst>
                  <dgm:ruleLst/>
                </dgm:layoutNode>
              </dgm:forEach>
              <dgm:forEach name="Name17" axis="self" ptType="node">
                <dgm:layoutNode name="childText" styleLbl="bgAcc1">
                  <dgm:varLst>
                    <dgm:bulletEnabled val="1"/>
                  </dgm:varLst>
                  <dgm:alg type="tx"/>
                  <dgm:shape xmlns:r="http://schemas.openxmlformats.org/officeDocument/2006/relationships" type="roundRect" r:blip="">
                    <dgm:adjLst>
                      <dgm:adj idx="1" val="0.1"/>
                    </dgm:adjLst>
                  </dgm:shape>
                  <dgm:presOf axis="self desOrSelf" ptType="node node" st="1 1" cnt="1 0"/>
                  <dgm:constrLst>
                    <dgm:constr type="tMarg" refType="primFontSz" fact="0.1"/>
                    <dgm:constr type="bMarg" refType="primFontSz" fact="0.1"/>
                    <dgm:constr type="lMarg" refType="primFontSz" fact="0.15"/>
                    <dgm:constr type="rMarg" refType="primFontSz" fact="0.15"/>
                  </dgm:constrLst>
                  <dgm:ruleLst>
                    <dgm:rule type="primFontSz" val="5" fact="NaN" max="NaN"/>
                  </dgm:ruleLst>
                </dgm:layoutNode>
              </dgm:forEach>
            </dgm:forEach>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A3147E8-1F84-354A-B3E7-97C8EB63659A}" type="datetimeFigureOut">
              <a:rPr lang="en-US" smtClean="0"/>
              <a:t>5/3/26</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A888C01-245B-B14F-8539-92B2F5FA58BC}" type="slidenum">
              <a:rPr lang="en-US" smtClean="0"/>
              <a:t>‹#›</a:t>
            </a:fld>
            <a:endParaRPr lang="en-US" dirty="0"/>
          </a:p>
        </p:txBody>
      </p:sp>
    </p:spTree>
    <p:extLst>
      <p:ext uri="{BB962C8B-B14F-4D97-AF65-F5344CB8AC3E}">
        <p14:creationId xmlns:p14="http://schemas.microsoft.com/office/powerpoint/2010/main" val="50262381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day we are going to talk about and practice skills surrounding difficult perioperative conversations.  You will or already encounter these conversations frequently in your practice.  It is our goal today to empower you with skills in how to manage these conversations.</a:t>
            </a:r>
          </a:p>
        </p:txBody>
      </p:sp>
      <p:sp>
        <p:nvSpPr>
          <p:cNvPr id="4" name="Slide Number Placeholder 3"/>
          <p:cNvSpPr>
            <a:spLocks noGrp="1"/>
          </p:cNvSpPr>
          <p:nvPr>
            <p:ph type="sldNum" sz="quarter" idx="5"/>
          </p:nvPr>
        </p:nvSpPr>
        <p:spPr/>
        <p:txBody>
          <a:bodyPr/>
          <a:lstStyle/>
          <a:p>
            <a:fld id="{8A888C01-245B-B14F-8539-92B2F5FA58BC}" type="slidenum">
              <a:rPr lang="en-US" smtClean="0"/>
              <a:t>1</a:t>
            </a:fld>
            <a:endParaRPr lang="en-US" dirty="0"/>
          </a:p>
        </p:txBody>
      </p:sp>
    </p:spTree>
    <p:extLst>
      <p:ext uri="{BB962C8B-B14F-4D97-AF65-F5344CB8AC3E}">
        <p14:creationId xmlns:p14="http://schemas.microsoft.com/office/powerpoint/2010/main" val="95435301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last step of SPIKES is summarize and strategize.  After mental preparation and taking the time to have a difficult conservation, it is imperative to ensure that your patient and their family understand the news you have given them and what to do next when they’re ready.  Just like you asked for permission to give them the bad news, it’s important to ask if they are ready to hear about the next steps.  They might not be ready to handle the cognitive load of getting information now.  Or they more need more information about what happened before they are ready to move forward with next steps.  In addition, our patients and family members may not understand what we have said due to their high emotional load or limited language and health literacy.  By asking the patient to summarize what was said, you can ensure that you were able to deliver the bad news effectively.  To avoid sounding condescending, a way you may want to say this is, “Just to make sure I am explaining this well, can you tell me what I said about your family member?”  This puts the onus on the person delivering the bad news instead of on the person receiving it.</a:t>
            </a:r>
          </a:p>
        </p:txBody>
      </p:sp>
      <p:sp>
        <p:nvSpPr>
          <p:cNvPr id="4" name="Slide Number Placeholder 3"/>
          <p:cNvSpPr>
            <a:spLocks noGrp="1"/>
          </p:cNvSpPr>
          <p:nvPr>
            <p:ph type="sldNum" sz="quarter" idx="5"/>
          </p:nvPr>
        </p:nvSpPr>
        <p:spPr/>
        <p:txBody>
          <a:bodyPr/>
          <a:lstStyle/>
          <a:p>
            <a:fld id="{8A888C01-245B-B14F-8539-92B2F5FA58BC}" type="slidenum">
              <a:rPr lang="en-US" smtClean="0"/>
              <a:t>10</a:t>
            </a:fld>
            <a:endParaRPr lang="en-US" dirty="0"/>
          </a:p>
        </p:txBody>
      </p:sp>
    </p:spTree>
    <p:extLst>
      <p:ext uri="{BB962C8B-B14F-4D97-AF65-F5344CB8AC3E}">
        <p14:creationId xmlns:p14="http://schemas.microsoft.com/office/powerpoint/2010/main" val="374574439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acronym NURSE stands for Naming, Understanding, Respecting, Supporting, Exploring statements.  There are all different ways to respond to emotion.  You may find that some of these statements come more naturally to you than others.  There are not meant to be played all together like playing cards.  You will decide by the patient and family responses what make work best in a particular situation.  Admittedly, these statements can also be quite helpful at home with partners or children.</a:t>
            </a:r>
          </a:p>
        </p:txBody>
      </p:sp>
      <p:sp>
        <p:nvSpPr>
          <p:cNvPr id="4" name="Slide Number Placeholder 3"/>
          <p:cNvSpPr>
            <a:spLocks noGrp="1"/>
          </p:cNvSpPr>
          <p:nvPr>
            <p:ph type="sldNum" sz="quarter" idx="5"/>
          </p:nvPr>
        </p:nvSpPr>
        <p:spPr/>
        <p:txBody>
          <a:bodyPr/>
          <a:lstStyle/>
          <a:p>
            <a:fld id="{8A888C01-245B-B14F-8539-92B2F5FA58BC}" type="slidenum">
              <a:rPr lang="en-US" smtClean="0"/>
              <a:t>11</a:t>
            </a:fld>
            <a:endParaRPr lang="en-US" dirty="0"/>
          </a:p>
        </p:txBody>
      </p:sp>
    </p:spTree>
    <p:extLst>
      <p:ext uri="{BB962C8B-B14F-4D97-AF65-F5344CB8AC3E}">
        <p14:creationId xmlns:p14="http://schemas.microsoft.com/office/powerpoint/2010/main" val="244862715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aming statements can be used to point out what emotions we are seeing from the patient and their family during the conversation.  Examples include, “It sounds like you’re worried about your family” or “Anyone in your shoes would be angry about this.” Be careful to tell the patient and family that this is YOUR perception of how they are feeling instead of telling them ”You’re angry about this.” The reason why is that the patient and family may feel that they are being told how to feel.</a:t>
            </a:r>
          </a:p>
        </p:txBody>
      </p:sp>
      <p:sp>
        <p:nvSpPr>
          <p:cNvPr id="4" name="Slide Number Placeholder 3"/>
          <p:cNvSpPr>
            <a:spLocks noGrp="1"/>
          </p:cNvSpPr>
          <p:nvPr>
            <p:ph type="sldNum" sz="quarter" idx="5"/>
          </p:nvPr>
        </p:nvSpPr>
        <p:spPr/>
        <p:txBody>
          <a:bodyPr/>
          <a:lstStyle/>
          <a:p>
            <a:fld id="{8A888C01-245B-B14F-8539-92B2F5FA58BC}" type="slidenum">
              <a:rPr lang="en-US" smtClean="0"/>
              <a:t>12</a:t>
            </a:fld>
            <a:endParaRPr lang="en-US" dirty="0"/>
          </a:p>
        </p:txBody>
      </p:sp>
    </p:spTree>
    <p:extLst>
      <p:ext uri="{BB962C8B-B14F-4D97-AF65-F5344CB8AC3E}">
        <p14:creationId xmlns:p14="http://schemas.microsoft.com/office/powerpoint/2010/main" val="9332980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nderstanding statements can be a powerful way to show your empathy to patients and their family.  Examples include “I know this isn’t what we were hoping for.” or “I can’t imagine how hard this must be.”  Though it seems counterintuitive, sometimes telling patients and their families that you understand can be expressed by telling them you can’t imagine what they are going through.  </a:t>
            </a:r>
          </a:p>
          <a:p>
            <a:endParaRPr lang="en-US" dirty="0"/>
          </a:p>
          <a:p>
            <a:r>
              <a:rPr lang="en-US" dirty="0"/>
              <a:t>By telling them patients and families that “this isn’t what we were hoping for,” you are partnering with them that you wanted the best outcome for their family members.  Unfortunately, bad outcomes still occur despite our best care and intentions. The “I wish” statements can be particularly powerful in this regard.   </a:t>
            </a:r>
          </a:p>
        </p:txBody>
      </p:sp>
      <p:sp>
        <p:nvSpPr>
          <p:cNvPr id="4" name="Slide Number Placeholder 3"/>
          <p:cNvSpPr>
            <a:spLocks noGrp="1"/>
          </p:cNvSpPr>
          <p:nvPr>
            <p:ph type="sldNum" sz="quarter" idx="5"/>
          </p:nvPr>
        </p:nvSpPr>
        <p:spPr/>
        <p:txBody>
          <a:bodyPr/>
          <a:lstStyle/>
          <a:p>
            <a:fld id="{8A888C01-245B-B14F-8539-92B2F5FA58BC}" type="slidenum">
              <a:rPr lang="en-US" smtClean="0"/>
              <a:t>13</a:t>
            </a:fld>
            <a:endParaRPr lang="en-US" dirty="0"/>
          </a:p>
        </p:txBody>
      </p:sp>
    </p:spTree>
    <p:extLst>
      <p:ext uri="{BB962C8B-B14F-4D97-AF65-F5344CB8AC3E}">
        <p14:creationId xmlns:p14="http://schemas.microsoft.com/office/powerpoint/2010/main" val="325245193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spect statements can be powerful in supporting the patient and their family.  Often, families doubt whether they are making the correct decisions for their family member.  By telling the family that “they have done the right thing by bringing their family member in for care” or that “they have been a wonderful advocate” helps to allay some of this self-doubt and may help them to open up about their concerns and feelings.</a:t>
            </a:r>
          </a:p>
        </p:txBody>
      </p:sp>
      <p:sp>
        <p:nvSpPr>
          <p:cNvPr id="4" name="Slide Number Placeholder 3"/>
          <p:cNvSpPr>
            <a:spLocks noGrp="1"/>
          </p:cNvSpPr>
          <p:nvPr>
            <p:ph type="sldNum" sz="quarter" idx="5"/>
          </p:nvPr>
        </p:nvSpPr>
        <p:spPr/>
        <p:txBody>
          <a:bodyPr/>
          <a:lstStyle/>
          <a:p>
            <a:fld id="{8A888C01-245B-B14F-8539-92B2F5FA58BC}" type="slidenum">
              <a:rPr lang="en-US" smtClean="0"/>
              <a:t>14</a:t>
            </a:fld>
            <a:endParaRPr lang="en-US" dirty="0"/>
          </a:p>
        </p:txBody>
      </p:sp>
    </p:spTree>
    <p:extLst>
      <p:ext uri="{BB962C8B-B14F-4D97-AF65-F5344CB8AC3E}">
        <p14:creationId xmlns:p14="http://schemas.microsoft.com/office/powerpoint/2010/main" val="68838264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ort statements show that you are partnering with the patient and their family.  Patients and families fear that they will be abandoned after a complication.  Statements such as “We will be there to help you through this” and “I will be here to answer your questions and provide support” help allay these fears.  After a complication, patient and families want to ensure that these complications don’t happen again to their family member or anyone else.  Stating that “we will work to make sure this doesn’t happen again” will let them know you are working towards this goal.</a:t>
            </a:r>
          </a:p>
        </p:txBody>
      </p:sp>
      <p:sp>
        <p:nvSpPr>
          <p:cNvPr id="4" name="Slide Number Placeholder 3"/>
          <p:cNvSpPr>
            <a:spLocks noGrp="1"/>
          </p:cNvSpPr>
          <p:nvPr>
            <p:ph type="sldNum" sz="quarter" idx="5"/>
          </p:nvPr>
        </p:nvSpPr>
        <p:spPr/>
        <p:txBody>
          <a:bodyPr/>
          <a:lstStyle/>
          <a:p>
            <a:fld id="{8A888C01-245B-B14F-8539-92B2F5FA58BC}" type="slidenum">
              <a:rPr lang="en-US" smtClean="0"/>
              <a:t>15</a:t>
            </a:fld>
            <a:endParaRPr lang="en-US" dirty="0"/>
          </a:p>
        </p:txBody>
      </p:sp>
    </p:spTree>
    <p:extLst>
      <p:ext uri="{BB962C8B-B14F-4D97-AF65-F5344CB8AC3E}">
        <p14:creationId xmlns:p14="http://schemas.microsoft.com/office/powerpoint/2010/main" val="155262263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last NURSE statement is Explore.  These statements can be particularly helpful when you don’t know what to say or what the patient needs. Statements such as “Tell me more” and “What’s going through your head right now?” are helpful when dealing with silence from a patient or family member.  Be prepared for a potential release of emotion when the family member or patient speaks.</a:t>
            </a:r>
          </a:p>
        </p:txBody>
      </p:sp>
      <p:sp>
        <p:nvSpPr>
          <p:cNvPr id="4" name="Slide Number Placeholder 3"/>
          <p:cNvSpPr>
            <a:spLocks noGrp="1"/>
          </p:cNvSpPr>
          <p:nvPr>
            <p:ph type="sldNum" sz="quarter" idx="5"/>
          </p:nvPr>
        </p:nvSpPr>
        <p:spPr/>
        <p:txBody>
          <a:bodyPr/>
          <a:lstStyle/>
          <a:p>
            <a:fld id="{8A888C01-245B-B14F-8539-92B2F5FA58BC}" type="slidenum">
              <a:rPr lang="en-US" smtClean="0"/>
              <a:t>16</a:t>
            </a:fld>
            <a:endParaRPr lang="en-US" dirty="0"/>
          </a:p>
        </p:txBody>
      </p:sp>
    </p:spTree>
    <p:extLst>
      <p:ext uri="{BB962C8B-B14F-4D97-AF65-F5344CB8AC3E}">
        <p14:creationId xmlns:p14="http://schemas.microsoft.com/office/powerpoint/2010/main" val="148959304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Cheat Sheet” sums up the lecture on both SPIKES and NURSE.  Any questions?  We hope that you have found this helpful.  I promise that the rest of the workshop will be much more active for you.  The next part of this curriculum will be practicing these skills with our talented simulated patients.</a:t>
            </a:r>
          </a:p>
        </p:txBody>
      </p:sp>
      <p:sp>
        <p:nvSpPr>
          <p:cNvPr id="4" name="Slide Number Placeholder 3"/>
          <p:cNvSpPr>
            <a:spLocks noGrp="1"/>
          </p:cNvSpPr>
          <p:nvPr>
            <p:ph type="sldNum" sz="quarter" idx="5"/>
          </p:nvPr>
        </p:nvSpPr>
        <p:spPr/>
        <p:txBody>
          <a:bodyPr/>
          <a:lstStyle/>
          <a:p>
            <a:fld id="{8A888C01-245B-B14F-8539-92B2F5FA58BC}" type="slidenum">
              <a:rPr lang="en-US" smtClean="0"/>
              <a:t>17</a:t>
            </a:fld>
            <a:endParaRPr lang="en-US" dirty="0"/>
          </a:p>
        </p:txBody>
      </p:sp>
    </p:spTree>
    <p:extLst>
      <p:ext uri="{BB962C8B-B14F-4D97-AF65-F5344CB8AC3E}">
        <p14:creationId xmlns:p14="http://schemas.microsoft.com/office/powerpoint/2010/main" val="309357315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a few references that support the framework and methods that we talked about today.  Please reach out if you have any questions or would like to talk further regarding this topic.</a:t>
            </a:r>
          </a:p>
        </p:txBody>
      </p:sp>
      <p:sp>
        <p:nvSpPr>
          <p:cNvPr id="4" name="Slide Number Placeholder 3"/>
          <p:cNvSpPr>
            <a:spLocks noGrp="1"/>
          </p:cNvSpPr>
          <p:nvPr>
            <p:ph type="sldNum" sz="quarter" idx="5"/>
          </p:nvPr>
        </p:nvSpPr>
        <p:spPr/>
        <p:txBody>
          <a:bodyPr/>
          <a:lstStyle/>
          <a:p>
            <a:fld id="{8A888C01-245B-B14F-8539-92B2F5FA58BC}" type="slidenum">
              <a:rPr lang="en-US" smtClean="0"/>
              <a:t>18</a:t>
            </a:fld>
            <a:endParaRPr lang="en-US" dirty="0"/>
          </a:p>
        </p:txBody>
      </p:sp>
    </p:spTree>
    <p:extLst>
      <p:ext uri="{BB962C8B-B14F-4D97-AF65-F5344CB8AC3E}">
        <p14:creationId xmlns:p14="http://schemas.microsoft.com/office/powerpoint/2010/main" val="208970832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would a good curriculum be without learning objectives?!?  These are our objectives for today.</a:t>
            </a:r>
          </a:p>
          <a:p>
            <a:endParaRPr lang="en-US" dirty="0"/>
          </a:p>
          <a:p>
            <a:r>
              <a:rPr lang="en-US" sz="1200" b="0" kern="1200" dirty="0">
                <a:solidFill>
                  <a:schemeClr val="tx1"/>
                </a:solidFill>
                <a:effectLst/>
                <a:latin typeface="+mn-lt"/>
                <a:ea typeface="+mn-ea"/>
                <a:cs typeface="+mn-cs"/>
              </a:rPr>
              <a:t>1.  Apply the SPIKES (situation, perception, invitation, knowledge, empathy, summary/next steps) to difficult perioperative conversations</a:t>
            </a:r>
            <a:endParaRPr lang="en-US" sz="1200" b="1" kern="1200" dirty="0">
              <a:solidFill>
                <a:schemeClr val="tx1"/>
              </a:solidFill>
              <a:effectLst/>
              <a:latin typeface="+mn-lt"/>
              <a:ea typeface="+mn-ea"/>
              <a:cs typeface="+mn-cs"/>
            </a:endParaRPr>
          </a:p>
          <a:p>
            <a:r>
              <a:rPr lang="en-US" sz="1200" b="0" kern="1200" dirty="0">
                <a:solidFill>
                  <a:schemeClr val="tx1"/>
                </a:solidFill>
                <a:effectLst/>
                <a:latin typeface="+mn-lt"/>
                <a:ea typeface="+mn-ea"/>
                <a:cs typeface="+mn-cs"/>
              </a:rPr>
              <a:t>2. Apply NURSE (naming, understanding, respecting, supporting, exploring) statements to explore patients’ and families’ emotions</a:t>
            </a:r>
            <a:endParaRPr lang="en-US" sz="1200" b="1" kern="1200" dirty="0">
              <a:solidFill>
                <a:schemeClr val="tx1"/>
              </a:solidFill>
              <a:effectLst/>
              <a:latin typeface="+mn-lt"/>
              <a:ea typeface="+mn-ea"/>
              <a:cs typeface="+mn-cs"/>
            </a:endParaRPr>
          </a:p>
          <a:p>
            <a:r>
              <a:rPr lang="en-US" sz="1200" b="0" kern="1200" dirty="0">
                <a:solidFill>
                  <a:schemeClr val="tx1"/>
                </a:solidFill>
                <a:effectLst/>
                <a:latin typeface="+mn-lt"/>
                <a:ea typeface="+mn-ea"/>
                <a:cs typeface="+mn-cs"/>
              </a:rPr>
              <a:t>3. Determine how to implement SPIKES/NURSE frameworks for disclosing serious news in their own clinical practice</a:t>
            </a:r>
            <a:endParaRPr lang="en-US" sz="1200" b="1"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8A888C01-245B-B14F-8539-92B2F5FA58BC}" type="slidenum">
              <a:rPr lang="en-US" smtClean="0"/>
              <a:t>2</a:t>
            </a:fld>
            <a:endParaRPr lang="en-US" dirty="0"/>
          </a:p>
        </p:txBody>
      </p:sp>
    </p:spTree>
    <p:extLst>
      <p:ext uri="{BB962C8B-B14F-4D97-AF65-F5344CB8AC3E}">
        <p14:creationId xmlns:p14="http://schemas.microsoft.com/office/powerpoint/2010/main" val="415645729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o has heard of the acronym ”SPIKES” before?  This is what it stands for:  Setting, Perception, Invitation, Knowledge, Emotions, and Summarize/Strategize.  We will individually talk about each of these steps.  Though it may seem that using these six steps will take a long time, we actually see the opposite in simulated testing scenarios.  After seeing many students go through difficult conversations before and after taking this course, we find that they are much more efficient at having difficult conversations because they have a framework of what to say and are more confident in their approach.  </a:t>
            </a:r>
          </a:p>
        </p:txBody>
      </p:sp>
      <p:sp>
        <p:nvSpPr>
          <p:cNvPr id="4" name="Slide Number Placeholder 3"/>
          <p:cNvSpPr>
            <a:spLocks noGrp="1"/>
          </p:cNvSpPr>
          <p:nvPr>
            <p:ph type="sldNum" sz="quarter" idx="5"/>
          </p:nvPr>
        </p:nvSpPr>
        <p:spPr/>
        <p:txBody>
          <a:bodyPr/>
          <a:lstStyle/>
          <a:p>
            <a:fld id="{8A888C01-245B-B14F-8539-92B2F5FA58BC}" type="slidenum">
              <a:rPr lang="en-US" smtClean="0"/>
              <a:t>3</a:t>
            </a:fld>
            <a:endParaRPr lang="en-US" dirty="0"/>
          </a:p>
        </p:txBody>
      </p:sp>
    </p:spTree>
    <p:extLst>
      <p:ext uri="{BB962C8B-B14F-4D97-AF65-F5344CB8AC3E}">
        <p14:creationId xmlns:p14="http://schemas.microsoft.com/office/powerpoint/2010/main" val="404682675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 stands for setting.  Most of ”Setting” is performed before you even meet the patient or their family.  It is important to set aside the time to have these important conversations.  If you are performing patient care, have one of your colleagues help you so you can spend your full attention on this conversation.  Forward your pager and/or cellphone if possible, to ensure there are no interruptions during the conversation. Secure a location where everyone can sit down comfortably.  If you think this conversation will evoke strong emotions and many do, have tissues ready for the patient and family.  </a:t>
            </a:r>
          </a:p>
          <a:p>
            <a:endParaRPr lang="en-US" dirty="0"/>
          </a:p>
          <a:p>
            <a:r>
              <a:rPr lang="en-US" dirty="0"/>
              <a:t>As anesthesia practice is often a team sport, there may be several members of the team meeting with the patient and family at the same time.  If this occurs, make sure there is a plan BEFORE the conversation occurs.  Figure out who is going to speak when and what the content of your conversation will be.  If the patient/family hears different perspectives from each member of the medical team, they might feel that care or communication was suboptimal.  At worst, they may feel that the team is lying or hiding the truth.</a:t>
            </a:r>
          </a:p>
          <a:p>
            <a:endParaRPr lang="en-US" dirty="0"/>
          </a:p>
          <a:p>
            <a:r>
              <a:rPr lang="en-US" dirty="0"/>
              <a:t>Remember to introduce yourself and ensure that you have the correct patient or family member when you walk in the room.</a:t>
            </a:r>
          </a:p>
        </p:txBody>
      </p:sp>
      <p:sp>
        <p:nvSpPr>
          <p:cNvPr id="4" name="Slide Number Placeholder 3"/>
          <p:cNvSpPr>
            <a:spLocks noGrp="1"/>
          </p:cNvSpPr>
          <p:nvPr>
            <p:ph type="sldNum" sz="quarter" idx="5"/>
          </p:nvPr>
        </p:nvSpPr>
        <p:spPr/>
        <p:txBody>
          <a:bodyPr/>
          <a:lstStyle/>
          <a:p>
            <a:fld id="{8A888C01-245B-B14F-8539-92B2F5FA58BC}" type="slidenum">
              <a:rPr lang="en-US" smtClean="0"/>
              <a:t>4</a:t>
            </a:fld>
            <a:endParaRPr lang="en-US" dirty="0"/>
          </a:p>
        </p:txBody>
      </p:sp>
    </p:spTree>
    <p:extLst>
      <p:ext uri="{BB962C8B-B14F-4D97-AF65-F5344CB8AC3E}">
        <p14:creationId xmlns:p14="http://schemas.microsoft.com/office/powerpoint/2010/main" val="33853367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ue to the nature of our specialty, it is quite common for the anesthesia practitioner to talk to the patient and family after other providers have already given an update.  For example, the surgeon or nurse may have updated the family while we were caring for their loved one or while we were engaged in patient care for another patient.  If order to ensure that we are on the same page as the patient and family, ask them what they already know.  ”What have you been told about your family member’s care?” is a simple place to start.</a:t>
            </a:r>
          </a:p>
        </p:txBody>
      </p:sp>
      <p:sp>
        <p:nvSpPr>
          <p:cNvPr id="4" name="Slide Number Placeholder 3"/>
          <p:cNvSpPr>
            <a:spLocks noGrp="1"/>
          </p:cNvSpPr>
          <p:nvPr>
            <p:ph type="sldNum" sz="quarter" idx="5"/>
          </p:nvPr>
        </p:nvSpPr>
        <p:spPr/>
        <p:txBody>
          <a:bodyPr/>
          <a:lstStyle/>
          <a:p>
            <a:fld id="{8A888C01-245B-B14F-8539-92B2F5FA58BC}" type="slidenum">
              <a:rPr lang="en-US" smtClean="0"/>
              <a:t>5</a:t>
            </a:fld>
            <a:endParaRPr lang="en-US" dirty="0"/>
          </a:p>
        </p:txBody>
      </p:sp>
    </p:spTree>
    <p:extLst>
      <p:ext uri="{BB962C8B-B14F-4D97-AF65-F5344CB8AC3E}">
        <p14:creationId xmlns:p14="http://schemas.microsoft.com/office/powerpoint/2010/main" val="180061993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fter you find out what the patient and family already know, it’s time to ask them if they are ready for an update.  If you think about your job during these difficult conversations as supporting the patient and family while they receive the news rather than just trying to get the information out there, it makes sense that you would ask the family for permission.  </a:t>
            </a:r>
          </a:p>
          <a:p>
            <a:endParaRPr lang="en-US" dirty="0"/>
          </a:p>
          <a:p>
            <a:r>
              <a:rPr lang="en-US" dirty="0"/>
              <a:t>It’s important that patients and families are ready to hear the information before we tell them.  It is also important that they have the support that the need.  It is very common that a patient or family member to want a support person with them when receiving bad news.  By giving the patient or family member time to call someone or maybe even wait for that person to come (i.e., bathroom), we can further support them through a difficult time.  </a:t>
            </a:r>
          </a:p>
        </p:txBody>
      </p:sp>
      <p:sp>
        <p:nvSpPr>
          <p:cNvPr id="4" name="Slide Number Placeholder 3"/>
          <p:cNvSpPr>
            <a:spLocks noGrp="1"/>
          </p:cNvSpPr>
          <p:nvPr>
            <p:ph type="sldNum" sz="quarter" idx="5"/>
          </p:nvPr>
        </p:nvSpPr>
        <p:spPr/>
        <p:txBody>
          <a:bodyPr/>
          <a:lstStyle/>
          <a:p>
            <a:fld id="{8A888C01-245B-B14F-8539-92B2F5FA58BC}" type="slidenum">
              <a:rPr lang="en-US" smtClean="0"/>
              <a:t>6</a:t>
            </a:fld>
            <a:endParaRPr lang="en-US" dirty="0"/>
          </a:p>
        </p:txBody>
      </p:sp>
    </p:spTree>
    <p:extLst>
      <p:ext uri="{BB962C8B-B14F-4D97-AF65-F5344CB8AC3E}">
        <p14:creationId xmlns:p14="http://schemas.microsoft.com/office/powerpoint/2010/main" val="288325584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irst three steps of SPIKES, Setting-Perception-Invitation happen very quickly.  These introductory steps are typically completed within the first two minutes of the conversation.  Now it’s time to tell the patient/family what happened.  In looking at patient preferences for receiving bad news, patients were found to prefer hearing a warning shot.  An example of a warning shot is: “I have some serious news to tell you about your family member.”  This simple statement prepared the patients for what was coming next, so they were ready to emotionally brace themselves.</a:t>
            </a:r>
          </a:p>
          <a:p>
            <a:endParaRPr lang="en-US" dirty="0"/>
          </a:p>
          <a:p>
            <a:r>
              <a:rPr lang="en-US" dirty="0"/>
              <a:t>One of the most difficult techniques of delivery difficult news in giving a good headline.  What’s a headline?  I think the best word to describe it is the headline is what the family member would tell ”Aunt Sally” when giving an update about their family member.  When you have so much medical knowledge and there are strong emotions involved, it is very difficult to say things succinctly and to avoid any medical jargon, so the patient and their families understand.  Many times, we use an ”inverted triangle” method of speaking.  Though common in writing essays, this method using an introductory sentence, supporting sentences, and a conclusion sentence at the end.  Though quite useful is essay writing, this is not what patients and families want.  They want you to get to the point.  Give the headline instead.  One to two sentences that described what happened and why.</a:t>
            </a:r>
          </a:p>
        </p:txBody>
      </p:sp>
      <p:sp>
        <p:nvSpPr>
          <p:cNvPr id="4" name="Slide Number Placeholder 3"/>
          <p:cNvSpPr>
            <a:spLocks noGrp="1"/>
          </p:cNvSpPr>
          <p:nvPr>
            <p:ph type="sldNum" sz="quarter" idx="5"/>
          </p:nvPr>
        </p:nvSpPr>
        <p:spPr/>
        <p:txBody>
          <a:bodyPr/>
          <a:lstStyle/>
          <a:p>
            <a:fld id="{8A888C01-245B-B14F-8539-92B2F5FA58BC}" type="slidenum">
              <a:rPr lang="en-US" smtClean="0"/>
              <a:t>7</a:t>
            </a:fld>
            <a:endParaRPr lang="en-US" dirty="0"/>
          </a:p>
        </p:txBody>
      </p:sp>
    </p:spTree>
    <p:extLst>
      <p:ext uri="{BB962C8B-B14F-4D97-AF65-F5344CB8AC3E}">
        <p14:creationId xmlns:p14="http://schemas.microsoft.com/office/powerpoint/2010/main" val="52705240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aring bad news is hard and evokes strong emotions.  Information flows through either an emotional (E) or cognitive channel (C).  When trying to give information in a highly emotional state, the patient and family may have difficulty understanding you because they need help dealing with their emotions first.  Alternatively, when patients and their families want information, they don’t want to hear “I’m sorry” or other empathetic comments.  They want answers!  When patients were asked to review breaking bad news videos, they appreciated when the practitioner knew when to acknowledge the patient’s emotions or when to give information and when to go back and forth between these two tasks.  Trying to understand what a patient and their family needs at a specific point in the conversation can be tricky because the need for empathy or knowledge can change.</a:t>
            </a:r>
          </a:p>
        </p:txBody>
      </p:sp>
      <p:sp>
        <p:nvSpPr>
          <p:cNvPr id="4" name="Slide Number Placeholder 3"/>
          <p:cNvSpPr>
            <a:spLocks noGrp="1"/>
          </p:cNvSpPr>
          <p:nvPr>
            <p:ph type="sldNum" sz="quarter" idx="5"/>
          </p:nvPr>
        </p:nvSpPr>
        <p:spPr/>
        <p:txBody>
          <a:bodyPr/>
          <a:lstStyle/>
          <a:p>
            <a:fld id="{8A888C01-245B-B14F-8539-92B2F5FA58BC}" type="slidenum">
              <a:rPr lang="en-US" smtClean="0"/>
              <a:t>8</a:t>
            </a:fld>
            <a:endParaRPr lang="en-US" dirty="0"/>
          </a:p>
        </p:txBody>
      </p:sp>
    </p:spTree>
    <p:extLst>
      <p:ext uri="{BB962C8B-B14F-4D97-AF65-F5344CB8AC3E}">
        <p14:creationId xmlns:p14="http://schemas.microsoft.com/office/powerpoint/2010/main" val="107113815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E in SPIKES is for Emotion.  In difficult conversations, most of the time may be spent responding to emotions.  Though we are used to giving information rapidly and objectively as clinicians, responding to patient’s and families’ emotions may not come naturally.  It’s important to give the patient and their family space to process through difficult news.  It’s important to give pauses if needed rather than trying to fill the time with conversation.  We will give you specific tools for how to respond to emotion using NURSE statements next.</a:t>
            </a:r>
          </a:p>
        </p:txBody>
      </p:sp>
      <p:sp>
        <p:nvSpPr>
          <p:cNvPr id="4" name="Slide Number Placeholder 3"/>
          <p:cNvSpPr>
            <a:spLocks noGrp="1"/>
          </p:cNvSpPr>
          <p:nvPr>
            <p:ph type="sldNum" sz="quarter" idx="5"/>
          </p:nvPr>
        </p:nvSpPr>
        <p:spPr/>
        <p:txBody>
          <a:bodyPr/>
          <a:lstStyle/>
          <a:p>
            <a:fld id="{8A888C01-245B-B14F-8539-92B2F5FA58BC}" type="slidenum">
              <a:rPr lang="en-US" smtClean="0"/>
              <a:t>9</a:t>
            </a:fld>
            <a:endParaRPr lang="en-US" dirty="0"/>
          </a:p>
        </p:txBody>
      </p:sp>
    </p:spTree>
    <p:extLst>
      <p:ext uri="{BB962C8B-B14F-4D97-AF65-F5344CB8AC3E}">
        <p14:creationId xmlns:p14="http://schemas.microsoft.com/office/powerpoint/2010/main" val="388757238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Graphic 1" descr="Tag=AccentColor&#10;Flavor=Light&#10;Target=Fill">
            <a:extLst>
              <a:ext uri="{FF2B5EF4-FFF2-40B4-BE49-F238E27FC236}">
                <a16:creationId xmlns:a16="http://schemas.microsoft.com/office/drawing/2014/main" id="{0D57E7FA-E8FC-45AC-868F-CDC8144939D6}"/>
              </a:ext>
            </a:extLst>
          </p:cNvPr>
          <p:cNvSpPr/>
          <p:nvPr/>
        </p:nvSpPr>
        <p:spPr>
          <a:xfrm rot="10800000" flipV="1">
            <a:off x="2599854" y="527562"/>
            <a:ext cx="6992292" cy="5102484"/>
          </a:xfrm>
          <a:custGeom>
            <a:avLst/>
            <a:gdLst>
              <a:gd name="connsiteX0" fmla="*/ 5458905 w 6886274"/>
              <a:gd name="connsiteY0" fmla="*/ 754119 h 5025119"/>
              <a:gd name="connsiteX1" fmla="*/ 3455557 w 6886274"/>
              <a:gd name="connsiteY1" fmla="*/ 1027709 h 5025119"/>
              <a:gd name="connsiteX2" fmla="*/ 3338677 w 6886274"/>
              <a:gd name="connsiteY2" fmla="*/ 1021381 h 5025119"/>
              <a:gd name="connsiteX3" fmla="*/ 2518280 w 6886274"/>
              <a:gd name="connsiteY3" fmla="*/ 980435 h 5025119"/>
              <a:gd name="connsiteX4" fmla="*/ 1673687 w 6886274"/>
              <a:gd name="connsiteY4" fmla="*/ 739229 h 5025119"/>
              <a:gd name="connsiteX5" fmla="*/ 1183459 w 6886274"/>
              <a:gd name="connsiteY5" fmla="*/ 397149 h 5025119"/>
              <a:gd name="connsiteX6" fmla="*/ 977987 w 6886274"/>
              <a:gd name="connsiteY6" fmla="*/ 241184 h 5025119"/>
              <a:gd name="connsiteX7" fmla="*/ 788150 w 6886274"/>
              <a:gd name="connsiteY7" fmla="*/ 66980 h 5025119"/>
              <a:gd name="connsiteX8" fmla="*/ 721148 w 6886274"/>
              <a:gd name="connsiteY8" fmla="*/ 31990 h 5025119"/>
              <a:gd name="connsiteX9" fmla="*/ 701792 w 6886274"/>
              <a:gd name="connsiteY9" fmla="*/ 32362 h 5025119"/>
              <a:gd name="connsiteX10" fmla="*/ 686530 w 6886274"/>
              <a:gd name="connsiteY10" fmla="*/ 43157 h 5025119"/>
              <a:gd name="connsiteX11" fmla="*/ 693603 w 6886274"/>
              <a:gd name="connsiteY11" fmla="*/ 58046 h 5025119"/>
              <a:gd name="connsiteX12" fmla="*/ 705886 w 6886274"/>
              <a:gd name="connsiteY12" fmla="*/ 65491 h 5025119"/>
              <a:gd name="connsiteX13" fmla="*/ 762838 w 6886274"/>
              <a:gd name="connsiteY13" fmla="*/ 112764 h 5025119"/>
              <a:gd name="connsiteX14" fmla="*/ 764327 w 6886274"/>
              <a:gd name="connsiteY14" fmla="*/ 140309 h 5025119"/>
              <a:gd name="connsiteX15" fmla="*/ 775121 w 6886274"/>
              <a:gd name="connsiteY15" fmla="*/ 159666 h 5025119"/>
              <a:gd name="connsiteX16" fmla="*/ 823139 w 6886274"/>
              <a:gd name="connsiteY16" fmla="*/ 176416 h 5025119"/>
              <a:gd name="connsiteX17" fmla="*/ 707748 w 6886274"/>
              <a:gd name="connsiteY17" fmla="*/ 109414 h 5025119"/>
              <a:gd name="connsiteX18" fmla="*/ 681319 w 6886274"/>
              <a:gd name="connsiteY18" fmla="*/ 69958 h 5025119"/>
              <a:gd name="connsiteX19" fmla="*/ 640746 w 6886274"/>
              <a:gd name="connsiteY19" fmla="*/ 67352 h 5025119"/>
              <a:gd name="connsiteX20" fmla="*/ 614318 w 6886274"/>
              <a:gd name="connsiteY20" fmla="*/ 61396 h 5025119"/>
              <a:gd name="connsiteX21" fmla="*/ 560716 w 6886274"/>
              <a:gd name="connsiteY21" fmla="*/ 3701 h 5025119"/>
              <a:gd name="connsiteX22" fmla="*/ 540616 w 6886274"/>
              <a:gd name="connsiteY22" fmla="*/ 3701 h 5025119"/>
              <a:gd name="connsiteX23" fmla="*/ 543594 w 6886274"/>
              <a:gd name="connsiteY23" fmla="*/ 21940 h 5025119"/>
              <a:gd name="connsiteX24" fmla="*/ 558855 w 6886274"/>
              <a:gd name="connsiteY24" fmla="*/ 51346 h 5025119"/>
              <a:gd name="connsiteX25" fmla="*/ 557366 w 6886274"/>
              <a:gd name="connsiteY25" fmla="*/ 72563 h 5025119"/>
              <a:gd name="connsiteX26" fmla="*/ 570022 w 6886274"/>
              <a:gd name="connsiteY26" fmla="*/ 120209 h 5025119"/>
              <a:gd name="connsiteX27" fmla="*/ 599801 w 6886274"/>
              <a:gd name="connsiteY27" fmla="*/ 192794 h 5025119"/>
              <a:gd name="connsiteX28" fmla="*/ 614318 w 6886274"/>
              <a:gd name="connsiteY28" fmla="*/ 212150 h 5025119"/>
              <a:gd name="connsiteX29" fmla="*/ 623996 w 6886274"/>
              <a:gd name="connsiteY29" fmla="*/ 220711 h 5025119"/>
              <a:gd name="connsiteX30" fmla="*/ 821278 w 6886274"/>
              <a:gd name="connsiteY30" fmla="*/ 503235 h 5025119"/>
              <a:gd name="connsiteX31" fmla="*/ 1033822 w 6886274"/>
              <a:gd name="connsiteY31" fmla="*/ 694562 h 5025119"/>
              <a:gd name="connsiteX32" fmla="*/ 1039406 w 6886274"/>
              <a:gd name="connsiteY32" fmla="*/ 702378 h 5025119"/>
              <a:gd name="connsiteX33" fmla="*/ 944114 w 6886274"/>
              <a:gd name="connsiteY33" fmla="*/ 662550 h 5025119"/>
              <a:gd name="connsiteX34" fmla="*/ 733432 w 6886274"/>
              <a:gd name="connsiteY34" fmla="*/ 500629 h 5025119"/>
              <a:gd name="connsiteX35" fmla="*/ 606501 w 6886274"/>
              <a:gd name="connsiteY35" fmla="*/ 399755 h 5025119"/>
              <a:gd name="connsiteX36" fmla="*/ 588634 w 6886274"/>
              <a:gd name="connsiteY36" fmla="*/ 381143 h 5025119"/>
              <a:gd name="connsiteX37" fmla="*/ 575978 w 6886274"/>
              <a:gd name="connsiteY37" fmla="*/ 375560 h 5025119"/>
              <a:gd name="connsiteX38" fmla="*/ 567044 w 6886274"/>
              <a:gd name="connsiteY38" fmla="*/ 388588 h 5025119"/>
              <a:gd name="connsiteX39" fmla="*/ 578956 w 6886274"/>
              <a:gd name="connsiteY39" fmla="*/ 437722 h 5025119"/>
              <a:gd name="connsiteX40" fmla="*/ 675736 w 6886274"/>
              <a:gd name="connsiteY40" fmla="*/ 535619 h 5025119"/>
              <a:gd name="connsiteX41" fmla="*/ 811600 w 6886274"/>
              <a:gd name="connsiteY41" fmla="*/ 652872 h 5025119"/>
              <a:gd name="connsiteX42" fmla="*/ 818300 w 6886274"/>
              <a:gd name="connsiteY42" fmla="*/ 666272 h 5025119"/>
              <a:gd name="connsiteX43" fmla="*/ 741621 w 6886274"/>
              <a:gd name="connsiteY43" fmla="*/ 608576 h 5025119"/>
              <a:gd name="connsiteX44" fmla="*/ 666430 w 6886274"/>
              <a:gd name="connsiteY44" fmla="*/ 553114 h 5025119"/>
              <a:gd name="connsiteX45" fmla="*/ 645585 w 6886274"/>
              <a:gd name="connsiteY45" fmla="*/ 547903 h 5025119"/>
              <a:gd name="connsiteX46" fmla="*/ 640002 w 6886274"/>
              <a:gd name="connsiteY46" fmla="*/ 570236 h 5025119"/>
              <a:gd name="connsiteX47" fmla="*/ 675736 w 6886274"/>
              <a:gd name="connsiteY47" fmla="*/ 628677 h 5025119"/>
              <a:gd name="connsiteX48" fmla="*/ 855896 w 6886274"/>
              <a:gd name="connsiteY48" fmla="*/ 786875 h 5025119"/>
              <a:gd name="connsiteX49" fmla="*/ 946348 w 6886274"/>
              <a:gd name="connsiteY49" fmla="*/ 877699 h 5025119"/>
              <a:gd name="connsiteX50" fmla="*/ 950442 w 6886274"/>
              <a:gd name="connsiteY50" fmla="*/ 899661 h 5025119"/>
              <a:gd name="connsiteX51" fmla="*/ 991760 w 6886274"/>
              <a:gd name="connsiteY51" fmla="*/ 937629 h 5025119"/>
              <a:gd name="connsiteX52" fmla="*/ 1018188 w 6886274"/>
              <a:gd name="connsiteY52" fmla="*/ 945445 h 5025119"/>
              <a:gd name="connsiteX53" fmla="*/ 1315601 w 6886274"/>
              <a:gd name="connsiteY53" fmla="*/ 1196329 h 5025119"/>
              <a:gd name="connsiteX54" fmla="*/ 1454443 w 6886274"/>
              <a:gd name="connsiteY54" fmla="*/ 1279709 h 5025119"/>
              <a:gd name="connsiteX55" fmla="*/ 1454443 w 6886274"/>
              <a:gd name="connsiteY55" fmla="*/ 1285665 h 5025119"/>
              <a:gd name="connsiteX56" fmla="*/ 1453327 w 6886274"/>
              <a:gd name="connsiteY56" fmla="*/ 1291993 h 5025119"/>
              <a:gd name="connsiteX57" fmla="*/ 1256416 w 6886274"/>
              <a:gd name="connsiteY57" fmla="*/ 1166923 h 5025119"/>
              <a:gd name="connsiteX58" fmla="*/ 745715 w 6886274"/>
              <a:gd name="connsiteY58" fmla="*/ 798786 h 5025119"/>
              <a:gd name="connsiteX59" fmla="*/ 592356 w 6886274"/>
              <a:gd name="connsiteY59" fmla="*/ 656966 h 5025119"/>
              <a:gd name="connsiteX60" fmla="*/ 485526 w 6886274"/>
              <a:gd name="connsiteY60" fmla="*/ 567259 h 5025119"/>
              <a:gd name="connsiteX61" fmla="*/ 430063 w 6886274"/>
              <a:gd name="connsiteY61" fmla="*/ 550136 h 5025119"/>
              <a:gd name="connsiteX62" fmla="*/ 408846 w 6886274"/>
              <a:gd name="connsiteY62" fmla="*/ 563164 h 5025119"/>
              <a:gd name="connsiteX63" fmla="*/ 421130 w 6886274"/>
              <a:gd name="connsiteY63" fmla="*/ 581403 h 5025119"/>
              <a:gd name="connsiteX64" fmla="*/ 426713 w 6886274"/>
              <a:gd name="connsiteY64" fmla="*/ 584009 h 5025119"/>
              <a:gd name="connsiteX65" fmla="*/ 487015 w 6886274"/>
              <a:gd name="connsiteY65" fmla="*/ 635005 h 5025119"/>
              <a:gd name="connsiteX66" fmla="*/ 487015 w 6886274"/>
              <a:gd name="connsiteY66" fmla="*/ 655105 h 5025119"/>
              <a:gd name="connsiteX67" fmla="*/ 497437 w 6886274"/>
              <a:gd name="connsiteY67" fmla="*/ 678183 h 5025119"/>
              <a:gd name="connsiteX68" fmla="*/ 539871 w 6886274"/>
              <a:gd name="connsiteY68" fmla="*/ 691584 h 5025119"/>
              <a:gd name="connsiteX69" fmla="*/ 485898 w 6886274"/>
              <a:gd name="connsiteY69" fmla="*/ 681906 h 5025119"/>
              <a:gd name="connsiteX70" fmla="*/ 410335 w 6886274"/>
              <a:gd name="connsiteY70" fmla="*/ 600387 h 5025119"/>
              <a:gd name="connsiteX71" fmla="*/ 397307 w 6886274"/>
              <a:gd name="connsiteY71" fmla="*/ 582892 h 5025119"/>
              <a:gd name="connsiteX72" fmla="*/ 363062 w 6886274"/>
              <a:gd name="connsiteY72" fmla="*/ 584009 h 5025119"/>
              <a:gd name="connsiteX73" fmla="*/ 334772 w 6886274"/>
              <a:gd name="connsiteY73" fmla="*/ 578426 h 5025119"/>
              <a:gd name="connsiteX74" fmla="*/ 281915 w 6886274"/>
              <a:gd name="connsiteY74" fmla="*/ 522219 h 5025119"/>
              <a:gd name="connsiteX75" fmla="*/ 263304 w 6886274"/>
              <a:gd name="connsiteY75" fmla="*/ 521846 h 5025119"/>
              <a:gd name="connsiteX76" fmla="*/ 263676 w 6886274"/>
              <a:gd name="connsiteY76" fmla="*/ 538225 h 5025119"/>
              <a:gd name="connsiteX77" fmla="*/ 275215 w 6886274"/>
              <a:gd name="connsiteY77" fmla="*/ 563164 h 5025119"/>
              <a:gd name="connsiteX78" fmla="*/ 271121 w 6886274"/>
              <a:gd name="connsiteY78" fmla="*/ 604854 h 5025119"/>
              <a:gd name="connsiteX79" fmla="*/ 274471 w 6886274"/>
              <a:gd name="connsiteY79" fmla="*/ 627560 h 5025119"/>
              <a:gd name="connsiteX80" fmla="*/ 319138 w 6886274"/>
              <a:gd name="connsiteY80" fmla="*/ 718012 h 5025119"/>
              <a:gd name="connsiteX81" fmla="*/ 326583 w 6886274"/>
              <a:gd name="connsiteY81" fmla="*/ 729551 h 5025119"/>
              <a:gd name="connsiteX82" fmla="*/ 349289 w 6886274"/>
              <a:gd name="connsiteY82" fmla="*/ 748163 h 5025119"/>
              <a:gd name="connsiteX83" fmla="*/ 528332 w 6886274"/>
              <a:gd name="connsiteY83" fmla="*/ 1007608 h 5025119"/>
              <a:gd name="connsiteX84" fmla="*/ 766932 w 6886274"/>
              <a:gd name="connsiteY84" fmla="*/ 1222758 h 5025119"/>
              <a:gd name="connsiteX85" fmla="*/ 681319 w 6886274"/>
              <a:gd name="connsiteY85" fmla="*/ 1190746 h 5025119"/>
              <a:gd name="connsiteX86" fmla="*/ 469520 w 6886274"/>
              <a:gd name="connsiteY86" fmla="*/ 1032920 h 5025119"/>
              <a:gd name="connsiteX87" fmla="*/ 325466 w 6886274"/>
              <a:gd name="connsiteY87" fmla="*/ 917900 h 5025119"/>
              <a:gd name="connsiteX88" fmla="*/ 312066 w 6886274"/>
              <a:gd name="connsiteY88" fmla="*/ 903383 h 5025119"/>
              <a:gd name="connsiteX89" fmla="*/ 296805 w 6886274"/>
              <a:gd name="connsiteY89" fmla="*/ 895566 h 5025119"/>
              <a:gd name="connsiteX90" fmla="*/ 288243 w 6886274"/>
              <a:gd name="connsiteY90" fmla="*/ 910828 h 5025119"/>
              <a:gd name="connsiteX91" fmla="*/ 309460 w 6886274"/>
              <a:gd name="connsiteY91" fmla="*/ 971129 h 5025119"/>
              <a:gd name="connsiteX92" fmla="*/ 407729 w 6886274"/>
              <a:gd name="connsiteY92" fmla="*/ 1062698 h 5025119"/>
              <a:gd name="connsiteX93" fmla="*/ 544338 w 6886274"/>
              <a:gd name="connsiteY93" fmla="*/ 1189257 h 5025119"/>
              <a:gd name="connsiteX94" fmla="*/ 454630 w 6886274"/>
              <a:gd name="connsiteY94" fmla="*/ 1120766 h 5025119"/>
              <a:gd name="connsiteX95" fmla="*/ 385396 w 6886274"/>
              <a:gd name="connsiteY95" fmla="*/ 1070515 h 5025119"/>
              <a:gd name="connsiteX96" fmla="*/ 366040 w 6886274"/>
              <a:gd name="connsiteY96" fmla="*/ 1067537 h 5025119"/>
              <a:gd name="connsiteX97" fmla="*/ 361573 w 6886274"/>
              <a:gd name="connsiteY97" fmla="*/ 1086149 h 5025119"/>
              <a:gd name="connsiteX98" fmla="*/ 402146 w 6886274"/>
              <a:gd name="connsiteY98" fmla="*/ 1152778 h 5025119"/>
              <a:gd name="connsiteX99" fmla="*/ 475475 w 6886274"/>
              <a:gd name="connsiteY99" fmla="*/ 1218663 h 5025119"/>
              <a:gd name="connsiteX100" fmla="*/ 393957 w 6886274"/>
              <a:gd name="connsiteY100" fmla="*/ 1201913 h 5025119"/>
              <a:gd name="connsiteX101" fmla="*/ 460586 w 6886274"/>
              <a:gd name="connsiteY101" fmla="*/ 1260353 h 5025119"/>
              <a:gd name="connsiteX102" fmla="*/ 561089 w 6886274"/>
              <a:gd name="connsiteY102" fmla="*/ 1291993 h 5025119"/>
              <a:gd name="connsiteX103" fmla="*/ 602034 w 6886274"/>
              <a:gd name="connsiteY103" fmla="*/ 1328843 h 5025119"/>
              <a:gd name="connsiteX104" fmla="*/ 641863 w 6886274"/>
              <a:gd name="connsiteY104" fmla="*/ 1368672 h 5025119"/>
              <a:gd name="connsiteX105" fmla="*/ 651541 w 6886274"/>
              <a:gd name="connsiteY105" fmla="*/ 1404406 h 5025119"/>
              <a:gd name="connsiteX106" fmla="*/ 688392 w 6886274"/>
              <a:gd name="connsiteY106" fmla="*/ 1457263 h 5025119"/>
              <a:gd name="connsiteX107" fmla="*/ 692486 w 6886274"/>
              <a:gd name="connsiteY107" fmla="*/ 1458008 h 5025119"/>
              <a:gd name="connsiteX108" fmla="*/ 719287 w 6886274"/>
              <a:gd name="connsiteY108" fmla="*/ 1485181 h 5025119"/>
              <a:gd name="connsiteX109" fmla="*/ 745343 w 6886274"/>
              <a:gd name="connsiteY109" fmla="*/ 1512353 h 5025119"/>
              <a:gd name="connsiteX110" fmla="*/ 750926 w 6886274"/>
              <a:gd name="connsiteY110" fmla="*/ 1516448 h 5025119"/>
              <a:gd name="connsiteX111" fmla="*/ 890141 w 6886274"/>
              <a:gd name="connsiteY111" fmla="*/ 1685813 h 5025119"/>
              <a:gd name="connsiteX112" fmla="*/ 899074 w 6886274"/>
              <a:gd name="connsiteY112" fmla="*/ 1693630 h 5025119"/>
              <a:gd name="connsiteX113" fmla="*/ 605012 w 6886274"/>
              <a:gd name="connsiteY113" fmla="*/ 1669435 h 5025119"/>
              <a:gd name="connsiteX114" fmla="*/ 229431 w 6886274"/>
              <a:gd name="connsiteY114" fmla="*/ 1545110 h 5025119"/>
              <a:gd name="connsiteX115" fmla="*/ 251765 w 6886274"/>
              <a:gd name="connsiteY115" fmla="*/ 1614717 h 5025119"/>
              <a:gd name="connsiteX116" fmla="*/ 237992 w 6886274"/>
              <a:gd name="connsiteY116" fmla="*/ 1675391 h 5025119"/>
              <a:gd name="connsiteX117" fmla="*/ 232781 w 6886274"/>
              <a:gd name="connsiteY117" fmla="*/ 1807160 h 5025119"/>
              <a:gd name="connsiteX118" fmla="*/ 236131 w 6886274"/>
              <a:gd name="connsiteY118" fmla="*/ 1828750 h 5025119"/>
              <a:gd name="connsiteX119" fmla="*/ 152007 w 6886274"/>
              <a:gd name="connsiteY119" fmla="*/ 1842150 h 5025119"/>
              <a:gd name="connsiteX120" fmla="*/ 653030 w 6886274"/>
              <a:gd name="connsiteY120" fmla="*/ 2213265 h 5025119"/>
              <a:gd name="connsiteX121" fmla="*/ 318394 w 6886274"/>
              <a:gd name="connsiteY121" fmla="*/ 2143285 h 5025119"/>
              <a:gd name="connsiteX122" fmla="*/ 272982 w 6886274"/>
              <a:gd name="connsiteY122" fmla="*/ 2258305 h 5025119"/>
              <a:gd name="connsiteX123" fmla="*/ 430435 w 6886274"/>
              <a:gd name="connsiteY123" fmla="*/ 2360668 h 5025119"/>
              <a:gd name="connsiteX124" fmla="*/ 488876 w 6886274"/>
              <a:gd name="connsiteY124" fmla="*/ 2563162 h 5025119"/>
              <a:gd name="connsiteX125" fmla="*/ 460586 w 6886274"/>
              <a:gd name="connsiteY125" fmla="*/ 2748533 h 5025119"/>
              <a:gd name="connsiteX126" fmla="*/ 393212 w 6886274"/>
              <a:gd name="connsiteY126" fmla="*/ 2807345 h 5025119"/>
              <a:gd name="connsiteX127" fmla="*/ 295688 w 6886274"/>
              <a:gd name="connsiteY127" fmla="*/ 2913059 h 5025119"/>
              <a:gd name="connsiteX128" fmla="*/ 235386 w 6886274"/>
              <a:gd name="connsiteY128" fmla="*/ 2978572 h 5025119"/>
              <a:gd name="connsiteX129" fmla="*/ 25448 w 6886274"/>
              <a:gd name="connsiteY129" fmla="*/ 2952888 h 5025119"/>
              <a:gd name="connsiteX130" fmla="*/ 305738 w 6886274"/>
              <a:gd name="connsiteY130" fmla="*/ 3119275 h 5025119"/>
              <a:gd name="connsiteX131" fmla="*/ 79049 w 6886274"/>
              <a:gd name="connsiteY131" fmla="*/ 3098430 h 5025119"/>
              <a:gd name="connsiteX132" fmla="*/ 4975 w 6886274"/>
              <a:gd name="connsiteY132" fmla="*/ 3109969 h 5025119"/>
              <a:gd name="connsiteX133" fmla="*/ 47037 w 6886274"/>
              <a:gd name="connsiteY133" fmla="*/ 3163943 h 5025119"/>
              <a:gd name="connsiteX134" fmla="*/ 213425 w 6886274"/>
              <a:gd name="connsiteY134" fmla="*/ 3255139 h 5025119"/>
              <a:gd name="connsiteX135" fmla="*/ 556622 w 6886274"/>
              <a:gd name="connsiteY135" fmla="*/ 3502301 h 5025119"/>
              <a:gd name="connsiteX136" fmla="*/ 224592 w 6886274"/>
              <a:gd name="connsiteY136" fmla="*/ 3388771 h 5025119"/>
              <a:gd name="connsiteX137" fmla="*/ 574861 w 6886274"/>
              <a:gd name="connsiteY137" fmla="*/ 3643004 h 5025119"/>
              <a:gd name="connsiteX138" fmla="*/ 652657 w 6886274"/>
              <a:gd name="connsiteY138" fmla="*/ 3727501 h 5025119"/>
              <a:gd name="connsiteX139" fmla="*/ 810111 w 6886274"/>
              <a:gd name="connsiteY139" fmla="*/ 3937067 h 5025119"/>
              <a:gd name="connsiteX140" fmla="*/ 802294 w 6886274"/>
              <a:gd name="connsiteY140" fmla="*/ 3960890 h 5025119"/>
              <a:gd name="connsiteX141" fmla="*/ 620646 w 6886274"/>
              <a:gd name="connsiteY141" fmla="*/ 3927017 h 5025119"/>
              <a:gd name="connsiteX142" fmla="*/ 856268 w 6886274"/>
              <a:gd name="connsiteY142" fmla="*/ 4103082 h 5025119"/>
              <a:gd name="connsiteX143" fmla="*/ 1099707 w 6886274"/>
              <a:gd name="connsiteY143" fmla="*/ 4238574 h 5025119"/>
              <a:gd name="connsiteX144" fmla="*/ 926992 w 6886274"/>
              <a:gd name="connsiteY144" fmla="*/ 4218102 h 5025119"/>
              <a:gd name="connsiteX145" fmla="*/ 689508 w 6886274"/>
              <a:gd name="connsiteY145" fmla="*/ 4140677 h 5025119"/>
              <a:gd name="connsiteX146" fmla="*/ 606873 w 6886274"/>
              <a:gd name="connsiteY146" fmla="*/ 4169711 h 5025119"/>
              <a:gd name="connsiteX147" fmla="*/ 831701 w 6886274"/>
              <a:gd name="connsiteY147" fmla="*/ 4297759 h 5025119"/>
              <a:gd name="connsiteX148" fmla="*/ 960493 w 6886274"/>
              <a:gd name="connsiteY148" fmla="*/ 4356944 h 5025119"/>
              <a:gd name="connsiteX149" fmla="*/ 1012233 w 6886274"/>
              <a:gd name="connsiteY149" fmla="*/ 4402356 h 5025119"/>
              <a:gd name="connsiteX150" fmla="*/ 1159636 w 6886274"/>
              <a:gd name="connsiteY150" fmla="*/ 4564276 h 5025119"/>
              <a:gd name="connsiteX151" fmla="*/ 1592169 w 6886274"/>
              <a:gd name="connsiteY151" fmla="*/ 4741458 h 5025119"/>
              <a:gd name="connsiteX152" fmla="*/ 3110499 w 6886274"/>
              <a:gd name="connsiteY152" fmla="*/ 5032171 h 5025119"/>
              <a:gd name="connsiteX153" fmla="*/ 6033630 w 6886274"/>
              <a:gd name="connsiteY153" fmla="*/ 4091915 h 5025119"/>
              <a:gd name="connsiteX154" fmla="*/ 6180661 w 6886274"/>
              <a:gd name="connsiteY154" fmla="*/ 3957912 h 5025119"/>
              <a:gd name="connsiteX155" fmla="*/ 6305359 w 6886274"/>
              <a:gd name="connsiteY155" fmla="*/ 3837309 h 5025119"/>
              <a:gd name="connsiteX156" fmla="*/ 6240218 w 6886274"/>
              <a:gd name="connsiteY156" fmla="*/ 3796364 h 5025119"/>
              <a:gd name="connsiteX157" fmla="*/ 6328437 w 6886274"/>
              <a:gd name="connsiteY157" fmla="*/ 3681344 h 5025119"/>
              <a:gd name="connsiteX158" fmla="*/ 6608355 w 6886274"/>
              <a:gd name="connsiteY158" fmla="*/ 3326236 h 5025119"/>
              <a:gd name="connsiteX159" fmla="*/ 6731191 w 6886274"/>
              <a:gd name="connsiteY159" fmla="*/ 3248067 h 5025119"/>
              <a:gd name="connsiteX160" fmla="*/ 6880456 w 6886274"/>
              <a:gd name="connsiteY160" fmla="*/ 3051529 h 5025119"/>
              <a:gd name="connsiteX161" fmla="*/ 6901673 w 6886274"/>
              <a:gd name="connsiteY161" fmla="*/ 2763795 h 5025119"/>
              <a:gd name="connsiteX162" fmla="*/ 6871150 w 6886274"/>
              <a:gd name="connsiteY162" fmla="*/ 2948421 h 5025119"/>
              <a:gd name="connsiteX163" fmla="*/ 6848444 w 6886274"/>
              <a:gd name="connsiteY163" fmla="*/ 2890353 h 5025119"/>
              <a:gd name="connsiteX164" fmla="*/ 6878223 w 6886274"/>
              <a:gd name="connsiteY164" fmla="*/ 2873230 h 5025119"/>
              <a:gd name="connsiteX165" fmla="*/ 6762459 w 6886274"/>
              <a:gd name="connsiteY165" fmla="*/ 2568745 h 5025119"/>
              <a:gd name="connsiteX166" fmla="*/ 6673123 w 6886274"/>
              <a:gd name="connsiteY166" fmla="*/ 2451493 h 5025119"/>
              <a:gd name="connsiteX167" fmla="*/ 6662700 w 6886274"/>
              <a:gd name="connsiteY167" fmla="*/ 2346896 h 5025119"/>
              <a:gd name="connsiteX168" fmla="*/ 6487752 w 6886274"/>
              <a:gd name="connsiteY168" fmla="*/ 2285105 h 5025119"/>
              <a:gd name="connsiteX169" fmla="*/ 6652278 w 6886274"/>
              <a:gd name="connsiteY169" fmla="*/ 2063628 h 5025119"/>
              <a:gd name="connsiteX170" fmla="*/ 6668656 w 6886274"/>
              <a:gd name="connsiteY170" fmla="*/ 2017843 h 5025119"/>
              <a:gd name="connsiteX171" fmla="*/ 6570015 w 6886274"/>
              <a:gd name="connsiteY171" fmla="*/ 1854062 h 5025119"/>
              <a:gd name="connsiteX172" fmla="*/ 6554009 w 6886274"/>
              <a:gd name="connsiteY172" fmla="*/ 1827633 h 5025119"/>
              <a:gd name="connsiteX173" fmla="*/ 6517531 w 6886274"/>
              <a:gd name="connsiteY173" fmla="*/ 1775149 h 5025119"/>
              <a:gd name="connsiteX174" fmla="*/ 6412934 w 6886274"/>
              <a:gd name="connsiteY174" fmla="*/ 1762493 h 5025119"/>
              <a:gd name="connsiteX175" fmla="*/ 6467279 w 6886274"/>
              <a:gd name="connsiteY175" fmla="*/ 1725642 h 5025119"/>
              <a:gd name="connsiteX176" fmla="*/ 6572621 w 6886274"/>
              <a:gd name="connsiteY176" fmla="*/ 1600200 h 5025119"/>
              <a:gd name="connsiteX177" fmla="*/ 6502641 w 6886274"/>
              <a:gd name="connsiteY177" fmla="*/ 1480341 h 5025119"/>
              <a:gd name="connsiteX178" fmla="*/ 6481796 w 6886274"/>
              <a:gd name="connsiteY178" fmla="*/ 1461358 h 5025119"/>
              <a:gd name="connsiteX179" fmla="*/ 6509713 w 6886274"/>
              <a:gd name="connsiteY179" fmla="*/ 1436418 h 5025119"/>
              <a:gd name="connsiteX180" fmla="*/ 6567037 w 6886274"/>
              <a:gd name="connsiteY180" fmla="*/ 1348199 h 5025119"/>
              <a:gd name="connsiteX181" fmla="*/ 6596816 w 6886274"/>
              <a:gd name="connsiteY181" fmla="*/ 1286781 h 5025119"/>
              <a:gd name="connsiteX182" fmla="*/ 6632178 w 6886274"/>
              <a:gd name="connsiteY182" fmla="*/ 1261842 h 5025119"/>
              <a:gd name="connsiteX183" fmla="*/ 6639994 w 6886274"/>
              <a:gd name="connsiteY183" fmla="*/ 1240625 h 5025119"/>
              <a:gd name="connsiteX184" fmla="*/ 6622127 w 6886274"/>
              <a:gd name="connsiteY184" fmla="*/ 1136400 h 5025119"/>
              <a:gd name="connsiteX185" fmla="*/ 6612077 w 6886274"/>
              <a:gd name="connsiteY185" fmla="*/ 1109599 h 5025119"/>
              <a:gd name="connsiteX186" fmla="*/ 6531675 w 6886274"/>
              <a:gd name="connsiteY186" fmla="*/ 1009469 h 5025119"/>
              <a:gd name="connsiteX187" fmla="*/ 6456113 w 6886274"/>
              <a:gd name="connsiteY187" fmla="*/ 845315 h 5025119"/>
              <a:gd name="connsiteX188" fmla="*/ 6440851 w 6886274"/>
              <a:gd name="connsiteY188" fmla="*/ 739229 h 5025119"/>
              <a:gd name="connsiteX189" fmla="*/ 6434523 w 6886274"/>
              <a:gd name="connsiteY189" fmla="*/ 715034 h 5025119"/>
              <a:gd name="connsiteX190" fmla="*/ 6432290 w 6886274"/>
              <a:gd name="connsiteY190" fmla="*/ 617510 h 5025119"/>
              <a:gd name="connsiteX191" fmla="*/ 6416284 w 6886274"/>
              <a:gd name="connsiteY191" fmla="*/ 595176 h 5025119"/>
              <a:gd name="connsiteX192" fmla="*/ 6267763 w 6886274"/>
              <a:gd name="connsiteY192" fmla="*/ 591826 h 5025119"/>
              <a:gd name="connsiteX193" fmla="*/ 6236496 w 6886274"/>
              <a:gd name="connsiteY193" fmla="*/ 521102 h 5025119"/>
              <a:gd name="connsiteX194" fmla="*/ 6257341 w 6886274"/>
              <a:gd name="connsiteY194" fmla="*/ 487229 h 5025119"/>
              <a:gd name="connsiteX195" fmla="*/ 6248780 w 6886274"/>
              <a:gd name="connsiteY195" fmla="*/ 465267 h 5025119"/>
              <a:gd name="connsiteX196" fmla="*/ 6226818 w 6886274"/>
              <a:gd name="connsiteY196" fmla="*/ 473456 h 5025119"/>
              <a:gd name="connsiteX197" fmla="*/ 6115149 w 6886274"/>
              <a:gd name="connsiteY197" fmla="*/ 551625 h 5025119"/>
              <a:gd name="connsiteX198" fmla="*/ 5951739 w 6886274"/>
              <a:gd name="connsiteY198" fmla="*/ 659944 h 5025119"/>
              <a:gd name="connsiteX199" fmla="*/ 5917122 w 6886274"/>
              <a:gd name="connsiteY199" fmla="*/ 644310 h 5025119"/>
              <a:gd name="connsiteX200" fmla="*/ 5890694 w 6886274"/>
              <a:gd name="connsiteY200" fmla="*/ 630538 h 5025119"/>
              <a:gd name="connsiteX201" fmla="*/ 5837464 w 6886274"/>
              <a:gd name="connsiteY201" fmla="*/ 646916 h 5025119"/>
              <a:gd name="connsiteX202" fmla="*/ 5809175 w 6886274"/>
              <a:gd name="connsiteY202" fmla="*/ 683395 h 5025119"/>
              <a:gd name="connsiteX203" fmla="*/ 5815503 w 6886274"/>
              <a:gd name="connsiteY203" fmla="*/ 698656 h 5025119"/>
              <a:gd name="connsiteX204" fmla="*/ 5746268 w 6886274"/>
              <a:gd name="connsiteY204" fmla="*/ 667389 h 5025119"/>
              <a:gd name="connsiteX205" fmla="*/ 5458905 w 6886274"/>
              <a:gd name="connsiteY205" fmla="*/ 754119 h 5025119"/>
              <a:gd name="connsiteX206" fmla="*/ 885302 w 6886274"/>
              <a:gd name="connsiteY206" fmla="*/ 1333310 h 5025119"/>
              <a:gd name="connsiteX207" fmla="*/ 862596 w 6886274"/>
              <a:gd name="connsiteY207" fmla="*/ 1314326 h 5025119"/>
              <a:gd name="connsiteX208" fmla="*/ 866318 w 6886274"/>
              <a:gd name="connsiteY208" fmla="*/ 1309860 h 5025119"/>
              <a:gd name="connsiteX209" fmla="*/ 912103 w 6886274"/>
              <a:gd name="connsiteY209" fmla="*/ 1341127 h 5025119"/>
              <a:gd name="connsiteX210" fmla="*/ 885302 w 6886274"/>
              <a:gd name="connsiteY210" fmla="*/ 1333310 h 5025119"/>
              <a:gd name="connsiteX211" fmla="*/ 1140280 w 6886274"/>
              <a:gd name="connsiteY211" fmla="*/ 787619 h 5025119"/>
              <a:gd name="connsiteX212" fmla="*/ 1414987 w 6886274"/>
              <a:gd name="connsiteY212" fmla="*/ 975596 h 5025119"/>
              <a:gd name="connsiteX213" fmla="*/ 1410892 w 6886274"/>
              <a:gd name="connsiteY213" fmla="*/ 980063 h 5025119"/>
              <a:gd name="connsiteX214" fmla="*/ 1140280 w 6886274"/>
              <a:gd name="connsiteY214" fmla="*/ 787619 h 502511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Lst>
            <a:rect l="l" t="t" r="r" b="b"/>
            <a:pathLst>
              <a:path w="6886274" h="5025119">
                <a:moveTo>
                  <a:pt x="5458905" y="754119"/>
                </a:moveTo>
                <a:cubicBezTo>
                  <a:pt x="5417216" y="775336"/>
                  <a:pt x="4594585" y="1111088"/>
                  <a:pt x="3455557" y="1027709"/>
                </a:cubicBezTo>
                <a:cubicBezTo>
                  <a:pt x="3415356" y="1024731"/>
                  <a:pt x="3377389" y="1022869"/>
                  <a:pt x="3338677" y="1021381"/>
                </a:cubicBezTo>
                <a:cubicBezTo>
                  <a:pt x="2996224" y="1006119"/>
                  <a:pt x="2660100" y="998674"/>
                  <a:pt x="2518280" y="980435"/>
                </a:cubicBezTo>
                <a:cubicBezTo>
                  <a:pt x="2407355" y="965918"/>
                  <a:pt x="1840075" y="843082"/>
                  <a:pt x="1673687" y="739229"/>
                </a:cubicBezTo>
                <a:cubicBezTo>
                  <a:pt x="1503578" y="632771"/>
                  <a:pt x="1343146" y="515146"/>
                  <a:pt x="1183459" y="397149"/>
                </a:cubicBezTo>
                <a:cubicBezTo>
                  <a:pt x="1114224" y="346153"/>
                  <a:pt x="1040522" y="299624"/>
                  <a:pt x="977987" y="241184"/>
                </a:cubicBezTo>
                <a:cubicBezTo>
                  <a:pt x="915453" y="182372"/>
                  <a:pt x="855896" y="121326"/>
                  <a:pt x="788150" y="66980"/>
                </a:cubicBezTo>
                <a:cubicBezTo>
                  <a:pt x="768794" y="51346"/>
                  <a:pt x="749438" y="34596"/>
                  <a:pt x="721148" y="31990"/>
                </a:cubicBezTo>
                <a:cubicBezTo>
                  <a:pt x="714820" y="31246"/>
                  <a:pt x="708120" y="31618"/>
                  <a:pt x="701792" y="32362"/>
                </a:cubicBezTo>
                <a:cubicBezTo>
                  <a:pt x="694720" y="33107"/>
                  <a:pt x="689136" y="36829"/>
                  <a:pt x="686530" y="43157"/>
                </a:cubicBezTo>
                <a:cubicBezTo>
                  <a:pt x="683925" y="50230"/>
                  <a:pt x="688392" y="54324"/>
                  <a:pt x="693603" y="58046"/>
                </a:cubicBezTo>
                <a:cubicBezTo>
                  <a:pt x="697325" y="60652"/>
                  <a:pt x="701047" y="64747"/>
                  <a:pt x="705886" y="65491"/>
                </a:cubicBezTo>
                <a:cubicBezTo>
                  <a:pt x="736782" y="69958"/>
                  <a:pt x="748321" y="92664"/>
                  <a:pt x="762838" y="112764"/>
                </a:cubicBezTo>
                <a:cubicBezTo>
                  <a:pt x="769166" y="121326"/>
                  <a:pt x="775866" y="128026"/>
                  <a:pt x="764327" y="140309"/>
                </a:cubicBezTo>
                <a:cubicBezTo>
                  <a:pt x="754277" y="151104"/>
                  <a:pt x="764699" y="156688"/>
                  <a:pt x="775121" y="159666"/>
                </a:cubicBezTo>
                <a:cubicBezTo>
                  <a:pt x="789638" y="163760"/>
                  <a:pt x="806761" y="163016"/>
                  <a:pt x="823139" y="176416"/>
                </a:cubicBezTo>
                <a:cubicBezTo>
                  <a:pt x="761721" y="177533"/>
                  <a:pt x="735665" y="142171"/>
                  <a:pt x="707748" y="109414"/>
                </a:cubicBezTo>
                <a:cubicBezTo>
                  <a:pt x="697325" y="97503"/>
                  <a:pt x="690253" y="83358"/>
                  <a:pt x="681319" y="69958"/>
                </a:cubicBezTo>
                <a:cubicBezTo>
                  <a:pt x="670152" y="53580"/>
                  <a:pt x="657124" y="52835"/>
                  <a:pt x="640746" y="67352"/>
                </a:cubicBezTo>
                <a:cubicBezTo>
                  <a:pt x="626229" y="80380"/>
                  <a:pt x="619157" y="79264"/>
                  <a:pt x="614318" y="61396"/>
                </a:cubicBezTo>
                <a:cubicBezTo>
                  <a:pt x="606873" y="33479"/>
                  <a:pt x="589750" y="13751"/>
                  <a:pt x="560716" y="3701"/>
                </a:cubicBezTo>
                <a:cubicBezTo>
                  <a:pt x="554388" y="1467"/>
                  <a:pt x="546572" y="-3372"/>
                  <a:pt x="540616" y="3701"/>
                </a:cubicBezTo>
                <a:cubicBezTo>
                  <a:pt x="535405" y="9656"/>
                  <a:pt x="539871" y="16729"/>
                  <a:pt x="543594" y="21940"/>
                </a:cubicBezTo>
                <a:cubicBezTo>
                  <a:pt x="550294" y="31246"/>
                  <a:pt x="556250" y="40179"/>
                  <a:pt x="558855" y="51346"/>
                </a:cubicBezTo>
                <a:cubicBezTo>
                  <a:pt x="560716" y="58791"/>
                  <a:pt x="562578" y="66980"/>
                  <a:pt x="557366" y="72563"/>
                </a:cubicBezTo>
                <a:cubicBezTo>
                  <a:pt x="535777" y="96386"/>
                  <a:pt x="551411" y="107553"/>
                  <a:pt x="570022" y="120209"/>
                </a:cubicBezTo>
                <a:cubicBezTo>
                  <a:pt x="595706" y="137332"/>
                  <a:pt x="605756" y="162643"/>
                  <a:pt x="599801" y="192794"/>
                </a:cubicBezTo>
                <a:cubicBezTo>
                  <a:pt x="597567" y="205078"/>
                  <a:pt x="599056" y="212522"/>
                  <a:pt x="614318" y="212150"/>
                </a:cubicBezTo>
                <a:cubicBezTo>
                  <a:pt x="620273" y="212150"/>
                  <a:pt x="621762" y="216245"/>
                  <a:pt x="623996" y="220711"/>
                </a:cubicBezTo>
                <a:cubicBezTo>
                  <a:pt x="671641" y="326053"/>
                  <a:pt x="740504" y="418366"/>
                  <a:pt x="821278" y="503235"/>
                </a:cubicBezTo>
                <a:cubicBezTo>
                  <a:pt x="886791" y="572098"/>
                  <a:pt x="959004" y="634260"/>
                  <a:pt x="1033822" y="694562"/>
                </a:cubicBezTo>
                <a:cubicBezTo>
                  <a:pt x="1036055" y="696423"/>
                  <a:pt x="1038289" y="698656"/>
                  <a:pt x="1039406" y="702378"/>
                </a:cubicBezTo>
                <a:cubicBezTo>
                  <a:pt x="1004044" y="694934"/>
                  <a:pt x="973521" y="679672"/>
                  <a:pt x="944114" y="662550"/>
                </a:cubicBezTo>
                <a:cubicBezTo>
                  <a:pt x="865946" y="617138"/>
                  <a:pt x="800061" y="558325"/>
                  <a:pt x="733432" y="500629"/>
                </a:cubicBezTo>
                <a:cubicBezTo>
                  <a:pt x="692858" y="465267"/>
                  <a:pt x="651169" y="431022"/>
                  <a:pt x="606501" y="399755"/>
                </a:cubicBezTo>
                <a:cubicBezTo>
                  <a:pt x="599056" y="394543"/>
                  <a:pt x="593845" y="387843"/>
                  <a:pt x="588634" y="381143"/>
                </a:cubicBezTo>
                <a:cubicBezTo>
                  <a:pt x="585656" y="377421"/>
                  <a:pt x="581934" y="374071"/>
                  <a:pt x="575978" y="375560"/>
                </a:cubicBezTo>
                <a:cubicBezTo>
                  <a:pt x="568533" y="377421"/>
                  <a:pt x="567789" y="383004"/>
                  <a:pt x="567044" y="388588"/>
                </a:cubicBezTo>
                <a:cubicBezTo>
                  <a:pt x="564811" y="406455"/>
                  <a:pt x="569650" y="422461"/>
                  <a:pt x="578956" y="437722"/>
                </a:cubicBezTo>
                <a:cubicBezTo>
                  <a:pt x="603151" y="476806"/>
                  <a:pt x="638885" y="506957"/>
                  <a:pt x="675736" y="535619"/>
                </a:cubicBezTo>
                <a:cubicBezTo>
                  <a:pt x="723381" y="572470"/>
                  <a:pt x="769538" y="610810"/>
                  <a:pt x="811600" y="652872"/>
                </a:cubicBezTo>
                <a:cubicBezTo>
                  <a:pt x="814578" y="655850"/>
                  <a:pt x="820161" y="657711"/>
                  <a:pt x="818300" y="666272"/>
                </a:cubicBezTo>
                <a:cubicBezTo>
                  <a:pt x="791872" y="646544"/>
                  <a:pt x="766932" y="627188"/>
                  <a:pt x="741621" y="608576"/>
                </a:cubicBezTo>
                <a:cubicBezTo>
                  <a:pt x="716681" y="589965"/>
                  <a:pt x="691369" y="571353"/>
                  <a:pt x="666430" y="553114"/>
                </a:cubicBezTo>
                <a:cubicBezTo>
                  <a:pt x="660474" y="548647"/>
                  <a:pt x="654146" y="542319"/>
                  <a:pt x="645585" y="547903"/>
                </a:cubicBezTo>
                <a:cubicBezTo>
                  <a:pt x="636652" y="553486"/>
                  <a:pt x="637768" y="562792"/>
                  <a:pt x="640002" y="570236"/>
                </a:cubicBezTo>
                <a:cubicBezTo>
                  <a:pt x="647074" y="592198"/>
                  <a:pt x="659358" y="611554"/>
                  <a:pt x="675736" y="628677"/>
                </a:cubicBezTo>
                <a:cubicBezTo>
                  <a:pt x="731570" y="685256"/>
                  <a:pt x="795966" y="734018"/>
                  <a:pt x="855896" y="786875"/>
                </a:cubicBezTo>
                <a:cubicBezTo>
                  <a:pt x="888280" y="815537"/>
                  <a:pt x="918058" y="846060"/>
                  <a:pt x="946348" y="877699"/>
                </a:cubicBezTo>
                <a:cubicBezTo>
                  <a:pt x="952676" y="884772"/>
                  <a:pt x="952303" y="891472"/>
                  <a:pt x="950442" y="899661"/>
                </a:cubicBezTo>
                <a:cubicBezTo>
                  <a:pt x="942998" y="932790"/>
                  <a:pt x="954537" y="943957"/>
                  <a:pt x="991760" y="937629"/>
                </a:cubicBezTo>
                <a:cubicBezTo>
                  <a:pt x="1003299" y="935767"/>
                  <a:pt x="1011116" y="937629"/>
                  <a:pt x="1018188" y="945445"/>
                </a:cubicBezTo>
                <a:cubicBezTo>
                  <a:pt x="1103802" y="1042225"/>
                  <a:pt x="1205048" y="1123744"/>
                  <a:pt x="1315601" y="1196329"/>
                </a:cubicBezTo>
                <a:cubicBezTo>
                  <a:pt x="1360641" y="1225735"/>
                  <a:pt x="1407170" y="1253653"/>
                  <a:pt x="1454443" y="1279709"/>
                </a:cubicBezTo>
                <a:cubicBezTo>
                  <a:pt x="1454443" y="1281570"/>
                  <a:pt x="1454443" y="1283804"/>
                  <a:pt x="1454443" y="1285665"/>
                </a:cubicBezTo>
                <a:cubicBezTo>
                  <a:pt x="1454071" y="1288270"/>
                  <a:pt x="1453699" y="1289759"/>
                  <a:pt x="1453327" y="1291993"/>
                </a:cubicBezTo>
                <a:cubicBezTo>
                  <a:pt x="1386697" y="1251792"/>
                  <a:pt x="1320812" y="1210474"/>
                  <a:pt x="1256416" y="1166923"/>
                </a:cubicBezTo>
                <a:cubicBezTo>
                  <a:pt x="1081840" y="1048926"/>
                  <a:pt x="915080" y="922367"/>
                  <a:pt x="745715" y="798786"/>
                </a:cubicBezTo>
                <a:cubicBezTo>
                  <a:pt x="688764" y="757096"/>
                  <a:pt x="643724" y="703867"/>
                  <a:pt x="592356" y="656966"/>
                </a:cubicBezTo>
                <a:cubicBezTo>
                  <a:pt x="558111" y="625699"/>
                  <a:pt x="525354" y="592943"/>
                  <a:pt x="485526" y="567259"/>
                </a:cubicBezTo>
                <a:cubicBezTo>
                  <a:pt x="469148" y="556836"/>
                  <a:pt x="452025" y="547530"/>
                  <a:pt x="430063" y="550136"/>
                </a:cubicBezTo>
                <a:cubicBezTo>
                  <a:pt x="421502" y="551253"/>
                  <a:pt x="411824" y="553486"/>
                  <a:pt x="408846" y="563164"/>
                </a:cubicBezTo>
                <a:cubicBezTo>
                  <a:pt x="406240" y="572842"/>
                  <a:pt x="414057" y="577309"/>
                  <a:pt x="421130" y="581403"/>
                </a:cubicBezTo>
                <a:cubicBezTo>
                  <a:pt x="422991" y="582520"/>
                  <a:pt x="424852" y="584009"/>
                  <a:pt x="426713" y="584009"/>
                </a:cubicBezTo>
                <a:cubicBezTo>
                  <a:pt x="462075" y="586242"/>
                  <a:pt x="470264" y="614532"/>
                  <a:pt x="487015" y="635005"/>
                </a:cubicBezTo>
                <a:cubicBezTo>
                  <a:pt x="492226" y="641333"/>
                  <a:pt x="492598" y="647661"/>
                  <a:pt x="487015" y="655105"/>
                </a:cubicBezTo>
                <a:cubicBezTo>
                  <a:pt x="476964" y="668505"/>
                  <a:pt x="484037" y="674461"/>
                  <a:pt x="497437" y="678183"/>
                </a:cubicBezTo>
                <a:cubicBezTo>
                  <a:pt x="510837" y="681906"/>
                  <a:pt x="525354" y="683022"/>
                  <a:pt x="539871" y="691584"/>
                </a:cubicBezTo>
                <a:cubicBezTo>
                  <a:pt x="516793" y="698656"/>
                  <a:pt x="500787" y="691212"/>
                  <a:pt x="485898" y="681906"/>
                </a:cubicBezTo>
                <a:cubicBezTo>
                  <a:pt x="452397" y="661433"/>
                  <a:pt x="430808" y="631282"/>
                  <a:pt x="410335" y="600387"/>
                </a:cubicBezTo>
                <a:cubicBezTo>
                  <a:pt x="406240" y="594431"/>
                  <a:pt x="402890" y="587731"/>
                  <a:pt x="397307" y="582892"/>
                </a:cubicBezTo>
                <a:cubicBezTo>
                  <a:pt x="386884" y="573214"/>
                  <a:pt x="375717" y="572098"/>
                  <a:pt x="363062" y="584009"/>
                </a:cubicBezTo>
                <a:cubicBezTo>
                  <a:pt x="346311" y="599643"/>
                  <a:pt x="340356" y="598526"/>
                  <a:pt x="334772" y="578426"/>
                </a:cubicBezTo>
                <a:cubicBezTo>
                  <a:pt x="327327" y="551253"/>
                  <a:pt x="310577" y="532269"/>
                  <a:pt x="281915" y="522219"/>
                </a:cubicBezTo>
                <a:cubicBezTo>
                  <a:pt x="275960" y="519985"/>
                  <a:pt x="269632" y="517007"/>
                  <a:pt x="263304" y="521846"/>
                </a:cubicBezTo>
                <a:cubicBezTo>
                  <a:pt x="256604" y="527430"/>
                  <a:pt x="261070" y="533013"/>
                  <a:pt x="263676" y="538225"/>
                </a:cubicBezTo>
                <a:cubicBezTo>
                  <a:pt x="267398" y="546414"/>
                  <a:pt x="271865" y="554603"/>
                  <a:pt x="275215" y="563164"/>
                </a:cubicBezTo>
                <a:cubicBezTo>
                  <a:pt x="281171" y="576937"/>
                  <a:pt x="282288" y="591454"/>
                  <a:pt x="271121" y="604854"/>
                </a:cubicBezTo>
                <a:cubicBezTo>
                  <a:pt x="262931" y="614532"/>
                  <a:pt x="263676" y="620860"/>
                  <a:pt x="274471" y="627560"/>
                </a:cubicBezTo>
                <a:cubicBezTo>
                  <a:pt x="309088" y="648405"/>
                  <a:pt x="331050" y="675578"/>
                  <a:pt x="319138" y="718012"/>
                </a:cubicBezTo>
                <a:cubicBezTo>
                  <a:pt x="317277" y="723968"/>
                  <a:pt x="319511" y="729924"/>
                  <a:pt x="326583" y="729551"/>
                </a:cubicBezTo>
                <a:cubicBezTo>
                  <a:pt x="342217" y="728435"/>
                  <a:pt x="344822" y="738113"/>
                  <a:pt x="349289" y="748163"/>
                </a:cubicBezTo>
                <a:cubicBezTo>
                  <a:pt x="392840" y="844571"/>
                  <a:pt x="455747" y="928695"/>
                  <a:pt x="528332" y="1007608"/>
                </a:cubicBezTo>
                <a:cubicBezTo>
                  <a:pt x="600173" y="1085777"/>
                  <a:pt x="680947" y="1155756"/>
                  <a:pt x="766932" y="1222758"/>
                </a:cubicBezTo>
                <a:cubicBezTo>
                  <a:pt x="742737" y="1220524"/>
                  <a:pt x="711470" y="1206752"/>
                  <a:pt x="681319" y="1190746"/>
                </a:cubicBezTo>
                <a:cubicBezTo>
                  <a:pt x="601662" y="1147939"/>
                  <a:pt x="536149" y="1089871"/>
                  <a:pt x="469520" y="1032920"/>
                </a:cubicBezTo>
                <a:cubicBezTo>
                  <a:pt x="422991" y="993091"/>
                  <a:pt x="377579" y="952146"/>
                  <a:pt x="325466" y="917900"/>
                </a:cubicBezTo>
                <a:cubicBezTo>
                  <a:pt x="319511" y="914178"/>
                  <a:pt x="315416" y="909339"/>
                  <a:pt x="312066" y="903383"/>
                </a:cubicBezTo>
                <a:cubicBezTo>
                  <a:pt x="309088" y="898172"/>
                  <a:pt x="304621" y="893333"/>
                  <a:pt x="296805" y="895566"/>
                </a:cubicBezTo>
                <a:cubicBezTo>
                  <a:pt x="288988" y="898172"/>
                  <a:pt x="288243" y="904872"/>
                  <a:pt x="288243" y="910828"/>
                </a:cubicBezTo>
                <a:cubicBezTo>
                  <a:pt x="289360" y="933162"/>
                  <a:pt x="295688" y="953262"/>
                  <a:pt x="309460" y="971129"/>
                </a:cubicBezTo>
                <a:cubicBezTo>
                  <a:pt x="336261" y="1006864"/>
                  <a:pt x="371995" y="1034781"/>
                  <a:pt x="407729" y="1062698"/>
                </a:cubicBezTo>
                <a:cubicBezTo>
                  <a:pt x="457236" y="1101038"/>
                  <a:pt x="503021" y="1142728"/>
                  <a:pt x="544338" y="1189257"/>
                </a:cubicBezTo>
                <a:cubicBezTo>
                  <a:pt x="514560" y="1166551"/>
                  <a:pt x="484781" y="1143472"/>
                  <a:pt x="454630" y="1120766"/>
                </a:cubicBezTo>
                <a:cubicBezTo>
                  <a:pt x="431924" y="1103644"/>
                  <a:pt x="408474" y="1087265"/>
                  <a:pt x="385396" y="1070515"/>
                </a:cubicBezTo>
                <a:cubicBezTo>
                  <a:pt x="379812" y="1066421"/>
                  <a:pt x="373856" y="1061954"/>
                  <a:pt x="366040" y="1067537"/>
                </a:cubicBezTo>
                <a:cubicBezTo>
                  <a:pt x="358967" y="1072376"/>
                  <a:pt x="360084" y="1079449"/>
                  <a:pt x="361573" y="1086149"/>
                </a:cubicBezTo>
                <a:cubicBezTo>
                  <a:pt x="367156" y="1112577"/>
                  <a:pt x="382790" y="1133794"/>
                  <a:pt x="402146" y="1152778"/>
                </a:cubicBezTo>
                <a:cubicBezTo>
                  <a:pt x="425596" y="1175484"/>
                  <a:pt x="450164" y="1197074"/>
                  <a:pt x="475475" y="1218663"/>
                </a:cubicBezTo>
                <a:cubicBezTo>
                  <a:pt x="448303" y="1212707"/>
                  <a:pt x="421130" y="1206752"/>
                  <a:pt x="393957" y="1201913"/>
                </a:cubicBezTo>
                <a:cubicBezTo>
                  <a:pt x="406240" y="1245091"/>
                  <a:pt x="434902" y="1253653"/>
                  <a:pt x="460586" y="1260353"/>
                </a:cubicBezTo>
                <a:cubicBezTo>
                  <a:pt x="495204" y="1268914"/>
                  <a:pt x="528332" y="1279709"/>
                  <a:pt x="561089" y="1291993"/>
                </a:cubicBezTo>
                <a:cubicBezTo>
                  <a:pt x="574861" y="1304276"/>
                  <a:pt x="588634" y="1316188"/>
                  <a:pt x="602034" y="1328843"/>
                </a:cubicBezTo>
                <a:cubicBezTo>
                  <a:pt x="615807" y="1341872"/>
                  <a:pt x="628835" y="1354900"/>
                  <a:pt x="641863" y="1368672"/>
                </a:cubicBezTo>
                <a:cubicBezTo>
                  <a:pt x="651169" y="1378722"/>
                  <a:pt x="662335" y="1387284"/>
                  <a:pt x="651541" y="1404406"/>
                </a:cubicBezTo>
                <a:cubicBezTo>
                  <a:pt x="646702" y="1412223"/>
                  <a:pt x="678341" y="1454658"/>
                  <a:pt x="688392" y="1457263"/>
                </a:cubicBezTo>
                <a:cubicBezTo>
                  <a:pt x="689881" y="1457635"/>
                  <a:pt x="691369" y="1458008"/>
                  <a:pt x="692486" y="1458008"/>
                </a:cubicBezTo>
                <a:cubicBezTo>
                  <a:pt x="714076" y="1456519"/>
                  <a:pt x="718915" y="1469175"/>
                  <a:pt x="719287" y="1485181"/>
                </a:cubicBezTo>
                <a:cubicBezTo>
                  <a:pt x="719659" y="1500814"/>
                  <a:pt x="715937" y="1520170"/>
                  <a:pt x="745343" y="1512353"/>
                </a:cubicBezTo>
                <a:cubicBezTo>
                  <a:pt x="748693" y="1511609"/>
                  <a:pt x="749438" y="1513842"/>
                  <a:pt x="750926" y="1516448"/>
                </a:cubicBezTo>
                <a:cubicBezTo>
                  <a:pt x="782938" y="1583077"/>
                  <a:pt x="836912" y="1634445"/>
                  <a:pt x="890141" y="1685813"/>
                </a:cubicBezTo>
                <a:cubicBezTo>
                  <a:pt x="893119" y="1688419"/>
                  <a:pt x="896097" y="1691024"/>
                  <a:pt x="899074" y="1693630"/>
                </a:cubicBezTo>
                <a:cubicBezTo>
                  <a:pt x="843240" y="1680602"/>
                  <a:pt x="658985" y="1663851"/>
                  <a:pt x="605012" y="1669435"/>
                </a:cubicBezTo>
                <a:cubicBezTo>
                  <a:pt x="556994" y="1674274"/>
                  <a:pt x="285638" y="1593128"/>
                  <a:pt x="229431" y="1545110"/>
                </a:cubicBezTo>
                <a:cubicBezTo>
                  <a:pt x="221614" y="1582705"/>
                  <a:pt x="238364" y="1597594"/>
                  <a:pt x="251765" y="1614717"/>
                </a:cubicBezTo>
                <a:cubicBezTo>
                  <a:pt x="270748" y="1638912"/>
                  <a:pt x="273726" y="1656035"/>
                  <a:pt x="237992" y="1675391"/>
                </a:cubicBezTo>
                <a:cubicBezTo>
                  <a:pt x="135628" y="1730481"/>
                  <a:pt x="136745" y="1732342"/>
                  <a:pt x="232781" y="1807160"/>
                </a:cubicBezTo>
                <a:cubicBezTo>
                  <a:pt x="237248" y="1810511"/>
                  <a:pt x="235014" y="1821305"/>
                  <a:pt x="236131" y="1828750"/>
                </a:cubicBezTo>
                <a:cubicBezTo>
                  <a:pt x="211191" y="1839917"/>
                  <a:pt x="181785" y="1810883"/>
                  <a:pt x="152007" y="1842150"/>
                </a:cubicBezTo>
                <a:cubicBezTo>
                  <a:pt x="280426" y="1979503"/>
                  <a:pt x="475848" y="2110157"/>
                  <a:pt x="653030" y="2213265"/>
                </a:cubicBezTo>
                <a:cubicBezTo>
                  <a:pt x="509721" y="2247138"/>
                  <a:pt x="423735" y="2128024"/>
                  <a:pt x="318394" y="2143285"/>
                </a:cubicBezTo>
                <a:cubicBezTo>
                  <a:pt x="265909" y="2180508"/>
                  <a:pt x="422246" y="2240810"/>
                  <a:pt x="272982" y="2258305"/>
                </a:cubicBezTo>
                <a:cubicBezTo>
                  <a:pt x="337750" y="2291061"/>
                  <a:pt x="385768" y="2323073"/>
                  <a:pt x="430435" y="2360668"/>
                </a:cubicBezTo>
                <a:cubicBezTo>
                  <a:pt x="509721" y="2428042"/>
                  <a:pt x="525354" y="2472710"/>
                  <a:pt x="488876" y="2563162"/>
                </a:cubicBezTo>
                <a:cubicBezTo>
                  <a:pt x="464681" y="2622719"/>
                  <a:pt x="429691" y="2677437"/>
                  <a:pt x="460586" y="2748533"/>
                </a:cubicBezTo>
                <a:cubicBezTo>
                  <a:pt x="481803" y="2797295"/>
                  <a:pt x="473614" y="2829307"/>
                  <a:pt x="393212" y="2807345"/>
                </a:cubicBezTo>
                <a:cubicBezTo>
                  <a:pt x="306483" y="2783895"/>
                  <a:pt x="273726" y="2827818"/>
                  <a:pt x="295688" y="2913059"/>
                </a:cubicBezTo>
                <a:cubicBezTo>
                  <a:pt x="309833" y="2967777"/>
                  <a:pt x="294943" y="2984900"/>
                  <a:pt x="235386" y="2978572"/>
                </a:cubicBezTo>
                <a:cubicBezTo>
                  <a:pt x="169501" y="2971499"/>
                  <a:pt x="106967" y="2935765"/>
                  <a:pt x="25448" y="2952888"/>
                </a:cubicBezTo>
                <a:cubicBezTo>
                  <a:pt x="90588" y="3052646"/>
                  <a:pt x="229803" y="3024356"/>
                  <a:pt x="305738" y="3119275"/>
                </a:cubicBezTo>
                <a:cubicBezTo>
                  <a:pt x="215286" y="3119647"/>
                  <a:pt x="146051" y="3119275"/>
                  <a:pt x="79049" y="3098430"/>
                </a:cubicBezTo>
                <a:cubicBezTo>
                  <a:pt x="51132" y="3089869"/>
                  <a:pt x="20609" y="3081308"/>
                  <a:pt x="4975" y="3109969"/>
                </a:cubicBezTo>
                <a:cubicBezTo>
                  <a:pt x="-13636" y="3144587"/>
                  <a:pt x="24331" y="3157615"/>
                  <a:pt x="47037" y="3163943"/>
                </a:cubicBezTo>
                <a:cubicBezTo>
                  <a:pt x="111061" y="3181438"/>
                  <a:pt x="160196" y="3222755"/>
                  <a:pt x="213425" y="3255139"/>
                </a:cubicBezTo>
                <a:cubicBezTo>
                  <a:pt x="329933" y="3326236"/>
                  <a:pt x="457981" y="3385420"/>
                  <a:pt x="556622" y="3502301"/>
                </a:cubicBezTo>
                <a:cubicBezTo>
                  <a:pt x="432669" y="3472523"/>
                  <a:pt x="339983" y="3402915"/>
                  <a:pt x="224592" y="3388771"/>
                </a:cubicBezTo>
                <a:cubicBezTo>
                  <a:pt x="324722" y="3495601"/>
                  <a:pt x="453142" y="3565208"/>
                  <a:pt x="574861" y="3643004"/>
                </a:cubicBezTo>
                <a:cubicBezTo>
                  <a:pt x="609479" y="3664966"/>
                  <a:pt x="644841" y="3679855"/>
                  <a:pt x="652657" y="3727501"/>
                </a:cubicBezTo>
                <a:cubicBezTo>
                  <a:pt x="667919" y="3819814"/>
                  <a:pt x="712959" y="3896494"/>
                  <a:pt x="810111" y="3937067"/>
                </a:cubicBezTo>
                <a:cubicBezTo>
                  <a:pt x="810856" y="3937439"/>
                  <a:pt x="805644" y="3951212"/>
                  <a:pt x="802294" y="3960890"/>
                </a:cubicBezTo>
                <a:cubicBezTo>
                  <a:pt x="743110" y="3963868"/>
                  <a:pt x="696581" y="3909149"/>
                  <a:pt x="620646" y="3927017"/>
                </a:cubicBezTo>
                <a:cubicBezTo>
                  <a:pt x="692858" y="4001091"/>
                  <a:pt x="753532" y="4067720"/>
                  <a:pt x="856268" y="4103082"/>
                </a:cubicBezTo>
                <a:cubicBezTo>
                  <a:pt x="938531" y="4131372"/>
                  <a:pt x="1040150" y="4147377"/>
                  <a:pt x="1099707" y="4238574"/>
                </a:cubicBezTo>
                <a:cubicBezTo>
                  <a:pt x="1030472" y="4256441"/>
                  <a:pt x="978732" y="4234107"/>
                  <a:pt x="926992" y="4218102"/>
                </a:cubicBezTo>
                <a:cubicBezTo>
                  <a:pt x="847334" y="4193534"/>
                  <a:pt x="769166" y="4165617"/>
                  <a:pt x="689508" y="4140677"/>
                </a:cubicBezTo>
                <a:cubicBezTo>
                  <a:pt x="659358" y="4131372"/>
                  <a:pt x="626229" y="4124299"/>
                  <a:pt x="606873" y="4169711"/>
                </a:cubicBezTo>
                <a:cubicBezTo>
                  <a:pt x="707748" y="4179389"/>
                  <a:pt x="768421" y="4240435"/>
                  <a:pt x="831701" y="4297759"/>
                </a:cubicBezTo>
                <a:cubicBezTo>
                  <a:pt x="867435" y="4330143"/>
                  <a:pt x="896469" y="4373322"/>
                  <a:pt x="960493" y="4356944"/>
                </a:cubicBezTo>
                <a:cubicBezTo>
                  <a:pt x="994366" y="4348382"/>
                  <a:pt x="1015955" y="4372578"/>
                  <a:pt x="1012233" y="4402356"/>
                </a:cubicBezTo>
                <a:cubicBezTo>
                  <a:pt x="999577" y="4507325"/>
                  <a:pt x="1078118" y="4544176"/>
                  <a:pt x="1159636" y="4564276"/>
                </a:cubicBezTo>
                <a:cubicBezTo>
                  <a:pt x="1313740" y="4602616"/>
                  <a:pt x="1442160" y="4692324"/>
                  <a:pt x="1592169" y="4741458"/>
                </a:cubicBezTo>
                <a:cubicBezTo>
                  <a:pt x="1738083" y="4789104"/>
                  <a:pt x="2833187" y="5010209"/>
                  <a:pt x="3110499" y="5032171"/>
                </a:cubicBezTo>
                <a:cubicBezTo>
                  <a:pt x="4807501" y="5166546"/>
                  <a:pt x="6028047" y="4106432"/>
                  <a:pt x="6033630" y="4091915"/>
                </a:cubicBezTo>
                <a:cubicBezTo>
                  <a:pt x="6059314" y="4023797"/>
                  <a:pt x="6122965" y="3994390"/>
                  <a:pt x="6180661" y="3957912"/>
                </a:cubicBezTo>
                <a:cubicBezTo>
                  <a:pt x="6230913" y="3925900"/>
                  <a:pt x="6284514" y="3892027"/>
                  <a:pt x="6305359" y="3837309"/>
                </a:cubicBezTo>
                <a:cubicBezTo>
                  <a:pt x="6332904" y="3764724"/>
                  <a:pt x="6254735" y="3824281"/>
                  <a:pt x="6240218" y="3796364"/>
                </a:cubicBezTo>
                <a:cubicBezTo>
                  <a:pt x="6269997" y="3758768"/>
                  <a:pt x="6316153" y="3724151"/>
                  <a:pt x="6328437" y="3681344"/>
                </a:cubicBezTo>
                <a:cubicBezTo>
                  <a:pt x="6372361" y="3526496"/>
                  <a:pt x="6466907" y="3413710"/>
                  <a:pt x="6608355" y="3326236"/>
                </a:cubicBezTo>
                <a:cubicBezTo>
                  <a:pt x="6648928" y="3300924"/>
                  <a:pt x="6675729" y="3255512"/>
                  <a:pt x="6731191" y="3248067"/>
                </a:cubicBezTo>
                <a:cubicBezTo>
                  <a:pt x="6854400" y="3232061"/>
                  <a:pt x="6815315" y="3106992"/>
                  <a:pt x="6880456" y="3051529"/>
                </a:cubicBezTo>
                <a:cubicBezTo>
                  <a:pt x="6892739" y="3041107"/>
                  <a:pt x="6903907" y="2777939"/>
                  <a:pt x="6901673" y="2763795"/>
                </a:cubicBezTo>
                <a:cubicBezTo>
                  <a:pt x="6898323" y="2743322"/>
                  <a:pt x="6883806" y="2966288"/>
                  <a:pt x="6871150" y="2948421"/>
                </a:cubicBezTo>
                <a:cubicBezTo>
                  <a:pt x="6858494" y="2930182"/>
                  <a:pt x="6839138" y="2914176"/>
                  <a:pt x="6848444" y="2890353"/>
                </a:cubicBezTo>
                <a:cubicBezTo>
                  <a:pt x="6852166" y="2880303"/>
                  <a:pt x="6849561" y="2846058"/>
                  <a:pt x="6878223" y="2873230"/>
                </a:cubicBezTo>
                <a:cubicBezTo>
                  <a:pt x="6956763" y="2946932"/>
                  <a:pt x="6870778" y="2578051"/>
                  <a:pt x="6762459" y="2568745"/>
                </a:cubicBezTo>
                <a:cubicBezTo>
                  <a:pt x="6801915" y="2465637"/>
                  <a:pt x="6801915" y="2465637"/>
                  <a:pt x="6673123" y="2451493"/>
                </a:cubicBezTo>
                <a:cubicBezTo>
                  <a:pt x="6722630" y="2385980"/>
                  <a:pt x="6722630" y="2369229"/>
                  <a:pt x="6662700" y="2346896"/>
                </a:cubicBezTo>
                <a:cubicBezTo>
                  <a:pt x="6605005" y="2325306"/>
                  <a:pt x="6540981" y="2318234"/>
                  <a:pt x="6487752" y="2285105"/>
                </a:cubicBezTo>
                <a:cubicBezTo>
                  <a:pt x="6536887" y="2201353"/>
                  <a:pt x="6550659" y="2104573"/>
                  <a:pt x="6652278" y="2063628"/>
                </a:cubicBezTo>
                <a:cubicBezTo>
                  <a:pt x="6668284" y="2057300"/>
                  <a:pt x="6679079" y="2031988"/>
                  <a:pt x="6668656" y="2017843"/>
                </a:cubicBezTo>
                <a:cubicBezTo>
                  <a:pt x="6631805" y="1965359"/>
                  <a:pt x="6684662" y="1864856"/>
                  <a:pt x="6570015" y="1854062"/>
                </a:cubicBezTo>
                <a:cubicBezTo>
                  <a:pt x="6555870" y="1852573"/>
                  <a:pt x="6542842" y="1842150"/>
                  <a:pt x="6554009" y="1827633"/>
                </a:cubicBezTo>
                <a:cubicBezTo>
                  <a:pt x="6592349" y="1778126"/>
                  <a:pt x="6545820" y="1781476"/>
                  <a:pt x="6517531" y="1775149"/>
                </a:cubicBezTo>
                <a:cubicBezTo>
                  <a:pt x="6483285" y="1767704"/>
                  <a:pt x="6444573" y="1789293"/>
                  <a:pt x="6412934" y="1762493"/>
                </a:cubicBezTo>
                <a:cubicBezTo>
                  <a:pt x="6420378" y="1734203"/>
                  <a:pt x="6447923" y="1734575"/>
                  <a:pt x="6467279" y="1725642"/>
                </a:cubicBezTo>
                <a:cubicBezTo>
                  <a:pt x="6523858" y="1699213"/>
                  <a:pt x="6570015" y="1667946"/>
                  <a:pt x="6572621" y="1600200"/>
                </a:cubicBezTo>
                <a:cubicBezTo>
                  <a:pt x="6574854" y="1545482"/>
                  <a:pt x="6580810" y="1497092"/>
                  <a:pt x="6502641" y="1480341"/>
                </a:cubicBezTo>
                <a:cubicBezTo>
                  <a:pt x="6490358" y="1477736"/>
                  <a:pt x="6484030" y="1470664"/>
                  <a:pt x="6481796" y="1461358"/>
                </a:cubicBezTo>
                <a:cubicBezTo>
                  <a:pt x="6490730" y="1452424"/>
                  <a:pt x="6499291" y="1443118"/>
                  <a:pt x="6509713" y="1436418"/>
                </a:cubicBezTo>
                <a:cubicBezTo>
                  <a:pt x="6544703" y="1414457"/>
                  <a:pt x="6556615" y="1382072"/>
                  <a:pt x="6567037" y="1348199"/>
                </a:cubicBezTo>
                <a:cubicBezTo>
                  <a:pt x="6573737" y="1326610"/>
                  <a:pt x="6581554" y="1305393"/>
                  <a:pt x="6596816" y="1286781"/>
                </a:cubicBezTo>
                <a:cubicBezTo>
                  <a:pt x="6606122" y="1275242"/>
                  <a:pt x="6617661" y="1266681"/>
                  <a:pt x="6632178" y="1261842"/>
                </a:cubicBezTo>
                <a:cubicBezTo>
                  <a:pt x="6644833" y="1257375"/>
                  <a:pt x="6648556" y="1251419"/>
                  <a:pt x="6639994" y="1240625"/>
                </a:cubicBezTo>
                <a:cubicBezTo>
                  <a:pt x="6615799" y="1209729"/>
                  <a:pt x="6606122" y="1175856"/>
                  <a:pt x="6622127" y="1136400"/>
                </a:cubicBezTo>
                <a:cubicBezTo>
                  <a:pt x="6626967" y="1124489"/>
                  <a:pt x="6623617" y="1114066"/>
                  <a:pt x="6612077" y="1109599"/>
                </a:cubicBezTo>
                <a:cubicBezTo>
                  <a:pt x="6564059" y="1090616"/>
                  <a:pt x="6552148" y="1046692"/>
                  <a:pt x="6531675" y="1009469"/>
                </a:cubicBezTo>
                <a:cubicBezTo>
                  <a:pt x="6502641" y="956612"/>
                  <a:pt x="6476213" y="902639"/>
                  <a:pt x="6456113" y="845315"/>
                </a:cubicBezTo>
                <a:cubicBezTo>
                  <a:pt x="6444201" y="811070"/>
                  <a:pt x="6432662" y="777197"/>
                  <a:pt x="6440851" y="739229"/>
                </a:cubicBezTo>
                <a:cubicBezTo>
                  <a:pt x="6442712" y="729924"/>
                  <a:pt x="6439362" y="722107"/>
                  <a:pt x="6434523" y="715034"/>
                </a:cubicBezTo>
                <a:cubicBezTo>
                  <a:pt x="6414050" y="684139"/>
                  <a:pt x="6416656" y="651383"/>
                  <a:pt x="6432290" y="617510"/>
                </a:cubicBezTo>
                <a:cubicBezTo>
                  <a:pt x="6441968" y="597037"/>
                  <a:pt x="6440851" y="594431"/>
                  <a:pt x="6416284" y="595176"/>
                </a:cubicBezTo>
                <a:cubicBezTo>
                  <a:pt x="6366405" y="596293"/>
                  <a:pt x="6316898" y="598154"/>
                  <a:pt x="6267763" y="591826"/>
                </a:cubicBezTo>
                <a:cubicBezTo>
                  <a:pt x="6212673" y="584753"/>
                  <a:pt x="6194806" y="568375"/>
                  <a:pt x="6236496" y="521102"/>
                </a:cubicBezTo>
                <a:cubicBezTo>
                  <a:pt x="6245430" y="511052"/>
                  <a:pt x="6253246" y="499885"/>
                  <a:pt x="6257341" y="487229"/>
                </a:cubicBezTo>
                <a:cubicBezTo>
                  <a:pt x="6260319" y="477179"/>
                  <a:pt x="6257713" y="470106"/>
                  <a:pt x="6248780" y="465267"/>
                </a:cubicBezTo>
                <a:cubicBezTo>
                  <a:pt x="6238357" y="459312"/>
                  <a:pt x="6232774" y="467501"/>
                  <a:pt x="6226818" y="473456"/>
                </a:cubicBezTo>
                <a:cubicBezTo>
                  <a:pt x="6194434" y="505468"/>
                  <a:pt x="6153861" y="527430"/>
                  <a:pt x="6115149" y="551625"/>
                </a:cubicBezTo>
                <a:cubicBezTo>
                  <a:pt x="6059686" y="586615"/>
                  <a:pt x="6001246" y="617510"/>
                  <a:pt x="5951739" y="659944"/>
                </a:cubicBezTo>
                <a:cubicBezTo>
                  <a:pt x="5939084" y="670739"/>
                  <a:pt x="5918611" y="662550"/>
                  <a:pt x="5917122" y="644310"/>
                </a:cubicBezTo>
                <a:cubicBezTo>
                  <a:pt x="5915633" y="626071"/>
                  <a:pt x="5905583" y="626071"/>
                  <a:pt x="5890694" y="630538"/>
                </a:cubicBezTo>
                <a:cubicBezTo>
                  <a:pt x="5872826" y="635749"/>
                  <a:pt x="5854959" y="640960"/>
                  <a:pt x="5837464" y="646916"/>
                </a:cubicBezTo>
                <a:cubicBezTo>
                  <a:pt x="5819225" y="653244"/>
                  <a:pt x="5811036" y="666644"/>
                  <a:pt x="5809175" y="683395"/>
                </a:cubicBezTo>
                <a:cubicBezTo>
                  <a:pt x="5808430" y="689723"/>
                  <a:pt x="5808803" y="697539"/>
                  <a:pt x="5815503" y="698656"/>
                </a:cubicBezTo>
                <a:cubicBezTo>
                  <a:pt x="5843048" y="703495"/>
                  <a:pt x="5755201" y="682278"/>
                  <a:pt x="5746268" y="667389"/>
                </a:cubicBezTo>
                <a:cubicBezTo>
                  <a:pt x="5745896" y="666644"/>
                  <a:pt x="5525907" y="720246"/>
                  <a:pt x="5458905" y="754119"/>
                </a:cubicBezTo>
                <a:close/>
                <a:moveTo>
                  <a:pt x="885302" y="1333310"/>
                </a:moveTo>
                <a:cubicBezTo>
                  <a:pt x="877857" y="1326982"/>
                  <a:pt x="870040" y="1321027"/>
                  <a:pt x="862596" y="1314326"/>
                </a:cubicBezTo>
                <a:cubicBezTo>
                  <a:pt x="863712" y="1312837"/>
                  <a:pt x="865201" y="1311349"/>
                  <a:pt x="866318" y="1309860"/>
                </a:cubicBezTo>
                <a:cubicBezTo>
                  <a:pt x="881580" y="1320282"/>
                  <a:pt x="896841" y="1330705"/>
                  <a:pt x="912103" y="1341127"/>
                </a:cubicBezTo>
                <a:cubicBezTo>
                  <a:pt x="903541" y="1338522"/>
                  <a:pt x="894235" y="1335916"/>
                  <a:pt x="885302" y="1333310"/>
                </a:cubicBezTo>
                <a:close/>
                <a:moveTo>
                  <a:pt x="1140280" y="787619"/>
                </a:moveTo>
                <a:cubicBezTo>
                  <a:pt x="1231849" y="850154"/>
                  <a:pt x="1323418" y="913061"/>
                  <a:pt x="1414987" y="975596"/>
                </a:cubicBezTo>
                <a:cubicBezTo>
                  <a:pt x="1413498" y="977085"/>
                  <a:pt x="1412381" y="978574"/>
                  <a:pt x="1410892" y="980063"/>
                </a:cubicBezTo>
                <a:cubicBezTo>
                  <a:pt x="1310390" y="927206"/>
                  <a:pt x="1215471" y="868394"/>
                  <a:pt x="1140280" y="787619"/>
                </a:cubicBezTo>
                <a:close/>
              </a:path>
            </a:pathLst>
          </a:custGeom>
          <a:solidFill>
            <a:schemeClr val="accent1">
              <a:alpha val="20000"/>
            </a:schemeClr>
          </a:solidFill>
          <a:ln w="32707" cap="flat">
            <a:noFill/>
            <a:prstDash val="solid"/>
            <a:miter/>
          </a:ln>
        </p:spPr>
        <p:txBody>
          <a:bodyPr rtlCol="0" anchor="ctr"/>
          <a:lstStyle/>
          <a:p>
            <a:endParaRPr lang="en-US" dirty="0"/>
          </a:p>
        </p:txBody>
      </p:sp>
      <p:sp>
        <p:nvSpPr>
          <p:cNvPr id="2" name="Title 1">
            <a:extLst>
              <a:ext uri="{FF2B5EF4-FFF2-40B4-BE49-F238E27FC236}">
                <a16:creationId xmlns:a16="http://schemas.microsoft.com/office/drawing/2014/main" id="{807094A5-EB6F-441D-88F8-CD7A30C84707}"/>
              </a:ext>
            </a:extLst>
          </p:cNvPr>
          <p:cNvSpPr>
            <a:spLocks noGrp="1"/>
          </p:cNvSpPr>
          <p:nvPr>
            <p:ph type="ctrTitle"/>
          </p:nvPr>
        </p:nvSpPr>
        <p:spPr>
          <a:xfrm>
            <a:off x="1508760" y="1591056"/>
            <a:ext cx="5705856" cy="3264408"/>
          </a:xfrm>
        </p:spPr>
        <p:txBody>
          <a:bodyPr anchor="b">
            <a:normAutofit/>
          </a:bodyPr>
          <a:lstStyle>
            <a:lvl1pPr algn="l">
              <a:defRPr sz="4800"/>
            </a:lvl1pPr>
          </a:lstStyle>
          <a:p>
            <a:r>
              <a:rPr lang="en-US"/>
              <a:t>Click to edit Master title style</a:t>
            </a:r>
            <a:endParaRPr lang="en-US" dirty="0"/>
          </a:p>
        </p:txBody>
      </p:sp>
      <p:sp>
        <p:nvSpPr>
          <p:cNvPr id="3" name="Subtitle 2">
            <a:extLst>
              <a:ext uri="{FF2B5EF4-FFF2-40B4-BE49-F238E27FC236}">
                <a16:creationId xmlns:a16="http://schemas.microsoft.com/office/drawing/2014/main" id="{1C7CE1E3-3929-42A6-81B7-056BD88EF353}"/>
              </a:ext>
            </a:extLst>
          </p:cNvPr>
          <p:cNvSpPr>
            <a:spLocks noGrp="1"/>
          </p:cNvSpPr>
          <p:nvPr>
            <p:ph type="subTitle" idx="1"/>
          </p:nvPr>
        </p:nvSpPr>
        <p:spPr>
          <a:xfrm>
            <a:off x="1524000" y="4928616"/>
            <a:ext cx="5705856" cy="996696"/>
          </a:xfrm>
        </p:spPr>
        <p:txBody>
          <a:bodyPr/>
          <a:lstStyle>
            <a:lvl1pPr marL="0" indent="0" algn="l">
              <a:buNone/>
              <a:defRPr sz="2400" cap="all" baseline="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a:extLst>
              <a:ext uri="{FF2B5EF4-FFF2-40B4-BE49-F238E27FC236}">
                <a16:creationId xmlns:a16="http://schemas.microsoft.com/office/drawing/2014/main" id="{5CE951E3-0794-422C-AF76-0AD4A7FB19EB}"/>
              </a:ext>
            </a:extLst>
          </p:cNvPr>
          <p:cNvSpPr>
            <a:spLocks noGrp="1"/>
          </p:cNvSpPr>
          <p:nvPr>
            <p:ph type="dt" sz="half" idx="10"/>
          </p:nvPr>
        </p:nvSpPr>
        <p:spPr/>
        <p:txBody>
          <a:bodyPr/>
          <a:lstStyle/>
          <a:p>
            <a:fld id="{3C04E684-10F4-4CC3-A0B9-F03AA7BE37CF}" type="datetimeFigureOut">
              <a:rPr lang="en-US" smtClean="0"/>
              <a:t>5/3/26</a:t>
            </a:fld>
            <a:endParaRPr lang="en-US" dirty="0"/>
          </a:p>
        </p:txBody>
      </p:sp>
      <p:sp>
        <p:nvSpPr>
          <p:cNvPr id="5" name="Footer Placeholder 4">
            <a:extLst>
              <a:ext uri="{FF2B5EF4-FFF2-40B4-BE49-F238E27FC236}">
                <a16:creationId xmlns:a16="http://schemas.microsoft.com/office/drawing/2014/main" id="{114EBFA8-0291-4D77-A9D9-B17FC2382A80}"/>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357AC4D4-C4EE-4624-A329-C608A1D5AFE1}"/>
              </a:ext>
            </a:extLst>
          </p:cNvPr>
          <p:cNvSpPr>
            <a:spLocks noGrp="1"/>
          </p:cNvSpPr>
          <p:nvPr>
            <p:ph type="sldNum" sz="quarter" idx="12"/>
          </p:nvPr>
        </p:nvSpPr>
        <p:spPr/>
        <p:txBody>
          <a:bodyPr/>
          <a:lstStyle/>
          <a:p>
            <a:fld id="{51845F5A-061D-4825-9AE9-D7794091C6CF}" type="slidenum">
              <a:rPr lang="en-US" smtClean="0"/>
              <a:t>‹#›</a:t>
            </a:fld>
            <a:endParaRPr lang="en-US" dirty="0"/>
          </a:p>
        </p:txBody>
      </p:sp>
    </p:spTree>
    <p:extLst>
      <p:ext uri="{BB962C8B-B14F-4D97-AF65-F5344CB8AC3E}">
        <p14:creationId xmlns:p14="http://schemas.microsoft.com/office/powerpoint/2010/main" val="23286396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8" name="Graphic 1" descr="Tag=AccentColor&#10;Flavor=Light&#10;Target=Fill">
            <a:extLst>
              <a:ext uri="{FF2B5EF4-FFF2-40B4-BE49-F238E27FC236}">
                <a16:creationId xmlns:a16="http://schemas.microsoft.com/office/drawing/2014/main" id="{0EE21C0F-70D8-4F3C-9392-07559C90EE6E}"/>
              </a:ext>
            </a:extLst>
          </p:cNvPr>
          <p:cNvSpPr/>
          <p:nvPr/>
        </p:nvSpPr>
        <p:spPr>
          <a:xfrm rot="10800000" flipH="1" flipV="1">
            <a:off x="684965" y="1332237"/>
            <a:ext cx="5263732" cy="3841102"/>
          </a:xfrm>
          <a:custGeom>
            <a:avLst/>
            <a:gdLst>
              <a:gd name="connsiteX0" fmla="*/ 5458905 w 6886274"/>
              <a:gd name="connsiteY0" fmla="*/ 754119 h 5025119"/>
              <a:gd name="connsiteX1" fmla="*/ 3455557 w 6886274"/>
              <a:gd name="connsiteY1" fmla="*/ 1027709 h 5025119"/>
              <a:gd name="connsiteX2" fmla="*/ 3338677 w 6886274"/>
              <a:gd name="connsiteY2" fmla="*/ 1021381 h 5025119"/>
              <a:gd name="connsiteX3" fmla="*/ 2518280 w 6886274"/>
              <a:gd name="connsiteY3" fmla="*/ 980435 h 5025119"/>
              <a:gd name="connsiteX4" fmla="*/ 1673687 w 6886274"/>
              <a:gd name="connsiteY4" fmla="*/ 739229 h 5025119"/>
              <a:gd name="connsiteX5" fmla="*/ 1183459 w 6886274"/>
              <a:gd name="connsiteY5" fmla="*/ 397149 h 5025119"/>
              <a:gd name="connsiteX6" fmla="*/ 977987 w 6886274"/>
              <a:gd name="connsiteY6" fmla="*/ 241184 h 5025119"/>
              <a:gd name="connsiteX7" fmla="*/ 788150 w 6886274"/>
              <a:gd name="connsiteY7" fmla="*/ 66980 h 5025119"/>
              <a:gd name="connsiteX8" fmla="*/ 721148 w 6886274"/>
              <a:gd name="connsiteY8" fmla="*/ 31990 h 5025119"/>
              <a:gd name="connsiteX9" fmla="*/ 701792 w 6886274"/>
              <a:gd name="connsiteY9" fmla="*/ 32362 h 5025119"/>
              <a:gd name="connsiteX10" fmla="*/ 686530 w 6886274"/>
              <a:gd name="connsiteY10" fmla="*/ 43157 h 5025119"/>
              <a:gd name="connsiteX11" fmla="*/ 693603 w 6886274"/>
              <a:gd name="connsiteY11" fmla="*/ 58046 h 5025119"/>
              <a:gd name="connsiteX12" fmla="*/ 705886 w 6886274"/>
              <a:gd name="connsiteY12" fmla="*/ 65491 h 5025119"/>
              <a:gd name="connsiteX13" fmla="*/ 762838 w 6886274"/>
              <a:gd name="connsiteY13" fmla="*/ 112764 h 5025119"/>
              <a:gd name="connsiteX14" fmla="*/ 764327 w 6886274"/>
              <a:gd name="connsiteY14" fmla="*/ 140309 h 5025119"/>
              <a:gd name="connsiteX15" fmla="*/ 775121 w 6886274"/>
              <a:gd name="connsiteY15" fmla="*/ 159666 h 5025119"/>
              <a:gd name="connsiteX16" fmla="*/ 823139 w 6886274"/>
              <a:gd name="connsiteY16" fmla="*/ 176416 h 5025119"/>
              <a:gd name="connsiteX17" fmla="*/ 707748 w 6886274"/>
              <a:gd name="connsiteY17" fmla="*/ 109414 h 5025119"/>
              <a:gd name="connsiteX18" fmla="*/ 681319 w 6886274"/>
              <a:gd name="connsiteY18" fmla="*/ 69958 h 5025119"/>
              <a:gd name="connsiteX19" fmla="*/ 640746 w 6886274"/>
              <a:gd name="connsiteY19" fmla="*/ 67352 h 5025119"/>
              <a:gd name="connsiteX20" fmla="*/ 614318 w 6886274"/>
              <a:gd name="connsiteY20" fmla="*/ 61396 h 5025119"/>
              <a:gd name="connsiteX21" fmla="*/ 560716 w 6886274"/>
              <a:gd name="connsiteY21" fmla="*/ 3701 h 5025119"/>
              <a:gd name="connsiteX22" fmla="*/ 540616 w 6886274"/>
              <a:gd name="connsiteY22" fmla="*/ 3701 h 5025119"/>
              <a:gd name="connsiteX23" fmla="*/ 543594 w 6886274"/>
              <a:gd name="connsiteY23" fmla="*/ 21940 h 5025119"/>
              <a:gd name="connsiteX24" fmla="*/ 558855 w 6886274"/>
              <a:gd name="connsiteY24" fmla="*/ 51346 h 5025119"/>
              <a:gd name="connsiteX25" fmla="*/ 557366 w 6886274"/>
              <a:gd name="connsiteY25" fmla="*/ 72563 h 5025119"/>
              <a:gd name="connsiteX26" fmla="*/ 570022 w 6886274"/>
              <a:gd name="connsiteY26" fmla="*/ 120209 h 5025119"/>
              <a:gd name="connsiteX27" fmla="*/ 599801 w 6886274"/>
              <a:gd name="connsiteY27" fmla="*/ 192794 h 5025119"/>
              <a:gd name="connsiteX28" fmla="*/ 614318 w 6886274"/>
              <a:gd name="connsiteY28" fmla="*/ 212150 h 5025119"/>
              <a:gd name="connsiteX29" fmla="*/ 623996 w 6886274"/>
              <a:gd name="connsiteY29" fmla="*/ 220711 h 5025119"/>
              <a:gd name="connsiteX30" fmla="*/ 821278 w 6886274"/>
              <a:gd name="connsiteY30" fmla="*/ 503235 h 5025119"/>
              <a:gd name="connsiteX31" fmla="*/ 1033822 w 6886274"/>
              <a:gd name="connsiteY31" fmla="*/ 694562 h 5025119"/>
              <a:gd name="connsiteX32" fmla="*/ 1039406 w 6886274"/>
              <a:gd name="connsiteY32" fmla="*/ 702378 h 5025119"/>
              <a:gd name="connsiteX33" fmla="*/ 944114 w 6886274"/>
              <a:gd name="connsiteY33" fmla="*/ 662550 h 5025119"/>
              <a:gd name="connsiteX34" fmla="*/ 733432 w 6886274"/>
              <a:gd name="connsiteY34" fmla="*/ 500629 h 5025119"/>
              <a:gd name="connsiteX35" fmla="*/ 606501 w 6886274"/>
              <a:gd name="connsiteY35" fmla="*/ 399755 h 5025119"/>
              <a:gd name="connsiteX36" fmla="*/ 588634 w 6886274"/>
              <a:gd name="connsiteY36" fmla="*/ 381143 h 5025119"/>
              <a:gd name="connsiteX37" fmla="*/ 575978 w 6886274"/>
              <a:gd name="connsiteY37" fmla="*/ 375560 h 5025119"/>
              <a:gd name="connsiteX38" fmla="*/ 567044 w 6886274"/>
              <a:gd name="connsiteY38" fmla="*/ 388588 h 5025119"/>
              <a:gd name="connsiteX39" fmla="*/ 578956 w 6886274"/>
              <a:gd name="connsiteY39" fmla="*/ 437722 h 5025119"/>
              <a:gd name="connsiteX40" fmla="*/ 675736 w 6886274"/>
              <a:gd name="connsiteY40" fmla="*/ 535619 h 5025119"/>
              <a:gd name="connsiteX41" fmla="*/ 811600 w 6886274"/>
              <a:gd name="connsiteY41" fmla="*/ 652872 h 5025119"/>
              <a:gd name="connsiteX42" fmla="*/ 818300 w 6886274"/>
              <a:gd name="connsiteY42" fmla="*/ 666272 h 5025119"/>
              <a:gd name="connsiteX43" fmla="*/ 741621 w 6886274"/>
              <a:gd name="connsiteY43" fmla="*/ 608576 h 5025119"/>
              <a:gd name="connsiteX44" fmla="*/ 666430 w 6886274"/>
              <a:gd name="connsiteY44" fmla="*/ 553114 h 5025119"/>
              <a:gd name="connsiteX45" fmla="*/ 645585 w 6886274"/>
              <a:gd name="connsiteY45" fmla="*/ 547903 h 5025119"/>
              <a:gd name="connsiteX46" fmla="*/ 640002 w 6886274"/>
              <a:gd name="connsiteY46" fmla="*/ 570236 h 5025119"/>
              <a:gd name="connsiteX47" fmla="*/ 675736 w 6886274"/>
              <a:gd name="connsiteY47" fmla="*/ 628677 h 5025119"/>
              <a:gd name="connsiteX48" fmla="*/ 855896 w 6886274"/>
              <a:gd name="connsiteY48" fmla="*/ 786875 h 5025119"/>
              <a:gd name="connsiteX49" fmla="*/ 946348 w 6886274"/>
              <a:gd name="connsiteY49" fmla="*/ 877699 h 5025119"/>
              <a:gd name="connsiteX50" fmla="*/ 950442 w 6886274"/>
              <a:gd name="connsiteY50" fmla="*/ 899661 h 5025119"/>
              <a:gd name="connsiteX51" fmla="*/ 991760 w 6886274"/>
              <a:gd name="connsiteY51" fmla="*/ 937629 h 5025119"/>
              <a:gd name="connsiteX52" fmla="*/ 1018188 w 6886274"/>
              <a:gd name="connsiteY52" fmla="*/ 945445 h 5025119"/>
              <a:gd name="connsiteX53" fmla="*/ 1315601 w 6886274"/>
              <a:gd name="connsiteY53" fmla="*/ 1196329 h 5025119"/>
              <a:gd name="connsiteX54" fmla="*/ 1454443 w 6886274"/>
              <a:gd name="connsiteY54" fmla="*/ 1279709 h 5025119"/>
              <a:gd name="connsiteX55" fmla="*/ 1454443 w 6886274"/>
              <a:gd name="connsiteY55" fmla="*/ 1285665 h 5025119"/>
              <a:gd name="connsiteX56" fmla="*/ 1453327 w 6886274"/>
              <a:gd name="connsiteY56" fmla="*/ 1291993 h 5025119"/>
              <a:gd name="connsiteX57" fmla="*/ 1256416 w 6886274"/>
              <a:gd name="connsiteY57" fmla="*/ 1166923 h 5025119"/>
              <a:gd name="connsiteX58" fmla="*/ 745715 w 6886274"/>
              <a:gd name="connsiteY58" fmla="*/ 798786 h 5025119"/>
              <a:gd name="connsiteX59" fmla="*/ 592356 w 6886274"/>
              <a:gd name="connsiteY59" fmla="*/ 656966 h 5025119"/>
              <a:gd name="connsiteX60" fmla="*/ 485526 w 6886274"/>
              <a:gd name="connsiteY60" fmla="*/ 567259 h 5025119"/>
              <a:gd name="connsiteX61" fmla="*/ 430063 w 6886274"/>
              <a:gd name="connsiteY61" fmla="*/ 550136 h 5025119"/>
              <a:gd name="connsiteX62" fmla="*/ 408846 w 6886274"/>
              <a:gd name="connsiteY62" fmla="*/ 563164 h 5025119"/>
              <a:gd name="connsiteX63" fmla="*/ 421130 w 6886274"/>
              <a:gd name="connsiteY63" fmla="*/ 581403 h 5025119"/>
              <a:gd name="connsiteX64" fmla="*/ 426713 w 6886274"/>
              <a:gd name="connsiteY64" fmla="*/ 584009 h 5025119"/>
              <a:gd name="connsiteX65" fmla="*/ 487015 w 6886274"/>
              <a:gd name="connsiteY65" fmla="*/ 635005 h 5025119"/>
              <a:gd name="connsiteX66" fmla="*/ 487015 w 6886274"/>
              <a:gd name="connsiteY66" fmla="*/ 655105 h 5025119"/>
              <a:gd name="connsiteX67" fmla="*/ 497437 w 6886274"/>
              <a:gd name="connsiteY67" fmla="*/ 678183 h 5025119"/>
              <a:gd name="connsiteX68" fmla="*/ 539871 w 6886274"/>
              <a:gd name="connsiteY68" fmla="*/ 691584 h 5025119"/>
              <a:gd name="connsiteX69" fmla="*/ 485898 w 6886274"/>
              <a:gd name="connsiteY69" fmla="*/ 681906 h 5025119"/>
              <a:gd name="connsiteX70" fmla="*/ 410335 w 6886274"/>
              <a:gd name="connsiteY70" fmla="*/ 600387 h 5025119"/>
              <a:gd name="connsiteX71" fmla="*/ 397307 w 6886274"/>
              <a:gd name="connsiteY71" fmla="*/ 582892 h 5025119"/>
              <a:gd name="connsiteX72" fmla="*/ 363062 w 6886274"/>
              <a:gd name="connsiteY72" fmla="*/ 584009 h 5025119"/>
              <a:gd name="connsiteX73" fmla="*/ 334772 w 6886274"/>
              <a:gd name="connsiteY73" fmla="*/ 578426 h 5025119"/>
              <a:gd name="connsiteX74" fmla="*/ 281915 w 6886274"/>
              <a:gd name="connsiteY74" fmla="*/ 522219 h 5025119"/>
              <a:gd name="connsiteX75" fmla="*/ 263304 w 6886274"/>
              <a:gd name="connsiteY75" fmla="*/ 521846 h 5025119"/>
              <a:gd name="connsiteX76" fmla="*/ 263676 w 6886274"/>
              <a:gd name="connsiteY76" fmla="*/ 538225 h 5025119"/>
              <a:gd name="connsiteX77" fmla="*/ 275215 w 6886274"/>
              <a:gd name="connsiteY77" fmla="*/ 563164 h 5025119"/>
              <a:gd name="connsiteX78" fmla="*/ 271121 w 6886274"/>
              <a:gd name="connsiteY78" fmla="*/ 604854 h 5025119"/>
              <a:gd name="connsiteX79" fmla="*/ 274471 w 6886274"/>
              <a:gd name="connsiteY79" fmla="*/ 627560 h 5025119"/>
              <a:gd name="connsiteX80" fmla="*/ 319138 w 6886274"/>
              <a:gd name="connsiteY80" fmla="*/ 718012 h 5025119"/>
              <a:gd name="connsiteX81" fmla="*/ 326583 w 6886274"/>
              <a:gd name="connsiteY81" fmla="*/ 729551 h 5025119"/>
              <a:gd name="connsiteX82" fmla="*/ 349289 w 6886274"/>
              <a:gd name="connsiteY82" fmla="*/ 748163 h 5025119"/>
              <a:gd name="connsiteX83" fmla="*/ 528332 w 6886274"/>
              <a:gd name="connsiteY83" fmla="*/ 1007608 h 5025119"/>
              <a:gd name="connsiteX84" fmla="*/ 766932 w 6886274"/>
              <a:gd name="connsiteY84" fmla="*/ 1222758 h 5025119"/>
              <a:gd name="connsiteX85" fmla="*/ 681319 w 6886274"/>
              <a:gd name="connsiteY85" fmla="*/ 1190746 h 5025119"/>
              <a:gd name="connsiteX86" fmla="*/ 469520 w 6886274"/>
              <a:gd name="connsiteY86" fmla="*/ 1032920 h 5025119"/>
              <a:gd name="connsiteX87" fmla="*/ 325466 w 6886274"/>
              <a:gd name="connsiteY87" fmla="*/ 917900 h 5025119"/>
              <a:gd name="connsiteX88" fmla="*/ 312066 w 6886274"/>
              <a:gd name="connsiteY88" fmla="*/ 903383 h 5025119"/>
              <a:gd name="connsiteX89" fmla="*/ 296805 w 6886274"/>
              <a:gd name="connsiteY89" fmla="*/ 895566 h 5025119"/>
              <a:gd name="connsiteX90" fmla="*/ 288243 w 6886274"/>
              <a:gd name="connsiteY90" fmla="*/ 910828 h 5025119"/>
              <a:gd name="connsiteX91" fmla="*/ 309460 w 6886274"/>
              <a:gd name="connsiteY91" fmla="*/ 971129 h 5025119"/>
              <a:gd name="connsiteX92" fmla="*/ 407729 w 6886274"/>
              <a:gd name="connsiteY92" fmla="*/ 1062698 h 5025119"/>
              <a:gd name="connsiteX93" fmla="*/ 544338 w 6886274"/>
              <a:gd name="connsiteY93" fmla="*/ 1189257 h 5025119"/>
              <a:gd name="connsiteX94" fmla="*/ 454630 w 6886274"/>
              <a:gd name="connsiteY94" fmla="*/ 1120766 h 5025119"/>
              <a:gd name="connsiteX95" fmla="*/ 385396 w 6886274"/>
              <a:gd name="connsiteY95" fmla="*/ 1070515 h 5025119"/>
              <a:gd name="connsiteX96" fmla="*/ 366040 w 6886274"/>
              <a:gd name="connsiteY96" fmla="*/ 1067537 h 5025119"/>
              <a:gd name="connsiteX97" fmla="*/ 361573 w 6886274"/>
              <a:gd name="connsiteY97" fmla="*/ 1086149 h 5025119"/>
              <a:gd name="connsiteX98" fmla="*/ 402146 w 6886274"/>
              <a:gd name="connsiteY98" fmla="*/ 1152778 h 5025119"/>
              <a:gd name="connsiteX99" fmla="*/ 475475 w 6886274"/>
              <a:gd name="connsiteY99" fmla="*/ 1218663 h 5025119"/>
              <a:gd name="connsiteX100" fmla="*/ 393957 w 6886274"/>
              <a:gd name="connsiteY100" fmla="*/ 1201913 h 5025119"/>
              <a:gd name="connsiteX101" fmla="*/ 460586 w 6886274"/>
              <a:gd name="connsiteY101" fmla="*/ 1260353 h 5025119"/>
              <a:gd name="connsiteX102" fmla="*/ 561089 w 6886274"/>
              <a:gd name="connsiteY102" fmla="*/ 1291993 h 5025119"/>
              <a:gd name="connsiteX103" fmla="*/ 602034 w 6886274"/>
              <a:gd name="connsiteY103" fmla="*/ 1328843 h 5025119"/>
              <a:gd name="connsiteX104" fmla="*/ 641863 w 6886274"/>
              <a:gd name="connsiteY104" fmla="*/ 1368672 h 5025119"/>
              <a:gd name="connsiteX105" fmla="*/ 651541 w 6886274"/>
              <a:gd name="connsiteY105" fmla="*/ 1404406 h 5025119"/>
              <a:gd name="connsiteX106" fmla="*/ 688392 w 6886274"/>
              <a:gd name="connsiteY106" fmla="*/ 1457263 h 5025119"/>
              <a:gd name="connsiteX107" fmla="*/ 692486 w 6886274"/>
              <a:gd name="connsiteY107" fmla="*/ 1458008 h 5025119"/>
              <a:gd name="connsiteX108" fmla="*/ 719287 w 6886274"/>
              <a:gd name="connsiteY108" fmla="*/ 1485181 h 5025119"/>
              <a:gd name="connsiteX109" fmla="*/ 745343 w 6886274"/>
              <a:gd name="connsiteY109" fmla="*/ 1512353 h 5025119"/>
              <a:gd name="connsiteX110" fmla="*/ 750926 w 6886274"/>
              <a:gd name="connsiteY110" fmla="*/ 1516448 h 5025119"/>
              <a:gd name="connsiteX111" fmla="*/ 890141 w 6886274"/>
              <a:gd name="connsiteY111" fmla="*/ 1685813 h 5025119"/>
              <a:gd name="connsiteX112" fmla="*/ 899074 w 6886274"/>
              <a:gd name="connsiteY112" fmla="*/ 1693630 h 5025119"/>
              <a:gd name="connsiteX113" fmla="*/ 605012 w 6886274"/>
              <a:gd name="connsiteY113" fmla="*/ 1669435 h 5025119"/>
              <a:gd name="connsiteX114" fmla="*/ 229431 w 6886274"/>
              <a:gd name="connsiteY114" fmla="*/ 1545110 h 5025119"/>
              <a:gd name="connsiteX115" fmla="*/ 251765 w 6886274"/>
              <a:gd name="connsiteY115" fmla="*/ 1614717 h 5025119"/>
              <a:gd name="connsiteX116" fmla="*/ 237992 w 6886274"/>
              <a:gd name="connsiteY116" fmla="*/ 1675391 h 5025119"/>
              <a:gd name="connsiteX117" fmla="*/ 232781 w 6886274"/>
              <a:gd name="connsiteY117" fmla="*/ 1807160 h 5025119"/>
              <a:gd name="connsiteX118" fmla="*/ 236131 w 6886274"/>
              <a:gd name="connsiteY118" fmla="*/ 1828750 h 5025119"/>
              <a:gd name="connsiteX119" fmla="*/ 152007 w 6886274"/>
              <a:gd name="connsiteY119" fmla="*/ 1842150 h 5025119"/>
              <a:gd name="connsiteX120" fmla="*/ 653030 w 6886274"/>
              <a:gd name="connsiteY120" fmla="*/ 2213265 h 5025119"/>
              <a:gd name="connsiteX121" fmla="*/ 318394 w 6886274"/>
              <a:gd name="connsiteY121" fmla="*/ 2143285 h 5025119"/>
              <a:gd name="connsiteX122" fmla="*/ 272982 w 6886274"/>
              <a:gd name="connsiteY122" fmla="*/ 2258305 h 5025119"/>
              <a:gd name="connsiteX123" fmla="*/ 430435 w 6886274"/>
              <a:gd name="connsiteY123" fmla="*/ 2360668 h 5025119"/>
              <a:gd name="connsiteX124" fmla="*/ 488876 w 6886274"/>
              <a:gd name="connsiteY124" fmla="*/ 2563162 h 5025119"/>
              <a:gd name="connsiteX125" fmla="*/ 460586 w 6886274"/>
              <a:gd name="connsiteY125" fmla="*/ 2748533 h 5025119"/>
              <a:gd name="connsiteX126" fmla="*/ 393212 w 6886274"/>
              <a:gd name="connsiteY126" fmla="*/ 2807345 h 5025119"/>
              <a:gd name="connsiteX127" fmla="*/ 295688 w 6886274"/>
              <a:gd name="connsiteY127" fmla="*/ 2913059 h 5025119"/>
              <a:gd name="connsiteX128" fmla="*/ 235386 w 6886274"/>
              <a:gd name="connsiteY128" fmla="*/ 2978572 h 5025119"/>
              <a:gd name="connsiteX129" fmla="*/ 25448 w 6886274"/>
              <a:gd name="connsiteY129" fmla="*/ 2952888 h 5025119"/>
              <a:gd name="connsiteX130" fmla="*/ 305738 w 6886274"/>
              <a:gd name="connsiteY130" fmla="*/ 3119275 h 5025119"/>
              <a:gd name="connsiteX131" fmla="*/ 79049 w 6886274"/>
              <a:gd name="connsiteY131" fmla="*/ 3098430 h 5025119"/>
              <a:gd name="connsiteX132" fmla="*/ 4975 w 6886274"/>
              <a:gd name="connsiteY132" fmla="*/ 3109969 h 5025119"/>
              <a:gd name="connsiteX133" fmla="*/ 47037 w 6886274"/>
              <a:gd name="connsiteY133" fmla="*/ 3163943 h 5025119"/>
              <a:gd name="connsiteX134" fmla="*/ 213425 w 6886274"/>
              <a:gd name="connsiteY134" fmla="*/ 3255139 h 5025119"/>
              <a:gd name="connsiteX135" fmla="*/ 556622 w 6886274"/>
              <a:gd name="connsiteY135" fmla="*/ 3502301 h 5025119"/>
              <a:gd name="connsiteX136" fmla="*/ 224592 w 6886274"/>
              <a:gd name="connsiteY136" fmla="*/ 3388771 h 5025119"/>
              <a:gd name="connsiteX137" fmla="*/ 574861 w 6886274"/>
              <a:gd name="connsiteY137" fmla="*/ 3643004 h 5025119"/>
              <a:gd name="connsiteX138" fmla="*/ 652657 w 6886274"/>
              <a:gd name="connsiteY138" fmla="*/ 3727501 h 5025119"/>
              <a:gd name="connsiteX139" fmla="*/ 810111 w 6886274"/>
              <a:gd name="connsiteY139" fmla="*/ 3937067 h 5025119"/>
              <a:gd name="connsiteX140" fmla="*/ 802294 w 6886274"/>
              <a:gd name="connsiteY140" fmla="*/ 3960890 h 5025119"/>
              <a:gd name="connsiteX141" fmla="*/ 620646 w 6886274"/>
              <a:gd name="connsiteY141" fmla="*/ 3927017 h 5025119"/>
              <a:gd name="connsiteX142" fmla="*/ 856268 w 6886274"/>
              <a:gd name="connsiteY142" fmla="*/ 4103082 h 5025119"/>
              <a:gd name="connsiteX143" fmla="*/ 1099707 w 6886274"/>
              <a:gd name="connsiteY143" fmla="*/ 4238574 h 5025119"/>
              <a:gd name="connsiteX144" fmla="*/ 926992 w 6886274"/>
              <a:gd name="connsiteY144" fmla="*/ 4218102 h 5025119"/>
              <a:gd name="connsiteX145" fmla="*/ 689508 w 6886274"/>
              <a:gd name="connsiteY145" fmla="*/ 4140677 h 5025119"/>
              <a:gd name="connsiteX146" fmla="*/ 606873 w 6886274"/>
              <a:gd name="connsiteY146" fmla="*/ 4169711 h 5025119"/>
              <a:gd name="connsiteX147" fmla="*/ 831701 w 6886274"/>
              <a:gd name="connsiteY147" fmla="*/ 4297759 h 5025119"/>
              <a:gd name="connsiteX148" fmla="*/ 960493 w 6886274"/>
              <a:gd name="connsiteY148" fmla="*/ 4356944 h 5025119"/>
              <a:gd name="connsiteX149" fmla="*/ 1012233 w 6886274"/>
              <a:gd name="connsiteY149" fmla="*/ 4402356 h 5025119"/>
              <a:gd name="connsiteX150" fmla="*/ 1159636 w 6886274"/>
              <a:gd name="connsiteY150" fmla="*/ 4564276 h 5025119"/>
              <a:gd name="connsiteX151" fmla="*/ 1592169 w 6886274"/>
              <a:gd name="connsiteY151" fmla="*/ 4741458 h 5025119"/>
              <a:gd name="connsiteX152" fmla="*/ 3110499 w 6886274"/>
              <a:gd name="connsiteY152" fmla="*/ 5032171 h 5025119"/>
              <a:gd name="connsiteX153" fmla="*/ 6033630 w 6886274"/>
              <a:gd name="connsiteY153" fmla="*/ 4091915 h 5025119"/>
              <a:gd name="connsiteX154" fmla="*/ 6180661 w 6886274"/>
              <a:gd name="connsiteY154" fmla="*/ 3957912 h 5025119"/>
              <a:gd name="connsiteX155" fmla="*/ 6305359 w 6886274"/>
              <a:gd name="connsiteY155" fmla="*/ 3837309 h 5025119"/>
              <a:gd name="connsiteX156" fmla="*/ 6240218 w 6886274"/>
              <a:gd name="connsiteY156" fmla="*/ 3796364 h 5025119"/>
              <a:gd name="connsiteX157" fmla="*/ 6328437 w 6886274"/>
              <a:gd name="connsiteY157" fmla="*/ 3681344 h 5025119"/>
              <a:gd name="connsiteX158" fmla="*/ 6608355 w 6886274"/>
              <a:gd name="connsiteY158" fmla="*/ 3326236 h 5025119"/>
              <a:gd name="connsiteX159" fmla="*/ 6731191 w 6886274"/>
              <a:gd name="connsiteY159" fmla="*/ 3248067 h 5025119"/>
              <a:gd name="connsiteX160" fmla="*/ 6880456 w 6886274"/>
              <a:gd name="connsiteY160" fmla="*/ 3051529 h 5025119"/>
              <a:gd name="connsiteX161" fmla="*/ 6901673 w 6886274"/>
              <a:gd name="connsiteY161" fmla="*/ 2763795 h 5025119"/>
              <a:gd name="connsiteX162" fmla="*/ 6871150 w 6886274"/>
              <a:gd name="connsiteY162" fmla="*/ 2948421 h 5025119"/>
              <a:gd name="connsiteX163" fmla="*/ 6848444 w 6886274"/>
              <a:gd name="connsiteY163" fmla="*/ 2890353 h 5025119"/>
              <a:gd name="connsiteX164" fmla="*/ 6878223 w 6886274"/>
              <a:gd name="connsiteY164" fmla="*/ 2873230 h 5025119"/>
              <a:gd name="connsiteX165" fmla="*/ 6762459 w 6886274"/>
              <a:gd name="connsiteY165" fmla="*/ 2568745 h 5025119"/>
              <a:gd name="connsiteX166" fmla="*/ 6673123 w 6886274"/>
              <a:gd name="connsiteY166" fmla="*/ 2451493 h 5025119"/>
              <a:gd name="connsiteX167" fmla="*/ 6662700 w 6886274"/>
              <a:gd name="connsiteY167" fmla="*/ 2346896 h 5025119"/>
              <a:gd name="connsiteX168" fmla="*/ 6487752 w 6886274"/>
              <a:gd name="connsiteY168" fmla="*/ 2285105 h 5025119"/>
              <a:gd name="connsiteX169" fmla="*/ 6652278 w 6886274"/>
              <a:gd name="connsiteY169" fmla="*/ 2063628 h 5025119"/>
              <a:gd name="connsiteX170" fmla="*/ 6668656 w 6886274"/>
              <a:gd name="connsiteY170" fmla="*/ 2017843 h 5025119"/>
              <a:gd name="connsiteX171" fmla="*/ 6570015 w 6886274"/>
              <a:gd name="connsiteY171" fmla="*/ 1854062 h 5025119"/>
              <a:gd name="connsiteX172" fmla="*/ 6554009 w 6886274"/>
              <a:gd name="connsiteY172" fmla="*/ 1827633 h 5025119"/>
              <a:gd name="connsiteX173" fmla="*/ 6517531 w 6886274"/>
              <a:gd name="connsiteY173" fmla="*/ 1775149 h 5025119"/>
              <a:gd name="connsiteX174" fmla="*/ 6412934 w 6886274"/>
              <a:gd name="connsiteY174" fmla="*/ 1762493 h 5025119"/>
              <a:gd name="connsiteX175" fmla="*/ 6467279 w 6886274"/>
              <a:gd name="connsiteY175" fmla="*/ 1725642 h 5025119"/>
              <a:gd name="connsiteX176" fmla="*/ 6572621 w 6886274"/>
              <a:gd name="connsiteY176" fmla="*/ 1600200 h 5025119"/>
              <a:gd name="connsiteX177" fmla="*/ 6502641 w 6886274"/>
              <a:gd name="connsiteY177" fmla="*/ 1480341 h 5025119"/>
              <a:gd name="connsiteX178" fmla="*/ 6481796 w 6886274"/>
              <a:gd name="connsiteY178" fmla="*/ 1461358 h 5025119"/>
              <a:gd name="connsiteX179" fmla="*/ 6509713 w 6886274"/>
              <a:gd name="connsiteY179" fmla="*/ 1436418 h 5025119"/>
              <a:gd name="connsiteX180" fmla="*/ 6567037 w 6886274"/>
              <a:gd name="connsiteY180" fmla="*/ 1348199 h 5025119"/>
              <a:gd name="connsiteX181" fmla="*/ 6596816 w 6886274"/>
              <a:gd name="connsiteY181" fmla="*/ 1286781 h 5025119"/>
              <a:gd name="connsiteX182" fmla="*/ 6632178 w 6886274"/>
              <a:gd name="connsiteY182" fmla="*/ 1261842 h 5025119"/>
              <a:gd name="connsiteX183" fmla="*/ 6639994 w 6886274"/>
              <a:gd name="connsiteY183" fmla="*/ 1240625 h 5025119"/>
              <a:gd name="connsiteX184" fmla="*/ 6622127 w 6886274"/>
              <a:gd name="connsiteY184" fmla="*/ 1136400 h 5025119"/>
              <a:gd name="connsiteX185" fmla="*/ 6612077 w 6886274"/>
              <a:gd name="connsiteY185" fmla="*/ 1109599 h 5025119"/>
              <a:gd name="connsiteX186" fmla="*/ 6531675 w 6886274"/>
              <a:gd name="connsiteY186" fmla="*/ 1009469 h 5025119"/>
              <a:gd name="connsiteX187" fmla="*/ 6456113 w 6886274"/>
              <a:gd name="connsiteY187" fmla="*/ 845315 h 5025119"/>
              <a:gd name="connsiteX188" fmla="*/ 6440851 w 6886274"/>
              <a:gd name="connsiteY188" fmla="*/ 739229 h 5025119"/>
              <a:gd name="connsiteX189" fmla="*/ 6434523 w 6886274"/>
              <a:gd name="connsiteY189" fmla="*/ 715034 h 5025119"/>
              <a:gd name="connsiteX190" fmla="*/ 6432290 w 6886274"/>
              <a:gd name="connsiteY190" fmla="*/ 617510 h 5025119"/>
              <a:gd name="connsiteX191" fmla="*/ 6416284 w 6886274"/>
              <a:gd name="connsiteY191" fmla="*/ 595176 h 5025119"/>
              <a:gd name="connsiteX192" fmla="*/ 6267763 w 6886274"/>
              <a:gd name="connsiteY192" fmla="*/ 591826 h 5025119"/>
              <a:gd name="connsiteX193" fmla="*/ 6236496 w 6886274"/>
              <a:gd name="connsiteY193" fmla="*/ 521102 h 5025119"/>
              <a:gd name="connsiteX194" fmla="*/ 6257341 w 6886274"/>
              <a:gd name="connsiteY194" fmla="*/ 487229 h 5025119"/>
              <a:gd name="connsiteX195" fmla="*/ 6248780 w 6886274"/>
              <a:gd name="connsiteY195" fmla="*/ 465267 h 5025119"/>
              <a:gd name="connsiteX196" fmla="*/ 6226818 w 6886274"/>
              <a:gd name="connsiteY196" fmla="*/ 473456 h 5025119"/>
              <a:gd name="connsiteX197" fmla="*/ 6115149 w 6886274"/>
              <a:gd name="connsiteY197" fmla="*/ 551625 h 5025119"/>
              <a:gd name="connsiteX198" fmla="*/ 5951739 w 6886274"/>
              <a:gd name="connsiteY198" fmla="*/ 659944 h 5025119"/>
              <a:gd name="connsiteX199" fmla="*/ 5917122 w 6886274"/>
              <a:gd name="connsiteY199" fmla="*/ 644310 h 5025119"/>
              <a:gd name="connsiteX200" fmla="*/ 5890694 w 6886274"/>
              <a:gd name="connsiteY200" fmla="*/ 630538 h 5025119"/>
              <a:gd name="connsiteX201" fmla="*/ 5837464 w 6886274"/>
              <a:gd name="connsiteY201" fmla="*/ 646916 h 5025119"/>
              <a:gd name="connsiteX202" fmla="*/ 5809175 w 6886274"/>
              <a:gd name="connsiteY202" fmla="*/ 683395 h 5025119"/>
              <a:gd name="connsiteX203" fmla="*/ 5815503 w 6886274"/>
              <a:gd name="connsiteY203" fmla="*/ 698656 h 5025119"/>
              <a:gd name="connsiteX204" fmla="*/ 5746268 w 6886274"/>
              <a:gd name="connsiteY204" fmla="*/ 667389 h 5025119"/>
              <a:gd name="connsiteX205" fmla="*/ 5458905 w 6886274"/>
              <a:gd name="connsiteY205" fmla="*/ 754119 h 5025119"/>
              <a:gd name="connsiteX206" fmla="*/ 885302 w 6886274"/>
              <a:gd name="connsiteY206" fmla="*/ 1333310 h 5025119"/>
              <a:gd name="connsiteX207" fmla="*/ 862596 w 6886274"/>
              <a:gd name="connsiteY207" fmla="*/ 1314326 h 5025119"/>
              <a:gd name="connsiteX208" fmla="*/ 866318 w 6886274"/>
              <a:gd name="connsiteY208" fmla="*/ 1309860 h 5025119"/>
              <a:gd name="connsiteX209" fmla="*/ 912103 w 6886274"/>
              <a:gd name="connsiteY209" fmla="*/ 1341127 h 5025119"/>
              <a:gd name="connsiteX210" fmla="*/ 885302 w 6886274"/>
              <a:gd name="connsiteY210" fmla="*/ 1333310 h 5025119"/>
              <a:gd name="connsiteX211" fmla="*/ 1140280 w 6886274"/>
              <a:gd name="connsiteY211" fmla="*/ 787619 h 5025119"/>
              <a:gd name="connsiteX212" fmla="*/ 1414987 w 6886274"/>
              <a:gd name="connsiteY212" fmla="*/ 975596 h 5025119"/>
              <a:gd name="connsiteX213" fmla="*/ 1410892 w 6886274"/>
              <a:gd name="connsiteY213" fmla="*/ 980063 h 5025119"/>
              <a:gd name="connsiteX214" fmla="*/ 1140280 w 6886274"/>
              <a:gd name="connsiteY214" fmla="*/ 787619 h 502511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Lst>
            <a:rect l="l" t="t" r="r" b="b"/>
            <a:pathLst>
              <a:path w="6886274" h="5025119">
                <a:moveTo>
                  <a:pt x="5458905" y="754119"/>
                </a:moveTo>
                <a:cubicBezTo>
                  <a:pt x="5417216" y="775336"/>
                  <a:pt x="4594585" y="1111088"/>
                  <a:pt x="3455557" y="1027709"/>
                </a:cubicBezTo>
                <a:cubicBezTo>
                  <a:pt x="3415356" y="1024731"/>
                  <a:pt x="3377389" y="1022869"/>
                  <a:pt x="3338677" y="1021381"/>
                </a:cubicBezTo>
                <a:cubicBezTo>
                  <a:pt x="2996224" y="1006119"/>
                  <a:pt x="2660100" y="998674"/>
                  <a:pt x="2518280" y="980435"/>
                </a:cubicBezTo>
                <a:cubicBezTo>
                  <a:pt x="2407355" y="965918"/>
                  <a:pt x="1840075" y="843082"/>
                  <a:pt x="1673687" y="739229"/>
                </a:cubicBezTo>
                <a:cubicBezTo>
                  <a:pt x="1503578" y="632771"/>
                  <a:pt x="1343146" y="515146"/>
                  <a:pt x="1183459" y="397149"/>
                </a:cubicBezTo>
                <a:cubicBezTo>
                  <a:pt x="1114224" y="346153"/>
                  <a:pt x="1040522" y="299624"/>
                  <a:pt x="977987" y="241184"/>
                </a:cubicBezTo>
                <a:cubicBezTo>
                  <a:pt x="915453" y="182372"/>
                  <a:pt x="855896" y="121326"/>
                  <a:pt x="788150" y="66980"/>
                </a:cubicBezTo>
                <a:cubicBezTo>
                  <a:pt x="768794" y="51346"/>
                  <a:pt x="749438" y="34596"/>
                  <a:pt x="721148" y="31990"/>
                </a:cubicBezTo>
                <a:cubicBezTo>
                  <a:pt x="714820" y="31246"/>
                  <a:pt x="708120" y="31618"/>
                  <a:pt x="701792" y="32362"/>
                </a:cubicBezTo>
                <a:cubicBezTo>
                  <a:pt x="694720" y="33107"/>
                  <a:pt x="689136" y="36829"/>
                  <a:pt x="686530" y="43157"/>
                </a:cubicBezTo>
                <a:cubicBezTo>
                  <a:pt x="683925" y="50230"/>
                  <a:pt x="688392" y="54324"/>
                  <a:pt x="693603" y="58046"/>
                </a:cubicBezTo>
                <a:cubicBezTo>
                  <a:pt x="697325" y="60652"/>
                  <a:pt x="701047" y="64747"/>
                  <a:pt x="705886" y="65491"/>
                </a:cubicBezTo>
                <a:cubicBezTo>
                  <a:pt x="736782" y="69958"/>
                  <a:pt x="748321" y="92664"/>
                  <a:pt x="762838" y="112764"/>
                </a:cubicBezTo>
                <a:cubicBezTo>
                  <a:pt x="769166" y="121326"/>
                  <a:pt x="775866" y="128026"/>
                  <a:pt x="764327" y="140309"/>
                </a:cubicBezTo>
                <a:cubicBezTo>
                  <a:pt x="754277" y="151104"/>
                  <a:pt x="764699" y="156688"/>
                  <a:pt x="775121" y="159666"/>
                </a:cubicBezTo>
                <a:cubicBezTo>
                  <a:pt x="789638" y="163760"/>
                  <a:pt x="806761" y="163016"/>
                  <a:pt x="823139" y="176416"/>
                </a:cubicBezTo>
                <a:cubicBezTo>
                  <a:pt x="761721" y="177533"/>
                  <a:pt x="735665" y="142171"/>
                  <a:pt x="707748" y="109414"/>
                </a:cubicBezTo>
                <a:cubicBezTo>
                  <a:pt x="697325" y="97503"/>
                  <a:pt x="690253" y="83358"/>
                  <a:pt x="681319" y="69958"/>
                </a:cubicBezTo>
                <a:cubicBezTo>
                  <a:pt x="670152" y="53580"/>
                  <a:pt x="657124" y="52835"/>
                  <a:pt x="640746" y="67352"/>
                </a:cubicBezTo>
                <a:cubicBezTo>
                  <a:pt x="626229" y="80380"/>
                  <a:pt x="619157" y="79264"/>
                  <a:pt x="614318" y="61396"/>
                </a:cubicBezTo>
                <a:cubicBezTo>
                  <a:pt x="606873" y="33479"/>
                  <a:pt x="589750" y="13751"/>
                  <a:pt x="560716" y="3701"/>
                </a:cubicBezTo>
                <a:cubicBezTo>
                  <a:pt x="554388" y="1467"/>
                  <a:pt x="546572" y="-3372"/>
                  <a:pt x="540616" y="3701"/>
                </a:cubicBezTo>
                <a:cubicBezTo>
                  <a:pt x="535405" y="9656"/>
                  <a:pt x="539871" y="16729"/>
                  <a:pt x="543594" y="21940"/>
                </a:cubicBezTo>
                <a:cubicBezTo>
                  <a:pt x="550294" y="31246"/>
                  <a:pt x="556250" y="40179"/>
                  <a:pt x="558855" y="51346"/>
                </a:cubicBezTo>
                <a:cubicBezTo>
                  <a:pt x="560716" y="58791"/>
                  <a:pt x="562578" y="66980"/>
                  <a:pt x="557366" y="72563"/>
                </a:cubicBezTo>
                <a:cubicBezTo>
                  <a:pt x="535777" y="96386"/>
                  <a:pt x="551411" y="107553"/>
                  <a:pt x="570022" y="120209"/>
                </a:cubicBezTo>
                <a:cubicBezTo>
                  <a:pt x="595706" y="137332"/>
                  <a:pt x="605756" y="162643"/>
                  <a:pt x="599801" y="192794"/>
                </a:cubicBezTo>
                <a:cubicBezTo>
                  <a:pt x="597567" y="205078"/>
                  <a:pt x="599056" y="212522"/>
                  <a:pt x="614318" y="212150"/>
                </a:cubicBezTo>
                <a:cubicBezTo>
                  <a:pt x="620273" y="212150"/>
                  <a:pt x="621762" y="216245"/>
                  <a:pt x="623996" y="220711"/>
                </a:cubicBezTo>
                <a:cubicBezTo>
                  <a:pt x="671641" y="326053"/>
                  <a:pt x="740504" y="418366"/>
                  <a:pt x="821278" y="503235"/>
                </a:cubicBezTo>
                <a:cubicBezTo>
                  <a:pt x="886791" y="572098"/>
                  <a:pt x="959004" y="634260"/>
                  <a:pt x="1033822" y="694562"/>
                </a:cubicBezTo>
                <a:cubicBezTo>
                  <a:pt x="1036055" y="696423"/>
                  <a:pt x="1038289" y="698656"/>
                  <a:pt x="1039406" y="702378"/>
                </a:cubicBezTo>
                <a:cubicBezTo>
                  <a:pt x="1004044" y="694934"/>
                  <a:pt x="973521" y="679672"/>
                  <a:pt x="944114" y="662550"/>
                </a:cubicBezTo>
                <a:cubicBezTo>
                  <a:pt x="865946" y="617138"/>
                  <a:pt x="800061" y="558325"/>
                  <a:pt x="733432" y="500629"/>
                </a:cubicBezTo>
                <a:cubicBezTo>
                  <a:pt x="692858" y="465267"/>
                  <a:pt x="651169" y="431022"/>
                  <a:pt x="606501" y="399755"/>
                </a:cubicBezTo>
                <a:cubicBezTo>
                  <a:pt x="599056" y="394543"/>
                  <a:pt x="593845" y="387843"/>
                  <a:pt x="588634" y="381143"/>
                </a:cubicBezTo>
                <a:cubicBezTo>
                  <a:pt x="585656" y="377421"/>
                  <a:pt x="581934" y="374071"/>
                  <a:pt x="575978" y="375560"/>
                </a:cubicBezTo>
                <a:cubicBezTo>
                  <a:pt x="568533" y="377421"/>
                  <a:pt x="567789" y="383004"/>
                  <a:pt x="567044" y="388588"/>
                </a:cubicBezTo>
                <a:cubicBezTo>
                  <a:pt x="564811" y="406455"/>
                  <a:pt x="569650" y="422461"/>
                  <a:pt x="578956" y="437722"/>
                </a:cubicBezTo>
                <a:cubicBezTo>
                  <a:pt x="603151" y="476806"/>
                  <a:pt x="638885" y="506957"/>
                  <a:pt x="675736" y="535619"/>
                </a:cubicBezTo>
                <a:cubicBezTo>
                  <a:pt x="723381" y="572470"/>
                  <a:pt x="769538" y="610810"/>
                  <a:pt x="811600" y="652872"/>
                </a:cubicBezTo>
                <a:cubicBezTo>
                  <a:pt x="814578" y="655850"/>
                  <a:pt x="820161" y="657711"/>
                  <a:pt x="818300" y="666272"/>
                </a:cubicBezTo>
                <a:cubicBezTo>
                  <a:pt x="791872" y="646544"/>
                  <a:pt x="766932" y="627188"/>
                  <a:pt x="741621" y="608576"/>
                </a:cubicBezTo>
                <a:cubicBezTo>
                  <a:pt x="716681" y="589965"/>
                  <a:pt x="691369" y="571353"/>
                  <a:pt x="666430" y="553114"/>
                </a:cubicBezTo>
                <a:cubicBezTo>
                  <a:pt x="660474" y="548647"/>
                  <a:pt x="654146" y="542319"/>
                  <a:pt x="645585" y="547903"/>
                </a:cubicBezTo>
                <a:cubicBezTo>
                  <a:pt x="636652" y="553486"/>
                  <a:pt x="637768" y="562792"/>
                  <a:pt x="640002" y="570236"/>
                </a:cubicBezTo>
                <a:cubicBezTo>
                  <a:pt x="647074" y="592198"/>
                  <a:pt x="659358" y="611554"/>
                  <a:pt x="675736" y="628677"/>
                </a:cubicBezTo>
                <a:cubicBezTo>
                  <a:pt x="731570" y="685256"/>
                  <a:pt x="795966" y="734018"/>
                  <a:pt x="855896" y="786875"/>
                </a:cubicBezTo>
                <a:cubicBezTo>
                  <a:pt x="888280" y="815537"/>
                  <a:pt x="918058" y="846060"/>
                  <a:pt x="946348" y="877699"/>
                </a:cubicBezTo>
                <a:cubicBezTo>
                  <a:pt x="952676" y="884772"/>
                  <a:pt x="952303" y="891472"/>
                  <a:pt x="950442" y="899661"/>
                </a:cubicBezTo>
                <a:cubicBezTo>
                  <a:pt x="942998" y="932790"/>
                  <a:pt x="954537" y="943957"/>
                  <a:pt x="991760" y="937629"/>
                </a:cubicBezTo>
                <a:cubicBezTo>
                  <a:pt x="1003299" y="935767"/>
                  <a:pt x="1011116" y="937629"/>
                  <a:pt x="1018188" y="945445"/>
                </a:cubicBezTo>
                <a:cubicBezTo>
                  <a:pt x="1103802" y="1042225"/>
                  <a:pt x="1205048" y="1123744"/>
                  <a:pt x="1315601" y="1196329"/>
                </a:cubicBezTo>
                <a:cubicBezTo>
                  <a:pt x="1360641" y="1225735"/>
                  <a:pt x="1407170" y="1253653"/>
                  <a:pt x="1454443" y="1279709"/>
                </a:cubicBezTo>
                <a:cubicBezTo>
                  <a:pt x="1454443" y="1281570"/>
                  <a:pt x="1454443" y="1283804"/>
                  <a:pt x="1454443" y="1285665"/>
                </a:cubicBezTo>
                <a:cubicBezTo>
                  <a:pt x="1454071" y="1288270"/>
                  <a:pt x="1453699" y="1289759"/>
                  <a:pt x="1453327" y="1291993"/>
                </a:cubicBezTo>
                <a:cubicBezTo>
                  <a:pt x="1386697" y="1251792"/>
                  <a:pt x="1320812" y="1210474"/>
                  <a:pt x="1256416" y="1166923"/>
                </a:cubicBezTo>
                <a:cubicBezTo>
                  <a:pt x="1081840" y="1048926"/>
                  <a:pt x="915080" y="922367"/>
                  <a:pt x="745715" y="798786"/>
                </a:cubicBezTo>
                <a:cubicBezTo>
                  <a:pt x="688764" y="757096"/>
                  <a:pt x="643724" y="703867"/>
                  <a:pt x="592356" y="656966"/>
                </a:cubicBezTo>
                <a:cubicBezTo>
                  <a:pt x="558111" y="625699"/>
                  <a:pt x="525354" y="592943"/>
                  <a:pt x="485526" y="567259"/>
                </a:cubicBezTo>
                <a:cubicBezTo>
                  <a:pt x="469148" y="556836"/>
                  <a:pt x="452025" y="547530"/>
                  <a:pt x="430063" y="550136"/>
                </a:cubicBezTo>
                <a:cubicBezTo>
                  <a:pt x="421502" y="551253"/>
                  <a:pt x="411824" y="553486"/>
                  <a:pt x="408846" y="563164"/>
                </a:cubicBezTo>
                <a:cubicBezTo>
                  <a:pt x="406240" y="572842"/>
                  <a:pt x="414057" y="577309"/>
                  <a:pt x="421130" y="581403"/>
                </a:cubicBezTo>
                <a:cubicBezTo>
                  <a:pt x="422991" y="582520"/>
                  <a:pt x="424852" y="584009"/>
                  <a:pt x="426713" y="584009"/>
                </a:cubicBezTo>
                <a:cubicBezTo>
                  <a:pt x="462075" y="586242"/>
                  <a:pt x="470264" y="614532"/>
                  <a:pt x="487015" y="635005"/>
                </a:cubicBezTo>
                <a:cubicBezTo>
                  <a:pt x="492226" y="641333"/>
                  <a:pt x="492598" y="647661"/>
                  <a:pt x="487015" y="655105"/>
                </a:cubicBezTo>
                <a:cubicBezTo>
                  <a:pt x="476964" y="668505"/>
                  <a:pt x="484037" y="674461"/>
                  <a:pt x="497437" y="678183"/>
                </a:cubicBezTo>
                <a:cubicBezTo>
                  <a:pt x="510837" y="681906"/>
                  <a:pt x="525354" y="683022"/>
                  <a:pt x="539871" y="691584"/>
                </a:cubicBezTo>
                <a:cubicBezTo>
                  <a:pt x="516793" y="698656"/>
                  <a:pt x="500787" y="691212"/>
                  <a:pt x="485898" y="681906"/>
                </a:cubicBezTo>
                <a:cubicBezTo>
                  <a:pt x="452397" y="661433"/>
                  <a:pt x="430808" y="631282"/>
                  <a:pt x="410335" y="600387"/>
                </a:cubicBezTo>
                <a:cubicBezTo>
                  <a:pt x="406240" y="594431"/>
                  <a:pt x="402890" y="587731"/>
                  <a:pt x="397307" y="582892"/>
                </a:cubicBezTo>
                <a:cubicBezTo>
                  <a:pt x="386884" y="573214"/>
                  <a:pt x="375717" y="572098"/>
                  <a:pt x="363062" y="584009"/>
                </a:cubicBezTo>
                <a:cubicBezTo>
                  <a:pt x="346311" y="599643"/>
                  <a:pt x="340356" y="598526"/>
                  <a:pt x="334772" y="578426"/>
                </a:cubicBezTo>
                <a:cubicBezTo>
                  <a:pt x="327327" y="551253"/>
                  <a:pt x="310577" y="532269"/>
                  <a:pt x="281915" y="522219"/>
                </a:cubicBezTo>
                <a:cubicBezTo>
                  <a:pt x="275960" y="519985"/>
                  <a:pt x="269632" y="517007"/>
                  <a:pt x="263304" y="521846"/>
                </a:cubicBezTo>
                <a:cubicBezTo>
                  <a:pt x="256604" y="527430"/>
                  <a:pt x="261070" y="533013"/>
                  <a:pt x="263676" y="538225"/>
                </a:cubicBezTo>
                <a:cubicBezTo>
                  <a:pt x="267398" y="546414"/>
                  <a:pt x="271865" y="554603"/>
                  <a:pt x="275215" y="563164"/>
                </a:cubicBezTo>
                <a:cubicBezTo>
                  <a:pt x="281171" y="576937"/>
                  <a:pt x="282288" y="591454"/>
                  <a:pt x="271121" y="604854"/>
                </a:cubicBezTo>
                <a:cubicBezTo>
                  <a:pt x="262931" y="614532"/>
                  <a:pt x="263676" y="620860"/>
                  <a:pt x="274471" y="627560"/>
                </a:cubicBezTo>
                <a:cubicBezTo>
                  <a:pt x="309088" y="648405"/>
                  <a:pt x="331050" y="675578"/>
                  <a:pt x="319138" y="718012"/>
                </a:cubicBezTo>
                <a:cubicBezTo>
                  <a:pt x="317277" y="723968"/>
                  <a:pt x="319511" y="729924"/>
                  <a:pt x="326583" y="729551"/>
                </a:cubicBezTo>
                <a:cubicBezTo>
                  <a:pt x="342217" y="728435"/>
                  <a:pt x="344822" y="738113"/>
                  <a:pt x="349289" y="748163"/>
                </a:cubicBezTo>
                <a:cubicBezTo>
                  <a:pt x="392840" y="844571"/>
                  <a:pt x="455747" y="928695"/>
                  <a:pt x="528332" y="1007608"/>
                </a:cubicBezTo>
                <a:cubicBezTo>
                  <a:pt x="600173" y="1085777"/>
                  <a:pt x="680947" y="1155756"/>
                  <a:pt x="766932" y="1222758"/>
                </a:cubicBezTo>
                <a:cubicBezTo>
                  <a:pt x="742737" y="1220524"/>
                  <a:pt x="711470" y="1206752"/>
                  <a:pt x="681319" y="1190746"/>
                </a:cubicBezTo>
                <a:cubicBezTo>
                  <a:pt x="601662" y="1147939"/>
                  <a:pt x="536149" y="1089871"/>
                  <a:pt x="469520" y="1032920"/>
                </a:cubicBezTo>
                <a:cubicBezTo>
                  <a:pt x="422991" y="993091"/>
                  <a:pt x="377579" y="952146"/>
                  <a:pt x="325466" y="917900"/>
                </a:cubicBezTo>
                <a:cubicBezTo>
                  <a:pt x="319511" y="914178"/>
                  <a:pt x="315416" y="909339"/>
                  <a:pt x="312066" y="903383"/>
                </a:cubicBezTo>
                <a:cubicBezTo>
                  <a:pt x="309088" y="898172"/>
                  <a:pt x="304621" y="893333"/>
                  <a:pt x="296805" y="895566"/>
                </a:cubicBezTo>
                <a:cubicBezTo>
                  <a:pt x="288988" y="898172"/>
                  <a:pt x="288243" y="904872"/>
                  <a:pt x="288243" y="910828"/>
                </a:cubicBezTo>
                <a:cubicBezTo>
                  <a:pt x="289360" y="933162"/>
                  <a:pt x="295688" y="953262"/>
                  <a:pt x="309460" y="971129"/>
                </a:cubicBezTo>
                <a:cubicBezTo>
                  <a:pt x="336261" y="1006864"/>
                  <a:pt x="371995" y="1034781"/>
                  <a:pt x="407729" y="1062698"/>
                </a:cubicBezTo>
                <a:cubicBezTo>
                  <a:pt x="457236" y="1101038"/>
                  <a:pt x="503021" y="1142728"/>
                  <a:pt x="544338" y="1189257"/>
                </a:cubicBezTo>
                <a:cubicBezTo>
                  <a:pt x="514560" y="1166551"/>
                  <a:pt x="484781" y="1143472"/>
                  <a:pt x="454630" y="1120766"/>
                </a:cubicBezTo>
                <a:cubicBezTo>
                  <a:pt x="431924" y="1103644"/>
                  <a:pt x="408474" y="1087265"/>
                  <a:pt x="385396" y="1070515"/>
                </a:cubicBezTo>
                <a:cubicBezTo>
                  <a:pt x="379812" y="1066421"/>
                  <a:pt x="373856" y="1061954"/>
                  <a:pt x="366040" y="1067537"/>
                </a:cubicBezTo>
                <a:cubicBezTo>
                  <a:pt x="358967" y="1072376"/>
                  <a:pt x="360084" y="1079449"/>
                  <a:pt x="361573" y="1086149"/>
                </a:cubicBezTo>
                <a:cubicBezTo>
                  <a:pt x="367156" y="1112577"/>
                  <a:pt x="382790" y="1133794"/>
                  <a:pt x="402146" y="1152778"/>
                </a:cubicBezTo>
                <a:cubicBezTo>
                  <a:pt x="425596" y="1175484"/>
                  <a:pt x="450164" y="1197074"/>
                  <a:pt x="475475" y="1218663"/>
                </a:cubicBezTo>
                <a:cubicBezTo>
                  <a:pt x="448303" y="1212707"/>
                  <a:pt x="421130" y="1206752"/>
                  <a:pt x="393957" y="1201913"/>
                </a:cubicBezTo>
                <a:cubicBezTo>
                  <a:pt x="406240" y="1245091"/>
                  <a:pt x="434902" y="1253653"/>
                  <a:pt x="460586" y="1260353"/>
                </a:cubicBezTo>
                <a:cubicBezTo>
                  <a:pt x="495204" y="1268914"/>
                  <a:pt x="528332" y="1279709"/>
                  <a:pt x="561089" y="1291993"/>
                </a:cubicBezTo>
                <a:cubicBezTo>
                  <a:pt x="574861" y="1304276"/>
                  <a:pt x="588634" y="1316188"/>
                  <a:pt x="602034" y="1328843"/>
                </a:cubicBezTo>
                <a:cubicBezTo>
                  <a:pt x="615807" y="1341872"/>
                  <a:pt x="628835" y="1354900"/>
                  <a:pt x="641863" y="1368672"/>
                </a:cubicBezTo>
                <a:cubicBezTo>
                  <a:pt x="651169" y="1378722"/>
                  <a:pt x="662335" y="1387284"/>
                  <a:pt x="651541" y="1404406"/>
                </a:cubicBezTo>
                <a:cubicBezTo>
                  <a:pt x="646702" y="1412223"/>
                  <a:pt x="678341" y="1454658"/>
                  <a:pt x="688392" y="1457263"/>
                </a:cubicBezTo>
                <a:cubicBezTo>
                  <a:pt x="689881" y="1457635"/>
                  <a:pt x="691369" y="1458008"/>
                  <a:pt x="692486" y="1458008"/>
                </a:cubicBezTo>
                <a:cubicBezTo>
                  <a:pt x="714076" y="1456519"/>
                  <a:pt x="718915" y="1469175"/>
                  <a:pt x="719287" y="1485181"/>
                </a:cubicBezTo>
                <a:cubicBezTo>
                  <a:pt x="719659" y="1500814"/>
                  <a:pt x="715937" y="1520170"/>
                  <a:pt x="745343" y="1512353"/>
                </a:cubicBezTo>
                <a:cubicBezTo>
                  <a:pt x="748693" y="1511609"/>
                  <a:pt x="749438" y="1513842"/>
                  <a:pt x="750926" y="1516448"/>
                </a:cubicBezTo>
                <a:cubicBezTo>
                  <a:pt x="782938" y="1583077"/>
                  <a:pt x="836912" y="1634445"/>
                  <a:pt x="890141" y="1685813"/>
                </a:cubicBezTo>
                <a:cubicBezTo>
                  <a:pt x="893119" y="1688419"/>
                  <a:pt x="896097" y="1691024"/>
                  <a:pt x="899074" y="1693630"/>
                </a:cubicBezTo>
                <a:cubicBezTo>
                  <a:pt x="843240" y="1680602"/>
                  <a:pt x="658985" y="1663851"/>
                  <a:pt x="605012" y="1669435"/>
                </a:cubicBezTo>
                <a:cubicBezTo>
                  <a:pt x="556994" y="1674274"/>
                  <a:pt x="285638" y="1593128"/>
                  <a:pt x="229431" y="1545110"/>
                </a:cubicBezTo>
                <a:cubicBezTo>
                  <a:pt x="221614" y="1582705"/>
                  <a:pt x="238364" y="1597594"/>
                  <a:pt x="251765" y="1614717"/>
                </a:cubicBezTo>
                <a:cubicBezTo>
                  <a:pt x="270748" y="1638912"/>
                  <a:pt x="273726" y="1656035"/>
                  <a:pt x="237992" y="1675391"/>
                </a:cubicBezTo>
                <a:cubicBezTo>
                  <a:pt x="135628" y="1730481"/>
                  <a:pt x="136745" y="1732342"/>
                  <a:pt x="232781" y="1807160"/>
                </a:cubicBezTo>
                <a:cubicBezTo>
                  <a:pt x="237248" y="1810511"/>
                  <a:pt x="235014" y="1821305"/>
                  <a:pt x="236131" y="1828750"/>
                </a:cubicBezTo>
                <a:cubicBezTo>
                  <a:pt x="211191" y="1839917"/>
                  <a:pt x="181785" y="1810883"/>
                  <a:pt x="152007" y="1842150"/>
                </a:cubicBezTo>
                <a:cubicBezTo>
                  <a:pt x="280426" y="1979503"/>
                  <a:pt x="475848" y="2110157"/>
                  <a:pt x="653030" y="2213265"/>
                </a:cubicBezTo>
                <a:cubicBezTo>
                  <a:pt x="509721" y="2247138"/>
                  <a:pt x="423735" y="2128024"/>
                  <a:pt x="318394" y="2143285"/>
                </a:cubicBezTo>
                <a:cubicBezTo>
                  <a:pt x="265909" y="2180508"/>
                  <a:pt x="422246" y="2240810"/>
                  <a:pt x="272982" y="2258305"/>
                </a:cubicBezTo>
                <a:cubicBezTo>
                  <a:pt x="337750" y="2291061"/>
                  <a:pt x="385768" y="2323073"/>
                  <a:pt x="430435" y="2360668"/>
                </a:cubicBezTo>
                <a:cubicBezTo>
                  <a:pt x="509721" y="2428042"/>
                  <a:pt x="525354" y="2472710"/>
                  <a:pt x="488876" y="2563162"/>
                </a:cubicBezTo>
                <a:cubicBezTo>
                  <a:pt x="464681" y="2622719"/>
                  <a:pt x="429691" y="2677437"/>
                  <a:pt x="460586" y="2748533"/>
                </a:cubicBezTo>
                <a:cubicBezTo>
                  <a:pt x="481803" y="2797295"/>
                  <a:pt x="473614" y="2829307"/>
                  <a:pt x="393212" y="2807345"/>
                </a:cubicBezTo>
                <a:cubicBezTo>
                  <a:pt x="306483" y="2783895"/>
                  <a:pt x="273726" y="2827818"/>
                  <a:pt x="295688" y="2913059"/>
                </a:cubicBezTo>
                <a:cubicBezTo>
                  <a:pt x="309833" y="2967777"/>
                  <a:pt x="294943" y="2984900"/>
                  <a:pt x="235386" y="2978572"/>
                </a:cubicBezTo>
                <a:cubicBezTo>
                  <a:pt x="169501" y="2971499"/>
                  <a:pt x="106967" y="2935765"/>
                  <a:pt x="25448" y="2952888"/>
                </a:cubicBezTo>
                <a:cubicBezTo>
                  <a:pt x="90588" y="3052646"/>
                  <a:pt x="229803" y="3024356"/>
                  <a:pt x="305738" y="3119275"/>
                </a:cubicBezTo>
                <a:cubicBezTo>
                  <a:pt x="215286" y="3119647"/>
                  <a:pt x="146051" y="3119275"/>
                  <a:pt x="79049" y="3098430"/>
                </a:cubicBezTo>
                <a:cubicBezTo>
                  <a:pt x="51132" y="3089869"/>
                  <a:pt x="20609" y="3081308"/>
                  <a:pt x="4975" y="3109969"/>
                </a:cubicBezTo>
                <a:cubicBezTo>
                  <a:pt x="-13636" y="3144587"/>
                  <a:pt x="24331" y="3157615"/>
                  <a:pt x="47037" y="3163943"/>
                </a:cubicBezTo>
                <a:cubicBezTo>
                  <a:pt x="111061" y="3181438"/>
                  <a:pt x="160196" y="3222755"/>
                  <a:pt x="213425" y="3255139"/>
                </a:cubicBezTo>
                <a:cubicBezTo>
                  <a:pt x="329933" y="3326236"/>
                  <a:pt x="457981" y="3385420"/>
                  <a:pt x="556622" y="3502301"/>
                </a:cubicBezTo>
                <a:cubicBezTo>
                  <a:pt x="432669" y="3472523"/>
                  <a:pt x="339983" y="3402915"/>
                  <a:pt x="224592" y="3388771"/>
                </a:cubicBezTo>
                <a:cubicBezTo>
                  <a:pt x="324722" y="3495601"/>
                  <a:pt x="453142" y="3565208"/>
                  <a:pt x="574861" y="3643004"/>
                </a:cubicBezTo>
                <a:cubicBezTo>
                  <a:pt x="609479" y="3664966"/>
                  <a:pt x="644841" y="3679855"/>
                  <a:pt x="652657" y="3727501"/>
                </a:cubicBezTo>
                <a:cubicBezTo>
                  <a:pt x="667919" y="3819814"/>
                  <a:pt x="712959" y="3896494"/>
                  <a:pt x="810111" y="3937067"/>
                </a:cubicBezTo>
                <a:cubicBezTo>
                  <a:pt x="810856" y="3937439"/>
                  <a:pt x="805644" y="3951212"/>
                  <a:pt x="802294" y="3960890"/>
                </a:cubicBezTo>
                <a:cubicBezTo>
                  <a:pt x="743110" y="3963868"/>
                  <a:pt x="696581" y="3909149"/>
                  <a:pt x="620646" y="3927017"/>
                </a:cubicBezTo>
                <a:cubicBezTo>
                  <a:pt x="692858" y="4001091"/>
                  <a:pt x="753532" y="4067720"/>
                  <a:pt x="856268" y="4103082"/>
                </a:cubicBezTo>
                <a:cubicBezTo>
                  <a:pt x="938531" y="4131372"/>
                  <a:pt x="1040150" y="4147377"/>
                  <a:pt x="1099707" y="4238574"/>
                </a:cubicBezTo>
                <a:cubicBezTo>
                  <a:pt x="1030472" y="4256441"/>
                  <a:pt x="978732" y="4234107"/>
                  <a:pt x="926992" y="4218102"/>
                </a:cubicBezTo>
                <a:cubicBezTo>
                  <a:pt x="847334" y="4193534"/>
                  <a:pt x="769166" y="4165617"/>
                  <a:pt x="689508" y="4140677"/>
                </a:cubicBezTo>
                <a:cubicBezTo>
                  <a:pt x="659358" y="4131372"/>
                  <a:pt x="626229" y="4124299"/>
                  <a:pt x="606873" y="4169711"/>
                </a:cubicBezTo>
                <a:cubicBezTo>
                  <a:pt x="707748" y="4179389"/>
                  <a:pt x="768421" y="4240435"/>
                  <a:pt x="831701" y="4297759"/>
                </a:cubicBezTo>
                <a:cubicBezTo>
                  <a:pt x="867435" y="4330143"/>
                  <a:pt x="896469" y="4373322"/>
                  <a:pt x="960493" y="4356944"/>
                </a:cubicBezTo>
                <a:cubicBezTo>
                  <a:pt x="994366" y="4348382"/>
                  <a:pt x="1015955" y="4372578"/>
                  <a:pt x="1012233" y="4402356"/>
                </a:cubicBezTo>
                <a:cubicBezTo>
                  <a:pt x="999577" y="4507325"/>
                  <a:pt x="1078118" y="4544176"/>
                  <a:pt x="1159636" y="4564276"/>
                </a:cubicBezTo>
                <a:cubicBezTo>
                  <a:pt x="1313740" y="4602616"/>
                  <a:pt x="1442160" y="4692324"/>
                  <a:pt x="1592169" y="4741458"/>
                </a:cubicBezTo>
                <a:cubicBezTo>
                  <a:pt x="1738083" y="4789104"/>
                  <a:pt x="2833187" y="5010209"/>
                  <a:pt x="3110499" y="5032171"/>
                </a:cubicBezTo>
                <a:cubicBezTo>
                  <a:pt x="4807501" y="5166546"/>
                  <a:pt x="6028047" y="4106432"/>
                  <a:pt x="6033630" y="4091915"/>
                </a:cubicBezTo>
                <a:cubicBezTo>
                  <a:pt x="6059314" y="4023797"/>
                  <a:pt x="6122965" y="3994390"/>
                  <a:pt x="6180661" y="3957912"/>
                </a:cubicBezTo>
                <a:cubicBezTo>
                  <a:pt x="6230913" y="3925900"/>
                  <a:pt x="6284514" y="3892027"/>
                  <a:pt x="6305359" y="3837309"/>
                </a:cubicBezTo>
                <a:cubicBezTo>
                  <a:pt x="6332904" y="3764724"/>
                  <a:pt x="6254735" y="3824281"/>
                  <a:pt x="6240218" y="3796364"/>
                </a:cubicBezTo>
                <a:cubicBezTo>
                  <a:pt x="6269997" y="3758768"/>
                  <a:pt x="6316153" y="3724151"/>
                  <a:pt x="6328437" y="3681344"/>
                </a:cubicBezTo>
                <a:cubicBezTo>
                  <a:pt x="6372361" y="3526496"/>
                  <a:pt x="6466907" y="3413710"/>
                  <a:pt x="6608355" y="3326236"/>
                </a:cubicBezTo>
                <a:cubicBezTo>
                  <a:pt x="6648928" y="3300924"/>
                  <a:pt x="6675729" y="3255512"/>
                  <a:pt x="6731191" y="3248067"/>
                </a:cubicBezTo>
                <a:cubicBezTo>
                  <a:pt x="6854400" y="3232061"/>
                  <a:pt x="6815315" y="3106992"/>
                  <a:pt x="6880456" y="3051529"/>
                </a:cubicBezTo>
                <a:cubicBezTo>
                  <a:pt x="6892739" y="3041107"/>
                  <a:pt x="6903907" y="2777939"/>
                  <a:pt x="6901673" y="2763795"/>
                </a:cubicBezTo>
                <a:cubicBezTo>
                  <a:pt x="6898323" y="2743322"/>
                  <a:pt x="6883806" y="2966288"/>
                  <a:pt x="6871150" y="2948421"/>
                </a:cubicBezTo>
                <a:cubicBezTo>
                  <a:pt x="6858494" y="2930182"/>
                  <a:pt x="6839138" y="2914176"/>
                  <a:pt x="6848444" y="2890353"/>
                </a:cubicBezTo>
                <a:cubicBezTo>
                  <a:pt x="6852166" y="2880303"/>
                  <a:pt x="6849561" y="2846058"/>
                  <a:pt x="6878223" y="2873230"/>
                </a:cubicBezTo>
                <a:cubicBezTo>
                  <a:pt x="6956763" y="2946932"/>
                  <a:pt x="6870778" y="2578051"/>
                  <a:pt x="6762459" y="2568745"/>
                </a:cubicBezTo>
                <a:cubicBezTo>
                  <a:pt x="6801915" y="2465637"/>
                  <a:pt x="6801915" y="2465637"/>
                  <a:pt x="6673123" y="2451493"/>
                </a:cubicBezTo>
                <a:cubicBezTo>
                  <a:pt x="6722630" y="2385980"/>
                  <a:pt x="6722630" y="2369229"/>
                  <a:pt x="6662700" y="2346896"/>
                </a:cubicBezTo>
                <a:cubicBezTo>
                  <a:pt x="6605005" y="2325306"/>
                  <a:pt x="6540981" y="2318234"/>
                  <a:pt x="6487752" y="2285105"/>
                </a:cubicBezTo>
                <a:cubicBezTo>
                  <a:pt x="6536887" y="2201353"/>
                  <a:pt x="6550659" y="2104573"/>
                  <a:pt x="6652278" y="2063628"/>
                </a:cubicBezTo>
                <a:cubicBezTo>
                  <a:pt x="6668284" y="2057300"/>
                  <a:pt x="6679079" y="2031988"/>
                  <a:pt x="6668656" y="2017843"/>
                </a:cubicBezTo>
                <a:cubicBezTo>
                  <a:pt x="6631805" y="1965359"/>
                  <a:pt x="6684662" y="1864856"/>
                  <a:pt x="6570015" y="1854062"/>
                </a:cubicBezTo>
                <a:cubicBezTo>
                  <a:pt x="6555870" y="1852573"/>
                  <a:pt x="6542842" y="1842150"/>
                  <a:pt x="6554009" y="1827633"/>
                </a:cubicBezTo>
                <a:cubicBezTo>
                  <a:pt x="6592349" y="1778126"/>
                  <a:pt x="6545820" y="1781476"/>
                  <a:pt x="6517531" y="1775149"/>
                </a:cubicBezTo>
                <a:cubicBezTo>
                  <a:pt x="6483285" y="1767704"/>
                  <a:pt x="6444573" y="1789293"/>
                  <a:pt x="6412934" y="1762493"/>
                </a:cubicBezTo>
                <a:cubicBezTo>
                  <a:pt x="6420378" y="1734203"/>
                  <a:pt x="6447923" y="1734575"/>
                  <a:pt x="6467279" y="1725642"/>
                </a:cubicBezTo>
                <a:cubicBezTo>
                  <a:pt x="6523858" y="1699213"/>
                  <a:pt x="6570015" y="1667946"/>
                  <a:pt x="6572621" y="1600200"/>
                </a:cubicBezTo>
                <a:cubicBezTo>
                  <a:pt x="6574854" y="1545482"/>
                  <a:pt x="6580810" y="1497092"/>
                  <a:pt x="6502641" y="1480341"/>
                </a:cubicBezTo>
                <a:cubicBezTo>
                  <a:pt x="6490358" y="1477736"/>
                  <a:pt x="6484030" y="1470664"/>
                  <a:pt x="6481796" y="1461358"/>
                </a:cubicBezTo>
                <a:cubicBezTo>
                  <a:pt x="6490730" y="1452424"/>
                  <a:pt x="6499291" y="1443118"/>
                  <a:pt x="6509713" y="1436418"/>
                </a:cubicBezTo>
                <a:cubicBezTo>
                  <a:pt x="6544703" y="1414457"/>
                  <a:pt x="6556615" y="1382072"/>
                  <a:pt x="6567037" y="1348199"/>
                </a:cubicBezTo>
                <a:cubicBezTo>
                  <a:pt x="6573737" y="1326610"/>
                  <a:pt x="6581554" y="1305393"/>
                  <a:pt x="6596816" y="1286781"/>
                </a:cubicBezTo>
                <a:cubicBezTo>
                  <a:pt x="6606122" y="1275242"/>
                  <a:pt x="6617661" y="1266681"/>
                  <a:pt x="6632178" y="1261842"/>
                </a:cubicBezTo>
                <a:cubicBezTo>
                  <a:pt x="6644833" y="1257375"/>
                  <a:pt x="6648556" y="1251419"/>
                  <a:pt x="6639994" y="1240625"/>
                </a:cubicBezTo>
                <a:cubicBezTo>
                  <a:pt x="6615799" y="1209729"/>
                  <a:pt x="6606122" y="1175856"/>
                  <a:pt x="6622127" y="1136400"/>
                </a:cubicBezTo>
                <a:cubicBezTo>
                  <a:pt x="6626967" y="1124489"/>
                  <a:pt x="6623617" y="1114066"/>
                  <a:pt x="6612077" y="1109599"/>
                </a:cubicBezTo>
                <a:cubicBezTo>
                  <a:pt x="6564059" y="1090616"/>
                  <a:pt x="6552148" y="1046692"/>
                  <a:pt x="6531675" y="1009469"/>
                </a:cubicBezTo>
                <a:cubicBezTo>
                  <a:pt x="6502641" y="956612"/>
                  <a:pt x="6476213" y="902639"/>
                  <a:pt x="6456113" y="845315"/>
                </a:cubicBezTo>
                <a:cubicBezTo>
                  <a:pt x="6444201" y="811070"/>
                  <a:pt x="6432662" y="777197"/>
                  <a:pt x="6440851" y="739229"/>
                </a:cubicBezTo>
                <a:cubicBezTo>
                  <a:pt x="6442712" y="729924"/>
                  <a:pt x="6439362" y="722107"/>
                  <a:pt x="6434523" y="715034"/>
                </a:cubicBezTo>
                <a:cubicBezTo>
                  <a:pt x="6414050" y="684139"/>
                  <a:pt x="6416656" y="651383"/>
                  <a:pt x="6432290" y="617510"/>
                </a:cubicBezTo>
                <a:cubicBezTo>
                  <a:pt x="6441968" y="597037"/>
                  <a:pt x="6440851" y="594431"/>
                  <a:pt x="6416284" y="595176"/>
                </a:cubicBezTo>
                <a:cubicBezTo>
                  <a:pt x="6366405" y="596293"/>
                  <a:pt x="6316898" y="598154"/>
                  <a:pt x="6267763" y="591826"/>
                </a:cubicBezTo>
                <a:cubicBezTo>
                  <a:pt x="6212673" y="584753"/>
                  <a:pt x="6194806" y="568375"/>
                  <a:pt x="6236496" y="521102"/>
                </a:cubicBezTo>
                <a:cubicBezTo>
                  <a:pt x="6245430" y="511052"/>
                  <a:pt x="6253246" y="499885"/>
                  <a:pt x="6257341" y="487229"/>
                </a:cubicBezTo>
                <a:cubicBezTo>
                  <a:pt x="6260319" y="477179"/>
                  <a:pt x="6257713" y="470106"/>
                  <a:pt x="6248780" y="465267"/>
                </a:cubicBezTo>
                <a:cubicBezTo>
                  <a:pt x="6238357" y="459312"/>
                  <a:pt x="6232774" y="467501"/>
                  <a:pt x="6226818" y="473456"/>
                </a:cubicBezTo>
                <a:cubicBezTo>
                  <a:pt x="6194434" y="505468"/>
                  <a:pt x="6153861" y="527430"/>
                  <a:pt x="6115149" y="551625"/>
                </a:cubicBezTo>
                <a:cubicBezTo>
                  <a:pt x="6059686" y="586615"/>
                  <a:pt x="6001246" y="617510"/>
                  <a:pt x="5951739" y="659944"/>
                </a:cubicBezTo>
                <a:cubicBezTo>
                  <a:pt x="5939084" y="670739"/>
                  <a:pt x="5918611" y="662550"/>
                  <a:pt x="5917122" y="644310"/>
                </a:cubicBezTo>
                <a:cubicBezTo>
                  <a:pt x="5915633" y="626071"/>
                  <a:pt x="5905583" y="626071"/>
                  <a:pt x="5890694" y="630538"/>
                </a:cubicBezTo>
                <a:cubicBezTo>
                  <a:pt x="5872826" y="635749"/>
                  <a:pt x="5854959" y="640960"/>
                  <a:pt x="5837464" y="646916"/>
                </a:cubicBezTo>
                <a:cubicBezTo>
                  <a:pt x="5819225" y="653244"/>
                  <a:pt x="5811036" y="666644"/>
                  <a:pt x="5809175" y="683395"/>
                </a:cubicBezTo>
                <a:cubicBezTo>
                  <a:pt x="5808430" y="689723"/>
                  <a:pt x="5808803" y="697539"/>
                  <a:pt x="5815503" y="698656"/>
                </a:cubicBezTo>
                <a:cubicBezTo>
                  <a:pt x="5843048" y="703495"/>
                  <a:pt x="5755201" y="682278"/>
                  <a:pt x="5746268" y="667389"/>
                </a:cubicBezTo>
                <a:cubicBezTo>
                  <a:pt x="5745896" y="666644"/>
                  <a:pt x="5525907" y="720246"/>
                  <a:pt x="5458905" y="754119"/>
                </a:cubicBezTo>
                <a:close/>
                <a:moveTo>
                  <a:pt x="885302" y="1333310"/>
                </a:moveTo>
                <a:cubicBezTo>
                  <a:pt x="877857" y="1326982"/>
                  <a:pt x="870040" y="1321027"/>
                  <a:pt x="862596" y="1314326"/>
                </a:cubicBezTo>
                <a:cubicBezTo>
                  <a:pt x="863712" y="1312837"/>
                  <a:pt x="865201" y="1311349"/>
                  <a:pt x="866318" y="1309860"/>
                </a:cubicBezTo>
                <a:cubicBezTo>
                  <a:pt x="881580" y="1320282"/>
                  <a:pt x="896841" y="1330705"/>
                  <a:pt x="912103" y="1341127"/>
                </a:cubicBezTo>
                <a:cubicBezTo>
                  <a:pt x="903541" y="1338522"/>
                  <a:pt x="894235" y="1335916"/>
                  <a:pt x="885302" y="1333310"/>
                </a:cubicBezTo>
                <a:close/>
                <a:moveTo>
                  <a:pt x="1140280" y="787619"/>
                </a:moveTo>
                <a:cubicBezTo>
                  <a:pt x="1231849" y="850154"/>
                  <a:pt x="1323418" y="913061"/>
                  <a:pt x="1414987" y="975596"/>
                </a:cubicBezTo>
                <a:cubicBezTo>
                  <a:pt x="1413498" y="977085"/>
                  <a:pt x="1412381" y="978574"/>
                  <a:pt x="1410892" y="980063"/>
                </a:cubicBezTo>
                <a:cubicBezTo>
                  <a:pt x="1310390" y="927206"/>
                  <a:pt x="1215471" y="868394"/>
                  <a:pt x="1140280" y="787619"/>
                </a:cubicBezTo>
                <a:close/>
              </a:path>
            </a:pathLst>
          </a:custGeom>
          <a:solidFill>
            <a:schemeClr val="accent1">
              <a:alpha val="20000"/>
            </a:schemeClr>
          </a:solidFill>
          <a:ln w="32707" cap="flat">
            <a:noFill/>
            <a:prstDash val="solid"/>
            <a:miter/>
          </a:ln>
        </p:spPr>
        <p:txBody>
          <a:bodyPr rtlCol="0" anchor="ctr"/>
          <a:lstStyle/>
          <a:p>
            <a:endParaRPr lang="en-US" dirty="0"/>
          </a:p>
        </p:txBody>
      </p:sp>
      <p:sp>
        <p:nvSpPr>
          <p:cNvPr id="2" name="Title 1">
            <a:extLst>
              <a:ext uri="{FF2B5EF4-FFF2-40B4-BE49-F238E27FC236}">
                <a16:creationId xmlns:a16="http://schemas.microsoft.com/office/drawing/2014/main" id="{48DB1DFE-8154-440D-93CF-FEF7860E897F}"/>
              </a:ext>
            </a:extLst>
          </p:cNvPr>
          <p:cNvSpPr>
            <a:spLocks noGrp="1"/>
          </p:cNvSpPr>
          <p:nvPr>
            <p:ph type="title"/>
          </p:nvPr>
        </p:nvSpPr>
        <p:spPr>
          <a:xfrm>
            <a:off x="1399032" y="2523744"/>
            <a:ext cx="3831336" cy="1453896"/>
          </a:xfrm>
        </p:spPr>
        <p:txBody>
          <a:bodyPr anchor="b"/>
          <a:lstStyle>
            <a:lvl1pPr algn="ctr">
              <a:defRPr sz="3200"/>
            </a:lvl1pPr>
          </a:lstStyle>
          <a:p>
            <a:r>
              <a:rPr lang="en-US"/>
              <a:t>Click to edit Master title style</a:t>
            </a:r>
            <a:endParaRPr lang="en-US" dirty="0"/>
          </a:p>
        </p:txBody>
      </p:sp>
      <p:sp>
        <p:nvSpPr>
          <p:cNvPr id="3" name="Picture Placeholder 2">
            <a:extLst>
              <a:ext uri="{FF2B5EF4-FFF2-40B4-BE49-F238E27FC236}">
                <a16:creationId xmlns:a16="http://schemas.microsoft.com/office/drawing/2014/main" id="{9CD9D1F5-05CC-48F3-A314-315EF1703043}"/>
              </a:ext>
            </a:extLst>
          </p:cNvPr>
          <p:cNvSpPr>
            <a:spLocks noGrp="1"/>
          </p:cNvSpPr>
          <p:nvPr>
            <p:ph type="pic" idx="1"/>
          </p:nvPr>
        </p:nvSpPr>
        <p:spPr>
          <a:xfrm>
            <a:off x="6711696" y="640079"/>
            <a:ext cx="4837176" cy="5568696"/>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a:extLst>
              <a:ext uri="{FF2B5EF4-FFF2-40B4-BE49-F238E27FC236}">
                <a16:creationId xmlns:a16="http://schemas.microsoft.com/office/drawing/2014/main" id="{211807DE-1178-4BBB-89D8-9046239C2DE9}"/>
              </a:ext>
            </a:extLst>
          </p:cNvPr>
          <p:cNvSpPr>
            <a:spLocks noGrp="1"/>
          </p:cNvSpPr>
          <p:nvPr>
            <p:ph type="body" sz="half" idx="2"/>
          </p:nvPr>
        </p:nvSpPr>
        <p:spPr>
          <a:xfrm>
            <a:off x="1655064" y="4087368"/>
            <a:ext cx="3319272" cy="649224"/>
          </a:xfrm>
        </p:spPr>
        <p:txBody>
          <a:bodyPr>
            <a:noAutofit/>
          </a:bodyPr>
          <a:lstStyle>
            <a:lvl1pPr marL="0" indent="0" algn="ctr">
              <a:buNone/>
              <a:defRPr sz="2000" cap="all" baseline="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D48EA59-A1BC-48B7-9495-6D5C6035B14B}"/>
              </a:ext>
            </a:extLst>
          </p:cNvPr>
          <p:cNvSpPr>
            <a:spLocks noGrp="1"/>
          </p:cNvSpPr>
          <p:nvPr>
            <p:ph type="dt" sz="half" idx="10"/>
          </p:nvPr>
        </p:nvSpPr>
        <p:spPr/>
        <p:txBody>
          <a:bodyPr/>
          <a:lstStyle/>
          <a:p>
            <a:fld id="{3C04E684-10F4-4CC3-A0B9-F03AA7BE37CF}" type="datetimeFigureOut">
              <a:rPr lang="en-US" smtClean="0"/>
              <a:t>5/3/26</a:t>
            </a:fld>
            <a:endParaRPr lang="en-US" dirty="0"/>
          </a:p>
        </p:txBody>
      </p:sp>
      <p:sp>
        <p:nvSpPr>
          <p:cNvPr id="6" name="Footer Placeholder 5">
            <a:extLst>
              <a:ext uri="{FF2B5EF4-FFF2-40B4-BE49-F238E27FC236}">
                <a16:creationId xmlns:a16="http://schemas.microsoft.com/office/drawing/2014/main" id="{49F85A72-B50F-440E-AAD3-53C099F6D9B6}"/>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72C2D00B-4207-4720-8C68-605CAFDD5CA2}"/>
              </a:ext>
            </a:extLst>
          </p:cNvPr>
          <p:cNvSpPr>
            <a:spLocks noGrp="1"/>
          </p:cNvSpPr>
          <p:nvPr>
            <p:ph type="sldNum" sz="quarter" idx="12"/>
          </p:nvPr>
        </p:nvSpPr>
        <p:spPr/>
        <p:txBody>
          <a:bodyPr/>
          <a:lstStyle/>
          <a:p>
            <a:fld id="{51845F5A-061D-4825-9AE9-D7794091C6CF}" type="slidenum">
              <a:rPr lang="en-US" smtClean="0"/>
              <a:t>‹#›</a:t>
            </a:fld>
            <a:endParaRPr lang="en-US" dirty="0"/>
          </a:p>
        </p:txBody>
      </p:sp>
    </p:spTree>
    <p:extLst>
      <p:ext uri="{BB962C8B-B14F-4D97-AF65-F5344CB8AC3E}">
        <p14:creationId xmlns:p14="http://schemas.microsoft.com/office/powerpoint/2010/main" val="27408753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1C888B-58B8-4428-8B1D-4E26FC5DD59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314F67B-D516-42FA-A2CA-2DCD37CFE8D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82BA5FF-4919-4FF8-9C04-06CE156B762F}"/>
              </a:ext>
            </a:extLst>
          </p:cNvPr>
          <p:cNvSpPr>
            <a:spLocks noGrp="1"/>
          </p:cNvSpPr>
          <p:nvPr>
            <p:ph type="dt" sz="half" idx="10"/>
          </p:nvPr>
        </p:nvSpPr>
        <p:spPr/>
        <p:txBody>
          <a:bodyPr/>
          <a:lstStyle/>
          <a:p>
            <a:fld id="{3C04E684-10F4-4CC3-A0B9-F03AA7BE37CF}" type="datetimeFigureOut">
              <a:rPr lang="en-US" smtClean="0"/>
              <a:t>5/3/26</a:t>
            </a:fld>
            <a:endParaRPr lang="en-US" dirty="0"/>
          </a:p>
        </p:txBody>
      </p:sp>
      <p:sp>
        <p:nvSpPr>
          <p:cNvPr id="5" name="Footer Placeholder 4">
            <a:extLst>
              <a:ext uri="{FF2B5EF4-FFF2-40B4-BE49-F238E27FC236}">
                <a16:creationId xmlns:a16="http://schemas.microsoft.com/office/drawing/2014/main" id="{CBEDA970-128E-4150-8E5A-A1B056E83502}"/>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EAEC6CD1-EE5E-42EF-B76D-BB803BA6AB5E}"/>
              </a:ext>
            </a:extLst>
          </p:cNvPr>
          <p:cNvSpPr>
            <a:spLocks noGrp="1"/>
          </p:cNvSpPr>
          <p:nvPr>
            <p:ph type="sldNum" sz="quarter" idx="12"/>
          </p:nvPr>
        </p:nvSpPr>
        <p:spPr/>
        <p:txBody>
          <a:bodyPr/>
          <a:lstStyle/>
          <a:p>
            <a:fld id="{51845F5A-061D-4825-9AE9-D7794091C6CF}" type="slidenum">
              <a:rPr lang="en-US" smtClean="0"/>
              <a:t>‹#›</a:t>
            </a:fld>
            <a:endParaRPr lang="en-US" dirty="0"/>
          </a:p>
        </p:txBody>
      </p:sp>
    </p:spTree>
    <p:extLst>
      <p:ext uri="{BB962C8B-B14F-4D97-AF65-F5344CB8AC3E}">
        <p14:creationId xmlns:p14="http://schemas.microsoft.com/office/powerpoint/2010/main" val="47077171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50C2A1B-34CA-4877-9435-D77DF325757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F255E5E-4A81-44CC-8D99-F56E625D463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19CEECF-A221-4ECC-AD9C-E197D516D24C}"/>
              </a:ext>
            </a:extLst>
          </p:cNvPr>
          <p:cNvSpPr>
            <a:spLocks noGrp="1"/>
          </p:cNvSpPr>
          <p:nvPr>
            <p:ph type="dt" sz="half" idx="10"/>
          </p:nvPr>
        </p:nvSpPr>
        <p:spPr/>
        <p:txBody>
          <a:bodyPr/>
          <a:lstStyle/>
          <a:p>
            <a:fld id="{3C04E684-10F4-4CC3-A0B9-F03AA7BE37CF}" type="datetimeFigureOut">
              <a:rPr lang="en-US" smtClean="0"/>
              <a:t>5/3/26</a:t>
            </a:fld>
            <a:endParaRPr lang="en-US" dirty="0"/>
          </a:p>
        </p:txBody>
      </p:sp>
      <p:sp>
        <p:nvSpPr>
          <p:cNvPr id="5" name="Footer Placeholder 4">
            <a:extLst>
              <a:ext uri="{FF2B5EF4-FFF2-40B4-BE49-F238E27FC236}">
                <a16:creationId xmlns:a16="http://schemas.microsoft.com/office/drawing/2014/main" id="{018F41AE-0DDE-49ED-9F0C-E0E16F599A0E}"/>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B7B47FB7-77F0-4C43-B81E-D04B31C953DA}"/>
              </a:ext>
            </a:extLst>
          </p:cNvPr>
          <p:cNvSpPr>
            <a:spLocks noGrp="1"/>
          </p:cNvSpPr>
          <p:nvPr>
            <p:ph type="sldNum" sz="quarter" idx="12"/>
          </p:nvPr>
        </p:nvSpPr>
        <p:spPr/>
        <p:txBody>
          <a:bodyPr/>
          <a:lstStyle/>
          <a:p>
            <a:fld id="{51845F5A-061D-4825-9AE9-D7794091C6CF}" type="slidenum">
              <a:rPr lang="en-US" smtClean="0"/>
              <a:t>‹#›</a:t>
            </a:fld>
            <a:endParaRPr lang="en-US" dirty="0"/>
          </a:p>
        </p:txBody>
      </p:sp>
    </p:spTree>
    <p:extLst>
      <p:ext uri="{BB962C8B-B14F-4D97-AF65-F5344CB8AC3E}">
        <p14:creationId xmlns:p14="http://schemas.microsoft.com/office/powerpoint/2010/main" val="35116253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7" name="Freeform: Shape 6" descr="Tag=AccentColor&#10;Flavor=Light&#10;Target=Fill">
            <a:extLst>
              <a:ext uri="{FF2B5EF4-FFF2-40B4-BE49-F238E27FC236}">
                <a16:creationId xmlns:a16="http://schemas.microsoft.com/office/drawing/2014/main" id="{13B7BB51-92B8-4089-8DAB-1202A4D1C6A3}"/>
              </a:ext>
            </a:extLst>
          </p:cNvPr>
          <p:cNvSpPr/>
          <p:nvPr/>
        </p:nvSpPr>
        <p:spPr>
          <a:xfrm flipH="1">
            <a:off x="1" y="315111"/>
            <a:ext cx="3021543" cy="1435442"/>
          </a:xfrm>
          <a:custGeom>
            <a:avLst/>
            <a:gdLst>
              <a:gd name="connsiteX0" fmla="*/ 3021543 w 3021543"/>
              <a:gd name="connsiteY0" fmla="*/ 0 h 1435442"/>
              <a:gd name="connsiteX1" fmla="*/ 2963800 w 3021543"/>
              <a:gd name="connsiteY1" fmla="*/ 7242 h 1435442"/>
              <a:gd name="connsiteX2" fmla="*/ 2793803 w 3021543"/>
              <a:gd name="connsiteY2" fmla="*/ 24082 h 1435442"/>
              <a:gd name="connsiteX3" fmla="*/ 2414348 w 3021543"/>
              <a:gd name="connsiteY3" fmla="*/ 29696 h 1435442"/>
              <a:gd name="connsiteX4" fmla="*/ 2091558 w 3021543"/>
              <a:gd name="connsiteY4" fmla="*/ 27450 h 1435442"/>
              <a:gd name="connsiteX5" fmla="*/ 1645319 w 3021543"/>
              <a:gd name="connsiteY5" fmla="*/ 28573 h 1435442"/>
              <a:gd name="connsiteX6" fmla="*/ 1243602 w 3021543"/>
              <a:gd name="connsiteY6" fmla="*/ 60008 h 1435442"/>
              <a:gd name="connsiteX7" fmla="*/ 753851 w 3021543"/>
              <a:gd name="connsiteY7" fmla="*/ 57763 h 1435442"/>
              <a:gd name="connsiteX8" fmla="*/ 465465 w 3021543"/>
              <a:gd name="connsiteY8" fmla="*/ 116142 h 1435442"/>
              <a:gd name="connsiteX9" fmla="*/ 546416 w 3021543"/>
              <a:gd name="connsiteY9" fmla="*/ 136351 h 1435442"/>
              <a:gd name="connsiteX10" fmla="*/ 689091 w 3021543"/>
              <a:gd name="connsiteY10" fmla="*/ 180136 h 1435442"/>
              <a:gd name="connsiteX11" fmla="*/ 704269 w 3021543"/>
              <a:gd name="connsiteY11" fmla="*/ 208203 h 1435442"/>
              <a:gd name="connsiteX12" fmla="*/ 683020 w 3021543"/>
              <a:gd name="connsiteY12" fmla="*/ 221675 h 1435442"/>
              <a:gd name="connsiteX13" fmla="*/ 621295 w 3021543"/>
              <a:gd name="connsiteY13" fmla="*/ 247496 h 1435442"/>
              <a:gd name="connsiteX14" fmla="*/ 848968 w 3021543"/>
              <a:gd name="connsiteY14" fmla="*/ 285668 h 1435442"/>
              <a:gd name="connsiteX15" fmla="*/ 768018 w 3021543"/>
              <a:gd name="connsiteY15" fmla="*/ 309244 h 1435442"/>
              <a:gd name="connsiteX16" fmla="*/ 684032 w 3021543"/>
              <a:gd name="connsiteY16" fmla="*/ 326085 h 1435442"/>
              <a:gd name="connsiteX17" fmla="*/ 592962 w 3021543"/>
              <a:gd name="connsiteY17" fmla="*/ 338434 h 1435442"/>
              <a:gd name="connsiteX18" fmla="*/ 509988 w 3021543"/>
              <a:gd name="connsiteY18" fmla="*/ 363133 h 1435442"/>
              <a:gd name="connsiteX19" fmla="*/ 726531 w 3021543"/>
              <a:gd name="connsiteY19" fmla="*/ 373237 h 1435442"/>
              <a:gd name="connsiteX20" fmla="*/ 614212 w 3021543"/>
              <a:gd name="connsiteY20" fmla="*/ 395691 h 1435442"/>
              <a:gd name="connsiteX21" fmla="*/ 522131 w 3021543"/>
              <a:gd name="connsiteY21" fmla="*/ 424881 h 1435442"/>
              <a:gd name="connsiteX22" fmla="*/ 457370 w 3021543"/>
              <a:gd name="connsiteY22" fmla="*/ 438353 h 1435442"/>
              <a:gd name="connsiteX23" fmla="*/ 388562 w 3021543"/>
              <a:gd name="connsiteY23" fmla="*/ 441721 h 1435442"/>
              <a:gd name="connsiteX24" fmla="*/ 372372 w 3021543"/>
              <a:gd name="connsiteY24" fmla="*/ 463052 h 1435442"/>
              <a:gd name="connsiteX25" fmla="*/ 393622 w 3021543"/>
              <a:gd name="connsiteY25" fmla="*/ 485506 h 1435442"/>
              <a:gd name="connsiteX26" fmla="*/ 426002 w 3021543"/>
              <a:gd name="connsiteY26" fmla="*/ 487751 h 1435442"/>
              <a:gd name="connsiteX27" fmla="*/ 619271 w 3021543"/>
              <a:gd name="connsiteY27" fmla="*/ 493365 h 1435442"/>
              <a:gd name="connsiteX28" fmla="*/ 0 w 3021543"/>
              <a:gd name="connsiteY28" fmla="*/ 542762 h 1435442"/>
              <a:gd name="connsiteX29" fmla="*/ 83986 w 3021543"/>
              <a:gd name="connsiteY29" fmla="*/ 573075 h 1435442"/>
              <a:gd name="connsiteX30" fmla="*/ 112319 w 3021543"/>
              <a:gd name="connsiteY30" fmla="*/ 656154 h 1435442"/>
              <a:gd name="connsiteX31" fmla="*/ 215531 w 3021543"/>
              <a:gd name="connsiteY31" fmla="*/ 703306 h 1435442"/>
              <a:gd name="connsiteX32" fmla="*/ 282315 w 3021543"/>
              <a:gd name="connsiteY32" fmla="*/ 720147 h 1435442"/>
              <a:gd name="connsiteX33" fmla="*/ 435109 w 3021543"/>
              <a:gd name="connsiteY33" fmla="*/ 744846 h 1435442"/>
              <a:gd name="connsiteX34" fmla="*/ 457370 w 3021543"/>
              <a:gd name="connsiteY34" fmla="*/ 785263 h 1435442"/>
              <a:gd name="connsiteX35" fmla="*/ 476596 w 3021543"/>
              <a:gd name="connsiteY35" fmla="*/ 830170 h 1435442"/>
              <a:gd name="connsiteX36" fmla="*/ 517071 w 3021543"/>
              <a:gd name="connsiteY36" fmla="*/ 859360 h 1435442"/>
              <a:gd name="connsiteX37" fmla="*/ 202377 w 3021543"/>
              <a:gd name="connsiteY37" fmla="*/ 854869 h 1435442"/>
              <a:gd name="connsiteX38" fmla="*/ 557546 w 3021543"/>
              <a:gd name="connsiteY38" fmla="*/ 949175 h 1435442"/>
              <a:gd name="connsiteX39" fmla="*/ 526178 w 3021543"/>
              <a:gd name="connsiteY39" fmla="*/ 986223 h 1435442"/>
              <a:gd name="connsiteX40" fmla="*/ 720459 w 3021543"/>
              <a:gd name="connsiteY40" fmla="*/ 1036744 h 1435442"/>
              <a:gd name="connsiteX41" fmla="*/ 616236 w 3021543"/>
              <a:gd name="connsiteY41" fmla="*/ 1042357 h 1435442"/>
              <a:gd name="connsiteX42" fmla="*/ 1222353 w 3021543"/>
              <a:gd name="connsiteY42" fmla="*/ 1253422 h 1435442"/>
              <a:gd name="connsiteX43" fmla="*/ 2087511 w 3021543"/>
              <a:gd name="connsiteY43" fmla="*/ 1406107 h 1435442"/>
              <a:gd name="connsiteX44" fmla="*/ 2425479 w 3021543"/>
              <a:gd name="connsiteY44" fmla="*/ 1435297 h 1435442"/>
              <a:gd name="connsiteX45" fmla="*/ 2809994 w 3021543"/>
              <a:gd name="connsiteY45" fmla="*/ 1426315 h 1435442"/>
              <a:gd name="connsiteX46" fmla="*/ 2953618 w 3021543"/>
              <a:gd name="connsiteY46" fmla="*/ 1417071 h 1435442"/>
              <a:gd name="connsiteX47" fmla="*/ 3021543 w 3021543"/>
              <a:gd name="connsiteY47" fmla="*/ 1407897 h 14354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Lst>
            <a:rect l="l" t="t" r="r" b="b"/>
            <a:pathLst>
              <a:path w="3021543" h="1435442">
                <a:moveTo>
                  <a:pt x="3021543" y="0"/>
                </a:moveTo>
                <a:lnTo>
                  <a:pt x="2963800" y="7242"/>
                </a:lnTo>
                <a:cubicBezTo>
                  <a:pt x="2907134" y="13978"/>
                  <a:pt x="2850469" y="22960"/>
                  <a:pt x="2793803" y="24082"/>
                </a:cubicBezTo>
                <a:cubicBezTo>
                  <a:pt x="2667318" y="27450"/>
                  <a:pt x="2539821" y="19592"/>
                  <a:pt x="2414348" y="29696"/>
                </a:cubicBezTo>
                <a:cubicBezTo>
                  <a:pt x="2307089" y="38677"/>
                  <a:pt x="2198818" y="28573"/>
                  <a:pt x="2091558" y="27450"/>
                </a:cubicBezTo>
                <a:cubicBezTo>
                  <a:pt x="1942812" y="26328"/>
                  <a:pt x="1793053" y="18469"/>
                  <a:pt x="1645319" y="28573"/>
                </a:cubicBezTo>
                <a:cubicBezTo>
                  <a:pt x="1510738" y="36432"/>
                  <a:pt x="1376158" y="38677"/>
                  <a:pt x="1243602" y="60008"/>
                </a:cubicBezTo>
                <a:cubicBezTo>
                  <a:pt x="1079677" y="71235"/>
                  <a:pt x="916765" y="64499"/>
                  <a:pt x="753851" y="57763"/>
                </a:cubicBezTo>
                <a:cubicBezTo>
                  <a:pt x="653675" y="53272"/>
                  <a:pt x="554511" y="38677"/>
                  <a:pt x="465465" y="116142"/>
                </a:cubicBezTo>
                <a:cubicBezTo>
                  <a:pt x="489751" y="134105"/>
                  <a:pt x="519095" y="130737"/>
                  <a:pt x="546416" y="136351"/>
                </a:cubicBezTo>
                <a:cubicBezTo>
                  <a:pt x="594986" y="147578"/>
                  <a:pt x="643557" y="158804"/>
                  <a:pt x="689091" y="180136"/>
                </a:cubicBezTo>
                <a:cubicBezTo>
                  <a:pt x="699210" y="184626"/>
                  <a:pt x="708317" y="193608"/>
                  <a:pt x="704269" y="208203"/>
                </a:cubicBezTo>
                <a:cubicBezTo>
                  <a:pt x="701234" y="219430"/>
                  <a:pt x="691115" y="219430"/>
                  <a:pt x="683020" y="221675"/>
                </a:cubicBezTo>
                <a:cubicBezTo>
                  <a:pt x="664806" y="228411"/>
                  <a:pt x="642545" y="223920"/>
                  <a:pt x="621295" y="247496"/>
                </a:cubicBezTo>
                <a:cubicBezTo>
                  <a:pt x="702245" y="259846"/>
                  <a:pt x="780160" y="236270"/>
                  <a:pt x="848968" y="285668"/>
                </a:cubicBezTo>
                <a:cubicBezTo>
                  <a:pt x="823671" y="310367"/>
                  <a:pt x="795339" y="304753"/>
                  <a:pt x="768018" y="309244"/>
                </a:cubicBezTo>
                <a:cubicBezTo>
                  <a:pt x="739685" y="313735"/>
                  <a:pt x="712365" y="321594"/>
                  <a:pt x="684032" y="326085"/>
                </a:cubicBezTo>
                <a:cubicBezTo>
                  <a:pt x="653675" y="331698"/>
                  <a:pt x="623319" y="332821"/>
                  <a:pt x="592962" y="338434"/>
                </a:cubicBezTo>
                <a:cubicBezTo>
                  <a:pt x="567666" y="342925"/>
                  <a:pt x="540345" y="335066"/>
                  <a:pt x="509988" y="363133"/>
                </a:cubicBezTo>
                <a:cubicBezTo>
                  <a:pt x="584867" y="383342"/>
                  <a:pt x="652663" y="353029"/>
                  <a:pt x="726531" y="373237"/>
                </a:cubicBezTo>
                <a:cubicBezTo>
                  <a:pt x="683020" y="391200"/>
                  <a:pt x="647604" y="385587"/>
                  <a:pt x="614212" y="395691"/>
                </a:cubicBezTo>
                <a:cubicBezTo>
                  <a:pt x="583855" y="405795"/>
                  <a:pt x="547428" y="394568"/>
                  <a:pt x="522131" y="424881"/>
                </a:cubicBezTo>
                <a:cubicBezTo>
                  <a:pt x="502905" y="448457"/>
                  <a:pt x="482668" y="451825"/>
                  <a:pt x="457370" y="438353"/>
                </a:cubicBezTo>
                <a:cubicBezTo>
                  <a:pt x="435109" y="426003"/>
                  <a:pt x="410824" y="429371"/>
                  <a:pt x="388562" y="441721"/>
                </a:cubicBezTo>
                <a:cubicBezTo>
                  <a:pt x="380468" y="446212"/>
                  <a:pt x="372372" y="451825"/>
                  <a:pt x="372372" y="463052"/>
                </a:cubicBezTo>
                <a:cubicBezTo>
                  <a:pt x="372372" y="478770"/>
                  <a:pt x="382491" y="483260"/>
                  <a:pt x="393622" y="485506"/>
                </a:cubicBezTo>
                <a:cubicBezTo>
                  <a:pt x="403741" y="487751"/>
                  <a:pt x="415883" y="489997"/>
                  <a:pt x="426002" y="487751"/>
                </a:cubicBezTo>
                <a:cubicBezTo>
                  <a:pt x="490762" y="475402"/>
                  <a:pt x="554511" y="495610"/>
                  <a:pt x="619271" y="493365"/>
                </a:cubicBezTo>
                <a:cubicBezTo>
                  <a:pt x="415883" y="541640"/>
                  <a:pt x="210471" y="525922"/>
                  <a:pt x="0" y="542762"/>
                </a:cubicBezTo>
                <a:cubicBezTo>
                  <a:pt x="27321" y="576443"/>
                  <a:pt x="62737" y="548376"/>
                  <a:pt x="83986" y="573075"/>
                </a:cubicBezTo>
                <a:cubicBezTo>
                  <a:pt x="63748" y="624719"/>
                  <a:pt x="71844" y="652785"/>
                  <a:pt x="112319" y="656154"/>
                </a:cubicBezTo>
                <a:cubicBezTo>
                  <a:pt x="151782" y="659522"/>
                  <a:pt x="194281" y="641559"/>
                  <a:pt x="215531" y="703306"/>
                </a:cubicBezTo>
                <a:cubicBezTo>
                  <a:pt x="221602" y="722392"/>
                  <a:pt x="259042" y="716779"/>
                  <a:pt x="282315" y="720147"/>
                </a:cubicBezTo>
                <a:cubicBezTo>
                  <a:pt x="332909" y="728005"/>
                  <a:pt x="386539" y="720147"/>
                  <a:pt x="435109" y="744846"/>
                </a:cubicBezTo>
                <a:cubicBezTo>
                  <a:pt x="454335" y="753827"/>
                  <a:pt x="467489" y="760563"/>
                  <a:pt x="457370" y="785263"/>
                </a:cubicBezTo>
                <a:cubicBezTo>
                  <a:pt x="447252" y="811084"/>
                  <a:pt x="460406" y="820066"/>
                  <a:pt x="476596" y="830170"/>
                </a:cubicBezTo>
                <a:cubicBezTo>
                  <a:pt x="488739" y="838028"/>
                  <a:pt x="506953" y="835783"/>
                  <a:pt x="517071" y="859360"/>
                </a:cubicBezTo>
                <a:cubicBezTo>
                  <a:pt x="410824" y="855992"/>
                  <a:pt x="307612" y="836906"/>
                  <a:pt x="202377" y="854869"/>
                </a:cubicBezTo>
                <a:cubicBezTo>
                  <a:pt x="317731" y="899776"/>
                  <a:pt x="444216" y="897531"/>
                  <a:pt x="557546" y="949175"/>
                </a:cubicBezTo>
                <a:cubicBezTo>
                  <a:pt x="553499" y="967137"/>
                  <a:pt x="527190" y="959278"/>
                  <a:pt x="526178" y="986223"/>
                </a:cubicBezTo>
                <a:cubicBezTo>
                  <a:pt x="585879" y="1014290"/>
                  <a:pt x="657723" y="995204"/>
                  <a:pt x="720459" y="1036744"/>
                </a:cubicBezTo>
                <a:cubicBezTo>
                  <a:pt x="684032" y="1055829"/>
                  <a:pt x="650640" y="1024394"/>
                  <a:pt x="616236" y="1042357"/>
                </a:cubicBezTo>
                <a:cubicBezTo>
                  <a:pt x="627367" y="1069302"/>
                  <a:pt x="1131283" y="1235459"/>
                  <a:pt x="1222353" y="1253422"/>
                </a:cubicBezTo>
                <a:cubicBezTo>
                  <a:pt x="1407527" y="1290470"/>
                  <a:pt x="1940788" y="1384776"/>
                  <a:pt x="2087511" y="1406107"/>
                </a:cubicBezTo>
                <a:cubicBezTo>
                  <a:pt x="2200841" y="1421824"/>
                  <a:pt x="2313160" y="1434174"/>
                  <a:pt x="2425479" y="1435297"/>
                </a:cubicBezTo>
                <a:cubicBezTo>
                  <a:pt x="2553988" y="1436419"/>
                  <a:pt x="2681485" y="1430806"/>
                  <a:pt x="2809994" y="1426315"/>
                </a:cubicBezTo>
                <a:cubicBezTo>
                  <a:pt x="2858058" y="1424631"/>
                  <a:pt x="2905933" y="1421684"/>
                  <a:pt x="2953618" y="1417071"/>
                </a:cubicBezTo>
                <a:lnTo>
                  <a:pt x="3021543" y="1407897"/>
                </a:lnTo>
                <a:close/>
              </a:path>
            </a:pathLst>
          </a:custGeom>
          <a:solidFill>
            <a:schemeClr val="accent1">
              <a:alpha val="20000"/>
            </a:schemeClr>
          </a:solidFill>
          <a:ln w="32707" cap="flat">
            <a:noFill/>
            <a:prstDash val="solid"/>
            <a:miter/>
          </a:ln>
        </p:spPr>
        <p:txBody>
          <a:bodyPr wrap="square" rtlCol="0" anchor="ctr">
            <a:noAutofit/>
          </a:bodyPr>
          <a:lstStyle/>
          <a:p>
            <a:endParaRPr lang="en-US" dirty="0"/>
          </a:p>
        </p:txBody>
      </p:sp>
      <p:sp>
        <p:nvSpPr>
          <p:cNvPr id="2" name="Title 1">
            <a:extLst>
              <a:ext uri="{FF2B5EF4-FFF2-40B4-BE49-F238E27FC236}">
                <a16:creationId xmlns:a16="http://schemas.microsoft.com/office/drawing/2014/main" id="{26030E26-A86A-417A-AA64-699AA8DD3DA5}"/>
              </a:ext>
            </a:extLst>
          </p:cNvPr>
          <p:cNvSpPr>
            <a:spLocks noGrp="1"/>
          </p:cNvSpPr>
          <p:nvPr>
            <p:ph type="title"/>
          </p:nvPr>
        </p:nvSpPr>
        <p:spPr/>
        <p:txBody>
          <a:bodyPr>
            <a:normAutofit/>
          </a:bodyPr>
          <a:lstStyle>
            <a:lvl1pPr>
              <a:defRPr sz="4000"/>
            </a:lvl1p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D19CF97E-0E6E-41E9-B75B-0371E744D1E8}"/>
              </a:ext>
            </a:extLst>
          </p:cNvPr>
          <p:cNvSpPr>
            <a:spLocks noGrp="1"/>
          </p:cNvSpPr>
          <p:nvPr>
            <p:ph idx="1"/>
          </p:nvPr>
        </p:nvSpPr>
        <p:spPr>
          <a:xfrm>
            <a:off x="838200" y="2011680"/>
            <a:ext cx="10515600" cy="41605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70BAE770-8363-44CD-8A22-AB26C5C5361B}"/>
              </a:ext>
            </a:extLst>
          </p:cNvPr>
          <p:cNvSpPr>
            <a:spLocks noGrp="1"/>
          </p:cNvSpPr>
          <p:nvPr>
            <p:ph type="dt" sz="half" idx="10"/>
          </p:nvPr>
        </p:nvSpPr>
        <p:spPr/>
        <p:txBody>
          <a:bodyPr/>
          <a:lstStyle/>
          <a:p>
            <a:fld id="{3C04E684-10F4-4CC3-A0B9-F03AA7BE37CF}" type="datetimeFigureOut">
              <a:rPr lang="en-US" smtClean="0"/>
              <a:t>5/3/26</a:t>
            </a:fld>
            <a:endParaRPr lang="en-US" dirty="0"/>
          </a:p>
        </p:txBody>
      </p:sp>
      <p:sp>
        <p:nvSpPr>
          <p:cNvPr id="5" name="Footer Placeholder 4">
            <a:extLst>
              <a:ext uri="{FF2B5EF4-FFF2-40B4-BE49-F238E27FC236}">
                <a16:creationId xmlns:a16="http://schemas.microsoft.com/office/drawing/2014/main" id="{36E618F2-3B8E-4449-91E7-F8AA4960938F}"/>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063428F0-E5C2-42A1-AB2F-1A19FFAD19CF}"/>
              </a:ext>
            </a:extLst>
          </p:cNvPr>
          <p:cNvSpPr>
            <a:spLocks noGrp="1"/>
          </p:cNvSpPr>
          <p:nvPr>
            <p:ph type="sldNum" sz="quarter" idx="12"/>
          </p:nvPr>
        </p:nvSpPr>
        <p:spPr/>
        <p:txBody>
          <a:bodyPr/>
          <a:lstStyle/>
          <a:p>
            <a:fld id="{51845F5A-061D-4825-9AE9-D7794091C6CF}" type="slidenum">
              <a:rPr lang="en-US" smtClean="0"/>
              <a:t>‹#›</a:t>
            </a:fld>
            <a:endParaRPr lang="en-US" dirty="0"/>
          </a:p>
        </p:txBody>
      </p:sp>
    </p:spTree>
    <p:extLst>
      <p:ext uri="{BB962C8B-B14F-4D97-AF65-F5344CB8AC3E}">
        <p14:creationId xmlns:p14="http://schemas.microsoft.com/office/powerpoint/2010/main" val="8505930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7" name="Graphic 9" descr="Tag=AccentColor&#10;Flavor=Light&#10;Target=Fill">
            <a:extLst>
              <a:ext uri="{FF2B5EF4-FFF2-40B4-BE49-F238E27FC236}">
                <a16:creationId xmlns:a16="http://schemas.microsoft.com/office/drawing/2014/main" id="{DB2CE8D6-5B4E-4EBE-9ED5-A1DA7E2A5CDA}"/>
              </a:ext>
            </a:extLst>
          </p:cNvPr>
          <p:cNvSpPr/>
          <p:nvPr/>
        </p:nvSpPr>
        <p:spPr>
          <a:xfrm>
            <a:off x="7209816" y="0"/>
            <a:ext cx="4143984" cy="5747660"/>
          </a:xfrm>
          <a:custGeom>
            <a:avLst/>
            <a:gdLst>
              <a:gd name="connsiteX0" fmla="*/ 0 w 3843750"/>
              <a:gd name="connsiteY0" fmla="*/ 346 h 5956080"/>
              <a:gd name="connsiteX1" fmla="*/ 72373 w 3843750"/>
              <a:gd name="connsiteY1" fmla="*/ 2447534 h 5956080"/>
              <a:gd name="connsiteX2" fmla="*/ 145093 w 3843750"/>
              <a:gd name="connsiteY2" fmla="*/ 3878724 h 5956080"/>
              <a:gd name="connsiteX3" fmla="*/ 237897 w 3843750"/>
              <a:gd name="connsiteY3" fmla="*/ 4208041 h 5956080"/>
              <a:gd name="connsiteX4" fmla="*/ 281875 w 3843750"/>
              <a:gd name="connsiteY4" fmla="*/ 4677601 h 5956080"/>
              <a:gd name="connsiteX5" fmla="*/ 360135 w 3843750"/>
              <a:gd name="connsiteY5" fmla="*/ 5287407 h 5956080"/>
              <a:gd name="connsiteX6" fmla="*/ 414155 w 3843750"/>
              <a:gd name="connsiteY6" fmla="*/ 5817914 h 5956080"/>
              <a:gd name="connsiteX7" fmla="*/ 681487 w 3843750"/>
              <a:gd name="connsiteY7" fmla="*/ 5914873 h 5956080"/>
              <a:gd name="connsiteX8" fmla="*/ 892373 w 3843750"/>
              <a:gd name="connsiteY8" fmla="*/ 5605295 h 5956080"/>
              <a:gd name="connsiteX9" fmla="*/ 1027770 w 3843750"/>
              <a:gd name="connsiteY9" fmla="*/ 5804063 h 5956080"/>
              <a:gd name="connsiteX10" fmla="*/ 1200566 w 3843750"/>
              <a:gd name="connsiteY10" fmla="*/ 5527036 h 5956080"/>
              <a:gd name="connsiteX11" fmla="*/ 1348083 w 3843750"/>
              <a:gd name="connsiteY11" fmla="*/ 5363590 h 5956080"/>
              <a:gd name="connsiteX12" fmla="*/ 1425997 w 3843750"/>
              <a:gd name="connsiteY12" fmla="*/ 4800532 h 5956080"/>
              <a:gd name="connsiteX13" fmla="*/ 1517416 w 3843750"/>
              <a:gd name="connsiteY13" fmla="*/ 4640549 h 5956080"/>
              <a:gd name="connsiteX14" fmla="*/ 1569705 w 3843750"/>
              <a:gd name="connsiteY14" fmla="*/ 4803995 h 5956080"/>
              <a:gd name="connsiteX15" fmla="*/ 1530921 w 3843750"/>
              <a:gd name="connsiteY15" fmla="*/ 5433885 h 5956080"/>
              <a:gd name="connsiteX16" fmla="*/ 1614721 w 3843750"/>
              <a:gd name="connsiteY16" fmla="*/ 5319957 h 5956080"/>
              <a:gd name="connsiteX17" fmla="*/ 1800676 w 3843750"/>
              <a:gd name="connsiteY17" fmla="*/ 4608691 h 5956080"/>
              <a:gd name="connsiteX18" fmla="*/ 1918759 w 3843750"/>
              <a:gd name="connsiteY18" fmla="*/ 4486799 h 5956080"/>
              <a:gd name="connsiteX19" fmla="*/ 2009139 w 3843750"/>
              <a:gd name="connsiteY19" fmla="*/ 4715000 h 5956080"/>
              <a:gd name="connsiteX20" fmla="*/ 2135532 w 3843750"/>
              <a:gd name="connsiteY20" fmla="*/ 5321689 h 5956080"/>
              <a:gd name="connsiteX21" fmla="*/ 2209291 w 3843750"/>
              <a:gd name="connsiteY21" fmla="*/ 5028733 h 5956080"/>
              <a:gd name="connsiteX22" fmla="*/ 2501208 w 3843750"/>
              <a:gd name="connsiteY22" fmla="*/ 4457711 h 5956080"/>
              <a:gd name="connsiteX23" fmla="*/ 2695127 w 3843750"/>
              <a:gd name="connsiteY23" fmla="*/ 4973674 h 5956080"/>
              <a:gd name="connsiteX24" fmla="*/ 2825329 w 3843750"/>
              <a:gd name="connsiteY24" fmla="*/ 4563328 h 5956080"/>
              <a:gd name="connsiteX25" fmla="*/ 2904628 w 3843750"/>
              <a:gd name="connsiteY25" fmla="*/ 4466368 h 5956080"/>
              <a:gd name="connsiteX26" fmla="*/ 2922635 w 3843750"/>
              <a:gd name="connsiteY26" fmla="*/ 4519696 h 5956080"/>
              <a:gd name="connsiteX27" fmla="*/ 3089544 w 3843750"/>
              <a:gd name="connsiteY27" fmla="*/ 3606545 h 5956080"/>
              <a:gd name="connsiteX28" fmla="*/ 3150490 w 3843750"/>
              <a:gd name="connsiteY28" fmla="*/ 3989882 h 5956080"/>
              <a:gd name="connsiteX29" fmla="*/ 3755448 w 3843750"/>
              <a:gd name="connsiteY29" fmla="*/ 1538193 h 5956080"/>
              <a:gd name="connsiteX30" fmla="*/ 3850330 w 3843750"/>
              <a:gd name="connsiteY30" fmla="*/ 0 h 5956080"/>
              <a:gd name="connsiteX31" fmla="*/ 0 w 3843750"/>
              <a:gd name="connsiteY31" fmla="*/ 0 h 59560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Lst>
            <a:rect l="l" t="t" r="r" b="b"/>
            <a:pathLst>
              <a:path w="3843750" h="5956080">
                <a:moveTo>
                  <a:pt x="0" y="346"/>
                </a:moveTo>
                <a:cubicBezTo>
                  <a:pt x="12120" y="1234155"/>
                  <a:pt x="72720" y="2447534"/>
                  <a:pt x="72373" y="2447534"/>
                </a:cubicBezTo>
                <a:cubicBezTo>
                  <a:pt x="72720" y="2449265"/>
                  <a:pt x="114274" y="3641520"/>
                  <a:pt x="145093" y="3878724"/>
                </a:cubicBezTo>
                <a:cubicBezTo>
                  <a:pt x="176258" y="4119392"/>
                  <a:pt x="210194" y="3969797"/>
                  <a:pt x="237897" y="4208041"/>
                </a:cubicBezTo>
                <a:cubicBezTo>
                  <a:pt x="250017" y="4367677"/>
                  <a:pt x="237204" y="4527661"/>
                  <a:pt x="281875" y="4677601"/>
                </a:cubicBezTo>
                <a:cubicBezTo>
                  <a:pt x="278758" y="4908226"/>
                  <a:pt x="338319" y="5059552"/>
                  <a:pt x="360135" y="5287407"/>
                </a:cubicBezTo>
                <a:cubicBezTo>
                  <a:pt x="370177" y="5468860"/>
                  <a:pt x="348015" y="5649274"/>
                  <a:pt x="414155" y="5817914"/>
                </a:cubicBezTo>
                <a:cubicBezTo>
                  <a:pt x="467137" y="5947770"/>
                  <a:pt x="534662" y="6049578"/>
                  <a:pt x="681487" y="5914873"/>
                </a:cubicBezTo>
                <a:cubicBezTo>
                  <a:pt x="680448" y="5747964"/>
                  <a:pt x="925963" y="5772897"/>
                  <a:pt x="892373" y="5605295"/>
                </a:cubicBezTo>
                <a:cubicBezTo>
                  <a:pt x="1003184" y="5641309"/>
                  <a:pt x="945009" y="5759046"/>
                  <a:pt x="1027770" y="5804063"/>
                </a:cubicBezTo>
                <a:cubicBezTo>
                  <a:pt x="1099105" y="5719915"/>
                  <a:pt x="1051664" y="5551968"/>
                  <a:pt x="1200566" y="5527036"/>
                </a:cubicBezTo>
                <a:cubicBezTo>
                  <a:pt x="1352931" y="5564088"/>
                  <a:pt x="1336655" y="5453970"/>
                  <a:pt x="1348083" y="5363590"/>
                </a:cubicBezTo>
                <a:cubicBezTo>
                  <a:pt x="1370938" y="5149586"/>
                  <a:pt x="1389291" y="5009687"/>
                  <a:pt x="1425997" y="4800532"/>
                </a:cubicBezTo>
                <a:cubicBezTo>
                  <a:pt x="1436385" y="4748243"/>
                  <a:pt x="1415608" y="4628775"/>
                  <a:pt x="1517416" y="4640549"/>
                </a:cubicBezTo>
                <a:cubicBezTo>
                  <a:pt x="1596022" y="4651976"/>
                  <a:pt x="1566242" y="4746512"/>
                  <a:pt x="1569705" y="4803995"/>
                </a:cubicBezTo>
                <a:cubicBezTo>
                  <a:pt x="1600177" y="5128809"/>
                  <a:pt x="1532998" y="5109763"/>
                  <a:pt x="1530921" y="5433885"/>
                </a:cubicBezTo>
                <a:cubicBezTo>
                  <a:pt x="1530574" y="5446697"/>
                  <a:pt x="1580786" y="5458125"/>
                  <a:pt x="1614721" y="5319957"/>
                </a:cubicBezTo>
                <a:cubicBezTo>
                  <a:pt x="1681208" y="5047432"/>
                  <a:pt x="1760507" y="4832736"/>
                  <a:pt x="1800676" y="4608691"/>
                </a:cubicBezTo>
                <a:cubicBezTo>
                  <a:pt x="1848463" y="4656824"/>
                  <a:pt x="1889671" y="4439704"/>
                  <a:pt x="1918759" y="4486799"/>
                </a:cubicBezTo>
                <a:cubicBezTo>
                  <a:pt x="1932264" y="4566098"/>
                  <a:pt x="1956503" y="4642626"/>
                  <a:pt x="2009139" y="4715000"/>
                </a:cubicBezTo>
                <a:cubicBezTo>
                  <a:pt x="2054502" y="4933851"/>
                  <a:pt x="2004983" y="5137812"/>
                  <a:pt x="2135532" y="5321689"/>
                </a:cubicBezTo>
                <a:cubicBezTo>
                  <a:pt x="2135532" y="5321689"/>
                  <a:pt x="2137610" y="5265245"/>
                  <a:pt x="2209291" y="5028733"/>
                </a:cubicBezTo>
                <a:cubicBezTo>
                  <a:pt x="2267120" y="4838277"/>
                  <a:pt x="2341225" y="4936622"/>
                  <a:pt x="2501208" y="4457711"/>
                </a:cubicBezTo>
                <a:cubicBezTo>
                  <a:pt x="2545186" y="4641934"/>
                  <a:pt x="2446495" y="4877753"/>
                  <a:pt x="2695127" y="4973674"/>
                </a:cubicBezTo>
                <a:cubicBezTo>
                  <a:pt x="2743260" y="4833775"/>
                  <a:pt x="2706208" y="4662365"/>
                  <a:pt x="2825329" y="4563328"/>
                </a:cubicBezTo>
                <a:cubicBezTo>
                  <a:pt x="2859958" y="4534586"/>
                  <a:pt x="2884890" y="4501689"/>
                  <a:pt x="2904628" y="4466368"/>
                </a:cubicBezTo>
                <a:cubicBezTo>
                  <a:pt x="2910515" y="4484375"/>
                  <a:pt x="2916749" y="4503074"/>
                  <a:pt x="2922635" y="4519696"/>
                </a:cubicBezTo>
                <a:cubicBezTo>
                  <a:pt x="2946529" y="4491647"/>
                  <a:pt x="3082618" y="3784882"/>
                  <a:pt x="3089544" y="3606545"/>
                </a:cubicBezTo>
                <a:cubicBezTo>
                  <a:pt x="3124172" y="3733285"/>
                  <a:pt x="3150490" y="3989882"/>
                  <a:pt x="3150490" y="3989882"/>
                </a:cubicBezTo>
                <a:cubicBezTo>
                  <a:pt x="3150490" y="3989882"/>
                  <a:pt x="3300085" y="3936900"/>
                  <a:pt x="3755448" y="1538193"/>
                </a:cubicBezTo>
                <a:cubicBezTo>
                  <a:pt x="3791461" y="1348775"/>
                  <a:pt x="3824704" y="697762"/>
                  <a:pt x="3850330" y="0"/>
                </a:cubicBezTo>
                <a:lnTo>
                  <a:pt x="0" y="0"/>
                </a:lnTo>
                <a:close/>
              </a:path>
            </a:pathLst>
          </a:custGeom>
          <a:solidFill>
            <a:schemeClr val="accent1">
              <a:alpha val="20000"/>
            </a:schemeClr>
          </a:solidFill>
          <a:ln w="32707" cap="flat">
            <a:noFill/>
            <a:prstDash val="solid"/>
            <a:miter/>
          </a:ln>
        </p:spPr>
        <p:txBody>
          <a:bodyPr rtlCol="0" anchor="ctr"/>
          <a:lstStyle/>
          <a:p>
            <a:endParaRPr lang="en-US" dirty="0"/>
          </a:p>
        </p:txBody>
      </p:sp>
      <p:sp>
        <p:nvSpPr>
          <p:cNvPr id="2" name="Title 1">
            <a:extLst>
              <a:ext uri="{FF2B5EF4-FFF2-40B4-BE49-F238E27FC236}">
                <a16:creationId xmlns:a16="http://schemas.microsoft.com/office/drawing/2014/main" id="{64AD5705-B027-4C44-B38A-60296E29EB12}"/>
              </a:ext>
            </a:extLst>
          </p:cNvPr>
          <p:cNvSpPr>
            <a:spLocks noGrp="1"/>
          </p:cNvSpPr>
          <p:nvPr>
            <p:ph type="title"/>
          </p:nvPr>
        </p:nvSpPr>
        <p:spPr>
          <a:xfrm>
            <a:off x="831850" y="1078991"/>
            <a:ext cx="5266944" cy="3136392"/>
          </a:xfrm>
        </p:spPr>
        <p:txBody>
          <a:bodyPr anchor="b">
            <a:normAutofit/>
          </a:bodyPr>
          <a:lstStyle>
            <a:lvl1pPr>
              <a:defRPr sz="4800"/>
            </a:lvl1p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BE8BBAC4-9088-44CF-BA2D-B8DD24FB5274}"/>
              </a:ext>
            </a:extLst>
          </p:cNvPr>
          <p:cNvSpPr>
            <a:spLocks noGrp="1"/>
          </p:cNvSpPr>
          <p:nvPr>
            <p:ph type="body" idx="1"/>
          </p:nvPr>
        </p:nvSpPr>
        <p:spPr>
          <a:xfrm>
            <a:off x="831850" y="4279392"/>
            <a:ext cx="5266944" cy="1500187"/>
          </a:xfrm>
        </p:spPr>
        <p:txBody>
          <a:bodyPr/>
          <a:lstStyle>
            <a:lvl1pPr marL="0" indent="0">
              <a:buNone/>
              <a:defRPr sz="2400" cap="all" baseline="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793FB3F-D2A6-4919-B57B-C08861D46303}"/>
              </a:ext>
            </a:extLst>
          </p:cNvPr>
          <p:cNvSpPr>
            <a:spLocks noGrp="1"/>
          </p:cNvSpPr>
          <p:nvPr>
            <p:ph type="dt" sz="half" idx="10"/>
          </p:nvPr>
        </p:nvSpPr>
        <p:spPr/>
        <p:txBody>
          <a:bodyPr/>
          <a:lstStyle/>
          <a:p>
            <a:fld id="{3C04E684-10F4-4CC3-A0B9-F03AA7BE37CF}" type="datetimeFigureOut">
              <a:rPr lang="en-US" smtClean="0"/>
              <a:t>5/3/26</a:t>
            </a:fld>
            <a:endParaRPr lang="en-US" dirty="0"/>
          </a:p>
        </p:txBody>
      </p:sp>
      <p:sp>
        <p:nvSpPr>
          <p:cNvPr id="5" name="Footer Placeholder 4">
            <a:extLst>
              <a:ext uri="{FF2B5EF4-FFF2-40B4-BE49-F238E27FC236}">
                <a16:creationId xmlns:a16="http://schemas.microsoft.com/office/drawing/2014/main" id="{989049E0-6BE5-43FA-A4D4-ACAFC871A79F}"/>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DF8C28D-1479-4F15-B906-0AEBBCCA8CFA}"/>
              </a:ext>
            </a:extLst>
          </p:cNvPr>
          <p:cNvSpPr>
            <a:spLocks noGrp="1"/>
          </p:cNvSpPr>
          <p:nvPr>
            <p:ph type="sldNum" sz="quarter" idx="12"/>
          </p:nvPr>
        </p:nvSpPr>
        <p:spPr/>
        <p:txBody>
          <a:bodyPr/>
          <a:lstStyle/>
          <a:p>
            <a:fld id="{51845F5A-061D-4825-9AE9-D7794091C6CF}" type="slidenum">
              <a:rPr lang="en-US" smtClean="0"/>
              <a:t>‹#›</a:t>
            </a:fld>
            <a:endParaRPr lang="en-US" dirty="0"/>
          </a:p>
        </p:txBody>
      </p:sp>
    </p:spTree>
    <p:extLst>
      <p:ext uri="{BB962C8B-B14F-4D97-AF65-F5344CB8AC3E}">
        <p14:creationId xmlns:p14="http://schemas.microsoft.com/office/powerpoint/2010/main" val="35260837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Freeform: Shape 7" descr="Tag=AccentColor&#10;Flavor=Light&#10;Target=Fill">
            <a:extLst>
              <a:ext uri="{FF2B5EF4-FFF2-40B4-BE49-F238E27FC236}">
                <a16:creationId xmlns:a16="http://schemas.microsoft.com/office/drawing/2014/main" id="{FD51F360-8860-4FB5-A0A5-773473DD8B39}"/>
              </a:ext>
            </a:extLst>
          </p:cNvPr>
          <p:cNvSpPr/>
          <p:nvPr/>
        </p:nvSpPr>
        <p:spPr>
          <a:xfrm flipH="1">
            <a:off x="1" y="315111"/>
            <a:ext cx="3021543" cy="1435442"/>
          </a:xfrm>
          <a:custGeom>
            <a:avLst/>
            <a:gdLst>
              <a:gd name="connsiteX0" fmla="*/ 3021543 w 3021543"/>
              <a:gd name="connsiteY0" fmla="*/ 0 h 1435442"/>
              <a:gd name="connsiteX1" fmla="*/ 2963800 w 3021543"/>
              <a:gd name="connsiteY1" fmla="*/ 7242 h 1435442"/>
              <a:gd name="connsiteX2" fmla="*/ 2793803 w 3021543"/>
              <a:gd name="connsiteY2" fmla="*/ 24082 h 1435442"/>
              <a:gd name="connsiteX3" fmla="*/ 2414348 w 3021543"/>
              <a:gd name="connsiteY3" fmla="*/ 29696 h 1435442"/>
              <a:gd name="connsiteX4" fmla="*/ 2091558 w 3021543"/>
              <a:gd name="connsiteY4" fmla="*/ 27450 h 1435442"/>
              <a:gd name="connsiteX5" fmla="*/ 1645319 w 3021543"/>
              <a:gd name="connsiteY5" fmla="*/ 28573 h 1435442"/>
              <a:gd name="connsiteX6" fmla="*/ 1243602 w 3021543"/>
              <a:gd name="connsiteY6" fmla="*/ 60008 h 1435442"/>
              <a:gd name="connsiteX7" fmla="*/ 753851 w 3021543"/>
              <a:gd name="connsiteY7" fmla="*/ 57763 h 1435442"/>
              <a:gd name="connsiteX8" fmla="*/ 465465 w 3021543"/>
              <a:gd name="connsiteY8" fmla="*/ 116142 h 1435442"/>
              <a:gd name="connsiteX9" fmla="*/ 546416 w 3021543"/>
              <a:gd name="connsiteY9" fmla="*/ 136351 h 1435442"/>
              <a:gd name="connsiteX10" fmla="*/ 689091 w 3021543"/>
              <a:gd name="connsiteY10" fmla="*/ 180136 h 1435442"/>
              <a:gd name="connsiteX11" fmla="*/ 704269 w 3021543"/>
              <a:gd name="connsiteY11" fmla="*/ 208203 h 1435442"/>
              <a:gd name="connsiteX12" fmla="*/ 683020 w 3021543"/>
              <a:gd name="connsiteY12" fmla="*/ 221675 h 1435442"/>
              <a:gd name="connsiteX13" fmla="*/ 621295 w 3021543"/>
              <a:gd name="connsiteY13" fmla="*/ 247496 h 1435442"/>
              <a:gd name="connsiteX14" fmla="*/ 848968 w 3021543"/>
              <a:gd name="connsiteY14" fmla="*/ 285668 h 1435442"/>
              <a:gd name="connsiteX15" fmla="*/ 768018 w 3021543"/>
              <a:gd name="connsiteY15" fmla="*/ 309244 h 1435442"/>
              <a:gd name="connsiteX16" fmla="*/ 684032 w 3021543"/>
              <a:gd name="connsiteY16" fmla="*/ 326085 h 1435442"/>
              <a:gd name="connsiteX17" fmla="*/ 592962 w 3021543"/>
              <a:gd name="connsiteY17" fmla="*/ 338434 h 1435442"/>
              <a:gd name="connsiteX18" fmla="*/ 509988 w 3021543"/>
              <a:gd name="connsiteY18" fmla="*/ 363133 h 1435442"/>
              <a:gd name="connsiteX19" fmla="*/ 726531 w 3021543"/>
              <a:gd name="connsiteY19" fmla="*/ 373237 h 1435442"/>
              <a:gd name="connsiteX20" fmla="*/ 614212 w 3021543"/>
              <a:gd name="connsiteY20" fmla="*/ 395691 h 1435442"/>
              <a:gd name="connsiteX21" fmla="*/ 522131 w 3021543"/>
              <a:gd name="connsiteY21" fmla="*/ 424881 h 1435442"/>
              <a:gd name="connsiteX22" fmla="*/ 457370 w 3021543"/>
              <a:gd name="connsiteY22" fmla="*/ 438353 h 1435442"/>
              <a:gd name="connsiteX23" fmla="*/ 388562 w 3021543"/>
              <a:gd name="connsiteY23" fmla="*/ 441721 h 1435442"/>
              <a:gd name="connsiteX24" fmla="*/ 372372 w 3021543"/>
              <a:gd name="connsiteY24" fmla="*/ 463052 h 1435442"/>
              <a:gd name="connsiteX25" fmla="*/ 393622 w 3021543"/>
              <a:gd name="connsiteY25" fmla="*/ 485506 h 1435442"/>
              <a:gd name="connsiteX26" fmla="*/ 426002 w 3021543"/>
              <a:gd name="connsiteY26" fmla="*/ 487751 h 1435442"/>
              <a:gd name="connsiteX27" fmla="*/ 619271 w 3021543"/>
              <a:gd name="connsiteY27" fmla="*/ 493365 h 1435442"/>
              <a:gd name="connsiteX28" fmla="*/ 0 w 3021543"/>
              <a:gd name="connsiteY28" fmla="*/ 542762 h 1435442"/>
              <a:gd name="connsiteX29" fmla="*/ 83986 w 3021543"/>
              <a:gd name="connsiteY29" fmla="*/ 573075 h 1435442"/>
              <a:gd name="connsiteX30" fmla="*/ 112319 w 3021543"/>
              <a:gd name="connsiteY30" fmla="*/ 656154 h 1435442"/>
              <a:gd name="connsiteX31" fmla="*/ 215531 w 3021543"/>
              <a:gd name="connsiteY31" fmla="*/ 703306 h 1435442"/>
              <a:gd name="connsiteX32" fmla="*/ 282315 w 3021543"/>
              <a:gd name="connsiteY32" fmla="*/ 720147 h 1435442"/>
              <a:gd name="connsiteX33" fmla="*/ 435109 w 3021543"/>
              <a:gd name="connsiteY33" fmla="*/ 744846 h 1435442"/>
              <a:gd name="connsiteX34" fmla="*/ 457370 w 3021543"/>
              <a:gd name="connsiteY34" fmla="*/ 785263 h 1435442"/>
              <a:gd name="connsiteX35" fmla="*/ 476596 w 3021543"/>
              <a:gd name="connsiteY35" fmla="*/ 830170 h 1435442"/>
              <a:gd name="connsiteX36" fmla="*/ 517071 w 3021543"/>
              <a:gd name="connsiteY36" fmla="*/ 859360 h 1435442"/>
              <a:gd name="connsiteX37" fmla="*/ 202377 w 3021543"/>
              <a:gd name="connsiteY37" fmla="*/ 854869 h 1435442"/>
              <a:gd name="connsiteX38" fmla="*/ 557546 w 3021543"/>
              <a:gd name="connsiteY38" fmla="*/ 949175 h 1435442"/>
              <a:gd name="connsiteX39" fmla="*/ 526178 w 3021543"/>
              <a:gd name="connsiteY39" fmla="*/ 986223 h 1435442"/>
              <a:gd name="connsiteX40" fmla="*/ 720459 w 3021543"/>
              <a:gd name="connsiteY40" fmla="*/ 1036744 h 1435442"/>
              <a:gd name="connsiteX41" fmla="*/ 616236 w 3021543"/>
              <a:gd name="connsiteY41" fmla="*/ 1042357 h 1435442"/>
              <a:gd name="connsiteX42" fmla="*/ 1222353 w 3021543"/>
              <a:gd name="connsiteY42" fmla="*/ 1253422 h 1435442"/>
              <a:gd name="connsiteX43" fmla="*/ 2087511 w 3021543"/>
              <a:gd name="connsiteY43" fmla="*/ 1406107 h 1435442"/>
              <a:gd name="connsiteX44" fmla="*/ 2425479 w 3021543"/>
              <a:gd name="connsiteY44" fmla="*/ 1435297 h 1435442"/>
              <a:gd name="connsiteX45" fmla="*/ 2809994 w 3021543"/>
              <a:gd name="connsiteY45" fmla="*/ 1426315 h 1435442"/>
              <a:gd name="connsiteX46" fmla="*/ 2953618 w 3021543"/>
              <a:gd name="connsiteY46" fmla="*/ 1417071 h 1435442"/>
              <a:gd name="connsiteX47" fmla="*/ 3021543 w 3021543"/>
              <a:gd name="connsiteY47" fmla="*/ 1407897 h 14354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Lst>
            <a:rect l="l" t="t" r="r" b="b"/>
            <a:pathLst>
              <a:path w="3021543" h="1435442">
                <a:moveTo>
                  <a:pt x="3021543" y="0"/>
                </a:moveTo>
                <a:lnTo>
                  <a:pt x="2963800" y="7242"/>
                </a:lnTo>
                <a:cubicBezTo>
                  <a:pt x="2907134" y="13978"/>
                  <a:pt x="2850469" y="22960"/>
                  <a:pt x="2793803" y="24082"/>
                </a:cubicBezTo>
                <a:cubicBezTo>
                  <a:pt x="2667318" y="27450"/>
                  <a:pt x="2539821" y="19592"/>
                  <a:pt x="2414348" y="29696"/>
                </a:cubicBezTo>
                <a:cubicBezTo>
                  <a:pt x="2307089" y="38677"/>
                  <a:pt x="2198818" y="28573"/>
                  <a:pt x="2091558" y="27450"/>
                </a:cubicBezTo>
                <a:cubicBezTo>
                  <a:pt x="1942812" y="26328"/>
                  <a:pt x="1793053" y="18469"/>
                  <a:pt x="1645319" y="28573"/>
                </a:cubicBezTo>
                <a:cubicBezTo>
                  <a:pt x="1510738" y="36432"/>
                  <a:pt x="1376158" y="38677"/>
                  <a:pt x="1243602" y="60008"/>
                </a:cubicBezTo>
                <a:cubicBezTo>
                  <a:pt x="1079677" y="71235"/>
                  <a:pt x="916765" y="64499"/>
                  <a:pt x="753851" y="57763"/>
                </a:cubicBezTo>
                <a:cubicBezTo>
                  <a:pt x="653675" y="53272"/>
                  <a:pt x="554511" y="38677"/>
                  <a:pt x="465465" y="116142"/>
                </a:cubicBezTo>
                <a:cubicBezTo>
                  <a:pt x="489751" y="134105"/>
                  <a:pt x="519095" y="130737"/>
                  <a:pt x="546416" y="136351"/>
                </a:cubicBezTo>
                <a:cubicBezTo>
                  <a:pt x="594986" y="147578"/>
                  <a:pt x="643557" y="158804"/>
                  <a:pt x="689091" y="180136"/>
                </a:cubicBezTo>
                <a:cubicBezTo>
                  <a:pt x="699210" y="184626"/>
                  <a:pt x="708317" y="193608"/>
                  <a:pt x="704269" y="208203"/>
                </a:cubicBezTo>
                <a:cubicBezTo>
                  <a:pt x="701234" y="219430"/>
                  <a:pt x="691115" y="219430"/>
                  <a:pt x="683020" y="221675"/>
                </a:cubicBezTo>
                <a:cubicBezTo>
                  <a:pt x="664806" y="228411"/>
                  <a:pt x="642545" y="223920"/>
                  <a:pt x="621295" y="247496"/>
                </a:cubicBezTo>
                <a:cubicBezTo>
                  <a:pt x="702245" y="259846"/>
                  <a:pt x="780160" y="236270"/>
                  <a:pt x="848968" y="285668"/>
                </a:cubicBezTo>
                <a:cubicBezTo>
                  <a:pt x="823671" y="310367"/>
                  <a:pt x="795339" y="304753"/>
                  <a:pt x="768018" y="309244"/>
                </a:cubicBezTo>
                <a:cubicBezTo>
                  <a:pt x="739685" y="313735"/>
                  <a:pt x="712365" y="321594"/>
                  <a:pt x="684032" y="326085"/>
                </a:cubicBezTo>
                <a:cubicBezTo>
                  <a:pt x="653675" y="331698"/>
                  <a:pt x="623319" y="332821"/>
                  <a:pt x="592962" y="338434"/>
                </a:cubicBezTo>
                <a:cubicBezTo>
                  <a:pt x="567666" y="342925"/>
                  <a:pt x="540345" y="335066"/>
                  <a:pt x="509988" y="363133"/>
                </a:cubicBezTo>
                <a:cubicBezTo>
                  <a:pt x="584867" y="383342"/>
                  <a:pt x="652663" y="353029"/>
                  <a:pt x="726531" y="373237"/>
                </a:cubicBezTo>
                <a:cubicBezTo>
                  <a:pt x="683020" y="391200"/>
                  <a:pt x="647604" y="385587"/>
                  <a:pt x="614212" y="395691"/>
                </a:cubicBezTo>
                <a:cubicBezTo>
                  <a:pt x="583855" y="405795"/>
                  <a:pt x="547428" y="394568"/>
                  <a:pt x="522131" y="424881"/>
                </a:cubicBezTo>
                <a:cubicBezTo>
                  <a:pt x="502905" y="448457"/>
                  <a:pt x="482668" y="451825"/>
                  <a:pt x="457370" y="438353"/>
                </a:cubicBezTo>
                <a:cubicBezTo>
                  <a:pt x="435109" y="426003"/>
                  <a:pt x="410824" y="429371"/>
                  <a:pt x="388562" y="441721"/>
                </a:cubicBezTo>
                <a:cubicBezTo>
                  <a:pt x="380468" y="446212"/>
                  <a:pt x="372372" y="451825"/>
                  <a:pt x="372372" y="463052"/>
                </a:cubicBezTo>
                <a:cubicBezTo>
                  <a:pt x="372372" y="478770"/>
                  <a:pt x="382491" y="483260"/>
                  <a:pt x="393622" y="485506"/>
                </a:cubicBezTo>
                <a:cubicBezTo>
                  <a:pt x="403741" y="487751"/>
                  <a:pt x="415883" y="489997"/>
                  <a:pt x="426002" y="487751"/>
                </a:cubicBezTo>
                <a:cubicBezTo>
                  <a:pt x="490762" y="475402"/>
                  <a:pt x="554511" y="495610"/>
                  <a:pt x="619271" y="493365"/>
                </a:cubicBezTo>
                <a:cubicBezTo>
                  <a:pt x="415883" y="541640"/>
                  <a:pt x="210471" y="525922"/>
                  <a:pt x="0" y="542762"/>
                </a:cubicBezTo>
                <a:cubicBezTo>
                  <a:pt x="27321" y="576443"/>
                  <a:pt x="62737" y="548376"/>
                  <a:pt x="83986" y="573075"/>
                </a:cubicBezTo>
                <a:cubicBezTo>
                  <a:pt x="63748" y="624719"/>
                  <a:pt x="71844" y="652785"/>
                  <a:pt x="112319" y="656154"/>
                </a:cubicBezTo>
                <a:cubicBezTo>
                  <a:pt x="151782" y="659522"/>
                  <a:pt x="194281" y="641559"/>
                  <a:pt x="215531" y="703306"/>
                </a:cubicBezTo>
                <a:cubicBezTo>
                  <a:pt x="221602" y="722392"/>
                  <a:pt x="259042" y="716779"/>
                  <a:pt x="282315" y="720147"/>
                </a:cubicBezTo>
                <a:cubicBezTo>
                  <a:pt x="332909" y="728005"/>
                  <a:pt x="386539" y="720147"/>
                  <a:pt x="435109" y="744846"/>
                </a:cubicBezTo>
                <a:cubicBezTo>
                  <a:pt x="454335" y="753827"/>
                  <a:pt x="467489" y="760563"/>
                  <a:pt x="457370" y="785263"/>
                </a:cubicBezTo>
                <a:cubicBezTo>
                  <a:pt x="447252" y="811084"/>
                  <a:pt x="460406" y="820066"/>
                  <a:pt x="476596" y="830170"/>
                </a:cubicBezTo>
                <a:cubicBezTo>
                  <a:pt x="488739" y="838028"/>
                  <a:pt x="506953" y="835783"/>
                  <a:pt x="517071" y="859360"/>
                </a:cubicBezTo>
                <a:cubicBezTo>
                  <a:pt x="410824" y="855992"/>
                  <a:pt x="307612" y="836906"/>
                  <a:pt x="202377" y="854869"/>
                </a:cubicBezTo>
                <a:cubicBezTo>
                  <a:pt x="317731" y="899776"/>
                  <a:pt x="444216" y="897531"/>
                  <a:pt x="557546" y="949175"/>
                </a:cubicBezTo>
                <a:cubicBezTo>
                  <a:pt x="553499" y="967137"/>
                  <a:pt x="527190" y="959278"/>
                  <a:pt x="526178" y="986223"/>
                </a:cubicBezTo>
                <a:cubicBezTo>
                  <a:pt x="585879" y="1014290"/>
                  <a:pt x="657723" y="995204"/>
                  <a:pt x="720459" y="1036744"/>
                </a:cubicBezTo>
                <a:cubicBezTo>
                  <a:pt x="684032" y="1055829"/>
                  <a:pt x="650640" y="1024394"/>
                  <a:pt x="616236" y="1042357"/>
                </a:cubicBezTo>
                <a:cubicBezTo>
                  <a:pt x="627367" y="1069302"/>
                  <a:pt x="1131283" y="1235459"/>
                  <a:pt x="1222353" y="1253422"/>
                </a:cubicBezTo>
                <a:cubicBezTo>
                  <a:pt x="1407527" y="1290470"/>
                  <a:pt x="1940788" y="1384776"/>
                  <a:pt x="2087511" y="1406107"/>
                </a:cubicBezTo>
                <a:cubicBezTo>
                  <a:pt x="2200841" y="1421824"/>
                  <a:pt x="2313160" y="1434174"/>
                  <a:pt x="2425479" y="1435297"/>
                </a:cubicBezTo>
                <a:cubicBezTo>
                  <a:pt x="2553988" y="1436419"/>
                  <a:pt x="2681485" y="1430806"/>
                  <a:pt x="2809994" y="1426315"/>
                </a:cubicBezTo>
                <a:cubicBezTo>
                  <a:pt x="2858058" y="1424631"/>
                  <a:pt x="2905933" y="1421684"/>
                  <a:pt x="2953618" y="1417071"/>
                </a:cubicBezTo>
                <a:lnTo>
                  <a:pt x="3021543" y="1407897"/>
                </a:lnTo>
                <a:close/>
              </a:path>
            </a:pathLst>
          </a:custGeom>
          <a:solidFill>
            <a:schemeClr val="accent1">
              <a:alpha val="20000"/>
            </a:schemeClr>
          </a:solidFill>
          <a:ln w="32707" cap="flat">
            <a:noFill/>
            <a:prstDash val="solid"/>
            <a:miter/>
          </a:ln>
        </p:spPr>
        <p:txBody>
          <a:bodyPr wrap="square" rtlCol="0" anchor="ctr">
            <a:noAutofit/>
          </a:bodyPr>
          <a:lstStyle/>
          <a:p>
            <a:endParaRPr lang="en-US" dirty="0"/>
          </a:p>
        </p:txBody>
      </p:sp>
      <p:sp>
        <p:nvSpPr>
          <p:cNvPr id="2" name="Title 1">
            <a:extLst>
              <a:ext uri="{FF2B5EF4-FFF2-40B4-BE49-F238E27FC236}">
                <a16:creationId xmlns:a16="http://schemas.microsoft.com/office/drawing/2014/main" id="{D2A77EC9-372A-4ECA-9088-780532AF057F}"/>
              </a:ext>
            </a:extLst>
          </p:cNvPr>
          <p:cNvSpPr>
            <a:spLocks noGrp="1"/>
          </p:cNvSpPr>
          <p:nvPr>
            <p:ph type="title"/>
          </p:nvPr>
        </p:nvSpPr>
        <p:spPr/>
        <p:txBody>
          <a:bodyPr>
            <a:normAutofit/>
          </a:bodyPr>
          <a:lstStyle>
            <a:lvl1pPr>
              <a:defRPr sz="4000"/>
            </a:lvl1p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57C882CE-1B27-414A-9B06-AA5D2DB683BA}"/>
              </a:ext>
            </a:extLst>
          </p:cNvPr>
          <p:cNvSpPr>
            <a:spLocks noGrp="1"/>
          </p:cNvSpPr>
          <p:nvPr>
            <p:ph sz="half" idx="1"/>
          </p:nvPr>
        </p:nvSpPr>
        <p:spPr>
          <a:xfrm>
            <a:off x="838200" y="2011680"/>
            <a:ext cx="4937760" cy="41605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a:extLst>
              <a:ext uri="{FF2B5EF4-FFF2-40B4-BE49-F238E27FC236}">
                <a16:creationId xmlns:a16="http://schemas.microsoft.com/office/drawing/2014/main" id="{A0397E60-5D92-4530-96D1-FC09AF3C2742}"/>
              </a:ext>
            </a:extLst>
          </p:cNvPr>
          <p:cNvSpPr>
            <a:spLocks noGrp="1"/>
          </p:cNvSpPr>
          <p:nvPr>
            <p:ph sz="half" idx="2"/>
          </p:nvPr>
        </p:nvSpPr>
        <p:spPr>
          <a:xfrm>
            <a:off x="6419088" y="2011680"/>
            <a:ext cx="4937760" cy="41605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a:extLst>
              <a:ext uri="{FF2B5EF4-FFF2-40B4-BE49-F238E27FC236}">
                <a16:creationId xmlns:a16="http://schemas.microsoft.com/office/drawing/2014/main" id="{034240FE-0C6A-47E9-9B0A-7B3C60877372}"/>
              </a:ext>
            </a:extLst>
          </p:cNvPr>
          <p:cNvSpPr>
            <a:spLocks noGrp="1"/>
          </p:cNvSpPr>
          <p:nvPr>
            <p:ph type="dt" sz="half" idx="10"/>
          </p:nvPr>
        </p:nvSpPr>
        <p:spPr/>
        <p:txBody>
          <a:bodyPr/>
          <a:lstStyle/>
          <a:p>
            <a:fld id="{3C04E684-10F4-4CC3-A0B9-F03AA7BE37CF}" type="datetimeFigureOut">
              <a:rPr lang="en-US" smtClean="0"/>
              <a:t>5/3/26</a:t>
            </a:fld>
            <a:endParaRPr lang="en-US" dirty="0"/>
          </a:p>
        </p:txBody>
      </p:sp>
      <p:sp>
        <p:nvSpPr>
          <p:cNvPr id="6" name="Footer Placeholder 5">
            <a:extLst>
              <a:ext uri="{FF2B5EF4-FFF2-40B4-BE49-F238E27FC236}">
                <a16:creationId xmlns:a16="http://schemas.microsoft.com/office/drawing/2014/main" id="{8671AE1B-BB18-4C7E-AA77-3A4D401A5F35}"/>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76FA7B1D-FEDD-4E29-A352-29E5F498B323}"/>
              </a:ext>
            </a:extLst>
          </p:cNvPr>
          <p:cNvSpPr>
            <a:spLocks noGrp="1"/>
          </p:cNvSpPr>
          <p:nvPr>
            <p:ph type="sldNum" sz="quarter" idx="12"/>
          </p:nvPr>
        </p:nvSpPr>
        <p:spPr/>
        <p:txBody>
          <a:bodyPr/>
          <a:lstStyle/>
          <a:p>
            <a:fld id="{51845F5A-061D-4825-9AE9-D7794091C6CF}" type="slidenum">
              <a:rPr lang="en-US" smtClean="0"/>
              <a:t>‹#›</a:t>
            </a:fld>
            <a:endParaRPr lang="en-US" dirty="0"/>
          </a:p>
        </p:txBody>
      </p:sp>
    </p:spTree>
    <p:extLst>
      <p:ext uri="{BB962C8B-B14F-4D97-AF65-F5344CB8AC3E}">
        <p14:creationId xmlns:p14="http://schemas.microsoft.com/office/powerpoint/2010/main" val="23642888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Freeform: Shape 9" descr="Tag=AccentColor&#10;Flavor=Light&#10;Target=Fill">
            <a:extLst>
              <a:ext uri="{FF2B5EF4-FFF2-40B4-BE49-F238E27FC236}">
                <a16:creationId xmlns:a16="http://schemas.microsoft.com/office/drawing/2014/main" id="{527D753D-3426-457C-9082-B92894509EC0}"/>
              </a:ext>
            </a:extLst>
          </p:cNvPr>
          <p:cNvSpPr/>
          <p:nvPr/>
        </p:nvSpPr>
        <p:spPr>
          <a:xfrm flipH="1">
            <a:off x="1" y="315111"/>
            <a:ext cx="3021543" cy="1435442"/>
          </a:xfrm>
          <a:custGeom>
            <a:avLst/>
            <a:gdLst>
              <a:gd name="connsiteX0" fmla="*/ 3021543 w 3021543"/>
              <a:gd name="connsiteY0" fmla="*/ 0 h 1435442"/>
              <a:gd name="connsiteX1" fmla="*/ 2963800 w 3021543"/>
              <a:gd name="connsiteY1" fmla="*/ 7242 h 1435442"/>
              <a:gd name="connsiteX2" fmla="*/ 2793803 w 3021543"/>
              <a:gd name="connsiteY2" fmla="*/ 24082 h 1435442"/>
              <a:gd name="connsiteX3" fmla="*/ 2414348 w 3021543"/>
              <a:gd name="connsiteY3" fmla="*/ 29696 h 1435442"/>
              <a:gd name="connsiteX4" fmla="*/ 2091558 w 3021543"/>
              <a:gd name="connsiteY4" fmla="*/ 27450 h 1435442"/>
              <a:gd name="connsiteX5" fmla="*/ 1645319 w 3021543"/>
              <a:gd name="connsiteY5" fmla="*/ 28573 h 1435442"/>
              <a:gd name="connsiteX6" fmla="*/ 1243602 w 3021543"/>
              <a:gd name="connsiteY6" fmla="*/ 60008 h 1435442"/>
              <a:gd name="connsiteX7" fmla="*/ 753851 w 3021543"/>
              <a:gd name="connsiteY7" fmla="*/ 57763 h 1435442"/>
              <a:gd name="connsiteX8" fmla="*/ 465465 w 3021543"/>
              <a:gd name="connsiteY8" fmla="*/ 116142 h 1435442"/>
              <a:gd name="connsiteX9" fmla="*/ 546416 w 3021543"/>
              <a:gd name="connsiteY9" fmla="*/ 136351 h 1435442"/>
              <a:gd name="connsiteX10" fmla="*/ 689091 w 3021543"/>
              <a:gd name="connsiteY10" fmla="*/ 180136 h 1435442"/>
              <a:gd name="connsiteX11" fmla="*/ 704269 w 3021543"/>
              <a:gd name="connsiteY11" fmla="*/ 208203 h 1435442"/>
              <a:gd name="connsiteX12" fmla="*/ 683020 w 3021543"/>
              <a:gd name="connsiteY12" fmla="*/ 221675 h 1435442"/>
              <a:gd name="connsiteX13" fmla="*/ 621295 w 3021543"/>
              <a:gd name="connsiteY13" fmla="*/ 247496 h 1435442"/>
              <a:gd name="connsiteX14" fmla="*/ 848968 w 3021543"/>
              <a:gd name="connsiteY14" fmla="*/ 285668 h 1435442"/>
              <a:gd name="connsiteX15" fmla="*/ 768018 w 3021543"/>
              <a:gd name="connsiteY15" fmla="*/ 309244 h 1435442"/>
              <a:gd name="connsiteX16" fmla="*/ 684032 w 3021543"/>
              <a:gd name="connsiteY16" fmla="*/ 326085 h 1435442"/>
              <a:gd name="connsiteX17" fmla="*/ 592962 w 3021543"/>
              <a:gd name="connsiteY17" fmla="*/ 338434 h 1435442"/>
              <a:gd name="connsiteX18" fmla="*/ 509988 w 3021543"/>
              <a:gd name="connsiteY18" fmla="*/ 363133 h 1435442"/>
              <a:gd name="connsiteX19" fmla="*/ 726531 w 3021543"/>
              <a:gd name="connsiteY19" fmla="*/ 373237 h 1435442"/>
              <a:gd name="connsiteX20" fmla="*/ 614212 w 3021543"/>
              <a:gd name="connsiteY20" fmla="*/ 395691 h 1435442"/>
              <a:gd name="connsiteX21" fmla="*/ 522131 w 3021543"/>
              <a:gd name="connsiteY21" fmla="*/ 424881 h 1435442"/>
              <a:gd name="connsiteX22" fmla="*/ 457370 w 3021543"/>
              <a:gd name="connsiteY22" fmla="*/ 438353 h 1435442"/>
              <a:gd name="connsiteX23" fmla="*/ 388562 w 3021543"/>
              <a:gd name="connsiteY23" fmla="*/ 441721 h 1435442"/>
              <a:gd name="connsiteX24" fmla="*/ 372372 w 3021543"/>
              <a:gd name="connsiteY24" fmla="*/ 463052 h 1435442"/>
              <a:gd name="connsiteX25" fmla="*/ 393622 w 3021543"/>
              <a:gd name="connsiteY25" fmla="*/ 485506 h 1435442"/>
              <a:gd name="connsiteX26" fmla="*/ 426002 w 3021543"/>
              <a:gd name="connsiteY26" fmla="*/ 487751 h 1435442"/>
              <a:gd name="connsiteX27" fmla="*/ 619271 w 3021543"/>
              <a:gd name="connsiteY27" fmla="*/ 493365 h 1435442"/>
              <a:gd name="connsiteX28" fmla="*/ 0 w 3021543"/>
              <a:gd name="connsiteY28" fmla="*/ 542762 h 1435442"/>
              <a:gd name="connsiteX29" fmla="*/ 83986 w 3021543"/>
              <a:gd name="connsiteY29" fmla="*/ 573075 h 1435442"/>
              <a:gd name="connsiteX30" fmla="*/ 112319 w 3021543"/>
              <a:gd name="connsiteY30" fmla="*/ 656154 h 1435442"/>
              <a:gd name="connsiteX31" fmla="*/ 215531 w 3021543"/>
              <a:gd name="connsiteY31" fmla="*/ 703306 h 1435442"/>
              <a:gd name="connsiteX32" fmla="*/ 282315 w 3021543"/>
              <a:gd name="connsiteY32" fmla="*/ 720147 h 1435442"/>
              <a:gd name="connsiteX33" fmla="*/ 435109 w 3021543"/>
              <a:gd name="connsiteY33" fmla="*/ 744846 h 1435442"/>
              <a:gd name="connsiteX34" fmla="*/ 457370 w 3021543"/>
              <a:gd name="connsiteY34" fmla="*/ 785263 h 1435442"/>
              <a:gd name="connsiteX35" fmla="*/ 476596 w 3021543"/>
              <a:gd name="connsiteY35" fmla="*/ 830170 h 1435442"/>
              <a:gd name="connsiteX36" fmla="*/ 517071 w 3021543"/>
              <a:gd name="connsiteY36" fmla="*/ 859360 h 1435442"/>
              <a:gd name="connsiteX37" fmla="*/ 202377 w 3021543"/>
              <a:gd name="connsiteY37" fmla="*/ 854869 h 1435442"/>
              <a:gd name="connsiteX38" fmla="*/ 557546 w 3021543"/>
              <a:gd name="connsiteY38" fmla="*/ 949175 h 1435442"/>
              <a:gd name="connsiteX39" fmla="*/ 526178 w 3021543"/>
              <a:gd name="connsiteY39" fmla="*/ 986223 h 1435442"/>
              <a:gd name="connsiteX40" fmla="*/ 720459 w 3021543"/>
              <a:gd name="connsiteY40" fmla="*/ 1036744 h 1435442"/>
              <a:gd name="connsiteX41" fmla="*/ 616236 w 3021543"/>
              <a:gd name="connsiteY41" fmla="*/ 1042357 h 1435442"/>
              <a:gd name="connsiteX42" fmla="*/ 1222353 w 3021543"/>
              <a:gd name="connsiteY42" fmla="*/ 1253422 h 1435442"/>
              <a:gd name="connsiteX43" fmla="*/ 2087511 w 3021543"/>
              <a:gd name="connsiteY43" fmla="*/ 1406107 h 1435442"/>
              <a:gd name="connsiteX44" fmla="*/ 2425479 w 3021543"/>
              <a:gd name="connsiteY44" fmla="*/ 1435297 h 1435442"/>
              <a:gd name="connsiteX45" fmla="*/ 2809994 w 3021543"/>
              <a:gd name="connsiteY45" fmla="*/ 1426315 h 1435442"/>
              <a:gd name="connsiteX46" fmla="*/ 2953618 w 3021543"/>
              <a:gd name="connsiteY46" fmla="*/ 1417071 h 1435442"/>
              <a:gd name="connsiteX47" fmla="*/ 3021543 w 3021543"/>
              <a:gd name="connsiteY47" fmla="*/ 1407897 h 14354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Lst>
            <a:rect l="l" t="t" r="r" b="b"/>
            <a:pathLst>
              <a:path w="3021543" h="1435442">
                <a:moveTo>
                  <a:pt x="3021543" y="0"/>
                </a:moveTo>
                <a:lnTo>
                  <a:pt x="2963800" y="7242"/>
                </a:lnTo>
                <a:cubicBezTo>
                  <a:pt x="2907134" y="13978"/>
                  <a:pt x="2850469" y="22960"/>
                  <a:pt x="2793803" y="24082"/>
                </a:cubicBezTo>
                <a:cubicBezTo>
                  <a:pt x="2667318" y="27450"/>
                  <a:pt x="2539821" y="19592"/>
                  <a:pt x="2414348" y="29696"/>
                </a:cubicBezTo>
                <a:cubicBezTo>
                  <a:pt x="2307089" y="38677"/>
                  <a:pt x="2198818" y="28573"/>
                  <a:pt x="2091558" y="27450"/>
                </a:cubicBezTo>
                <a:cubicBezTo>
                  <a:pt x="1942812" y="26328"/>
                  <a:pt x="1793053" y="18469"/>
                  <a:pt x="1645319" y="28573"/>
                </a:cubicBezTo>
                <a:cubicBezTo>
                  <a:pt x="1510738" y="36432"/>
                  <a:pt x="1376158" y="38677"/>
                  <a:pt x="1243602" y="60008"/>
                </a:cubicBezTo>
                <a:cubicBezTo>
                  <a:pt x="1079677" y="71235"/>
                  <a:pt x="916765" y="64499"/>
                  <a:pt x="753851" y="57763"/>
                </a:cubicBezTo>
                <a:cubicBezTo>
                  <a:pt x="653675" y="53272"/>
                  <a:pt x="554511" y="38677"/>
                  <a:pt x="465465" y="116142"/>
                </a:cubicBezTo>
                <a:cubicBezTo>
                  <a:pt x="489751" y="134105"/>
                  <a:pt x="519095" y="130737"/>
                  <a:pt x="546416" y="136351"/>
                </a:cubicBezTo>
                <a:cubicBezTo>
                  <a:pt x="594986" y="147578"/>
                  <a:pt x="643557" y="158804"/>
                  <a:pt x="689091" y="180136"/>
                </a:cubicBezTo>
                <a:cubicBezTo>
                  <a:pt x="699210" y="184626"/>
                  <a:pt x="708317" y="193608"/>
                  <a:pt x="704269" y="208203"/>
                </a:cubicBezTo>
                <a:cubicBezTo>
                  <a:pt x="701234" y="219430"/>
                  <a:pt x="691115" y="219430"/>
                  <a:pt x="683020" y="221675"/>
                </a:cubicBezTo>
                <a:cubicBezTo>
                  <a:pt x="664806" y="228411"/>
                  <a:pt x="642545" y="223920"/>
                  <a:pt x="621295" y="247496"/>
                </a:cubicBezTo>
                <a:cubicBezTo>
                  <a:pt x="702245" y="259846"/>
                  <a:pt x="780160" y="236270"/>
                  <a:pt x="848968" y="285668"/>
                </a:cubicBezTo>
                <a:cubicBezTo>
                  <a:pt x="823671" y="310367"/>
                  <a:pt x="795339" y="304753"/>
                  <a:pt x="768018" y="309244"/>
                </a:cubicBezTo>
                <a:cubicBezTo>
                  <a:pt x="739685" y="313735"/>
                  <a:pt x="712365" y="321594"/>
                  <a:pt x="684032" y="326085"/>
                </a:cubicBezTo>
                <a:cubicBezTo>
                  <a:pt x="653675" y="331698"/>
                  <a:pt x="623319" y="332821"/>
                  <a:pt x="592962" y="338434"/>
                </a:cubicBezTo>
                <a:cubicBezTo>
                  <a:pt x="567666" y="342925"/>
                  <a:pt x="540345" y="335066"/>
                  <a:pt x="509988" y="363133"/>
                </a:cubicBezTo>
                <a:cubicBezTo>
                  <a:pt x="584867" y="383342"/>
                  <a:pt x="652663" y="353029"/>
                  <a:pt x="726531" y="373237"/>
                </a:cubicBezTo>
                <a:cubicBezTo>
                  <a:pt x="683020" y="391200"/>
                  <a:pt x="647604" y="385587"/>
                  <a:pt x="614212" y="395691"/>
                </a:cubicBezTo>
                <a:cubicBezTo>
                  <a:pt x="583855" y="405795"/>
                  <a:pt x="547428" y="394568"/>
                  <a:pt x="522131" y="424881"/>
                </a:cubicBezTo>
                <a:cubicBezTo>
                  <a:pt x="502905" y="448457"/>
                  <a:pt x="482668" y="451825"/>
                  <a:pt x="457370" y="438353"/>
                </a:cubicBezTo>
                <a:cubicBezTo>
                  <a:pt x="435109" y="426003"/>
                  <a:pt x="410824" y="429371"/>
                  <a:pt x="388562" y="441721"/>
                </a:cubicBezTo>
                <a:cubicBezTo>
                  <a:pt x="380468" y="446212"/>
                  <a:pt x="372372" y="451825"/>
                  <a:pt x="372372" y="463052"/>
                </a:cubicBezTo>
                <a:cubicBezTo>
                  <a:pt x="372372" y="478770"/>
                  <a:pt x="382491" y="483260"/>
                  <a:pt x="393622" y="485506"/>
                </a:cubicBezTo>
                <a:cubicBezTo>
                  <a:pt x="403741" y="487751"/>
                  <a:pt x="415883" y="489997"/>
                  <a:pt x="426002" y="487751"/>
                </a:cubicBezTo>
                <a:cubicBezTo>
                  <a:pt x="490762" y="475402"/>
                  <a:pt x="554511" y="495610"/>
                  <a:pt x="619271" y="493365"/>
                </a:cubicBezTo>
                <a:cubicBezTo>
                  <a:pt x="415883" y="541640"/>
                  <a:pt x="210471" y="525922"/>
                  <a:pt x="0" y="542762"/>
                </a:cubicBezTo>
                <a:cubicBezTo>
                  <a:pt x="27321" y="576443"/>
                  <a:pt x="62737" y="548376"/>
                  <a:pt x="83986" y="573075"/>
                </a:cubicBezTo>
                <a:cubicBezTo>
                  <a:pt x="63748" y="624719"/>
                  <a:pt x="71844" y="652785"/>
                  <a:pt x="112319" y="656154"/>
                </a:cubicBezTo>
                <a:cubicBezTo>
                  <a:pt x="151782" y="659522"/>
                  <a:pt x="194281" y="641559"/>
                  <a:pt x="215531" y="703306"/>
                </a:cubicBezTo>
                <a:cubicBezTo>
                  <a:pt x="221602" y="722392"/>
                  <a:pt x="259042" y="716779"/>
                  <a:pt x="282315" y="720147"/>
                </a:cubicBezTo>
                <a:cubicBezTo>
                  <a:pt x="332909" y="728005"/>
                  <a:pt x="386539" y="720147"/>
                  <a:pt x="435109" y="744846"/>
                </a:cubicBezTo>
                <a:cubicBezTo>
                  <a:pt x="454335" y="753827"/>
                  <a:pt x="467489" y="760563"/>
                  <a:pt x="457370" y="785263"/>
                </a:cubicBezTo>
                <a:cubicBezTo>
                  <a:pt x="447252" y="811084"/>
                  <a:pt x="460406" y="820066"/>
                  <a:pt x="476596" y="830170"/>
                </a:cubicBezTo>
                <a:cubicBezTo>
                  <a:pt x="488739" y="838028"/>
                  <a:pt x="506953" y="835783"/>
                  <a:pt x="517071" y="859360"/>
                </a:cubicBezTo>
                <a:cubicBezTo>
                  <a:pt x="410824" y="855992"/>
                  <a:pt x="307612" y="836906"/>
                  <a:pt x="202377" y="854869"/>
                </a:cubicBezTo>
                <a:cubicBezTo>
                  <a:pt x="317731" y="899776"/>
                  <a:pt x="444216" y="897531"/>
                  <a:pt x="557546" y="949175"/>
                </a:cubicBezTo>
                <a:cubicBezTo>
                  <a:pt x="553499" y="967137"/>
                  <a:pt x="527190" y="959278"/>
                  <a:pt x="526178" y="986223"/>
                </a:cubicBezTo>
                <a:cubicBezTo>
                  <a:pt x="585879" y="1014290"/>
                  <a:pt x="657723" y="995204"/>
                  <a:pt x="720459" y="1036744"/>
                </a:cubicBezTo>
                <a:cubicBezTo>
                  <a:pt x="684032" y="1055829"/>
                  <a:pt x="650640" y="1024394"/>
                  <a:pt x="616236" y="1042357"/>
                </a:cubicBezTo>
                <a:cubicBezTo>
                  <a:pt x="627367" y="1069302"/>
                  <a:pt x="1131283" y="1235459"/>
                  <a:pt x="1222353" y="1253422"/>
                </a:cubicBezTo>
                <a:cubicBezTo>
                  <a:pt x="1407527" y="1290470"/>
                  <a:pt x="1940788" y="1384776"/>
                  <a:pt x="2087511" y="1406107"/>
                </a:cubicBezTo>
                <a:cubicBezTo>
                  <a:pt x="2200841" y="1421824"/>
                  <a:pt x="2313160" y="1434174"/>
                  <a:pt x="2425479" y="1435297"/>
                </a:cubicBezTo>
                <a:cubicBezTo>
                  <a:pt x="2553988" y="1436419"/>
                  <a:pt x="2681485" y="1430806"/>
                  <a:pt x="2809994" y="1426315"/>
                </a:cubicBezTo>
                <a:cubicBezTo>
                  <a:pt x="2858058" y="1424631"/>
                  <a:pt x="2905933" y="1421684"/>
                  <a:pt x="2953618" y="1417071"/>
                </a:cubicBezTo>
                <a:lnTo>
                  <a:pt x="3021543" y="1407897"/>
                </a:lnTo>
                <a:close/>
              </a:path>
            </a:pathLst>
          </a:custGeom>
          <a:solidFill>
            <a:schemeClr val="accent1">
              <a:alpha val="20000"/>
            </a:schemeClr>
          </a:solidFill>
          <a:ln w="32707" cap="flat">
            <a:noFill/>
            <a:prstDash val="solid"/>
            <a:miter/>
          </a:ln>
        </p:spPr>
        <p:txBody>
          <a:bodyPr wrap="square" rtlCol="0" anchor="ctr">
            <a:noAutofit/>
          </a:bodyPr>
          <a:lstStyle/>
          <a:p>
            <a:endParaRPr lang="en-US" dirty="0"/>
          </a:p>
        </p:txBody>
      </p:sp>
      <p:sp>
        <p:nvSpPr>
          <p:cNvPr id="2" name="Title 1">
            <a:extLst>
              <a:ext uri="{FF2B5EF4-FFF2-40B4-BE49-F238E27FC236}">
                <a16:creationId xmlns:a16="http://schemas.microsoft.com/office/drawing/2014/main" id="{164D2B94-0682-4185-BCE3-89AF214A4FA8}"/>
              </a:ext>
            </a:extLst>
          </p:cNvPr>
          <p:cNvSpPr>
            <a:spLocks noGrp="1"/>
          </p:cNvSpPr>
          <p:nvPr>
            <p:ph type="title"/>
          </p:nvPr>
        </p:nvSpPr>
        <p:spPr>
          <a:xfrm>
            <a:off x="839788" y="365125"/>
            <a:ext cx="10515600" cy="1325563"/>
          </a:xfrm>
        </p:spPr>
        <p:txBody>
          <a:bodyPr>
            <a:normAutofit/>
          </a:bodyPr>
          <a:lstStyle>
            <a:lvl1pPr>
              <a:defRPr sz="4000"/>
            </a:lvl1p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8D65C47E-B85E-4B3E-A669-DEEC7F5DF2FB}"/>
              </a:ext>
            </a:extLst>
          </p:cNvPr>
          <p:cNvSpPr>
            <a:spLocks noGrp="1"/>
          </p:cNvSpPr>
          <p:nvPr>
            <p:ph type="body" idx="1"/>
          </p:nvPr>
        </p:nvSpPr>
        <p:spPr>
          <a:xfrm>
            <a:off x="839788" y="2011680"/>
            <a:ext cx="4937760" cy="950976"/>
          </a:xfrm>
        </p:spPr>
        <p:txBody>
          <a:bodyPr anchor="b">
            <a:normAutofit/>
          </a:bodyPr>
          <a:lstStyle>
            <a:lvl1pPr marL="0" indent="0">
              <a:buNone/>
              <a:defRPr sz="28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324517F-FE8C-49AD-9A52-0F4301052699}"/>
              </a:ext>
            </a:extLst>
          </p:cNvPr>
          <p:cNvSpPr>
            <a:spLocks noGrp="1"/>
          </p:cNvSpPr>
          <p:nvPr>
            <p:ph sz="half" idx="2"/>
          </p:nvPr>
        </p:nvSpPr>
        <p:spPr>
          <a:xfrm>
            <a:off x="839788" y="3127248"/>
            <a:ext cx="4937760" cy="306324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a:extLst>
              <a:ext uri="{FF2B5EF4-FFF2-40B4-BE49-F238E27FC236}">
                <a16:creationId xmlns:a16="http://schemas.microsoft.com/office/drawing/2014/main" id="{C80C73EC-7117-4DC2-9075-14102F2E282B}"/>
              </a:ext>
            </a:extLst>
          </p:cNvPr>
          <p:cNvSpPr>
            <a:spLocks noGrp="1"/>
          </p:cNvSpPr>
          <p:nvPr>
            <p:ph type="body" sz="quarter" idx="3"/>
          </p:nvPr>
        </p:nvSpPr>
        <p:spPr>
          <a:xfrm>
            <a:off x="6419088" y="2011680"/>
            <a:ext cx="4937760" cy="950976"/>
          </a:xfrm>
        </p:spPr>
        <p:txBody>
          <a:bodyPr anchor="b">
            <a:normAutofit/>
          </a:bodyPr>
          <a:lstStyle>
            <a:lvl1pPr marL="0" indent="0">
              <a:buNone/>
              <a:defRPr sz="28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DD9A323-865B-4177-8F98-9BA304E022E0}"/>
              </a:ext>
            </a:extLst>
          </p:cNvPr>
          <p:cNvSpPr>
            <a:spLocks noGrp="1"/>
          </p:cNvSpPr>
          <p:nvPr>
            <p:ph sz="quarter" idx="4"/>
          </p:nvPr>
        </p:nvSpPr>
        <p:spPr>
          <a:xfrm>
            <a:off x="6419088" y="3127248"/>
            <a:ext cx="4937760" cy="306324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a:extLst>
              <a:ext uri="{FF2B5EF4-FFF2-40B4-BE49-F238E27FC236}">
                <a16:creationId xmlns:a16="http://schemas.microsoft.com/office/drawing/2014/main" id="{2AA4E5D6-7075-4584-BD43-D966F0B58E6D}"/>
              </a:ext>
            </a:extLst>
          </p:cNvPr>
          <p:cNvSpPr>
            <a:spLocks noGrp="1"/>
          </p:cNvSpPr>
          <p:nvPr>
            <p:ph type="dt" sz="half" idx="10"/>
          </p:nvPr>
        </p:nvSpPr>
        <p:spPr/>
        <p:txBody>
          <a:bodyPr/>
          <a:lstStyle/>
          <a:p>
            <a:fld id="{3C04E684-10F4-4CC3-A0B9-F03AA7BE37CF}" type="datetimeFigureOut">
              <a:rPr lang="en-US" smtClean="0"/>
              <a:t>5/3/26</a:t>
            </a:fld>
            <a:endParaRPr lang="en-US" dirty="0"/>
          </a:p>
        </p:txBody>
      </p:sp>
      <p:sp>
        <p:nvSpPr>
          <p:cNvPr id="8" name="Footer Placeholder 7">
            <a:extLst>
              <a:ext uri="{FF2B5EF4-FFF2-40B4-BE49-F238E27FC236}">
                <a16:creationId xmlns:a16="http://schemas.microsoft.com/office/drawing/2014/main" id="{8C38B83D-8A05-4F3C-A409-1602C9630750}"/>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BAD250E7-8A73-449C-A140-A2A2582D7F33}"/>
              </a:ext>
            </a:extLst>
          </p:cNvPr>
          <p:cNvSpPr>
            <a:spLocks noGrp="1"/>
          </p:cNvSpPr>
          <p:nvPr>
            <p:ph type="sldNum" sz="quarter" idx="12"/>
          </p:nvPr>
        </p:nvSpPr>
        <p:spPr/>
        <p:txBody>
          <a:bodyPr/>
          <a:lstStyle/>
          <a:p>
            <a:fld id="{51845F5A-061D-4825-9AE9-D7794091C6CF}" type="slidenum">
              <a:rPr lang="en-US" smtClean="0"/>
              <a:t>‹#›</a:t>
            </a:fld>
            <a:endParaRPr lang="en-US" dirty="0"/>
          </a:p>
        </p:txBody>
      </p:sp>
    </p:spTree>
    <p:extLst>
      <p:ext uri="{BB962C8B-B14F-4D97-AF65-F5344CB8AC3E}">
        <p14:creationId xmlns:p14="http://schemas.microsoft.com/office/powerpoint/2010/main" val="29342341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Graphic 1" descr="Tag=AccentColor&#10;Flavor=Light&#10;Target=Fill">
            <a:extLst>
              <a:ext uri="{FF2B5EF4-FFF2-40B4-BE49-F238E27FC236}">
                <a16:creationId xmlns:a16="http://schemas.microsoft.com/office/drawing/2014/main" id="{AAFBE1F6-FC6D-4C3D-9AC3-97028E6F18C7}"/>
              </a:ext>
            </a:extLst>
          </p:cNvPr>
          <p:cNvSpPr/>
          <p:nvPr/>
        </p:nvSpPr>
        <p:spPr>
          <a:xfrm rot="10800000" flipV="1">
            <a:off x="1969639" y="181596"/>
            <a:ext cx="8252722" cy="6022258"/>
          </a:xfrm>
          <a:custGeom>
            <a:avLst/>
            <a:gdLst>
              <a:gd name="connsiteX0" fmla="*/ 5458905 w 6886274"/>
              <a:gd name="connsiteY0" fmla="*/ 754119 h 5025119"/>
              <a:gd name="connsiteX1" fmla="*/ 3455557 w 6886274"/>
              <a:gd name="connsiteY1" fmla="*/ 1027709 h 5025119"/>
              <a:gd name="connsiteX2" fmla="*/ 3338677 w 6886274"/>
              <a:gd name="connsiteY2" fmla="*/ 1021381 h 5025119"/>
              <a:gd name="connsiteX3" fmla="*/ 2518280 w 6886274"/>
              <a:gd name="connsiteY3" fmla="*/ 980435 h 5025119"/>
              <a:gd name="connsiteX4" fmla="*/ 1673687 w 6886274"/>
              <a:gd name="connsiteY4" fmla="*/ 739229 h 5025119"/>
              <a:gd name="connsiteX5" fmla="*/ 1183459 w 6886274"/>
              <a:gd name="connsiteY5" fmla="*/ 397149 h 5025119"/>
              <a:gd name="connsiteX6" fmla="*/ 977987 w 6886274"/>
              <a:gd name="connsiteY6" fmla="*/ 241184 h 5025119"/>
              <a:gd name="connsiteX7" fmla="*/ 788150 w 6886274"/>
              <a:gd name="connsiteY7" fmla="*/ 66980 h 5025119"/>
              <a:gd name="connsiteX8" fmla="*/ 721148 w 6886274"/>
              <a:gd name="connsiteY8" fmla="*/ 31990 h 5025119"/>
              <a:gd name="connsiteX9" fmla="*/ 701792 w 6886274"/>
              <a:gd name="connsiteY9" fmla="*/ 32362 h 5025119"/>
              <a:gd name="connsiteX10" fmla="*/ 686530 w 6886274"/>
              <a:gd name="connsiteY10" fmla="*/ 43157 h 5025119"/>
              <a:gd name="connsiteX11" fmla="*/ 693603 w 6886274"/>
              <a:gd name="connsiteY11" fmla="*/ 58046 h 5025119"/>
              <a:gd name="connsiteX12" fmla="*/ 705886 w 6886274"/>
              <a:gd name="connsiteY12" fmla="*/ 65491 h 5025119"/>
              <a:gd name="connsiteX13" fmla="*/ 762838 w 6886274"/>
              <a:gd name="connsiteY13" fmla="*/ 112764 h 5025119"/>
              <a:gd name="connsiteX14" fmla="*/ 764327 w 6886274"/>
              <a:gd name="connsiteY14" fmla="*/ 140309 h 5025119"/>
              <a:gd name="connsiteX15" fmla="*/ 775121 w 6886274"/>
              <a:gd name="connsiteY15" fmla="*/ 159666 h 5025119"/>
              <a:gd name="connsiteX16" fmla="*/ 823139 w 6886274"/>
              <a:gd name="connsiteY16" fmla="*/ 176416 h 5025119"/>
              <a:gd name="connsiteX17" fmla="*/ 707748 w 6886274"/>
              <a:gd name="connsiteY17" fmla="*/ 109414 h 5025119"/>
              <a:gd name="connsiteX18" fmla="*/ 681319 w 6886274"/>
              <a:gd name="connsiteY18" fmla="*/ 69958 h 5025119"/>
              <a:gd name="connsiteX19" fmla="*/ 640746 w 6886274"/>
              <a:gd name="connsiteY19" fmla="*/ 67352 h 5025119"/>
              <a:gd name="connsiteX20" fmla="*/ 614318 w 6886274"/>
              <a:gd name="connsiteY20" fmla="*/ 61396 h 5025119"/>
              <a:gd name="connsiteX21" fmla="*/ 560716 w 6886274"/>
              <a:gd name="connsiteY21" fmla="*/ 3701 h 5025119"/>
              <a:gd name="connsiteX22" fmla="*/ 540616 w 6886274"/>
              <a:gd name="connsiteY22" fmla="*/ 3701 h 5025119"/>
              <a:gd name="connsiteX23" fmla="*/ 543594 w 6886274"/>
              <a:gd name="connsiteY23" fmla="*/ 21940 h 5025119"/>
              <a:gd name="connsiteX24" fmla="*/ 558855 w 6886274"/>
              <a:gd name="connsiteY24" fmla="*/ 51346 h 5025119"/>
              <a:gd name="connsiteX25" fmla="*/ 557366 w 6886274"/>
              <a:gd name="connsiteY25" fmla="*/ 72563 h 5025119"/>
              <a:gd name="connsiteX26" fmla="*/ 570022 w 6886274"/>
              <a:gd name="connsiteY26" fmla="*/ 120209 h 5025119"/>
              <a:gd name="connsiteX27" fmla="*/ 599801 w 6886274"/>
              <a:gd name="connsiteY27" fmla="*/ 192794 h 5025119"/>
              <a:gd name="connsiteX28" fmla="*/ 614318 w 6886274"/>
              <a:gd name="connsiteY28" fmla="*/ 212150 h 5025119"/>
              <a:gd name="connsiteX29" fmla="*/ 623996 w 6886274"/>
              <a:gd name="connsiteY29" fmla="*/ 220711 h 5025119"/>
              <a:gd name="connsiteX30" fmla="*/ 821278 w 6886274"/>
              <a:gd name="connsiteY30" fmla="*/ 503235 h 5025119"/>
              <a:gd name="connsiteX31" fmla="*/ 1033822 w 6886274"/>
              <a:gd name="connsiteY31" fmla="*/ 694562 h 5025119"/>
              <a:gd name="connsiteX32" fmla="*/ 1039406 w 6886274"/>
              <a:gd name="connsiteY32" fmla="*/ 702378 h 5025119"/>
              <a:gd name="connsiteX33" fmla="*/ 944114 w 6886274"/>
              <a:gd name="connsiteY33" fmla="*/ 662550 h 5025119"/>
              <a:gd name="connsiteX34" fmla="*/ 733432 w 6886274"/>
              <a:gd name="connsiteY34" fmla="*/ 500629 h 5025119"/>
              <a:gd name="connsiteX35" fmla="*/ 606501 w 6886274"/>
              <a:gd name="connsiteY35" fmla="*/ 399755 h 5025119"/>
              <a:gd name="connsiteX36" fmla="*/ 588634 w 6886274"/>
              <a:gd name="connsiteY36" fmla="*/ 381143 h 5025119"/>
              <a:gd name="connsiteX37" fmla="*/ 575978 w 6886274"/>
              <a:gd name="connsiteY37" fmla="*/ 375560 h 5025119"/>
              <a:gd name="connsiteX38" fmla="*/ 567044 w 6886274"/>
              <a:gd name="connsiteY38" fmla="*/ 388588 h 5025119"/>
              <a:gd name="connsiteX39" fmla="*/ 578956 w 6886274"/>
              <a:gd name="connsiteY39" fmla="*/ 437722 h 5025119"/>
              <a:gd name="connsiteX40" fmla="*/ 675736 w 6886274"/>
              <a:gd name="connsiteY40" fmla="*/ 535619 h 5025119"/>
              <a:gd name="connsiteX41" fmla="*/ 811600 w 6886274"/>
              <a:gd name="connsiteY41" fmla="*/ 652872 h 5025119"/>
              <a:gd name="connsiteX42" fmla="*/ 818300 w 6886274"/>
              <a:gd name="connsiteY42" fmla="*/ 666272 h 5025119"/>
              <a:gd name="connsiteX43" fmla="*/ 741621 w 6886274"/>
              <a:gd name="connsiteY43" fmla="*/ 608576 h 5025119"/>
              <a:gd name="connsiteX44" fmla="*/ 666430 w 6886274"/>
              <a:gd name="connsiteY44" fmla="*/ 553114 h 5025119"/>
              <a:gd name="connsiteX45" fmla="*/ 645585 w 6886274"/>
              <a:gd name="connsiteY45" fmla="*/ 547903 h 5025119"/>
              <a:gd name="connsiteX46" fmla="*/ 640002 w 6886274"/>
              <a:gd name="connsiteY46" fmla="*/ 570236 h 5025119"/>
              <a:gd name="connsiteX47" fmla="*/ 675736 w 6886274"/>
              <a:gd name="connsiteY47" fmla="*/ 628677 h 5025119"/>
              <a:gd name="connsiteX48" fmla="*/ 855896 w 6886274"/>
              <a:gd name="connsiteY48" fmla="*/ 786875 h 5025119"/>
              <a:gd name="connsiteX49" fmla="*/ 946348 w 6886274"/>
              <a:gd name="connsiteY49" fmla="*/ 877699 h 5025119"/>
              <a:gd name="connsiteX50" fmla="*/ 950442 w 6886274"/>
              <a:gd name="connsiteY50" fmla="*/ 899661 h 5025119"/>
              <a:gd name="connsiteX51" fmla="*/ 991760 w 6886274"/>
              <a:gd name="connsiteY51" fmla="*/ 937629 h 5025119"/>
              <a:gd name="connsiteX52" fmla="*/ 1018188 w 6886274"/>
              <a:gd name="connsiteY52" fmla="*/ 945445 h 5025119"/>
              <a:gd name="connsiteX53" fmla="*/ 1315601 w 6886274"/>
              <a:gd name="connsiteY53" fmla="*/ 1196329 h 5025119"/>
              <a:gd name="connsiteX54" fmla="*/ 1454443 w 6886274"/>
              <a:gd name="connsiteY54" fmla="*/ 1279709 h 5025119"/>
              <a:gd name="connsiteX55" fmla="*/ 1454443 w 6886274"/>
              <a:gd name="connsiteY55" fmla="*/ 1285665 h 5025119"/>
              <a:gd name="connsiteX56" fmla="*/ 1453327 w 6886274"/>
              <a:gd name="connsiteY56" fmla="*/ 1291993 h 5025119"/>
              <a:gd name="connsiteX57" fmla="*/ 1256416 w 6886274"/>
              <a:gd name="connsiteY57" fmla="*/ 1166923 h 5025119"/>
              <a:gd name="connsiteX58" fmla="*/ 745715 w 6886274"/>
              <a:gd name="connsiteY58" fmla="*/ 798786 h 5025119"/>
              <a:gd name="connsiteX59" fmla="*/ 592356 w 6886274"/>
              <a:gd name="connsiteY59" fmla="*/ 656966 h 5025119"/>
              <a:gd name="connsiteX60" fmla="*/ 485526 w 6886274"/>
              <a:gd name="connsiteY60" fmla="*/ 567259 h 5025119"/>
              <a:gd name="connsiteX61" fmla="*/ 430063 w 6886274"/>
              <a:gd name="connsiteY61" fmla="*/ 550136 h 5025119"/>
              <a:gd name="connsiteX62" fmla="*/ 408846 w 6886274"/>
              <a:gd name="connsiteY62" fmla="*/ 563164 h 5025119"/>
              <a:gd name="connsiteX63" fmla="*/ 421130 w 6886274"/>
              <a:gd name="connsiteY63" fmla="*/ 581403 h 5025119"/>
              <a:gd name="connsiteX64" fmla="*/ 426713 w 6886274"/>
              <a:gd name="connsiteY64" fmla="*/ 584009 h 5025119"/>
              <a:gd name="connsiteX65" fmla="*/ 487015 w 6886274"/>
              <a:gd name="connsiteY65" fmla="*/ 635005 h 5025119"/>
              <a:gd name="connsiteX66" fmla="*/ 487015 w 6886274"/>
              <a:gd name="connsiteY66" fmla="*/ 655105 h 5025119"/>
              <a:gd name="connsiteX67" fmla="*/ 497437 w 6886274"/>
              <a:gd name="connsiteY67" fmla="*/ 678183 h 5025119"/>
              <a:gd name="connsiteX68" fmla="*/ 539871 w 6886274"/>
              <a:gd name="connsiteY68" fmla="*/ 691584 h 5025119"/>
              <a:gd name="connsiteX69" fmla="*/ 485898 w 6886274"/>
              <a:gd name="connsiteY69" fmla="*/ 681906 h 5025119"/>
              <a:gd name="connsiteX70" fmla="*/ 410335 w 6886274"/>
              <a:gd name="connsiteY70" fmla="*/ 600387 h 5025119"/>
              <a:gd name="connsiteX71" fmla="*/ 397307 w 6886274"/>
              <a:gd name="connsiteY71" fmla="*/ 582892 h 5025119"/>
              <a:gd name="connsiteX72" fmla="*/ 363062 w 6886274"/>
              <a:gd name="connsiteY72" fmla="*/ 584009 h 5025119"/>
              <a:gd name="connsiteX73" fmla="*/ 334772 w 6886274"/>
              <a:gd name="connsiteY73" fmla="*/ 578426 h 5025119"/>
              <a:gd name="connsiteX74" fmla="*/ 281915 w 6886274"/>
              <a:gd name="connsiteY74" fmla="*/ 522219 h 5025119"/>
              <a:gd name="connsiteX75" fmla="*/ 263304 w 6886274"/>
              <a:gd name="connsiteY75" fmla="*/ 521846 h 5025119"/>
              <a:gd name="connsiteX76" fmla="*/ 263676 w 6886274"/>
              <a:gd name="connsiteY76" fmla="*/ 538225 h 5025119"/>
              <a:gd name="connsiteX77" fmla="*/ 275215 w 6886274"/>
              <a:gd name="connsiteY77" fmla="*/ 563164 h 5025119"/>
              <a:gd name="connsiteX78" fmla="*/ 271121 w 6886274"/>
              <a:gd name="connsiteY78" fmla="*/ 604854 h 5025119"/>
              <a:gd name="connsiteX79" fmla="*/ 274471 w 6886274"/>
              <a:gd name="connsiteY79" fmla="*/ 627560 h 5025119"/>
              <a:gd name="connsiteX80" fmla="*/ 319138 w 6886274"/>
              <a:gd name="connsiteY80" fmla="*/ 718012 h 5025119"/>
              <a:gd name="connsiteX81" fmla="*/ 326583 w 6886274"/>
              <a:gd name="connsiteY81" fmla="*/ 729551 h 5025119"/>
              <a:gd name="connsiteX82" fmla="*/ 349289 w 6886274"/>
              <a:gd name="connsiteY82" fmla="*/ 748163 h 5025119"/>
              <a:gd name="connsiteX83" fmla="*/ 528332 w 6886274"/>
              <a:gd name="connsiteY83" fmla="*/ 1007608 h 5025119"/>
              <a:gd name="connsiteX84" fmla="*/ 766932 w 6886274"/>
              <a:gd name="connsiteY84" fmla="*/ 1222758 h 5025119"/>
              <a:gd name="connsiteX85" fmla="*/ 681319 w 6886274"/>
              <a:gd name="connsiteY85" fmla="*/ 1190746 h 5025119"/>
              <a:gd name="connsiteX86" fmla="*/ 469520 w 6886274"/>
              <a:gd name="connsiteY86" fmla="*/ 1032920 h 5025119"/>
              <a:gd name="connsiteX87" fmla="*/ 325466 w 6886274"/>
              <a:gd name="connsiteY87" fmla="*/ 917900 h 5025119"/>
              <a:gd name="connsiteX88" fmla="*/ 312066 w 6886274"/>
              <a:gd name="connsiteY88" fmla="*/ 903383 h 5025119"/>
              <a:gd name="connsiteX89" fmla="*/ 296805 w 6886274"/>
              <a:gd name="connsiteY89" fmla="*/ 895566 h 5025119"/>
              <a:gd name="connsiteX90" fmla="*/ 288243 w 6886274"/>
              <a:gd name="connsiteY90" fmla="*/ 910828 h 5025119"/>
              <a:gd name="connsiteX91" fmla="*/ 309460 w 6886274"/>
              <a:gd name="connsiteY91" fmla="*/ 971129 h 5025119"/>
              <a:gd name="connsiteX92" fmla="*/ 407729 w 6886274"/>
              <a:gd name="connsiteY92" fmla="*/ 1062698 h 5025119"/>
              <a:gd name="connsiteX93" fmla="*/ 544338 w 6886274"/>
              <a:gd name="connsiteY93" fmla="*/ 1189257 h 5025119"/>
              <a:gd name="connsiteX94" fmla="*/ 454630 w 6886274"/>
              <a:gd name="connsiteY94" fmla="*/ 1120766 h 5025119"/>
              <a:gd name="connsiteX95" fmla="*/ 385396 w 6886274"/>
              <a:gd name="connsiteY95" fmla="*/ 1070515 h 5025119"/>
              <a:gd name="connsiteX96" fmla="*/ 366040 w 6886274"/>
              <a:gd name="connsiteY96" fmla="*/ 1067537 h 5025119"/>
              <a:gd name="connsiteX97" fmla="*/ 361573 w 6886274"/>
              <a:gd name="connsiteY97" fmla="*/ 1086149 h 5025119"/>
              <a:gd name="connsiteX98" fmla="*/ 402146 w 6886274"/>
              <a:gd name="connsiteY98" fmla="*/ 1152778 h 5025119"/>
              <a:gd name="connsiteX99" fmla="*/ 475475 w 6886274"/>
              <a:gd name="connsiteY99" fmla="*/ 1218663 h 5025119"/>
              <a:gd name="connsiteX100" fmla="*/ 393957 w 6886274"/>
              <a:gd name="connsiteY100" fmla="*/ 1201913 h 5025119"/>
              <a:gd name="connsiteX101" fmla="*/ 460586 w 6886274"/>
              <a:gd name="connsiteY101" fmla="*/ 1260353 h 5025119"/>
              <a:gd name="connsiteX102" fmla="*/ 561089 w 6886274"/>
              <a:gd name="connsiteY102" fmla="*/ 1291993 h 5025119"/>
              <a:gd name="connsiteX103" fmla="*/ 602034 w 6886274"/>
              <a:gd name="connsiteY103" fmla="*/ 1328843 h 5025119"/>
              <a:gd name="connsiteX104" fmla="*/ 641863 w 6886274"/>
              <a:gd name="connsiteY104" fmla="*/ 1368672 h 5025119"/>
              <a:gd name="connsiteX105" fmla="*/ 651541 w 6886274"/>
              <a:gd name="connsiteY105" fmla="*/ 1404406 h 5025119"/>
              <a:gd name="connsiteX106" fmla="*/ 688392 w 6886274"/>
              <a:gd name="connsiteY106" fmla="*/ 1457263 h 5025119"/>
              <a:gd name="connsiteX107" fmla="*/ 692486 w 6886274"/>
              <a:gd name="connsiteY107" fmla="*/ 1458008 h 5025119"/>
              <a:gd name="connsiteX108" fmla="*/ 719287 w 6886274"/>
              <a:gd name="connsiteY108" fmla="*/ 1485181 h 5025119"/>
              <a:gd name="connsiteX109" fmla="*/ 745343 w 6886274"/>
              <a:gd name="connsiteY109" fmla="*/ 1512353 h 5025119"/>
              <a:gd name="connsiteX110" fmla="*/ 750926 w 6886274"/>
              <a:gd name="connsiteY110" fmla="*/ 1516448 h 5025119"/>
              <a:gd name="connsiteX111" fmla="*/ 890141 w 6886274"/>
              <a:gd name="connsiteY111" fmla="*/ 1685813 h 5025119"/>
              <a:gd name="connsiteX112" fmla="*/ 899074 w 6886274"/>
              <a:gd name="connsiteY112" fmla="*/ 1693630 h 5025119"/>
              <a:gd name="connsiteX113" fmla="*/ 605012 w 6886274"/>
              <a:gd name="connsiteY113" fmla="*/ 1669435 h 5025119"/>
              <a:gd name="connsiteX114" fmla="*/ 229431 w 6886274"/>
              <a:gd name="connsiteY114" fmla="*/ 1545110 h 5025119"/>
              <a:gd name="connsiteX115" fmla="*/ 251765 w 6886274"/>
              <a:gd name="connsiteY115" fmla="*/ 1614717 h 5025119"/>
              <a:gd name="connsiteX116" fmla="*/ 237992 w 6886274"/>
              <a:gd name="connsiteY116" fmla="*/ 1675391 h 5025119"/>
              <a:gd name="connsiteX117" fmla="*/ 232781 w 6886274"/>
              <a:gd name="connsiteY117" fmla="*/ 1807160 h 5025119"/>
              <a:gd name="connsiteX118" fmla="*/ 236131 w 6886274"/>
              <a:gd name="connsiteY118" fmla="*/ 1828750 h 5025119"/>
              <a:gd name="connsiteX119" fmla="*/ 152007 w 6886274"/>
              <a:gd name="connsiteY119" fmla="*/ 1842150 h 5025119"/>
              <a:gd name="connsiteX120" fmla="*/ 653030 w 6886274"/>
              <a:gd name="connsiteY120" fmla="*/ 2213265 h 5025119"/>
              <a:gd name="connsiteX121" fmla="*/ 318394 w 6886274"/>
              <a:gd name="connsiteY121" fmla="*/ 2143285 h 5025119"/>
              <a:gd name="connsiteX122" fmla="*/ 272982 w 6886274"/>
              <a:gd name="connsiteY122" fmla="*/ 2258305 h 5025119"/>
              <a:gd name="connsiteX123" fmla="*/ 430435 w 6886274"/>
              <a:gd name="connsiteY123" fmla="*/ 2360668 h 5025119"/>
              <a:gd name="connsiteX124" fmla="*/ 488876 w 6886274"/>
              <a:gd name="connsiteY124" fmla="*/ 2563162 h 5025119"/>
              <a:gd name="connsiteX125" fmla="*/ 460586 w 6886274"/>
              <a:gd name="connsiteY125" fmla="*/ 2748533 h 5025119"/>
              <a:gd name="connsiteX126" fmla="*/ 393212 w 6886274"/>
              <a:gd name="connsiteY126" fmla="*/ 2807345 h 5025119"/>
              <a:gd name="connsiteX127" fmla="*/ 295688 w 6886274"/>
              <a:gd name="connsiteY127" fmla="*/ 2913059 h 5025119"/>
              <a:gd name="connsiteX128" fmla="*/ 235386 w 6886274"/>
              <a:gd name="connsiteY128" fmla="*/ 2978572 h 5025119"/>
              <a:gd name="connsiteX129" fmla="*/ 25448 w 6886274"/>
              <a:gd name="connsiteY129" fmla="*/ 2952888 h 5025119"/>
              <a:gd name="connsiteX130" fmla="*/ 305738 w 6886274"/>
              <a:gd name="connsiteY130" fmla="*/ 3119275 h 5025119"/>
              <a:gd name="connsiteX131" fmla="*/ 79049 w 6886274"/>
              <a:gd name="connsiteY131" fmla="*/ 3098430 h 5025119"/>
              <a:gd name="connsiteX132" fmla="*/ 4975 w 6886274"/>
              <a:gd name="connsiteY132" fmla="*/ 3109969 h 5025119"/>
              <a:gd name="connsiteX133" fmla="*/ 47037 w 6886274"/>
              <a:gd name="connsiteY133" fmla="*/ 3163943 h 5025119"/>
              <a:gd name="connsiteX134" fmla="*/ 213425 w 6886274"/>
              <a:gd name="connsiteY134" fmla="*/ 3255139 h 5025119"/>
              <a:gd name="connsiteX135" fmla="*/ 556622 w 6886274"/>
              <a:gd name="connsiteY135" fmla="*/ 3502301 h 5025119"/>
              <a:gd name="connsiteX136" fmla="*/ 224592 w 6886274"/>
              <a:gd name="connsiteY136" fmla="*/ 3388771 h 5025119"/>
              <a:gd name="connsiteX137" fmla="*/ 574861 w 6886274"/>
              <a:gd name="connsiteY137" fmla="*/ 3643004 h 5025119"/>
              <a:gd name="connsiteX138" fmla="*/ 652657 w 6886274"/>
              <a:gd name="connsiteY138" fmla="*/ 3727501 h 5025119"/>
              <a:gd name="connsiteX139" fmla="*/ 810111 w 6886274"/>
              <a:gd name="connsiteY139" fmla="*/ 3937067 h 5025119"/>
              <a:gd name="connsiteX140" fmla="*/ 802294 w 6886274"/>
              <a:gd name="connsiteY140" fmla="*/ 3960890 h 5025119"/>
              <a:gd name="connsiteX141" fmla="*/ 620646 w 6886274"/>
              <a:gd name="connsiteY141" fmla="*/ 3927017 h 5025119"/>
              <a:gd name="connsiteX142" fmla="*/ 856268 w 6886274"/>
              <a:gd name="connsiteY142" fmla="*/ 4103082 h 5025119"/>
              <a:gd name="connsiteX143" fmla="*/ 1099707 w 6886274"/>
              <a:gd name="connsiteY143" fmla="*/ 4238574 h 5025119"/>
              <a:gd name="connsiteX144" fmla="*/ 926992 w 6886274"/>
              <a:gd name="connsiteY144" fmla="*/ 4218102 h 5025119"/>
              <a:gd name="connsiteX145" fmla="*/ 689508 w 6886274"/>
              <a:gd name="connsiteY145" fmla="*/ 4140677 h 5025119"/>
              <a:gd name="connsiteX146" fmla="*/ 606873 w 6886274"/>
              <a:gd name="connsiteY146" fmla="*/ 4169711 h 5025119"/>
              <a:gd name="connsiteX147" fmla="*/ 831701 w 6886274"/>
              <a:gd name="connsiteY147" fmla="*/ 4297759 h 5025119"/>
              <a:gd name="connsiteX148" fmla="*/ 960493 w 6886274"/>
              <a:gd name="connsiteY148" fmla="*/ 4356944 h 5025119"/>
              <a:gd name="connsiteX149" fmla="*/ 1012233 w 6886274"/>
              <a:gd name="connsiteY149" fmla="*/ 4402356 h 5025119"/>
              <a:gd name="connsiteX150" fmla="*/ 1159636 w 6886274"/>
              <a:gd name="connsiteY150" fmla="*/ 4564276 h 5025119"/>
              <a:gd name="connsiteX151" fmla="*/ 1592169 w 6886274"/>
              <a:gd name="connsiteY151" fmla="*/ 4741458 h 5025119"/>
              <a:gd name="connsiteX152" fmla="*/ 3110499 w 6886274"/>
              <a:gd name="connsiteY152" fmla="*/ 5032171 h 5025119"/>
              <a:gd name="connsiteX153" fmla="*/ 6033630 w 6886274"/>
              <a:gd name="connsiteY153" fmla="*/ 4091915 h 5025119"/>
              <a:gd name="connsiteX154" fmla="*/ 6180661 w 6886274"/>
              <a:gd name="connsiteY154" fmla="*/ 3957912 h 5025119"/>
              <a:gd name="connsiteX155" fmla="*/ 6305359 w 6886274"/>
              <a:gd name="connsiteY155" fmla="*/ 3837309 h 5025119"/>
              <a:gd name="connsiteX156" fmla="*/ 6240218 w 6886274"/>
              <a:gd name="connsiteY156" fmla="*/ 3796364 h 5025119"/>
              <a:gd name="connsiteX157" fmla="*/ 6328437 w 6886274"/>
              <a:gd name="connsiteY157" fmla="*/ 3681344 h 5025119"/>
              <a:gd name="connsiteX158" fmla="*/ 6608355 w 6886274"/>
              <a:gd name="connsiteY158" fmla="*/ 3326236 h 5025119"/>
              <a:gd name="connsiteX159" fmla="*/ 6731191 w 6886274"/>
              <a:gd name="connsiteY159" fmla="*/ 3248067 h 5025119"/>
              <a:gd name="connsiteX160" fmla="*/ 6880456 w 6886274"/>
              <a:gd name="connsiteY160" fmla="*/ 3051529 h 5025119"/>
              <a:gd name="connsiteX161" fmla="*/ 6901673 w 6886274"/>
              <a:gd name="connsiteY161" fmla="*/ 2763795 h 5025119"/>
              <a:gd name="connsiteX162" fmla="*/ 6871150 w 6886274"/>
              <a:gd name="connsiteY162" fmla="*/ 2948421 h 5025119"/>
              <a:gd name="connsiteX163" fmla="*/ 6848444 w 6886274"/>
              <a:gd name="connsiteY163" fmla="*/ 2890353 h 5025119"/>
              <a:gd name="connsiteX164" fmla="*/ 6878223 w 6886274"/>
              <a:gd name="connsiteY164" fmla="*/ 2873230 h 5025119"/>
              <a:gd name="connsiteX165" fmla="*/ 6762459 w 6886274"/>
              <a:gd name="connsiteY165" fmla="*/ 2568745 h 5025119"/>
              <a:gd name="connsiteX166" fmla="*/ 6673123 w 6886274"/>
              <a:gd name="connsiteY166" fmla="*/ 2451493 h 5025119"/>
              <a:gd name="connsiteX167" fmla="*/ 6662700 w 6886274"/>
              <a:gd name="connsiteY167" fmla="*/ 2346896 h 5025119"/>
              <a:gd name="connsiteX168" fmla="*/ 6487752 w 6886274"/>
              <a:gd name="connsiteY168" fmla="*/ 2285105 h 5025119"/>
              <a:gd name="connsiteX169" fmla="*/ 6652278 w 6886274"/>
              <a:gd name="connsiteY169" fmla="*/ 2063628 h 5025119"/>
              <a:gd name="connsiteX170" fmla="*/ 6668656 w 6886274"/>
              <a:gd name="connsiteY170" fmla="*/ 2017843 h 5025119"/>
              <a:gd name="connsiteX171" fmla="*/ 6570015 w 6886274"/>
              <a:gd name="connsiteY171" fmla="*/ 1854062 h 5025119"/>
              <a:gd name="connsiteX172" fmla="*/ 6554009 w 6886274"/>
              <a:gd name="connsiteY172" fmla="*/ 1827633 h 5025119"/>
              <a:gd name="connsiteX173" fmla="*/ 6517531 w 6886274"/>
              <a:gd name="connsiteY173" fmla="*/ 1775149 h 5025119"/>
              <a:gd name="connsiteX174" fmla="*/ 6412934 w 6886274"/>
              <a:gd name="connsiteY174" fmla="*/ 1762493 h 5025119"/>
              <a:gd name="connsiteX175" fmla="*/ 6467279 w 6886274"/>
              <a:gd name="connsiteY175" fmla="*/ 1725642 h 5025119"/>
              <a:gd name="connsiteX176" fmla="*/ 6572621 w 6886274"/>
              <a:gd name="connsiteY176" fmla="*/ 1600200 h 5025119"/>
              <a:gd name="connsiteX177" fmla="*/ 6502641 w 6886274"/>
              <a:gd name="connsiteY177" fmla="*/ 1480341 h 5025119"/>
              <a:gd name="connsiteX178" fmla="*/ 6481796 w 6886274"/>
              <a:gd name="connsiteY178" fmla="*/ 1461358 h 5025119"/>
              <a:gd name="connsiteX179" fmla="*/ 6509713 w 6886274"/>
              <a:gd name="connsiteY179" fmla="*/ 1436418 h 5025119"/>
              <a:gd name="connsiteX180" fmla="*/ 6567037 w 6886274"/>
              <a:gd name="connsiteY180" fmla="*/ 1348199 h 5025119"/>
              <a:gd name="connsiteX181" fmla="*/ 6596816 w 6886274"/>
              <a:gd name="connsiteY181" fmla="*/ 1286781 h 5025119"/>
              <a:gd name="connsiteX182" fmla="*/ 6632178 w 6886274"/>
              <a:gd name="connsiteY182" fmla="*/ 1261842 h 5025119"/>
              <a:gd name="connsiteX183" fmla="*/ 6639994 w 6886274"/>
              <a:gd name="connsiteY183" fmla="*/ 1240625 h 5025119"/>
              <a:gd name="connsiteX184" fmla="*/ 6622127 w 6886274"/>
              <a:gd name="connsiteY184" fmla="*/ 1136400 h 5025119"/>
              <a:gd name="connsiteX185" fmla="*/ 6612077 w 6886274"/>
              <a:gd name="connsiteY185" fmla="*/ 1109599 h 5025119"/>
              <a:gd name="connsiteX186" fmla="*/ 6531675 w 6886274"/>
              <a:gd name="connsiteY186" fmla="*/ 1009469 h 5025119"/>
              <a:gd name="connsiteX187" fmla="*/ 6456113 w 6886274"/>
              <a:gd name="connsiteY187" fmla="*/ 845315 h 5025119"/>
              <a:gd name="connsiteX188" fmla="*/ 6440851 w 6886274"/>
              <a:gd name="connsiteY188" fmla="*/ 739229 h 5025119"/>
              <a:gd name="connsiteX189" fmla="*/ 6434523 w 6886274"/>
              <a:gd name="connsiteY189" fmla="*/ 715034 h 5025119"/>
              <a:gd name="connsiteX190" fmla="*/ 6432290 w 6886274"/>
              <a:gd name="connsiteY190" fmla="*/ 617510 h 5025119"/>
              <a:gd name="connsiteX191" fmla="*/ 6416284 w 6886274"/>
              <a:gd name="connsiteY191" fmla="*/ 595176 h 5025119"/>
              <a:gd name="connsiteX192" fmla="*/ 6267763 w 6886274"/>
              <a:gd name="connsiteY192" fmla="*/ 591826 h 5025119"/>
              <a:gd name="connsiteX193" fmla="*/ 6236496 w 6886274"/>
              <a:gd name="connsiteY193" fmla="*/ 521102 h 5025119"/>
              <a:gd name="connsiteX194" fmla="*/ 6257341 w 6886274"/>
              <a:gd name="connsiteY194" fmla="*/ 487229 h 5025119"/>
              <a:gd name="connsiteX195" fmla="*/ 6248780 w 6886274"/>
              <a:gd name="connsiteY195" fmla="*/ 465267 h 5025119"/>
              <a:gd name="connsiteX196" fmla="*/ 6226818 w 6886274"/>
              <a:gd name="connsiteY196" fmla="*/ 473456 h 5025119"/>
              <a:gd name="connsiteX197" fmla="*/ 6115149 w 6886274"/>
              <a:gd name="connsiteY197" fmla="*/ 551625 h 5025119"/>
              <a:gd name="connsiteX198" fmla="*/ 5951739 w 6886274"/>
              <a:gd name="connsiteY198" fmla="*/ 659944 h 5025119"/>
              <a:gd name="connsiteX199" fmla="*/ 5917122 w 6886274"/>
              <a:gd name="connsiteY199" fmla="*/ 644310 h 5025119"/>
              <a:gd name="connsiteX200" fmla="*/ 5890694 w 6886274"/>
              <a:gd name="connsiteY200" fmla="*/ 630538 h 5025119"/>
              <a:gd name="connsiteX201" fmla="*/ 5837464 w 6886274"/>
              <a:gd name="connsiteY201" fmla="*/ 646916 h 5025119"/>
              <a:gd name="connsiteX202" fmla="*/ 5809175 w 6886274"/>
              <a:gd name="connsiteY202" fmla="*/ 683395 h 5025119"/>
              <a:gd name="connsiteX203" fmla="*/ 5815503 w 6886274"/>
              <a:gd name="connsiteY203" fmla="*/ 698656 h 5025119"/>
              <a:gd name="connsiteX204" fmla="*/ 5746268 w 6886274"/>
              <a:gd name="connsiteY204" fmla="*/ 667389 h 5025119"/>
              <a:gd name="connsiteX205" fmla="*/ 5458905 w 6886274"/>
              <a:gd name="connsiteY205" fmla="*/ 754119 h 5025119"/>
              <a:gd name="connsiteX206" fmla="*/ 885302 w 6886274"/>
              <a:gd name="connsiteY206" fmla="*/ 1333310 h 5025119"/>
              <a:gd name="connsiteX207" fmla="*/ 862596 w 6886274"/>
              <a:gd name="connsiteY207" fmla="*/ 1314326 h 5025119"/>
              <a:gd name="connsiteX208" fmla="*/ 866318 w 6886274"/>
              <a:gd name="connsiteY208" fmla="*/ 1309860 h 5025119"/>
              <a:gd name="connsiteX209" fmla="*/ 912103 w 6886274"/>
              <a:gd name="connsiteY209" fmla="*/ 1341127 h 5025119"/>
              <a:gd name="connsiteX210" fmla="*/ 885302 w 6886274"/>
              <a:gd name="connsiteY210" fmla="*/ 1333310 h 5025119"/>
              <a:gd name="connsiteX211" fmla="*/ 1140280 w 6886274"/>
              <a:gd name="connsiteY211" fmla="*/ 787619 h 5025119"/>
              <a:gd name="connsiteX212" fmla="*/ 1414987 w 6886274"/>
              <a:gd name="connsiteY212" fmla="*/ 975596 h 5025119"/>
              <a:gd name="connsiteX213" fmla="*/ 1410892 w 6886274"/>
              <a:gd name="connsiteY213" fmla="*/ 980063 h 5025119"/>
              <a:gd name="connsiteX214" fmla="*/ 1140280 w 6886274"/>
              <a:gd name="connsiteY214" fmla="*/ 787619 h 502511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Lst>
            <a:rect l="l" t="t" r="r" b="b"/>
            <a:pathLst>
              <a:path w="6886274" h="5025119">
                <a:moveTo>
                  <a:pt x="5458905" y="754119"/>
                </a:moveTo>
                <a:cubicBezTo>
                  <a:pt x="5417216" y="775336"/>
                  <a:pt x="4594585" y="1111088"/>
                  <a:pt x="3455557" y="1027709"/>
                </a:cubicBezTo>
                <a:cubicBezTo>
                  <a:pt x="3415356" y="1024731"/>
                  <a:pt x="3377389" y="1022869"/>
                  <a:pt x="3338677" y="1021381"/>
                </a:cubicBezTo>
                <a:cubicBezTo>
                  <a:pt x="2996224" y="1006119"/>
                  <a:pt x="2660100" y="998674"/>
                  <a:pt x="2518280" y="980435"/>
                </a:cubicBezTo>
                <a:cubicBezTo>
                  <a:pt x="2407355" y="965918"/>
                  <a:pt x="1840075" y="843082"/>
                  <a:pt x="1673687" y="739229"/>
                </a:cubicBezTo>
                <a:cubicBezTo>
                  <a:pt x="1503578" y="632771"/>
                  <a:pt x="1343146" y="515146"/>
                  <a:pt x="1183459" y="397149"/>
                </a:cubicBezTo>
                <a:cubicBezTo>
                  <a:pt x="1114224" y="346153"/>
                  <a:pt x="1040522" y="299624"/>
                  <a:pt x="977987" y="241184"/>
                </a:cubicBezTo>
                <a:cubicBezTo>
                  <a:pt x="915453" y="182372"/>
                  <a:pt x="855896" y="121326"/>
                  <a:pt x="788150" y="66980"/>
                </a:cubicBezTo>
                <a:cubicBezTo>
                  <a:pt x="768794" y="51346"/>
                  <a:pt x="749438" y="34596"/>
                  <a:pt x="721148" y="31990"/>
                </a:cubicBezTo>
                <a:cubicBezTo>
                  <a:pt x="714820" y="31246"/>
                  <a:pt x="708120" y="31618"/>
                  <a:pt x="701792" y="32362"/>
                </a:cubicBezTo>
                <a:cubicBezTo>
                  <a:pt x="694720" y="33107"/>
                  <a:pt x="689136" y="36829"/>
                  <a:pt x="686530" y="43157"/>
                </a:cubicBezTo>
                <a:cubicBezTo>
                  <a:pt x="683925" y="50230"/>
                  <a:pt x="688392" y="54324"/>
                  <a:pt x="693603" y="58046"/>
                </a:cubicBezTo>
                <a:cubicBezTo>
                  <a:pt x="697325" y="60652"/>
                  <a:pt x="701047" y="64747"/>
                  <a:pt x="705886" y="65491"/>
                </a:cubicBezTo>
                <a:cubicBezTo>
                  <a:pt x="736782" y="69958"/>
                  <a:pt x="748321" y="92664"/>
                  <a:pt x="762838" y="112764"/>
                </a:cubicBezTo>
                <a:cubicBezTo>
                  <a:pt x="769166" y="121326"/>
                  <a:pt x="775866" y="128026"/>
                  <a:pt x="764327" y="140309"/>
                </a:cubicBezTo>
                <a:cubicBezTo>
                  <a:pt x="754277" y="151104"/>
                  <a:pt x="764699" y="156688"/>
                  <a:pt x="775121" y="159666"/>
                </a:cubicBezTo>
                <a:cubicBezTo>
                  <a:pt x="789638" y="163760"/>
                  <a:pt x="806761" y="163016"/>
                  <a:pt x="823139" y="176416"/>
                </a:cubicBezTo>
                <a:cubicBezTo>
                  <a:pt x="761721" y="177533"/>
                  <a:pt x="735665" y="142171"/>
                  <a:pt x="707748" y="109414"/>
                </a:cubicBezTo>
                <a:cubicBezTo>
                  <a:pt x="697325" y="97503"/>
                  <a:pt x="690253" y="83358"/>
                  <a:pt x="681319" y="69958"/>
                </a:cubicBezTo>
                <a:cubicBezTo>
                  <a:pt x="670152" y="53580"/>
                  <a:pt x="657124" y="52835"/>
                  <a:pt x="640746" y="67352"/>
                </a:cubicBezTo>
                <a:cubicBezTo>
                  <a:pt x="626229" y="80380"/>
                  <a:pt x="619157" y="79264"/>
                  <a:pt x="614318" y="61396"/>
                </a:cubicBezTo>
                <a:cubicBezTo>
                  <a:pt x="606873" y="33479"/>
                  <a:pt x="589750" y="13751"/>
                  <a:pt x="560716" y="3701"/>
                </a:cubicBezTo>
                <a:cubicBezTo>
                  <a:pt x="554388" y="1467"/>
                  <a:pt x="546572" y="-3372"/>
                  <a:pt x="540616" y="3701"/>
                </a:cubicBezTo>
                <a:cubicBezTo>
                  <a:pt x="535405" y="9656"/>
                  <a:pt x="539871" y="16729"/>
                  <a:pt x="543594" y="21940"/>
                </a:cubicBezTo>
                <a:cubicBezTo>
                  <a:pt x="550294" y="31246"/>
                  <a:pt x="556250" y="40179"/>
                  <a:pt x="558855" y="51346"/>
                </a:cubicBezTo>
                <a:cubicBezTo>
                  <a:pt x="560716" y="58791"/>
                  <a:pt x="562578" y="66980"/>
                  <a:pt x="557366" y="72563"/>
                </a:cubicBezTo>
                <a:cubicBezTo>
                  <a:pt x="535777" y="96386"/>
                  <a:pt x="551411" y="107553"/>
                  <a:pt x="570022" y="120209"/>
                </a:cubicBezTo>
                <a:cubicBezTo>
                  <a:pt x="595706" y="137332"/>
                  <a:pt x="605756" y="162643"/>
                  <a:pt x="599801" y="192794"/>
                </a:cubicBezTo>
                <a:cubicBezTo>
                  <a:pt x="597567" y="205078"/>
                  <a:pt x="599056" y="212522"/>
                  <a:pt x="614318" y="212150"/>
                </a:cubicBezTo>
                <a:cubicBezTo>
                  <a:pt x="620273" y="212150"/>
                  <a:pt x="621762" y="216245"/>
                  <a:pt x="623996" y="220711"/>
                </a:cubicBezTo>
                <a:cubicBezTo>
                  <a:pt x="671641" y="326053"/>
                  <a:pt x="740504" y="418366"/>
                  <a:pt x="821278" y="503235"/>
                </a:cubicBezTo>
                <a:cubicBezTo>
                  <a:pt x="886791" y="572098"/>
                  <a:pt x="959004" y="634260"/>
                  <a:pt x="1033822" y="694562"/>
                </a:cubicBezTo>
                <a:cubicBezTo>
                  <a:pt x="1036055" y="696423"/>
                  <a:pt x="1038289" y="698656"/>
                  <a:pt x="1039406" y="702378"/>
                </a:cubicBezTo>
                <a:cubicBezTo>
                  <a:pt x="1004044" y="694934"/>
                  <a:pt x="973521" y="679672"/>
                  <a:pt x="944114" y="662550"/>
                </a:cubicBezTo>
                <a:cubicBezTo>
                  <a:pt x="865946" y="617138"/>
                  <a:pt x="800061" y="558325"/>
                  <a:pt x="733432" y="500629"/>
                </a:cubicBezTo>
                <a:cubicBezTo>
                  <a:pt x="692858" y="465267"/>
                  <a:pt x="651169" y="431022"/>
                  <a:pt x="606501" y="399755"/>
                </a:cubicBezTo>
                <a:cubicBezTo>
                  <a:pt x="599056" y="394543"/>
                  <a:pt x="593845" y="387843"/>
                  <a:pt x="588634" y="381143"/>
                </a:cubicBezTo>
                <a:cubicBezTo>
                  <a:pt x="585656" y="377421"/>
                  <a:pt x="581934" y="374071"/>
                  <a:pt x="575978" y="375560"/>
                </a:cubicBezTo>
                <a:cubicBezTo>
                  <a:pt x="568533" y="377421"/>
                  <a:pt x="567789" y="383004"/>
                  <a:pt x="567044" y="388588"/>
                </a:cubicBezTo>
                <a:cubicBezTo>
                  <a:pt x="564811" y="406455"/>
                  <a:pt x="569650" y="422461"/>
                  <a:pt x="578956" y="437722"/>
                </a:cubicBezTo>
                <a:cubicBezTo>
                  <a:pt x="603151" y="476806"/>
                  <a:pt x="638885" y="506957"/>
                  <a:pt x="675736" y="535619"/>
                </a:cubicBezTo>
                <a:cubicBezTo>
                  <a:pt x="723381" y="572470"/>
                  <a:pt x="769538" y="610810"/>
                  <a:pt x="811600" y="652872"/>
                </a:cubicBezTo>
                <a:cubicBezTo>
                  <a:pt x="814578" y="655850"/>
                  <a:pt x="820161" y="657711"/>
                  <a:pt x="818300" y="666272"/>
                </a:cubicBezTo>
                <a:cubicBezTo>
                  <a:pt x="791872" y="646544"/>
                  <a:pt x="766932" y="627188"/>
                  <a:pt x="741621" y="608576"/>
                </a:cubicBezTo>
                <a:cubicBezTo>
                  <a:pt x="716681" y="589965"/>
                  <a:pt x="691369" y="571353"/>
                  <a:pt x="666430" y="553114"/>
                </a:cubicBezTo>
                <a:cubicBezTo>
                  <a:pt x="660474" y="548647"/>
                  <a:pt x="654146" y="542319"/>
                  <a:pt x="645585" y="547903"/>
                </a:cubicBezTo>
                <a:cubicBezTo>
                  <a:pt x="636652" y="553486"/>
                  <a:pt x="637768" y="562792"/>
                  <a:pt x="640002" y="570236"/>
                </a:cubicBezTo>
                <a:cubicBezTo>
                  <a:pt x="647074" y="592198"/>
                  <a:pt x="659358" y="611554"/>
                  <a:pt x="675736" y="628677"/>
                </a:cubicBezTo>
                <a:cubicBezTo>
                  <a:pt x="731570" y="685256"/>
                  <a:pt x="795966" y="734018"/>
                  <a:pt x="855896" y="786875"/>
                </a:cubicBezTo>
                <a:cubicBezTo>
                  <a:pt x="888280" y="815537"/>
                  <a:pt x="918058" y="846060"/>
                  <a:pt x="946348" y="877699"/>
                </a:cubicBezTo>
                <a:cubicBezTo>
                  <a:pt x="952676" y="884772"/>
                  <a:pt x="952303" y="891472"/>
                  <a:pt x="950442" y="899661"/>
                </a:cubicBezTo>
                <a:cubicBezTo>
                  <a:pt x="942998" y="932790"/>
                  <a:pt x="954537" y="943957"/>
                  <a:pt x="991760" y="937629"/>
                </a:cubicBezTo>
                <a:cubicBezTo>
                  <a:pt x="1003299" y="935767"/>
                  <a:pt x="1011116" y="937629"/>
                  <a:pt x="1018188" y="945445"/>
                </a:cubicBezTo>
                <a:cubicBezTo>
                  <a:pt x="1103802" y="1042225"/>
                  <a:pt x="1205048" y="1123744"/>
                  <a:pt x="1315601" y="1196329"/>
                </a:cubicBezTo>
                <a:cubicBezTo>
                  <a:pt x="1360641" y="1225735"/>
                  <a:pt x="1407170" y="1253653"/>
                  <a:pt x="1454443" y="1279709"/>
                </a:cubicBezTo>
                <a:cubicBezTo>
                  <a:pt x="1454443" y="1281570"/>
                  <a:pt x="1454443" y="1283804"/>
                  <a:pt x="1454443" y="1285665"/>
                </a:cubicBezTo>
                <a:cubicBezTo>
                  <a:pt x="1454071" y="1288270"/>
                  <a:pt x="1453699" y="1289759"/>
                  <a:pt x="1453327" y="1291993"/>
                </a:cubicBezTo>
                <a:cubicBezTo>
                  <a:pt x="1386697" y="1251792"/>
                  <a:pt x="1320812" y="1210474"/>
                  <a:pt x="1256416" y="1166923"/>
                </a:cubicBezTo>
                <a:cubicBezTo>
                  <a:pt x="1081840" y="1048926"/>
                  <a:pt x="915080" y="922367"/>
                  <a:pt x="745715" y="798786"/>
                </a:cubicBezTo>
                <a:cubicBezTo>
                  <a:pt x="688764" y="757096"/>
                  <a:pt x="643724" y="703867"/>
                  <a:pt x="592356" y="656966"/>
                </a:cubicBezTo>
                <a:cubicBezTo>
                  <a:pt x="558111" y="625699"/>
                  <a:pt x="525354" y="592943"/>
                  <a:pt x="485526" y="567259"/>
                </a:cubicBezTo>
                <a:cubicBezTo>
                  <a:pt x="469148" y="556836"/>
                  <a:pt x="452025" y="547530"/>
                  <a:pt x="430063" y="550136"/>
                </a:cubicBezTo>
                <a:cubicBezTo>
                  <a:pt x="421502" y="551253"/>
                  <a:pt x="411824" y="553486"/>
                  <a:pt x="408846" y="563164"/>
                </a:cubicBezTo>
                <a:cubicBezTo>
                  <a:pt x="406240" y="572842"/>
                  <a:pt x="414057" y="577309"/>
                  <a:pt x="421130" y="581403"/>
                </a:cubicBezTo>
                <a:cubicBezTo>
                  <a:pt x="422991" y="582520"/>
                  <a:pt x="424852" y="584009"/>
                  <a:pt x="426713" y="584009"/>
                </a:cubicBezTo>
                <a:cubicBezTo>
                  <a:pt x="462075" y="586242"/>
                  <a:pt x="470264" y="614532"/>
                  <a:pt x="487015" y="635005"/>
                </a:cubicBezTo>
                <a:cubicBezTo>
                  <a:pt x="492226" y="641333"/>
                  <a:pt x="492598" y="647661"/>
                  <a:pt x="487015" y="655105"/>
                </a:cubicBezTo>
                <a:cubicBezTo>
                  <a:pt x="476964" y="668505"/>
                  <a:pt x="484037" y="674461"/>
                  <a:pt x="497437" y="678183"/>
                </a:cubicBezTo>
                <a:cubicBezTo>
                  <a:pt x="510837" y="681906"/>
                  <a:pt x="525354" y="683022"/>
                  <a:pt x="539871" y="691584"/>
                </a:cubicBezTo>
                <a:cubicBezTo>
                  <a:pt x="516793" y="698656"/>
                  <a:pt x="500787" y="691212"/>
                  <a:pt x="485898" y="681906"/>
                </a:cubicBezTo>
                <a:cubicBezTo>
                  <a:pt x="452397" y="661433"/>
                  <a:pt x="430808" y="631282"/>
                  <a:pt x="410335" y="600387"/>
                </a:cubicBezTo>
                <a:cubicBezTo>
                  <a:pt x="406240" y="594431"/>
                  <a:pt x="402890" y="587731"/>
                  <a:pt x="397307" y="582892"/>
                </a:cubicBezTo>
                <a:cubicBezTo>
                  <a:pt x="386884" y="573214"/>
                  <a:pt x="375717" y="572098"/>
                  <a:pt x="363062" y="584009"/>
                </a:cubicBezTo>
                <a:cubicBezTo>
                  <a:pt x="346311" y="599643"/>
                  <a:pt x="340356" y="598526"/>
                  <a:pt x="334772" y="578426"/>
                </a:cubicBezTo>
                <a:cubicBezTo>
                  <a:pt x="327327" y="551253"/>
                  <a:pt x="310577" y="532269"/>
                  <a:pt x="281915" y="522219"/>
                </a:cubicBezTo>
                <a:cubicBezTo>
                  <a:pt x="275960" y="519985"/>
                  <a:pt x="269632" y="517007"/>
                  <a:pt x="263304" y="521846"/>
                </a:cubicBezTo>
                <a:cubicBezTo>
                  <a:pt x="256604" y="527430"/>
                  <a:pt x="261070" y="533013"/>
                  <a:pt x="263676" y="538225"/>
                </a:cubicBezTo>
                <a:cubicBezTo>
                  <a:pt x="267398" y="546414"/>
                  <a:pt x="271865" y="554603"/>
                  <a:pt x="275215" y="563164"/>
                </a:cubicBezTo>
                <a:cubicBezTo>
                  <a:pt x="281171" y="576937"/>
                  <a:pt x="282288" y="591454"/>
                  <a:pt x="271121" y="604854"/>
                </a:cubicBezTo>
                <a:cubicBezTo>
                  <a:pt x="262931" y="614532"/>
                  <a:pt x="263676" y="620860"/>
                  <a:pt x="274471" y="627560"/>
                </a:cubicBezTo>
                <a:cubicBezTo>
                  <a:pt x="309088" y="648405"/>
                  <a:pt x="331050" y="675578"/>
                  <a:pt x="319138" y="718012"/>
                </a:cubicBezTo>
                <a:cubicBezTo>
                  <a:pt x="317277" y="723968"/>
                  <a:pt x="319511" y="729924"/>
                  <a:pt x="326583" y="729551"/>
                </a:cubicBezTo>
                <a:cubicBezTo>
                  <a:pt x="342217" y="728435"/>
                  <a:pt x="344822" y="738113"/>
                  <a:pt x="349289" y="748163"/>
                </a:cubicBezTo>
                <a:cubicBezTo>
                  <a:pt x="392840" y="844571"/>
                  <a:pt x="455747" y="928695"/>
                  <a:pt x="528332" y="1007608"/>
                </a:cubicBezTo>
                <a:cubicBezTo>
                  <a:pt x="600173" y="1085777"/>
                  <a:pt x="680947" y="1155756"/>
                  <a:pt x="766932" y="1222758"/>
                </a:cubicBezTo>
                <a:cubicBezTo>
                  <a:pt x="742737" y="1220524"/>
                  <a:pt x="711470" y="1206752"/>
                  <a:pt x="681319" y="1190746"/>
                </a:cubicBezTo>
                <a:cubicBezTo>
                  <a:pt x="601662" y="1147939"/>
                  <a:pt x="536149" y="1089871"/>
                  <a:pt x="469520" y="1032920"/>
                </a:cubicBezTo>
                <a:cubicBezTo>
                  <a:pt x="422991" y="993091"/>
                  <a:pt x="377579" y="952146"/>
                  <a:pt x="325466" y="917900"/>
                </a:cubicBezTo>
                <a:cubicBezTo>
                  <a:pt x="319511" y="914178"/>
                  <a:pt x="315416" y="909339"/>
                  <a:pt x="312066" y="903383"/>
                </a:cubicBezTo>
                <a:cubicBezTo>
                  <a:pt x="309088" y="898172"/>
                  <a:pt x="304621" y="893333"/>
                  <a:pt x="296805" y="895566"/>
                </a:cubicBezTo>
                <a:cubicBezTo>
                  <a:pt x="288988" y="898172"/>
                  <a:pt x="288243" y="904872"/>
                  <a:pt x="288243" y="910828"/>
                </a:cubicBezTo>
                <a:cubicBezTo>
                  <a:pt x="289360" y="933162"/>
                  <a:pt x="295688" y="953262"/>
                  <a:pt x="309460" y="971129"/>
                </a:cubicBezTo>
                <a:cubicBezTo>
                  <a:pt x="336261" y="1006864"/>
                  <a:pt x="371995" y="1034781"/>
                  <a:pt x="407729" y="1062698"/>
                </a:cubicBezTo>
                <a:cubicBezTo>
                  <a:pt x="457236" y="1101038"/>
                  <a:pt x="503021" y="1142728"/>
                  <a:pt x="544338" y="1189257"/>
                </a:cubicBezTo>
                <a:cubicBezTo>
                  <a:pt x="514560" y="1166551"/>
                  <a:pt x="484781" y="1143472"/>
                  <a:pt x="454630" y="1120766"/>
                </a:cubicBezTo>
                <a:cubicBezTo>
                  <a:pt x="431924" y="1103644"/>
                  <a:pt x="408474" y="1087265"/>
                  <a:pt x="385396" y="1070515"/>
                </a:cubicBezTo>
                <a:cubicBezTo>
                  <a:pt x="379812" y="1066421"/>
                  <a:pt x="373856" y="1061954"/>
                  <a:pt x="366040" y="1067537"/>
                </a:cubicBezTo>
                <a:cubicBezTo>
                  <a:pt x="358967" y="1072376"/>
                  <a:pt x="360084" y="1079449"/>
                  <a:pt x="361573" y="1086149"/>
                </a:cubicBezTo>
                <a:cubicBezTo>
                  <a:pt x="367156" y="1112577"/>
                  <a:pt x="382790" y="1133794"/>
                  <a:pt x="402146" y="1152778"/>
                </a:cubicBezTo>
                <a:cubicBezTo>
                  <a:pt x="425596" y="1175484"/>
                  <a:pt x="450164" y="1197074"/>
                  <a:pt x="475475" y="1218663"/>
                </a:cubicBezTo>
                <a:cubicBezTo>
                  <a:pt x="448303" y="1212707"/>
                  <a:pt x="421130" y="1206752"/>
                  <a:pt x="393957" y="1201913"/>
                </a:cubicBezTo>
                <a:cubicBezTo>
                  <a:pt x="406240" y="1245091"/>
                  <a:pt x="434902" y="1253653"/>
                  <a:pt x="460586" y="1260353"/>
                </a:cubicBezTo>
                <a:cubicBezTo>
                  <a:pt x="495204" y="1268914"/>
                  <a:pt x="528332" y="1279709"/>
                  <a:pt x="561089" y="1291993"/>
                </a:cubicBezTo>
                <a:cubicBezTo>
                  <a:pt x="574861" y="1304276"/>
                  <a:pt x="588634" y="1316188"/>
                  <a:pt x="602034" y="1328843"/>
                </a:cubicBezTo>
                <a:cubicBezTo>
                  <a:pt x="615807" y="1341872"/>
                  <a:pt x="628835" y="1354900"/>
                  <a:pt x="641863" y="1368672"/>
                </a:cubicBezTo>
                <a:cubicBezTo>
                  <a:pt x="651169" y="1378722"/>
                  <a:pt x="662335" y="1387284"/>
                  <a:pt x="651541" y="1404406"/>
                </a:cubicBezTo>
                <a:cubicBezTo>
                  <a:pt x="646702" y="1412223"/>
                  <a:pt x="678341" y="1454658"/>
                  <a:pt x="688392" y="1457263"/>
                </a:cubicBezTo>
                <a:cubicBezTo>
                  <a:pt x="689881" y="1457635"/>
                  <a:pt x="691369" y="1458008"/>
                  <a:pt x="692486" y="1458008"/>
                </a:cubicBezTo>
                <a:cubicBezTo>
                  <a:pt x="714076" y="1456519"/>
                  <a:pt x="718915" y="1469175"/>
                  <a:pt x="719287" y="1485181"/>
                </a:cubicBezTo>
                <a:cubicBezTo>
                  <a:pt x="719659" y="1500814"/>
                  <a:pt x="715937" y="1520170"/>
                  <a:pt x="745343" y="1512353"/>
                </a:cubicBezTo>
                <a:cubicBezTo>
                  <a:pt x="748693" y="1511609"/>
                  <a:pt x="749438" y="1513842"/>
                  <a:pt x="750926" y="1516448"/>
                </a:cubicBezTo>
                <a:cubicBezTo>
                  <a:pt x="782938" y="1583077"/>
                  <a:pt x="836912" y="1634445"/>
                  <a:pt x="890141" y="1685813"/>
                </a:cubicBezTo>
                <a:cubicBezTo>
                  <a:pt x="893119" y="1688419"/>
                  <a:pt x="896097" y="1691024"/>
                  <a:pt x="899074" y="1693630"/>
                </a:cubicBezTo>
                <a:cubicBezTo>
                  <a:pt x="843240" y="1680602"/>
                  <a:pt x="658985" y="1663851"/>
                  <a:pt x="605012" y="1669435"/>
                </a:cubicBezTo>
                <a:cubicBezTo>
                  <a:pt x="556994" y="1674274"/>
                  <a:pt x="285638" y="1593128"/>
                  <a:pt x="229431" y="1545110"/>
                </a:cubicBezTo>
                <a:cubicBezTo>
                  <a:pt x="221614" y="1582705"/>
                  <a:pt x="238364" y="1597594"/>
                  <a:pt x="251765" y="1614717"/>
                </a:cubicBezTo>
                <a:cubicBezTo>
                  <a:pt x="270748" y="1638912"/>
                  <a:pt x="273726" y="1656035"/>
                  <a:pt x="237992" y="1675391"/>
                </a:cubicBezTo>
                <a:cubicBezTo>
                  <a:pt x="135628" y="1730481"/>
                  <a:pt x="136745" y="1732342"/>
                  <a:pt x="232781" y="1807160"/>
                </a:cubicBezTo>
                <a:cubicBezTo>
                  <a:pt x="237248" y="1810511"/>
                  <a:pt x="235014" y="1821305"/>
                  <a:pt x="236131" y="1828750"/>
                </a:cubicBezTo>
                <a:cubicBezTo>
                  <a:pt x="211191" y="1839917"/>
                  <a:pt x="181785" y="1810883"/>
                  <a:pt x="152007" y="1842150"/>
                </a:cubicBezTo>
                <a:cubicBezTo>
                  <a:pt x="280426" y="1979503"/>
                  <a:pt x="475848" y="2110157"/>
                  <a:pt x="653030" y="2213265"/>
                </a:cubicBezTo>
                <a:cubicBezTo>
                  <a:pt x="509721" y="2247138"/>
                  <a:pt x="423735" y="2128024"/>
                  <a:pt x="318394" y="2143285"/>
                </a:cubicBezTo>
                <a:cubicBezTo>
                  <a:pt x="265909" y="2180508"/>
                  <a:pt x="422246" y="2240810"/>
                  <a:pt x="272982" y="2258305"/>
                </a:cubicBezTo>
                <a:cubicBezTo>
                  <a:pt x="337750" y="2291061"/>
                  <a:pt x="385768" y="2323073"/>
                  <a:pt x="430435" y="2360668"/>
                </a:cubicBezTo>
                <a:cubicBezTo>
                  <a:pt x="509721" y="2428042"/>
                  <a:pt x="525354" y="2472710"/>
                  <a:pt x="488876" y="2563162"/>
                </a:cubicBezTo>
                <a:cubicBezTo>
                  <a:pt x="464681" y="2622719"/>
                  <a:pt x="429691" y="2677437"/>
                  <a:pt x="460586" y="2748533"/>
                </a:cubicBezTo>
                <a:cubicBezTo>
                  <a:pt x="481803" y="2797295"/>
                  <a:pt x="473614" y="2829307"/>
                  <a:pt x="393212" y="2807345"/>
                </a:cubicBezTo>
                <a:cubicBezTo>
                  <a:pt x="306483" y="2783895"/>
                  <a:pt x="273726" y="2827818"/>
                  <a:pt x="295688" y="2913059"/>
                </a:cubicBezTo>
                <a:cubicBezTo>
                  <a:pt x="309833" y="2967777"/>
                  <a:pt x="294943" y="2984900"/>
                  <a:pt x="235386" y="2978572"/>
                </a:cubicBezTo>
                <a:cubicBezTo>
                  <a:pt x="169501" y="2971499"/>
                  <a:pt x="106967" y="2935765"/>
                  <a:pt x="25448" y="2952888"/>
                </a:cubicBezTo>
                <a:cubicBezTo>
                  <a:pt x="90588" y="3052646"/>
                  <a:pt x="229803" y="3024356"/>
                  <a:pt x="305738" y="3119275"/>
                </a:cubicBezTo>
                <a:cubicBezTo>
                  <a:pt x="215286" y="3119647"/>
                  <a:pt x="146051" y="3119275"/>
                  <a:pt x="79049" y="3098430"/>
                </a:cubicBezTo>
                <a:cubicBezTo>
                  <a:pt x="51132" y="3089869"/>
                  <a:pt x="20609" y="3081308"/>
                  <a:pt x="4975" y="3109969"/>
                </a:cubicBezTo>
                <a:cubicBezTo>
                  <a:pt x="-13636" y="3144587"/>
                  <a:pt x="24331" y="3157615"/>
                  <a:pt x="47037" y="3163943"/>
                </a:cubicBezTo>
                <a:cubicBezTo>
                  <a:pt x="111061" y="3181438"/>
                  <a:pt x="160196" y="3222755"/>
                  <a:pt x="213425" y="3255139"/>
                </a:cubicBezTo>
                <a:cubicBezTo>
                  <a:pt x="329933" y="3326236"/>
                  <a:pt x="457981" y="3385420"/>
                  <a:pt x="556622" y="3502301"/>
                </a:cubicBezTo>
                <a:cubicBezTo>
                  <a:pt x="432669" y="3472523"/>
                  <a:pt x="339983" y="3402915"/>
                  <a:pt x="224592" y="3388771"/>
                </a:cubicBezTo>
                <a:cubicBezTo>
                  <a:pt x="324722" y="3495601"/>
                  <a:pt x="453142" y="3565208"/>
                  <a:pt x="574861" y="3643004"/>
                </a:cubicBezTo>
                <a:cubicBezTo>
                  <a:pt x="609479" y="3664966"/>
                  <a:pt x="644841" y="3679855"/>
                  <a:pt x="652657" y="3727501"/>
                </a:cubicBezTo>
                <a:cubicBezTo>
                  <a:pt x="667919" y="3819814"/>
                  <a:pt x="712959" y="3896494"/>
                  <a:pt x="810111" y="3937067"/>
                </a:cubicBezTo>
                <a:cubicBezTo>
                  <a:pt x="810856" y="3937439"/>
                  <a:pt x="805644" y="3951212"/>
                  <a:pt x="802294" y="3960890"/>
                </a:cubicBezTo>
                <a:cubicBezTo>
                  <a:pt x="743110" y="3963868"/>
                  <a:pt x="696581" y="3909149"/>
                  <a:pt x="620646" y="3927017"/>
                </a:cubicBezTo>
                <a:cubicBezTo>
                  <a:pt x="692858" y="4001091"/>
                  <a:pt x="753532" y="4067720"/>
                  <a:pt x="856268" y="4103082"/>
                </a:cubicBezTo>
                <a:cubicBezTo>
                  <a:pt x="938531" y="4131372"/>
                  <a:pt x="1040150" y="4147377"/>
                  <a:pt x="1099707" y="4238574"/>
                </a:cubicBezTo>
                <a:cubicBezTo>
                  <a:pt x="1030472" y="4256441"/>
                  <a:pt x="978732" y="4234107"/>
                  <a:pt x="926992" y="4218102"/>
                </a:cubicBezTo>
                <a:cubicBezTo>
                  <a:pt x="847334" y="4193534"/>
                  <a:pt x="769166" y="4165617"/>
                  <a:pt x="689508" y="4140677"/>
                </a:cubicBezTo>
                <a:cubicBezTo>
                  <a:pt x="659358" y="4131372"/>
                  <a:pt x="626229" y="4124299"/>
                  <a:pt x="606873" y="4169711"/>
                </a:cubicBezTo>
                <a:cubicBezTo>
                  <a:pt x="707748" y="4179389"/>
                  <a:pt x="768421" y="4240435"/>
                  <a:pt x="831701" y="4297759"/>
                </a:cubicBezTo>
                <a:cubicBezTo>
                  <a:pt x="867435" y="4330143"/>
                  <a:pt x="896469" y="4373322"/>
                  <a:pt x="960493" y="4356944"/>
                </a:cubicBezTo>
                <a:cubicBezTo>
                  <a:pt x="994366" y="4348382"/>
                  <a:pt x="1015955" y="4372578"/>
                  <a:pt x="1012233" y="4402356"/>
                </a:cubicBezTo>
                <a:cubicBezTo>
                  <a:pt x="999577" y="4507325"/>
                  <a:pt x="1078118" y="4544176"/>
                  <a:pt x="1159636" y="4564276"/>
                </a:cubicBezTo>
                <a:cubicBezTo>
                  <a:pt x="1313740" y="4602616"/>
                  <a:pt x="1442160" y="4692324"/>
                  <a:pt x="1592169" y="4741458"/>
                </a:cubicBezTo>
                <a:cubicBezTo>
                  <a:pt x="1738083" y="4789104"/>
                  <a:pt x="2833187" y="5010209"/>
                  <a:pt x="3110499" y="5032171"/>
                </a:cubicBezTo>
                <a:cubicBezTo>
                  <a:pt x="4807501" y="5166546"/>
                  <a:pt x="6028047" y="4106432"/>
                  <a:pt x="6033630" y="4091915"/>
                </a:cubicBezTo>
                <a:cubicBezTo>
                  <a:pt x="6059314" y="4023797"/>
                  <a:pt x="6122965" y="3994390"/>
                  <a:pt x="6180661" y="3957912"/>
                </a:cubicBezTo>
                <a:cubicBezTo>
                  <a:pt x="6230913" y="3925900"/>
                  <a:pt x="6284514" y="3892027"/>
                  <a:pt x="6305359" y="3837309"/>
                </a:cubicBezTo>
                <a:cubicBezTo>
                  <a:pt x="6332904" y="3764724"/>
                  <a:pt x="6254735" y="3824281"/>
                  <a:pt x="6240218" y="3796364"/>
                </a:cubicBezTo>
                <a:cubicBezTo>
                  <a:pt x="6269997" y="3758768"/>
                  <a:pt x="6316153" y="3724151"/>
                  <a:pt x="6328437" y="3681344"/>
                </a:cubicBezTo>
                <a:cubicBezTo>
                  <a:pt x="6372361" y="3526496"/>
                  <a:pt x="6466907" y="3413710"/>
                  <a:pt x="6608355" y="3326236"/>
                </a:cubicBezTo>
                <a:cubicBezTo>
                  <a:pt x="6648928" y="3300924"/>
                  <a:pt x="6675729" y="3255512"/>
                  <a:pt x="6731191" y="3248067"/>
                </a:cubicBezTo>
                <a:cubicBezTo>
                  <a:pt x="6854400" y="3232061"/>
                  <a:pt x="6815315" y="3106992"/>
                  <a:pt x="6880456" y="3051529"/>
                </a:cubicBezTo>
                <a:cubicBezTo>
                  <a:pt x="6892739" y="3041107"/>
                  <a:pt x="6903907" y="2777939"/>
                  <a:pt x="6901673" y="2763795"/>
                </a:cubicBezTo>
                <a:cubicBezTo>
                  <a:pt x="6898323" y="2743322"/>
                  <a:pt x="6883806" y="2966288"/>
                  <a:pt x="6871150" y="2948421"/>
                </a:cubicBezTo>
                <a:cubicBezTo>
                  <a:pt x="6858494" y="2930182"/>
                  <a:pt x="6839138" y="2914176"/>
                  <a:pt x="6848444" y="2890353"/>
                </a:cubicBezTo>
                <a:cubicBezTo>
                  <a:pt x="6852166" y="2880303"/>
                  <a:pt x="6849561" y="2846058"/>
                  <a:pt x="6878223" y="2873230"/>
                </a:cubicBezTo>
                <a:cubicBezTo>
                  <a:pt x="6956763" y="2946932"/>
                  <a:pt x="6870778" y="2578051"/>
                  <a:pt x="6762459" y="2568745"/>
                </a:cubicBezTo>
                <a:cubicBezTo>
                  <a:pt x="6801915" y="2465637"/>
                  <a:pt x="6801915" y="2465637"/>
                  <a:pt x="6673123" y="2451493"/>
                </a:cubicBezTo>
                <a:cubicBezTo>
                  <a:pt x="6722630" y="2385980"/>
                  <a:pt x="6722630" y="2369229"/>
                  <a:pt x="6662700" y="2346896"/>
                </a:cubicBezTo>
                <a:cubicBezTo>
                  <a:pt x="6605005" y="2325306"/>
                  <a:pt x="6540981" y="2318234"/>
                  <a:pt x="6487752" y="2285105"/>
                </a:cubicBezTo>
                <a:cubicBezTo>
                  <a:pt x="6536887" y="2201353"/>
                  <a:pt x="6550659" y="2104573"/>
                  <a:pt x="6652278" y="2063628"/>
                </a:cubicBezTo>
                <a:cubicBezTo>
                  <a:pt x="6668284" y="2057300"/>
                  <a:pt x="6679079" y="2031988"/>
                  <a:pt x="6668656" y="2017843"/>
                </a:cubicBezTo>
                <a:cubicBezTo>
                  <a:pt x="6631805" y="1965359"/>
                  <a:pt x="6684662" y="1864856"/>
                  <a:pt x="6570015" y="1854062"/>
                </a:cubicBezTo>
                <a:cubicBezTo>
                  <a:pt x="6555870" y="1852573"/>
                  <a:pt x="6542842" y="1842150"/>
                  <a:pt x="6554009" y="1827633"/>
                </a:cubicBezTo>
                <a:cubicBezTo>
                  <a:pt x="6592349" y="1778126"/>
                  <a:pt x="6545820" y="1781476"/>
                  <a:pt x="6517531" y="1775149"/>
                </a:cubicBezTo>
                <a:cubicBezTo>
                  <a:pt x="6483285" y="1767704"/>
                  <a:pt x="6444573" y="1789293"/>
                  <a:pt x="6412934" y="1762493"/>
                </a:cubicBezTo>
                <a:cubicBezTo>
                  <a:pt x="6420378" y="1734203"/>
                  <a:pt x="6447923" y="1734575"/>
                  <a:pt x="6467279" y="1725642"/>
                </a:cubicBezTo>
                <a:cubicBezTo>
                  <a:pt x="6523858" y="1699213"/>
                  <a:pt x="6570015" y="1667946"/>
                  <a:pt x="6572621" y="1600200"/>
                </a:cubicBezTo>
                <a:cubicBezTo>
                  <a:pt x="6574854" y="1545482"/>
                  <a:pt x="6580810" y="1497092"/>
                  <a:pt x="6502641" y="1480341"/>
                </a:cubicBezTo>
                <a:cubicBezTo>
                  <a:pt x="6490358" y="1477736"/>
                  <a:pt x="6484030" y="1470664"/>
                  <a:pt x="6481796" y="1461358"/>
                </a:cubicBezTo>
                <a:cubicBezTo>
                  <a:pt x="6490730" y="1452424"/>
                  <a:pt x="6499291" y="1443118"/>
                  <a:pt x="6509713" y="1436418"/>
                </a:cubicBezTo>
                <a:cubicBezTo>
                  <a:pt x="6544703" y="1414457"/>
                  <a:pt x="6556615" y="1382072"/>
                  <a:pt x="6567037" y="1348199"/>
                </a:cubicBezTo>
                <a:cubicBezTo>
                  <a:pt x="6573737" y="1326610"/>
                  <a:pt x="6581554" y="1305393"/>
                  <a:pt x="6596816" y="1286781"/>
                </a:cubicBezTo>
                <a:cubicBezTo>
                  <a:pt x="6606122" y="1275242"/>
                  <a:pt x="6617661" y="1266681"/>
                  <a:pt x="6632178" y="1261842"/>
                </a:cubicBezTo>
                <a:cubicBezTo>
                  <a:pt x="6644833" y="1257375"/>
                  <a:pt x="6648556" y="1251419"/>
                  <a:pt x="6639994" y="1240625"/>
                </a:cubicBezTo>
                <a:cubicBezTo>
                  <a:pt x="6615799" y="1209729"/>
                  <a:pt x="6606122" y="1175856"/>
                  <a:pt x="6622127" y="1136400"/>
                </a:cubicBezTo>
                <a:cubicBezTo>
                  <a:pt x="6626967" y="1124489"/>
                  <a:pt x="6623617" y="1114066"/>
                  <a:pt x="6612077" y="1109599"/>
                </a:cubicBezTo>
                <a:cubicBezTo>
                  <a:pt x="6564059" y="1090616"/>
                  <a:pt x="6552148" y="1046692"/>
                  <a:pt x="6531675" y="1009469"/>
                </a:cubicBezTo>
                <a:cubicBezTo>
                  <a:pt x="6502641" y="956612"/>
                  <a:pt x="6476213" y="902639"/>
                  <a:pt x="6456113" y="845315"/>
                </a:cubicBezTo>
                <a:cubicBezTo>
                  <a:pt x="6444201" y="811070"/>
                  <a:pt x="6432662" y="777197"/>
                  <a:pt x="6440851" y="739229"/>
                </a:cubicBezTo>
                <a:cubicBezTo>
                  <a:pt x="6442712" y="729924"/>
                  <a:pt x="6439362" y="722107"/>
                  <a:pt x="6434523" y="715034"/>
                </a:cubicBezTo>
                <a:cubicBezTo>
                  <a:pt x="6414050" y="684139"/>
                  <a:pt x="6416656" y="651383"/>
                  <a:pt x="6432290" y="617510"/>
                </a:cubicBezTo>
                <a:cubicBezTo>
                  <a:pt x="6441968" y="597037"/>
                  <a:pt x="6440851" y="594431"/>
                  <a:pt x="6416284" y="595176"/>
                </a:cubicBezTo>
                <a:cubicBezTo>
                  <a:pt x="6366405" y="596293"/>
                  <a:pt x="6316898" y="598154"/>
                  <a:pt x="6267763" y="591826"/>
                </a:cubicBezTo>
                <a:cubicBezTo>
                  <a:pt x="6212673" y="584753"/>
                  <a:pt x="6194806" y="568375"/>
                  <a:pt x="6236496" y="521102"/>
                </a:cubicBezTo>
                <a:cubicBezTo>
                  <a:pt x="6245430" y="511052"/>
                  <a:pt x="6253246" y="499885"/>
                  <a:pt x="6257341" y="487229"/>
                </a:cubicBezTo>
                <a:cubicBezTo>
                  <a:pt x="6260319" y="477179"/>
                  <a:pt x="6257713" y="470106"/>
                  <a:pt x="6248780" y="465267"/>
                </a:cubicBezTo>
                <a:cubicBezTo>
                  <a:pt x="6238357" y="459312"/>
                  <a:pt x="6232774" y="467501"/>
                  <a:pt x="6226818" y="473456"/>
                </a:cubicBezTo>
                <a:cubicBezTo>
                  <a:pt x="6194434" y="505468"/>
                  <a:pt x="6153861" y="527430"/>
                  <a:pt x="6115149" y="551625"/>
                </a:cubicBezTo>
                <a:cubicBezTo>
                  <a:pt x="6059686" y="586615"/>
                  <a:pt x="6001246" y="617510"/>
                  <a:pt x="5951739" y="659944"/>
                </a:cubicBezTo>
                <a:cubicBezTo>
                  <a:pt x="5939084" y="670739"/>
                  <a:pt x="5918611" y="662550"/>
                  <a:pt x="5917122" y="644310"/>
                </a:cubicBezTo>
                <a:cubicBezTo>
                  <a:pt x="5915633" y="626071"/>
                  <a:pt x="5905583" y="626071"/>
                  <a:pt x="5890694" y="630538"/>
                </a:cubicBezTo>
                <a:cubicBezTo>
                  <a:pt x="5872826" y="635749"/>
                  <a:pt x="5854959" y="640960"/>
                  <a:pt x="5837464" y="646916"/>
                </a:cubicBezTo>
                <a:cubicBezTo>
                  <a:pt x="5819225" y="653244"/>
                  <a:pt x="5811036" y="666644"/>
                  <a:pt x="5809175" y="683395"/>
                </a:cubicBezTo>
                <a:cubicBezTo>
                  <a:pt x="5808430" y="689723"/>
                  <a:pt x="5808803" y="697539"/>
                  <a:pt x="5815503" y="698656"/>
                </a:cubicBezTo>
                <a:cubicBezTo>
                  <a:pt x="5843048" y="703495"/>
                  <a:pt x="5755201" y="682278"/>
                  <a:pt x="5746268" y="667389"/>
                </a:cubicBezTo>
                <a:cubicBezTo>
                  <a:pt x="5745896" y="666644"/>
                  <a:pt x="5525907" y="720246"/>
                  <a:pt x="5458905" y="754119"/>
                </a:cubicBezTo>
                <a:close/>
                <a:moveTo>
                  <a:pt x="885302" y="1333310"/>
                </a:moveTo>
                <a:cubicBezTo>
                  <a:pt x="877857" y="1326982"/>
                  <a:pt x="870040" y="1321027"/>
                  <a:pt x="862596" y="1314326"/>
                </a:cubicBezTo>
                <a:cubicBezTo>
                  <a:pt x="863712" y="1312837"/>
                  <a:pt x="865201" y="1311349"/>
                  <a:pt x="866318" y="1309860"/>
                </a:cubicBezTo>
                <a:cubicBezTo>
                  <a:pt x="881580" y="1320282"/>
                  <a:pt x="896841" y="1330705"/>
                  <a:pt x="912103" y="1341127"/>
                </a:cubicBezTo>
                <a:cubicBezTo>
                  <a:pt x="903541" y="1338522"/>
                  <a:pt x="894235" y="1335916"/>
                  <a:pt x="885302" y="1333310"/>
                </a:cubicBezTo>
                <a:close/>
                <a:moveTo>
                  <a:pt x="1140280" y="787619"/>
                </a:moveTo>
                <a:cubicBezTo>
                  <a:pt x="1231849" y="850154"/>
                  <a:pt x="1323418" y="913061"/>
                  <a:pt x="1414987" y="975596"/>
                </a:cubicBezTo>
                <a:cubicBezTo>
                  <a:pt x="1413498" y="977085"/>
                  <a:pt x="1412381" y="978574"/>
                  <a:pt x="1410892" y="980063"/>
                </a:cubicBezTo>
                <a:cubicBezTo>
                  <a:pt x="1310390" y="927206"/>
                  <a:pt x="1215471" y="868394"/>
                  <a:pt x="1140280" y="787619"/>
                </a:cubicBezTo>
                <a:close/>
              </a:path>
            </a:pathLst>
          </a:custGeom>
          <a:solidFill>
            <a:schemeClr val="accent1">
              <a:alpha val="20000"/>
            </a:schemeClr>
          </a:solidFill>
          <a:ln w="32707" cap="flat">
            <a:noFill/>
            <a:prstDash val="solid"/>
            <a:miter/>
          </a:ln>
        </p:spPr>
        <p:txBody>
          <a:bodyPr rtlCol="0" anchor="ctr"/>
          <a:lstStyle/>
          <a:p>
            <a:endParaRPr lang="en-US" dirty="0"/>
          </a:p>
        </p:txBody>
      </p:sp>
      <p:sp>
        <p:nvSpPr>
          <p:cNvPr id="2" name="Title 1">
            <a:extLst>
              <a:ext uri="{FF2B5EF4-FFF2-40B4-BE49-F238E27FC236}">
                <a16:creationId xmlns:a16="http://schemas.microsoft.com/office/drawing/2014/main" id="{192825A4-268B-4301-8432-F9E9B2661AEC}"/>
              </a:ext>
            </a:extLst>
          </p:cNvPr>
          <p:cNvSpPr>
            <a:spLocks noGrp="1"/>
          </p:cNvSpPr>
          <p:nvPr>
            <p:ph type="title"/>
          </p:nvPr>
        </p:nvSpPr>
        <p:spPr>
          <a:xfrm>
            <a:off x="2843784" y="1572768"/>
            <a:ext cx="6501384" cy="4096512"/>
          </a:xfrm>
        </p:spPr>
        <p:txBody>
          <a:bodyPr>
            <a:normAutofit/>
          </a:bodyPr>
          <a:lstStyle>
            <a:lvl1pPr algn="ctr">
              <a:defRPr sz="4000"/>
            </a:lvl1pPr>
          </a:lstStyle>
          <a:p>
            <a:r>
              <a:rPr lang="en-US"/>
              <a:t>Click to edit Master title style</a:t>
            </a:r>
            <a:endParaRPr lang="en-US" dirty="0"/>
          </a:p>
        </p:txBody>
      </p:sp>
      <p:sp>
        <p:nvSpPr>
          <p:cNvPr id="3" name="Date Placeholder 2">
            <a:extLst>
              <a:ext uri="{FF2B5EF4-FFF2-40B4-BE49-F238E27FC236}">
                <a16:creationId xmlns:a16="http://schemas.microsoft.com/office/drawing/2014/main" id="{DA33410F-8A90-47F6-BD39-4AC0E4358351}"/>
              </a:ext>
            </a:extLst>
          </p:cNvPr>
          <p:cNvSpPr>
            <a:spLocks noGrp="1"/>
          </p:cNvSpPr>
          <p:nvPr>
            <p:ph type="dt" sz="half" idx="10"/>
          </p:nvPr>
        </p:nvSpPr>
        <p:spPr/>
        <p:txBody>
          <a:bodyPr/>
          <a:lstStyle/>
          <a:p>
            <a:fld id="{3C04E684-10F4-4CC3-A0B9-F03AA7BE37CF}" type="datetimeFigureOut">
              <a:rPr lang="en-US" smtClean="0"/>
              <a:t>5/3/26</a:t>
            </a:fld>
            <a:endParaRPr lang="en-US" dirty="0"/>
          </a:p>
        </p:txBody>
      </p:sp>
      <p:sp>
        <p:nvSpPr>
          <p:cNvPr id="4" name="Footer Placeholder 3">
            <a:extLst>
              <a:ext uri="{FF2B5EF4-FFF2-40B4-BE49-F238E27FC236}">
                <a16:creationId xmlns:a16="http://schemas.microsoft.com/office/drawing/2014/main" id="{D1D819A9-F8DE-4E5C-AFC3-E0105ACD8295}"/>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A4E25320-A12F-4F3E-8EC9-11292FF36BEA}"/>
              </a:ext>
            </a:extLst>
          </p:cNvPr>
          <p:cNvSpPr>
            <a:spLocks noGrp="1"/>
          </p:cNvSpPr>
          <p:nvPr>
            <p:ph type="sldNum" sz="quarter" idx="12"/>
          </p:nvPr>
        </p:nvSpPr>
        <p:spPr/>
        <p:txBody>
          <a:bodyPr/>
          <a:lstStyle/>
          <a:p>
            <a:fld id="{51845F5A-061D-4825-9AE9-D7794091C6CF}" type="slidenum">
              <a:rPr lang="en-US" smtClean="0"/>
              <a:t>‹#›</a:t>
            </a:fld>
            <a:endParaRPr lang="en-US" dirty="0"/>
          </a:p>
        </p:txBody>
      </p:sp>
    </p:spTree>
    <p:extLst>
      <p:ext uri="{BB962C8B-B14F-4D97-AF65-F5344CB8AC3E}">
        <p14:creationId xmlns:p14="http://schemas.microsoft.com/office/powerpoint/2010/main" val="42744149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1">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1C9756B-145D-4BA8-AA43-904C1E7CB86D}"/>
              </a:ext>
            </a:extLst>
          </p:cNvPr>
          <p:cNvSpPr>
            <a:spLocks noGrp="1"/>
          </p:cNvSpPr>
          <p:nvPr>
            <p:ph type="dt" sz="half" idx="10"/>
          </p:nvPr>
        </p:nvSpPr>
        <p:spPr/>
        <p:txBody>
          <a:bodyPr/>
          <a:lstStyle/>
          <a:p>
            <a:fld id="{3C04E684-10F4-4CC3-A0B9-F03AA7BE37CF}" type="datetimeFigureOut">
              <a:rPr lang="en-US" smtClean="0"/>
              <a:t>5/3/26</a:t>
            </a:fld>
            <a:endParaRPr lang="en-US" dirty="0"/>
          </a:p>
        </p:txBody>
      </p:sp>
      <p:sp>
        <p:nvSpPr>
          <p:cNvPr id="3" name="Footer Placeholder 2">
            <a:extLst>
              <a:ext uri="{FF2B5EF4-FFF2-40B4-BE49-F238E27FC236}">
                <a16:creationId xmlns:a16="http://schemas.microsoft.com/office/drawing/2014/main" id="{B21DB60F-139E-4C44-89AF-3F8F5EC241FB}"/>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388226C9-C193-4B47-9717-4BC86C9092C7}"/>
              </a:ext>
            </a:extLst>
          </p:cNvPr>
          <p:cNvSpPr>
            <a:spLocks noGrp="1"/>
          </p:cNvSpPr>
          <p:nvPr>
            <p:ph type="sldNum" sz="quarter" idx="12"/>
          </p:nvPr>
        </p:nvSpPr>
        <p:spPr/>
        <p:txBody>
          <a:bodyPr/>
          <a:lstStyle/>
          <a:p>
            <a:fld id="{51845F5A-061D-4825-9AE9-D7794091C6CF}" type="slidenum">
              <a:rPr lang="en-US" smtClean="0"/>
              <a:t>‹#›</a:t>
            </a:fld>
            <a:endParaRPr lang="en-US" dirty="0"/>
          </a:p>
        </p:txBody>
      </p:sp>
    </p:spTree>
    <p:extLst>
      <p:ext uri="{BB962C8B-B14F-4D97-AF65-F5344CB8AC3E}">
        <p14:creationId xmlns:p14="http://schemas.microsoft.com/office/powerpoint/2010/main" val="5509243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2">
    <p:spTree>
      <p:nvGrpSpPr>
        <p:cNvPr id="1" name=""/>
        <p:cNvGrpSpPr/>
        <p:nvPr/>
      </p:nvGrpSpPr>
      <p:grpSpPr>
        <a:xfrm>
          <a:off x="0" y="0"/>
          <a:ext cx="0" cy="0"/>
          <a:chOff x="0" y="0"/>
          <a:chExt cx="0" cy="0"/>
        </a:xfrm>
      </p:grpSpPr>
      <p:sp>
        <p:nvSpPr>
          <p:cNvPr id="6" name="Freeform: Shape 5" descr="Mask ID=&#10;Mask position=bottom, center&#10;Mask family= brushstroke, landscape, wide">
            <a:extLst>
              <a:ext uri="{FF2B5EF4-FFF2-40B4-BE49-F238E27FC236}">
                <a16:creationId xmlns:a16="http://schemas.microsoft.com/office/drawing/2014/main" id="{736BF44D-E8DD-45FA-931D-CBCC67D57944}"/>
              </a:ext>
            </a:extLst>
          </p:cNvPr>
          <p:cNvSpPr/>
          <p:nvPr/>
        </p:nvSpPr>
        <p:spPr>
          <a:xfrm>
            <a:off x="1768100" y="-1"/>
            <a:ext cx="10423900" cy="5920155"/>
          </a:xfrm>
          <a:custGeom>
            <a:avLst/>
            <a:gdLst>
              <a:gd name="connsiteX0" fmla="*/ 10423900 w 10423900"/>
              <a:gd name="connsiteY0" fmla="*/ 0 h 5491534"/>
              <a:gd name="connsiteX1" fmla="*/ 3493157 w 10423900"/>
              <a:gd name="connsiteY1" fmla="*/ 0 h 5491534"/>
              <a:gd name="connsiteX2" fmla="*/ 3493018 w 10423900"/>
              <a:gd name="connsiteY2" fmla="*/ 31 h 5491534"/>
              <a:gd name="connsiteX3" fmla="*/ 3245493 w 10423900"/>
              <a:gd name="connsiteY3" fmla="*/ 104839 h 5491534"/>
              <a:gd name="connsiteX4" fmla="*/ 4434802 w 10423900"/>
              <a:gd name="connsiteY4" fmla="*/ 284558 h 5491534"/>
              <a:gd name="connsiteX5" fmla="*/ 4011937 w 10423900"/>
              <a:gd name="connsiteY5" fmla="*/ 395559 h 5491534"/>
              <a:gd name="connsiteX6" fmla="*/ 3573213 w 10423900"/>
              <a:gd name="connsiteY6" fmla="*/ 474847 h 5491534"/>
              <a:gd name="connsiteX7" fmla="*/ 3097489 w 10423900"/>
              <a:gd name="connsiteY7" fmla="*/ 532990 h 5491534"/>
              <a:gd name="connsiteX8" fmla="*/ 2664052 w 10423900"/>
              <a:gd name="connsiteY8" fmla="*/ 649279 h 5491534"/>
              <a:gd name="connsiteX9" fmla="*/ 3795218 w 10423900"/>
              <a:gd name="connsiteY9" fmla="*/ 696852 h 5491534"/>
              <a:gd name="connsiteX10" fmla="*/ 3208492 w 10423900"/>
              <a:gd name="connsiteY10" fmla="*/ 802568 h 5491534"/>
              <a:gd name="connsiteX11" fmla="*/ 2727483 w 10423900"/>
              <a:gd name="connsiteY11" fmla="*/ 939999 h 5491534"/>
              <a:gd name="connsiteX12" fmla="*/ 2389190 w 10423900"/>
              <a:gd name="connsiteY12" fmla="*/ 1003429 h 5491534"/>
              <a:gd name="connsiteX13" fmla="*/ 2029754 w 10423900"/>
              <a:gd name="connsiteY13" fmla="*/ 1019287 h 5491534"/>
              <a:gd name="connsiteX14" fmla="*/ 1945181 w 10423900"/>
              <a:gd name="connsiteY14" fmla="*/ 1119716 h 5491534"/>
              <a:gd name="connsiteX15" fmla="*/ 2056184 w 10423900"/>
              <a:gd name="connsiteY15" fmla="*/ 1225434 h 5491534"/>
              <a:gd name="connsiteX16" fmla="*/ 2225329 w 10423900"/>
              <a:gd name="connsiteY16" fmla="*/ 1236004 h 5491534"/>
              <a:gd name="connsiteX17" fmla="*/ 3234920 w 10423900"/>
              <a:gd name="connsiteY17" fmla="*/ 1262435 h 5491534"/>
              <a:gd name="connsiteX18" fmla="*/ 0 w 10423900"/>
              <a:gd name="connsiteY18" fmla="*/ 1495009 h 5491534"/>
              <a:gd name="connsiteX19" fmla="*/ 438724 w 10423900"/>
              <a:gd name="connsiteY19" fmla="*/ 1637728 h 5491534"/>
              <a:gd name="connsiteX20" fmla="*/ 586726 w 10423900"/>
              <a:gd name="connsiteY20" fmla="*/ 2028877 h 5491534"/>
              <a:gd name="connsiteX21" fmla="*/ 1125878 w 10423900"/>
              <a:gd name="connsiteY21" fmla="*/ 2250882 h 5491534"/>
              <a:gd name="connsiteX22" fmla="*/ 1474744 w 10423900"/>
              <a:gd name="connsiteY22" fmla="*/ 2330169 h 5491534"/>
              <a:gd name="connsiteX23" fmla="*/ 2272901 w 10423900"/>
              <a:gd name="connsiteY23" fmla="*/ 2446458 h 5491534"/>
              <a:gd name="connsiteX24" fmla="*/ 2389190 w 10423900"/>
              <a:gd name="connsiteY24" fmla="*/ 2636747 h 5491534"/>
              <a:gd name="connsiteX25" fmla="*/ 2489621 w 10423900"/>
              <a:gd name="connsiteY25" fmla="*/ 2848179 h 5491534"/>
              <a:gd name="connsiteX26" fmla="*/ 2701053 w 10423900"/>
              <a:gd name="connsiteY26" fmla="*/ 2985611 h 5491534"/>
              <a:gd name="connsiteX27" fmla="*/ 1057165 w 10423900"/>
              <a:gd name="connsiteY27" fmla="*/ 2964468 h 5491534"/>
              <a:gd name="connsiteX28" fmla="*/ 2912485 w 10423900"/>
              <a:gd name="connsiteY28" fmla="*/ 3408477 h 5491534"/>
              <a:gd name="connsiteX29" fmla="*/ 2748626 w 10423900"/>
              <a:gd name="connsiteY29" fmla="*/ 3582909 h 5491534"/>
              <a:gd name="connsiteX30" fmla="*/ 3763503 w 10423900"/>
              <a:gd name="connsiteY30" fmla="*/ 3820771 h 5491534"/>
              <a:gd name="connsiteX31" fmla="*/ 3219063 w 10423900"/>
              <a:gd name="connsiteY31" fmla="*/ 3847199 h 5491534"/>
              <a:gd name="connsiteX32" fmla="*/ 6385269 w 10423900"/>
              <a:gd name="connsiteY32" fmla="*/ 4840933 h 5491534"/>
              <a:gd name="connsiteX33" fmla="*/ 10285854 w 10423900"/>
              <a:gd name="connsiteY33" fmla="*/ 5471118 h 5491534"/>
              <a:gd name="connsiteX34" fmla="*/ 10423900 w 10423900"/>
              <a:gd name="connsiteY34" fmla="*/ 5491534 h 549153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Lst>
            <a:rect l="l" t="t" r="r" b="b"/>
            <a:pathLst>
              <a:path w="10423900" h="5491534">
                <a:moveTo>
                  <a:pt x="10423900" y="0"/>
                </a:moveTo>
                <a:lnTo>
                  <a:pt x="3493157" y="0"/>
                </a:lnTo>
                <a:lnTo>
                  <a:pt x="3493018" y="31"/>
                </a:lnTo>
                <a:cubicBezTo>
                  <a:pt x="3414969" y="12668"/>
                  <a:pt x="3328744" y="21588"/>
                  <a:pt x="3245493" y="104839"/>
                </a:cubicBezTo>
                <a:cubicBezTo>
                  <a:pt x="3668357" y="162984"/>
                  <a:pt x="4075366" y="51981"/>
                  <a:pt x="4434802" y="284558"/>
                </a:cubicBezTo>
                <a:cubicBezTo>
                  <a:pt x="4302656" y="400846"/>
                  <a:pt x="4154654" y="374416"/>
                  <a:pt x="4011937" y="395559"/>
                </a:cubicBezTo>
                <a:cubicBezTo>
                  <a:pt x="3863934" y="416704"/>
                  <a:pt x="3721217" y="453704"/>
                  <a:pt x="3573213" y="474847"/>
                </a:cubicBezTo>
                <a:cubicBezTo>
                  <a:pt x="3414639" y="501275"/>
                  <a:pt x="3256063" y="506562"/>
                  <a:pt x="3097489" y="532990"/>
                </a:cubicBezTo>
                <a:cubicBezTo>
                  <a:pt x="2965345" y="554135"/>
                  <a:pt x="2822627" y="517133"/>
                  <a:pt x="2664052" y="649279"/>
                </a:cubicBezTo>
                <a:cubicBezTo>
                  <a:pt x="3055203" y="744424"/>
                  <a:pt x="3409352" y="601706"/>
                  <a:pt x="3795218" y="696852"/>
                </a:cubicBezTo>
                <a:cubicBezTo>
                  <a:pt x="3567928" y="781425"/>
                  <a:pt x="3382924" y="754995"/>
                  <a:pt x="3208492" y="802568"/>
                </a:cubicBezTo>
                <a:cubicBezTo>
                  <a:pt x="3049916" y="850140"/>
                  <a:pt x="2859627" y="797282"/>
                  <a:pt x="2727483" y="939999"/>
                </a:cubicBezTo>
                <a:cubicBezTo>
                  <a:pt x="2627052" y="1051000"/>
                  <a:pt x="2521336" y="1066858"/>
                  <a:pt x="2389190" y="1003429"/>
                </a:cubicBezTo>
                <a:cubicBezTo>
                  <a:pt x="2272901" y="945284"/>
                  <a:pt x="2146043" y="961142"/>
                  <a:pt x="2029754" y="1019287"/>
                </a:cubicBezTo>
                <a:cubicBezTo>
                  <a:pt x="1987468" y="1040430"/>
                  <a:pt x="1945181" y="1066858"/>
                  <a:pt x="1945181" y="1119716"/>
                </a:cubicBezTo>
                <a:cubicBezTo>
                  <a:pt x="1945181" y="1193719"/>
                  <a:pt x="1998039" y="1214862"/>
                  <a:pt x="2056184" y="1225434"/>
                </a:cubicBezTo>
                <a:cubicBezTo>
                  <a:pt x="2109042" y="1236004"/>
                  <a:pt x="2172471" y="1246577"/>
                  <a:pt x="2225329" y="1236004"/>
                </a:cubicBezTo>
                <a:cubicBezTo>
                  <a:pt x="2563622" y="1177861"/>
                  <a:pt x="2896629" y="1273005"/>
                  <a:pt x="3234920" y="1262435"/>
                </a:cubicBezTo>
                <a:cubicBezTo>
                  <a:pt x="2172471" y="1489724"/>
                  <a:pt x="1099450" y="1415723"/>
                  <a:pt x="0" y="1495009"/>
                </a:cubicBezTo>
                <a:cubicBezTo>
                  <a:pt x="142717" y="1653583"/>
                  <a:pt x="327721" y="1521439"/>
                  <a:pt x="438724" y="1637728"/>
                </a:cubicBezTo>
                <a:cubicBezTo>
                  <a:pt x="333006" y="1880875"/>
                  <a:pt x="375293" y="2013020"/>
                  <a:pt x="586726" y="2028877"/>
                </a:cubicBezTo>
                <a:cubicBezTo>
                  <a:pt x="792873" y="2044734"/>
                  <a:pt x="1014877" y="1960161"/>
                  <a:pt x="1125878" y="2250882"/>
                </a:cubicBezTo>
                <a:cubicBezTo>
                  <a:pt x="1157593" y="2340740"/>
                  <a:pt x="1353170" y="2314312"/>
                  <a:pt x="1474744" y="2330169"/>
                </a:cubicBezTo>
                <a:cubicBezTo>
                  <a:pt x="1739034" y="2367170"/>
                  <a:pt x="2019183" y="2330169"/>
                  <a:pt x="2272901" y="2446458"/>
                </a:cubicBezTo>
                <a:cubicBezTo>
                  <a:pt x="2373332" y="2488744"/>
                  <a:pt x="2442048" y="2520459"/>
                  <a:pt x="2389190" y="2636747"/>
                </a:cubicBezTo>
                <a:cubicBezTo>
                  <a:pt x="2336332" y="2758321"/>
                  <a:pt x="2405048" y="2800607"/>
                  <a:pt x="2489621" y="2848179"/>
                </a:cubicBezTo>
                <a:cubicBezTo>
                  <a:pt x="2553051" y="2885180"/>
                  <a:pt x="2648195" y="2874609"/>
                  <a:pt x="2701053" y="2985611"/>
                </a:cubicBezTo>
                <a:cubicBezTo>
                  <a:pt x="2146043" y="2969753"/>
                  <a:pt x="1606888" y="2879895"/>
                  <a:pt x="1057165" y="2964468"/>
                </a:cubicBezTo>
                <a:cubicBezTo>
                  <a:pt x="1659748" y="3175900"/>
                  <a:pt x="2320474" y="3165328"/>
                  <a:pt x="2912485" y="3408477"/>
                </a:cubicBezTo>
                <a:cubicBezTo>
                  <a:pt x="2891342" y="3493050"/>
                  <a:pt x="2753911" y="3456048"/>
                  <a:pt x="2748626" y="3582909"/>
                </a:cubicBezTo>
                <a:cubicBezTo>
                  <a:pt x="3060489" y="3715055"/>
                  <a:pt x="3435782" y="3625195"/>
                  <a:pt x="3763503" y="3820771"/>
                </a:cubicBezTo>
                <a:cubicBezTo>
                  <a:pt x="3573213" y="3910629"/>
                  <a:pt x="3398782" y="3762626"/>
                  <a:pt x="3219063" y="3847199"/>
                </a:cubicBezTo>
                <a:cubicBezTo>
                  <a:pt x="3277208" y="3974060"/>
                  <a:pt x="5909545" y="4756360"/>
                  <a:pt x="6385269" y="4840933"/>
                </a:cubicBezTo>
                <a:cubicBezTo>
                  <a:pt x="7171204" y="4982659"/>
                  <a:pt x="9157515" y="5302348"/>
                  <a:pt x="10285854" y="5471118"/>
                </a:cubicBezTo>
                <a:lnTo>
                  <a:pt x="10423900" y="5491534"/>
                </a:lnTo>
                <a:close/>
              </a:path>
            </a:pathLst>
          </a:custGeom>
          <a:solidFill>
            <a:schemeClr val="accent1">
              <a:alpha val="20000"/>
            </a:schemeClr>
          </a:solidFill>
          <a:ln w="32707" cap="flat">
            <a:noFill/>
            <a:prstDash val="solid"/>
            <a:miter/>
          </a:ln>
        </p:spPr>
        <p:txBody>
          <a:bodyPr wrap="square" rtlCol="0" anchor="ctr">
            <a:noAutofit/>
          </a:bodyPr>
          <a:lstStyle/>
          <a:p>
            <a:endParaRPr lang="en-US" dirty="0"/>
          </a:p>
        </p:txBody>
      </p:sp>
      <p:sp>
        <p:nvSpPr>
          <p:cNvPr id="2" name="Date Placeholder 1">
            <a:extLst>
              <a:ext uri="{FF2B5EF4-FFF2-40B4-BE49-F238E27FC236}">
                <a16:creationId xmlns:a16="http://schemas.microsoft.com/office/drawing/2014/main" id="{71C9756B-145D-4BA8-AA43-904C1E7CB86D}"/>
              </a:ext>
            </a:extLst>
          </p:cNvPr>
          <p:cNvSpPr>
            <a:spLocks noGrp="1"/>
          </p:cNvSpPr>
          <p:nvPr>
            <p:ph type="dt" sz="half" idx="10"/>
          </p:nvPr>
        </p:nvSpPr>
        <p:spPr/>
        <p:txBody>
          <a:bodyPr/>
          <a:lstStyle/>
          <a:p>
            <a:fld id="{3C04E684-10F4-4CC3-A0B9-F03AA7BE37CF}" type="datetimeFigureOut">
              <a:rPr lang="en-US" smtClean="0"/>
              <a:t>5/3/26</a:t>
            </a:fld>
            <a:endParaRPr lang="en-US" dirty="0"/>
          </a:p>
        </p:txBody>
      </p:sp>
      <p:sp>
        <p:nvSpPr>
          <p:cNvPr id="3" name="Footer Placeholder 2">
            <a:extLst>
              <a:ext uri="{FF2B5EF4-FFF2-40B4-BE49-F238E27FC236}">
                <a16:creationId xmlns:a16="http://schemas.microsoft.com/office/drawing/2014/main" id="{B21DB60F-139E-4C44-89AF-3F8F5EC241FB}"/>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388226C9-C193-4B47-9717-4BC86C9092C7}"/>
              </a:ext>
            </a:extLst>
          </p:cNvPr>
          <p:cNvSpPr>
            <a:spLocks noGrp="1"/>
          </p:cNvSpPr>
          <p:nvPr>
            <p:ph type="sldNum" sz="quarter" idx="12"/>
          </p:nvPr>
        </p:nvSpPr>
        <p:spPr/>
        <p:txBody>
          <a:bodyPr/>
          <a:lstStyle/>
          <a:p>
            <a:fld id="{51845F5A-061D-4825-9AE9-D7794091C6CF}" type="slidenum">
              <a:rPr lang="en-US" smtClean="0"/>
              <a:t>‹#›</a:t>
            </a:fld>
            <a:endParaRPr lang="en-US" dirty="0"/>
          </a:p>
        </p:txBody>
      </p:sp>
    </p:spTree>
    <p:extLst>
      <p:ext uri="{BB962C8B-B14F-4D97-AF65-F5344CB8AC3E}">
        <p14:creationId xmlns:p14="http://schemas.microsoft.com/office/powerpoint/2010/main" val="14831120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8" name="Freeform: Shape 7" descr="Tag=AccentColor&#10;Flavor=Light&#10;Target=Fill">
            <a:extLst>
              <a:ext uri="{FF2B5EF4-FFF2-40B4-BE49-F238E27FC236}">
                <a16:creationId xmlns:a16="http://schemas.microsoft.com/office/drawing/2014/main" id="{76C5A8FA-6B61-4934-AF55-C595090CA5DC}"/>
              </a:ext>
            </a:extLst>
          </p:cNvPr>
          <p:cNvSpPr/>
          <p:nvPr/>
        </p:nvSpPr>
        <p:spPr>
          <a:xfrm>
            <a:off x="4726728" y="0"/>
            <a:ext cx="7472381" cy="6858000"/>
          </a:xfrm>
          <a:custGeom>
            <a:avLst/>
            <a:gdLst>
              <a:gd name="connsiteX0" fmla="*/ 1232666 w 7472381"/>
              <a:gd name="connsiteY0" fmla="*/ 0 h 6886575"/>
              <a:gd name="connsiteX1" fmla="*/ 7472381 w 7472381"/>
              <a:gd name="connsiteY1" fmla="*/ 0 h 6886575"/>
              <a:gd name="connsiteX2" fmla="*/ 7472381 w 7472381"/>
              <a:gd name="connsiteY2" fmla="*/ 814388 h 6886575"/>
              <a:gd name="connsiteX3" fmla="*/ 7472381 w 7472381"/>
              <a:gd name="connsiteY3" fmla="*/ 6411516 h 6886575"/>
              <a:gd name="connsiteX4" fmla="*/ 7472381 w 7472381"/>
              <a:gd name="connsiteY4" fmla="*/ 6886575 h 6886575"/>
              <a:gd name="connsiteX5" fmla="*/ 6992676 w 7472381"/>
              <a:gd name="connsiteY5" fmla="*/ 6886575 h 6886575"/>
              <a:gd name="connsiteX6" fmla="*/ 1946893 w 7472381"/>
              <a:gd name="connsiteY6" fmla="*/ 6886575 h 6886575"/>
              <a:gd name="connsiteX7" fmla="*/ 1506276 w 7472381"/>
              <a:gd name="connsiteY7" fmla="*/ 6686550 h 6886575"/>
              <a:gd name="connsiteX8" fmla="*/ 1314394 w 7472381"/>
              <a:gd name="connsiteY8" fmla="*/ 6457949 h 6886575"/>
              <a:gd name="connsiteX9" fmla="*/ 1246880 w 7472381"/>
              <a:gd name="connsiteY9" fmla="*/ 6393656 h 6886575"/>
              <a:gd name="connsiteX10" fmla="*/ 1079872 w 7472381"/>
              <a:gd name="connsiteY10" fmla="*/ 6307931 h 6886575"/>
              <a:gd name="connsiteX11" fmla="*/ 788495 w 7472381"/>
              <a:gd name="connsiteY11" fmla="*/ 6125765 h 6886575"/>
              <a:gd name="connsiteX12" fmla="*/ 895097 w 7472381"/>
              <a:gd name="connsiteY12" fmla="*/ 6082903 h 6886575"/>
              <a:gd name="connsiteX13" fmla="*/ 1204239 w 7472381"/>
              <a:gd name="connsiteY13" fmla="*/ 6193631 h 6886575"/>
              <a:gd name="connsiteX14" fmla="*/ 1428102 w 7472381"/>
              <a:gd name="connsiteY14" fmla="*/ 6222206 h 6886575"/>
              <a:gd name="connsiteX15" fmla="*/ 1111852 w 7472381"/>
              <a:gd name="connsiteY15" fmla="*/ 6029325 h 6886575"/>
              <a:gd name="connsiteX16" fmla="*/ 806262 w 7472381"/>
              <a:gd name="connsiteY16" fmla="*/ 5779294 h 6886575"/>
              <a:gd name="connsiteX17" fmla="*/ 1040785 w 7472381"/>
              <a:gd name="connsiteY17" fmla="*/ 5825728 h 6886575"/>
              <a:gd name="connsiteX18" fmla="*/ 1051445 w 7472381"/>
              <a:gd name="connsiteY18" fmla="*/ 5793581 h 6886575"/>
              <a:gd name="connsiteX19" fmla="*/ 845349 w 7472381"/>
              <a:gd name="connsiteY19" fmla="*/ 5497115 h 6886575"/>
              <a:gd name="connsiteX20" fmla="*/ 745855 w 7472381"/>
              <a:gd name="connsiteY20" fmla="*/ 5375672 h 6886575"/>
              <a:gd name="connsiteX21" fmla="*/ 291024 w 7472381"/>
              <a:gd name="connsiteY21" fmla="*/ 5014913 h 6886575"/>
              <a:gd name="connsiteX22" fmla="*/ 724535 w 7472381"/>
              <a:gd name="connsiteY22" fmla="*/ 5175647 h 6886575"/>
              <a:gd name="connsiteX23" fmla="*/ 276811 w 7472381"/>
              <a:gd name="connsiteY23" fmla="*/ 4825603 h 6886575"/>
              <a:gd name="connsiteX24" fmla="*/ 60055 w 7472381"/>
              <a:gd name="connsiteY24" fmla="*/ 4697016 h 6886575"/>
              <a:gd name="connsiteX25" fmla="*/ 6755 w 7472381"/>
              <a:gd name="connsiteY25" fmla="*/ 4622006 h 6886575"/>
              <a:gd name="connsiteX26" fmla="*/ 102696 w 7472381"/>
              <a:gd name="connsiteY26" fmla="*/ 4604146 h 6886575"/>
              <a:gd name="connsiteX27" fmla="*/ 397625 w 7472381"/>
              <a:gd name="connsiteY27" fmla="*/ 4632722 h 6886575"/>
              <a:gd name="connsiteX28" fmla="*/ 31628 w 7472381"/>
              <a:gd name="connsiteY28" fmla="*/ 4396978 h 6886575"/>
              <a:gd name="connsiteX29" fmla="*/ 305237 w 7472381"/>
              <a:gd name="connsiteY29" fmla="*/ 4432697 h 6886575"/>
              <a:gd name="connsiteX30" fmla="*/ 383412 w 7472381"/>
              <a:gd name="connsiteY30" fmla="*/ 4339828 h 6886575"/>
              <a:gd name="connsiteX31" fmla="*/ 511333 w 7472381"/>
              <a:gd name="connsiteY31" fmla="*/ 4189810 h 6886575"/>
              <a:gd name="connsiteX32" fmla="*/ 600167 w 7472381"/>
              <a:gd name="connsiteY32" fmla="*/ 4107656 h 6886575"/>
              <a:gd name="connsiteX33" fmla="*/ 635701 w 7472381"/>
              <a:gd name="connsiteY33" fmla="*/ 3843337 h 6886575"/>
              <a:gd name="connsiteX34" fmla="*/ 561080 w 7472381"/>
              <a:gd name="connsiteY34" fmla="*/ 3554015 h 6886575"/>
              <a:gd name="connsiteX35" fmla="*/ 354985 w 7472381"/>
              <a:gd name="connsiteY35" fmla="*/ 3407569 h 6886575"/>
              <a:gd name="connsiteX36" fmla="*/ 415392 w 7472381"/>
              <a:gd name="connsiteY36" fmla="*/ 3243263 h 6886575"/>
              <a:gd name="connsiteX37" fmla="*/ 852456 w 7472381"/>
              <a:gd name="connsiteY37" fmla="*/ 3343275 h 6886575"/>
              <a:gd name="connsiteX38" fmla="*/ 202190 w 7472381"/>
              <a:gd name="connsiteY38" fmla="*/ 2953940 h 6886575"/>
              <a:gd name="connsiteX39" fmla="*/ 312344 w 7472381"/>
              <a:gd name="connsiteY39" fmla="*/ 2936081 h 6886575"/>
              <a:gd name="connsiteX40" fmla="*/ 706768 w 7472381"/>
              <a:gd name="connsiteY40" fmla="*/ 2714625 h 6886575"/>
              <a:gd name="connsiteX41" fmla="*/ 728088 w 7472381"/>
              <a:gd name="connsiteY41" fmla="*/ 2703909 h 6886575"/>
              <a:gd name="connsiteX42" fmla="*/ 795602 w 7472381"/>
              <a:gd name="connsiteY42" fmla="*/ 2564606 h 6886575"/>
              <a:gd name="connsiteX43" fmla="*/ 1008804 w 7472381"/>
              <a:gd name="connsiteY43" fmla="*/ 2543175 h 6886575"/>
              <a:gd name="connsiteX44" fmla="*/ 1186473 w 7472381"/>
              <a:gd name="connsiteY44" fmla="*/ 2575322 h 6886575"/>
              <a:gd name="connsiteX45" fmla="*/ 1378355 w 7472381"/>
              <a:gd name="connsiteY45" fmla="*/ 2536031 h 6886575"/>
              <a:gd name="connsiteX46" fmla="*/ 1548916 w 7472381"/>
              <a:gd name="connsiteY46" fmla="*/ 2553891 h 6886575"/>
              <a:gd name="connsiteX47" fmla="*/ 1694604 w 7472381"/>
              <a:gd name="connsiteY47" fmla="*/ 2528888 h 6886575"/>
              <a:gd name="connsiteX48" fmla="*/ 1552469 w 7472381"/>
              <a:gd name="connsiteY48" fmla="*/ 2411015 h 6886575"/>
              <a:gd name="connsiteX49" fmla="*/ 1353481 w 7472381"/>
              <a:gd name="connsiteY49" fmla="*/ 2411015 h 6886575"/>
              <a:gd name="connsiteX50" fmla="*/ 1211346 w 7472381"/>
              <a:gd name="connsiteY50" fmla="*/ 2336007 h 6886575"/>
              <a:gd name="connsiteX51" fmla="*/ 1076318 w 7472381"/>
              <a:gd name="connsiteY51" fmla="*/ 2200275 h 6886575"/>
              <a:gd name="connsiteX52" fmla="*/ 600167 w 7472381"/>
              <a:gd name="connsiteY52" fmla="*/ 1982390 h 6886575"/>
              <a:gd name="connsiteX53" fmla="*/ 514886 w 7472381"/>
              <a:gd name="connsiteY53" fmla="*/ 1900238 h 6886575"/>
              <a:gd name="connsiteX54" fmla="*/ 1872273 w 7472381"/>
              <a:gd name="connsiteY54" fmla="*/ 2218135 h 6886575"/>
              <a:gd name="connsiteX55" fmla="*/ 1452975 w 7472381"/>
              <a:gd name="connsiteY55" fmla="*/ 2085975 h 6886575"/>
              <a:gd name="connsiteX56" fmla="*/ 1737245 w 7472381"/>
              <a:gd name="connsiteY56" fmla="*/ 2110978 h 6886575"/>
              <a:gd name="connsiteX57" fmla="*/ 1893593 w 7472381"/>
              <a:gd name="connsiteY57" fmla="*/ 2021681 h 6886575"/>
              <a:gd name="connsiteX58" fmla="*/ 1893593 w 7472381"/>
              <a:gd name="connsiteY58" fmla="*/ 1993106 h 6886575"/>
              <a:gd name="connsiteX59" fmla="*/ 1776332 w 7472381"/>
              <a:gd name="connsiteY59" fmla="*/ 1910953 h 6886575"/>
              <a:gd name="connsiteX60" fmla="*/ 1708818 w 7472381"/>
              <a:gd name="connsiteY60" fmla="*/ 1857375 h 6886575"/>
              <a:gd name="connsiteX61" fmla="*/ 1524043 w 7472381"/>
              <a:gd name="connsiteY61" fmla="*/ 1664493 h 6886575"/>
              <a:gd name="connsiteX62" fmla="*/ 1655517 w 7472381"/>
              <a:gd name="connsiteY62" fmla="*/ 1643062 h 6886575"/>
              <a:gd name="connsiteX63" fmla="*/ 1705264 w 7472381"/>
              <a:gd name="connsiteY63" fmla="*/ 1603772 h 6886575"/>
              <a:gd name="connsiteX64" fmla="*/ 1669731 w 7472381"/>
              <a:gd name="connsiteY64" fmla="*/ 1546622 h 6886575"/>
              <a:gd name="connsiteX65" fmla="*/ 1261093 w 7472381"/>
              <a:gd name="connsiteY65" fmla="*/ 1371600 h 6886575"/>
              <a:gd name="connsiteX66" fmla="*/ 1229113 w 7472381"/>
              <a:gd name="connsiteY66" fmla="*/ 1235869 h 6886575"/>
              <a:gd name="connsiteX67" fmla="*/ 1307287 w 7472381"/>
              <a:gd name="connsiteY67" fmla="*/ 1214437 h 6886575"/>
              <a:gd name="connsiteX68" fmla="*/ 1396121 w 7472381"/>
              <a:gd name="connsiteY68" fmla="*/ 1225153 h 6886575"/>
              <a:gd name="connsiteX69" fmla="*/ 1325054 w 7472381"/>
              <a:gd name="connsiteY69" fmla="*/ 1117997 h 6886575"/>
              <a:gd name="connsiteX70" fmla="*/ 1037231 w 7472381"/>
              <a:gd name="connsiteY70" fmla="*/ 1010841 h 6886575"/>
              <a:gd name="connsiteX71" fmla="*/ 983931 w 7472381"/>
              <a:gd name="connsiteY71" fmla="*/ 953690 h 6886575"/>
              <a:gd name="connsiteX72" fmla="*/ 1054998 w 7472381"/>
              <a:gd name="connsiteY72" fmla="*/ 925115 h 6886575"/>
              <a:gd name="connsiteX73" fmla="*/ 1108299 w 7472381"/>
              <a:gd name="connsiteY73" fmla="*/ 914400 h 6886575"/>
              <a:gd name="connsiteX74" fmla="*/ 6755 w 7472381"/>
              <a:gd name="connsiteY74" fmla="*/ 467915 h 6886575"/>
              <a:gd name="connsiteX75" fmla="*/ 255490 w 7472381"/>
              <a:gd name="connsiteY75" fmla="*/ 464344 h 6886575"/>
              <a:gd name="connsiteX76" fmla="*/ 500673 w 7472381"/>
              <a:gd name="connsiteY76" fmla="*/ 535781 h 6886575"/>
              <a:gd name="connsiteX77" fmla="*/ 760069 w 7472381"/>
              <a:gd name="connsiteY77" fmla="*/ 525066 h 6886575"/>
              <a:gd name="connsiteX78" fmla="*/ 1005251 w 7472381"/>
              <a:gd name="connsiteY78" fmla="*/ 560785 h 6886575"/>
              <a:gd name="connsiteX79" fmla="*/ 1218453 w 7472381"/>
              <a:gd name="connsiteY79" fmla="*/ 560785 h 6886575"/>
              <a:gd name="connsiteX80" fmla="*/ 1019464 w 7472381"/>
              <a:gd name="connsiteY80" fmla="*/ 507206 h 6886575"/>
              <a:gd name="connsiteX81" fmla="*/ 944844 w 7472381"/>
              <a:gd name="connsiteY81" fmla="*/ 417909 h 6886575"/>
              <a:gd name="connsiteX82" fmla="*/ 969717 w 7472381"/>
              <a:gd name="connsiteY82" fmla="*/ 335757 h 6886575"/>
              <a:gd name="connsiteX83" fmla="*/ 1051445 w 7472381"/>
              <a:gd name="connsiteY83" fmla="*/ 360759 h 6886575"/>
              <a:gd name="connsiteX84" fmla="*/ 1147386 w 7472381"/>
              <a:gd name="connsiteY84" fmla="*/ 453629 h 6886575"/>
              <a:gd name="connsiteX85" fmla="*/ 1168706 w 7472381"/>
              <a:gd name="connsiteY85" fmla="*/ 396478 h 6886575"/>
              <a:gd name="connsiteX86" fmla="*/ 1225560 w 7472381"/>
              <a:gd name="connsiteY86" fmla="*/ 353615 h 6886575"/>
              <a:gd name="connsiteX87" fmla="*/ 1552469 w 7472381"/>
              <a:gd name="connsiteY87" fmla="*/ 375047 h 6886575"/>
              <a:gd name="connsiteX88" fmla="*/ 1335714 w 7472381"/>
              <a:gd name="connsiteY88" fmla="*/ 192881 h 6886575"/>
              <a:gd name="connsiteX89" fmla="*/ 1197133 w 7472381"/>
              <a:gd name="connsiteY89" fmla="*/ 164306 h 6886575"/>
              <a:gd name="connsiteX90" fmla="*/ 1165153 w 7472381"/>
              <a:gd name="connsiteY90" fmla="*/ 89297 h 6886575"/>
              <a:gd name="connsiteX91" fmla="*/ 1229113 w 7472381"/>
              <a:gd name="connsiteY91" fmla="*/ 71437 h 6886575"/>
              <a:gd name="connsiteX92" fmla="*/ 1548916 w 7472381"/>
              <a:gd name="connsiteY92" fmla="*/ 135731 h 6886575"/>
              <a:gd name="connsiteX93" fmla="*/ 1602217 w 7472381"/>
              <a:gd name="connsiteY93" fmla="*/ 110728 h 6886575"/>
              <a:gd name="connsiteX94" fmla="*/ 1232666 w 7472381"/>
              <a:gd name="connsiteY94" fmla="*/ 0 h 68865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Lst>
            <a:rect l="l" t="t" r="r" b="b"/>
            <a:pathLst>
              <a:path w="7472381" h="6886575">
                <a:moveTo>
                  <a:pt x="1232666" y="0"/>
                </a:moveTo>
                <a:lnTo>
                  <a:pt x="7472381" y="0"/>
                </a:lnTo>
                <a:lnTo>
                  <a:pt x="7472381" y="814388"/>
                </a:lnTo>
                <a:lnTo>
                  <a:pt x="7472381" y="6411516"/>
                </a:lnTo>
                <a:lnTo>
                  <a:pt x="7472381" y="6886575"/>
                </a:lnTo>
                <a:lnTo>
                  <a:pt x="6992676" y="6886575"/>
                </a:lnTo>
                <a:lnTo>
                  <a:pt x="1946893" y="6886575"/>
                </a:lnTo>
                <a:cubicBezTo>
                  <a:pt x="1801205" y="6815137"/>
                  <a:pt x="1662624" y="6729412"/>
                  <a:pt x="1506276" y="6686550"/>
                </a:cubicBezTo>
                <a:cubicBezTo>
                  <a:pt x="1399675" y="6657975"/>
                  <a:pt x="1296627" y="6607969"/>
                  <a:pt x="1314394" y="6457949"/>
                </a:cubicBezTo>
                <a:cubicBezTo>
                  <a:pt x="1317947" y="6415087"/>
                  <a:pt x="1289520" y="6382941"/>
                  <a:pt x="1246880" y="6393656"/>
                </a:cubicBezTo>
                <a:cubicBezTo>
                  <a:pt x="1165153" y="6415087"/>
                  <a:pt x="1126065" y="6354365"/>
                  <a:pt x="1079872" y="6307931"/>
                </a:cubicBezTo>
                <a:cubicBezTo>
                  <a:pt x="998144" y="6225779"/>
                  <a:pt x="919970" y="6140052"/>
                  <a:pt x="788495" y="6125765"/>
                </a:cubicBezTo>
                <a:cubicBezTo>
                  <a:pt x="813369" y="6061471"/>
                  <a:pt x="856009" y="6068615"/>
                  <a:pt x="895097" y="6082903"/>
                </a:cubicBezTo>
                <a:cubicBezTo>
                  <a:pt x="998144" y="6118622"/>
                  <a:pt x="1101192" y="6157912"/>
                  <a:pt x="1204239" y="6193631"/>
                </a:cubicBezTo>
                <a:cubicBezTo>
                  <a:pt x="1271754" y="6215062"/>
                  <a:pt x="1339267" y="6247209"/>
                  <a:pt x="1428102" y="6222206"/>
                </a:cubicBezTo>
                <a:cubicBezTo>
                  <a:pt x="1349928" y="6093619"/>
                  <a:pt x="1218453" y="6068615"/>
                  <a:pt x="1111852" y="6029325"/>
                </a:cubicBezTo>
                <a:cubicBezTo>
                  <a:pt x="980377" y="5979319"/>
                  <a:pt x="902203" y="5886450"/>
                  <a:pt x="806262" y="5779294"/>
                </a:cubicBezTo>
                <a:cubicBezTo>
                  <a:pt x="902203" y="5750719"/>
                  <a:pt x="962610" y="5829300"/>
                  <a:pt x="1040785" y="5825728"/>
                </a:cubicBezTo>
                <a:cubicBezTo>
                  <a:pt x="1044338" y="5815012"/>
                  <a:pt x="1051445" y="5793581"/>
                  <a:pt x="1051445" y="5793581"/>
                </a:cubicBezTo>
                <a:cubicBezTo>
                  <a:pt x="923523" y="5736431"/>
                  <a:pt x="866670" y="5629275"/>
                  <a:pt x="845349" y="5497115"/>
                </a:cubicBezTo>
                <a:cubicBezTo>
                  <a:pt x="838243" y="5429250"/>
                  <a:pt x="792049" y="5407819"/>
                  <a:pt x="745855" y="5375672"/>
                </a:cubicBezTo>
                <a:cubicBezTo>
                  <a:pt x="589507" y="5264943"/>
                  <a:pt x="422499" y="5164931"/>
                  <a:pt x="291024" y="5014913"/>
                </a:cubicBezTo>
                <a:cubicBezTo>
                  <a:pt x="443819" y="5032771"/>
                  <a:pt x="564633" y="5132784"/>
                  <a:pt x="724535" y="5175647"/>
                </a:cubicBezTo>
                <a:cubicBezTo>
                  <a:pt x="596614" y="5011340"/>
                  <a:pt x="429605" y="4925615"/>
                  <a:pt x="276811" y="4825603"/>
                </a:cubicBezTo>
                <a:cubicBezTo>
                  <a:pt x="205743" y="4779169"/>
                  <a:pt x="141783" y="4722018"/>
                  <a:pt x="60055" y="4697016"/>
                </a:cubicBezTo>
                <a:cubicBezTo>
                  <a:pt x="31628" y="4689872"/>
                  <a:pt x="-18119" y="4672013"/>
                  <a:pt x="6755" y="4622006"/>
                </a:cubicBezTo>
                <a:cubicBezTo>
                  <a:pt x="28075" y="4579144"/>
                  <a:pt x="67162" y="4593432"/>
                  <a:pt x="102696" y="4604146"/>
                </a:cubicBezTo>
                <a:cubicBezTo>
                  <a:pt x="187976" y="4632722"/>
                  <a:pt x="280364" y="4632722"/>
                  <a:pt x="397625" y="4632722"/>
                </a:cubicBezTo>
                <a:cubicBezTo>
                  <a:pt x="298131" y="4496990"/>
                  <a:pt x="116909" y="4539853"/>
                  <a:pt x="31628" y="4396978"/>
                </a:cubicBezTo>
                <a:cubicBezTo>
                  <a:pt x="138229" y="4371976"/>
                  <a:pt x="219957" y="4421982"/>
                  <a:pt x="305237" y="4432697"/>
                </a:cubicBezTo>
                <a:cubicBezTo>
                  <a:pt x="383412" y="4443413"/>
                  <a:pt x="401178" y="4418409"/>
                  <a:pt x="383412" y="4339828"/>
                </a:cubicBezTo>
                <a:cubicBezTo>
                  <a:pt x="354985" y="4218385"/>
                  <a:pt x="397625" y="4157662"/>
                  <a:pt x="511333" y="4189810"/>
                </a:cubicBezTo>
                <a:cubicBezTo>
                  <a:pt x="617934" y="4221956"/>
                  <a:pt x="628594" y="4175522"/>
                  <a:pt x="600167" y="4107656"/>
                </a:cubicBezTo>
                <a:cubicBezTo>
                  <a:pt x="557527" y="4007644"/>
                  <a:pt x="603720" y="3929063"/>
                  <a:pt x="635701" y="3843337"/>
                </a:cubicBezTo>
                <a:cubicBezTo>
                  <a:pt x="685448" y="3714750"/>
                  <a:pt x="664128" y="3650456"/>
                  <a:pt x="561080" y="3554015"/>
                </a:cubicBezTo>
                <a:cubicBezTo>
                  <a:pt x="500673" y="3500438"/>
                  <a:pt x="440265" y="3454003"/>
                  <a:pt x="354985" y="3407569"/>
                </a:cubicBezTo>
                <a:cubicBezTo>
                  <a:pt x="550420" y="3382565"/>
                  <a:pt x="347878" y="3296841"/>
                  <a:pt x="415392" y="3243263"/>
                </a:cubicBezTo>
                <a:cubicBezTo>
                  <a:pt x="553973" y="3221831"/>
                  <a:pt x="664128" y="3393282"/>
                  <a:pt x="852456" y="3343275"/>
                </a:cubicBezTo>
                <a:cubicBezTo>
                  <a:pt x="625041" y="3196828"/>
                  <a:pt x="369198" y="3150393"/>
                  <a:pt x="202190" y="2953940"/>
                </a:cubicBezTo>
                <a:cubicBezTo>
                  <a:pt x="241277" y="2911078"/>
                  <a:pt x="280364" y="2953940"/>
                  <a:pt x="312344" y="2936081"/>
                </a:cubicBezTo>
                <a:cubicBezTo>
                  <a:pt x="312344" y="2925365"/>
                  <a:pt x="685448" y="2993232"/>
                  <a:pt x="706768" y="2714625"/>
                </a:cubicBezTo>
                <a:cubicBezTo>
                  <a:pt x="713875" y="2714625"/>
                  <a:pt x="720982" y="2714625"/>
                  <a:pt x="728088" y="2703909"/>
                </a:cubicBezTo>
                <a:cubicBezTo>
                  <a:pt x="767175" y="2664619"/>
                  <a:pt x="731642" y="2571750"/>
                  <a:pt x="795602" y="2564606"/>
                </a:cubicBezTo>
                <a:cubicBezTo>
                  <a:pt x="866670" y="2557462"/>
                  <a:pt x="934184" y="2525315"/>
                  <a:pt x="1008804" y="2543175"/>
                </a:cubicBezTo>
                <a:cubicBezTo>
                  <a:pt x="1065658" y="2557462"/>
                  <a:pt x="1126065" y="2575322"/>
                  <a:pt x="1186473" y="2575322"/>
                </a:cubicBezTo>
                <a:cubicBezTo>
                  <a:pt x="1250433" y="2575322"/>
                  <a:pt x="1339267" y="2696766"/>
                  <a:pt x="1378355" y="2536031"/>
                </a:cubicBezTo>
                <a:cubicBezTo>
                  <a:pt x="1378355" y="2528888"/>
                  <a:pt x="1488509" y="2546747"/>
                  <a:pt x="1548916" y="2553891"/>
                </a:cubicBezTo>
                <a:cubicBezTo>
                  <a:pt x="1598663" y="2561035"/>
                  <a:pt x="1659071" y="2593181"/>
                  <a:pt x="1694604" y="2528888"/>
                </a:cubicBezTo>
                <a:cubicBezTo>
                  <a:pt x="1712371" y="2489596"/>
                  <a:pt x="1627090" y="2418159"/>
                  <a:pt x="1552469" y="2411015"/>
                </a:cubicBezTo>
                <a:cubicBezTo>
                  <a:pt x="1484956" y="2403872"/>
                  <a:pt x="1417442" y="2396728"/>
                  <a:pt x="1353481" y="2411015"/>
                </a:cubicBezTo>
                <a:cubicBezTo>
                  <a:pt x="1275307" y="2428875"/>
                  <a:pt x="1232666" y="2400300"/>
                  <a:pt x="1211346" y="2336007"/>
                </a:cubicBezTo>
                <a:cubicBezTo>
                  <a:pt x="1186473" y="2268141"/>
                  <a:pt x="1140279" y="2232422"/>
                  <a:pt x="1076318" y="2200275"/>
                </a:cubicBezTo>
                <a:cubicBezTo>
                  <a:pt x="919970" y="2121694"/>
                  <a:pt x="770729" y="2028825"/>
                  <a:pt x="600167" y="1982390"/>
                </a:cubicBezTo>
                <a:cubicBezTo>
                  <a:pt x="568187" y="1975246"/>
                  <a:pt x="529100" y="1960959"/>
                  <a:pt x="514886" y="1900238"/>
                </a:cubicBezTo>
                <a:cubicBezTo>
                  <a:pt x="976824" y="1993106"/>
                  <a:pt x="1396121" y="2232422"/>
                  <a:pt x="1872273" y="2218135"/>
                </a:cubicBezTo>
                <a:cubicBezTo>
                  <a:pt x="1744351" y="2143125"/>
                  <a:pt x="1591557" y="2139554"/>
                  <a:pt x="1452975" y="2085975"/>
                </a:cubicBezTo>
                <a:cubicBezTo>
                  <a:pt x="1552469" y="2046685"/>
                  <a:pt x="1644857" y="2089547"/>
                  <a:pt x="1737245" y="2110978"/>
                </a:cubicBezTo>
                <a:cubicBezTo>
                  <a:pt x="1815419" y="2128837"/>
                  <a:pt x="1886486" y="2132410"/>
                  <a:pt x="1893593" y="2021681"/>
                </a:cubicBezTo>
                <a:cubicBezTo>
                  <a:pt x="1893593" y="2010965"/>
                  <a:pt x="1893593" y="2003821"/>
                  <a:pt x="1893593" y="1993106"/>
                </a:cubicBezTo>
                <a:cubicBezTo>
                  <a:pt x="1865166" y="1946672"/>
                  <a:pt x="1826079" y="1925240"/>
                  <a:pt x="1776332" y="1910953"/>
                </a:cubicBezTo>
                <a:cubicBezTo>
                  <a:pt x="1747905" y="1903809"/>
                  <a:pt x="1708818" y="1889522"/>
                  <a:pt x="1708818" y="1857375"/>
                </a:cubicBezTo>
                <a:cubicBezTo>
                  <a:pt x="1712371" y="1735931"/>
                  <a:pt x="1616430" y="1700212"/>
                  <a:pt x="1524043" y="1664493"/>
                </a:cubicBezTo>
                <a:cubicBezTo>
                  <a:pt x="1573790" y="1603772"/>
                  <a:pt x="1616430" y="1646635"/>
                  <a:pt x="1655517" y="1643062"/>
                </a:cubicBezTo>
                <a:cubicBezTo>
                  <a:pt x="1680391" y="1639491"/>
                  <a:pt x="1705264" y="1635919"/>
                  <a:pt x="1705264" y="1603772"/>
                </a:cubicBezTo>
                <a:cubicBezTo>
                  <a:pt x="1705264" y="1578769"/>
                  <a:pt x="1694604" y="1546622"/>
                  <a:pt x="1669731" y="1546622"/>
                </a:cubicBezTo>
                <a:cubicBezTo>
                  <a:pt x="1513383" y="1543050"/>
                  <a:pt x="1424548" y="1371600"/>
                  <a:pt x="1261093" y="1371600"/>
                </a:cubicBezTo>
                <a:cubicBezTo>
                  <a:pt x="1161599" y="1371600"/>
                  <a:pt x="1310841" y="1275159"/>
                  <a:pt x="1229113" y="1235869"/>
                </a:cubicBezTo>
                <a:cubicBezTo>
                  <a:pt x="1211346" y="1225153"/>
                  <a:pt x="1278860" y="1210866"/>
                  <a:pt x="1307287" y="1214437"/>
                </a:cubicBezTo>
                <a:cubicBezTo>
                  <a:pt x="1335714" y="1218009"/>
                  <a:pt x="1360588" y="1243013"/>
                  <a:pt x="1396121" y="1225153"/>
                </a:cubicBezTo>
                <a:cubicBezTo>
                  <a:pt x="1413888" y="1160860"/>
                  <a:pt x="1367694" y="1135856"/>
                  <a:pt x="1325054" y="1117997"/>
                </a:cubicBezTo>
                <a:cubicBezTo>
                  <a:pt x="1232666" y="1075135"/>
                  <a:pt x="1140279" y="1025129"/>
                  <a:pt x="1037231" y="1010841"/>
                </a:cubicBezTo>
                <a:cubicBezTo>
                  <a:pt x="1001698" y="1007269"/>
                  <a:pt x="980377" y="989409"/>
                  <a:pt x="983931" y="953690"/>
                </a:cubicBezTo>
                <a:cubicBezTo>
                  <a:pt x="991037" y="907256"/>
                  <a:pt x="1026571" y="921544"/>
                  <a:pt x="1054998" y="925115"/>
                </a:cubicBezTo>
                <a:cubicBezTo>
                  <a:pt x="1072765" y="928688"/>
                  <a:pt x="1090532" y="939403"/>
                  <a:pt x="1108299" y="914400"/>
                </a:cubicBezTo>
                <a:cubicBezTo>
                  <a:pt x="692555" y="660797"/>
                  <a:pt x="472246" y="675085"/>
                  <a:pt x="6755" y="467915"/>
                </a:cubicBezTo>
                <a:cubicBezTo>
                  <a:pt x="109802" y="428625"/>
                  <a:pt x="184423" y="457200"/>
                  <a:pt x="255490" y="464344"/>
                </a:cubicBezTo>
                <a:cubicBezTo>
                  <a:pt x="433159" y="482203"/>
                  <a:pt x="323004" y="514350"/>
                  <a:pt x="500673" y="535781"/>
                </a:cubicBezTo>
                <a:cubicBezTo>
                  <a:pt x="585954" y="546497"/>
                  <a:pt x="664128" y="582216"/>
                  <a:pt x="760069" y="525066"/>
                </a:cubicBezTo>
                <a:cubicBezTo>
                  <a:pt x="824029" y="485775"/>
                  <a:pt x="927077" y="528637"/>
                  <a:pt x="1005251" y="560785"/>
                </a:cubicBezTo>
                <a:cubicBezTo>
                  <a:pt x="1069212" y="589360"/>
                  <a:pt x="1133172" y="596503"/>
                  <a:pt x="1218453" y="560785"/>
                </a:cubicBezTo>
                <a:cubicBezTo>
                  <a:pt x="1140279" y="539354"/>
                  <a:pt x="1079872" y="521494"/>
                  <a:pt x="1019464" y="507206"/>
                </a:cubicBezTo>
                <a:cubicBezTo>
                  <a:pt x="969717" y="496491"/>
                  <a:pt x="941290" y="471488"/>
                  <a:pt x="944844" y="417909"/>
                </a:cubicBezTo>
                <a:cubicBezTo>
                  <a:pt x="944844" y="389334"/>
                  <a:pt x="934184" y="350044"/>
                  <a:pt x="969717" y="335757"/>
                </a:cubicBezTo>
                <a:cubicBezTo>
                  <a:pt x="998144" y="321469"/>
                  <a:pt x="1037231" y="335757"/>
                  <a:pt x="1051445" y="360759"/>
                </a:cubicBezTo>
                <a:cubicBezTo>
                  <a:pt x="1069212" y="407194"/>
                  <a:pt x="1086978" y="450056"/>
                  <a:pt x="1147386" y="453629"/>
                </a:cubicBezTo>
                <a:cubicBezTo>
                  <a:pt x="1229113" y="460771"/>
                  <a:pt x="1182919" y="432197"/>
                  <a:pt x="1168706" y="396478"/>
                </a:cubicBezTo>
                <a:cubicBezTo>
                  <a:pt x="1154492" y="357188"/>
                  <a:pt x="1197133" y="346472"/>
                  <a:pt x="1225560" y="353615"/>
                </a:cubicBezTo>
                <a:cubicBezTo>
                  <a:pt x="1332161" y="385763"/>
                  <a:pt x="1442315" y="328613"/>
                  <a:pt x="1552469" y="375047"/>
                </a:cubicBezTo>
                <a:cubicBezTo>
                  <a:pt x="1524043" y="260747"/>
                  <a:pt x="1463635" y="210741"/>
                  <a:pt x="1335714" y="192881"/>
                </a:cubicBezTo>
                <a:cubicBezTo>
                  <a:pt x="1289520" y="189310"/>
                  <a:pt x="1239773" y="196453"/>
                  <a:pt x="1197133" y="164306"/>
                </a:cubicBezTo>
                <a:cubicBezTo>
                  <a:pt x="1172259" y="146447"/>
                  <a:pt x="1147386" y="125016"/>
                  <a:pt x="1165153" y="89297"/>
                </a:cubicBezTo>
                <a:cubicBezTo>
                  <a:pt x="1175813" y="64294"/>
                  <a:pt x="1204239" y="64294"/>
                  <a:pt x="1229113" y="71437"/>
                </a:cubicBezTo>
                <a:cubicBezTo>
                  <a:pt x="1332161" y="110728"/>
                  <a:pt x="1442315" y="121444"/>
                  <a:pt x="1548916" y="135731"/>
                </a:cubicBezTo>
                <a:cubicBezTo>
                  <a:pt x="1566683" y="139303"/>
                  <a:pt x="1584450" y="146447"/>
                  <a:pt x="1602217" y="110728"/>
                </a:cubicBezTo>
                <a:cubicBezTo>
                  <a:pt x="1477849" y="78581"/>
                  <a:pt x="1357034" y="35719"/>
                  <a:pt x="1232666" y="0"/>
                </a:cubicBezTo>
                <a:close/>
              </a:path>
            </a:pathLst>
          </a:custGeom>
          <a:solidFill>
            <a:schemeClr val="accent1">
              <a:alpha val="20000"/>
            </a:schemeClr>
          </a:solidFill>
          <a:ln w="32707" cap="flat">
            <a:noFill/>
            <a:prstDash val="solid"/>
            <a:miter/>
          </a:ln>
        </p:spPr>
        <p:txBody>
          <a:bodyPr rtlCol="0" anchor="ctr"/>
          <a:lstStyle/>
          <a:p>
            <a:endParaRPr lang="en-US" dirty="0">
              <a:solidFill>
                <a:schemeClr val="tx1"/>
              </a:solidFill>
            </a:endParaRPr>
          </a:p>
        </p:txBody>
      </p:sp>
      <p:sp>
        <p:nvSpPr>
          <p:cNvPr id="2" name="Title 1">
            <a:extLst>
              <a:ext uri="{FF2B5EF4-FFF2-40B4-BE49-F238E27FC236}">
                <a16:creationId xmlns:a16="http://schemas.microsoft.com/office/drawing/2014/main" id="{146AD042-DE90-4088-8A07-B9A64C2CE03E}"/>
              </a:ext>
            </a:extLst>
          </p:cNvPr>
          <p:cNvSpPr>
            <a:spLocks noGrp="1"/>
          </p:cNvSpPr>
          <p:nvPr>
            <p:ph type="title"/>
          </p:nvPr>
        </p:nvSpPr>
        <p:spPr>
          <a:xfrm>
            <a:off x="839788" y="640080"/>
            <a:ext cx="3886200" cy="2953512"/>
          </a:xfrm>
        </p:spPr>
        <p:txBody>
          <a:bodyPr anchor="b"/>
          <a:lstStyle>
            <a:lvl1pPr>
              <a:defRPr sz="3200"/>
            </a:lvl1p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BF2FFC98-62A0-445A-BEDA-785BE925A1D8}"/>
              </a:ext>
            </a:extLst>
          </p:cNvPr>
          <p:cNvSpPr>
            <a:spLocks noGrp="1"/>
          </p:cNvSpPr>
          <p:nvPr>
            <p:ph idx="1"/>
          </p:nvPr>
        </p:nvSpPr>
        <p:spPr>
          <a:xfrm>
            <a:off x="7059168" y="640080"/>
            <a:ext cx="4489704" cy="5596128"/>
          </a:xfrm>
        </p:spPr>
        <p:txBody>
          <a:bodyPr anchor="ct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a:extLst>
              <a:ext uri="{FF2B5EF4-FFF2-40B4-BE49-F238E27FC236}">
                <a16:creationId xmlns:a16="http://schemas.microsoft.com/office/drawing/2014/main" id="{DB4D7827-8489-4EE4-88EE-16685FE6DE8A}"/>
              </a:ext>
            </a:extLst>
          </p:cNvPr>
          <p:cNvSpPr>
            <a:spLocks noGrp="1"/>
          </p:cNvSpPr>
          <p:nvPr>
            <p:ph type="body" sz="half" idx="2"/>
          </p:nvPr>
        </p:nvSpPr>
        <p:spPr>
          <a:xfrm>
            <a:off x="839788" y="3776472"/>
            <a:ext cx="3886200" cy="2468880"/>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C33534F-EA91-4A50-B0F6-10D689E458EF}"/>
              </a:ext>
            </a:extLst>
          </p:cNvPr>
          <p:cNvSpPr>
            <a:spLocks noGrp="1"/>
          </p:cNvSpPr>
          <p:nvPr>
            <p:ph type="dt" sz="half" idx="10"/>
          </p:nvPr>
        </p:nvSpPr>
        <p:spPr/>
        <p:txBody>
          <a:bodyPr/>
          <a:lstStyle/>
          <a:p>
            <a:fld id="{3C04E684-10F4-4CC3-A0B9-F03AA7BE37CF}" type="datetimeFigureOut">
              <a:rPr lang="en-US" smtClean="0"/>
              <a:t>5/3/26</a:t>
            </a:fld>
            <a:endParaRPr lang="en-US" dirty="0"/>
          </a:p>
        </p:txBody>
      </p:sp>
      <p:sp>
        <p:nvSpPr>
          <p:cNvPr id="6" name="Footer Placeholder 5">
            <a:extLst>
              <a:ext uri="{FF2B5EF4-FFF2-40B4-BE49-F238E27FC236}">
                <a16:creationId xmlns:a16="http://schemas.microsoft.com/office/drawing/2014/main" id="{6C20F3F7-8B4B-4015-AA9C-109D05B2F146}"/>
              </a:ext>
            </a:extLst>
          </p:cNvPr>
          <p:cNvSpPr>
            <a:spLocks noGrp="1"/>
          </p:cNvSpPr>
          <p:nvPr>
            <p:ph type="ftr" sz="quarter" idx="11"/>
          </p:nvPr>
        </p:nvSpPr>
        <p:spPr/>
        <p:txBody>
          <a:bodyPr/>
          <a:lstStyle>
            <a:lvl1pPr algn="l">
              <a:defRPr/>
            </a:lvl1pPr>
          </a:lstStyle>
          <a:p>
            <a:endParaRPr lang="en-US" dirty="0"/>
          </a:p>
        </p:txBody>
      </p:sp>
      <p:sp>
        <p:nvSpPr>
          <p:cNvPr id="7" name="Slide Number Placeholder 6">
            <a:extLst>
              <a:ext uri="{FF2B5EF4-FFF2-40B4-BE49-F238E27FC236}">
                <a16:creationId xmlns:a16="http://schemas.microsoft.com/office/drawing/2014/main" id="{910B6EE2-78A1-4D01-87BE-A1487FBD271F}"/>
              </a:ext>
            </a:extLst>
          </p:cNvPr>
          <p:cNvSpPr>
            <a:spLocks noGrp="1"/>
          </p:cNvSpPr>
          <p:nvPr>
            <p:ph type="sldNum" sz="quarter" idx="12"/>
          </p:nvPr>
        </p:nvSpPr>
        <p:spPr/>
        <p:txBody>
          <a:bodyPr/>
          <a:lstStyle/>
          <a:p>
            <a:fld id="{51845F5A-061D-4825-9AE9-D7794091C6CF}" type="slidenum">
              <a:rPr lang="en-US" smtClean="0"/>
              <a:t>‹#›</a:t>
            </a:fld>
            <a:endParaRPr lang="en-US" dirty="0"/>
          </a:p>
        </p:txBody>
      </p:sp>
    </p:spTree>
    <p:extLst>
      <p:ext uri="{BB962C8B-B14F-4D97-AF65-F5344CB8AC3E}">
        <p14:creationId xmlns:p14="http://schemas.microsoft.com/office/powerpoint/2010/main" val="42076981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8615C6B-1C98-4B1C-AB4B-1E1898E593B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2E8DFF97-B7FD-47F9-BC7F-DD4B4C5EA2F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A1831D22-079E-43E3-86A4-BA12DB888C7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C04E684-10F4-4CC3-A0B9-F03AA7BE37CF}" type="datetimeFigureOut">
              <a:rPr lang="en-US" smtClean="0"/>
              <a:t>5/3/26</a:t>
            </a:fld>
            <a:endParaRPr lang="en-US" dirty="0"/>
          </a:p>
        </p:txBody>
      </p:sp>
      <p:sp>
        <p:nvSpPr>
          <p:cNvPr id="5" name="Footer Placeholder 4">
            <a:extLst>
              <a:ext uri="{FF2B5EF4-FFF2-40B4-BE49-F238E27FC236}">
                <a16:creationId xmlns:a16="http://schemas.microsoft.com/office/drawing/2014/main" id="{A14C30A2-140B-4A5D-BEEC-C1314AF1F3F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1B71BA8F-7826-496D-91F8-B3ECDF34DA7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1845F5A-061D-4825-9AE9-D7794091C6CF}" type="slidenum">
              <a:rPr lang="en-US" smtClean="0"/>
              <a:t>‹#›</a:t>
            </a:fld>
            <a:endParaRPr lang="en-US" dirty="0"/>
          </a:p>
        </p:txBody>
      </p:sp>
    </p:spTree>
    <p:extLst>
      <p:ext uri="{BB962C8B-B14F-4D97-AF65-F5344CB8AC3E}">
        <p14:creationId xmlns:p14="http://schemas.microsoft.com/office/powerpoint/2010/main" val="2122115948"/>
      </p:ext>
    </p:extLst>
  </p:cSld>
  <p:clrMap bg1="lt1" tx1="dk1" bg2="lt2" tx2="dk2" accent1="accent1" accent2="accent2" accent3="accent3" accent4="accent4" accent5="accent5" accent6="accent6" hlink="hlink" folHlink="folHlink"/>
  <p:sldLayoutIdLst>
    <p:sldLayoutId id="2147483748" r:id="rId1"/>
    <p:sldLayoutId id="2147483749" r:id="rId2"/>
    <p:sldLayoutId id="2147483750" r:id="rId3"/>
    <p:sldLayoutId id="2147483751" r:id="rId4"/>
    <p:sldLayoutId id="2147483740" r:id="rId5"/>
    <p:sldLayoutId id="2147483741" r:id="rId6"/>
    <p:sldLayoutId id="2147483747" r:id="rId7"/>
    <p:sldLayoutId id="2147483742" r:id="rId8"/>
    <p:sldLayoutId id="2147483743" r:id="rId9"/>
    <p:sldLayoutId id="2147483744" r:id="rId10"/>
    <p:sldLayoutId id="2147483745" r:id="rId11"/>
    <p:sldLayoutId id="2147483746" r:id="rId12"/>
  </p:sldLayoutIdLst>
  <p:txStyles>
    <p:titleStyle>
      <a:lvl1pPr algn="l" defTabSz="914400" rtl="0" eaLnBrk="1" latinLnBrk="0" hangingPunct="1">
        <a:lnSpc>
          <a:spcPct val="90000"/>
        </a:lnSpc>
        <a:spcBef>
          <a:spcPct val="0"/>
        </a:spcBef>
        <a:buNone/>
        <a:defRPr sz="4400" i="1" kern="1200">
          <a:solidFill>
            <a:schemeClr val="tx1"/>
          </a:solidFill>
          <a:latin typeface="+mj-lt"/>
          <a:ea typeface="+mj-ea"/>
          <a:cs typeface="+mj-cs"/>
        </a:defRPr>
      </a:lvl1pPr>
    </p:titleStyle>
    <p:bodyStyle>
      <a:lvl1pPr marL="228600" indent="-228600" algn="l" defTabSz="914400" rtl="0" eaLnBrk="1" latinLnBrk="0" hangingPunct="1">
        <a:lnSpc>
          <a:spcPct val="10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10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10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10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10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1.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12.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8.xml"/><Relationship Id="rId7" Type="http://schemas.microsoft.com/office/2007/relationships/diagramDrawing" Target="../diagrams/drawing8.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diagramColors" Target="../diagrams/colors8.xml"/><Relationship Id="rId5" Type="http://schemas.openxmlformats.org/officeDocument/2006/relationships/diagramQuickStyle" Target="../diagrams/quickStyle8.xml"/><Relationship Id="rId4" Type="http://schemas.openxmlformats.org/officeDocument/2006/relationships/diagramLayout" Target="../diagrams/layout8.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9.xml"/><Relationship Id="rId7" Type="http://schemas.microsoft.com/office/2007/relationships/diagramDrawing" Target="../diagrams/drawing9.xml"/><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diagramColors" Target="../diagrams/colors9.xml"/><Relationship Id="rId5" Type="http://schemas.openxmlformats.org/officeDocument/2006/relationships/diagramQuickStyle" Target="../diagrams/quickStyle9.xml"/><Relationship Id="rId4" Type="http://schemas.openxmlformats.org/officeDocument/2006/relationships/diagramLayout" Target="../diagrams/layout9.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10.xml"/><Relationship Id="rId7" Type="http://schemas.microsoft.com/office/2007/relationships/diagramDrawing" Target="../diagrams/drawing10.xm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diagramColors" Target="../diagrams/colors10.xml"/><Relationship Id="rId5" Type="http://schemas.openxmlformats.org/officeDocument/2006/relationships/diagramQuickStyle" Target="../diagrams/quickStyle10.xml"/><Relationship Id="rId4" Type="http://schemas.openxmlformats.org/officeDocument/2006/relationships/diagramLayout" Target="../diagrams/layout10.xml"/></Relationships>
</file>

<file path=ppt/slides/_rels/slide16.xml.rels><?xml version="1.0" encoding="UTF-8" standalone="yes"?>
<Relationships xmlns="http://schemas.openxmlformats.org/package/2006/relationships"><Relationship Id="rId3" Type="http://schemas.openxmlformats.org/officeDocument/2006/relationships/diagramData" Target="../diagrams/data11.xml"/><Relationship Id="rId7" Type="http://schemas.microsoft.com/office/2007/relationships/diagramDrawing" Target="../diagrams/drawing11.xml"/><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diagramColors" Target="../diagrams/colors11.xml"/><Relationship Id="rId5" Type="http://schemas.openxmlformats.org/officeDocument/2006/relationships/diagramQuickStyle" Target="../diagrams/quickStyle11.xml"/><Relationship Id="rId4" Type="http://schemas.openxmlformats.org/officeDocument/2006/relationships/diagramLayout" Target="../diagrams/layout11.xml"/></Relationships>
</file>

<file path=ppt/slides/_rels/slide17.xml.rels><?xml version="1.0" encoding="UTF-8" standalone="yes"?>
<Relationships xmlns="http://schemas.openxmlformats.org/package/2006/relationships"><Relationship Id="rId3" Type="http://schemas.openxmlformats.org/officeDocument/2006/relationships/diagramData" Target="../diagrams/data12.xml"/><Relationship Id="rId7" Type="http://schemas.microsoft.com/office/2007/relationships/diagramDrawing" Target="../diagrams/drawing12.xml"/><Relationship Id="rId2" Type="http://schemas.openxmlformats.org/officeDocument/2006/relationships/notesSlide" Target="../notesSlides/notesSlide17.xml"/><Relationship Id="rId1" Type="http://schemas.openxmlformats.org/officeDocument/2006/relationships/slideLayout" Target="../slideLayouts/slideLayout2.xml"/><Relationship Id="rId6" Type="http://schemas.openxmlformats.org/officeDocument/2006/relationships/diagramColors" Target="../diagrams/colors12.xml"/><Relationship Id="rId5" Type="http://schemas.openxmlformats.org/officeDocument/2006/relationships/diagramQuickStyle" Target="../diagrams/quickStyle12.xml"/><Relationship Id="rId4" Type="http://schemas.openxmlformats.org/officeDocument/2006/relationships/diagramLayout" Target="../diagrams/layout12.xml"/></Relationships>
</file>

<file path=ppt/slides/_rels/slide18.xml.rels><?xml version="1.0" encoding="UTF-8" standalone="yes"?>
<Relationships xmlns="http://schemas.openxmlformats.org/package/2006/relationships"><Relationship Id="rId3" Type="http://schemas.openxmlformats.org/officeDocument/2006/relationships/diagramData" Target="../diagrams/data13.xml"/><Relationship Id="rId7" Type="http://schemas.microsoft.com/office/2007/relationships/diagramDrawing" Target="../diagrams/drawing13.xml"/><Relationship Id="rId2" Type="http://schemas.openxmlformats.org/officeDocument/2006/relationships/notesSlide" Target="../notesSlides/notesSlide18.xml"/><Relationship Id="rId1" Type="http://schemas.openxmlformats.org/officeDocument/2006/relationships/slideLayout" Target="../slideLayouts/slideLayout2.xml"/><Relationship Id="rId6" Type="http://schemas.openxmlformats.org/officeDocument/2006/relationships/diagramColors" Target="../diagrams/colors13.xml"/><Relationship Id="rId5" Type="http://schemas.openxmlformats.org/officeDocument/2006/relationships/diagramQuickStyle" Target="../diagrams/quickStyle13.xml"/><Relationship Id="rId4" Type="http://schemas.openxmlformats.org/officeDocument/2006/relationships/diagramLayout" Target="../diagrams/layout1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4.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6" name="Rectangle 15">
            <a:extLst>
              <a:ext uri="{FF2B5EF4-FFF2-40B4-BE49-F238E27FC236}">
                <a16:creationId xmlns:a16="http://schemas.microsoft.com/office/drawing/2014/main" id="{E2CFBC99-FB8F-41F7-A81D-A5288D688D7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4" name="Picture 3" descr="Abstract smoke background">
            <a:extLst>
              <a:ext uri="{FF2B5EF4-FFF2-40B4-BE49-F238E27FC236}">
                <a16:creationId xmlns:a16="http://schemas.microsoft.com/office/drawing/2014/main" id="{9B8D8D4D-36B3-D09B-A3C9-A0F3B8A831F2}"/>
              </a:ext>
            </a:extLst>
          </p:cNvPr>
          <p:cNvPicPr>
            <a:picLocks noChangeAspect="1"/>
          </p:cNvPicPr>
          <p:nvPr/>
        </p:nvPicPr>
        <p:blipFill>
          <a:blip r:embed="rId3"/>
          <a:srcRect t="6687" b="8727"/>
          <a:stretch/>
        </p:blipFill>
        <p:spPr>
          <a:xfrm>
            <a:off x="20" y="10"/>
            <a:ext cx="12191980" cy="6857990"/>
          </a:xfrm>
          <a:custGeom>
            <a:avLst/>
            <a:gdLst/>
            <a:ahLst/>
            <a:cxnLst/>
            <a:rect l="l" t="t" r="r" b="b"/>
            <a:pathLst>
              <a:path w="12192000" h="6858000">
                <a:moveTo>
                  <a:pt x="0" y="0"/>
                </a:moveTo>
                <a:lnTo>
                  <a:pt x="12192000" y="0"/>
                </a:lnTo>
                <a:lnTo>
                  <a:pt x="12192000" y="6858000"/>
                </a:lnTo>
                <a:lnTo>
                  <a:pt x="11560655" y="6858000"/>
                </a:lnTo>
                <a:lnTo>
                  <a:pt x="11572884" y="6759738"/>
                </a:lnTo>
                <a:cubicBezTo>
                  <a:pt x="11663744" y="6693104"/>
                  <a:pt x="11749315" y="6619456"/>
                  <a:pt x="11812292" y="6532282"/>
                </a:cubicBezTo>
                <a:cubicBezTo>
                  <a:pt x="11851232" y="6478675"/>
                  <a:pt x="11886807" y="6425068"/>
                  <a:pt x="11956995" y="6386992"/>
                </a:cubicBezTo>
                <a:cubicBezTo>
                  <a:pt x="11918054" y="6334888"/>
                  <a:pt x="11851232" y="6322863"/>
                  <a:pt x="11801234" y="6284788"/>
                </a:cubicBezTo>
                <a:cubicBezTo>
                  <a:pt x="11797390" y="6253224"/>
                  <a:pt x="11876711" y="6262743"/>
                  <a:pt x="11856520" y="6193604"/>
                </a:cubicBezTo>
                <a:cubicBezTo>
                  <a:pt x="11829119" y="6101419"/>
                  <a:pt x="11858923" y="5996209"/>
                  <a:pt x="11722875" y="5956630"/>
                </a:cubicBezTo>
                <a:cubicBezTo>
                  <a:pt x="11686819" y="5866950"/>
                  <a:pt x="11676724" y="5723664"/>
                  <a:pt x="11763258" y="5635988"/>
                </a:cubicBezTo>
                <a:cubicBezTo>
                  <a:pt x="11892094" y="5505226"/>
                  <a:pt x="11871424" y="5422059"/>
                  <a:pt x="11706050" y="5351418"/>
                </a:cubicBezTo>
                <a:cubicBezTo>
                  <a:pt x="11684896" y="5342400"/>
                  <a:pt x="11707491" y="4786287"/>
                  <a:pt x="11697876" y="4763241"/>
                </a:cubicBezTo>
                <a:cubicBezTo>
                  <a:pt x="11713260" y="4731677"/>
                  <a:pt x="11749315" y="4739192"/>
                  <a:pt x="11776236" y="4730675"/>
                </a:cubicBezTo>
                <a:cubicBezTo>
                  <a:pt x="11894018" y="4694603"/>
                  <a:pt x="11897864" y="4694603"/>
                  <a:pt x="11868540" y="4584884"/>
                </a:cubicBezTo>
                <a:cubicBezTo>
                  <a:pt x="11859884" y="4551817"/>
                  <a:pt x="11880076" y="4538289"/>
                  <a:pt x="11898825" y="4517749"/>
                </a:cubicBezTo>
                <a:cubicBezTo>
                  <a:pt x="11969013" y="4441095"/>
                  <a:pt x="11969494" y="4440094"/>
                  <a:pt x="11897864" y="4375464"/>
                </a:cubicBezTo>
                <a:cubicBezTo>
                  <a:pt x="11877192" y="4356928"/>
                  <a:pt x="11863252" y="4336887"/>
                  <a:pt x="11854116" y="4311838"/>
                </a:cubicBezTo>
                <a:cubicBezTo>
                  <a:pt x="11837290" y="4266245"/>
                  <a:pt x="11837771" y="4228169"/>
                  <a:pt x="11901709" y="4203620"/>
                </a:cubicBezTo>
                <a:cubicBezTo>
                  <a:pt x="11946418" y="4186086"/>
                  <a:pt x="11971897" y="4166044"/>
                  <a:pt x="11974782" y="4114442"/>
                </a:cubicBezTo>
                <a:cubicBezTo>
                  <a:pt x="11976706" y="4071355"/>
                  <a:pt x="11981993" y="4043299"/>
                  <a:pt x="11932476" y="4024762"/>
                </a:cubicBezTo>
                <a:cubicBezTo>
                  <a:pt x="11892576" y="4009732"/>
                  <a:pt x="11881038" y="3977668"/>
                  <a:pt x="11885365" y="3939592"/>
                </a:cubicBezTo>
                <a:cubicBezTo>
                  <a:pt x="11895460" y="3846405"/>
                  <a:pt x="11841137" y="3791796"/>
                  <a:pt x="11751719" y="3749211"/>
                </a:cubicBezTo>
                <a:cubicBezTo>
                  <a:pt x="11666628" y="3708629"/>
                  <a:pt x="11592115" y="3654019"/>
                  <a:pt x="11513754" y="3604420"/>
                </a:cubicBezTo>
                <a:cubicBezTo>
                  <a:pt x="11426740" y="3549310"/>
                  <a:pt x="11325786" y="3516243"/>
                  <a:pt x="11220504" y="3488188"/>
                </a:cubicBezTo>
                <a:cubicBezTo>
                  <a:pt x="11239734" y="3448108"/>
                  <a:pt x="11306076" y="3470653"/>
                  <a:pt x="11312805" y="3414541"/>
                </a:cubicBezTo>
                <a:cubicBezTo>
                  <a:pt x="11148394" y="3366945"/>
                  <a:pt x="10991193" y="3295301"/>
                  <a:pt x="10805146" y="3277767"/>
                </a:cubicBezTo>
                <a:cubicBezTo>
                  <a:pt x="10955618" y="3286784"/>
                  <a:pt x="11092147" y="3222154"/>
                  <a:pt x="11234926" y="3203117"/>
                </a:cubicBezTo>
                <a:cubicBezTo>
                  <a:pt x="11248386" y="3171554"/>
                  <a:pt x="11217140" y="3179569"/>
                  <a:pt x="11204640" y="3174060"/>
                </a:cubicBezTo>
                <a:cubicBezTo>
                  <a:pt x="11192140" y="3168047"/>
                  <a:pt x="11176757" y="3166042"/>
                  <a:pt x="11174834" y="3143498"/>
                </a:cubicBezTo>
                <a:cubicBezTo>
                  <a:pt x="11243580" y="3110932"/>
                  <a:pt x="11329632" y="3132475"/>
                  <a:pt x="11400780" y="3099410"/>
                </a:cubicBezTo>
                <a:cubicBezTo>
                  <a:pt x="11384916" y="3051314"/>
                  <a:pt x="11323382" y="3080371"/>
                  <a:pt x="11297902" y="3041793"/>
                </a:cubicBezTo>
                <a:cubicBezTo>
                  <a:pt x="11364246" y="3034780"/>
                  <a:pt x="11425779" y="3031774"/>
                  <a:pt x="11485870" y="3021253"/>
                </a:cubicBezTo>
                <a:cubicBezTo>
                  <a:pt x="11532984" y="3013236"/>
                  <a:pt x="11545964" y="2972154"/>
                  <a:pt x="11513754" y="2944098"/>
                </a:cubicBezTo>
                <a:cubicBezTo>
                  <a:pt x="11484909" y="2919049"/>
                  <a:pt x="11442604" y="2917044"/>
                  <a:pt x="11405107" y="2906523"/>
                </a:cubicBezTo>
                <a:cubicBezTo>
                  <a:pt x="11137817" y="2833377"/>
                  <a:pt x="10857066" y="2809829"/>
                  <a:pt x="10572950" y="2803317"/>
                </a:cubicBezTo>
                <a:cubicBezTo>
                  <a:pt x="10117210" y="2792795"/>
                  <a:pt x="9660028" y="2793297"/>
                  <a:pt x="9205250" y="2778767"/>
                </a:cubicBezTo>
                <a:cubicBezTo>
                  <a:pt x="8996489" y="2772379"/>
                  <a:pt x="8788540" y="2761765"/>
                  <a:pt x="8579578" y="2759181"/>
                </a:cubicBezTo>
                <a:cubicBezTo>
                  <a:pt x="8509922" y="2758320"/>
                  <a:pt x="8440155" y="2758352"/>
                  <a:pt x="8370208" y="2759730"/>
                </a:cubicBezTo>
                <a:cubicBezTo>
                  <a:pt x="8070708" y="2765742"/>
                  <a:pt x="7771690" y="2764238"/>
                  <a:pt x="7470748" y="2819849"/>
                </a:cubicBezTo>
                <a:cubicBezTo>
                  <a:pt x="7316911" y="2848407"/>
                  <a:pt x="7156825" y="2838887"/>
                  <a:pt x="7001547" y="2861432"/>
                </a:cubicBezTo>
                <a:cubicBezTo>
                  <a:pt x="6765024" y="2896002"/>
                  <a:pt x="6528501" y="2936583"/>
                  <a:pt x="6295343" y="2988688"/>
                </a:cubicBezTo>
                <a:cubicBezTo>
                  <a:pt x="6222271" y="3005220"/>
                  <a:pt x="6131892" y="3015241"/>
                  <a:pt x="6075166" y="3078367"/>
                </a:cubicBezTo>
                <a:cubicBezTo>
                  <a:pt x="5985266" y="3038288"/>
                  <a:pt x="5929502" y="3113938"/>
                  <a:pt x="5859314" y="3139490"/>
                </a:cubicBezTo>
                <a:cubicBezTo>
                  <a:pt x="5831912" y="3149510"/>
                  <a:pt x="5795857" y="3163538"/>
                  <a:pt x="5800183" y="3195101"/>
                </a:cubicBezTo>
                <a:cubicBezTo>
                  <a:pt x="5804030" y="3234680"/>
                  <a:pt x="5844410" y="3260231"/>
                  <a:pt x="5882870" y="3252215"/>
                </a:cubicBezTo>
                <a:cubicBezTo>
                  <a:pt x="6002574" y="3227164"/>
                  <a:pt x="6109777" y="3283277"/>
                  <a:pt x="6232848" y="3274760"/>
                </a:cubicBezTo>
                <a:cubicBezTo>
                  <a:pt x="6125643" y="3298808"/>
                  <a:pt x="6018918" y="3323358"/>
                  <a:pt x="5911715" y="3347407"/>
                </a:cubicBezTo>
                <a:cubicBezTo>
                  <a:pt x="6070839" y="3366444"/>
                  <a:pt x="6227559" y="3332376"/>
                  <a:pt x="6384279" y="3312836"/>
                </a:cubicBezTo>
                <a:cubicBezTo>
                  <a:pt x="6434757" y="3306824"/>
                  <a:pt x="6513117" y="3260732"/>
                  <a:pt x="6526097" y="3325362"/>
                </a:cubicBezTo>
                <a:cubicBezTo>
                  <a:pt x="6534750" y="3368448"/>
                  <a:pt x="6450622" y="3371454"/>
                  <a:pt x="6403028" y="3383478"/>
                </a:cubicBezTo>
                <a:cubicBezTo>
                  <a:pt x="6192945" y="3435081"/>
                  <a:pt x="5979497" y="3465141"/>
                  <a:pt x="5767013" y="3500713"/>
                </a:cubicBezTo>
                <a:cubicBezTo>
                  <a:pt x="5746822" y="3504220"/>
                  <a:pt x="5720381" y="3501214"/>
                  <a:pt x="5706920" y="3511233"/>
                </a:cubicBezTo>
                <a:cubicBezTo>
                  <a:pt x="5598272" y="3591895"/>
                  <a:pt x="5460782" y="3618449"/>
                  <a:pt x="5310793" y="3677066"/>
                </a:cubicBezTo>
                <a:cubicBezTo>
                  <a:pt x="5405498" y="3704622"/>
                  <a:pt x="5469435" y="3648007"/>
                  <a:pt x="5548276" y="3660533"/>
                </a:cubicBezTo>
                <a:cubicBezTo>
                  <a:pt x="5467993" y="3721154"/>
                  <a:pt x="5374730" y="3732677"/>
                  <a:pt x="5293005" y="3765743"/>
                </a:cubicBezTo>
                <a:cubicBezTo>
                  <a:pt x="5234355" y="3789291"/>
                  <a:pt x="5016580" y="3862938"/>
                  <a:pt x="4983410" y="3883981"/>
                </a:cubicBezTo>
                <a:cubicBezTo>
                  <a:pt x="4883416" y="3949110"/>
                  <a:pt x="4756501" y="3979672"/>
                  <a:pt x="4674775" y="4068850"/>
                </a:cubicBezTo>
                <a:cubicBezTo>
                  <a:pt x="4617087" y="4131477"/>
                  <a:pt x="4520939" y="4119952"/>
                  <a:pt x="4453155" y="4163539"/>
                </a:cubicBezTo>
                <a:cubicBezTo>
                  <a:pt x="4429119" y="4204622"/>
                  <a:pt x="4475751" y="4215143"/>
                  <a:pt x="4492095" y="4237188"/>
                </a:cubicBezTo>
                <a:cubicBezTo>
                  <a:pt x="4513728" y="4266746"/>
                  <a:pt x="4475269" y="4283280"/>
                  <a:pt x="4464213" y="4318851"/>
                </a:cubicBezTo>
                <a:cubicBezTo>
                  <a:pt x="4591608" y="4278771"/>
                  <a:pt x="4713234" y="4255223"/>
                  <a:pt x="4857456" y="4241696"/>
                </a:cubicBezTo>
                <a:cubicBezTo>
                  <a:pt x="4809862" y="4299311"/>
                  <a:pt x="4752174" y="4274261"/>
                  <a:pt x="4713234" y="4295303"/>
                </a:cubicBezTo>
                <a:cubicBezTo>
                  <a:pt x="4687756" y="4308830"/>
                  <a:pt x="4648816" y="4314843"/>
                  <a:pt x="4656026" y="4348410"/>
                </a:cubicBezTo>
                <a:cubicBezTo>
                  <a:pt x="4661795" y="4374963"/>
                  <a:pt x="4694486" y="4371456"/>
                  <a:pt x="4718523" y="4368951"/>
                </a:cubicBezTo>
                <a:cubicBezTo>
                  <a:pt x="4810825" y="4359433"/>
                  <a:pt x="4900722" y="4356425"/>
                  <a:pt x="4989178" y="4420054"/>
                </a:cubicBezTo>
                <a:cubicBezTo>
                  <a:pt x="4764193" y="4512739"/>
                  <a:pt x="4505557" y="4473661"/>
                  <a:pt x="4304127" y="4609933"/>
                </a:cubicBezTo>
                <a:cubicBezTo>
                  <a:pt x="4332491" y="4652018"/>
                  <a:pt x="4372871" y="4629473"/>
                  <a:pt x="4402677" y="4624463"/>
                </a:cubicBezTo>
                <a:cubicBezTo>
                  <a:pt x="4598338" y="4590394"/>
                  <a:pt x="5297331" y="4651016"/>
                  <a:pt x="5398287" y="4608430"/>
                </a:cubicBezTo>
                <a:cubicBezTo>
                  <a:pt x="5460301" y="4582379"/>
                  <a:pt x="5525682" y="4569853"/>
                  <a:pt x="5592504" y="4585886"/>
                </a:cubicBezTo>
                <a:cubicBezTo>
                  <a:pt x="5656923" y="4601416"/>
                  <a:pt x="5640578" y="4819353"/>
                  <a:pt x="5411266" y="4964142"/>
                </a:cubicBezTo>
                <a:cubicBezTo>
                  <a:pt x="5378575" y="4984684"/>
                  <a:pt x="5524721" y="5014244"/>
                  <a:pt x="5480493" y="5031277"/>
                </a:cubicBezTo>
                <a:cubicBezTo>
                  <a:pt x="5445880" y="5044804"/>
                  <a:pt x="5276179" y="5037289"/>
                  <a:pt x="5233393" y="5047810"/>
                </a:cubicBezTo>
                <a:cubicBezTo>
                  <a:pt x="5216567" y="5052318"/>
                  <a:pt x="4701216" y="5221157"/>
                  <a:pt x="4750251" y="5256728"/>
                </a:cubicBezTo>
                <a:cubicBezTo>
                  <a:pt x="4896877" y="5363441"/>
                  <a:pt x="5388190" y="5558833"/>
                  <a:pt x="4508440" y="5624965"/>
                </a:cubicBezTo>
                <a:cubicBezTo>
                  <a:pt x="4536323" y="5663542"/>
                  <a:pt x="4613241" y="5638994"/>
                  <a:pt x="4602665" y="5706629"/>
                </a:cubicBezTo>
                <a:cubicBezTo>
                  <a:pt x="4485845" y="5743202"/>
                  <a:pt x="4350758" y="5741198"/>
                  <a:pt x="4215189" y="5797811"/>
                </a:cubicBezTo>
                <a:cubicBezTo>
                  <a:pt x="4276245" y="5838893"/>
                  <a:pt x="4346432" y="5813844"/>
                  <a:pt x="4407966" y="5826870"/>
                </a:cubicBezTo>
                <a:cubicBezTo>
                  <a:pt x="4373353" y="5878473"/>
                  <a:pt x="4313741" y="5870457"/>
                  <a:pt x="4265186" y="5881478"/>
                </a:cubicBezTo>
                <a:cubicBezTo>
                  <a:pt x="4220479" y="5892001"/>
                  <a:pt x="4125774" y="5981680"/>
                  <a:pt x="4145964" y="5977170"/>
                </a:cubicBezTo>
                <a:cubicBezTo>
                  <a:pt x="4332971" y="5937091"/>
                  <a:pt x="4522862" y="5948113"/>
                  <a:pt x="4710350" y="5909035"/>
                </a:cubicBezTo>
                <a:cubicBezTo>
                  <a:pt x="4772366" y="5896009"/>
                  <a:pt x="4842554" y="5870958"/>
                  <a:pt x="4870916" y="5949616"/>
                </a:cubicBezTo>
                <a:cubicBezTo>
                  <a:pt x="4879571" y="5972663"/>
                  <a:pt x="4873320" y="5980177"/>
                  <a:pt x="4960333" y="5949115"/>
                </a:cubicBezTo>
                <a:cubicBezTo>
                  <a:pt x="4994466" y="5937091"/>
                  <a:pt x="5039656" y="5924065"/>
                  <a:pt x="5073788" y="5953623"/>
                </a:cubicBezTo>
                <a:cubicBezTo>
                  <a:pt x="5052154" y="5990698"/>
                  <a:pt x="5010331" y="5979675"/>
                  <a:pt x="4979084" y="5990197"/>
                </a:cubicBezTo>
                <a:cubicBezTo>
                  <a:pt x="4896397" y="6017250"/>
                  <a:pt x="5180513" y="6120457"/>
                  <a:pt x="5100228" y="6151519"/>
                </a:cubicBezTo>
                <a:cubicBezTo>
                  <a:pt x="4935817" y="6215148"/>
                  <a:pt x="4832938" y="6196611"/>
                  <a:pt x="4666602" y="6266250"/>
                </a:cubicBezTo>
                <a:cubicBezTo>
                  <a:pt x="4723331" y="6264746"/>
                  <a:pt x="4706024" y="6288795"/>
                  <a:pt x="4762750" y="6288795"/>
                </a:cubicBezTo>
                <a:cubicBezTo>
                  <a:pt x="4788229" y="6288795"/>
                  <a:pt x="4815151" y="6294807"/>
                  <a:pt x="4815151" y="6322363"/>
                </a:cubicBezTo>
                <a:cubicBezTo>
                  <a:pt x="4815151" y="6348414"/>
                  <a:pt x="4516613" y="6491199"/>
                  <a:pt x="4558918" y="6504727"/>
                </a:cubicBezTo>
                <a:cubicBezTo>
                  <a:pt x="4674295" y="6541299"/>
                  <a:pt x="4970431" y="6429075"/>
                  <a:pt x="4899280" y="6480679"/>
                </a:cubicBezTo>
                <a:cubicBezTo>
                  <a:pt x="4791114" y="6559337"/>
                  <a:pt x="4774769" y="6574868"/>
                  <a:pt x="4692563" y="6586391"/>
                </a:cubicBezTo>
                <a:cubicBezTo>
                  <a:pt x="4621894" y="6596411"/>
                  <a:pt x="4373353" y="6816352"/>
                  <a:pt x="4303645" y="6834888"/>
                </a:cubicBezTo>
                <a:cubicBezTo>
                  <a:pt x="4288262" y="6838896"/>
                  <a:pt x="4291687" y="6845065"/>
                  <a:pt x="4307829" y="6852361"/>
                </a:cubicBezTo>
                <a:lnTo>
                  <a:pt x="4323786" y="6858000"/>
                </a:lnTo>
                <a:lnTo>
                  <a:pt x="0" y="6858000"/>
                </a:lnTo>
                <a:close/>
              </a:path>
            </a:pathLst>
          </a:custGeom>
        </p:spPr>
      </p:pic>
      <p:sp>
        <p:nvSpPr>
          <p:cNvPr id="2" name="Title 1">
            <a:extLst>
              <a:ext uri="{FF2B5EF4-FFF2-40B4-BE49-F238E27FC236}">
                <a16:creationId xmlns:a16="http://schemas.microsoft.com/office/drawing/2014/main" id="{C5F51587-4799-0DAE-9D49-3BCD9C5F5B02}"/>
              </a:ext>
            </a:extLst>
          </p:cNvPr>
          <p:cNvSpPr>
            <a:spLocks noGrp="1"/>
          </p:cNvSpPr>
          <p:nvPr>
            <p:ph type="ctrTitle"/>
          </p:nvPr>
        </p:nvSpPr>
        <p:spPr>
          <a:xfrm>
            <a:off x="6095999" y="3834174"/>
            <a:ext cx="5257800" cy="1701570"/>
          </a:xfrm>
        </p:spPr>
        <p:txBody>
          <a:bodyPr anchor="b">
            <a:normAutofit/>
          </a:bodyPr>
          <a:lstStyle/>
          <a:p>
            <a:r>
              <a:rPr lang="en-US" sz="3700" dirty="0"/>
              <a:t>Perioperative Difficult Conversations</a:t>
            </a:r>
          </a:p>
        </p:txBody>
      </p:sp>
    </p:spTree>
    <p:extLst>
      <p:ext uri="{BB962C8B-B14F-4D97-AF65-F5344CB8AC3E}">
        <p14:creationId xmlns:p14="http://schemas.microsoft.com/office/powerpoint/2010/main" val="3990471018"/>
      </p:ext>
    </p:extLst>
  </p:cSld>
  <p:clrMapOvr>
    <a:overrideClrMapping bg1="dk1" tx1="lt1" bg2="dk2" tx2="lt2" accent1="accent1" accent2="accent2" accent3="accent3" accent4="accent4" accent5="accent5" accent6="accent6" hlink="hlink" folHlink="folHlink"/>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3" name="Rectangle 12">
            <a:extLst>
              <a:ext uri="{FF2B5EF4-FFF2-40B4-BE49-F238E27FC236}">
                <a16:creationId xmlns:a16="http://schemas.microsoft.com/office/drawing/2014/main" id="{92070828-E616-4355-9C8A-A1065032B27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 name="Freeform: Shape 10">
            <a:extLst>
              <a:ext uri="{FF2B5EF4-FFF2-40B4-BE49-F238E27FC236}">
                <a16:creationId xmlns:a16="http://schemas.microsoft.com/office/drawing/2014/main" id="{355161C6-1218-4EAF-A9E9-A319CFD760C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65747" y="2116753"/>
            <a:ext cx="4088106" cy="2781653"/>
          </a:xfrm>
          <a:custGeom>
            <a:avLst/>
            <a:gdLst>
              <a:gd name="connsiteX0" fmla="*/ 3362388 w 6230568"/>
              <a:gd name="connsiteY0" fmla="*/ 861 h 4239440"/>
              <a:gd name="connsiteX1" fmla="*/ 4026621 w 6230568"/>
              <a:gd name="connsiteY1" fmla="*/ 15392 h 4239440"/>
              <a:gd name="connsiteX2" fmla="*/ 5114556 w 6230568"/>
              <a:gd name="connsiteY2" fmla="*/ 34130 h 4239440"/>
              <a:gd name="connsiteX3" fmla="*/ 5776495 w 6230568"/>
              <a:gd name="connsiteY3" fmla="*/ 112905 h 4239440"/>
              <a:gd name="connsiteX4" fmla="*/ 5862918 w 6230568"/>
              <a:gd name="connsiteY4" fmla="*/ 141585 h 4239440"/>
              <a:gd name="connsiteX5" fmla="*/ 5840738 w 6230568"/>
              <a:gd name="connsiteY5" fmla="*/ 200475 h 4239440"/>
              <a:gd name="connsiteX6" fmla="*/ 5691219 w 6230568"/>
              <a:gd name="connsiteY6" fmla="*/ 216153 h 4239440"/>
              <a:gd name="connsiteX7" fmla="*/ 5773053 w 6230568"/>
              <a:gd name="connsiteY7" fmla="*/ 260130 h 4239440"/>
              <a:gd name="connsiteX8" fmla="*/ 5593324 w 6230568"/>
              <a:gd name="connsiteY8" fmla="*/ 293781 h 4239440"/>
              <a:gd name="connsiteX9" fmla="*/ 5617033 w 6230568"/>
              <a:gd name="connsiteY9" fmla="*/ 317108 h 4239440"/>
              <a:gd name="connsiteX10" fmla="*/ 5641124 w 6230568"/>
              <a:gd name="connsiteY10" fmla="*/ 339287 h 4239440"/>
              <a:gd name="connsiteX11" fmla="*/ 5299256 w 6230568"/>
              <a:gd name="connsiteY11" fmla="*/ 396265 h 4239440"/>
              <a:gd name="connsiteX12" fmla="*/ 5703073 w 6230568"/>
              <a:gd name="connsiteY12" fmla="*/ 500661 h 4239440"/>
              <a:gd name="connsiteX13" fmla="*/ 5629652 w 6230568"/>
              <a:gd name="connsiteY13" fmla="*/ 556874 h 4239440"/>
              <a:gd name="connsiteX14" fmla="*/ 5862918 w 6230568"/>
              <a:gd name="connsiteY14" fmla="*/ 645591 h 4239440"/>
              <a:gd name="connsiteX15" fmla="*/ 6052207 w 6230568"/>
              <a:gd name="connsiteY15" fmla="*/ 756106 h 4239440"/>
              <a:gd name="connsiteX16" fmla="*/ 6158515 w 6230568"/>
              <a:gd name="connsiteY16" fmla="*/ 901419 h 4239440"/>
              <a:gd name="connsiteX17" fmla="*/ 6195990 w 6230568"/>
              <a:gd name="connsiteY17" fmla="*/ 966427 h 4239440"/>
              <a:gd name="connsiteX18" fmla="*/ 6229642 w 6230568"/>
              <a:gd name="connsiteY18" fmla="*/ 1034878 h 4239440"/>
              <a:gd name="connsiteX19" fmla="*/ 6171516 w 6230568"/>
              <a:gd name="connsiteY19" fmla="*/ 1102946 h 4239440"/>
              <a:gd name="connsiteX20" fmla="*/ 6133659 w 6230568"/>
              <a:gd name="connsiteY20" fmla="*/ 1185545 h 4239440"/>
              <a:gd name="connsiteX21" fmla="*/ 6168458 w 6230568"/>
              <a:gd name="connsiteY21" fmla="*/ 1234110 h 4239440"/>
              <a:gd name="connsiteX22" fmla="*/ 6169222 w 6230568"/>
              <a:gd name="connsiteY22" fmla="*/ 1342712 h 4239440"/>
              <a:gd name="connsiteX23" fmla="*/ 6145131 w 6230568"/>
              <a:gd name="connsiteY23" fmla="*/ 1393954 h 4239440"/>
              <a:gd name="connsiteX24" fmla="*/ 6071709 w 6230568"/>
              <a:gd name="connsiteY24" fmla="*/ 1505233 h 4239440"/>
              <a:gd name="connsiteX25" fmla="*/ 6009378 w 6230568"/>
              <a:gd name="connsiteY25" fmla="*/ 1530089 h 4239440"/>
              <a:gd name="connsiteX26" fmla="*/ 6015879 w 6230568"/>
              <a:gd name="connsiteY26" fmla="*/ 1979030 h 4239440"/>
              <a:gd name="connsiteX27" fmla="*/ 6061385 w 6230568"/>
              <a:gd name="connsiteY27" fmla="*/ 2196234 h 4239440"/>
              <a:gd name="connsiteX28" fmla="*/ 6029263 w 6230568"/>
              <a:gd name="connsiteY28" fmla="*/ 2440972 h 4239440"/>
              <a:gd name="connsiteX29" fmla="*/ 6135571 w 6230568"/>
              <a:gd name="connsiteY29" fmla="*/ 2621848 h 4239440"/>
              <a:gd name="connsiteX30" fmla="*/ 6091594 w 6230568"/>
              <a:gd name="connsiteY30" fmla="*/ 2691446 h 4239440"/>
              <a:gd name="connsiteX31" fmla="*/ 6215493 w 6230568"/>
              <a:gd name="connsiteY31" fmla="*/ 2769456 h 4239440"/>
              <a:gd name="connsiteX32" fmla="*/ 6100389 w 6230568"/>
              <a:gd name="connsiteY32" fmla="*/ 2880352 h 4239440"/>
              <a:gd name="connsiteX33" fmla="*/ 5909953 w 6230568"/>
              <a:gd name="connsiteY33" fmla="*/ 3053963 h 4239440"/>
              <a:gd name="connsiteX34" fmla="*/ 5741696 w 6230568"/>
              <a:gd name="connsiteY34" fmla="*/ 3798118 h 4239440"/>
              <a:gd name="connsiteX35" fmla="*/ 5493899 w 6230568"/>
              <a:gd name="connsiteY35" fmla="*/ 4026795 h 4239440"/>
              <a:gd name="connsiteX36" fmla="*/ 3773471 w 6230568"/>
              <a:gd name="connsiteY36" fmla="*/ 4239028 h 4239440"/>
              <a:gd name="connsiteX37" fmla="*/ 2569285 w 6230568"/>
              <a:gd name="connsiteY37" fmla="*/ 4103275 h 4239440"/>
              <a:gd name="connsiteX38" fmla="*/ 2693948 w 6230568"/>
              <a:gd name="connsiteY38" fmla="*/ 4061593 h 4239440"/>
              <a:gd name="connsiteX39" fmla="*/ 2588788 w 6230568"/>
              <a:gd name="connsiteY39" fmla="*/ 4062358 h 4239440"/>
              <a:gd name="connsiteX40" fmla="*/ 2300073 w 6230568"/>
              <a:gd name="connsiteY40" fmla="*/ 4008822 h 4239440"/>
              <a:gd name="connsiteX41" fmla="*/ 1508500 w 6230568"/>
              <a:gd name="connsiteY41" fmla="*/ 3798118 h 4239440"/>
              <a:gd name="connsiteX42" fmla="*/ 1061089 w 6230568"/>
              <a:gd name="connsiteY42" fmla="*/ 3697546 h 4239440"/>
              <a:gd name="connsiteX43" fmla="*/ 939102 w 6230568"/>
              <a:gd name="connsiteY43" fmla="*/ 3648216 h 4239440"/>
              <a:gd name="connsiteX44" fmla="*/ 1243495 w 6230568"/>
              <a:gd name="connsiteY44" fmla="*/ 3624890 h 4239440"/>
              <a:gd name="connsiteX45" fmla="*/ 1083651 w 6230568"/>
              <a:gd name="connsiteY45" fmla="*/ 3595827 h 4239440"/>
              <a:gd name="connsiteX46" fmla="*/ 966636 w 6230568"/>
              <a:gd name="connsiteY46" fmla="*/ 3605770 h 4239440"/>
              <a:gd name="connsiteX47" fmla="*/ 885566 w 6230568"/>
              <a:gd name="connsiteY47" fmla="*/ 3609976 h 4239440"/>
              <a:gd name="connsiteX48" fmla="*/ 641976 w 6230568"/>
              <a:gd name="connsiteY48" fmla="*/ 3567912 h 4239440"/>
              <a:gd name="connsiteX49" fmla="*/ 399533 w 6230568"/>
              <a:gd name="connsiteY49" fmla="*/ 3583590 h 4239440"/>
              <a:gd name="connsiteX50" fmla="*/ 409093 w 6230568"/>
              <a:gd name="connsiteY50" fmla="*/ 3548792 h 4239440"/>
              <a:gd name="connsiteX51" fmla="*/ 792642 w 6230568"/>
              <a:gd name="connsiteY51" fmla="*/ 3417628 h 4239440"/>
              <a:gd name="connsiteX52" fmla="*/ 771610 w 6230568"/>
              <a:gd name="connsiteY52" fmla="*/ 3345736 h 4239440"/>
              <a:gd name="connsiteX53" fmla="*/ 945986 w 6230568"/>
              <a:gd name="connsiteY53" fmla="*/ 3317056 h 4239440"/>
              <a:gd name="connsiteX54" fmla="*/ 892449 w 6230568"/>
              <a:gd name="connsiteY54" fmla="*/ 3285316 h 4239440"/>
              <a:gd name="connsiteX55" fmla="*/ 949045 w 6230568"/>
              <a:gd name="connsiteY55" fmla="*/ 3262755 h 4239440"/>
              <a:gd name="connsiteX56" fmla="*/ 1252673 w 6230568"/>
              <a:gd name="connsiteY56" fmla="*/ 3200041 h 4239440"/>
              <a:gd name="connsiteX57" fmla="*/ 388825 w 6230568"/>
              <a:gd name="connsiteY57" fmla="*/ 3176714 h 4239440"/>
              <a:gd name="connsiteX58" fmla="*/ 127644 w 6230568"/>
              <a:gd name="connsiteY58" fmla="*/ 3111323 h 4239440"/>
              <a:gd name="connsiteX59" fmla="*/ 437008 w 6230568"/>
              <a:gd name="connsiteY59" fmla="*/ 2921652 h 4239440"/>
              <a:gd name="connsiteX60" fmla="*/ 601441 w 6230568"/>
              <a:gd name="connsiteY60" fmla="*/ 2840965 h 4239440"/>
              <a:gd name="connsiteX61" fmla="*/ 330700 w 6230568"/>
              <a:gd name="connsiteY61" fmla="*/ 2859320 h 4239440"/>
              <a:gd name="connsiteX62" fmla="*/ 534521 w 6230568"/>
              <a:gd name="connsiteY62" fmla="*/ 2720126 h 4239440"/>
              <a:gd name="connsiteX63" fmla="*/ 492839 w 6230568"/>
              <a:gd name="connsiteY63" fmla="*/ 2694505 h 4239440"/>
              <a:gd name="connsiteX64" fmla="*/ 416358 w 6230568"/>
              <a:gd name="connsiteY64" fmla="*/ 2677297 h 4239440"/>
              <a:gd name="connsiteX65" fmla="*/ 761285 w 6230568"/>
              <a:gd name="connsiteY65" fmla="*/ 2589726 h 4239440"/>
              <a:gd name="connsiteX66" fmla="*/ 664920 w 6230568"/>
              <a:gd name="connsiteY66" fmla="*/ 2466593 h 4239440"/>
              <a:gd name="connsiteX67" fmla="*/ 740253 w 6230568"/>
              <a:gd name="connsiteY67" fmla="*/ 2438677 h 4239440"/>
              <a:gd name="connsiteX68" fmla="*/ 650006 w 6230568"/>
              <a:gd name="connsiteY68" fmla="*/ 2435236 h 4239440"/>
              <a:gd name="connsiteX69" fmla="*/ 578879 w 6230568"/>
              <a:gd name="connsiteY69" fmla="*/ 2435618 h 4239440"/>
              <a:gd name="connsiteX70" fmla="*/ 451157 w 6230568"/>
              <a:gd name="connsiteY70" fmla="*/ 2404644 h 4239440"/>
              <a:gd name="connsiteX71" fmla="*/ 2216 w 6230568"/>
              <a:gd name="connsiteY71" fmla="*/ 2456650 h 4239440"/>
              <a:gd name="connsiteX72" fmla="*/ 97052 w 6230568"/>
              <a:gd name="connsiteY72" fmla="*/ 2383611 h 4239440"/>
              <a:gd name="connsiteX73" fmla="*/ 210626 w 6230568"/>
              <a:gd name="connsiteY73" fmla="*/ 2341930 h 4239440"/>
              <a:gd name="connsiteX74" fmla="*/ 57282 w 6230568"/>
              <a:gd name="connsiteY74" fmla="*/ 2319750 h 4239440"/>
              <a:gd name="connsiteX75" fmla="*/ 365499 w 6230568"/>
              <a:gd name="connsiteY75" fmla="*/ 2250153 h 4239440"/>
              <a:gd name="connsiteX76" fmla="*/ 290548 w 6230568"/>
              <a:gd name="connsiteY76" fmla="*/ 2187821 h 4239440"/>
              <a:gd name="connsiteX77" fmla="*/ 482896 w 6230568"/>
              <a:gd name="connsiteY77" fmla="*/ 1906755 h 4239440"/>
              <a:gd name="connsiteX78" fmla="*/ 867211 w 6230568"/>
              <a:gd name="connsiteY78" fmla="*/ 1747294 h 4239440"/>
              <a:gd name="connsiteX79" fmla="*/ 1063766 w 6230568"/>
              <a:gd name="connsiteY79" fmla="*/ 1734674 h 4239440"/>
              <a:gd name="connsiteX80" fmla="*/ 1008701 w 6230568"/>
              <a:gd name="connsiteY80" fmla="*/ 1683432 h 4239440"/>
              <a:gd name="connsiteX81" fmla="*/ 1152865 w 6230568"/>
              <a:gd name="connsiteY81" fmla="*/ 1394719 h 4239440"/>
              <a:gd name="connsiteX82" fmla="*/ 998376 w 6230568"/>
              <a:gd name="connsiteY82" fmla="*/ 1411927 h 4239440"/>
              <a:gd name="connsiteX83" fmla="*/ 206419 w 6230568"/>
              <a:gd name="connsiteY83" fmla="*/ 1424164 h 4239440"/>
              <a:gd name="connsiteX84" fmla="*/ 128027 w 6230568"/>
              <a:gd name="connsiteY84" fmla="*/ 1413074 h 4239440"/>
              <a:gd name="connsiteX85" fmla="*/ 672950 w 6230568"/>
              <a:gd name="connsiteY85" fmla="*/ 1268143 h 4239440"/>
              <a:gd name="connsiteX86" fmla="*/ 457658 w 6230568"/>
              <a:gd name="connsiteY86" fmla="*/ 1229138 h 4239440"/>
              <a:gd name="connsiteX87" fmla="*/ 407945 w 6230568"/>
              <a:gd name="connsiteY87" fmla="*/ 1213459 h 4239440"/>
              <a:gd name="connsiteX88" fmla="*/ 453451 w 6230568"/>
              <a:gd name="connsiteY88" fmla="*/ 1172924 h 4239440"/>
              <a:gd name="connsiteX89" fmla="*/ 568172 w 6230568"/>
              <a:gd name="connsiteY89" fmla="*/ 1132007 h 4239440"/>
              <a:gd name="connsiteX90" fmla="*/ 255367 w 6230568"/>
              <a:gd name="connsiteY90" fmla="*/ 1190898 h 4239440"/>
              <a:gd name="connsiteX91" fmla="*/ 277546 w 6230568"/>
              <a:gd name="connsiteY91" fmla="*/ 1128567 h 4239440"/>
              <a:gd name="connsiteX92" fmla="*/ 246572 w 6230568"/>
              <a:gd name="connsiteY92" fmla="*/ 1072353 h 4239440"/>
              <a:gd name="connsiteX93" fmla="*/ 422859 w 6230568"/>
              <a:gd name="connsiteY93" fmla="*/ 1000078 h 4239440"/>
              <a:gd name="connsiteX94" fmla="*/ 668362 w 6230568"/>
              <a:gd name="connsiteY94" fmla="*/ 858972 h 4239440"/>
              <a:gd name="connsiteX95" fmla="*/ 914629 w 6230568"/>
              <a:gd name="connsiteY95" fmla="*/ 768725 h 4239440"/>
              <a:gd name="connsiteX96" fmla="*/ 1117684 w 6230568"/>
              <a:gd name="connsiteY96" fmla="*/ 688420 h 4239440"/>
              <a:gd name="connsiteX97" fmla="*/ 928778 w 6230568"/>
              <a:gd name="connsiteY97" fmla="*/ 701040 h 4239440"/>
              <a:gd name="connsiteX98" fmla="*/ 1243877 w 6230568"/>
              <a:gd name="connsiteY98" fmla="*/ 574464 h 4239440"/>
              <a:gd name="connsiteX99" fmla="*/ 1291678 w 6230568"/>
              <a:gd name="connsiteY99" fmla="*/ 566434 h 4239440"/>
              <a:gd name="connsiteX100" fmla="*/ 1797596 w 6230568"/>
              <a:gd name="connsiteY100" fmla="*/ 476952 h 4239440"/>
              <a:gd name="connsiteX101" fmla="*/ 1895491 w 6230568"/>
              <a:gd name="connsiteY101" fmla="*/ 432593 h 4239440"/>
              <a:gd name="connsiteX102" fmla="*/ 1782682 w 6230568"/>
              <a:gd name="connsiteY102" fmla="*/ 423033 h 4239440"/>
              <a:gd name="connsiteX103" fmla="*/ 1406781 w 6230568"/>
              <a:gd name="connsiteY103" fmla="*/ 449419 h 4239440"/>
              <a:gd name="connsiteX104" fmla="*/ 1662226 w 6230568"/>
              <a:gd name="connsiteY104" fmla="*/ 393970 h 4239440"/>
              <a:gd name="connsiteX105" fmla="*/ 1383837 w 6230568"/>
              <a:gd name="connsiteY105" fmla="*/ 376762 h 4239440"/>
              <a:gd name="connsiteX106" fmla="*/ 1318063 w 6230568"/>
              <a:gd name="connsiteY106" fmla="*/ 333168 h 4239440"/>
              <a:gd name="connsiteX107" fmla="*/ 1365099 w 6230568"/>
              <a:gd name="connsiteY107" fmla="*/ 290722 h 4239440"/>
              <a:gd name="connsiteX108" fmla="*/ 1536798 w 6230568"/>
              <a:gd name="connsiteY108" fmla="*/ 244069 h 4239440"/>
              <a:gd name="connsiteX109" fmla="*/ 1711938 w 6230568"/>
              <a:gd name="connsiteY109" fmla="*/ 175619 h 4239440"/>
              <a:gd name="connsiteX110" fmla="*/ 2273687 w 6230568"/>
              <a:gd name="connsiteY110" fmla="*/ 78488 h 4239440"/>
              <a:gd name="connsiteX111" fmla="*/ 2646913 w 6230568"/>
              <a:gd name="connsiteY111" fmla="*/ 46749 h 4239440"/>
              <a:gd name="connsiteX112" fmla="*/ 3362388 w 6230568"/>
              <a:gd name="connsiteY112" fmla="*/ 861 h 42394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Lst>
            <a:rect l="l" t="t" r="r" b="b"/>
            <a:pathLst>
              <a:path w="6230568" h="4239440">
                <a:moveTo>
                  <a:pt x="3362388" y="861"/>
                </a:moveTo>
                <a:cubicBezTo>
                  <a:pt x="3584946" y="-3346"/>
                  <a:pt x="3805210" y="8891"/>
                  <a:pt x="4026621" y="15392"/>
                </a:cubicBezTo>
                <a:cubicBezTo>
                  <a:pt x="4388374" y="26482"/>
                  <a:pt x="4752039" y="26099"/>
                  <a:pt x="5114556" y="34130"/>
                </a:cubicBezTo>
                <a:cubicBezTo>
                  <a:pt x="5340556" y="39101"/>
                  <a:pt x="5563879" y="57074"/>
                  <a:pt x="5776495" y="112905"/>
                </a:cubicBezTo>
                <a:cubicBezTo>
                  <a:pt x="5806322" y="120935"/>
                  <a:pt x="5839973" y="122465"/>
                  <a:pt x="5862918" y="141585"/>
                </a:cubicBezTo>
                <a:cubicBezTo>
                  <a:pt x="5888539" y="162999"/>
                  <a:pt x="5878214" y="194356"/>
                  <a:pt x="5840738" y="200475"/>
                </a:cubicBezTo>
                <a:cubicBezTo>
                  <a:pt x="5792938" y="208505"/>
                  <a:pt x="5743991" y="210800"/>
                  <a:pt x="5691219" y="216153"/>
                </a:cubicBezTo>
                <a:cubicBezTo>
                  <a:pt x="5711486" y="245598"/>
                  <a:pt x="5760434" y="223419"/>
                  <a:pt x="5773053" y="260130"/>
                </a:cubicBezTo>
                <a:cubicBezTo>
                  <a:pt x="5716458" y="285368"/>
                  <a:pt x="5648008" y="268925"/>
                  <a:pt x="5593324" y="293781"/>
                </a:cubicBezTo>
                <a:cubicBezTo>
                  <a:pt x="5594854" y="310989"/>
                  <a:pt x="5607090" y="312519"/>
                  <a:pt x="5617033" y="317108"/>
                </a:cubicBezTo>
                <a:cubicBezTo>
                  <a:pt x="5626976" y="321314"/>
                  <a:pt x="5651831" y="315196"/>
                  <a:pt x="5641124" y="339287"/>
                </a:cubicBezTo>
                <a:cubicBezTo>
                  <a:pt x="5527551" y="353818"/>
                  <a:pt x="5418949" y="403148"/>
                  <a:pt x="5299256" y="396265"/>
                </a:cubicBezTo>
                <a:cubicBezTo>
                  <a:pt x="5447247" y="409649"/>
                  <a:pt x="5572292" y="464333"/>
                  <a:pt x="5703073" y="500661"/>
                </a:cubicBezTo>
                <a:cubicBezTo>
                  <a:pt x="5697720" y="543490"/>
                  <a:pt x="5644949" y="526282"/>
                  <a:pt x="5629652" y="556874"/>
                </a:cubicBezTo>
                <a:cubicBezTo>
                  <a:pt x="5713398" y="578288"/>
                  <a:pt x="5793703" y="603527"/>
                  <a:pt x="5862918" y="645591"/>
                </a:cubicBezTo>
                <a:cubicBezTo>
                  <a:pt x="5925250" y="683449"/>
                  <a:pt x="5984521" y="725131"/>
                  <a:pt x="6052207" y="756106"/>
                </a:cubicBezTo>
                <a:cubicBezTo>
                  <a:pt x="6123334" y="788611"/>
                  <a:pt x="6166545" y="830293"/>
                  <a:pt x="6158515" y="901419"/>
                </a:cubicBezTo>
                <a:cubicBezTo>
                  <a:pt x="6155073" y="930482"/>
                  <a:pt x="6164251" y="954955"/>
                  <a:pt x="6195990" y="966427"/>
                </a:cubicBezTo>
                <a:cubicBezTo>
                  <a:pt x="6235378" y="980576"/>
                  <a:pt x="6231172" y="1001990"/>
                  <a:pt x="6229642" y="1034878"/>
                </a:cubicBezTo>
                <a:cubicBezTo>
                  <a:pt x="6227347" y="1074265"/>
                  <a:pt x="6207080" y="1089562"/>
                  <a:pt x="6171516" y="1102946"/>
                </a:cubicBezTo>
                <a:cubicBezTo>
                  <a:pt x="6120657" y="1121682"/>
                  <a:pt x="6120274" y="1150745"/>
                  <a:pt x="6133659" y="1185545"/>
                </a:cubicBezTo>
                <a:cubicBezTo>
                  <a:pt x="6140925" y="1204664"/>
                  <a:pt x="6152014" y="1219961"/>
                  <a:pt x="6168458" y="1234110"/>
                </a:cubicBezTo>
                <a:cubicBezTo>
                  <a:pt x="6225435" y="1283439"/>
                  <a:pt x="6225053" y="1284204"/>
                  <a:pt x="6169222" y="1342712"/>
                </a:cubicBezTo>
                <a:cubicBezTo>
                  <a:pt x="6154308" y="1358390"/>
                  <a:pt x="6138247" y="1368715"/>
                  <a:pt x="6145131" y="1393954"/>
                </a:cubicBezTo>
                <a:cubicBezTo>
                  <a:pt x="6168458" y="1477700"/>
                  <a:pt x="6165398" y="1477700"/>
                  <a:pt x="6071709" y="1505233"/>
                </a:cubicBezTo>
                <a:cubicBezTo>
                  <a:pt x="6050295" y="1511734"/>
                  <a:pt x="6021615" y="1505998"/>
                  <a:pt x="6009378" y="1530089"/>
                </a:cubicBezTo>
                <a:cubicBezTo>
                  <a:pt x="6017026" y="1547680"/>
                  <a:pt x="5999053" y="1972146"/>
                  <a:pt x="6015879" y="1979030"/>
                </a:cubicBezTo>
                <a:cubicBezTo>
                  <a:pt x="6147425" y="2032948"/>
                  <a:pt x="6163868" y="2096427"/>
                  <a:pt x="6061385" y="2196234"/>
                </a:cubicBezTo>
                <a:cubicBezTo>
                  <a:pt x="5992552" y="2263155"/>
                  <a:pt x="6000582" y="2372522"/>
                  <a:pt x="6029263" y="2440972"/>
                </a:cubicBezTo>
                <a:cubicBezTo>
                  <a:pt x="6137482" y="2471182"/>
                  <a:pt x="6113774" y="2551486"/>
                  <a:pt x="6135571" y="2621848"/>
                </a:cubicBezTo>
                <a:cubicBezTo>
                  <a:pt x="6151632" y="2674620"/>
                  <a:pt x="6088535" y="2667354"/>
                  <a:pt x="6091594" y="2691446"/>
                </a:cubicBezTo>
                <a:cubicBezTo>
                  <a:pt x="6131364" y="2720508"/>
                  <a:pt x="6184518" y="2729686"/>
                  <a:pt x="6215493" y="2769456"/>
                </a:cubicBezTo>
                <a:cubicBezTo>
                  <a:pt x="6159662" y="2798518"/>
                  <a:pt x="6131364" y="2839435"/>
                  <a:pt x="6100389" y="2880352"/>
                </a:cubicBezTo>
                <a:cubicBezTo>
                  <a:pt x="6050295" y="2946890"/>
                  <a:pt x="5982227" y="3003103"/>
                  <a:pt x="5909953" y="3053963"/>
                </a:cubicBezTo>
                <a:cubicBezTo>
                  <a:pt x="5873243" y="3408068"/>
                  <a:pt x="5754698" y="3779763"/>
                  <a:pt x="5741696" y="3798118"/>
                </a:cubicBezTo>
                <a:cubicBezTo>
                  <a:pt x="5688160" y="3792764"/>
                  <a:pt x="5584146" y="4006910"/>
                  <a:pt x="5493899" y="4026795"/>
                </a:cubicBezTo>
                <a:cubicBezTo>
                  <a:pt x="5399063" y="4048592"/>
                  <a:pt x="3988763" y="4249736"/>
                  <a:pt x="3773471" y="4239028"/>
                </a:cubicBezTo>
                <a:cubicBezTo>
                  <a:pt x="2603319" y="4182050"/>
                  <a:pt x="2569285" y="4103275"/>
                  <a:pt x="2569285" y="4103275"/>
                </a:cubicBezTo>
                <a:cubicBezTo>
                  <a:pt x="2569285" y="4103275"/>
                  <a:pt x="2635823" y="4083773"/>
                  <a:pt x="2693948" y="4061593"/>
                </a:cubicBezTo>
                <a:cubicBezTo>
                  <a:pt x="2658767" y="4062741"/>
                  <a:pt x="2623587" y="4063505"/>
                  <a:pt x="2588788" y="4062358"/>
                </a:cubicBezTo>
                <a:cubicBezTo>
                  <a:pt x="2319193" y="4054328"/>
                  <a:pt x="2565461" y="4039414"/>
                  <a:pt x="2300073" y="4008822"/>
                </a:cubicBezTo>
                <a:cubicBezTo>
                  <a:pt x="1852280" y="3957198"/>
                  <a:pt x="1919582" y="3943813"/>
                  <a:pt x="1508500" y="3798118"/>
                </a:cubicBezTo>
                <a:cubicBezTo>
                  <a:pt x="1472171" y="3785116"/>
                  <a:pt x="1217109" y="3706342"/>
                  <a:pt x="1061089" y="3697546"/>
                </a:cubicBezTo>
                <a:cubicBezTo>
                  <a:pt x="1019790" y="3695252"/>
                  <a:pt x="974667" y="3696017"/>
                  <a:pt x="939102" y="3648216"/>
                </a:cubicBezTo>
                <a:cubicBezTo>
                  <a:pt x="1048088" y="3649746"/>
                  <a:pt x="1141776" y="3649746"/>
                  <a:pt x="1243495" y="3624890"/>
                </a:cubicBezTo>
                <a:cubicBezTo>
                  <a:pt x="1189194" y="3590473"/>
                  <a:pt x="1126862" y="3619919"/>
                  <a:pt x="1083651" y="3595827"/>
                </a:cubicBezTo>
                <a:cubicBezTo>
                  <a:pt x="1043116" y="3573648"/>
                  <a:pt x="1007935" y="3570589"/>
                  <a:pt x="966636" y="3605770"/>
                </a:cubicBezTo>
                <a:cubicBezTo>
                  <a:pt x="945221" y="3624125"/>
                  <a:pt x="907363" y="3620683"/>
                  <a:pt x="885566" y="3609976"/>
                </a:cubicBezTo>
                <a:cubicBezTo>
                  <a:pt x="768933" y="3552233"/>
                  <a:pt x="771610" y="3552998"/>
                  <a:pt x="641976" y="3567912"/>
                </a:cubicBezTo>
                <a:cubicBezTo>
                  <a:pt x="559377" y="3577089"/>
                  <a:pt x="475248" y="3593533"/>
                  <a:pt x="399533" y="3583590"/>
                </a:cubicBezTo>
                <a:cubicBezTo>
                  <a:pt x="389973" y="3561793"/>
                  <a:pt x="398385" y="3551851"/>
                  <a:pt x="409093" y="3548792"/>
                </a:cubicBezTo>
                <a:cubicBezTo>
                  <a:pt x="583468" y="3501374"/>
                  <a:pt x="615972" y="3447073"/>
                  <a:pt x="792642" y="3417628"/>
                </a:cubicBezTo>
                <a:cubicBezTo>
                  <a:pt x="805644" y="3384359"/>
                  <a:pt x="741400" y="3378622"/>
                  <a:pt x="771610" y="3345736"/>
                </a:cubicBezTo>
                <a:cubicBezTo>
                  <a:pt x="826676" y="3320115"/>
                  <a:pt x="891302" y="3350325"/>
                  <a:pt x="945986" y="3317056"/>
                </a:cubicBezTo>
                <a:cubicBezTo>
                  <a:pt x="936426" y="3293347"/>
                  <a:pt x="890537" y="3310555"/>
                  <a:pt x="892449" y="3285316"/>
                </a:cubicBezTo>
                <a:cubicBezTo>
                  <a:pt x="894744" y="3256254"/>
                  <a:pt x="926866" y="3260843"/>
                  <a:pt x="949045" y="3262755"/>
                </a:cubicBezTo>
                <a:cubicBezTo>
                  <a:pt x="1056500" y="3272697"/>
                  <a:pt x="1149806" y="3218396"/>
                  <a:pt x="1252673" y="3200041"/>
                </a:cubicBezTo>
                <a:cubicBezTo>
                  <a:pt x="1142923" y="3154152"/>
                  <a:pt x="503164" y="3190863"/>
                  <a:pt x="388825" y="3176714"/>
                </a:cubicBezTo>
                <a:cubicBezTo>
                  <a:pt x="269133" y="3162183"/>
                  <a:pt x="78697" y="3123560"/>
                  <a:pt x="127644" y="3111323"/>
                </a:cubicBezTo>
                <a:cubicBezTo>
                  <a:pt x="183093" y="3097175"/>
                  <a:pt x="380795" y="2929300"/>
                  <a:pt x="437008" y="2921652"/>
                </a:cubicBezTo>
                <a:cubicBezTo>
                  <a:pt x="502399" y="2912857"/>
                  <a:pt x="515401" y="2901002"/>
                  <a:pt x="601441" y="2840965"/>
                </a:cubicBezTo>
                <a:cubicBezTo>
                  <a:pt x="658037" y="2801577"/>
                  <a:pt x="422477" y="2887235"/>
                  <a:pt x="330700" y="2859320"/>
                </a:cubicBezTo>
                <a:cubicBezTo>
                  <a:pt x="297049" y="2848995"/>
                  <a:pt x="534521" y="2740010"/>
                  <a:pt x="534521" y="2720126"/>
                </a:cubicBezTo>
                <a:cubicBezTo>
                  <a:pt x="534521" y="2699093"/>
                  <a:pt x="513106" y="2694505"/>
                  <a:pt x="492839" y="2694505"/>
                </a:cubicBezTo>
                <a:cubicBezTo>
                  <a:pt x="447715" y="2694505"/>
                  <a:pt x="461482" y="2676149"/>
                  <a:pt x="416358" y="2677297"/>
                </a:cubicBezTo>
                <a:cubicBezTo>
                  <a:pt x="548670" y="2624143"/>
                  <a:pt x="630504" y="2638292"/>
                  <a:pt x="761285" y="2589726"/>
                </a:cubicBezTo>
                <a:cubicBezTo>
                  <a:pt x="825147" y="2566017"/>
                  <a:pt x="599147" y="2487242"/>
                  <a:pt x="664920" y="2466593"/>
                </a:cubicBezTo>
                <a:cubicBezTo>
                  <a:pt x="689776" y="2458562"/>
                  <a:pt x="723045" y="2466975"/>
                  <a:pt x="740253" y="2438677"/>
                </a:cubicBezTo>
                <a:cubicBezTo>
                  <a:pt x="713103" y="2416116"/>
                  <a:pt x="677157" y="2426058"/>
                  <a:pt x="650006" y="2435236"/>
                </a:cubicBezTo>
                <a:cubicBezTo>
                  <a:pt x="580791" y="2458945"/>
                  <a:pt x="585763" y="2453209"/>
                  <a:pt x="578879" y="2435618"/>
                </a:cubicBezTo>
                <a:cubicBezTo>
                  <a:pt x="556318" y="2375581"/>
                  <a:pt x="500487" y="2394701"/>
                  <a:pt x="451157" y="2404644"/>
                </a:cubicBezTo>
                <a:cubicBezTo>
                  <a:pt x="302020" y="2434471"/>
                  <a:pt x="150971" y="2426058"/>
                  <a:pt x="2216" y="2456650"/>
                </a:cubicBezTo>
                <a:cubicBezTo>
                  <a:pt x="-13844" y="2460092"/>
                  <a:pt x="61489" y="2391642"/>
                  <a:pt x="97052" y="2383611"/>
                </a:cubicBezTo>
                <a:cubicBezTo>
                  <a:pt x="135675" y="2375199"/>
                  <a:pt x="183093" y="2381317"/>
                  <a:pt x="210626" y="2341930"/>
                </a:cubicBezTo>
                <a:cubicBezTo>
                  <a:pt x="161678" y="2331987"/>
                  <a:pt x="105848" y="2351107"/>
                  <a:pt x="57282" y="2319750"/>
                </a:cubicBezTo>
                <a:cubicBezTo>
                  <a:pt x="165120" y="2276539"/>
                  <a:pt x="272575" y="2278068"/>
                  <a:pt x="365499" y="2250153"/>
                </a:cubicBezTo>
                <a:cubicBezTo>
                  <a:pt x="373912" y="2198529"/>
                  <a:pt x="312727" y="2217266"/>
                  <a:pt x="290548" y="2187821"/>
                </a:cubicBezTo>
                <a:cubicBezTo>
                  <a:pt x="990345" y="2137344"/>
                  <a:pt x="599529" y="1988207"/>
                  <a:pt x="482896" y="1906755"/>
                </a:cubicBezTo>
                <a:cubicBezTo>
                  <a:pt x="443891" y="1879605"/>
                  <a:pt x="853827" y="1750735"/>
                  <a:pt x="867211" y="1747294"/>
                </a:cubicBezTo>
                <a:cubicBezTo>
                  <a:pt x="901245" y="1739263"/>
                  <a:pt x="1036233" y="1744999"/>
                  <a:pt x="1063766" y="1734674"/>
                </a:cubicBezTo>
                <a:cubicBezTo>
                  <a:pt x="1098947" y="1721673"/>
                  <a:pt x="982696" y="1699111"/>
                  <a:pt x="1008701" y="1683432"/>
                </a:cubicBezTo>
                <a:cubicBezTo>
                  <a:pt x="1191107" y="1572918"/>
                  <a:pt x="1204107" y="1406573"/>
                  <a:pt x="1152865" y="1394719"/>
                </a:cubicBezTo>
                <a:cubicBezTo>
                  <a:pt x="1099712" y="1382482"/>
                  <a:pt x="1047706" y="1392042"/>
                  <a:pt x="998376" y="1411927"/>
                </a:cubicBezTo>
                <a:cubicBezTo>
                  <a:pt x="918070" y="1444431"/>
                  <a:pt x="362057" y="1398160"/>
                  <a:pt x="206419" y="1424164"/>
                </a:cubicBezTo>
                <a:cubicBezTo>
                  <a:pt x="182710" y="1427988"/>
                  <a:pt x="150589" y="1445196"/>
                  <a:pt x="128027" y="1413074"/>
                </a:cubicBezTo>
                <a:cubicBezTo>
                  <a:pt x="288254" y="1309060"/>
                  <a:pt x="493986" y="1338888"/>
                  <a:pt x="672950" y="1268143"/>
                </a:cubicBezTo>
                <a:cubicBezTo>
                  <a:pt x="602588" y="1219578"/>
                  <a:pt x="531079" y="1221873"/>
                  <a:pt x="457658" y="1229138"/>
                </a:cubicBezTo>
                <a:cubicBezTo>
                  <a:pt x="438538" y="1231050"/>
                  <a:pt x="412534" y="1233727"/>
                  <a:pt x="407945" y="1213459"/>
                </a:cubicBezTo>
                <a:cubicBezTo>
                  <a:pt x="402209" y="1187838"/>
                  <a:pt x="433184" y="1183250"/>
                  <a:pt x="453451" y="1172924"/>
                </a:cubicBezTo>
                <a:cubicBezTo>
                  <a:pt x="484426" y="1156863"/>
                  <a:pt x="530314" y="1175984"/>
                  <a:pt x="568172" y="1132007"/>
                </a:cubicBezTo>
                <a:cubicBezTo>
                  <a:pt x="453451" y="1142333"/>
                  <a:pt x="356704" y="1160305"/>
                  <a:pt x="255367" y="1190898"/>
                </a:cubicBezTo>
                <a:cubicBezTo>
                  <a:pt x="264162" y="1163747"/>
                  <a:pt x="294754" y="1151128"/>
                  <a:pt x="277546" y="1128567"/>
                </a:cubicBezTo>
                <a:cubicBezTo>
                  <a:pt x="264545" y="1111740"/>
                  <a:pt x="227452" y="1103709"/>
                  <a:pt x="246572" y="1072353"/>
                </a:cubicBezTo>
                <a:cubicBezTo>
                  <a:pt x="300490" y="1039083"/>
                  <a:pt x="376971" y="1047879"/>
                  <a:pt x="422859" y="1000078"/>
                </a:cubicBezTo>
                <a:cubicBezTo>
                  <a:pt x="487868" y="932012"/>
                  <a:pt x="588822" y="908684"/>
                  <a:pt x="668362" y="858972"/>
                </a:cubicBezTo>
                <a:cubicBezTo>
                  <a:pt x="694747" y="842911"/>
                  <a:pt x="867976" y="786699"/>
                  <a:pt x="914629" y="768725"/>
                </a:cubicBezTo>
                <a:cubicBezTo>
                  <a:pt x="979637" y="743486"/>
                  <a:pt x="1053823" y="734691"/>
                  <a:pt x="1117684" y="688420"/>
                </a:cubicBezTo>
                <a:cubicBezTo>
                  <a:pt x="1054970" y="678860"/>
                  <a:pt x="1004112" y="722072"/>
                  <a:pt x="928778" y="701040"/>
                </a:cubicBezTo>
                <a:cubicBezTo>
                  <a:pt x="1048088" y="656299"/>
                  <a:pt x="1157454" y="636031"/>
                  <a:pt x="1243877" y="574464"/>
                </a:cubicBezTo>
                <a:cubicBezTo>
                  <a:pt x="1254585" y="566816"/>
                  <a:pt x="1275617" y="569111"/>
                  <a:pt x="1291678" y="566434"/>
                </a:cubicBezTo>
                <a:cubicBezTo>
                  <a:pt x="1460699" y="539283"/>
                  <a:pt x="1630486" y="516339"/>
                  <a:pt x="1797596" y="476952"/>
                </a:cubicBezTo>
                <a:cubicBezTo>
                  <a:pt x="1835454" y="467774"/>
                  <a:pt x="1902374" y="465480"/>
                  <a:pt x="1895491" y="432593"/>
                </a:cubicBezTo>
                <a:cubicBezTo>
                  <a:pt x="1885166" y="383263"/>
                  <a:pt x="1822835" y="418444"/>
                  <a:pt x="1782682" y="423033"/>
                </a:cubicBezTo>
                <a:cubicBezTo>
                  <a:pt x="1658019" y="437947"/>
                  <a:pt x="1533356" y="463950"/>
                  <a:pt x="1406781" y="449419"/>
                </a:cubicBezTo>
                <a:cubicBezTo>
                  <a:pt x="1492056" y="431064"/>
                  <a:pt x="1576950" y="412326"/>
                  <a:pt x="1662226" y="393970"/>
                </a:cubicBezTo>
                <a:cubicBezTo>
                  <a:pt x="1564330" y="400471"/>
                  <a:pt x="1479055" y="357642"/>
                  <a:pt x="1383837" y="376762"/>
                </a:cubicBezTo>
                <a:cubicBezTo>
                  <a:pt x="1353244" y="382881"/>
                  <a:pt x="1321123" y="363378"/>
                  <a:pt x="1318063" y="333168"/>
                </a:cubicBezTo>
                <a:cubicBezTo>
                  <a:pt x="1314622" y="309077"/>
                  <a:pt x="1343302" y="298370"/>
                  <a:pt x="1365099" y="290722"/>
                </a:cubicBezTo>
                <a:cubicBezTo>
                  <a:pt x="1420930" y="271219"/>
                  <a:pt x="1465288" y="213477"/>
                  <a:pt x="1536798" y="244069"/>
                </a:cubicBezTo>
                <a:cubicBezTo>
                  <a:pt x="1581921" y="195886"/>
                  <a:pt x="1653813" y="188238"/>
                  <a:pt x="1711938" y="175619"/>
                </a:cubicBezTo>
                <a:cubicBezTo>
                  <a:pt x="1897403" y="135849"/>
                  <a:pt x="2085546" y="104874"/>
                  <a:pt x="2273687" y="78488"/>
                </a:cubicBezTo>
                <a:cubicBezTo>
                  <a:pt x="2397204" y="61280"/>
                  <a:pt x="2524544" y="68546"/>
                  <a:pt x="2646913" y="46749"/>
                </a:cubicBezTo>
                <a:cubicBezTo>
                  <a:pt x="2886297" y="4302"/>
                  <a:pt x="3124151" y="5450"/>
                  <a:pt x="3362388" y="861"/>
                </a:cubicBezTo>
                <a:close/>
              </a:path>
            </a:pathLst>
          </a:custGeom>
          <a:solidFill>
            <a:schemeClr val="bg1">
              <a:lumMod val="85000"/>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DADEF8A6-F0CE-DF4B-9244-30F6E03BE4B4}"/>
              </a:ext>
            </a:extLst>
          </p:cNvPr>
          <p:cNvSpPr>
            <a:spLocks noGrp="1"/>
          </p:cNvSpPr>
          <p:nvPr>
            <p:ph type="title"/>
          </p:nvPr>
        </p:nvSpPr>
        <p:spPr>
          <a:xfrm>
            <a:off x="838200" y="1495426"/>
            <a:ext cx="3220880" cy="4024310"/>
          </a:xfrm>
        </p:spPr>
        <p:txBody>
          <a:bodyPr>
            <a:normAutofit/>
          </a:bodyPr>
          <a:lstStyle/>
          <a:p>
            <a:r>
              <a:rPr lang="en-US" sz="2000" dirty="0"/>
              <a:t>Summarize/Strategize</a:t>
            </a:r>
          </a:p>
        </p:txBody>
      </p:sp>
      <p:graphicFrame>
        <p:nvGraphicFramePr>
          <p:cNvPr id="15" name="Content Placeholder 2">
            <a:extLst>
              <a:ext uri="{FF2B5EF4-FFF2-40B4-BE49-F238E27FC236}">
                <a16:creationId xmlns:a16="http://schemas.microsoft.com/office/drawing/2014/main" id="{81897187-E7E7-018B-1E62-98AB17258FEB}"/>
              </a:ext>
            </a:extLst>
          </p:cNvPr>
          <p:cNvGraphicFramePr>
            <a:graphicFrameLocks noGrp="1"/>
          </p:cNvGraphicFramePr>
          <p:nvPr>
            <p:ph idx="1"/>
            <p:extLst>
              <p:ext uri="{D42A27DB-BD31-4B8C-83A1-F6EECF244321}">
                <p14:modId xmlns:p14="http://schemas.microsoft.com/office/powerpoint/2010/main" val="416987142"/>
              </p:ext>
            </p:extLst>
          </p:nvPr>
        </p:nvGraphicFramePr>
        <p:xfrm>
          <a:off x="4702547" y="838199"/>
          <a:ext cx="6651253" cy="533876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68379540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DA8886A6-5426-494B-96D8-D962D2BA08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2" name="Freeform: Shape 11">
            <a:extLst>
              <a:ext uri="{FF2B5EF4-FFF2-40B4-BE49-F238E27FC236}">
                <a16:creationId xmlns:a16="http://schemas.microsoft.com/office/drawing/2014/main" id="{AA3ED336-C09E-46E8-9774-B977D15FC5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752347"/>
            <a:ext cx="12191999" cy="6105653"/>
          </a:xfrm>
          <a:custGeom>
            <a:avLst/>
            <a:gdLst>
              <a:gd name="connsiteX0" fmla="*/ 7538181 w 12191999"/>
              <a:gd name="connsiteY0" fmla="*/ 484 h 6105653"/>
              <a:gd name="connsiteX1" fmla="*/ 7569993 w 12191999"/>
              <a:gd name="connsiteY1" fmla="*/ 5527 h 6105653"/>
              <a:gd name="connsiteX2" fmla="*/ 7587853 w 12191999"/>
              <a:gd name="connsiteY2" fmla="*/ 84028 h 6105653"/>
              <a:gd name="connsiteX3" fmla="*/ 7559278 w 12191999"/>
              <a:gd name="connsiteY3" fmla="*/ 325347 h 6105653"/>
              <a:gd name="connsiteX4" fmla="*/ 7795021 w 12191999"/>
              <a:gd name="connsiteY4" fmla="*/ 25878 h 6105653"/>
              <a:gd name="connsiteX5" fmla="*/ 7759302 w 12191999"/>
              <a:gd name="connsiteY5" fmla="*/ 249752 h 6105653"/>
              <a:gd name="connsiteX6" fmla="*/ 7852171 w 12191999"/>
              <a:gd name="connsiteY6" fmla="*/ 313717 h 6105653"/>
              <a:gd name="connsiteX7" fmla="*/ 8002190 w 12191999"/>
              <a:gd name="connsiteY7" fmla="*/ 418385 h 6105653"/>
              <a:gd name="connsiteX8" fmla="*/ 8084343 w 12191999"/>
              <a:gd name="connsiteY8" fmla="*/ 491072 h 6105653"/>
              <a:gd name="connsiteX9" fmla="*/ 8348662 w 12191999"/>
              <a:gd name="connsiteY9" fmla="*/ 520146 h 6105653"/>
              <a:gd name="connsiteX10" fmla="*/ 8637984 w 12191999"/>
              <a:gd name="connsiteY10" fmla="*/ 459090 h 6105653"/>
              <a:gd name="connsiteX11" fmla="*/ 8784431 w 12191999"/>
              <a:gd name="connsiteY11" fmla="*/ 290457 h 6105653"/>
              <a:gd name="connsiteX12" fmla="*/ 8948737 w 12191999"/>
              <a:gd name="connsiteY12" fmla="*/ 339884 h 6105653"/>
              <a:gd name="connsiteX13" fmla="*/ 8848725 w 12191999"/>
              <a:gd name="connsiteY13" fmla="*/ 697501 h 6105653"/>
              <a:gd name="connsiteX14" fmla="*/ 9238059 w 12191999"/>
              <a:gd name="connsiteY14" fmla="*/ 165437 h 6105653"/>
              <a:gd name="connsiteX15" fmla="*/ 9255919 w 12191999"/>
              <a:gd name="connsiteY15" fmla="*/ 255567 h 6105653"/>
              <a:gd name="connsiteX16" fmla="*/ 9477374 w 12191999"/>
              <a:gd name="connsiteY16" fmla="*/ 578295 h 6105653"/>
              <a:gd name="connsiteX17" fmla="*/ 9488091 w 12191999"/>
              <a:gd name="connsiteY17" fmla="*/ 595740 h 6105653"/>
              <a:gd name="connsiteX18" fmla="*/ 9627393 w 12191999"/>
              <a:gd name="connsiteY18" fmla="*/ 650981 h 6105653"/>
              <a:gd name="connsiteX19" fmla="*/ 9648824 w 12191999"/>
              <a:gd name="connsiteY19" fmla="*/ 825429 h 6105653"/>
              <a:gd name="connsiteX20" fmla="*/ 9616678 w 12191999"/>
              <a:gd name="connsiteY20" fmla="*/ 970802 h 6105653"/>
              <a:gd name="connsiteX21" fmla="*/ 9655968 w 12191999"/>
              <a:gd name="connsiteY21" fmla="*/ 1127805 h 6105653"/>
              <a:gd name="connsiteX22" fmla="*/ 9638109 w 12191999"/>
              <a:gd name="connsiteY22" fmla="*/ 1267362 h 6105653"/>
              <a:gd name="connsiteX23" fmla="*/ 9663111 w 12191999"/>
              <a:gd name="connsiteY23" fmla="*/ 1386568 h 6105653"/>
              <a:gd name="connsiteX24" fmla="*/ 9780984 w 12191999"/>
              <a:gd name="connsiteY24" fmla="*/ 1270269 h 6105653"/>
              <a:gd name="connsiteX25" fmla="*/ 9780984 w 12191999"/>
              <a:gd name="connsiteY25" fmla="*/ 1107452 h 6105653"/>
              <a:gd name="connsiteX26" fmla="*/ 9855993 w 12191999"/>
              <a:gd name="connsiteY26" fmla="*/ 991154 h 6105653"/>
              <a:gd name="connsiteX27" fmla="*/ 9991724 w 12191999"/>
              <a:gd name="connsiteY27" fmla="*/ 880670 h 6105653"/>
              <a:gd name="connsiteX28" fmla="*/ 10209609 w 12191999"/>
              <a:gd name="connsiteY28" fmla="*/ 491071 h 6105653"/>
              <a:gd name="connsiteX29" fmla="*/ 10291762 w 12191999"/>
              <a:gd name="connsiteY29" fmla="*/ 421292 h 6105653"/>
              <a:gd name="connsiteX30" fmla="*/ 9973865 w 12191999"/>
              <a:gd name="connsiteY30" fmla="*/ 1531941 h 6105653"/>
              <a:gd name="connsiteX31" fmla="*/ 10106024 w 12191999"/>
              <a:gd name="connsiteY31" fmla="*/ 1188861 h 6105653"/>
              <a:gd name="connsiteX32" fmla="*/ 10081022 w 12191999"/>
              <a:gd name="connsiteY32" fmla="*/ 1421458 h 6105653"/>
              <a:gd name="connsiteX33" fmla="*/ 10170318 w 12191999"/>
              <a:gd name="connsiteY33" fmla="*/ 1549385 h 6105653"/>
              <a:gd name="connsiteX34" fmla="*/ 10198893 w 12191999"/>
              <a:gd name="connsiteY34" fmla="*/ 1549385 h 6105653"/>
              <a:gd name="connsiteX35" fmla="*/ 10281046 w 12191999"/>
              <a:gd name="connsiteY35" fmla="*/ 1453439 h 6105653"/>
              <a:gd name="connsiteX36" fmla="*/ 10334625 w 12191999"/>
              <a:gd name="connsiteY36" fmla="*/ 1398198 h 6105653"/>
              <a:gd name="connsiteX37" fmla="*/ 10527506 w 12191999"/>
              <a:gd name="connsiteY37" fmla="*/ 1247010 h 6105653"/>
              <a:gd name="connsiteX38" fmla="*/ 10548937 w 12191999"/>
              <a:gd name="connsiteY38" fmla="*/ 1354586 h 6105653"/>
              <a:gd name="connsiteX39" fmla="*/ 10588228 w 12191999"/>
              <a:gd name="connsiteY39" fmla="*/ 1395290 h 6105653"/>
              <a:gd name="connsiteX40" fmla="*/ 10645378 w 12191999"/>
              <a:gd name="connsiteY40" fmla="*/ 1366216 h 6105653"/>
              <a:gd name="connsiteX41" fmla="*/ 10820400 w 12191999"/>
              <a:gd name="connsiteY41" fmla="*/ 1031858 h 6105653"/>
              <a:gd name="connsiteX42" fmla="*/ 10956131 w 12191999"/>
              <a:gd name="connsiteY42" fmla="*/ 1005691 h 6105653"/>
              <a:gd name="connsiteX43" fmla="*/ 10977562 w 12191999"/>
              <a:gd name="connsiteY43" fmla="*/ 1069655 h 6105653"/>
              <a:gd name="connsiteX44" fmla="*/ 10966847 w 12191999"/>
              <a:gd name="connsiteY44" fmla="*/ 1142341 h 6105653"/>
              <a:gd name="connsiteX45" fmla="*/ 11074003 w 12191999"/>
              <a:gd name="connsiteY45" fmla="*/ 1084192 h 6105653"/>
              <a:gd name="connsiteX46" fmla="*/ 11181159 w 12191999"/>
              <a:gd name="connsiteY46" fmla="*/ 848688 h 6105653"/>
              <a:gd name="connsiteX47" fmla="*/ 11238309 w 12191999"/>
              <a:gd name="connsiteY47" fmla="*/ 805077 h 6105653"/>
              <a:gd name="connsiteX48" fmla="*/ 11266884 w 12191999"/>
              <a:gd name="connsiteY48" fmla="*/ 863226 h 6105653"/>
              <a:gd name="connsiteX49" fmla="*/ 11277600 w 12191999"/>
              <a:gd name="connsiteY49" fmla="*/ 906838 h 6105653"/>
              <a:gd name="connsiteX50" fmla="*/ 11724084 w 12191999"/>
              <a:gd name="connsiteY50" fmla="*/ 5527 h 6105653"/>
              <a:gd name="connsiteX51" fmla="*/ 11727656 w 12191999"/>
              <a:gd name="connsiteY51" fmla="*/ 209048 h 6105653"/>
              <a:gd name="connsiteX52" fmla="*/ 11656218 w 12191999"/>
              <a:gd name="connsiteY52" fmla="*/ 409663 h 6105653"/>
              <a:gd name="connsiteX53" fmla="*/ 11666934 w 12191999"/>
              <a:gd name="connsiteY53" fmla="*/ 621907 h 6105653"/>
              <a:gd name="connsiteX54" fmla="*/ 11631215 w 12191999"/>
              <a:gd name="connsiteY54" fmla="*/ 822521 h 6105653"/>
              <a:gd name="connsiteX55" fmla="*/ 11631215 w 12191999"/>
              <a:gd name="connsiteY55" fmla="*/ 996969 h 6105653"/>
              <a:gd name="connsiteX56" fmla="*/ 11684793 w 12191999"/>
              <a:gd name="connsiteY56" fmla="*/ 834151 h 6105653"/>
              <a:gd name="connsiteX57" fmla="*/ 11774090 w 12191999"/>
              <a:gd name="connsiteY57" fmla="*/ 773095 h 6105653"/>
              <a:gd name="connsiteX58" fmla="*/ 11856243 w 12191999"/>
              <a:gd name="connsiteY58" fmla="*/ 793447 h 6105653"/>
              <a:gd name="connsiteX59" fmla="*/ 11831240 w 12191999"/>
              <a:gd name="connsiteY59" fmla="*/ 860319 h 6105653"/>
              <a:gd name="connsiteX60" fmla="*/ 11738371 w 12191999"/>
              <a:gd name="connsiteY60" fmla="*/ 938820 h 6105653"/>
              <a:gd name="connsiteX61" fmla="*/ 11795521 w 12191999"/>
              <a:gd name="connsiteY61" fmla="*/ 956264 h 6105653"/>
              <a:gd name="connsiteX62" fmla="*/ 11838384 w 12191999"/>
              <a:gd name="connsiteY62" fmla="*/ 1002784 h 6105653"/>
              <a:gd name="connsiteX63" fmla="*/ 11816952 w 12191999"/>
              <a:gd name="connsiteY63" fmla="*/ 1270269 h 6105653"/>
              <a:gd name="connsiteX64" fmla="*/ 11999118 w 12191999"/>
              <a:gd name="connsiteY64" fmla="*/ 1092915 h 6105653"/>
              <a:gd name="connsiteX65" fmla="*/ 12027693 w 12191999"/>
              <a:gd name="connsiteY65" fmla="*/ 979524 h 6105653"/>
              <a:gd name="connsiteX66" fmla="*/ 12102703 w 12191999"/>
              <a:gd name="connsiteY66" fmla="*/ 953357 h 6105653"/>
              <a:gd name="connsiteX67" fmla="*/ 12120562 w 12191999"/>
              <a:gd name="connsiteY67" fmla="*/ 1005691 h 6105653"/>
              <a:gd name="connsiteX68" fmla="*/ 12056268 w 12191999"/>
              <a:gd name="connsiteY68" fmla="*/ 1267362 h 6105653"/>
              <a:gd name="connsiteX69" fmla="*/ 12081272 w 12191999"/>
              <a:gd name="connsiteY69" fmla="*/ 1310974 h 6105653"/>
              <a:gd name="connsiteX70" fmla="*/ 12191999 w 12191999"/>
              <a:gd name="connsiteY70" fmla="*/ 1008598 h 6105653"/>
              <a:gd name="connsiteX71" fmla="*/ 12191999 w 12191999"/>
              <a:gd name="connsiteY71" fmla="*/ 6105653 h 6105653"/>
              <a:gd name="connsiteX72" fmla="*/ 0 w 12191999"/>
              <a:gd name="connsiteY72" fmla="*/ 6105653 h 6105653"/>
              <a:gd name="connsiteX73" fmla="*/ 0 w 12191999"/>
              <a:gd name="connsiteY73" fmla="*/ 927116 h 6105653"/>
              <a:gd name="connsiteX74" fmla="*/ 61930 w 12191999"/>
              <a:gd name="connsiteY74" fmla="*/ 902578 h 6105653"/>
              <a:gd name="connsiteX75" fmla="*/ 155971 w 12191999"/>
              <a:gd name="connsiteY75" fmla="*/ 883588 h 6105653"/>
              <a:gd name="connsiteX76" fmla="*/ 277414 w 12191999"/>
              <a:gd name="connsiteY76" fmla="*/ 802179 h 6105653"/>
              <a:gd name="connsiteX77" fmla="*/ 638174 w 12191999"/>
              <a:gd name="connsiteY77" fmla="*/ 430025 h 6105653"/>
              <a:gd name="connsiteX78" fmla="*/ 477440 w 12191999"/>
              <a:gd name="connsiteY78" fmla="*/ 784735 h 6105653"/>
              <a:gd name="connsiteX79" fmla="*/ 827483 w 12191999"/>
              <a:gd name="connsiteY79" fmla="*/ 418395 h 6105653"/>
              <a:gd name="connsiteX80" fmla="*/ 956071 w 12191999"/>
              <a:gd name="connsiteY80" fmla="*/ 241040 h 6105653"/>
              <a:gd name="connsiteX81" fmla="*/ 999268 w 12191999"/>
              <a:gd name="connsiteY81" fmla="*/ 192386 h 6105653"/>
              <a:gd name="connsiteX82" fmla="*/ 1031080 w 12191999"/>
              <a:gd name="connsiteY82" fmla="*/ 197429 h 6105653"/>
              <a:gd name="connsiteX83" fmla="*/ 1048940 w 12191999"/>
              <a:gd name="connsiteY83" fmla="*/ 275930 h 6105653"/>
              <a:gd name="connsiteX84" fmla="*/ 1020365 w 12191999"/>
              <a:gd name="connsiteY84" fmla="*/ 517249 h 6105653"/>
              <a:gd name="connsiteX85" fmla="*/ 1256108 w 12191999"/>
              <a:gd name="connsiteY85" fmla="*/ 217780 h 6105653"/>
              <a:gd name="connsiteX86" fmla="*/ 1220389 w 12191999"/>
              <a:gd name="connsiteY86" fmla="*/ 441654 h 6105653"/>
              <a:gd name="connsiteX87" fmla="*/ 1313258 w 12191999"/>
              <a:gd name="connsiteY87" fmla="*/ 505619 h 6105653"/>
              <a:gd name="connsiteX88" fmla="*/ 1463277 w 12191999"/>
              <a:gd name="connsiteY88" fmla="*/ 610287 h 6105653"/>
              <a:gd name="connsiteX89" fmla="*/ 1545430 w 12191999"/>
              <a:gd name="connsiteY89" fmla="*/ 682974 h 6105653"/>
              <a:gd name="connsiteX90" fmla="*/ 1809749 w 12191999"/>
              <a:gd name="connsiteY90" fmla="*/ 712048 h 6105653"/>
              <a:gd name="connsiteX91" fmla="*/ 2099071 w 12191999"/>
              <a:gd name="connsiteY91" fmla="*/ 650992 h 6105653"/>
              <a:gd name="connsiteX92" fmla="*/ 2245518 w 12191999"/>
              <a:gd name="connsiteY92" fmla="*/ 482359 h 6105653"/>
              <a:gd name="connsiteX93" fmla="*/ 2409824 w 12191999"/>
              <a:gd name="connsiteY93" fmla="*/ 531786 h 6105653"/>
              <a:gd name="connsiteX94" fmla="*/ 2309812 w 12191999"/>
              <a:gd name="connsiteY94" fmla="*/ 889403 h 6105653"/>
              <a:gd name="connsiteX95" fmla="*/ 2699146 w 12191999"/>
              <a:gd name="connsiteY95" fmla="*/ 357339 h 6105653"/>
              <a:gd name="connsiteX96" fmla="*/ 2717006 w 12191999"/>
              <a:gd name="connsiteY96" fmla="*/ 447469 h 6105653"/>
              <a:gd name="connsiteX97" fmla="*/ 2938461 w 12191999"/>
              <a:gd name="connsiteY97" fmla="*/ 770197 h 6105653"/>
              <a:gd name="connsiteX98" fmla="*/ 2949178 w 12191999"/>
              <a:gd name="connsiteY98" fmla="*/ 787642 h 6105653"/>
              <a:gd name="connsiteX99" fmla="*/ 3088480 w 12191999"/>
              <a:gd name="connsiteY99" fmla="*/ 842883 h 6105653"/>
              <a:gd name="connsiteX100" fmla="*/ 3109911 w 12191999"/>
              <a:gd name="connsiteY100" fmla="*/ 1017331 h 6105653"/>
              <a:gd name="connsiteX101" fmla="*/ 3077765 w 12191999"/>
              <a:gd name="connsiteY101" fmla="*/ 1162704 h 6105653"/>
              <a:gd name="connsiteX102" fmla="*/ 3117055 w 12191999"/>
              <a:gd name="connsiteY102" fmla="*/ 1319707 h 6105653"/>
              <a:gd name="connsiteX103" fmla="*/ 3099196 w 12191999"/>
              <a:gd name="connsiteY103" fmla="*/ 1459264 h 6105653"/>
              <a:gd name="connsiteX104" fmla="*/ 3124198 w 12191999"/>
              <a:gd name="connsiteY104" fmla="*/ 1578470 h 6105653"/>
              <a:gd name="connsiteX105" fmla="*/ 3242071 w 12191999"/>
              <a:gd name="connsiteY105" fmla="*/ 1462171 h 6105653"/>
              <a:gd name="connsiteX106" fmla="*/ 3242071 w 12191999"/>
              <a:gd name="connsiteY106" fmla="*/ 1299354 h 6105653"/>
              <a:gd name="connsiteX107" fmla="*/ 3317080 w 12191999"/>
              <a:gd name="connsiteY107" fmla="*/ 1183056 h 6105653"/>
              <a:gd name="connsiteX108" fmla="*/ 3452811 w 12191999"/>
              <a:gd name="connsiteY108" fmla="*/ 1072572 h 6105653"/>
              <a:gd name="connsiteX109" fmla="*/ 3670696 w 12191999"/>
              <a:gd name="connsiteY109" fmla="*/ 682973 h 6105653"/>
              <a:gd name="connsiteX110" fmla="*/ 3752849 w 12191999"/>
              <a:gd name="connsiteY110" fmla="*/ 613194 h 6105653"/>
              <a:gd name="connsiteX111" fmla="*/ 3434952 w 12191999"/>
              <a:gd name="connsiteY111" fmla="*/ 1723843 h 6105653"/>
              <a:gd name="connsiteX112" fmla="*/ 3567111 w 12191999"/>
              <a:gd name="connsiteY112" fmla="*/ 1380763 h 6105653"/>
              <a:gd name="connsiteX113" fmla="*/ 3542109 w 12191999"/>
              <a:gd name="connsiteY113" fmla="*/ 1613360 h 6105653"/>
              <a:gd name="connsiteX114" fmla="*/ 3631405 w 12191999"/>
              <a:gd name="connsiteY114" fmla="*/ 1741287 h 6105653"/>
              <a:gd name="connsiteX115" fmla="*/ 3659980 w 12191999"/>
              <a:gd name="connsiteY115" fmla="*/ 1741287 h 6105653"/>
              <a:gd name="connsiteX116" fmla="*/ 3742133 w 12191999"/>
              <a:gd name="connsiteY116" fmla="*/ 1645341 h 6105653"/>
              <a:gd name="connsiteX117" fmla="*/ 3795712 w 12191999"/>
              <a:gd name="connsiteY117" fmla="*/ 1590100 h 6105653"/>
              <a:gd name="connsiteX118" fmla="*/ 3988593 w 12191999"/>
              <a:gd name="connsiteY118" fmla="*/ 1438912 h 6105653"/>
              <a:gd name="connsiteX119" fmla="*/ 4010024 w 12191999"/>
              <a:gd name="connsiteY119" fmla="*/ 1546488 h 6105653"/>
              <a:gd name="connsiteX120" fmla="*/ 4049315 w 12191999"/>
              <a:gd name="connsiteY120" fmla="*/ 1587192 h 6105653"/>
              <a:gd name="connsiteX121" fmla="*/ 4106465 w 12191999"/>
              <a:gd name="connsiteY121" fmla="*/ 1558118 h 6105653"/>
              <a:gd name="connsiteX122" fmla="*/ 4281487 w 12191999"/>
              <a:gd name="connsiteY122" fmla="*/ 1223760 h 6105653"/>
              <a:gd name="connsiteX123" fmla="*/ 4417219 w 12191999"/>
              <a:gd name="connsiteY123" fmla="*/ 1197593 h 6105653"/>
              <a:gd name="connsiteX124" fmla="*/ 4438649 w 12191999"/>
              <a:gd name="connsiteY124" fmla="*/ 1261557 h 6105653"/>
              <a:gd name="connsiteX125" fmla="*/ 4427935 w 12191999"/>
              <a:gd name="connsiteY125" fmla="*/ 1334243 h 6105653"/>
              <a:gd name="connsiteX126" fmla="*/ 4535090 w 12191999"/>
              <a:gd name="connsiteY126" fmla="*/ 1276094 h 6105653"/>
              <a:gd name="connsiteX127" fmla="*/ 4642246 w 12191999"/>
              <a:gd name="connsiteY127" fmla="*/ 1040590 h 6105653"/>
              <a:gd name="connsiteX128" fmla="*/ 4699396 w 12191999"/>
              <a:gd name="connsiteY128" fmla="*/ 996979 h 6105653"/>
              <a:gd name="connsiteX129" fmla="*/ 4727971 w 12191999"/>
              <a:gd name="connsiteY129" fmla="*/ 1055128 h 6105653"/>
              <a:gd name="connsiteX130" fmla="*/ 4738688 w 12191999"/>
              <a:gd name="connsiteY130" fmla="*/ 1098740 h 6105653"/>
              <a:gd name="connsiteX131" fmla="*/ 5185172 w 12191999"/>
              <a:gd name="connsiteY131" fmla="*/ 197429 h 6105653"/>
              <a:gd name="connsiteX132" fmla="*/ 5188744 w 12191999"/>
              <a:gd name="connsiteY132" fmla="*/ 400950 h 6105653"/>
              <a:gd name="connsiteX133" fmla="*/ 5117306 w 12191999"/>
              <a:gd name="connsiteY133" fmla="*/ 601565 h 6105653"/>
              <a:gd name="connsiteX134" fmla="*/ 5128021 w 12191999"/>
              <a:gd name="connsiteY134" fmla="*/ 813809 h 6105653"/>
              <a:gd name="connsiteX135" fmla="*/ 5092302 w 12191999"/>
              <a:gd name="connsiteY135" fmla="*/ 1014423 h 6105653"/>
              <a:gd name="connsiteX136" fmla="*/ 5092302 w 12191999"/>
              <a:gd name="connsiteY136" fmla="*/ 1188871 h 6105653"/>
              <a:gd name="connsiteX137" fmla="*/ 5145880 w 12191999"/>
              <a:gd name="connsiteY137" fmla="*/ 1026053 h 6105653"/>
              <a:gd name="connsiteX138" fmla="*/ 5235177 w 12191999"/>
              <a:gd name="connsiteY138" fmla="*/ 964997 h 6105653"/>
              <a:gd name="connsiteX139" fmla="*/ 5317331 w 12191999"/>
              <a:gd name="connsiteY139" fmla="*/ 985349 h 6105653"/>
              <a:gd name="connsiteX140" fmla="*/ 5292327 w 12191999"/>
              <a:gd name="connsiteY140" fmla="*/ 1052221 h 6105653"/>
              <a:gd name="connsiteX141" fmla="*/ 5199458 w 12191999"/>
              <a:gd name="connsiteY141" fmla="*/ 1130722 h 6105653"/>
              <a:gd name="connsiteX142" fmla="*/ 5256608 w 12191999"/>
              <a:gd name="connsiteY142" fmla="*/ 1148166 h 6105653"/>
              <a:gd name="connsiteX143" fmla="*/ 5299471 w 12191999"/>
              <a:gd name="connsiteY143" fmla="*/ 1194686 h 6105653"/>
              <a:gd name="connsiteX144" fmla="*/ 5278039 w 12191999"/>
              <a:gd name="connsiteY144" fmla="*/ 1462171 h 6105653"/>
              <a:gd name="connsiteX145" fmla="*/ 5460205 w 12191999"/>
              <a:gd name="connsiteY145" fmla="*/ 1284817 h 6105653"/>
              <a:gd name="connsiteX146" fmla="*/ 5488780 w 12191999"/>
              <a:gd name="connsiteY146" fmla="*/ 1171426 h 6105653"/>
              <a:gd name="connsiteX147" fmla="*/ 5539513 w 12191999"/>
              <a:gd name="connsiteY147" fmla="*/ 1140353 h 6105653"/>
              <a:gd name="connsiteX148" fmla="*/ 5552720 w 12191999"/>
              <a:gd name="connsiteY148" fmla="*/ 1143022 h 6105653"/>
              <a:gd name="connsiteX149" fmla="*/ 5574208 w 12191999"/>
              <a:gd name="connsiteY149" fmla="*/ 1115811 h 6105653"/>
              <a:gd name="connsiteX150" fmla="*/ 5734050 w 12191999"/>
              <a:gd name="connsiteY150" fmla="*/ 1075470 h 6105653"/>
              <a:gd name="connsiteX151" fmla="*/ 5798343 w 12191999"/>
              <a:gd name="connsiteY151" fmla="*/ 1020228 h 6105653"/>
              <a:gd name="connsiteX152" fmla="*/ 5884068 w 12191999"/>
              <a:gd name="connsiteY152" fmla="*/ 883578 h 6105653"/>
              <a:gd name="connsiteX153" fmla="*/ 6066234 w 12191999"/>
              <a:gd name="connsiteY153" fmla="*/ 645166 h 6105653"/>
              <a:gd name="connsiteX154" fmla="*/ 6109096 w 12191999"/>
              <a:gd name="connsiteY154" fmla="*/ 732391 h 6105653"/>
              <a:gd name="connsiteX155" fmla="*/ 5998368 w 12191999"/>
              <a:gd name="connsiteY155" fmla="*/ 985338 h 6105653"/>
              <a:gd name="connsiteX156" fmla="*/ 5969793 w 12191999"/>
              <a:gd name="connsiteY156" fmla="*/ 1168509 h 6105653"/>
              <a:gd name="connsiteX157" fmla="*/ 6162674 w 12191999"/>
              <a:gd name="connsiteY157" fmla="*/ 909745 h 6105653"/>
              <a:gd name="connsiteX158" fmla="*/ 6412705 w 12191999"/>
              <a:gd name="connsiteY158" fmla="*/ 659704 h 6105653"/>
              <a:gd name="connsiteX159" fmla="*/ 6366271 w 12191999"/>
              <a:gd name="connsiteY159" fmla="*/ 851596 h 6105653"/>
              <a:gd name="connsiteX160" fmla="*/ 6398418 w 12191999"/>
              <a:gd name="connsiteY160" fmla="*/ 860319 h 6105653"/>
              <a:gd name="connsiteX161" fmla="*/ 6694884 w 12191999"/>
              <a:gd name="connsiteY161" fmla="*/ 691686 h 6105653"/>
              <a:gd name="connsiteX162" fmla="*/ 6816327 w 12191999"/>
              <a:gd name="connsiteY162" fmla="*/ 610277 h 6105653"/>
              <a:gd name="connsiteX163" fmla="*/ 7177087 w 12191999"/>
              <a:gd name="connsiteY163" fmla="*/ 238123 h 6105653"/>
              <a:gd name="connsiteX164" fmla="*/ 7016353 w 12191999"/>
              <a:gd name="connsiteY164" fmla="*/ 592833 h 6105653"/>
              <a:gd name="connsiteX165" fmla="*/ 7366396 w 12191999"/>
              <a:gd name="connsiteY165" fmla="*/ 226493 h 6105653"/>
              <a:gd name="connsiteX166" fmla="*/ 7494984 w 12191999"/>
              <a:gd name="connsiteY166" fmla="*/ 49138 h 6105653"/>
              <a:gd name="connsiteX167" fmla="*/ 7538181 w 12191999"/>
              <a:gd name="connsiteY167" fmla="*/ 484 h 610565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Lst>
            <a:rect l="l" t="t" r="r" b="b"/>
            <a:pathLst>
              <a:path w="12191999" h="6105653">
                <a:moveTo>
                  <a:pt x="7538181" y="484"/>
                </a:moveTo>
                <a:cubicBezTo>
                  <a:pt x="7546999" y="-833"/>
                  <a:pt x="7557492" y="439"/>
                  <a:pt x="7569993" y="5527"/>
                </a:cubicBezTo>
                <a:cubicBezTo>
                  <a:pt x="7612855" y="22971"/>
                  <a:pt x="7598567" y="54953"/>
                  <a:pt x="7587853" y="84028"/>
                </a:cubicBezTo>
                <a:cubicBezTo>
                  <a:pt x="7559278" y="153806"/>
                  <a:pt x="7559278" y="229401"/>
                  <a:pt x="7559278" y="325347"/>
                </a:cubicBezTo>
                <a:cubicBezTo>
                  <a:pt x="7695009" y="243938"/>
                  <a:pt x="7652146" y="95658"/>
                  <a:pt x="7795021" y="25878"/>
                </a:cubicBezTo>
                <a:cubicBezTo>
                  <a:pt x="7820024" y="113102"/>
                  <a:pt x="7770018" y="179974"/>
                  <a:pt x="7759302" y="249752"/>
                </a:cubicBezTo>
                <a:cubicBezTo>
                  <a:pt x="7748587" y="313717"/>
                  <a:pt x="7773590" y="328254"/>
                  <a:pt x="7852171" y="313717"/>
                </a:cubicBezTo>
                <a:cubicBezTo>
                  <a:pt x="7973615" y="290457"/>
                  <a:pt x="8034337" y="325347"/>
                  <a:pt x="8002190" y="418385"/>
                </a:cubicBezTo>
                <a:cubicBezTo>
                  <a:pt x="7970043" y="505609"/>
                  <a:pt x="8016478" y="514331"/>
                  <a:pt x="8084343" y="491072"/>
                </a:cubicBezTo>
                <a:cubicBezTo>
                  <a:pt x="8184355" y="456182"/>
                  <a:pt x="8262937" y="493979"/>
                  <a:pt x="8348662" y="520146"/>
                </a:cubicBezTo>
                <a:cubicBezTo>
                  <a:pt x="8477249" y="560851"/>
                  <a:pt x="8541543" y="543406"/>
                  <a:pt x="8637984" y="459090"/>
                </a:cubicBezTo>
                <a:cubicBezTo>
                  <a:pt x="8691561" y="409663"/>
                  <a:pt x="8737996" y="360236"/>
                  <a:pt x="8784431" y="290457"/>
                </a:cubicBezTo>
                <a:cubicBezTo>
                  <a:pt x="8809434" y="450367"/>
                  <a:pt x="8895158" y="284642"/>
                  <a:pt x="8948737" y="339884"/>
                </a:cubicBezTo>
                <a:cubicBezTo>
                  <a:pt x="8970168" y="453274"/>
                  <a:pt x="8798717" y="543406"/>
                  <a:pt x="8848725" y="697501"/>
                </a:cubicBezTo>
                <a:cubicBezTo>
                  <a:pt x="8995171" y="511424"/>
                  <a:pt x="9041606" y="302087"/>
                  <a:pt x="9238059" y="165437"/>
                </a:cubicBezTo>
                <a:cubicBezTo>
                  <a:pt x="9280921" y="197419"/>
                  <a:pt x="9238059" y="229401"/>
                  <a:pt x="9255919" y="255567"/>
                </a:cubicBezTo>
                <a:cubicBezTo>
                  <a:pt x="9266634" y="255567"/>
                  <a:pt x="9198767" y="560851"/>
                  <a:pt x="9477374" y="578295"/>
                </a:cubicBezTo>
                <a:cubicBezTo>
                  <a:pt x="9477374" y="584110"/>
                  <a:pt x="9477374" y="589925"/>
                  <a:pt x="9488091" y="595740"/>
                </a:cubicBezTo>
                <a:cubicBezTo>
                  <a:pt x="9527380" y="627722"/>
                  <a:pt x="9620249" y="598648"/>
                  <a:pt x="9627393" y="650981"/>
                </a:cubicBezTo>
                <a:cubicBezTo>
                  <a:pt x="9634537" y="709131"/>
                  <a:pt x="9666684" y="764373"/>
                  <a:pt x="9648824" y="825429"/>
                </a:cubicBezTo>
                <a:cubicBezTo>
                  <a:pt x="9634537" y="871948"/>
                  <a:pt x="9616678" y="921374"/>
                  <a:pt x="9616678" y="970802"/>
                </a:cubicBezTo>
                <a:cubicBezTo>
                  <a:pt x="9616678" y="1023136"/>
                  <a:pt x="9495233" y="1095822"/>
                  <a:pt x="9655968" y="1127805"/>
                </a:cubicBezTo>
                <a:cubicBezTo>
                  <a:pt x="9663111" y="1127805"/>
                  <a:pt x="9645252" y="1217935"/>
                  <a:pt x="9638109" y="1267362"/>
                </a:cubicBezTo>
                <a:cubicBezTo>
                  <a:pt x="9630965" y="1308066"/>
                  <a:pt x="9598818" y="1357494"/>
                  <a:pt x="9663111" y="1386568"/>
                </a:cubicBezTo>
                <a:cubicBezTo>
                  <a:pt x="9702403" y="1401105"/>
                  <a:pt x="9773840" y="1331326"/>
                  <a:pt x="9780984" y="1270269"/>
                </a:cubicBezTo>
                <a:cubicBezTo>
                  <a:pt x="9788127" y="1215028"/>
                  <a:pt x="9795271" y="1159787"/>
                  <a:pt x="9780984" y="1107452"/>
                </a:cubicBezTo>
                <a:cubicBezTo>
                  <a:pt x="9763125" y="1043488"/>
                  <a:pt x="9791699" y="1008598"/>
                  <a:pt x="9855993" y="991154"/>
                </a:cubicBezTo>
                <a:cubicBezTo>
                  <a:pt x="9923858" y="970802"/>
                  <a:pt x="9959577" y="933005"/>
                  <a:pt x="9991724" y="880670"/>
                </a:cubicBezTo>
                <a:cubicBezTo>
                  <a:pt x="10070305" y="752742"/>
                  <a:pt x="10163174" y="630630"/>
                  <a:pt x="10209609" y="491071"/>
                </a:cubicBezTo>
                <a:cubicBezTo>
                  <a:pt x="10216753" y="464905"/>
                  <a:pt x="10231040" y="432923"/>
                  <a:pt x="10291762" y="421292"/>
                </a:cubicBezTo>
                <a:cubicBezTo>
                  <a:pt x="10198893" y="799262"/>
                  <a:pt x="9959577" y="1142341"/>
                  <a:pt x="9973865" y="1531941"/>
                </a:cubicBezTo>
                <a:cubicBezTo>
                  <a:pt x="10048874" y="1427272"/>
                  <a:pt x="10052446" y="1302252"/>
                  <a:pt x="10106024" y="1188861"/>
                </a:cubicBezTo>
                <a:cubicBezTo>
                  <a:pt x="10145315" y="1270269"/>
                  <a:pt x="10102453" y="1345863"/>
                  <a:pt x="10081022" y="1421458"/>
                </a:cubicBezTo>
                <a:cubicBezTo>
                  <a:pt x="10063162" y="1485421"/>
                  <a:pt x="10059590" y="1543570"/>
                  <a:pt x="10170318" y="1549385"/>
                </a:cubicBezTo>
                <a:cubicBezTo>
                  <a:pt x="10181034" y="1549385"/>
                  <a:pt x="10188178" y="1549385"/>
                  <a:pt x="10198893" y="1549385"/>
                </a:cubicBezTo>
                <a:cubicBezTo>
                  <a:pt x="10245327" y="1526126"/>
                  <a:pt x="10266759" y="1494144"/>
                  <a:pt x="10281046" y="1453439"/>
                </a:cubicBezTo>
                <a:cubicBezTo>
                  <a:pt x="10288190" y="1430180"/>
                  <a:pt x="10302477" y="1398198"/>
                  <a:pt x="10334625" y="1398198"/>
                </a:cubicBezTo>
                <a:cubicBezTo>
                  <a:pt x="10456068" y="1401105"/>
                  <a:pt x="10491787" y="1322604"/>
                  <a:pt x="10527506" y="1247010"/>
                </a:cubicBezTo>
                <a:cubicBezTo>
                  <a:pt x="10588228" y="1287714"/>
                  <a:pt x="10545365" y="1322604"/>
                  <a:pt x="10548937" y="1354586"/>
                </a:cubicBezTo>
                <a:cubicBezTo>
                  <a:pt x="10552509" y="1374938"/>
                  <a:pt x="10556080" y="1395290"/>
                  <a:pt x="10588228" y="1395290"/>
                </a:cubicBezTo>
                <a:cubicBezTo>
                  <a:pt x="10613230" y="1395290"/>
                  <a:pt x="10645378" y="1386568"/>
                  <a:pt x="10645378" y="1366216"/>
                </a:cubicBezTo>
                <a:cubicBezTo>
                  <a:pt x="10648949" y="1238288"/>
                  <a:pt x="10820400" y="1165601"/>
                  <a:pt x="10820400" y="1031858"/>
                </a:cubicBezTo>
                <a:cubicBezTo>
                  <a:pt x="10820400" y="950449"/>
                  <a:pt x="10916840" y="1072563"/>
                  <a:pt x="10956131" y="1005691"/>
                </a:cubicBezTo>
                <a:cubicBezTo>
                  <a:pt x="10966847" y="991154"/>
                  <a:pt x="10981133" y="1046395"/>
                  <a:pt x="10977562" y="1069655"/>
                </a:cubicBezTo>
                <a:cubicBezTo>
                  <a:pt x="10973991" y="1092915"/>
                  <a:pt x="10948987" y="1113267"/>
                  <a:pt x="10966847" y="1142341"/>
                </a:cubicBezTo>
                <a:cubicBezTo>
                  <a:pt x="11031140" y="1156879"/>
                  <a:pt x="11056143" y="1119081"/>
                  <a:pt x="11074003" y="1084192"/>
                </a:cubicBezTo>
                <a:cubicBezTo>
                  <a:pt x="11116865" y="1008598"/>
                  <a:pt x="11166871" y="933005"/>
                  <a:pt x="11181159" y="848688"/>
                </a:cubicBezTo>
                <a:cubicBezTo>
                  <a:pt x="11184730" y="819614"/>
                  <a:pt x="11202590" y="802169"/>
                  <a:pt x="11238309" y="805077"/>
                </a:cubicBezTo>
                <a:cubicBezTo>
                  <a:pt x="11284744" y="810891"/>
                  <a:pt x="11270456" y="839966"/>
                  <a:pt x="11266884" y="863226"/>
                </a:cubicBezTo>
                <a:cubicBezTo>
                  <a:pt x="11263312" y="877763"/>
                  <a:pt x="11252596" y="892300"/>
                  <a:pt x="11277600" y="906838"/>
                </a:cubicBezTo>
                <a:cubicBezTo>
                  <a:pt x="11531203" y="566666"/>
                  <a:pt x="11516915" y="386403"/>
                  <a:pt x="11724084" y="5527"/>
                </a:cubicBezTo>
                <a:cubicBezTo>
                  <a:pt x="11763375" y="89842"/>
                  <a:pt x="11734800" y="150899"/>
                  <a:pt x="11727656" y="209048"/>
                </a:cubicBezTo>
                <a:cubicBezTo>
                  <a:pt x="11709796" y="354421"/>
                  <a:pt x="11677649" y="264290"/>
                  <a:pt x="11656218" y="409663"/>
                </a:cubicBezTo>
                <a:cubicBezTo>
                  <a:pt x="11645503" y="479442"/>
                  <a:pt x="11609784" y="543406"/>
                  <a:pt x="11666934" y="621907"/>
                </a:cubicBezTo>
                <a:cubicBezTo>
                  <a:pt x="11706225" y="674241"/>
                  <a:pt x="11663362" y="758557"/>
                  <a:pt x="11631215" y="822521"/>
                </a:cubicBezTo>
                <a:cubicBezTo>
                  <a:pt x="11602640" y="874856"/>
                  <a:pt x="11595497" y="927190"/>
                  <a:pt x="11631215" y="996969"/>
                </a:cubicBezTo>
                <a:cubicBezTo>
                  <a:pt x="11652646" y="933005"/>
                  <a:pt x="11670505" y="883578"/>
                  <a:pt x="11684793" y="834151"/>
                </a:cubicBezTo>
                <a:cubicBezTo>
                  <a:pt x="11695509" y="793447"/>
                  <a:pt x="11720512" y="770187"/>
                  <a:pt x="11774090" y="773095"/>
                </a:cubicBezTo>
                <a:cubicBezTo>
                  <a:pt x="11802665" y="773095"/>
                  <a:pt x="11841956" y="764373"/>
                  <a:pt x="11856243" y="793447"/>
                </a:cubicBezTo>
                <a:cubicBezTo>
                  <a:pt x="11870531" y="816706"/>
                  <a:pt x="11856243" y="848688"/>
                  <a:pt x="11831240" y="860319"/>
                </a:cubicBezTo>
                <a:cubicBezTo>
                  <a:pt x="11784806" y="874856"/>
                  <a:pt x="11741944" y="889393"/>
                  <a:pt x="11738371" y="938820"/>
                </a:cubicBezTo>
                <a:cubicBezTo>
                  <a:pt x="11731228" y="1005691"/>
                  <a:pt x="11759802" y="967894"/>
                  <a:pt x="11795521" y="956264"/>
                </a:cubicBezTo>
                <a:cubicBezTo>
                  <a:pt x="11834812" y="944634"/>
                  <a:pt x="11845527" y="979524"/>
                  <a:pt x="11838384" y="1002784"/>
                </a:cubicBezTo>
                <a:cubicBezTo>
                  <a:pt x="11806237" y="1090007"/>
                  <a:pt x="11863387" y="1180138"/>
                  <a:pt x="11816952" y="1270269"/>
                </a:cubicBezTo>
                <a:cubicBezTo>
                  <a:pt x="11931252" y="1247010"/>
                  <a:pt x="11981259" y="1197583"/>
                  <a:pt x="11999118" y="1092915"/>
                </a:cubicBezTo>
                <a:cubicBezTo>
                  <a:pt x="12002690" y="1055118"/>
                  <a:pt x="11995547" y="1014413"/>
                  <a:pt x="12027693" y="979524"/>
                </a:cubicBezTo>
                <a:cubicBezTo>
                  <a:pt x="12045553" y="959172"/>
                  <a:pt x="12066984" y="938820"/>
                  <a:pt x="12102703" y="953357"/>
                </a:cubicBezTo>
                <a:cubicBezTo>
                  <a:pt x="12127705" y="962080"/>
                  <a:pt x="12127705" y="985338"/>
                  <a:pt x="12120562" y="1005691"/>
                </a:cubicBezTo>
                <a:cubicBezTo>
                  <a:pt x="12081272" y="1090007"/>
                  <a:pt x="12070555" y="1180138"/>
                  <a:pt x="12056268" y="1267362"/>
                </a:cubicBezTo>
                <a:cubicBezTo>
                  <a:pt x="12052697" y="1281899"/>
                  <a:pt x="12045553" y="1296437"/>
                  <a:pt x="12081272" y="1310974"/>
                </a:cubicBezTo>
                <a:cubicBezTo>
                  <a:pt x="12113418" y="1209213"/>
                  <a:pt x="12156280" y="1110359"/>
                  <a:pt x="12191999" y="1008598"/>
                </a:cubicBezTo>
                <a:lnTo>
                  <a:pt x="12191999" y="6105653"/>
                </a:lnTo>
                <a:lnTo>
                  <a:pt x="0" y="6105653"/>
                </a:lnTo>
                <a:lnTo>
                  <a:pt x="0" y="927116"/>
                </a:lnTo>
                <a:lnTo>
                  <a:pt x="61930" y="902578"/>
                </a:lnTo>
                <a:cubicBezTo>
                  <a:pt x="91454" y="894128"/>
                  <a:pt x="122931" y="887949"/>
                  <a:pt x="155971" y="883588"/>
                </a:cubicBezTo>
                <a:cubicBezTo>
                  <a:pt x="223837" y="877773"/>
                  <a:pt x="245268" y="839976"/>
                  <a:pt x="277414" y="802179"/>
                </a:cubicBezTo>
                <a:cubicBezTo>
                  <a:pt x="388143" y="674251"/>
                  <a:pt x="488155" y="537601"/>
                  <a:pt x="638174" y="430025"/>
                </a:cubicBezTo>
                <a:cubicBezTo>
                  <a:pt x="620315" y="555046"/>
                  <a:pt x="520302" y="653899"/>
                  <a:pt x="477440" y="784735"/>
                </a:cubicBezTo>
                <a:cubicBezTo>
                  <a:pt x="641746" y="680066"/>
                  <a:pt x="727471" y="543415"/>
                  <a:pt x="827483" y="418395"/>
                </a:cubicBezTo>
                <a:cubicBezTo>
                  <a:pt x="873917" y="360246"/>
                  <a:pt x="931068" y="307912"/>
                  <a:pt x="956071" y="241040"/>
                </a:cubicBezTo>
                <a:cubicBezTo>
                  <a:pt x="961429" y="223595"/>
                  <a:pt x="972814" y="196338"/>
                  <a:pt x="999268" y="192386"/>
                </a:cubicBezTo>
                <a:cubicBezTo>
                  <a:pt x="1008086" y="191069"/>
                  <a:pt x="1018579" y="192341"/>
                  <a:pt x="1031080" y="197429"/>
                </a:cubicBezTo>
                <a:cubicBezTo>
                  <a:pt x="1073942" y="214873"/>
                  <a:pt x="1059654" y="246855"/>
                  <a:pt x="1048940" y="275930"/>
                </a:cubicBezTo>
                <a:cubicBezTo>
                  <a:pt x="1020365" y="345708"/>
                  <a:pt x="1020365" y="421303"/>
                  <a:pt x="1020365" y="517249"/>
                </a:cubicBezTo>
                <a:cubicBezTo>
                  <a:pt x="1156096" y="435840"/>
                  <a:pt x="1113233" y="287560"/>
                  <a:pt x="1256108" y="217780"/>
                </a:cubicBezTo>
                <a:cubicBezTo>
                  <a:pt x="1281111" y="305004"/>
                  <a:pt x="1231105" y="371876"/>
                  <a:pt x="1220389" y="441654"/>
                </a:cubicBezTo>
                <a:cubicBezTo>
                  <a:pt x="1209674" y="505619"/>
                  <a:pt x="1234677" y="520156"/>
                  <a:pt x="1313258" y="505619"/>
                </a:cubicBezTo>
                <a:cubicBezTo>
                  <a:pt x="1434702" y="482359"/>
                  <a:pt x="1495424" y="517249"/>
                  <a:pt x="1463277" y="610287"/>
                </a:cubicBezTo>
                <a:cubicBezTo>
                  <a:pt x="1431130" y="697511"/>
                  <a:pt x="1477565" y="706233"/>
                  <a:pt x="1545430" y="682974"/>
                </a:cubicBezTo>
                <a:cubicBezTo>
                  <a:pt x="1645442" y="648084"/>
                  <a:pt x="1724024" y="685881"/>
                  <a:pt x="1809749" y="712048"/>
                </a:cubicBezTo>
                <a:cubicBezTo>
                  <a:pt x="1938336" y="752753"/>
                  <a:pt x="2002630" y="735308"/>
                  <a:pt x="2099071" y="650992"/>
                </a:cubicBezTo>
                <a:cubicBezTo>
                  <a:pt x="2152648" y="601565"/>
                  <a:pt x="2199083" y="552138"/>
                  <a:pt x="2245518" y="482359"/>
                </a:cubicBezTo>
                <a:cubicBezTo>
                  <a:pt x="2270521" y="642269"/>
                  <a:pt x="2356245" y="476544"/>
                  <a:pt x="2409824" y="531786"/>
                </a:cubicBezTo>
                <a:cubicBezTo>
                  <a:pt x="2431255" y="645176"/>
                  <a:pt x="2259804" y="735308"/>
                  <a:pt x="2309812" y="889403"/>
                </a:cubicBezTo>
                <a:cubicBezTo>
                  <a:pt x="2456258" y="703326"/>
                  <a:pt x="2502693" y="493989"/>
                  <a:pt x="2699146" y="357339"/>
                </a:cubicBezTo>
                <a:cubicBezTo>
                  <a:pt x="2742008" y="389321"/>
                  <a:pt x="2699146" y="421303"/>
                  <a:pt x="2717006" y="447469"/>
                </a:cubicBezTo>
                <a:cubicBezTo>
                  <a:pt x="2727721" y="447469"/>
                  <a:pt x="2659854" y="752753"/>
                  <a:pt x="2938461" y="770197"/>
                </a:cubicBezTo>
                <a:cubicBezTo>
                  <a:pt x="2938461" y="776012"/>
                  <a:pt x="2938461" y="781827"/>
                  <a:pt x="2949178" y="787642"/>
                </a:cubicBezTo>
                <a:cubicBezTo>
                  <a:pt x="2988467" y="819624"/>
                  <a:pt x="3081336" y="790550"/>
                  <a:pt x="3088480" y="842883"/>
                </a:cubicBezTo>
                <a:cubicBezTo>
                  <a:pt x="3095624" y="901033"/>
                  <a:pt x="3127771" y="956275"/>
                  <a:pt x="3109911" y="1017331"/>
                </a:cubicBezTo>
                <a:cubicBezTo>
                  <a:pt x="3095624" y="1063850"/>
                  <a:pt x="3077765" y="1113276"/>
                  <a:pt x="3077765" y="1162704"/>
                </a:cubicBezTo>
                <a:cubicBezTo>
                  <a:pt x="3077765" y="1215038"/>
                  <a:pt x="2956320" y="1287724"/>
                  <a:pt x="3117055" y="1319707"/>
                </a:cubicBezTo>
                <a:cubicBezTo>
                  <a:pt x="3124198" y="1319707"/>
                  <a:pt x="3106339" y="1409837"/>
                  <a:pt x="3099196" y="1459264"/>
                </a:cubicBezTo>
                <a:cubicBezTo>
                  <a:pt x="3092052" y="1499968"/>
                  <a:pt x="3059905" y="1549396"/>
                  <a:pt x="3124198" y="1578470"/>
                </a:cubicBezTo>
                <a:cubicBezTo>
                  <a:pt x="3163490" y="1593007"/>
                  <a:pt x="3234927" y="1523228"/>
                  <a:pt x="3242071" y="1462171"/>
                </a:cubicBezTo>
                <a:cubicBezTo>
                  <a:pt x="3249214" y="1406930"/>
                  <a:pt x="3256358" y="1351689"/>
                  <a:pt x="3242071" y="1299354"/>
                </a:cubicBezTo>
                <a:cubicBezTo>
                  <a:pt x="3224212" y="1235390"/>
                  <a:pt x="3252786" y="1200500"/>
                  <a:pt x="3317080" y="1183056"/>
                </a:cubicBezTo>
                <a:cubicBezTo>
                  <a:pt x="3384945" y="1162704"/>
                  <a:pt x="3420664" y="1124907"/>
                  <a:pt x="3452811" y="1072572"/>
                </a:cubicBezTo>
                <a:cubicBezTo>
                  <a:pt x="3531392" y="944644"/>
                  <a:pt x="3624261" y="822532"/>
                  <a:pt x="3670696" y="682973"/>
                </a:cubicBezTo>
                <a:cubicBezTo>
                  <a:pt x="3677840" y="656807"/>
                  <a:pt x="3692127" y="624825"/>
                  <a:pt x="3752849" y="613194"/>
                </a:cubicBezTo>
                <a:cubicBezTo>
                  <a:pt x="3659980" y="991164"/>
                  <a:pt x="3420664" y="1334243"/>
                  <a:pt x="3434952" y="1723843"/>
                </a:cubicBezTo>
                <a:cubicBezTo>
                  <a:pt x="3509961" y="1619174"/>
                  <a:pt x="3513533" y="1494154"/>
                  <a:pt x="3567111" y="1380763"/>
                </a:cubicBezTo>
                <a:cubicBezTo>
                  <a:pt x="3606402" y="1462171"/>
                  <a:pt x="3563540" y="1537765"/>
                  <a:pt x="3542109" y="1613360"/>
                </a:cubicBezTo>
                <a:cubicBezTo>
                  <a:pt x="3524249" y="1677323"/>
                  <a:pt x="3520677" y="1735472"/>
                  <a:pt x="3631405" y="1741287"/>
                </a:cubicBezTo>
                <a:cubicBezTo>
                  <a:pt x="3642121" y="1741287"/>
                  <a:pt x="3649265" y="1741287"/>
                  <a:pt x="3659980" y="1741287"/>
                </a:cubicBezTo>
                <a:cubicBezTo>
                  <a:pt x="3706414" y="1718028"/>
                  <a:pt x="3727846" y="1686046"/>
                  <a:pt x="3742133" y="1645341"/>
                </a:cubicBezTo>
                <a:cubicBezTo>
                  <a:pt x="3749277" y="1622082"/>
                  <a:pt x="3763564" y="1590100"/>
                  <a:pt x="3795712" y="1590100"/>
                </a:cubicBezTo>
                <a:cubicBezTo>
                  <a:pt x="3917155" y="1593007"/>
                  <a:pt x="3952874" y="1514506"/>
                  <a:pt x="3988593" y="1438912"/>
                </a:cubicBezTo>
                <a:cubicBezTo>
                  <a:pt x="4049315" y="1479616"/>
                  <a:pt x="4006452" y="1514506"/>
                  <a:pt x="4010024" y="1546488"/>
                </a:cubicBezTo>
                <a:cubicBezTo>
                  <a:pt x="4013596" y="1566840"/>
                  <a:pt x="4017167" y="1587192"/>
                  <a:pt x="4049315" y="1587192"/>
                </a:cubicBezTo>
                <a:cubicBezTo>
                  <a:pt x="4074317" y="1587192"/>
                  <a:pt x="4106465" y="1578470"/>
                  <a:pt x="4106465" y="1558118"/>
                </a:cubicBezTo>
                <a:cubicBezTo>
                  <a:pt x="4110036" y="1430190"/>
                  <a:pt x="4281487" y="1357503"/>
                  <a:pt x="4281487" y="1223760"/>
                </a:cubicBezTo>
                <a:cubicBezTo>
                  <a:pt x="4281487" y="1142351"/>
                  <a:pt x="4377927" y="1264465"/>
                  <a:pt x="4417219" y="1197593"/>
                </a:cubicBezTo>
                <a:cubicBezTo>
                  <a:pt x="4427935" y="1183056"/>
                  <a:pt x="4442220" y="1238297"/>
                  <a:pt x="4438649" y="1261557"/>
                </a:cubicBezTo>
                <a:cubicBezTo>
                  <a:pt x="4435078" y="1284817"/>
                  <a:pt x="4410074" y="1305169"/>
                  <a:pt x="4427935" y="1334243"/>
                </a:cubicBezTo>
                <a:cubicBezTo>
                  <a:pt x="4492228" y="1348781"/>
                  <a:pt x="4517230" y="1310983"/>
                  <a:pt x="4535090" y="1276094"/>
                </a:cubicBezTo>
                <a:cubicBezTo>
                  <a:pt x="4577952" y="1200500"/>
                  <a:pt x="4627958" y="1124907"/>
                  <a:pt x="4642246" y="1040590"/>
                </a:cubicBezTo>
                <a:cubicBezTo>
                  <a:pt x="4645817" y="1011516"/>
                  <a:pt x="4663677" y="994071"/>
                  <a:pt x="4699396" y="996979"/>
                </a:cubicBezTo>
                <a:cubicBezTo>
                  <a:pt x="4745832" y="1002793"/>
                  <a:pt x="4731544" y="1031868"/>
                  <a:pt x="4727971" y="1055128"/>
                </a:cubicBezTo>
                <a:cubicBezTo>
                  <a:pt x="4724399" y="1069665"/>
                  <a:pt x="4713683" y="1084202"/>
                  <a:pt x="4738688" y="1098740"/>
                </a:cubicBezTo>
                <a:cubicBezTo>
                  <a:pt x="4992291" y="758568"/>
                  <a:pt x="4978002" y="578305"/>
                  <a:pt x="5185172" y="197429"/>
                </a:cubicBezTo>
                <a:cubicBezTo>
                  <a:pt x="5224462" y="281744"/>
                  <a:pt x="5195887" y="342801"/>
                  <a:pt x="5188744" y="400950"/>
                </a:cubicBezTo>
                <a:cubicBezTo>
                  <a:pt x="5170883" y="546323"/>
                  <a:pt x="5138736" y="456192"/>
                  <a:pt x="5117306" y="601565"/>
                </a:cubicBezTo>
                <a:cubicBezTo>
                  <a:pt x="5106590" y="671344"/>
                  <a:pt x="5070871" y="735308"/>
                  <a:pt x="5128021" y="813809"/>
                </a:cubicBezTo>
                <a:cubicBezTo>
                  <a:pt x="5167312" y="866143"/>
                  <a:pt x="5124450" y="950459"/>
                  <a:pt x="5092302" y="1014423"/>
                </a:cubicBezTo>
                <a:cubicBezTo>
                  <a:pt x="5063727" y="1066758"/>
                  <a:pt x="5056585" y="1119092"/>
                  <a:pt x="5092302" y="1188871"/>
                </a:cubicBezTo>
                <a:cubicBezTo>
                  <a:pt x="5113734" y="1124907"/>
                  <a:pt x="5131592" y="1075480"/>
                  <a:pt x="5145880" y="1026053"/>
                </a:cubicBezTo>
                <a:cubicBezTo>
                  <a:pt x="5156596" y="985349"/>
                  <a:pt x="5181600" y="962089"/>
                  <a:pt x="5235177" y="964997"/>
                </a:cubicBezTo>
                <a:cubicBezTo>
                  <a:pt x="5263752" y="964997"/>
                  <a:pt x="5303044" y="956275"/>
                  <a:pt x="5317331" y="985349"/>
                </a:cubicBezTo>
                <a:cubicBezTo>
                  <a:pt x="5331618" y="1008608"/>
                  <a:pt x="5317331" y="1040590"/>
                  <a:pt x="5292327" y="1052221"/>
                </a:cubicBezTo>
                <a:cubicBezTo>
                  <a:pt x="5245894" y="1066758"/>
                  <a:pt x="5203031" y="1081295"/>
                  <a:pt x="5199458" y="1130722"/>
                </a:cubicBezTo>
                <a:cubicBezTo>
                  <a:pt x="5192315" y="1197593"/>
                  <a:pt x="5220889" y="1159796"/>
                  <a:pt x="5256608" y="1148166"/>
                </a:cubicBezTo>
                <a:cubicBezTo>
                  <a:pt x="5295899" y="1136536"/>
                  <a:pt x="5306616" y="1171426"/>
                  <a:pt x="5299471" y="1194686"/>
                </a:cubicBezTo>
                <a:cubicBezTo>
                  <a:pt x="5267324" y="1281909"/>
                  <a:pt x="5324474" y="1372040"/>
                  <a:pt x="5278039" y="1462171"/>
                </a:cubicBezTo>
                <a:cubicBezTo>
                  <a:pt x="5392339" y="1438912"/>
                  <a:pt x="5442347" y="1389485"/>
                  <a:pt x="5460205" y="1284817"/>
                </a:cubicBezTo>
                <a:cubicBezTo>
                  <a:pt x="5463777" y="1247020"/>
                  <a:pt x="5456634" y="1206315"/>
                  <a:pt x="5488780" y="1171426"/>
                </a:cubicBezTo>
                <a:cubicBezTo>
                  <a:pt x="5502175" y="1156162"/>
                  <a:pt x="5517579" y="1140898"/>
                  <a:pt x="5539513" y="1140353"/>
                </a:cubicBezTo>
                <a:lnTo>
                  <a:pt x="5552720" y="1143022"/>
                </a:lnTo>
                <a:lnTo>
                  <a:pt x="5574208" y="1115811"/>
                </a:lnTo>
                <a:cubicBezTo>
                  <a:pt x="5609034" y="1085646"/>
                  <a:pt x="5659040" y="1068202"/>
                  <a:pt x="5734050" y="1075470"/>
                </a:cubicBezTo>
                <a:cubicBezTo>
                  <a:pt x="5776912" y="1078377"/>
                  <a:pt x="5809058" y="1055118"/>
                  <a:pt x="5798343" y="1020228"/>
                </a:cubicBezTo>
                <a:cubicBezTo>
                  <a:pt x="5776912" y="953357"/>
                  <a:pt x="5837634" y="921375"/>
                  <a:pt x="5884068" y="883578"/>
                </a:cubicBezTo>
                <a:cubicBezTo>
                  <a:pt x="5966221" y="816706"/>
                  <a:pt x="6051947" y="752742"/>
                  <a:pt x="6066234" y="645166"/>
                </a:cubicBezTo>
                <a:cubicBezTo>
                  <a:pt x="6130528" y="665519"/>
                  <a:pt x="6123384" y="700408"/>
                  <a:pt x="6109096" y="732391"/>
                </a:cubicBezTo>
                <a:cubicBezTo>
                  <a:pt x="6073377" y="816706"/>
                  <a:pt x="6034087" y="901023"/>
                  <a:pt x="5998368" y="985338"/>
                </a:cubicBezTo>
                <a:cubicBezTo>
                  <a:pt x="5976937" y="1040581"/>
                  <a:pt x="5944790" y="1095822"/>
                  <a:pt x="5969793" y="1168509"/>
                </a:cubicBezTo>
                <a:cubicBezTo>
                  <a:pt x="6098380" y="1104545"/>
                  <a:pt x="6123384" y="996969"/>
                  <a:pt x="6162674" y="909745"/>
                </a:cubicBezTo>
                <a:cubicBezTo>
                  <a:pt x="6212681" y="802169"/>
                  <a:pt x="6305549" y="738205"/>
                  <a:pt x="6412705" y="659704"/>
                </a:cubicBezTo>
                <a:cubicBezTo>
                  <a:pt x="6441280" y="738205"/>
                  <a:pt x="6362699" y="787632"/>
                  <a:pt x="6366271" y="851596"/>
                </a:cubicBezTo>
                <a:cubicBezTo>
                  <a:pt x="6376987" y="854503"/>
                  <a:pt x="6398418" y="860319"/>
                  <a:pt x="6398418" y="860319"/>
                </a:cubicBezTo>
                <a:cubicBezTo>
                  <a:pt x="6455568" y="755650"/>
                  <a:pt x="6562724" y="709131"/>
                  <a:pt x="6694884" y="691686"/>
                </a:cubicBezTo>
                <a:cubicBezTo>
                  <a:pt x="6762750" y="685871"/>
                  <a:pt x="6784181" y="648074"/>
                  <a:pt x="6816327" y="610277"/>
                </a:cubicBezTo>
                <a:cubicBezTo>
                  <a:pt x="6927056" y="482349"/>
                  <a:pt x="7027068" y="345699"/>
                  <a:pt x="7177087" y="238123"/>
                </a:cubicBezTo>
                <a:cubicBezTo>
                  <a:pt x="7159228" y="363144"/>
                  <a:pt x="7059215" y="461997"/>
                  <a:pt x="7016353" y="592833"/>
                </a:cubicBezTo>
                <a:cubicBezTo>
                  <a:pt x="7180659" y="488164"/>
                  <a:pt x="7266384" y="351513"/>
                  <a:pt x="7366396" y="226493"/>
                </a:cubicBezTo>
                <a:cubicBezTo>
                  <a:pt x="7412830" y="168344"/>
                  <a:pt x="7469981" y="116010"/>
                  <a:pt x="7494984" y="49138"/>
                </a:cubicBezTo>
                <a:cubicBezTo>
                  <a:pt x="7500342" y="31693"/>
                  <a:pt x="7511727" y="4436"/>
                  <a:pt x="7538181" y="484"/>
                </a:cubicBezTo>
                <a:close/>
              </a:path>
            </a:pathLst>
          </a:custGeom>
          <a:solidFill>
            <a:schemeClr val="accent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4BEEDA05-D61B-094C-A40E-C9386C9B1494}"/>
              </a:ext>
            </a:extLst>
          </p:cNvPr>
          <p:cNvSpPr>
            <a:spLocks noGrp="1"/>
          </p:cNvSpPr>
          <p:nvPr>
            <p:ph type="title"/>
          </p:nvPr>
        </p:nvSpPr>
        <p:spPr>
          <a:xfrm>
            <a:off x="838200" y="365125"/>
            <a:ext cx="10515600" cy="1325563"/>
          </a:xfrm>
        </p:spPr>
        <p:txBody>
          <a:bodyPr>
            <a:normAutofit/>
          </a:bodyPr>
          <a:lstStyle/>
          <a:p>
            <a:r>
              <a:rPr lang="en-US" dirty="0"/>
              <a:t>NURSE</a:t>
            </a:r>
          </a:p>
        </p:txBody>
      </p:sp>
      <p:graphicFrame>
        <p:nvGraphicFramePr>
          <p:cNvPr id="6" name="Content Placeholder 3">
            <a:extLst>
              <a:ext uri="{FF2B5EF4-FFF2-40B4-BE49-F238E27FC236}">
                <a16:creationId xmlns:a16="http://schemas.microsoft.com/office/drawing/2014/main" id="{387E2FCA-E4F2-32E6-C836-F8041AEE9E04}"/>
              </a:ext>
            </a:extLst>
          </p:cNvPr>
          <p:cNvGraphicFramePr>
            <a:graphicFrameLocks noGrp="1"/>
          </p:cNvGraphicFramePr>
          <p:nvPr>
            <p:ph idx="1"/>
            <p:extLst>
              <p:ext uri="{D42A27DB-BD31-4B8C-83A1-F6EECF244321}">
                <p14:modId xmlns:p14="http://schemas.microsoft.com/office/powerpoint/2010/main" val="142947774"/>
              </p:ext>
            </p:extLst>
          </p:nvPr>
        </p:nvGraphicFramePr>
        <p:xfrm>
          <a:off x="838200" y="2011363"/>
          <a:ext cx="10515600" cy="416083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69545379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2" name="Rectangle 11">
            <a:extLst>
              <a:ext uri="{FF2B5EF4-FFF2-40B4-BE49-F238E27FC236}">
                <a16:creationId xmlns:a16="http://schemas.microsoft.com/office/drawing/2014/main" id="{DA8886A6-5426-494B-96D8-D962D2BA08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 name="Freeform: Shape 13">
            <a:extLst>
              <a:ext uri="{FF2B5EF4-FFF2-40B4-BE49-F238E27FC236}">
                <a16:creationId xmlns:a16="http://schemas.microsoft.com/office/drawing/2014/main" id="{AA3ED336-C09E-46E8-9774-B977D15FC5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752347"/>
            <a:ext cx="12191999" cy="6105653"/>
          </a:xfrm>
          <a:custGeom>
            <a:avLst/>
            <a:gdLst>
              <a:gd name="connsiteX0" fmla="*/ 7538181 w 12191999"/>
              <a:gd name="connsiteY0" fmla="*/ 484 h 6105653"/>
              <a:gd name="connsiteX1" fmla="*/ 7569993 w 12191999"/>
              <a:gd name="connsiteY1" fmla="*/ 5527 h 6105653"/>
              <a:gd name="connsiteX2" fmla="*/ 7587853 w 12191999"/>
              <a:gd name="connsiteY2" fmla="*/ 84028 h 6105653"/>
              <a:gd name="connsiteX3" fmla="*/ 7559278 w 12191999"/>
              <a:gd name="connsiteY3" fmla="*/ 325347 h 6105653"/>
              <a:gd name="connsiteX4" fmla="*/ 7795021 w 12191999"/>
              <a:gd name="connsiteY4" fmla="*/ 25878 h 6105653"/>
              <a:gd name="connsiteX5" fmla="*/ 7759302 w 12191999"/>
              <a:gd name="connsiteY5" fmla="*/ 249752 h 6105653"/>
              <a:gd name="connsiteX6" fmla="*/ 7852171 w 12191999"/>
              <a:gd name="connsiteY6" fmla="*/ 313717 h 6105653"/>
              <a:gd name="connsiteX7" fmla="*/ 8002190 w 12191999"/>
              <a:gd name="connsiteY7" fmla="*/ 418385 h 6105653"/>
              <a:gd name="connsiteX8" fmla="*/ 8084343 w 12191999"/>
              <a:gd name="connsiteY8" fmla="*/ 491072 h 6105653"/>
              <a:gd name="connsiteX9" fmla="*/ 8348662 w 12191999"/>
              <a:gd name="connsiteY9" fmla="*/ 520146 h 6105653"/>
              <a:gd name="connsiteX10" fmla="*/ 8637984 w 12191999"/>
              <a:gd name="connsiteY10" fmla="*/ 459090 h 6105653"/>
              <a:gd name="connsiteX11" fmla="*/ 8784431 w 12191999"/>
              <a:gd name="connsiteY11" fmla="*/ 290457 h 6105653"/>
              <a:gd name="connsiteX12" fmla="*/ 8948737 w 12191999"/>
              <a:gd name="connsiteY12" fmla="*/ 339884 h 6105653"/>
              <a:gd name="connsiteX13" fmla="*/ 8848725 w 12191999"/>
              <a:gd name="connsiteY13" fmla="*/ 697501 h 6105653"/>
              <a:gd name="connsiteX14" fmla="*/ 9238059 w 12191999"/>
              <a:gd name="connsiteY14" fmla="*/ 165437 h 6105653"/>
              <a:gd name="connsiteX15" fmla="*/ 9255919 w 12191999"/>
              <a:gd name="connsiteY15" fmla="*/ 255567 h 6105653"/>
              <a:gd name="connsiteX16" fmla="*/ 9477374 w 12191999"/>
              <a:gd name="connsiteY16" fmla="*/ 578295 h 6105653"/>
              <a:gd name="connsiteX17" fmla="*/ 9488091 w 12191999"/>
              <a:gd name="connsiteY17" fmla="*/ 595740 h 6105653"/>
              <a:gd name="connsiteX18" fmla="*/ 9627393 w 12191999"/>
              <a:gd name="connsiteY18" fmla="*/ 650981 h 6105653"/>
              <a:gd name="connsiteX19" fmla="*/ 9648824 w 12191999"/>
              <a:gd name="connsiteY19" fmla="*/ 825429 h 6105653"/>
              <a:gd name="connsiteX20" fmla="*/ 9616678 w 12191999"/>
              <a:gd name="connsiteY20" fmla="*/ 970802 h 6105653"/>
              <a:gd name="connsiteX21" fmla="*/ 9655968 w 12191999"/>
              <a:gd name="connsiteY21" fmla="*/ 1127805 h 6105653"/>
              <a:gd name="connsiteX22" fmla="*/ 9638109 w 12191999"/>
              <a:gd name="connsiteY22" fmla="*/ 1267362 h 6105653"/>
              <a:gd name="connsiteX23" fmla="*/ 9663111 w 12191999"/>
              <a:gd name="connsiteY23" fmla="*/ 1386568 h 6105653"/>
              <a:gd name="connsiteX24" fmla="*/ 9780984 w 12191999"/>
              <a:gd name="connsiteY24" fmla="*/ 1270269 h 6105653"/>
              <a:gd name="connsiteX25" fmla="*/ 9780984 w 12191999"/>
              <a:gd name="connsiteY25" fmla="*/ 1107452 h 6105653"/>
              <a:gd name="connsiteX26" fmla="*/ 9855993 w 12191999"/>
              <a:gd name="connsiteY26" fmla="*/ 991154 h 6105653"/>
              <a:gd name="connsiteX27" fmla="*/ 9991724 w 12191999"/>
              <a:gd name="connsiteY27" fmla="*/ 880670 h 6105653"/>
              <a:gd name="connsiteX28" fmla="*/ 10209609 w 12191999"/>
              <a:gd name="connsiteY28" fmla="*/ 491071 h 6105653"/>
              <a:gd name="connsiteX29" fmla="*/ 10291762 w 12191999"/>
              <a:gd name="connsiteY29" fmla="*/ 421292 h 6105653"/>
              <a:gd name="connsiteX30" fmla="*/ 9973865 w 12191999"/>
              <a:gd name="connsiteY30" fmla="*/ 1531941 h 6105653"/>
              <a:gd name="connsiteX31" fmla="*/ 10106024 w 12191999"/>
              <a:gd name="connsiteY31" fmla="*/ 1188861 h 6105653"/>
              <a:gd name="connsiteX32" fmla="*/ 10081022 w 12191999"/>
              <a:gd name="connsiteY32" fmla="*/ 1421458 h 6105653"/>
              <a:gd name="connsiteX33" fmla="*/ 10170318 w 12191999"/>
              <a:gd name="connsiteY33" fmla="*/ 1549385 h 6105653"/>
              <a:gd name="connsiteX34" fmla="*/ 10198893 w 12191999"/>
              <a:gd name="connsiteY34" fmla="*/ 1549385 h 6105653"/>
              <a:gd name="connsiteX35" fmla="*/ 10281046 w 12191999"/>
              <a:gd name="connsiteY35" fmla="*/ 1453439 h 6105653"/>
              <a:gd name="connsiteX36" fmla="*/ 10334625 w 12191999"/>
              <a:gd name="connsiteY36" fmla="*/ 1398198 h 6105653"/>
              <a:gd name="connsiteX37" fmla="*/ 10527506 w 12191999"/>
              <a:gd name="connsiteY37" fmla="*/ 1247010 h 6105653"/>
              <a:gd name="connsiteX38" fmla="*/ 10548937 w 12191999"/>
              <a:gd name="connsiteY38" fmla="*/ 1354586 h 6105653"/>
              <a:gd name="connsiteX39" fmla="*/ 10588228 w 12191999"/>
              <a:gd name="connsiteY39" fmla="*/ 1395290 h 6105653"/>
              <a:gd name="connsiteX40" fmla="*/ 10645378 w 12191999"/>
              <a:gd name="connsiteY40" fmla="*/ 1366216 h 6105653"/>
              <a:gd name="connsiteX41" fmla="*/ 10820400 w 12191999"/>
              <a:gd name="connsiteY41" fmla="*/ 1031858 h 6105653"/>
              <a:gd name="connsiteX42" fmla="*/ 10956131 w 12191999"/>
              <a:gd name="connsiteY42" fmla="*/ 1005691 h 6105653"/>
              <a:gd name="connsiteX43" fmla="*/ 10977562 w 12191999"/>
              <a:gd name="connsiteY43" fmla="*/ 1069655 h 6105653"/>
              <a:gd name="connsiteX44" fmla="*/ 10966847 w 12191999"/>
              <a:gd name="connsiteY44" fmla="*/ 1142341 h 6105653"/>
              <a:gd name="connsiteX45" fmla="*/ 11074003 w 12191999"/>
              <a:gd name="connsiteY45" fmla="*/ 1084192 h 6105653"/>
              <a:gd name="connsiteX46" fmla="*/ 11181159 w 12191999"/>
              <a:gd name="connsiteY46" fmla="*/ 848688 h 6105653"/>
              <a:gd name="connsiteX47" fmla="*/ 11238309 w 12191999"/>
              <a:gd name="connsiteY47" fmla="*/ 805077 h 6105653"/>
              <a:gd name="connsiteX48" fmla="*/ 11266884 w 12191999"/>
              <a:gd name="connsiteY48" fmla="*/ 863226 h 6105653"/>
              <a:gd name="connsiteX49" fmla="*/ 11277600 w 12191999"/>
              <a:gd name="connsiteY49" fmla="*/ 906838 h 6105653"/>
              <a:gd name="connsiteX50" fmla="*/ 11724084 w 12191999"/>
              <a:gd name="connsiteY50" fmla="*/ 5527 h 6105653"/>
              <a:gd name="connsiteX51" fmla="*/ 11727656 w 12191999"/>
              <a:gd name="connsiteY51" fmla="*/ 209048 h 6105653"/>
              <a:gd name="connsiteX52" fmla="*/ 11656218 w 12191999"/>
              <a:gd name="connsiteY52" fmla="*/ 409663 h 6105653"/>
              <a:gd name="connsiteX53" fmla="*/ 11666934 w 12191999"/>
              <a:gd name="connsiteY53" fmla="*/ 621907 h 6105653"/>
              <a:gd name="connsiteX54" fmla="*/ 11631215 w 12191999"/>
              <a:gd name="connsiteY54" fmla="*/ 822521 h 6105653"/>
              <a:gd name="connsiteX55" fmla="*/ 11631215 w 12191999"/>
              <a:gd name="connsiteY55" fmla="*/ 996969 h 6105653"/>
              <a:gd name="connsiteX56" fmla="*/ 11684793 w 12191999"/>
              <a:gd name="connsiteY56" fmla="*/ 834151 h 6105653"/>
              <a:gd name="connsiteX57" fmla="*/ 11774090 w 12191999"/>
              <a:gd name="connsiteY57" fmla="*/ 773095 h 6105653"/>
              <a:gd name="connsiteX58" fmla="*/ 11856243 w 12191999"/>
              <a:gd name="connsiteY58" fmla="*/ 793447 h 6105653"/>
              <a:gd name="connsiteX59" fmla="*/ 11831240 w 12191999"/>
              <a:gd name="connsiteY59" fmla="*/ 860319 h 6105653"/>
              <a:gd name="connsiteX60" fmla="*/ 11738371 w 12191999"/>
              <a:gd name="connsiteY60" fmla="*/ 938820 h 6105653"/>
              <a:gd name="connsiteX61" fmla="*/ 11795521 w 12191999"/>
              <a:gd name="connsiteY61" fmla="*/ 956264 h 6105653"/>
              <a:gd name="connsiteX62" fmla="*/ 11838384 w 12191999"/>
              <a:gd name="connsiteY62" fmla="*/ 1002784 h 6105653"/>
              <a:gd name="connsiteX63" fmla="*/ 11816952 w 12191999"/>
              <a:gd name="connsiteY63" fmla="*/ 1270269 h 6105653"/>
              <a:gd name="connsiteX64" fmla="*/ 11999118 w 12191999"/>
              <a:gd name="connsiteY64" fmla="*/ 1092915 h 6105653"/>
              <a:gd name="connsiteX65" fmla="*/ 12027693 w 12191999"/>
              <a:gd name="connsiteY65" fmla="*/ 979524 h 6105653"/>
              <a:gd name="connsiteX66" fmla="*/ 12102703 w 12191999"/>
              <a:gd name="connsiteY66" fmla="*/ 953357 h 6105653"/>
              <a:gd name="connsiteX67" fmla="*/ 12120562 w 12191999"/>
              <a:gd name="connsiteY67" fmla="*/ 1005691 h 6105653"/>
              <a:gd name="connsiteX68" fmla="*/ 12056268 w 12191999"/>
              <a:gd name="connsiteY68" fmla="*/ 1267362 h 6105653"/>
              <a:gd name="connsiteX69" fmla="*/ 12081272 w 12191999"/>
              <a:gd name="connsiteY69" fmla="*/ 1310974 h 6105653"/>
              <a:gd name="connsiteX70" fmla="*/ 12191999 w 12191999"/>
              <a:gd name="connsiteY70" fmla="*/ 1008598 h 6105653"/>
              <a:gd name="connsiteX71" fmla="*/ 12191999 w 12191999"/>
              <a:gd name="connsiteY71" fmla="*/ 6105653 h 6105653"/>
              <a:gd name="connsiteX72" fmla="*/ 0 w 12191999"/>
              <a:gd name="connsiteY72" fmla="*/ 6105653 h 6105653"/>
              <a:gd name="connsiteX73" fmla="*/ 0 w 12191999"/>
              <a:gd name="connsiteY73" fmla="*/ 927116 h 6105653"/>
              <a:gd name="connsiteX74" fmla="*/ 61930 w 12191999"/>
              <a:gd name="connsiteY74" fmla="*/ 902578 h 6105653"/>
              <a:gd name="connsiteX75" fmla="*/ 155971 w 12191999"/>
              <a:gd name="connsiteY75" fmla="*/ 883588 h 6105653"/>
              <a:gd name="connsiteX76" fmla="*/ 277414 w 12191999"/>
              <a:gd name="connsiteY76" fmla="*/ 802179 h 6105653"/>
              <a:gd name="connsiteX77" fmla="*/ 638174 w 12191999"/>
              <a:gd name="connsiteY77" fmla="*/ 430025 h 6105653"/>
              <a:gd name="connsiteX78" fmla="*/ 477440 w 12191999"/>
              <a:gd name="connsiteY78" fmla="*/ 784735 h 6105653"/>
              <a:gd name="connsiteX79" fmla="*/ 827483 w 12191999"/>
              <a:gd name="connsiteY79" fmla="*/ 418395 h 6105653"/>
              <a:gd name="connsiteX80" fmla="*/ 956071 w 12191999"/>
              <a:gd name="connsiteY80" fmla="*/ 241040 h 6105653"/>
              <a:gd name="connsiteX81" fmla="*/ 999268 w 12191999"/>
              <a:gd name="connsiteY81" fmla="*/ 192386 h 6105653"/>
              <a:gd name="connsiteX82" fmla="*/ 1031080 w 12191999"/>
              <a:gd name="connsiteY82" fmla="*/ 197429 h 6105653"/>
              <a:gd name="connsiteX83" fmla="*/ 1048940 w 12191999"/>
              <a:gd name="connsiteY83" fmla="*/ 275930 h 6105653"/>
              <a:gd name="connsiteX84" fmla="*/ 1020365 w 12191999"/>
              <a:gd name="connsiteY84" fmla="*/ 517249 h 6105653"/>
              <a:gd name="connsiteX85" fmla="*/ 1256108 w 12191999"/>
              <a:gd name="connsiteY85" fmla="*/ 217780 h 6105653"/>
              <a:gd name="connsiteX86" fmla="*/ 1220389 w 12191999"/>
              <a:gd name="connsiteY86" fmla="*/ 441654 h 6105653"/>
              <a:gd name="connsiteX87" fmla="*/ 1313258 w 12191999"/>
              <a:gd name="connsiteY87" fmla="*/ 505619 h 6105653"/>
              <a:gd name="connsiteX88" fmla="*/ 1463277 w 12191999"/>
              <a:gd name="connsiteY88" fmla="*/ 610287 h 6105653"/>
              <a:gd name="connsiteX89" fmla="*/ 1545430 w 12191999"/>
              <a:gd name="connsiteY89" fmla="*/ 682974 h 6105653"/>
              <a:gd name="connsiteX90" fmla="*/ 1809749 w 12191999"/>
              <a:gd name="connsiteY90" fmla="*/ 712048 h 6105653"/>
              <a:gd name="connsiteX91" fmla="*/ 2099071 w 12191999"/>
              <a:gd name="connsiteY91" fmla="*/ 650992 h 6105653"/>
              <a:gd name="connsiteX92" fmla="*/ 2245518 w 12191999"/>
              <a:gd name="connsiteY92" fmla="*/ 482359 h 6105653"/>
              <a:gd name="connsiteX93" fmla="*/ 2409824 w 12191999"/>
              <a:gd name="connsiteY93" fmla="*/ 531786 h 6105653"/>
              <a:gd name="connsiteX94" fmla="*/ 2309812 w 12191999"/>
              <a:gd name="connsiteY94" fmla="*/ 889403 h 6105653"/>
              <a:gd name="connsiteX95" fmla="*/ 2699146 w 12191999"/>
              <a:gd name="connsiteY95" fmla="*/ 357339 h 6105653"/>
              <a:gd name="connsiteX96" fmla="*/ 2717006 w 12191999"/>
              <a:gd name="connsiteY96" fmla="*/ 447469 h 6105653"/>
              <a:gd name="connsiteX97" fmla="*/ 2938461 w 12191999"/>
              <a:gd name="connsiteY97" fmla="*/ 770197 h 6105653"/>
              <a:gd name="connsiteX98" fmla="*/ 2949178 w 12191999"/>
              <a:gd name="connsiteY98" fmla="*/ 787642 h 6105653"/>
              <a:gd name="connsiteX99" fmla="*/ 3088480 w 12191999"/>
              <a:gd name="connsiteY99" fmla="*/ 842883 h 6105653"/>
              <a:gd name="connsiteX100" fmla="*/ 3109911 w 12191999"/>
              <a:gd name="connsiteY100" fmla="*/ 1017331 h 6105653"/>
              <a:gd name="connsiteX101" fmla="*/ 3077765 w 12191999"/>
              <a:gd name="connsiteY101" fmla="*/ 1162704 h 6105653"/>
              <a:gd name="connsiteX102" fmla="*/ 3117055 w 12191999"/>
              <a:gd name="connsiteY102" fmla="*/ 1319707 h 6105653"/>
              <a:gd name="connsiteX103" fmla="*/ 3099196 w 12191999"/>
              <a:gd name="connsiteY103" fmla="*/ 1459264 h 6105653"/>
              <a:gd name="connsiteX104" fmla="*/ 3124198 w 12191999"/>
              <a:gd name="connsiteY104" fmla="*/ 1578470 h 6105653"/>
              <a:gd name="connsiteX105" fmla="*/ 3242071 w 12191999"/>
              <a:gd name="connsiteY105" fmla="*/ 1462171 h 6105653"/>
              <a:gd name="connsiteX106" fmla="*/ 3242071 w 12191999"/>
              <a:gd name="connsiteY106" fmla="*/ 1299354 h 6105653"/>
              <a:gd name="connsiteX107" fmla="*/ 3317080 w 12191999"/>
              <a:gd name="connsiteY107" fmla="*/ 1183056 h 6105653"/>
              <a:gd name="connsiteX108" fmla="*/ 3452811 w 12191999"/>
              <a:gd name="connsiteY108" fmla="*/ 1072572 h 6105653"/>
              <a:gd name="connsiteX109" fmla="*/ 3670696 w 12191999"/>
              <a:gd name="connsiteY109" fmla="*/ 682973 h 6105653"/>
              <a:gd name="connsiteX110" fmla="*/ 3752849 w 12191999"/>
              <a:gd name="connsiteY110" fmla="*/ 613194 h 6105653"/>
              <a:gd name="connsiteX111" fmla="*/ 3434952 w 12191999"/>
              <a:gd name="connsiteY111" fmla="*/ 1723843 h 6105653"/>
              <a:gd name="connsiteX112" fmla="*/ 3567111 w 12191999"/>
              <a:gd name="connsiteY112" fmla="*/ 1380763 h 6105653"/>
              <a:gd name="connsiteX113" fmla="*/ 3542109 w 12191999"/>
              <a:gd name="connsiteY113" fmla="*/ 1613360 h 6105653"/>
              <a:gd name="connsiteX114" fmla="*/ 3631405 w 12191999"/>
              <a:gd name="connsiteY114" fmla="*/ 1741287 h 6105653"/>
              <a:gd name="connsiteX115" fmla="*/ 3659980 w 12191999"/>
              <a:gd name="connsiteY115" fmla="*/ 1741287 h 6105653"/>
              <a:gd name="connsiteX116" fmla="*/ 3742133 w 12191999"/>
              <a:gd name="connsiteY116" fmla="*/ 1645341 h 6105653"/>
              <a:gd name="connsiteX117" fmla="*/ 3795712 w 12191999"/>
              <a:gd name="connsiteY117" fmla="*/ 1590100 h 6105653"/>
              <a:gd name="connsiteX118" fmla="*/ 3988593 w 12191999"/>
              <a:gd name="connsiteY118" fmla="*/ 1438912 h 6105653"/>
              <a:gd name="connsiteX119" fmla="*/ 4010024 w 12191999"/>
              <a:gd name="connsiteY119" fmla="*/ 1546488 h 6105653"/>
              <a:gd name="connsiteX120" fmla="*/ 4049315 w 12191999"/>
              <a:gd name="connsiteY120" fmla="*/ 1587192 h 6105653"/>
              <a:gd name="connsiteX121" fmla="*/ 4106465 w 12191999"/>
              <a:gd name="connsiteY121" fmla="*/ 1558118 h 6105653"/>
              <a:gd name="connsiteX122" fmla="*/ 4281487 w 12191999"/>
              <a:gd name="connsiteY122" fmla="*/ 1223760 h 6105653"/>
              <a:gd name="connsiteX123" fmla="*/ 4417219 w 12191999"/>
              <a:gd name="connsiteY123" fmla="*/ 1197593 h 6105653"/>
              <a:gd name="connsiteX124" fmla="*/ 4438649 w 12191999"/>
              <a:gd name="connsiteY124" fmla="*/ 1261557 h 6105653"/>
              <a:gd name="connsiteX125" fmla="*/ 4427935 w 12191999"/>
              <a:gd name="connsiteY125" fmla="*/ 1334243 h 6105653"/>
              <a:gd name="connsiteX126" fmla="*/ 4535090 w 12191999"/>
              <a:gd name="connsiteY126" fmla="*/ 1276094 h 6105653"/>
              <a:gd name="connsiteX127" fmla="*/ 4642246 w 12191999"/>
              <a:gd name="connsiteY127" fmla="*/ 1040590 h 6105653"/>
              <a:gd name="connsiteX128" fmla="*/ 4699396 w 12191999"/>
              <a:gd name="connsiteY128" fmla="*/ 996979 h 6105653"/>
              <a:gd name="connsiteX129" fmla="*/ 4727971 w 12191999"/>
              <a:gd name="connsiteY129" fmla="*/ 1055128 h 6105653"/>
              <a:gd name="connsiteX130" fmla="*/ 4738688 w 12191999"/>
              <a:gd name="connsiteY130" fmla="*/ 1098740 h 6105653"/>
              <a:gd name="connsiteX131" fmla="*/ 5185172 w 12191999"/>
              <a:gd name="connsiteY131" fmla="*/ 197429 h 6105653"/>
              <a:gd name="connsiteX132" fmla="*/ 5188744 w 12191999"/>
              <a:gd name="connsiteY132" fmla="*/ 400950 h 6105653"/>
              <a:gd name="connsiteX133" fmla="*/ 5117306 w 12191999"/>
              <a:gd name="connsiteY133" fmla="*/ 601565 h 6105653"/>
              <a:gd name="connsiteX134" fmla="*/ 5128021 w 12191999"/>
              <a:gd name="connsiteY134" fmla="*/ 813809 h 6105653"/>
              <a:gd name="connsiteX135" fmla="*/ 5092302 w 12191999"/>
              <a:gd name="connsiteY135" fmla="*/ 1014423 h 6105653"/>
              <a:gd name="connsiteX136" fmla="*/ 5092302 w 12191999"/>
              <a:gd name="connsiteY136" fmla="*/ 1188871 h 6105653"/>
              <a:gd name="connsiteX137" fmla="*/ 5145880 w 12191999"/>
              <a:gd name="connsiteY137" fmla="*/ 1026053 h 6105653"/>
              <a:gd name="connsiteX138" fmla="*/ 5235177 w 12191999"/>
              <a:gd name="connsiteY138" fmla="*/ 964997 h 6105653"/>
              <a:gd name="connsiteX139" fmla="*/ 5317331 w 12191999"/>
              <a:gd name="connsiteY139" fmla="*/ 985349 h 6105653"/>
              <a:gd name="connsiteX140" fmla="*/ 5292327 w 12191999"/>
              <a:gd name="connsiteY140" fmla="*/ 1052221 h 6105653"/>
              <a:gd name="connsiteX141" fmla="*/ 5199458 w 12191999"/>
              <a:gd name="connsiteY141" fmla="*/ 1130722 h 6105653"/>
              <a:gd name="connsiteX142" fmla="*/ 5256608 w 12191999"/>
              <a:gd name="connsiteY142" fmla="*/ 1148166 h 6105653"/>
              <a:gd name="connsiteX143" fmla="*/ 5299471 w 12191999"/>
              <a:gd name="connsiteY143" fmla="*/ 1194686 h 6105653"/>
              <a:gd name="connsiteX144" fmla="*/ 5278039 w 12191999"/>
              <a:gd name="connsiteY144" fmla="*/ 1462171 h 6105653"/>
              <a:gd name="connsiteX145" fmla="*/ 5460205 w 12191999"/>
              <a:gd name="connsiteY145" fmla="*/ 1284817 h 6105653"/>
              <a:gd name="connsiteX146" fmla="*/ 5488780 w 12191999"/>
              <a:gd name="connsiteY146" fmla="*/ 1171426 h 6105653"/>
              <a:gd name="connsiteX147" fmla="*/ 5539513 w 12191999"/>
              <a:gd name="connsiteY147" fmla="*/ 1140353 h 6105653"/>
              <a:gd name="connsiteX148" fmla="*/ 5552720 w 12191999"/>
              <a:gd name="connsiteY148" fmla="*/ 1143022 h 6105653"/>
              <a:gd name="connsiteX149" fmla="*/ 5574208 w 12191999"/>
              <a:gd name="connsiteY149" fmla="*/ 1115811 h 6105653"/>
              <a:gd name="connsiteX150" fmla="*/ 5734050 w 12191999"/>
              <a:gd name="connsiteY150" fmla="*/ 1075470 h 6105653"/>
              <a:gd name="connsiteX151" fmla="*/ 5798343 w 12191999"/>
              <a:gd name="connsiteY151" fmla="*/ 1020228 h 6105653"/>
              <a:gd name="connsiteX152" fmla="*/ 5884068 w 12191999"/>
              <a:gd name="connsiteY152" fmla="*/ 883578 h 6105653"/>
              <a:gd name="connsiteX153" fmla="*/ 6066234 w 12191999"/>
              <a:gd name="connsiteY153" fmla="*/ 645166 h 6105653"/>
              <a:gd name="connsiteX154" fmla="*/ 6109096 w 12191999"/>
              <a:gd name="connsiteY154" fmla="*/ 732391 h 6105653"/>
              <a:gd name="connsiteX155" fmla="*/ 5998368 w 12191999"/>
              <a:gd name="connsiteY155" fmla="*/ 985338 h 6105653"/>
              <a:gd name="connsiteX156" fmla="*/ 5969793 w 12191999"/>
              <a:gd name="connsiteY156" fmla="*/ 1168509 h 6105653"/>
              <a:gd name="connsiteX157" fmla="*/ 6162674 w 12191999"/>
              <a:gd name="connsiteY157" fmla="*/ 909745 h 6105653"/>
              <a:gd name="connsiteX158" fmla="*/ 6412705 w 12191999"/>
              <a:gd name="connsiteY158" fmla="*/ 659704 h 6105653"/>
              <a:gd name="connsiteX159" fmla="*/ 6366271 w 12191999"/>
              <a:gd name="connsiteY159" fmla="*/ 851596 h 6105653"/>
              <a:gd name="connsiteX160" fmla="*/ 6398418 w 12191999"/>
              <a:gd name="connsiteY160" fmla="*/ 860319 h 6105653"/>
              <a:gd name="connsiteX161" fmla="*/ 6694884 w 12191999"/>
              <a:gd name="connsiteY161" fmla="*/ 691686 h 6105653"/>
              <a:gd name="connsiteX162" fmla="*/ 6816327 w 12191999"/>
              <a:gd name="connsiteY162" fmla="*/ 610277 h 6105653"/>
              <a:gd name="connsiteX163" fmla="*/ 7177087 w 12191999"/>
              <a:gd name="connsiteY163" fmla="*/ 238123 h 6105653"/>
              <a:gd name="connsiteX164" fmla="*/ 7016353 w 12191999"/>
              <a:gd name="connsiteY164" fmla="*/ 592833 h 6105653"/>
              <a:gd name="connsiteX165" fmla="*/ 7366396 w 12191999"/>
              <a:gd name="connsiteY165" fmla="*/ 226493 h 6105653"/>
              <a:gd name="connsiteX166" fmla="*/ 7494984 w 12191999"/>
              <a:gd name="connsiteY166" fmla="*/ 49138 h 6105653"/>
              <a:gd name="connsiteX167" fmla="*/ 7538181 w 12191999"/>
              <a:gd name="connsiteY167" fmla="*/ 484 h 610565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Lst>
            <a:rect l="l" t="t" r="r" b="b"/>
            <a:pathLst>
              <a:path w="12191999" h="6105653">
                <a:moveTo>
                  <a:pt x="7538181" y="484"/>
                </a:moveTo>
                <a:cubicBezTo>
                  <a:pt x="7546999" y="-833"/>
                  <a:pt x="7557492" y="439"/>
                  <a:pt x="7569993" y="5527"/>
                </a:cubicBezTo>
                <a:cubicBezTo>
                  <a:pt x="7612855" y="22971"/>
                  <a:pt x="7598567" y="54953"/>
                  <a:pt x="7587853" y="84028"/>
                </a:cubicBezTo>
                <a:cubicBezTo>
                  <a:pt x="7559278" y="153806"/>
                  <a:pt x="7559278" y="229401"/>
                  <a:pt x="7559278" y="325347"/>
                </a:cubicBezTo>
                <a:cubicBezTo>
                  <a:pt x="7695009" y="243938"/>
                  <a:pt x="7652146" y="95658"/>
                  <a:pt x="7795021" y="25878"/>
                </a:cubicBezTo>
                <a:cubicBezTo>
                  <a:pt x="7820024" y="113102"/>
                  <a:pt x="7770018" y="179974"/>
                  <a:pt x="7759302" y="249752"/>
                </a:cubicBezTo>
                <a:cubicBezTo>
                  <a:pt x="7748587" y="313717"/>
                  <a:pt x="7773590" y="328254"/>
                  <a:pt x="7852171" y="313717"/>
                </a:cubicBezTo>
                <a:cubicBezTo>
                  <a:pt x="7973615" y="290457"/>
                  <a:pt x="8034337" y="325347"/>
                  <a:pt x="8002190" y="418385"/>
                </a:cubicBezTo>
                <a:cubicBezTo>
                  <a:pt x="7970043" y="505609"/>
                  <a:pt x="8016478" y="514331"/>
                  <a:pt x="8084343" y="491072"/>
                </a:cubicBezTo>
                <a:cubicBezTo>
                  <a:pt x="8184355" y="456182"/>
                  <a:pt x="8262937" y="493979"/>
                  <a:pt x="8348662" y="520146"/>
                </a:cubicBezTo>
                <a:cubicBezTo>
                  <a:pt x="8477249" y="560851"/>
                  <a:pt x="8541543" y="543406"/>
                  <a:pt x="8637984" y="459090"/>
                </a:cubicBezTo>
                <a:cubicBezTo>
                  <a:pt x="8691561" y="409663"/>
                  <a:pt x="8737996" y="360236"/>
                  <a:pt x="8784431" y="290457"/>
                </a:cubicBezTo>
                <a:cubicBezTo>
                  <a:pt x="8809434" y="450367"/>
                  <a:pt x="8895158" y="284642"/>
                  <a:pt x="8948737" y="339884"/>
                </a:cubicBezTo>
                <a:cubicBezTo>
                  <a:pt x="8970168" y="453274"/>
                  <a:pt x="8798717" y="543406"/>
                  <a:pt x="8848725" y="697501"/>
                </a:cubicBezTo>
                <a:cubicBezTo>
                  <a:pt x="8995171" y="511424"/>
                  <a:pt x="9041606" y="302087"/>
                  <a:pt x="9238059" y="165437"/>
                </a:cubicBezTo>
                <a:cubicBezTo>
                  <a:pt x="9280921" y="197419"/>
                  <a:pt x="9238059" y="229401"/>
                  <a:pt x="9255919" y="255567"/>
                </a:cubicBezTo>
                <a:cubicBezTo>
                  <a:pt x="9266634" y="255567"/>
                  <a:pt x="9198767" y="560851"/>
                  <a:pt x="9477374" y="578295"/>
                </a:cubicBezTo>
                <a:cubicBezTo>
                  <a:pt x="9477374" y="584110"/>
                  <a:pt x="9477374" y="589925"/>
                  <a:pt x="9488091" y="595740"/>
                </a:cubicBezTo>
                <a:cubicBezTo>
                  <a:pt x="9527380" y="627722"/>
                  <a:pt x="9620249" y="598648"/>
                  <a:pt x="9627393" y="650981"/>
                </a:cubicBezTo>
                <a:cubicBezTo>
                  <a:pt x="9634537" y="709131"/>
                  <a:pt x="9666684" y="764373"/>
                  <a:pt x="9648824" y="825429"/>
                </a:cubicBezTo>
                <a:cubicBezTo>
                  <a:pt x="9634537" y="871948"/>
                  <a:pt x="9616678" y="921374"/>
                  <a:pt x="9616678" y="970802"/>
                </a:cubicBezTo>
                <a:cubicBezTo>
                  <a:pt x="9616678" y="1023136"/>
                  <a:pt x="9495233" y="1095822"/>
                  <a:pt x="9655968" y="1127805"/>
                </a:cubicBezTo>
                <a:cubicBezTo>
                  <a:pt x="9663111" y="1127805"/>
                  <a:pt x="9645252" y="1217935"/>
                  <a:pt x="9638109" y="1267362"/>
                </a:cubicBezTo>
                <a:cubicBezTo>
                  <a:pt x="9630965" y="1308066"/>
                  <a:pt x="9598818" y="1357494"/>
                  <a:pt x="9663111" y="1386568"/>
                </a:cubicBezTo>
                <a:cubicBezTo>
                  <a:pt x="9702403" y="1401105"/>
                  <a:pt x="9773840" y="1331326"/>
                  <a:pt x="9780984" y="1270269"/>
                </a:cubicBezTo>
                <a:cubicBezTo>
                  <a:pt x="9788127" y="1215028"/>
                  <a:pt x="9795271" y="1159787"/>
                  <a:pt x="9780984" y="1107452"/>
                </a:cubicBezTo>
                <a:cubicBezTo>
                  <a:pt x="9763125" y="1043488"/>
                  <a:pt x="9791699" y="1008598"/>
                  <a:pt x="9855993" y="991154"/>
                </a:cubicBezTo>
                <a:cubicBezTo>
                  <a:pt x="9923858" y="970802"/>
                  <a:pt x="9959577" y="933005"/>
                  <a:pt x="9991724" y="880670"/>
                </a:cubicBezTo>
                <a:cubicBezTo>
                  <a:pt x="10070305" y="752742"/>
                  <a:pt x="10163174" y="630630"/>
                  <a:pt x="10209609" y="491071"/>
                </a:cubicBezTo>
                <a:cubicBezTo>
                  <a:pt x="10216753" y="464905"/>
                  <a:pt x="10231040" y="432923"/>
                  <a:pt x="10291762" y="421292"/>
                </a:cubicBezTo>
                <a:cubicBezTo>
                  <a:pt x="10198893" y="799262"/>
                  <a:pt x="9959577" y="1142341"/>
                  <a:pt x="9973865" y="1531941"/>
                </a:cubicBezTo>
                <a:cubicBezTo>
                  <a:pt x="10048874" y="1427272"/>
                  <a:pt x="10052446" y="1302252"/>
                  <a:pt x="10106024" y="1188861"/>
                </a:cubicBezTo>
                <a:cubicBezTo>
                  <a:pt x="10145315" y="1270269"/>
                  <a:pt x="10102453" y="1345863"/>
                  <a:pt x="10081022" y="1421458"/>
                </a:cubicBezTo>
                <a:cubicBezTo>
                  <a:pt x="10063162" y="1485421"/>
                  <a:pt x="10059590" y="1543570"/>
                  <a:pt x="10170318" y="1549385"/>
                </a:cubicBezTo>
                <a:cubicBezTo>
                  <a:pt x="10181034" y="1549385"/>
                  <a:pt x="10188178" y="1549385"/>
                  <a:pt x="10198893" y="1549385"/>
                </a:cubicBezTo>
                <a:cubicBezTo>
                  <a:pt x="10245327" y="1526126"/>
                  <a:pt x="10266759" y="1494144"/>
                  <a:pt x="10281046" y="1453439"/>
                </a:cubicBezTo>
                <a:cubicBezTo>
                  <a:pt x="10288190" y="1430180"/>
                  <a:pt x="10302477" y="1398198"/>
                  <a:pt x="10334625" y="1398198"/>
                </a:cubicBezTo>
                <a:cubicBezTo>
                  <a:pt x="10456068" y="1401105"/>
                  <a:pt x="10491787" y="1322604"/>
                  <a:pt x="10527506" y="1247010"/>
                </a:cubicBezTo>
                <a:cubicBezTo>
                  <a:pt x="10588228" y="1287714"/>
                  <a:pt x="10545365" y="1322604"/>
                  <a:pt x="10548937" y="1354586"/>
                </a:cubicBezTo>
                <a:cubicBezTo>
                  <a:pt x="10552509" y="1374938"/>
                  <a:pt x="10556080" y="1395290"/>
                  <a:pt x="10588228" y="1395290"/>
                </a:cubicBezTo>
                <a:cubicBezTo>
                  <a:pt x="10613230" y="1395290"/>
                  <a:pt x="10645378" y="1386568"/>
                  <a:pt x="10645378" y="1366216"/>
                </a:cubicBezTo>
                <a:cubicBezTo>
                  <a:pt x="10648949" y="1238288"/>
                  <a:pt x="10820400" y="1165601"/>
                  <a:pt x="10820400" y="1031858"/>
                </a:cubicBezTo>
                <a:cubicBezTo>
                  <a:pt x="10820400" y="950449"/>
                  <a:pt x="10916840" y="1072563"/>
                  <a:pt x="10956131" y="1005691"/>
                </a:cubicBezTo>
                <a:cubicBezTo>
                  <a:pt x="10966847" y="991154"/>
                  <a:pt x="10981133" y="1046395"/>
                  <a:pt x="10977562" y="1069655"/>
                </a:cubicBezTo>
                <a:cubicBezTo>
                  <a:pt x="10973991" y="1092915"/>
                  <a:pt x="10948987" y="1113267"/>
                  <a:pt x="10966847" y="1142341"/>
                </a:cubicBezTo>
                <a:cubicBezTo>
                  <a:pt x="11031140" y="1156879"/>
                  <a:pt x="11056143" y="1119081"/>
                  <a:pt x="11074003" y="1084192"/>
                </a:cubicBezTo>
                <a:cubicBezTo>
                  <a:pt x="11116865" y="1008598"/>
                  <a:pt x="11166871" y="933005"/>
                  <a:pt x="11181159" y="848688"/>
                </a:cubicBezTo>
                <a:cubicBezTo>
                  <a:pt x="11184730" y="819614"/>
                  <a:pt x="11202590" y="802169"/>
                  <a:pt x="11238309" y="805077"/>
                </a:cubicBezTo>
                <a:cubicBezTo>
                  <a:pt x="11284744" y="810891"/>
                  <a:pt x="11270456" y="839966"/>
                  <a:pt x="11266884" y="863226"/>
                </a:cubicBezTo>
                <a:cubicBezTo>
                  <a:pt x="11263312" y="877763"/>
                  <a:pt x="11252596" y="892300"/>
                  <a:pt x="11277600" y="906838"/>
                </a:cubicBezTo>
                <a:cubicBezTo>
                  <a:pt x="11531203" y="566666"/>
                  <a:pt x="11516915" y="386403"/>
                  <a:pt x="11724084" y="5527"/>
                </a:cubicBezTo>
                <a:cubicBezTo>
                  <a:pt x="11763375" y="89842"/>
                  <a:pt x="11734800" y="150899"/>
                  <a:pt x="11727656" y="209048"/>
                </a:cubicBezTo>
                <a:cubicBezTo>
                  <a:pt x="11709796" y="354421"/>
                  <a:pt x="11677649" y="264290"/>
                  <a:pt x="11656218" y="409663"/>
                </a:cubicBezTo>
                <a:cubicBezTo>
                  <a:pt x="11645503" y="479442"/>
                  <a:pt x="11609784" y="543406"/>
                  <a:pt x="11666934" y="621907"/>
                </a:cubicBezTo>
                <a:cubicBezTo>
                  <a:pt x="11706225" y="674241"/>
                  <a:pt x="11663362" y="758557"/>
                  <a:pt x="11631215" y="822521"/>
                </a:cubicBezTo>
                <a:cubicBezTo>
                  <a:pt x="11602640" y="874856"/>
                  <a:pt x="11595497" y="927190"/>
                  <a:pt x="11631215" y="996969"/>
                </a:cubicBezTo>
                <a:cubicBezTo>
                  <a:pt x="11652646" y="933005"/>
                  <a:pt x="11670505" y="883578"/>
                  <a:pt x="11684793" y="834151"/>
                </a:cubicBezTo>
                <a:cubicBezTo>
                  <a:pt x="11695509" y="793447"/>
                  <a:pt x="11720512" y="770187"/>
                  <a:pt x="11774090" y="773095"/>
                </a:cubicBezTo>
                <a:cubicBezTo>
                  <a:pt x="11802665" y="773095"/>
                  <a:pt x="11841956" y="764373"/>
                  <a:pt x="11856243" y="793447"/>
                </a:cubicBezTo>
                <a:cubicBezTo>
                  <a:pt x="11870531" y="816706"/>
                  <a:pt x="11856243" y="848688"/>
                  <a:pt x="11831240" y="860319"/>
                </a:cubicBezTo>
                <a:cubicBezTo>
                  <a:pt x="11784806" y="874856"/>
                  <a:pt x="11741944" y="889393"/>
                  <a:pt x="11738371" y="938820"/>
                </a:cubicBezTo>
                <a:cubicBezTo>
                  <a:pt x="11731228" y="1005691"/>
                  <a:pt x="11759802" y="967894"/>
                  <a:pt x="11795521" y="956264"/>
                </a:cubicBezTo>
                <a:cubicBezTo>
                  <a:pt x="11834812" y="944634"/>
                  <a:pt x="11845527" y="979524"/>
                  <a:pt x="11838384" y="1002784"/>
                </a:cubicBezTo>
                <a:cubicBezTo>
                  <a:pt x="11806237" y="1090007"/>
                  <a:pt x="11863387" y="1180138"/>
                  <a:pt x="11816952" y="1270269"/>
                </a:cubicBezTo>
                <a:cubicBezTo>
                  <a:pt x="11931252" y="1247010"/>
                  <a:pt x="11981259" y="1197583"/>
                  <a:pt x="11999118" y="1092915"/>
                </a:cubicBezTo>
                <a:cubicBezTo>
                  <a:pt x="12002690" y="1055118"/>
                  <a:pt x="11995547" y="1014413"/>
                  <a:pt x="12027693" y="979524"/>
                </a:cubicBezTo>
                <a:cubicBezTo>
                  <a:pt x="12045553" y="959172"/>
                  <a:pt x="12066984" y="938820"/>
                  <a:pt x="12102703" y="953357"/>
                </a:cubicBezTo>
                <a:cubicBezTo>
                  <a:pt x="12127705" y="962080"/>
                  <a:pt x="12127705" y="985338"/>
                  <a:pt x="12120562" y="1005691"/>
                </a:cubicBezTo>
                <a:cubicBezTo>
                  <a:pt x="12081272" y="1090007"/>
                  <a:pt x="12070555" y="1180138"/>
                  <a:pt x="12056268" y="1267362"/>
                </a:cubicBezTo>
                <a:cubicBezTo>
                  <a:pt x="12052697" y="1281899"/>
                  <a:pt x="12045553" y="1296437"/>
                  <a:pt x="12081272" y="1310974"/>
                </a:cubicBezTo>
                <a:cubicBezTo>
                  <a:pt x="12113418" y="1209213"/>
                  <a:pt x="12156280" y="1110359"/>
                  <a:pt x="12191999" y="1008598"/>
                </a:cubicBezTo>
                <a:lnTo>
                  <a:pt x="12191999" y="6105653"/>
                </a:lnTo>
                <a:lnTo>
                  <a:pt x="0" y="6105653"/>
                </a:lnTo>
                <a:lnTo>
                  <a:pt x="0" y="927116"/>
                </a:lnTo>
                <a:lnTo>
                  <a:pt x="61930" y="902578"/>
                </a:lnTo>
                <a:cubicBezTo>
                  <a:pt x="91454" y="894128"/>
                  <a:pt x="122931" y="887949"/>
                  <a:pt x="155971" y="883588"/>
                </a:cubicBezTo>
                <a:cubicBezTo>
                  <a:pt x="223837" y="877773"/>
                  <a:pt x="245268" y="839976"/>
                  <a:pt x="277414" y="802179"/>
                </a:cubicBezTo>
                <a:cubicBezTo>
                  <a:pt x="388143" y="674251"/>
                  <a:pt x="488155" y="537601"/>
                  <a:pt x="638174" y="430025"/>
                </a:cubicBezTo>
                <a:cubicBezTo>
                  <a:pt x="620315" y="555046"/>
                  <a:pt x="520302" y="653899"/>
                  <a:pt x="477440" y="784735"/>
                </a:cubicBezTo>
                <a:cubicBezTo>
                  <a:pt x="641746" y="680066"/>
                  <a:pt x="727471" y="543415"/>
                  <a:pt x="827483" y="418395"/>
                </a:cubicBezTo>
                <a:cubicBezTo>
                  <a:pt x="873917" y="360246"/>
                  <a:pt x="931068" y="307912"/>
                  <a:pt x="956071" y="241040"/>
                </a:cubicBezTo>
                <a:cubicBezTo>
                  <a:pt x="961429" y="223595"/>
                  <a:pt x="972814" y="196338"/>
                  <a:pt x="999268" y="192386"/>
                </a:cubicBezTo>
                <a:cubicBezTo>
                  <a:pt x="1008086" y="191069"/>
                  <a:pt x="1018579" y="192341"/>
                  <a:pt x="1031080" y="197429"/>
                </a:cubicBezTo>
                <a:cubicBezTo>
                  <a:pt x="1073942" y="214873"/>
                  <a:pt x="1059654" y="246855"/>
                  <a:pt x="1048940" y="275930"/>
                </a:cubicBezTo>
                <a:cubicBezTo>
                  <a:pt x="1020365" y="345708"/>
                  <a:pt x="1020365" y="421303"/>
                  <a:pt x="1020365" y="517249"/>
                </a:cubicBezTo>
                <a:cubicBezTo>
                  <a:pt x="1156096" y="435840"/>
                  <a:pt x="1113233" y="287560"/>
                  <a:pt x="1256108" y="217780"/>
                </a:cubicBezTo>
                <a:cubicBezTo>
                  <a:pt x="1281111" y="305004"/>
                  <a:pt x="1231105" y="371876"/>
                  <a:pt x="1220389" y="441654"/>
                </a:cubicBezTo>
                <a:cubicBezTo>
                  <a:pt x="1209674" y="505619"/>
                  <a:pt x="1234677" y="520156"/>
                  <a:pt x="1313258" y="505619"/>
                </a:cubicBezTo>
                <a:cubicBezTo>
                  <a:pt x="1434702" y="482359"/>
                  <a:pt x="1495424" y="517249"/>
                  <a:pt x="1463277" y="610287"/>
                </a:cubicBezTo>
                <a:cubicBezTo>
                  <a:pt x="1431130" y="697511"/>
                  <a:pt x="1477565" y="706233"/>
                  <a:pt x="1545430" y="682974"/>
                </a:cubicBezTo>
                <a:cubicBezTo>
                  <a:pt x="1645442" y="648084"/>
                  <a:pt x="1724024" y="685881"/>
                  <a:pt x="1809749" y="712048"/>
                </a:cubicBezTo>
                <a:cubicBezTo>
                  <a:pt x="1938336" y="752753"/>
                  <a:pt x="2002630" y="735308"/>
                  <a:pt x="2099071" y="650992"/>
                </a:cubicBezTo>
                <a:cubicBezTo>
                  <a:pt x="2152648" y="601565"/>
                  <a:pt x="2199083" y="552138"/>
                  <a:pt x="2245518" y="482359"/>
                </a:cubicBezTo>
                <a:cubicBezTo>
                  <a:pt x="2270521" y="642269"/>
                  <a:pt x="2356245" y="476544"/>
                  <a:pt x="2409824" y="531786"/>
                </a:cubicBezTo>
                <a:cubicBezTo>
                  <a:pt x="2431255" y="645176"/>
                  <a:pt x="2259804" y="735308"/>
                  <a:pt x="2309812" y="889403"/>
                </a:cubicBezTo>
                <a:cubicBezTo>
                  <a:pt x="2456258" y="703326"/>
                  <a:pt x="2502693" y="493989"/>
                  <a:pt x="2699146" y="357339"/>
                </a:cubicBezTo>
                <a:cubicBezTo>
                  <a:pt x="2742008" y="389321"/>
                  <a:pt x="2699146" y="421303"/>
                  <a:pt x="2717006" y="447469"/>
                </a:cubicBezTo>
                <a:cubicBezTo>
                  <a:pt x="2727721" y="447469"/>
                  <a:pt x="2659854" y="752753"/>
                  <a:pt x="2938461" y="770197"/>
                </a:cubicBezTo>
                <a:cubicBezTo>
                  <a:pt x="2938461" y="776012"/>
                  <a:pt x="2938461" y="781827"/>
                  <a:pt x="2949178" y="787642"/>
                </a:cubicBezTo>
                <a:cubicBezTo>
                  <a:pt x="2988467" y="819624"/>
                  <a:pt x="3081336" y="790550"/>
                  <a:pt x="3088480" y="842883"/>
                </a:cubicBezTo>
                <a:cubicBezTo>
                  <a:pt x="3095624" y="901033"/>
                  <a:pt x="3127771" y="956275"/>
                  <a:pt x="3109911" y="1017331"/>
                </a:cubicBezTo>
                <a:cubicBezTo>
                  <a:pt x="3095624" y="1063850"/>
                  <a:pt x="3077765" y="1113276"/>
                  <a:pt x="3077765" y="1162704"/>
                </a:cubicBezTo>
                <a:cubicBezTo>
                  <a:pt x="3077765" y="1215038"/>
                  <a:pt x="2956320" y="1287724"/>
                  <a:pt x="3117055" y="1319707"/>
                </a:cubicBezTo>
                <a:cubicBezTo>
                  <a:pt x="3124198" y="1319707"/>
                  <a:pt x="3106339" y="1409837"/>
                  <a:pt x="3099196" y="1459264"/>
                </a:cubicBezTo>
                <a:cubicBezTo>
                  <a:pt x="3092052" y="1499968"/>
                  <a:pt x="3059905" y="1549396"/>
                  <a:pt x="3124198" y="1578470"/>
                </a:cubicBezTo>
                <a:cubicBezTo>
                  <a:pt x="3163490" y="1593007"/>
                  <a:pt x="3234927" y="1523228"/>
                  <a:pt x="3242071" y="1462171"/>
                </a:cubicBezTo>
                <a:cubicBezTo>
                  <a:pt x="3249214" y="1406930"/>
                  <a:pt x="3256358" y="1351689"/>
                  <a:pt x="3242071" y="1299354"/>
                </a:cubicBezTo>
                <a:cubicBezTo>
                  <a:pt x="3224212" y="1235390"/>
                  <a:pt x="3252786" y="1200500"/>
                  <a:pt x="3317080" y="1183056"/>
                </a:cubicBezTo>
                <a:cubicBezTo>
                  <a:pt x="3384945" y="1162704"/>
                  <a:pt x="3420664" y="1124907"/>
                  <a:pt x="3452811" y="1072572"/>
                </a:cubicBezTo>
                <a:cubicBezTo>
                  <a:pt x="3531392" y="944644"/>
                  <a:pt x="3624261" y="822532"/>
                  <a:pt x="3670696" y="682973"/>
                </a:cubicBezTo>
                <a:cubicBezTo>
                  <a:pt x="3677840" y="656807"/>
                  <a:pt x="3692127" y="624825"/>
                  <a:pt x="3752849" y="613194"/>
                </a:cubicBezTo>
                <a:cubicBezTo>
                  <a:pt x="3659980" y="991164"/>
                  <a:pt x="3420664" y="1334243"/>
                  <a:pt x="3434952" y="1723843"/>
                </a:cubicBezTo>
                <a:cubicBezTo>
                  <a:pt x="3509961" y="1619174"/>
                  <a:pt x="3513533" y="1494154"/>
                  <a:pt x="3567111" y="1380763"/>
                </a:cubicBezTo>
                <a:cubicBezTo>
                  <a:pt x="3606402" y="1462171"/>
                  <a:pt x="3563540" y="1537765"/>
                  <a:pt x="3542109" y="1613360"/>
                </a:cubicBezTo>
                <a:cubicBezTo>
                  <a:pt x="3524249" y="1677323"/>
                  <a:pt x="3520677" y="1735472"/>
                  <a:pt x="3631405" y="1741287"/>
                </a:cubicBezTo>
                <a:cubicBezTo>
                  <a:pt x="3642121" y="1741287"/>
                  <a:pt x="3649265" y="1741287"/>
                  <a:pt x="3659980" y="1741287"/>
                </a:cubicBezTo>
                <a:cubicBezTo>
                  <a:pt x="3706414" y="1718028"/>
                  <a:pt x="3727846" y="1686046"/>
                  <a:pt x="3742133" y="1645341"/>
                </a:cubicBezTo>
                <a:cubicBezTo>
                  <a:pt x="3749277" y="1622082"/>
                  <a:pt x="3763564" y="1590100"/>
                  <a:pt x="3795712" y="1590100"/>
                </a:cubicBezTo>
                <a:cubicBezTo>
                  <a:pt x="3917155" y="1593007"/>
                  <a:pt x="3952874" y="1514506"/>
                  <a:pt x="3988593" y="1438912"/>
                </a:cubicBezTo>
                <a:cubicBezTo>
                  <a:pt x="4049315" y="1479616"/>
                  <a:pt x="4006452" y="1514506"/>
                  <a:pt x="4010024" y="1546488"/>
                </a:cubicBezTo>
                <a:cubicBezTo>
                  <a:pt x="4013596" y="1566840"/>
                  <a:pt x="4017167" y="1587192"/>
                  <a:pt x="4049315" y="1587192"/>
                </a:cubicBezTo>
                <a:cubicBezTo>
                  <a:pt x="4074317" y="1587192"/>
                  <a:pt x="4106465" y="1578470"/>
                  <a:pt x="4106465" y="1558118"/>
                </a:cubicBezTo>
                <a:cubicBezTo>
                  <a:pt x="4110036" y="1430190"/>
                  <a:pt x="4281487" y="1357503"/>
                  <a:pt x="4281487" y="1223760"/>
                </a:cubicBezTo>
                <a:cubicBezTo>
                  <a:pt x="4281487" y="1142351"/>
                  <a:pt x="4377927" y="1264465"/>
                  <a:pt x="4417219" y="1197593"/>
                </a:cubicBezTo>
                <a:cubicBezTo>
                  <a:pt x="4427935" y="1183056"/>
                  <a:pt x="4442220" y="1238297"/>
                  <a:pt x="4438649" y="1261557"/>
                </a:cubicBezTo>
                <a:cubicBezTo>
                  <a:pt x="4435078" y="1284817"/>
                  <a:pt x="4410074" y="1305169"/>
                  <a:pt x="4427935" y="1334243"/>
                </a:cubicBezTo>
                <a:cubicBezTo>
                  <a:pt x="4492228" y="1348781"/>
                  <a:pt x="4517230" y="1310983"/>
                  <a:pt x="4535090" y="1276094"/>
                </a:cubicBezTo>
                <a:cubicBezTo>
                  <a:pt x="4577952" y="1200500"/>
                  <a:pt x="4627958" y="1124907"/>
                  <a:pt x="4642246" y="1040590"/>
                </a:cubicBezTo>
                <a:cubicBezTo>
                  <a:pt x="4645817" y="1011516"/>
                  <a:pt x="4663677" y="994071"/>
                  <a:pt x="4699396" y="996979"/>
                </a:cubicBezTo>
                <a:cubicBezTo>
                  <a:pt x="4745832" y="1002793"/>
                  <a:pt x="4731544" y="1031868"/>
                  <a:pt x="4727971" y="1055128"/>
                </a:cubicBezTo>
                <a:cubicBezTo>
                  <a:pt x="4724399" y="1069665"/>
                  <a:pt x="4713683" y="1084202"/>
                  <a:pt x="4738688" y="1098740"/>
                </a:cubicBezTo>
                <a:cubicBezTo>
                  <a:pt x="4992291" y="758568"/>
                  <a:pt x="4978002" y="578305"/>
                  <a:pt x="5185172" y="197429"/>
                </a:cubicBezTo>
                <a:cubicBezTo>
                  <a:pt x="5224462" y="281744"/>
                  <a:pt x="5195887" y="342801"/>
                  <a:pt x="5188744" y="400950"/>
                </a:cubicBezTo>
                <a:cubicBezTo>
                  <a:pt x="5170883" y="546323"/>
                  <a:pt x="5138736" y="456192"/>
                  <a:pt x="5117306" y="601565"/>
                </a:cubicBezTo>
                <a:cubicBezTo>
                  <a:pt x="5106590" y="671344"/>
                  <a:pt x="5070871" y="735308"/>
                  <a:pt x="5128021" y="813809"/>
                </a:cubicBezTo>
                <a:cubicBezTo>
                  <a:pt x="5167312" y="866143"/>
                  <a:pt x="5124450" y="950459"/>
                  <a:pt x="5092302" y="1014423"/>
                </a:cubicBezTo>
                <a:cubicBezTo>
                  <a:pt x="5063727" y="1066758"/>
                  <a:pt x="5056585" y="1119092"/>
                  <a:pt x="5092302" y="1188871"/>
                </a:cubicBezTo>
                <a:cubicBezTo>
                  <a:pt x="5113734" y="1124907"/>
                  <a:pt x="5131592" y="1075480"/>
                  <a:pt x="5145880" y="1026053"/>
                </a:cubicBezTo>
                <a:cubicBezTo>
                  <a:pt x="5156596" y="985349"/>
                  <a:pt x="5181600" y="962089"/>
                  <a:pt x="5235177" y="964997"/>
                </a:cubicBezTo>
                <a:cubicBezTo>
                  <a:pt x="5263752" y="964997"/>
                  <a:pt x="5303044" y="956275"/>
                  <a:pt x="5317331" y="985349"/>
                </a:cubicBezTo>
                <a:cubicBezTo>
                  <a:pt x="5331618" y="1008608"/>
                  <a:pt x="5317331" y="1040590"/>
                  <a:pt x="5292327" y="1052221"/>
                </a:cubicBezTo>
                <a:cubicBezTo>
                  <a:pt x="5245894" y="1066758"/>
                  <a:pt x="5203031" y="1081295"/>
                  <a:pt x="5199458" y="1130722"/>
                </a:cubicBezTo>
                <a:cubicBezTo>
                  <a:pt x="5192315" y="1197593"/>
                  <a:pt x="5220889" y="1159796"/>
                  <a:pt x="5256608" y="1148166"/>
                </a:cubicBezTo>
                <a:cubicBezTo>
                  <a:pt x="5295899" y="1136536"/>
                  <a:pt x="5306616" y="1171426"/>
                  <a:pt x="5299471" y="1194686"/>
                </a:cubicBezTo>
                <a:cubicBezTo>
                  <a:pt x="5267324" y="1281909"/>
                  <a:pt x="5324474" y="1372040"/>
                  <a:pt x="5278039" y="1462171"/>
                </a:cubicBezTo>
                <a:cubicBezTo>
                  <a:pt x="5392339" y="1438912"/>
                  <a:pt x="5442347" y="1389485"/>
                  <a:pt x="5460205" y="1284817"/>
                </a:cubicBezTo>
                <a:cubicBezTo>
                  <a:pt x="5463777" y="1247020"/>
                  <a:pt x="5456634" y="1206315"/>
                  <a:pt x="5488780" y="1171426"/>
                </a:cubicBezTo>
                <a:cubicBezTo>
                  <a:pt x="5502175" y="1156162"/>
                  <a:pt x="5517579" y="1140898"/>
                  <a:pt x="5539513" y="1140353"/>
                </a:cubicBezTo>
                <a:lnTo>
                  <a:pt x="5552720" y="1143022"/>
                </a:lnTo>
                <a:lnTo>
                  <a:pt x="5574208" y="1115811"/>
                </a:lnTo>
                <a:cubicBezTo>
                  <a:pt x="5609034" y="1085646"/>
                  <a:pt x="5659040" y="1068202"/>
                  <a:pt x="5734050" y="1075470"/>
                </a:cubicBezTo>
                <a:cubicBezTo>
                  <a:pt x="5776912" y="1078377"/>
                  <a:pt x="5809058" y="1055118"/>
                  <a:pt x="5798343" y="1020228"/>
                </a:cubicBezTo>
                <a:cubicBezTo>
                  <a:pt x="5776912" y="953357"/>
                  <a:pt x="5837634" y="921375"/>
                  <a:pt x="5884068" y="883578"/>
                </a:cubicBezTo>
                <a:cubicBezTo>
                  <a:pt x="5966221" y="816706"/>
                  <a:pt x="6051947" y="752742"/>
                  <a:pt x="6066234" y="645166"/>
                </a:cubicBezTo>
                <a:cubicBezTo>
                  <a:pt x="6130528" y="665519"/>
                  <a:pt x="6123384" y="700408"/>
                  <a:pt x="6109096" y="732391"/>
                </a:cubicBezTo>
                <a:cubicBezTo>
                  <a:pt x="6073377" y="816706"/>
                  <a:pt x="6034087" y="901023"/>
                  <a:pt x="5998368" y="985338"/>
                </a:cubicBezTo>
                <a:cubicBezTo>
                  <a:pt x="5976937" y="1040581"/>
                  <a:pt x="5944790" y="1095822"/>
                  <a:pt x="5969793" y="1168509"/>
                </a:cubicBezTo>
                <a:cubicBezTo>
                  <a:pt x="6098380" y="1104545"/>
                  <a:pt x="6123384" y="996969"/>
                  <a:pt x="6162674" y="909745"/>
                </a:cubicBezTo>
                <a:cubicBezTo>
                  <a:pt x="6212681" y="802169"/>
                  <a:pt x="6305549" y="738205"/>
                  <a:pt x="6412705" y="659704"/>
                </a:cubicBezTo>
                <a:cubicBezTo>
                  <a:pt x="6441280" y="738205"/>
                  <a:pt x="6362699" y="787632"/>
                  <a:pt x="6366271" y="851596"/>
                </a:cubicBezTo>
                <a:cubicBezTo>
                  <a:pt x="6376987" y="854503"/>
                  <a:pt x="6398418" y="860319"/>
                  <a:pt x="6398418" y="860319"/>
                </a:cubicBezTo>
                <a:cubicBezTo>
                  <a:pt x="6455568" y="755650"/>
                  <a:pt x="6562724" y="709131"/>
                  <a:pt x="6694884" y="691686"/>
                </a:cubicBezTo>
                <a:cubicBezTo>
                  <a:pt x="6762750" y="685871"/>
                  <a:pt x="6784181" y="648074"/>
                  <a:pt x="6816327" y="610277"/>
                </a:cubicBezTo>
                <a:cubicBezTo>
                  <a:pt x="6927056" y="482349"/>
                  <a:pt x="7027068" y="345699"/>
                  <a:pt x="7177087" y="238123"/>
                </a:cubicBezTo>
                <a:cubicBezTo>
                  <a:pt x="7159228" y="363144"/>
                  <a:pt x="7059215" y="461997"/>
                  <a:pt x="7016353" y="592833"/>
                </a:cubicBezTo>
                <a:cubicBezTo>
                  <a:pt x="7180659" y="488164"/>
                  <a:pt x="7266384" y="351513"/>
                  <a:pt x="7366396" y="226493"/>
                </a:cubicBezTo>
                <a:cubicBezTo>
                  <a:pt x="7412830" y="168344"/>
                  <a:pt x="7469981" y="116010"/>
                  <a:pt x="7494984" y="49138"/>
                </a:cubicBezTo>
                <a:cubicBezTo>
                  <a:pt x="7500342" y="31693"/>
                  <a:pt x="7511727" y="4436"/>
                  <a:pt x="7538181" y="484"/>
                </a:cubicBezTo>
                <a:close/>
              </a:path>
            </a:pathLst>
          </a:custGeom>
          <a:solidFill>
            <a:schemeClr val="accent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73E18DEE-B2E3-5941-AA00-0473F3A81EDD}"/>
              </a:ext>
            </a:extLst>
          </p:cNvPr>
          <p:cNvSpPr>
            <a:spLocks noGrp="1"/>
          </p:cNvSpPr>
          <p:nvPr>
            <p:ph type="title"/>
          </p:nvPr>
        </p:nvSpPr>
        <p:spPr>
          <a:xfrm>
            <a:off x="838200" y="365125"/>
            <a:ext cx="10515600" cy="1325563"/>
          </a:xfrm>
        </p:spPr>
        <p:txBody>
          <a:bodyPr>
            <a:normAutofit/>
          </a:bodyPr>
          <a:lstStyle/>
          <a:p>
            <a:r>
              <a:rPr lang="en-US" dirty="0"/>
              <a:t>Naming</a:t>
            </a:r>
          </a:p>
        </p:txBody>
      </p:sp>
      <p:graphicFrame>
        <p:nvGraphicFramePr>
          <p:cNvPr id="8" name="Content Placeholder 5">
            <a:extLst>
              <a:ext uri="{FF2B5EF4-FFF2-40B4-BE49-F238E27FC236}">
                <a16:creationId xmlns:a16="http://schemas.microsoft.com/office/drawing/2014/main" id="{EBE33992-AEAD-4505-1924-026D083418FB}"/>
              </a:ext>
            </a:extLst>
          </p:cNvPr>
          <p:cNvGraphicFramePr>
            <a:graphicFrameLocks noGrp="1"/>
          </p:cNvGraphicFramePr>
          <p:nvPr>
            <p:ph idx="1"/>
            <p:extLst>
              <p:ext uri="{D42A27DB-BD31-4B8C-83A1-F6EECF244321}">
                <p14:modId xmlns:p14="http://schemas.microsoft.com/office/powerpoint/2010/main" val="3579908884"/>
              </p:ext>
            </p:extLst>
          </p:nvPr>
        </p:nvGraphicFramePr>
        <p:xfrm>
          <a:off x="838200" y="2011363"/>
          <a:ext cx="10515600" cy="416083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35787794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5" name="Rectangle 14">
            <a:extLst>
              <a:ext uri="{FF2B5EF4-FFF2-40B4-BE49-F238E27FC236}">
                <a16:creationId xmlns:a16="http://schemas.microsoft.com/office/drawing/2014/main" id="{DA8886A6-5426-494B-96D8-D962D2BA08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Freeform: Shape 16">
            <a:extLst>
              <a:ext uri="{FF2B5EF4-FFF2-40B4-BE49-F238E27FC236}">
                <a16:creationId xmlns:a16="http://schemas.microsoft.com/office/drawing/2014/main" id="{AA3ED336-C09E-46E8-9774-B977D15FC5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752347"/>
            <a:ext cx="12191999" cy="6105653"/>
          </a:xfrm>
          <a:custGeom>
            <a:avLst/>
            <a:gdLst>
              <a:gd name="connsiteX0" fmla="*/ 7538181 w 12191999"/>
              <a:gd name="connsiteY0" fmla="*/ 484 h 6105653"/>
              <a:gd name="connsiteX1" fmla="*/ 7569993 w 12191999"/>
              <a:gd name="connsiteY1" fmla="*/ 5527 h 6105653"/>
              <a:gd name="connsiteX2" fmla="*/ 7587853 w 12191999"/>
              <a:gd name="connsiteY2" fmla="*/ 84028 h 6105653"/>
              <a:gd name="connsiteX3" fmla="*/ 7559278 w 12191999"/>
              <a:gd name="connsiteY3" fmla="*/ 325347 h 6105653"/>
              <a:gd name="connsiteX4" fmla="*/ 7795021 w 12191999"/>
              <a:gd name="connsiteY4" fmla="*/ 25878 h 6105653"/>
              <a:gd name="connsiteX5" fmla="*/ 7759302 w 12191999"/>
              <a:gd name="connsiteY5" fmla="*/ 249752 h 6105653"/>
              <a:gd name="connsiteX6" fmla="*/ 7852171 w 12191999"/>
              <a:gd name="connsiteY6" fmla="*/ 313717 h 6105653"/>
              <a:gd name="connsiteX7" fmla="*/ 8002190 w 12191999"/>
              <a:gd name="connsiteY7" fmla="*/ 418385 h 6105653"/>
              <a:gd name="connsiteX8" fmla="*/ 8084343 w 12191999"/>
              <a:gd name="connsiteY8" fmla="*/ 491072 h 6105653"/>
              <a:gd name="connsiteX9" fmla="*/ 8348662 w 12191999"/>
              <a:gd name="connsiteY9" fmla="*/ 520146 h 6105653"/>
              <a:gd name="connsiteX10" fmla="*/ 8637984 w 12191999"/>
              <a:gd name="connsiteY10" fmla="*/ 459090 h 6105653"/>
              <a:gd name="connsiteX11" fmla="*/ 8784431 w 12191999"/>
              <a:gd name="connsiteY11" fmla="*/ 290457 h 6105653"/>
              <a:gd name="connsiteX12" fmla="*/ 8948737 w 12191999"/>
              <a:gd name="connsiteY12" fmla="*/ 339884 h 6105653"/>
              <a:gd name="connsiteX13" fmla="*/ 8848725 w 12191999"/>
              <a:gd name="connsiteY13" fmla="*/ 697501 h 6105653"/>
              <a:gd name="connsiteX14" fmla="*/ 9238059 w 12191999"/>
              <a:gd name="connsiteY14" fmla="*/ 165437 h 6105653"/>
              <a:gd name="connsiteX15" fmla="*/ 9255919 w 12191999"/>
              <a:gd name="connsiteY15" fmla="*/ 255567 h 6105653"/>
              <a:gd name="connsiteX16" fmla="*/ 9477374 w 12191999"/>
              <a:gd name="connsiteY16" fmla="*/ 578295 h 6105653"/>
              <a:gd name="connsiteX17" fmla="*/ 9488091 w 12191999"/>
              <a:gd name="connsiteY17" fmla="*/ 595740 h 6105653"/>
              <a:gd name="connsiteX18" fmla="*/ 9627393 w 12191999"/>
              <a:gd name="connsiteY18" fmla="*/ 650981 h 6105653"/>
              <a:gd name="connsiteX19" fmla="*/ 9648824 w 12191999"/>
              <a:gd name="connsiteY19" fmla="*/ 825429 h 6105653"/>
              <a:gd name="connsiteX20" fmla="*/ 9616678 w 12191999"/>
              <a:gd name="connsiteY20" fmla="*/ 970802 h 6105653"/>
              <a:gd name="connsiteX21" fmla="*/ 9655968 w 12191999"/>
              <a:gd name="connsiteY21" fmla="*/ 1127805 h 6105653"/>
              <a:gd name="connsiteX22" fmla="*/ 9638109 w 12191999"/>
              <a:gd name="connsiteY22" fmla="*/ 1267362 h 6105653"/>
              <a:gd name="connsiteX23" fmla="*/ 9663111 w 12191999"/>
              <a:gd name="connsiteY23" fmla="*/ 1386568 h 6105653"/>
              <a:gd name="connsiteX24" fmla="*/ 9780984 w 12191999"/>
              <a:gd name="connsiteY24" fmla="*/ 1270269 h 6105653"/>
              <a:gd name="connsiteX25" fmla="*/ 9780984 w 12191999"/>
              <a:gd name="connsiteY25" fmla="*/ 1107452 h 6105653"/>
              <a:gd name="connsiteX26" fmla="*/ 9855993 w 12191999"/>
              <a:gd name="connsiteY26" fmla="*/ 991154 h 6105653"/>
              <a:gd name="connsiteX27" fmla="*/ 9991724 w 12191999"/>
              <a:gd name="connsiteY27" fmla="*/ 880670 h 6105653"/>
              <a:gd name="connsiteX28" fmla="*/ 10209609 w 12191999"/>
              <a:gd name="connsiteY28" fmla="*/ 491071 h 6105653"/>
              <a:gd name="connsiteX29" fmla="*/ 10291762 w 12191999"/>
              <a:gd name="connsiteY29" fmla="*/ 421292 h 6105653"/>
              <a:gd name="connsiteX30" fmla="*/ 9973865 w 12191999"/>
              <a:gd name="connsiteY30" fmla="*/ 1531941 h 6105653"/>
              <a:gd name="connsiteX31" fmla="*/ 10106024 w 12191999"/>
              <a:gd name="connsiteY31" fmla="*/ 1188861 h 6105653"/>
              <a:gd name="connsiteX32" fmla="*/ 10081022 w 12191999"/>
              <a:gd name="connsiteY32" fmla="*/ 1421458 h 6105653"/>
              <a:gd name="connsiteX33" fmla="*/ 10170318 w 12191999"/>
              <a:gd name="connsiteY33" fmla="*/ 1549385 h 6105653"/>
              <a:gd name="connsiteX34" fmla="*/ 10198893 w 12191999"/>
              <a:gd name="connsiteY34" fmla="*/ 1549385 h 6105653"/>
              <a:gd name="connsiteX35" fmla="*/ 10281046 w 12191999"/>
              <a:gd name="connsiteY35" fmla="*/ 1453439 h 6105653"/>
              <a:gd name="connsiteX36" fmla="*/ 10334625 w 12191999"/>
              <a:gd name="connsiteY36" fmla="*/ 1398198 h 6105653"/>
              <a:gd name="connsiteX37" fmla="*/ 10527506 w 12191999"/>
              <a:gd name="connsiteY37" fmla="*/ 1247010 h 6105653"/>
              <a:gd name="connsiteX38" fmla="*/ 10548937 w 12191999"/>
              <a:gd name="connsiteY38" fmla="*/ 1354586 h 6105653"/>
              <a:gd name="connsiteX39" fmla="*/ 10588228 w 12191999"/>
              <a:gd name="connsiteY39" fmla="*/ 1395290 h 6105653"/>
              <a:gd name="connsiteX40" fmla="*/ 10645378 w 12191999"/>
              <a:gd name="connsiteY40" fmla="*/ 1366216 h 6105653"/>
              <a:gd name="connsiteX41" fmla="*/ 10820400 w 12191999"/>
              <a:gd name="connsiteY41" fmla="*/ 1031858 h 6105653"/>
              <a:gd name="connsiteX42" fmla="*/ 10956131 w 12191999"/>
              <a:gd name="connsiteY42" fmla="*/ 1005691 h 6105653"/>
              <a:gd name="connsiteX43" fmla="*/ 10977562 w 12191999"/>
              <a:gd name="connsiteY43" fmla="*/ 1069655 h 6105653"/>
              <a:gd name="connsiteX44" fmla="*/ 10966847 w 12191999"/>
              <a:gd name="connsiteY44" fmla="*/ 1142341 h 6105653"/>
              <a:gd name="connsiteX45" fmla="*/ 11074003 w 12191999"/>
              <a:gd name="connsiteY45" fmla="*/ 1084192 h 6105653"/>
              <a:gd name="connsiteX46" fmla="*/ 11181159 w 12191999"/>
              <a:gd name="connsiteY46" fmla="*/ 848688 h 6105653"/>
              <a:gd name="connsiteX47" fmla="*/ 11238309 w 12191999"/>
              <a:gd name="connsiteY47" fmla="*/ 805077 h 6105653"/>
              <a:gd name="connsiteX48" fmla="*/ 11266884 w 12191999"/>
              <a:gd name="connsiteY48" fmla="*/ 863226 h 6105653"/>
              <a:gd name="connsiteX49" fmla="*/ 11277600 w 12191999"/>
              <a:gd name="connsiteY49" fmla="*/ 906838 h 6105653"/>
              <a:gd name="connsiteX50" fmla="*/ 11724084 w 12191999"/>
              <a:gd name="connsiteY50" fmla="*/ 5527 h 6105653"/>
              <a:gd name="connsiteX51" fmla="*/ 11727656 w 12191999"/>
              <a:gd name="connsiteY51" fmla="*/ 209048 h 6105653"/>
              <a:gd name="connsiteX52" fmla="*/ 11656218 w 12191999"/>
              <a:gd name="connsiteY52" fmla="*/ 409663 h 6105653"/>
              <a:gd name="connsiteX53" fmla="*/ 11666934 w 12191999"/>
              <a:gd name="connsiteY53" fmla="*/ 621907 h 6105653"/>
              <a:gd name="connsiteX54" fmla="*/ 11631215 w 12191999"/>
              <a:gd name="connsiteY54" fmla="*/ 822521 h 6105653"/>
              <a:gd name="connsiteX55" fmla="*/ 11631215 w 12191999"/>
              <a:gd name="connsiteY55" fmla="*/ 996969 h 6105653"/>
              <a:gd name="connsiteX56" fmla="*/ 11684793 w 12191999"/>
              <a:gd name="connsiteY56" fmla="*/ 834151 h 6105653"/>
              <a:gd name="connsiteX57" fmla="*/ 11774090 w 12191999"/>
              <a:gd name="connsiteY57" fmla="*/ 773095 h 6105653"/>
              <a:gd name="connsiteX58" fmla="*/ 11856243 w 12191999"/>
              <a:gd name="connsiteY58" fmla="*/ 793447 h 6105653"/>
              <a:gd name="connsiteX59" fmla="*/ 11831240 w 12191999"/>
              <a:gd name="connsiteY59" fmla="*/ 860319 h 6105653"/>
              <a:gd name="connsiteX60" fmla="*/ 11738371 w 12191999"/>
              <a:gd name="connsiteY60" fmla="*/ 938820 h 6105653"/>
              <a:gd name="connsiteX61" fmla="*/ 11795521 w 12191999"/>
              <a:gd name="connsiteY61" fmla="*/ 956264 h 6105653"/>
              <a:gd name="connsiteX62" fmla="*/ 11838384 w 12191999"/>
              <a:gd name="connsiteY62" fmla="*/ 1002784 h 6105653"/>
              <a:gd name="connsiteX63" fmla="*/ 11816952 w 12191999"/>
              <a:gd name="connsiteY63" fmla="*/ 1270269 h 6105653"/>
              <a:gd name="connsiteX64" fmla="*/ 11999118 w 12191999"/>
              <a:gd name="connsiteY64" fmla="*/ 1092915 h 6105653"/>
              <a:gd name="connsiteX65" fmla="*/ 12027693 w 12191999"/>
              <a:gd name="connsiteY65" fmla="*/ 979524 h 6105653"/>
              <a:gd name="connsiteX66" fmla="*/ 12102703 w 12191999"/>
              <a:gd name="connsiteY66" fmla="*/ 953357 h 6105653"/>
              <a:gd name="connsiteX67" fmla="*/ 12120562 w 12191999"/>
              <a:gd name="connsiteY67" fmla="*/ 1005691 h 6105653"/>
              <a:gd name="connsiteX68" fmla="*/ 12056268 w 12191999"/>
              <a:gd name="connsiteY68" fmla="*/ 1267362 h 6105653"/>
              <a:gd name="connsiteX69" fmla="*/ 12081272 w 12191999"/>
              <a:gd name="connsiteY69" fmla="*/ 1310974 h 6105653"/>
              <a:gd name="connsiteX70" fmla="*/ 12191999 w 12191999"/>
              <a:gd name="connsiteY70" fmla="*/ 1008598 h 6105653"/>
              <a:gd name="connsiteX71" fmla="*/ 12191999 w 12191999"/>
              <a:gd name="connsiteY71" fmla="*/ 6105653 h 6105653"/>
              <a:gd name="connsiteX72" fmla="*/ 0 w 12191999"/>
              <a:gd name="connsiteY72" fmla="*/ 6105653 h 6105653"/>
              <a:gd name="connsiteX73" fmla="*/ 0 w 12191999"/>
              <a:gd name="connsiteY73" fmla="*/ 927116 h 6105653"/>
              <a:gd name="connsiteX74" fmla="*/ 61930 w 12191999"/>
              <a:gd name="connsiteY74" fmla="*/ 902578 h 6105653"/>
              <a:gd name="connsiteX75" fmla="*/ 155971 w 12191999"/>
              <a:gd name="connsiteY75" fmla="*/ 883588 h 6105653"/>
              <a:gd name="connsiteX76" fmla="*/ 277414 w 12191999"/>
              <a:gd name="connsiteY76" fmla="*/ 802179 h 6105653"/>
              <a:gd name="connsiteX77" fmla="*/ 638174 w 12191999"/>
              <a:gd name="connsiteY77" fmla="*/ 430025 h 6105653"/>
              <a:gd name="connsiteX78" fmla="*/ 477440 w 12191999"/>
              <a:gd name="connsiteY78" fmla="*/ 784735 h 6105653"/>
              <a:gd name="connsiteX79" fmla="*/ 827483 w 12191999"/>
              <a:gd name="connsiteY79" fmla="*/ 418395 h 6105653"/>
              <a:gd name="connsiteX80" fmla="*/ 956071 w 12191999"/>
              <a:gd name="connsiteY80" fmla="*/ 241040 h 6105653"/>
              <a:gd name="connsiteX81" fmla="*/ 999268 w 12191999"/>
              <a:gd name="connsiteY81" fmla="*/ 192386 h 6105653"/>
              <a:gd name="connsiteX82" fmla="*/ 1031080 w 12191999"/>
              <a:gd name="connsiteY82" fmla="*/ 197429 h 6105653"/>
              <a:gd name="connsiteX83" fmla="*/ 1048940 w 12191999"/>
              <a:gd name="connsiteY83" fmla="*/ 275930 h 6105653"/>
              <a:gd name="connsiteX84" fmla="*/ 1020365 w 12191999"/>
              <a:gd name="connsiteY84" fmla="*/ 517249 h 6105653"/>
              <a:gd name="connsiteX85" fmla="*/ 1256108 w 12191999"/>
              <a:gd name="connsiteY85" fmla="*/ 217780 h 6105653"/>
              <a:gd name="connsiteX86" fmla="*/ 1220389 w 12191999"/>
              <a:gd name="connsiteY86" fmla="*/ 441654 h 6105653"/>
              <a:gd name="connsiteX87" fmla="*/ 1313258 w 12191999"/>
              <a:gd name="connsiteY87" fmla="*/ 505619 h 6105653"/>
              <a:gd name="connsiteX88" fmla="*/ 1463277 w 12191999"/>
              <a:gd name="connsiteY88" fmla="*/ 610287 h 6105653"/>
              <a:gd name="connsiteX89" fmla="*/ 1545430 w 12191999"/>
              <a:gd name="connsiteY89" fmla="*/ 682974 h 6105653"/>
              <a:gd name="connsiteX90" fmla="*/ 1809749 w 12191999"/>
              <a:gd name="connsiteY90" fmla="*/ 712048 h 6105653"/>
              <a:gd name="connsiteX91" fmla="*/ 2099071 w 12191999"/>
              <a:gd name="connsiteY91" fmla="*/ 650992 h 6105653"/>
              <a:gd name="connsiteX92" fmla="*/ 2245518 w 12191999"/>
              <a:gd name="connsiteY92" fmla="*/ 482359 h 6105653"/>
              <a:gd name="connsiteX93" fmla="*/ 2409824 w 12191999"/>
              <a:gd name="connsiteY93" fmla="*/ 531786 h 6105653"/>
              <a:gd name="connsiteX94" fmla="*/ 2309812 w 12191999"/>
              <a:gd name="connsiteY94" fmla="*/ 889403 h 6105653"/>
              <a:gd name="connsiteX95" fmla="*/ 2699146 w 12191999"/>
              <a:gd name="connsiteY95" fmla="*/ 357339 h 6105653"/>
              <a:gd name="connsiteX96" fmla="*/ 2717006 w 12191999"/>
              <a:gd name="connsiteY96" fmla="*/ 447469 h 6105653"/>
              <a:gd name="connsiteX97" fmla="*/ 2938461 w 12191999"/>
              <a:gd name="connsiteY97" fmla="*/ 770197 h 6105653"/>
              <a:gd name="connsiteX98" fmla="*/ 2949178 w 12191999"/>
              <a:gd name="connsiteY98" fmla="*/ 787642 h 6105653"/>
              <a:gd name="connsiteX99" fmla="*/ 3088480 w 12191999"/>
              <a:gd name="connsiteY99" fmla="*/ 842883 h 6105653"/>
              <a:gd name="connsiteX100" fmla="*/ 3109911 w 12191999"/>
              <a:gd name="connsiteY100" fmla="*/ 1017331 h 6105653"/>
              <a:gd name="connsiteX101" fmla="*/ 3077765 w 12191999"/>
              <a:gd name="connsiteY101" fmla="*/ 1162704 h 6105653"/>
              <a:gd name="connsiteX102" fmla="*/ 3117055 w 12191999"/>
              <a:gd name="connsiteY102" fmla="*/ 1319707 h 6105653"/>
              <a:gd name="connsiteX103" fmla="*/ 3099196 w 12191999"/>
              <a:gd name="connsiteY103" fmla="*/ 1459264 h 6105653"/>
              <a:gd name="connsiteX104" fmla="*/ 3124198 w 12191999"/>
              <a:gd name="connsiteY104" fmla="*/ 1578470 h 6105653"/>
              <a:gd name="connsiteX105" fmla="*/ 3242071 w 12191999"/>
              <a:gd name="connsiteY105" fmla="*/ 1462171 h 6105653"/>
              <a:gd name="connsiteX106" fmla="*/ 3242071 w 12191999"/>
              <a:gd name="connsiteY106" fmla="*/ 1299354 h 6105653"/>
              <a:gd name="connsiteX107" fmla="*/ 3317080 w 12191999"/>
              <a:gd name="connsiteY107" fmla="*/ 1183056 h 6105653"/>
              <a:gd name="connsiteX108" fmla="*/ 3452811 w 12191999"/>
              <a:gd name="connsiteY108" fmla="*/ 1072572 h 6105653"/>
              <a:gd name="connsiteX109" fmla="*/ 3670696 w 12191999"/>
              <a:gd name="connsiteY109" fmla="*/ 682973 h 6105653"/>
              <a:gd name="connsiteX110" fmla="*/ 3752849 w 12191999"/>
              <a:gd name="connsiteY110" fmla="*/ 613194 h 6105653"/>
              <a:gd name="connsiteX111" fmla="*/ 3434952 w 12191999"/>
              <a:gd name="connsiteY111" fmla="*/ 1723843 h 6105653"/>
              <a:gd name="connsiteX112" fmla="*/ 3567111 w 12191999"/>
              <a:gd name="connsiteY112" fmla="*/ 1380763 h 6105653"/>
              <a:gd name="connsiteX113" fmla="*/ 3542109 w 12191999"/>
              <a:gd name="connsiteY113" fmla="*/ 1613360 h 6105653"/>
              <a:gd name="connsiteX114" fmla="*/ 3631405 w 12191999"/>
              <a:gd name="connsiteY114" fmla="*/ 1741287 h 6105653"/>
              <a:gd name="connsiteX115" fmla="*/ 3659980 w 12191999"/>
              <a:gd name="connsiteY115" fmla="*/ 1741287 h 6105653"/>
              <a:gd name="connsiteX116" fmla="*/ 3742133 w 12191999"/>
              <a:gd name="connsiteY116" fmla="*/ 1645341 h 6105653"/>
              <a:gd name="connsiteX117" fmla="*/ 3795712 w 12191999"/>
              <a:gd name="connsiteY117" fmla="*/ 1590100 h 6105653"/>
              <a:gd name="connsiteX118" fmla="*/ 3988593 w 12191999"/>
              <a:gd name="connsiteY118" fmla="*/ 1438912 h 6105653"/>
              <a:gd name="connsiteX119" fmla="*/ 4010024 w 12191999"/>
              <a:gd name="connsiteY119" fmla="*/ 1546488 h 6105653"/>
              <a:gd name="connsiteX120" fmla="*/ 4049315 w 12191999"/>
              <a:gd name="connsiteY120" fmla="*/ 1587192 h 6105653"/>
              <a:gd name="connsiteX121" fmla="*/ 4106465 w 12191999"/>
              <a:gd name="connsiteY121" fmla="*/ 1558118 h 6105653"/>
              <a:gd name="connsiteX122" fmla="*/ 4281487 w 12191999"/>
              <a:gd name="connsiteY122" fmla="*/ 1223760 h 6105653"/>
              <a:gd name="connsiteX123" fmla="*/ 4417219 w 12191999"/>
              <a:gd name="connsiteY123" fmla="*/ 1197593 h 6105653"/>
              <a:gd name="connsiteX124" fmla="*/ 4438649 w 12191999"/>
              <a:gd name="connsiteY124" fmla="*/ 1261557 h 6105653"/>
              <a:gd name="connsiteX125" fmla="*/ 4427935 w 12191999"/>
              <a:gd name="connsiteY125" fmla="*/ 1334243 h 6105653"/>
              <a:gd name="connsiteX126" fmla="*/ 4535090 w 12191999"/>
              <a:gd name="connsiteY126" fmla="*/ 1276094 h 6105653"/>
              <a:gd name="connsiteX127" fmla="*/ 4642246 w 12191999"/>
              <a:gd name="connsiteY127" fmla="*/ 1040590 h 6105653"/>
              <a:gd name="connsiteX128" fmla="*/ 4699396 w 12191999"/>
              <a:gd name="connsiteY128" fmla="*/ 996979 h 6105653"/>
              <a:gd name="connsiteX129" fmla="*/ 4727971 w 12191999"/>
              <a:gd name="connsiteY129" fmla="*/ 1055128 h 6105653"/>
              <a:gd name="connsiteX130" fmla="*/ 4738688 w 12191999"/>
              <a:gd name="connsiteY130" fmla="*/ 1098740 h 6105653"/>
              <a:gd name="connsiteX131" fmla="*/ 5185172 w 12191999"/>
              <a:gd name="connsiteY131" fmla="*/ 197429 h 6105653"/>
              <a:gd name="connsiteX132" fmla="*/ 5188744 w 12191999"/>
              <a:gd name="connsiteY132" fmla="*/ 400950 h 6105653"/>
              <a:gd name="connsiteX133" fmla="*/ 5117306 w 12191999"/>
              <a:gd name="connsiteY133" fmla="*/ 601565 h 6105653"/>
              <a:gd name="connsiteX134" fmla="*/ 5128021 w 12191999"/>
              <a:gd name="connsiteY134" fmla="*/ 813809 h 6105653"/>
              <a:gd name="connsiteX135" fmla="*/ 5092302 w 12191999"/>
              <a:gd name="connsiteY135" fmla="*/ 1014423 h 6105653"/>
              <a:gd name="connsiteX136" fmla="*/ 5092302 w 12191999"/>
              <a:gd name="connsiteY136" fmla="*/ 1188871 h 6105653"/>
              <a:gd name="connsiteX137" fmla="*/ 5145880 w 12191999"/>
              <a:gd name="connsiteY137" fmla="*/ 1026053 h 6105653"/>
              <a:gd name="connsiteX138" fmla="*/ 5235177 w 12191999"/>
              <a:gd name="connsiteY138" fmla="*/ 964997 h 6105653"/>
              <a:gd name="connsiteX139" fmla="*/ 5317331 w 12191999"/>
              <a:gd name="connsiteY139" fmla="*/ 985349 h 6105653"/>
              <a:gd name="connsiteX140" fmla="*/ 5292327 w 12191999"/>
              <a:gd name="connsiteY140" fmla="*/ 1052221 h 6105653"/>
              <a:gd name="connsiteX141" fmla="*/ 5199458 w 12191999"/>
              <a:gd name="connsiteY141" fmla="*/ 1130722 h 6105653"/>
              <a:gd name="connsiteX142" fmla="*/ 5256608 w 12191999"/>
              <a:gd name="connsiteY142" fmla="*/ 1148166 h 6105653"/>
              <a:gd name="connsiteX143" fmla="*/ 5299471 w 12191999"/>
              <a:gd name="connsiteY143" fmla="*/ 1194686 h 6105653"/>
              <a:gd name="connsiteX144" fmla="*/ 5278039 w 12191999"/>
              <a:gd name="connsiteY144" fmla="*/ 1462171 h 6105653"/>
              <a:gd name="connsiteX145" fmla="*/ 5460205 w 12191999"/>
              <a:gd name="connsiteY145" fmla="*/ 1284817 h 6105653"/>
              <a:gd name="connsiteX146" fmla="*/ 5488780 w 12191999"/>
              <a:gd name="connsiteY146" fmla="*/ 1171426 h 6105653"/>
              <a:gd name="connsiteX147" fmla="*/ 5539513 w 12191999"/>
              <a:gd name="connsiteY147" fmla="*/ 1140353 h 6105653"/>
              <a:gd name="connsiteX148" fmla="*/ 5552720 w 12191999"/>
              <a:gd name="connsiteY148" fmla="*/ 1143022 h 6105653"/>
              <a:gd name="connsiteX149" fmla="*/ 5574208 w 12191999"/>
              <a:gd name="connsiteY149" fmla="*/ 1115811 h 6105653"/>
              <a:gd name="connsiteX150" fmla="*/ 5734050 w 12191999"/>
              <a:gd name="connsiteY150" fmla="*/ 1075470 h 6105653"/>
              <a:gd name="connsiteX151" fmla="*/ 5798343 w 12191999"/>
              <a:gd name="connsiteY151" fmla="*/ 1020228 h 6105653"/>
              <a:gd name="connsiteX152" fmla="*/ 5884068 w 12191999"/>
              <a:gd name="connsiteY152" fmla="*/ 883578 h 6105653"/>
              <a:gd name="connsiteX153" fmla="*/ 6066234 w 12191999"/>
              <a:gd name="connsiteY153" fmla="*/ 645166 h 6105653"/>
              <a:gd name="connsiteX154" fmla="*/ 6109096 w 12191999"/>
              <a:gd name="connsiteY154" fmla="*/ 732391 h 6105653"/>
              <a:gd name="connsiteX155" fmla="*/ 5998368 w 12191999"/>
              <a:gd name="connsiteY155" fmla="*/ 985338 h 6105653"/>
              <a:gd name="connsiteX156" fmla="*/ 5969793 w 12191999"/>
              <a:gd name="connsiteY156" fmla="*/ 1168509 h 6105653"/>
              <a:gd name="connsiteX157" fmla="*/ 6162674 w 12191999"/>
              <a:gd name="connsiteY157" fmla="*/ 909745 h 6105653"/>
              <a:gd name="connsiteX158" fmla="*/ 6412705 w 12191999"/>
              <a:gd name="connsiteY158" fmla="*/ 659704 h 6105653"/>
              <a:gd name="connsiteX159" fmla="*/ 6366271 w 12191999"/>
              <a:gd name="connsiteY159" fmla="*/ 851596 h 6105653"/>
              <a:gd name="connsiteX160" fmla="*/ 6398418 w 12191999"/>
              <a:gd name="connsiteY160" fmla="*/ 860319 h 6105653"/>
              <a:gd name="connsiteX161" fmla="*/ 6694884 w 12191999"/>
              <a:gd name="connsiteY161" fmla="*/ 691686 h 6105653"/>
              <a:gd name="connsiteX162" fmla="*/ 6816327 w 12191999"/>
              <a:gd name="connsiteY162" fmla="*/ 610277 h 6105653"/>
              <a:gd name="connsiteX163" fmla="*/ 7177087 w 12191999"/>
              <a:gd name="connsiteY163" fmla="*/ 238123 h 6105653"/>
              <a:gd name="connsiteX164" fmla="*/ 7016353 w 12191999"/>
              <a:gd name="connsiteY164" fmla="*/ 592833 h 6105653"/>
              <a:gd name="connsiteX165" fmla="*/ 7366396 w 12191999"/>
              <a:gd name="connsiteY165" fmla="*/ 226493 h 6105653"/>
              <a:gd name="connsiteX166" fmla="*/ 7494984 w 12191999"/>
              <a:gd name="connsiteY166" fmla="*/ 49138 h 6105653"/>
              <a:gd name="connsiteX167" fmla="*/ 7538181 w 12191999"/>
              <a:gd name="connsiteY167" fmla="*/ 484 h 610565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Lst>
            <a:rect l="l" t="t" r="r" b="b"/>
            <a:pathLst>
              <a:path w="12191999" h="6105653">
                <a:moveTo>
                  <a:pt x="7538181" y="484"/>
                </a:moveTo>
                <a:cubicBezTo>
                  <a:pt x="7546999" y="-833"/>
                  <a:pt x="7557492" y="439"/>
                  <a:pt x="7569993" y="5527"/>
                </a:cubicBezTo>
                <a:cubicBezTo>
                  <a:pt x="7612855" y="22971"/>
                  <a:pt x="7598567" y="54953"/>
                  <a:pt x="7587853" y="84028"/>
                </a:cubicBezTo>
                <a:cubicBezTo>
                  <a:pt x="7559278" y="153806"/>
                  <a:pt x="7559278" y="229401"/>
                  <a:pt x="7559278" y="325347"/>
                </a:cubicBezTo>
                <a:cubicBezTo>
                  <a:pt x="7695009" y="243938"/>
                  <a:pt x="7652146" y="95658"/>
                  <a:pt x="7795021" y="25878"/>
                </a:cubicBezTo>
                <a:cubicBezTo>
                  <a:pt x="7820024" y="113102"/>
                  <a:pt x="7770018" y="179974"/>
                  <a:pt x="7759302" y="249752"/>
                </a:cubicBezTo>
                <a:cubicBezTo>
                  <a:pt x="7748587" y="313717"/>
                  <a:pt x="7773590" y="328254"/>
                  <a:pt x="7852171" y="313717"/>
                </a:cubicBezTo>
                <a:cubicBezTo>
                  <a:pt x="7973615" y="290457"/>
                  <a:pt x="8034337" y="325347"/>
                  <a:pt x="8002190" y="418385"/>
                </a:cubicBezTo>
                <a:cubicBezTo>
                  <a:pt x="7970043" y="505609"/>
                  <a:pt x="8016478" y="514331"/>
                  <a:pt x="8084343" y="491072"/>
                </a:cubicBezTo>
                <a:cubicBezTo>
                  <a:pt x="8184355" y="456182"/>
                  <a:pt x="8262937" y="493979"/>
                  <a:pt x="8348662" y="520146"/>
                </a:cubicBezTo>
                <a:cubicBezTo>
                  <a:pt x="8477249" y="560851"/>
                  <a:pt x="8541543" y="543406"/>
                  <a:pt x="8637984" y="459090"/>
                </a:cubicBezTo>
                <a:cubicBezTo>
                  <a:pt x="8691561" y="409663"/>
                  <a:pt x="8737996" y="360236"/>
                  <a:pt x="8784431" y="290457"/>
                </a:cubicBezTo>
                <a:cubicBezTo>
                  <a:pt x="8809434" y="450367"/>
                  <a:pt x="8895158" y="284642"/>
                  <a:pt x="8948737" y="339884"/>
                </a:cubicBezTo>
                <a:cubicBezTo>
                  <a:pt x="8970168" y="453274"/>
                  <a:pt x="8798717" y="543406"/>
                  <a:pt x="8848725" y="697501"/>
                </a:cubicBezTo>
                <a:cubicBezTo>
                  <a:pt x="8995171" y="511424"/>
                  <a:pt x="9041606" y="302087"/>
                  <a:pt x="9238059" y="165437"/>
                </a:cubicBezTo>
                <a:cubicBezTo>
                  <a:pt x="9280921" y="197419"/>
                  <a:pt x="9238059" y="229401"/>
                  <a:pt x="9255919" y="255567"/>
                </a:cubicBezTo>
                <a:cubicBezTo>
                  <a:pt x="9266634" y="255567"/>
                  <a:pt x="9198767" y="560851"/>
                  <a:pt x="9477374" y="578295"/>
                </a:cubicBezTo>
                <a:cubicBezTo>
                  <a:pt x="9477374" y="584110"/>
                  <a:pt x="9477374" y="589925"/>
                  <a:pt x="9488091" y="595740"/>
                </a:cubicBezTo>
                <a:cubicBezTo>
                  <a:pt x="9527380" y="627722"/>
                  <a:pt x="9620249" y="598648"/>
                  <a:pt x="9627393" y="650981"/>
                </a:cubicBezTo>
                <a:cubicBezTo>
                  <a:pt x="9634537" y="709131"/>
                  <a:pt x="9666684" y="764373"/>
                  <a:pt x="9648824" y="825429"/>
                </a:cubicBezTo>
                <a:cubicBezTo>
                  <a:pt x="9634537" y="871948"/>
                  <a:pt x="9616678" y="921374"/>
                  <a:pt x="9616678" y="970802"/>
                </a:cubicBezTo>
                <a:cubicBezTo>
                  <a:pt x="9616678" y="1023136"/>
                  <a:pt x="9495233" y="1095822"/>
                  <a:pt x="9655968" y="1127805"/>
                </a:cubicBezTo>
                <a:cubicBezTo>
                  <a:pt x="9663111" y="1127805"/>
                  <a:pt x="9645252" y="1217935"/>
                  <a:pt x="9638109" y="1267362"/>
                </a:cubicBezTo>
                <a:cubicBezTo>
                  <a:pt x="9630965" y="1308066"/>
                  <a:pt x="9598818" y="1357494"/>
                  <a:pt x="9663111" y="1386568"/>
                </a:cubicBezTo>
                <a:cubicBezTo>
                  <a:pt x="9702403" y="1401105"/>
                  <a:pt x="9773840" y="1331326"/>
                  <a:pt x="9780984" y="1270269"/>
                </a:cubicBezTo>
                <a:cubicBezTo>
                  <a:pt x="9788127" y="1215028"/>
                  <a:pt x="9795271" y="1159787"/>
                  <a:pt x="9780984" y="1107452"/>
                </a:cubicBezTo>
                <a:cubicBezTo>
                  <a:pt x="9763125" y="1043488"/>
                  <a:pt x="9791699" y="1008598"/>
                  <a:pt x="9855993" y="991154"/>
                </a:cubicBezTo>
                <a:cubicBezTo>
                  <a:pt x="9923858" y="970802"/>
                  <a:pt x="9959577" y="933005"/>
                  <a:pt x="9991724" y="880670"/>
                </a:cubicBezTo>
                <a:cubicBezTo>
                  <a:pt x="10070305" y="752742"/>
                  <a:pt x="10163174" y="630630"/>
                  <a:pt x="10209609" y="491071"/>
                </a:cubicBezTo>
                <a:cubicBezTo>
                  <a:pt x="10216753" y="464905"/>
                  <a:pt x="10231040" y="432923"/>
                  <a:pt x="10291762" y="421292"/>
                </a:cubicBezTo>
                <a:cubicBezTo>
                  <a:pt x="10198893" y="799262"/>
                  <a:pt x="9959577" y="1142341"/>
                  <a:pt x="9973865" y="1531941"/>
                </a:cubicBezTo>
                <a:cubicBezTo>
                  <a:pt x="10048874" y="1427272"/>
                  <a:pt x="10052446" y="1302252"/>
                  <a:pt x="10106024" y="1188861"/>
                </a:cubicBezTo>
                <a:cubicBezTo>
                  <a:pt x="10145315" y="1270269"/>
                  <a:pt x="10102453" y="1345863"/>
                  <a:pt x="10081022" y="1421458"/>
                </a:cubicBezTo>
                <a:cubicBezTo>
                  <a:pt x="10063162" y="1485421"/>
                  <a:pt x="10059590" y="1543570"/>
                  <a:pt x="10170318" y="1549385"/>
                </a:cubicBezTo>
                <a:cubicBezTo>
                  <a:pt x="10181034" y="1549385"/>
                  <a:pt x="10188178" y="1549385"/>
                  <a:pt x="10198893" y="1549385"/>
                </a:cubicBezTo>
                <a:cubicBezTo>
                  <a:pt x="10245327" y="1526126"/>
                  <a:pt x="10266759" y="1494144"/>
                  <a:pt x="10281046" y="1453439"/>
                </a:cubicBezTo>
                <a:cubicBezTo>
                  <a:pt x="10288190" y="1430180"/>
                  <a:pt x="10302477" y="1398198"/>
                  <a:pt x="10334625" y="1398198"/>
                </a:cubicBezTo>
                <a:cubicBezTo>
                  <a:pt x="10456068" y="1401105"/>
                  <a:pt x="10491787" y="1322604"/>
                  <a:pt x="10527506" y="1247010"/>
                </a:cubicBezTo>
                <a:cubicBezTo>
                  <a:pt x="10588228" y="1287714"/>
                  <a:pt x="10545365" y="1322604"/>
                  <a:pt x="10548937" y="1354586"/>
                </a:cubicBezTo>
                <a:cubicBezTo>
                  <a:pt x="10552509" y="1374938"/>
                  <a:pt x="10556080" y="1395290"/>
                  <a:pt x="10588228" y="1395290"/>
                </a:cubicBezTo>
                <a:cubicBezTo>
                  <a:pt x="10613230" y="1395290"/>
                  <a:pt x="10645378" y="1386568"/>
                  <a:pt x="10645378" y="1366216"/>
                </a:cubicBezTo>
                <a:cubicBezTo>
                  <a:pt x="10648949" y="1238288"/>
                  <a:pt x="10820400" y="1165601"/>
                  <a:pt x="10820400" y="1031858"/>
                </a:cubicBezTo>
                <a:cubicBezTo>
                  <a:pt x="10820400" y="950449"/>
                  <a:pt x="10916840" y="1072563"/>
                  <a:pt x="10956131" y="1005691"/>
                </a:cubicBezTo>
                <a:cubicBezTo>
                  <a:pt x="10966847" y="991154"/>
                  <a:pt x="10981133" y="1046395"/>
                  <a:pt x="10977562" y="1069655"/>
                </a:cubicBezTo>
                <a:cubicBezTo>
                  <a:pt x="10973991" y="1092915"/>
                  <a:pt x="10948987" y="1113267"/>
                  <a:pt x="10966847" y="1142341"/>
                </a:cubicBezTo>
                <a:cubicBezTo>
                  <a:pt x="11031140" y="1156879"/>
                  <a:pt x="11056143" y="1119081"/>
                  <a:pt x="11074003" y="1084192"/>
                </a:cubicBezTo>
                <a:cubicBezTo>
                  <a:pt x="11116865" y="1008598"/>
                  <a:pt x="11166871" y="933005"/>
                  <a:pt x="11181159" y="848688"/>
                </a:cubicBezTo>
                <a:cubicBezTo>
                  <a:pt x="11184730" y="819614"/>
                  <a:pt x="11202590" y="802169"/>
                  <a:pt x="11238309" y="805077"/>
                </a:cubicBezTo>
                <a:cubicBezTo>
                  <a:pt x="11284744" y="810891"/>
                  <a:pt x="11270456" y="839966"/>
                  <a:pt x="11266884" y="863226"/>
                </a:cubicBezTo>
                <a:cubicBezTo>
                  <a:pt x="11263312" y="877763"/>
                  <a:pt x="11252596" y="892300"/>
                  <a:pt x="11277600" y="906838"/>
                </a:cubicBezTo>
                <a:cubicBezTo>
                  <a:pt x="11531203" y="566666"/>
                  <a:pt x="11516915" y="386403"/>
                  <a:pt x="11724084" y="5527"/>
                </a:cubicBezTo>
                <a:cubicBezTo>
                  <a:pt x="11763375" y="89842"/>
                  <a:pt x="11734800" y="150899"/>
                  <a:pt x="11727656" y="209048"/>
                </a:cubicBezTo>
                <a:cubicBezTo>
                  <a:pt x="11709796" y="354421"/>
                  <a:pt x="11677649" y="264290"/>
                  <a:pt x="11656218" y="409663"/>
                </a:cubicBezTo>
                <a:cubicBezTo>
                  <a:pt x="11645503" y="479442"/>
                  <a:pt x="11609784" y="543406"/>
                  <a:pt x="11666934" y="621907"/>
                </a:cubicBezTo>
                <a:cubicBezTo>
                  <a:pt x="11706225" y="674241"/>
                  <a:pt x="11663362" y="758557"/>
                  <a:pt x="11631215" y="822521"/>
                </a:cubicBezTo>
                <a:cubicBezTo>
                  <a:pt x="11602640" y="874856"/>
                  <a:pt x="11595497" y="927190"/>
                  <a:pt x="11631215" y="996969"/>
                </a:cubicBezTo>
                <a:cubicBezTo>
                  <a:pt x="11652646" y="933005"/>
                  <a:pt x="11670505" y="883578"/>
                  <a:pt x="11684793" y="834151"/>
                </a:cubicBezTo>
                <a:cubicBezTo>
                  <a:pt x="11695509" y="793447"/>
                  <a:pt x="11720512" y="770187"/>
                  <a:pt x="11774090" y="773095"/>
                </a:cubicBezTo>
                <a:cubicBezTo>
                  <a:pt x="11802665" y="773095"/>
                  <a:pt x="11841956" y="764373"/>
                  <a:pt x="11856243" y="793447"/>
                </a:cubicBezTo>
                <a:cubicBezTo>
                  <a:pt x="11870531" y="816706"/>
                  <a:pt x="11856243" y="848688"/>
                  <a:pt x="11831240" y="860319"/>
                </a:cubicBezTo>
                <a:cubicBezTo>
                  <a:pt x="11784806" y="874856"/>
                  <a:pt x="11741944" y="889393"/>
                  <a:pt x="11738371" y="938820"/>
                </a:cubicBezTo>
                <a:cubicBezTo>
                  <a:pt x="11731228" y="1005691"/>
                  <a:pt x="11759802" y="967894"/>
                  <a:pt x="11795521" y="956264"/>
                </a:cubicBezTo>
                <a:cubicBezTo>
                  <a:pt x="11834812" y="944634"/>
                  <a:pt x="11845527" y="979524"/>
                  <a:pt x="11838384" y="1002784"/>
                </a:cubicBezTo>
                <a:cubicBezTo>
                  <a:pt x="11806237" y="1090007"/>
                  <a:pt x="11863387" y="1180138"/>
                  <a:pt x="11816952" y="1270269"/>
                </a:cubicBezTo>
                <a:cubicBezTo>
                  <a:pt x="11931252" y="1247010"/>
                  <a:pt x="11981259" y="1197583"/>
                  <a:pt x="11999118" y="1092915"/>
                </a:cubicBezTo>
                <a:cubicBezTo>
                  <a:pt x="12002690" y="1055118"/>
                  <a:pt x="11995547" y="1014413"/>
                  <a:pt x="12027693" y="979524"/>
                </a:cubicBezTo>
                <a:cubicBezTo>
                  <a:pt x="12045553" y="959172"/>
                  <a:pt x="12066984" y="938820"/>
                  <a:pt x="12102703" y="953357"/>
                </a:cubicBezTo>
                <a:cubicBezTo>
                  <a:pt x="12127705" y="962080"/>
                  <a:pt x="12127705" y="985338"/>
                  <a:pt x="12120562" y="1005691"/>
                </a:cubicBezTo>
                <a:cubicBezTo>
                  <a:pt x="12081272" y="1090007"/>
                  <a:pt x="12070555" y="1180138"/>
                  <a:pt x="12056268" y="1267362"/>
                </a:cubicBezTo>
                <a:cubicBezTo>
                  <a:pt x="12052697" y="1281899"/>
                  <a:pt x="12045553" y="1296437"/>
                  <a:pt x="12081272" y="1310974"/>
                </a:cubicBezTo>
                <a:cubicBezTo>
                  <a:pt x="12113418" y="1209213"/>
                  <a:pt x="12156280" y="1110359"/>
                  <a:pt x="12191999" y="1008598"/>
                </a:cubicBezTo>
                <a:lnTo>
                  <a:pt x="12191999" y="6105653"/>
                </a:lnTo>
                <a:lnTo>
                  <a:pt x="0" y="6105653"/>
                </a:lnTo>
                <a:lnTo>
                  <a:pt x="0" y="927116"/>
                </a:lnTo>
                <a:lnTo>
                  <a:pt x="61930" y="902578"/>
                </a:lnTo>
                <a:cubicBezTo>
                  <a:pt x="91454" y="894128"/>
                  <a:pt x="122931" y="887949"/>
                  <a:pt x="155971" y="883588"/>
                </a:cubicBezTo>
                <a:cubicBezTo>
                  <a:pt x="223837" y="877773"/>
                  <a:pt x="245268" y="839976"/>
                  <a:pt x="277414" y="802179"/>
                </a:cubicBezTo>
                <a:cubicBezTo>
                  <a:pt x="388143" y="674251"/>
                  <a:pt x="488155" y="537601"/>
                  <a:pt x="638174" y="430025"/>
                </a:cubicBezTo>
                <a:cubicBezTo>
                  <a:pt x="620315" y="555046"/>
                  <a:pt x="520302" y="653899"/>
                  <a:pt x="477440" y="784735"/>
                </a:cubicBezTo>
                <a:cubicBezTo>
                  <a:pt x="641746" y="680066"/>
                  <a:pt x="727471" y="543415"/>
                  <a:pt x="827483" y="418395"/>
                </a:cubicBezTo>
                <a:cubicBezTo>
                  <a:pt x="873917" y="360246"/>
                  <a:pt x="931068" y="307912"/>
                  <a:pt x="956071" y="241040"/>
                </a:cubicBezTo>
                <a:cubicBezTo>
                  <a:pt x="961429" y="223595"/>
                  <a:pt x="972814" y="196338"/>
                  <a:pt x="999268" y="192386"/>
                </a:cubicBezTo>
                <a:cubicBezTo>
                  <a:pt x="1008086" y="191069"/>
                  <a:pt x="1018579" y="192341"/>
                  <a:pt x="1031080" y="197429"/>
                </a:cubicBezTo>
                <a:cubicBezTo>
                  <a:pt x="1073942" y="214873"/>
                  <a:pt x="1059654" y="246855"/>
                  <a:pt x="1048940" y="275930"/>
                </a:cubicBezTo>
                <a:cubicBezTo>
                  <a:pt x="1020365" y="345708"/>
                  <a:pt x="1020365" y="421303"/>
                  <a:pt x="1020365" y="517249"/>
                </a:cubicBezTo>
                <a:cubicBezTo>
                  <a:pt x="1156096" y="435840"/>
                  <a:pt x="1113233" y="287560"/>
                  <a:pt x="1256108" y="217780"/>
                </a:cubicBezTo>
                <a:cubicBezTo>
                  <a:pt x="1281111" y="305004"/>
                  <a:pt x="1231105" y="371876"/>
                  <a:pt x="1220389" y="441654"/>
                </a:cubicBezTo>
                <a:cubicBezTo>
                  <a:pt x="1209674" y="505619"/>
                  <a:pt x="1234677" y="520156"/>
                  <a:pt x="1313258" y="505619"/>
                </a:cubicBezTo>
                <a:cubicBezTo>
                  <a:pt x="1434702" y="482359"/>
                  <a:pt x="1495424" y="517249"/>
                  <a:pt x="1463277" y="610287"/>
                </a:cubicBezTo>
                <a:cubicBezTo>
                  <a:pt x="1431130" y="697511"/>
                  <a:pt x="1477565" y="706233"/>
                  <a:pt x="1545430" y="682974"/>
                </a:cubicBezTo>
                <a:cubicBezTo>
                  <a:pt x="1645442" y="648084"/>
                  <a:pt x="1724024" y="685881"/>
                  <a:pt x="1809749" y="712048"/>
                </a:cubicBezTo>
                <a:cubicBezTo>
                  <a:pt x="1938336" y="752753"/>
                  <a:pt x="2002630" y="735308"/>
                  <a:pt x="2099071" y="650992"/>
                </a:cubicBezTo>
                <a:cubicBezTo>
                  <a:pt x="2152648" y="601565"/>
                  <a:pt x="2199083" y="552138"/>
                  <a:pt x="2245518" y="482359"/>
                </a:cubicBezTo>
                <a:cubicBezTo>
                  <a:pt x="2270521" y="642269"/>
                  <a:pt x="2356245" y="476544"/>
                  <a:pt x="2409824" y="531786"/>
                </a:cubicBezTo>
                <a:cubicBezTo>
                  <a:pt x="2431255" y="645176"/>
                  <a:pt x="2259804" y="735308"/>
                  <a:pt x="2309812" y="889403"/>
                </a:cubicBezTo>
                <a:cubicBezTo>
                  <a:pt x="2456258" y="703326"/>
                  <a:pt x="2502693" y="493989"/>
                  <a:pt x="2699146" y="357339"/>
                </a:cubicBezTo>
                <a:cubicBezTo>
                  <a:pt x="2742008" y="389321"/>
                  <a:pt x="2699146" y="421303"/>
                  <a:pt x="2717006" y="447469"/>
                </a:cubicBezTo>
                <a:cubicBezTo>
                  <a:pt x="2727721" y="447469"/>
                  <a:pt x="2659854" y="752753"/>
                  <a:pt x="2938461" y="770197"/>
                </a:cubicBezTo>
                <a:cubicBezTo>
                  <a:pt x="2938461" y="776012"/>
                  <a:pt x="2938461" y="781827"/>
                  <a:pt x="2949178" y="787642"/>
                </a:cubicBezTo>
                <a:cubicBezTo>
                  <a:pt x="2988467" y="819624"/>
                  <a:pt x="3081336" y="790550"/>
                  <a:pt x="3088480" y="842883"/>
                </a:cubicBezTo>
                <a:cubicBezTo>
                  <a:pt x="3095624" y="901033"/>
                  <a:pt x="3127771" y="956275"/>
                  <a:pt x="3109911" y="1017331"/>
                </a:cubicBezTo>
                <a:cubicBezTo>
                  <a:pt x="3095624" y="1063850"/>
                  <a:pt x="3077765" y="1113276"/>
                  <a:pt x="3077765" y="1162704"/>
                </a:cubicBezTo>
                <a:cubicBezTo>
                  <a:pt x="3077765" y="1215038"/>
                  <a:pt x="2956320" y="1287724"/>
                  <a:pt x="3117055" y="1319707"/>
                </a:cubicBezTo>
                <a:cubicBezTo>
                  <a:pt x="3124198" y="1319707"/>
                  <a:pt x="3106339" y="1409837"/>
                  <a:pt x="3099196" y="1459264"/>
                </a:cubicBezTo>
                <a:cubicBezTo>
                  <a:pt x="3092052" y="1499968"/>
                  <a:pt x="3059905" y="1549396"/>
                  <a:pt x="3124198" y="1578470"/>
                </a:cubicBezTo>
                <a:cubicBezTo>
                  <a:pt x="3163490" y="1593007"/>
                  <a:pt x="3234927" y="1523228"/>
                  <a:pt x="3242071" y="1462171"/>
                </a:cubicBezTo>
                <a:cubicBezTo>
                  <a:pt x="3249214" y="1406930"/>
                  <a:pt x="3256358" y="1351689"/>
                  <a:pt x="3242071" y="1299354"/>
                </a:cubicBezTo>
                <a:cubicBezTo>
                  <a:pt x="3224212" y="1235390"/>
                  <a:pt x="3252786" y="1200500"/>
                  <a:pt x="3317080" y="1183056"/>
                </a:cubicBezTo>
                <a:cubicBezTo>
                  <a:pt x="3384945" y="1162704"/>
                  <a:pt x="3420664" y="1124907"/>
                  <a:pt x="3452811" y="1072572"/>
                </a:cubicBezTo>
                <a:cubicBezTo>
                  <a:pt x="3531392" y="944644"/>
                  <a:pt x="3624261" y="822532"/>
                  <a:pt x="3670696" y="682973"/>
                </a:cubicBezTo>
                <a:cubicBezTo>
                  <a:pt x="3677840" y="656807"/>
                  <a:pt x="3692127" y="624825"/>
                  <a:pt x="3752849" y="613194"/>
                </a:cubicBezTo>
                <a:cubicBezTo>
                  <a:pt x="3659980" y="991164"/>
                  <a:pt x="3420664" y="1334243"/>
                  <a:pt x="3434952" y="1723843"/>
                </a:cubicBezTo>
                <a:cubicBezTo>
                  <a:pt x="3509961" y="1619174"/>
                  <a:pt x="3513533" y="1494154"/>
                  <a:pt x="3567111" y="1380763"/>
                </a:cubicBezTo>
                <a:cubicBezTo>
                  <a:pt x="3606402" y="1462171"/>
                  <a:pt x="3563540" y="1537765"/>
                  <a:pt x="3542109" y="1613360"/>
                </a:cubicBezTo>
                <a:cubicBezTo>
                  <a:pt x="3524249" y="1677323"/>
                  <a:pt x="3520677" y="1735472"/>
                  <a:pt x="3631405" y="1741287"/>
                </a:cubicBezTo>
                <a:cubicBezTo>
                  <a:pt x="3642121" y="1741287"/>
                  <a:pt x="3649265" y="1741287"/>
                  <a:pt x="3659980" y="1741287"/>
                </a:cubicBezTo>
                <a:cubicBezTo>
                  <a:pt x="3706414" y="1718028"/>
                  <a:pt x="3727846" y="1686046"/>
                  <a:pt x="3742133" y="1645341"/>
                </a:cubicBezTo>
                <a:cubicBezTo>
                  <a:pt x="3749277" y="1622082"/>
                  <a:pt x="3763564" y="1590100"/>
                  <a:pt x="3795712" y="1590100"/>
                </a:cubicBezTo>
                <a:cubicBezTo>
                  <a:pt x="3917155" y="1593007"/>
                  <a:pt x="3952874" y="1514506"/>
                  <a:pt x="3988593" y="1438912"/>
                </a:cubicBezTo>
                <a:cubicBezTo>
                  <a:pt x="4049315" y="1479616"/>
                  <a:pt x="4006452" y="1514506"/>
                  <a:pt x="4010024" y="1546488"/>
                </a:cubicBezTo>
                <a:cubicBezTo>
                  <a:pt x="4013596" y="1566840"/>
                  <a:pt x="4017167" y="1587192"/>
                  <a:pt x="4049315" y="1587192"/>
                </a:cubicBezTo>
                <a:cubicBezTo>
                  <a:pt x="4074317" y="1587192"/>
                  <a:pt x="4106465" y="1578470"/>
                  <a:pt x="4106465" y="1558118"/>
                </a:cubicBezTo>
                <a:cubicBezTo>
                  <a:pt x="4110036" y="1430190"/>
                  <a:pt x="4281487" y="1357503"/>
                  <a:pt x="4281487" y="1223760"/>
                </a:cubicBezTo>
                <a:cubicBezTo>
                  <a:pt x="4281487" y="1142351"/>
                  <a:pt x="4377927" y="1264465"/>
                  <a:pt x="4417219" y="1197593"/>
                </a:cubicBezTo>
                <a:cubicBezTo>
                  <a:pt x="4427935" y="1183056"/>
                  <a:pt x="4442220" y="1238297"/>
                  <a:pt x="4438649" y="1261557"/>
                </a:cubicBezTo>
                <a:cubicBezTo>
                  <a:pt x="4435078" y="1284817"/>
                  <a:pt x="4410074" y="1305169"/>
                  <a:pt x="4427935" y="1334243"/>
                </a:cubicBezTo>
                <a:cubicBezTo>
                  <a:pt x="4492228" y="1348781"/>
                  <a:pt x="4517230" y="1310983"/>
                  <a:pt x="4535090" y="1276094"/>
                </a:cubicBezTo>
                <a:cubicBezTo>
                  <a:pt x="4577952" y="1200500"/>
                  <a:pt x="4627958" y="1124907"/>
                  <a:pt x="4642246" y="1040590"/>
                </a:cubicBezTo>
                <a:cubicBezTo>
                  <a:pt x="4645817" y="1011516"/>
                  <a:pt x="4663677" y="994071"/>
                  <a:pt x="4699396" y="996979"/>
                </a:cubicBezTo>
                <a:cubicBezTo>
                  <a:pt x="4745832" y="1002793"/>
                  <a:pt x="4731544" y="1031868"/>
                  <a:pt x="4727971" y="1055128"/>
                </a:cubicBezTo>
                <a:cubicBezTo>
                  <a:pt x="4724399" y="1069665"/>
                  <a:pt x="4713683" y="1084202"/>
                  <a:pt x="4738688" y="1098740"/>
                </a:cubicBezTo>
                <a:cubicBezTo>
                  <a:pt x="4992291" y="758568"/>
                  <a:pt x="4978002" y="578305"/>
                  <a:pt x="5185172" y="197429"/>
                </a:cubicBezTo>
                <a:cubicBezTo>
                  <a:pt x="5224462" y="281744"/>
                  <a:pt x="5195887" y="342801"/>
                  <a:pt x="5188744" y="400950"/>
                </a:cubicBezTo>
                <a:cubicBezTo>
                  <a:pt x="5170883" y="546323"/>
                  <a:pt x="5138736" y="456192"/>
                  <a:pt x="5117306" y="601565"/>
                </a:cubicBezTo>
                <a:cubicBezTo>
                  <a:pt x="5106590" y="671344"/>
                  <a:pt x="5070871" y="735308"/>
                  <a:pt x="5128021" y="813809"/>
                </a:cubicBezTo>
                <a:cubicBezTo>
                  <a:pt x="5167312" y="866143"/>
                  <a:pt x="5124450" y="950459"/>
                  <a:pt x="5092302" y="1014423"/>
                </a:cubicBezTo>
                <a:cubicBezTo>
                  <a:pt x="5063727" y="1066758"/>
                  <a:pt x="5056585" y="1119092"/>
                  <a:pt x="5092302" y="1188871"/>
                </a:cubicBezTo>
                <a:cubicBezTo>
                  <a:pt x="5113734" y="1124907"/>
                  <a:pt x="5131592" y="1075480"/>
                  <a:pt x="5145880" y="1026053"/>
                </a:cubicBezTo>
                <a:cubicBezTo>
                  <a:pt x="5156596" y="985349"/>
                  <a:pt x="5181600" y="962089"/>
                  <a:pt x="5235177" y="964997"/>
                </a:cubicBezTo>
                <a:cubicBezTo>
                  <a:pt x="5263752" y="964997"/>
                  <a:pt x="5303044" y="956275"/>
                  <a:pt x="5317331" y="985349"/>
                </a:cubicBezTo>
                <a:cubicBezTo>
                  <a:pt x="5331618" y="1008608"/>
                  <a:pt x="5317331" y="1040590"/>
                  <a:pt x="5292327" y="1052221"/>
                </a:cubicBezTo>
                <a:cubicBezTo>
                  <a:pt x="5245894" y="1066758"/>
                  <a:pt x="5203031" y="1081295"/>
                  <a:pt x="5199458" y="1130722"/>
                </a:cubicBezTo>
                <a:cubicBezTo>
                  <a:pt x="5192315" y="1197593"/>
                  <a:pt x="5220889" y="1159796"/>
                  <a:pt x="5256608" y="1148166"/>
                </a:cubicBezTo>
                <a:cubicBezTo>
                  <a:pt x="5295899" y="1136536"/>
                  <a:pt x="5306616" y="1171426"/>
                  <a:pt x="5299471" y="1194686"/>
                </a:cubicBezTo>
                <a:cubicBezTo>
                  <a:pt x="5267324" y="1281909"/>
                  <a:pt x="5324474" y="1372040"/>
                  <a:pt x="5278039" y="1462171"/>
                </a:cubicBezTo>
                <a:cubicBezTo>
                  <a:pt x="5392339" y="1438912"/>
                  <a:pt x="5442347" y="1389485"/>
                  <a:pt x="5460205" y="1284817"/>
                </a:cubicBezTo>
                <a:cubicBezTo>
                  <a:pt x="5463777" y="1247020"/>
                  <a:pt x="5456634" y="1206315"/>
                  <a:pt x="5488780" y="1171426"/>
                </a:cubicBezTo>
                <a:cubicBezTo>
                  <a:pt x="5502175" y="1156162"/>
                  <a:pt x="5517579" y="1140898"/>
                  <a:pt x="5539513" y="1140353"/>
                </a:cubicBezTo>
                <a:lnTo>
                  <a:pt x="5552720" y="1143022"/>
                </a:lnTo>
                <a:lnTo>
                  <a:pt x="5574208" y="1115811"/>
                </a:lnTo>
                <a:cubicBezTo>
                  <a:pt x="5609034" y="1085646"/>
                  <a:pt x="5659040" y="1068202"/>
                  <a:pt x="5734050" y="1075470"/>
                </a:cubicBezTo>
                <a:cubicBezTo>
                  <a:pt x="5776912" y="1078377"/>
                  <a:pt x="5809058" y="1055118"/>
                  <a:pt x="5798343" y="1020228"/>
                </a:cubicBezTo>
                <a:cubicBezTo>
                  <a:pt x="5776912" y="953357"/>
                  <a:pt x="5837634" y="921375"/>
                  <a:pt x="5884068" y="883578"/>
                </a:cubicBezTo>
                <a:cubicBezTo>
                  <a:pt x="5966221" y="816706"/>
                  <a:pt x="6051947" y="752742"/>
                  <a:pt x="6066234" y="645166"/>
                </a:cubicBezTo>
                <a:cubicBezTo>
                  <a:pt x="6130528" y="665519"/>
                  <a:pt x="6123384" y="700408"/>
                  <a:pt x="6109096" y="732391"/>
                </a:cubicBezTo>
                <a:cubicBezTo>
                  <a:pt x="6073377" y="816706"/>
                  <a:pt x="6034087" y="901023"/>
                  <a:pt x="5998368" y="985338"/>
                </a:cubicBezTo>
                <a:cubicBezTo>
                  <a:pt x="5976937" y="1040581"/>
                  <a:pt x="5944790" y="1095822"/>
                  <a:pt x="5969793" y="1168509"/>
                </a:cubicBezTo>
                <a:cubicBezTo>
                  <a:pt x="6098380" y="1104545"/>
                  <a:pt x="6123384" y="996969"/>
                  <a:pt x="6162674" y="909745"/>
                </a:cubicBezTo>
                <a:cubicBezTo>
                  <a:pt x="6212681" y="802169"/>
                  <a:pt x="6305549" y="738205"/>
                  <a:pt x="6412705" y="659704"/>
                </a:cubicBezTo>
                <a:cubicBezTo>
                  <a:pt x="6441280" y="738205"/>
                  <a:pt x="6362699" y="787632"/>
                  <a:pt x="6366271" y="851596"/>
                </a:cubicBezTo>
                <a:cubicBezTo>
                  <a:pt x="6376987" y="854503"/>
                  <a:pt x="6398418" y="860319"/>
                  <a:pt x="6398418" y="860319"/>
                </a:cubicBezTo>
                <a:cubicBezTo>
                  <a:pt x="6455568" y="755650"/>
                  <a:pt x="6562724" y="709131"/>
                  <a:pt x="6694884" y="691686"/>
                </a:cubicBezTo>
                <a:cubicBezTo>
                  <a:pt x="6762750" y="685871"/>
                  <a:pt x="6784181" y="648074"/>
                  <a:pt x="6816327" y="610277"/>
                </a:cubicBezTo>
                <a:cubicBezTo>
                  <a:pt x="6927056" y="482349"/>
                  <a:pt x="7027068" y="345699"/>
                  <a:pt x="7177087" y="238123"/>
                </a:cubicBezTo>
                <a:cubicBezTo>
                  <a:pt x="7159228" y="363144"/>
                  <a:pt x="7059215" y="461997"/>
                  <a:pt x="7016353" y="592833"/>
                </a:cubicBezTo>
                <a:cubicBezTo>
                  <a:pt x="7180659" y="488164"/>
                  <a:pt x="7266384" y="351513"/>
                  <a:pt x="7366396" y="226493"/>
                </a:cubicBezTo>
                <a:cubicBezTo>
                  <a:pt x="7412830" y="168344"/>
                  <a:pt x="7469981" y="116010"/>
                  <a:pt x="7494984" y="49138"/>
                </a:cubicBezTo>
                <a:cubicBezTo>
                  <a:pt x="7500342" y="31693"/>
                  <a:pt x="7511727" y="4436"/>
                  <a:pt x="7538181" y="484"/>
                </a:cubicBezTo>
                <a:close/>
              </a:path>
            </a:pathLst>
          </a:custGeom>
          <a:solidFill>
            <a:schemeClr val="accent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C6E2D2B2-2D78-F147-AB21-5DDB9C407677}"/>
              </a:ext>
            </a:extLst>
          </p:cNvPr>
          <p:cNvSpPr>
            <a:spLocks noGrp="1"/>
          </p:cNvSpPr>
          <p:nvPr>
            <p:ph type="title"/>
          </p:nvPr>
        </p:nvSpPr>
        <p:spPr>
          <a:xfrm>
            <a:off x="838200" y="365125"/>
            <a:ext cx="10515600" cy="1325563"/>
          </a:xfrm>
        </p:spPr>
        <p:txBody>
          <a:bodyPr>
            <a:normAutofit/>
          </a:bodyPr>
          <a:lstStyle/>
          <a:p>
            <a:r>
              <a:rPr lang="en-US" dirty="0"/>
              <a:t>Understand</a:t>
            </a:r>
          </a:p>
        </p:txBody>
      </p:sp>
      <p:graphicFrame>
        <p:nvGraphicFramePr>
          <p:cNvPr id="11" name="Content Placeholder 8">
            <a:extLst>
              <a:ext uri="{FF2B5EF4-FFF2-40B4-BE49-F238E27FC236}">
                <a16:creationId xmlns:a16="http://schemas.microsoft.com/office/drawing/2014/main" id="{2E89DD98-6827-5FCD-4C4A-0D3BB154B2BE}"/>
              </a:ext>
            </a:extLst>
          </p:cNvPr>
          <p:cNvGraphicFramePr>
            <a:graphicFrameLocks noGrp="1"/>
          </p:cNvGraphicFramePr>
          <p:nvPr>
            <p:ph idx="1"/>
            <p:extLst>
              <p:ext uri="{D42A27DB-BD31-4B8C-83A1-F6EECF244321}">
                <p14:modId xmlns:p14="http://schemas.microsoft.com/office/powerpoint/2010/main" val="4009121503"/>
              </p:ext>
            </p:extLst>
          </p:nvPr>
        </p:nvGraphicFramePr>
        <p:xfrm>
          <a:off x="838200" y="2011363"/>
          <a:ext cx="10515600" cy="416083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16252426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DA8886A6-5426-494B-96D8-D962D2BA08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Freeform: Shape 10">
            <a:extLst>
              <a:ext uri="{FF2B5EF4-FFF2-40B4-BE49-F238E27FC236}">
                <a16:creationId xmlns:a16="http://schemas.microsoft.com/office/drawing/2014/main" id="{AA3ED336-C09E-46E8-9774-B977D15FC5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752347"/>
            <a:ext cx="12191999" cy="6105653"/>
          </a:xfrm>
          <a:custGeom>
            <a:avLst/>
            <a:gdLst>
              <a:gd name="connsiteX0" fmla="*/ 7538181 w 12191999"/>
              <a:gd name="connsiteY0" fmla="*/ 484 h 6105653"/>
              <a:gd name="connsiteX1" fmla="*/ 7569993 w 12191999"/>
              <a:gd name="connsiteY1" fmla="*/ 5527 h 6105653"/>
              <a:gd name="connsiteX2" fmla="*/ 7587853 w 12191999"/>
              <a:gd name="connsiteY2" fmla="*/ 84028 h 6105653"/>
              <a:gd name="connsiteX3" fmla="*/ 7559278 w 12191999"/>
              <a:gd name="connsiteY3" fmla="*/ 325347 h 6105653"/>
              <a:gd name="connsiteX4" fmla="*/ 7795021 w 12191999"/>
              <a:gd name="connsiteY4" fmla="*/ 25878 h 6105653"/>
              <a:gd name="connsiteX5" fmla="*/ 7759302 w 12191999"/>
              <a:gd name="connsiteY5" fmla="*/ 249752 h 6105653"/>
              <a:gd name="connsiteX6" fmla="*/ 7852171 w 12191999"/>
              <a:gd name="connsiteY6" fmla="*/ 313717 h 6105653"/>
              <a:gd name="connsiteX7" fmla="*/ 8002190 w 12191999"/>
              <a:gd name="connsiteY7" fmla="*/ 418385 h 6105653"/>
              <a:gd name="connsiteX8" fmla="*/ 8084343 w 12191999"/>
              <a:gd name="connsiteY8" fmla="*/ 491072 h 6105653"/>
              <a:gd name="connsiteX9" fmla="*/ 8348662 w 12191999"/>
              <a:gd name="connsiteY9" fmla="*/ 520146 h 6105653"/>
              <a:gd name="connsiteX10" fmla="*/ 8637984 w 12191999"/>
              <a:gd name="connsiteY10" fmla="*/ 459090 h 6105653"/>
              <a:gd name="connsiteX11" fmla="*/ 8784431 w 12191999"/>
              <a:gd name="connsiteY11" fmla="*/ 290457 h 6105653"/>
              <a:gd name="connsiteX12" fmla="*/ 8948737 w 12191999"/>
              <a:gd name="connsiteY12" fmla="*/ 339884 h 6105653"/>
              <a:gd name="connsiteX13" fmla="*/ 8848725 w 12191999"/>
              <a:gd name="connsiteY13" fmla="*/ 697501 h 6105653"/>
              <a:gd name="connsiteX14" fmla="*/ 9238059 w 12191999"/>
              <a:gd name="connsiteY14" fmla="*/ 165437 h 6105653"/>
              <a:gd name="connsiteX15" fmla="*/ 9255919 w 12191999"/>
              <a:gd name="connsiteY15" fmla="*/ 255567 h 6105653"/>
              <a:gd name="connsiteX16" fmla="*/ 9477374 w 12191999"/>
              <a:gd name="connsiteY16" fmla="*/ 578295 h 6105653"/>
              <a:gd name="connsiteX17" fmla="*/ 9488091 w 12191999"/>
              <a:gd name="connsiteY17" fmla="*/ 595740 h 6105653"/>
              <a:gd name="connsiteX18" fmla="*/ 9627393 w 12191999"/>
              <a:gd name="connsiteY18" fmla="*/ 650981 h 6105653"/>
              <a:gd name="connsiteX19" fmla="*/ 9648824 w 12191999"/>
              <a:gd name="connsiteY19" fmla="*/ 825429 h 6105653"/>
              <a:gd name="connsiteX20" fmla="*/ 9616678 w 12191999"/>
              <a:gd name="connsiteY20" fmla="*/ 970802 h 6105653"/>
              <a:gd name="connsiteX21" fmla="*/ 9655968 w 12191999"/>
              <a:gd name="connsiteY21" fmla="*/ 1127805 h 6105653"/>
              <a:gd name="connsiteX22" fmla="*/ 9638109 w 12191999"/>
              <a:gd name="connsiteY22" fmla="*/ 1267362 h 6105653"/>
              <a:gd name="connsiteX23" fmla="*/ 9663111 w 12191999"/>
              <a:gd name="connsiteY23" fmla="*/ 1386568 h 6105653"/>
              <a:gd name="connsiteX24" fmla="*/ 9780984 w 12191999"/>
              <a:gd name="connsiteY24" fmla="*/ 1270269 h 6105653"/>
              <a:gd name="connsiteX25" fmla="*/ 9780984 w 12191999"/>
              <a:gd name="connsiteY25" fmla="*/ 1107452 h 6105653"/>
              <a:gd name="connsiteX26" fmla="*/ 9855993 w 12191999"/>
              <a:gd name="connsiteY26" fmla="*/ 991154 h 6105653"/>
              <a:gd name="connsiteX27" fmla="*/ 9991724 w 12191999"/>
              <a:gd name="connsiteY27" fmla="*/ 880670 h 6105653"/>
              <a:gd name="connsiteX28" fmla="*/ 10209609 w 12191999"/>
              <a:gd name="connsiteY28" fmla="*/ 491071 h 6105653"/>
              <a:gd name="connsiteX29" fmla="*/ 10291762 w 12191999"/>
              <a:gd name="connsiteY29" fmla="*/ 421292 h 6105653"/>
              <a:gd name="connsiteX30" fmla="*/ 9973865 w 12191999"/>
              <a:gd name="connsiteY30" fmla="*/ 1531941 h 6105653"/>
              <a:gd name="connsiteX31" fmla="*/ 10106024 w 12191999"/>
              <a:gd name="connsiteY31" fmla="*/ 1188861 h 6105653"/>
              <a:gd name="connsiteX32" fmla="*/ 10081022 w 12191999"/>
              <a:gd name="connsiteY32" fmla="*/ 1421458 h 6105653"/>
              <a:gd name="connsiteX33" fmla="*/ 10170318 w 12191999"/>
              <a:gd name="connsiteY33" fmla="*/ 1549385 h 6105653"/>
              <a:gd name="connsiteX34" fmla="*/ 10198893 w 12191999"/>
              <a:gd name="connsiteY34" fmla="*/ 1549385 h 6105653"/>
              <a:gd name="connsiteX35" fmla="*/ 10281046 w 12191999"/>
              <a:gd name="connsiteY35" fmla="*/ 1453439 h 6105653"/>
              <a:gd name="connsiteX36" fmla="*/ 10334625 w 12191999"/>
              <a:gd name="connsiteY36" fmla="*/ 1398198 h 6105653"/>
              <a:gd name="connsiteX37" fmla="*/ 10527506 w 12191999"/>
              <a:gd name="connsiteY37" fmla="*/ 1247010 h 6105653"/>
              <a:gd name="connsiteX38" fmla="*/ 10548937 w 12191999"/>
              <a:gd name="connsiteY38" fmla="*/ 1354586 h 6105653"/>
              <a:gd name="connsiteX39" fmla="*/ 10588228 w 12191999"/>
              <a:gd name="connsiteY39" fmla="*/ 1395290 h 6105653"/>
              <a:gd name="connsiteX40" fmla="*/ 10645378 w 12191999"/>
              <a:gd name="connsiteY40" fmla="*/ 1366216 h 6105653"/>
              <a:gd name="connsiteX41" fmla="*/ 10820400 w 12191999"/>
              <a:gd name="connsiteY41" fmla="*/ 1031858 h 6105653"/>
              <a:gd name="connsiteX42" fmla="*/ 10956131 w 12191999"/>
              <a:gd name="connsiteY42" fmla="*/ 1005691 h 6105653"/>
              <a:gd name="connsiteX43" fmla="*/ 10977562 w 12191999"/>
              <a:gd name="connsiteY43" fmla="*/ 1069655 h 6105653"/>
              <a:gd name="connsiteX44" fmla="*/ 10966847 w 12191999"/>
              <a:gd name="connsiteY44" fmla="*/ 1142341 h 6105653"/>
              <a:gd name="connsiteX45" fmla="*/ 11074003 w 12191999"/>
              <a:gd name="connsiteY45" fmla="*/ 1084192 h 6105653"/>
              <a:gd name="connsiteX46" fmla="*/ 11181159 w 12191999"/>
              <a:gd name="connsiteY46" fmla="*/ 848688 h 6105653"/>
              <a:gd name="connsiteX47" fmla="*/ 11238309 w 12191999"/>
              <a:gd name="connsiteY47" fmla="*/ 805077 h 6105653"/>
              <a:gd name="connsiteX48" fmla="*/ 11266884 w 12191999"/>
              <a:gd name="connsiteY48" fmla="*/ 863226 h 6105653"/>
              <a:gd name="connsiteX49" fmla="*/ 11277600 w 12191999"/>
              <a:gd name="connsiteY49" fmla="*/ 906838 h 6105653"/>
              <a:gd name="connsiteX50" fmla="*/ 11724084 w 12191999"/>
              <a:gd name="connsiteY50" fmla="*/ 5527 h 6105653"/>
              <a:gd name="connsiteX51" fmla="*/ 11727656 w 12191999"/>
              <a:gd name="connsiteY51" fmla="*/ 209048 h 6105653"/>
              <a:gd name="connsiteX52" fmla="*/ 11656218 w 12191999"/>
              <a:gd name="connsiteY52" fmla="*/ 409663 h 6105653"/>
              <a:gd name="connsiteX53" fmla="*/ 11666934 w 12191999"/>
              <a:gd name="connsiteY53" fmla="*/ 621907 h 6105653"/>
              <a:gd name="connsiteX54" fmla="*/ 11631215 w 12191999"/>
              <a:gd name="connsiteY54" fmla="*/ 822521 h 6105653"/>
              <a:gd name="connsiteX55" fmla="*/ 11631215 w 12191999"/>
              <a:gd name="connsiteY55" fmla="*/ 996969 h 6105653"/>
              <a:gd name="connsiteX56" fmla="*/ 11684793 w 12191999"/>
              <a:gd name="connsiteY56" fmla="*/ 834151 h 6105653"/>
              <a:gd name="connsiteX57" fmla="*/ 11774090 w 12191999"/>
              <a:gd name="connsiteY57" fmla="*/ 773095 h 6105653"/>
              <a:gd name="connsiteX58" fmla="*/ 11856243 w 12191999"/>
              <a:gd name="connsiteY58" fmla="*/ 793447 h 6105653"/>
              <a:gd name="connsiteX59" fmla="*/ 11831240 w 12191999"/>
              <a:gd name="connsiteY59" fmla="*/ 860319 h 6105653"/>
              <a:gd name="connsiteX60" fmla="*/ 11738371 w 12191999"/>
              <a:gd name="connsiteY60" fmla="*/ 938820 h 6105653"/>
              <a:gd name="connsiteX61" fmla="*/ 11795521 w 12191999"/>
              <a:gd name="connsiteY61" fmla="*/ 956264 h 6105653"/>
              <a:gd name="connsiteX62" fmla="*/ 11838384 w 12191999"/>
              <a:gd name="connsiteY62" fmla="*/ 1002784 h 6105653"/>
              <a:gd name="connsiteX63" fmla="*/ 11816952 w 12191999"/>
              <a:gd name="connsiteY63" fmla="*/ 1270269 h 6105653"/>
              <a:gd name="connsiteX64" fmla="*/ 11999118 w 12191999"/>
              <a:gd name="connsiteY64" fmla="*/ 1092915 h 6105653"/>
              <a:gd name="connsiteX65" fmla="*/ 12027693 w 12191999"/>
              <a:gd name="connsiteY65" fmla="*/ 979524 h 6105653"/>
              <a:gd name="connsiteX66" fmla="*/ 12102703 w 12191999"/>
              <a:gd name="connsiteY66" fmla="*/ 953357 h 6105653"/>
              <a:gd name="connsiteX67" fmla="*/ 12120562 w 12191999"/>
              <a:gd name="connsiteY67" fmla="*/ 1005691 h 6105653"/>
              <a:gd name="connsiteX68" fmla="*/ 12056268 w 12191999"/>
              <a:gd name="connsiteY68" fmla="*/ 1267362 h 6105653"/>
              <a:gd name="connsiteX69" fmla="*/ 12081272 w 12191999"/>
              <a:gd name="connsiteY69" fmla="*/ 1310974 h 6105653"/>
              <a:gd name="connsiteX70" fmla="*/ 12191999 w 12191999"/>
              <a:gd name="connsiteY70" fmla="*/ 1008598 h 6105653"/>
              <a:gd name="connsiteX71" fmla="*/ 12191999 w 12191999"/>
              <a:gd name="connsiteY71" fmla="*/ 6105653 h 6105653"/>
              <a:gd name="connsiteX72" fmla="*/ 0 w 12191999"/>
              <a:gd name="connsiteY72" fmla="*/ 6105653 h 6105653"/>
              <a:gd name="connsiteX73" fmla="*/ 0 w 12191999"/>
              <a:gd name="connsiteY73" fmla="*/ 927116 h 6105653"/>
              <a:gd name="connsiteX74" fmla="*/ 61930 w 12191999"/>
              <a:gd name="connsiteY74" fmla="*/ 902578 h 6105653"/>
              <a:gd name="connsiteX75" fmla="*/ 155971 w 12191999"/>
              <a:gd name="connsiteY75" fmla="*/ 883588 h 6105653"/>
              <a:gd name="connsiteX76" fmla="*/ 277414 w 12191999"/>
              <a:gd name="connsiteY76" fmla="*/ 802179 h 6105653"/>
              <a:gd name="connsiteX77" fmla="*/ 638174 w 12191999"/>
              <a:gd name="connsiteY77" fmla="*/ 430025 h 6105653"/>
              <a:gd name="connsiteX78" fmla="*/ 477440 w 12191999"/>
              <a:gd name="connsiteY78" fmla="*/ 784735 h 6105653"/>
              <a:gd name="connsiteX79" fmla="*/ 827483 w 12191999"/>
              <a:gd name="connsiteY79" fmla="*/ 418395 h 6105653"/>
              <a:gd name="connsiteX80" fmla="*/ 956071 w 12191999"/>
              <a:gd name="connsiteY80" fmla="*/ 241040 h 6105653"/>
              <a:gd name="connsiteX81" fmla="*/ 999268 w 12191999"/>
              <a:gd name="connsiteY81" fmla="*/ 192386 h 6105653"/>
              <a:gd name="connsiteX82" fmla="*/ 1031080 w 12191999"/>
              <a:gd name="connsiteY82" fmla="*/ 197429 h 6105653"/>
              <a:gd name="connsiteX83" fmla="*/ 1048940 w 12191999"/>
              <a:gd name="connsiteY83" fmla="*/ 275930 h 6105653"/>
              <a:gd name="connsiteX84" fmla="*/ 1020365 w 12191999"/>
              <a:gd name="connsiteY84" fmla="*/ 517249 h 6105653"/>
              <a:gd name="connsiteX85" fmla="*/ 1256108 w 12191999"/>
              <a:gd name="connsiteY85" fmla="*/ 217780 h 6105653"/>
              <a:gd name="connsiteX86" fmla="*/ 1220389 w 12191999"/>
              <a:gd name="connsiteY86" fmla="*/ 441654 h 6105653"/>
              <a:gd name="connsiteX87" fmla="*/ 1313258 w 12191999"/>
              <a:gd name="connsiteY87" fmla="*/ 505619 h 6105653"/>
              <a:gd name="connsiteX88" fmla="*/ 1463277 w 12191999"/>
              <a:gd name="connsiteY88" fmla="*/ 610287 h 6105653"/>
              <a:gd name="connsiteX89" fmla="*/ 1545430 w 12191999"/>
              <a:gd name="connsiteY89" fmla="*/ 682974 h 6105653"/>
              <a:gd name="connsiteX90" fmla="*/ 1809749 w 12191999"/>
              <a:gd name="connsiteY90" fmla="*/ 712048 h 6105653"/>
              <a:gd name="connsiteX91" fmla="*/ 2099071 w 12191999"/>
              <a:gd name="connsiteY91" fmla="*/ 650992 h 6105653"/>
              <a:gd name="connsiteX92" fmla="*/ 2245518 w 12191999"/>
              <a:gd name="connsiteY92" fmla="*/ 482359 h 6105653"/>
              <a:gd name="connsiteX93" fmla="*/ 2409824 w 12191999"/>
              <a:gd name="connsiteY93" fmla="*/ 531786 h 6105653"/>
              <a:gd name="connsiteX94" fmla="*/ 2309812 w 12191999"/>
              <a:gd name="connsiteY94" fmla="*/ 889403 h 6105653"/>
              <a:gd name="connsiteX95" fmla="*/ 2699146 w 12191999"/>
              <a:gd name="connsiteY95" fmla="*/ 357339 h 6105653"/>
              <a:gd name="connsiteX96" fmla="*/ 2717006 w 12191999"/>
              <a:gd name="connsiteY96" fmla="*/ 447469 h 6105653"/>
              <a:gd name="connsiteX97" fmla="*/ 2938461 w 12191999"/>
              <a:gd name="connsiteY97" fmla="*/ 770197 h 6105653"/>
              <a:gd name="connsiteX98" fmla="*/ 2949178 w 12191999"/>
              <a:gd name="connsiteY98" fmla="*/ 787642 h 6105653"/>
              <a:gd name="connsiteX99" fmla="*/ 3088480 w 12191999"/>
              <a:gd name="connsiteY99" fmla="*/ 842883 h 6105653"/>
              <a:gd name="connsiteX100" fmla="*/ 3109911 w 12191999"/>
              <a:gd name="connsiteY100" fmla="*/ 1017331 h 6105653"/>
              <a:gd name="connsiteX101" fmla="*/ 3077765 w 12191999"/>
              <a:gd name="connsiteY101" fmla="*/ 1162704 h 6105653"/>
              <a:gd name="connsiteX102" fmla="*/ 3117055 w 12191999"/>
              <a:gd name="connsiteY102" fmla="*/ 1319707 h 6105653"/>
              <a:gd name="connsiteX103" fmla="*/ 3099196 w 12191999"/>
              <a:gd name="connsiteY103" fmla="*/ 1459264 h 6105653"/>
              <a:gd name="connsiteX104" fmla="*/ 3124198 w 12191999"/>
              <a:gd name="connsiteY104" fmla="*/ 1578470 h 6105653"/>
              <a:gd name="connsiteX105" fmla="*/ 3242071 w 12191999"/>
              <a:gd name="connsiteY105" fmla="*/ 1462171 h 6105653"/>
              <a:gd name="connsiteX106" fmla="*/ 3242071 w 12191999"/>
              <a:gd name="connsiteY106" fmla="*/ 1299354 h 6105653"/>
              <a:gd name="connsiteX107" fmla="*/ 3317080 w 12191999"/>
              <a:gd name="connsiteY107" fmla="*/ 1183056 h 6105653"/>
              <a:gd name="connsiteX108" fmla="*/ 3452811 w 12191999"/>
              <a:gd name="connsiteY108" fmla="*/ 1072572 h 6105653"/>
              <a:gd name="connsiteX109" fmla="*/ 3670696 w 12191999"/>
              <a:gd name="connsiteY109" fmla="*/ 682973 h 6105653"/>
              <a:gd name="connsiteX110" fmla="*/ 3752849 w 12191999"/>
              <a:gd name="connsiteY110" fmla="*/ 613194 h 6105653"/>
              <a:gd name="connsiteX111" fmla="*/ 3434952 w 12191999"/>
              <a:gd name="connsiteY111" fmla="*/ 1723843 h 6105653"/>
              <a:gd name="connsiteX112" fmla="*/ 3567111 w 12191999"/>
              <a:gd name="connsiteY112" fmla="*/ 1380763 h 6105653"/>
              <a:gd name="connsiteX113" fmla="*/ 3542109 w 12191999"/>
              <a:gd name="connsiteY113" fmla="*/ 1613360 h 6105653"/>
              <a:gd name="connsiteX114" fmla="*/ 3631405 w 12191999"/>
              <a:gd name="connsiteY114" fmla="*/ 1741287 h 6105653"/>
              <a:gd name="connsiteX115" fmla="*/ 3659980 w 12191999"/>
              <a:gd name="connsiteY115" fmla="*/ 1741287 h 6105653"/>
              <a:gd name="connsiteX116" fmla="*/ 3742133 w 12191999"/>
              <a:gd name="connsiteY116" fmla="*/ 1645341 h 6105653"/>
              <a:gd name="connsiteX117" fmla="*/ 3795712 w 12191999"/>
              <a:gd name="connsiteY117" fmla="*/ 1590100 h 6105653"/>
              <a:gd name="connsiteX118" fmla="*/ 3988593 w 12191999"/>
              <a:gd name="connsiteY118" fmla="*/ 1438912 h 6105653"/>
              <a:gd name="connsiteX119" fmla="*/ 4010024 w 12191999"/>
              <a:gd name="connsiteY119" fmla="*/ 1546488 h 6105653"/>
              <a:gd name="connsiteX120" fmla="*/ 4049315 w 12191999"/>
              <a:gd name="connsiteY120" fmla="*/ 1587192 h 6105653"/>
              <a:gd name="connsiteX121" fmla="*/ 4106465 w 12191999"/>
              <a:gd name="connsiteY121" fmla="*/ 1558118 h 6105653"/>
              <a:gd name="connsiteX122" fmla="*/ 4281487 w 12191999"/>
              <a:gd name="connsiteY122" fmla="*/ 1223760 h 6105653"/>
              <a:gd name="connsiteX123" fmla="*/ 4417219 w 12191999"/>
              <a:gd name="connsiteY123" fmla="*/ 1197593 h 6105653"/>
              <a:gd name="connsiteX124" fmla="*/ 4438649 w 12191999"/>
              <a:gd name="connsiteY124" fmla="*/ 1261557 h 6105653"/>
              <a:gd name="connsiteX125" fmla="*/ 4427935 w 12191999"/>
              <a:gd name="connsiteY125" fmla="*/ 1334243 h 6105653"/>
              <a:gd name="connsiteX126" fmla="*/ 4535090 w 12191999"/>
              <a:gd name="connsiteY126" fmla="*/ 1276094 h 6105653"/>
              <a:gd name="connsiteX127" fmla="*/ 4642246 w 12191999"/>
              <a:gd name="connsiteY127" fmla="*/ 1040590 h 6105653"/>
              <a:gd name="connsiteX128" fmla="*/ 4699396 w 12191999"/>
              <a:gd name="connsiteY128" fmla="*/ 996979 h 6105653"/>
              <a:gd name="connsiteX129" fmla="*/ 4727971 w 12191999"/>
              <a:gd name="connsiteY129" fmla="*/ 1055128 h 6105653"/>
              <a:gd name="connsiteX130" fmla="*/ 4738688 w 12191999"/>
              <a:gd name="connsiteY130" fmla="*/ 1098740 h 6105653"/>
              <a:gd name="connsiteX131" fmla="*/ 5185172 w 12191999"/>
              <a:gd name="connsiteY131" fmla="*/ 197429 h 6105653"/>
              <a:gd name="connsiteX132" fmla="*/ 5188744 w 12191999"/>
              <a:gd name="connsiteY132" fmla="*/ 400950 h 6105653"/>
              <a:gd name="connsiteX133" fmla="*/ 5117306 w 12191999"/>
              <a:gd name="connsiteY133" fmla="*/ 601565 h 6105653"/>
              <a:gd name="connsiteX134" fmla="*/ 5128021 w 12191999"/>
              <a:gd name="connsiteY134" fmla="*/ 813809 h 6105653"/>
              <a:gd name="connsiteX135" fmla="*/ 5092302 w 12191999"/>
              <a:gd name="connsiteY135" fmla="*/ 1014423 h 6105653"/>
              <a:gd name="connsiteX136" fmla="*/ 5092302 w 12191999"/>
              <a:gd name="connsiteY136" fmla="*/ 1188871 h 6105653"/>
              <a:gd name="connsiteX137" fmla="*/ 5145880 w 12191999"/>
              <a:gd name="connsiteY137" fmla="*/ 1026053 h 6105653"/>
              <a:gd name="connsiteX138" fmla="*/ 5235177 w 12191999"/>
              <a:gd name="connsiteY138" fmla="*/ 964997 h 6105653"/>
              <a:gd name="connsiteX139" fmla="*/ 5317331 w 12191999"/>
              <a:gd name="connsiteY139" fmla="*/ 985349 h 6105653"/>
              <a:gd name="connsiteX140" fmla="*/ 5292327 w 12191999"/>
              <a:gd name="connsiteY140" fmla="*/ 1052221 h 6105653"/>
              <a:gd name="connsiteX141" fmla="*/ 5199458 w 12191999"/>
              <a:gd name="connsiteY141" fmla="*/ 1130722 h 6105653"/>
              <a:gd name="connsiteX142" fmla="*/ 5256608 w 12191999"/>
              <a:gd name="connsiteY142" fmla="*/ 1148166 h 6105653"/>
              <a:gd name="connsiteX143" fmla="*/ 5299471 w 12191999"/>
              <a:gd name="connsiteY143" fmla="*/ 1194686 h 6105653"/>
              <a:gd name="connsiteX144" fmla="*/ 5278039 w 12191999"/>
              <a:gd name="connsiteY144" fmla="*/ 1462171 h 6105653"/>
              <a:gd name="connsiteX145" fmla="*/ 5460205 w 12191999"/>
              <a:gd name="connsiteY145" fmla="*/ 1284817 h 6105653"/>
              <a:gd name="connsiteX146" fmla="*/ 5488780 w 12191999"/>
              <a:gd name="connsiteY146" fmla="*/ 1171426 h 6105653"/>
              <a:gd name="connsiteX147" fmla="*/ 5539513 w 12191999"/>
              <a:gd name="connsiteY147" fmla="*/ 1140353 h 6105653"/>
              <a:gd name="connsiteX148" fmla="*/ 5552720 w 12191999"/>
              <a:gd name="connsiteY148" fmla="*/ 1143022 h 6105653"/>
              <a:gd name="connsiteX149" fmla="*/ 5574208 w 12191999"/>
              <a:gd name="connsiteY149" fmla="*/ 1115811 h 6105653"/>
              <a:gd name="connsiteX150" fmla="*/ 5734050 w 12191999"/>
              <a:gd name="connsiteY150" fmla="*/ 1075470 h 6105653"/>
              <a:gd name="connsiteX151" fmla="*/ 5798343 w 12191999"/>
              <a:gd name="connsiteY151" fmla="*/ 1020228 h 6105653"/>
              <a:gd name="connsiteX152" fmla="*/ 5884068 w 12191999"/>
              <a:gd name="connsiteY152" fmla="*/ 883578 h 6105653"/>
              <a:gd name="connsiteX153" fmla="*/ 6066234 w 12191999"/>
              <a:gd name="connsiteY153" fmla="*/ 645166 h 6105653"/>
              <a:gd name="connsiteX154" fmla="*/ 6109096 w 12191999"/>
              <a:gd name="connsiteY154" fmla="*/ 732391 h 6105653"/>
              <a:gd name="connsiteX155" fmla="*/ 5998368 w 12191999"/>
              <a:gd name="connsiteY155" fmla="*/ 985338 h 6105653"/>
              <a:gd name="connsiteX156" fmla="*/ 5969793 w 12191999"/>
              <a:gd name="connsiteY156" fmla="*/ 1168509 h 6105653"/>
              <a:gd name="connsiteX157" fmla="*/ 6162674 w 12191999"/>
              <a:gd name="connsiteY157" fmla="*/ 909745 h 6105653"/>
              <a:gd name="connsiteX158" fmla="*/ 6412705 w 12191999"/>
              <a:gd name="connsiteY158" fmla="*/ 659704 h 6105653"/>
              <a:gd name="connsiteX159" fmla="*/ 6366271 w 12191999"/>
              <a:gd name="connsiteY159" fmla="*/ 851596 h 6105653"/>
              <a:gd name="connsiteX160" fmla="*/ 6398418 w 12191999"/>
              <a:gd name="connsiteY160" fmla="*/ 860319 h 6105653"/>
              <a:gd name="connsiteX161" fmla="*/ 6694884 w 12191999"/>
              <a:gd name="connsiteY161" fmla="*/ 691686 h 6105653"/>
              <a:gd name="connsiteX162" fmla="*/ 6816327 w 12191999"/>
              <a:gd name="connsiteY162" fmla="*/ 610277 h 6105653"/>
              <a:gd name="connsiteX163" fmla="*/ 7177087 w 12191999"/>
              <a:gd name="connsiteY163" fmla="*/ 238123 h 6105653"/>
              <a:gd name="connsiteX164" fmla="*/ 7016353 w 12191999"/>
              <a:gd name="connsiteY164" fmla="*/ 592833 h 6105653"/>
              <a:gd name="connsiteX165" fmla="*/ 7366396 w 12191999"/>
              <a:gd name="connsiteY165" fmla="*/ 226493 h 6105653"/>
              <a:gd name="connsiteX166" fmla="*/ 7494984 w 12191999"/>
              <a:gd name="connsiteY166" fmla="*/ 49138 h 6105653"/>
              <a:gd name="connsiteX167" fmla="*/ 7538181 w 12191999"/>
              <a:gd name="connsiteY167" fmla="*/ 484 h 610565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Lst>
            <a:rect l="l" t="t" r="r" b="b"/>
            <a:pathLst>
              <a:path w="12191999" h="6105653">
                <a:moveTo>
                  <a:pt x="7538181" y="484"/>
                </a:moveTo>
                <a:cubicBezTo>
                  <a:pt x="7546999" y="-833"/>
                  <a:pt x="7557492" y="439"/>
                  <a:pt x="7569993" y="5527"/>
                </a:cubicBezTo>
                <a:cubicBezTo>
                  <a:pt x="7612855" y="22971"/>
                  <a:pt x="7598567" y="54953"/>
                  <a:pt x="7587853" y="84028"/>
                </a:cubicBezTo>
                <a:cubicBezTo>
                  <a:pt x="7559278" y="153806"/>
                  <a:pt x="7559278" y="229401"/>
                  <a:pt x="7559278" y="325347"/>
                </a:cubicBezTo>
                <a:cubicBezTo>
                  <a:pt x="7695009" y="243938"/>
                  <a:pt x="7652146" y="95658"/>
                  <a:pt x="7795021" y="25878"/>
                </a:cubicBezTo>
                <a:cubicBezTo>
                  <a:pt x="7820024" y="113102"/>
                  <a:pt x="7770018" y="179974"/>
                  <a:pt x="7759302" y="249752"/>
                </a:cubicBezTo>
                <a:cubicBezTo>
                  <a:pt x="7748587" y="313717"/>
                  <a:pt x="7773590" y="328254"/>
                  <a:pt x="7852171" y="313717"/>
                </a:cubicBezTo>
                <a:cubicBezTo>
                  <a:pt x="7973615" y="290457"/>
                  <a:pt x="8034337" y="325347"/>
                  <a:pt x="8002190" y="418385"/>
                </a:cubicBezTo>
                <a:cubicBezTo>
                  <a:pt x="7970043" y="505609"/>
                  <a:pt x="8016478" y="514331"/>
                  <a:pt x="8084343" y="491072"/>
                </a:cubicBezTo>
                <a:cubicBezTo>
                  <a:pt x="8184355" y="456182"/>
                  <a:pt x="8262937" y="493979"/>
                  <a:pt x="8348662" y="520146"/>
                </a:cubicBezTo>
                <a:cubicBezTo>
                  <a:pt x="8477249" y="560851"/>
                  <a:pt x="8541543" y="543406"/>
                  <a:pt x="8637984" y="459090"/>
                </a:cubicBezTo>
                <a:cubicBezTo>
                  <a:pt x="8691561" y="409663"/>
                  <a:pt x="8737996" y="360236"/>
                  <a:pt x="8784431" y="290457"/>
                </a:cubicBezTo>
                <a:cubicBezTo>
                  <a:pt x="8809434" y="450367"/>
                  <a:pt x="8895158" y="284642"/>
                  <a:pt x="8948737" y="339884"/>
                </a:cubicBezTo>
                <a:cubicBezTo>
                  <a:pt x="8970168" y="453274"/>
                  <a:pt x="8798717" y="543406"/>
                  <a:pt x="8848725" y="697501"/>
                </a:cubicBezTo>
                <a:cubicBezTo>
                  <a:pt x="8995171" y="511424"/>
                  <a:pt x="9041606" y="302087"/>
                  <a:pt x="9238059" y="165437"/>
                </a:cubicBezTo>
                <a:cubicBezTo>
                  <a:pt x="9280921" y="197419"/>
                  <a:pt x="9238059" y="229401"/>
                  <a:pt x="9255919" y="255567"/>
                </a:cubicBezTo>
                <a:cubicBezTo>
                  <a:pt x="9266634" y="255567"/>
                  <a:pt x="9198767" y="560851"/>
                  <a:pt x="9477374" y="578295"/>
                </a:cubicBezTo>
                <a:cubicBezTo>
                  <a:pt x="9477374" y="584110"/>
                  <a:pt x="9477374" y="589925"/>
                  <a:pt x="9488091" y="595740"/>
                </a:cubicBezTo>
                <a:cubicBezTo>
                  <a:pt x="9527380" y="627722"/>
                  <a:pt x="9620249" y="598648"/>
                  <a:pt x="9627393" y="650981"/>
                </a:cubicBezTo>
                <a:cubicBezTo>
                  <a:pt x="9634537" y="709131"/>
                  <a:pt x="9666684" y="764373"/>
                  <a:pt x="9648824" y="825429"/>
                </a:cubicBezTo>
                <a:cubicBezTo>
                  <a:pt x="9634537" y="871948"/>
                  <a:pt x="9616678" y="921374"/>
                  <a:pt x="9616678" y="970802"/>
                </a:cubicBezTo>
                <a:cubicBezTo>
                  <a:pt x="9616678" y="1023136"/>
                  <a:pt x="9495233" y="1095822"/>
                  <a:pt x="9655968" y="1127805"/>
                </a:cubicBezTo>
                <a:cubicBezTo>
                  <a:pt x="9663111" y="1127805"/>
                  <a:pt x="9645252" y="1217935"/>
                  <a:pt x="9638109" y="1267362"/>
                </a:cubicBezTo>
                <a:cubicBezTo>
                  <a:pt x="9630965" y="1308066"/>
                  <a:pt x="9598818" y="1357494"/>
                  <a:pt x="9663111" y="1386568"/>
                </a:cubicBezTo>
                <a:cubicBezTo>
                  <a:pt x="9702403" y="1401105"/>
                  <a:pt x="9773840" y="1331326"/>
                  <a:pt x="9780984" y="1270269"/>
                </a:cubicBezTo>
                <a:cubicBezTo>
                  <a:pt x="9788127" y="1215028"/>
                  <a:pt x="9795271" y="1159787"/>
                  <a:pt x="9780984" y="1107452"/>
                </a:cubicBezTo>
                <a:cubicBezTo>
                  <a:pt x="9763125" y="1043488"/>
                  <a:pt x="9791699" y="1008598"/>
                  <a:pt x="9855993" y="991154"/>
                </a:cubicBezTo>
                <a:cubicBezTo>
                  <a:pt x="9923858" y="970802"/>
                  <a:pt x="9959577" y="933005"/>
                  <a:pt x="9991724" y="880670"/>
                </a:cubicBezTo>
                <a:cubicBezTo>
                  <a:pt x="10070305" y="752742"/>
                  <a:pt x="10163174" y="630630"/>
                  <a:pt x="10209609" y="491071"/>
                </a:cubicBezTo>
                <a:cubicBezTo>
                  <a:pt x="10216753" y="464905"/>
                  <a:pt x="10231040" y="432923"/>
                  <a:pt x="10291762" y="421292"/>
                </a:cubicBezTo>
                <a:cubicBezTo>
                  <a:pt x="10198893" y="799262"/>
                  <a:pt x="9959577" y="1142341"/>
                  <a:pt x="9973865" y="1531941"/>
                </a:cubicBezTo>
                <a:cubicBezTo>
                  <a:pt x="10048874" y="1427272"/>
                  <a:pt x="10052446" y="1302252"/>
                  <a:pt x="10106024" y="1188861"/>
                </a:cubicBezTo>
                <a:cubicBezTo>
                  <a:pt x="10145315" y="1270269"/>
                  <a:pt x="10102453" y="1345863"/>
                  <a:pt x="10081022" y="1421458"/>
                </a:cubicBezTo>
                <a:cubicBezTo>
                  <a:pt x="10063162" y="1485421"/>
                  <a:pt x="10059590" y="1543570"/>
                  <a:pt x="10170318" y="1549385"/>
                </a:cubicBezTo>
                <a:cubicBezTo>
                  <a:pt x="10181034" y="1549385"/>
                  <a:pt x="10188178" y="1549385"/>
                  <a:pt x="10198893" y="1549385"/>
                </a:cubicBezTo>
                <a:cubicBezTo>
                  <a:pt x="10245327" y="1526126"/>
                  <a:pt x="10266759" y="1494144"/>
                  <a:pt x="10281046" y="1453439"/>
                </a:cubicBezTo>
                <a:cubicBezTo>
                  <a:pt x="10288190" y="1430180"/>
                  <a:pt x="10302477" y="1398198"/>
                  <a:pt x="10334625" y="1398198"/>
                </a:cubicBezTo>
                <a:cubicBezTo>
                  <a:pt x="10456068" y="1401105"/>
                  <a:pt x="10491787" y="1322604"/>
                  <a:pt x="10527506" y="1247010"/>
                </a:cubicBezTo>
                <a:cubicBezTo>
                  <a:pt x="10588228" y="1287714"/>
                  <a:pt x="10545365" y="1322604"/>
                  <a:pt x="10548937" y="1354586"/>
                </a:cubicBezTo>
                <a:cubicBezTo>
                  <a:pt x="10552509" y="1374938"/>
                  <a:pt x="10556080" y="1395290"/>
                  <a:pt x="10588228" y="1395290"/>
                </a:cubicBezTo>
                <a:cubicBezTo>
                  <a:pt x="10613230" y="1395290"/>
                  <a:pt x="10645378" y="1386568"/>
                  <a:pt x="10645378" y="1366216"/>
                </a:cubicBezTo>
                <a:cubicBezTo>
                  <a:pt x="10648949" y="1238288"/>
                  <a:pt x="10820400" y="1165601"/>
                  <a:pt x="10820400" y="1031858"/>
                </a:cubicBezTo>
                <a:cubicBezTo>
                  <a:pt x="10820400" y="950449"/>
                  <a:pt x="10916840" y="1072563"/>
                  <a:pt x="10956131" y="1005691"/>
                </a:cubicBezTo>
                <a:cubicBezTo>
                  <a:pt x="10966847" y="991154"/>
                  <a:pt x="10981133" y="1046395"/>
                  <a:pt x="10977562" y="1069655"/>
                </a:cubicBezTo>
                <a:cubicBezTo>
                  <a:pt x="10973991" y="1092915"/>
                  <a:pt x="10948987" y="1113267"/>
                  <a:pt x="10966847" y="1142341"/>
                </a:cubicBezTo>
                <a:cubicBezTo>
                  <a:pt x="11031140" y="1156879"/>
                  <a:pt x="11056143" y="1119081"/>
                  <a:pt x="11074003" y="1084192"/>
                </a:cubicBezTo>
                <a:cubicBezTo>
                  <a:pt x="11116865" y="1008598"/>
                  <a:pt x="11166871" y="933005"/>
                  <a:pt x="11181159" y="848688"/>
                </a:cubicBezTo>
                <a:cubicBezTo>
                  <a:pt x="11184730" y="819614"/>
                  <a:pt x="11202590" y="802169"/>
                  <a:pt x="11238309" y="805077"/>
                </a:cubicBezTo>
                <a:cubicBezTo>
                  <a:pt x="11284744" y="810891"/>
                  <a:pt x="11270456" y="839966"/>
                  <a:pt x="11266884" y="863226"/>
                </a:cubicBezTo>
                <a:cubicBezTo>
                  <a:pt x="11263312" y="877763"/>
                  <a:pt x="11252596" y="892300"/>
                  <a:pt x="11277600" y="906838"/>
                </a:cubicBezTo>
                <a:cubicBezTo>
                  <a:pt x="11531203" y="566666"/>
                  <a:pt x="11516915" y="386403"/>
                  <a:pt x="11724084" y="5527"/>
                </a:cubicBezTo>
                <a:cubicBezTo>
                  <a:pt x="11763375" y="89842"/>
                  <a:pt x="11734800" y="150899"/>
                  <a:pt x="11727656" y="209048"/>
                </a:cubicBezTo>
                <a:cubicBezTo>
                  <a:pt x="11709796" y="354421"/>
                  <a:pt x="11677649" y="264290"/>
                  <a:pt x="11656218" y="409663"/>
                </a:cubicBezTo>
                <a:cubicBezTo>
                  <a:pt x="11645503" y="479442"/>
                  <a:pt x="11609784" y="543406"/>
                  <a:pt x="11666934" y="621907"/>
                </a:cubicBezTo>
                <a:cubicBezTo>
                  <a:pt x="11706225" y="674241"/>
                  <a:pt x="11663362" y="758557"/>
                  <a:pt x="11631215" y="822521"/>
                </a:cubicBezTo>
                <a:cubicBezTo>
                  <a:pt x="11602640" y="874856"/>
                  <a:pt x="11595497" y="927190"/>
                  <a:pt x="11631215" y="996969"/>
                </a:cubicBezTo>
                <a:cubicBezTo>
                  <a:pt x="11652646" y="933005"/>
                  <a:pt x="11670505" y="883578"/>
                  <a:pt x="11684793" y="834151"/>
                </a:cubicBezTo>
                <a:cubicBezTo>
                  <a:pt x="11695509" y="793447"/>
                  <a:pt x="11720512" y="770187"/>
                  <a:pt x="11774090" y="773095"/>
                </a:cubicBezTo>
                <a:cubicBezTo>
                  <a:pt x="11802665" y="773095"/>
                  <a:pt x="11841956" y="764373"/>
                  <a:pt x="11856243" y="793447"/>
                </a:cubicBezTo>
                <a:cubicBezTo>
                  <a:pt x="11870531" y="816706"/>
                  <a:pt x="11856243" y="848688"/>
                  <a:pt x="11831240" y="860319"/>
                </a:cubicBezTo>
                <a:cubicBezTo>
                  <a:pt x="11784806" y="874856"/>
                  <a:pt x="11741944" y="889393"/>
                  <a:pt x="11738371" y="938820"/>
                </a:cubicBezTo>
                <a:cubicBezTo>
                  <a:pt x="11731228" y="1005691"/>
                  <a:pt x="11759802" y="967894"/>
                  <a:pt x="11795521" y="956264"/>
                </a:cubicBezTo>
                <a:cubicBezTo>
                  <a:pt x="11834812" y="944634"/>
                  <a:pt x="11845527" y="979524"/>
                  <a:pt x="11838384" y="1002784"/>
                </a:cubicBezTo>
                <a:cubicBezTo>
                  <a:pt x="11806237" y="1090007"/>
                  <a:pt x="11863387" y="1180138"/>
                  <a:pt x="11816952" y="1270269"/>
                </a:cubicBezTo>
                <a:cubicBezTo>
                  <a:pt x="11931252" y="1247010"/>
                  <a:pt x="11981259" y="1197583"/>
                  <a:pt x="11999118" y="1092915"/>
                </a:cubicBezTo>
                <a:cubicBezTo>
                  <a:pt x="12002690" y="1055118"/>
                  <a:pt x="11995547" y="1014413"/>
                  <a:pt x="12027693" y="979524"/>
                </a:cubicBezTo>
                <a:cubicBezTo>
                  <a:pt x="12045553" y="959172"/>
                  <a:pt x="12066984" y="938820"/>
                  <a:pt x="12102703" y="953357"/>
                </a:cubicBezTo>
                <a:cubicBezTo>
                  <a:pt x="12127705" y="962080"/>
                  <a:pt x="12127705" y="985338"/>
                  <a:pt x="12120562" y="1005691"/>
                </a:cubicBezTo>
                <a:cubicBezTo>
                  <a:pt x="12081272" y="1090007"/>
                  <a:pt x="12070555" y="1180138"/>
                  <a:pt x="12056268" y="1267362"/>
                </a:cubicBezTo>
                <a:cubicBezTo>
                  <a:pt x="12052697" y="1281899"/>
                  <a:pt x="12045553" y="1296437"/>
                  <a:pt x="12081272" y="1310974"/>
                </a:cubicBezTo>
                <a:cubicBezTo>
                  <a:pt x="12113418" y="1209213"/>
                  <a:pt x="12156280" y="1110359"/>
                  <a:pt x="12191999" y="1008598"/>
                </a:cubicBezTo>
                <a:lnTo>
                  <a:pt x="12191999" y="6105653"/>
                </a:lnTo>
                <a:lnTo>
                  <a:pt x="0" y="6105653"/>
                </a:lnTo>
                <a:lnTo>
                  <a:pt x="0" y="927116"/>
                </a:lnTo>
                <a:lnTo>
                  <a:pt x="61930" y="902578"/>
                </a:lnTo>
                <a:cubicBezTo>
                  <a:pt x="91454" y="894128"/>
                  <a:pt x="122931" y="887949"/>
                  <a:pt x="155971" y="883588"/>
                </a:cubicBezTo>
                <a:cubicBezTo>
                  <a:pt x="223837" y="877773"/>
                  <a:pt x="245268" y="839976"/>
                  <a:pt x="277414" y="802179"/>
                </a:cubicBezTo>
                <a:cubicBezTo>
                  <a:pt x="388143" y="674251"/>
                  <a:pt x="488155" y="537601"/>
                  <a:pt x="638174" y="430025"/>
                </a:cubicBezTo>
                <a:cubicBezTo>
                  <a:pt x="620315" y="555046"/>
                  <a:pt x="520302" y="653899"/>
                  <a:pt x="477440" y="784735"/>
                </a:cubicBezTo>
                <a:cubicBezTo>
                  <a:pt x="641746" y="680066"/>
                  <a:pt x="727471" y="543415"/>
                  <a:pt x="827483" y="418395"/>
                </a:cubicBezTo>
                <a:cubicBezTo>
                  <a:pt x="873917" y="360246"/>
                  <a:pt x="931068" y="307912"/>
                  <a:pt x="956071" y="241040"/>
                </a:cubicBezTo>
                <a:cubicBezTo>
                  <a:pt x="961429" y="223595"/>
                  <a:pt x="972814" y="196338"/>
                  <a:pt x="999268" y="192386"/>
                </a:cubicBezTo>
                <a:cubicBezTo>
                  <a:pt x="1008086" y="191069"/>
                  <a:pt x="1018579" y="192341"/>
                  <a:pt x="1031080" y="197429"/>
                </a:cubicBezTo>
                <a:cubicBezTo>
                  <a:pt x="1073942" y="214873"/>
                  <a:pt x="1059654" y="246855"/>
                  <a:pt x="1048940" y="275930"/>
                </a:cubicBezTo>
                <a:cubicBezTo>
                  <a:pt x="1020365" y="345708"/>
                  <a:pt x="1020365" y="421303"/>
                  <a:pt x="1020365" y="517249"/>
                </a:cubicBezTo>
                <a:cubicBezTo>
                  <a:pt x="1156096" y="435840"/>
                  <a:pt x="1113233" y="287560"/>
                  <a:pt x="1256108" y="217780"/>
                </a:cubicBezTo>
                <a:cubicBezTo>
                  <a:pt x="1281111" y="305004"/>
                  <a:pt x="1231105" y="371876"/>
                  <a:pt x="1220389" y="441654"/>
                </a:cubicBezTo>
                <a:cubicBezTo>
                  <a:pt x="1209674" y="505619"/>
                  <a:pt x="1234677" y="520156"/>
                  <a:pt x="1313258" y="505619"/>
                </a:cubicBezTo>
                <a:cubicBezTo>
                  <a:pt x="1434702" y="482359"/>
                  <a:pt x="1495424" y="517249"/>
                  <a:pt x="1463277" y="610287"/>
                </a:cubicBezTo>
                <a:cubicBezTo>
                  <a:pt x="1431130" y="697511"/>
                  <a:pt x="1477565" y="706233"/>
                  <a:pt x="1545430" y="682974"/>
                </a:cubicBezTo>
                <a:cubicBezTo>
                  <a:pt x="1645442" y="648084"/>
                  <a:pt x="1724024" y="685881"/>
                  <a:pt x="1809749" y="712048"/>
                </a:cubicBezTo>
                <a:cubicBezTo>
                  <a:pt x="1938336" y="752753"/>
                  <a:pt x="2002630" y="735308"/>
                  <a:pt x="2099071" y="650992"/>
                </a:cubicBezTo>
                <a:cubicBezTo>
                  <a:pt x="2152648" y="601565"/>
                  <a:pt x="2199083" y="552138"/>
                  <a:pt x="2245518" y="482359"/>
                </a:cubicBezTo>
                <a:cubicBezTo>
                  <a:pt x="2270521" y="642269"/>
                  <a:pt x="2356245" y="476544"/>
                  <a:pt x="2409824" y="531786"/>
                </a:cubicBezTo>
                <a:cubicBezTo>
                  <a:pt x="2431255" y="645176"/>
                  <a:pt x="2259804" y="735308"/>
                  <a:pt x="2309812" y="889403"/>
                </a:cubicBezTo>
                <a:cubicBezTo>
                  <a:pt x="2456258" y="703326"/>
                  <a:pt x="2502693" y="493989"/>
                  <a:pt x="2699146" y="357339"/>
                </a:cubicBezTo>
                <a:cubicBezTo>
                  <a:pt x="2742008" y="389321"/>
                  <a:pt x="2699146" y="421303"/>
                  <a:pt x="2717006" y="447469"/>
                </a:cubicBezTo>
                <a:cubicBezTo>
                  <a:pt x="2727721" y="447469"/>
                  <a:pt x="2659854" y="752753"/>
                  <a:pt x="2938461" y="770197"/>
                </a:cubicBezTo>
                <a:cubicBezTo>
                  <a:pt x="2938461" y="776012"/>
                  <a:pt x="2938461" y="781827"/>
                  <a:pt x="2949178" y="787642"/>
                </a:cubicBezTo>
                <a:cubicBezTo>
                  <a:pt x="2988467" y="819624"/>
                  <a:pt x="3081336" y="790550"/>
                  <a:pt x="3088480" y="842883"/>
                </a:cubicBezTo>
                <a:cubicBezTo>
                  <a:pt x="3095624" y="901033"/>
                  <a:pt x="3127771" y="956275"/>
                  <a:pt x="3109911" y="1017331"/>
                </a:cubicBezTo>
                <a:cubicBezTo>
                  <a:pt x="3095624" y="1063850"/>
                  <a:pt x="3077765" y="1113276"/>
                  <a:pt x="3077765" y="1162704"/>
                </a:cubicBezTo>
                <a:cubicBezTo>
                  <a:pt x="3077765" y="1215038"/>
                  <a:pt x="2956320" y="1287724"/>
                  <a:pt x="3117055" y="1319707"/>
                </a:cubicBezTo>
                <a:cubicBezTo>
                  <a:pt x="3124198" y="1319707"/>
                  <a:pt x="3106339" y="1409837"/>
                  <a:pt x="3099196" y="1459264"/>
                </a:cubicBezTo>
                <a:cubicBezTo>
                  <a:pt x="3092052" y="1499968"/>
                  <a:pt x="3059905" y="1549396"/>
                  <a:pt x="3124198" y="1578470"/>
                </a:cubicBezTo>
                <a:cubicBezTo>
                  <a:pt x="3163490" y="1593007"/>
                  <a:pt x="3234927" y="1523228"/>
                  <a:pt x="3242071" y="1462171"/>
                </a:cubicBezTo>
                <a:cubicBezTo>
                  <a:pt x="3249214" y="1406930"/>
                  <a:pt x="3256358" y="1351689"/>
                  <a:pt x="3242071" y="1299354"/>
                </a:cubicBezTo>
                <a:cubicBezTo>
                  <a:pt x="3224212" y="1235390"/>
                  <a:pt x="3252786" y="1200500"/>
                  <a:pt x="3317080" y="1183056"/>
                </a:cubicBezTo>
                <a:cubicBezTo>
                  <a:pt x="3384945" y="1162704"/>
                  <a:pt x="3420664" y="1124907"/>
                  <a:pt x="3452811" y="1072572"/>
                </a:cubicBezTo>
                <a:cubicBezTo>
                  <a:pt x="3531392" y="944644"/>
                  <a:pt x="3624261" y="822532"/>
                  <a:pt x="3670696" y="682973"/>
                </a:cubicBezTo>
                <a:cubicBezTo>
                  <a:pt x="3677840" y="656807"/>
                  <a:pt x="3692127" y="624825"/>
                  <a:pt x="3752849" y="613194"/>
                </a:cubicBezTo>
                <a:cubicBezTo>
                  <a:pt x="3659980" y="991164"/>
                  <a:pt x="3420664" y="1334243"/>
                  <a:pt x="3434952" y="1723843"/>
                </a:cubicBezTo>
                <a:cubicBezTo>
                  <a:pt x="3509961" y="1619174"/>
                  <a:pt x="3513533" y="1494154"/>
                  <a:pt x="3567111" y="1380763"/>
                </a:cubicBezTo>
                <a:cubicBezTo>
                  <a:pt x="3606402" y="1462171"/>
                  <a:pt x="3563540" y="1537765"/>
                  <a:pt x="3542109" y="1613360"/>
                </a:cubicBezTo>
                <a:cubicBezTo>
                  <a:pt x="3524249" y="1677323"/>
                  <a:pt x="3520677" y="1735472"/>
                  <a:pt x="3631405" y="1741287"/>
                </a:cubicBezTo>
                <a:cubicBezTo>
                  <a:pt x="3642121" y="1741287"/>
                  <a:pt x="3649265" y="1741287"/>
                  <a:pt x="3659980" y="1741287"/>
                </a:cubicBezTo>
                <a:cubicBezTo>
                  <a:pt x="3706414" y="1718028"/>
                  <a:pt x="3727846" y="1686046"/>
                  <a:pt x="3742133" y="1645341"/>
                </a:cubicBezTo>
                <a:cubicBezTo>
                  <a:pt x="3749277" y="1622082"/>
                  <a:pt x="3763564" y="1590100"/>
                  <a:pt x="3795712" y="1590100"/>
                </a:cubicBezTo>
                <a:cubicBezTo>
                  <a:pt x="3917155" y="1593007"/>
                  <a:pt x="3952874" y="1514506"/>
                  <a:pt x="3988593" y="1438912"/>
                </a:cubicBezTo>
                <a:cubicBezTo>
                  <a:pt x="4049315" y="1479616"/>
                  <a:pt x="4006452" y="1514506"/>
                  <a:pt x="4010024" y="1546488"/>
                </a:cubicBezTo>
                <a:cubicBezTo>
                  <a:pt x="4013596" y="1566840"/>
                  <a:pt x="4017167" y="1587192"/>
                  <a:pt x="4049315" y="1587192"/>
                </a:cubicBezTo>
                <a:cubicBezTo>
                  <a:pt x="4074317" y="1587192"/>
                  <a:pt x="4106465" y="1578470"/>
                  <a:pt x="4106465" y="1558118"/>
                </a:cubicBezTo>
                <a:cubicBezTo>
                  <a:pt x="4110036" y="1430190"/>
                  <a:pt x="4281487" y="1357503"/>
                  <a:pt x="4281487" y="1223760"/>
                </a:cubicBezTo>
                <a:cubicBezTo>
                  <a:pt x="4281487" y="1142351"/>
                  <a:pt x="4377927" y="1264465"/>
                  <a:pt x="4417219" y="1197593"/>
                </a:cubicBezTo>
                <a:cubicBezTo>
                  <a:pt x="4427935" y="1183056"/>
                  <a:pt x="4442220" y="1238297"/>
                  <a:pt x="4438649" y="1261557"/>
                </a:cubicBezTo>
                <a:cubicBezTo>
                  <a:pt x="4435078" y="1284817"/>
                  <a:pt x="4410074" y="1305169"/>
                  <a:pt x="4427935" y="1334243"/>
                </a:cubicBezTo>
                <a:cubicBezTo>
                  <a:pt x="4492228" y="1348781"/>
                  <a:pt x="4517230" y="1310983"/>
                  <a:pt x="4535090" y="1276094"/>
                </a:cubicBezTo>
                <a:cubicBezTo>
                  <a:pt x="4577952" y="1200500"/>
                  <a:pt x="4627958" y="1124907"/>
                  <a:pt x="4642246" y="1040590"/>
                </a:cubicBezTo>
                <a:cubicBezTo>
                  <a:pt x="4645817" y="1011516"/>
                  <a:pt x="4663677" y="994071"/>
                  <a:pt x="4699396" y="996979"/>
                </a:cubicBezTo>
                <a:cubicBezTo>
                  <a:pt x="4745832" y="1002793"/>
                  <a:pt x="4731544" y="1031868"/>
                  <a:pt x="4727971" y="1055128"/>
                </a:cubicBezTo>
                <a:cubicBezTo>
                  <a:pt x="4724399" y="1069665"/>
                  <a:pt x="4713683" y="1084202"/>
                  <a:pt x="4738688" y="1098740"/>
                </a:cubicBezTo>
                <a:cubicBezTo>
                  <a:pt x="4992291" y="758568"/>
                  <a:pt x="4978002" y="578305"/>
                  <a:pt x="5185172" y="197429"/>
                </a:cubicBezTo>
                <a:cubicBezTo>
                  <a:pt x="5224462" y="281744"/>
                  <a:pt x="5195887" y="342801"/>
                  <a:pt x="5188744" y="400950"/>
                </a:cubicBezTo>
                <a:cubicBezTo>
                  <a:pt x="5170883" y="546323"/>
                  <a:pt x="5138736" y="456192"/>
                  <a:pt x="5117306" y="601565"/>
                </a:cubicBezTo>
                <a:cubicBezTo>
                  <a:pt x="5106590" y="671344"/>
                  <a:pt x="5070871" y="735308"/>
                  <a:pt x="5128021" y="813809"/>
                </a:cubicBezTo>
                <a:cubicBezTo>
                  <a:pt x="5167312" y="866143"/>
                  <a:pt x="5124450" y="950459"/>
                  <a:pt x="5092302" y="1014423"/>
                </a:cubicBezTo>
                <a:cubicBezTo>
                  <a:pt x="5063727" y="1066758"/>
                  <a:pt x="5056585" y="1119092"/>
                  <a:pt x="5092302" y="1188871"/>
                </a:cubicBezTo>
                <a:cubicBezTo>
                  <a:pt x="5113734" y="1124907"/>
                  <a:pt x="5131592" y="1075480"/>
                  <a:pt x="5145880" y="1026053"/>
                </a:cubicBezTo>
                <a:cubicBezTo>
                  <a:pt x="5156596" y="985349"/>
                  <a:pt x="5181600" y="962089"/>
                  <a:pt x="5235177" y="964997"/>
                </a:cubicBezTo>
                <a:cubicBezTo>
                  <a:pt x="5263752" y="964997"/>
                  <a:pt x="5303044" y="956275"/>
                  <a:pt x="5317331" y="985349"/>
                </a:cubicBezTo>
                <a:cubicBezTo>
                  <a:pt x="5331618" y="1008608"/>
                  <a:pt x="5317331" y="1040590"/>
                  <a:pt x="5292327" y="1052221"/>
                </a:cubicBezTo>
                <a:cubicBezTo>
                  <a:pt x="5245894" y="1066758"/>
                  <a:pt x="5203031" y="1081295"/>
                  <a:pt x="5199458" y="1130722"/>
                </a:cubicBezTo>
                <a:cubicBezTo>
                  <a:pt x="5192315" y="1197593"/>
                  <a:pt x="5220889" y="1159796"/>
                  <a:pt x="5256608" y="1148166"/>
                </a:cubicBezTo>
                <a:cubicBezTo>
                  <a:pt x="5295899" y="1136536"/>
                  <a:pt x="5306616" y="1171426"/>
                  <a:pt x="5299471" y="1194686"/>
                </a:cubicBezTo>
                <a:cubicBezTo>
                  <a:pt x="5267324" y="1281909"/>
                  <a:pt x="5324474" y="1372040"/>
                  <a:pt x="5278039" y="1462171"/>
                </a:cubicBezTo>
                <a:cubicBezTo>
                  <a:pt x="5392339" y="1438912"/>
                  <a:pt x="5442347" y="1389485"/>
                  <a:pt x="5460205" y="1284817"/>
                </a:cubicBezTo>
                <a:cubicBezTo>
                  <a:pt x="5463777" y="1247020"/>
                  <a:pt x="5456634" y="1206315"/>
                  <a:pt x="5488780" y="1171426"/>
                </a:cubicBezTo>
                <a:cubicBezTo>
                  <a:pt x="5502175" y="1156162"/>
                  <a:pt x="5517579" y="1140898"/>
                  <a:pt x="5539513" y="1140353"/>
                </a:cubicBezTo>
                <a:lnTo>
                  <a:pt x="5552720" y="1143022"/>
                </a:lnTo>
                <a:lnTo>
                  <a:pt x="5574208" y="1115811"/>
                </a:lnTo>
                <a:cubicBezTo>
                  <a:pt x="5609034" y="1085646"/>
                  <a:pt x="5659040" y="1068202"/>
                  <a:pt x="5734050" y="1075470"/>
                </a:cubicBezTo>
                <a:cubicBezTo>
                  <a:pt x="5776912" y="1078377"/>
                  <a:pt x="5809058" y="1055118"/>
                  <a:pt x="5798343" y="1020228"/>
                </a:cubicBezTo>
                <a:cubicBezTo>
                  <a:pt x="5776912" y="953357"/>
                  <a:pt x="5837634" y="921375"/>
                  <a:pt x="5884068" y="883578"/>
                </a:cubicBezTo>
                <a:cubicBezTo>
                  <a:pt x="5966221" y="816706"/>
                  <a:pt x="6051947" y="752742"/>
                  <a:pt x="6066234" y="645166"/>
                </a:cubicBezTo>
                <a:cubicBezTo>
                  <a:pt x="6130528" y="665519"/>
                  <a:pt x="6123384" y="700408"/>
                  <a:pt x="6109096" y="732391"/>
                </a:cubicBezTo>
                <a:cubicBezTo>
                  <a:pt x="6073377" y="816706"/>
                  <a:pt x="6034087" y="901023"/>
                  <a:pt x="5998368" y="985338"/>
                </a:cubicBezTo>
                <a:cubicBezTo>
                  <a:pt x="5976937" y="1040581"/>
                  <a:pt x="5944790" y="1095822"/>
                  <a:pt x="5969793" y="1168509"/>
                </a:cubicBezTo>
                <a:cubicBezTo>
                  <a:pt x="6098380" y="1104545"/>
                  <a:pt x="6123384" y="996969"/>
                  <a:pt x="6162674" y="909745"/>
                </a:cubicBezTo>
                <a:cubicBezTo>
                  <a:pt x="6212681" y="802169"/>
                  <a:pt x="6305549" y="738205"/>
                  <a:pt x="6412705" y="659704"/>
                </a:cubicBezTo>
                <a:cubicBezTo>
                  <a:pt x="6441280" y="738205"/>
                  <a:pt x="6362699" y="787632"/>
                  <a:pt x="6366271" y="851596"/>
                </a:cubicBezTo>
                <a:cubicBezTo>
                  <a:pt x="6376987" y="854503"/>
                  <a:pt x="6398418" y="860319"/>
                  <a:pt x="6398418" y="860319"/>
                </a:cubicBezTo>
                <a:cubicBezTo>
                  <a:pt x="6455568" y="755650"/>
                  <a:pt x="6562724" y="709131"/>
                  <a:pt x="6694884" y="691686"/>
                </a:cubicBezTo>
                <a:cubicBezTo>
                  <a:pt x="6762750" y="685871"/>
                  <a:pt x="6784181" y="648074"/>
                  <a:pt x="6816327" y="610277"/>
                </a:cubicBezTo>
                <a:cubicBezTo>
                  <a:pt x="6927056" y="482349"/>
                  <a:pt x="7027068" y="345699"/>
                  <a:pt x="7177087" y="238123"/>
                </a:cubicBezTo>
                <a:cubicBezTo>
                  <a:pt x="7159228" y="363144"/>
                  <a:pt x="7059215" y="461997"/>
                  <a:pt x="7016353" y="592833"/>
                </a:cubicBezTo>
                <a:cubicBezTo>
                  <a:pt x="7180659" y="488164"/>
                  <a:pt x="7266384" y="351513"/>
                  <a:pt x="7366396" y="226493"/>
                </a:cubicBezTo>
                <a:cubicBezTo>
                  <a:pt x="7412830" y="168344"/>
                  <a:pt x="7469981" y="116010"/>
                  <a:pt x="7494984" y="49138"/>
                </a:cubicBezTo>
                <a:cubicBezTo>
                  <a:pt x="7500342" y="31693"/>
                  <a:pt x="7511727" y="4436"/>
                  <a:pt x="7538181" y="484"/>
                </a:cubicBezTo>
                <a:close/>
              </a:path>
            </a:pathLst>
          </a:custGeom>
          <a:solidFill>
            <a:schemeClr val="accent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D1FABB22-1B8F-0143-BE28-20FD93E07B06}"/>
              </a:ext>
            </a:extLst>
          </p:cNvPr>
          <p:cNvSpPr>
            <a:spLocks noGrp="1"/>
          </p:cNvSpPr>
          <p:nvPr>
            <p:ph type="title"/>
          </p:nvPr>
        </p:nvSpPr>
        <p:spPr>
          <a:xfrm>
            <a:off x="838200" y="365125"/>
            <a:ext cx="10515600" cy="1325563"/>
          </a:xfrm>
        </p:spPr>
        <p:txBody>
          <a:bodyPr>
            <a:normAutofit/>
          </a:bodyPr>
          <a:lstStyle/>
          <a:p>
            <a:r>
              <a:rPr lang="en-US" dirty="0"/>
              <a:t>Respect</a:t>
            </a:r>
          </a:p>
        </p:txBody>
      </p:sp>
      <p:graphicFrame>
        <p:nvGraphicFramePr>
          <p:cNvPr id="5" name="Content Placeholder 2">
            <a:extLst>
              <a:ext uri="{FF2B5EF4-FFF2-40B4-BE49-F238E27FC236}">
                <a16:creationId xmlns:a16="http://schemas.microsoft.com/office/drawing/2014/main" id="{F84A338B-1153-6584-F82E-455B9567A097}"/>
              </a:ext>
            </a:extLst>
          </p:cNvPr>
          <p:cNvGraphicFramePr>
            <a:graphicFrameLocks noGrp="1"/>
          </p:cNvGraphicFramePr>
          <p:nvPr>
            <p:ph idx="1"/>
            <p:extLst>
              <p:ext uri="{D42A27DB-BD31-4B8C-83A1-F6EECF244321}">
                <p14:modId xmlns:p14="http://schemas.microsoft.com/office/powerpoint/2010/main" val="2938717475"/>
              </p:ext>
            </p:extLst>
          </p:nvPr>
        </p:nvGraphicFramePr>
        <p:xfrm>
          <a:off x="838200" y="2011363"/>
          <a:ext cx="10515600" cy="416083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09156478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DA8886A6-5426-494B-96D8-D962D2BA08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Freeform: Shape 10">
            <a:extLst>
              <a:ext uri="{FF2B5EF4-FFF2-40B4-BE49-F238E27FC236}">
                <a16:creationId xmlns:a16="http://schemas.microsoft.com/office/drawing/2014/main" id="{AA3ED336-C09E-46E8-9774-B977D15FC5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752347"/>
            <a:ext cx="12191999" cy="6105653"/>
          </a:xfrm>
          <a:custGeom>
            <a:avLst/>
            <a:gdLst>
              <a:gd name="connsiteX0" fmla="*/ 7538181 w 12191999"/>
              <a:gd name="connsiteY0" fmla="*/ 484 h 6105653"/>
              <a:gd name="connsiteX1" fmla="*/ 7569993 w 12191999"/>
              <a:gd name="connsiteY1" fmla="*/ 5527 h 6105653"/>
              <a:gd name="connsiteX2" fmla="*/ 7587853 w 12191999"/>
              <a:gd name="connsiteY2" fmla="*/ 84028 h 6105653"/>
              <a:gd name="connsiteX3" fmla="*/ 7559278 w 12191999"/>
              <a:gd name="connsiteY3" fmla="*/ 325347 h 6105653"/>
              <a:gd name="connsiteX4" fmla="*/ 7795021 w 12191999"/>
              <a:gd name="connsiteY4" fmla="*/ 25878 h 6105653"/>
              <a:gd name="connsiteX5" fmla="*/ 7759302 w 12191999"/>
              <a:gd name="connsiteY5" fmla="*/ 249752 h 6105653"/>
              <a:gd name="connsiteX6" fmla="*/ 7852171 w 12191999"/>
              <a:gd name="connsiteY6" fmla="*/ 313717 h 6105653"/>
              <a:gd name="connsiteX7" fmla="*/ 8002190 w 12191999"/>
              <a:gd name="connsiteY7" fmla="*/ 418385 h 6105653"/>
              <a:gd name="connsiteX8" fmla="*/ 8084343 w 12191999"/>
              <a:gd name="connsiteY8" fmla="*/ 491072 h 6105653"/>
              <a:gd name="connsiteX9" fmla="*/ 8348662 w 12191999"/>
              <a:gd name="connsiteY9" fmla="*/ 520146 h 6105653"/>
              <a:gd name="connsiteX10" fmla="*/ 8637984 w 12191999"/>
              <a:gd name="connsiteY10" fmla="*/ 459090 h 6105653"/>
              <a:gd name="connsiteX11" fmla="*/ 8784431 w 12191999"/>
              <a:gd name="connsiteY11" fmla="*/ 290457 h 6105653"/>
              <a:gd name="connsiteX12" fmla="*/ 8948737 w 12191999"/>
              <a:gd name="connsiteY12" fmla="*/ 339884 h 6105653"/>
              <a:gd name="connsiteX13" fmla="*/ 8848725 w 12191999"/>
              <a:gd name="connsiteY13" fmla="*/ 697501 h 6105653"/>
              <a:gd name="connsiteX14" fmla="*/ 9238059 w 12191999"/>
              <a:gd name="connsiteY14" fmla="*/ 165437 h 6105653"/>
              <a:gd name="connsiteX15" fmla="*/ 9255919 w 12191999"/>
              <a:gd name="connsiteY15" fmla="*/ 255567 h 6105653"/>
              <a:gd name="connsiteX16" fmla="*/ 9477374 w 12191999"/>
              <a:gd name="connsiteY16" fmla="*/ 578295 h 6105653"/>
              <a:gd name="connsiteX17" fmla="*/ 9488091 w 12191999"/>
              <a:gd name="connsiteY17" fmla="*/ 595740 h 6105653"/>
              <a:gd name="connsiteX18" fmla="*/ 9627393 w 12191999"/>
              <a:gd name="connsiteY18" fmla="*/ 650981 h 6105653"/>
              <a:gd name="connsiteX19" fmla="*/ 9648824 w 12191999"/>
              <a:gd name="connsiteY19" fmla="*/ 825429 h 6105653"/>
              <a:gd name="connsiteX20" fmla="*/ 9616678 w 12191999"/>
              <a:gd name="connsiteY20" fmla="*/ 970802 h 6105653"/>
              <a:gd name="connsiteX21" fmla="*/ 9655968 w 12191999"/>
              <a:gd name="connsiteY21" fmla="*/ 1127805 h 6105653"/>
              <a:gd name="connsiteX22" fmla="*/ 9638109 w 12191999"/>
              <a:gd name="connsiteY22" fmla="*/ 1267362 h 6105653"/>
              <a:gd name="connsiteX23" fmla="*/ 9663111 w 12191999"/>
              <a:gd name="connsiteY23" fmla="*/ 1386568 h 6105653"/>
              <a:gd name="connsiteX24" fmla="*/ 9780984 w 12191999"/>
              <a:gd name="connsiteY24" fmla="*/ 1270269 h 6105653"/>
              <a:gd name="connsiteX25" fmla="*/ 9780984 w 12191999"/>
              <a:gd name="connsiteY25" fmla="*/ 1107452 h 6105653"/>
              <a:gd name="connsiteX26" fmla="*/ 9855993 w 12191999"/>
              <a:gd name="connsiteY26" fmla="*/ 991154 h 6105653"/>
              <a:gd name="connsiteX27" fmla="*/ 9991724 w 12191999"/>
              <a:gd name="connsiteY27" fmla="*/ 880670 h 6105653"/>
              <a:gd name="connsiteX28" fmla="*/ 10209609 w 12191999"/>
              <a:gd name="connsiteY28" fmla="*/ 491071 h 6105653"/>
              <a:gd name="connsiteX29" fmla="*/ 10291762 w 12191999"/>
              <a:gd name="connsiteY29" fmla="*/ 421292 h 6105653"/>
              <a:gd name="connsiteX30" fmla="*/ 9973865 w 12191999"/>
              <a:gd name="connsiteY30" fmla="*/ 1531941 h 6105653"/>
              <a:gd name="connsiteX31" fmla="*/ 10106024 w 12191999"/>
              <a:gd name="connsiteY31" fmla="*/ 1188861 h 6105653"/>
              <a:gd name="connsiteX32" fmla="*/ 10081022 w 12191999"/>
              <a:gd name="connsiteY32" fmla="*/ 1421458 h 6105653"/>
              <a:gd name="connsiteX33" fmla="*/ 10170318 w 12191999"/>
              <a:gd name="connsiteY33" fmla="*/ 1549385 h 6105653"/>
              <a:gd name="connsiteX34" fmla="*/ 10198893 w 12191999"/>
              <a:gd name="connsiteY34" fmla="*/ 1549385 h 6105653"/>
              <a:gd name="connsiteX35" fmla="*/ 10281046 w 12191999"/>
              <a:gd name="connsiteY35" fmla="*/ 1453439 h 6105653"/>
              <a:gd name="connsiteX36" fmla="*/ 10334625 w 12191999"/>
              <a:gd name="connsiteY36" fmla="*/ 1398198 h 6105653"/>
              <a:gd name="connsiteX37" fmla="*/ 10527506 w 12191999"/>
              <a:gd name="connsiteY37" fmla="*/ 1247010 h 6105653"/>
              <a:gd name="connsiteX38" fmla="*/ 10548937 w 12191999"/>
              <a:gd name="connsiteY38" fmla="*/ 1354586 h 6105653"/>
              <a:gd name="connsiteX39" fmla="*/ 10588228 w 12191999"/>
              <a:gd name="connsiteY39" fmla="*/ 1395290 h 6105653"/>
              <a:gd name="connsiteX40" fmla="*/ 10645378 w 12191999"/>
              <a:gd name="connsiteY40" fmla="*/ 1366216 h 6105653"/>
              <a:gd name="connsiteX41" fmla="*/ 10820400 w 12191999"/>
              <a:gd name="connsiteY41" fmla="*/ 1031858 h 6105653"/>
              <a:gd name="connsiteX42" fmla="*/ 10956131 w 12191999"/>
              <a:gd name="connsiteY42" fmla="*/ 1005691 h 6105653"/>
              <a:gd name="connsiteX43" fmla="*/ 10977562 w 12191999"/>
              <a:gd name="connsiteY43" fmla="*/ 1069655 h 6105653"/>
              <a:gd name="connsiteX44" fmla="*/ 10966847 w 12191999"/>
              <a:gd name="connsiteY44" fmla="*/ 1142341 h 6105653"/>
              <a:gd name="connsiteX45" fmla="*/ 11074003 w 12191999"/>
              <a:gd name="connsiteY45" fmla="*/ 1084192 h 6105653"/>
              <a:gd name="connsiteX46" fmla="*/ 11181159 w 12191999"/>
              <a:gd name="connsiteY46" fmla="*/ 848688 h 6105653"/>
              <a:gd name="connsiteX47" fmla="*/ 11238309 w 12191999"/>
              <a:gd name="connsiteY47" fmla="*/ 805077 h 6105653"/>
              <a:gd name="connsiteX48" fmla="*/ 11266884 w 12191999"/>
              <a:gd name="connsiteY48" fmla="*/ 863226 h 6105653"/>
              <a:gd name="connsiteX49" fmla="*/ 11277600 w 12191999"/>
              <a:gd name="connsiteY49" fmla="*/ 906838 h 6105653"/>
              <a:gd name="connsiteX50" fmla="*/ 11724084 w 12191999"/>
              <a:gd name="connsiteY50" fmla="*/ 5527 h 6105653"/>
              <a:gd name="connsiteX51" fmla="*/ 11727656 w 12191999"/>
              <a:gd name="connsiteY51" fmla="*/ 209048 h 6105653"/>
              <a:gd name="connsiteX52" fmla="*/ 11656218 w 12191999"/>
              <a:gd name="connsiteY52" fmla="*/ 409663 h 6105653"/>
              <a:gd name="connsiteX53" fmla="*/ 11666934 w 12191999"/>
              <a:gd name="connsiteY53" fmla="*/ 621907 h 6105653"/>
              <a:gd name="connsiteX54" fmla="*/ 11631215 w 12191999"/>
              <a:gd name="connsiteY54" fmla="*/ 822521 h 6105653"/>
              <a:gd name="connsiteX55" fmla="*/ 11631215 w 12191999"/>
              <a:gd name="connsiteY55" fmla="*/ 996969 h 6105653"/>
              <a:gd name="connsiteX56" fmla="*/ 11684793 w 12191999"/>
              <a:gd name="connsiteY56" fmla="*/ 834151 h 6105653"/>
              <a:gd name="connsiteX57" fmla="*/ 11774090 w 12191999"/>
              <a:gd name="connsiteY57" fmla="*/ 773095 h 6105653"/>
              <a:gd name="connsiteX58" fmla="*/ 11856243 w 12191999"/>
              <a:gd name="connsiteY58" fmla="*/ 793447 h 6105653"/>
              <a:gd name="connsiteX59" fmla="*/ 11831240 w 12191999"/>
              <a:gd name="connsiteY59" fmla="*/ 860319 h 6105653"/>
              <a:gd name="connsiteX60" fmla="*/ 11738371 w 12191999"/>
              <a:gd name="connsiteY60" fmla="*/ 938820 h 6105653"/>
              <a:gd name="connsiteX61" fmla="*/ 11795521 w 12191999"/>
              <a:gd name="connsiteY61" fmla="*/ 956264 h 6105653"/>
              <a:gd name="connsiteX62" fmla="*/ 11838384 w 12191999"/>
              <a:gd name="connsiteY62" fmla="*/ 1002784 h 6105653"/>
              <a:gd name="connsiteX63" fmla="*/ 11816952 w 12191999"/>
              <a:gd name="connsiteY63" fmla="*/ 1270269 h 6105653"/>
              <a:gd name="connsiteX64" fmla="*/ 11999118 w 12191999"/>
              <a:gd name="connsiteY64" fmla="*/ 1092915 h 6105653"/>
              <a:gd name="connsiteX65" fmla="*/ 12027693 w 12191999"/>
              <a:gd name="connsiteY65" fmla="*/ 979524 h 6105653"/>
              <a:gd name="connsiteX66" fmla="*/ 12102703 w 12191999"/>
              <a:gd name="connsiteY66" fmla="*/ 953357 h 6105653"/>
              <a:gd name="connsiteX67" fmla="*/ 12120562 w 12191999"/>
              <a:gd name="connsiteY67" fmla="*/ 1005691 h 6105653"/>
              <a:gd name="connsiteX68" fmla="*/ 12056268 w 12191999"/>
              <a:gd name="connsiteY68" fmla="*/ 1267362 h 6105653"/>
              <a:gd name="connsiteX69" fmla="*/ 12081272 w 12191999"/>
              <a:gd name="connsiteY69" fmla="*/ 1310974 h 6105653"/>
              <a:gd name="connsiteX70" fmla="*/ 12191999 w 12191999"/>
              <a:gd name="connsiteY70" fmla="*/ 1008598 h 6105653"/>
              <a:gd name="connsiteX71" fmla="*/ 12191999 w 12191999"/>
              <a:gd name="connsiteY71" fmla="*/ 6105653 h 6105653"/>
              <a:gd name="connsiteX72" fmla="*/ 0 w 12191999"/>
              <a:gd name="connsiteY72" fmla="*/ 6105653 h 6105653"/>
              <a:gd name="connsiteX73" fmla="*/ 0 w 12191999"/>
              <a:gd name="connsiteY73" fmla="*/ 927116 h 6105653"/>
              <a:gd name="connsiteX74" fmla="*/ 61930 w 12191999"/>
              <a:gd name="connsiteY74" fmla="*/ 902578 h 6105653"/>
              <a:gd name="connsiteX75" fmla="*/ 155971 w 12191999"/>
              <a:gd name="connsiteY75" fmla="*/ 883588 h 6105653"/>
              <a:gd name="connsiteX76" fmla="*/ 277414 w 12191999"/>
              <a:gd name="connsiteY76" fmla="*/ 802179 h 6105653"/>
              <a:gd name="connsiteX77" fmla="*/ 638174 w 12191999"/>
              <a:gd name="connsiteY77" fmla="*/ 430025 h 6105653"/>
              <a:gd name="connsiteX78" fmla="*/ 477440 w 12191999"/>
              <a:gd name="connsiteY78" fmla="*/ 784735 h 6105653"/>
              <a:gd name="connsiteX79" fmla="*/ 827483 w 12191999"/>
              <a:gd name="connsiteY79" fmla="*/ 418395 h 6105653"/>
              <a:gd name="connsiteX80" fmla="*/ 956071 w 12191999"/>
              <a:gd name="connsiteY80" fmla="*/ 241040 h 6105653"/>
              <a:gd name="connsiteX81" fmla="*/ 999268 w 12191999"/>
              <a:gd name="connsiteY81" fmla="*/ 192386 h 6105653"/>
              <a:gd name="connsiteX82" fmla="*/ 1031080 w 12191999"/>
              <a:gd name="connsiteY82" fmla="*/ 197429 h 6105653"/>
              <a:gd name="connsiteX83" fmla="*/ 1048940 w 12191999"/>
              <a:gd name="connsiteY83" fmla="*/ 275930 h 6105653"/>
              <a:gd name="connsiteX84" fmla="*/ 1020365 w 12191999"/>
              <a:gd name="connsiteY84" fmla="*/ 517249 h 6105653"/>
              <a:gd name="connsiteX85" fmla="*/ 1256108 w 12191999"/>
              <a:gd name="connsiteY85" fmla="*/ 217780 h 6105653"/>
              <a:gd name="connsiteX86" fmla="*/ 1220389 w 12191999"/>
              <a:gd name="connsiteY86" fmla="*/ 441654 h 6105653"/>
              <a:gd name="connsiteX87" fmla="*/ 1313258 w 12191999"/>
              <a:gd name="connsiteY87" fmla="*/ 505619 h 6105653"/>
              <a:gd name="connsiteX88" fmla="*/ 1463277 w 12191999"/>
              <a:gd name="connsiteY88" fmla="*/ 610287 h 6105653"/>
              <a:gd name="connsiteX89" fmla="*/ 1545430 w 12191999"/>
              <a:gd name="connsiteY89" fmla="*/ 682974 h 6105653"/>
              <a:gd name="connsiteX90" fmla="*/ 1809749 w 12191999"/>
              <a:gd name="connsiteY90" fmla="*/ 712048 h 6105653"/>
              <a:gd name="connsiteX91" fmla="*/ 2099071 w 12191999"/>
              <a:gd name="connsiteY91" fmla="*/ 650992 h 6105653"/>
              <a:gd name="connsiteX92" fmla="*/ 2245518 w 12191999"/>
              <a:gd name="connsiteY92" fmla="*/ 482359 h 6105653"/>
              <a:gd name="connsiteX93" fmla="*/ 2409824 w 12191999"/>
              <a:gd name="connsiteY93" fmla="*/ 531786 h 6105653"/>
              <a:gd name="connsiteX94" fmla="*/ 2309812 w 12191999"/>
              <a:gd name="connsiteY94" fmla="*/ 889403 h 6105653"/>
              <a:gd name="connsiteX95" fmla="*/ 2699146 w 12191999"/>
              <a:gd name="connsiteY95" fmla="*/ 357339 h 6105653"/>
              <a:gd name="connsiteX96" fmla="*/ 2717006 w 12191999"/>
              <a:gd name="connsiteY96" fmla="*/ 447469 h 6105653"/>
              <a:gd name="connsiteX97" fmla="*/ 2938461 w 12191999"/>
              <a:gd name="connsiteY97" fmla="*/ 770197 h 6105653"/>
              <a:gd name="connsiteX98" fmla="*/ 2949178 w 12191999"/>
              <a:gd name="connsiteY98" fmla="*/ 787642 h 6105653"/>
              <a:gd name="connsiteX99" fmla="*/ 3088480 w 12191999"/>
              <a:gd name="connsiteY99" fmla="*/ 842883 h 6105653"/>
              <a:gd name="connsiteX100" fmla="*/ 3109911 w 12191999"/>
              <a:gd name="connsiteY100" fmla="*/ 1017331 h 6105653"/>
              <a:gd name="connsiteX101" fmla="*/ 3077765 w 12191999"/>
              <a:gd name="connsiteY101" fmla="*/ 1162704 h 6105653"/>
              <a:gd name="connsiteX102" fmla="*/ 3117055 w 12191999"/>
              <a:gd name="connsiteY102" fmla="*/ 1319707 h 6105653"/>
              <a:gd name="connsiteX103" fmla="*/ 3099196 w 12191999"/>
              <a:gd name="connsiteY103" fmla="*/ 1459264 h 6105653"/>
              <a:gd name="connsiteX104" fmla="*/ 3124198 w 12191999"/>
              <a:gd name="connsiteY104" fmla="*/ 1578470 h 6105653"/>
              <a:gd name="connsiteX105" fmla="*/ 3242071 w 12191999"/>
              <a:gd name="connsiteY105" fmla="*/ 1462171 h 6105653"/>
              <a:gd name="connsiteX106" fmla="*/ 3242071 w 12191999"/>
              <a:gd name="connsiteY106" fmla="*/ 1299354 h 6105653"/>
              <a:gd name="connsiteX107" fmla="*/ 3317080 w 12191999"/>
              <a:gd name="connsiteY107" fmla="*/ 1183056 h 6105653"/>
              <a:gd name="connsiteX108" fmla="*/ 3452811 w 12191999"/>
              <a:gd name="connsiteY108" fmla="*/ 1072572 h 6105653"/>
              <a:gd name="connsiteX109" fmla="*/ 3670696 w 12191999"/>
              <a:gd name="connsiteY109" fmla="*/ 682973 h 6105653"/>
              <a:gd name="connsiteX110" fmla="*/ 3752849 w 12191999"/>
              <a:gd name="connsiteY110" fmla="*/ 613194 h 6105653"/>
              <a:gd name="connsiteX111" fmla="*/ 3434952 w 12191999"/>
              <a:gd name="connsiteY111" fmla="*/ 1723843 h 6105653"/>
              <a:gd name="connsiteX112" fmla="*/ 3567111 w 12191999"/>
              <a:gd name="connsiteY112" fmla="*/ 1380763 h 6105653"/>
              <a:gd name="connsiteX113" fmla="*/ 3542109 w 12191999"/>
              <a:gd name="connsiteY113" fmla="*/ 1613360 h 6105653"/>
              <a:gd name="connsiteX114" fmla="*/ 3631405 w 12191999"/>
              <a:gd name="connsiteY114" fmla="*/ 1741287 h 6105653"/>
              <a:gd name="connsiteX115" fmla="*/ 3659980 w 12191999"/>
              <a:gd name="connsiteY115" fmla="*/ 1741287 h 6105653"/>
              <a:gd name="connsiteX116" fmla="*/ 3742133 w 12191999"/>
              <a:gd name="connsiteY116" fmla="*/ 1645341 h 6105653"/>
              <a:gd name="connsiteX117" fmla="*/ 3795712 w 12191999"/>
              <a:gd name="connsiteY117" fmla="*/ 1590100 h 6105653"/>
              <a:gd name="connsiteX118" fmla="*/ 3988593 w 12191999"/>
              <a:gd name="connsiteY118" fmla="*/ 1438912 h 6105653"/>
              <a:gd name="connsiteX119" fmla="*/ 4010024 w 12191999"/>
              <a:gd name="connsiteY119" fmla="*/ 1546488 h 6105653"/>
              <a:gd name="connsiteX120" fmla="*/ 4049315 w 12191999"/>
              <a:gd name="connsiteY120" fmla="*/ 1587192 h 6105653"/>
              <a:gd name="connsiteX121" fmla="*/ 4106465 w 12191999"/>
              <a:gd name="connsiteY121" fmla="*/ 1558118 h 6105653"/>
              <a:gd name="connsiteX122" fmla="*/ 4281487 w 12191999"/>
              <a:gd name="connsiteY122" fmla="*/ 1223760 h 6105653"/>
              <a:gd name="connsiteX123" fmla="*/ 4417219 w 12191999"/>
              <a:gd name="connsiteY123" fmla="*/ 1197593 h 6105653"/>
              <a:gd name="connsiteX124" fmla="*/ 4438649 w 12191999"/>
              <a:gd name="connsiteY124" fmla="*/ 1261557 h 6105653"/>
              <a:gd name="connsiteX125" fmla="*/ 4427935 w 12191999"/>
              <a:gd name="connsiteY125" fmla="*/ 1334243 h 6105653"/>
              <a:gd name="connsiteX126" fmla="*/ 4535090 w 12191999"/>
              <a:gd name="connsiteY126" fmla="*/ 1276094 h 6105653"/>
              <a:gd name="connsiteX127" fmla="*/ 4642246 w 12191999"/>
              <a:gd name="connsiteY127" fmla="*/ 1040590 h 6105653"/>
              <a:gd name="connsiteX128" fmla="*/ 4699396 w 12191999"/>
              <a:gd name="connsiteY128" fmla="*/ 996979 h 6105653"/>
              <a:gd name="connsiteX129" fmla="*/ 4727971 w 12191999"/>
              <a:gd name="connsiteY129" fmla="*/ 1055128 h 6105653"/>
              <a:gd name="connsiteX130" fmla="*/ 4738688 w 12191999"/>
              <a:gd name="connsiteY130" fmla="*/ 1098740 h 6105653"/>
              <a:gd name="connsiteX131" fmla="*/ 5185172 w 12191999"/>
              <a:gd name="connsiteY131" fmla="*/ 197429 h 6105653"/>
              <a:gd name="connsiteX132" fmla="*/ 5188744 w 12191999"/>
              <a:gd name="connsiteY132" fmla="*/ 400950 h 6105653"/>
              <a:gd name="connsiteX133" fmla="*/ 5117306 w 12191999"/>
              <a:gd name="connsiteY133" fmla="*/ 601565 h 6105653"/>
              <a:gd name="connsiteX134" fmla="*/ 5128021 w 12191999"/>
              <a:gd name="connsiteY134" fmla="*/ 813809 h 6105653"/>
              <a:gd name="connsiteX135" fmla="*/ 5092302 w 12191999"/>
              <a:gd name="connsiteY135" fmla="*/ 1014423 h 6105653"/>
              <a:gd name="connsiteX136" fmla="*/ 5092302 w 12191999"/>
              <a:gd name="connsiteY136" fmla="*/ 1188871 h 6105653"/>
              <a:gd name="connsiteX137" fmla="*/ 5145880 w 12191999"/>
              <a:gd name="connsiteY137" fmla="*/ 1026053 h 6105653"/>
              <a:gd name="connsiteX138" fmla="*/ 5235177 w 12191999"/>
              <a:gd name="connsiteY138" fmla="*/ 964997 h 6105653"/>
              <a:gd name="connsiteX139" fmla="*/ 5317331 w 12191999"/>
              <a:gd name="connsiteY139" fmla="*/ 985349 h 6105653"/>
              <a:gd name="connsiteX140" fmla="*/ 5292327 w 12191999"/>
              <a:gd name="connsiteY140" fmla="*/ 1052221 h 6105653"/>
              <a:gd name="connsiteX141" fmla="*/ 5199458 w 12191999"/>
              <a:gd name="connsiteY141" fmla="*/ 1130722 h 6105653"/>
              <a:gd name="connsiteX142" fmla="*/ 5256608 w 12191999"/>
              <a:gd name="connsiteY142" fmla="*/ 1148166 h 6105653"/>
              <a:gd name="connsiteX143" fmla="*/ 5299471 w 12191999"/>
              <a:gd name="connsiteY143" fmla="*/ 1194686 h 6105653"/>
              <a:gd name="connsiteX144" fmla="*/ 5278039 w 12191999"/>
              <a:gd name="connsiteY144" fmla="*/ 1462171 h 6105653"/>
              <a:gd name="connsiteX145" fmla="*/ 5460205 w 12191999"/>
              <a:gd name="connsiteY145" fmla="*/ 1284817 h 6105653"/>
              <a:gd name="connsiteX146" fmla="*/ 5488780 w 12191999"/>
              <a:gd name="connsiteY146" fmla="*/ 1171426 h 6105653"/>
              <a:gd name="connsiteX147" fmla="*/ 5539513 w 12191999"/>
              <a:gd name="connsiteY147" fmla="*/ 1140353 h 6105653"/>
              <a:gd name="connsiteX148" fmla="*/ 5552720 w 12191999"/>
              <a:gd name="connsiteY148" fmla="*/ 1143022 h 6105653"/>
              <a:gd name="connsiteX149" fmla="*/ 5574208 w 12191999"/>
              <a:gd name="connsiteY149" fmla="*/ 1115811 h 6105653"/>
              <a:gd name="connsiteX150" fmla="*/ 5734050 w 12191999"/>
              <a:gd name="connsiteY150" fmla="*/ 1075470 h 6105653"/>
              <a:gd name="connsiteX151" fmla="*/ 5798343 w 12191999"/>
              <a:gd name="connsiteY151" fmla="*/ 1020228 h 6105653"/>
              <a:gd name="connsiteX152" fmla="*/ 5884068 w 12191999"/>
              <a:gd name="connsiteY152" fmla="*/ 883578 h 6105653"/>
              <a:gd name="connsiteX153" fmla="*/ 6066234 w 12191999"/>
              <a:gd name="connsiteY153" fmla="*/ 645166 h 6105653"/>
              <a:gd name="connsiteX154" fmla="*/ 6109096 w 12191999"/>
              <a:gd name="connsiteY154" fmla="*/ 732391 h 6105653"/>
              <a:gd name="connsiteX155" fmla="*/ 5998368 w 12191999"/>
              <a:gd name="connsiteY155" fmla="*/ 985338 h 6105653"/>
              <a:gd name="connsiteX156" fmla="*/ 5969793 w 12191999"/>
              <a:gd name="connsiteY156" fmla="*/ 1168509 h 6105653"/>
              <a:gd name="connsiteX157" fmla="*/ 6162674 w 12191999"/>
              <a:gd name="connsiteY157" fmla="*/ 909745 h 6105653"/>
              <a:gd name="connsiteX158" fmla="*/ 6412705 w 12191999"/>
              <a:gd name="connsiteY158" fmla="*/ 659704 h 6105653"/>
              <a:gd name="connsiteX159" fmla="*/ 6366271 w 12191999"/>
              <a:gd name="connsiteY159" fmla="*/ 851596 h 6105653"/>
              <a:gd name="connsiteX160" fmla="*/ 6398418 w 12191999"/>
              <a:gd name="connsiteY160" fmla="*/ 860319 h 6105653"/>
              <a:gd name="connsiteX161" fmla="*/ 6694884 w 12191999"/>
              <a:gd name="connsiteY161" fmla="*/ 691686 h 6105653"/>
              <a:gd name="connsiteX162" fmla="*/ 6816327 w 12191999"/>
              <a:gd name="connsiteY162" fmla="*/ 610277 h 6105653"/>
              <a:gd name="connsiteX163" fmla="*/ 7177087 w 12191999"/>
              <a:gd name="connsiteY163" fmla="*/ 238123 h 6105653"/>
              <a:gd name="connsiteX164" fmla="*/ 7016353 w 12191999"/>
              <a:gd name="connsiteY164" fmla="*/ 592833 h 6105653"/>
              <a:gd name="connsiteX165" fmla="*/ 7366396 w 12191999"/>
              <a:gd name="connsiteY165" fmla="*/ 226493 h 6105653"/>
              <a:gd name="connsiteX166" fmla="*/ 7494984 w 12191999"/>
              <a:gd name="connsiteY166" fmla="*/ 49138 h 6105653"/>
              <a:gd name="connsiteX167" fmla="*/ 7538181 w 12191999"/>
              <a:gd name="connsiteY167" fmla="*/ 484 h 610565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Lst>
            <a:rect l="l" t="t" r="r" b="b"/>
            <a:pathLst>
              <a:path w="12191999" h="6105653">
                <a:moveTo>
                  <a:pt x="7538181" y="484"/>
                </a:moveTo>
                <a:cubicBezTo>
                  <a:pt x="7546999" y="-833"/>
                  <a:pt x="7557492" y="439"/>
                  <a:pt x="7569993" y="5527"/>
                </a:cubicBezTo>
                <a:cubicBezTo>
                  <a:pt x="7612855" y="22971"/>
                  <a:pt x="7598567" y="54953"/>
                  <a:pt x="7587853" y="84028"/>
                </a:cubicBezTo>
                <a:cubicBezTo>
                  <a:pt x="7559278" y="153806"/>
                  <a:pt x="7559278" y="229401"/>
                  <a:pt x="7559278" y="325347"/>
                </a:cubicBezTo>
                <a:cubicBezTo>
                  <a:pt x="7695009" y="243938"/>
                  <a:pt x="7652146" y="95658"/>
                  <a:pt x="7795021" y="25878"/>
                </a:cubicBezTo>
                <a:cubicBezTo>
                  <a:pt x="7820024" y="113102"/>
                  <a:pt x="7770018" y="179974"/>
                  <a:pt x="7759302" y="249752"/>
                </a:cubicBezTo>
                <a:cubicBezTo>
                  <a:pt x="7748587" y="313717"/>
                  <a:pt x="7773590" y="328254"/>
                  <a:pt x="7852171" y="313717"/>
                </a:cubicBezTo>
                <a:cubicBezTo>
                  <a:pt x="7973615" y="290457"/>
                  <a:pt x="8034337" y="325347"/>
                  <a:pt x="8002190" y="418385"/>
                </a:cubicBezTo>
                <a:cubicBezTo>
                  <a:pt x="7970043" y="505609"/>
                  <a:pt x="8016478" y="514331"/>
                  <a:pt x="8084343" y="491072"/>
                </a:cubicBezTo>
                <a:cubicBezTo>
                  <a:pt x="8184355" y="456182"/>
                  <a:pt x="8262937" y="493979"/>
                  <a:pt x="8348662" y="520146"/>
                </a:cubicBezTo>
                <a:cubicBezTo>
                  <a:pt x="8477249" y="560851"/>
                  <a:pt x="8541543" y="543406"/>
                  <a:pt x="8637984" y="459090"/>
                </a:cubicBezTo>
                <a:cubicBezTo>
                  <a:pt x="8691561" y="409663"/>
                  <a:pt x="8737996" y="360236"/>
                  <a:pt x="8784431" y="290457"/>
                </a:cubicBezTo>
                <a:cubicBezTo>
                  <a:pt x="8809434" y="450367"/>
                  <a:pt x="8895158" y="284642"/>
                  <a:pt x="8948737" y="339884"/>
                </a:cubicBezTo>
                <a:cubicBezTo>
                  <a:pt x="8970168" y="453274"/>
                  <a:pt x="8798717" y="543406"/>
                  <a:pt x="8848725" y="697501"/>
                </a:cubicBezTo>
                <a:cubicBezTo>
                  <a:pt x="8995171" y="511424"/>
                  <a:pt x="9041606" y="302087"/>
                  <a:pt x="9238059" y="165437"/>
                </a:cubicBezTo>
                <a:cubicBezTo>
                  <a:pt x="9280921" y="197419"/>
                  <a:pt x="9238059" y="229401"/>
                  <a:pt x="9255919" y="255567"/>
                </a:cubicBezTo>
                <a:cubicBezTo>
                  <a:pt x="9266634" y="255567"/>
                  <a:pt x="9198767" y="560851"/>
                  <a:pt x="9477374" y="578295"/>
                </a:cubicBezTo>
                <a:cubicBezTo>
                  <a:pt x="9477374" y="584110"/>
                  <a:pt x="9477374" y="589925"/>
                  <a:pt x="9488091" y="595740"/>
                </a:cubicBezTo>
                <a:cubicBezTo>
                  <a:pt x="9527380" y="627722"/>
                  <a:pt x="9620249" y="598648"/>
                  <a:pt x="9627393" y="650981"/>
                </a:cubicBezTo>
                <a:cubicBezTo>
                  <a:pt x="9634537" y="709131"/>
                  <a:pt x="9666684" y="764373"/>
                  <a:pt x="9648824" y="825429"/>
                </a:cubicBezTo>
                <a:cubicBezTo>
                  <a:pt x="9634537" y="871948"/>
                  <a:pt x="9616678" y="921374"/>
                  <a:pt x="9616678" y="970802"/>
                </a:cubicBezTo>
                <a:cubicBezTo>
                  <a:pt x="9616678" y="1023136"/>
                  <a:pt x="9495233" y="1095822"/>
                  <a:pt x="9655968" y="1127805"/>
                </a:cubicBezTo>
                <a:cubicBezTo>
                  <a:pt x="9663111" y="1127805"/>
                  <a:pt x="9645252" y="1217935"/>
                  <a:pt x="9638109" y="1267362"/>
                </a:cubicBezTo>
                <a:cubicBezTo>
                  <a:pt x="9630965" y="1308066"/>
                  <a:pt x="9598818" y="1357494"/>
                  <a:pt x="9663111" y="1386568"/>
                </a:cubicBezTo>
                <a:cubicBezTo>
                  <a:pt x="9702403" y="1401105"/>
                  <a:pt x="9773840" y="1331326"/>
                  <a:pt x="9780984" y="1270269"/>
                </a:cubicBezTo>
                <a:cubicBezTo>
                  <a:pt x="9788127" y="1215028"/>
                  <a:pt x="9795271" y="1159787"/>
                  <a:pt x="9780984" y="1107452"/>
                </a:cubicBezTo>
                <a:cubicBezTo>
                  <a:pt x="9763125" y="1043488"/>
                  <a:pt x="9791699" y="1008598"/>
                  <a:pt x="9855993" y="991154"/>
                </a:cubicBezTo>
                <a:cubicBezTo>
                  <a:pt x="9923858" y="970802"/>
                  <a:pt x="9959577" y="933005"/>
                  <a:pt x="9991724" y="880670"/>
                </a:cubicBezTo>
                <a:cubicBezTo>
                  <a:pt x="10070305" y="752742"/>
                  <a:pt x="10163174" y="630630"/>
                  <a:pt x="10209609" y="491071"/>
                </a:cubicBezTo>
                <a:cubicBezTo>
                  <a:pt x="10216753" y="464905"/>
                  <a:pt x="10231040" y="432923"/>
                  <a:pt x="10291762" y="421292"/>
                </a:cubicBezTo>
                <a:cubicBezTo>
                  <a:pt x="10198893" y="799262"/>
                  <a:pt x="9959577" y="1142341"/>
                  <a:pt x="9973865" y="1531941"/>
                </a:cubicBezTo>
                <a:cubicBezTo>
                  <a:pt x="10048874" y="1427272"/>
                  <a:pt x="10052446" y="1302252"/>
                  <a:pt x="10106024" y="1188861"/>
                </a:cubicBezTo>
                <a:cubicBezTo>
                  <a:pt x="10145315" y="1270269"/>
                  <a:pt x="10102453" y="1345863"/>
                  <a:pt x="10081022" y="1421458"/>
                </a:cubicBezTo>
                <a:cubicBezTo>
                  <a:pt x="10063162" y="1485421"/>
                  <a:pt x="10059590" y="1543570"/>
                  <a:pt x="10170318" y="1549385"/>
                </a:cubicBezTo>
                <a:cubicBezTo>
                  <a:pt x="10181034" y="1549385"/>
                  <a:pt x="10188178" y="1549385"/>
                  <a:pt x="10198893" y="1549385"/>
                </a:cubicBezTo>
                <a:cubicBezTo>
                  <a:pt x="10245327" y="1526126"/>
                  <a:pt x="10266759" y="1494144"/>
                  <a:pt x="10281046" y="1453439"/>
                </a:cubicBezTo>
                <a:cubicBezTo>
                  <a:pt x="10288190" y="1430180"/>
                  <a:pt x="10302477" y="1398198"/>
                  <a:pt x="10334625" y="1398198"/>
                </a:cubicBezTo>
                <a:cubicBezTo>
                  <a:pt x="10456068" y="1401105"/>
                  <a:pt x="10491787" y="1322604"/>
                  <a:pt x="10527506" y="1247010"/>
                </a:cubicBezTo>
                <a:cubicBezTo>
                  <a:pt x="10588228" y="1287714"/>
                  <a:pt x="10545365" y="1322604"/>
                  <a:pt x="10548937" y="1354586"/>
                </a:cubicBezTo>
                <a:cubicBezTo>
                  <a:pt x="10552509" y="1374938"/>
                  <a:pt x="10556080" y="1395290"/>
                  <a:pt x="10588228" y="1395290"/>
                </a:cubicBezTo>
                <a:cubicBezTo>
                  <a:pt x="10613230" y="1395290"/>
                  <a:pt x="10645378" y="1386568"/>
                  <a:pt x="10645378" y="1366216"/>
                </a:cubicBezTo>
                <a:cubicBezTo>
                  <a:pt x="10648949" y="1238288"/>
                  <a:pt x="10820400" y="1165601"/>
                  <a:pt x="10820400" y="1031858"/>
                </a:cubicBezTo>
                <a:cubicBezTo>
                  <a:pt x="10820400" y="950449"/>
                  <a:pt x="10916840" y="1072563"/>
                  <a:pt x="10956131" y="1005691"/>
                </a:cubicBezTo>
                <a:cubicBezTo>
                  <a:pt x="10966847" y="991154"/>
                  <a:pt x="10981133" y="1046395"/>
                  <a:pt x="10977562" y="1069655"/>
                </a:cubicBezTo>
                <a:cubicBezTo>
                  <a:pt x="10973991" y="1092915"/>
                  <a:pt x="10948987" y="1113267"/>
                  <a:pt x="10966847" y="1142341"/>
                </a:cubicBezTo>
                <a:cubicBezTo>
                  <a:pt x="11031140" y="1156879"/>
                  <a:pt x="11056143" y="1119081"/>
                  <a:pt x="11074003" y="1084192"/>
                </a:cubicBezTo>
                <a:cubicBezTo>
                  <a:pt x="11116865" y="1008598"/>
                  <a:pt x="11166871" y="933005"/>
                  <a:pt x="11181159" y="848688"/>
                </a:cubicBezTo>
                <a:cubicBezTo>
                  <a:pt x="11184730" y="819614"/>
                  <a:pt x="11202590" y="802169"/>
                  <a:pt x="11238309" y="805077"/>
                </a:cubicBezTo>
                <a:cubicBezTo>
                  <a:pt x="11284744" y="810891"/>
                  <a:pt x="11270456" y="839966"/>
                  <a:pt x="11266884" y="863226"/>
                </a:cubicBezTo>
                <a:cubicBezTo>
                  <a:pt x="11263312" y="877763"/>
                  <a:pt x="11252596" y="892300"/>
                  <a:pt x="11277600" y="906838"/>
                </a:cubicBezTo>
                <a:cubicBezTo>
                  <a:pt x="11531203" y="566666"/>
                  <a:pt x="11516915" y="386403"/>
                  <a:pt x="11724084" y="5527"/>
                </a:cubicBezTo>
                <a:cubicBezTo>
                  <a:pt x="11763375" y="89842"/>
                  <a:pt x="11734800" y="150899"/>
                  <a:pt x="11727656" y="209048"/>
                </a:cubicBezTo>
                <a:cubicBezTo>
                  <a:pt x="11709796" y="354421"/>
                  <a:pt x="11677649" y="264290"/>
                  <a:pt x="11656218" y="409663"/>
                </a:cubicBezTo>
                <a:cubicBezTo>
                  <a:pt x="11645503" y="479442"/>
                  <a:pt x="11609784" y="543406"/>
                  <a:pt x="11666934" y="621907"/>
                </a:cubicBezTo>
                <a:cubicBezTo>
                  <a:pt x="11706225" y="674241"/>
                  <a:pt x="11663362" y="758557"/>
                  <a:pt x="11631215" y="822521"/>
                </a:cubicBezTo>
                <a:cubicBezTo>
                  <a:pt x="11602640" y="874856"/>
                  <a:pt x="11595497" y="927190"/>
                  <a:pt x="11631215" y="996969"/>
                </a:cubicBezTo>
                <a:cubicBezTo>
                  <a:pt x="11652646" y="933005"/>
                  <a:pt x="11670505" y="883578"/>
                  <a:pt x="11684793" y="834151"/>
                </a:cubicBezTo>
                <a:cubicBezTo>
                  <a:pt x="11695509" y="793447"/>
                  <a:pt x="11720512" y="770187"/>
                  <a:pt x="11774090" y="773095"/>
                </a:cubicBezTo>
                <a:cubicBezTo>
                  <a:pt x="11802665" y="773095"/>
                  <a:pt x="11841956" y="764373"/>
                  <a:pt x="11856243" y="793447"/>
                </a:cubicBezTo>
                <a:cubicBezTo>
                  <a:pt x="11870531" y="816706"/>
                  <a:pt x="11856243" y="848688"/>
                  <a:pt x="11831240" y="860319"/>
                </a:cubicBezTo>
                <a:cubicBezTo>
                  <a:pt x="11784806" y="874856"/>
                  <a:pt x="11741944" y="889393"/>
                  <a:pt x="11738371" y="938820"/>
                </a:cubicBezTo>
                <a:cubicBezTo>
                  <a:pt x="11731228" y="1005691"/>
                  <a:pt x="11759802" y="967894"/>
                  <a:pt x="11795521" y="956264"/>
                </a:cubicBezTo>
                <a:cubicBezTo>
                  <a:pt x="11834812" y="944634"/>
                  <a:pt x="11845527" y="979524"/>
                  <a:pt x="11838384" y="1002784"/>
                </a:cubicBezTo>
                <a:cubicBezTo>
                  <a:pt x="11806237" y="1090007"/>
                  <a:pt x="11863387" y="1180138"/>
                  <a:pt x="11816952" y="1270269"/>
                </a:cubicBezTo>
                <a:cubicBezTo>
                  <a:pt x="11931252" y="1247010"/>
                  <a:pt x="11981259" y="1197583"/>
                  <a:pt x="11999118" y="1092915"/>
                </a:cubicBezTo>
                <a:cubicBezTo>
                  <a:pt x="12002690" y="1055118"/>
                  <a:pt x="11995547" y="1014413"/>
                  <a:pt x="12027693" y="979524"/>
                </a:cubicBezTo>
                <a:cubicBezTo>
                  <a:pt x="12045553" y="959172"/>
                  <a:pt x="12066984" y="938820"/>
                  <a:pt x="12102703" y="953357"/>
                </a:cubicBezTo>
                <a:cubicBezTo>
                  <a:pt x="12127705" y="962080"/>
                  <a:pt x="12127705" y="985338"/>
                  <a:pt x="12120562" y="1005691"/>
                </a:cubicBezTo>
                <a:cubicBezTo>
                  <a:pt x="12081272" y="1090007"/>
                  <a:pt x="12070555" y="1180138"/>
                  <a:pt x="12056268" y="1267362"/>
                </a:cubicBezTo>
                <a:cubicBezTo>
                  <a:pt x="12052697" y="1281899"/>
                  <a:pt x="12045553" y="1296437"/>
                  <a:pt x="12081272" y="1310974"/>
                </a:cubicBezTo>
                <a:cubicBezTo>
                  <a:pt x="12113418" y="1209213"/>
                  <a:pt x="12156280" y="1110359"/>
                  <a:pt x="12191999" y="1008598"/>
                </a:cubicBezTo>
                <a:lnTo>
                  <a:pt x="12191999" y="6105653"/>
                </a:lnTo>
                <a:lnTo>
                  <a:pt x="0" y="6105653"/>
                </a:lnTo>
                <a:lnTo>
                  <a:pt x="0" y="927116"/>
                </a:lnTo>
                <a:lnTo>
                  <a:pt x="61930" y="902578"/>
                </a:lnTo>
                <a:cubicBezTo>
                  <a:pt x="91454" y="894128"/>
                  <a:pt x="122931" y="887949"/>
                  <a:pt x="155971" y="883588"/>
                </a:cubicBezTo>
                <a:cubicBezTo>
                  <a:pt x="223837" y="877773"/>
                  <a:pt x="245268" y="839976"/>
                  <a:pt x="277414" y="802179"/>
                </a:cubicBezTo>
                <a:cubicBezTo>
                  <a:pt x="388143" y="674251"/>
                  <a:pt x="488155" y="537601"/>
                  <a:pt x="638174" y="430025"/>
                </a:cubicBezTo>
                <a:cubicBezTo>
                  <a:pt x="620315" y="555046"/>
                  <a:pt x="520302" y="653899"/>
                  <a:pt x="477440" y="784735"/>
                </a:cubicBezTo>
                <a:cubicBezTo>
                  <a:pt x="641746" y="680066"/>
                  <a:pt x="727471" y="543415"/>
                  <a:pt x="827483" y="418395"/>
                </a:cubicBezTo>
                <a:cubicBezTo>
                  <a:pt x="873917" y="360246"/>
                  <a:pt x="931068" y="307912"/>
                  <a:pt x="956071" y="241040"/>
                </a:cubicBezTo>
                <a:cubicBezTo>
                  <a:pt x="961429" y="223595"/>
                  <a:pt x="972814" y="196338"/>
                  <a:pt x="999268" y="192386"/>
                </a:cubicBezTo>
                <a:cubicBezTo>
                  <a:pt x="1008086" y="191069"/>
                  <a:pt x="1018579" y="192341"/>
                  <a:pt x="1031080" y="197429"/>
                </a:cubicBezTo>
                <a:cubicBezTo>
                  <a:pt x="1073942" y="214873"/>
                  <a:pt x="1059654" y="246855"/>
                  <a:pt x="1048940" y="275930"/>
                </a:cubicBezTo>
                <a:cubicBezTo>
                  <a:pt x="1020365" y="345708"/>
                  <a:pt x="1020365" y="421303"/>
                  <a:pt x="1020365" y="517249"/>
                </a:cubicBezTo>
                <a:cubicBezTo>
                  <a:pt x="1156096" y="435840"/>
                  <a:pt x="1113233" y="287560"/>
                  <a:pt x="1256108" y="217780"/>
                </a:cubicBezTo>
                <a:cubicBezTo>
                  <a:pt x="1281111" y="305004"/>
                  <a:pt x="1231105" y="371876"/>
                  <a:pt x="1220389" y="441654"/>
                </a:cubicBezTo>
                <a:cubicBezTo>
                  <a:pt x="1209674" y="505619"/>
                  <a:pt x="1234677" y="520156"/>
                  <a:pt x="1313258" y="505619"/>
                </a:cubicBezTo>
                <a:cubicBezTo>
                  <a:pt x="1434702" y="482359"/>
                  <a:pt x="1495424" y="517249"/>
                  <a:pt x="1463277" y="610287"/>
                </a:cubicBezTo>
                <a:cubicBezTo>
                  <a:pt x="1431130" y="697511"/>
                  <a:pt x="1477565" y="706233"/>
                  <a:pt x="1545430" y="682974"/>
                </a:cubicBezTo>
                <a:cubicBezTo>
                  <a:pt x="1645442" y="648084"/>
                  <a:pt x="1724024" y="685881"/>
                  <a:pt x="1809749" y="712048"/>
                </a:cubicBezTo>
                <a:cubicBezTo>
                  <a:pt x="1938336" y="752753"/>
                  <a:pt x="2002630" y="735308"/>
                  <a:pt x="2099071" y="650992"/>
                </a:cubicBezTo>
                <a:cubicBezTo>
                  <a:pt x="2152648" y="601565"/>
                  <a:pt x="2199083" y="552138"/>
                  <a:pt x="2245518" y="482359"/>
                </a:cubicBezTo>
                <a:cubicBezTo>
                  <a:pt x="2270521" y="642269"/>
                  <a:pt x="2356245" y="476544"/>
                  <a:pt x="2409824" y="531786"/>
                </a:cubicBezTo>
                <a:cubicBezTo>
                  <a:pt x="2431255" y="645176"/>
                  <a:pt x="2259804" y="735308"/>
                  <a:pt x="2309812" y="889403"/>
                </a:cubicBezTo>
                <a:cubicBezTo>
                  <a:pt x="2456258" y="703326"/>
                  <a:pt x="2502693" y="493989"/>
                  <a:pt x="2699146" y="357339"/>
                </a:cubicBezTo>
                <a:cubicBezTo>
                  <a:pt x="2742008" y="389321"/>
                  <a:pt x="2699146" y="421303"/>
                  <a:pt x="2717006" y="447469"/>
                </a:cubicBezTo>
                <a:cubicBezTo>
                  <a:pt x="2727721" y="447469"/>
                  <a:pt x="2659854" y="752753"/>
                  <a:pt x="2938461" y="770197"/>
                </a:cubicBezTo>
                <a:cubicBezTo>
                  <a:pt x="2938461" y="776012"/>
                  <a:pt x="2938461" y="781827"/>
                  <a:pt x="2949178" y="787642"/>
                </a:cubicBezTo>
                <a:cubicBezTo>
                  <a:pt x="2988467" y="819624"/>
                  <a:pt x="3081336" y="790550"/>
                  <a:pt x="3088480" y="842883"/>
                </a:cubicBezTo>
                <a:cubicBezTo>
                  <a:pt x="3095624" y="901033"/>
                  <a:pt x="3127771" y="956275"/>
                  <a:pt x="3109911" y="1017331"/>
                </a:cubicBezTo>
                <a:cubicBezTo>
                  <a:pt x="3095624" y="1063850"/>
                  <a:pt x="3077765" y="1113276"/>
                  <a:pt x="3077765" y="1162704"/>
                </a:cubicBezTo>
                <a:cubicBezTo>
                  <a:pt x="3077765" y="1215038"/>
                  <a:pt x="2956320" y="1287724"/>
                  <a:pt x="3117055" y="1319707"/>
                </a:cubicBezTo>
                <a:cubicBezTo>
                  <a:pt x="3124198" y="1319707"/>
                  <a:pt x="3106339" y="1409837"/>
                  <a:pt x="3099196" y="1459264"/>
                </a:cubicBezTo>
                <a:cubicBezTo>
                  <a:pt x="3092052" y="1499968"/>
                  <a:pt x="3059905" y="1549396"/>
                  <a:pt x="3124198" y="1578470"/>
                </a:cubicBezTo>
                <a:cubicBezTo>
                  <a:pt x="3163490" y="1593007"/>
                  <a:pt x="3234927" y="1523228"/>
                  <a:pt x="3242071" y="1462171"/>
                </a:cubicBezTo>
                <a:cubicBezTo>
                  <a:pt x="3249214" y="1406930"/>
                  <a:pt x="3256358" y="1351689"/>
                  <a:pt x="3242071" y="1299354"/>
                </a:cubicBezTo>
                <a:cubicBezTo>
                  <a:pt x="3224212" y="1235390"/>
                  <a:pt x="3252786" y="1200500"/>
                  <a:pt x="3317080" y="1183056"/>
                </a:cubicBezTo>
                <a:cubicBezTo>
                  <a:pt x="3384945" y="1162704"/>
                  <a:pt x="3420664" y="1124907"/>
                  <a:pt x="3452811" y="1072572"/>
                </a:cubicBezTo>
                <a:cubicBezTo>
                  <a:pt x="3531392" y="944644"/>
                  <a:pt x="3624261" y="822532"/>
                  <a:pt x="3670696" y="682973"/>
                </a:cubicBezTo>
                <a:cubicBezTo>
                  <a:pt x="3677840" y="656807"/>
                  <a:pt x="3692127" y="624825"/>
                  <a:pt x="3752849" y="613194"/>
                </a:cubicBezTo>
                <a:cubicBezTo>
                  <a:pt x="3659980" y="991164"/>
                  <a:pt x="3420664" y="1334243"/>
                  <a:pt x="3434952" y="1723843"/>
                </a:cubicBezTo>
                <a:cubicBezTo>
                  <a:pt x="3509961" y="1619174"/>
                  <a:pt x="3513533" y="1494154"/>
                  <a:pt x="3567111" y="1380763"/>
                </a:cubicBezTo>
                <a:cubicBezTo>
                  <a:pt x="3606402" y="1462171"/>
                  <a:pt x="3563540" y="1537765"/>
                  <a:pt x="3542109" y="1613360"/>
                </a:cubicBezTo>
                <a:cubicBezTo>
                  <a:pt x="3524249" y="1677323"/>
                  <a:pt x="3520677" y="1735472"/>
                  <a:pt x="3631405" y="1741287"/>
                </a:cubicBezTo>
                <a:cubicBezTo>
                  <a:pt x="3642121" y="1741287"/>
                  <a:pt x="3649265" y="1741287"/>
                  <a:pt x="3659980" y="1741287"/>
                </a:cubicBezTo>
                <a:cubicBezTo>
                  <a:pt x="3706414" y="1718028"/>
                  <a:pt x="3727846" y="1686046"/>
                  <a:pt x="3742133" y="1645341"/>
                </a:cubicBezTo>
                <a:cubicBezTo>
                  <a:pt x="3749277" y="1622082"/>
                  <a:pt x="3763564" y="1590100"/>
                  <a:pt x="3795712" y="1590100"/>
                </a:cubicBezTo>
                <a:cubicBezTo>
                  <a:pt x="3917155" y="1593007"/>
                  <a:pt x="3952874" y="1514506"/>
                  <a:pt x="3988593" y="1438912"/>
                </a:cubicBezTo>
                <a:cubicBezTo>
                  <a:pt x="4049315" y="1479616"/>
                  <a:pt x="4006452" y="1514506"/>
                  <a:pt x="4010024" y="1546488"/>
                </a:cubicBezTo>
                <a:cubicBezTo>
                  <a:pt x="4013596" y="1566840"/>
                  <a:pt x="4017167" y="1587192"/>
                  <a:pt x="4049315" y="1587192"/>
                </a:cubicBezTo>
                <a:cubicBezTo>
                  <a:pt x="4074317" y="1587192"/>
                  <a:pt x="4106465" y="1578470"/>
                  <a:pt x="4106465" y="1558118"/>
                </a:cubicBezTo>
                <a:cubicBezTo>
                  <a:pt x="4110036" y="1430190"/>
                  <a:pt x="4281487" y="1357503"/>
                  <a:pt x="4281487" y="1223760"/>
                </a:cubicBezTo>
                <a:cubicBezTo>
                  <a:pt x="4281487" y="1142351"/>
                  <a:pt x="4377927" y="1264465"/>
                  <a:pt x="4417219" y="1197593"/>
                </a:cubicBezTo>
                <a:cubicBezTo>
                  <a:pt x="4427935" y="1183056"/>
                  <a:pt x="4442220" y="1238297"/>
                  <a:pt x="4438649" y="1261557"/>
                </a:cubicBezTo>
                <a:cubicBezTo>
                  <a:pt x="4435078" y="1284817"/>
                  <a:pt x="4410074" y="1305169"/>
                  <a:pt x="4427935" y="1334243"/>
                </a:cubicBezTo>
                <a:cubicBezTo>
                  <a:pt x="4492228" y="1348781"/>
                  <a:pt x="4517230" y="1310983"/>
                  <a:pt x="4535090" y="1276094"/>
                </a:cubicBezTo>
                <a:cubicBezTo>
                  <a:pt x="4577952" y="1200500"/>
                  <a:pt x="4627958" y="1124907"/>
                  <a:pt x="4642246" y="1040590"/>
                </a:cubicBezTo>
                <a:cubicBezTo>
                  <a:pt x="4645817" y="1011516"/>
                  <a:pt x="4663677" y="994071"/>
                  <a:pt x="4699396" y="996979"/>
                </a:cubicBezTo>
                <a:cubicBezTo>
                  <a:pt x="4745832" y="1002793"/>
                  <a:pt x="4731544" y="1031868"/>
                  <a:pt x="4727971" y="1055128"/>
                </a:cubicBezTo>
                <a:cubicBezTo>
                  <a:pt x="4724399" y="1069665"/>
                  <a:pt x="4713683" y="1084202"/>
                  <a:pt x="4738688" y="1098740"/>
                </a:cubicBezTo>
                <a:cubicBezTo>
                  <a:pt x="4992291" y="758568"/>
                  <a:pt x="4978002" y="578305"/>
                  <a:pt x="5185172" y="197429"/>
                </a:cubicBezTo>
                <a:cubicBezTo>
                  <a:pt x="5224462" y="281744"/>
                  <a:pt x="5195887" y="342801"/>
                  <a:pt x="5188744" y="400950"/>
                </a:cubicBezTo>
                <a:cubicBezTo>
                  <a:pt x="5170883" y="546323"/>
                  <a:pt x="5138736" y="456192"/>
                  <a:pt x="5117306" y="601565"/>
                </a:cubicBezTo>
                <a:cubicBezTo>
                  <a:pt x="5106590" y="671344"/>
                  <a:pt x="5070871" y="735308"/>
                  <a:pt x="5128021" y="813809"/>
                </a:cubicBezTo>
                <a:cubicBezTo>
                  <a:pt x="5167312" y="866143"/>
                  <a:pt x="5124450" y="950459"/>
                  <a:pt x="5092302" y="1014423"/>
                </a:cubicBezTo>
                <a:cubicBezTo>
                  <a:pt x="5063727" y="1066758"/>
                  <a:pt x="5056585" y="1119092"/>
                  <a:pt x="5092302" y="1188871"/>
                </a:cubicBezTo>
                <a:cubicBezTo>
                  <a:pt x="5113734" y="1124907"/>
                  <a:pt x="5131592" y="1075480"/>
                  <a:pt x="5145880" y="1026053"/>
                </a:cubicBezTo>
                <a:cubicBezTo>
                  <a:pt x="5156596" y="985349"/>
                  <a:pt x="5181600" y="962089"/>
                  <a:pt x="5235177" y="964997"/>
                </a:cubicBezTo>
                <a:cubicBezTo>
                  <a:pt x="5263752" y="964997"/>
                  <a:pt x="5303044" y="956275"/>
                  <a:pt x="5317331" y="985349"/>
                </a:cubicBezTo>
                <a:cubicBezTo>
                  <a:pt x="5331618" y="1008608"/>
                  <a:pt x="5317331" y="1040590"/>
                  <a:pt x="5292327" y="1052221"/>
                </a:cubicBezTo>
                <a:cubicBezTo>
                  <a:pt x="5245894" y="1066758"/>
                  <a:pt x="5203031" y="1081295"/>
                  <a:pt x="5199458" y="1130722"/>
                </a:cubicBezTo>
                <a:cubicBezTo>
                  <a:pt x="5192315" y="1197593"/>
                  <a:pt x="5220889" y="1159796"/>
                  <a:pt x="5256608" y="1148166"/>
                </a:cubicBezTo>
                <a:cubicBezTo>
                  <a:pt x="5295899" y="1136536"/>
                  <a:pt x="5306616" y="1171426"/>
                  <a:pt x="5299471" y="1194686"/>
                </a:cubicBezTo>
                <a:cubicBezTo>
                  <a:pt x="5267324" y="1281909"/>
                  <a:pt x="5324474" y="1372040"/>
                  <a:pt x="5278039" y="1462171"/>
                </a:cubicBezTo>
                <a:cubicBezTo>
                  <a:pt x="5392339" y="1438912"/>
                  <a:pt x="5442347" y="1389485"/>
                  <a:pt x="5460205" y="1284817"/>
                </a:cubicBezTo>
                <a:cubicBezTo>
                  <a:pt x="5463777" y="1247020"/>
                  <a:pt x="5456634" y="1206315"/>
                  <a:pt x="5488780" y="1171426"/>
                </a:cubicBezTo>
                <a:cubicBezTo>
                  <a:pt x="5502175" y="1156162"/>
                  <a:pt x="5517579" y="1140898"/>
                  <a:pt x="5539513" y="1140353"/>
                </a:cubicBezTo>
                <a:lnTo>
                  <a:pt x="5552720" y="1143022"/>
                </a:lnTo>
                <a:lnTo>
                  <a:pt x="5574208" y="1115811"/>
                </a:lnTo>
                <a:cubicBezTo>
                  <a:pt x="5609034" y="1085646"/>
                  <a:pt x="5659040" y="1068202"/>
                  <a:pt x="5734050" y="1075470"/>
                </a:cubicBezTo>
                <a:cubicBezTo>
                  <a:pt x="5776912" y="1078377"/>
                  <a:pt x="5809058" y="1055118"/>
                  <a:pt x="5798343" y="1020228"/>
                </a:cubicBezTo>
                <a:cubicBezTo>
                  <a:pt x="5776912" y="953357"/>
                  <a:pt x="5837634" y="921375"/>
                  <a:pt x="5884068" y="883578"/>
                </a:cubicBezTo>
                <a:cubicBezTo>
                  <a:pt x="5966221" y="816706"/>
                  <a:pt x="6051947" y="752742"/>
                  <a:pt x="6066234" y="645166"/>
                </a:cubicBezTo>
                <a:cubicBezTo>
                  <a:pt x="6130528" y="665519"/>
                  <a:pt x="6123384" y="700408"/>
                  <a:pt x="6109096" y="732391"/>
                </a:cubicBezTo>
                <a:cubicBezTo>
                  <a:pt x="6073377" y="816706"/>
                  <a:pt x="6034087" y="901023"/>
                  <a:pt x="5998368" y="985338"/>
                </a:cubicBezTo>
                <a:cubicBezTo>
                  <a:pt x="5976937" y="1040581"/>
                  <a:pt x="5944790" y="1095822"/>
                  <a:pt x="5969793" y="1168509"/>
                </a:cubicBezTo>
                <a:cubicBezTo>
                  <a:pt x="6098380" y="1104545"/>
                  <a:pt x="6123384" y="996969"/>
                  <a:pt x="6162674" y="909745"/>
                </a:cubicBezTo>
                <a:cubicBezTo>
                  <a:pt x="6212681" y="802169"/>
                  <a:pt x="6305549" y="738205"/>
                  <a:pt x="6412705" y="659704"/>
                </a:cubicBezTo>
                <a:cubicBezTo>
                  <a:pt x="6441280" y="738205"/>
                  <a:pt x="6362699" y="787632"/>
                  <a:pt x="6366271" y="851596"/>
                </a:cubicBezTo>
                <a:cubicBezTo>
                  <a:pt x="6376987" y="854503"/>
                  <a:pt x="6398418" y="860319"/>
                  <a:pt x="6398418" y="860319"/>
                </a:cubicBezTo>
                <a:cubicBezTo>
                  <a:pt x="6455568" y="755650"/>
                  <a:pt x="6562724" y="709131"/>
                  <a:pt x="6694884" y="691686"/>
                </a:cubicBezTo>
                <a:cubicBezTo>
                  <a:pt x="6762750" y="685871"/>
                  <a:pt x="6784181" y="648074"/>
                  <a:pt x="6816327" y="610277"/>
                </a:cubicBezTo>
                <a:cubicBezTo>
                  <a:pt x="6927056" y="482349"/>
                  <a:pt x="7027068" y="345699"/>
                  <a:pt x="7177087" y="238123"/>
                </a:cubicBezTo>
                <a:cubicBezTo>
                  <a:pt x="7159228" y="363144"/>
                  <a:pt x="7059215" y="461997"/>
                  <a:pt x="7016353" y="592833"/>
                </a:cubicBezTo>
                <a:cubicBezTo>
                  <a:pt x="7180659" y="488164"/>
                  <a:pt x="7266384" y="351513"/>
                  <a:pt x="7366396" y="226493"/>
                </a:cubicBezTo>
                <a:cubicBezTo>
                  <a:pt x="7412830" y="168344"/>
                  <a:pt x="7469981" y="116010"/>
                  <a:pt x="7494984" y="49138"/>
                </a:cubicBezTo>
                <a:cubicBezTo>
                  <a:pt x="7500342" y="31693"/>
                  <a:pt x="7511727" y="4436"/>
                  <a:pt x="7538181" y="484"/>
                </a:cubicBezTo>
                <a:close/>
              </a:path>
            </a:pathLst>
          </a:custGeom>
          <a:solidFill>
            <a:schemeClr val="accent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E27F41FC-F763-F14F-B2D6-37CD2B4A0420}"/>
              </a:ext>
            </a:extLst>
          </p:cNvPr>
          <p:cNvSpPr>
            <a:spLocks noGrp="1"/>
          </p:cNvSpPr>
          <p:nvPr>
            <p:ph type="title"/>
          </p:nvPr>
        </p:nvSpPr>
        <p:spPr>
          <a:xfrm>
            <a:off x="838200" y="365125"/>
            <a:ext cx="10515600" cy="1325563"/>
          </a:xfrm>
        </p:spPr>
        <p:txBody>
          <a:bodyPr>
            <a:normAutofit/>
          </a:bodyPr>
          <a:lstStyle/>
          <a:p>
            <a:r>
              <a:rPr lang="en-US" dirty="0"/>
              <a:t>Support</a:t>
            </a:r>
          </a:p>
        </p:txBody>
      </p:sp>
      <p:graphicFrame>
        <p:nvGraphicFramePr>
          <p:cNvPr id="5" name="Content Placeholder 2">
            <a:extLst>
              <a:ext uri="{FF2B5EF4-FFF2-40B4-BE49-F238E27FC236}">
                <a16:creationId xmlns:a16="http://schemas.microsoft.com/office/drawing/2014/main" id="{0646DDFC-515B-5DF9-5F06-9BDC454E2FB9}"/>
              </a:ext>
            </a:extLst>
          </p:cNvPr>
          <p:cNvGraphicFramePr>
            <a:graphicFrameLocks noGrp="1"/>
          </p:cNvGraphicFramePr>
          <p:nvPr>
            <p:ph idx="1"/>
            <p:extLst>
              <p:ext uri="{D42A27DB-BD31-4B8C-83A1-F6EECF244321}">
                <p14:modId xmlns:p14="http://schemas.microsoft.com/office/powerpoint/2010/main" val="398072656"/>
              </p:ext>
            </p:extLst>
          </p:nvPr>
        </p:nvGraphicFramePr>
        <p:xfrm>
          <a:off x="838200" y="2011363"/>
          <a:ext cx="10515600" cy="416083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64067266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DA8886A6-5426-494B-96D8-D962D2BA08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Freeform: Shape 10">
            <a:extLst>
              <a:ext uri="{FF2B5EF4-FFF2-40B4-BE49-F238E27FC236}">
                <a16:creationId xmlns:a16="http://schemas.microsoft.com/office/drawing/2014/main" id="{AA3ED336-C09E-46E8-9774-B977D15FC5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752347"/>
            <a:ext cx="12191999" cy="6105653"/>
          </a:xfrm>
          <a:custGeom>
            <a:avLst/>
            <a:gdLst>
              <a:gd name="connsiteX0" fmla="*/ 7538181 w 12191999"/>
              <a:gd name="connsiteY0" fmla="*/ 484 h 6105653"/>
              <a:gd name="connsiteX1" fmla="*/ 7569993 w 12191999"/>
              <a:gd name="connsiteY1" fmla="*/ 5527 h 6105653"/>
              <a:gd name="connsiteX2" fmla="*/ 7587853 w 12191999"/>
              <a:gd name="connsiteY2" fmla="*/ 84028 h 6105653"/>
              <a:gd name="connsiteX3" fmla="*/ 7559278 w 12191999"/>
              <a:gd name="connsiteY3" fmla="*/ 325347 h 6105653"/>
              <a:gd name="connsiteX4" fmla="*/ 7795021 w 12191999"/>
              <a:gd name="connsiteY4" fmla="*/ 25878 h 6105653"/>
              <a:gd name="connsiteX5" fmla="*/ 7759302 w 12191999"/>
              <a:gd name="connsiteY5" fmla="*/ 249752 h 6105653"/>
              <a:gd name="connsiteX6" fmla="*/ 7852171 w 12191999"/>
              <a:gd name="connsiteY6" fmla="*/ 313717 h 6105653"/>
              <a:gd name="connsiteX7" fmla="*/ 8002190 w 12191999"/>
              <a:gd name="connsiteY7" fmla="*/ 418385 h 6105653"/>
              <a:gd name="connsiteX8" fmla="*/ 8084343 w 12191999"/>
              <a:gd name="connsiteY8" fmla="*/ 491072 h 6105653"/>
              <a:gd name="connsiteX9" fmla="*/ 8348662 w 12191999"/>
              <a:gd name="connsiteY9" fmla="*/ 520146 h 6105653"/>
              <a:gd name="connsiteX10" fmla="*/ 8637984 w 12191999"/>
              <a:gd name="connsiteY10" fmla="*/ 459090 h 6105653"/>
              <a:gd name="connsiteX11" fmla="*/ 8784431 w 12191999"/>
              <a:gd name="connsiteY11" fmla="*/ 290457 h 6105653"/>
              <a:gd name="connsiteX12" fmla="*/ 8948737 w 12191999"/>
              <a:gd name="connsiteY12" fmla="*/ 339884 h 6105653"/>
              <a:gd name="connsiteX13" fmla="*/ 8848725 w 12191999"/>
              <a:gd name="connsiteY13" fmla="*/ 697501 h 6105653"/>
              <a:gd name="connsiteX14" fmla="*/ 9238059 w 12191999"/>
              <a:gd name="connsiteY14" fmla="*/ 165437 h 6105653"/>
              <a:gd name="connsiteX15" fmla="*/ 9255919 w 12191999"/>
              <a:gd name="connsiteY15" fmla="*/ 255567 h 6105653"/>
              <a:gd name="connsiteX16" fmla="*/ 9477374 w 12191999"/>
              <a:gd name="connsiteY16" fmla="*/ 578295 h 6105653"/>
              <a:gd name="connsiteX17" fmla="*/ 9488091 w 12191999"/>
              <a:gd name="connsiteY17" fmla="*/ 595740 h 6105653"/>
              <a:gd name="connsiteX18" fmla="*/ 9627393 w 12191999"/>
              <a:gd name="connsiteY18" fmla="*/ 650981 h 6105653"/>
              <a:gd name="connsiteX19" fmla="*/ 9648824 w 12191999"/>
              <a:gd name="connsiteY19" fmla="*/ 825429 h 6105653"/>
              <a:gd name="connsiteX20" fmla="*/ 9616678 w 12191999"/>
              <a:gd name="connsiteY20" fmla="*/ 970802 h 6105653"/>
              <a:gd name="connsiteX21" fmla="*/ 9655968 w 12191999"/>
              <a:gd name="connsiteY21" fmla="*/ 1127805 h 6105653"/>
              <a:gd name="connsiteX22" fmla="*/ 9638109 w 12191999"/>
              <a:gd name="connsiteY22" fmla="*/ 1267362 h 6105653"/>
              <a:gd name="connsiteX23" fmla="*/ 9663111 w 12191999"/>
              <a:gd name="connsiteY23" fmla="*/ 1386568 h 6105653"/>
              <a:gd name="connsiteX24" fmla="*/ 9780984 w 12191999"/>
              <a:gd name="connsiteY24" fmla="*/ 1270269 h 6105653"/>
              <a:gd name="connsiteX25" fmla="*/ 9780984 w 12191999"/>
              <a:gd name="connsiteY25" fmla="*/ 1107452 h 6105653"/>
              <a:gd name="connsiteX26" fmla="*/ 9855993 w 12191999"/>
              <a:gd name="connsiteY26" fmla="*/ 991154 h 6105653"/>
              <a:gd name="connsiteX27" fmla="*/ 9991724 w 12191999"/>
              <a:gd name="connsiteY27" fmla="*/ 880670 h 6105653"/>
              <a:gd name="connsiteX28" fmla="*/ 10209609 w 12191999"/>
              <a:gd name="connsiteY28" fmla="*/ 491071 h 6105653"/>
              <a:gd name="connsiteX29" fmla="*/ 10291762 w 12191999"/>
              <a:gd name="connsiteY29" fmla="*/ 421292 h 6105653"/>
              <a:gd name="connsiteX30" fmla="*/ 9973865 w 12191999"/>
              <a:gd name="connsiteY30" fmla="*/ 1531941 h 6105653"/>
              <a:gd name="connsiteX31" fmla="*/ 10106024 w 12191999"/>
              <a:gd name="connsiteY31" fmla="*/ 1188861 h 6105653"/>
              <a:gd name="connsiteX32" fmla="*/ 10081022 w 12191999"/>
              <a:gd name="connsiteY32" fmla="*/ 1421458 h 6105653"/>
              <a:gd name="connsiteX33" fmla="*/ 10170318 w 12191999"/>
              <a:gd name="connsiteY33" fmla="*/ 1549385 h 6105653"/>
              <a:gd name="connsiteX34" fmla="*/ 10198893 w 12191999"/>
              <a:gd name="connsiteY34" fmla="*/ 1549385 h 6105653"/>
              <a:gd name="connsiteX35" fmla="*/ 10281046 w 12191999"/>
              <a:gd name="connsiteY35" fmla="*/ 1453439 h 6105653"/>
              <a:gd name="connsiteX36" fmla="*/ 10334625 w 12191999"/>
              <a:gd name="connsiteY36" fmla="*/ 1398198 h 6105653"/>
              <a:gd name="connsiteX37" fmla="*/ 10527506 w 12191999"/>
              <a:gd name="connsiteY37" fmla="*/ 1247010 h 6105653"/>
              <a:gd name="connsiteX38" fmla="*/ 10548937 w 12191999"/>
              <a:gd name="connsiteY38" fmla="*/ 1354586 h 6105653"/>
              <a:gd name="connsiteX39" fmla="*/ 10588228 w 12191999"/>
              <a:gd name="connsiteY39" fmla="*/ 1395290 h 6105653"/>
              <a:gd name="connsiteX40" fmla="*/ 10645378 w 12191999"/>
              <a:gd name="connsiteY40" fmla="*/ 1366216 h 6105653"/>
              <a:gd name="connsiteX41" fmla="*/ 10820400 w 12191999"/>
              <a:gd name="connsiteY41" fmla="*/ 1031858 h 6105653"/>
              <a:gd name="connsiteX42" fmla="*/ 10956131 w 12191999"/>
              <a:gd name="connsiteY42" fmla="*/ 1005691 h 6105653"/>
              <a:gd name="connsiteX43" fmla="*/ 10977562 w 12191999"/>
              <a:gd name="connsiteY43" fmla="*/ 1069655 h 6105653"/>
              <a:gd name="connsiteX44" fmla="*/ 10966847 w 12191999"/>
              <a:gd name="connsiteY44" fmla="*/ 1142341 h 6105653"/>
              <a:gd name="connsiteX45" fmla="*/ 11074003 w 12191999"/>
              <a:gd name="connsiteY45" fmla="*/ 1084192 h 6105653"/>
              <a:gd name="connsiteX46" fmla="*/ 11181159 w 12191999"/>
              <a:gd name="connsiteY46" fmla="*/ 848688 h 6105653"/>
              <a:gd name="connsiteX47" fmla="*/ 11238309 w 12191999"/>
              <a:gd name="connsiteY47" fmla="*/ 805077 h 6105653"/>
              <a:gd name="connsiteX48" fmla="*/ 11266884 w 12191999"/>
              <a:gd name="connsiteY48" fmla="*/ 863226 h 6105653"/>
              <a:gd name="connsiteX49" fmla="*/ 11277600 w 12191999"/>
              <a:gd name="connsiteY49" fmla="*/ 906838 h 6105653"/>
              <a:gd name="connsiteX50" fmla="*/ 11724084 w 12191999"/>
              <a:gd name="connsiteY50" fmla="*/ 5527 h 6105653"/>
              <a:gd name="connsiteX51" fmla="*/ 11727656 w 12191999"/>
              <a:gd name="connsiteY51" fmla="*/ 209048 h 6105653"/>
              <a:gd name="connsiteX52" fmla="*/ 11656218 w 12191999"/>
              <a:gd name="connsiteY52" fmla="*/ 409663 h 6105653"/>
              <a:gd name="connsiteX53" fmla="*/ 11666934 w 12191999"/>
              <a:gd name="connsiteY53" fmla="*/ 621907 h 6105653"/>
              <a:gd name="connsiteX54" fmla="*/ 11631215 w 12191999"/>
              <a:gd name="connsiteY54" fmla="*/ 822521 h 6105653"/>
              <a:gd name="connsiteX55" fmla="*/ 11631215 w 12191999"/>
              <a:gd name="connsiteY55" fmla="*/ 996969 h 6105653"/>
              <a:gd name="connsiteX56" fmla="*/ 11684793 w 12191999"/>
              <a:gd name="connsiteY56" fmla="*/ 834151 h 6105653"/>
              <a:gd name="connsiteX57" fmla="*/ 11774090 w 12191999"/>
              <a:gd name="connsiteY57" fmla="*/ 773095 h 6105653"/>
              <a:gd name="connsiteX58" fmla="*/ 11856243 w 12191999"/>
              <a:gd name="connsiteY58" fmla="*/ 793447 h 6105653"/>
              <a:gd name="connsiteX59" fmla="*/ 11831240 w 12191999"/>
              <a:gd name="connsiteY59" fmla="*/ 860319 h 6105653"/>
              <a:gd name="connsiteX60" fmla="*/ 11738371 w 12191999"/>
              <a:gd name="connsiteY60" fmla="*/ 938820 h 6105653"/>
              <a:gd name="connsiteX61" fmla="*/ 11795521 w 12191999"/>
              <a:gd name="connsiteY61" fmla="*/ 956264 h 6105653"/>
              <a:gd name="connsiteX62" fmla="*/ 11838384 w 12191999"/>
              <a:gd name="connsiteY62" fmla="*/ 1002784 h 6105653"/>
              <a:gd name="connsiteX63" fmla="*/ 11816952 w 12191999"/>
              <a:gd name="connsiteY63" fmla="*/ 1270269 h 6105653"/>
              <a:gd name="connsiteX64" fmla="*/ 11999118 w 12191999"/>
              <a:gd name="connsiteY64" fmla="*/ 1092915 h 6105653"/>
              <a:gd name="connsiteX65" fmla="*/ 12027693 w 12191999"/>
              <a:gd name="connsiteY65" fmla="*/ 979524 h 6105653"/>
              <a:gd name="connsiteX66" fmla="*/ 12102703 w 12191999"/>
              <a:gd name="connsiteY66" fmla="*/ 953357 h 6105653"/>
              <a:gd name="connsiteX67" fmla="*/ 12120562 w 12191999"/>
              <a:gd name="connsiteY67" fmla="*/ 1005691 h 6105653"/>
              <a:gd name="connsiteX68" fmla="*/ 12056268 w 12191999"/>
              <a:gd name="connsiteY68" fmla="*/ 1267362 h 6105653"/>
              <a:gd name="connsiteX69" fmla="*/ 12081272 w 12191999"/>
              <a:gd name="connsiteY69" fmla="*/ 1310974 h 6105653"/>
              <a:gd name="connsiteX70" fmla="*/ 12191999 w 12191999"/>
              <a:gd name="connsiteY70" fmla="*/ 1008598 h 6105653"/>
              <a:gd name="connsiteX71" fmla="*/ 12191999 w 12191999"/>
              <a:gd name="connsiteY71" fmla="*/ 6105653 h 6105653"/>
              <a:gd name="connsiteX72" fmla="*/ 0 w 12191999"/>
              <a:gd name="connsiteY72" fmla="*/ 6105653 h 6105653"/>
              <a:gd name="connsiteX73" fmla="*/ 0 w 12191999"/>
              <a:gd name="connsiteY73" fmla="*/ 927116 h 6105653"/>
              <a:gd name="connsiteX74" fmla="*/ 61930 w 12191999"/>
              <a:gd name="connsiteY74" fmla="*/ 902578 h 6105653"/>
              <a:gd name="connsiteX75" fmla="*/ 155971 w 12191999"/>
              <a:gd name="connsiteY75" fmla="*/ 883588 h 6105653"/>
              <a:gd name="connsiteX76" fmla="*/ 277414 w 12191999"/>
              <a:gd name="connsiteY76" fmla="*/ 802179 h 6105653"/>
              <a:gd name="connsiteX77" fmla="*/ 638174 w 12191999"/>
              <a:gd name="connsiteY77" fmla="*/ 430025 h 6105653"/>
              <a:gd name="connsiteX78" fmla="*/ 477440 w 12191999"/>
              <a:gd name="connsiteY78" fmla="*/ 784735 h 6105653"/>
              <a:gd name="connsiteX79" fmla="*/ 827483 w 12191999"/>
              <a:gd name="connsiteY79" fmla="*/ 418395 h 6105653"/>
              <a:gd name="connsiteX80" fmla="*/ 956071 w 12191999"/>
              <a:gd name="connsiteY80" fmla="*/ 241040 h 6105653"/>
              <a:gd name="connsiteX81" fmla="*/ 999268 w 12191999"/>
              <a:gd name="connsiteY81" fmla="*/ 192386 h 6105653"/>
              <a:gd name="connsiteX82" fmla="*/ 1031080 w 12191999"/>
              <a:gd name="connsiteY82" fmla="*/ 197429 h 6105653"/>
              <a:gd name="connsiteX83" fmla="*/ 1048940 w 12191999"/>
              <a:gd name="connsiteY83" fmla="*/ 275930 h 6105653"/>
              <a:gd name="connsiteX84" fmla="*/ 1020365 w 12191999"/>
              <a:gd name="connsiteY84" fmla="*/ 517249 h 6105653"/>
              <a:gd name="connsiteX85" fmla="*/ 1256108 w 12191999"/>
              <a:gd name="connsiteY85" fmla="*/ 217780 h 6105653"/>
              <a:gd name="connsiteX86" fmla="*/ 1220389 w 12191999"/>
              <a:gd name="connsiteY86" fmla="*/ 441654 h 6105653"/>
              <a:gd name="connsiteX87" fmla="*/ 1313258 w 12191999"/>
              <a:gd name="connsiteY87" fmla="*/ 505619 h 6105653"/>
              <a:gd name="connsiteX88" fmla="*/ 1463277 w 12191999"/>
              <a:gd name="connsiteY88" fmla="*/ 610287 h 6105653"/>
              <a:gd name="connsiteX89" fmla="*/ 1545430 w 12191999"/>
              <a:gd name="connsiteY89" fmla="*/ 682974 h 6105653"/>
              <a:gd name="connsiteX90" fmla="*/ 1809749 w 12191999"/>
              <a:gd name="connsiteY90" fmla="*/ 712048 h 6105653"/>
              <a:gd name="connsiteX91" fmla="*/ 2099071 w 12191999"/>
              <a:gd name="connsiteY91" fmla="*/ 650992 h 6105653"/>
              <a:gd name="connsiteX92" fmla="*/ 2245518 w 12191999"/>
              <a:gd name="connsiteY92" fmla="*/ 482359 h 6105653"/>
              <a:gd name="connsiteX93" fmla="*/ 2409824 w 12191999"/>
              <a:gd name="connsiteY93" fmla="*/ 531786 h 6105653"/>
              <a:gd name="connsiteX94" fmla="*/ 2309812 w 12191999"/>
              <a:gd name="connsiteY94" fmla="*/ 889403 h 6105653"/>
              <a:gd name="connsiteX95" fmla="*/ 2699146 w 12191999"/>
              <a:gd name="connsiteY95" fmla="*/ 357339 h 6105653"/>
              <a:gd name="connsiteX96" fmla="*/ 2717006 w 12191999"/>
              <a:gd name="connsiteY96" fmla="*/ 447469 h 6105653"/>
              <a:gd name="connsiteX97" fmla="*/ 2938461 w 12191999"/>
              <a:gd name="connsiteY97" fmla="*/ 770197 h 6105653"/>
              <a:gd name="connsiteX98" fmla="*/ 2949178 w 12191999"/>
              <a:gd name="connsiteY98" fmla="*/ 787642 h 6105653"/>
              <a:gd name="connsiteX99" fmla="*/ 3088480 w 12191999"/>
              <a:gd name="connsiteY99" fmla="*/ 842883 h 6105653"/>
              <a:gd name="connsiteX100" fmla="*/ 3109911 w 12191999"/>
              <a:gd name="connsiteY100" fmla="*/ 1017331 h 6105653"/>
              <a:gd name="connsiteX101" fmla="*/ 3077765 w 12191999"/>
              <a:gd name="connsiteY101" fmla="*/ 1162704 h 6105653"/>
              <a:gd name="connsiteX102" fmla="*/ 3117055 w 12191999"/>
              <a:gd name="connsiteY102" fmla="*/ 1319707 h 6105653"/>
              <a:gd name="connsiteX103" fmla="*/ 3099196 w 12191999"/>
              <a:gd name="connsiteY103" fmla="*/ 1459264 h 6105653"/>
              <a:gd name="connsiteX104" fmla="*/ 3124198 w 12191999"/>
              <a:gd name="connsiteY104" fmla="*/ 1578470 h 6105653"/>
              <a:gd name="connsiteX105" fmla="*/ 3242071 w 12191999"/>
              <a:gd name="connsiteY105" fmla="*/ 1462171 h 6105653"/>
              <a:gd name="connsiteX106" fmla="*/ 3242071 w 12191999"/>
              <a:gd name="connsiteY106" fmla="*/ 1299354 h 6105653"/>
              <a:gd name="connsiteX107" fmla="*/ 3317080 w 12191999"/>
              <a:gd name="connsiteY107" fmla="*/ 1183056 h 6105653"/>
              <a:gd name="connsiteX108" fmla="*/ 3452811 w 12191999"/>
              <a:gd name="connsiteY108" fmla="*/ 1072572 h 6105653"/>
              <a:gd name="connsiteX109" fmla="*/ 3670696 w 12191999"/>
              <a:gd name="connsiteY109" fmla="*/ 682973 h 6105653"/>
              <a:gd name="connsiteX110" fmla="*/ 3752849 w 12191999"/>
              <a:gd name="connsiteY110" fmla="*/ 613194 h 6105653"/>
              <a:gd name="connsiteX111" fmla="*/ 3434952 w 12191999"/>
              <a:gd name="connsiteY111" fmla="*/ 1723843 h 6105653"/>
              <a:gd name="connsiteX112" fmla="*/ 3567111 w 12191999"/>
              <a:gd name="connsiteY112" fmla="*/ 1380763 h 6105653"/>
              <a:gd name="connsiteX113" fmla="*/ 3542109 w 12191999"/>
              <a:gd name="connsiteY113" fmla="*/ 1613360 h 6105653"/>
              <a:gd name="connsiteX114" fmla="*/ 3631405 w 12191999"/>
              <a:gd name="connsiteY114" fmla="*/ 1741287 h 6105653"/>
              <a:gd name="connsiteX115" fmla="*/ 3659980 w 12191999"/>
              <a:gd name="connsiteY115" fmla="*/ 1741287 h 6105653"/>
              <a:gd name="connsiteX116" fmla="*/ 3742133 w 12191999"/>
              <a:gd name="connsiteY116" fmla="*/ 1645341 h 6105653"/>
              <a:gd name="connsiteX117" fmla="*/ 3795712 w 12191999"/>
              <a:gd name="connsiteY117" fmla="*/ 1590100 h 6105653"/>
              <a:gd name="connsiteX118" fmla="*/ 3988593 w 12191999"/>
              <a:gd name="connsiteY118" fmla="*/ 1438912 h 6105653"/>
              <a:gd name="connsiteX119" fmla="*/ 4010024 w 12191999"/>
              <a:gd name="connsiteY119" fmla="*/ 1546488 h 6105653"/>
              <a:gd name="connsiteX120" fmla="*/ 4049315 w 12191999"/>
              <a:gd name="connsiteY120" fmla="*/ 1587192 h 6105653"/>
              <a:gd name="connsiteX121" fmla="*/ 4106465 w 12191999"/>
              <a:gd name="connsiteY121" fmla="*/ 1558118 h 6105653"/>
              <a:gd name="connsiteX122" fmla="*/ 4281487 w 12191999"/>
              <a:gd name="connsiteY122" fmla="*/ 1223760 h 6105653"/>
              <a:gd name="connsiteX123" fmla="*/ 4417219 w 12191999"/>
              <a:gd name="connsiteY123" fmla="*/ 1197593 h 6105653"/>
              <a:gd name="connsiteX124" fmla="*/ 4438649 w 12191999"/>
              <a:gd name="connsiteY124" fmla="*/ 1261557 h 6105653"/>
              <a:gd name="connsiteX125" fmla="*/ 4427935 w 12191999"/>
              <a:gd name="connsiteY125" fmla="*/ 1334243 h 6105653"/>
              <a:gd name="connsiteX126" fmla="*/ 4535090 w 12191999"/>
              <a:gd name="connsiteY126" fmla="*/ 1276094 h 6105653"/>
              <a:gd name="connsiteX127" fmla="*/ 4642246 w 12191999"/>
              <a:gd name="connsiteY127" fmla="*/ 1040590 h 6105653"/>
              <a:gd name="connsiteX128" fmla="*/ 4699396 w 12191999"/>
              <a:gd name="connsiteY128" fmla="*/ 996979 h 6105653"/>
              <a:gd name="connsiteX129" fmla="*/ 4727971 w 12191999"/>
              <a:gd name="connsiteY129" fmla="*/ 1055128 h 6105653"/>
              <a:gd name="connsiteX130" fmla="*/ 4738688 w 12191999"/>
              <a:gd name="connsiteY130" fmla="*/ 1098740 h 6105653"/>
              <a:gd name="connsiteX131" fmla="*/ 5185172 w 12191999"/>
              <a:gd name="connsiteY131" fmla="*/ 197429 h 6105653"/>
              <a:gd name="connsiteX132" fmla="*/ 5188744 w 12191999"/>
              <a:gd name="connsiteY132" fmla="*/ 400950 h 6105653"/>
              <a:gd name="connsiteX133" fmla="*/ 5117306 w 12191999"/>
              <a:gd name="connsiteY133" fmla="*/ 601565 h 6105653"/>
              <a:gd name="connsiteX134" fmla="*/ 5128021 w 12191999"/>
              <a:gd name="connsiteY134" fmla="*/ 813809 h 6105653"/>
              <a:gd name="connsiteX135" fmla="*/ 5092302 w 12191999"/>
              <a:gd name="connsiteY135" fmla="*/ 1014423 h 6105653"/>
              <a:gd name="connsiteX136" fmla="*/ 5092302 w 12191999"/>
              <a:gd name="connsiteY136" fmla="*/ 1188871 h 6105653"/>
              <a:gd name="connsiteX137" fmla="*/ 5145880 w 12191999"/>
              <a:gd name="connsiteY137" fmla="*/ 1026053 h 6105653"/>
              <a:gd name="connsiteX138" fmla="*/ 5235177 w 12191999"/>
              <a:gd name="connsiteY138" fmla="*/ 964997 h 6105653"/>
              <a:gd name="connsiteX139" fmla="*/ 5317331 w 12191999"/>
              <a:gd name="connsiteY139" fmla="*/ 985349 h 6105653"/>
              <a:gd name="connsiteX140" fmla="*/ 5292327 w 12191999"/>
              <a:gd name="connsiteY140" fmla="*/ 1052221 h 6105653"/>
              <a:gd name="connsiteX141" fmla="*/ 5199458 w 12191999"/>
              <a:gd name="connsiteY141" fmla="*/ 1130722 h 6105653"/>
              <a:gd name="connsiteX142" fmla="*/ 5256608 w 12191999"/>
              <a:gd name="connsiteY142" fmla="*/ 1148166 h 6105653"/>
              <a:gd name="connsiteX143" fmla="*/ 5299471 w 12191999"/>
              <a:gd name="connsiteY143" fmla="*/ 1194686 h 6105653"/>
              <a:gd name="connsiteX144" fmla="*/ 5278039 w 12191999"/>
              <a:gd name="connsiteY144" fmla="*/ 1462171 h 6105653"/>
              <a:gd name="connsiteX145" fmla="*/ 5460205 w 12191999"/>
              <a:gd name="connsiteY145" fmla="*/ 1284817 h 6105653"/>
              <a:gd name="connsiteX146" fmla="*/ 5488780 w 12191999"/>
              <a:gd name="connsiteY146" fmla="*/ 1171426 h 6105653"/>
              <a:gd name="connsiteX147" fmla="*/ 5539513 w 12191999"/>
              <a:gd name="connsiteY147" fmla="*/ 1140353 h 6105653"/>
              <a:gd name="connsiteX148" fmla="*/ 5552720 w 12191999"/>
              <a:gd name="connsiteY148" fmla="*/ 1143022 h 6105653"/>
              <a:gd name="connsiteX149" fmla="*/ 5574208 w 12191999"/>
              <a:gd name="connsiteY149" fmla="*/ 1115811 h 6105653"/>
              <a:gd name="connsiteX150" fmla="*/ 5734050 w 12191999"/>
              <a:gd name="connsiteY150" fmla="*/ 1075470 h 6105653"/>
              <a:gd name="connsiteX151" fmla="*/ 5798343 w 12191999"/>
              <a:gd name="connsiteY151" fmla="*/ 1020228 h 6105653"/>
              <a:gd name="connsiteX152" fmla="*/ 5884068 w 12191999"/>
              <a:gd name="connsiteY152" fmla="*/ 883578 h 6105653"/>
              <a:gd name="connsiteX153" fmla="*/ 6066234 w 12191999"/>
              <a:gd name="connsiteY153" fmla="*/ 645166 h 6105653"/>
              <a:gd name="connsiteX154" fmla="*/ 6109096 w 12191999"/>
              <a:gd name="connsiteY154" fmla="*/ 732391 h 6105653"/>
              <a:gd name="connsiteX155" fmla="*/ 5998368 w 12191999"/>
              <a:gd name="connsiteY155" fmla="*/ 985338 h 6105653"/>
              <a:gd name="connsiteX156" fmla="*/ 5969793 w 12191999"/>
              <a:gd name="connsiteY156" fmla="*/ 1168509 h 6105653"/>
              <a:gd name="connsiteX157" fmla="*/ 6162674 w 12191999"/>
              <a:gd name="connsiteY157" fmla="*/ 909745 h 6105653"/>
              <a:gd name="connsiteX158" fmla="*/ 6412705 w 12191999"/>
              <a:gd name="connsiteY158" fmla="*/ 659704 h 6105653"/>
              <a:gd name="connsiteX159" fmla="*/ 6366271 w 12191999"/>
              <a:gd name="connsiteY159" fmla="*/ 851596 h 6105653"/>
              <a:gd name="connsiteX160" fmla="*/ 6398418 w 12191999"/>
              <a:gd name="connsiteY160" fmla="*/ 860319 h 6105653"/>
              <a:gd name="connsiteX161" fmla="*/ 6694884 w 12191999"/>
              <a:gd name="connsiteY161" fmla="*/ 691686 h 6105653"/>
              <a:gd name="connsiteX162" fmla="*/ 6816327 w 12191999"/>
              <a:gd name="connsiteY162" fmla="*/ 610277 h 6105653"/>
              <a:gd name="connsiteX163" fmla="*/ 7177087 w 12191999"/>
              <a:gd name="connsiteY163" fmla="*/ 238123 h 6105653"/>
              <a:gd name="connsiteX164" fmla="*/ 7016353 w 12191999"/>
              <a:gd name="connsiteY164" fmla="*/ 592833 h 6105653"/>
              <a:gd name="connsiteX165" fmla="*/ 7366396 w 12191999"/>
              <a:gd name="connsiteY165" fmla="*/ 226493 h 6105653"/>
              <a:gd name="connsiteX166" fmla="*/ 7494984 w 12191999"/>
              <a:gd name="connsiteY166" fmla="*/ 49138 h 6105653"/>
              <a:gd name="connsiteX167" fmla="*/ 7538181 w 12191999"/>
              <a:gd name="connsiteY167" fmla="*/ 484 h 610565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Lst>
            <a:rect l="l" t="t" r="r" b="b"/>
            <a:pathLst>
              <a:path w="12191999" h="6105653">
                <a:moveTo>
                  <a:pt x="7538181" y="484"/>
                </a:moveTo>
                <a:cubicBezTo>
                  <a:pt x="7546999" y="-833"/>
                  <a:pt x="7557492" y="439"/>
                  <a:pt x="7569993" y="5527"/>
                </a:cubicBezTo>
                <a:cubicBezTo>
                  <a:pt x="7612855" y="22971"/>
                  <a:pt x="7598567" y="54953"/>
                  <a:pt x="7587853" y="84028"/>
                </a:cubicBezTo>
                <a:cubicBezTo>
                  <a:pt x="7559278" y="153806"/>
                  <a:pt x="7559278" y="229401"/>
                  <a:pt x="7559278" y="325347"/>
                </a:cubicBezTo>
                <a:cubicBezTo>
                  <a:pt x="7695009" y="243938"/>
                  <a:pt x="7652146" y="95658"/>
                  <a:pt x="7795021" y="25878"/>
                </a:cubicBezTo>
                <a:cubicBezTo>
                  <a:pt x="7820024" y="113102"/>
                  <a:pt x="7770018" y="179974"/>
                  <a:pt x="7759302" y="249752"/>
                </a:cubicBezTo>
                <a:cubicBezTo>
                  <a:pt x="7748587" y="313717"/>
                  <a:pt x="7773590" y="328254"/>
                  <a:pt x="7852171" y="313717"/>
                </a:cubicBezTo>
                <a:cubicBezTo>
                  <a:pt x="7973615" y="290457"/>
                  <a:pt x="8034337" y="325347"/>
                  <a:pt x="8002190" y="418385"/>
                </a:cubicBezTo>
                <a:cubicBezTo>
                  <a:pt x="7970043" y="505609"/>
                  <a:pt x="8016478" y="514331"/>
                  <a:pt x="8084343" y="491072"/>
                </a:cubicBezTo>
                <a:cubicBezTo>
                  <a:pt x="8184355" y="456182"/>
                  <a:pt x="8262937" y="493979"/>
                  <a:pt x="8348662" y="520146"/>
                </a:cubicBezTo>
                <a:cubicBezTo>
                  <a:pt x="8477249" y="560851"/>
                  <a:pt x="8541543" y="543406"/>
                  <a:pt x="8637984" y="459090"/>
                </a:cubicBezTo>
                <a:cubicBezTo>
                  <a:pt x="8691561" y="409663"/>
                  <a:pt x="8737996" y="360236"/>
                  <a:pt x="8784431" y="290457"/>
                </a:cubicBezTo>
                <a:cubicBezTo>
                  <a:pt x="8809434" y="450367"/>
                  <a:pt x="8895158" y="284642"/>
                  <a:pt x="8948737" y="339884"/>
                </a:cubicBezTo>
                <a:cubicBezTo>
                  <a:pt x="8970168" y="453274"/>
                  <a:pt x="8798717" y="543406"/>
                  <a:pt x="8848725" y="697501"/>
                </a:cubicBezTo>
                <a:cubicBezTo>
                  <a:pt x="8995171" y="511424"/>
                  <a:pt x="9041606" y="302087"/>
                  <a:pt x="9238059" y="165437"/>
                </a:cubicBezTo>
                <a:cubicBezTo>
                  <a:pt x="9280921" y="197419"/>
                  <a:pt x="9238059" y="229401"/>
                  <a:pt x="9255919" y="255567"/>
                </a:cubicBezTo>
                <a:cubicBezTo>
                  <a:pt x="9266634" y="255567"/>
                  <a:pt x="9198767" y="560851"/>
                  <a:pt x="9477374" y="578295"/>
                </a:cubicBezTo>
                <a:cubicBezTo>
                  <a:pt x="9477374" y="584110"/>
                  <a:pt x="9477374" y="589925"/>
                  <a:pt x="9488091" y="595740"/>
                </a:cubicBezTo>
                <a:cubicBezTo>
                  <a:pt x="9527380" y="627722"/>
                  <a:pt x="9620249" y="598648"/>
                  <a:pt x="9627393" y="650981"/>
                </a:cubicBezTo>
                <a:cubicBezTo>
                  <a:pt x="9634537" y="709131"/>
                  <a:pt x="9666684" y="764373"/>
                  <a:pt x="9648824" y="825429"/>
                </a:cubicBezTo>
                <a:cubicBezTo>
                  <a:pt x="9634537" y="871948"/>
                  <a:pt x="9616678" y="921374"/>
                  <a:pt x="9616678" y="970802"/>
                </a:cubicBezTo>
                <a:cubicBezTo>
                  <a:pt x="9616678" y="1023136"/>
                  <a:pt x="9495233" y="1095822"/>
                  <a:pt x="9655968" y="1127805"/>
                </a:cubicBezTo>
                <a:cubicBezTo>
                  <a:pt x="9663111" y="1127805"/>
                  <a:pt x="9645252" y="1217935"/>
                  <a:pt x="9638109" y="1267362"/>
                </a:cubicBezTo>
                <a:cubicBezTo>
                  <a:pt x="9630965" y="1308066"/>
                  <a:pt x="9598818" y="1357494"/>
                  <a:pt x="9663111" y="1386568"/>
                </a:cubicBezTo>
                <a:cubicBezTo>
                  <a:pt x="9702403" y="1401105"/>
                  <a:pt x="9773840" y="1331326"/>
                  <a:pt x="9780984" y="1270269"/>
                </a:cubicBezTo>
                <a:cubicBezTo>
                  <a:pt x="9788127" y="1215028"/>
                  <a:pt x="9795271" y="1159787"/>
                  <a:pt x="9780984" y="1107452"/>
                </a:cubicBezTo>
                <a:cubicBezTo>
                  <a:pt x="9763125" y="1043488"/>
                  <a:pt x="9791699" y="1008598"/>
                  <a:pt x="9855993" y="991154"/>
                </a:cubicBezTo>
                <a:cubicBezTo>
                  <a:pt x="9923858" y="970802"/>
                  <a:pt x="9959577" y="933005"/>
                  <a:pt x="9991724" y="880670"/>
                </a:cubicBezTo>
                <a:cubicBezTo>
                  <a:pt x="10070305" y="752742"/>
                  <a:pt x="10163174" y="630630"/>
                  <a:pt x="10209609" y="491071"/>
                </a:cubicBezTo>
                <a:cubicBezTo>
                  <a:pt x="10216753" y="464905"/>
                  <a:pt x="10231040" y="432923"/>
                  <a:pt x="10291762" y="421292"/>
                </a:cubicBezTo>
                <a:cubicBezTo>
                  <a:pt x="10198893" y="799262"/>
                  <a:pt x="9959577" y="1142341"/>
                  <a:pt x="9973865" y="1531941"/>
                </a:cubicBezTo>
                <a:cubicBezTo>
                  <a:pt x="10048874" y="1427272"/>
                  <a:pt x="10052446" y="1302252"/>
                  <a:pt x="10106024" y="1188861"/>
                </a:cubicBezTo>
                <a:cubicBezTo>
                  <a:pt x="10145315" y="1270269"/>
                  <a:pt x="10102453" y="1345863"/>
                  <a:pt x="10081022" y="1421458"/>
                </a:cubicBezTo>
                <a:cubicBezTo>
                  <a:pt x="10063162" y="1485421"/>
                  <a:pt x="10059590" y="1543570"/>
                  <a:pt x="10170318" y="1549385"/>
                </a:cubicBezTo>
                <a:cubicBezTo>
                  <a:pt x="10181034" y="1549385"/>
                  <a:pt x="10188178" y="1549385"/>
                  <a:pt x="10198893" y="1549385"/>
                </a:cubicBezTo>
                <a:cubicBezTo>
                  <a:pt x="10245327" y="1526126"/>
                  <a:pt x="10266759" y="1494144"/>
                  <a:pt x="10281046" y="1453439"/>
                </a:cubicBezTo>
                <a:cubicBezTo>
                  <a:pt x="10288190" y="1430180"/>
                  <a:pt x="10302477" y="1398198"/>
                  <a:pt x="10334625" y="1398198"/>
                </a:cubicBezTo>
                <a:cubicBezTo>
                  <a:pt x="10456068" y="1401105"/>
                  <a:pt x="10491787" y="1322604"/>
                  <a:pt x="10527506" y="1247010"/>
                </a:cubicBezTo>
                <a:cubicBezTo>
                  <a:pt x="10588228" y="1287714"/>
                  <a:pt x="10545365" y="1322604"/>
                  <a:pt x="10548937" y="1354586"/>
                </a:cubicBezTo>
                <a:cubicBezTo>
                  <a:pt x="10552509" y="1374938"/>
                  <a:pt x="10556080" y="1395290"/>
                  <a:pt x="10588228" y="1395290"/>
                </a:cubicBezTo>
                <a:cubicBezTo>
                  <a:pt x="10613230" y="1395290"/>
                  <a:pt x="10645378" y="1386568"/>
                  <a:pt x="10645378" y="1366216"/>
                </a:cubicBezTo>
                <a:cubicBezTo>
                  <a:pt x="10648949" y="1238288"/>
                  <a:pt x="10820400" y="1165601"/>
                  <a:pt x="10820400" y="1031858"/>
                </a:cubicBezTo>
                <a:cubicBezTo>
                  <a:pt x="10820400" y="950449"/>
                  <a:pt x="10916840" y="1072563"/>
                  <a:pt x="10956131" y="1005691"/>
                </a:cubicBezTo>
                <a:cubicBezTo>
                  <a:pt x="10966847" y="991154"/>
                  <a:pt x="10981133" y="1046395"/>
                  <a:pt x="10977562" y="1069655"/>
                </a:cubicBezTo>
                <a:cubicBezTo>
                  <a:pt x="10973991" y="1092915"/>
                  <a:pt x="10948987" y="1113267"/>
                  <a:pt x="10966847" y="1142341"/>
                </a:cubicBezTo>
                <a:cubicBezTo>
                  <a:pt x="11031140" y="1156879"/>
                  <a:pt x="11056143" y="1119081"/>
                  <a:pt x="11074003" y="1084192"/>
                </a:cubicBezTo>
                <a:cubicBezTo>
                  <a:pt x="11116865" y="1008598"/>
                  <a:pt x="11166871" y="933005"/>
                  <a:pt x="11181159" y="848688"/>
                </a:cubicBezTo>
                <a:cubicBezTo>
                  <a:pt x="11184730" y="819614"/>
                  <a:pt x="11202590" y="802169"/>
                  <a:pt x="11238309" y="805077"/>
                </a:cubicBezTo>
                <a:cubicBezTo>
                  <a:pt x="11284744" y="810891"/>
                  <a:pt x="11270456" y="839966"/>
                  <a:pt x="11266884" y="863226"/>
                </a:cubicBezTo>
                <a:cubicBezTo>
                  <a:pt x="11263312" y="877763"/>
                  <a:pt x="11252596" y="892300"/>
                  <a:pt x="11277600" y="906838"/>
                </a:cubicBezTo>
                <a:cubicBezTo>
                  <a:pt x="11531203" y="566666"/>
                  <a:pt x="11516915" y="386403"/>
                  <a:pt x="11724084" y="5527"/>
                </a:cubicBezTo>
                <a:cubicBezTo>
                  <a:pt x="11763375" y="89842"/>
                  <a:pt x="11734800" y="150899"/>
                  <a:pt x="11727656" y="209048"/>
                </a:cubicBezTo>
                <a:cubicBezTo>
                  <a:pt x="11709796" y="354421"/>
                  <a:pt x="11677649" y="264290"/>
                  <a:pt x="11656218" y="409663"/>
                </a:cubicBezTo>
                <a:cubicBezTo>
                  <a:pt x="11645503" y="479442"/>
                  <a:pt x="11609784" y="543406"/>
                  <a:pt x="11666934" y="621907"/>
                </a:cubicBezTo>
                <a:cubicBezTo>
                  <a:pt x="11706225" y="674241"/>
                  <a:pt x="11663362" y="758557"/>
                  <a:pt x="11631215" y="822521"/>
                </a:cubicBezTo>
                <a:cubicBezTo>
                  <a:pt x="11602640" y="874856"/>
                  <a:pt x="11595497" y="927190"/>
                  <a:pt x="11631215" y="996969"/>
                </a:cubicBezTo>
                <a:cubicBezTo>
                  <a:pt x="11652646" y="933005"/>
                  <a:pt x="11670505" y="883578"/>
                  <a:pt x="11684793" y="834151"/>
                </a:cubicBezTo>
                <a:cubicBezTo>
                  <a:pt x="11695509" y="793447"/>
                  <a:pt x="11720512" y="770187"/>
                  <a:pt x="11774090" y="773095"/>
                </a:cubicBezTo>
                <a:cubicBezTo>
                  <a:pt x="11802665" y="773095"/>
                  <a:pt x="11841956" y="764373"/>
                  <a:pt x="11856243" y="793447"/>
                </a:cubicBezTo>
                <a:cubicBezTo>
                  <a:pt x="11870531" y="816706"/>
                  <a:pt x="11856243" y="848688"/>
                  <a:pt x="11831240" y="860319"/>
                </a:cubicBezTo>
                <a:cubicBezTo>
                  <a:pt x="11784806" y="874856"/>
                  <a:pt x="11741944" y="889393"/>
                  <a:pt x="11738371" y="938820"/>
                </a:cubicBezTo>
                <a:cubicBezTo>
                  <a:pt x="11731228" y="1005691"/>
                  <a:pt x="11759802" y="967894"/>
                  <a:pt x="11795521" y="956264"/>
                </a:cubicBezTo>
                <a:cubicBezTo>
                  <a:pt x="11834812" y="944634"/>
                  <a:pt x="11845527" y="979524"/>
                  <a:pt x="11838384" y="1002784"/>
                </a:cubicBezTo>
                <a:cubicBezTo>
                  <a:pt x="11806237" y="1090007"/>
                  <a:pt x="11863387" y="1180138"/>
                  <a:pt x="11816952" y="1270269"/>
                </a:cubicBezTo>
                <a:cubicBezTo>
                  <a:pt x="11931252" y="1247010"/>
                  <a:pt x="11981259" y="1197583"/>
                  <a:pt x="11999118" y="1092915"/>
                </a:cubicBezTo>
                <a:cubicBezTo>
                  <a:pt x="12002690" y="1055118"/>
                  <a:pt x="11995547" y="1014413"/>
                  <a:pt x="12027693" y="979524"/>
                </a:cubicBezTo>
                <a:cubicBezTo>
                  <a:pt x="12045553" y="959172"/>
                  <a:pt x="12066984" y="938820"/>
                  <a:pt x="12102703" y="953357"/>
                </a:cubicBezTo>
                <a:cubicBezTo>
                  <a:pt x="12127705" y="962080"/>
                  <a:pt x="12127705" y="985338"/>
                  <a:pt x="12120562" y="1005691"/>
                </a:cubicBezTo>
                <a:cubicBezTo>
                  <a:pt x="12081272" y="1090007"/>
                  <a:pt x="12070555" y="1180138"/>
                  <a:pt x="12056268" y="1267362"/>
                </a:cubicBezTo>
                <a:cubicBezTo>
                  <a:pt x="12052697" y="1281899"/>
                  <a:pt x="12045553" y="1296437"/>
                  <a:pt x="12081272" y="1310974"/>
                </a:cubicBezTo>
                <a:cubicBezTo>
                  <a:pt x="12113418" y="1209213"/>
                  <a:pt x="12156280" y="1110359"/>
                  <a:pt x="12191999" y="1008598"/>
                </a:cubicBezTo>
                <a:lnTo>
                  <a:pt x="12191999" y="6105653"/>
                </a:lnTo>
                <a:lnTo>
                  <a:pt x="0" y="6105653"/>
                </a:lnTo>
                <a:lnTo>
                  <a:pt x="0" y="927116"/>
                </a:lnTo>
                <a:lnTo>
                  <a:pt x="61930" y="902578"/>
                </a:lnTo>
                <a:cubicBezTo>
                  <a:pt x="91454" y="894128"/>
                  <a:pt x="122931" y="887949"/>
                  <a:pt x="155971" y="883588"/>
                </a:cubicBezTo>
                <a:cubicBezTo>
                  <a:pt x="223837" y="877773"/>
                  <a:pt x="245268" y="839976"/>
                  <a:pt x="277414" y="802179"/>
                </a:cubicBezTo>
                <a:cubicBezTo>
                  <a:pt x="388143" y="674251"/>
                  <a:pt x="488155" y="537601"/>
                  <a:pt x="638174" y="430025"/>
                </a:cubicBezTo>
                <a:cubicBezTo>
                  <a:pt x="620315" y="555046"/>
                  <a:pt x="520302" y="653899"/>
                  <a:pt x="477440" y="784735"/>
                </a:cubicBezTo>
                <a:cubicBezTo>
                  <a:pt x="641746" y="680066"/>
                  <a:pt x="727471" y="543415"/>
                  <a:pt x="827483" y="418395"/>
                </a:cubicBezTo>
                <a:cubicBezTo>
                  <a:pt x="873917" y="360246"/>
                  <a:pt x="931068" y="307912"/>
                  <a:pt x="956071" y="241040"/>
                </a:cubicBezTo>
                <a:cubicBezTo>
                  <a:pt x="961429" y="223595"/>
                  <a:pt x="972814" y="196338"/>
                  <a:pt x="999268" y="192386"/>
                </a:cubicBezTo>
                <a:cubicBezTo>
                  <a:pt x="1008086" y="191069"/>
                  <a:pt x="1018579" y="192341"/>
                  <a:pt x="1031080" y="197429"/>
                </a:cubicBezTo>
                <a:cubicBezTo>
                  <a:pt x="1073942" y="214873"/>
                  <a:pt x="1059654" y="246855"/>
                  <a:pt x="1048940" y="275930"/>
                </a:cubicBezTo>
                <a:cubicBezTo>
                  <a:pt x="1020365" y="345708"/>
                  <a:pt x="1020365" y="421303"/>
                  <a:pt x="1020365" y="517249"/>
                </a:cubicBezTo>
                <a:cubicBezTo>
                  <a:pt x="1156096" y="435840"/>
                  <a:pt x="1113233" y="287560"/>
                  <a:pt x="1256108" y="217780"/>
                </a:cubicBezTo>
                <a:cubicBezTo>
                  <a:pt x="1281111" y="305004"/>
                  <a:pt x="1231105" y="371876"/>
                  <a:pt x="1220389" y="441654"/>
                </a:cubicBezTo>
                <a:cubicBezTo>
                  <a:pt x="1209674" y="505619"/>
                  <a:pt x="1234677" y="520156"/>
                  <a:pt x="1313258" y="505619"/>
                </a:cubicBezTo>
                <a:cubicBezTo>
                  <a:pt x="1434702" y="482359"/>
                  <a:pt x="1495424" y="517249"/>
                  <a:pt x="1463277" y="610287"/>
                </a:cubicBezTo>
                <a:cubicBezTo>
                  <a:pt x="1431130" y="697511"/>
                  <a:pt x="1477565" y="706233"/>
                  <a:pt x="1545430" y="682974"/>
                </a:cubicBezTo>
                <a:cubicBezTo>
                  <a:pt x="1645442" y="648084"/>
                  <a:pt x="1724024" y="685881"/>
                  <a:pt x="1809749" y="712048"/>
                </a:cubicBezTo>
                <a:cubicBezTo>
                  <a:pt x="1938336" y="752753"/>
                  <a:pt x="2002630" y="735308"/>
                  <a:pt x="2099071" y="650992"/>
                </a:cubicBezTo>
                <a:cubicBezTo>
                  <a:pt x="2152648" y="601565"/>
                  <a:pt x="2199083" y="552138"/>
                  <a:pt x="2245518" y="482359"/>
                </a:cubicBezTo>
                <a:cubicBezTo>
                  <a:pt x="2270521" y="642269"/>
                  <a:pt x="2356245" y="476544"/>
                  <a:pt x="2409824" y="531786"/>
                </a:cubicBezTo>
                <a:cubicBezTo>
                  <a:pt x="2431255" y="645176"/>
                  <a:pt x="2259804" y="735308"/>
                  <a:pt x="2309812" y="889403"/>
                </a:cubicBezTo>
                <a:cubicBezTo>
                  <a:pt x="2456258" y="703326"/>
                  <a:pt x="2502693" y="493989"/>
                  <a:pt x="2699146" y="357339"/>
                </a:cubicBezTo>
                <a:cubicBezTo>
                  <a:pt x="2742008" y="389321"/>
                  <a:pt x="2699146" y="421303"/>
                  <a:pt x="2717006" y="447469"/>
                </a:cubicBezTo>
                <a:cubicBezTo>
                  <a:pt x="2727721" y="447469"/>
                  <a:pt x="2659854" y="752753"/>
                  <a:pt x="2938461" y="770197"/>
                </a:cubicBezTo>
                <a:cubicBezTo>
                  <a:pt x="2938461" y="776012"/>
                  <a:pt x="2938461" y="781827"/>
                  <a:pt x="2949178" y="787642"/>
                </a:cubicBezTo>
                <a:cubicBezTo>
                  <a:pt x="2988467" y="819624"/>
                  <a:pt x="3081336" y="790550"/>
                  <a:pt x="3088480" y="842883"/>
                </a:cubicBezTo>
                <a:cubicBezTo>
                  <a:pt x="3095624" y="901033"/>
                  <a:pt x="3127771" y="956275"/>
                  <a:pt x="3109911" y="1017331"/>
                </a:cubicBezTo>
                <a:cubicBezTo>
                  <a:pt x="3095624" y="1063850"/>
                  <a:pt x="3077765" y="1113276"/>
                  <a:pt x="3077765" y="1162704"/>
                </a:cubicBezTo>
                <a:cubicBezTo>
                  <a:pt x="3077765" y="1215038"/>
                  <a:pt x="2956320" y="1287724"/>
                  <a:pt x="3117055" y="1319707"/>
                </a:cubicBezTo>
                <a:cubicBezTo>
                  <a:pt x="3124198" y="1319707"/>
                  <a:pt x="3106339" y="1409837"/>
                  <a:pt x="3099196" y="1459264"/>
                </a:cubicBezTo>
                <a:cubicBezTo>
                  <a:pt x="3092052" y="1499968"/>
                  <a:pt x="3059905" y="1549396"/>
                  <a:pt x="3124198" y="1578470"/>
                </a:cubicBezTo>
                <a:cubicBezTo>
                  <a:pt x="3163490" y="1593007"/>
                  <a:pt x="3234927" y="1523228"/>
                  <a:pt x="3242071" y="1462171"/>
                </a:cubicBezTo>
                <a:cubicBezTo>
                  <a:pt x="3249214" y="1406930"/>
                  <a:pt x="3256358" y="1351689"/>
                  <a:pt x="3242071" y="1299354"/>
                </a:cubicBezTo>
                <a:cubicBezTo>
                  <a:pt x="3224212" y="1235390"/>
                  <a:pt x="3252786" y="1200500"/>
                  <a:pt x="3317080" y="1183056"/>
                </a:cubicBezTo>
                <a:cubicBezTo>
                  <a:pt x="3384945" y="1162704"/>
                  <a:pt x="3420664" y="1124907"/>
                  <a:pt x="3452811" y="1072572"/>
                </a:cubicBezTo>
                <a:cubicBezTo>
                  <a:pt x="3531392" y="944644"/>
                  <a:pt x="3624261" y="822532"/>
                  <a:pt x="3670696" y="682973"/>
                </a:cubicBezTo>
                <a:cubicBezTo>
                  <a:pt x="3677840" y="656807"/>
                  <a:pt x="3692127" y="624825"/>
                  <a:pt x="3752849" y="613194"/>
                </a:cubicBezTo>
                <a:cubicBezTo>
                  <a:pt x="3659980" y="991164"/>
                  <a:pt x="3420664" y="1334243"/>
                  <a:pt x="3434952" y="1723843"/>
                </a:cubicBezTo>
                <a:cubicBezTo>
                  <a:pt x="3509961" y="1619174"/>
                  <a:pt x="3513533" y="1494154"/>
                  <a:pt x="3567111" y="1380763"/>
                </a:cubicBezTo>
                <a:cubicBezTo>
                  <a:pt x="3606402" y="1462171"/>
                  <a:pt x="3563540" y="1537765"/>
                  <a:pt x="3542109" y="1613360"/>
                </a:cubicBezTo>
                <a:cubicBezTo>
                  <a:pt x="3524249" y="1677323"/>
                  <a:pt x="3520677" y="1735472"/>
                  <a:pt x="3631405" y="1741287"/>
                </a:cubicBezTo>
                <a:cubicBezTo>
                  <a:pt x="3642121" y="1741287"/>
                  <a:pt x="3649265" y="1741287"/>
                  <a:pt x="3659980" y="1741287"/>
                </a:cubicBezTo>
                <a:cubicBezTo>
                  <a:pt x="3706414" y="1718028"/>
                  <a:pt x="3727846" y="1686046"/>
                  <a:pt x="3742133" y="1645341"/>
                </a:cubicBezTo>
                <a:cubicBezTo>
                  <a:pt x="3749277" y="1622082"/>
                  <a:pt x="3763564" y="1590100"/>
                  <a:pt x="3795712" y="1590100"/>
                </a:cubicBezTo>
                <a:cubicBezTo>
                  <a:pt x="3917155" y="1593007"/>
                  <a:pt x="3952874" y="1514506"/>
                  <a:pt x="3988593" y="1438912"/>
                </a:cubicBezTo>
                <a:cubicBezTo>
                  <a:pt x="4049315" y="1479616"/>
                  <a:pt x="4006452" y="1514506"/>
                  <a:pt x="4010024" y="1546488"/>
                </a:cubicBezTo>
                <a:cubicBezTo>
                  <a:pt x="4013596" y="1566840"/>
                  <a:pt x="4017167" y="1587192"/>
                  <a:pt x="4049315" y="1587192"/>
                </a:cubicBezTo>
                <a:cubicBezTo>
                  <a:pt x="4074317" y="1587192"/>
                  <a:pt x="4106465" y="1578470"/>
                  <a:pt x="4106465" y="1558118"/>
                </a:cubicBezTo>
                <a:cubicBezTo>
                  <a:pt x="4110036" y="1430190"/>
                  <a:pt x="4281487" y="1357503"/>
                  <a:pt x="4281487" y="1223760"/>
                </a:cubicBezTo>
                <a:cubicBezTo>
                  <a:pt x="4281487" y="1142351"/>
                  <a:pt x="4377927" y="1264465"/>
                  <a:pt x="4417219" y="1197593"/>
                </a:cubicBezTo>
                <a:cubicBezTo>
                  <a:pt x="4427935" y="1183056"/>
                  <a:pt x="4442220" y="1238297"/>
                  <a:pt x="4438649" y="1261557"/>
                </a:cubicBezTo>
                <a:cubicBezTo>
                  <a:pt x="4435078" y="1284817"/>
                  <a:pt x="4410074" y="1305169"/>
                  <a:pt x="4427935" y="1334243"/>
                </a:cubicBezTo>
                <a:cubicBezTo>
                  <a:pt x="4492228" y="1348781"/>
                  <a:pt x="4517230" y="1310983"/>
                  <a:pt x="4535090" y="1276094"/>
                </a:cubicBezTo>
                <a:cubicBezTo>
                  <a:pt x="4577952" y="1200500"/>
                  <a:pt x="4627958" y="1124907"/>
                  <a:pt x="4642246" y="1040590"/>
                </a:cubicBezTo>
                <a:cubicBezTo>
                  <a:pt x="4645817" y="1011516"/>
                  <a:pt x="4663677" y="994071"/>
                  <a:pt x="4699396" y="996979"/>
                </a:cubicBezTo>
                <a:cubicBezTo>
                  <a:pt x="4745832" y="1002793"/>
                  <a:pt x="4731544" y="1031868"/>
                  <a:pt x="4727971" y="1055128"/>
                </a:cubicBezTo>
                <a:cubicBezTo>
                  <a:pt x="4724399" y="1069665"/>
                  <a:pt x="4713683" y="1084202"/>
                  <a:pt x="4738688" y="1098740"/>
                </a:cubicBezTo>
                <a:cubicBezTo>
                  <a:pt x="4992291" y="758568"/>
                  <a:pt x="4978002" y="578305"/>
                  <a:pt x="5185172" y="197429"/>
                </a:cubicBezTo>
                <a:cubicBezTo>
                  <a:pt x="5224462" y="281744"/>
                  <a:pt x="5195887" y="342801"/>
                  <a:pt x="5188744" y="400950"/>
                </a:cubicBezTo>
                <a:cubicBezTo>
                  <a:pt x="5170883" y="546323"/>
                  <a:pt x="5138736" y="456192"/>
                  <a:pt x="5117306" y="601565"/>
                </a:cubicBezTo>
                <a:cubicBezTo>
                  <a:pt x="5106590" y="671344"/>
                  <a:pt x="5070871" y="735308"/>
                  <a:pt x="5128021" y="813809"/>
                </a:cubicBezTo>
                <a:cubicBezTo>
                  <a:pt x="5167312" y="866143"/>
                  <a:pt x="5124450" y="950459"/>
                  <a:pt x="5092302" y="1014423"/>
                </a:cubicBezTo>
                <a:cubicBezTo>
                  <a:pt x="5063727" y="1066758"/>
                  <a:pt x="5056585" y="1119092"/>
                  <a:pt x="5092302" y="1188871"/>
                </a:cubicBezTo>
                <a:cubicBezTo>
                  <a:pt x="5113734" y="1124907"/>
                  <a:pt x="5131592" y="1075480"/>
                  <a:pt x="5145880" y="1026053"/>
                </a:cubicBezTo>
                <a:cubicBezTo>
                  <a:pt x="5156596" y="985349"/>
                  <a:pt x="5181600" y="962089"/>
                  <a:pt x="5235177" y="964997"/>
                </a:cubicBezTo>
                <a:cubicBezTo>
                  <a:pt x="5263752" y="964997"/>
                  <a:pt x="5303044" y="956275"/>
                  <a:pt x="5317331" y="985349"/>
                </a:cubicBezTo>
                <a:cubicBezTo>
                  <a:pt x="5331618" y="1008608"/>
                  <a:pt x="5317331" y="1040590"/>
                  <a:pt x="5292327" y="1052221"/>
                </a:cubicBezTo>
                <a:cubicBezTo>
                  <a:pt x="5245894" y="1066758"/>
                  <a:pt x="5203031" y="1081295"/>
                  <a:pt x="5199458" y="1130722"/>
                </a:cubicBezTo>
                <a:cubicBezTo>
                  <a:pt x="5192315" y="1197593"/>
                  <a:pt x="5220889" y="1159796"/>
                  <a:pt x="5256608" y="1148166"/>
                </a:cubicBezTo>
                <a:cubicBezTo>
                  <a:pt x="5295899" y="1136536"/>
                  <a:pt x="5306616" y="1171426"/>
                  <a:pt x="5299471" y="1194686"/>
                </a:cubicBezTo>
                <a:cubicBezTo>
                  <a:pt x="5267324" y="1281909"/>
                  <a:pt x="5324474" y="1372040"/>
                  <a:pt x="5278039" y="1462171"/>
                </a:cubicBezTo>
                <a:cubicBezTo>
                  <a:pt x="5392339" y="1438912"/>
                  <a:pt x="5442347" y="1389485"/>
                  <a:pt x="5460205" y="1284817"/>
                </a:cubicBezTo>
                <a:cubicBezTo>
                  <a:pt x="5463777" y="1247020"/>
                  <a:pt x="5456634" y="1206315"/>
                  <a:pt x="5488780" y="1171426"/>
                </a:cubicBezTo>
                <a:cubicBezTo>
                  <a:pt x="5502175" y="1156162"/>
                  <a:pt x="5517579" y="1140898"/>
                  <a:pt x="5539513" y="1140353"/>
                </a:cubicBezTo>
                <a:lnTo>
                  <a:pt x="5552720" y="1143022"/>
                </a:lnTo>
                <a:lnTo>
                  <a:pt x="5574208" y="1115811"/>
                </a:lnTo>
                <a:cubicBezTo>
                  <a:pt x="5609034" y="1085646"/>
                  <a:pt x="5659040" y="1068202"/>
                  <a:pt x="5734050" y="1075470"/>
                </a:cubicBezTo>
                <a:cubicBezTo>
                  <a:pt x="5776912" y="1078377"/>
                  <a:pt x="5809058" y="1055118"/>
                  <a:pt x="5798343" y="1020228"/>
                </a:cubicBezTo>
                <a:cubicBezTo>
                  <a:pt x="5776912" y="953357"/>
                  <a:pt x="5837634" y="921375"/>
                  <a:pt x="5884068" y="883578"/>
                </a:cubicBezTo>
                <a:cubicBezTo>
                  <a:pt x="5966221" y="816706"/>
                  <a:pt x="6051947" y="752742"/>
                  <a:pt x="6066234" y="645166"/>
                </a:cubicBezTo>
                <a:cubicBezTo>
                  <a:pt x="6130528" y="665519"/>
                  <a:pt x="6123384" y="700408"/>
                  <a:pt x="6109096" y="732391"/>
                </a:cubicBezTo>
                <a:cubicBezTo>
                  <a:pt x="6073377" y="816706"/>
                  <a:pt x="6034087" y="901023"/>
                  <a:pt x="5998368" y="985338"/>
                </a:cubicBezTo>
                <a:cubicBezTo>
                  <a:pt x="5976937" y="1040581"/>
                  <a:pt x="5944790" y="1095822"/>
                  <a:pt x="5969793" y="1168509"/>
                </a:cubicBezTo>
                <a:cubicBezTo>
                  <a:pt x="6098380" y="1104545"/>
                  <a:pt x="6123384" y="996969"/>
                  <a:pt x="6162674" y="909745"/>
                </a:cubicBezTo>
                <a:cubicBezTo>
                  <a:pt x="6212681" y="802169"/>
                  <a:pt x="6305549" y="738205"/>
                  <a:pt x="6412705" y="659704"/>
                </a:cubicBezTo>
                <a:cubicBezTo>
                  <a:pt x="6441280" y="738205"/>
                  <a:pt x="6362699" y="787632"/>
                  <a:pt x="6366271" y="851596"/>
                </a:cubicBezTo>
                <a:cubicBezTo>
                  <a:pt x="6376987" y="854503"/>
                  <a:pt x="6398418" y="860319"/>
                  <a:pt x="6398418" y="860319"/>
                </a:cubicBezTo>
                <a:cubicBezTo>
                  <a:pt x="6455568" y="755650"/>
                  <a:pt x="6562724" y="709131"/>
                  <a:pt x="6694884" y="691686"/>
                </a:cubicBezTo>
                <a:cubicBezTo>
                  <a:pt x="6762750" y="685871"/>
                  <a:pt x="6784181" y="648074"/>
                  <a:pt x="6816327" y="610277"/>
                </a:cubicBezTo>
                <a:cubicBezTo>
                  <a:pt x="6927056" y="482349"/>
                  <a:pt x="7027068" y="345699"/>
                  <a:pt x="7177087" y="238123"/>
                </a:cubicBezTo>
                <a:cubicBezTo>
                  <a:pt x="7159228" y="363144"/>
                  <a:pt x="7059215" y="461997"/>
                  <a:pt x="7016353" y="592833"/>
                </a:cubicBezTo>
                <a:cubicBezTo>
                  <a:pt x="7180659" y="488164"/>
                  <a:pt x="7266384" y="351513"/>
                  <a:pt x="7366396" y="226493"/>
                </a:cubicBezTo>
                <a:cubicBezTo>
                  <a:pt x="7412830" y="168344"/>
                  <a:pt x="7469981" y="116010"/>
                  <a:pt x="7494984" y="49138"/>
                </a:cubicBezTo>
                <a:cubicBezTo>
                  <a:pt x="7500342" y="31693"/>
                  <a:pt x="7511727" y="4436"/>
                  <a:pt x="7538181" y="484"/>
                </a:cubicBezTo>
                <a:close/>
              </a:path>
            </a:pathLst>
          </a:custGeom>
          <a:solidFill>
            <a:schemeClr val="accent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EE91FF0E-B777-2448-B6FB-64A088031102}"/>
              </a:ext>
            </a:extLst>
          </p:cNvPr>
          <p:cNvSpPr>
            <a:spLocks noGrp="1"/>
          </p:cNvSpPr>
          <p:nvPr>
            <p:ph type="title"/>
          </p:nvPr>
        </p:nvSpPr>
        <p:spPr>
          <a:xfrm>
            <a:off x="838200" y="365125"/>
            <a:ext cx="10515600" cy="1325563"/>
          </a:xfrm>
        </p:spPr>
        <p:txBody>
          <a:bodyPr>
            <a:normAutofit/>
          </a:bodyPr>
          <a:lstStyle/>
          <a:p>
            <a:r>
              <a:rPr lang="en-US" dirty="0"/>
              <a:t>Explore</a:t>
            </a:r>
          </a:p>
        </p:txBody>
      </p:sp>
      <p:graphicFrame>
        <p:nvGraphicFramePr>
          <p:cNvPr id="5" name="Content Placeholder 2">
            <a:extLst>
              <a:ext uri="{FF2B5EF4-FFF2-40B4-BE49-F238E27FC236}">
                <a16:creationId xmlns:a16="http://schemas.microsoft.com/office/drawing/2014/main" id="{7F7C5BF9-DFF5-F4C9-4C1F-4DD455D28911}"/>
              </a:ext>
            </a:extLst>
          </p:cNvPr>
          <p:cNvGraphicFramePr>
            <a:graphicFrameLocks noGrp="1"/>
          </p:cNvGraphicFramePr>
          <p:nvPr>
            <p:ph idx="1"/>
            <p:extLst>
              <p:ext uri="{D42A27DB-BD31-4B8C-83A1-F6EECF244321}">
                <p14:modId xmlns:p14="http://schemas.microsoft.com/office/powerpoint/2010/main" val="2883891149"/>
              </p:ext>
            </p:extLst>
          </p:nvPr>
        </p:nvGraphicFramePr>
        <p:xfrm>
          <a:off x="838200" y="2011363"/>
          <a:ext cx="10515600" cy="416083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38924582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2EA95F-D78A-E342-97A4-62E105EA9CA0}"/>
              </a:ext>
            </a:extLst>
          </p:cNvPr>
          <p:cNvSpPr>
            <a:spLocks noGrp="1"/>
          </p:cNvSpPr>
          <p:nvPr>
            <p:ph type="title"/>
          </p:nvPr>
        </p:nvSpPr>
        <p:spPr/>
        <p:txBody>
          <a:bodyPr/>
          <a:lstStyle/>
          <a:p>
            <a:r>
              <a:rPr lang="en-US" dirty="0"/>
              <a:t>Cheat Sheet</a:t>
            </a:r>
          </a:p>
        </p:txBody>
      </p:sp>
      <p:graphicFrame>
        <p:nvGraphicFramePr>
          <p:cNvPr id="6" name="Content Placeholder 2">
            <a:extLst>
              <a:ext uri="{FF2B5EF4-FFF2-40B4-BE49-F238E27FC236}">
                <a16:creationId xmlns:a16="http://schemas.microsoft.com/office/drawing/2014/main" id="{1F3795AD-F29D-3809-F5EB-F55306A288D0}"/>
              </a:ext>
            </a:extLst>
          </p:cNvPr>
          <p:cNvGraphicFramePr>
            <a:graphicFrameLocks noGrp="1"/>
          </p:cNvGraphicFramePr>
          <p:nvPr>
            <p:ph idx="1"/>
          </p:nvPr>
        </p:nvGraphicFramePr>
        <p:xfrm>
          <a:off x="364067" y="1416052"/>
          <a:ext cx="5987037" cy="316588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TextBox 3">
            <a:extLst>
              <a:ext uri="{FF2B5EF4-FFF2-40B4-BE49-F238E27FC236}">
                <a16:creationId xmlns:a16="http://schemas.microsoft.com/office/drawing/2014/main" id="{E1EB3CC4-4D32-9F49-B1FE-CE6E0C95F8AF}"/>
              </a:ext>
            </a:extLst>
          </p:cNvPr>
          <p:cNvSpPr txBox="1"/>
          <p:nvPr/>
        </p:nvSpPr>
        <p:spPr>
          <a:xfrm>
            <a:off x="6564793" y="1470445"/>
            <a:ext cx="5521189" cy="1938992"/>
          </a:xfrm>
          <a:prstGeom prst="rect">
            <a:avLst/>
          </a:prstGeom>
          <a:noFill/>
        </p:spPr>
        <p:txBody>
          <a:bodyPr wrap="square" rtlCol="0">
            <a:spAutoFit/>
          </a:bodyPr>
          <a:lstStyle/>
          <a:p>
            <a:r>
              <a:rPr lang="en-US" sz="2400" dirty="0"/>
              <a:t>N – Name “It sounds like…”</a:t>
            </a:r>
          </a:p>
          <a:p>
            <a:r>
              <a:rPr lang="en-US" sz="2400" dirty="0"/>
              <a:t>U – Understand “I can’t imagine…”</a:t>
            </a:r>
          </a:p>
          <a:p>
            <a:r>
              <a:rPr lang="en-US" sz="2400" dirty="0"/>
              <a:t>R – Respect “You have done…”</a:t>
            </a:r>
          </a:p>
          <a:p>
            <a:r>
              <a:rPr lang="en-US" sz="2400" dirty="0"/>
              <a:t>S – Support “I’ll be there…”</a:t>
            </a:r>
          </a:p>
          <a:p>
            <a:r>
              <a:rPr lang="en-US" sz="2400" dirty="0"/>
              <a:t>E – Explore “Tell me more…”</a:t>
            </a:r>
          </a:p>
        </p:txBody>
      </p:sp>
    </p:spTree>
    <p:extLst>
      <p:ext uri="{BB962C8B-B14F-4D97-AF65-F5344CB8AC3E}">
        <p14:creationId xmlns:p14="http://schemas.microsoft.com/office/powerpoint/2010/main" val="70818515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FF8323-BF20-6145-B4D3-375629CCC9FD}"/>
              </a:ext>
            </a:extLst>
          </p:cNvPr>
          <p:cNvSpPr>
            <a:spLocks noGrp="1"/>
          </p:cNvSpPr>
          <p:nvPr>
            <p:ph type="title"/>
          </p:nvPr>
        </p:nvSpPr>
        <p:spPr/>
        <p:txBody>
          <a:bodyPr/>
          <a:lstStyle/>
          <a:p>
            <a:r>
              <a:rPr lang="en-US" dirty="0"/>
              <a:t>References</a:t>
            </a:r>
          </a:p>
        </p:txBody>
      </p:sp>
      <p:graphicFrame>
        <p:nvGraphicFramePr>
          <p:cNvPr id="5" name="Content Placeholder 2">
            <a:extLst>
              <a:ext uri="{FF2B5EF4-FFF2-40B4-BE49-F238E27FC236}">
                <a16:creationId xmlns:a16="http://schemas.microsoft.com/office/drawing/2014/main" id="{316DB1B9-8A1E-8575-E395-F2F05234556F}"/>
              </a:ext>
            </a:extLst>
          </p:cNvPr>
          <p:cNvGraphicFramePr>
            <a:graphicFrameLocks noGrp="1"/>
          </p:cNvGraphicFramePr>
          <p:nvPr>
            <p:ph idx="1"/>
            <p:extLst>
              <p:ext uri="{D42A27DB-BD31-4B8C-83A1-F6EECF244321}">
                <p14:modId xmlns:p14="http://schemas.microsoft.com/office/powerpoint/2010/main" val="3963007452"/>
              </p:ext>
            </p:extLst>
          </p:nvPr>
        </p:nvGraphicFramePr>
        <p:xfrm>
          <a:off x="838200" y="2011680"/>
          <a:ext cx="10515600" cy="416052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1331440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CC1BBA-5D81-9A45-B492-41EC59E82B24}"/>
              </a:ext>
            </a:extLst>
          </p:cNvPr>
          <p:cNvSpPr>
            <a:spLocks noGrp="1"/>
          </p:cNvSpPr>
          <p:nvPr>
            <p:ph type="title"/>
          </p:nvPr>
        </p:nvSpPr>
        <p:spPr/>
        <p:txBody>
          <a:bodyPr/>
          <a:lstStyle/>
          <a:p>
            <a:r>
              <a:rPr lang="en-US" dirty="0"/>
              <a:t>Learning Objectives</a:t>
            </a:r>
          </a:p>
        </p:txBody>
      </p:sp>
      <p:sp>
        <p:nvSpPr>
          <p:cNvPr id="3" name="Content Placeholder 2">
            <a:extLst>
              <a:ext uri="{FF2B5EF4-FFF2-40B4-BE49-F238E27FC236}">
                <a16:creationId xmlns:a16="http://schemas.microsoft.com/office/drawing/2014/main" id="{0AD17513-06C5-0146-8BC6-64889836E1DA}"/>
              </a:ext>
            </a:extLst>
          </p:cNvPr>
          <p:cNvSpPr>
            <a:spLocks noGrp="1"/>
          </p:cNvSpPr>
          <p:nvPr>
            <p:ph idx="1"/>
          </p:nvPr>
        </p:nvSpPr>
        <p:spPr>
          <a:xfrm>
            <a:off x="364068" y="1416051"/>
            <a:ext cx="10451078" cy="4710113"/>
          </a:xfrm>
        </p:spPr>
        <p:txBody>
          <a:bodyPr/>
          <a:lstStyle/>
          <a:p>
            <a:pPr marL="342900" indent="-342900" fontAlgn="auto">
              <a:spcAft>
                <a:spcPts val="0"/>
              </a:spcAft>
              <a:buFont typeface="Arial" panose="020B0604020202020204" pitchFamily="34" charset="0"/>
              <a:buChar char="•"/>
              <a:defRPr/>
            </a:pPr>
            <a:endParaRPr lang="en-US" dirty="0"/>
          </a:p>
          <a:p>
            <a:r>
              <a:rPr lang="en-US" dirty="0"/>
              <a:t>By the end of this activity, participants will be able to:</a:t>
            </a:r>
          </a:p>
          <a:p>
            <a:pPr lvl="1"/>
            <a:r>
              <a:rPr lang="en-US" dirty="0"/>
              <a:t>Apply</a:t>
            </a:r>
            <a:r>
              <a:rPr lang="en-US" sz="2400" dirty="0"/>
              <a:t> SPIKES as a roadmap for difficult conversations</a:t>
            </a:r>
          </a:p>
          <a:p>
            <a:pPr lvl="1"/>
            <a:r>
              <a:rPr lang="en-US" dirty="0"/>
              <a:t>Apply</a:t>
            </a:r>
            <a:r>
              <a:rPr lang="en-US" sz="2400" dirty="0"/>
              <a:t> NURSE as a roadmap for exploring emotions</a:t>
            </a:r>
          </a:p>
          <a:p>
            <a:pPr lvl="1"/>
            <a:r>
              <a:rPr lang="en-US" sz="2400" dirty="0"/>
              <a:t>Determine how to implement SPIKES/NURSE frameworks for disclosing serious news in their own clinical practice</a:t>
            </a:r>
          </a:p>
        </p:txBody>
      </p:sp>
    </p:spTree>
    <p:extLst>
      <p:ext uri="{BB962C8B-B14F-4D97-AF65-F5344CB8AC3E}">
        <p14:creationId xmlns:p14="http://schemas.microsoft.com/office/powerpoint/2010/main" val="322247194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DA8886A6-5426-494B-96D8-D962D2BA08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Freeform: Shape 10">
            <a:extLst>
              <a:ext uri="{FF2B5EF4-FFF2-40B4-BE49-F238E27FC236}">
                <a16:creationId xmlns:a16="http://schemas.microsoft.com/office/drawing/2014/main" id="{AA3ED336-C09E-46E8-9774-B977D15FC5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752347"/>
            <a:ext cx="12191999" cy="6105653"/>
          </a:xfrm>
          <a:custGeom>
            <a:avLst/>
            <a:gdLst>
              <a:gd name="connsiteX0" fmla="*/ 7538181 w 12191999"/>
              <a:gd name="connsiteY0" fmla="*/ 484 h 6105653"/>
              <a:gd name="connsiteX1" fmla="*/ 7569993 w 12191999"/>
              <a:gd name="connsiteY1" fmla="*/ 5527 h 6105653"/>
              <a:gd name="connsiteX2" fmla="*/ 7587853 w 12191999"/>
              <a:gd name="connsiteY2" fmla="*/ 84028 h 6105653"/>
              <a:gd name="connsiteX3" fmla="*/ 7559278 w 12191999"/>
              <a:gd name="connsiteY3" fmla="*/ 325347 h 6105653"/>
              <a:gd name="connsiteX4" fmla="*/ 7795021 w 12191999"/>
              <a:gd name="connsiteY4" fmla="*/ 25878 h 6105653"/>
              <a:gd name="connsiteX5" fmla="*/ 7759302 w 12191999"/>
              <a:gd name="connsiteY5" fmla="*/ 249752 h 6105653"/>
              <a:gd name="connsiteX6" fmla="*/ 7852171 w 12191999"/>
              <a:gd name="connsiteY6" fmla="*/ 313717 h 6105653"/>
              <a:gd name="connsiteX7" fmla="*/ 8002190 w 12191999"/>
              <a:gd name="connsiteY7" fmla="*/ 418385 h 6105653"/>
              <a:gd name="connsiteX8" fmla="*/ 8084343 w 12191999"/>
              <a:gd name="connsiteY8" fmla="*/ 491072 h 6105653"/>
              <a:gd name="connsiteX9" fmla="*/ 8348662 w 12191999"/>
              <a:gd name="connsiteY9" fmla="*/ 520146 h 6105653"/>
              <a:gd name="connsiteX10" fmla="*/ 8637984 w 12191999"/>
              <a:gd name="connsiteY10" fmla="*/ 459090 h 6105653"/>
              <a:gd name="connsiteX11" fmla="*/ 8784431 w 12191999"/>
              <a:gd name="connsiteY11" fmla="*/ 290457 h 6105653"/>
              <a:gd name="connsiteX12" fmla="*/ 8948737 w 12191999"/>
              <a:gd name="connsiteY12" fmla="*/ 339884 h 6105653"/>
              <a:gd name="connsiteX13" fmla="*/ 8848725 w 12191999"/>
              <a:gd name="connsiteY13" fmla="*/ 697501 h 6105653"/>
              <a:gd name="connsiteX14" fmla="*/ 9238059 w 12191999"/>
              <a:gd name="connsiteY14" fmla="*/ 165437 h 6105653"/>
              <a:gd name="connsiteX15" fmla="*/ 9255919 w 12191999"/>
              <a:gd name="connsiteY15" fmla="*/ 255567 h 6105653"/>
              <a:gd name="connsiteX16" fmla="*/ 9477374 w 12191999"/>
              <a:gd name="connsiteY16" fmla="*/ 578295 h 6105653"/>
              <a:gd name="connsiteX17" fmla="*/ 9488091 w 12191999"/>
              <a:gd name="connsiteY17" fmla="*/ 595740 h 6105653"/>
              <a:gd name="connsiteX18" fmla="*/ 9627393 w 12191999"/>
              <a:gd name="connsiteY18" fmla="*/ 650981 h 6105653"/>
              <a:gd name="connsiteX19" fmla="*/ 9648824 w 12191999"/>
              <a:gd name="connsiteY19" fmla="*/ 825429 h 6105653"/>
              <a:gd name="connsiteX20" fmla="*/ 9616678 w 12191999"/>
              <a:gd name="connsiteY20" fmla="*/ 970802 h 6105653"/>
              <a:gd name="connsiteX21" fmla="*/ 9655968 w 12191999"/>
              <a:gd name="connsiteY21" fmla="*/ 1127805 h 6105653"/>
              <a:gd name="connsiteX22" fmla="*/ 9638109 w 12191999"/>
              <a:gd name="connsiteY22" fmla="*/ 1267362 h 6105653"/>
              <a:gd name="connsiteX23" fmla="*/ 9663111 w 12191999"/>
              <a:gd name="connsiteY23" fmla="*/ 1386568 h 6105653"/>
              <a:gd name="connsiteX24" fmla="*/ 9780984 w 12191999"/>
              <a:gd name="connsiteY24" fmla="*/ 1270269 h 6105653"/>
              <a:gd name="connsiteX25" fmla="*/ 9780984 w 12191999"/>
              <a:gd name="connsiteY25" fmla="*/ 1107452 h 6105653"/>
              <a:gd name="connsiteX26" fmla="*/ 9855993 w 12191999"/>
              <a:gd name="connsiteY26" fmla="*/ 991154 h 6105653"/>
              <a:gd name="connsiteX27" fmla="*/ 9991724 w 12191999"/>
              <a:gd name="connsiteY27" fmla="*/ 880670 h 6105653"/>
              <a:gd name="connsiteX28" fmla="*/ 10209609 w 12191999"/>
              <a:gd name="connsiteY28" fmla="*/ 491071 h 6105653"/>
              <a:gd name="connsiteX29" fmla="*/ 10291762 w 12191999"/>
              <a:gd name="connsiteY29" fmla="*/ 421292 h 6105653"/>
              <a:gd name="connsiteX30" fmla="*/ 9973865 w 12191999"/>
              <a:gd name="connsiteY30" fmla="*/ 1531941 h 6105653"/>
              <a:gd name="connsiteX31" fmla="*/ 10106024 w 12191999"/>
              <a:gd name="connsiteY31" fmla="*/ 1188861 h 6105653"/>
              <a:gd name="connsiteX32" fmla="*/ 10081022 w 12191999"/>
              <a:gd name="connsiteY32" fmla="*/ 1421458 h 6105653"/>
              <a:gd name="connsiteX33" fmla="*/ 10170318 w 12191999"/>
              <a:gd name="connsiteY33" fmla="*/ 1549385 h 6105653"/>
              <a:gd name="connsiteX34" fmla="*/ 10198893 w 12191999"/>
              <a:gd name="connsiteY34" fmla="*/ 1549385 h 6105653"/>
              <a:gd name="connsiteX35" fmla="*/ 10281046 w 12191999"/>
              <a:gd name="connsiteY35" fmla="*/ 1453439 h 6105653"/>
              <a:gd name="connsiteX36" fmla="*/ 10334625 w 12191999"/>
              <a:gd name="connsiteY36" fmla="*/ 1398198 h 6105653"/>
              <a:gd name="connsiteX37" fmla="*/ 10527506 w 12191999"/>
              <a:gd name="connsiteY37" fmla="*/ 1247010 h 6105653"/>
              <a:gd name="connsiteX38" fmla="*/ 10548937 w 12191999"/>
              <a:gd name="connsiteY38" fmla="*/ 1354586 h 6105653"/>
              <a:gd name="connsiteX39" fmla="*/ 10588228 w 12191999"/>
              <a:gd name="connsiteY39" fmla="*/ 1395290 h 6105653"/>
              <a:gd name="connsiteX40" fmla="*/ 10645378 w 12191999"/>
              <a:gd name="connsiteY40" fmla="*/ 1366216 h 6105653"/>
              <a:gd name="connsiteX41" fmla="*/ 10820400 w 12191999"/>
              <a:gd name="connsiteY41" fmla="*/ 1031858 h 6105653"/>
              <a:gd name="connsiteX42" fmla="*/ 10956131 w 12191999"/>
              <a:gd name="connsiteY42" fmla="*/ 1005691 h 6105653"/>
              <a:gd name="connsiteX43" fmla="*/ 10977562 w 12191999"/>
              <a:gd name="connsiteY43" fmla="*/ 1069655 h 6105653"/>
              <a:gd name="connsiteX44" fmla="*/ 10966847 w 12191999"/>
              <a:gd name="connsiteY44" fmla="*/ 1142341 h 6105653"/>
              <a:gd name="connsiteX45" fmla="*/ 11074003 w 12191999"/>
              <a:gd name="connsiteY45" fmla="*/ 1084192 h 6105653"/>
              <a:gd name="connsiteX46" fmla="*/ 11181159 w 12191999"/>
              <a:gd name="connsiteY46" fmla="*/ 848688 h 6105653"/>
              <a:gd name="connsiteX47" fmla="*/ 11238309 w 12191999"/>
              <a:gd name="connsiteY47" fmla="*/ 805077 h 6105653"/>
              <a:gd name="connsiteX48" fmla="*/ 11266884 w 12191999"/>
              <a:gd name="connsiteY48" fmla="*/ 863226 h 6105653"/>
              <a:gd name="connsiteX49" fmla="*/ 11277600 w 12191999"/>
              <a:gd name="connsiteY49" fmla="*/ 906838 h 6105653"/>
              <a:gd name="connsiteX50" fmla="*/ 11724084 w 12191999"/>
              <a:gd name="connsiteY50" fmla="*/ 5527 h 6105653"/>
              <a:gd name="connsiteX51" fmla="*/ 11727656 w 12191999"/>
              <a:gd name="connsiteY51" fmla="*/ 209048 h 6105653"/>
              <a:gd name="connsiteX52" fmla="*/ 11656218 w 12191999"/>
              <a:gd name="connsiteY52" fmla="*/ 409663 h 6105653"/>
              <a:gd name="connsiteX53" fmla="*/ 11666934 w 12191999"/>
              <a:gd name="connsiteY53" fmla="*/ 621907 h 6105653"/>
              <a:gd name="connsiteX54" fmla="*/ 11631215 w 12191999"/>
              <a:gd name="connsiteY54" fmla="*/ 822521 h 6105653"/>
              <a:gd name="connsiteX55" fmla="*/ 11631215 w 12191999"/>
              <a:gd name="connsiteY55" fmla="*/ 996969 h 6105653"/>
              <a:gd name="connsiteX56" fmla="*/ 11684793 w 12191999"/>
              <a:gd name="connsiteY56" fmla="*/ 834151 h 6105653"/>
              <a:gd name="connsiteX57" fmla="*/ 11774090 w 12191999"/>
              <a:gd name="connsiteY57" fmla="*/ 773095 h 6105653"/>
              <a:gd name="connsiteX58" fmla="*/ 11856243 w 12191999"/>
              <a:gd name="connsiteY58" fmla="*/ 793447 h 6105653"/>
              <a:gd name="connsiteX59" fmla="*/ 11831240 w 12191999"/>
              <a:gd name="connsiteY59" fmla="*/ 860319 h 6105653"/>
              <a:gd name="connsiteX60" fmla="*/ 11738371 w 12191999"/>
              <a:gd name="connsiteY60" fmla="*/ 938820 h 6105653"/>
              <a:gd name="connsiteX61" fmla="*/ 11795521 w 12191999"/>
              <a:gd name="connsiteY61" fmla="*/ 956264 h 6105653"/>
              <a:gd name="connsiteX62" fmla="*/ 11838384 w 12191999"/>
              <a:gd name="connsiteY62" fmla="*/ 1002784 h 6105653"/>
              <a:gd name="connsiteX63" fmla="*/ 11816952 w 12191999"/>
              <a:gd name="connsiteY63" fmla="*/ 1270269 h 6105653"/>
              <a:gd name="connsiteX64" fmla="*/ 11999118 w 12191999"/>
              <a:gd name="connsiteY64" fmla="*/ 1092915 h 6105653"/>
              <a:gd name="connsiteX65" fmla="*/ 12027693 w 12191999"/>
              <a:gd name="connsiteY65" fmla="*/ 979524 h 6105653"/>
              <a:gd name="connsiteX66" fmla="*/ 12102703 w 12191999"/>
              <a:gd name="connsiteY66" fmla="*/ 953357 h 6105653"/>
              <a:gd name="connsiteX67" fmla="*/ 12120562 w 12191999"/>
              <a:gd name="connsiteY67" fmla="*/ 1005691 h 6105653"/>
              <a:gd name="connsiteX68" fmla="*/ 12056268 w 12191999"/>
              <a:gd name="connsiteY68" fmla="*/ 1267362 h 6105653"/>
              <a:gd name="connsiteX69" fmla="*/ 12081272 w 12191999"/>
              <a:gd name="connsiteY69" fmla="*/ 1310974 h 6105653"/>
              <a:gd name="connsiteX70" fmla="*/ 12191999 w 12191999"/>
              <a:gd name="connsiteY70" fmla="*/ 1008598 h 6105653"/>
              <a:gd name="connsiteX71" fmla="*/ 12191999 w 12191999"/>
              <a:gd name="connsiteY71" fmla="*/ 6105653 h 6105653"/>
              <a:gd name="connsiteX72" fmla="*/ 0 w 12191999"/>
              <a:gd name="connsiteY72" fmla="*/ 6105653 h 6105653"/>
              <a:gd name="connsiteX73" fmla="*/ 0 w 12191999"/>
              <a:gd name="connsiteY73" fmla="*/ 927116 h 6105653"/>
              <a:gd name="connsiteX74" fmla="*/ 61930 w 12191999"/>
              <a:gd name="connsiteY74" fmla="*/ 902578 h 6105653"/>
              <a:gd name="connsiteX75" fmla="*/ 155971 w 12191999"/>
              <a:gd name="connsiteY75" fmla="*/ 883588 h 6105653"/>
              <a:gd name="connsiteX76" fmla="*/ 277414 w 12191999"/>
              <a:gd name="connsiteY76" fmla="*/ 802179 h 6105653"/>
              <a:gd name="connsiteX77" fmla="*/ 638174 w 12191999"/>
              <a:gd name="connsiteY77" fmla="*/ 430025 h 6105653"/>
              <a:gd name="connsiteX78" fmla="*/ 477440 w 12191999"/>
              <a:gd name="connsiteY78" fmla="*/ 784735 h 6105653"/>
              <a:gd name="connsiteX79" fmla="*/ 827483 w 12191999"/>
              <a:gd name="connsiteY79" fmla="*/ 418395 h 6105653"/>
              <a:gd name="connsiteX80" fmla="*/ 956071 w 12191999"/>
              <a:gd name="connsiteY80" fmla="*/ 241040 h 6105653"/>
              <a:gd name="connsiteX81" fmla="*/ 999268 w 12191999"/>
              <a:gd name="connsiteY81" fmla="*/ 192386 h 6105653"/>
              <a:gd name="connsiteX82" fmla="*/ 1031080 w 12191999"/>
              <a:gd name="connsiteY82" fmla="*/ 197429 h 6105653"/>
              <a:gd name="connsiteX83" fmla="*/ 1048940 w 12191999"/>
              <a:gd name="connsiteY83" fmla="*/ 275930 h 6105653"/>
              <a:gd name="connsiteX84" fmla="*/ 1020365 w 12191999"/>
              <a:gd name="connsiteY84" fmla="*/ 517249 h 6105653"/>
              <a:gd name="connsiteX85" fmla="*/ 1256108 w 12191999"/>
              <a:gd name="connsiteY85" fmla="*/ 217780 h 6105653"/>
              <a:gd name="connsiteX86" fmla="*/ 1220389 w 12191999"/>
              <a:gd name="connsiteY86" fmla="*/ 441654 h 6105653"/>
              <a:gd name="connsiteX87" fmla="*/ 1313258 w 12191999"/>
              <a:gd name="connsiteY87" fmla="*/ 505619 h 6105653"/>
              <a:gd name="connsiteX88" fmla="*/ 1463277 w 12191999"/>
              <a:gd name="connsiteY88" fmla="*/ 610287 h 6105653"/>
              <a:gd name="connsiteX89" fmla="*/ 1545430 w 12191999"/>
              <a:gd name="connsiteY89" fmla="*/ 682974 h 6105653"/>
              <a:gd name="connsiteX90" fmla="*/ 1809749 w 12191999"/>
              <a:gd name="connsiteY90" fmla="*/ 712048 h 6105653"/>
              <a:gd name="connsiteX91" fmla="*/ 2099071 w 12191999"/>
              <a:gd name="connsiteY91" fmla="*/ 650992 h 6105653"/>
              <a:gd name="connsiteX92" fmla="*/ 2245518 w 12191999"/>
              <a:gd name="connsiteY92" fmla="*/ 482359 h 6105653"/>
              <a:gd name="connsiteX93" fmla="*/ 2409824 w 12191999"/>
              <a:gd name="connsiteY93" fmla="*/ 531786 h 6105653"/>
              <a:gd name="connsiteX94" fmla="*/ 2309812 w 12191999"/>
              <a:gd name="connsiteY94" fmla="*/ 889403 h 6105653"/>
              <a:gd name="connsiteX95" fmla="*/ 2699146 w 12191999"/>
              <a:gd name="connsiteY95" fmla="*/ 357339 h 6105653"/>
              <a:gd name="connsiteX96" fmla="*/ 2717006 w 12191999"/>
              <a:gd name="connsiteY96" fmla="*/ 447469 h 6105653"/>
              <a:gd name="connsiteX97" fmla="*/ 2938461 w 12191999"/>
              <a:gd name="connsiteY97" fmla="*/ 770197 h 6105653"/>
              <a:gd name="connsiteX98" fmla="*/ 2949178 w 12191999"/>
              <a:gd name="connsiteY98" fmla="*/ 787642 h 6105653"/>
              <a:gd name="connsiteX99" fmla="*/ 3088480 w 12191999"/>
              <a:gd name="connsiteY99" fmla="*/ 842883 h 6105653"/>
              <a:gd name="connsiteX100" fmla="*/ 3109911 w 12191999"/>
              <a:gd name="connsiteY100" fmla="*/ 1017331 h 6105653"/>
              <a:gd name="connsiteX101" fmla="*/ 3077765 w 12191999"/>
              <a:gd name="connsiteY101" fmla="*/ 1162704 h 6105653"/>
              <a:gd name="connsiteX102" fmla="*/ 3117055 w 12191999"/>
              <a:gd name="connsiteY102" fmla="*/ 1319707 h 6105653"/>
              <a:gd name="connsiteX103" fmla="*/ 3099196 w 12191999"/>
              <a:gd name="connsiteY103" fmla="*/ 1459264 h 6105653"/>
              <a:gd name="connsiteX104" fmla="*/ 3124198 w 12191999"/>
              <a:gd name="connsiteY104" fmla="*/ 1578470 h 6105653"/>
              <a:gd name="connsiteX105" fmla="*/ 3242071 w 12191999"/>
              <a:gd name="connsiteY105" fmla="*/ 1462171 h 6105653"/>
              <a:gd name="connsiteX106" fmla="*/ 3242071 w 12191999"/>
              <a:gd name="connsiteY106" fmla="*/ 1299354 h 6105653"/>
              <a:gd name="connsiteX107" fmla="*/ 3317080 w 12191999"/>
              <a:gd name="connsiteY107" fmla="*/ 1183056 h 6105653"/>
              <a:gd name="connsiteX108" fmla="*/ 3452811 w 12191999"/>
              <a:gd name="connsiteY108" fmla="*/ 1072572 h 6105653"/>
              <a:gd name="connsiteX109" fmla="*/ 3670696 w 12191999"/>
              <a:gd name="connsiteY109" fmla="*/ 682973 h 6105653"/>
              <a:gd name="connsiteX110" fmla="*/ 3752849 w 12191999"/>
              <a:gd name="connsiteY110" fmla="*/ 613194 h 6105653"/>
              <a:gd name="connsiteX111" fmla="*/ 3434952 w 12191999"/>
              <a:gd name="connsiteY111" fmla="*/ 1723843 h 6105653"/>
              <a:gd name="connsiteX112" fmla="*/ 3567111 w 12191999"/>
              <a:gd name="connsiteY112" fmla="*/ 1380763 h 6105653"/>
              <a:gd name="connsiteX113" fmla="*/ 3542109 w 12191999"/>
              <a:gd name="connsiteY113" fmla="*/ 1613360 h 6105653"/>
              <a:gd name="connsiteX114" fmla="*/ 3631405 w 12191999"/>
              <a:gd name="connsiteY114" fmla="*/ 1741287 h 6105653"/>
              <a:gd name="connsiteX115" fmla="*/ 3659980 w 12191999"/>
              <a:gd name="connsiteY115" fmla="*/ 1741287 h 6105653"/>
              <a:gd name="connsiteX116" fmla="*/ 3742133 w 12191999"/>
              <a:gd name="connsiteY116" fmla="*/ 1645341 h 6105653"/>
              <a:gd name="connsiteX117" fmla="*/ 3795712 w 12191999"/>
              <a:gd name="connsiteY117" fmla="*/ 1590100 h 6105653"/>
              <a:gd name="connsiteX118" fmla="*/ 3988593 w 12191999"/>
              <a:gd name="connsiteY118" fmla="*/ 1438912 h 6105653"/>
              <a:gd name="connsiteX119" fmla="*/ 4010024 w 12191999"/>
              <a:gd name="connsiteY119" fmla="*/ 1546488 h 6105653"/>
              <a:gd name="connsiteX120" fmla="*/ 4049315 w 12191999"/>
              <a:gd name="connsiteY120" fmla="*/ 1587192 h 6105653"/>
              <a:gd name="connsiteX121" fmla="*/ 4106465 w 12191999"/>
              <a:gd name="connsiteY121" fmla="*/ 1558118 h 6105653"/>
              <a:gd name="connsiteX122" fmla="*/ 4281487 w 12191999"/>
              <a:gd name="connsiteY122" fmla="*/ 1223760 h 6105653"/>
              <a:gd name="connsiteX123" fmla="*/ 4417219 w 12191999"/>
              <a:gd name="connsiteY123" fmla="*/ 1197593 h 6105653"/>
              <a:gd name="connsiteX124" fmla="*/ 4438649 w 12191999"/>
              <a:gd name="connsiteY124" fmla="*/ 1261557 h 6105653"/>
              <a:gd name="connsiteX125" fmla="*/ 4427935 w 12191999"/>
              <a:gd name="connsiteY125" fmla="*/ 1334243 h 6105653"/>
              <a:gd name="connsiteX126" fmla="*/ 4535090 w 12191999"/>
              <a:gd name="connsiteY126" fmla="*/ 1276094 h 6105653"/>
              <a:gd name="connsiteX127" fmla="*/ 4642246 w 12191999"/>
              <a:gd name="connsiteY127" fmla="*/ 1040590 h 6105653"/>
              <a:gd name="connsiteX128" fmla="*/ 4699396 w 12191999"/>
              <a:gd name="connsiteY128" fmla="*/ 996979 h 6105653"/>
              <a:gd name="connsiteX129" fmla="*/ 4727971 w 12191999"/>
              <a:gd name="connsiteY129" fmla="*/ 1055128 h 6105653"/>
              <a:gd name="connsiteX130" fmla="*/ 4738688 w 12191999"/>
              <a:gd name="connsiteY130" fmla="*/ 1098740 h 6105653"/>
              <a:gd name="connsiteX131" fmla="*/ 5185172 w 12191999"/>
              <a:gd name="connsiteY131" fmla="*/ 197429 h 6105653"/>
              <a:gd name="connsiteX132" fmla="*/ 5188744 w 12191999"/>
              <a:gd name="connsiteY132" fmla="*/ 400950 h 6105653"/>
              <a:gd name="connsiteX133" fmla="*/ 5117306 w 12191999"/>
              <a:gd name="connsiteY133" fmla="*/ 601565 h 6105653"/>
              <a:gd name="connsiteX134" fmla="*/ 5128021 w 12191999"/>
              <a:gd name="connsiteY134" fmla="*/ 813809 h 6105653"/>
              <a:gd name="connsiteX135" fmla="*/ 5092302 w 12191999"/>
              <a:gd name="connsiteY135" fmla="*/ 1014423 h 6105653"/>
              <a:gd name="connsiteX136" fmla="*/ 5092302 w 12191999"/>
              <a:gd name="connsiteY136" fmla="*/ 1188871 h 6105653"/>
              <a:gd name="connsiteX137" fmla="*/ 5145880 w 12191999"/>
              <a:gd name="connsiteY137" fmla="*/ 1026053 h 6105653"/>
              <a:gd name="connsiteX138" fmla="*/ 5235177 w 12191999"/>
              <a:gd name="connsiteY138" fmla="*/ 964997 h 6105653"/>
              <a:gd name="connsiteX139" fmla="*/ 5317331 w 12191999"/>
              <a:gd name="connsiteY139" fmla="*/ 985349 h 6105653"/>
              <a:gd name="connsiteX140" fmla="*/ 5292327 w 12191999"/>
              <a:gd name="connsiteY140" fmla="*/ 1052221 h 6105653"/>
              <a:gd name="connsiteX141" fmla="*/ 5199458 w 12191999"/>
              <a:gd name="connsiteY141" fmla="*/ 1130722 h 6105653"/>
              <a:gd name="connsiteX142" fmla="*/ 5256608 w 12191999"/>
              <a:gd name="connsiteY142" fmla="*/ 1148166 h 6105653"/>
              <a:gd name="connsiteX143" fmla="*/ 5299471 w 12191999"/>
              <a:gd name="connsiteY143" fmla="*/ 1194686 h 6105653"/>
              <a:gd name="connsiteX144" fmla="*/ 5278039 w 12191999"/>
              <a:gd name="connsiteY144" fmla="*/ 1462171 h 6105653"/>
              <a:gd name="connsiteX145" fmla="*/ 5460205 w 12191999"/>
              <a:gd name="connsiteY145" fmla="*/ 1284817 h 6105653"/>
              <a:gd name="connsiteX146" fmla="*/ 5488780 w 12191999"/>
              <a:gd name="connsiteY146" fmla="*/ 1171426 h 6105653"/>
              <a:gd name="connsiteX147" fmla="*/ 5539513 w 12191999"/>
              <a:gd name="connsiteY147" fmla="*/ 1140353 h 6105653"/>
              <a:gd name="connsiteX148" fmla="*/ 5552720 w 12191999"/>
              <a:gd name="connsiteY148" fmla="*/ 1143022 h 6105653"/>
              <a:gd name="connsiteX149" fmla="*/ 5574208 w 12191999"/>
              <a:gd name="connsiteY149" fmla="*/ 1115811 h 6105653"/>
              <a:gd name="connsiteX150" fmla="*/ 5734050 w 12191999"/>
              <a:gd name="connsiteY150" fmla="*/ 1075470 h 6105653"/>
              <a:gd name="connsiteX151" fmla="*/ 5798343 w 12191999"/>
              <a:gd name="connsiteY151" fmla="*/ 1020228 h 6105653"/>
              <a:gd name="connsiteX152" fmla="*/ 5884068 w 12191999"/>
              <a:gd name="connsiteY152" fmla="*/ 883578 h 6105653"/>
              <a:gd name="connsiteX153" fmla="*/ 6066234 w 12191999"/>
              <a:gd name="connsiteY153" fmla="*/ 645166 h 6105653"/>
              <a:gd name="connsiteX154" fmla="*/ 6109096 w 12191999"/>
              <a:gd name="connsiteY154" fmla="*/ 732391 h 6105653"/>
              <a:gd name="connsiteX155" fmla="*/ 5998368 w 12191999"/>
              <a:gd name="connsiteY155" fmla="*/ 985338 h 6105653"/>
              <a:gd name="connsiteX156" fmla="*/ 5969793 w 12191999"/>
              <a:gd name="connsiteY156" fmla="*/ 1168509 h 6105653"/>
              <a:gd name="connsiteX157" fmla="*/ 6162674 w 12191999"/>
              <a:gd name="connsiteY157" fmla="*/ 909745 h 6105653"/>
              <a:gd name="connsiteX158" fmla="*/ 6412705 w 12191999"/>
              <a:gd name="connsiteY158" fmla="*/ 659704 h 6105653"/>
              <a:gd name="connsiteX159" fmla="*/ 6366271 w 12191999"/>
              <a:gd name="connsiteY159" fmla="*/ 851596 h 6105653"/>
              <a:gd name="connsiteX160" fmla="*/ 6398418 w 12191999"/>
              <a:gd name="connsiteY160" fmla="*/ 860319 h 6105653"/>
              <a:gd name="connsiteX161" fmla="*/ 6694884 w 12191999"/>
              <a:gd name="connsiteY161" fmla="*/ 691686 h 6105653"/>
              <a:gd name="connsiteX162" fmla="*/ 6816327 w 12191999"/>
              <a:gd name="connsiteY162" fmla="*/ 610277 h 6105653"/>
              <a:gd name="connsiteX163" fmla="*/ 7177087 w 12191999"/>
              <a:gd name="connsiteY163" fmla="*/ 238123 h 6105653"/>
              <a:gd name="connsiteX164" fmla="*/ 7016353 w 12191999"/>
              <a:gd name="connsiteY164" fmla="*/ 592833 h 6105653"/>
              <a:gd name="connsiteX165" fmla="*/ 7366396 w 12191999"/>
              <a:gd name="connsiteY165" fmla="*/ 226493 h 6105653"/>
              <a:gd name="connsiteX166" fmla="*/ 7494984 w 12191999"/>
              <a:gd name="connsiteY166" fmla="*/ 49138 h 6105653"/>
              <a:gd name="connsiteX167" fmla="*/ 7538181 w 12191999"/>
              <a:gd name="connsiteY167" fmla="*/ 484 h 610565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Lst>
            <a:rect l="l" t="t" r="r" b="b"/>
            <a:pathLst>
              <a:path w="12191999" h="6105653">
                <a:moveTo>
                  <a:pt x="7538181" y="484"/>
                </a:moveTo>
                <a:cubicBezTo>
                  <a:pt x="7546999" y="-833"/>
                  <a:pt x="7557492" y="439"/>
                  <a:pt x="7569993" y="5527"/>
                </a:cubicBezTo>
                <a:cubicBezTo>
                  <a:pt x="7612855" y="22971"/>
                  <a:pt x="7598567" y="54953"/>
                  <a:pt x="7587853" y="84028"/>
                </a:cubicBezTo>
                <a:cubicBezTo>
                  <a:pt x="7559278" y="153806"/>
                  <a:pt x="7559278" y="229401"/>
                  <a:pt x="7559278" y="325347"/>
                </a:cubicBezTo>
                <a:cubicBezTo>
                  <a:pt x="7695009" y="243938"/>
                  <a:pt x="7652146" y="95658"/>
                  <a:pt x="7795021" y="25878"/>
                </a:cubicBezTo>
                <a:cubicBezTo>
                  <a:pt x="7820024" y="113102"/>
                  <a:pt x="7770018" y="179974"/>
                  <a:pt x="7759302" y="249752"/>
                </a:cubicBezTo>
                <a:cubicBezTo>
                  <a:pt x="7748587" y="313717"/>
                  <a:pt x="7773590" y="328254"/>
                  <a:pt x="7852171" y="313717"/>
                </a:cubicBezTo>
                <a:cubicBezTo>
                  <a:pt x="7973615" y="290457"/>
                  <a:pt x="8034337" y="325347"/>
                  <a:pt x="8002190" y="418385"/>
                </a:cubicBezTo>
                <a:cubicBezTo>
                  <a:pt x="7970043" y="505609"/>
                  <a:pt x="8016478" y="514331"/>
                  <a:pt x="8084343" y="491072"/>
                </a:cubicBezTo>
                <a:cubicBezTo>
                  <a:pt x="8184355" y="456182"/>
                  <a:pt x="8262937" y="493979"/>
                  <a:pt x="8348662" y="520146"/>
                </a:cubicBezTo>
                <a:cubicBezTo>
                  <a:pt x="8477249" y="560851"/>
                  <a:pt x="8541543" y="543406"/>
                  <a:pt x="8637984" y="459090"/>
                </a:cubicBezTo>
                <a:cubicBezTo>
                  <a:pt x="8691561" y="409663"/>
                  <a:pt x="8737996" y="360236"/>
                  <a:pt x="8784431" y="290457"/>
                </a:cubicBezTo>
                <a:cubicBezTo>
                  <a:pt x="8809434" y="450367"/>
                  <a:pt x="8895158" y="284642"/>
                  <a:pt x="8948737" y="339884"/>
                </a:cubicBezTo>
                <a:cubicBezTo>
                  <a:pt x="8970168" y="453274"/>
                  <a:pt x="8798717" y="543406"/>
                  <a:pt x="8848725" y="697501"/>
                </a:cubicBezTo>
                <a:cubicBezTo>
                  <a:pt x="8995171" y="511424"/>
                  <a:pt x="9041606" y="302087"/>
                  <a:pt x="9238059" y="165437"/>
                </a:cubicBezTo>
                <a:cubicBezTo>
                  <a:pt x="9280921" y="197419"/>
                  <a:pt x="9238059" y="229401"/>
                  <a:pt x="9255919" y="255567"/>
                </a:cubicBezTo>
                <a:cubicBezTo>
                  <a:pt x="9266634" y="255567"/>
                  <a:pt x="9198767" y="560851"/>
                  <a:pt x="9477374" y="578295"/>
                </a:cubicBezTo>
                <a:cubicBezTo>
                  <a:pt x="9477374" y="584110"/>
                  <a:pt x="9477374" y="589925"/>
                  <a:pt x="9488091" y="595740"/>
                </a:cubicBezTo>
                <a:cubicBezTo>
                  <a:pt x="9527380" y="627722"/>
                  <a:pt x="9620249" y="598648"/>
                  <a:pt x="9627393" y="650981"/>
                </a:cubicBezTo>
                <a:cubicBezTo>
                  <a:pt x="9634537" y="709131"/>
                  <a:pt x="9666684" y="764373"/>
                  <a:pt x="9648824" y="825429"/>
                </a:cubicBezTo>
                <a:cubicBezTo>
                  <a:pt x="9634537" y="871948"/>
                  <a:pt x="9616678" y="921374"/>
                  <a:pt x="9616678" y="970802"/>
                </a:cubicBezTo>
                <a:cubicBezTo>
                  <a:pt x="9616678" y="1023136"/>
                  <a:pt x="9495233" y="1095822"/>
                  <a:pt x="9655968" y="1127805"/>
                </a:cubicBezTo>
                <a:cubicBezTo>
                  <a:pt x="9663111" y="1127805"/>
                  <a:pt x="9645252" y="1217935"/>
                  <a:pt x="9638109" y="1267362"/>
                </a:cubicBezTo>
                <a:cubicBezTo>
                  <a:pt x="9630965" y="1308066"/>
                  <a:pt x="9598818" y="1357494"/>
                  <a:pt x="9663111" y="1386568"/>
                </a:cubicBezTo>
                <a:cubicBezTo>
                  <a:pt x="9702403" y="1401105"/>
                  <a:pt x="9773840" y="1331326"/>
                  <a:pt x="9780984" y="1270269"/>
                </a:cubicBezTo>
                <a:cubicBezTo>
                  <a:pt x="9788127" y="1215028"/>
                  <a:pt x="9795271" y="1159787"/>
                  <a:pt x="9780984" y="1107452"/>
                </a:cubicBezTo>
                <a:cubicBezTo>
                  <a:pt x="9763125" y="1043488"/>
                  <a:pt x="9791699" y="1008598"/>
                  <a:pt x="9855993" y="991154"/>
                </a:cubicBezTo>
                <a:cubicBezTo>
                  <a:pt x="9923858" y="970802"/>
                  <a:pt x="9959577" y="933005"/>
                  <a:pt x="9991724" y="880670"/>
                </a:cubicBezTo>
                <a:cubicBezTo>
                  <a:pt x="10070305" y="752742"/>
                  <a:pt x="10163174" y="630630"/>
                  <a:pt x="10209609" y="491071"/>
                </a:cubicBezTo>
                <a:cubicBezTo>
                  <a:pt x="10216753" y="464905"/>
                  <a:pt x="10231040" y="432923"/>
                  <a:pt x="10291762" y="421292"/>
                </a:cubicBezTo>
                <a:cubicBezTo>
                  <a:pt x="10198893" y="799262"/>
                  <a:pt x="9959577" y="1142341"/>
                  <a:pt x="9973865" y="1531941"/>
                </a:cubicBezTo>
                <a:cubicBezTo>
                  <a:pt x="10048874" y="1427272"/>
                  <a:pt x="10052446" y="1302252"/>
                  <a:pt x="10106024" y="1188861"/>
                </a:cubicBezTo>
                <a:cubicBezTo>
                  <a:pt x="10145315" y="1270269"/>
                  <a:pt x="10102453" y="1345863"/>
                  <a:pt x="10081022" y="1421458"/>
                </a:cubicBezTo>
                <a:cubicBezTo>
                  <a:pt x="10063162" y="1485421"/>
                  <a:pt x="10059590" y="1543570"/>
                  <a:pt x="10170318" y="1549385"/>
                </a:cubicBezTo>
                <a:cubicBezTo>
                  <a:pt x="10181034" y="1549385"/>
                  <a:pt x="10188178" y="1549385"/>
                  <a:pt x="10198893" y="1549385"/>
                </a:cubicBezTo>
                <a:cubicBezTo>
                  <a:pt x="10245327" y="1526126"/>
                  <a:pt x="10266759" y="1494144"/>
                  <a:pt x="10281046" y="1453439"/>
                </a:cubicBezTo>
                <a:cubicBezTo>
                  <a:pt x="10288190" y="1430180"/>
                  <a:pt x="10302477" y="1398198"/>
                  <a:pt x="10334625" y="1398198"/>
                </a:cubicBezTo>
                <a:cubicBezTo>
                  <a:pt x="10456068" y="1401105"/>
                  <a:pt x="10491787" y="1322604"/>
                  <a:pt x="10527506" y="1247010"/>
                </a:cubicBezTo>
                <a:cubicBezTo>
                  <a:pt x="10588228" y="1287714"/>
                  <a:pt x="10545365" y="1322604"/>
                  <a:pt x="10548937" y="1354586"/>
                </a:cubicBezTo>
                <a:cubicBezTo>
                  <a:pt x="10552509" y="1374938"/>
                  <a:pt x="10556080" y="1395290"/>
                  <a:pt x="10588228" y="1395290"/>
                </a:cubicBezTo>
                <a:cubicBezTo>
                  <a:pt x="10613230" y="1395290"/>
                  <a:pt x="10645378" y="1386568"/>
                  <a:pt x="10645378" y="1366216"/>
                </a:cubicBezTo>
                <a:cubicBezTo>
                  <a:pt x="10648949" y="1238288"/>
                  <a:pt x="10820400" y="1165601"/>
                  <a:pt x="10820400" y="1031858"/>
                </a:cubicBezTo>
                <a:cubicBezTo>
                  <a:pt x="10820400" y="950449"/>
                  <a:pt x="10916840" y="1072563"/>
                  <a:pt x="10956131" y="1005691"/>
                </a:cubicBezTo>
                <a:cubicBezTo>
                  <a:pt x="10966847" y="991154"/>
                  <a:pt x="10981133" y="1046395"/>
                  <a:pt x="10977562" y="1069655"/>
                </a:cubicBezTo>
                <a:cubicBezTo>
                  <a:pt x="10973991" y="1092915"/>
                  <a:pt x="10948987" y="1113267"/>
                  <a:pt x="10966847" y="1142341"/>
                </a:cubicBezTo>
                <a:cubicBezTo>
                  <a:pt x="11031140" y="1156879"/>
                  <a:pt x="11056143" y="1119081"/>
                  <a:pt x="11074003" y="1084192"/>
                </a:cubicBezTo>
                <a:cubicBezTo>
                  <a:pt x="11116865" y="1008598"/>
                  <a:pt x="11166871" y="933005"/>
                  <a:pt x="11181159" y="848688"/>
                </a:cubicBezTo>
                <a:cubicBezTo>
                  <a:pt x="11184730" y="819614"/>
                  <a:pt x="11202590" y="802169"/>
                  <a:pt x="11238309" y="805077"/>
                </a:cubicBezTo>
                <a:cubicBezTo>
                  <a:pt x="11284744" y="810891"/>
                  <a:pt x="11270456" y="839966"/>
                  <a:pt x="11266884" y="863226"/>
                </a:cubicBezTo>
                <a:cubicBezTo>
                  <a:pt x="11263312" y="877763"/>
                  <a:pt x="11252596" y="892300"/>
                  <a:pt x="11277600" y="906838"/>
                </a:cubicBezTo>
                <a:cubicBezTo>
                  <a:pt x="11531203" y="566666"/>
                  <a:pt x="11516915" y="386403"/>
                  <a:pt x="11724084" y="5527"/>
                </a:cubicBezTo>
                <a:cubicBezTo>
                  <a:pt x="11763375" y="89842"/>
                  <a:pt x="11734800" y="150899"/>
                  <a:pt x="11727656" y="209048"/>
                </a:cubicBezTo>
                <a:cubicBezTo>
                  <a:pt x="11709796" y="354421"/>
                  <a:pt x="11677649" y="264290"/>
                  <a:pt x="11656218" y="409663"/>
                </a:cubicBezTo>
                <a:cubicBezTo>
                  <a:pt x="11645503" y="479442"/>
                  <a:pt x="11609784" y="543406"/>
                  <a:pt x="11666934" y="621907"/>
                </a:cubicBezTo>
                <a:cubicBezTo>
                  <a:pt x="11706225" y="674241"/>
                  <a:pt x="11663362" y="758557"/>
                  <a:pt x="11631215" y="822521"/>
                </a:cubicBezTo>
                <a:cubicBezTo>
                  <a:pt x="11602640" y="874856"/>
                  <a:pt x="11595497" y="927190"/>
                  <a:pt x="11631215" y="996969"/>
                </a:cubicBezTo>
                <a:cubicBezTo>
                  <a:pt x="11652646" y="933005"/>
                  <a:pt x="11670505" y="883578"/>
                  <a:pt x="11684793" y="834151"/>
                </a:cubicBezTo>
                <a:cubicBezTo>
                  <a:pt x="11695509" y="793447"/>
                  <a:pt x="11720512" y="770187"/>
                  <a:pt x="11774090" y="773095"/>
                </a:cubicBezTo>
                <a:cubicBezTo>
                  <a:pt x="11802665" y="773095"/>
                  <a:pt x="11841956" y="764373"/>
                  <a:pt x="11856243" y="793447"/>
                </a:cubicBezTo>
                <a:cubicBezTo>
                  <a:pt x="11870531" y="816706"/>
                  <a:pt x="11856243" y="848688"/>
                  <a:pt x="11831240" y="860319"/>
                </a:cubicBezTo>
                <a:cubicBezTo>
                  <a:pt x="11784806" y="874856"/>
                  <a:pt x="11741944" y="889393"/>
                  <a:pt x="11738371" y="938820"/>
                </a:cubicBezTo>
                <a:cubicBezTo>
                  <a:pt x="11731228" y="1005691"/>
                  <a:pt x="11759802" y="967894"/>
                  <a:pt x="11795521" y="956264"/>
                </a:cubicBezTo>
                <a:cubicBezTo>
                  <a:pt x="11834812" y="944634"/>
                  <a:pt x="11845527" y="979524"/>
                  <a:pt x="11838384" y="1002784"/>
                </a:cubicBezTo>
                <a:cubicBezTo>
                  <a:pt x="11806237" y="1090007"/>
                  <a:pt x="11863387" y="1180138"/>
                  <a:pt x="11816952" y="1270269"/>
                </a:cubicBezTo>
                <a:cubicBezTo>
                  <a:pt x="11931252" y="1247010"/>
                  <a:pt x="11981259" y="1197583"/>
                  <a:pt x="11999118" y="1092915"/>
                </a:cubicBezTo>
                <a:cubicBezTo>
                  <a:pt x="12002690" y="1055118"/>
                  <a:pt x="11995547" y="1014413"/>
                  <a:pt x="12027693" y="979524"/>
                </a:cubicBezTo>
                <a:cubicBezTo>
                  <a:pt x="12045553" y="959172"/>
                  <a:pt x="12066984" y="938820"/>
                  <a:pt x="12102703" y="953357"/>
                </a:cubicBezTo>
                <a:cubicBezTo>
                  <a:pt x="12127705" y="962080"/>
                  <a:pt x="12127705" y="985338"/>
                  <a:pt x="12120562" y="1005691"/>
                </a:cubicBezTo>
                <a:cubicBezTo>
                  <a:pt x="12081272" y="1090007"/>
                  <a:pt x="12070555" y="1180138"/>
                  <a:pt x="12056268" y="1267362"/>
                </a:cubicBezTo>
                <a:cubicBezTo>
                  <a:pt x="12052697" y="1281899"/>
                  <a:pt x="12045553" y="1296437"/>
                  <a:pt x="12081272" y="1310974"/>
                </a:cubicBezTo>
                <a:cubicBezTo>
                  <a:pt x="12113418" y="1209213"/>
                  <a:pt x="12156280" y="1110359"/>
                  <a:pt x="12191999" y="1008598"/>
                </a:cubicBezTo>
                <a:lnTo>
                  <a:pt x="12191999" y="6105653"/>
                </a:lnTo>
                <a:lnTo>
                  <a:pt x="0" y="6105653"/>
                </a:lnTo>
                <a:lnTo>
                  <a:pt x="0" y="927116"/>
                </a:lnTo>
                <a:lnTo>
                  <a:pt x="61930" y="902578"/>
                </a:lnTo>
                <a:cubicBezTo>
                  <a:pt x="91454" y="894128"/>
                  <a:pt x="122931" y="887949"/>
                  <a:pt x="155971" y="883588"/>
                </a:cubicBezTo>
                <a:cubicBezTo>
                  <a:pt x="223837" y="877773"/>
                  <a:pt x="245268" y="839976"/>
                  <a:pt x="277414" y="802179"/>
                </a:cubicBezTo>
                <a:cubicBezTo>
                  <a:pt x="388143" y="674251"/>
                  <a:pt x="488155" y="537601"/>
                  <a:pt x="638174" y="430025"/>
                </a:cubicBezTo>
                <a:cubicBezTo>
                  <a:pt x="620315" y="555046"/>
                  <a:pt x="520302" y="653899"/>
                  <a:pt x="477440" y="784735"/>
                </a:cubicBezTo>
                <a:cubicBezTo>
                  <a:pt x="641746" y="680066"/>
                  <a:pt x="727471" y="543415"/>
                  <a:pt x="827483" y="418395"/>
                </a:cubicBezTo>
                <a:cubicBezTo>
                  <a:pt x="873917" y="360246"/>
                  <a:pt x="931068" y="307912"/>
                  <a:pt x="956071" y="241040"/>
                </a:cubicBezTo>
                <a:cubicBezTo>
                  <a:pt x="961429" y="223595"/>
                  <a:pt x="972814" y="196338"/>
                  <a:pt x="999268" y="192386"/>
                </a:cubicBezTo>
                <a:cubicBezTo>
                  <a:pt x="1008086" y="191069"/>
                  <a:pt x="1018579" y="192341"/>
                  <a:pt x="1031080" y="197429"/>
                </a:cubicBezTo>
                <a:cubicBezTo>
                  <a:pt x="1073942" y="214873"/>
                  <a:pt x="1059654" y="246855"/>
                  <a:pt x="1048940" y="275930"/>
                </a:cubicBezTo>
                <a:cubicBezTo>
                  <a:pt x="1020365" y="345708"/>
                  <a:pt x="1020365" y="421303"/>
                  <a:pt x="1020365" y="517249"/>
                </a:cubicBezTo>
                <a:cubicBezTo>
                  <a:pt x="1156096" y="435840"/>
                  <a:pt x="1113233" y="287560"/>
                  <a:pt x="1256108" y="217780"/>
                </a:cubicBezTo>
                <a:cubicBezTo>
                  <a:pt x="1281111" y="305004"/>
                  <a:pt x="1231105" y="371876"/>
                  <a:pt x="1220389" y="441654"/>
                </a:cubicBezTo>
                <a:cubicBezTo>
                  <a:pt x="1209674" y="505619"/>
                  <a:pt x="1234677" y="520156"/>
                  <a:pt x="1313258" y="505619"/>
                </a:cubicBezTo>
                <a:cubicBezTo>
                  <a:pt x="1434702" y="482359"/>
                  <a:pt x="1495424" y="517249"/>
                  <a:pt x="1463277" y="610287"/>
                </a:cubicBezTo>
                <a:cubicBezTo>
                  <a:pt x="1431130" y="697511"/>
                  <a:pt x="1477565" y="706233"/>
                  <a:pt x="1545430" y="682974"/>
                </a:cubicBezTo>
                <a:cubicBezTo>
                  <a:pt x="1645442" y="648084"/>
                  <a:pt x="1724024" y="685881"/>
                  <a:pt x="1809749" y="712048"/>
                </a:cubicBezTo>
                <a:cubicBezTo>
                  <a:pt x="1938336" y="752753"/>
                  <a:pt x="2002630" y="735308"/>
                  <a:pt x="2099071" y="650992"/>
                </a:cubicBezTo>
                <a:cubicBezTo>
                  <a:pt x="2152648" y="601565"/>
                  <a:pt x="2199083" y="552138"/>
                  <a:pt x="2245518" y="482359"/>
                </a:cubicBezTo>
                <a:cubicBezTo>
                  <a:pt x="2270521" y="642269"/>
                  <a:pt x="2356245" y="476544"/>
                  <a:pt x="2409824" y="531786"/>
                </a:cubicBezTo>
                <a:cubicBezTo>
                  <a:pt x="2431255" y="645176"/>
                  <a:pt x="2259804" y="735308"/>
                  <a:pt x="2309812" y="889403"/>
                </a:cubicBezTo>
                <a:cubicBezTo>
                  <a:pt x="2456258" y="703326"/>
                  <a:pt x="2502693" y="493989"/>
                  <a:pt x="2699146" y="357339"/>
                </a:cubicBezTo>
                <a:cubicBezTo>
                  <a:pt x="2742008" y="389321"/>
                  <a:pt x="2699146" y="421303"/>
                  <a:pt x="2717006" y="447469"/>
                </a:cubicBezTo>
                <a:cubicBezTo>
                  <a:pt x="2727721" y="447469"/>
                  <a:pt x="2659854" y="752753"/>
                  <a:pt x="2938461" y="770197"/>
                </a:cubicBezTo>
                <a:cubicBezTo>
                  <a:pt x="2938461" y="776012"/>
                  <a:pt x="2938461" y="781827"/>
                  <a:pt x="2949178" y="787642"/>
                </a:cubicBezTo>
                <a:cubicBezTo>
                  <a:pt x="2988467" y="819624"/>
                  <a:pt x="3081336" y="790550"/>
                  <a:pt x="3088480" y="842883"/>
                </a:cubicBezTo>
                <a:cubicBezTo>
                  <a:pt x="3095624" y="901033"/>
                  <a:pt x="3127771" y="956275"/>
                  <a:pt x="3109911" y="1017331"/>
                </a:cubicBezTo>
                <a:cubicBezTo>
                  <a:pt x="3095624" y="1063850"/>
                  <a:pt x="3077765" y="1113276"/>
                  <a:pt x="3077765" y="1162704"/>
                </a:cubicBezTo>
                <a:cubicBezTo>
                  <a:pt x="3077765" y="1215038"/>
                  <a:pt x="2956320" y="1287724"/>
                  <a:pt x="3117055" y="1319707"/>
                </a:cubicBezTo>
                <a:cubicBezTo>
                  <a:pt x="3124198" y="1319707"/>
                  <a:pt x="3106339" y="1409837"/>
                  <a:pt x="3099196" y="1459264"/>
                </a:cubicBezTo>
                <a:cubicBezTo>
                  <a:pt x="3092052" y="1499968"/>
                  <a:pt x="3059905" y="1549396"/>
                  <a:pt x="3124198" y="1578470"/>
                </a:cubicBezTo>
                <a:cubicBezTo>
                  <a:pt x="3163490" y="1593007"/>
                  <a:pt x="3234927" y="1523228"/>
                  <a:pt x="3242071" y="1462171"/>
                </a:cubicBezTo>
                <a:cubicBezTo>
                  <a:pt x="3249214" y="1406930"/>
                  <a:pt x="3256358" y="1351689"/>
                  <a:pt x="3242071" y="1299354"/>
                </a:cubicBezTo>
                <a:cubicBezTo>
                  <a:pt x="3224212" y="1235390"/>
                  <a:pt x="3252786" y="1200500"/>
                  <a:pt x="3317080" y="1183056"/>
                </a:cubicBezTo>
                <a:cubicBezTo>
                  <a:pt x="3384945" y="1162704"/>
                  <a:pt x="3420664" y="1124907"/>
                  <a:pt x="3452811" y="1072572"/>
                </a:cubicBezTo>
                <a:cubicBezTo>
                  <a:pt x="3531392" y="944644"/>
                  <a:pt x="3624261" y="822532"/>
                  <a:pt x="3670696" y="682973"/>
                </a:cubicBezTo>
                <a:cubicBezTo>
                  <a:pt x="3677840" y="656807"/>
                  <a:pt x="3692127" y="624825"/>
                  <a:pt x="3752849" y="613194"/>
                </a:cubicBezTo>
                <a:cubicBezTo>
                  <a:pt x="3659980" y="991164"/>
                  <a:pt x="3420664" y="1334243"/>
                  <a:pt x="3434952" y="1723843"/>
                </a:cubicBezTo>
                <a:cubicBezTo>
                  <a:pt x="3509961" y="1619174"/>
                  <a:pt x="3513533" y="1494154"/>
                  <a:pt x="3567111" y="1380763"/>
                </a:cubicBezTo>
                <a:cubicBezTo>
                  <a:pt x="3606402" y="1462171"/>
                  <a:pt x="3563540" y="1537765"/>
                  <a:pt x="3542109" y="1613360"/>
                </a:cubicBezTo>
                <a:cubicBezTo>
                  <a:pt x="3524249" y="1677323"/>
                  <a:pt x="3520677" y="1735472"/>
                  <a:pt x="3631405" y="1741287"/>
                </a:cubicBezTo>
                <a:cubicBezTo>
                  <a:pt x="3642121" y="1741287"/>
                  <a:pt x="3649265" y="1741287"/>
                  <a:pt x="3659980" y="1741287"/>
                </a:cubicBezTo>
                <a:cubicBezTo>
                  <a:pt x="3706414" y="1718028"/>
                  <a:pt x="3727846" y="1686046"/>
                  <a:pt x="3742133" y="1645341"/>
                </a:cubicBezTo>
                <a:cubicBezTo>
                  <a:pt x="3749277" y="1622082"/>
                  <a:pt x="3763564" y="1590100"/>
                  <a:pt x="3795712" y="1590100"/>
                </a:cubicBezTo>
                <a:cubicBezTo>
                  <a:pt x="3917155" y="1593007"/>
                  <a:pt x="3952874" y="1514506"/>
                  <a:pt x="3988593" y="1438912"/>
                </a:cubicBezTo>
                <a:cubicBezTo>
                  <a:pt x="4049315" y="1479616"/>
                  <a:pt x="4006452" y="1514506"/>
                  <a:pt x="4010024" y="1546488"/>
                </a:cubicBezTo>
                <a:cubicBezTo>
                  <a:pt x="4013596" y="1566840"/>
                  <a:pt x="4017167" y="1587192"/>
                  <a:pt x="4049315" y="1587192"/>
                </a:cubicBezTo>
                <a:cubicBezTo>
                  <a:pt x="4074317" y="1587192"/>
                  <a:pt x="4106465" y="1578470"/>
                  <a:pt x="4106465" y="1558118"/>
                </a:cubicBezTo>
                <a:cubicBezTo>
                  <a:pt x="4110036" y="1430190"/>
                  <a:pt x="4281487" y="1357503"/>
                  <a:pt x="4281487" y="1223760"/>
                </a:cubicBezTo>
                <a:cubicBezTo>
                  <a:pt x="4281487" y="1142351"/>
                  <a:pt x="4377927" y="1264465"/>
                  <a:pt x="4417219" y="1197593"/>
                </a:cubicBezTo>
                <a:cubicBezTo>
                  <a:pt x="4427935" y="1183056"/>
                  <a:pt x="4442220" y="1238297"/>
                  <a:pt x="4438649" y="1261557"/>
                </a:cubicBezTo>
                <a:cubicBezTo>
                  <a:pt x="4435078" y="1284817"/>
                  <a:pt x="4410074" y="1305169"/>
                  <a:pt x="4427935" y="1334243"/>
                </a:cubicBezTo>
                <a:cubicBezTo>
                  <a:pt x="4492228" y="1348781"/>
                  <a:pt x="4517230" y="1310983"/>
                  <a:pt x="4535090" y="1276094"/>
                </a:cubicBezTo>
                <a:cubicBezTo>
                  <a:pt x="4577952" y="1200500"/>
                  <a:pt x="4627958" y="1124907"/>
                  <a:pt x="4642246" y="1040590"/>
                </a:cubicBezTo>
                <a:cubicBezTo>
                  <a:pt x="4645817" y="1011516"/>
                  <a:pt x="4663677" y="994071"/>
                  <a:pt x="4699396" y="996979"/>
                </a:cubicBezTo>
                <a:cubicBezTo>
                  <a:pt x="4745832" y="1002793"/>
                  <a:pt x="4731544" y="1031868"/>
                  <a:pt x="4727971" y="1055128"/>
                </a:cubicBezTo>
                <a:cubicBezTo>
                  <a:pt x="4724399" y="1069665"/>
                  <a:pt x="4713683" y="1084202"/>
                  <a:pt x="4738688" y="1098740"/>
                </a:cubicBezTo>
                <a:cubicBezTo>
                  <a:pt x="4992291" y="758568"/>
                  <a:pt x="4978002" y="578305"/>
                  <a:pt x="5185172" y="197429"/>
                </a:cubicBezTo>
                <a:cubicBezTo>
                  <a:pt x="5224462" y="281744"/>
                  <a:pt x="5195887" y="342801"/>
                  <a:pt x="5188744" y="400950"/>
                </a:cubicBezTo>
                <a:cubicBezTo>
                  <a:pt x="5170883" y="546323"/>
                  <a:pt x="5138736" y="456192"/>
                  <a:pt x="5117306" y="601565"/>
                </a:cubicBezTo>
                <a:cubicBezTo>
                  <a:pt x="5106590" y="671344"/>
                  <a:pt x="5070871" y="735308"/>
                  <a:pt x="5128021" y="813809"/>
                </a:cubicBezTo>
                <a:cubicBezTo>
                  <a:pt x="5167312" y="866143"/>
                  <a:pt x="5124450" y="950459"/>
                  <a:pt x="5092302" y="1014423"/>
                </a:cubicBezTo>
                <a:cubicBezTo>
                  <a:pt x="5063727" y="1066758"/>
                  <a:pt x="5056585" y="1119092"/>
                  <a:pt x="5092302" y="1188871"/>
                </a:cubicBezTo>
                <a:cubicBezTo>
                  <a:pt x="5113734" y="1124907"/>
                  <a:pt x="5131592" y="1075480"/>
                  <a:pt x="5145880" y="1026053"/>
                </a:cubicBezTo>
                <a:cubicBezTo>
                  <a:pt x="5156596" y="985349"/>
                  <a:pt x="5181600" y="962089"/>
                  <a:pt x="5235177" y="964997"/>
                </a:cubicBezTo>
                <a:cubicBezTo>
                  <a:pt x="5263752" y="964997"/>
                  <a:pt x="5303044" y="956275"/>
                  <a:pt x="5317331" y="985349"/>
                </a:cubicBezTo>
                <a:cubicBezTo>
                  <a:pt x="5331618" y="1008608"/>
                  <a:pt x="5317331" y="1040590"/>
                  <a:pt x="5292327" y="1052221"/>
                </a:cubicBezTo>
                <a:cubicBezTo>
                  <a:pt x="5245894" y="1066758"/>
                  <a:pt x="5203031" y="1081295"/>
                  <a:pt x="5199458" y="1130722"/>
                </a:cubicBezTo>
                <a:cubicBezTo>
                  <a:pt x="5192315" y="1197593"/>
                  <a:pt x="5220889" y="1159796"/>
                  <a:pt x="5256608" y="1148166"/>
                </a:cubicBezTo>
                <a:cubicBezTo>
                  <a:pt x="5295899" y="1136536"/>
                  <a:pt x="5306616" y="1171426"/>
                  <a:pt x="5299471" y="1194686"/>
                </a:cubicBezTo>
                <a:cubicBezTo>
                  <a:pt x="5267324" y="1281909"/>
                  <a:pt x="5324474" y="1372040"/>
                  <a:pt x="5278039" y="1462171"/>
                </a:cubicBezTo>
                <a:cubicBezTo>
                  <a:pt x="5392339" y="1438912"/>
                  <a:pt x="5442347" y="1389485"/>
                  <a:pt x="5460205" y="1284817"/>
                </a:cubicBezTo>
                <a:cubicBezTo>
                  <a:pt x="5463777" y="1247020"/>
                  <a:pt x="5456634" y="1206315"/>
                  <a:pt x="5488780" y="1171426"/>
                </a:cubicBezTo>
                <a:cubicBezTo>
                  <a:pt x="5502175" y="1156162"/>
                  <a:pt x="5517579" y="1140898"/>
                  <a:pt x="5539513" y="1140353"/>
                </a:cubicBezTo>
                <a:lnTo>
                  <a:pt x="5552720" y="1143022"/>
                </a:lnTo>
                <a:lnTo>
                  <a:pt x="5574208" y="1115811"/>
                </a:lnTo>
                <a:cubicBezTo>
                  <a:pt x="5609034" y="1085646"/>
                  <a:pt x="5659040" y="1068202"/>
                  <a:pt x="5734050" y="1075470"/>
                </a:cubicBezTo>
                <a:cubicBezTo>
                  <a:pt x="5776912" y="1078377"/>
                  <a:pt x="5809058" y="1055118"/>
                  <a:pt x="5798343" y="1020228"/>
                </a:cubicBezTo>
                <a:cubicBezTo>
                  <a:pt x="5776912" y="953357"/>
                  <a:pt x="5837634" y="921375"/>
                  <a:pt x="5884068" y="883578"/>
                </a:cubicBezTo>
                <a:cubicBezTo>
                  <a:pt x="5966221" y="816706"/>
                  <a:pt x="6051947" y="752742"/>
                  <a:pt x="6066234" y="645166"/>
                </a:cubicBezTo>
                <a:cubicBezTo>
                  <a:pt x="6130528" y="665519"/>
                  <a:pt x="6123384" y="700408"/>
                  <a:pt x="6109096" y="732391"/>
                </a:cubicBezTo>
                <a:cubicBezTo>
                  <a:pt x="6073377" y="816706"/>
                  <a:pt x="6034087" y="901023"/>
                  <a:pt x="5998368" y="985338"/>
                </a:cubicBezTo>
                <a:cubicBezTo>
                  <a:pt x="5976937" y="1040581"/>
                  <a:pt x="5944790" y="1095822"/>
                  <a:pt x="5969793" y="1168509"/>
                </a:cubicBezTo>
                <a:cubicBezTo>
                  <a:pt x="6098380" y="1104545"/>
                  <a:pt x="6123384" y="996969"/>
                  <a:pt x="6162674" y="909745"/>
                </a:cubicBezTo>
                <a:cubicBezTo>
                  <a:pt x="6212681" y="802169"/>
                  <a:pt x="6305549" y="738205"/>
                  <a:pt x="6412705" y="659704"/>
                </a:cubicBezTo>
                <a:cubicBezTo>
                  <a:pt x="6441280" y="738205"/>
                  <a:pt x="6362699" y="787632"/>
                  <a:pt x="6366271" y="851596"/>
                </a:cubicBezTo>
                <a:cubicBezTo>
                  <a:pt x="6376987" y="854503"/>
                  <a:pt x="6398418" y="860319"/>
                  <a:pt x="6398418" y="860319"/>
                </a:cubicBezTo>
                <a:cubicBezTo>
                  <a:pt x="6455568" y="755650"/>
                  <a:pt x="6562724" y="709131"/>
                  <a:pt x="6694884" y="691686"/>
                </a:cubicBezTo>
                <a:cubicBezTo>
                  <a:pt x="6762750" y="685871"/>
                  <a:pt x="6784181" y="648074"/>
                  <a:pt x="6816327" y="610277"/>
                </a:cubicBezTo>
                <a:cubicBezTo>
                  <a:pt x="6927056" y="482349"/>
                  <a:pt x="7027068" y="345699"/>
                  <a:pt x="7177087" y="238123"/>
                </a:cubicBezTo>
                <a:cubicBezTo>
                  <a:pt x="7159228" y="363144"/>
                  <a:pt x="7059215" y="461997"/>
                  <a:pt x="7016353" y="592833"/>
                </a:cubicBezTo>
                <a:cubicBezTo>
                  <a:pt x="7180659" y="488164"/>
                  <a:pt x="7266384" y="351513"/>
                  <a:pt x="7366396" y="226493"/>
                </a:cubicBezTo>
                <a:cubicBezTo>
                  <a:pt x="7412830" y="168344"/>
                  <a:pt x="7469981" y="116010"/>
                  <a:pt x="7494984" y="49138"/>
                </a:cubicBezTo>
                <a:cubicBezTo>
                  <a:pt x="7500342" y="31693"/>
                  <a:pt x="7511727" y="4436"/>
                  <a:pt x="7538181" y="484"/>
                </a:cubicBezTo>
                <a:close/>
              </a:path>
            </a:pathLst>
          </a:custGeom>
          <a:solidFill>
            <a:schemeClr val="accent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58D378E1-14C1-F048-8518-E1B7434025A8}"/>
              </a:ext>
            </a:extLst>
          </p:cNvPr>
          <p:cNvSpPr>
            <a:spLocks noGrp="1"/>
          </p:cNvSpPr>
          <p:nvPr>
            <p:ph type="title"/>
          </p:nvPr>
        </p:nvSpPr>
        <p:spPr>
          <a:xfrm>
            <a:off x="838200" y="365125"/>
            <a:ext cx="10515600" cy="1325563"/>
          </a:xfrm>
        </p:spPr>
        <p:txBody>
          <a:bodyPr>
            <a:normAutofit/>
          </a:bodyPr>
          <a:lstStyle/>
          <a:p>
            <a:r>
              <a:rPr lang="en-US" dirty="0"/>
              <a:t>SPIKES</a:t>
            </a:r>
          </a:p>
        </p:txBody>
      </p:sp>
      <p:graphicFrame>
        <p:nvGraphicFramePr>
          <p:cNvPr id="5" name="Content Placeholder 2">
            <a:extLst>
              <a:ext uri="{FF2B5EF4-FFF2-40B4-BE49-F238E27FC236}">
                <a16:creationId xmlns:a16="http://schemas.microsoft.com/office/drawing/2014/main" id="{5C28B09D-B382-5B4F-87D3-FBFC6C6C199E}"/>
              </a:ext>
            </a:extLst>
          </p:cNvPr>
          <p:cNvGraphicFramePr>
            <a:graphicFrameLocks noGrp="1"/>
          </p:cNvGraphicFramePr>
          <p:nvPr>
            <p:ph idx="1"/>
            <p:extLst>
              <p:ext uri="{D42A27DB-BD31-4B8C-83A1-F6EECF244321}">
                <p14:modId xmlns:p14="http://schemas.microsoft.com/office/powerpoint/2010/main" val="4134369480"/>
              </p:ext>
            </p:extLst>
          </p:nvPr>
        </p:nvGraphicFramePr>
        <p:xfrm>
          <a:off x="838200" y="2011363"/>
          <a:ext cx="10515600" cy="416083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1638981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2" name="Rectangle 11">
            <a:extLst>
              <a:ext uri="{FF2B5EF4-FFF2-40B4-BE49-F238E27FC236}">
                <a16:creationId xmlns:a16="http://schemas.microsoft.com/office/drawing/2014/main" id="{DA8886A6-5426-494B-96D8-D962D2BA08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Freeform: Shape 10">
            <a:extLst>
              <a:ext uri="{FF2B5EF4-FFF2-40B4-BE49-F238E27FC236}">
                <a16:creationId xmlns:a16="http://schemas.microsoft.com/office/drawing/2014/main" id="{AA3ED336-C09E-46E8-9774-B977D15FC5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752347"/>
            <a:ext cx="12191999" cy="6105653"/>
          </a:xfrm>
          <a:custGeom>
            <a:avLst/>
            <a:gdLst>
              <a:gd name="connsiteX0" fmla="*/ 7538181 w 12191999"/>
              <a:gd name="connsiteY0" fmla="*/ 484 h 6105653"/>
              <a:gd name="connsiteX1" fmla="*/ 7569993 w 12191999"/>
              <a:gd name="connsiteY1" fmla="*/ 5527 h 6105653"/>
              <a:gd name="connsiteX2" fmla="*/ 7587853 w 12191999"/>
              <a:gd name="connsiteY2" fmla="*/ 84028 h 6105653"/>
              <a:gd name="connsiteX3" fmla="*/ 7559278 w 12191999"/>
              <a:gd name="connsiteY3" fmla="*/ 325347 h 6105653"/>
              <a:gd name="connsiteX4" fmla="*/ 7795021 w 12191999"/>
              <a:gd name="connsiteY4" fmla="*/ 25878 h 6105653"/>
              <a:gd name="connsiteX5" fmla="*/ 7759302 w 12191999"/>
              <a:gd name="connsiteY5" fmla="*/ 249752 h 6105653"/>
              <a:gd name="connsiteX6" fmla="*/ 7852171 w 12191999"/>
              <a:gd name="connsiteY6" fmla="*/ 313717 h 6105653"/>
              <a:gd name="connsiteX7" fmla="*/ 8002190 w 12191999"/>
              <a:gd name="connsiteY7" fmla="*/ 418385 h 6105653"/>
              <a:gd name="connsiteX8" fmla="*/ 8084343 w 12191999"/>
              <a:gd name="connsiteY8" fmla="*/ 491072 h 6105653"/>
              <a:gd name="connsiteX9" fmla="*/ 8348662 w 12191999"/>
              <a:gd name="connsiteY9" fmla="*/ 520146 h 6105653"/>
              <a:gd name="connsiteX10" fmla="*/ 8637984 w 12191999"/>
              <a:gd name="connsiteY10" fmla="*/ 459090 h 6105653"/>
              <a:gd name="connsiteX11" fmla="*/ 8784431 w 12191999"/>
              <a:gd name="connsiteY11" fmla="*/ 290457 h 6105653"/>
              <a:gd name="connsiteX12" fmla="*/ 8948737 w 12191999"/>
              <a:gd name="connsiteY12" fmla="*/ 339884 h 6105653"/>
              <a:gd name="connsiteX13" fmla="*/ 8848725 w 12191999"/>
              <a:gd name="connsiteY13" fmla="*/ 697501 h 6105653"/>
              <a:gd name="connsiteX14" fmla="*/ 9238059 w 12191999"/>
              <a:gd name="connsiteY14" fmla="*/ 165437 h 6105653"/>
              <a:gd name="connsiteX15" fmla="*/ 9255919 w 12191999"/>
              <a:gd name="connsiteY15" fmla="*/ 255567 h 6105653"/>
              <a:gd name="connsiteX16" fmla="*/ 9477374 w 12191999"/>
              <a:gd name="connsiteY16" fmla="*/ 578295 h 6105653"/>
              <a:gd name="connsiteX17" fmla="*/ 9488091 w 12191999"/>
              <a:gd name="connsiteY17" fmla="*/ 595740 h 6105653"/>
              <a:gd name="connsiteX18" fmla="*/ 9627393 w 12191999"/>
              <a:gd name="connsiteY18" fmla="*/ 650981 h 6105653"/>
              <a:gd name="connsiteX19" fmla="*/ 9648824 w 12191999"/>
              <a:gd name="connsiteY19" fmla="*/ 825429 h 6105653"/>
              <a:gd name="connsiteX20" fmla="*/ 9616678 w 12191999"/>
              <a:gd name="connsiteY20" fmla="*/ 970802 h 6105653"/>
              <a:gd name="connsiteX21" fmla="*/ 9655968 w 12191999"/>
              <a:gd name="connsiteY21" fmla="*/ 1127805 h 6105653"/>
              <a:gd name="connsiteX22" fmla="*/ 9638109 w 12191999"/>
              <a:gd name="connsiteY22" fmla="*/ 1267362 h 6105653"/>
              <a:gd name="connsiteX23" fmla="*/ 9663111 w 12191999"/>
              <a:gd name="connsiteY23" fmla="*/ 1386568 h 6105653"/>
              <a:gd name="connsiteX24" fmla="*/ 9780984 w 12191999"/>
              <a:gd name="connsiteY24" fmla="*/ 1270269 h 6105653"/>
              <a:gd name="connsiteX25" fmla="*/ 9780984 w 12191999"/>
              <a:gd name="connsiteY25" fmla="*/ 1107452 h 6105653"/>
              <a:gd name="connsiteX26" fmla="*/ 9855993 w 12191999"/>
              <a:gd name="connsiteY26" fmla="*/ 991154 h 6105653"/>
              <a:gd name="connsiteX27" fmla="*/ 9991724 w 12191999"/>
              <a:gd name="connsiteY27" fmla="*/ 880670 h 6105653"/>
              <a:gd name="connsiteX28" fmla="*/ 10209609 w 12191999"/>
              <a:gd name="connsiteY28" fmla="*/ 491071 h 6105653"/>
              <a:gd name="connsiteX29" fmla="*/ 10291762 w 12191999"/>
              <a:gd name="connsiteY29" fmla="*/ 421292 h 6105653"/>
              <a:gd name="connsiteX30" fmla="*/ 9973865 w 12191999"/>
              <a:gd name="connsiteY30" fmla="*/ 1531941 h 6105653"/>
              <a:gd name="connsiteX31" fmla="*/ 10106024 w 12191999"/>
              <a:gd name="connsiteY31" fmla="*/ 1188861 h 6105653"/>
              <a:gd name="connsiteX32" fmla="*/ 10081022 w 12191999"/>
              <a:gd name="connsiteY32" fmla="*/ 1421458 h 6105653"/>
              <a:gd name="connsiteX33" fmla="*/ 10170318 w 12191999"/>
              <a:gd name="connsiteY33" fmla="*/ 1549385 h 6105653"/>
              <a:gd name="connsiteX34" fmla="*/ 10198893 w 12191999"/>
              <a:gd name="connsiteY34" fmla="*/ 1549385 h 6105653"/>
              <a:gd name="connsiteX35" fmla="*/ 10281046 w 12191999"/>
              <a:gd name="connsiteY35" fmla="*/ 1453439 h 6105653"/>
              <a:gd name="connsiteX36" fmla="*/ 10334625 w 12191999"/>
              <a:gd name="connsiteY36" fmla="*/ 1398198 h 6105653"/>
              <a:gd name="connsiteX37" fmla="*/ 10527506 w 12191999"/>
              <a:gd name="connsiteY37" fmla="*/ 1247010 h 6105653"/>
              <a:gd name="connsiteX38" fmla="*/ 10548937 w 12191999"/>
              <a:gd name="connsiteY38" fmla="*/ 1354586 h 6105653"/>
              <a:gd name="connsiteX39" fmla="*/ 10588228 w 12191999"/>
              <a:gd name="connsiteY39" fmla="*/ 1395290 h 6105653"/>
              <a:gd name="connsiteX40" fmla="*/ 10645378 w 12191999"/>
              <a:gd name="connsiteY40" fmla="*/ 1366216 h 6105653"/>
              <a:gd name="connsiteX41" fmla="*/ 10820400 w 12191999"/>
              <a:gd name="connsiteY41" fmla="*/ 1031858 h 6105653"/>
              <a:gd name="connsiteX42" fmla="*/ 10956131 w 12191999"/>
              <a:gd name="connsiteY42" fmla="*/ 1005691 h 6105653"/>
              <a:gd name="connsiteX43" fmla="*/ 10977562 w 12191999"/>
              <a:gd name="connsiteY43" fmla="*/ 1069655 h 6105653"/>
              <a:gd name="connsiteX44" fmla="*/ 10966847 w 12191999"/>
              <a:gd name="connsiteY44" fmla="*/ 1142341 h 6105653"/>
              <a:gd name="connsiteX45" fmla="*/ 11074003 w 12191999"/>
              <a:gd name="connsiteY45" fmla="*/ 1084192 h 6105653"/>
              <a:gd name="connsiteX46" fmla="*/ 11181159 w 12191999"/>
              <a:gd name="connsiteY46" fmla="*/ 848688 h 6105653"/>
              <a:gd name="connsiteX47" fmla="*/ 11238309 w 12191999"/>
              <a:gd name="connsiteY47" fmla="*/ 805077 h 6105653"/>
              <a:gd name="connsiteX48" fmla="*/ 11266884 w 12191999"/>
              <a:gd name="connsiteY48" fmla="*/ 863226 h 6105653"/>
              <a:gd name="connsiteX49" fmla="*/ 11277600 w 12191999"/>
              <a:gd name="connsiteY49" fmla="*/ 906838 h 6105653"/>
              <a:gd name="connsiteX50" fmla="*/ 11724084 w 12191999"/>
              <a:gd name="connsiteY50" fmla="*/ 5527 h 6105653"/>
              <a:gd name="connsiteX51" fmla="*/ 11727656 w 12191999"/>
              <a:gd name="connsiteY51" fmla="*/ 209048 h 6105653"/>
              <a:gd name="connsiteX52" fmla="*/ 11656218 w 12191999"/>
              <a:gd name="connsiteY52" fmla="*/ 409663 h 6105653"/>
              <a:gd name="connsiteX53" fmla="*/ 11666934 w 12191999"/>
              <a:gd name="connsiteY53" fmla="*/ 621907 h 6105653"/>
              <a:gd name="connsiteX54" fmla="*/ 11631215 w 12191999"/>
              <a:gd name="connsiteY54" fmla="*/ 822521 h 6105653"/>
              <a:gd name="connsiteX55" fmla="*/ 11631215 w 12191999"/>
              <a:gd name="connsiteY55" fmla="*/ 996969 h 6105653"/>
              <a:gd name="connsiteX56" fmla="*/ 11684793 w 12191999"/>
              <a:gd name="connsiteY56" fmla="*/ 834151 h 6105653"/>
              <a:gd name="connsiteX57" fmla="*/ 11774090 w 12191999"/>
              <a:gd name="connsiteY57" fmla="*/ 773095 h 6105653"/>
              <a:gd name="connsiteX58" fmla="*/ 11856243 w 12191999"/>
              <a:gd name="connsiteY58" fmla="*/ 793447 h 6105653"/>
              <a:gd name="connsiteX59" fmla="*/ 11831240 w 12191999"/>
              <a:gd name="connsiteY59" fmla="*/ 860319 h 6105653"/>
              <a:gd name="connsiteX60" fmla="*/ 11738371 w 12191999"/>
              <a:gd name="connsiteY60" fmla="*/ 938820 h 6105653"/>
              <a:gd name="connsiteX61" fmla="*/ 11795521 w 12191999"/>
              <a:gd name="connsiteY61" fmla="*/ 956264 h 6105653"/>
              <a:gd name="connsiteX62" fmla="*/ 11838384 w 12191999"/>
              <a:gd name="connsiteY62" fmla="*/ 1002784 h 6105653"/>
              <a:gd name="connsiteX63" fmla="*/ 11816952 w 12191999"/>
              <a:gd name="connsiteY63" fmla="*/ 1270269 h 6105653"/>
              <a:gd name="connsiteX64" fmla="*/ 11999118 w 12191999"/>
              <a:gd name="connsiteY64" fmla="*/ 1092915 h 6105653"/>
              <a:gd name="connsiteX65" fmla="*/ 12027693 w 12191999"/>
              <a:gd name="connsiteY65" fmla="*/ 979524 h 6105653"/>
              <a:gd name="connsiteX66" fmla="*/ 12102703 w 12191999"/>
              <a:gd name="connsiteY66" fmla="*/ 953357 h 6105653"/>
              <a:gd name="connsiteX67" fmla="*/ 12120562 w 12191999"/>
              <a:gd name="connsiteY67" fmla="*/ 1005691 h 6105653"/>
              <a:gd name="connsiteX68" fmla="*/ 12056268 w 12191999"/>
              <a:gd name="connsiteY68" fmla="*/ 1267362 h 6105653"/>
              <a:gd name="connsiteX69" fmla="*/ 12081272 w 12191999"/>
              <a:gd name="connsiteY69" fmla="*/ 1310974 h 6105653"/>
              <a:gd name="connsiteX70" fmla="*/ 12191999 w 12191999"/>
              <a:gd name="connsiteY70" fmla="*/ 1008598 h 6105653"/>
              <a:gd name="connsiteX71" fmla="*/ 12191999 w 12191999"/>
              <a:gd name="connsiteY71" fmla="*/ 6105653 h 6105653"/>
              <a:gd name="connsiteX72" fmla="*/ 0 w 12191999"/>
              <a:gd name="connsiteY72" fmla="*/ 6105653 h 6105653"/>
              <a:gd name="connsiteX73" fmla="*/ 0 w 12191999"/>
              <a:gd name="connsiteY73" fmla="*/ 927116 h 6105653"/>
              <a:gd name="connsiteX74" fmla="*/ 61930 w 12191999"/>
              <a:gd name="connsiteY74" fmla="*/ 902578 h 6105653"/>
              <a:gd name="connsiteX75" fmla="*/ 155971 w 12191999"/>
              <a:gd name="connsiteY75" fmla="*/ 883588 h 6105653"/>
              <a:gd name="connsiteX76" fmla="*/ 277414 w 12191999"/>
              <a:gd name="connsiteY76" fmla="*/ 802179 h 6105653"/>
              <a:gd name="connsiteX77" fmla="*/ 638174 w 12191999"/>
              <a:gd name="connsiteY77" fmla="*/ 430025 h 6105653"/>
              <a:gd name="connsiteX78" fmla="*/ 477440 w 12191999"/>
              <a:gd name="connsiteY78" fmla="*/ 784735 h 6105653"/>
              <a:gd name="connsiteX79" fmla="*/ 827483 w 12191999"/>
              <a:gd name="connsiteY79" fmla="*/ 418395 h 6105653"/>
              <a:gd name="connsiteX80" fmla="*/ 956071 w 12191999"/>
              <a:gd name="connsiteY80" fmla="*/ 241040 h 6105653"/>
              <a:gd name="connsiteX81" fmla="*/ 999268 w 12191999"/>
              <a:gd name="connsiteY81" fmla="*/ 192386 h 6105653"/>
              <a:gd name="connsiteX82" fmla="*/ 1031080 w 12191999"/>
              <a:gd name="connsiteY82" fmla="*/ 197429 h 6105653"/>
              <a:gd name="connsiteX83" fmla="*/ 1048940 w 12191999"/>
              <a:gd name="connsiteY83" fmla="*/ 275930 h 6105653"/>
              <a:gd name="connsiteX84" fmla="*/ 1020365 w 12191999"/>
              <a:gd name="connsiteY84" fmla="*/ 517249 h 6105653"/>
              <a:gd name="connsiteX85" fmla="*/ 1256108 w 12191999"/>
              <a:gd name="connsiteY85" fmla="*/ 217780 h 6105653"/>
              <a:gd name="connsiteX86" fmla="*/ 1220389 w 12191999"/>
              <a:gd name="connsiteY86" fmla="*/ 441654 h 6105653"/>
              <a:gd name="connsiteX87" fmla="*/ 1313258 w 12191999"/>
              <a:gd name="connsiteY87" fmla="*/ 505619 h 6105653"/>
              <a:gd name="connsiteX88" fmla="*/ 1463277 w 12191999"/>
              <a:gd name="connsiteY88" fmla="*/ 610287 h 6105653"/>
              <a:gd name="connsiteX89" fmla="*/ 1545430 w 12191999"/>
              <a:gd name="connsiteY89" fmla="*/ 682974 h 6105653"/>
              <a:gd name="connsiteX90" fmla="*/ 1809749 w 12191999"/>
              <a:gd name="connsiteY90" fmla="*/ 712048 h 6105653"/>
              <a:gd name="connsiteX91" fmla="*/ 2099071 w 12191999"/>
              <a:gd name="connsiteY91" fmla="*/ 650992 h 6105653"/>
              <a:gd name="connsiteX92" fmla="*/ 2245518 w 12191999"/>
              <a:gd name="connsiteY92" fmla="*/ 482359 h 6105653"/>
              <a:gd name="connsiteX93" fmla="*/ 2409824 w 12191999"/>
              <a:gd name="connsiteY93" fmla="*/ 531786 h 6105653"/>
              <a:gd name="connsiteX94" fmla="*/ 2309812 w 12191999"/>
              <a:gd name="connsiteY94" fmla="*/ 889403 h 6105653"/>
              <a:gd name="connsiteX95" fmla="*/ 2699146 w 12191999"/>
              <a:gd name="connsiteY95" fmla="*/ 357339 h 6105653"/>
              <a:gd name="connsiteX96" fmla="*/ 2717006 w 12191999"/>
              <a:gd name="connsiteY96" fmla="*/ 447469 h 6105653"/>
              <a:gd name="connsiteX97" fmla="*/ 2938461 w 12191999"/>
              <a:gd name="connsiteY97" fmla="*/ 770197 h 6105653"/>
              <a:gd name="connsiteX98" fmla="*/ 2949178 w 12191999"/>
              <a:gd name="connsiteY98" fmla="*/ 787642 h 6105653"/>
              <a:gd name="connsiteX99" fmla="*/ 3088480 w 12191999"/>
              <a:gd name="connsiteY99" fmla="*/ 842883 h 6105653"/>
              <a:gd name="connsiteX100" fmla="*/ 3109911 w 12191999"/>
              <a:gd name="connsiteY100" fmla="*/ 1017331 h 6105653"/>
              <a:gd name="connsiteX101" fmla="*/ 3077765 w 12191999"/>
              <a:gd name="connsiteY101" fmla="*/ 1162704 h 6105653"/>
              <a:gd name="connsiteX102" fmla="*/ 3117055 w 12191999"/>
              <a:gd name="connsiteY102" fmla="*/ 1319707 h 6105653"/>
              <a:gd name="connsiteX103" fmla="*/ 3099196 w 12191999"/>
              <a:gd name="connsiteY103" fmla="*/ 1459264 h 6105653"/>
              <a:gd name="connsiteX104" fmla="*/ 3124198 w 12191999"/>
              <a:gd name="connsiteY104" fmla="*/ 1578470 h 6105653"/>
              <a:gd name="connsiteX105" fmla="*/ 3242071 w 12191999"/>
              <a:gd name="connsiteY105" fmla="*/ 1462171 h 6105653"/>
              <a:gd name="connsiteX106" fmla="*/ 3242071 w 12191999"/>
              <a:gd name="connsiteY106" fmla="*/ 1299354 h 6105653"/>
              <a:gd name="connsiteX107" fmla="*/ 3317080 w 12191999"/>
              <a:gd name="connsiteY107" fmla="*/ 1183056 h 6105653"/>
              <a:gd name="connsiteX108" fmla="*/ 3452811 w 12191999"/>
              <a:gd name="connsiteY108" fmla="*/ 1072572 h 6105653"/>
              <a:gd name="connsiteX109" fmla="*/ 3670696 w 12191999"/>
              <a:gd name="connsiteY109" fmla="*/ 682973 h 6105653"/>
              <a:gd name="connsiteX110" fmla="*/ 3752849 w 12191999"/>
              <a:gd name="connsiteY110" fmla="*/ 613194 h 6105653"/>
              <a:gd name="connsiteX111" fmla="*/ 3434952 w 12191999"/>
              <a:gd name="connsiteY111" fmla="*/ 1723843 h 6105653"/>
              <a:gd name="connsiteX112" fmla="*/ 3567111 w 12191999"/>
              <a:gd name="connsiteY112" fmla="*/ 1380763 h 6105653"/>
              <a:gd name="connsiteX113" fmla="*/ 3542109 w 12191999"/>
              <a:gd name="connsiteY113" fmla="*/ 1613360 h 6105653"/>
              <a:gd name="connsiteX114" fmla="*/ 3631405 w 12191999"/>
              <a:gd name="connsiteY114" fmla="*/ 1741287 h 6105653"/>
              <a:gd name="connsiteX115" fmla="*/ 3659980 w 12191999"/>
              <a:gd name="connsiteY115" fmla="*/ 1741287 h 6105653"/>
              <a:gd name="connsiteX116" fmla="*/ 3742133 w 12191999"/>
              <a:gd name="connsiteY116" fmla="*/ 1645341 h 6105653"/>
              <a:gd name="connsiteX117" fmla="*/ 3795712 w 12191999"/>
              <a:gd name="connsiteY117" fmla="*/ 1590100 h 6105653"/>
              <a:gd name="connsiteX118" fmla="*/ 3988593 w 12191999"/>
              <a:gd name="connsiteY118" fmla="*/ 1438912 h 6105653"/>
              <a:gd name="connsiteX119" fmla="*/ 4010024 w 12191999"/>
              <a:gd name="connsiteY119" fmla="*/ 1546488 h 6105653"/>
              <a:gd name="connsiteX120" fmla="*/ 4049315 w 12191999"/>
              <a:gd name="connsiteY120" fmla="*/ 1587192 h 6105653"/>
              <a:gd name="connsiteX121" fmla="*/ 4106465 w 12191999"/>
              <a:gd name="connsiteY121" fmla="*/ 1558118 h 6105653"/>
              <a:gd name="connsiteX122" fmla="*/ 4281487 w 12191999"/>
              <a:gd name="connsiteY122" fmla="*/ 1223760 h 6105653"/>
              <a:gd name="connsiteX123" fmla="*/ 4417219 w 12191999"/>
              <a:gd name="connsiteY123" fmla="*/ 1197593 h 6105653"/>
              <a:gd name="connsiteX124" fmla="*/ 4438649 w 12191999"/>
              <a:gd name="connsiteY124" fmla="*/ 1261557 h 6105653"/>
              <a:gd name="connsiteX125" fmla="*/ 4427935 w 12191999"/>
              <a:gd name="connsiteY125" fmla="*/ 1334243 h 6105653"/>
              <a:gd name="connsiteX126" fmla="*/ 4535090 w 12191999"/>
              <a:gd name="connsiteY126" fmla="*/ 1276094 h 6105653"/>
              <a:gd name="connsiteX127" fmla="*/ 4642246 w 12191999"/>
              <a:gd name="connsiteY127" fmla="*/ 1040590 h 6105653"/>
              <a:gd name="connsiteX128" fmla="*/ 4699396 w 12191999"/>
              <a:gd name="connsiteY128" fmla="*/ 996979 h 6105653"/>
              <a:gd name="connsiteX129" fmla="*/ 4727971 w 12191999"/>
              <a:gd name="connsiteY129" fmla="*/ 1055128 h 6105653"/>
              <a:gd name="connsiteX130" fmla="*/ 4738688 w 12191999"/>
              <a:gd name="connsiteY130" fmla="*/ 1098740 h 6105653"/>
              <a:gd name="connsiteX131" fmla="*/ 5185172 w 12191999"/>
              <a:gd name="connsiteY131" fmla="*/ 197429 h 6105653"/>
              <a:gd name="connsiteX132" fmla="*/ 5188744 w 12191999"/>
              <a:gd name="connsiteY132" fmla="*/ 400950 h 6105653"/>
              <a:gd name="connsiteX133" fmla="*/ 5117306 w 12191999"/>
              <a:gd name="connsiteY133" fmla="*/ 601565 h 6105653"/>
              <a:gd name="connsiteX134" fmla="*/ 5128021 w 12191999"/>
              <a:gd name="connsiteY134" fmla="*/ 813809 h 6105653"/>
              <a:gd name="connsiteX135" fmla="*/ 5092302 w 12191999"/>
              <a:gd name="connsiteY135" fmla="*/ 1014423 h 6105653"/>
              <a:gd name="connsiteX136" fmla="*/ 5092302 w 12191999"/>
              <a:gd name="connsiteY136" fmla="*/ 1188871 h 6105653"/>
              <a:gd name="connsiteX137" fmla="*/ 5145880 w 12191999"/>
              <a:gd name="connsiteY137" fmla="*/ 1026053 h 6105653"/>
              <a:gd name="connsiteX138" fmla="*/ 5235177 w 12191999"/>
              <a:gd name="connsiteY138" fmla="*/ 964997 h 6105653"/>
              <a:gd name="connsiteX139" fmla="*/ 5317331 w 12191999"/>
              <a:gd name="connsiteY139" fmla="*/ 985349 h 6105653"/>
              <a:gd name="connsiteX140" fmla="*/ 5292327 w 12191999"/>
              <a:gd name="connsiteY140" fmla="*/ 1052221 h 6105653"/>
              <a:gd name="connsiteX141" fmla="*/ 5199458 w 12191999"/>
              <a:gd name="connsiteY141" fmla="*/ 1130722 h 6105653"/>
              <a:gd name="connsiteX142" fmla="*/ 5256608 w 12191999"/>
              <a:gd name="connsiteY142" fmla="*/ 1148166 h 6105653"/>
              <a:gd name="connsiteX143" fmla="*/ 5299471 w 12191999"/>
              <a:gd name="connsiteY143" fmla="*/ 1194686 h 6105653"/>
              <a:gd name="connsiteX144" fmla="*/ 5278039 w 12191999"/>
              <a:gd name="connsiteY144" fmla="*/ 1462171 h 6105653"/>
              <a:gd name="connsiteX145" fmla="*/ 5460205 w 12191999"/>
              <a:gd name="connsiteY145" fmla="*/ 1284817 h 6105653"/>
              <a:gd name="connsiteX146" fmla="*/ 5488780 w 12191999"/>
              <a:gd name="connsiteY146" fmla="*/ 1171426 h 6105653"/>
              <a:gd name="connsiteX147" fmla="*/ 5539513 w 12191999"/>
              <a:gd name="connsiteY147" fmla="*/ 1140353 h 6105653"/>
              <a:gd name="connsiteX148" fmla="*/ 5552720 w 12191999"/>
              <a:gd name="connsiteY148" fmla="*/ 1143022 h 6105653"/>
              <a:gd name="connsiteX149" fmla="*/ 5574208 w 12191999"/>
              <a:gd name="connsiteY149" fmla="*/ 1115811 h 6105653"/>
              <a:gd name="connsiteX150" fmla="*/ 5734050 w 12191999"/>
              <a:gd name="connsiteY150" fmla="*/ 1075470 h 6105653"/>
              <a:gd name="connsiteX151" fmla="*/ 5798343 w 12191999"/>
              <a:gd name="connsiteY151" fmla="*/ 1020228 h 6105653"/>
              <a:gd name="connsiteX152" fmla="*/ 5884068 w 12191999"/>
              <a:gd name="connsiteY152" fmla="*/ 883578 h 6105653"/>
              <a:gd name="connsiteX153" fmla="*/ 6066234 w 12191999"/>
              <a:gd name="connsiteY153" fmla="*/ 645166 h 6105653"/>
              <a:gd name="connsiteX154" fmla="*/ 6109096 w 12191999"/>
              <a:gd name="connsiteY154" fmla="*/ 732391 h 6105653"/>
              <a:gd name="connsiteX155" fmla="*/ 5998368 w 12191999"/>
              <a:gd name="connsiteY155" fmla="*/ 985338 h 6105653"/>
              <a:gd name="connsiteX156" fmla="*/ 5969793 w 12191999"/>
              <a:gd name="connsiteY156" fmla="*/ 1168509 h 6105653"/>
              <a:gd name="connsiteX157" fmla="*/ 6162674 w 12191999"/>
              <a:gd name="connsiteY157" fmla="*/ 909745 h 6105653"/>
              <a:gd name="connsiteX158" fmla="*/ 6412705 w 12191999"/>
              <a:gd name="connsiteY158" fmla="*/ 659704 h 6105653"/>
              <a:gd name="connsiteX159" fmla="*/ 6366271 w 12191999"/>
              <a:gd name="connsiteY159" fmla="*/ 851596 h 6105653"/>
              <a:gd name="connsiteX160" fmla="*/ 6398418 w 12191999"/>
              <a:gd name="connsiteY160" fmla="*/ 860319 h 6105653"/>
              <a:gd name="connsiteX161" fmla="*/ 6694884 w 12191999"/>
              <a:gd name="connsiteY161" fmla="*/ 691686 h 6105653"/>
              <a:gd name="connsiteX162" fmla="*/ 6816327 w 12191999"/>
              <a:gd name="connsiteY162" fmla="*/ 610277 h 6105653"/>
              <a:gd name="connsiteX163" fmla="*/ 7177087 w 12191999"/>
              <a:gd name="connsiteY163" fmla="*/ 238123 h 6105653"/>
              <a:gd name="connsiteX164" fmla="*/ 7016353 w 12191999"/>
              <a:gd name="connsiteY164" fmla="*/ 592833 h 6105653"/>
              <a:gd name="connsiteX165" fmla="*/ 7366396 w 12191999"/>
              <a:gd name="connsiteY165" fmla="*/ 226493 h 6105653"/>
              <a:gd name="connsiteX166" fmla="*/ 7494984 w 12191999"/>
              <a:gd name="connsiteY166" fmla="*/ 49138 h 6105653"/>
              <a:gd name="connsiteX167" fmla="*/ 7538181 w 12191999"/>
              <a:gd name="connsiteY167" fmla="*/ 484 h 610565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Lst>
            <a:rect l="l" t="t" r="r" b="b"/>
            <a:pathLst>
              <a:path w="12191999" h="6105653">
                <a:moveTo>
                  <a:pt x="7538181" y="484"/>
                </a:moveTo>
                <a:cubicBezTo>
                  <a:pt x="7546999" y="-833"/>
                  <a:pt x="7557492" y="439"/>
                  <a:pt x="7569993" y="5527"/>
                </a:cubicBezTo>
                <a:cubicBezTo>
                  <a:pt x="7612855" y="22971"/>
                  <a:pt x="7598567" y="54953"/>
                  <a:pt x="7587853" y="84028"/>
                </a:cubicBezTo>
                <a:cubicBezTo>
                  <a:pt x="7559278" y="153806"/>
                  <a:pt x="7559278" y="229401"/>
                  <a:pt x="7559278" y="325347"/>
                </a:cubicBezTo>
                <a:cubicBezTo>
                  <a:pt x="7695009" y="243938"/>
                  <a:pt x="7652146" y="95658"/>
                  <a:pt x="7795021" y="25878"/>
                </a:cubicBezTo>
                <a:cubicBezTo>
                  <a:pt x="7820024" y="113102"/>
                  <a:pt x="7770018" y="179974"/>
                  <a:pt x="7759302" y="249752"/>
                </a:cubicBezTo>
                <a:cubicBezTo>
                  <a:pt x="7748587" y="313717"/>
                  <a:pt x="7773590" y="328254"/>
                  <a:pt x="7852171" y="313717"/>
                </a:cubicBezTo>
                <a:cubicBezTo>
                  <a:pt x="7973615" y="290457"/>
                  <a:pt x="8034337" y="325347"/>
                  <a:pt x="8002190" y="418385"/>
                </a:cubicBezTo>
                <a:cubicBezTo>
                  <a:pt x="7970043" y="505609"/>
                  <a:pt x="8016478" y="514331"/>
                  <a:pt x="8084343" y="491072"/>
                </a:cubicBezTo>
                <a:cubicBezTo>
                  <a:pt x="8184355" y="456182"/>
                  <a:pt x="8262937" y="493979"/>
                  <a:pt x="8348662" y="520146"/>
                </a:cubicBezTo>
                <a:cubicBezTo>
                  <a:pt x="8477249" y="560851"/>
                  <a:pt x="8541543" y="543406"/>
                  <a:pt x="8637984" y="459090"/>
                </a:cubicBezTo>
                <a:cubicBezTo>
                  <a:pt x="8691561" y="409663"/>
                  <a:pt x="8737996" y="360236"/>
                  <a:pt x="8784431" y="290457"/>
                </a:cubicBezTo>
                <a:cubicBezTo>
                  <a:pt x="8809434" y="450367"/>
                  <a:pt x="8895158" y="284642"/>
                  <a:pt x="8948737" y="339884"/>
                </a:cubicBezTo>
                <a:cubicBezTo>
                  <a:pt x="8970168" y="453274"/>
                  <a:pt x="8798717" y="543406"/>
                  <a:pt x="8848725" y="697501"/>
                </a:cubicBezTo>
                <a:cubicBezTo>
                  <a:pt x="8995171" y="511424"/>
                  <a:pt x="9041606" y="302087"/>
                  <a:pt x="9238059" y="165437"/>
                </a:cubicBezTo>
                <a:cubicBezTo>
                  <a:pt x="9280921" y="197419"/>
                  <a:pt x="9238059" y="229401"/>
                  <a:pt x="9255919" y="255567"/>
                </a:cubicBezTo>
                <a:cubicBezTo>
                  <a:pt x="9266634" y="255567"/>
                  <a:pt x="9198767" y="560851"/>
                  <a:pt x="9477374" y="578295"/>
                </a:cubicBezTo>
                <a:cubicBezTo>
                  <a:pt x="9477374" y="584110"/>
                  <a:pt x="9477374" y="589925"/>
                  <a:pt x="9488091" y="595740"/>
                </a:cubicBezTo>
                <a:cubicBezTo>
                  <a:pt x="9527380" y="627722"/>
                  <a:pt x="9620249" y="598648"/>
                  <a:pt x="9627393" y="650981"/>
                </a:cubicBezTo>
                <a:cubicBezTo>
                  <a:pt x="9634537" y="709131"/>
                  <a:pt x="9666684" y="764373"/>
                  <a:pt x="9648824" y="825429"/>
                </a:cubicBezTo>
                <a:cubicBezTo>
                  <a:pt x="9634537" y="871948"/>
                  <a:pt x="9616678" y="921374"/>
                  <a:pt x="9616678" y="970802"/>
                </a:cubicBezTo>
                <a:cubicBezTo>
                  <a:pt x="9616678" y="1023136"/>
                  <a:pt x="9495233" y="1095822"/>
                  <a:pt x="9655968" y="1127805"/>
                </a:cubicBezTo>
                <a:cubicBezTo>
                  <a:pt x="9663111" y="1127805"/>
                  <a:pt x="9645252" y="1217935"/>
                  <a:pt x="9638109" y="1267362"/>
                </a:cubicBezTo>
                <a:cubicBezTo>
                  <a:pt x="9630965" y="1308066"/>
                  <a:pt x="9598818" y="1357494"/>
                  <a:pt x="9663111" y="1386568"/>
                </a:cubicBezTo>
                <a:cubicBezTo>
                  <a:pt x="9702403" y="1401105"/>
                  <a:pt x="9773840" y="1331326"/>
                  <a:pt x="9780984" y="1270269"/>
                </a:cubicBezTo>
                <a:cubicBezTo>
                  <a:pt x="9788127" y="1215028"/>
                  <a:pt x="9795271" y="1159787"/>
                  <a:pt x="9780984" y="1107452"/>
                </a:cubicBezTo>
                <a:cubicBezTo>
                  <a:pt x="9763125" y="1043488"/>
                  <a:pt x="9791699" y="1008598"/>
                  <a:pt x="9855993" y="991154"/>
                </a:cubicBezTo>
                <a:cubicBezTo>
                  <a:pt x="9923858" y="970802"/>
                  <a:pt x="9959577" y="933005"/>
                  <a:pt x="9991724" y="880670"/>
                </a:cubicBezTo>
                <a:cubicBezTo>
                  <a:pt x="10070305" y="752742"/>
                  <a:pt x="10163174" y="630630"/>
                  <a:pt x="10209609" y="491071"/>
                </a:cubicBezTo>
                <a:cubicBezTo>
                  <a:pt x="10216753" y="464905"/>
                  <a:pt x="10231040" y="432923"/>
                  <a:pt x="10291762" y="421292"/>
                </a:cubicBezTo>
                <a:cubicBezTo>
                  <a:pt x="10198893" y="799262"/>
                  <a:pt x="9959577" y="1142341"/>
                  <a:pt x="9973865" y="1531941"/>
                </a:cubicBezTo>
                <a:cubicBezTo>
                  <a:pt x="10048874" y="1427272"/>
                  <a:pt x="10052446" y="1302252"/>
                  <a:pt x="10106024" y="1188861"/>
                </a:cubicBezTo>
                <a:cubicBezTo>
                  <a:pt x="10145315" y="1270269"/>
                  <a:pt x="10102453" y="1345863"/>
                  <a:pt x="10081022" y="1421458"/>
                </a:cubicBezTo>
                <a:cubicBezTo>
                  <a:pt x="10063162" y="1485421"/>
                  <a:pt x="10059590" y="1543570"/>
                  <a:pt x="10170318" y="1549385"/>
                </a:cubicBezTo>
                <a:cubicBezTo>
                  <a:pt x="10181034" y="1549385"/>
                  <a:pt x="10188178" y="1549385"/>
                  <a:pt x="10198893" y="1549385"/>
                </a:cubicBezTo>
                <a:cubicBezTo>
                  <a:pt x="10245327" y="1526126"/>
                  <a:pt x="10266759" y="1494144"/>
                  <a:pt x="10281046" y="1453439"/>
                </a:cubicBezTo>
                <a:cubicBezTo>
                  <a:pt x="10288190" y="1430180"/>
                  <a:pt x="10302477" y="1398198"/>
                  <a:pt x="10334625" y="1398198"/>
                </a:cubicBezTo>
                <a:cubicBezTo>
                  <a:pt x="10456068" y="1401105"/>
                  <a:pt x="10491787" y="1322604"/>
                  <a:pt x="10527506" y="1247010"/>
                </a:cubicBezTo>
                <a:cubicBezTo>
                  <a:pt x="10588228" y="1287714"/>
                  <a:pt x="10545365" y="1322604"/>
                  <a:pt x="10548937" y="1354586"/>
                </a:cubicBezTo>
                <a:cubicBezTo>
                  <a:pt x="10552509" y="1374938"/>
                  <a:pt x="10556080" y="1395290"/>
                  <a:pt x="10588228" y="1395290"/>
                </a:cubicBezTo>
                <a:cubicBezTo>
                  <a:pt x="10613230" y="1395290"/>
                  <a:pt x="10645378" y="1386568"/>
                  <a:pt x="10645378" y="1366216"/>
                </a:cubicBezTo>
                <a:cubicBezTo>
                  <a:pt x="10648949" y="1238288"/>
                  <a:pt x="10820400" y="1165601"/>
                  <a:pt x="10820400" y="1031858"/>
                </a:cubicBezTo>
                <a:cubicBezTo>
                  <a:pt x="10820400" y="950449"/>
                  <a:pt x="10916840" y="1072563"/>
                  <a:pt x="10956131" y="1005691"/>
                </a:cubicBezTo>
                <a:cubicBezTo>
                  <a:pt x="10966847" y="991154"/>
                  <a:pt x="10981133" y="1046395"/>
                  <a:pt x="10977562" y="1069655"/>
                </a:cubicBezTo>
                <a:cubicBezTo>
                  <a:pt x="10973991" y="1092915"/>
                  <a:pt x="10948987" y="1113267"/>
                  <a:pt x="10966847" y="1142341"/>
                </a:cubicBezTo>
                <a:cubicBezTo>
                  <a:pt x="11031140" y="1156879"/>
                  <a:pt x="11056143" y="1119081"/>
                  <a:pt x="11074003" y="1084192"/>
                </a:cubicBezTo>
                <a:cubicBezTo>
                  <a:pt x="11116865" y="1008598"/>
                  <a:pt x="11166871" y="933005"/>
                  <a:pt x="11181159" y="848688"/>
                </a:cubicBezTo>
                <a:cubicBezTo>
                  <a:pt x="11184730" y="819614"/>
                  <a:pt x="11202590" y="802169"/>
                  <a:pt x="11238309" y="805077"/>
                </a:cubicBezTo>
                <a:cubicBezTo>
                  <a:pt x="11284744" y="810891"/>
                  <a:pt x="11270456" y="839966"/>
                  <a:pt x="11266884" y="863226"/>
                </a:cubicBezTo>
                <a:cubicBezTo>
                  <a:pt x="11263312" y="877763"/>
                  <a:pt x="11252596" y="892300"/>
                  <a:pt x="11277600" y="906838"/>
                </a:cubicBezTo>
                <a:cubicBezTo>
                  <a:pt x="11531203" y="566666"/>
                  <a:pt x="11516915" y="386403"/>
                  <a:pt x="11724084" y="5527"/>
                </a:cubicBezTo>
                <a:cubicBezTo>
                  <a:pt x="11763375" y="89842"/>
                  <a:pt x="11734800" y="150899"/>
                  <a:pt x="11727656" y="209048"/>
                </a:cubicBezTo>
                <a:cubicBezTo>
                  <a:pt x="11709796" y="354421"/>
                  <a:pt x="11677649" y="264290"/>
                  <a:pt x="11656218" y="409663"/>
                </a:cubicBezTo>
                <a:cubicBezTo>
                  <a:pt x="11645503" y="479442"/>
                  <a:pt x="11609784" y="543406"/>
                  <a:pt x="11666934" y="621907"/>
                </a:cubicBezTo>
                <a:cubicBezTo>
                  <a:pt x="11706225" y="674241"/>
                  <a:pt x="11663362" y="758557"/>
                  <a:pt x="11631215" y="822521"/>
                </a:cubicBezTo>
                <a:cubicBezTo>
                  <a:pt x="11602640" y="874856"/>
                  <a:pt x="11595497" y="927190"/>
                  <a:pt x="11631215" y="996969"/>
                </a:cubicBezTo>
                <a:cubicBezTo>
                  <a:pt x="11652646" y="933005"/>
                  <a:pt x="11670505" y="883578"/>
                  <a:pt x="11684793" y="834151"/>
                </a:cubicBezTo>
                <a:cubicBezTo>
                  <a:pt x="11695509" y="793447"/>
                  <a:pt x="11720512" y="770187"/>
                  <a:pt x="11774090" y="773095"/>
                </a:cubicBezTo>
                <a:cubicBezTo>
                  <a:pt x="11802665" y="773095"/>
                  <a:pt x="11841956" y="764373"/>
                  <a:pt x="11856243" y="793447"/>
                </a:cubicBezTo>
                <a:cubicBezTo>
                  <a:pt x="11870531" y="816706"/>
                  <a:pt x="11856243" y="848688"/>
                  <a:pt x="11831240" y="860319"/>
                </a:cubicBezTo>
                <a:cubicBezTo>
                  <a:pt x="11784806" y="874856"/>
                  <a:pt x="11741944" y="889393"/>
                  <a:pt x="11738371" y="938820"/>
                </a:cubicBezTo>
                <a:cubicBezTo>
                  <a:pt x="11731228" y="1005691"/>
                  <a:pt x="11759802" y="967894"/>
                  <a:pt x="11795521" y="956264"/>
                </a:cubicBezTo>
                <a:cubicBezTo>
                  <a:pt x="11834812" y="944634"/>
                  <a:pt x="11845527" y="979524"/>
                  <a:pt x="11838384" y="1002784"/>
                </a:cubicBezTo>
                <a:cubicBezTo>
                  <a:pt x="11806237" y="1090007"/>
                  <a:pt x="11863387" y="1180138"/>
                  <a:pt x="11816952" y="1270269"/>
                </a:cubicBezTo>
                <a:cubicBezTo>
                  <a:pt x="11931252" y="1247010"/>
                  <a:pt x="11981259" y="1197583"/>
                  <a:pt x="11999118" y="1092915"/>
                </a:cubicBezTo>
                <a:cubicBezTo>
                  <a:pt x="12002690" y="1055118"/>
                  <a:pt x="11995547" y="1014413"/>
                  <a:pt x="12027693" y="979524"/>
                </a:cubicBezTo>
                <a:cubicBezTo>
                  <a:pt x="12045553" y="959172"/>
                  <a:pt x="12066984" y="938820"/>
                  <a:pt x="12102703" y="953357"/>
                </a:cubicBezTo>
                <a:cubicBezTo>
                  <a:pt x="12127705" y="962080"/>
                  <a:pt x="12127705" y="985338"/>
                  <a:pt x="12120562" y="1005691"/>
                </a:cubicBezTo>
                <a:cubicBezTo>
                  <a:pt x="12081272" y="1090007"/>
                  <a:pt x="12070555" y="1180138"/>
                  <a:pt x="12056268" y="1267362"/>
                </a:cubicBezTo>
                <a:cubicBezTo>
                  <a:pt x="12052697" y="1281899"/>
                  <a:pt x="12045553" y="1296437"/>
                  <a:pt x="12081272" y="1310974"/>
                </a:cubicBezTo>
                <a:cubicBezTo>
                  <a:pt x="12113418" y="1209213"/>
                  <a:pt x="12156280" y="1110359"/>
                  <a:pt x="12191999" y="1008598"/>
                </a:cubicBezTo>
                <a:lnTo>
                  <a:pt x="12191999" y="6105653"/>
                </a:lnTo>
                <a:lnTo>
                  <a:pt x="0" y="6105653"/>
                </a:lnTo>
                <a:lnTo>
                  <a:pt x="0" y="927116"/>
                </a:lnTo>
                <a:lnTo>
                  <a:pt x="61930" y="902578"/>
                </a:lnTo>
                <a:cubicBezTo>
                  <a:pt x="91454" y="894128"/>
                  <a:pt x="122931" y="887949"/>
                  <a:pt x="155971" y="883588"/>
                </a:cubicBezTo>
                <a:cubicBezTo>
                  <a:pt x="223837" y="877773"/>
                  <a:pt x="245268" y="839976"/>
                  <a:pt x="277414" y="802179"/>
                </a:cubicBezTo>
                <a:cubicBezTo>
                  <a:pt x="388143" y="674251"/>
                  <a:pt x="488155" y="537601"/>
                  <a:pt x="638174" y="430025"/>
                </a:cubicBezTo>
                <a:cubicBezTo>
                  <a:pt x="620315" y="555046"/>
                  <a:pt x="520302" y="653899"/>
                  <a:pt x="477440" y="784735"/>
                </a:cubicBezTo>
                <a:cubicBezTo>
                  <a:pt x="641746" y="680066"/>
                  <a:pt x="727471" y="543415"/>
                  <a:pt x="827483" y="418395"/>
                </a:cubicBezTo>
                <a:cubicBezTo>
                  <a:pt x="873917" y="360246"/>
                  <a:pt x="931068" y="307912"/>
                  <a:pt x="956071" y="241040"/>
                </a:cubicBezTo>
                <a:cubicBezTo>
                  <a:pt x="961429" y="223595"/>
                  <a:pt x="972814" y="196338"/>
                  <a:pt x="999268" y="192386"/>
                </a:cubicBezTo>
                <a:cubicBezTo>
                  <a:pt x="1008086" y="191069"/>
                  <a:pt x="1018579" y="192341"/>
                  <a:pt x="1031080" y="197429"/>
                </a:cubicBezTo>
                <a:cubicBezTo>
                  <a:pt x="1073942" y="214873"/>
                  <a:pt x="1059654" y="246855"/>
                  <a:pt x="1048940" y="275930"/>
                </a:cubicBezTo>
                <a:cubicBezTo>
                  <a:pt x="1020365" y="345708"/>
                  <a:pt x="1020365" y="421303"/>
                  <a:pt x="1020365" y="517249"/>
                </a:cubicBezTo>
                <a:cubicBezTo>
                  <a:pt x="1156096" y="435840"/>
                  <a:pt x="1113233" y="287560"/>
                  <a:pt x="1256108" y="217780"/>
                </a:cubicBezTo>
                <a:cubicBezTo>
                  <a:pt x="1281111" y="305004"/>
                  <a:pt x="1231105" y="371876"/>
                  <a:pt x="1220389" y="441654"/>
                </a:cubicBezTo>
                <a:cubicBezTo>
                  <a:pt x="1209674" y="505619"/>
                  <a:pt x="1234677" y="520156"/>
                  <a:pt x="1313258" y="505619"/>
                </a:cubicBezTo>
                <a:cubicBezTo>
                  <a:pt x="1434702" y="482359"/>
                  <a:pt x="1495424" y="517249"/>
                  <a:pt x="1463277" y="610287"/>
                </a:cubicBezTo>
                <a:cubicBezTo>
                  <a:pt x="1431130" y="697511"/>
                  <a:pt x="1477565" y="706233"/>
                  <a:pt x="1545430" y="682974"/>
                </a:cubicBezTo>
                <a:cubicBezTo>
                  <a:pt x="1645442" y="648084"/>
                  <a:pt x="1724024" y="685881"/>
                  <a:pt x="1809749" y="712048"/>
                </a:cubicBezTo>
                <a:cubicBezTo>
                  <a:pt x="1938336" y="752753"/>
                  <a:pt x="2002630" y="735308"/>
                  <a:pt x="2099071" y="650992"/>
                </a:cubicBezTo>
                <a:cubicBezTo>
                  <a:pt x="2152648" y="601565"/>
                  <a:pt x="2199083" y="552138"/>
                  <a:pt x="2245518" y="482359"/>
                </a:cubicBezTo>
                <a:cubicBezTo>
                  <a:pt x="2270521" y="642269"/>
                  <a:pt x="2356245" y="476544"/>
                  <a:pt x="2409824" y="531786"/>
                </a:cubicBezTo>
                <a:cubicBezTo>
                  <a:pt x="2431255" y="645176"/>
                  <a:pt x="2259804" y="735308"/>
                  <a:pt x="2309812" y="889403"/>
                </a:cubicBezTo>
                <a:cubicBezTo>
                  <a:pt x="2456258" y="703326"/>
                  <a:pt x="2502693" y="493989"/>
                  <a:pt x="2699146" y="357339"/>
                </a:cubicBezTo>
                <a:cubicBezTo>
                  <a:pt x="2742008" y="389321"/>
                  <a:pt x="2699146" y="421303"/>
                  <a:pt x="2717006" y="447469"/>
                </a:cubicBezTo>
                <a:cubicBezTo>
                  <a:pt x="2727721" y="447469"/>
                  <a:pt x="2659854" y="752753"/>
                  <a:pt x="2938461" y="770197"/>
                </a:cubicBezTo>
                <a:cubicBezTo>
                  <a:pt x="2938461" y="776012"/>
                  <a:pt x="2938461" y="781827"/>
                  <a:pt x="2949178" y="787642"/>
                </a:cubicBezTo>
                <a:cubicBezTo>
                  <a:pt x="2988467" y="819624"/>
                  <a:pt x="3081336" y="790550"/>
                  <a:pt x="3088480" y="842883"/>
                </a:cubicBezTo>
                <a:cubicBezTo>
                  <a:pt x="3095624" y="901033"/>
                  <a:pt x="3127771" y="956275"/>
                  <a:pt x="3109911" y="1017331"/>
                </a:cubicBezTo>
                <a:cubicBezTo>
                  <a:pt x="3095624" y="1063850"/>
                  <a:pt x="3077765" y="1113276"/>
                  <a:pt x="3077765" y="1162704"/>
                </a:cubicBezTo>
                <a:cubicBezTo>
                  <a:pt x="3077765" y="1215038"/>
                  <a:pt x="2956320" y="1287724"/>
                  <a:pt x="3117055" y="1319707"/>
                </a:cubicBezTo>
                <a:cubicBezTo>
                  <a:pt x="3124198" y="1319707"/>
                  <a:pt x="3106339" y="1409837"/>
                  <a:pt x="3099196" y="1459264"/>
                </a:cubicBezTo>
                <a:cubicBezTo>
                  <a:pt x="3092052" y="1499968"/>
                  <a:pt x="3059905" y="1549396"/>
                  <a:pt x="3124198" y="1578470"/>
                </a:cubicBezTo>
                <a:cubicBezTo>
                  <a:pt x="3163490" y="1593007"/>
                  <a:pt x="3234927" y="1523228"/>
                  <a:pt x="3242071" y="1462171"/>
                </a:cubicBezTo>
                <a:cubicBezTo>
                  <a:pt x="3249214" y="1406930"/>
                  <a:pt x="3256358" y="1351689"/>
                  <a:pt x="3242071" y="1299354"/>
                </a:cubicBezTo>
                <a:cubicBezTo>
                  <a:pt x="3224212" y="1235390"/>
                  <a:pt x="3252786" y="1200500"/>
                  <a:pt x="3317080" y="1183056"/>
                </a:cubicBezTo>
                <a:cubicBezTo>
                  <a:pt x="3384945" y="1162704"/>
                  <a:pt x="3420664" y="1124907"/>
                  <a:pt x="3452811" y="1072572"/>
                </a:cubicBezTo>
                <a:cubicBezTo>
                  <a:pt x="3531392" y="944644"/>
                  <a:pt x="3624261" y="822532"/>
                  <a:pt x="3670696" y="682973"/>
                </a:cubicBezTo>
                <a:cubicBezTo>
                  <a:pt x="3677840" y="656807"/>
                  <a:pt x="3692127" y="624825"/>
                  <a:pt x="3752849" y="613194"/>
                </a:cubicBezTo>
                <a:cubicBezTo>
                  <a:pt x="3659980" y="991164"/>
                  <a:pt x="3420664" y="1334243"/>
                  <a:pt x="3434952" y="1723843"/>
                </a:cubicBezTo>
                <a:cubicBezTo>
                  <a:pt x="3509961" y="1619174"/>
                  <a:pt x="3513533" y="1494154"/>
                  <a:pt x="3567111" y="1380763"/>
                </a:cubicBezTo>
                <a:cubicBezTo>
                  <a:pt x="3606402" y="1462171"/>
                  <a:pt x="3563540" y="1537765"/>
                  <a:pt x="3542109" y="1613360"/>
                </a:cubicBezTo>
                <a:cubicBezTo>
                  <a:pt x="3524249" y="1677323"/>
                  <a:pt x="3520677" y="1735472"/>
                  <a:pt x="3631405" y="1741287"/>
                </a:cubicBezTo>
                <a:cubicBezTo>
                  <a:pt x="3642121" y="1741287"/>
                  <a:pt x="3649265" y="1741287"/>
                  <a:pt x="3659980" y="1741287"/>
                </a:cubicBezTo>
                <a:cubicBezTo>
                  <a:pt x="3706414" y="1718028"/>
                  <a:pt x="3727846" y="1686046"/>
                  <a:pt x="3742133" y="1645341"/>
                </a:cubicBezTo>
                <a:cubicBezTo>
                  <a:pt x="3749277" y="1622082"/>
                  <a:pt x="3763564" y="1590100"/>
                  <a:pt x="3795712" y="1590100"/>
                </a:cubicBezTo>
                <a:cubicBezTo>
                  <a:pt x="3917155" y="1593007"/>
                  <a:pt x="3952874" y="1514506"/>
                  <a:pt x="3988593" y="1438912"/>
                </a:cubicBezTo>
                <a:cubicBezTo>
                  <a:pt x="4049315" y="1479616"/>
                  <a:pt x="4006452" y="1514506"/>
                  <a:pt x="4010024" y="1546488"/>
                </a:cubicBezTo>
                <a:cubicBezTo>
                  <a:pt x="4013596" y="1566840"/>
                  <a:pt x="4017167" y="1587192"/>
                  <a:pt x="4049315" y="1587192"/>
                </a:cubicBezTo>
                <a:cubicBezTo>
                  <a:pt x="4074317" y="1587192"/>
                  <a:pt x="4106465" y="1578470"/>
                  <a:pt x="4106465" y="1558118"/>
                </a:cubicBezTo>
                <a:cubicBezTo>
                  <a:pt x="4110036" y="1430190"/>
                  <a:pt x="4281487" y="1357503"/>
                  <a:pt x="4281487" y="1223760"/>
                </a:cubicBezTo>
                <a:cubicBezTo>
                  <a:pt x="4281487" y="1142351"/>
                  <a:pt x="4377927" y="1264465"/>
                  <a:pt x="4417219" y="1197593"/>
                </a:cubicBezTo>
                <a:cubicBezTo>
                  <a:pt x="4427935" y="1183056"/>
                  <a:pt x="4442220" y="1238297"/>
                  <a:pt x="4438649" y="1261557"/>
                </a:cubicBezTo>
                <a:cubicBezTo>
                  <a:pt x="4435078" y="1284817"/>
                  <a:pt x="4410074" y="1305169"/>
                  <a:pt x="4427935" y="1334243"/>
                </a:cubicBezTo>
                <a:cubicBezTo>
                  <a:pt x="4492228" y="1348781"/>
                  <a:pt x="4517230" y="1310983"/>
                  <a:pt x="4535090" y="1276094"/>
                </a:cubicBezTo>
                <a:cubicBezTo>
                  <a:pt x="4577952" y="1200500"/>
                  <a:pt x="4627958" y="1124907"/>
                  <a:pt x="4642246" y="1040590"/>
                </a:cubicBezTo>
                <a:cubicBezTo>
                  <a:pt x="4645817" y="1011516"/>
                  <a:pt x="4663677" y="994071"/>
                  <a:pt x="4699396" y="996979"/>
                </a:cubicBezTo>
                <a:cubicBezTo>
                  <a:pt x="4745832" y="1002793"/>
                  <a:pt x="4731544" y="1031868"/>
                  <a:pt x="4727971" y="1055128"/>
                </a:cubicBezTo>
                <a:cubicBezTo>
                  <a:pt x="4724399" y="1069665"/>
                  <a:pt x="4713683" y="1084202"/>
                  <a:pt x="4738688" y="1098740"/>
                </a:cubicBezTo>
                <a:cubicBezTo>
                  <a:pt x="4992291" y="758568"/>
                  <a:pt x="4978002" y="578305"/>
                  <a:pt x="5185172" y="197429"/>
                </a:cubicBezTo>
                <a:cubicBezTo>
                  <a:pt x="5224462" y="281744"/>
                  <a:pt x="5195887" y="342801"/>
                  <a:pt x="5188744" y="400950"/>
                </a:cubicBezTo>
                <a:cubicBezTo>
                  <a:pt x="5170883" y="546323"/>
                  <a:pt x="5138736" y="456192"/>
                  <a:pt x="5117306" y="601565"/>
                </a:cubicBezTo>
                <a:cubicBezTo>
                  <a:pt x="5106590" y="671344"/>
                  <a:pt x="5070871" y="735308"/>
                  <a:pt x="5128021" y="813809"/>
                </a:cubicBezTo>
                <a:cubicBezTo>
                  <a:pt x="5167312" y="866143"/>
                  <a:pt x="5124450" y="950459"/>
                  <a:pt x="5092302" y="1014423"/>
                </a:cubicBezTo>
                <a:cubicBezTo>
                  <a:pt x="5063727" y="1066758"/>
                  <a:pt x="5056585" y="1119092"/>
                  <a:pt x="5092302" y="1188871"/>
                </a:cubicBezTo>
                <a:cubicBezTo>
                  <a:pt x="5113734" y="1124907"/>
                  <a:pt x="5131592" y="1075480"/>
                  <a:pt x="5145880" y="1026053"/>
                </a:cubicBezTo>
                <a:cubicBezTo>
                  <a:pt x="5156596" y="985349"/>
                  <a:pt x="5181600" y="962089"/>
                  <a:pt x="5235177" y="964997"/>
                </a:cubicBezTo>
                <a:cubicBezTo>
                  <a:pt x="5263752" y="964997"/>
                  <a:pt x="5303044" y="956275"/>
                  <a:pt x="5317331" y="985349"/>
                </a:cubicBezTo>
                <a:cubicBezTo>
                  <a:pt x="5331618" y="1008608"/>
                  <a:pt x="5317331" y="1040590"/>
                  <a:pt x="5292327" y="1052221"/>
                </a:cubicBezTo>
                <a:cubicBezTo>
                  <a:pt x="5245894" y="1066758"/>
                  <a:pt x="5203031" y="1081295"/>
                  <a:pt x="5199458" y="1130722"/>
                </a:cubicBezTo>
                <a:cubicBezTo>
                  <a:pt x="5192315" y="1197593"/>
                  <a:pt x="5220889" y="1159796"/>
                  <a:pt x="5256608" y="1148166"/>
                </a:cubicBezTo>
                <a:cubicBezTo>
                  <a:pt x="5295899" y="1136536"/>
                  <a:pt x="5306616" y="1171426"/>
                  <a:pt x="5299471" y="1194686"/>
                </a:cubicBezTo>
                <a:cubicBezTo>
                  <a:pt x="5267324" y="1281909"/>
                  <a:pt x="5324474" y="1372040"/>
                  <a:pt x="5278039" y="1462171"/>
                </a:cubicBezTo>
                <a:cubicBezTo>
                  <a:pt x="5392339" y="1438912"/>
                  <a:pt x="5442347" y="1389485"/>
                  <a:pt x="5460205" y="1284817"/>
                </a:cubicBezTo>
                <a:cubicBezTo>
                  <a:pt x="5463777" y="1247020"/>
                  <a:pt x="5456634" y="1206315"/>
                  <a:pt x="5488780" y="1171426"/>
                </a:cubicBezTo>
                <a:cubicBezTo>
                  <a:pt x="5502175" y="1156162"/>
                  <a:pt x="5517579" y="1140898"/>
                  <a:pt x="5539513" y="1140353"/>
                </a:cubicBezTo>
                <a:lnTo>
                  <a:pt x="5552720" y="1143022"/>
                </a:lnTo>
                <a:lnTo>
                  <a:pt x="5574208" y="1115811"/>
                </a:lnTo>
                <a:cubicBezTo>
                  <a:pt x="5609034" y="1085646"/>
                  <a:pt x="5659040" y="1068202"/>
                  <a:pt x="5734050" y="1075470"/>
                </a:cubicBezTo>
                <a:cubicBezTo>
                  <a:pt x="5776912" y="1078377"/>
                  <a:pt x="5809058" y="1055118"/>
                  <a:pt x="5798343" y="1020228"/>
                </a:cubicBezTo>
                <a:cubicBezTo>
                  <a:pt x="5776912" y="953357"/>
                  <a:pt x="5837634" y="921375"/>
                  <a:pt x="5884068" y="883578"/>
                </a:cubicBezTo>
                <a:cubicBezTo>
                  <a:pt x="5966221" y="816706"/>
                  <a:pt x="6051947" y="752742"/>
                  <a:pt x="6066234" y="645166"/>
                </a:cubicBezTo>
                <a:cubicBezTo>
                  <a:pt x="6130528" y="665519"/>
                  <a:pt x="6123384" y="700408"/>
                  <a:pt x="6109096" y="732391"/>
                </a:cubicBezTo>
                <a:cubicBezTo>
                  <a:pt x="6073377" y="816706"/>
                  <a:pt x="6034087" y="901023"/>
                  <a:pt x="5998368" y="985338"/>
                </a:cubicBezTo>
                <a:cubicBezTo>
                  <a:pt x="5976937" y="1040581"/>
                  <a:pt x="5944790" y="1095822"/>
                  <a:pt x="5969793" y="1168509"/>
                </a:cubicBezTo>
                <a:cubicBezTo>
                  <a:pt x="6098380" y="1104545"/>
                  <a:pt x="6123384" y="996969"/>
                  <a:pt x="6162674" y="909745"/>
                </a:cubicBezTo>
                <a:cubicBezTo>
                  <a:pt x="6212681" y="802169"/>
                  <a:pt x="6305549" y="738205"/>
                  <a:pt x="6412705" y="659704"/>
                </a:cubicBezTo>
                <a:cubicBezTo>
                  <a:pt x="6441280" y="738205"/>
                  <a:pt x="6362699" y="787632"/>
                  <a:pt x="6366271" y="851596"/>
                </a:cubicBezTo>
                <a:cubicBezTo>
                  <a:pt x="6376987" y="854503"/>
                  <a:pt x="6398418" y="860319"/>
                  <a:pt x="6398418" y="860319"/>
                </a:cubicBezTo>
                <a:cubicBezTo>
                  <a:pt x="6455568" y="755650"/>
                  <a:pt x="6562724" y="709131"/>
                  <a:pt x="6694884" y="691686"/>
                </a:cubicBezTo>
                <a:cubicBezTo>
                  <a:pt x="6762750" y="685871"/>
                  <a:pt x="6784181" y="648074"/>
                  <a:pt x="6816327" y="610277"/>
                </a:cubicBezTo>
                <a:cubicBezTo>
                  <a:pt x="6927056" y="482349"/>
                  <a:pt x="7027068" y="345699"/>
                  <a:pt x="7177087" y="238123"/>
                </a:cubicBezTo>
                <a:cubicBezTo>
                  <a:pt x="7159228" y="363144"/>
                  <a:pt x="7059215" y="461997"/>
                  <a:pt x="7016353" y="592833"/>
                </a:cubicBezTo>
                <a:cubicBezTo>
                  <a:pt x="7180659" y="488164"/>
                  <a:pt x="7266384" y="351513"/>
                  <a:pt x="7366396" y="226493"/>
                </a:cubicBezTo>
                <a:cubicBezTo>
                  <a:pt x="7412830" y="168344"/>
                  <a:pt x="7469981" y="116010"/>
                  <a:pt x="7494984" y="49138"/>
                </a:cubicBezTo>
                <a:cubicBezTo>
                  <a:pt x="7500342" y="31693"/>
                  <a:pt x="7511727" y="4436"/>
                  <a:pt x="7538181" y="484"/>
                </a:cubicBezTo>
                <a:close/>
              </a:path>
            </a:pathLst>
          </a:custGeom>
          <a:solidFill>
            <a:schemeClr val="accent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88351018-2D57-B44F-9E99-0042CE8604E6}"/>
              </a:ext>
            </a:extLst>
          </p:cNvPr>
          <p:cNvSpPr>
            <a:spLocks noGrp="1"/>
          </p:cNvSpPr>
          <p:nvPr>
            <p:ph type="title"/>
          </p:nvPr>
        </p:nvSpPr>
        <p:spPr>
          <a:xfrm>
            <a:off x="838200" y="365125"/>
            <a:ext cx="10515600" cy="1325563"/>
          </a:xfrm>
        </p:spPr>
        <p:txBody>
          <a:bodyPr>
            <a:normAutofit/>
          </a:bodyPr>
          <a:lstStyle/>
          <a:p>
            <a:r>
              <a:rPr lang="en-US" dirty="0"/>
              <a:t>Setting</a:t>
            </a:r>
          </a:p>
        </p:txBody>
      </p:sp>
      <p:graphicFrame>
        <p:nvGraphicFramePr>
          <p:cNvPr id="13" name="Content Placeholder 2">
            <a:extLst>
              <a:ext uri="{FF2B5EF4-FFF2-40B4-BE49-F238E27FC236}">
                <a16:creationId xmlns:a16="http://schemas.microsoft.com/office/drawing/2014/main" id="{C217B043-2ADC-58E5-53D6-9C276E89870D}"/>
              </a:ext>
            </a:extLst>
          </p:cNvPr>
          <p:cNvGraphicFramePr>
            <a:graphicFrameLocks noGrp="1"/>
          </p:cNvGraphicFramePr>
          <p:nvPr>
            <p:ph idx="1"/>
            <p:extLst>
              <p:ext uri="{D42A27DB-BD31-4B8C-83A1-F6EECF244321}">
                <p14:modId xmlns:p14="http://schemas.microsoft.com/office/powerpoint/2010/main" val="1813640389"/>
              </p:ext>
            </p:extLst>
          </p:nvPr>
        </p:nvGraphicFramePr>
        <p:xfrm>
          <a:off x="838200" y="2011363"/>
          <a:ext cx="10515600" cy="416083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15011162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FBE20309-1FB9-4818-BAFA-9C4C053417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Freeform: Shape 9">
            <a:extLst>
              <a:ext uri="{FF2B5EF4-FFF2-40B4-BE49-F238E27FC236}">
                <a16:creationId xmlns:a16="http://schemas.microsoft.com/office/drawing/2014/main" id="{FBD77573-9EF2-4C35-8285-A1CF6FBB0E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1" y="0"/>
            <a:ext cx="5511704" cy="6858000"/>
          </a:xfrm>
          <a:custGeom>
            <a:avLst/>
            <a:gdLst>
              <a:gd name="connsiteX0" fmla="*/ 5511704 w 5511704"/>
              <a:gd name="connsiteY0" fmla="*/ 0 h 6886576"/>
              <a:gd name="connsiteX1" fmla="*/ 1008599 w 5511704"/>
              <a:gd name="connsiteY1" fmla="*/ 0 h 6886576"/>
              <a:gd name="connsiteX2" fmla="*/ 1310975 w 5511704"/>
              <a:gd name="connsiteY2" fmla="*/ 110728 h 6886576"/>
              <a:gd name="connsiteX3" fmla="*/ 1267362 w 5511704"/>
              <a:gd name="connsiteY3" fmla="*/ 135731 h 6886576"/>
              <a:gd name="connsiteX4" fmla="*/ 1005692 w 5511704"/>
              <a:gd name="connsiteY4" fmla="*/ 71437 h 6886576"/>
              <a:gd name="connsiteX5" fmla="*/ 953358 w 5511704"/>
              <a:gd name="connsiteY5" fmla="*/ 89297 h 6886576"/>
              <a:gd name="connsiteX6" fmla="*/ 979525 w 5511704"/>
              <a:gd name="connsiteY6" fmla="*/ 164307 h 6886576"/>
              <a:gd name="connsiteX7" fmla="*/ 1092915 w 5511704"/>
              <a:gd name="connsiteY7" fmla="*/ 192882 h 6886576"/>
              <a:gd name="connsiteX8" fmla="*/ 1270270 w 5511704"/>
              <a:gd name="connsiteY8" fmla="*/ 375047 h 6886576"/>
              <a:gd name="connsiteX9" fmla="*/ 1002784 w 5511704"/>
              <a:gd name="connsiteY9" fmla="*/ 353615 h 6886576"/>
              <a:gd name="connsiteX10" fmla="*/ 956265 w 5511704"/>
              <a:gd name="connsiteY10" fmla="*/ 396479 h 6886576"/>
              <a:gd name="connsiteX11" fmla="*/ 938820 w 5511704"/>
              <a:gd name="connsiteY11" fmla="*/ 453629 h 6886576"/>
              <a:gd name="connsiteX12" fmla="*/ 860319 w 5511704"/>
              <a:gd name="connsiteY12" fmla="*/ 360759 h 6886576"/>
              <a:gd name="connsiteX13" fmla="*/ 793447 w 5511704"/>
              <a:gd name="connsiteY13" fmla="*/ 335757 h 6886576"/>
              <a:gd name="connsiteX14" fmla="*/ 773095 w 5511704"/>
              <a:gd name="connsiteY14" fmla="*/ 417910 h 6886576"/>
              <a:gd name="connsiteX15" fmla="*/ 834151 w 5511704"/>
              <a:gd name="connsiteY15" fmla="*/ 507206 h 6886576"/>
              <a:gd name="connsiteX16" fmla="*/ 996969 w 5511704"/>
              <a:gd name="connsiteY16" fmla="*/ 560785 h 6886576"/>
              <a:gd name="connsiteX17" fmla="*/ 822522 w 5511704"/>
              <a:gd name="connsiteY17" fmla="*/ 560785 h 6886576"/>
              <a:gd name="connsiteX18" fmla="*/ 621908 w 5511704"/>
              <a:gd name="connsiteY18" fmla="*/ 525066 h 6886576"/>
              <a:gd name="connsiteX19" fmla="*/ 409664 w 5511704"/>
              <a:gd name="connsiteY19" fmla="*/ 535781 h 6886576"/>
              <a:gd name="connsiteX20" fmla="*/ 209049 w 5511704"/>
              <a:gd name="connsiteY20" fmla="*/ 464344 h 6886576"/>
              <a:gd name="connsiteX21" fmla="*/ 5527 w 5511704"/>
              <a:gd name="connsiteY21" fmla="*/ 467916 h 6886576"/>
              <a:gd name="connsiteX22" fmla="*/ 906838 w 5511704"/>
              <a:gd name="connsiteY22" fmla="*/ 914400 h 6886576"/>
              <a:gd name="connsiteX23" fmla="*/ 863226 w 5511704"/>
              <a:gd name="connsiteY23" fmla="*/ 925116 h 6886576"/>
              <a:gd name="connsiteX24" fmla="*/ 805077 w 5511704"/>
              <a:gd name="connsiteY24" fmla="*/ 953691 h 6886576"/>
              <a:gd name="connsiteX25" fmla="*/ 848689 w 5511704"/>
              <a:gd name="connsiteY25" fmla="*/ 1010841 h 6886576"/>
              <a:gd name="connsiteX26" fmla="*/ 1084193 w 5511704"/>
              <a:gd name="connsiteY26" fmla="*/ 1117997 h 6886576"/>
              <a:gd name="connsiteX27" fmla="*/ 1142342 w 5511704"/>
              <a:gd name="connsiteY27" fmla="*/ 1225153 h 6886576"/>
              <a:gd name="connsiteX28" fmla="*/ 1069655 w 5511704"/>
              <a:gd name="connsiteY28" fmla="*/ 1214438 h 6886576"/>
              <a:gd name="connsiteX29" fmla="*/ 1005692 w 5511704"/>
              <a:gd name="connsiteY29" fmla="*/ 1235869 h 6886576"/>
              <a:gd name="connsiteX30" fmla="*/ 1031858 w 5511704"/>
              <a:gd name="connsiteY30" fmla="*/ 1371600 h 6886576"/>
              <a:gd name="connsiteX31" fmla="*/ 1366216 w 5511704"/>
              <a:gd name="connsiteY31" fmla="*/ 1546622 h 6886576"/>
              <a:gd name="connsiteX32" fmla="*/ 1395290 w 5511704"/>
              <a:gd name="connsiteY32" fmla="*/ 1603772 h 6886576"/>
              <a:gd name="connsiteX33" fmla="*/ 1354586 w 5511704"/>
              <a:gd name="connsiteY33" fmla="*/ 1643063 h 6886576"/>
              <a:gd name="connsiteX34" fmla="*/ 1247011 w 5511704"/>
              <a:gd name="connsiteY34" fmla="*/ 1664494 h 6886576"/>
              <a:gd name="connsiteX35" fmla="*/ 1398198 w 5511704"/>
              <a:gd name="connsiteY35" fmla="*/ 1857375 h 6886576"/>
              <a:gd name="connsiteX36" fmla="*/ 1453440 w 5511704"/>
              <a:gd name="connsiteY36" fmla="*/ 1910954 h 6886576"/>
              <a:gd name="connsiteX37" fmla="*/ 1549386 w 5511704"/>
              <a:gd name="connsiteY37" fmla="*/ 1993106 h 6886576"/>
              <a:gd name="connsiteX38" fmla="*/ 1549386 w 5511704"/>
              <a:gd name="connsiteY38" fmla="*/ 2021681 h 6886576"/>
              <a:gd name="connsiteX39" fmla="*/ 1421458 w 5511704"/>
              <a:gd name="connsiteY39" fmla="*/ 2110978 h 6886576"/>
              <a:gd name="connsiteX40" fmla="*/ 1188861 w 5511704"/>
              <a:gd name="connsiteY40" fmla="*/ 2085976 h 6886576"/>
              <a:gd name="connsiteX41" fmla="*/ 1531941 w 5511704"/>
              <a:gd name="connsiteY41" fmla="*/ 2218135 h 6886576"/>
              <a:gd name="connsiteX42" fmla="*/ 421293 w 5511704"/>
              <a:gd name="connsiteY42" fmla="*/ 1900238 h 6886576"/>
              <a:gd name="connsiteX43" fmla="*/ 491072 w 5511704"/>
              <a:gd name="connsiteY43" fmla="*/ 1982391 h 6886576"/>
              <a:gd name="connsiteX44" fmla="*/ 880671 w 5511704"/>
              <a:gd name="connsiteY44" fmla="*/ 2200276 h 6886576"/>
              <a:gd name="connsiteX45" fmla="*/ 991154 w 5511704"/>
              <a:gd name="connsiteY45" fmla="*/ 2336007 h 6886576"/>
              <a:gd name="connsiteX46" fmla="*/ 1107453 w 5511704"/>
              <a:gd name="connsiteY46" fmla="*/ 2411016 h 6886576"/>
              <a:gd name="connsiteX47" fmla="*/ 1270270 w 5511704"/>
              <a:gd name="connsiteY47" fmla="*/ 2411016 h 6886576"/>
              <a:gd name="connsiteX48" fmla="*/ 1386568 w 5511704"/>
              <a:gd name="connsiteY48" fmla="*/ 2528889 h 6886576"/>
              <a:gd name="connsiteX49" fmla="*/ 1267362 w 5511704"/>
              <a:gd name="connsiteY49" fmla="*/ 2553891 h 6886576"/>
              <a:gd name="connsiteX50" fmla="*/ 1127805 w 5511704"/>
              <a:gd name="connsiteY50" fmla="*/ 2536032 h 6886576"/>
              <a:gd name="connsiteX51" fmla="*/ 970802 w 5511704"/>
              <a:gd name="connsiteY51" fmla="*/ 2575322 h 6886576"/>
              <a:gd name="connsiteX52" fmla="*/ 825429 w 5511704"/>
              <a:gd name="connsiteY52" fmla="*/ 2543176 h 6886576"/>
              <a:gd name="connsiteX53" fmla="*/ 650982 w 5511704"/>
              <a:gd name="connsiteY53" fmla="*/ 2564607 h 6886576"/>
              <a:gd name="connsiteX54" fmla="*/ 595740 w 5511704"/>
              <a:gd name="connsiteY54" fmla="*/ 2703909 h 6886576"/>
              <a:gd name="connsiteX55" fmla="*/ 578296 w 5511704"/>
              <a:gd name="connsiteY55" fmla="*/ 2714626 h 6886576"/>
              <a:gd name="connsiteX56" fmla="*/ 255568 w 5511704"/>
              <a:gd name="connsiteY56" fmla="*/ 2936081 h 6886576"/>
              <a:gd name="connsiteX57" fmla="*/ 165437 w 5511704"/>
              <a:gd name="connsiteY57" fmla="*/ 2953941 h 6886576"/>
              <a:gd name="connsiteX58" fmla="*/ 697501 w 5511704"/>
              <a:gd name="connsiteY58" fmla="*/ 3343275 h 6886576"/>
              <a:gd name="connsiteX59" fmla="*/ 339884 w 5511704"/>
              <a:gd name="connsiteY59" fmla="*/ 3243263 h 6886576"/>
              <a:gd name="connsiteX60" fmla="*/ 290458 w 5511704"/>
              <a:gd name="connsiteY60" fmla="*/ 3407569 h 6886576"/>
              <a:gd name="connsiteX61" fmla="*/ 459090 w 5511704"/>
              <a:gd name="connsiteY61" fmla="*/ 3554016 h 6886576"/>
              <a:gd name="connsiteX62" fmla="*/ 520147 w 5511704"/>
              <a:gd name="connsiteY62" fmla="*/ 3843338 h 6886576"/>
              <a:gd name="connsiteX63" fmla="*/ 491072 w 5511704"/>
              <a:gd name="connsiteY63" fmla="*/ 4107657 h 6886576"/>
              <a:gd name="connsiteX64" fmla="*/ 418386 w 5511704"/>
              <a:gd name="connsiteY64" fmla="*/ 4189810 h 6886576"/>
              <a:gd name="connsiteX65" fmla="*/ 313718 w 5511704"/>
              <a:gd name="connsiteY65" fmla="*/ 4339829 h 6886576"/>
              <a:gd name="connsiteX66" fmla="*/ 249753 w 5511704"/>
              <a:gd name="connsiteY66" fmla="*/ 4432698 h 6886576"/>
              <a:gd name="connsiteX67" fmla="*/ 25879 w 5511704"/>
              <a:gd name="connsiteY67" fmla="*/ 4396979 h 6886576"/>
              <a:gd name="connsiteX68" fmla="*/ 325347 w 5511704"/>
              <a:gd name="connsiteY68" fmla="*/ 4632722 h 6886576"/>
              <a:gd name="connsiteX69" fmla="*/ 84029 w 5511704"/>
              <a:gd name="connsiteY69" fmla="*/ 4604147 h 6886576"/>
              <a:gd name="connsiteX70" fmla="*/ 5527 w 5511704"/>
              <a:gd name="connsiteY70" fmla="*/ 4622007 h 6886576"/>
              <a:gd name="connsiteX71" fmla="*/ 49139 w 5511704"/>
              <a:gd name="connsiteY71" fmla="*/ 4697016 h 6886576"/>
              <a:gd name="connsiteX72" fmla="*/ 226494 w 5511704"/>
              <a:gd name="connsiteY72" fmla="*/ 4825604 h 6886576"/>
              <a:gd name="connsiteX73" fmla="*/ 592833 w 5511704"/>
              <a:gd name="connsiteY73" fmla="*/ 5175647 h 6886576"/>
              <a:gd name="connsiteX74" fmla="*/ 238123 w 5511704"/>
              <a:gd name="connsiteY74" fmla="*/ 5014913 h 6886576"/>
              <a:gd name="connsiteX75" fmla="*/ 610278 w 5511704"/>
              <a:gd name="connsiteY75" fmla="*/ 5375673 h 6886576"/>
              <a:gd name="connsiteX76" fmla="*/ 691686 w 5511704"/>
              <a:gd name="connsiteY76" fmla="*/ 5497116 h 6886576"/>
              <a:gd name="connsiteX77" fmla="*/ 860319 w 5511704"/>
              <a:gd name="connsiteY77" fmla="*/ 5793582 h 6886576"/>
              <a:gd name="connsiteX78" fmla="*/ 851597 w 5511704"/>
              <a:gd name="connsiteY78" fmla="*/ 5825729 h 6886576"/>
              <a:gd name="connsiteX79" fmla="*/ 659704 w 5511704"/>
              <a:gd name="connsiteY79" fmla="*/ 5779295 h 6886576"/>
              <a:gd name="connsiteX80" fmla="*/ 909746 w 5511704"/>
              <a:gd name="connsiteY80" fmla="*/ 6029326 h 6886576"/>
              <a:gd name="connsiteX81" fmla="*/ 1168509 w 5511704"/>
              <a:gd name="connsiteY81" fmla="*/ 6222207 h 6886576"/>
              <a:gd name="connsiteX82" fmla="*/ 985339 w 5511704"/>
              <a:gd name="connsiteY82" fmla="*/ 6193632 h 6886576"/>
              <a:gd name="connsiteX83" fmla="*/ 732391 w 5511704"/>
              <a:gd name="connsiteY83" fmla="*/ 6082904 h 6886576"/>
              <a:gd name="connsiteX84" fmla="*/ 645167 w 5511704"/>
              <a:gd name="connsiteY84" fmla="*/ 6125766 h 6886576"/>
              <a:gd name="connsiteX85" fmla="*/ 883579 w 5511704"/>
              <a:gd name="connsiteY85" fmla="*/ 6307932 h 6886576"/>
              <a:gd name="connsiteX86" fmla="*/ 1020229 w 5511704"/>
              <a:gd name="connsiteY86" fmla="*/ 6393657 h 6886576"/>
              <a:gd name="connsiteX87" fmla="*/ 1075471 w 5511704"/>
              <a:gd name="connsiteY87" fmla="*/ 6457950 h 6886576"/>
              <a:gd name="connsiteX88" fmla="*/ 1232473 w 5511704"/>
              <a:gd name="connsiteY88" fmla="*/ 6686551 h 6886576"/>
              <a:gd name="connsiteX89" fmla="*/ 1592997 w 5511704"/>
              <a:gd name="connsiteY89" fmla="*/ 6886576 h 6886576"/>
              <a:gd name="connsiteX90" fmla="*/ 5511704 w 5511704"/>
              <a:gd name="connsiteY90" fmla="*/ 6886576 h 68865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Lst>
            <a:rect l="l" t="t" r="r" b="b"/>
            <a:pathLst>
              <a:path w="5511704" h="6886576">
                <a:moveTo>
                  <a:pt x="5511704" y="0"/>
                </a:moveTo>
                <a:lnTo>
                  <a:pt x="1008599" y="0"/>
                </a:lnTo>
                <a:cubicBezTo>
                  <a:pt x="1110360" y="35719"/>
                  <a:pt x="1209214" y="78581"/>
                  <a:pt x="1310975" y="110728"/>
                </a:cubicBezTo>
                <a:cubicBezTo>
                  <a:pt x="1296437" y="146447"/>
                  <a:pt x="1281900" y="139303"/>
                  <a:pt x="1267362" y="135731"/>
                </a:cubicBezTo>
                <a:cubicBezTo>
                  <a:pt x="1180139" y="121445"/>
                  <a:pt x="1090008" y="110728"/>
                  <a:pt x="1005692" y="71437"/>
                </a:cubicBezTo>
                <a:cubicBezTo>
                  <a:pt x="985339" y="64294"/>
                  <a:pt x="962080" y="64294"/>
                  <a:pt x="953358" y="89297"/>
                </a:cubicBezTo>
                <a:cubicBezTo>
                  <a:pt x="938820" y="125016"/>
                  <a:pt x="959172" y="146447"/>
                  <a:pt x="979525" y="164307"/>
                </a:cubicBezTo>
                <a:cubicBezTo>
                  <a:pt x="1014414" y="196453"/>
                  <a:pt x="1055118" y="189310"/>
                  <a:pt x="1092915" y="192882"/>
                </a:cubicBezTo>
                <a:cubicBezTo>
                  <a:pt x="1197583" y="210741"/>
                  <a:pt x="1247011" y="260747"/>
                  <a:pt x="1270270" y="375047"/>
                </a:cubicBezTo>
                <a:cubicBezTo>
                  <a:pt x="1180139" y="328613"/>
                  <a:pt x="1090008" y="385763"/>
                  <a:pt x="1002784" y="353615"/>
                </a:cubicBezTo>
                <a:cubicBezTo>
                  <a:pt x="979525" y="346472"/>
                  <a:pt x="944635" y="357188"/>
                  <a:pt x="956265" y="396479"/>
                </a:cubicBezTo>
                <a:cubicBezTo>
                  <a:pt x="967894" y="432198"/>
                  <a:pt x="1005692" y="460772"/>
                  <a:pt x="938820" y="453629"/>
                </a:cubicBezTo>
                <a:cubicBezTo>
                  <a:pt x="889393" y="450056"/>
                  <a:pt x="874856" y="407194"/>
                  <a:pt x="860319" y="360759"/>
                </a:cubicBezTo>
                <a:cubicBezTo>
                  <a:pt x="848689" y="335757"/>
                  <a:pt x="816707" y="321469"/>
                  <a:pt x="793447" y="335757"/>
                </a:cubicBezTo>
                <a:cubicBezTo>
                  <a:pt x="764373" y="350044"/>
                  <a:pt x="773095" y="389335"/>
                  <a:pt x="773095" y="417910"/>
                </a:cubicBezTo>
                <a:cubicBezTo>
                  <a:pt x="770187" y="471488"/>
                  <a:pt x="793447" y="496491"/>
                  <a:pt x="834151" y="507206"/>
                </a:cubicBezTo>
                <a:cubicBezTo>
                  <a:pt x="883579" y="521494"/>
                  <a:pt x="933005" y="539354"/>
                  <a:pt x="996969" y="560785"/>
                </a:cubicBezTo>
                <a:cubicBezTo>
                  <a:pt x="927190" y="596503"/>
                  <a:pt x="874856" y="589360"/>
                  <a:pt x="822522" y="560785"/>
                </a:cubicBezTo>
                <a:cubicBezTo>
                  <a:pt x="758558" y="528637"/>
                  <a:pt x="674242" y="485775"/>
                  <a:pt x="621908" y="525066"/>
                </a:cubicBezTo>
                <a:cubicBezTo>
                  <a:pt x="543407" y="582216"/>
                  <a:pt x="479443" y="546497"/>
                  <a:pt x="409664" y="535781"/>
                </a:cubicBezTo>
                <a:cubicBezTo>
                  <a:pt x="264290" y="514350"/>
                  <a:pt x="354422" y="482204"/>
                  <a:pt x="209049" y="464344"/>
                </a:cubicBezTo>
                <a:cubicBezTo>
                  <a:pt x="150900" y="457200"/>
                  <a:pt x="89843" y="428625"/>
                  <a:pt x="5527" y="467916"/>
                </a:cubicBezTo>
                <a:cubicBezTo>
                  <a:pt x="386404" y="675085"/>
                  <a:pt x="566666" y="660797"/>
                  <a:pt x="906838" y="914400"/>
                </a:cubicBezTo>
                <a:cubicBezTo>
                  <a:pt x="892301" y="939404"/>
                  <a:pt x="877764" y="928688"/>
                  <a:pt x="863226" y="925116"/>
                </a:cubicBezTo>
                <a:cubicBezTo>
                  <a:pt x="839967" y="921544"/>
                  <a:pt x="810892" y="907256"/>
                  <a:pt x="805077" y="953691"/>
                </a:cubicBezTo>
                <a:cubicBezTo>
                  <a:pt x="802169" y="989410"/>
                  <a:pt x="819615" y="1007269"/>
                  <a:pt x="848689" y="1010841"/>
                </a:cubicBezTo>
                <a:cubicBezTo>
                  <a:pt x="933005" y="1025129"/>
                  <a:pt x="1008599" y="1075135"/>
                  <a:pt x="1084193" y="1117997"/>
                </a:cubicBezTo>
                <a:cubicBezTo>
                  <a:pt x="1119082" y="1135857"/>
                  <a:pt x="1156879" y="1160860"/>
                  <a:pt x="1142342" y="1225153"/>
                </a:cubicBezTo>
                <a:cubicBezTo>
                  <a:pt x="1113268" y="1243013"/>
                  <a:pt x="1092915" y="1218009"/>
                  <a:pt x="1069655" y="1214438"/>
                </a:cubicBezTo>
                <a:cubicBezTo>
                  <a:pt x="1046396" y="1210866"/>
                  <a:pt x="991154" y="1225153"/>
                  <a:pt x="1005692" y="1235869"/>
                </a:cubicBezTo>
                <a:cubicBezTo>
                  <a:pt x="1072563" y="1275159"/>
                  <a:pt x="950450" y="1371600"/>
                  <a:pt x="1031858" y="1371600"/>
                </a:cubicBezTo>
                <a:cubicBezTo>
                  <a:pt x="1165601" y="1371600"/>
                  <a:pt x="1238288" y="1543050"/>
                  <a:pt x="1366216" y="1546622"/>
                </a:cubicBezTo>
                <a:cubicBezTo>
                  <a:pt x="1386568" y="1546622"/>
                  <a:pt x="1395290" y="1578770"/>
                  <a:pt x="1395290" y="1603772"/>
                </a:cubicBezTo>
                <a:cubicBezTo>
                  <a:pt x="1395290" y="1635920"/>
                  <a:pt x="1374939" y="1639491"/>
                  <a:pt x="1354586" y="1643063"/>
                </a:cubicBezTo>
                <a:cubicBezTo>
                  <a:pt x="1322604" y="1646635"/>
                  <a:pt x="1287715" y="1603772"/>
                  <a:pt x="1247011" y="1664494"/>
                </a:cubicBezTo>
                <a:cubicBezTo>
                  <a:pt x="1322604" y="1700213"/>
                  <a:pt x="1401105" y="1735932"/>
                  <a:pt x="1398198" y="1857375"/>
                </a:cubicBezTo>
                <a:cubicBezTo>
                  <a:pt x="1398198" y="1889523"/>
                  <a:pt x="1430180" y="1903810"/>
                  <a:pt x="1453440" y="1910954"/>
                </a:cubicBezTo>
                <a:cubicBezTo>
                  <a:pt x="1494144" y="1925241"/>
                  <a:pt x="1526126" y="1946673"/>
                  <a:pt x="1549386" y="1993106"/>
                </a:cubicBezTo>
                <a:cubicBezTo>
                  <a:pt x="1549386" y="2003822"/>
                  <a:pt x="1549386" y="2010966"/>
                  <a:pt x="1549386" y="2021681"/>
                </a:cubicBezTo>
                <a:cubicBezTo>
                  <a:pt x="1543571" y="2132410"/>
                  <a:pt x="1485422" y="2128838"/>
                  <a:pt x="1421458" y="2110978"/>
                </a:cubicBezTo>
                <a:cubicBezTo>
                  <a:pt x="1345864" y="2089547"/>
                  <a:pt x="1270270" y="2046685"/>
                  <a:pt x="1188861" y="2085976"/>
                </a:cubicBezTo>
                <a:cubicBezTo>
                  <a:pt x="1302252" y="2139554"/>
                  <a:pt x="1427272" y="2143126"/>
                  <a:pt x="1531941" y="2218135"/>
                </a:cubicBezTo>
                <a:cubicBezTo>
                  <a:pt x="1142342" y="2232422"/>
                  <a:pt x="799262" y="1993106"/>
                  <a:pt x="421293" y="1900238"/>
                </a:cubicBezTo>
                <a:cubicBezTo>
                  <a:pt x="432923" y="1960960"/>
                  <a:pt x="464905" y="1975247"/>
                  <a:pt x="491072" y="1982391"/>
                </a:cubicBezTo>
                <a:cubicBezTo>
                  <a:pt x="630630" y="2028825"/>
                  <a:pt x="752743" y="2121695"/>
                  <a:pt x="880671" y="2200276"/>
                </a:cubicBezTo>
                <a:cubicBezTo>
                  <a:pt x="933005" y="2232422"/>
                  <a:pt x="970802" y="2268142"/>
                  <a:pt x="991154" y="2336007"/>
                </a:cubicBezTo>
                <a:cubicBezTo>
                  <a:pt x="1008599" y="2400300"/>
                  <a:pt x="1043489" y="2428875"/>
                  <a:pt x="1107453" y="2411016"/>
                </a:cubicBezTo>
                <a:cubicBezTo>
                  <a:pt x="1159787" y="2396729"/>
                  <a:pt x="1215029" y="2403873"/>
                  <a:pt x="1270270" y="2411016"/>
                </a:cubicBezTo>
                <a:cubicBezTo>
                  <a:pt x="1331326" y="2418160"/>
                  <a:pt x="1401105" y="2489597"/>
                  <a:pt x="1386568" y="2528889"/>
                </a:cubicBezTo>
                <a:cubicBezTo>
                  <a:pt x="1357494" y="2593182"/>
                  <a:pt x="1308067" y="2561035"/>
                  <a:pt x="1267362" y="2553891"/>
                </a:cubicBezTo>
                <a:cubicBezTo>
                  <a:pt x="1217936" y="2546748"/>
                  <a:pt x="1127805" y="2528889"/>
                  <a:pt x="1127805" y="2536032"/>
                </a:cubicBezTo>
                <a:cubicBezTo>
                  <a:pt x="1095822" y="2696766"/>
                  <a:pt x="1023136" y="2575322"/>
                  <a:pt x="970802" y="2575322"/>
                </a:cubicBezTo>
                <a:cubicBezTo>
                  <a:pt x="921375" y="2575322"/>
                  <a:pt x="871949" y="2557463"/>
                  <a:pt x="825429" y="2543176"/>
                </a:cubicBezTo>
                <a:cubicBezTo>
                  <a:pt x="764373" y="2525316"/>
                  <a:pt x="709132" y="2557463"/>
                  <a:pt x="650982" y="2564607"/>
                </a:cubicBezTo>
                <a:cubicBezTo>
                  <a:pt x="598648" y="2571751"/>
                  <a:pt x="627722" y="2664620"/>
                  <a:pt x="595740" y="2703909"/>
                </a:cubicBezTo>
                <a:cubicBezTo>
                  <a:pt x="589926" y="2714626"/>
                  <a:pt x="584111" y="2714626"/>
                  <a:pt x="578296" y="2714626"/>
                </a:cubicBezTo>
                <a:cubicBezTo>
                  <a:pt x="560851" y="2993232"/>
                  <a:pt x="255568" y="2925366"/>
                  <a:pt x="255568" y="2936081"/>
                </a:cubicBezTo>
                <a:cubicBezTo>
                  <a:pt x="229401" y="2953941"/>
                  <a:pt x="197419" y="2911079"/>
                  <a:pt x="165437" y="2953941"/>
                </a:cubicBezTo>
                <a:cubicBezTo>
                  <a:pt x="302087" y="3150394"/>
                  <a:pt x="511425" y="3196828"/>
                  <a:pt x="697501" y="3343275"/>
                </a:cubicBezTo>
                <a:cubicBezTo>
                  <a:pt x="543407" y="3393282"/>
                  <a:pt x="453275" y="3221832"/>
                  <a:pt x="339884" y="3243263"/>
                </a:cubicBezTo>
                <a:cubicBezTo>
                  <a:pt x="284643" y="3296842"/>
                  <a:pt x="450368" y="3382566"/>
                  <a:pt x="290458" y="3407569"/>
                </a:cubicBezTo>
                <a:cubicBezTo>
                  <a:pt x="360236" y="3454004"/>
                  <a:pt x="409664" y="3500439"/>
                  <a:pt x="459090" y="3554016"/>
                </a:cubicBezTo>
                <a:cubicBezTo>
                  <a:pt x="543407" y="3650457"/>
                  <a:pt x="560851" y="3714751"/>
                  <a:pt x="520147" y="3843338"/>
                </a:cubicBezTo>
                <a:cubicBezTo>
                  <a:pt x="493979" y="3929063"/>
                  <a:pt x="456183" y="4007645"/>
                  <a:pt x="491072" y="4107657"/>
                </a:cubicBezTo>
                <a:cubicBezTo>
                  <a:pt x="514332" y="4175522"/>
                  <a:pt x="505609" y="4221957"/>
                  <a:pt x="418386" y="4189810"/>
                </a:cubicBezTo>
                <a:cubicBezTo>
                  <a:pt x="325347" y="4157663"/>
                  <a:pt x="290458" y="4218386"/>
                  <a:pt x="313718" y="4339829"/>
                </a:cubicBezTo>
                <a:cubicBezTo>
                  <a:pt x="328254" y="4418410"/>
                  <a:pt x="313718" y="4443413"/>
                  <a:pt x="249753" y="4432698"/>
                </a:cubicBezTo>
                <a:cubicBezTo>
                  <a:pt x="179975" y="4421982"/>
                  <a:pt x="113103" y="4371976"/>
                  <a:pt x="25879" y="4396979"/>
                </a:cubicBezTo>
                <a:cubicBezTo>
                  <a:pt x="95658" y="4539854"/>
                  <a:pt x="243939" y="4496991"/>
                  <a:pt x="325347" y="4632722"/>
                </a:cubicBezTo>
                <a:cubicBezTo>
                  <a:pt x="229401" y="4632722"/>
                  <a:pt x="153807" y="4632722"/>
                  <a:pt x="84029" y="4604147"/>
                </a:cubicBezTo>
                <a:cubicBezTo>
                  <a:pt x="54954" y="4593433"/>
                  <a:pt x="22972" y="4579145"/>
                  <a:pt x="5527" y="4622007"/>
                </a:cubicBezTo>
                <a:cubicBezTo>
                  <a:pt x="-14826" y="4672014"/>
                  <a:pt x="25879" y="4689872"/>
                  <a:pt x="49139" y="4697016"/>
                </a:cubicBezTo>
                <a:cubicBezTo>
                  <a:pt x="116011" y="4722019"/>
                  <a:pt x="168344" y="4779170"/>
                  <a:pt x="226494" y="4825604"/>
                </a:cubicBezTo>
                <a:cubicBezTo>
                  <a:pt x="351514" y="4925616"/>
                  <a:pt x="488165" y="5011341"/>
                  <a:pt x="592833" y="5175647"/>
                </a:cubicBezTo>
                <a:cubicBezTo>
                  <a:pt x="461997" y="5132785"/>
                  <a:pt x="363144" y="5032772"/>
                  <a:pt x="238123" y="5014913"/>
                </a:cubicBezTo>
                <a:cubicBezTo>
                  <a:pt x="345700" y="5164932"/>
                  <a:pt x="482350" y="5264944"/>
                  <a:pt x="610278" y="5375673"/>
                </a:cubicBezTo>
                <a:cubicBezTo>
                  <a:pt x="648075" y="5407819"/>
                  <a:pt x="685872" y="5429250"/>
                  <a:pt x="691686" y="5497116"/>
                </a:cubicBezTo>
                <a:cubicBezTo>
                  <a:pt x="709132" y="5629276"/>
                  <a:pt x="755650" y="5736432"/>
                  <a:pt x="860319" y="5793582"/>
                </a:cubicBezTo>
                <a:cubicBezTo>
                  <a:pt x="860319" y="5793582"/>
                  <a:pt x="854504" y="5815013"/>
                  <a:pt x="851597" y="5825729"/>
                </a:cubicBezTo>
                <a:cubicBezTo>
                  <a:pt x="787632" y="5829301"/>
                  <a:pt x="738206" y="5750720"/>
                  <a:pt x="659704" y="5779295"/>
                </a:cubicBezTo>
                <a:cubicBezTo>
                  <a:pt x="738206" y="5886451"/>
                  <a:pt x="802169" y="5979319"/>
                  <a:pt x="909746" y="6029326"/>
                </a:cubicBezTo>
                <a:cubicBezTo>
                  <a:pt x="996969" y="6068616"/>
                  <a:pt x="1104545" y="6093620"/>
                  <a:pt x="1168509" y="6222207"/>
                </a:cubicBezTo>
                <a:cubicBezTo>
                  <a:pt x="1095822" y="6247210"/>
                  <a:pt x="1040581" y="6215063"/>
                  <a:pt x="985339" y="6193632"/>
                </a:cubicBezTo>
                <a:cubicBezTo>
                  <a:pt x="901023" y="6157913"/>
                  <a:pt x="816707" y="6118623"/>
                  <a:pt x="732391" y="6082904"/>
                </a:cubicBezTo>
                <a:cubicBezTo>
                  <a:pt x="700408" y="6068616"/>
                  <a:pt x="665519" y="6061472"/>
                  <a:pt x="645167" y="6125766"/>
                </a:cubicBezTo>
                <a:cubicBezTo>
                  <a:pt x="752743" y="6140053"/>
                  <a:pt x="816707" y="6225779"/>
                  <a:pt x="883579" y="6307932"/>
                </a:cubicBezTo>
                <a:cubicBezTo>
                  <a:pt x="921375" y="6354366"/>
                  <a:pt x="953358" y="6415088"/>
                  <a:pt x="1020229" y="6393657"/>
                </a:cubicBezTo>
                <a:cubicBezTo>
                  <a:pt x="1055118" y="6382942"/>
                  <a:pt x="1078378" y="6415088"/>
                  <a:pt x="1075471" y="6457950"/>
                </a:cubicBezTo>
                <a:cubicBezTo>
                  <a:pt x="1060933" y="6607970"/>
                  <a:pt x="1145250" y="6657976"/>
                  <a:pt x="1232473" y="6686551"/>
                </a:cubicBezTo>
                <a:cubicBezTo>
                  <a:pt x="1360401" y="6729413"/>
                  <a:pt x="1473792" y="6815138"/>
                  <a:pt x="1592997" y="6886576"/>
                </a:cubicBezTo>
                <a:lnTo>
                  <a:pt x="5511704" y="6886576"/>
                </a:lnTo>
                <a:close/>
              </a:path>
            </a:pathLst>
          </a:custGeom>
          <a:solidFill>
            <a:schemeClr val="accent1">
              <a:alpha val="20000"/>
            </a:schemeClr>
          </a:solidFill>
          <a:ln w="32707" cap="flat">
            <a:noFill/>
            <a:prstDash val="solid"/>
            <a:miter/>
          </a:ln>
        </p:spPr>
        <p:txBody>
          <a:bodyPr rtlCol="0" anchor="ctr"/>
          <a:lstStyle/>
          <a:p>
            <a:endParaRPr lang="en-US" dirty="0"/>
          </a:p>
        </p:txBody>
      </p:sp>
      <p:sp>
        <p:nvSpPr>
          <p:cNvPr id="2" name="Title 1">
            <a:extLst>
              <a:ext uri="{FF2B5EF4-FFF2-40B4-BE49-F238E27FC236}">
                <a16:creationId xmlns:a16="http://schemas.microsoft.com/office/drawing/2014/main" id="{67D2B088-59D4-F74F-8AC3-2D1F5E7FCC4F}"/>
              </a:ext>
            </a:extLst>
          </p:cNvPr>
          <p:cNvSpPr>
            <a:spLocks noGrp="1"/>
          </p:cNvSpPr>
          <p:nvPr>
            <p:ph type="title"/>
          </p:nvPr>
        </p:nvSpPr>
        <p:spPr>
          <a:xfrm>
            <a:off x="838200" y="713312"/>
            <a:ext cx="3524250" cy="5431376"/>
          </a:xfrm>
        </p:spPr>
        <p:txBody>
          <a:bodyPr>
            <a:normAutofit/>
          </a:bodyPr>
          <a:lstStyle/>
          <a:p>
            <a:r>
              <a:rPr lang="en-US" dirty="0"/>
              <a:t>Perception</a:t>
            </a:r>
          </a:p>
        </p:txBody>
      </p:sp>
      <p:sp>
        <p:nvSpPr>
          <p:cNvPr id="3" name="Content Placeholder 2">
            <a:extLst>
              <a:ext uri="{FF2B5EF4-FFF2-40B4-BE49-F238E27FC236}">
                <a16:creationId xmlns:a16="http://schemas.microsoft.com/office/drawing/2014/main" id="{1581B41D-D159-E648-B85C-EF30B892D5AC}"/>
              </a:ext>
            </a:extLst>
          </p:cNvPr>
          <p:cNvSpPr>
            <a:spLocks noGrp="1"/>
          </p:cNvSpPr>
          <p:nvPr>
            <p:ph idx="1"/>
          </p:nvPr>
        </p:nvSpPr>
        <p:spPr>
          <a:xfrm>
            <a:off x="6095999" y="713313"/>
            <a:ext cx="5257801" cy="5431376"/>
          </a:xfrm>
        </p:spPr>
        <p:txBody>
          <a:bodyPr anchor="ctr">
            <a:normAutofit/>
          </a:bodyPr>
          <a:lstStyle/>
          <a:p>
            <a:pPr fontAlgn="auto">
              <a:spcAft>
                <a:spcPts val="0"/>
              </a:spcAft>
              <a:defRPr/>
            </a:pPr>
            <a:r>
              <a:rPr lang="en-US" sz="2000" dirty="0"/>
              <a:t>What does the parent or patient know?</a:t>
            </a:r>
          </a:p>
          <a:p>
            <a:pPr lvl="1" fontAlgn="auto">
              <a:spcAft>
                <a:spcPts val="0"/>
              </a:spcAft>
              <a:defRPr/>
            </a:pPr>
            <a:r>
              <a:rPr lang="en-US" sz="2000" dirty="0"/>
              <a:t>“Just so I know where to begin, tell me what you know about what’s going on.”</a:t>
            </a:r>
          </a:p>
          <a:p>
            <a:pPr lvl="1" fontAlgn="auto">
              <a:spcAft>
                <a:spcPts val="0"/>
              </a:spcAft>
              <a:defRPr/>
            </a:pPr>
            <a:r>
              <a:rPr lang="en-US" sz="2000" dirty="0"/>
              <a:t>“What have the other doctors and nurses told you?”</a:t>
            </a:r>
          </a:p>
          <a:p>
            <a:endParaRPr lang="en-US" sz="2000" dirty="0"/>
          </a:p>
        </p:txBody>
      </p:sp>
    </p:spTree>
    <p:extLst>
      <p:ext uri="{BB962C8B-B14F-4D97-AF65-F5344CB8AC3E}">
        <p14:creationId xmlns:p14="http://schemas.microsoft.com/office/powerpoint/2010/main" val="16221659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4" name="Rectangle 13">
            <a:extLst>
              <a:ext uri="{FF2B5EF4-FFF2-40B4-BE49-F238E27FC236}">
                <a16:creationId xmlns:a16="http://schemas.microsoft.com/office/drawing/2014/main" id="{DA8886A6-5426-494B-96D8-D962D2BA08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6" name="Freeform: Shape 15">
            <a:extLst>
              <a:ext uri="{FF2B5EF4-FFF2-40B4-BE49-F238E27FC236}">
                <a16:creationId xmlns:a16="http://schemas.microsoft.com/office/drawing/2014/main" id="{AA3ED336-C09E-46E8-9774-B977D15FC5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752347"/>
            <a:ext cx="12191999" cy="6105653"/>
          </a:xfrm>
          <a:custGeom>
            <a:avLst/>
            <a:gdLst>
              <a:gd name="connsiteX0" fmla="*/ 7538181 w 12191999"/>
              <a:gd name="connsiteY0" fmla="*/ 484 h 6105653"/>
              <a:gd name="connsiteX1" fmla="*/ 7569993 w 12191999"/>
              <a:gd name="connsiteY1" fmla="*/ 5527 h 6105653"/>
              <a:gd name="connsiteX2" fmla="*/ 7587853 w 12191999"/>
              <a:gd name="connsiteY2" fmla="*/ 84028 h 6105653"/>
              <a:gd name="connsiteX3" fmla="*/ 7559278 w 12191999"/>
              <a:gd name="connsiteY3" fmla="*/ 325347 h 6105653"/>
              <a:gd name="connsiteX4" fmla="*/ 7795021 w 12191999"/>
              <a:gd name="connsiteY4" fmla="*/ 25878 h 6105653"/>
              <a:gd name="connsiteX5" fmla="*/ 7759302 w 12191999"/>
              <a:gd name="connsiteY5" fmla="*/ 249752 h 6105653"/>
              <a:gd name="connsiteX6" fmla="*/ 7852171 w 12191999"/>
              <a:gd name="connsiteY6" fmla="*/ 313717 h 6105653"/>
              <a:gd name="connsiteX7" fmla="*/ 8002190 w 12191999"/>
              <a:gd name="connsiteY7" fmla="*/ 418385 h 6105653"/>
              <a:gd name="connsiteX8" fmla="*/ 8084343 w 12191999"/>
              <a:gd name="connsiteY8" fmla="*/ 491072 h 6105653"/>
              <a:gd name="connsiteX9" fmla="*/ 8348662 w 12191999"/>
              <a:gd name="connsiteY9" fmla="*/ 520146 h 6105653"/>
              <a:gd name="connsiteX10" fmla="*/ 8637984 w 12191999"/>
              <a:gd name="connsiteY10" fmla="*/ 459090 h 6105653"/>
              <a:gd name="connsiteX11" fmla="*/ 8784431 w 12191999"/>
              <a:gd name="connsiteY11" fmla="*/ 290457 h 6105653"/>
              <a:gd name="connsiteX12" fmla="*/ 8948737 w 12191999"/>
              <a:gd name="connsiteY12" fmla="*/ 339884 h 6105653"/>
              <a:gd name="connsiteX13" fmla="*/ 8848725 w 12191999"/>
              <a:gd name="connsiteY13" fmla="*/ 697501 h 6105653"/>
              <a:gd name="connsiteX14" fmla="*/ 9238059 w 12191999"/>
              <a:gd name="connsiteY14" fmla="*/ 165437 h 6105653"/>
              <a:gd name="connsiteX15" fmla="*/ 9255919 w 12191999"/>
              <a:gd name="connsiteY15" fmla="*/ 255567 h 6105653"/>
              <a:gd name="connsiteX16" fmla="*/ 9477374 w 12191999"/>
              <a:gd name="connsiteY16" fmla="*/ 578295 h 6105653"/>
              <a:gd name="connsiteX17" fmla="*/ 9488091 w 12191999"/>
              <a:gd name="connsiteY17" fmla="*/ 595740 h 6105653"/>
              <a:gd name="connsiteX18" fmla="*/ 9627393 w 12191999"/>
              <a:gd name="connsiteY18" fmla="*/ 650981 h 6105653"/>
              <a:gd name="connsiteX19" fmla="*/ 9648824 w 12191999"/>
              <a:gd name="connsiteY19" fmla="*/ 825429 h 6105653"/>
              <a:gd name="connsiteX20" fmla="*/ 9616678 w 12191999"/>
              <a:gd name="connsiteY20" fmla="*/ 970802 h 6105653"/>
              <a:gd name="connsiteX21" fmla="*/ 9655968 w 12191999"/>
              <a:gd name="connsiteY21" fmla="*/ 1127805 h 6105653"/>
              <a:gd name="connsiteX22" fmla="*/ 9638109 w 12191999"/>
              <a:gd name="connsiteY22" fmla="*/ 1267362 h 6105653"/>
              <a:gd name="connsiteX23" fmla="*/ 9663111 w 12191999"/>
              <a:gd name="connsiteY23" fmla="*/ 1386568 h 6105653"/>
              <a:gd name="connsiteX24" fmla="*/ 9780984 w 12191999"/>
              <a:gd name="connsiteY24" fmla="*/ 1270269 h 6105653"/>
              <a:gd name="connsiteX25" fmla="*/ 9780984 w 12191999"/>
              <a:gd name="connsiteY25" fmla="*/ 1107452 h 6105653"/>
              <a:gd name="connsiteX26" fmla="*/ 9855993 w 12191999"/>
              <a:gd name="connsiteY26" fmla="*/ 991154 h 6105653"/>
              <a:gd name="connsiteX27" fmla="*/ 9991724 w 12191999"/>
              <a:gd name="connsiteY27" fmla="*/ 880670 h 6105653"/>
              <a:gd name="connsiteX28" fmla="*/ 10209609 w 12191999"/>
              <a:gd name="connsiteY28" fmla="*/ 491071 h 6105653"/>
              <a:gd name="connsiteX29" fmla="*/ 10291762 w 12191999"/>
              <a:gd name="connsiteY29" fmla="*/ 421292 h 6105653"/>
              <a:gd name="connsiteX30" fmla="*/ 9973865 w 12191999"/>
              <a:gd name="connsiteY30" fmla="*/ 1531941 h 6105653"/>
              <a:gd name="connsiteX31" fmla="*/ 10106024 w 12191999"/>
              <a:gd name="connsiteY31" fmla="*/ 1188861 h 6105653"/>
              <a:gd name="connsiteX32" fmla="*/ 10081022 w 12191999"/>
              <a:gd name="connsiteY32" fmla="*/ 1421458 h 6105653"/>
              <a:gd name="connsiteX33" fmla="*/ 10170318 w 12191999"/>
              <a:gd name="connsiteY33" fmla="*/ 1549385 h 6105653"/>
              <a:gd name="connsiteX34" fmla="*/ 10198893 w 12191999"/>
              <a:gd name="connsiteY34" fmla="*/ 1549385 h 6105653"/>
              <a:gd name="connsiteX35" fmla="*/ 10281046 w 12191999"/>
              <a:gd name="connsiteY35" fmla="*/ 1453439 h 6105653"/>
              <a:gd name="connsiteX36" fmla="*/ 10334625 w 12191999"/>
              <a:gd name="connsiteY36" fmla="*/ 1398198 h 6105653"/>
              <a:gd name="connsiteX37" fmla="*/ 10527506 w 12191999"/>
              <a:gd name="connsiteY37" fmla="*/ 1247010 h 6105653"/>
              <a:gd name="connsiteX38" fmla="*/ 10548937 w 12191999"/>
              <a:gd name="connsiteY38" fmla="*/ 1354586 h 6105653"/>
              <a:gd name="connsiteX39" fmla="*/ 10588228 w 12191999"/>
              <a:gd name="connsiteY39" fmla="*/ 1395290 h 6105653"/>
              <a:gd name="connsiteX40" fmla="*/ 10645378 w 12191999"/>
              <a:gd name="connsiteY40" fmla="*/ 1366216 h 6105653"/>
              <a:gd name="connsiteX41" fmla="*/ 10820400 w 12191999"/>
              <a:gd name="connsiteY41" fmla="*/ 1031858 h 6105653"/>
              <a:gd name="connsiteX42" fmla="*/ 10956131 w 12191999"/>
              <a:gd name="connsiteY42" fmla="*/ 1005691 h 6105653"/>
              <a:gd name="connsiteX43" fmla="*/ 10977562 w 12191999"/>
              <a:gd name="connsiteY43" fmla="*/ 1069655 h 6105653"/>
              <a:gd name="connsiteX44" fmla="*/ 10966847 w 12191999"/>
              <a:gd name="connsiteY44" fmla="*/ 1142341 h 6105653"/>
              <a:gd name="connsiteX45" fmla="*/ 11074003 w 12191999"/>
              <a:gd name="connsiteY45" fmla="*/ 1084192 h 6105653"/>
              <a:gd name="connsiteX46" fmla="*/ 11181159 w 12191999"/>
              <a:gd name="connsiteY46" fmla="*/ 848688 h 6105653"/>
              <a:gd name="connsiteX47" fmla="*/ 11238309 w 12191999"/>
              <a:gd name="connsiteY47" fmla="*/ 805077 h 6105653"/>
              <a:gd name="connsiteX48" fmla="*/ 11266884 w 12191999"/>
              <a:gd name="connsiteY48" fmla="*/ 863226 h 6105653"/>
              <a:gd name="connsiteX49" fmla="*/ 11277600 w 12191999"/>
              <a:gd name="connsiteY49" fmla="*/ 906838 h 6105653"/>
              <a:gd name="connsiteX50" fmla="*/ 11724084 w 12191999"/>
              <a:gd name="connsiteY50" fmla="*/ 5527 h 6105653"/>
              <a:gd name="connsiteX51" fmla="*/ 11727656 w 12191999"/>
              <a:gd name="connsiteY51" fmla="*/ 209048 h 6105653"/>
              <a:gd name="connsiteX52" fmla="*/ 11656218 w 12191999"/>
              <a:gd name="connsiteY52" fmla="*/ 409663 h 6105653"/>
              <a:gd name="connsiteX53" fmla="*/ 11666934 w 12191999"/>
              <a:gd name="connsiteY53" fmla="*/ 621907 h 6105653"/>
              <a:gd name="connsiteX54" fmla="*/ 11631215 w 12191999"/>
              <a:gd name="connsiteY54" fmla="*/ 822521 h 6105653"/>
              <a:gd name="connsiteX55" fmla="*/ 11631215 w 12191999"/>
              <a:gd name="connsiteY55" fmla="*/ 996969 h 6105653"/>
              <a:gd name="connsiteX56" fmla="*/ 11684793 w 12191999"/>
              <a:gd name="connsiteY56" fmla="*/ 834151 h 6105653"/>
              <a:gd name="connsiteX57" fmla="*/ 11774090 w 12191999"/>
              <a:gd name="connsiteY57" fmla="*/ 773095 h 6105653"/>
              <a:gd name="connsiteX58" fmla="*/ 11856243 w 12191999"/>
              <a:gd name="connsiteY58" fmla="*/ 793447 h 6105653"/>
              <a:gd name="connsiteX59" fmla="*/ 11831240 w 12191999"/>
              <a:gd name="connsiteY59" fmla="*/ 860319 h 6105653"/>
              <a:gd name="connsiteX60" fmla="*/ 11738371 w 12191999"/>
              <a:gd name="connsiteY60" fmla="*/ 938820 h 6105653"/>
              <a:gd name="connsiteX61" fmla="*/ 11795521 w 12191999"/>
              <a:gd name="connsiteY61" fmla="*/ 956264 h 6105653"/>
              <a:gd name="connsiteX62" fmla="*/ 11838384 w 12191999"/>
              <a:gd name="connsiteY62" fmla="*/ 1002784 h 6105653"/>
              <a:gd name="connsiteX63" fmla="*/ 11816952 w 12191999"/>
              <a:gd name="connsiteY63" fmla="*/ 1270269 h 6105653"/>
              <a:gd name="connsiteX64" fmla="*/ 11999118 w 12191999"/>
              <a:gd name="connsiteY64" fmla="*/ 1092915 h 6105653"/>
              <a:gd name="connsiteX65" fmla="*/ 12027693 w 12191999"/>
              <a:gd name="connsiteY65" fmla="*/ 979524 h 6105653"/>
              <a:gd name="connsiteX66" fmla="*/ 12102703 w 12191999"/>
              <a:gd name="connsiteY66" fmla="*/ 953357 h 6105653"/>
              <a:gd name="connsiteX67" fmla="*/ 12120562 w 12191999"/>
              <a:gd name="connsiteY67" fmla="*/ 1005691 h 6105653"/>
              <a:gd name="connsiteX68" fmla="*/ 12056268 w 12191999"/>
              <a:gd name="connsiteY68" fmla="*/ 1267362 h 6105653"/>
              <a:gd name="connsiteX69" fmla="*/ 12081272 w 12191999"/>
              <a:gd name="connsiteY69" fmla="*/ 1310974 h 6105653"/>
              <a:gd name="connsiteX70" fmla="*/ 12191999 w 12191999"/>
              <a:gd name="connsiteY70" fmla="*/ 1008598 h 6105653"/>
              <a:gd name="connsiteX71" fmla="*/ 12191999 w 12191999"/>
              <a:gd name="connsiteY71" fmla="*/ 6105653 h 6105653"/>
              <a:gd name="connsiteX72" fmla="*/ 0 w 12191999"/>
              <a:gd name="connsiteY72" fmla="*/ 6105653 h 6105653"/>
              <a:gd name="connsiteX73" fmla="*/ 0 w 12191999"/>
              <a:gd name="connsiteY73" fmla="*/ 927116 h 6105653"/>
              <a:gd name="connsiteX74" fmla="*/ 61930 w 12191999"/>
              <a:gd name="connsiteY74" fmla="*/ 902578 h 6105653"/>
              <a:gd name="connsiteX75" fmla="*/ 155971 w 12191999"/>
              <a:gd name="connsiteY75" fmla="*/ 883588 h 6105653"/>
              <a:gd name="connsiteX76" fmla="*/ 277414 w 12191999"/>
              <a:gd name="connsiteY76" fmla="*/ 802179 h 6105653"/>
              <a:gd name="connsiteX77" fmla="*/ 638174 w 12191999"/>
              <a:gd name="connsiteY77" fmla="*/ 430025 h 6105653"/>
              <a:gd name="connsiteX78" fmla="*/ 477440 w 12191999"/>
              <a:gd name="connsiteY78" fmla="*/ 784735 h 6105653"/>
              <a:gd name="connsiteX79" fmla="*/ 827483 w 12191999"/>
              <a:gd name="connsiteY79" fmla="*/ 418395 h 6105653"/>
              <a:gd name="connsiteX80" fmla="*/ 956071 w 12191999"/>
              <a:gd name="connsiteY80" fmla="*/ 241040 h 6105653"/>
              <a:gd name="connsiteX81" fmla="*/ 999268 w 12191999"/>
              <a:gd name="connsiteY81" fmla="*/ 192386 h 6105653"/>
              <a:gd name="connsiteX82" fmla="*/ 1031080 w 12191999"/>
              <a:gd name="connsiteY82" fmla="*/ 197429 h 6105653"/>
              <a:gd name="connsiteX83" fmla="*/ 1048940 w 12191999"/>
              <a:gd name="connsiteY83" fmla="*/ 275930 h 6105653"/>
              <a:gd name="connsiteX84" fmla="*/ 1020365 w 12191999"/>
              <a:gd name="connsiteY84" fmla="*/ 517249 h 6105653"/>
              <a:gd name="connsiteX85" fmla="*/ 1256108 w 12191999"/>
              <a:gd name="connsiteY85" fmla="*/ 217780 h 6105653"/>
              <a:gd name="connsiteX86" fmla="*/ 1220389 w 12191999"/>
              <a:gd name="connsiteY86" fmla="*/ 441654 h 6105653"/>
              <a:gd name="connsiteX87" fmla="*/ 1313258 w 12191999"/>
              <a:gd name="connsiteY87" fmla="*/ 505619 h 6105653"/>
              <a:gd name="connsiteX88" fmla="*/ 1463277 w 12191999"/>
              <a:gd name="connsiteY88" fmla="*/ 610287 h 6105653"/>
              <a:gd name="connsiteX89" fmla="*/ 1545430 w 12191999"/>
              <a:gd name="connsiteY89" fmla="*/ 682974 h 6105653"/>
              <a:gd name="connsiteX90" fmla="*/ 1809749 w 12191999"/>
              <a:gd name="connsiteY90" fmla="*/ 712048 h 6105653"/>
              <a:gd name="connsiteX91" fmla="*/ 2099071 w 12191999"/>
              <a:gd name="connsiteY91" fmla="*/ 650992 h 6105653"/>
              <a:gd name="connsiteX92" fmla="*/ 2245518 w 12191999"/>
              <a:gd name="connsiteY92" fmla="*/ 482359 h 6105653"/>
              <a:gd name="connsiteX93" fmla="*/ 2409824 w 12191999"/>
              <a:gd name="connsiteY93" fmla="*/ 531786 h 6105653"/>
              <a:gd name="connsiteX94" fmla="*/ 2309812 w 12191999"/>
              <a:gd name="connsiteY94" fmla="*/ 889403 h 6105653"/>
              <a:gd name="connsiteX95" fmla="*/ 2699146 w 12191999"/>
              <a:gd name="connsiteY95" fmla="*/ 357339 h 6105653"/>
              <a:gd name="connsiteX96" fmla="*/ 2717006 w 12191999"/>
              <a:gd name="connsiteY96" fmla="*/ 447469 h 6105653"/>
              <a:gd name="connsiteX97" fmla="*/ 2938461 w 12191999"/>
              <a:gd name="connsiteY97" fmla="*/ 770197 h 6105653"/>
              <a:gd name="connsiteX98" fmla="*/ 2949178 w 12191999"/>
              <a:gd name="connsiteY98" fmla="*/ 787642 h 6105653"/>
              <a:gd name="connsiteX99" fmla="*/ 3088480 w 12191999"/>
              <a:gd name="connsiteY99" fmla="*/ 842883 h 6105653"/>
              <a:gd name="connsiteX100" fmla="*/ 3109911 w 12191999"/>
              <a:gd name="connsiteY100" fmla="*/ 1017331 h 6105653"/>
              <a:gd name="connsiteX101" fmla="*/ 3077765 w 12191999"/>
              <a:gd name="connsiteY101" fmla="*/ 1162704 h 6105653"/>
              <a:gd name="connsiteX102" fmla="*/ 3117055 w 12191999"/>
              <a:gd name="connsiteY102" fmla="*/ 1319707 h 6105653"/>
              <a:gd name="connsiteX103" fmla="*/ 3099196 w 12191999"/>
              <a:gd name="connsiteY103" fmla="*/ 1459264 h 6105653"/>
              <a:gd name="connsiteX104" fmla="*/ 3124198 w 12191999"/>
              <a:gd name="connsiteY104" fmla="*/ 1578470 h 6105653"/>
              <a:gd name="connsiteX105" fmla="*/ 3242071 w 12191999"/>
              <a:gd name="connsiteY105" fmla="*/ 1462171 h 6105653"/>
              <a:gd name="connsiteX106" fmla="*/ 3242071 w 12191999"/>
              <a:gd name="connsiteY106" fmla="*/ 1299354 h 6105653"/>
              <a:gd name="connsiteX107" fmla="*/ 3317080 w 12191999"/>
              <a:gd name="connsiteY107" fmla="*/ 1183056 h 6105653"/>
              <a:gd name="connsiteX108" fmla="*/ 3452811 w 12191999"/>
              <a:gd name="connsiteY108" fmla="*/ 1072572 h 6105653"/>
              <a:gd name="connsiteX109" fmla="*/ 3670696 w 12191999"/>
              <a:gd name="connsiteY109" fmla="*/ 682973 h 6105653"/>
              <a:gd name="connsiteX110" fmla="*/ 3752849 w 12191999"/>
              <a:gd name="connsiteY110" fmla="*/ 613194 h 6105653"/>
              <a:gd name="connsiteX111" fmla="*/ 3434952 w 12191999"/>
              <a:gd name="connsiteY111" fmla="*/ 1723843 h 6105653"/>
              <a:gd name="connsiteX112" fmla="*/ 3567111 w 12191999"/>
              <a:gd name="connsiteY112" fmla="*/ 1380763 h 6105653"/>
              <a:gd name="connsiteX113" fmla="*/ 3542109 w 12191999"/>
              <a:gd name="connsiteY113" fmla="*/ 1613360 h 6105653"/>
              <a:gd name="connsiteX114" fmla="*/ 3631405 w 12191999"/>
              <a:gd name="connsiteY114" fmla="*/ 1741287 h 6105653"/>
              <a:gd name="connsiteX115" fmla="*/ 3659980 w 12191999"/>
              <a:gd name="connsiteY115" fmla="*/ 1741287 h 6105653"/>
              <a:gd name="connsiteX116" fmla="*/ 3742133 w 12191999"/>
              <a:gd name="connsiteY116" fmla="*/ 1645341 h 6105653"/>
              <a:gd name="connsiteX117" fmla="*/ 3795712 w 12191999"/>
              <a:gd name="connsiteY117" fmla="*/ 1590100 h 6105653"/>
              <a:gd name="connsiteX118" fmla="*/ 3988593 w 12191999"/>
              <a:gd name="connsiteY118" fmla="*/ 1438912 h 6105653"/>
              <a:gd name="connsiteX119" fmla="*/ 4010024 w 12191999"/>
              <a:gd name="connsiteY119" fmla="*/ 1546488 h 6105653"/>
              <a:gd name="connsiteX120" fmla="*/ 4049315 w 12191999"/>
              <a:gd name="connsiteY120" fmla="*/ 1587192 h 6105653"/>
              <a:gd name="connsiteX121" fmla="*/ 4106465 w 12191999"/>
              <a:gd name="connsiteY121" fmla="*/ 1558118 h 6105653"/>
              <a:gd name="connsiteX122" fmla="*/ 4281487 w 12191999"/>
              <a:gd name="connsiteY122" fmla="*/ 1223760 h 6105653"/>
              <a:gd name="connsiteX123" fmla="*/ 4417219 w 12191999"/>
              <a:gd name="connsiteY123" fmla="*/ 1197593 h 6105653"/>
              <a:gd name="connsiteX124" fmla="*/ 4438649 w 12191999"/>
              <a:gd name="connsiteY124" fmla="*/ 1261557 h 6105653"/>
              <a:gd name="connsiteX125" fmla="*/ 4427935 w 12191999"/>
              <a:gd name="connsiteY125" fmla="*/ 1334243 h 6105653"/>
              <a:gd name="connsiteX126" fmla="*/ 4535090 w 12191999"/>
              <a:gd name="connsiteY126" fmla="*/ 1276094 h 6105653"/>
              <a:gd name="connsiteX127" fmla="*/ 4642246 w 12191999"/>
              <a:gd name="connsiteY127" fmla="*/ 1040590 h 6105653"/>
              <a:gd name="connsiteX128" fmla="*/ 4699396 w 12191999"/>
              <a:gd name="connsiteY128" fmla="*/ 996979 h 6105653"/>
              <a:gd name="connsiteX129" fmla="*/ 4727971 w 12191999"/>
              <a:gd name="connsiteY129" fmla="*/ 1055128 h 6105653"/>
              <a:gd name="connsiteX130" fmla="*/ 4738688 w 12191999"/>
              <a:gd name="connsiteY130" fmla="*/ 1098740 h 6105653"/>
              <a:gd name="connsiteX131" fmla="*/ 5185172 w 12191999"/>
              <a:gd name="connsiteY131" fmla="*/ 197429 h 6105653"/>
              <a:gd name="connsiteX132" fmla="*/ 5188744 w 12191999"/>
              <a:gd name="connsiteY132" fmla="*/ 400950 h 6105653"/>
              <a:gd name="connsiteX133" fmla="*/ 5117306 w 12191999"/>
              <a:gd name="connsiteY133" fmla="*/ 601565 h 6105653"/>
              <a:gd name="connsiteX134" fmla="*/ 5128021 w 12191999"/>
              <a:gd name="connsiteY134" fmla="*/ 813809 h 6105653"/>
              <a:gd name="connsiteX135" fmla="*/ 5092302 w 12191999"/>
              <a:gd name="connsiteY135" fmla="*/ 1014423 h 6105653"/>
              <a:gd name="connsiteX136" fmla="*/ 5092302 w 12191999"/>
              <a:gd name="connsiteY136" fmla="*/ 1188871 h 6105653"/>
              <a:gd name="connsiteX137" fmla="*/ 5145880 w 12191999"/>
              <a:gd name="connsiteY137" fmla="*/ 1026053 h 6105653"/>
              <a:gd name="connsiteX138" fmla="*/ 5235177 w 12191999"/>
              <a:gd name="connsiteY138" fmla="*/ 964997 h 6105653"/>
              <a:gd name="connsiteX139" fmla="*/ 5317331 w 12191999"/>
              <a:gd name="connsiteY139" fmla="*/ 985349 h 6105653"/>
              <a:gd name="connsiteX140" fmla="*/ 5292327 w 12191999"/>
              <a:gd name="connsiteY140" fmla="*/ 1052221 h 6105653"/>
              <a:gd name="connsiteX141" fmla="*/ 5199458 w 12191999"/>
              <a:gd name="connsiteY141" fmla="*/ 1130722 h 6105653"/>
              <a:gd name="connsiteX142" fmla="*/ 5256608 w 12191999"/>
              <a:gd name="connsiteY142" fmla="*/ 1148166 h 6105653"/>
              <a:gd name="connsiteX143" fmla="*/ 5299471 w 12191999"/>
              <a:gd name="connsiteY143" fmla="*/ 1194686 h 6105653"/>
              <a:gd name="connsiteX144" fmla="*/ 5278039 w 12191999"/>
              <a:gd name="connsiteY144" fmla="*/ 1462171 h 6105653"/>
              <a:gd name="connsiteX145" fmla="*/ 5460205 w 12191999"/>
              <a:gd name="connsiteY145" fmla="*/ 1284817 h 6105653"/>
              <a:gd name="connsiteX146" fmla="*/ 5488780 w 12191999"/>
              <a:gd name="connsiteY146" fmla="*/ 1171426 h 6105653"/>
              <a:gd name="connsiteX147" fmla="*/ 5539513 w 12191999"/>
              <a:gd name="connsiteY147" fmla="*/ 1140353 h 6105653"/>
              <a:gd name="connsiteX148" fmla="*/ 5552720 w 12191999"/>
              <a:gd name="connsiteY148" fmla="*/ 1143022 h 6105653"/>
              <a:gd name="connsiteX149" fmla="*/ 5574208 w 12191999"/>
              <a:gd name="connsiteY149" fmla="*/ 1115811 h 6105653"/>
              <a:gd name="connsiteX150" fmla="*/ 5734050 w 12191999"/>
              <a:gd name="connsiteY150" fmla="*/ 1075470 h 6105653"/>
              <a:gd name="connsiteX151" fmla="*/ 5798343 w 12191999"/>
              <a:gd name="connsiteY151" fmla="*/ 1020228 h 6105653"/>
              <a:gd name="connsiteX152" fmla="*/ 5884068 w 12191999"/>
              <a:gd name="connsiteY152" fmla="*/ 883578 h 6105653"/>
              <a:gd name="connsiteX153" fmla="*/ 6066234 w 12191999"/>
              <a:gd name="connsiteY153" fmla="*/ 645166 h 6105653"/>
              <a:gd name="connsiteX154" fmla="*/ 6109096 w 12191999"/>
              <a:gd name="connsiteY154" fmla="*/ 732391 h 6105653"/>
              <a:gd name="connsiteX155" fmla="*/ 5998368 w 12191999"/>
              <a:gd name="connsiteY155" fmla="*/ 985338 h 6105653"/>
              <a:gd name="connsiteX156" fmla="*/ 5969793 w 12191999"/>
              <a:gd name="connsiteY156" fmla="*/ 1168509 h 6105653"/>
              <a:gd name="connsiteX157" fmla="*/ 6162674 w 12191999"/>
              <a:gd name="connsiteY157" fmla="*/ 909745 h 6105653"/>
              <a:gd name="connsiteX158" fmla="*/ 6412705 w 12191999"/>
              <a:gd name="connsiteY158" fmla="*/ 659704 h 6105653"/>
              <a:gd name="connsiteX159" fmla="*/ 6366271 w 12191999"/>
              <a:gd name="connsiteY159" fmla="*/ 851596 h 6105653"/>
              <a:gd name="connsiteX160" fmla="*/ 6398418 w 12191999"/>
              <a:gd name="connsiteY160" fmla="*/ 860319 h 6105653"/>
              <a:gd name="connsiteX161" fmla="*/ 6694884 w 12191999"/>
              <a:gd name="connsiteY161" fmla="*/ 691686 h 6105653"/>
              <a:gd name="connsiteX162" fmla="*/ 6816327 w 12191999"/>
              <a:gd name="connsiteY162" fmla="*/ 610277 h 6105653"/>
              <a:gd name="connsiteX163" fmla="*/ 7177087 w 12191999"/>
              <a:gd name="connsiteY163" fmla="*/ 238123 h 6105653"/>
              <a:gd name="connsiteX164" fmla="*/ 7016353 w 12191999"/>
              <a:gd name="connsiteY164" fmla="*/ 592833 h 6105653"/>
              <a:gd name="connsiteX165" fmla="*/ 7366396 w 12191999"/>
              <a:gd name="connsiteY165" fmla="*/ 226493 h 6105653"/>
              <a:gd name="connsiteX166" fmla="*/ 7494984 w 12191999"/>
              <a:gd name="connsiteY166" fmla="*/ 49138 h 6105653"/>
              <a:gd name="connsiteX167" fmla="*/ 7538181 w 12191999"/>
              <a:gd name="connsiteY167" fmla="*/ 484 h 610565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Lst>
            <a:rect l="l" t="t" r="r" b="b"/>
            <a:pathLst>
              <a:path w="12191999" h="6105653">
                <a:moveTo>
                  <a:pt x="7538181" y="484"/>
                </a:moveTo>
                <a:cubicBezTo>
                  <a:pt x="7546999" y="-833"/>
                  <a:pt x="7557492" y="439"/>
                  <a:pt x="7569993" y="5527"/>
                </a:cubicBezTo>
                <a:cubicBezTo>
                  <a:pt x="7612855" y="22971"/>
                  <a:pt x="7598567" y="54953"/>
                  <a:pt x="7587853" y="84028"/>
                </a:cubicBezTo>
                <a:cubicBezTo>
                  <a:pt x="7559278" y="153806"/>
                  <a:pt x="7559278" y="229401"/>
                  <a:pt x="7559278" y="325347"/>
                </a:cubicBezTo>
                <a:cubicBezTo>
                  <a:pt x="7695009" y="243938"/>
                  <a:pt x="7652146" y="95658"/>
                  <a:pt x="7795021" y="25878"/>
                </a:cubicBezTo>
                <a:cubicBezTo>
                  <a:pt x="7820024" y="113102"/>
                  <a:pt x="7770018" y="179974"/>
                  <a:pt x="7759302" y="249752"/>
                </a:cubicBezTo>
                <a:cubicBezTo>
                  <a:pt x="7748587" y="313717"/>
                  <a:pt x="7773590" y="328254"/>
                  <a:pt x="7852171" y="313717"/>
                </a:cubicBezTo>
                <a:cubicBezTo>
                  <a:pt x="7973615" y="290457"/>
                  <a:pt x="8034337" y="325347"/>
                  <a:pt x="8002190" y="418385"/>
                </a:cubicBezTo>
                <a:cubicBezTo>
                  <a:pt x="7970043" y="505609"/>
                  <a:pt x="8016478" y="514331"/>
                  <a:pt x="8084343" y="491072"/>
                </a:cubicBezTo>
                <a:cubicBezTo>
                  <a:pt x="8184355" y="456182"/>
                  <a:pt x="8262937" y="493979"/>
                  <a:pt x="8348662" y="520146"/>
                </a:cubicBezTo>
                <a:cubicBezTo>
                  <a:pt x="8477249" y="560851"/>
                  <a:pt x="8541543" y="543406"/>
                  <a:pt x="8637984" y="459090"/>
                </a:cubicBezTo>
                <a:cubicBezTo>
                  <a:pt x="8691561" y="409663"/>
                  <a:pt x="8737996" y="360236"/>
                  <a:pt x="8784431" y="290457"/>
                </a:cubicBezTo>
                <a:cubicBezTo>
                  <a:pt x="8809434" y="450367"/>
                  <a:pt x="8895158" y="284642"/>
                  <a:pt x="8948737" y="339884"/>
                </a:cubicBezTo>
                <a:cubicBezTo>
                  <a:pt x="8970168" y="453274"/>
                  <a:pt x="8798717" y="543406"/>
                  <a:pt x="8848725" y="697501"/>
                </a:cubicBezTo>
                <a:cubicBezTo>
                  <a:pt x="8995171" y="511424"/>
                  <a:pt x="9041606" y="302087"/>
                  <a:pt x="9238059" y="165437"/>
                </a:cubicBezTo>
                <a:cubicBezTo>
                  <a:pt x="9280921" y="197419"/>
                  <a:pt x="9238059" y="229401"/>
                  <a:pt x="9255919" y="255567"/>
                </a:cubicBezTo>
                <a:cubicBezTo>
                  <a:pt x="9266634" y="255567"/>
                  <a:pt x="9198767" y="560851"/>
                  <a:pt x="9477374" y="578295"/>
                </a:cubicBezTo>
                <a:cubicBezTo>
                  <a:pt x="9477374" y="584110"/>
                  <a:pt x="9477374" y="589925"/>
                  <a:pt x="9488091" y="595740"/>
                </a:cubicBezTo>
                <a:cubicBezTo>
                  <a:pt x="9527380" y="627722"/>
                  <a:pt x="9620249" y="598648"/>
                  <a:pt x="9627393" y="650981"/>
                </a:cubicBezTo>
                <a:cubicBezTo>
                  <a:pt x="9634537" y="709131"/>
                  <a:pt x="9666684" y="764373"/>
                  <a:pt x="9648824" y="825429"/>
                </a:cubicBezTo>
                <a:cubicBezTo>
                  <a:pt x="9634537" y="871948"/>
                  <a:pt x="9616678" y="921374"/>
                  <a:pt x="9616678" y="970802"/>
                </a:cubicBezTo>
                <a:cubicBezTo>
                  <a:pt x="9616678" y="1023136"/>
                  <a:pt x="9495233" y="1095822"/>
                  <a:pt x="9655968" y="1127805"/>
                </a:cubicBezTo>
                <a:cubicBezTo>
                  <a:pt x="9663111" y="1127805"/>
                  <a:pt x="9645252" y="1217935"/>
                  <a:pt x="9638109" y="1267362"/>
                </a:cubicBezTo>
                <a:cubicBezTo>
                  <a:pt x="9630965" y="1308066"/>
                  <a:pt x="9598818" y="1357494"/>
                  <a:pt x="9663111" y="1386568"/>
                </a:cubicBezTo>
                <a:cubicBezTo>
                  <a:pt x="9702403" y="1401105"/>
                  <a:pt x="9773840" y="1331326"/>
                  <a:pt x="9780984" y="1270269"/>
                </a:cubicBezTo>
                <a:cubicBezTo>
                  <a:pt x="9788127" y="1215028"/>
                  <a:pt x="9795271" y="1159787"/>
                  <a:pt x="9780984" y="1107452"/>
                </a:cubicBezTo>
                <a:cubicBezTo>
                  <a:pt x="9763125" y="1043488"/>
                  <a:pt x="9791699" y="1008598"/>
                  <a:pt x="9855993" y="991154"/>
                </a:cubicBezTo>
                <a:cubicBezTo>
                  <a:pt x="9923858" y="970802"/>
                  <a:pt x="9959577" y="933005"/>
                  <a:pt x="9991724" y="880670"/>
                </a:cubicBezTo>
                <a:cubicBezTo>
                  <a:pt x="10070305" y="752742"/>
                  <a:pt x="10163174" y="630630"/>
                  <a:pt x="10209609" y="491071"/>
                </a:cubicBezTo>
                <a:cubicBezTo>
                  <a:pt x="10216753" y="464905"/>
                  <a:pt x="10231040" y="432923"/>
                  <a:pt x="10291762" y="421292"/>
                </a:cubicBezTo>
                <a:cubicBezTo>
                  <a:pt x="10198893" y="799262"/>
                  <a:pt x="9959577" y="1142341"/>
                  <a:pt x="9973865" y="1531941"/>
                </a:cubicBezTo>
                <a:cubicBezTo>
                  <a:pt x="10048874" y="1427272"/>
                  <a:pt x="10052446" y="1302252"/>
                  <a:pt x="10106024" y="1188861"/>
                </a:cubicBezTo>
                <a:cubicBezTo>
                  <a:pt x="10145315" y="1270269"/>
                  <a:pt x="10102453" y="1345863"/>
                  <a:pt x="10081022" y="1421458"/>
                </a:cubicBezTo>
                <a:cubicBezTo>
                  <a:pt x="10063162" y="1485421"/>
                  <a:pt x="10059590" y="1543570"/>
                  <a:pt x="10170318" y="1549385"/>
                </a:cubicBezTo>
                <a:cubicBezTo>
                  <a:pt x="10181034" y="1549385"/>
                  <a:pt x="10188178" y="1549385"/>
                  <a:pt x="10198893" y="1549385"/>
                </a:cubicBezTo>
                <a:cubicBezTo>
                  <a:pt x="10245327" y="1526126"/>
                  <a:pt x="10266759" y="1494144"/>
                  <a:pt x="10281046" y="1453439"/>
                </a:cubicBezTo>
                <a:cubicBezTo>
                  <a:pt x="10288190" y="1430180"/>
                  <a:pt x="10302477" y="1398198"/>
                  <a:pt x="10334625" y="1398198"/>
                </a:cubicBezTo>
                <a:cubicBezTo>
                  <a:pt x="10456068" y="1401105"/>
                  <a:pt x="10491787" y="1322604"/>
                  <a:pt x="10527506" y="1247010"/>
                </a:cubicBezTo>
                <a:cubicBezTo>
                  <a:pt x="10588228" y="1287714"/>
                  <a:pt x="10545365" y="1322604"/>
                  <a:pt x="10548937" y="1354586"/>
                </a:cubicBezTo>
                <a:cubicBezTo>
                  <a:pt x="10552509" y="1374938"/>
                  <a:pt x="10556080" y="1395290"/>
                  <a:pt x="10588228" y="1395290"/>
                </a:cubicBezTo>
                <a:cubicBezTo>
                  <a:pt x="10613230" y="1395290"/>
                  <a:pt x="10645378" y="1386568"/>
                  <a:pt x="10645378" y="1366216"/>
                </a:cubicBezTo>
                <a:cubicBezTo>
                  <a:pt x="10648949" y="1238288"/>
                  <a:pt x="10820400" y="1165601"/>
                  <a:pt x="10820400" y="1031858"/>
                </a:cubicBezTo>
                <a:cubicBezTo>
                  <a:pt x="10820400" y="950449"/>
                  <a:pt x="10916840" y="1072563"/>
                  <a:pt x="10956131" y="1005691"/>
                </a:cubicBezTo>
                <a:cubicBezTo>
                  <a:pt x="10966847" y="991154"/>
                  <a:pt x="10981133" y="1046395"/>
                  <a:pt x="10977562" y="1069655"/>
                </a:cubicBezTo>
                <a:cubicBezTo>
                  <a:pt x="10973991" y="1092915"/>
                  <a:pt x="10948987" y="1113267"/>
                  <a:pt x="10966847" y="1142341"/>
                </a:cubicBezTo>
                <a:cubicBezTo>
                  <a:pt x="11031140" y="1156879"/>
                  <a:pt x="11056143" y="1119081"/>
                  <a:pt x="11074003" y="1084192"/>
                </a:cubicBezTo>
                <a:cubicBezTo>
                  <a:pt x="11116865" y="1008598"/>
                  <a:pt x="11166871" y="933005"/>
                  <a:pt x="11181159" y="848688"/>
                </a:cubicBezTo>
                <a:cubicBezTo>
                  <a:pt x="11184730" y="819614"/>
                  <a:pt x="11202590" y="802169"/>
                  <a:pt x="11238309" y="805077"/>
                </a:cubicBezTo>
                <a:cubicBezTo>
                  <a:pt x="11284744" y="810891"/>
                  <a:pt x="11270456" y="839966"/>
                  <a:pt x="11266884" y="863226"/>
                </a:cubicBezTo>
                <a:cubicBezTo>
                  <a:pt x="11263312" y="877763"/>
                  <a:pt x="11252596" y="892300"/>
                  <a:pt x="11277600" y="906838"/>
                </a:cubicBezTo>
                <a:cubicBezTo>
                  <a:pt x="11531203" y="566666"/>
                  <a:pt x="11516915" y="386403"/>
                  <a:pt x="11724084" y="5527"/>
                </a:cubicBezTo>
                <a:cubicBezTo>
                  <a:pt x="11763375" y="89842"/>
                  <a:pt x="11734800" y="150899"/>
                  <a:pt x="11727656" y="209048"/>
                </a:cubicBezTo>
                <a:cubicBezTo>
                  <a:pt x="11709796" y="354421"/>
                  <a:pt x="11677649" y="264290"/>
                  <a:pt x="11656218" y="409663"/>
                </a:cubicBezTo>
                <a:cubicBezTo>
                  <a:pt x="11645503" y="479442"/>
                  <a:pt x="11609784" y="543406"/>
                  <a:pt x="11666934" y="621907"/>
                </a:cubicBezTo>
                <a:cubicBezTo>
                  <a:pt x="11706225" y="674241"/>
                  <a:pt x="11663362" y="758557"/>
                  <a:pt x="11631215" y="822521"/>
                </a:cubicBezTo>
                <a:cubicBezTo>
                  <a:pt x="11602640" y="874856"/>
                  <a:pt x="11595497" y="927190"/>
                  <a:pt x="11631215" y="996969"/>
                </a:cubicBezTo>
                <a:cubicBezTo>
                  <a:pt x="11652646" y="933005"/>
                  <a:pt x="11670505" y="883578"/>
                  <a:pt x="11684793" y="834151"/>
                </a:cubicBezTo>
                <a:cubicBezTo>
                  <a:pt x="11695509" y="793447"/>
                  <a:pt x="11720512" y="770187"/>
                  <a:pt x="11774090" y="773095"/>
                </a:cubicBezTo>
                <a:cubicBezTo>
                  <a:pt x="11802665" y="773095"/>
                  <a:pt x="11841956" y="764373"/>
                  <a:pt x="11856243" y="793447"/>
                </a:cubicBezTo>
                <a:cubicBezTo>
                  <a:pt x="11870531" y="816706"/>
                  <a:pt x="11856243" y="848688"/>
                  <a:pt x="11831240" y="860319"/>
                </a:cubicBezTo>
                <a:cubicBezTo>
                  <a:pt x="11784806" y="874856"/>
                  <a:pt x="11741944" y="889393"/>
                  <a:pt x="11738371" y="938820"/>
                </a:cubicBezTo>
                <a:cubicBezTo>
                  <a:pt x="11731228" y="1005691"/>
                  <a:pt x="11759802" y="967894"/>
                  <a:pt x="11795521" y="956264"/>
                </a:cubicBezTo>
                <a:cubicBezTo>
                  <a:pt x="11834812" y="944634"/>
                  <a:pt x="11845527" y="979524"/>
                  <a:pt x="11838384" y="1002784"/>
                </a:cubicBezTo>
                <a:cubicBezTo>
                  <a:pt x="11806237" y="1090007"/>
                  <a:pt x="11863387" y="1180138"/>
                  <a:pt x="11816952" y="1270269"/>
                </a:cubicBezTo>
                <a:cubicBezTo>
                  <a:pt x="11931252" y="1247010"/>
                  <a:pt x="11981259" y="1197583"/>
                  <a:pt x="11999118" y="1092915"/>
                </a:cubicBezTo>
                <a:cubicBezTo>
                  <a:pt x="12002690" y="1055118"/>
                  <a:pt x="11995547" y="1014413"/>
                  <a:pt x="12027693" y="979524"/>
                </a:cubicBezTo>
                <a:cubicBezTo>
                  <a:pt x="12045553" y="959172"/>
                  <a:pt x="12066984" y="938820"/>
                  <a:pt x="12102703" y="953357"/>
                </a:cubicBezTo>
                <a:cubicBezTo>
                  <a:pt x="12127705" y="962080"/>
                  <a:pt x="12127705" y="985338"/>
                  <a:pt x="12120562" y="1005691"/>
                </a:cubicBezTo>
                <a:cubicBezTo>
                  <a:pt x="12081272" y="1090007"/>
                  <a:pt x="12070555" y="1180138"/>
                  <a:pt x="12056268" y="1267362"/>
                </a:cubicBezTo>
                <a:cubicBezTo>
                  <a:pt x="12052697" y="1281899"/>
                  <a:pt x="12045553" y="1296437"/>
                  <a:pt x="12081272" y="1310974"/>
                </a:cubicBezTo>
                <a:cubicBezTo>
                  <a:pt x="12113418" y="1209213"/>
                  <a:pt x="12156280" y="1110359"/>
                  <a:pt x="12191999" y="1008598"/>
                </a:cubicBezTo>
                <a:lnTo>
                  <a:pt x="12191999" y="6105653"/>
                </a:lnTo>
                <a:lnTo>
                  <a:pt x="0" y="6105653"/>
                </a:lnTo>
                <a:lnTo>
                  <a:pt x="0" y="927116"/>
                </a:lnTo>
                <a:lnTo>
                  <a:pt x="61930" y="902578"/>
                </a:lnTo>
                <a:cubicBezTo>
                  <a:pt x="91454" y="894128"/>
                  <a:pt x="122931" y="887949"/>
                  <a:pt x="155971" y="883588"/>
                </a:cubicBezTo>
                <a:cubicBezTo>
                  <a:pt x="223837" y="877773"/>
                  <a:pt x="245268" y="839976"/>
                  <a:pt x="277414" y="802179"/>
                </a:cubicBezTo>
                <a:cubicBezTo>
                  <a:pt x="388143" y="674251"/>
                  <a:pt x="488155" y="537601"/>
                  <a:pt x="638174" y="430025"/>
                </a:cubicBezTo>
                <a:cubicBezTo>
                  <a:pt x="620315" y="555046"/>
                  <a:pt x="520302" y="653899"/>
                  <a:pt x="477440" y="784735"/>
                </a:cubicBezTo>
                <a:cubicBezTo>
                  <a:pt x="641746" y="680066"/>
                  <a:pt x="727471" y="543415"/>
                  <a:pt x="827483" y="418395"/>
                </a:cubicBezTo>
                <a:cubicBezTo>
                  <a:pt x="873917" y="360246"/>
                  <a:pt x="931068" y="307912"/>
                  <a:pt x="956071" y="241040"/>
                </a:cubicBezTo>
                <a:cubicBezTo>
                  <a:pt x="961429" y="223595"/>
                  <a:pt x="972814" y="196338"/>
                  <a:pt x="999268" y="192386"/>
                </a:cubicBezTo>
                <a:cubicBezTo>
                  <a:pt x="1008086" y="191069"/>
                  <a:pt x="1018579" y="192341"/>
                  <a:pt x="1031080" y="197429"/>
                </a:cubicBezTo>
                <a:cubicBezTo>
                  <a:pt x="1073942" y="214873"/>
                  <a:pt x="1059654" y="246855"/>
                  <a:pt x="1048940" y="275930"/>
                </a:cubicBezTo>
                <a:cubicBezTo>
                  <a:pt x="1020365" y="345708"/>
                  <a:pt x="1020365" y="421303"/>
                  <a:pt x="1020365" y="517249"/>
                </a:cubicBezTo>
                <a:cubicBezTo>
                  <a:pt x="1156096" y="435840"/>
                  <a:pt x="1113233" y="287560"/>
                  <a:pt x="1256108" y="217780"/>
                </a:cubicBezTo>
                <a:cubicBezTo>
                  <a:pt x="1281111" y="305004"/>
                  <a:pt x="1231105" y="371876"/>
                  <a:pt x="1220389" y="441654"/>
                </a:cubicBezTo>
                <a:cubicBezTo>
                  <a:pt x="1209674" y="505619"/>
                  <a:pt x="1234677" y="520156"/>
                  <a:pt x="1313258" y="505619"/>
                </a:cubicBezTo>
                <a:cubicBezTo>
                  <a:pt x="1434702" y="482359"/>
                  <a:pt x="1495424" y="517249"/>
                  <a:pt x="1463277" y="610287"/>
                </a:cubicBezTo>
                <a:cubicBezTo>
                  <a:pt x="1431130" y="697511"/>
                  <a:pt x="1477565" y="706233"/>
                  <a:pt x="1545430" y="682974"/>
                </a:cubicBezTo>
                <a:cubicBezTo>
                  <a:pt x="1645442" y="648084"/>
                  <a:pt x="1724024" y="685881"/>
                  <a:pt x="1809749" y="712048"/>
                </a:cubicBezTo>
                <a:cubicBezTo>
                  <a:pt x="1938336" y="752753"/>
                  <a:pt x="2002630" y="735308"/>
                  <a:pt x="2099071" y="650992"/>
                </a:cubicBezTo>
                <a:cubicBezTo>
                  <a:pt x="2152648" y="601565"/>
                  <a:pt x="2199083" y="552138"/>
                  <a:pt x="2245518" y="482359"/>
                </a:cubicBezTo>
                <a:cubicBezTo>
                  <a:pt x="2270521" y="642269"/>
                  <a:pt x="2356245" y="476544"/>
                  <a:pt x="2409824" y="531786"/>
                </a:cubicBezTo>
                <a:cubicBezTo>
                  <a:pt x="2431255" y="645176"/>
                  <a:pt x="2259804" y="735308"/>
                  <a:pt x="2309812" y="889403"/>
                </a:cubicBezTo>
                <a:cubicBezTo>
                  <a:pt x="2456258" y="703326"/>
                  <a:pt x="2502693" y="493989"/>
                  <a:pt x="2699146" y="357339"/>
                </a:cubicBezTo>
                <a:cubicBezTo>
                  <a:pt x="2742008" y="389321"/>
                  <a:pt x="2699146" y="421303"/>
                  <a:pt x="2717006" y="447469"/>
                </a:cubicBezTo>
                <a:cubicBezTo>
                  <a:pt x="2727721" y="447469"/>
                  <a:pt x="2659854" y="752753"/>
                  <a:pt x="2938461" y="770197"/>
                </a:cubicBezTo>
                <a:cubicBezTo>
                  <a:pt x="2938461" y="776012"/>
                  <a:pt x="2938461" y="781827"/>
                  <a:pt x="2949178" y="787642"/>
                </a:cubicBezTo>
                <a:cubicBezTo>
                  <a:pt x="2988467" y="819624"/>
                  <a:pt x="3081336" y="790550"/>
                  <a:pt x="3088480" y="842883"/>
                </a:cubicBezTo>
                <a:cubicBezTo>
                  <a:pt x="3095624" y="901033"/>
                  <a:pt x="3127771" y="956275"/>
                  <a:pt x="3109911" y="1017331"/>
                </a:cubicBezTo>
                <a:cubicBezTo>
                  <a:pt x="3095624" y="1063850"/>
                  <a:pt x="3077765" y="1113276"/>
                  <a:pt x="3077765" y="1162704"/>
                </a:cubicBezTo>
                <a:cubicBezTo>
                  <a:pt x="3077765" y="1215038"/>
                  <a:pt x="2956320" y="1287724"/>
                  <a:pt x="3117055" y="1319707"/>
                </a:cubicBezTo>
                <a:cubicBezTo>
                  <a:pt x="3124198" y="1319707"/>
                  <a:pt x="3106339" y="1409837"/>
                  <a:pt x="3099196" y="1459264"/>
                </a:cubicBezTo>
                <a:cubicBezTo>
                  <a:pt x="3092052" y="1499968"/>
                  <a:pt x="3059905" y="1549396"/>
                  <a:pt x="3124198" y="1578470"/>
                </a:cubicBezTo>
                <a:cubicBezTo>
                  <a:pt x="3163490" y="1593007"/>
                  <a:pt x="3234927" y="1523228"/>
                  <a:pt x="3242071" y="1462171"/>
                </a:cubicBezTo>
                <a:cubicBezTo>
                  <a:pt x="3249214" y="1406930"/>
                  <a:pt x="3256358" y="1351689"/>
                  <a:pt x="3242071" y="1299354"/>
                </a:cubicBezTo>
                <a:cubicBezTo>
                  <a:pt x="3224212" y="1235390"/>
                  <a:pt x="3252786" y="1200500"/>
                  <a:pt x="3317080" y="1183056"/>
                </a:cubicBezTo>
                <a:cubicBezTo>
                  <a:pt x="3384945" y="1162704"/>
                  <a:pt x="3420664" y="1124907"/>
                  <a:pt x="3452811" y="1072572"/>
                </a:cubicBezTo>
                <a:cubicBezTo>
                  <a:pt x="3531392" y="944644"/>
                  <a:pt x="3624261" y="822532"/>
                  <a:pt x="3670696" y="682973"/>
                </a:cubicBezTo>
                <a:cubicBezTo>
                  <a:pt x="3677840" y="656807"/>
                  <a:pt x="3692127" y="624825"/>
                  <a:pt x="3752849" y="613194"/>
                </a:cubicBezTo>
                <a:cubicBezTo>
                  <a:pt x="3659980" y="991164"/>
                  <a:pt x="3420664" y="1334243"/>
                  <a:pt x="3434952" y="1723843"/>
                </a:cubicBezTo>
                <a:cubicBezTo>
                  <a:pt x="3509961" y="1619174"/>
                  <a:pt x="3513533" y="1494154"/>
                  <a:pt x="3567111" y="1380763"/>
                </a:cubicBezTo>
                <a:cubicBezTo>
                  <a:pt x="3606402" y="1462171"/>
                  <a:pt x="3563540" y="1537765"/>
                  <a:pt x="3542109" y="1613360"/>
                </a:cubicBezTo>
                <a:cubicBezTo>
                  <a:pt x="3524249" y="1677323"/>
                  <a:pt x="3520677" y="1735472"/>
                  <a:pt x="3631405" y="1741287"/>
                </a:cubicBezTo>
                <a:cubicBezTo>
                  <a:pt x="3642121" y="1741287"/>
                  <a:pt x="3649265" y="1741287"/>
                  <a:pt x="3659980" y="1741287"/>
                </a:cubicBezTo>
                <a:cubicBezTo>
                  <a:pt x="3706414" y="1718028"/>
                  <a:pt x="3727846" y="1686046"/>
                  <a:pt x="3742133" y="1645341"/>
                </a:cubicBezTo>
                <a:cubicBezTo>
                  <a:pt x="3749277" y="1622082"/>
                  <a:pt x="3763564" y="1590100"/>
                  <a:pt x="3795712" y="1590100"/>
                </a:cubicBezTo>
                <a:cubicBezTo>
                  <a:pt x="3917155" y="1593007"/>
                  <a:pt x="3952874" y="1514506"/>
                  <a:pt x="3988593" y="1438912"/>
                </a:cubicBezTo>
                <a:cubicBezTo>
                  <a:pt x="4049315" y="1479616"/>
                  <a:pt x="4006452" y="1514506"/>
                  <a:pt x="4010024" y="1546488"/>
                </a:cubicBezTo>
                <a:cubicBezTo>
                  <a:pt x="4013596" y="1566840"/>
                  <a:pt x="4017167" y="1587192"/>
                  <a:pt x="4049315" y="1587192"/>
                </a:cubicBezTo>
                <a:cubicBezTo>
                  <a:pt x="4074317" y="1587192"/>
                  <a:pt x="4106465" y="1578470"/>
                  <a:pt x="4106465" y="1558118"/>
                </a:cubicBezTo>
                <a:cubicBezTo>
                  <a:pt x="4110036" y="1430190"/>
                  <a:pt x="4281487" y="1357503"/>
                  <a:pt x="4281487" y="1223760"/>
                </a:cubicBezTo>
                <a:cubicBezTo>
                  <a:pt x="4281487" y="1142351"/>
                  <a:pt x="4377927" y="1264465"/>
                  <a:pt x="4417219" y="1197593"/>
                </a:cubicBezTo>
                <a:cubicBezTo>
                  <a:pt x="4427935" y="1183056"/>
                  <a:pt x="4442220" y="1238297"/>
                  <a:pt x="4438649" y="1261557"/>
                </a:cubicBezTo>
                <a:cubicBezTo>
                  <a:pt x="4435078" y="1284817"/>
                  <a:pt x="4410074" y="1305169"/>
                  <a:pt x="4427935" y="1334243"/>
                </a:cubicBezTo>
                <a:cubicBezTo>
                  <a:pt x="4492228" y="1348781"/>
                  <a:pt x="4517230" y="1310983"/>
                  <a:pt x="4535090" y="1276094"/>
                </a:cubicBezTo>
                <a:cubicBezTo>
                  <a:pt x="4577952" y="1200500"/>
                  <a:pt x="4627958" y="1124907"/>
                  <a:pt x="4642246" y="1040590"/>
                </a:cubicBezTo>
                <a:cubicBezTo>
                  <a:pt x="4645817" y="1011516"/>
                  <a:pt x="4663677" y="994071"/>
                  <a:pt x="4699396" y="996979"/>
                </a:cubicBezTo>
                <a:cubicBezTo>
                  <a:pt x="4745832" y="1002793"/>
                  <a:pt x="4731544" y="1031868"/>
                  <a:pt x="4727971" y="1055128"/>
                </a:cubicBezTo>
                <a:cubicBezTo>
                  <a:pt x="4724399" y="1069665"/>
                  <a:pt x="4713683" y="1084202"/>
                  <a:pt x="4738688" y="1098740"/>
                </a:cubicBezTo>
                <a:cubicBezTo>
                  <a:pt x="4992291" y="758568"/>
                  <a:pt x="4978002" y="578305"/>
                  <a:pt x="5185172" y="197429"/>
                </a:cubicBezTo>
                <a:cubicBezTo>
                  <a:pt x="5224462" y="281744"/>
                  <a:pt x="5195887" y="342801"/>
                  <a:pt x="5188744" y="400950"/>
                </a:cubicBezTo>
                <a:cubicBezTo>
                  <a:pt x="5170883" y="546323"/>
                  <a:pt x="5138736" y="456192"/>
                  <a:pt x="5117306" y="601565"/>
                </a:cubicBezTo>
                <a:cubicBezTo>
                  <a:pt x="5106590" y="671344"/>
                  <a:pt x="5070871" y="735308"/>
                  <a:pt x="5128021" y="813809"/>
                </a:cubicBezTo>
                <a:cubicBezTo>
                  <a:pt x="5167312" y="866143"/>
                  <a:pt x="5124450" y="950459"/>
                  <a:pt x="5092302" y="1014423"/>
                </a:cubicBezTo>
                <a:cubicBezTo>
                  <a:pt x="5063727" y="1066758"/>
                  <a:pt x="5056585" y="1119092"/>
                  <a:pt x="5092302" y="1188871"/>
                </a:cubicBezTo>
                <a:cubicBezTo>
                  <a:pt x="5113734" y="1124907"/>
                  <a:pt x="5131592" y="1075480"/>
                  <a:pt x="5145880" y="1026053"/>
                </a:cubicBezTo>
                <a:cubicBezTo>
                  <a:pt x="5156596" y="985349"/>
                  <a:pt x="5181600" y="962089"/>
                  <a:pt x="5235177" y="964997"/>
                </a:cubicBezTo>
                <a:cubicBezTo>
                  <a:pt x="5263752" y="964997"/>
                  <a:pt x="5303044" y="956275"/>
                  <a:pt x="5317331" y="985349"/>
                </a:cubicBezTo>
                <a:cubicBezTo>
                  <a:pt x="5331618" y="1008608"/>
                  <a:pt x="5317331" y="1040590"/>
                  <a:pt x="5292327" y="1052221"/>
                </a:cubicBezTo>
                <a:cubicBezTo>
                  <a:pt x="5245894" y="1066758"/>
                  <a:pt x="5203031" y="1081295"/>
                  <a:pt x="5199458" y="1130722"/>
                </a:cubicBezTo>
                <a:cubicBezTo>
                  <a:pt x="5192315" y="1197593"/>
                  <a:pt x="5220889" y="1159796"/>
                  <a:pt x="5256608" y="1148166"/>
                </a:cubicBezTo>
                <a:cubicBezTo>
                  <a:pt x="5295899" y="1136536"/>
                  <a:pt x="5306616" y="1171426"/>
                  <a:pt x="5299471" y="1194686"/>
                </a:cubicBezTo>
                <a:cubicBezTo>
                  <a:pt x="5267324" y="1281909"/>
                  <a:pt x="5324474" y="1372040"/>
                  <a:pt x="5278039" y="1462171"/>
                </a:cubicBezTo>
                <a:cubicBezTo>
                  <a:pt x="5392339" y="1438912"/>
                  <a:pt x="5442347" y="1389485"/>
                  <a:pt x="5460205" y="1284817"/>
                </a:cubicBezTo>
                <a:cubicBezTo>
                  <a:pt x="5463777" y="1247020"/>
                  <a:pt x="5456634" y="1206315"/>
                  <a:pt x="5488780" y="1171426"/>
                </a:cubicBezTo>
                <a:cubicBezTo>
                  <a:pt x="5502175" y="1156162"/>
                  <a:pt x="5517579" y="1140898"/>
                  <a:pt x="5539513" y="1140353"/>
                </a:cubicBezTo>
                <a:lnTo>
                  <a:pt x="5552720" y="1143022"/>
                </a:lnTo>
                <a:lnTo>
                  <a:pt x="5574208" y="1115811"/>
                </a:lnTo>
                <a:cubicBezTo>
                  <a:pt x="5609034" y="1085646"/>
                  <a:pt x="5659040" y="1068202"/>
                  <a:pt x="5734050" y="1075470"/>
                </a:cubicBezTo>
                <a:cubicBezTo>
                  <a:pt x="5776912" y="1078377"/>
                  <a:pt x="5809058" y="1055118"/>
                  <a:pt x="5798343" y="1020228"/>
                </a:cubicBezTo>
                <a:cubicBezTo>
                  <a:pt x="5776912" y="953357"/>
                  <a:pt x="5837634" y="921375"/>
                  <a:pt x="5884068" y="883578"/>
                </a:cubicBezTo>
                <a:cubicBezTo>
                  <a:pt x="5966221" y="816706"/>
                  <a:pt x="6051947" y="752742"/>
                  <a:pt x="6066234" y="645166"/>
                </a:cubicBezTo>
                <a:cubicBezTo>
                  <a:pt x="6130528" y="665519"/>
                  <a:pt x="6123384" y="700408"/>
                  <a:pt x="6109096" y="732391"/>
                </a:cubicBezTo>
                <a:cubicBezTo>
                  <a:pt x="6073377" y="816706"/>
                  <a:pt x="6034087" y="901023"/>
                  <a:pt x="5998368" y="985338"/>
                </a:cubicBezTo>
                <a:cubicBezTo>
                  <a:pt x="5976937" y="1040581"/>
                  <a:pt x="5944790" y="1095822"/>
                  <a:pt x="5969793" y="1168509"/>
                </a:cubicBezTo>
                <a:cubicBezTo>
                  <a:pt x="6098380" y="1104545"/>
                  <a:pt x="6123384" y="996969"/>
                  <a:pt x="6162674" y="909745"/>
                </a:cubicBezTo>
                <a:cubicBezTo>
                  <a:pt x="6212681" y="802169"/>
                  <a:pt x="6305549" y="738205"/>
                  <a:pt x="6412705" y="659704"/>
                </a:cubicBezTo>
                <a:cubicBezTo>
                  <a:pt x="6441280" y="738205"/>
                  <a:pt x="6362699" y="787632"/>
                  <a:pt x="6366271" y="851596"/>
                </a:cubicBezTo>
                <a:cubicBezTo>
                  <a:pt x="6376987" y="854503"/>
                  <a:pt x="6398418" y="860319"/>
                  <a:pt x="6398418" y="860319"/>
                </a:cubicBezTo>
                <a:cubicBezTo>
                  <a:pt x="6455568" y="755650"/>
                  <a:pt x="6562724" y="709131"/>
                  <a:pt x="6694884" y="691686"/>
                </a:cubicBezTo>
                <a:cubicBezTo>
                  <a:pt x="6762750" y="685871"/>
                  <a:pt x="6784181" y="648074"/>
                  <a:pt x="6816327" y="610277"/>
                </a:cubicBezTo>
                <a:cubicBezTo>
                  <a:pt x="6927056" y="482349"/>
                  <a:pt x="7027068" y="345699"/>
                  <a:pt x="7177087" y="238123"/>
                </a:cubicBezTo>
                <a:cubicBezTo>
                  <a:pt x="7159228" y="363144"/>
                  <a:pt x="7059215" y="461997"/>
                  <a:pt x="7016353" y="592833"/>
                </a:cubicBezTo>
                <a:cubicBezTo>
                  <a:pt x="7180659" y="488164"/>
                  <a:pt x="7266384" y="351513"/>
                  <a:pt x="7366396" y="226493"/>
                </a:cubicBezTo>
                <a:cubicBezTo>
                  <a:pt x="7412830" y="168344"/>
                  <a:pt x="7469981" y="116010"/>
                  <a:pt x="7494984" y="49138"/>
                </a:cubicBezTo>
                <a:cubicBezTo>
                  <a:pt x="7500342" y="31693"/>
                  <a:pt x="7511727" y="4436"/>
                  <a:pt x="7538181" y="484"/>
                </a:cubicBezTo>
                <a:close/>
              </a:path>
            </a:pathLst>
          </a:custGeom>
          <a:solidFill>
            <a:schemeClr val="accent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A47DDCA0-F3B0-794B-82DA-60FA9BB95750}"/>
              </a:ext>
            </a:extLst>
          </p:cNvPr>
          <p:cNvSpPr>
            <a:spLocks noGrp="1"/>
          </p:cNvSpPr>
          <p:nvPr>
            <p:ph type="title"/>
          </p:nvPr>
        </p:nvSpPr>
        <p:spPr>
          <a:xfrm>
            <a:off x="838200" y="365125"/>
            <a:ext cx="10515600" cy="1325563"/>
          </a:xfrm>
        </p:spPr>
        <p:txBody>
          <a:bodyPr vert="horz" lIns="91440" tIns="45720" rIns="91440" bIns="45720" rtlCol="0" anchor="ctr">
            <a:normAutofit/>
          </a:bodyPr>
          <a:lstStyle/>
          <a:p>
            <a:r>
              <a:rPr lang="en-US" dirty="0"/>
              <a:t>Invitation</a:t>
            </a:r>
          </a:p>
        </p:txBody>
      </p:sp>
      <p:sp>
        <p:nvSpPr>
          <p:cNvPr id="6" name="TextBox 5">
            <a:extLst>
              <a:ext uri="{FF2B5EF4-FFF2-40B4-BE49-F238E27FC236}">
                <a16:creationId xmlns:a16="http://schemas.microsoft.com/office/drawing/2014/main" id="{25306D74-1E55-D244-B811-4BA996F00C76}"/>
              </a:ext>
            </a:extLst>
          </p:cNvPr>
          <p:cNvSpPr txBox="1"/>
          <p:nvPr/>
        </p:nvSpPr>
        <p:spPr>
          <a:xfrm>
            <a:off x="2781300" y="2247900"/>
            <a:ext cx="0" cy="0"/>
          </a:xfrm>
          <a:prstGeom prst="rect">
            <a:avLst/>
          </a:prstGeom>
          <a:noFill/>
        </p:spPr>
        <p:txBody>
          <a:bodyPr wrap="none" lIns="0" tIns="0" rIns="0" bIns="0"/>
          <a:lstStyle/>
          <a:p>
            <a:pPr eaLnBrk="1" fontAlgn="auto" hangingPunct="1">
              <a:lnSpc>
                <a:spcPct val="90000"/>
              </a:lnSpc>
              <a:spcBef>
                <a:spcPts val="600"/>
              </a:spcBef>
              <a:spcAft>
                <a:spcPts val="0"/>
              </a:spcAft>
              <a:defRPr/>
            </a:pPr>
            <a:endParaRPr lang="en-US" sz="1850" spc="-50" dirty="0">
              <a:latin typeface="+mn-lt"/>
            </a:endParaRPr>
          </a:p>
        </p:txBody>
      </p:sp>
      <p:graphicFrame>
        <p:nvGraphicFramePr>
          <p:cNvPr id="10" name="TextBox 7">
            <a:extLst>
              <a:ext uri="{FF2B5EF4-FFF2-40B4-BE49-F238E27FC236}">
                <a16:creationId xmlns:a16="http://schemas.microsoft.com/office/drawing/2014/main" id="{F42B8B4B-77EF-A6B3-A88E-95954D9AFCB8}"/>
              </a:ext>
            </a:extLst>
          </p:cNvPr>
          <p:cNvGraphicFramePr/>
          <p:nvPr>
            <p:extLst>
              <p:ext uri="{D42A27DB-BD31-4B8C-83A1-F6EECF244321}">
                <p14:modId xmlns:p14="http://schemas.microsoft.com/office/powerpoint/2010/main" val="3274495875"/>
              </p:ext>
            </p:extLst>
          </p:nvPr>
        </p:nvGraphicFramePr>
        <p:xfrm>
          <a:off x="838200" y="2011363"/>
          <a:ext cx="10515600" cy="416083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44003969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71E346-9DCF-0E4B-8A52-D9921F998A49}"/>
              </a:ext>
            </a:extLst>
          </p:cNvPr>
          <p:cNvSpPr>
            <a:spLocks noGrp="1"/>
          </p:cNvSpPr>
          <p:nvPr>
            <p:ph type="title"/>
          </p:nvPr>
        </p:nvSpPr>
        <p:spPr/>
        <p:txBody>
          <a:bodyPr/>
          <a:lstStyle/>
          <a:p>
            <a:r>
              <a:rPr lang="en-US" dirty="0"/>
              <a:t>Knowledge</a:t>
            </a:r>
          </a:p>
        </p:txBody>
      </p:sp>
      <p:sp>
        <p:nvSpPr>
          <p:cNvPr id="3" name="Content Placeholder 2">
            <a:extLst>
              <a:ext uri="{FF2B5EF4-FFF2-40B4-BE49-F238E27FC236}">
                <a16:creationId xmlns:a16="http://schemas.microsoft.com/office/drawing/2014/main" id="{CAEDB4C1-551F-7B47-9FD1-003A3791C4DA}"/>
              </a:ext>
            </a:extLst>
          </p:cNvPr>
          <p:cNvSpPr>
            <a:spLocks noGrp="1"/>
          </p:cNvSpPr>
          <p:nvPr>
            <p:ph idx="1"/>
          </p:nvPr>
        </p:nvSpPr>
        <p:spPr>
          <a:xfrm>
            <a:off x="838200" y="1425271"/>
            <a:ext cx="10515600" cy="4160520"/>
          </a:xfrm>
        </p:spPr>
        <p:txBody>
          <a:bodyPr/>
          <a:lstStyle/>
          <a:p>
            <a:r>
              <a:rPr lang="en-US" sz="3200" dirty="0"/>
              <a:t>WARNING SHOT: “I have some serious news to tell you…”</a:t>
            </a:r>
          </a:p>
          <a:p>
            <a:r>
              <a:rPr lang="en-US" sz="3200" dirty="0"/>
              <a:t>GIVE A HEADLINE – say it simply and then STOP</a:t>
            </a:r>
          </a:p>
          <a:p>
            <a:r>
              <a:rPr lang="en-US" sz="3200" dirty="0"/>
              <a:t>Avoid medical jargon</a:t>
            </a:r>
          </a:p>
        </p:txBody>
      </p:sp>
      <p:sp>
        <p:nvSpPr>
          <p:cNvPr id="13" name="Triangle 12">
            <a:extLst>
              <a:ext uri="{FF2B5EF4-FFF2-40B4-BE49-F238E27FC236}">
                <a16:creationId xmlns:a16="http://schemas.microsoft.com/office/drawing/2014/main" id="{0A07A707-60E0-2B46-8C9D-5D8AB7F6BBCF}"/>
              </a:ext>
            </a:extLst>
          </p:cNvPr>
          <p:cNvSpPr/>
          <p:nvPr/>
        </p:nvSpPr>
        <p:spPr>
          <a:xfrm>
            <a:off x="1555182" y="3798951"/>
            <a:ext cx="2864392" cy="2251074"/>
          </a:xfrm>
          <a:prstGeom prs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 name="Triangle 13">
            <a:extLst>
              <a:ext uri="{FF2B5EF4-FFF2-40B4-BE49-F238E27FC236}">
                <a16:creationId xmlns:a16="http://schemas.microsoft.com/office/drawing/2014/main" id="{D3EBB9B4-F615-C946-B1E4-E7665BBA6ED4}"/>
              </a:ext>
            </a:extLst>
          </p:cNvPr>
          <p:cNvSpPr/>
          <p:nvPr/>
        </p:nvSpPr>
        <p:spPr>
          <a:xfrm rot="10800000">
            <a:off x="6677921" y="3798951"/>
            <a:ext cx="2693872" cy="2251074"/>
          </a:xfrm>
          <a:prstGeom prs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5" name="&quot;No&quot; Symbol 14">
            <a:extLst>
              <a:ext uri="{FF2B5EF4-FFF2-40B4-BE49-F238E27FC236}">
                <a16:creationId xmlns:a16="http://schemas.microsoft.com/office/drawing/2014/main" id="{95D933CE-17EB-A64C-86F3-0718C924E7E6}"/>
              </a:ext>
            </a:extLst>
          </p:cNvPr>
          <p:cNvSpPr/>
          <p:nvPr/>
        </p:nvSpPr>
        <p:spPr>
          <a:xfrm>
            <a:off x="7060034" y="3906077"/>
            <a:ext cx="1704562" cy="1679714"/>
          </a:xfrm>
          <a:prstGeom prst="noSmoking">
            <a:avLst/>
          </a:prstGeom>
          <a:solidFill>
            <a:srgbClr val="FF0000"/>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Tree>
    <p:extLst>
      <p:ext uri="{BB962C8B-B14F-4D97-AF65-F5344CB8AC3E}">
        <p14:creationId xmlns:p14="http://schemas.microsoft.com/office/powerpoint/2010/main" val="163536814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0D82C0-07BF-A44C-AE8F-4F68DC2437D4}"/>
              </a:ext>
            </a:extLst>
          </p:cNvPr>
          <p:cNvSpPr>
            <a:spLocks noGrp="1"/>
          </p:cNvSpPr>
          <p:nvPr>
            <p:ph type="title"/>
          </p:nvPr>
        </p:nvSpPr>
        <p:spPr/>
        <p:txBody>
          <a:bodyPr/>
          <a:lstStyle/>
          <a:p>
            <a:r>
              <a:rPr lang="en-US" dirty="0"/>
              <a:t>What parents and patients value</a:t>
            </a:r>
          </a:p>
        </p:txBody>
      </p:sp>
      <p:sp>
        <p:nvSpPr>
          <p:cNvPr id="7" name="Rectangle 1">
            <a:extLst>
              <a:ext uri="{FF2B5EF4-FFF2-40B4-BE49-F238E27FC236}">
                <a16:creationId xmlns:a16="http://schemas.microsoft.com/office/drawing/2014/main" id="{52253A48-CBD3-F84B-A412-A5C85E2A1657}"/>
              </a:ext>
            </a:extLst>
          </p:cNvPr>
          <p:cNvSpPr>
            <a:spLocks noChangeArrowheads="1"/>
          </p:cNvSpPr>
          <p:nvPr/>
        </p:nvSpPr>
        <p:spPr bwMode="auto">
          <a:xfrm>
            <a:off x="1560368" y="5374474"/>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dirty="0"/>
          </a:p>
        </p:txBody>
      </p:sp>
      <p:sp>
        <p:nvSpPr>
          <p:cNvPr id="9" name="Oval 8">
            <a:extLst>
              <a:ext uri="{FF2B5EF4-FFF2-40B4-BE49-F238E27FC236}">
                <a16:creationId xmlns:a16="http://schemas.microsoft.com/office/drawing/2014/main" id="{6582E1E8-D9F3-1441-B88A-7D2BE18653C5}"/>
              </a:ext>
            </a:extLst>
          </p:cNvPr>
          <p:cNvSpPr/>
          <p:nvPr/>
        </p:nvSpPr>
        <p:spPr>
          <a:xfrm>
            <a:off x="1674744" y="2246243"/>
            <a:ext cx="2151822" cy="1967947"/>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Oval 9">
            <a:extLst>
              <a:ext uri="{FF2B5EF4-FFF2-40B4-BE49-F238E27FC236}">
                <a16:creationId xmlns:a16="http://schemas.microsoft.com/office/drawing/2014/main" id="{DDB1440F-028A-9548-874D-1FFC30FEFBE0}"/>
              </a:ext>
            </a:extLst>
          </p:cNvPr>
          <p:cNvSpPr/>
          <p:nvPr/>
        </p:nvSpPr>
        <p:spPr>
          <a:xfrm>
            <a:off x="6195392" y="2246244"/>
            <a:ext cx="2317106" cy="1967946"/>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Left Arrow 10">
            <a:extLst>
              <a:ext uri="{FF2B5EF4-FFF2-40B4-BE49-F238E27FC236}">
                <a16:creationId xmlns:a16="http://schemas.microsoft.com/office/drawing/2014/main" id="{43E03466-A47C-D544-9793-72AC7DA7A7F7}"/>
              </a:ext>
            </a:extLst>
          </p:cNvPr>
          <p:cNvSpPr/>
          <p:nvPr/>
        </p:nvSpPr>
        <p:spPr>
          <a:xfrm>
            <a:off x="4521775" y="2534878"/>
            <a:ext cx="978408" cy="484632"/>
          </a:xfrm>
          <a:prstGeom prst="lef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2" name="Right Arrow 11">
            <a:extLst>
              <a:ext uri="{FF2B5EF4-FFF2-40B4-BE49-F238E27FC236}">
                <a16:creationId xmlns:a16="http://schemas.microsoft.com/office/drawing/2014/main" id="{F074F1BA-A8C0-4645-8193-97B0FA9B03BE}"/>
              </a:ext>
            </a:extLst>
          </p:cNvPr>
          <p:cNvSpPr/>
          <p:nvPr/>
        </p:nvSpPr>
        <p:spPr>
          <a:xfrm>
            <a:off x="4555572" y="3348932"/>
            <a:ext cx="978408" cy="484632"/>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TextBox 12">
            <a:extLst>
              <a:ext uri="{FF2B5EF4-FFF2-40B4-BE49-F238E27FC236}">
                <a16:creationId xmlns:a16="http://schemas.microsoft.com/office/drawing/2014/main" id="{2367785F-4EFB-564E-A0ED-86521B74220C}"/>
              </a:ext>
            </a:extLst>
          </p:cNvPr>
          <p:cNvSpPr txBox="1"/>
          <p:nvPr/>
        </p:nvSpPr>
        <p:spPr>
          <a:xfrm>
            <a:off x="2456759" y="2834843"/>
            <a:ext cx="914400" cy="830997"/>
          </a:xfrm>
          <a:prstGeom prst="rect">
            <a:avLst/>
          </a:prstGeom>
          <a:noFill/>
        </p:spPr>
        <p:txBody>
          <a:bodyPr wrap="square" rtlCol="0">
            <a:spAutoFit/>
          </a:bodyPr>
          <a:lstStyle/>
          <a:p>
            <a:r>
              <a:rPr lang="en-US" sz="4800" dirty="0"/>
              <a:t>E</a:t>
            </a:r>
          </a:p>
        </p:txBody>
      </p:sp>
      <p:sp>
        <p:nvSpPr>
          <p:cNvPr id="14" name="TextBox 13">
            <a:extLst>
              <a:ext uri="{FF2B5EF4-FFF2-40B4-BE49-F238E27FC236}">
                <a16:creationId xmlns:a16="http://schemas.microsoft.com/office/drawing/2014/main" id="{0276B694-20D6-3E46-8622-74CF461AF35F}"/>
              </a:ext>
            </a:extLst>
          </p:cNvPr>
          <p:cNvSpPr txBox="1"/>
          <p:nvPr/>
        </p:nvSpPr>
        <p:spPr>
          <a:xfrm>
            <a:off x="6988406" y="2814717"/>
            <a:ext cx="914400" cy="830997"/>
          </a:xfrm>
          <a:prstGeom prst="rect">
            <a:avLst/>
          </a:prstGeom>
          <a:noFill/>
        </p:spPr>
        <p:txBody>
          <a:bodyPr wrap="square" rtlCol="0">
            <a:spAutoFit/>
          </a:bodyPr>
          <a:lstStyle/>
          <a:p>
            <a:r>
              <a:rPr lang="en-US" sz="4800" dirty="0"/>
              <a:t>C</a:t>
            </a:r>
          </a:p>
        </p:txBody>
      </p:sp>
      <p:sp>
        <p:nvSpPr>
          <p:cNvPr id="15" name="TextBox 14">
            <a:extLst>
              <a:ext uri="{FF2B5EF4-FFF2-40B4-BE49-F238E27FC236}">
                <a16:creationId xmlns:a16="http://schemas.microsoft.com/office/drawing/2014/main" id="{4FF8C31B-5C28-9649-A010-E9BA0F480E63}"/>
              </a:ext>
            </a:extLst>
          </p:cNvPr>
          <p:cNvSpPr txBox="1"/>
          <p:nvPr/>
        </p:nvSpPr>
        <p:spPr>
          <a:xfrm>
            <a:off x="1771855" y="4254440"/>
            <a:ext cx="2284207" cy="369332"/>
          </a:xfrm>
          <a:prstGeom prst="rect">
            <a:avLst/>
          </a:prstGeom>
          <a:noFill/>
        </p:spPr>
        <p:txBody>
          <a:bodyPr wrap="square" rtlCol="0">
            <a:spAutoFit/>
          </a:bodyPr>
          <a:lstStyle/>
          <a:p>
            <a:r>
              <a:rPr lang="en-US" dirty="0">
                <a:solidFill>
                  <a:schemeClr val="bg1"/>
                </a:solidFill>
              </a:rPr>
              <a:t>Emotional Channel</a:t>
            </a:r>
          </a:p>
        </p:txBody>
      </p:sp>
      <p:sp>
        <p:nvSpPr>
          <p:cNvPr id="16" name="TextBox 15">
            <a:extLst>
              <a:ext uri="{FF2B5EF4-FFF2-40B4-BE49-F238E27FC236}">
                <a16:creationId xmlns:a16="http://schemas.microsoft.com/office/drawing/2014/main" id="{8E8D4880-33B9-4843-8BD1-3D86E86168C4}"/>
              </a:ext>
            </a:extLst>
          </p:cNvPr>
          <p:cNvSpPr txBox="1"/>
          <p:nvPr/>
        </p:nvSpPr>
        <p:spPr>
          <a:xfrm>
            <a:off x="6369695" y="4254440"/>
            <a:ext cx="2151822" cy="369332"/>
          </a:xfrm>
          <a:prstGeom prst="rect">
            <a:avLst/>
          </a:prstGeom>
          <a:noFill/>
        </p:spPr>
        <p:txBody>
          <a:bodyPr wrap="square" rtlCol="0">
            <a:spAutoFit/>
          </a:bodyPr>
          <a:lstStyle/>
          <a:p>
            <a:r>
              <a:rPr lang="en-US" dirty="0">
                <a:solidFill>
                  <a:schemeClr val="bg1"/>
                </a:solidFill>
              </a:rPr>
              <a:t>Cognitive Channel</a:t>
            </a:r>
          </a:p>
        </p:txBody>
      </p:sp>
    </p:spTree>
    <p:extLst>
      <p:ext uri="{BB962C8B-B14F-4D97-AF65-F5344CB8AC3E}">
        <p14:creationId xmlns:p14="http://schemas.microsoft.com/office/powerpoint/2010/main" val="164874971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DA8886A6-5426-494B-96D8-D962D2BA08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Freeform: Shape 12">
            <a:extLst>
              <a:ext uri="{FF2B5EF4-FFF2-40B4-BE49-F238E27FC236}">
                <a16:creationId xmlns:a16="http://schemas.microsoft.com/office/drawing/2014/main" id="{AA3ED336-C09E-46E8-9774-B977D15FC5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752347"/>
            <a:ext cx="12191999" cy="6105653"/>
          </a:xfrm>
          <a:custGeom>
            <a:avLst/>
            <a:gdLst>
              <a:gd name="connsiteX0" fmla="*/ 7538181 w 12191999"/>
              <a:gd name="connsiteY0" fmla="*/ 484 h 6105653"/>
              <a:gd name="connsiteX1" fmla="*/ 7569993 w 12191999"/>
              <a:gd name="connsiteY1" fmla="*/ 5527 h 6105653"/>
              <a:gd name="connsiteX2" fmla="*/ 7587853 w 12191999"/>
              <a:gd name="connsiteY2" fmla="*/ 84028 h 6105653"/>
              <a:gd name="connsiteX3" fmla="*/ 7559278 w 12191999"/>
              <a:gd name="connsiteY3" fmla="*/ 325347 h 6105653"/>
              <a:gd name="connsiteX4" fmla="*/ 7795021 w 12191999"/>
              <a:gd name="connsiteY4" fmla="*/ 25878 h 6105653"/>
              <a:gd name="connsiteX5" fmla="*/ 7759302 w 12191999"/>
              <a:gd name="connsiteY5" fmla="*/ 249752 h 6105653"/>
              <a:gd name="connsiteX6" fmla="*/ 7852171 w 12191999"/>
              <a:gd name="connsiteY6" fmla="*/ 313717 h 6105653"/>
              <a:gd name="connsiteX7" fmla="*/ 8002190 w 12191999"/>
              <a:gd name="connsiteY7" fmla="*/ 418385 h 6105653"/>
              <a:gd name="connsiteX8" fmla="*/ 8084343 w 12191999"/>
              <a:gd name="connsiteY8" fmla="*/ 491072 h 6105653"/>
              <a:gd name="connsiteX9" fmla="*/ 8348662 w 12191999"/>
              <a:gd name="connsiteY9" fmla="*/ 520146 h 6105653"/>
              <a:gd name="connsiteX10" fmla="*/ 8637984 w 12191999"/>
              <a:gd name="connsiteY10" fmla="*/ 459090 h 6105653"/>
              <a:gd name="connsiteX11" fmla="*/ 8784431 w 12191999"/>
              <a:gd name="connsiteY11" fmla="*/ 290457 h 6105653"/>
              <a:gd name="connsiteX12" fmla="*/ 8948737 w 12191999"/>
              <a:gd name="connsiteY12" fmla="*/ 339884 h 6105653"/>
              <a:gd name="connsiteX13" fmla="*/ 8848725 w 12191999"/>
              <a:gd name="connsiteY13" fmla="*/ 697501 h 6105653"/>
              <a:gd name="connsiteX14" fmla="*/ 9238059 w 12191999"/>
              <a:gd name="connsiteY14" fmla="*/ 165437 h 6105653"/>
              <a:gd name="connsiteX15" fmla="*/ 9255919 w 12191999"/>
              <a:gd name="connsiteY15" fmla="*/ 255567 h 6105653"/>
              <a:gd name="connsiteX16" fmla="*/ 9477374 w 12191999"/>
              <a:gd name="connsiteY16" fmla="*/ 578295 h 6105653"/>
              <a:gd name="connsiteX17" fmla="*/ 9488091 w 12191999"/>
              <a:gd name="connsiteY17" fmla="*/ 595740 h 6105653"/>
              <a:gd name="connsiteX18" fmla="*/ 9627393 w 12191999"/>
              <a:gd name="connsiteY18" fmla="*/ 650981 h 6105653"/>
              <a:gd name="connsiteX19" fmla="*/ 9648824 w 12191999"/>
              <a:gd name="connsiteY19" fmla="*/ 825429 h 6105653"/>
              <a:gd name="connsiteX20" fmla="*/ 9616678 w 12191999"/>
              <a:gd name="connsiteY20" fmla="*/ 970802 h 6105653"/>
              <a:gd name="connsiteX21" fmla="*/ 9655968 w 12191999"/>
              <a:gd name="connsiteY21" fmla="*/ 1127805 h 6105653"/>
              <a:gd name="connsiteX22" fmla="*/ 9638109 w 12191999"/>
              <a:gd name="connsiteY22" fmla="*/ 1267362 h 6105653"/>
              <a:gd name="connsiteX23" fmla="*/ 9663111 w 12191999"/>
              <a:gd name="connsiteY23" fmla="*/ 1386568 h 6105653"/>
              <a:gd name="connsiteX24" fmla="*/ 9780984 w 12191999"/>
              <a:gd name="connsiteY24" fmla="*/ 1270269 h 6105653"/>
              <a:gd name="connsiteX25" fmla="*/ 9780984 w 12191999"/>
              <a:gd name="connsiteY25" fmla="*/ 1107452 h 6105653"/>
              <a:gd name="connsiteX26" fmla="*/ 9855993 w 12191999"/>
              <a:gd name="connsiteY26" fmla="*/ 991154 h 6105653"/>
              <a:gd name="connsiteX27" fmla="*/ 9991724 w 12191999"/>
              <a:gd name="connsiteY27" fmla="*/ 880670 h 6105653"/>
              <a:gd name="connsiteX28" fmla="*/ 10209609 w 12191999"/>
              <a:gd name="connsiteY28" fmla="*/ 491071 h 6105653"/>
              <a:gd name="connsiteX29" fmla="*/ 10291762 w 12191999"/>
              <a:gd name="connsiteY29" fmla="*/ 421292 h 6105653"/>
              <a:gd name="connsiteX30" fmla="*/ 9973865 w 12191999"/>
              <a:gd name="connsiteY30" fmla="*/ 1531941 h 6105653"/>
              <a:gd name="connsiteX31" fmla="*/ 10106024 w 12191999"/>
              <a:gd name="connsiteY31" fmla="*/ 1188861 h 6105653"/>
              <a:gd name="connsiteX32" fmla="*/ 10081022 w 12191999"/>
              <a:gd name="connsiteY32" fmla="*/ 1421458 h 6105653"/>
              <a:gd name="connsiteX33" fmla="*/ 10170318 w 12191999"/>
              <a:gd name="connsiteY33" fmla="*/ 1549385 h 6105653"/>
              <a:gd name="connsiteX34" fmla="*/ 10198893 w 12191999"/>
              <a:gd name="connsiteY34" fmla="*/ 1549385 h 6105653"/>
              <a:gd name="connsiteX35" fmla="*/ 10281046 w 12191999"/>
              <a:gd name="connsiteY35" fmla="*/ 1453439 h 6105653"/>
              <a:gd name="connsiteX36" fmla="*/ 10334625 w 12191999"/>
              <a:gd name="connsiteY36" fmla="*/ 1398198 h 6105653"/>
              <a:gd name="connsiteX37" fmla="*/ 10527506 w 12191999"/>
              <a:gd name="connsiteY37" fmla="*/ 1247010 h 6105653"/>
              <a:gd name="connsiteX38" fmla="*/ 10548937 w 12191999"/>
              <a:gd name="connsiteY38" fmla="*/ 1354586 h 6105653"/>
              <a:gd name="connsiteX39" fmla="*/ 10588228 w 12191999"/>
              <a:gd name="connsiteY39" fmla="*/ 1395290 h 6105653"/>
              <a:gd name="connsiteX40" fmla="*/ 10645378 w 12191999"/>
              <a:gd name="connsiteY40" fmla="*/ 1366216 h 6105653"/>
              <a:gd name="connsiteX41" fmla="*/ 10820400 w 12191999"/>
              <a:gd name="connsiteY41" fmla="*/ 1031858 h 6105653"/>
              <a:gd name="connsiteX42" fmla="*/ 10956131 w 12191999"/>
              <a:gd name="connsiteY42" fmla="*/ 1005691 h 6105653"/>
              <a:gd name="connsiteX43" fmla="*/ 10977562 w 12191999"/>
              <a:gd name="connsiteY43" fmla="*/ 1069655 h 6105653"/>
              <a:gd name="connsiteX44" fmla="*/ 10966847 w 12191999"/>
              <a:gd name="connsiteY44" fmla="*/ 1142341 h 6105653"/>
              <a:gd name="connsiteX45" fmla="*/ 11074003 w 12191999"/>
              <a:gd name="connsiteY45" fmla="*/ 1084192 h 6105653"/>
              <a:gd name="connsiteX46" fmla="*/ 11181159 w 12191999"/>
              <a:gd name="connsiteY46" fmla="*/ 848688 h 6105653"/>
              <a:gd name="connsiteX47" fmla="*/ 11238309 w 12191999"/>
              <a:gd name="connsiteY47" fmla="*/ 805077 h 6105653"/>
              <a:gd name="connsiteX48" fmla="*/ 11266884 w 12191999"/>
              <a:gd name="connsiteY48" fmla="*/ 863226 h 6105653"/>
              <a:gd name="connsiteX49" fmla="*/ 11277600 w 12191999"/>
              <a:gd name="connsiteY49" fmla="*/ 906838 h 6105653"/>
              <a:gd name="connsiteX50" fmla="*/ 11724084 w 12191999"/>
              <a:gd name="connsiteY50" fmla="*/ 5527 h 6105653"/>
              <a:gd name="connsiteX51" fmla="*/ 11727656 w 12191999"/>
              <a:gd name="connsiteY51" fmla="*/ 209048 h 6105653"/>
              <a:gd name="connsiteX52" fmla="*/ 11656218 w 12191999"/>
              <a:gd name="connsiteY52" fmla="*/ 409663 h 6105653"/>
              <a:gd name="connsiteX53" fmla="*/ 11666934 w 12191999"/>
              <a:gd name="connsiteY53" fmla="*/ 621907 h 6105653"/>
              <a:gd name="connsiteX54" fmla="*/ 11631215 w 12191999"/>
              <a:gd name="connsiteY54" fmla="*/ 822521 h 6105653"/>
              <a:gd name="connsiteX55" fmla="*/ 11631215 w 12191999"/>
              <a:gd name="connsiteY55" fmla="*/ 996969 h 6105653"/>
              <a:gd name="connsiteX56" fmla="*/ 11684793 w 12191999"/>
              <a:gd name="connsiteY56" fmla="*/ 834151 h 6105653"/>
              <a:gd name="connsiteX57" fmla="*/ 11774090 w 12191999"/>
              <a:gd name="connsiteY57" fmla="*/ 773095 h 6105653"/>
              <a:gd name="connsiteX58" fmla="*/ 11856243 w 12191999"/>
              <a:gd name="connsiteY58" fmla="*/ 793447 h 6105653"/>
              <a:gd name="connsiteX59" fmla="*/ 11831240 w 12191999"/>
              <a:gd name="connsiteY59" fmla="*/ 860319 h 6105653"/>
              <a:gd name="connsiteX60" fmla="*/ 11738371 w 12191999"/>
              <a:gd name="connsiteY60" fmla="*/ 938820 h 6105653"/>
              <a:gd name="connsiteX61" fmla="*/ 11795521 w 12191999"/>
              <a:gd name="connsiteY61" fmla="*/ 956264 h 6105653"/>
              <a:gd name="connsiteX62" fmla="*/ 11838384 w 12191999"/>
              <a:gd name="connsiteY62" fmla="*/ 1002784 h 6105653"/>
              <a:gd name="connsiteX63" fmla="*/ 11816952 w 12191999"/>
              <a:gd name="connsiteY63" fmla="*/ 1270269 h 6105653"/>
              <a:gd name="connsiteX64" fmla="*/ 11999118 w 12191999"/>
              <a:gd name="connsiteY64" fmla="*/ 1092915 h 6105653"/>
              <a:gd name="connsiteX65" fmla="*/ 12027693 w 12191999"/>
              <a:gd name="connsiteY65" fmla="*/ 979524 h 6105653"/>
              <a:gd name="connsiteX66" fmla="*/ 12102703 w 12191999"/>
              <a:gd name="connsiteY66" fmla="*/ 953357 h 6105653"/>
              <a:gd name="connsiteX67" fmla="*/ 12120562 w 12191999"/>
              <a:gd name="connsiteY67" fmla="*/ 1005691 h 6105653"/>
              <a:gd name="connsiteX68" fmla="*/ 12056268 w 12191999"/>
              <a:gd name="connsiteY68" fmla="*/ 1267362 h 6105653"/>
              <a:gd name="connsiteX69" fmla="*/ 12081272 w 12191999"/>
              <a:gd name="connsiteY69" fmla="*/ 1310974 h 6105653"/>
              <a:gd name="connsiteX70" fmla="*/ 12191999 w 12191999"/>
              <a:gd name="connsiteY70" fmla="*/ 1008598 h 6105653"/>
              <a:gd name="connsiteX71" fmla="*/ 12191999 w 12191999"/>
              <a:gd name="connsiteY71" fmla="*/ 6105653 h 6105653"/>
              <a:gd name="connsiteX72" fmla="*/ 0 w 12191999"/>
              <a:gd name="connsiteY72" fmla="*/ 6105653 h 6105653"/>
              <a:gd name="connsiteX73" fmla="*/ 0 w 12191999"/>
              <a:gd name="connsiteY73" fmla="*/ 927116 h 6105653"/>
              <a:gd name="connsiteX74" fmla="*/ 61930 w 12191999"/>
              <a:gd name="connsiteY74" fmla="*/ 902578 h 6105653"/>
              <a:gd name="connsiteX75" fmla="*/ 155971 w 12191999"/>
              <a:gd name="connsiteY75" fmla="*/ 883588 h 6105653"/>
              <a:gd name="connsiteX76" fmla="*/ 277414 w 12191999"/>
              <a:gd name="connsiteY76" fmla="*/ 802179 h 6105653"/>
              <a:gd name="connsiteX77" fmla="*/ 638174 w 12191999"/>
              <a:gd name="connsiteY77" fmla="*/ 430025 h 6105653"/>
              <a:gd name="connsiteX78" fmla="*/ 477440 w 12191999"/>
              <a:gd name="connsiteY78" fmla="*/ 784735 h 6105653"/>
              <a:gd name="connsiteX79" fmla="*/ 827483 w 12191999"/>
              <a:gd name="connsiteY79" fmla="*/ 418395 h 6105653"/>
              <a:gd name="connsiteX80" fmla="*/ 956071 w 12191999"/>
              <a:gd name="connsiteY80" fmla="*/ 241040 h 6105653"/>
              <a:gd name="connsiteX81" fmla="*/ 999268 w 12191999"/>
              <a:gd name="connsiteY81" fmla="*/ 192386 h 6105653"/>
              <a:gd name="connsiteX82" fmla="*/ 1031080 w 12191999"/>
              <a:gd name="connsiteY82" fmla="*/ 197429 h 6105653"/>
              <a:gd name="connsiteX83" fmla="*/ 1048940 w 12191999"/>
              <a:gd name="connsiteY83" fmla="*/ 275930 h 6105653"/>
              <a:gd name="connsiteX84" fmla="*/ 1020365 w 12191999"/>
              <a:gd name="connsiteY84" fmla="*/ 517249 h 6105653"/>
              <a:gd name="connsiteX85" fmla="*/ 1256108 w 12191999"/>
              <a:gd name="connsiteY85" fmla="*/ 217780 h 6105653"/>
              <a:gd name="connsiteX86" fmla="*/ 1220389 w 12191999"/>
              <a:gd name="connsiteY86" fmla="*/ 441654 h 6105653"/>
              <a:gd name="connsiteX87" fmla="*/ 1313258 w 12191999"/>
              <a:gd name="connsiteY87" fmla="*/ 505619 h 6105653"/>
              <a:gd name="connsiteX88" fmla="*/ 1463277 w 12191999"/>
              <a:gd name="connsiteY88" fmla="*/ 610287 h 6105653"/>
              <a:gd name="connsiteX89" fmla="*/ 1545430 w 12191999"/>
              <a:gd name="connsiteY89" fmla="*/ 682974 h 6105653"/>
              <a:gd name="connsiteX90" fmla="*/ 1809749 w 12191999"/>
              <a:gd name="connsiteY90" fmla="*/ 712048 h 6105653"/>
              <a:gd name="connsiteX91" fmla="*/ 2099071 w 12191999"/>
              <a:gd name="connsiteY91" fmla="*/ 650992 h 6105653"/>
              <a:gd name="connsiteX92" fmla="*/ 2245518 w 12191999"/>
              <a:gd name="connsiteY92" fmla="*/ 482359 h 6105653"/>
              <a:gd name="connsiteX93" fmla="*/ 2409824 w 12191999"/>
              <a:gd name="connsiteY93" fmla="*/ 531786 h 6105653"/>
              <a:gd name="connsiteX94" fmla="*/ 2309812 w 12191999"/>
              <a:gd name="connsiteY94" fmla="*/ 889403 h 6105653"/>
              <a:gd name="connsiteX95" fmla="*/ 2699146 w 12191999"/>
              <a:gd name="connsiteY95" fmla="*/ 357339 h 6105653"/>
              <a:gd name="connsiteX96" fmla="*/ 2717006 w 12191999"/>
              <a:gd name="connsiteY96" fmla="*/ 447469 h 6105653"/>
              <a:gd name="connsiteX97" fmla="*/ 2938461 w 12191999"/>
              <a:gd name="connsiteY97" fmla="*/ 770197 h 6105653"/>
              <a:gd name="connsiteX98" fmla="*/ 2949178 w 12191999"/>
              <a:gd name="connsiteY98" fmla="*/ 787642 h 6105653"/>
              <a:gd name="connsiteX99" fmla="*/ 3088480 w 12191999"/>
              <a:gd name="connsiteY99" fmla="*/ 842883 h 6105653"/>
              <a:gd name="connsiteX100" fmla="*/ 3109911 w 12191999"/>
              <a:gd name="connsiteY100" fmla="*/ 1017331 h 6105653"/>
              <a:gd name="connsiteX101" fmla="*/ 3077765 w 12191999"/>
              <a:gd name="connsiteY101" fmla="*/ 1162704 h 6105653"/>
              <a:gd name="connsiteX102" fmla="*/ 3117055 w 12191999"/>
              <a:gd name="connsiteY102" fmla="*/ 1319707 h 6105653"/>
              <a:gd name="connsiteX103" fmla="*/ 3099196 w 12191999"/>
              <a:gd name="connsiteY103" fmla="*/ 1459264 h 6105653"/>
              <a:gd name="connsiteX104" fmla="*/ 3124198 w 12191999"/>
              <a:gd name="connsiteY104" fmla="*/ 1578470 h 6105653"/>
              <a:gd name="connsiteX105" fmla="*/ 3242071 w 12191999"/>
              <a:gd name="connsiteY105" fmla="*/ 1462171 h 6105653"/>
              <a:gd name="connsiteX106" fmla="*/ 3242071 w 12191999"/>
              <a:gd name="connsiteY106" fmla="*/ 1299354 h 6105653"/>
              <a:gd name="connsiteX107" fmla="*/ 3317080 w 12191999"/>
              <a:gd name="connsiteY107" fmla="*/ 1183056 h 6105653"/>
              <a:gd name="connsiteX108" fmla="*/ 3452811 w 12191999"/>
              <a:gd name="connsiteY108" fmla="*/ 1072572 h 6105653"/>
              <a:gd name="connsiteX109" fmla="*/ 3670696 w 12191999"/>
              <a:gd name="connsiteY109" fmla="*/ 682973 h 6105653"/>
              <a:gd name="connsiteX110" fmla="*/ 3752849 w 12191999"/>
              <a:gd name="connsiteY110" fmla="*/ 613194 h 6105653"/>
              <a:gd name="connsiteX111" fmla="*/ 3434952 w 12191999"/>
              <a:gd name="connsiteY111" fmla="*/ 1723843 h 6105653"/>
              <a:gd name="connsiteX112" fmla="*/ 3567111 w 12191999"/>
              <a:gd name="connsiteY112" fmla="*/ 1380763 h 6105653"/>
              <a:gd name="connsiteX113" fmla="*/ 3542109 w 12191999"/>
              <a:gd name="connsiteY113" fmla="*/ 1613360 h 6105653"/>
              <a:gd name="connsiteX114" fmla="*/ 3631405 w 12191999"/>
              <a:gd name="connsiteY114" fmla="*/ 1741287 h 6105653"/>
              <a:gd name="connsiteX115" fmla="*/ 3659980 w 12191999"/>
              <a:gd name="connsiteY115" fmla="*/ 1741287 h 6105653"/>
              <a:gd name="connsiteX116" fmla="*/ 3742133 w 12191999"/>
              <a:gd name="connsiteY116" fmla="*/ 1645341 h 6105653"/>
              <a:gd name="connsiteX117" fmla="*/ 3795712 w 12191999"/>
              <a:gd name="connsiteY117" fmla="*/ 1590100 h 6105653"/>
              <a:gd name="connsiteX118" fmla="*/ 3988593 w 12191999"/>
              <a:gd name="connsiteY118" fmla="*/ 1438912 h 6105653"/>
              <a:gd name="connsiteX119" fmla="*/ 4010024 w 12191999"/>
              <a:gd name="connsiteY119" fmla="*/ 1546488 h 6105653"/>
              <a:gd name="connsiteX120" fmla="*/ 4049315 w 12191999"/>
              <a:gd name="connsiteY120" fmla="*/ 1587192 h 6105653"/>
              <a:gd name="connsiteX121" fmla="*/ 4106465 w 12191999"/>
              <a:gd name="connsiteY121" fmla="*/ 1558118 h 6105653"/>
              <a:gd name="connsiteX122" fmla="*/ 4281487 w 12191999"/>
              <a:gd name="connsiteY122" fmla="*/ 1223760 h 6105653"/>
              <a:gd name="connsiteX123" fmla="*/ 4417219 w 12191999"/>
              <a:gd name="connsiteY123" fmla="*/ 1197593 h 6105653"/>
              <a:gd name="connsiteX124" fmla="*/ 4438649 w 12191999"/>
              <a:gd name="connsiteY124" fmla="*/ 1261557 h 6105653"/>
              <a:gd name="connsiteX125" fmla="*/ 4427935 w 12191999"/>
              <a:gd name="connsiteY125" fmla="*/ 1334243 h 6105653"/>
              <a:gd name="connsiteX126" fmla="*/ 4535090 w 12191999"/>
              <a:gd name="connsiteY126" fmla="*/ 1276094 h 6105653"/>
              <a:gd name="connsiteX127" fmla="*/ 4642246 w 12191999"/>
              <a:gd name="connsiteY127" fmla="*/ 1040590 h 6105653"/>
              <a:gd name="connsiteX128" fmla="*/ 4699396 w 12191999"/>
              <a:gd name="connsiteY128" fmla="*/ 996979 h 6105653"/>
              <a:gd name="connsiteX129" fmla="*/ 4727971 w 12191999"/>
              <a:gd name="connsiteY129" fmla="*/ 1055128 h 6105653"/>
              <a:gd name="connsiteX130" fmla="*/ 4738688 w 12191999"/>
              <a:gd name="connsiteY130" fmla="*/ 1098740 h 6105653"/>
              <a:gd name="connsiteX131" fmla="*/ 5185172 w 12191999"/>
              <a:gd name="connsiteY131" fmla="*/ 197429 h 6105653"/>
              <a:gd name="connsiteX132" fmla="*/ 5188744 w 12191999"/>
              <a:gd name="connsiteY132" fmla="*/ 400950 h 6105653"/>
              <a:gd name="connsiteX133" fmla="*/ 5117306 w 12191999"/>
              <a:gd name="connsiteY133" fmla="*/ 601565 h 6105653"/>
              <a:gd name="connsiteX134" fmla="*/ 5128021 w 12191999"/>
              <a:gd name="connsiteY134" fmla="*/ 813809 h 6105653"/>
              <a:gd name="connsiteX135" fmla="*/ 5092302 w 12191999"/>
              <a:gd name="connsiteY135" fmla="*/ 1014423 h 6105653"/>
              <a:gd name="connsiteX136" fmla="*/ 5092302 w 12191999"/>
              <a:gd name="connsiteY136" fmla="*/ 1188871 h 6105653"/>
              <a:gd name="connsiteX137" fmla="*/ 5145880 w 12191999"/>
              <a:gd name="connsiteY137" fmla="*/ 1026053 h 6105653"/>
              <a:gd name="connsiteX138" fmla="*/ 5235177 w 12191999"/>
              <a:gd name="connsiteY138" fmla="*/ 964997 h 6105653"/>
              <a:gd name="connsiteX139" fmla="*/ 5317331 w 12191999"/>
              <a:gd name="connsiteY139" fmla="*/ 985349 h 6105653"/>
              <a:gd name="connsiteX140" fmla="*/ 5292327 w 12191999"/>
              <a:gd name="connsiteY140" fmla="*/ 1052221 h 6105653"/>
              <a:gd name="connsiteX141" fmla="*/ 5199458 w 12191999"/>
              <a:gd name="connsiteY141" fmla="*/ 1130722 h 6105653"/>
              <a:gd name="connsiteX142" fmla="*/ 5256608 w 12191999"/>
              <a:gd name="connsiteY142" fmla="*/ 1148166 h 6105653"/>
              <a:gd name="connsiteX143" fmla="*/ 5299471 w 12191999"/>
              <a:gd name="connsiteY143" fmla="*/ 1194686 h 6105653"/>
              <a:gd name="connsiteX144" fmla="*/ 5278039 w 12191999"/>
              <a:gd name="connsiteY144" fmla="*/ 1462171 h 6105653"/>
              <a:gd name="connsiteX145" fmla="*/ 5460205 w 12191999"/>
              <a:gd name="connsiteY145" fmla="*/ 1284817 h 6105653"/>
              <a:gd name="connsiteX146" fmla="*/ 5488780 w 12191999"/>
              <a:gd name="connsiteY146" fmla="*/ 1171426 h 6105653"/>
              <a:gd name="connsiteX147" fmla="*/ 5539513 w 12191999"/>
              <a:gd name="connsiteY147" fmla="*/ 1140353 h 6105653"/>
              <a:gd name="connsiteX148" fmla="*/ 5552720 w 12191999"/>
              <a:gd name="connsiteY148" fmla="*/ 1143022 h 6105653"/>
              <a:gd name="connsiteX149" fmla="*/ 5574208 w 12191999"/>
              <a:gd name="connsiteY149" fmla="*/ 1115811 h 6105653"/>
              <a:gd name="connsiteX150" fmla="*/ 5734050 w 12191999"/>
              <a:gd name="connsiteY150" fmla="*/ 1075470 h 6105653"/>
              <a:gd name="connsiteX151" fmla="*/ 5798343 w 12191999"/>
              <a:gd name="connsiteY151" fmla="*/ 1020228 h 6105653"/>
              <a:gd name="connsiteX152" fmla="*/ 5884068 w 12191999"/>
              <a:gd name="connsiteY152" fmla="*/ 883578 h 6105653"/>
              <a:gd name="connsiteX153" fmla="*/ 6066234 w 12191999"/>
              <a:gd name="connsiteY153" fmla="*/ 645166 h 6105653"/>
              <a:gd name="connsiteX154" fmla="*/ 6109096 w 12191999"/>
              <a:gd name="connsiteY154" fmla="*/ 732391 h 6105653"/>
              <a:gd name="connsiteX155" fmla="*/ 5998368 w 12191999"/>
              <a:gd name="connsiteY155" fmla="*/ 985338 h 6105653"/>
              <a:gd name="connsiteX156" fmla="*/ 5969793 w 12191999"/>
              <a:gd name="connsiteY156" fmla="*/ 1168509 h 6105653"/>
              <a:gd name="connsiteX157" fmla="*/ 6162674 w 12191999"/>
              <a:gd name="connsiteY157" fmla="*/ 909745 h 6105653"/>
              <a:gd name="connsiteX158" fmla="*/ 6412705 w 12191999"/>
              <a:gd name="connsiteY158" fmla="*/ 659704 h 6105653"/>
              <a:gd name="connsiteX159" fmla="*/ 6366271 w 12191999"/>
              <a:gd name="connsiteY159" fmla="*/ 851596 h 6105653"/>
              <a:gd name="connsiteX160" fmla="*/ 6398418 w 12191999"/>
              <a:gd name="connsiteY160" fmla="*/ 860319 h 6105653"/>
              <a:gd name="connsiteX161" fmla="*/ 6694884 w 12191999"/>
              <a:gd name="connsiteY161" fmla="*/ 691686 h 6105653"/>
              <a:gd name="connsiteX162" fmla="*/ 6816327 w 12191999"/>
              <a:gd name="connsiteY162" fmla="*/ 610277 h 6105653"/>
              <a:gd name="connsiteX163" fmla="*/ 7177087 w 12191999"/>
              <a:gd name="connsiteY163" fmla="*/ 238123 h 6105653"/>
              <a:gd name="connsiteX164" fmla="*/ 7016353 w 12191999"/>
              <a:gd name="connsiteY164" fmla="*/ 592833 h 6105653"/>
              <a:gd name="connsiteX165" fmla="*/ 7366396 w 12191999"/>
              <a:gd name="connsiteY165" fmla="*/ 226493 h 6105653"/>
              <a:gd name="connsiteX166" fmla="*/ 7494984 w 12191999"/>
              <a:gd name="connsiteY166" fmla="*/ 49138 h 6105653"/>
              <a:gd name="connsiteX167" fmla="*/ 7538181 w 12191999"/>
              <a:gd name="connsiteY167" fmla="*/ 484 h 610565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Lst>
            <a:rect l="l" t="t" r="r" b="b"/>
            <a:pathLst>
              <a:path w="12191999" h="6105653">
                <a:moveTo>
                  <a:pt x="7538181" y="484"/>
                </a:moveTo>
                <a:cubicBezTo>
                  <a:pt x="7546999" y="-833"/>
                  <a:pt x="7557492" y="439"/>
                  <a:pt x="7569993" y="5527"/>
                </a:cubicBezTo>
                <a:cubicBezTo>
                  <a:pt x="7612855" y="22971"/>
                  <a:pt x="7598567" y="54953"/>
                  <a:pt x="7587853" y="84028"/>
                </a:cubicBezTo>
                <a:cubicBezTo>
                  <a:pt x="7559278" y="153806"/>
                  <a:pt x="7559278" y="229401"/>
                  <a:pt x="7559278" y="325347"/>
                </a:cubicBezTo>
                <a:cubicBezTo>
                  <a:pt x="7695009" y="243938"/>
                  <a:pt x="7652146" y="95658"/>
                  <a:pt x="7795021" y="25878"/>
                </a:cubicBezTo>
                <a:cubicBezTo>
                  <a:pt x="7820024" y="113102"/>
                  <a:pt x="7770018" y="179974"/>
                  <a:pt x="7759302" y="249752"/>
                </a:cubicBezTo>
                <a:cubicBezTo>
                  <a:pt x="7748587" y="313717"/>
                  <a:pt x="7773590" y="328254"/>
                  <a:pt x="7852171" y="313717"/>
                </a:cubicBezTo>
                <a:cubicBezTo>
                  <a:pt x="7973615" y="290457"/>
                  <a:pt x="8034337" y="325347"/>
                  <a:pt x="8002190" y="418385"/>
                </a:cubicBezTo>
                <a:cubicBezTo>
                  <a:pt x="7970043" y="505609"/>
                  <a:pt x="8016478" y="514331"/>
                  <a:pt x="8084343" y="491072"/>
                </a:cubicBezTo>
                <a:cubicBezTo>
                  <a:pt x="8184355" y="456182"/>
                  <a:pt x="8262937" y="493979"/>
                  <a:pt x="8348662" y="520146"/>
                </a:cubicBezTo>
                <a:cubicBezTo>
                  <a:pt x="8477249" y="560851"/>
                  <a:pt x="8541543" y="543406"/>
                  <a:pt x="8637984" y="459090"/>
                </a:cubicBezTo>
                <a:cubicBezTo>
                  <a:pt x="8691561" y="409663"/>
                  <a:pt x="8737996" y="360236"/>
                  <a:pt x="8784431" y="290457"/>
                </a:cubicBezTo>
                <a:cubicBezTo>
                  <a:pt x="8809434" y="450367"/>
                  <a:pt x="8895158" y="284642"/>
                  <a:pt x="8948737" y="339884"/>
                </a:cubicBezTo>
                <a:cubicBezTo>
                  <a:pt x="8970168" y="453274"/>
                  <a:pt x="8798717" y="543406"/>
                  <a:pt x="8848725" y="697501"/>
                </a:cubicBezTo>
                <a:cubicBezTo>
                  <a:pt x="8995171" y="511424"/>
                  <a:pt x="9041606" y="302087"/>
                  <a:pt x="9238059" y="165437"/>
                </a:cubicBezTo>
                <a:cubicBezTo>
                  <a:pt x="9280921" y="197419"/>
                  <a:pt x="9238059" y="229401"/>
                  <a:pt x="9255919" y="255567"/>
                </a:cubicBezTo>
                <a:cubicBezTo>
                  <a:pt x="9266634" y="255567"/>
                  <a:pt x="9198767" y="560851"/>
                  <a:pt x="9477374" y="578295"/>
                </a:cubicBezTo>
                <a:cubicBezTo>
                  <a:pt x="9477374" y="584110"/>
                  <a:pt x="9477374" y="589925"/>
                  <a:pt x="9488091" y="595740"/>
                </a:cubicBezTo>
                <a:cubicBezTo>
                  <a:pt x="9527380" y="627722"/>
                  <a:pt x="9620249" y="598648"/>
                  <a:pt x="9627393" y="650981"/>
                </a:cubicBezTo>
                <a:cubicBezTo>
                  <a:pt x="9634537" y="709131"/>
                  <a:pt x="9666684" y="764373"/>
                  <a:pt x="9648824" y="825429"/>
                </a:cubicBezTo>
                <a:cubicBezTo>
                  <a:pt x="9634537" y="871948"/>
                  <a:pt x="9616678" y="921374"/>
                  <a:pt x="9616678" y="970802"/>
                </a:cubicBezTo>
                <a:cubicBezTo>
                  <a:pt x="9616678" y="1023136"/>
                  <a:pt x="9495233" y="1095822"/>
                  <a:pt x="9655968" y="1127805"/>
                </a:cubicBezTo>
                <a:cubicBezTo>
                  <a:pt x="9663111" y="1127805"/>
                  <a:pt x="9645252" y="1217935"/>
                  <a:pt x="9638109" y="1267362"/>
                </a:cubicBezTo>
                <a:cubicBezTo>
                  <a:pt x="9630965" y="1308066"/>
                  <a:pt x="9598818" y="1357494"/>
                  <a:pt x="9663111" y="1386568"/>
                </a:cubicBezTo>
                <a:cubicBezTo>
                  <a:pt x="9702403" y="1401105"/>
                  <a:pt x="9773840" y="1331326"/>
                  <a:pt x="9780984" y="1270269"/>
                </a:cubicBezTo>
                <a:cubicBezTo>
                  <a:pt x="9788127" y="1215028"/>
                  <a:pt x="9795271" y="1159787"/>
                  <a:pt x="9780984" y="1107452"/>
                </a:cubicBezTo>
                <a:cubicBezTo>
                  <a:pt x="9763125" y="1043488"/>
                  <a:pt x="9791699" y="1008598"/>
                  <a:pt x="9855993" y="991154"/>
                </a:cubicBezTo>
                <a:cubicBezTo>
                  <a:pt x="9923858" y="970802"/>
                  <a:pt x="9959577" y="933005"/>
                  <a:pt x="9991724" y="880670"/>
                </a:cubicBezTo>
                <a:cubicBezTo>
                  <a:pt x="10070305" y="752742"/>
                  <a:pt x="10163174" y="630630"/>
                  <a:pt x="10209609" y="491071"/>
                </a:cubicBezTo>
                <a:cubicBezTo>
                  <a:pt x="10216753" y="464905"/>
                  <a:pt x="10231040" y="432923"/>
                  <a:pt x="10291762" y="421292"/>
                </a:cubicBezTo>
                <a:cubicBezTo>
                  <a:pt x="10198893" y="799262"/>
                  <a:pt x="9959577" y="1142341"/>
                  <a:pt x="9973865" y="1531941"/>
                </a:cubicBezTo>
                <a:cubicBezTo>
                  <a:pt x="10048874" y="1427272"/>
                  <a:pt x="10052446" y="1302252"/>
                  <a:pt x="10106024" y="1188861"/>
                </a:cubicBezTo>
                <a:cubicBezTo>
                  <a:pt x="10145315" y="1270269"/>
                  <a:pt x="10102453" y="1345863"/>
                  <a:pt x="10081022" y="1421458"/>
                </a:cubicBezTo>
                <a:cubicBezTo>
                  <a:pt x="10063162" y="1485421"/>
                  <a:pt x="10059590" y="1543570"/>
                  <a:pt x="10170318" y="1549385"/>
                </a:cubicBezTo>
                <a:cubicBezTo>
                  <a:pt x="10181034" y="1549385"/>
                  <a:pt x="10188178" y="1549385"/>
                  <a:pt x="10198893" y="1549385"/>
                </a:cubicBezTo>
                <a:cubicBezTo>
                  <a:pt x="10245327" y="1526126"/>
                  <a:pt x="10266759" y="1494144"/>
                  <a:pt x="10281046" y="1453439"/>
                </a:cubicBezTo>
                <a:cubicBezTo>
                  <a:pt x="10288190" y="1430180"/>
                  <a:pt x="10302477" y="1398198"/>
                  <a:pt x="10334625" y="1398198"/>
                </a:cubicBezTo>
                <a:cubicBezTo>
                  <a:pt x="10456068" y="1401105"/>
                  <a:pt x="10491787" y="1322604"/>
                  <a:pt x="10527506" y="1247010"/>
                </a:cubicBezTo>
                <a:cubicBezTo>
                  <a:pt x="10588228" y="1287714"/>
                  <a:pt x="10545365" y="1322604"/>
                  <a:pt x="10548937" y="1354586"/>
                </a:cubicBezTo>
                <a:cubicBezTo>
                  <a:pt x="10552509" y="1374938"/>
                  <a:pt x="10556080" y="1395290"/>
                  <a:pt x="10588228" y="1395290"/>
                </a:cubicBezTo>
                <a:cubicBezTo>
                  <a:pt x="10613230" y="1395290"/>
                  <a:pt x="10645378" y="1386568"/>
                  <a:pt x="10645378" y="1366216"/>
                </a:cubicBezTo>
                <a:cubicBezTo>
                  <a:pt x="10648949" y="1238288"/>
                  <a:pt x="10820400" y="1165601"/>
                  <a:pt x="10820400" y="1031858"/>
                </a:cubicBezTo>
                <a:cubicBezTo>
                  <a:pt x="10820400" y="950449"/>
                  <a:pt x="10916840" y="1072563"/>
                  <a:pt x="10956131" y="1005691"/>
                </a:cubicBezTo>
                <a:cubicBezTo>
                  <a:pt x="10966847" y="991154"/>
                  <a:pt x="10981133" y="1046395"/>
                  <a:pt x="10977562" y="1069655"/>
                </a:cubicBezTo>
                <a:cubicBezTo>
                  <a:pt x="10973991" y="1092915"/>
                  <a:pt x="10948987" y="1113267"/>
                  <a:pt x="10966847" y="1142341"/>
                </a:cubicBezTo>
                <a:cubicBezTo>
                  <a:pt x="11031140" y="1156879"/>
                  <a:pt x="11056143" y="1119081"/>
                  <a:pt x="11074003" y="1084192"/>
                </a:cubicBezTo>
                <a:cubicBezTo>
                  <a:pt x="11116865" y="1008598"/>
                  <a:pt x="11166871" y="933005"/>
                  <a:pt x="11181159" y="848688"/>
                </a:cubicBezTo>
                <a:cubicBezTo>
                  <a:pt x="11184730" y="819614"/>
                  <a:pt x="11202590" y="802169"/>
                  <a:pt x="11238309" y="805077"/>
                </a:cubicBezTo>
                <a:cubicBezTo>
                  <a:pt x="11284744" y="810891"/>
                  <a:pt x="11270456" y="839966"/>
                  <a:pt x="11266884" y="863226"/>
                </a:cubicBezTo>
                <a:cubicBezTo>
                  <a:pt x="11263312" y="877763"/>
                  <a:pt x="11252596" y="892300"/>
                  <a:pt x="11277600" y="906838"/>
                </a:cubicBezTo>
                <a:cubicBezTo>
                  <a:pt x="11531203" y="566666"/>
                  <a:pt x="11516915" y="386403"/>
                  <a:pt x="11724084" y="5527"/>
                </a:cubicBezTo>
                <a:cubicBezTo>
                  <a:pt x="11763375" y="89842"/>
                  <a:pt x="11734800" y="150899"/>
                  <a:pt x="11727656" y="209048"/>
                </a:cubicBezTo>
                <a:cubicBezTo>
                  <a:pt x="11709796" y="354421"/>
                  <a:pt x="11677649" y="264290"/>
                  <a:pt x="11656218" y="409663"/>
                </a:cubicBezTo>
                <a:cubicBezTo>
                  <a:pt x="11645503" y="479442"/>
                  <a:pt x="11609784" y="543406"/>
                  <a:pt x="11666934" y="621907"/>
                </a:cubicBezTo>
                <a:cubicBezTo>
                  <a:pt x="11706225" y="674241"/>
                  <a:pt x="11663362" y="758557"/>
                  <a:pt x="11631215" y="822521"/>
                </a:cubicBezTo>
                <a:cubicBezTo>
                  <a:pt x="11602640" y="874856"/>
                  <a:pt x="11595497" y="927190"/>
                  <a:pt x="11631215" y="996969"/>
                </a:cubicBezTo>
                <a:cubicBezTo>
                  <a:pt x="11652646" y="933005"/>
                  <a:pt x="11670505" y="883578"/>
                  <a:pt x="11684793" y="834151"/>
                </a:cubicBezTo>
                <a:cubicBezTo>
                  <a:pt x="11695509" y="793447"/>
                  <a:pt x="11720512" y="770187"/>
                  <a:pt x="11774090" y="773095"/>
                </a:cubicBezTo>
                <a:cubicBezTo>
                  <a:pt x="11802665" y="773095"/>
                  <a:pt x="11841956" y="764373"/>
                  <a:pt x="11856243" y="793447"/>
                </a:cubicBezTo>
                <a:cubicBezTo>
                  <a:pt x="11870531" y="816706"/>
                  <a:pt x="11856243" y="848688"/>
                  <a:pt x="11831240" y="860319"/>
                </a:cubicBezTo>
                <a:cubicBezTo>
                  <a:pt x="11784806" y="874856"/>
                  <a:pt x="11741944" y="889393"/>
                  <a:pt x="11738371" y="938820"/>
                </a:cubicBezTo>
                <a:cubicBezTo>
                  <a:pt x="11731228" y="1005691"/>
                  <a:pt x="11759802" y="967894"/>
                  <a:pt x="11795521" y="956264"/>
                </a:cubicBezTo>
                <a:cubicBezTo>
                  <a:pt x="11834812" y="944634"/>
                  <a:pt x="11845527" y="979524"/>
                  <a:pt x="11838384" y="1002784"/>
                </a:cubicBezTo>
                <a:cubicBezTo>
                  <a:pt x="11806237" y="1090007"/>
                  <a:pt x="11863387" y="1180138"/>
                  <a:pt x="11816952" y="1270269"/>
                </a:cubicBezTo>
                <a:cubicBezTo>
                  <a:pt x="11931252" y="1247010"/>
                  <a:pt x="11981259" y="1197583"/>
                  <a:pt x="11999118" y="1092915"/>
                </a:cubicBezTo>
                <a:cubicBezTo>
                  <a:pt x="12002690" y="1055118"/>
                  <a:pt x="11995547" y="1014413"/>
                  <a:pt x="12027693" y="979524"/>
                </a:cubicBezTo>
                <a:cubicBezTo>
                  <a:pt x="12045553" y="959172"/>
                  <a:pt x="12066984" y="938820"/>
                  <a:pt x="12102703" y="953357"/>
                </a:cubicBezTo>
                <a:cubicBezTo>
                  <a:pt x="12127705" y="962080"/>
                  <a:pt x="12127705" y="985338"/>
                  <a:pt x="12120562" y="1005691"/>
                </a:cubicBezTo>
                <a:cubicBezTo>
                  <a:pt x="12081272" y="1090007"/>
                  <a:pt x="12070555" y="1180138"/>
                  <a:pt x="12056268" y="1267362"/>
                </a:cubicBezTo>
                <a:cubicBezTo>
                  <a:pt x="12052697" y="1281899"/>
                  <a:pt x="12045553" y="1296437"/>
                  <a:pt x="12081272" y="1310974"/>
                </a:cubicBezTo>
                <a:cubicBezTo>
                  <a:pt x="12113418" y="1209213"/>
                  <a:pt x="12156280" y="1110359"/>
                  <a:pt x="12191999" y="1008598"/>
                </a:cubicBezTo>
                <a:lnTo>
                  <a:pt x="12191999" y="6105653"/>
                </a:lnTo>
                <a:lnTo>
                  <a:pt x="0" y="6105653"/>
                </a:lnTo>
                <a:lnTo>
                  <a:pt x="0" y="927116"/>
                </a:lnTo>
                <a:lnTo>
                  <a:pt x="61930" y="902578"/>
                </a:lnTo>
                <a:cubicBezTo>
                  <a:pt x="91454" y="894128"/>
                  <a:pt x="122931" y="887949"/>
                  <a:pt x="155971" y="883588"/>
                </a:cubicBezTo>
                <a:cubicBezTo>
                  <a:pt x="223837" y="877773"/>
                  <a:pt x="245268" y="839976"/>
                  <a:pt x="277414" y="802179"/>
                </a:cubicBezTo>
                <a:cubicBezTo>
                  <a:pt x="388143" y="674251"/>
                  <a:pt x="488155" y="537601"/>
                  <a:pt x="638174" y="430025"/>
                </a:cubicBezTo>
                <a:cubicBezTo>
                  <a:pt x="620315" y="555046"/>
                  <a:pt x="520302" y="653899"/>
                  <a:pt x="477440" y="784735"/>
                </a:cubicBezTo>
                <a:cubicBezTo>
                  <a:pt x="641746" y="680066"/>
                  <a:pt x="727471" y="543415"/>
                  <a:pt x="827483" y="418395"/>
                </a:cubicBezTo>
                <a:cubicBezTo>
                  <a:pt x="873917" y="360246"/>
                  <a:pt x="931068" y="307912"/>
                  <a:pt x="956071" y="241040"/>
                </a:cubicBezTo>
                <a:cubicBezTo>
                  <a:pt x="961429" y="223595"/>
                  <a:pt x="972814" y="196338"/>
                  <a:pt x="999268" y="192386"/>
                </a:cubicBezTo>
                <a:cubicBezTo>
                  <a:pt x="1008086" y="191069"/>
                  <a:pt x="1018579" y="192341"/>
                  <a:pt x="1031080" y="197429"/>
                </a:cubicBezTo>
                <a:cubicBezTo>
                  <a:pt x="1073942" y="214873"/>
                  <a:pt x="1059654" y="246855"/>
                  <a:pt x="1048940" y="275930"/>
                </a:cubicBezTo>
                <a:cubicBezTo>
                  <a:pt x="1020365" y="345708"/>
                  <a:pt x="1020365" y="421303"/>
                  <a:pt x="1020365" y="517249"/>
                </a:cubicBezTo>
                <a:cubicBezTo>
                  <a:pt x="1156096" y="435840"/>
                  <a:pt x="1113233" y="287560"/>
                  <a:pt x="1256108" y="217780"/>
                </a:cubicBezTo>
                <a:cubicBezTo>
                  <a:pt x="1281111" y="305004"/>
                  <a:pt x="1231105" y="371876"/>
                  <a:pt x="1220389" y="441654"/>
                </a:cubicBezTo>
                <a:cubicBezTo>
                  <a:pt x="1209674" y="505619"/>
                  <a:pt x="1234677" y="520156"/>
                  <a:pt x="1313258" y="505619"/>
                </a:cubicBezTo>
                <a:cubicBezTo>
                  <a:pt x="1434702" y="482359"/>
                  <a:pt x="1495424" y="517249"/>
                  <a:pt x="1463277" y="610287"/>
                </a:cubicBezTo>
                <a:cubicBezTo>
                  <a:pt x="1431130" y="697511"/>
                  <a:pt x="1477565" y="706233"/>
                  <a:pt x="1545430" y="682974"/>
                </a:cubicBezTo>
                <a:cubicBezTo>
                  <a:pt x="1645442" y="648084"/>
                  <a:pt x="1724024" y="685881"/>
                  <a:pt x="1809749" y="712048"/>
                </a:cubicBezTo>
                <a:cubicBezTo>
                  <a:pt x="1938336" y="752753"/>
                  <a:pt x="2002630" y="735308"/>
                  <a:pt x="2099071" y="650992"/>
                </a:cubicBezTo>
                <a:cubicBezTo>
                  <a:pt x="2152648" y="601565"/>
                  <a:pt x="2199083" y="552138"/>
                  <a:pt x="2245518" y="482359"/>
                </a:cubicBezTo>
                <a:cubicBezTo>
                  <a:pt x="2270521" y="642269"/>
                  <a:pt x="2356245" y="476544"/>
                  <a:pt x="2409824" y="531786"/>
                </a:cubicBezTo>
                <a:cubicBezTo>
                  <a:pt x="2431255" y="645176"/>
                  <a:pt x="2259804" y="735308"/>
                  <a:pt x="2309812" y="889403"/>
                </a:cubicBezTo>
                <a:cubicBezTo>
                  <a:pt x="2456258" y="703326"/>
                  <a:pt x="2502693" y="493989"/>
                  <a:pt x="2699146" y="357339"/>
                </a:cubicBezTo>
                <a:cubicBezTo>
                  <a:pt x="2742008" y="389321"/>
                  <a:pt x="2699146" y="421303"/>
                  <a:pt x="2717006" y="447469"/>
                </a:cubicBezTo>
                <a:cubicBezTo>
                  <a:pt x="2727721" y="447469"/>
                  <a:pt x="2659854" y="752753"/>
                  <a:pt x="2938461" y="770197"/>
                </a:cubicBezTo>
                <a:cubicBezTo>
                  <a:pt x="2938461" y="776012"/>
                  <a:pt x="2938461" y="781827"/>
                  <a:pt x="2949178" y="787642"/>
                </a:cubicBezTo>
                <a:cubicBezTo>
                  <a:pt x="2988467" y="819624"/>
                  <a:pt x="3081336" y="790550"/>
                  <a:pt x="3088480" y="842883"/>
                </a:cubicBezTo>
                <a:cubicBezTo>
                  <a:pt x="3095624" y="901033"/>
                  <a:pt x="3127771" y="956275"/>
                  <a:pt x="3109911" y="1017331"/>
                </a:cubicBezTo>
                <a:cubicBezTo>
                  <a:pt x="3095624" y="1063850"/>
                  <a:pt x="3077765" y="1113276"/>
                  <a:pt x="3077765" y="1162704"/>
                </a:cubicBezTo>
                <a:cubicBezTo>
                  <a:pt x="3077765" y="1215038"/>
                  <a:pt x="2956320" y="1287724"/>
                  <a:pt x="3117055" y="1319707"/>
                </a:cubicBezTo>
                <a:cubicBezTo>
                  <a:pt x="3124198" y="1319707"/>
                  <a:pt x="3106339" y="1409837"/>
                  <a:pt x="3099196" y="1459264"/>
                </a:cubicBezTo>
                <a:cubicBezTo>
                  <a:pt x="3092052" y="1499968"/>
                  <a:pt x="3059905" y="1549396"/>
                  <a:pt x="3124198" y="1578470"/>
                </a:cubicBezTo>
                <a:cubicBezTo>
                  <a:pt x="3163490" y="1593007"/>
                  <a:pt x="3234927" y="1523228"/>
                  <a:pt x="3242071" y="1462171"/>
                </a:cubicBezTo>
                <a:cubicBezTo>
                  <a:pt x="3249214" y="1406930"/>
                  <a:pt x="3256358" y="1351689"/>
                  <a:pt x="3242071" y="1299354"/>
                </a:cubicBezTo>
                <a:cubicBezTo>
                  <a:pt x="3224212" y="1235390"/>
                  <a:pt x="3252786" y="1200500"/>
                  <a:pt x="3317080" y="1183056"/>
                </a:cubicBezTo>
                <a:cubicBezTo>
                  <a:pt x="3384945" y="1162704"/>
                  <a:pt x="3420664" y="1124907"/>
                  <a:pt x="3452811" y="1072572"/>
                </a:cubicBezTo>
                <a:cubicBezTo>
                  <a:pt x="3531392" y="944644"/>
                  <a:pt x="3624261" y="822532"/>
                  <a:pt x="3670696" y="682973"/>
                </a:cubicBezTo>
                <a:cubicBezTo>
                  <a:pt x="3677840" y="656807"/>
                  <a:pt x="3692127" y="624825"/>
                  <a:pt x="3752849" y="613194"/>
                </a:cubicBezTo>
                <a:cubicBezTo>
                  <a:pt x="3659980" y="991164"/>
                  <a:pt x="3420664" y="1334243"/>
                  <a:pt x="3434952" y="1723843"/>
                </a:cubicBezTo>
                <a:cubicBezTo>
                  <a:pt x="3509961" y="1619174"/>
                  <a:pt x="3513533" y="1494154"/>
                  <a:pt x="3567111" y="1380763"/>
                </a:cubicBezTo>
                <a:cubicBezTo>
                  <a:pt x="3606402" y="1462171"/>
                  <a:pt x="3563540" y="1537765"/>
                  <a:pt x="3542109" y="1613360"/>
                </a:cubicBezTo>
                <a:cubicBezTo>
                  <a:pt x="3524249" y="1677323"/>
                  <a:pt x="3520677" y="1735472"/>
                  <a:pt x="3631405" y="1741287"/>
                </a:cubicBezTo>
                <a:cubicBezTo>
                  <a:pt x="3642121" y="1741287"/>
                  <a:pt x="3649265" y="1741287"/>
                  <a:pt x="3659980" y="1741287"/>
                </a:cubicBezTo>
                <a:cubicBezTo>
                  <a:pt x="3706414" y="1718028"/>
                  <a:pt x="3727846" y="1686046"/>
                  <a:pt x="3742133" y="1645341"/>
                </a:cubicBezTo>
                <a:cubicBezTo>
                  <a:pt x="3749277" y="1622082"/>
                  <a:pt x="3763564" y="1590100"/>
                  <a:pt x="3795712" y="1590100"/>
                </a:cubicBezTo>
                <a:cubicBezTo>
                  <a:pt x="3917155" y="1593007"/>
                  <a:pt x="3952874" y="1514506"/>
                  <a:pt x="3988593" y="1438912"/>
                </a:cubicBezTo>
                <a:cubicBezTo>
                  <a:pt x="4049315" y="1479616"/>
                  <a:pt x="4006452" y="1514506"/>
                  <a:pt x="4010024" y="1546488"/>
                </a:cubicBezTo>
                <a:cubicBezTo>
                  <a:pt x="4013596" y="1566840"/>
                  <a:pt x="4017167" y="1587192"/>
                  <a:pt x="4049315" y="1587192"/>
                </a:cubicBezTo>
                <a:cubicBezTo>
                  <a:pt x="4074317" y="1587192"/>
                  <a:pt x="4106465" y="1578470"/>
                  <a:pt x="4106465" y="1558118"/>
                </a:cubicBezTo>
                <a:cubicBezTo>
                  <a:pt x="4110036" y="1430190"/>
                  <a:pt x="4281487" y="1357503"/>
                  <a:pt x="4281487" y="1223760"/>
                </a:cubicBezTo>
                <a:cubicBezTo>
                  <a:pt x="4281487" y="1142351"/>
                  <a:pt x="4377927" y="1264465"/>
                  <a:pt x="4417219" y="1197593"/>
                </a:cubicBezTo>
                <a:cubicBezTo>
                  <a:pt x="4427935" y="1183056"/>
                  <a:pt x="4442220" y="1238297"/>
                  <a:pt x="4438649" y="1261557"/>
                </a:cubicBezTo>
                <a:cubicBezTo>
                  <a:pt x="4435078" y="1284817"/>
                  <a:pt x="4410074" y="1305169"/>
                  <a:pt x="4427935" y="1334243"/>
                </a:cubicBezTo>
                <a:cubicBezTo>
                  <a:pt x="4492228" y="1348781"/>
                  <a:pt x="4517230" y="1310983"/>
                  <a:pt x="4535090" y="1276094"/>
                </a:cubicBezTo>
                <a:cubicBezTo>
                  <a:pt x="4577952" y="1200500"/>
                  <a:pt x="4627958" y="1124907"/>
                  <a:pt x="4642246" y="1040590"/>
                </a:cubicBezTo>
                <a:cubicBezTo>
                  <a:pt x="4645817" y="1011516"/>
                  <a:pt x="4663677" y="994071"/>
                  <a:pt x="4699396" y="996979"/>
                </a:cubicBezTo>
                <a:cubicBezTo>
                  <a:pt x="4745832" y="1002793"/>
                  <a:pt x="4731544" y="1031868"/>
                  <a:pt x="4727971" y="1055128"/>
                </a:cubicBezTo>
                <a:cubicBezTo>
                  <a:pt x="4724399" y="1069665"/>
                  <a:pt x="4713683" y="1084202"/>
                  <a:pt x="4738688" y="1098740"/>
                </a:cubicBezTo>
                <a:cubicBezTo>
                  <a:pt x="4992291" y="758568"/>
                  <a:pt x="4978002" y="578305"/>
                  <a:pt x="5185172" y="197429"/>
                </a:cubicBezTo>
                <a:cubicBezTo>
                  <a:pt x="5224462" y="281744"/>
                  <a:pt x="5195887" y="342801"/>
                  <a:pt x="5188744" y="400950"/>
                </a:cubicBezTo>
                <a:cubicBezTo>
                  <a:pt x="5170883" y="546323"/>
                  <a:pt x="5138736" y="456192"/>
                  <a:pt x="5117306" y="601565"/>
                </a:cubicBezTo>
                <a:cubicBezTo>
                  <a:pt x="5106590" y="671344"/>
                  <a:pt x="5070871" y="735308"/>
                  <a:pt x="5128021" y="813809"/>
                </a:cubicBezTo>
                <a:cubicBezTo>
                  <a:pt x="5167312" y="866143"/>
                  <a:pt x="5124450" y="950459"/>
                  <a:pt x="5092302" y="1014423"/>
                </a:cubicBezTo>
                <a:cubicBezTo>
                  <a:pt x="5063727" y="1066758"/>
                  <a:pt x="5056585" y="1119092"/>
                  <a:pt x="5092302" y="1188871"/>
                </a:cubicBezTo>
                <a:cubicBezTo>
                  <a:pt x="5113734" y="1124907"/>
                  <a:pt x="5131592" y="1075480"/>
                  <a:pt x="5145880" y="1026053"/>
                </a:cubicBezTo>
                <a:cubicBezTo>
                  <a:pt x="5156596" y="985349"/>
                  <a:pt x="5181600" y="962089"/>
                  <a:pt x="5235177" y="964997"/>
                </a:cubicBezTo>
                <a:cubicBezTo>
                  <a:pt x="5263752" y="964997"/>
                  <a:pt x="5303044" y="956275"/>
                  <a:pt x="5317331" y="985349"/>
                </a:cubicBezTo>
                <a:cubicBezTo>
                  <a:pt x="5331618" y="1008608"/>
                  <a:pt x="5317331" y="1040590"/>
                  <a:pt x="5292327" y="1052221"/>
                </a:cubicBezTo>
                <a:cubicBezTo>
                  <a:pt x="5245894" y="1066758"/>
                  <a:pt x="5203031" y="1081295"/>
                  <a:pt x="5199458" y="1130722"/>
                </a:cubicBezTo>
                <a:cubicBezTo>
                  <a:pt x="5192315" y="1197593"/>
                  <a:pt x="5220889" y="1159796"/>
                  <a:pt x="5256608" y="1148166"/>
                </a:cubicBezTo>
                <a:cubicBezTo>
                  <a:pt x="5295899" y="1136536"/>
                  <a:pt x="5306616" y="1171426"/>
                  <a:pt x="5299471" y="1194686"/>
                </a:cubicBezTo>
                <a:cubicBezTo>
                  <a:pt x="5267324" y="1281909"/>
                  <a:pt x="5324474" y="1372040"/>
                  <a:pt x="5278039" y="1462171"/>
                </a:cubicBezTo>
                <a:cubicBezTo>
                  <a:pt x="5392339" y="1438912"/>
                  <a:pt x="5442347" y="1389485"/>
                  <a:pt x="5460205" y="1284817"/>
                </a:cubicBezTo>
                <a:cubicBezTo>
                  <a:pt x="5463777" y="1247020"/>
                  <a:pt x="5456634" y="1206315"/>
                  <a:pt x="5488780" y="1171426"/>
                </a:cubicBezTo>
                <a:cubicBezTo>
                  <a:pt x="5502175" y="1156162"/>
                  <a:pt x="5517579" y="1140898"/>
                  <a:pt x="5539513" y="1140353"/>
                </a:cubicBezTo>
                <a:lnTo>
                  <a:pt x="5552720" y="1143022"/>
                </a:lnTo>
                <a:lnTo>
                  <a:pt x="5574208" y="1115811"/>
                </a:lnTo>
                <a:cubicBezTo>
                  <a:pt x="5609034" y="1085646"/>
                  <a:pt x="5659040" y="1068202"/>
                  <a:pt x="5734050" y="1075470"/>
                </a:cubicBezTo>
                <a:cubicBezTo>
                  <a:pt x="5776912" y="1078377"/>
                  <a:pt x="5809058" y="1055118"/>
                  <a:pt x="5798343" y="1020228"/>
                </a:cubicBezTo>
                <a:cubicBezTo>
                  <a:pt x="5776912" y="953357"/>
                  <a:pt x="5837634" y="921375"/>
                  <a:pt x="5884068" y="883578"/>
                </a:cubicBezTo>
                <a:cubicBezTo>
                  <a:pt x="5966221" y="816706"/>
                  <a:pt x="6051947" y="752742"/>
                  <a:pt x="6066234" y="645166"/>
                </a:cubicBezTo>
                <a:cubicBezTo>
                  <a:pt x="6130528" y="665519"/>
                  <a:pt x="6123384" y="700408"/>
                  <a:pt x="6109096" y="732391"/>
                </a:cubicBezTo>
                <a:cubicBezTo>
                  <a:pt x="6073377" y="816706"/>
                  <a:pt x="6034087" y="901023"/>
                  <a:pt x="5998368" y="985338"/>
                </a:cubicBezTo>
                <a:cubicBezTo>
                  <a:pt x="5976937" y="1040581"/>
                  <a:pt x="5944790" y="1095822"/>
                  <a:pt x="5969793" y="1168509"/>
                </a:cubicBezTo>
                <a:cubicBezTo>
                  <a:pt x="6098380" y="1104545"/>
                  <a:pt x="6123384" y="996969"/>
                  <a:pt x="6162674" y="909745"/>
                </a:cubicBezTo>
                <a:cubicBezTo>
                  <a:pt x="6212681" y="802169"/>
                  <a:pt x="6305549" y="738205"/>
                  <a:pt x="6412705" y="659704"/>
                </a:cubicBezTo>
                <a:cubicBezTo>
                  <a:pt x="6441280" y="738205"/>
                  <a:pt x="6362699" y="787632"/>
                  <a:pt x="6366271" y="851596"/>
                </a:cubicBezTo>
                <a:cubicBezTo>
                  <a:pt x="6376987" y="854503"/>
                  <a:pt x="6398418" y="860319"/>
                  <a:pt x="6398418" y="860319"/>
                </a:cubicBezTo>
                <a:cubicBezTo>
                  <a:pt x="6455568" y="755650"/>
                  <a:pt x="6562724" y="709131"/>
                  <a:pt x="6694884" y="691686"/>
                </a:cubicBezTo>
                <a:cubicBezTo>
                  <a:pt x="6762750" y="685871"/>
                  <a:pt x="6784181" y="648074"/>
                  <a:pt x="6816327" y="610277"/>
                </a:cubicBezTo>
                <a:cubicBezTo>
                  <a:pt x="6927056" y="482349"/>
                  <a:pt x="7027068" y="345699"/>
                  <a:pt x="7177087" y="238123"/>
                </a:cubicBezTo>
                <a:cubicBezTo>
                  <a:pt x="7159228" y="363144"/>
                  <a:pt x="7059215" y="461997"/>
                  <a:pt x="7016353" y="592833"/>
                </a:cubicBezTo>
                <a:cubicBezTo>
                  <a:pt x="7180659" y="488164"/>
                  <a:pt x="7266384" y="351513"/>
                  <a:pt x="7366396" y="226493"/>
                </a:cubicBezTo>
                <a:cubicBezTo>
                  <a:pt x="7412830" y="168344"/>
                  <a:pt x="7469981" y="116010"/>
                  <a:pt x="7494984" y="49138"/>
                </a:cubicBezTo>
                <a:cubicBezTo>
                  <a:pt x="7500342" y="31693"/>
                  <a:pt x="7511727" y="4436"/>
                  <a:pt x="7538181" y="484"/>
                </a:cubicBezTo>
                <a:close/>
              </a:path>
            </a:pathLst>
          </a:custGeom>
          <a:solidFill>
            <a:schemeClr val="accent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3661BF5B-7CDE-FB49-A4D2-7FA7A067CA23}"/>
              </a:ext>
            </a:extLst>
          </p:cNvPr>
          <p:cNvSpPr>
            <a:spLocks noGrp="1"/>
          </p:cNvSpPr>
          <p:nvPr>
            <p:ph type="title"/>
          </p:nvPr>
        </p:nvSpPr>
        <p:spPr>
          <a:xfrm>
            <a:off x="838200" y="365125"/>
            <a:ext cx="10515600" cy="1325563"/>
          </a:xfrm>
        </p:spPr>
        <p:txBody>
          <a:bodyPr>
            <a:normAutofit/>
          </a:bodyPr>
          <a:lstStyle/>
          <a:p>
            <a:r>
              <a:rPr lang="en-US" dirty="0"/>
              <a:t>Emotions</a:t>
            </a:r>
          </a:p>
        </p:txBody>
      </p:sp>
      <p:graphicFrame>
        <p:nvGraphicFramePr>
          <p:cNvPr id="7" name="Content Placeholder 4">
            <a:extLst>
              <a:ext uri="{FF2B5EF4-FFF2-40B4-BE49-F238E27FC236}">
                <a16:creationId xmlns:a16="http://schemas.microsoft.com/office/drawing/2014/main" id="{433AE65A-DFC7-9349-1ABD-5AC4A7C985C3}"/>
              </a:ext>
            </a:extLst>
          </p:cNvPr>
          <p:cNvGraphicFramePr>
            <a:graphicFrameLocks noGrp="1"/>
          </p:cNvGraphicFramePr>
          <p:nvPr>
            <p:ph idx="1"/>
            <p:extLst>
              <p:ext uri="{D42A27DB-BD31-4B8C-83A1-F6EECF244321}">
                <p14:modId xmlns:p14="http://schemas.microsoft.com/office/powerpoint/2010/main" val="3872557513"/>
              </p:ext>
            </p:extLst>
          </p:nvPr>
        </p:nvGraphicFramePr>
        <p:xfrm>
          <a:off x="838200" y="2011363"/>
          <a:ext cx="10515600" cy="416083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995932883"/>
      </p:ext>
    </p:extLst>
  </p:cSld>
  <p:clrMapOvr>
    <a:masterClrMapping/>
  </p:clrMapOvr>
</p:sld>
</file>

<file path=ppt/theme/theme1.xml><?xml version="1.0" encoding="utf-8"?>
<a:theme xmlns:a="http://schemas.openxmlformats.org/drawingml/2006/main" name="BrushVTI">
  <a:themeElements>
    <a:clrScheme name="Custom 17">
      <a:dk1>
        <a:sysClr val="windowText" lastClr="000000"/>
      </a:dk1>
      <a:lt1>
        <a:sysClr val="window" lastClr="FFFFFF"/>
      </a:lt1>
      <a:dk2>
        <a:srgbClr val="57495C"/>
      </a:dk2>
      <a:lt2>
        <a:srgbClr val="E7E6E6"/>
      </a:lt2>
      <a:accent1>
        <a:srgbClr val="F07C98"/>
      </a:accent1>
      <a:accent2>
        <a:srgbClr val="A6778D"/>
      </a:accent2>
      <a:accent3>
        <a:srgbClr val="768BA6"/>
      </a:accent3>
      <a:accent4>
        <a:srgbClr val="E8908B"/>
      </a:accent4>
      <a:accent5>
        <a:srgbClr val="C47A93"/>
      </a:accent5>
      <a:accent6>
        <a:srgbClr val="70A8DB"/>
      </a:accent6>
      <a:hlink>
        <a:srgbClr val="EB8067"/>
      </a:hlink>
      <a:folHlink>
        <a:srgbClr val="7BC7C0"/>
      </a:folHlink>
    </a:clrScheme>
    <a:fontScheme name="Custom 3">
      <a:majorFont>
        <a:latin typeface="Elephant"/>
        <a:ea typeface=""/>
        <a:cs typeface=""/>
      </a:majorFont>
      <a:minorFont>
        <a:latin typeface="Century Gothic"/>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BrushVTI" id="{7102FA3A-9D7B-4497-8C4B-FB535AAFDE06}" vid="{C6D41F62-6FAB-440A-BEC7-CB7BF190811F}"/>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593</TotalTime>
  <Words>2811</Words>
  <Application>Microsoft Macintosh PowerPoint</Application>
  <PresentationFormat>Widescreen</PresentationFormat>
  <Paragraphs>133</Paragraphs>
  <Slides>18</Slides>
  <Notes>1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8</vt:i4>
      </vt:variant>
    </vt:vector>
  </HeadingPairs>
  <TitlesOfParts>
    <vt:vector size="23" baseType="lpstr">
      <vt:lpstr>Aptos</vt:lpstr>
      <vt:lpstr>Arial</vt:lpstr>
      <vt:lpstr>Century Gothic</vt:lpstr>
      <vt:lpstr>Elephant</vt:lpstr>
      <vt:lpstr>BrushVTI</vt:lpstr>
      <vt:lpstr>Perioperative Difficult Conversations</vt:lpstr>
      <vt:lpstr>Learning Objectives</vt:lpstr>
      <vt:lpstr>SPIKES</vt:lpstr>
      <vt:lpstr>Setting</vt:lpstr>
      <vt:lpstr>Perception</vt:lpstr>
      <vt:lpstr>Invitation</vt:lpstr>
      <vt:lpstr>Knowledge</vt:lpstr>
      <vt:lpstr>What parents and patients value</vt:lpstr>
      <vt:lpstr>Emotions</vt:lpstr>
      <vt:lpstr>Summarize/Strategize</vt:lpstr>
      <vt:lpstr>NURSE</vt:lpstr>
      <vt:lpstr>Naming</vt:lpstr>
      <vt:lpstr>Understand</vt:lpstr>
      <vt:lpstr>Respect</vt:lpstr>
      <vt:lpstr>Support</vt:lpstr>
      <vt:lpstr>Explore</vt:lpstr>
      <vt:lpstr>Cheat Sheet</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Heather Ballard</dc:creator>
  <cp:lastModifiedBy>Heather Ballard</cp:lastModifiedBy>
  <cp:revision>36</cp:revision>
  <dcterms:created xsi:type="dcterms:W3CDTF">2025-02-20T21:45:08Z</dcterms:created>
  <dcterms:modified xsi:type="dcterms:W3CDTF">2026-05-03T14:02:0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b1b86c14-7a6f-495c-8ad3-202986669410_Enabled">
    <vt:lpwstr>true</vt:lpwstr>
  </property>
  <property fmtid="{D5CDD505-2E9C-101B-9397-08002B2CF9AE}" pid="3" name="MSIP_Label_b1b86c14-7a6f-495c-8ad3-202986669410_SetDate">
    <vt:lpwstr>2025-06-19T15:37:12Z</vt:lpwstr>
  </property>
  <property fmtid="{D5CDD505-2E9C-101B-9397-08002B2CF9AE}" pid="4" name="MSIP_Label_b1b86c14-7a6f-495c-8ad3-202986669410_Method">
    <vt:lpwstr>Standard</vt:lpwstr>
  </property>
  <property fmtid="{D5CDD505-2E9C-101B-9397-08002B2CF9AE}" pid="5" name="MSIP_Label_b1b86c14-7a6f-495c-8ad3-202986669410_Name">
    <vt:lpwstr>Internal</vt:lpwstr>
  </property>
  <property fmtid="{D5CDD505-2E9C-101B-9397-08002B2CF9AE}" pid="6" name="MSIP_Label_b1b86c14-7a6f-495c-8ad3-202986669410_SiteId">
    <vt:lpwstr>2596038f-3ea4-4f0c-aed1-066eb6544c3b</vt:lpwstr>
  </property>
  <property fmtid="{D5CDD505-2E9C-101B-9397-08002B2CF9AE}" pid="7" name="MSIP_Label_b1b86c14-7a6f-495c-8ad3-202986669410_ActionId">
    <vt:lpwstr>0464a1a7-9841-47d2-bcb2-664b10dd7f52</vt:lpwstr>
  </property>
  <property fmtid="{D5CDD505-2E9C-101B-9397-08002B2CF9AE}" pid="8" name="MSIP_Label_b1b86c14-7a6f-495c-8ad3-202986669410_ContentBits">
    <vt:lpwstr>0</vt:lpwstr>
  </property>
  <property fmtid="{D5CDD505-2E9C-101B-9397-08002B2CF9AE}" pid="9" name="MSIP_Label_b1b86c14-7a6f-495c-8ad3-202986669410_Tag">
    <vt:lpwstr>10, 3, 0, 1</vt:lpwstr>
  </property>
</Properties>
</file>